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ink/ink1.xml" ContentType="application/inkml+xml"/>
  <Override PartName="/ppt/ink/ink2.xml" ContentType="application/inkml+xml"/>
  <Override PartName="/ppt/ink/ink3.xml" ContentType="application/inkml+xml"/>
  <Override PartName="/ppt/notesSlides/notesSlide30.xml" ContentType="application/vnd.openxmlformats-officedocument.presentationml.notesSlide+xml"/>
  <Override PartName="/ppt/ink/ink4.xml" ContentType="application/inkml+xml"/>
  <Override PartName="/ppt/ink/ink5.xml" ContentType="application/inkml+xml"/>
  <Override PartName="/ppt/ink/ink6.xml" ContentType="application/inkml+xml"/>
  <Override PartName="/ppt/notesSlides/notesSlide31.xml" ContentType="application/vnd.openxmlformats-officedocument.presentationml.notesSlide+xml"/>
  <Override PartName="/ppt/ink/ink7.xml" ContentType="application/inkml+xml"/>
  <Override PartName="/ppt/ink/ink8.xml" ContentType="application/inkml+xml"/>
  <Override PartName="/ppt/ink/ink9.xml" ContentType="application/inkml+xml"/>
  <Override PartName="/ppt/notesSlides/notesSlide32.xml" ContentType="application/vnd.openxmlformats-officedocument.presentationml.notesSlide+xml"/>
  <Override PartName="/ppt/ink/ink10.xml" ContentType="application/inkml+xml"/>
  <Override PartName="/ppt/ink/ink11.xml" ContentType="application/inkml+xml"/>
  <Override PartName="/ppt/ink/ink12.xml" ContentType="application/inkml+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ink/ink13.xml" ContentType="application/inkml+xml"/>
  <Override PartName="/ppt/ink/ink14.xml" ContentType="application/inkml+xml"/>
  <Override PartName="/ppt/ink/ink15.xml" ContentType="application/inkml+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ink/ink16.xml" ContentType="application/inkml+xml"/>
  <Override PartName="/ppt/ink/ink17.xml" ContentType="application/inkml+xml"/>
  <Override PartName="/ppt/ink/ink18.xml" ContentType="application/inkml+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2.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7" r:id="rId3"/>
  </p:sldMasterIdLst>
  <p:notesMasterIdLst>
    <p:notesMasterId r:id="rId46"/>
  </p:notesMasterIdLst>
  <p:handoutMasterIdLst>
    <p:handoutMasterId r:id="rId47"/>
  </p:handoutMasterIdLst>
  <p:sldIdLst>
    <p:sldId id="256" r:id="rId4"/>
    <p:sldId id="647" r:id="rId5"/>
    <p:sldId id="752" r:id="rId6"/>
    <p:sldId id="692" r:id="rId7"/>
    <p:sldId id="676" r:id="rId8"/>
    <p:sldId id="687" r:id="rId9"/>
    <p:sldId id="698" r:id="rId10"/>
    <p:sldId id="530" r:id="rId11"/>
    <p:sldId id="358" r:id="rId12"/>
    <p:sldId id="699" r:id="rId13"/>
    <p:sldId id="420" r:id="rId14"/>
    <p:sldId id="701" r:id="rId15"/>
    <p:sldId id="730" r:id="rId16"/>
    <p:sldId id="725" r:id="rId17"/>
    <p:sldId id="726" r:id="rId18"/>
    <p:sldId id="727" r:id="rId19"/>
    <p:sldId id="728" r:id="rId20"/>
    <p:sldId id="732" r:id="rId21"/>
    <p:sldId id="733" r:id="rId22"/>
    <p:sldId id="710" r:id="rId23"/>
    <p:sldId id="579" r:id="rId24"/>
    <p:sldId id="734" r:id="rId25"/>
    <p:sldId id="736" r:id="rId26"/>
    <p:sldId id="659" r:id="rId27"/>
    <p:sldId id="735" r:id="rId28"/>
    <p:sldId id="739" r:id="rId29"/>
    <p:sldId id="740" r:id="rId30"/>
    <p:sldId id="562" r:id="rId31"/>
    <p:sldId id="746" r:id="rId32"/>
    <p:sldId id="742" r:id="rId33"/>
    <p:sldId id="743" r:id="rId34"/>
    <p:sldId id="744" r:id="rId35"/>
    <p:sldId id="634" r:id="rId36"/>
    <p:sldId id="745" r:id="rId37"/>
    <p:sldId id="747" r:id="rId38"/>
    <p:sldId id="748" r:id="rId39"/>
    <p:sldId id="741" r:id="rId40"/>
    <p:sldId id="578" r:id="rId41"/>
    <p:sldId id="749" r:id="rId42"/>
    <p:sldId id="750" r:id="rId43"/>
    <p:sldId id="298" r:id="rId44"/>
    <p:sldId id="697" r:id="rId45"/>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9797"/>
    <a:srgbClr val="FFF275"/>
    <a:srgbClr val="FFE701"/>
    <a:srgbClr val="EED700"/>
    <a:srgbClr val="33CC33"/>
    <a:srgbClr val="996633"/>
    <a:srgbClr val="000086"/>
    <a:srgbClr val="00A852"/>
    <a:srgbClr val="B9B9B9"/>
    <a:srgbClr val="00B05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6388" autoAdjust="0"/>
    <p:restoredTop sz="68990" autoAdjust="0"/>
  </p:normalViewPr>
  <p:slideViewPr>
    <p:cSldViewPr>
      <p:cViewPr varScale="1">
        <p:scale>
          <a:sx n="53" d="100"/>
          <a:sy n="53" d="100"/>
        </p:scale>
        <p:origin x="1248" y="4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notesViewPr>
    <p:cSldViewPr>
      <p:cViewPr varScale="1">
        <p:scale>
          <a:sx n="58" d="100"/>
          <a:sy n="58" d="100"/>
        </p:scale>
        <p:origin x="2516" y="44"/>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slide" Target="slides/slide36.xml"/><Relationship Id="rId21" Type="http://schemas.openxmlformats.org/officeDocument/2006/relationships/slide" Target="slides/slide18.xml"/><Relationship Id="rId34" Type="http://schemas.openxmlformats.org/officeDocument/2006/relationships/slide" Target="slides/slide31.xml"/><Relationship Id="rId42" Type="http://schemas.openxmlformats.org/officeDocument/2006/relationships/slide" Target="slides/slide39.xml"/><Relationship Id="rId47" Type="http://schemas.openxmlformats.org/officeDocument/2006/relationships/handoutMaster" Target="handoutMasters/handoutMaster1.xml"/><Relationship Id="rId50" Type="http://schemas.openxmlformats.org/officeDocument/2006/relationships/theme" Target="theme/theme1.xml"/><Relationship Id="rId7" Type="http://schemas.openxmlformats.org/officeDocument/2006/relationships/slide" Target="slides/slide4.xml"/><Relationship Id="rId2" Type="http://schemas.openxmlformats.org/officeDocument/2006/relationships/customXml" Target="../customXml/item2.xml"/><Relationship Id="rId16" Type="http://schemas.openxmlformats.org/officeDocument/2006/relationships/slide" Target="slides/slide13.xml"/><Relationship Id="rId29" Type="http://schemas.openxmlformats.org/officeDocument/2006/relationships/slide" Target="slides/slide26.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slide" Target="slides/slide34.xml"/><Relationship Id="rId40" Type="http://schemas.openxmlformats.org/officeDocument/2006/relationships/slide" Target="slides/slide37.xml"/><Relationship Id="rId45" Type="http://schemas.openxmlformats.org/officeDocument/2006/relationships/slide" Target="slides/slide42.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49" Type="http://schemas.openxmlformats.org/officeDocument/2006/relationships/viewProps" Target="viewProps.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slide" Target="slides/slide28.xml"/><Relationship Id="rId44" Type="http://schemas.openxmlformats.org/officeDocument/2006/relationships/slide" Target="slides/slide41.xml"/><Relationship Id="rId52" Type="http://schemas.microsoft.com/office/2016/11/relationships/changesInfo" Target="changesInfos/changesInfo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 Id="rId43" Type="http://schemas.openxmlformats.org/officeDocument/2006/relationships/slide" Target="slides/slide40.xml"/><Relationship Id="rId48" Type="http://schemas.openxmlformats.org/officeDocument/2006/relationships/presProps" Target="presProps.xml"/><Relationship Id="rId8" Type="http://schemas.openxmlformats.org/officeDocument/2006/relationships/slide" Target="slides/slide5.xml"/><Relationship Id="rId51" Type="http://schemas.openxmlformats.org/officeDocument/2006/relationships/tableStyles" Target="tableStyles.xml"/><Relationship Id="rId3" Type="http://schemas.openxmlformats.org/officeDocument/2006/relationships/slideMaster" Target="slideMasters/slideMaster1.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slide" Target="slides/slide35.xml"/><Relationship Id="rId46" Type="http://schemas.openxmlformats.org/officeDocument/2006/relationships/notesMaster" Target="notesMasters/notesMaster1.xml"/><Relationship Id="rId20" Type="http://schemas.openxmlformats.org/officeDocument/2006/relationships/slide" Target="slides/slide17.xml"/><Relationship Id="rId41" Type="http://schemas.openxmlformats.org/officeDocument/2006/relationships/slide" Target="slides/slide38.xml"/><Relationship Id="rId1" Type="http://schemas.openxmlformats.org/officeDocument/2006/relationships/customXml" Target="../customXml/item1.xml"/><Relationship Id="rId6" Type="http://schemas.openxmlformats.org/officeDocument/2006/relationships/slide" Target="slides/slide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CF2A22AE-906D-4DF7-B9A2-807F8414A5D7}"/>
    <pc:docChg chg="modSld">
      <pc:chgData name="Charles Rhoads" userId="4e3119f2-0491-4713-8c5f-db334eb91838" providerId="ADAL" clId="{CF2A22AE-906D-4DF7-B9A2-807F8414A5D7}" dt="2023-04-18T15:13:37.706" v="11" actId="6549"/>
      <pc:docMkLst>
        <pc:docMk/>
      </pc:docMkLst>
      <pc:sldChg chg="modSp mod">
        <pc:chgData name="Charles Rhoads" userId="4e3119f2-0491-4713-8c5f-db334eb91838" providerId="ADAL" clId="{CF2A22AE-906D-4DF7-B9A2-807F8414A5D7}" dt="2023-04-18T15:13:37.706" v="11" actId="6549"/>
        <pc:sldMkLst>
          <pc:docMk/>
          <pc:sldMk cId="0" sldId="256"/>
        </pc:sldMkLst>
        <pc:spChg chg="mod">
          <ac:chgData name="Charles Rhoads" userId="4e3119f2-0491-4713-8c5f-db334eb91838" providerId="ADAL" clId="{CF2A22AE-906D-4DF7-B9A2-807F8414A5D7}" dt="2023-04-18T15:13:37.706" v="11" actId="6549"/>
          <ac:spMkLst>
            <pc:docMk/>
            <pc:sldMk cId="0" sldId="256"/>
            <ac:spMk id="2050" creationId="{00000000-0000-0000-0000-000000000000}"/>
          </ac:spMkLst>
        </pc:spChg>
      </pc:sldChg>
      <pc:sldChg chg="modNotesTx">
        <pc:chgData name="Charles Rhoads" userId="4e3119f2-0491-4713-8c5f-db334eb91838" providerId="ADAL" clId="{CF2A22AE-906D-4DF7-B9A2-807F8414A5D7}" dt="2023-04-18T15:13:30.706" v="5" actId="6549"/>
        <pc:sldMkLst>
          <pc:docMk/>
          <pc:sldMk cId="2225112996" sldId="699"/>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2DA5EEF9-6167-4411-B135-1872F4F4FB44}"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B5BE0D82-B57E-4313-9BF9-5AB24EB95836}">
      <dgm:prSet phldrT="[Text]"/>
      <dgm:spPr>
        <a:solidFill>
          <a:srgbClr val="FFE701"/>
        </a:solidFill>
      </dgm:spPr>
      <dgm:t>
        <a:bodyPr/>
        <a:lstStyle/>
        <a:p>
          <a:r>
            <a:rPr lang="en-US" dirty="0"/>
            <a:t>Reframe</a:t>
          </a:r>
        </a:p>
      </dgm:t>
    </dgm:pt>
    <dgm:pt modelId="{A06E99C2-6E97-4095-94CE-53B0E9FAB3E2}" type="parTrans" cxnId="{D0F98494-F4B2-4AF8-9EE0-D7B1DF5C2658}">
      <dgm:prSet/>
      <dgm:spPr/>
      <dgm:t>
        <a:bodyPr/>
        <a:lstStyle/>
        <a:p>
          <a:endParaRPr lang="en-US"/>
        </a:p>
      </dgm:t>
    </dgm:pt>
    <dgm:pt modelId="{A49F6D3C-5A65-4203-A80B-3494961EDD48}" type="sibTrans" cxnId="{D0F98494-F4B2-4AF8-9EE0-D7B1DF5C2658}">
      <dgm:prSet/>
      <dgm:spPr/>
      <dgm:t>
        <a:bodyPr/>
        <a:lstStyle/>
        <a:p>
          <a:endParaRPr lang="en-US"/>
        </a:p>
      </dgm:t>
    </dgm:pt>
    <dgm:pt modelId="{3B0DB532-C0FC-4E7A-9C86-168AA92A0170}">
      <dgm:prSet phldrT="[Text]"/>
      <dgm:spPr>
        <a:solidFill>
          <a:srgbClr val="FFF275">
            <a:alpha val="89804"/>
          </a:srgbClr>
        </a:solidFill>
      </dgm:spPr>
      <dgm:t>
        <a:bodyPr/>
        <a:lstStyle/>
        <a:p>
          <a:r>
            <a:rPr lang="en-US" dirty="0"/>
            <a:t>Mediators resist interpretations of behavior based on pathology or character</a:t>
          </a:r>
        </a:p>
      </dgm:t>
    </dgm:pt>
    <dgm:pt modelId="{008EBD4C-1064-423E-B733-07071BA10FFE}" type="parTrans" cxnId="{6862C9CB-02D1-40A5-8DAC-08904071332A}">
      <dgm:prSet/>
      <dgm:spPr/>
      <dgm:t>
        <a:bodyPr/>
        <a:lstStyle/>
        <a:p>
          <a:endParaRPr lang="en-US"/>
        </a:p>
      </dgm:t>
    </dgm:pt>
    <dgm:pt modelId="{7CDFD194-52BA-4486-BFC7-2423151F54CC}" type="sibTrans" cxnId="{6862C9CB-02D1-40A5-8DAC-08904071332A}">
      <dgm:prSet/>
      <dgm:spPr/>
      <dgm:t>
        <a:bodyPr/>
        <a:lstStyle/>
        <a:p>
          <a:endParaRPr lang="en-US"/>
        </a:p>
      </dgm:t>
    </dgm:pt>
    <dgm:pt modelId="{3059BD48-F8AF-4F93-9444-12F446CD2526}">
      <dgm:prSet phldrT="[Text]"/>
      <dgm:spPr>
        <a:solidFill>
          <a:srgbClr val="FFF275">
            <a:alpha val="89804"/>
          </a:srgbClr>
        </a:solidFill>
      </dgm:spPr>
      <dgm:t>
        <a:bodyPr/>
        <a:lstStyle/>
        <a:p>
          <a:r>
            <a:rPr lang="en-US" dirty="0"/>
            <a:t>Focusing on misperceptions, miscommunication, misunderstanding, misinterpretation, &amp; bias is more constructive</a:t>
          </a:r>
        </a:p>
      </dgm:t>
    </dgm:pt>
    <dgm:pt modelId="{C845FF74-5E99-4747-B82D-41E4ADF71A49}" type="parTrans" cxnId="{B964D0A5-26CC-4CE1-812C-B441AA2A5959}">
      <dgm:prSet/>
      <dgm:spPr/>
      <dgm:t>
        <a:bodyPr/>
        <a:lstStyle/>
        <a:p>
          <a:endParaRPr lang="en-US"/>
        </a:p>
      </dgm:t>
    </dgm:pt>
    <dgm:pt modelId="{3E762ABA-258D-4302-B113-7D5C07C8F7C1}" type="sibTrans" cxnId="{B964D0A5-26CC-4CE1-812C-B441AA2A5959}">
      <dgm:prSet/>
      <dgm:spPr/>
      <dgm:t>
        <a:bodyPr/>
        <a:lstStyle/>
        <a:p>
          <a:endParaRPr lang="en-US"/>
        </a:p>
      </dgm:t>
    </dgm:pt>
    <dgm:pt modelId="{854F5BAC-FD99-42B7-8A31-C33C61D39D93}">
      <dgm:prSet phldrT="[Text]"/>
      <dgm:spPr>
        <a:solidFill>
          <a:srgbClr val="FF0000"/>
        </a:solidFill>
      </dgm:spPr>
      <dgm:t>
        <a:bodyPr/>
        <a:lstStyle/>
        <a:p>
          <a:r>
            <a:rPr lang="en-US" dirty="0"/>
            <a:t>360° View</a:t>
          </a:r>
        </a:p>
      </dgm:t>
    </dgm:pt>
    <dgm:pt modelId="{622C93C4-AFDE-4D14-A675-046993D956F2}" type="parTrans" cxnId="{D6FB34BE-9FE7-4050-A4B1-3F1CE17349AF}">
      <dgm:prSet/>
      <dgm:spPr/>
      <dgm:t>
        <a:bodyPr/>
        <a:lstStyle/>
        <a:p>
          <a:endParaRPr lang="en-US"/>
        </a:p>
      </dgm:t>
    </dgm:pt>
    <dgm:pt modelId="{22D7E520-1634-4CF4-8FB3-B9C243193523}" type="sibTrans" cxnId="{D6FB34BE-9FE7-4050-A4B1-3F1CE17349AF}">
      <dgm:prSet/>
      <dgm:spPr/>
      <dgm:t>
        <a:bodyPr/>
        <a:lstStyle/>
        <a:p>
          <a:endParaRPr lang="en-US"/>
        </a:p>
      </dgm:t>
    </dgm:pt>
    <dgm:pt modelId="{54976FAA-10AA-4B6C-8481-AF744410E27E}">
      <dgm:prSet phldrT="[Text]"/>
      <dgm:spPr>
        <a:solidFill>
          <a:srgbClr val="FF9797">
            <a:alpha val="89804"/>
          </a:srgbClr>
        </a:solidFill>
      </dgm:spPr>
      <dgm:t>
        <a:bodyPr/>
        <a:lstStyle/>
        <a:p>
          <a:r>
            <a:rPr lang="en-US" dirty="0"/>
            <a:t>Any diagnosis of the problem that is not accepted by all stakeholders is fatally flawed (i.e., it will prevent effective resolution) </a:t>
          </a:r>
        </a:p>
      </dgm:t>
    </dgm:pt>
    <dgm:pt modelId="{3CA2AE0B-19FF-486B-AA4A-893A164B0E3E}" type="parTrans" cxnId="{857D49B2-ED5F-4BEC-B3EA-5A1B197023F0}">
      <dgm:prSet/>
      <dgm:spPr/>
      <dgm:t>
        <a:bodyPr/>
        <a:lstStyle/>
        <a:p>
          <a:endParaRPr lang="en-US"/>
        </a:p>
      </dgm:t>
    </dgm:pt>
    <dgm:pt modelId="{4A3BDE25-6237-48CC-80AF-1AEADD519BC2}" type="sibTrans" cxnId="{857D49B2-ED5F-4BEC-B3EA-5A1B197023F0}">
      <dgm:prSet/>
      <dgm:spPr/>
      <dgm:t>
        <a:bodyPr/>
        <a:lstStyle/>
        <a:p>
          <a:endParaRPr lang="en-US"/>
        </a:p>
      </dgm:t>
    </dgm:pt>
    <dgm:pt modelId="{7EBB3338-6009-4A66-98C6-499B80DFFC3B}">
      <dgm:prSet phldrT="[Text]"/>
      <dgm:spPr>
        <a:solidFill>
          <a:srgbClr val="FF9797">
            <a:alpha val="89804"/>
          </a:srgbClr>
        </a:solidFill>
      </dgm:spPr>
      <dgm:t>
        <a:bodyPr/>
        <a:lstStyle/>
        <a:p>
          <a:r>
            <a:rPr lang="en-US" dirty="0"/>
            <a:t>Mediators seek the perspective from everyone, a.k.a. the "View from Everywhere"</a:t>
          </a:r>
        </a:p>
      </dgm:t>
    </dgm:pt>
    <dgm:pt modelId="{62317B4A-22AE-407F-921D-F68071A0410B}" type="parTrans" cxnId="{C9E99177-7B0B-49D0-984D-749C7C7F6976}">
      <dgm:prSet/>
      <dgm:spPr/>
      <dgm:t>
        <a:bodyPr/>
        <a:lstStyle/>
        <a:p>
          <a:endParaRPr lang="en-US"/>
        </a:p>
      </dgm:t>
    </dgm:pt>
    <dgm:pt modelId="{82303D66-F2DE-45D7-890A-BA8FA1378751}" type="sibTrans" cxnId="{C9E99177-7B0B-49D0-984D-749C7C7F6976}">
      <dgm:prSet/>
      <dgm:spPr/>
      <dgm:t>
        <a:bodyPr/>
        <a:lstStyle/>
        <a:p>
          <a:endParaRPr lang="en-US"/>
        </a:p>
      </dgm:t>
    </dgm:pt>
    <dgm:pt modelId="{EDD9F41F-A977-4C66-8B94-3CF27C022345}">
      <dgm:prSet phldrT="[Text]"/>
      <dgm:spPr>
        <a:solidFill>
          <a:schemeClr val="bg2">
            <a:lumMod val="50000"/>
          </a:schemeClr>
        </a:solidFill>
      </dgm:spPr>
      <dgm:t>
        <a:bodyPr/>
        <a:lstStyle/>
        <a:p>
          <a:pPr algn="l"/>
          <a:r>
            <a:rPr lang="en-US" dirty="0"/>
            <a:t>Interests</a:t>
          </a:r>
        </a:p>
      </dgm:t>
    </dgm:pt>
    <dgm:pt modelId="{65E31FAD-F50D-4FCF-9D6F-A71B899D9701}" type="parTrans" cxnId="{3EF56B18-765D-475F-8E56-B6EA6FA8C902}">
      <dgm:prSet/>
      <dgm:spPr/>
      <dgm:t>
        <a:bodyPr/>
        <a:lstStyle/>
        <a:p>
          <a:endParaRPr lang="en-US"/>
        </a:p>
      </dgm:t>
    </dgm:pt>
    <dgm:pt modelId="{E123CE69-F385-4B77-8FF8-38784A481BBA}" type="sibTrans" cxnId="{3EF56B18-765D-475F-8E56-B6EA6FA8C902}">
      <dgm:prSet/>
      <dgm:spPr/>
      <dgm:t>
        <a:bodyPr/>
        <a:lstStyle/>
        <a:p>
          <a:endParaRPr lang="en-US"/>
        </a:p>
      </dgm:t>
    </dgm:pt>
    <dgm:pt modelId="{25FBD0C1-9464-4417-93F7-8F118A8D04DC}">
      <dgm:prSet phldrT="[Text]"/>
      <dgm:spPr/>
      <dgm:t>
        <a:bodyPr/>
        <a:lstStyle/>
        <a:p>
          <a:pPr>
            <a:buClr>
              <a:schemeClr val="tx1"/>
            </a:buClr>
          </a:pPr>
          <a:r>
            <a:rPr lang="en-US" dirty="0">
              <a:solidFill>
                <a:schemeClr val="tx1"/>
              </a:solidFill>
              <a:effectLst/>
            </a:rPr>
            <a:t>Mediators do not fixate on the stakeholders’ positions but instead try to uncover their interests</a:t>
          </a:r>
          <a:endParaRPr lang="en-US" dirty="0">
            <a:solidFill>
              <a:schemeClr val="tx1"/>
            </a:solidFill>
          </a:endParaRPr>
        </a:p>
      </dgm:t>
    </dgm:pt>
    <dgm:pt modelId="{18D238D3-69DF-4C46-8271-B77B83739187}" type="parTrans" cxnId="{9E2CD384-9D8B-460F-AA37-CE8847B2057E}">
      <dgm:prSet/>
      <dgm:spPr/>
      <dgm:t>
        <a:bodyPr/>
        <a:lstStyle/>
        <a:p>
          <a:endParaRPr lang="en-US"/>
        </a:p>
      </dgm:t>
    </dgm:pt>
    <dgm:pt modelId="{7D992F46-5A5F-4FD5-B080-E82CBCD89D0E}" type="sibTrans" cxnId="{9E2CD384-9D8B-460F-AA37-CE8847B2057E}">
      <dgm:prSet/>
      <dgm:spPr/>
      <dgm:t>
        <a:bodyPr/>
        <a:lstStyle/>
        <a:p>
          <a:endParaRPr lang="en-US"/>
        </a:p>
      </dgm:t>
    </dgm:pt>
    <dgm:pt modelId="{97C16781-537B-439B-8D0F-13C8314AF110}">
      <dgm:prSet/>
      <dgm:spPr/>
      <dgm:t>
        <a:bodyPr/>
        <a:lstStyle/>
        <a:p>
          <a:r>
            <a:rPr lang="en-US" dirty="0">
              <a:solidFill>
                <a:schemeClr val="tx1"/>
              </a:solidFill>
              <a:effectLst/>
            </a:rPr>
            <a:t>Resolution of a conflict requires illumination of the underlying concerns of the parties</a:t>
          </a:r>
        </a:p>
      </dgm:t>
    </dgm:pt>
    <dgm:pt modelId="{E4313735-1C13-49B6-9E7B-A96BFA84896B}" type="parTrans" cxnId="{FFE32C12-CC70-4EBC-9739-0DDDE97E21A0}">
      <dgm:prSet/>
      <dgm:spPr/>
      <dgm:t>
        <a:bodyPr/>
        <a:lstStyle/>
        <a:p>
          <a:endParaRPr lang="en-US"/>
        </a:p>
      </dgm:t>
    </dgm:pt>
    <dgm:pt modelId="{2A450769-9633-42EE-9B11-1A7D8941B6C0}" type="sibTrans" cxnId="{FFE32C12-CC70-4EBC-9739-0DDDE97E21A0}">
      <dgm:prSet/>
      <dgm:spPr/>
      <dgm:t>
        <a:bodyPr/>
        <a:lstStyle/>
        <a:p>
          <a:endParaRPr lang="en-US"/>
        </a:p>
      </dgm:t>
    </dgm:pt>
    <dgm:pt modelId="{0199CD2E-9BCD-4B24-B010-709D573A4DA7}" type="pres">
      <dgm:prSet presAssocID="{2DA5EEF9-6167-4411-B135-1872F4F4FB44}" presName="Name0" presStyleCnt="0">
        <dgm:presLayoutVars>
          <dgm:dir/>
          <dgm:animLvl val="lvl"/>
          <dgm:resizeHandles val="exact"/>
        </dgm:presLayoutVars>
      </dgm:prSet>
      <dgm:spPr/>
    </dgm:pt>
    <dgm:pt modelId="{A7B5465D-5B1F-4547-8CE4-A81915B3FD35}" type="pres">
      <dgm:prSet presAssocID="{B5BE0D82-B57E-4313-9BF9-5AB24EB95836}" presName="linNode" presStyleCnt="0"/>
      <dgm:spPr/>
    </dgm:pt>
    <dgm:pt modelId="{4A834879-C1C4-4BB2-9D5B-247EC55400B9}" type="pres">
      <dgm:prSet presAssocID="{B5BE0D82-B57E-4313-9BF9-5AB24EB95836}" presName="parentText" presStyleLbl="node1" presStyleIdx="0" presStyleCnt="3" custScaleX="79539" custScaleY="101448" custLinFactNeighborY="5908">
        <dgm:presLayoutVars>
          <dgm:chMax val="1"/>
          <dgm:bulletEnabled val="1"/>
        </dgm:presLayoutVars>
      </dgm:prSet>
      <dgm:spPr/>
    </dgm:pt>
    <dgm:pt modelId="{DEA41C13-F06E-40F9-BF60-7F976B370D2D}" type="pres">
      <dgm:prSet presAssocID="{B5BE0D82-B57E-4313-9BF9-5AB24EB95836}" presName="descendantText" presStyleLbl="alignAccFollowNode1" presStyleIdx="0" presStyleCnt="3" custScaleX="110016" custScaleY="116059" custLinFactNeighborX="348" custLinFactNeighborY="3685">
        <dgm:presLayoutVars>
          <dgm:bulletEnabled val="1"/>
        </dgm:presLayoutVars>
      </dgm:prSet>
      <dgm:spPr/>
    </dgm:pt>
    <dgm:pt modelId="{F06E3112-633C-42B8-9DB5-3F5BEADC23A6}" type="pres">
      <dgm:prSet presAssocID="{A49F6D3C-5A65-4203-A80B-3494961EDD48}" presName="sp" presStyleCnt="0"/>
      <dgm:spPr/>
    </dgm:pt>
    <dgm:pt modelId="{26CD779C-C50C-49FE-A096-238209672F9D}" type="pres">
      <dgm:prSet presAssocID="{854F5BAC-FD99-42B7-8A31-C33C61D39D93}" presName="linNode" presStyleCnt="0"/>
      <dgm:spPr/>
    </dgm:pt>
    <dgm:pt modelId="{F6F0A641-73E2-4760-BAEB-8244D0250C56}" type="pres">
      <dgm:prSet presAssocID="{854F5BAC-FD99-42B7-8A31-C33C61D39D93}" presName="parentText" presStyleLbl="node1" presStyleIdx="1" presStyleCnt="3" custScaleX="95002">
        <dgm:presLayoutVars>
          <dgm:chMax val="1"/>
          <dgm:bulletEnabled val="1"/>
        </dgm:presLayoutVars>
      </dgm:prSet>
      <dgm:spPr/>
    </dgm:pt>
    <dgm:pt modelId="{91FE9DB4-344F-4DB2-9CD2-8C76A87949D7}" type="pres">
      <dgm:prSet presAssocID="{854F5BAC-FD99-42B7-8A31-C33C61D39D93}" presName="descendantText" presStyleLbl="alignAccFollowNode1" presStyleIdx="1" presStyleCnt="3" custScaleX="110308" custScaleY="122943">
        <dgm:presLayoutVars>
          <dgm:bulletEnabled val="1"/>
        </dgm:presLayoutVars>
      </dgm:prSet>
      <dgm:spPr/>
    </dgm:pt>
    <dgm:pt modelId="{3206F37D-FCD4-4550-8388-972C9FABDDD6}" type="pres">
      <dgm:prSet presAssocID="{22D7E520-1634-4CF4-8FB3-B9C243193523}" presName="sp" presStyleCnt="0"/>
      <dgm:spPr/>
    </dgm:pt>
    <dgm:pt modelId="{8FAB4417-7AB7-406F-AE07-01B7A3C6F5F0}" type="pres">
      <dgm:prSet presAssocID="{EDD9F41F-A977-4C66-8B94-3CF27C022345}" presName="linNode" presStyleCnt="0"/>
      <dgm:spPr/>
    </dgm:pt>
    <dgm:pt modelId="{F90342F5-9C71-4C52-97CA-DD6DFC77BDA7}" type="pres">
      <dgm:prSet presAssocID="{EDD9F41F-A977-4C66-8B94-3CF27C022345}" presName="parentText" presStyleLbl="node1" presStyleIdx="2" presStyleCnt="3">
        <dgm:presLayoutVars>
          <dgm:chMax val="1"/>
          <dgm:bulletEnabled val="1"/>
        </dgm:presLayoutVars>
      </dgm:prSet>
      <dgm:spPr/>
    </dgm:pt>
    <dgm:pt modelId="{65557CB9-33D9-4224-8CE5-CC2296715CFB}" type="pres">
      <dgm:prSet presAssocID="{EDD9F41F-A977-4C66-8B94-3CF27C022345}" presName="descendantText" presStyleLbl="alignAccFollowNode1" presStyleIdx="2" presStyleCnt="3">
        <dgm:presLayoutVars>
          <dgm:bulletEnabled val="1"/>
        </dgm:presLayoutVars>
      </dgm:prSet>
      <dgm:spPr/>
    </dgm:pt>
  </dgm:ptLst>
  <dgm:cxnLst>
    <dgm:cxn modelId="{EB481401-7D38-423C-B30A-56F3BAD48A73}" type="presOf" srcId="{97C16781-537B-439B-8D0F-13C8314AF110}" destId="{65557CB9-33D9-4224-8CE5-CC2296715CFB}" srcOrd="0" destOrd="1" presId="urn:microsoft.com/office/officeart/2005/8/layout/vList5"/>
    <dgm:cxn modelId="{FFE32C12-CC70-4EBC-9739-0DDDE97E21A0}" srcId="{EDD9F41F-A977-4C66-8B94-3CF27C022345}" destId="{97C16781-537B-439B-8D0F-13C8314AF110}" srcOrd="1" destOrd="0" parTransId="{E4313735-1C13-49B6-9E7B-A96BFA84896B}" sibTransId="{2A450769-9633-42EE-9B11-1A7D8941B6C0}"/>
    <dgm:cxn modelId="{3EF56B18-765D-475F-8E56-B6EA6FA8C902}" srcId="{2DA5EEF9-6167-4411-B135-1872F4F4FB44}" destId="{EDD9F41F-A977-4C66-8B94-3CF27C022345}" srcOrd="2" destOrd="0" parTransId="{65E31FAD-F50D-4FCF-9D6F-A71B899D9701}" sibTransId="{E123CE69-F385-4B77-8FF8-38784A481BBA}"/>
    <dgm:cxn modelId="{955B4D24-2D0C-474F-8B24-E57D774D3F3F}" type="presOf" srcId="{854F5BAC-FD99-42B7-8A31-C33C61D39D93}" destId="{F6F0A641-73E2-4760-BAEB-8244D0250C56}" srcOrd="0" destOrd="0" presId="urn:microsoft.com/office/officeart/2005/8/layout/vList5"/>
    <dgm:cxn modelId="{7C54E369-7D55-424C-B6FA-EE523694F2AA}" type="presOf" srcId="{2DA5EEF9-6167-4411-B135-1872F4F4FB44}" destId="{0199CD2E-9BCD-4B24-B010-709D573A4DA7}" srcOrd="0" destOrd="0" presId="urn:microsoft.com/office/officeart/2005/8/layout/vList5"/>
    <dgm:cxn modelId="{505E576D-BE37-4188-8619-15A7F8C29545}" type="presOf" srcId="{3B0DB532-C0FC-4E7A-9C86-168AA92A0170}" destId="{DEA41C13-F06E-40F9-BF60-7F976B370D2D}" srcOrd="0" destOrd="0" presId="urn:microsoft.com/office/officeart/2005/8/layout/vList5"/>
    <dgm:cxn modelId="{3D0D0975-4713-4274-8BBA-1614E671EFF3}" type="presOf" srcId="{B5BE0D82-B57E-4313-9BF9-5AB24EB95836}" destId="{4A834879-C1C4-4BB2-9D5B-247EC55400B9}" srcOrd="0" destOrd="0" presId="urn:microsoft.com/office/officeart/2005/8/layout/vList5"/>
    <dgm:cxn modelId="{C9E99177-7B0B-49D0-984D-749C7C7F6976}" srcId="{854F5BAC-FD99-42B7-8A31-C33C61D39D93}" destId="{7EBB3338-6009-4A66-98C6-499B80DFFC3B}" srcOrd="1" destOrd="0" parTransId="{62317B4A-22AE-407F-921D-F68071A0410B}" sibTransId="{82303D66-F2DE-45D7-890A-BA8FA1378751}"/>
    <dgm:cxn modelId="{9E2CD384-9D8B-460F-AA37-CE8847B2057E}" srcId="{EDD9F41F-A977-4C66-8B94-3CF27C022345}" destId="{25FBD0C1-9464-4417-93F7-8F118A8D04DC}" srcOrd="0" destOrd="0" parTransId="{18D238D3-69DF-4C46-8271-B77B83739187}" sibTransId="{7D992F46-5A5F-4FD5-B080-E82CBCD89D0E}"/>
    <dgm:cxn modelId="{D0F98494-F4B2-4AF8-9EE0-D7B1DF5C2658}" srcId="{2DA5EEF9-6167-4411-B135-1872F4F4FB44}" destId="{B5BE0D82-B57E-4313-9BF9-5AB24EB95836}" srcOrd="0" destOrd="0" parTransId="{A06E99C2-6E97-4095-94CE-53B0E9FAB3E2}" sibTransId="{A49F6D3C-5A65-4203-A80B-3494961EDD48}"/>
    <dgm:cxn modelId="{E9ACB29A-098A-41A8-AA77-F313D0E9D1AD}" type="presOf" srcId="{7EBB3338-6009-4A66-98C6-499B80DFFC3B}" destId="{91FE9DB4-344F-4DB2-9CD2-8C76A87949D7}" srcOrd="0" destOrd="1" presId="urn:microsoft.com/office/officeart/2005/8/layout/vList5"/>
    <dgm:cxn modelId="{B964D0A5-26CC-4CE1-812C-B441AA2A5959}" srcId="{B5BE0D82-B57E-4313-9BF9-5AB24EB95836}" destId="{3059BD48-F8AF-4F93-9444-12F446CD2526}" srcOrd="1" destOrd="0" parTransId="{C845FF74-5E99-4747-B82D-41E4ADF71A49}" sibTransId="{3E762ABA-258D-4302-B113-7D5C07C8F7C1}"/>
    <dgm:cxn modelId="{D37212A8-0DEA-496D-ABFF-32206CF45E4A}" type="presOf" srcId="{54976FAA-10AA-4B6C-8481-AF744410E27E}" destId="{91FE9DB4-344F-4DB2-9CD2-8C76A87949D7}" srcOrd="0" destOrd="0" presId="urn:microsoft.com/office/officeart/2005/8/layout/vList5"/>
    <dgm:cxn modelId="{857D49B2-ED5F-4BEC-B3EA-5A1B197023F0}" srcId="{854F5BAC-FD99-42B7-8A31-C33C61D39D93}" destId="{54976FAA-10AA-4B6C-8481-AF744410E27E}" srcOrd="0" destOrd="0" parTransId="{3CA2AE0B-19FF-486B-AA4A-893A164B0E3E}" sibTransId="{4A3BDE25-6237-48CC-80AF-1AEADD519BC2}"/>
    <dgm:cxn modelId="{D6FB34BE-9FE7-4050-A4B1-3F1CE17349AF}" srcId="{2DA5EEF9-6167-4411-B135-1872F4F4FB44}" destId="{854F5BAC-FD99-42B7-8A31-C33C61D39D93}" srcOrd="1" destOrd="0" parTransId="{622C93C4-AFDE-4D14-A675-046993D956F2}" sibTransId="{22D7E520-1634-4CF4-8FB3-B9C243193523}"/>
    <dgm:cxn modelId="{6862C9CB-02D1-40A5-8DAC-08904071332A}" srcId="{B5BE0D82-B57E-4313-9BF9-5AB24EB95836}" destId="{3B0DB532-C0FC-4E7A-9C86-168AA92A0170}" srcOrd="0" destOrd="0" parTransId="{008EBD4C-1064-423E-B733-07071BA10FFE}" sibTransId="{7CDFD194-52BA-4486-BFC7-2423151F54CC}"/>
    <dgm:cxn modelId="{B3BF6DD2-3874-4002-8E47-BC613787BF61}" type="presOf" srcId="{3059BD48-F8AF-4F93-9444-12F446CD2526}" destId="{DEA41C13-F06E-40F9-BF60-7F976B370D2D}" srcOrd="0" destOrd="1" presId="urn:microsoft.com/office/officeart/2005/8/layout/vList5"/>
    <dgm:cxn modelId="{490549DA-9A56-4C19-A7FF-27686A53DDE9}" type="presOf" srcId="{25FBD0C1-9464-4417-93F7-8F118A8D04DC}" destId="{65557CB9-33D9-4224-8CE5-CC2296715CFB}" srcOrd="0" destOrd="0" presId="urn:microsoft.com/office/officeart/2005/8/layout/vList5"/>
    <dgm:cxn modelId="{065B4AE8-DB27-49B3-B21A-DDB46C7C6A29}" type="presOf" srcId="{EDD9F41F-A977-4C66-8B94-3CF27C022345}" destId="{F90342F5-9C71-4C52-97CA-DD6DFC77BDA7}" srcOrd="0" destOrd="0" presId="urn:microsoft.com/office/officeart/2005/8/layout/vList5"/>
    <dgm:cxn modelId="{866EBE4D-CF01-412B-9B4B-A7C06A7B9A9F}" type="presParOf" srcId="{0199CD2E-9BCD-4B24-B010-709D573A4DA7}" destId="{A7B5465D-5B1F-4547-8CE4-A81915B3FD35}" srcOrd="0" destOrd="0" presId="urn:microsoft.com/office/officeart/2005/8/layout/vList5"/>
    <dgm:cxn modelId="{CB285F6C-AE39-45B6-B662-C5E78A15C191}" type="presParOf" srcId="{A7B5465D-5B1F-4547-8CE4-A81915B3FD35}" destId="{4A834879-C1C4-4BB2-9D5B-247EC55400B9}" srcOrd="0" destOrd="0" presId="urn:microsoft.com/office/officeart/2005/8/layout/vList5"/>
    <dgm:cxn modelId="{13A9F86F-9970-4E27-A0AF-10417C22700A}" type="presParOf" srcId="{A7B5465D-5B1F-4547-8CE4-A81915B3FD35}" destId="{DEA41C13-F06E-40F9-BF60-7F976B370D2D}" srcOrd="1" destOrd="0" presId="urn:microsoft.com/office/officeart/2005/8/layout/vList5"/>
    <dgm:cxn modelId="{39AE3ECE-68BB-410A-9EBF-479AAAF941AB}" type="presParOf" srcId="{0199CD2E-9BCD-4B24-B010-709D573A4DA7}" destId="{F06E3112-633C-42B8-9DB5-3F5BEADC23A6}" srcOrd="1" destOrd="0" presId="urn:microsoft.com/office/officeart/2005/8/layout/vList5"/>
    <dgm:cxn modelId="{D5D33673-9151-4FA5-8745-8117126F6A04}" type="presParOf" srcId="{0199CD2E-9BCD-4B24-B010-709D573A4DA7}" destId="{26CD779C-C50C-49FE-A096-238209672F9D}" srcOrd="2" destOrd="0" presId="urn:microsoft.com/office/officeart/2005/8/layout/vList5"/>
    <dgm:cxn modelId="{1825C12B-53E0-424D-AB1E-2B0796BF2698}" type="presParOf" srcId="{26CD779C-C50C-49FE-A096-238209672F9D}" destId="{F6F0A641-73E2-4760-BAEB-8244D0250C56}" srcOrd="0" destOrd="0" presId="urn:microsoft.com/office/officeart/2005/8/layout/vList5"/>
    <dgm:cxn modelId="{BA5BAB67-A329-4AE4-A763-46C1A72B84A0}" type="presParOf" srcId="{26CD779C-C50C-49FE-A096-238209672F9D}" destId="{91FE9DB4-344F-4DB2-9CD2-8C76A87949D7}" srcOrd="1" destOrd="0" presId="urn:microsoft.com/office/officeart/2005/8/layout/vList5"/>
    <dgm:cxn modelId="{C4D26CA9-75B8-435A-9353-FDC8197E75B5}" type="presParOf" srcId="{0199CD2E-9BCD-4B24-B010-709D573A4DA7}" destId="{3206F37D-FCD4-4550-8388-972C9FABDDD6}" srcOrd="3" destOrd="0" presId="urn:microsoft.com/office/officeart/2005/8/layout/vList5"/>
    <dgm:cxn modelId="{EE42F1C9-F25E-4B2C-85E1-F02A03971451}" type="presParOf" srcId="{0199CD2E-9BCD-4B24-B010-709D573A4DA7}" destId="{8FAB4417-7AB7-406F-AE07-01B7A3C6F5F0}" srcOrd="4" destOrd="0" presId="urn:microsoft.com/office/officeart/2005/8/layout/vList5"/>
    <dgm:cxn modelId="{71A51BA9-9D32-4100-B4EA-EDEBC80AB70F}" type="presParOf" srcId="{8FAB4417-7AB7-406F-AE07-01B7A3C6F5F0}" destId="{F90342F5-9C71-4C52-97CA-DD6DFC77BDA7}" srcOrd="0" destOrd="0" presId="urn:microsoft.com/office/officeart/2005/8/layout/vList5"/>
    <dgm:cxn modelId="{CF0928D8-3F91-490A-9C92-8CF41C528CA0}" type="presParOf" srcId="{8FAB4417-7AB7-406F-AE07-01B7A3C6F5F0}" destId="{65557CB9-33D9-4224-8CE5-CC2296715CFB}" srcOrd="1" destOrd="0" presId="urn:microsoft.com/office/officeart/2005/8/layout/vList5"/>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EA41C13-F06E-40F9-BF60-7F976B370D2D}">
      <dsp:nvSpPr>
        <dsp:cNvPr id="0" name=""/>
        <dsp:cNvSpPr/>
      </dsp:nvSpPr>
      <dsp:spPr>
        <a:xfrm rot="5400000">
          <a:off x="4609116" y="-2051414"/>
          <a:ext cx="1594854" cy="5951369"/>
        </a:xfrm>
        <a:prstGeom prst="round2SameRect">
          <a:avLst/>
        </a:prstGeom>
        <a:solidFill>
          <a:srgbClr val="FFF275">
            <a:alpha val="89804"/>
          </a:srgb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68580" tIns="34290" rIns="68580" bIns="34290" numCol="1" spcCol="1270" anchor="ctr" anchorCtr="0">
          <a:noAutofit/>
        </a:bodyPr>
        <a:lstStyle/>
        <a:p>
          <a:pPr marL="171450" lvl="1" indent="-171450" algn="l" defTabSz="800100">
            <a:lnSpc>
              <a:spcPct val="90000"/>
            </a:lnSpc>
            <a:spcBef>
              <a:spcPct val="0"/>
            </a:spcBef>
            <a:spcAft>
              <a:spcPct val="15000"/>
            </a:spcAft>
            <a:buChar char="•"/>
          </a:pPr>
          <a:r>
            <a:rPr lang="en-US" sz="1800" kern="1200" dirty="0"/>
            <a:t>Mediators resist interpretations of behavior based on pathology or character</a:t>
          </a:r>
        </a:p>
        <a:p>
          <a:pPr marL="171450" lvl="1" indent="-171450" algn="l" defTabSz="800100">
            <a:lnSpc>
              <a:spcPct val="90000"/>
            </a:lnSpc>
            <a:spcBef>
              <a:spcPct val="0"/>
            </a:spcBef>
            <a:spcAft>
              <a:spcPct val="15000"/>
            </a:spcAft>
            <a:buChar char="•"/>
          </a:pPr>
          <a:r>
            <a:rPr lang="en-US" sz="1800" kern="1200" dirty="0"/>
            <a:t>Focusing on misperceptions, miscommunication, misunderstanding, misinterpretation, &amp; bias is more constructive</a:t>
          </a:r>
        </a:p>
      </dsp:txBody>
      <dsp:txXfrm rot="-5400000">
        <a:off x="2430859" y="204697"/>
        <a:ext cx="5873515" cy="1439146"/>
      </dsp:txXfrm>
    </dsp:sp>
    <dsp:sp modelId="{4A834879-C1C4-4BB2-9D5B-247EC55400B9}">
      <dsp:nvSpPr>
        <dsp:cNvPr id="0" name=""/>
        <dsp:cNvSpPr/>
      </dsp:nvSpPr>
      <dsp:spPr>
        <a:xfrm>
          <a:off x="0" y="103818"/>
          <a:ext cx="2420269" cy="1742591"/>
        </a:xfrm>
        <a:prstGeom prst="roundRect">
          <a:avLst/>
        </a:prstGeom>
        <a:solidFill>
          <a:srgbClr val="FFE701"/>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0020" tIns="80010" rIns="160020" bIns="80010" numCol="1" spcCol="1270" anchor="ctr" anchorCtr="0">
          <a:noAutofit/>
        </a:bodyPr>
        <a:lstStyle/>
        <a:p>
          <a:pPr marL="0" lvl="0" indent="0" algn="ctr" defTabSz="1866900">
            <a:lnSpc>
              <a:spcPct val="90000"/>
            </a:lnSpc>
            <a:spcBef>
              <a:spcPct val="0"/>
            </a:spcBef>
            <a:spcAft>
              <a:spcPct val="35000"/>
            </a:spcAft>
            <a:buNone/>
          </a:pPr>
          <a:r>
            <a:rPr lang="en-US" sz="4200" kern="1200" dirty="0"/>
            <a:t>Reframe</a:t>
          </a:r>
        </a:p>
      </dsp:txBody>
      <dsp:txXfrm>
        <a:off x="85066" y="188884"/>
        <a:ext cx="2250137" cy="1572459"/>
      </dsp:txXfrm>
    </dsp:sp>
    <dsp:sp modelId="{91FE9DB4-344F-4DB2-9CD2-8C76A87949D7}">
      <dsp:nvSpPr>
        <dsp:cNvPr id="0" name=""/>
        <dsp:cNvSpPr/>
      </dsp:nvSpPr>
      <dsp:spPr>
        <a:xfrm rot="5400000">
          <a:off x="4770983" y="-162536"/>
          <a:ext cx="1689452" cy="5704417"/>
        </a:xfrm>
        <a:prstGeom prst="round2SameRect">
          <a:avLst/>
        </a:prstGeom>
        <a:solidFill>
          <a:srgbClr val="FF9797">
            <a:alpha val="89804"/>
          </a:srgb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68580" tIns="34290" rIns="68580" bIns="34290" numCol="1" spcCol="1270" anchor="ctr" anchorCtr="0">
          <a:noAutofit/>
        </a:bodyPr>
        <a:lstStyle/>
        <a:p>
          <a:pPr marL="171450" lvl="1" indent="-171450" algn="l" defTabSz="800100">
            <a:lnSpc>
              <a:spcPct val="90000"/>
            </a:lnSpc>
            <a:spcBef>
              <a:spcPct val="0"/>
            </a:spcBef>
            <a:spcAft>
              <a:spcPct val="15000"/>
            </a:spcAft>
            <a:buChar char="•"/>
          </a:pPr>
          <a:r>
            <a:rPr lang="en-US" sz="1800" kern="1200" dirty="0"/>
            <a:t>Any diagnosis of the problem that is not accepted by all stakeholders is fatally flawed (i.e., it will prevent effective resolution) </a:t>
          </a:r>
        </a:p>
        <a:p>
          <a:pPr marL="171450" lvl="1" indent="-171450" algn="l" defTabSz="800100">
            <a:lnSpc>
              <a:spcPct val="90000"/>
            </a:lnSpc>
            <a:spcBef>
              <a:spcPct val="0"/>
            </a:spcBef>
            <a:spcAft>
              <a:spcPct val="15000"/>
            </a:spcAft>
            <a:buChar char="•"/>
          </a:pPr>
          <a:r>
            <a:rPr lang="en-US" sz="1800" kern="1200" dirty="0"/>
            <a:t>Mediators seek the perspective from everyone, a.k.a. the "View from Everywhere"</a:t>
          </a:r>
        </a:p>
      </dsp:txBody>
      <dsp:txXfrm rot="-5400000">
        <a:off x="2763501" y="1927418"/>
        <a:ext cx="5621945" cy="1524508"/>
      </dsp:txXfrm>
    </dsp:sp>
    <dsp:sp modelId="{F6F0A641-73E2-4760-BAEB-8244D0250C56}">
      <dsp:nvSpPr>
        <dsp:cNvPr id="0" name=""/>
        <dsp:cNvSpPr/>
      </dsp:nvSpPr>
      <dsp:spPr>
        <a:xfrm>
          <a:off x="0" y="1830813"/>
          <a:ext cx="2763500" cy="1717719"/>
        </a:xfrm>
        <a:prstGeom prst="roundRect">
          <a:avLst/>
        </a:prstGeom>
        <a:solidFill>
          <a:srgbClr val="FF000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0020" tIns="80010" rIns="160020" bIns="80010" numCol="1" spcCol="1270" anchor="ctr" anchorCtr="0">
          <a:noAutofit/>
        </a:bodyPr>
        <a:lstStyle/>
        <a:p>
          <a:pPr marL="0" lvl="0" indent="0" algn="ctr" defTabSz="1866900">
            <a:lnSpc>
              <a:spcPct val="90000"/>
            </a:lnSpc>
            <a:spcBef>
              <a:spcPct val="0"/>
            </a:spcBef>
            <a:spcAft>
              <a:spcPct val="35000"/>
            </a:spcAft>
            <a:buNone/>
          </a:pPr>
          <a:r>
            <a:rPr lang="en-US" sz="4200" kern="1200" dirty="0"/>
            <a:t>360° View</a:t>
          </a:r>
        </a:p>
      </dsp:txBody>
      <dsp:txXfrm>
        <a:off x="83852" y="1914665"/>
        <a:ext cx="2595796" cy="1550015"/>
      </dsp:txXfrm>
    </dsp:sp>
    <dsp:sp modelId="{65557CB9-33D9-4224-8CE5-CC2296715CFB}">
      <dsp:nvSpPr>
        <dsp:cNvPr id="0" name=""/>
        <dsp:cNvSpPr/>
      </dsp:nvSpPr>
      <dsp:spPr>
        <a:xfrm rot="5400000">
          <a:off x="5071800" y="1783212"/>
          <a:ext cx="1374175" cy="5420129"/>
        </a:xfrm>
        <a:prstGeom prst="round2Same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68580" tIns="34290" rIns="68580" bIns="34290" numCol="1" spcCol="1270" anchor="ctr" anchorCtr="0">
          <a:noAutofit/>
        </a:bodyPr>
        <a:lstStyle/>
        <a:p>
          <a:pPr marL="171450" lvl="1" indent="-171450" algn="l" defTabSz="800100">
            <a:lnSpc>
              <a:spcPct val="90000"/>
            </a:lnSpc>
            <a:spcBef>
              <a:spcPct val="0"/>
            </a:spcBef>
            <a:spcAft>
              <a:spcPct val="15000"/>
            </a:spcAft>
            <a:buClr>
              <a:schemeClr val="tx1"/>
            </a:buClr>
            <a:buChar char="•"/>
          </a:pPr>
          <a:r>
            <a:rPr lang="en-US" sz="1800" kern="1200" dirty="0">
              <a:solidFill>
                <a:schemeClr val="tx1"/>
              </a:solidFill>
              <a:effectLst/>
            </a:rPr>
            <a:t>Mediators do not fixate on the stakeholders’ positions but instead try to uncover their interests</a:t>
          </a:r>
          <a:endParaRPr lang="en-US" sz="1800" kern="1200" dirty="0">
            <a:solidFill>
              <a:schemeClr val="tx1"/>
            </a:solidFill>
          </a:endParaRPr>
        </a:p>
        <a:p>
          <a:pPr marL="171450" lvl="1" indent="-171450" algn="l" defTabSz="800100">
            <a:lnSpc>
              <a:spcPct val="90000"/>
            </a:lnSpc>
            <a:spcBef>
              <a:spcPct val="0"/>
            </a:spcBef>
            <a:spcAft>
              <a:spcPct val="15000"/>
            </a:spcAft>
            <a:buChar char="•"/>
          </a:pPr>
          <a:r>
            <a:rPr lang="en-US" sz="1800" kern="1200" dirty="0">
              <a:solidFill>
                <a:schemeClr val="tx1"/>
              </a:solidFill>
              <a:effectLst/>
            </a:rPr>
            <a:t>Resolution of a conflict requires illumination of the underlying concerns of the parties</a:t>
          </a:r>
        </a:p>
      </dsp:txBody>
      <dsp:txXfrm rot="-5400000">
        <a:off x="3048823" y="3873271"/>
        <a:ext cx="5353047" cy="1240011"/>
      </dsp:txXfrm>
    </dsp:sp>
    <dsp:sp modelId="{F90342F5-9C71-4C52-97CA-DD6DFC77BDA7}">
      <dsp:nvSpPr>
        <dsp:cNvPr id="0" name=""/>
        <dsp:cNvSpPr/>
      </dsp:nvSpPr>
      <dsp:spPr>
        <a:xfrm>
          <a:off x="0" y="3634418"/>
          <a:ext cx="3048823" cy="1717719"/>
        </a:xfrm>
        <a:prstGeom prst="roundRect">
          <a:avLst/>
        </a:prstGeom>
        <a:solidFill>
          <a:schemeClr val="bg2">
            <a:lumMod val="5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0020" tIns="80010" rIns="160020" bIns="80010" numCol="1" spcCol="1270" anchor="ctr" anchorCtr="0">
          <a:noAutofit/>
        </a:bodyPr>
        <a:lstStyle/>
        <a:p>
          <a:pPr marL="0" lvl="0" indent="0" algn="l" defTabSz="1866900">
            <a:lnSpc>
              <a:spcPct val="90000"/>
            </a:lnSpc>
            <a:spcBef>
              <a:spcPct val="0"/>
            </a:spcBef>
            <a:spcAft>
              <a:spcPct val="35000"/>
            </a:spcAft>
            <a:buNone/>
          </a:pPr>
          <a:r>
            <a:rPr lang="en-US" sz="4200" kern="1200" dirty="0"/>
            <a:t>Interests</a:t>
          </a:r>
        </a:p>
      </dsp:txBody>
      <dsp:txXfrm>
        <a:off x="83852" y="3718270"/>
        <a:ext cx="2881119" cy="1550015"/>
      </dsp:txXfrm>
    </dsp:sp>
  </dsp:spTree>
</dsp:drawing>
</file>

<file path=ppt/diagrams/layout1.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1618" name="Rectangle 2"/>
          <p:cNvSpPr>
            <a:spLocks noGrp="1" noChangeArrowheads="1"/>
          </p:cNvSpPr>
          <p:nvPr>
            <p:ph type="hdr" sz="quarter"/>
          </p:nvPr>
        </p:nvSpPr>
        <p:spPr bwMode="auto">
          <a:xfrm>
            <a:off x="0" y="0"/>
            <a:ext cx="3037840" cy="4648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76" tIns="46588" rIns="93176" bIns="46588" numCol="1" anchor="t" anchorCtr="0" compatLnSpc="1">
            <a:prstTxWarp prst="textNoShape">
              <a:avLst/>
            </a:prstTxWarp>
          </a:bodyPr>
          <a:lstStyle>
            <a:lvl1pPr>
              <a:defRPr sz="1200" smtClean="0">
                <a:latin typeface="Arial" charset="0"/>
              </a:defRPr>
            </a:lvl1pPr>
          </a:lstStyle>
          <a:p>
            <a:pPr>
              <a:defRPr/>
            </a:pPr>
            <a:endParaRPr lang="en-US"/>
          </a:p>
        </p:txBody>
      </p:sp>
      <p:sp>
        <p:nvSpPr>
          <p:cNvPr id="111619" name="Rectangle 3"/>
          <p:cNvSpPr>
            <a:spLocks noGrp="1" noChangeArrowheads="1"/>
          </p:cNvSpPr>
          <p:nvPr>
            <p:ph type="dt" sz="quarter" idx="1"/>
          </p:nvPr>
        </p:nvSpPr>
        <p:spPr bwMode="auto">
          <a:xfrm>
            <a:off x="3970938" y="0"/>
            <a:ext cx="3037840" cy="4648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76" tIns="46588" rIns="93176" bIns="46588" numCol="1" anchor="t" anchorCtr="0" compatLnSpc="1">
            <a:prstTxWarp prst="textNoShape">
              <a:avLst/>
            </a:prstTxWarp>
          </a:bodyPr>
          <a:lstStyle>
            <a:lvl1pPr algn="r">
              <a:defRPr sz="1200" smtClean="0">
                <a:latin typeface="Arial" charset="0"/>
              </a:defRPr>
            </a:lvl1pPr>
          </a:lstStyle>
          <a:p>
            <a:pPr>
              <a:defRPr/>
            </a:pPr>
            <a:endParaRPr lang="en-US"/>
          </a:p>
        </p:txBody>
      </p:sp>
      <p:sp>
        <p:nvSpPr>
          <p:cNvPr id="111620" name="Rectangle 4"/>
          <p:cNvSpPr>
            <a:spLocks noGrp="1" noChangeArrowheads="1"/>
          </p:cNvSpPr>
          <p:nvPr>
            <p:ph type="ftr" sz="quarter" idx="2"/>
          </p:nvPr>
        </p:nvSpPr>
        <p:spPr bwMode="auto">
          <a:xfrm>
            <a:off x="0" y="8829968"/>
            <a:ext cx="3037840" cy="4648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76" tIns="46588" rIns="93176" bIns="46588" numCol="1" anchor="b" anchorCtr="0" compatLnSpc="1">
            <a:prstTxWarp prst="textNoShape">
              <a:avLst/>
            </a:prstTxWarp>
          </a:bodyPr>
          <a:lstStyle>
            <a:lvl1pPr>
              <a:defRPr sz="1200" smtClean="0">
                <a:latin typeface="Arial" charset="0"/>
              </a:defRPr>
            </a:lvl1pPr>
          </a:lstStyle>
          <a:p>
            <a:pPr>
              <a:defRPr/>
            </a:pPr>
            <a:endParaRPr lang="en-US"/>
          </a:p>
        </p:txBody>
      </p:sp>
      <p:sp>
        <p:nvSpPr>
          <p:cNvPr id="111621" name="Rectangle 5"/>
          <p:cNvSpPr>
            <a:spLocks noGrp="1" noChangeArrowheads="1"/>
          </p:cNvSpPr>
          <p:nvPr>
            <p:ph type="sldNum" sz="quarter" idx="3"/>
          </p:nvPr>
        </p:nvSpPr>
        <p:spPr bwMode="auto">
          <a:xfrm>
            <a:off x="3970938" y="8829968"/>
            <a:ext cx="3037840" cy="4648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76" tIns="46588" rIns="93176" bIns="46588" numCol="1" anchor="b" anchorCtr="0" compatLnSpc="1">
            <a:prstTxWarp prst="textNoShape">
              <a:avLst/>
            </a:prstTxWarp>
          </a:bodyPr>
          <a:lstStyle>
            <a:lvl1pPr algn="r">
              <a:defRPr sz="1200" smtClean="0">
                <a:latin typeface="Arial" charset="0"/>
              </a:defRPr>
            </a:lvl1pPr>
          </a:lstStyle>
          <a:p>
            <a:pPr>
              <a:defRPr/>
            </a:pPr>
            <a:fld id="{81DE6FD7-B115-487F-B6E4-944F02241840}" type="slidenum">
              <a:rPr lang="en-US"/>
              <a:pPr>
                <a:defRPr/>
              </a:pPr>
              <a:t>‹#›</a:t>
            </a:fld>
            <a:endParaRPr lang="en-US"/>
          </a:p>
        </p:txBody>
      </p:sp>
    </p:spTree>
    <p:extLst>
      <p:ext uri="{BB962C8B-B14F-4D97-AF65-F5344CB8AC3E}">
        <p14:creationId xmlns:p14="http://schemas.microsoft.com/office/powerpoint/2010/main" val="3539989502"/>
      </p:ext>
    </p:extLst>
  </p:cSld>
  <p:clrMap bg1="lt1" tx1="dk1" bg2="lt2" tx2="dk2" accent1="accent1" accent2="accent2" accent3="accent3" accent4="accent4" accent5="accent5" accent6="accent6" hlink="hlink" folHlink="folHlink"/>
</p:handoutMaster>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4.482"/>
    </inkml:context>
    <inkml:brush xml:id="br0">
      <inkml:brushProperty name="width" value="0.05" units="cm"/>
      <inkml:brushProperty name="height" value="0.05" units="cm"/>
      <inkml:brushProperty name="color" value="#66CC00"/>
      <inkml:brushProperty name="ignorePressure" value="1"/>
    </inkml:brush>
  </inkml:definitions>
  <inkml:trace contextRef="#ctx0" brushRef="#br0">304 42,'0'-1,"0"-1,0 1,-1-1,1 1,-1-1,0 1,1 0,-1-1,0 1,0 0,0 0,0-1,0 1,0 0,0 0,0 0,0 0,0 0,-1 0,1 1,0-1,-1 0,1 1,-1-1,1 0,-3 1,-40-10,42 10,-6-1,-1 0,1 1,-1 0,0 0,1 1,-1 1,1-1,-1 1,1 1,0-1,0 1,0 1,0 0,0 0,1 0,0 1,0 0,0 1,0-1,1 1,0 0,0 1,-7 10,8-8,0-1,0 1,1 0,0 1,1-1,0 1,0-1,1 1,1 0,-2 16,2-15,1 0,1 1,-1-1,2 0,-1 0,2 0,-1 0,1-1,7 15,-7-18,1-1,1 0,-1 1,1-1,0-1,1 1,-1-1,1 0,0 0,0-1,12 7,-14-8,0-1,1 0,-1 0,0 0,1-1,-1 0,1 0,0 0,-1 0,1-1,0 1,-1-1,1-1,0 1,0 0,-1-1,1 0,-1 0,9-4,1-3</inkml:trace>
</inkml:ink>
</file>

<file path=ppt/ink/ink1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4.482"/>
    </inkml:context>
    <inkml:brush xml:id="br0">
      <inkml:brushProperty name="width" value="0.05" units="cm"/>
      <inkml:brushProperty name="height" value="0.05" units="cm"/>
      <inkml:brushProperty name="color" value="#66CC00"/>
      <inkml:brushProperty name="ignorePressure" value="1"/>
    </inkml:brush>
  </inkml:definitions>
  <inkml:trace contextRef="#ctx0" brushRef="#br0">304 42,'0'-1,"0"-1,0 1,-1-1,1 1,-1-1,0 1,1 0,-1-1,0 1,0 0,0 0,0-1,0 1,0 0,0 0,0 0,0 0,0 0,-1 0,1 1,0-1,-1 0,1 1,-1-1,1 0,-3 1,-40-10,42 10,-6-1,-1 0,1 1,-1 0,0 0,1 1,-1 1,1-1,-1 1,1 1,0-1,0 1,0 1,0 0,0 0,1 0,0 1,0 0,0 1,0-1,1 1,0 0,0 1,-7 10,8-8,0-1,0 1,1 0,0 1,1-1,0 1,0-1,1 1,1 0,-2 16,2-15,1 0,1 1,-1-1,2 0,-1 0,2 0,-1 0,1-1,7 15,-7-18,1-1,1 0,-1 1,1-1,0-1,1 1,-1-1,1 0,0 0,0-1,12 7,-14-8,0-1,1 0,-1 0,0 0,1-1,-1 0,1 0,0 0,-1 0,1-1,0 1,-1-1,1-1,0 1,0 0,-1-1,1 0,-1 0,9-4,1-3</inkml:trace>
</inkml:ink>
</file>

<file path=ppt/ink/ink1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8.139"/>
    </inkml:context>
    <inkml:brush xml:id="br0">
      <inkml:brushProperty name="width" value="0.05" units="cm"/>
      <inkml:brushProperty name="height" value="0.05" units="cm"/>
      <inkml:brushProperty name="color" value="#66CC00"/>
      <inkml:brushProperty name="ignorePressure" value="1"/>
    </inkml:brush>
  </inkml:definitions>
  <inkml:trace contextRef="#ctx0" brushRef="#br0">1321 261,'-23'-3,"21"2,-1 0,1 1,0-1,0 1,-1 0,1-1,0 1,0 0,-1 0,1 1,0-1,0 0,-1 1,-3 1,3 0,0 0,0-1,0 2,0-1,0 0,1 1,-1-1,1 1,-1 0,1 0,0 0,0 0,0 0,1 0,-1 0,1 1,0-1,0 1,0-1,-1 7,0 3,0 0,2 0,-1 0,3 20,-1-24,1 0,0 0,1-1,0 1,0 0,1-1,0 0,1 0,-1 0,2 0,7 8,-5-6,1 0,1 0,0-1,0-1,1 0,0 0,14 7,-19-12,1 0,0 0,0-1,0 1,0-2,1 1,-1-1,0 0,1-1,-1 1,0-2,1 1,8-2,-5 0,-1-1,0 0,-1-1,1 0,-1 0,1-1,-1 0,15-12,-12 7,1-1,-2 0,0-1,0 0,-1-1,0 0,-1-1,-1 0,0 0,-1-1,0 0,4-18,-8 22,0 0,-1-1,-1 1,1-1,-2 1,0-1,0 1,-1-1,-1 1,-5-22,4 23,-1 1,1 0,-2 0,1 0,-2 0,1 1,-1 0,0 0,0 1,-1-1,0 1,-1 1,-8-7,1 4,-1-1,0 2,0 0,-1 1,0 1,-1 0,1 2,-1 0,0 0,0 2,0 0,-1 1,1 1,-35 5,48-4,1 0,-1 0,0 0,1 1,-1-1,1 1,-1 0,1 1,0-1,0 1,0 0,0 0,1 0,-1 0,1 1,0 0,0-1,0 1,0 0,1 0,-1 1,1-1,0 0,0 1,-1 6,0 3,-1 0,2 0,0 1,1-1,0 1,2-1,1 18,-1-26,0-1,0 0,0 0,1 0,-1 0,1-1,1 1,-1 0,1-1,-1 1,1-1,1 0,-1 0,0 0,1-1,0 1,0-1,0 1,0-2,1 1,-1 0,1-1,0 0,7 3,-8-3,0-1,1 0,-1-1,0 1,0-1,0 1,0-1,1-1,-1 1,0 0,0-1,0 0,0 0,0 0,0-1,0 1,0-1,0 0,-1 0,1 0,-1-1,1 1,-1-1,0 0,0 0,0 0,0 0,-1 0,1-1,2-5,-1 1,-1 1,0-1,0 0,-1 0,0-1,0 1,-1 0,0-1,0 1,-1-1,-1 1,1-1,-1 1,0-1,-1 1,0 0,-1 0,1 0,-1 0,-1 0,0 0,0 1,0 0,-1 0,0 0,0 0,-10-8,7 8,0 0,0 1,-1 0,1 1,-1 0,-1 0,1 1,-1 0,0 1,0 0,0 0,0 1,0 0,0 1,-1 1,1-1,0 1,-1 1,1 0,-20 5,27-5,0 0,0 0,0 1,0 0,0-1,1 1,-1 0,1 0,0 0,-1 1,1-1,0 1,0-1,0 1,1-1,-1 1,1 0,-1 0,1 0,0 0,0 0,0 0,0 0,1 0,0 1,-1-1,1 6,0 1,1 0,-1-1,2 1,-1-1,1 1,1-1,0 1,5 11,-1-9,0 0,0 0,1-1,1 0,0-1,0 0,1 0,0-1,1-1,0 1,0-2,1 1,0-2,16 7,-16-7,0-2,0 0,0 0,1-1,-1-1,1 0,0 0,0-2,0 1,-1-2,1 0,0 0,0-1,-1-1,19-5,-26 6,-1 0,1 0,0-1,-1 1,0-1,1 0,-1-1,0 1,-1-1,1 1,-1-1,1 0,-1 0,0-1,-1 1,1-1,-1 1,0-1,0 0,0 0,-1 0,3-10,-4 9,1-1,-1 0,0 1,-1-1,1 0,-1 1,0-1,-1 1,0-1,0 1,0 0,-1 0,0 0,0 0,-1 0,1 1,-8-9,-2-1,-1 2,-1 0,1 1,-2 1,0 0,0 1,-30-14,32 18,0 0,-1 1,1 1,-1 0,0 1,0 0,0 2,-1-1,1 2,-20 1,31 0,0 0,0 0,1 0,-1 0,0 0,1 1,-1 0,1 0,0 0,-1 0,1 0,0 0,0 1,1 0,-1-1,0 1,1 0,0 0,-1 1,1-1,1 0,-1 1,0-1,1 1,0 0,-1-1,0 7,-1 9,0 0,2 0,0 0,1 25,1-26,-1-5,0-1,2 0,-1 0,1 0,1 0,4 12,-6-20,1-1,-1 1,1-1,0 0,0 1,0-1,0 0,1 0,-1-1,1 1,0 0,0-1,0 1,0-1,0 0,0 0,1 0,-1-1,1 1,-1-1,1 0,0 0,5 1,-5-1,0-1,0 1,0-1,0 0,0 0,0 0,0-1,0 1,0-1,-1 0,1 0,0 0,6-3,-8 2,0 1,0-1,0 0,0 0,0 0,-1 0,1 0,-1-1,1 1,-1 0,0-1,1 1,-1-1,-1 1,1-1,0 0,-1 1,1-1,-1 0,0 1,0-4,0-3,0 1,-1 0,-1-1,0 1,0 0,0 0,-1 0,0 0,0 1,-1-1,0 1,-9-12,5 8,0 1,0 0,-1 0,0 1,-1 0,0 1,-18-12,24 18,1 0,-1 0,0 0,0 0,0 1,0-1,0 1,0 0,0 1,0-1,-1 1,1-1,0 1,0 0,-1 1,1-1,0 1,0 0,0 0,0 0,0 1,-5 1,3 1,-1 0,1 1,1 0,-1 0,0 0,1 0,0 1,1 0,-1 0,1 1,-6 11,1 0,1 0,1 1,1 0,-6 28,9-34,1 1,0 0,1-1,1 1,0 0,1 0,4 17,-4-25,0-1,1 0,0 0,0 0,0-1,1 1,-1 0,1-1,0 0,0 0,1 0,0 0,-1 0,1 0,0-1,1 0,-1 0,0 0,1 0,0-1,0 0,0 0,-1 0,2-1,-1 1,0-1,7 0,4 1,-1-1,1-1,-1 0,1-2,-1 1,1-2,-1 0,18-7,-28 9,-1-1,1 0,-1 0,0 0,0 0,0-1,0 1,0-1,-1 0,1-1,-1 1,0 0,0-1,0 0,0 0,-1 0,0 0,1 0,-1 0,-1-1,1 1,-1-1,1 1,-1-1,-1 1,1-1,-1 0,0-6,0 2,0 0,-1 0,-1-1,0 1,0 0,-1 0,1 1,-2-1,0 0,0 1,0 0,-1 0,-9-12,-1 4,-1 0,-1 1,0 0,-1 1,0 1,-1 1,0 1,-1 1,-1 0,0 1,0 2,0 0,-1 1,0 1,0 1,0 1,-1 1,1 1,0 1,-1 1,-41 7,55-5,-1 0,0 0,1 1,0 1,0-1,0 2,1-1,-1 1,1 0,1 1,-1 0,1 0,0 1,1-1,0 2,0-1,1 0,-7 14,4-5,1 0,1 1,0 0,1 0,1 0,1 0,1 1,0-1,1 24,2-29,0 1,1-1,1 0,0 0,0 0,2-1,-1 1,1-1,1 0,1-1,-1 1,2-1,-1 0,2-1,-1 0,15 13,-11-13,0 0,1 0,0-2,1 0,-1 0,2-1,-1-1,1 0,0-1,0-1,0 0,0-1,25 2,-29-4,0-1,0 0,0-1,0 0,0-1,0 0,-1 0,1-1,18-8,-22 7,1 0,-1-1,0 0,0 0,-1-1,0 0,0 0,0 0,0-1,-1 1,0-1,-1-1,6-9,-5 7,-1-1,0 1,0-1,-1 0,0 0,-1 0,0 0,-1 0,0-1,-1 1,-1 0,1-1,-2 1,1 0,-1 0,-1 0,-4-12,0 7,-1 0,0 0,-1 1,0 0,-1 0,-1 1,0 1,-1 0,-1 0,-19-14,8 9,0 2,-2 1,0 1,0 1,-2 1,1 1,-1 2,-1 1,0 1,0 1,0 2,0 1,-1 1,-45 3,55 1,1 0,0 2,0 0,0 1,0 0,1 2,0 0,0 2,1-1,-22 16,18-9,1 2,0 0,2 0,0 2,0 1,2 0,-16 25,11-8,0 0,3 2,1 0,2 1,2 0,1 1,2 0,2 1,-3 56,10-80,1 0,1-1,0 1,2 0,0 0,1-1,0 1,2-1,0 0,0-1,2 0,11 18,-5-12,1-1,1 0,1-2,1 0,1 0,1-2,36 25,-13-14,1-2,0-3,2-1,1-2,1-3,0-1,97 17,-96-25,0-3,0-2,0-2,0-2,1-2,-1-2,-1-3,58-16,-78 16,-1-2,0-1,0-1,-1-1,-1-2,0 0,-1-2,-1 0,0-2,39-41,-51 46,0 1,-2-2,1 1,-2-1,0 0,-1-1,0 0,7-26,-11 28,-1-1,0 1,0-1,-2 0,0 1,0-1,-2 0,0 1,0-1,-9-27,2 18,-1 1,-1 0,-1 1,-1 0,0 1,-2 0,0 2,-2-1,0 2,-1 0,-1 1,0 1,-26-16,24 19,-1 0,0 1,0 1,-1 1,-1 1,0 1,0 2,0 0,-1 1,0 2,0 0,0 2,-32 2,51-1,1 1,0 0,0 0,0 1,0 0,0 0,0 0,0 0,1 1,-1 0,1 0,-1 0,1 0,0 1,1-1,-1 1,1 0,-1 0,1 1,0-1,1 0,-1 1,1 0,0 0,0 0,-2 5,-1 12,0 0,0 0,2 0,0 41,2-55,1 1,1-1,-1 1,1-1,1 1,-1-1,2 1,-1-1,6 13,-6-17,1-1,-1 1,1-1,-1 1,1-1,0 0,0 0,1 0,-1 0,1-1,-1 1,1-1,0 0,0 0,0 0,0-1,0 1,0-1,0 0,7 1,1 0,0-1,-1 0,1-1,0-1,0 1,0-2,-1 0,1 0,-1-1,1 0,-1-1,0 0,0-1,-1 0,1-1,-1 0,13-11,-11 6,0 0,-1-1,0 0,0-1,-2 0,1-1,-2 1,0-2,0 1,-2-1,10-31,-10 25,-1 0,-1-1,-1 1,-1-1,-1 0,-1 0,-1 1,-1-1,0 0,-2 1,-1 0,0 0,-1 0,-2 0,0 1,-1 0,-1 1,-1 0,-22-30,31 47,1 0,-1 0,0 0,0 0,0 0,0 0,-1 0,1 1,0-1,-1 1,-3-2,5 3,0 0,0 0,0 0,0 0,0 0,-1 0,1 0,0 0,0 1,0-1,0 0,0 1,0-1,0 1,0-1,0 1,0-1,0 1,0-1,1 1,-1 0,0 0,0 0,1-1,-1 1,0 0,1 0,-1 0,1 0,-1 2,-6 9</inkml:trace>
</inkml:ink>
</file>

<file path=ppt/ink/ink1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1:55.243"/>
    </inkml:context>
    <inkml:brush xml:id="br0">
      <inkml:brushProperty name="width" value="0.35" units="cm"/>
      <inkml:brushProperty name="height" value="0.35" units="cm"/>
      <inkml:brushProperty name="color" value="#33CC33"/>
      <inkml:brushProperty name="ignorePressure" value="1"/>
    </inkml:brush>
  </inkml:definitions>
  <inkml:trace contextRef="#ctx0" brushRef="#br0">3927 2864,'22'0,"30"5,6 2,95 2,75-1,348-3,1-43,-311 0,-215 27,-1-2,-1-2,51-23,-82 29,0 0,0-1,-1 0,0-1,19-17,-31 23,1-1,-1 1,1-1,-1 0,-1 0,1 0,-1-1,0 0,-1 0,0 0,0 0,0 0,-1 0,0-1,0 0,0-7,-2 9,-1 1,1-1,-1 1,0-1,-1 0,1 1,-1 0,0-1,0 1,-1 0,1 0,-1 0,-1 1,1-1,0 1,-1-1,0 1,0 1,0-1,-8-5,-4-2,0 1,0 0,-1 1,0 1,-19-6,-21-4,-2 1,1 4,-64-7,-181-2,-20 23,277 3,1 2,-1 1,1 3,0 1,-44 19,66-20,1 1,0 1,0 2,1 0,1 1,0 1,1 0,1 2,1 0,0 1,1 1,-16 28,15-20,1 1,2 0,1 1,2 1,0 0,2 0,2 1,-7 64,8-4,5-1,10 94,-9-182,0 1,0-1,0 1,1-1,0 1,0-1,0 0,0 0,0 1,1-1,-1 0,1 0,4 5,-6-8,0 0,0 1,0-1,1 0,-1 0,0 0,0 0,1 0,-1 0,0 1,0-1,1 0,-1 0,0 0,0 0,1 0,-1 0,0 0,0 0,1 0,-1 0,0 0,0 0,1-1,-1 1,0 0,0 0,1 0,-1 0,0 0,0 0,1-1,-1 1,0 0,6-11,0-15,-4 13,-1 0,0 0,-1 0,0 0,-1 0,-1 0,0 0,-1 1,0-1,-1 1,0-1,-8-13,4 11,-1 0,-1 1,0 0,0 1,-2 0,0 0,0 1,-26-19,22 21,0 0,-1 0,0 2,0 0,-1 1,0 0,0 2,-27-5,4 4,0 1,-76 3,98 3,0 0,0 2,1 0,-1 1,1 1,0 0,0 2,0 0,1 1,-19 12,22-12,2 1,0 1,0 0,0 1,1 0,1 0,0 1,1 1,0 0,1 0,0 0,-11 27,15-29,1 0,-1 1,2-1,0 0,0 1,1 0,0-1,1 1,0 0,1-1,0 1,1-1,5 18,-3-17,1 0,0 0,1-1,0 1,1-2,0 1,1-1,0 0,1 0,0-1,0 0,14 9,-5-5,2-1,-1-1,1-1,1-1,0-1,0-1,0-1,1 0,0-2,25 2,0-1,1-3,0-3,79-9,-68 1,-1-2,67-22,-96 23,0-1,0-1,-1-2,0-1,49-35,-72 46,1-1,-1 0,0 0,0-1,0 0,-1 1,1-2,-1 1,-1 0,1-1,-1 1,3-11,-5 13,0 0,-1-1,1 1,-1-1,0 1,0 0,0-1,0 1,-1-1,0 1,0 0,0 0,0-1,-1 1,0 0,0 0,0 0,0 1,0-1,-1 0,-4-4,-4-3,0 1,-1-1,0 2,-1 0,0 1,0 0,-25-10,4 4,-1 1,-40-8,12 7,0 3,-115-6,128 16,0 3,1 1,0 3,-59 14,90-15,2 0,-1 1,1 1,-1 0,2 1,-1 1,1 0,1 1,-14 13,21-18,2 1,-1 0,0 0,1 0,0 1,1-1,0 1,0 1,0-1,1 0,0 1,0 0,1-1,0 1,0 0,1 0,0 0,0 1,1-1,0 0,2 14,1-8,1-1,0 0,1 1,1-2,0 1,0-1,2 0,-1 0,16 18,3 0,2-1,37 30,-16-19,2-3,2-1,1-3,1-3,2-1,0-4,2-1,1-4,1-2,93 15,-128-29,1-1,-1-2,1 0,-1-2,39-6,-52 4,0 0,0 0,-1-1,1-1,-1 0,0-1,0 0,-1-1,0 0,0-1,0 0,16-17,-11 5,0 0,-1 0,-1-2,-2 0,0 0,-1-1,-1-1,7-25,-7 17,-2-1,-1-1,-2 1,-1-1,-1-52,-4 68,-1 0,0 0,-2 0,0 1,0-1,-2 1,0 0,-1 0,-1 1,0 0,-1 0,-1 1,0 0,-1 1,-1 0,0 1,-1 0,-1 1,1 1,-2 0,0 0,0 2,-1 0,0 0,-26-8,16 7,-1 2,-1 1,1 2,-1 0,0 2,-1 0,1 3,0 0,-1 2,1 0,-31 9,42-7,0 1,0 1,1 0,-1 1,2 1,-1 1,1 0,-17 14,21-13,0 0,0 1,1 0,1 0,0 1,0 1,1-1,1 1,0 1,-8 22,7-12,1 0,2 1,0-1,1 1,2 0,0 0,2 0,1 0,1 0,1 0,1 0,1-1,14 43,-11-47,1 1,0-1,2 0,0-1,1 0,1-1,1-1,1 0,0 0,1-2,0 0,2-1,-1 0,2-2,36 20,-21-17,1-1,-1-2,2-1,0-2,69 8,-59-13,1-2,0-3,-1-1,58-11,-38 0,-1-3,0-4,-1-2,-1-2,-1-4,97-59,-90 42,-2-2,-2-4,-2-2,-3-3,61-73,-73 71,-3-3,-2-1,-3-1,-3-3,50-122,-74 153,-1 0,-2 0,-2-1,-1 0,-1 0,0-58,-6 76,-1-1,-1 1,0-1,-2 1,0 0,-1 0,0 1,-2-1,0 1,-1 1,-1-1,0 1,-1 1,-24-29,15 25,0 1,-2 1,0 1,-1 0,0 2,-2 0,1 2,-37-14,-5 3,-1 3,-75-13,22 11,0 4,-1 6,-212 5,185 22,125-11,0 1,0 1,0 1,-27 12,43-16,0 0,1 0,-1 1,1-1,-1 1,1 1,0-1,1 1,-1-1,1 1,0 1,0-1,0 1,1-1,0 1,0 0,0 0,1 0,0 1,0-1,1 0,0 1,0 0,0-1,1 1,0-1,1 8,0 6,0-1,2 1,1-1,0 0,1-1,1 1,10 21,-4-15,2 0,0-1,2-1,26 31,-4-12,3-3,1-1,1-2,69 43,-51-41,109 52,-127-72,1-1,1-2,73 14,-104-27,-1 0,1 0,-1-2,1 1,-1-2,1 0,-1-1,19-4,-24 4,0-1,-1 0,1-1,-1 1,0-2,0 1,0-1,-1 0,1 0,-1 0,0-1,-1 0,0-1,9-12,-3 1,-2 0,0-1,-1 0,-1 0,0-1,-2 1,0-2,-2 1,0 0,-1-1,-1 1,-1-1,0 1,-2-1,-5-26,-1 11,-1 1,-2 0,-1 1,-1 1,-2 0,-2 0,-37-54,27 49,-2 1,-1 2,-2 1,-1 1,-55-41,79 68,1 0,-1 1,-1-1,1 2,0-1,-16-3,22 7,0 0,-1 0,1 1,-1-1,1 1,-1 0,1 0,-1 1,1-1,-1 1,1-1,0 1,-1 0,1 0,0 1,-1-1,1 1,0-1,0 1,0 0,1 0,-6 5,1 1,0 0,0 1,0 0,1 0,1 0,-1 1,-3 12,-4 10,-7 35,0 19,3 2,4 0,4 1,4 0,13 174,-2-201,24 100,-22-133,1 0,1 0,1-1,2-1,22 37,-30-57,-1-1,1 1,1-1,-1-1,1 1,0-1,1 0,11 7,-17-11,1 0,0 0,0 0,0 0,0 0,0 0,0-1,0 1,0-1,0 0,0 1,0-1,0 0,0 0,0 0,0-1,0 1,0 0,0-1,0 1,0-1,0 0,0 0,0 0,-1 0,1 0,0 0,-1 0,1 0,0-1,-1 1,1-1,-1 1,0-1,0 1,0-1,1 0,0-2,-1 1,1 1,0-1,-1 0,0-1,1 1,-1 0,0 0,-1 0,1-1,-1 1,1 0,-1-1,0 1,0 0,-1-1,1 1,-1 0,1-1,-1 1,0 0,0 0,0-1,-1 1,1 0,-1 1,0-1,0 0,0 0,0 1,0-1,-1 1,1-1,-5-2,-1-1,-1 0,1 1,-1 0,0 1,0 0,-1 0,1 1,-1 0,0 1,-13-2,3 3,1 1,0 0,0 1,0 2,0 0,1 0,-1 2,1 0,0 2,0 0,1 0,0 2,0 0,-19 14,23-13,0 0,0 0,0 1,2 1,-1 0,2 0,-1 1,2 1,0-1,0 2,1-1,1 1,1 0,0 1,1 0,-6 28,10-34,1 0,0 0,0-1,1 1,1 0,-1 0,2 0,-1-1,1 1,1-1,0 0,0 0,0 0,1-1,1 1,-1-1,2 0,10 11,-5-7,1 0,0-1,1 0,1-1,-1 0,1-2,1 1,-1-2,31 10,-39-15,-1-1,1 1,0-1,-1-1,1 0,0 1,-1-2,1 1,0-1,-1 0,1-1,7-2,-4 0,0 0,0-1,-1 0,1 0,-1-1,16-14,-7 3,-1-1,-1-1,-1 0,0-1,-2 0,12-23,-10 13,-1 0,-2-1,-1 0,-2-1,11-59,-17 66,-1 1,-1-1,0 0,-2 0,-1 0,-1 1,-2-1,-9-33,9 45,0-1,-1 1,-1 0,0 1,-1-1,0 1,-14-15,15 20,0-1,-1 1,0 0,0 1,0 0,-1 0,0 0,0 1,-1 1,-18-7,22 10,0 0,0 1,0-1,0 1,0 1,0-1,0 1,0 0,1 0,-1 1,0-1,1 1,-1 1,1-1,-1 1,1 0,0 0,-6 5,-5 4,1 1,0 1,0 0,-13 18,6-3,0 1,2 1,1 1,2 1,1 0,2 1,-16 55,18-43,2 0,2 1,2 0,3 0,2 71,1-110,1 1,0-1,0 1,1-1,0 0,1 0,0 1,4 8,-5-13,0-1,0 0,1 0,-1 0,1 0,-1 0,1-1,0 1,0-1,0 0,1 1,-1-1,0-1,1 1,-1 0,1-1,0 0,-1 0,1 0,6 0,-1 0,1-1,-1 0,0 0,1-1,-1-1,1 0,-1 0,0-1,0 0,0 0,13-8,9-6,50-38,-15 4,-2-3,-3-3,-2-2,-3-3,84-120,-117 149,-2-1,-1 0,-2-2,-1 0,17-55,-30 76,0-1,-2 0,1 0,-2 0,0 0,-1 1,-2-18,0 21,0 1,-1 0,0 0,-1 0,0 1,0-1,-1 1,-1 0,0 0,-13-17,3 10,-1 0,-1 1,0 0,-1 2,0 0,-1 1,0 2,-1 0,-1 0,-25-7,0 3,-1 1,0 3,-97-10,73 17,-1 3,-136 15,-142 52,220-32,-207 81,274-88,1 3,2 3,1 2,1 3,-57 49,97-71,1 1,0 1,1 1,1 1,1 0,-19 31,28-38,0 0,0-1,2 2,-1-1,2 0,-1 1,2 0,0 0,1 0,0 0,1 0,0 0,4 15,0-10,0 0,2-1,0 0,1 0,1-1,1 0,0 0,1-1,1 0,1-1,0 0,1-1,0 0,21 16,5 1,0-3,2-1,2-2,63 27,-37-22,0-3,2-3,118 24,-144-40,-1-2,1-2,0-2,0-2,0-2,0-2,56-12,-82 12,1-2,-1 0,0-2,-1 0,0 0,0-2,-1 0,0-2,-1 1,-1-2,1 0,17-20,-25 23,0 0,0-1,-1 0,-1 0,0-1,0 1,-1-1,-1-1,0 1,0 0,-1-1,-1 0,0 0,-1 0,0 0,-1 0,0 0,-1 0,-1 0,-3-13,-1 7,0 0,-1 1,-1-1,-1 1,0 1,-2 0,0 0,-1 1,0 0,-1 1,-1 1,-21-18,4 7,-1 1,-1 2,-1 1,0 1,-53-20,34 20,0 2,-62-12,15 11,-2 5,-171-2,-211 45,280-1,-234 64,273-45,-284 120,218-54,194-91,0 1,2 2,-57 53,81-67,0 0,1 1,0 1,1-1,0 1,1 1,1 0,0 0,0 0,-6 26,10-29,1 0,1 0,0 1,0-1,1 0,0 1,1-1,0 1,1-1,1 0,0 0,0 0,1 0,0-1,7 13,-2-8,1 0,1 0,0-1,1 0,0-1,1 0,1-1,0-1,25 16,0-3,2-2,74 28,-33-21,1-4,1-3,1-4,1-4,0-3,1-5,-1-3,95-9,-130 1,0-1,0-3,0-3,-2-1,1-3,-2-2,86-44,-108 48,-1-2,-1-1,0 0,-2-2,0-1,-1 0,0-2,-2 0,-1-2,-1 0,-1 0,-1-2,-1 0,-1 0,9-30,-15 35,-1 0,-1 0,-1 0,-1-1,-1 1,-1-1,-1 0,0 1,-2-1,-1 0,0 1,-9-27,7 31,-2 1,0 0,0 0,-2 1,0 0,0 0,-2 1,0 1,0-1,-1 2,-1 0,0 0,0 1,-1 1,-31-17,7 8,-1 2,-1 2,0 2,0 1,-76-11,13 10,-129 2,77 13,1 7,0 7,-177 41,87 9,204-51,1 1,1 2,-66 42,91-51,0 0,1 1,0 1,1 0,0 0,0 1,1 0,-8 15,14-21,1 0,0 0,0 0,1 0,-1 1,1-1,1 1,-1-1,1 1,1 0,-1-1,1 1,0 0,0 0,1-1,0 1,0-1,1 1,0 0,0-1,4 9,-1-6,0-1,0 1,1-1,0-1,0 1,1-1,10 9,7 3,32 20,-7-10,55 26,116 33,-48-33,2-9,2-6,1-9,351 16,-421-45,211-25,-272 16,0-2,0-2,-1-2,0-2,-1-2,78-43,-102 48,-2-1,0-1,-1 0,0-1,-1-1,-1-1,0 0,-1-1,-1 0,15-31,-20 35,-1-1,-1 0,0-1,-1 1,-1-1,-1 0,0-1,-1 1,0 0,-2-1,0 1,0 0,-2-1,0 1,-4-16,3 21,-1 0,0 1,0-1,-1 1,0 0,-1 1,0-1,-1 1,0 0,0 1,-9-9,5 8,-1-1,0 2,-1 0,1 0,-2 1,1 0,-22-6,2 4,1 1,-1 2,0 1,-1 1,1 2,-60 5,30 3,1 3,0 2,1 4,0 2,1 2,1 3,1 3,2 2,0 3,2 2,-89 70,116-80,2 1,0 2,2 1,-33 45,46-57,2 1,-1-1,2 1,0 1,1-1,1 1,0 0,1 0,1 1,0-1,0 26,4-20,1 0,1 0,1-1,0 0,2 0,1 0,0 0,2-1,0 0,1-1,1 0,1-1,0 0,2-1,0 0,22 20,2-5,1-1,1-3,2-1,50 24,-5-10,107 35,-151-60,-1-3,2-1,0-3,0-1,55 2,-92-9,1-1,-1 0,0-1,1 0,-1 0,0 0,0-1,0 0,0-1,0 0,8-4,-11 4,0 0,0 0,-1 0,1 0,-1-1,0 0,0 1,0-1,0-1,-1 1,1 0,-1-1,0 1,0-1,-1 1,0-1,2-7,-1-1,0 0,-1 0,-1 0,0 0,0 0,-1 0,-1 0,-5-20,1 15,0 0,-1 1,0 0,-2 0,-14-22,2 10,-2 0,-1 1,-1 2,-1 0,-50-37,18 23,-2 2,-1 3,-1 3,-2 2,-1 4,-96-27,57 27,-1 4,0 5,-168-6,171 21,0 4,-140 23,187-16,0 2,1 3,1 3,1 1,0 3,-50 28,87-40,-1 1,1 0,1 0,0 2,1 0,0 0,-20 26,28-31,0 1,0 0,1 0,0 1,0-1,0 1,2 0,-1 0,1 0,0 0,1 0,0 1,0-1,1 0,0 1,3 14,-1-11,1 0,0 0,1 0,0-1,1 1,0-1,1 0,1 0,0-1,0 0,1 0,1-1,0 1,0-2,1 0,0 0,0-1,1 0,0 0,1-1,15 7,18 4,0-2,1-2,1-2,0-2,94 7,-131-16,-1-1,1 0,-1-1,1 0,-1 0,1-1,-1 0,0-1,0 0,13-6,-13 3,-1 1,1-2,-1 1,0-1,-1 0,1 0,-1-1,-1 0,9-13,1-4,-1-1,-2 0,0-1,-2 0,0-1,-2 0,-2-1,0 0,-2 0,-1 0,0-36,-4 42,-1-1,-1 1,-1 0,-1 0,-1 0,0 0,-2 1,-1 0,-1 0,-1 1,-1 0,0 1,-2 0,-28-35,17 30,-2 1,0 1,-2 2,0 0,-1 2,-1 1,-1 2,-1 0,-36-11,-3 3,-1 3,-1 3,-89-10,-105 5,231 22,0 3,0 0,0 3,0 0,-46 15,76-18,1 0,0 0,0 0,-1 0,1 1,1 0,-1 0,0 1,1-1,0 1,-1 0,2 0,-7 9,7-9,1 0,0 0,0 0,1 1,-1-1,1 1,0-1,0 1,1 0,-1-1,1 1,0 0,0-1,1 1,-1 0,1-1,2 6,2 8,1 1,1-1,1-1,0 0,2 0,0 0,0-1,18 19,-2-5,2-2,0-1,40 29,-16-20,1-2,1-2,2-2,1-4,1-1,67 18,-47-22,0-3,2-3,0-4,110 2,-137-13,1-3,0-1,-1-3,0-3,-1-1,0-3,0-3,65-30,-84 31,-1-1,-1-2,-1-2,0 0,39-40,-48 41,-2-2,0 0,-2-1,0-1,-2-1,-1 0,18-42,-26 50,1-1,-2 0,-1 0,0 0,-1-1,-1 1,-1-1,0 0,-4-32,1 40,0-1,0 1,-2-1,1 1,-1 0,-1 1,0-1,-1 1,0 0,0 0,-1 0,0 1,-1 0,0 1,0 0,-16-13,6 9,-1 1,0 0,-1 2,1 0,-2 1,-35-9,1 5,-81-8,45 13,-1 4,1 3,-1 5,1 4,0 4,1 3,1 5,0 3,2 5,1 3,-111 58,150-64,1 1,-78 63,106-75,0 1,1 1,1 1,1 0,1 0,0 2,1 0,-19 41,29-54,1 0,0-1,0 2,0-1,0 0,1 0,1 0,-1 1,1-1,0 0,1 1,0-1,2 11,0-11,-1 0,2 0,-1 0,1 0,0-1,0 1,0-1,1 0,0-1,1 1,-1-1,1 0,7 5,7 3,0-1,1-1,1 0,0-2,0-1,1 0,24 4,28 5,1-4,1-3,-1-3,134-5,-108-9,0-4,-2-4,111-33,-140 28,130-56,-173 63,-1-1,0-2,-1 0,-1-2,0-1,-2 0,25-27,-41 38,-1 0,1 0,-1-1,-1 1,0-1,0-1,0 1,-2-1,1 0,-1 0,2-10,-4 12,0 0,-1 1,0-1,0 1,-1-1,0 1,0-1,-1 1,0-1,0 1,0 0,-1 0,0 0,-1 0,-6-9,0 3,-1 1,0 0,0 0,-1 1,-1 1,0 0,0 1,-1 0,0 1,0 1,-1 0,-16-5,-18-4,-1 2,-78-13,25 13,0 3,-109 4,130 9,0 4,1 3,-90 23,140-25,1 2,1 0,0 2,0 2,-27 15,47-22,-1 1,1 0,0 0,0 1,1 0,0 0,-8 12,11-13,1 0,0 0,1 0,-1 0,1 1,1-1,0 1,0 0,0-1,1 1,-1 13,3-5,0 0,1 0,1 0,0 0,1-1,1 1,0-1,1 0,1-1,0 1,18 25,1-4,2-1,1-1,36 33,-7-14,2-4,2-1,2-4,2-3,1-2,2-3,2-4,1-2,2-4,109 24,-148-43,0-1,1-2,-1-2,1-1,-1-2,68-10,-80 6,0-1,0-1,0 0,-1-2,-1-1,1-1,-2 0,1-2,-2 0,0-1,22-22,-12 8,-2-2,-1-1,-1-1,-2-1,-1-1,18-41,-26 46,-2 0,-1-1,-1 0,-1 0,-2-1,-1-1,-2 1,1-43,-5 63,0-1,-1 1,0 0,-1 0,0 0,-5-12,6 19,-1 0,0 0,0 0,-1 0,1 0,-1 0,0 0,0 1,0 0,0-1,-1 1,1 0,-1 1,0-1,1 1,-1-1,-6-1,1 0,-1 1,0 1,1-1,-1 2,0-1,0 1,0 1,0 0,0 0,0 1,0 0,0 1,1 0,-1 1,0 0,1 0,0 1,0 0,-11 7,7-3,1 0,0 0,0 2,1-1,0 1,1 1,0 0,0 1,2-1,-1 2,1-1,-9 22,10-18,1 1,0 0,2 0,0 1,0-1,0 20,4-27,0 0,0 0,1 0,0 0,1-1,0 1,0 0,1-1,0 1,1-1,0 0,1 0,5 8,2-1,1 0,1-1,0-1,1 0,0-1,1 0,0-1,28 14,2-2,0-2,61 18,-31-15,2-3,0-3,149 14,-179-29,0-3,0-1,0-3,0-2,0-2,-1-2,81-27,-111 30,0-1,-1-1,1-1,-2-1,1 0,-1 0,23-23,-34 28,1 0,-1 0,0 0,0-1,0 0,-1 0,0 0,0 0,-1 0,4-11,-6 12,1 0,-1 0,1 0,-1 0,-1 0,1 0,-1 0,0 0,0 1,0-1,-1 0,1 0,-1 1,0-1,-1 1,-3-5,-1-2,-2 1,1 0,-1 0,-1 1,0 1,0-1,0 2,-1-1,-1 2,1-1,-25-9,12 7,0 2,-1 0,0 1,0 1,-30-1,27 4,0 2,0 0,0 2,0 1,0 2,1 0,-1 2,1 1,1 1,0 1,-35 20,54-26,0 0,1 1,0 0,0 0,0 0,1 1,0 0,0 0,0 0,1 0,0 1,-5 10,5-7,0 1,1 0,0 0,1 0,0 0,1 0,-1 22,3-12,1 0,1 0,1 0,1-1,0 1,2-1,0-1,19 36,-10-27,2-1,1 0,1-2,1 0,1-1,1-1,52 39,-52-46,0-1,1-1,1-1,1-1,-1-1,2-1,-1-2,1 0,46 5,-63-12,-1 0,1 0,-1-2,1 1,0-1,-1 0,1-1,-1 0,0-1,16-6,-18 5,-1 1,1-1,-1 0,0-1,-1 1,1-1,-1 0,0-1,0 1,-1-1,1 0,-1 0,-1 0,7-13,-4 2,-1 0,0 1,-1-2,-1 1,-1 0,0-1,-1 1,-1-1,-1 1,0 0,-2-1,0 1,0 0,-10-26,4 19,0 0,-2 1,0 0,-2 0,0 1,-2 1,0 1,-2 0,-23-23,16 21,-44-31,57 46,-1-1,0 2,0-1,0 2,-1-1,-19-4,28 10,-1-1,1 1,0-1,0 1,0 1,0-1,0 1,0-1,0 1,0 0,0 0,0 1,0-1,0 1,1 0,-1 0,-3 3,4-3,1 0,0 0,0 0,0 0,0 0,0 0,1 0,-1 0,1 1,-1-1,1 1,0-1,0 1,0-1,0 1,1 0,-1-1,1 1,-1 0,1 0,0 0,0-1,0 1,1 0,-1 0,1 3,1-3,-1 0,1 0,-1 0,1 0,0 0,0-1,0 1,0-1,1 1,-1-1,1 0,0 0,-1 0,1 0,0 0,0-1,0 1,0-1,0 0,1 0,3 1,5 1,0-1,0 0,0 0,22-1,-18-2,0-1,1-1,-1 0,-1-1,1-1,-1 0,1-2,-2 1,1-2,-1 0,0 0,0-1,-1-1,-1-1,1 1,11-16,0-1,-1-1,-1-1,-2-1,-1-1,-2-1,18-43,-17 29,-1-2,-3 0,-2 0,-2-1,-2-1,-2 1,-3-1,-1 0,-3-1,-2 1,-2 1,-2-1,-3 1,-27-82,31 113,-1 0,-1 0,-1 1,0 1,-1-1,-14-16,16 24,-1-1,0 1,0 1,-1 0,0 0,-1 1,0 0,0 1,-21-9,9 6,1 2,-1 1,0 1,-1 1,1 1,-27-1,37 4,0 0,0 1,0 0,0 1,1 1,-1 0,0 0,1 1,0 1,0 0,0 1,-17 11,23-12,0 0,0 0,1 0,-1 1,1 0,1 0,-1 0,1 1,0 0,1-1,-1 1,2 0,-1 1,1-1,0 0,0 1,1 0,0-1,0 1,0 0,1-1,2 14,0-9,0-1,1 0,0 1,0-1,2 0,-1 0,1-1,1 1,0-1,0-1,1 1,0-1,1 0,13 12,-2-5,1-2,0 0,1-1,0-1,1-1,0-1,38 12,-6-7,-1-3,75 8,-60-14,0-3,-1-3,1-2,-1-4,1-3,-2-2,1-4,-2-2,0-3,-2-3,0-3,-1-3,87-55,-111 60,-2-2,-1-2,50-51,-71 65,-1-1,-1-1,0 0,-1 0,-1-1,0 0,-1-1,-1 0,-1-1,7-27,-12 37,0 0,-1 0,-1 0,1-1,-1 1,-1 0,0 0,0 0,-1 0,0 0,0 0,-1 0,0 1,-9-17,5 14,0 1,-1-1,0 2,-1-1,0 1,0 1,-1-1,0 2,-20-12,0 3,-1 2,0 1,-1 1,-1 2,0 1,0 2,-40-4,14 7,0 2,0 2,0 4,1 2,-111 25,128-20,0 1,1 2,0 2,1 2,-60 37,73-38,0 2,1 0,2 2,0 0,1 2,1 0,1 2,-22 35,33-46,1 0,1 1,0 0,1 1,1 0,0 0,1 0,1 0,-2 20,4-27,1 0,1 0,-1 0,1 0,1 0,0 0,0 0,1 0,0 0,0-1,1 0,0 1,1-1,0-1,0 1,0-1,1 0,8 8,4 0,1 0,0-1,1-1,1-1,0 0,0-2,1-1,0 0,33 7,-1-3,0-3,111 7,-99-15,1-3,-1-2,0-4,77-16,-106 14,1-1,-1-2,-1-2,0-1,-1-2,-1-1,-1-2,46-35,-62 41,-1 0,0-2,-1 0,-1-1,-1 0,0-1,-2-1,0 0,17-40,-24 48,0-1,-2 1,1-1,-1 0,-1 0,0 0,0 0,-3-19,1 22,-1 0,0-1,-1 1,0 0,0 0,-1 0,0 1,0-1,-1 1,-1 0,-10-13,6 11,0 1,0 0,-1 0,0 1,0 1,-1 0,0 0,-1 1,1 1,-1 0,0 0,0 2,-1-1,-19-1,1 2,1 1,-1 1,1 2,-1 2,-41 7,14 3,0 3,1 2,1 2,1 3,1 2,1 3,-67 46,60-31,3 2,1 3,2 2,3 3,-75 97,101-114,1 0,2 2,1 1,2 1,2 0,2 1,-14 53,25-70,1 1,0-1,2 1,1-1,1 1,3 26,0-32,0 0,1-1,2 1,-1-1,2 0,0-1,2 0,15 26,-12-26,0-2,1 0,0 0,1-1,1-1,0 0,1-1,0-1,34 18,-10-10,0-3,2 0,57 12,-86-25,0 0,0-1,0 0,1-1,-1 0,1-1,-1-1,1 0,-1-1,0-1,0 0,0 0,0-1,0-1,-1 0,1-1,-1 0,-1-1,0 0,0-1,17-15,-15 10,-1 0,-1 0,0-1,15-25,-21 30,0 0,-1-1,0 0,0 0,-1 0,0 0,-1 0,0 0,0-12,-2 19,0 0,0 0,0-1,0 1,-1 0,1 0,-1 0,0 0,0 0,0 0,0 0,-1 0,1 1,-1-1,0 0,0 1,0-1,0 1,-3-3,2 3,0 0,0 0,0 0,-1 0,1 1,-1 0,0-1,1 1,-1 0,0 1,1-1,-1 1,0 0,0 0,-7 0,-11 3,-1 1,1 1,1 1,-1 0,1 2,-33 16,24-8,1 1,1 2,-47 39,55-40,1 1,2 1,-1 0,2 1,1 1,1 1,1 0,1 1,0 0,2 0,1 1,2 1,-9 40,15-54,0-1,1 0,0 1,1-1,0 0,0 1,1-1,1 0,0 0,0 0,7 12,-3-10,0 0,1-1,0 0,1 0,0-1,1 0,0-1,12 10,-3-5,2-1,0 0,1-2,0 0,0-1,1-2,1 0,0-2,47 9,-50-13,-1-1,1-2,-1 0,1-1,0-1,-1-1,0-1,0 0,0-2,0 0,-1-1,0-1,0-1,-1-1,-1 0,30-23,-28 17,0 0,0-2,-2 0,0-1,-2 0,0-2,-1 0,-1 0,0-1,-2-1,-1 0,-1-1,8-32,-13 40,-1 0,-1-1,0 1,-1-1,-1 0,-1 1,0-1,-2 0,-4-21,4 27,-1 1,1-1,-1 1,-1 0,0 1,0-1,-1 1,-1 0,1 1,-1-1,0 1,-1 1,0-1,0 1,-13-7,9 6,-1 1,1 1,-2 0,1 1,-1 1,1 0,-1 0,0 2,-1-1,1 2,0 0,-1 1,1 0,-21 4,13 0,0 1,0 1,1 1,0 1,1 1,0 1,0 0,-28 21,26-16,0 2,2 0,0 1,1 1,0 1,-30 44,42-54,1 1,0 0,1 0,0 1,1-1,0 1,0 0,1 0,1 0,0 1,1-1,0 1,1-1,1 0,0 1,0-1,4 16,-2-19,0 0,0-1,0 0,1 0,0 0,1 0,0-1,0 1,0-1,1-1,0 1,0-1,10 7,-5-5,0 0,1-2,0 1,0-2,0 1,1-2,0 0,14 3,2-2,0-1,-1-2,1-1,0-1,0-1,0-2,45-10,-34 3,0-2,-1-2,0-2,-1-1,-1-2,-1-1,-1-2,-1-2,0 0,-2-3,37-39,-47 42,-2-1,0 0,-1-2,-2 0,-1-2,18-42,-24 47,-2-2,-1 1,0-1,-2 0,-1 0,-2 0,0 0,-3-40,-1 44,-1 0,-1 0,-1 0,-1 0,-1 1,0-1,-2 2,-1-1,0 1,-21-29,15 28,-1 0,-1 1,0 1,-2 1,0 0,-1 2,-1 0,-36-19,23 17,0 1,-1 2,0 2,-2 1,1 2,-1 1,-1 2,1 2,-61 0,93 5,0 0,0 0,1 1,-1 0,0 0,1 0,-7 3,11-3,-1-1,1 1,0 0,0 0,0 0,0-1,0 1,0 0,0 0,0 1,0-1,0 0,0 0,1 0,-1 0,0 1,1-1,-1 0,1 1,0-1,-1 0,1 1,0-1,0 0,0 1,0-1,0 1,0-1,0 0,0 1,1-1,-1 0,0 1,2 1,0 2,0 1,1-1,-1 0,1 0,0 0,1-1,-1 1,1-1,0 0,0 0,1 0,-1 0,1-1,0 0,0 0,0 0,0 0,0-1,6 2,5 2,0-1,1-1,-1-1,1 0,23 1,-19-3,-1-2,1 0,-1-1,0-1,0-1,0-1,-1 0,1-2,-1 0,0-1,-1-1,0-1,-1-1,17-12,-22 14,-1 0,-1-1,0 0,0-1,-1 0,0 0,-1-1,0 0,-1-1,-1 0,0 0,0 0,-1-1,-1 1,0-1,-1 0,-1 0,0-1,-1 1,-1-26,-1 23,-1 0,-1 1,-1-1,0 1,-1-1,-1 1,-1 1,-10-20,5 15,0 1,-2 0,0 1,-1 1,-27-25,13 19,0 0,-1 2,-1 2,-1 1,-1 1,0 1,-53-16,64 26,-1 0,0 1,-1 2,1 0,0 2,-1 0,0 2,1 0,-24 5,30-3,0 1,0 1,1 0,-1 1,1 1,1 0,-1 1,1 1,1 1,-1 0,2 0,-21 21,30-26,-1 0,1 0,0 0,0 1,1-1,0 1,0 0,0 0,-2 9,4-11,0 0,1 1,-1-1,1 0,0 1,0-1,0 1,1-1,-1 0,1 1,0-1,1 0,-1 1,1-1,2 4,1 1,1 0,0 0,0-1,1 1,0-2,0 1,1-1,0 0,1 0,17 10,0-3,0-1,50 16,-30-15,1-2,1-2,0-2,0-2,0-2,1-2,-1-3,1-1,-1-3,0-2,0-1,-1-3,0-2,-1-2,0-2,-1-2,68-41,-90 46,-1-2,0-1,-2 0,0-2,-1 0,0-1,-2-1,15-23,-24 33,-1-1,0-1,-1 1,-1-1,0 0,-1 0,0 0,-1-1,0 1,-1-1,-1 0,0 0,-1 0,0 1,-1-1,-1 0,-4-18,0 14,0 1,-2 0,0 0,0 1,-2 0,0 0,-1 1,0 1,-2 0,1 0,-28-21,2 5,0 3,-2 1,-61-29,22 15,-1 3,-112-34,184 69,3 0,-1 0,0 0,0 1,0-1,0 2,0-1,0 1,0 0,-1 0,1 0,-7 2,12-1,0-1,0 1,0-1,0 1,0 0,0 0,0 0,0 0,1 0,-1 0,0 0,1 0,-1 0,0 0,1 0,-1 0,1 0,-1 0,1 1,0-1,0 0,-1 0,1 0,0 1,0-1,0 0,0 0,1 1,-1-1,0 0,0 0,1 0,-1 1,1-1,0 2,2 6,1 0,0 0,7 11,-9-18,14 23,1-1,1-1,1 0,1-2,1 0,1-1,0-2,2 0,0-1,1-2,36 18,-56-31,0 0,0 0,0 0,1-1,-1 1,0-1,1-1,-1 1,1-1,-1 0,7-1,-10 1,1-1,0 0,0 0,-1 0,1 0,0 0,-1-1,0 1,1-1,-1 1,0-1,1 0,-1 0,0 0,-1-1,1 1,0 0,0-1,-1 1,0-1,1 1,1-6,2-8,0-1,-1 0,-1-1,0 1,-1-1,-1 1,-2-23,-3-13,-10-58,-6 4,-5 1,-4 1,-46-106,72 202,-5-12,-2 1,-20-35,28 51,-1 0,1 1,-1-1,0 1,0-1,0 1,0 0,0 0,-1 1,0-1,1 1,-1 0,0 0,0 0,0 0,0 1,0-1,-1 1,1 0,-9-1,9 3,0-1,-1 1,1 0,0 0,0 0,-1 1,1 0,0-1,0 1,1 1,-1-1,0 0,-3 4,-5 5,0 0,-12 15,14-15,-28 32,2 2,2 1,-53 94,73-113,1 1,1 1,1 0,2 1,0 0,3 0,0 1,-2 56,8-71,1-1,0 1,1-1,1 0,0 0,1 0,1 0,12 26,-12-31,0-1,1 0,0 0,1-1,-1 0,2 0,-1-1,1 0,0 0,1 0,-1-1,1-1,1 0,10 5,-4-3,1-1,0-1,0-1,1 0,-1-1,1-1,29 0,-22-4,1 0,0-1,-1-2,45-13,-30 4,-1-2,0-2,-1-1,-1-3,0 0,40-35,-42 28,-1-2,-1-1,-3-1,0-2,-2 0,24-43,-38 54,-1 0,-1-2,-2 1,13-45,-19 51,0 0,-1 0,-2-1,1 1,-2-1,-1 1,-3-25,1 29,-1 0,0 1,-1 0,0 0,-2 0,1 0,-1 1,-1 0,-1 1,0 0,0 0,-1 1,0 0,-1 0,-1 2,1-1,-1 1,-16-8,0 1,0 2,-1 1,0 2,-1 0,0 2,-1 2,-54-7,11 7,0 4,1 3,-133 17,91 2,-186 55,237-54,-77 36,111-42,1 2,0 1,1 1,-35 30,57-43,0 0,1 0,0 1,0-1,0 1,1 1,0-1,0 0,0 1,1 0,0 0,1 0,-1 0,1 1,1-1,-1 1,1-1,1 1,-1-1,1 1,0-1,1 1,0-1,0 1,1-1,0 1,0-1,1 0,-1 0,2 0,-1 0,6 8,8 7,0 0,1-1,1-1,0-1,2 0,29 19,-20-17,2-1,0-2,1-1,44 15,-58-25,0-2,0 0,39 4,-50-8,-1 0,1-1,0 0,-1-1,1 0,-1 0,1 0,-1-1,1 0,-1-1,0 1,0-1,8-5,-11 5,-1 0,1-1,-1 1,1-1,-1 1,0-1,-1 0,1-1,0 1,-1 0,0-1,0 1,-1-1,1 0,-1 1,0-1,0 0,-1 0,1 0,-1 0,0-7,-1-2,-1 0,0 1,-1 0,0-1,-1 1,-10-23,1 10,-2 1,0 1,-1 0,-2 1,0 1,-2 1,0 1,-27-21,3 6,-2 2,-1 2,-64-31,46 31,-2 3,-1 3,-1 3,-140-25,145 37,0 4,-1 2,1 3,-1 3,-117 19,138-12,1 3,-1 1,2 2,-59 29,72-29,1 1,0 1,2 2,0 1,1 1,-42 45,59-57,0 2,1-1,0 1,0 0,1 1,1-1,0 1,1 0,0 1,0-1,2 0,-1 1,2 0,-1 24,3-21,0 0,2 0,0 0,0-1,2 1,0-1,0 0,2 0,0-1,0 0,17 23,0-6,3 0,0-1,2-2,1 0,1-3,62 40,-29-27,2-2,127 48,-137-64,0-3,1-2,1-2,0-4,0-1,1-4,66-2,-87-4,0-1,0-3,0 0,-1-3,0-1,-1-2,0-1,-1-2,0-1,-1-2,61-43,-73 43,-1-1,-1 0,-1-2,-1 0,-1-1,0-1,-2 0,-1-1,-1-1,-1 0,-1-1,-1 0,7-30,-12 35,-1 1,-1-2,-1 1,-1 0,-1 0,0-1,-7-36,4 42,-2-1,1 1,-2 0,0 0,-1 1,-1 0,0 0,-1 0,-1 1,-15-18,11 18,-1 0,0 0,-1 2,-1 0,0 1,0 0,-1 2,0 0,-1 1,0 1,0 0,-38-6,13 6,-1 1,-1 2,1 3,-79 7,56 2,1 3,0 4,1 2,0 3,-71 33,39-8,3 4,-138 95,147-83,2 5,4 3,-122 135,149-141,2 2,3 3,2 2,5 2,-41 93,62-118,2 1,3 0,2 2,-14 90,25-118,0 1,2-1,0 0,1 1,2-1,0 0,1 0,1 0,1-1,1 0,1 0,1 0,17 27,-12-27,2 0,0-1,1 0,2-1,36 29,-25-26,1-1,1-2,54 25,-29-21,1-3,1-2,0-2,108 12,-93-20,1-4,-1-3,1-4,123-19,-146 13,0-3,-1-2,0-3,-2-1,0-3,-1-1,61-41,-81 45,-2-2,0-1,-2-1,0-1,38-49,-48 53,-1-1,-1 0,-1-1,0-1,-2 1,0-2,-1 1,7-42,-12 53,-2 0,0 0,0 0,-1 0,0 0,-1 1,0-1,-1 0,0 0,0 0,-2 1,1-1,-1 1,-1 0,1 0,-2 1,0-1,0 1,0 0,-1 1,0 0,-1 0,0 0,0 1,-1 0,0 1,0 0,0 0,-1 1,-17-8,5 6,1 0,-1 2,-1 0,-34-2,-99 4,66 10,1 3,0 5,-165 48,118-17,-220 108,252-100,2 4,-169 129,214-141,3 2,2 3,2 1,2 3,-70 105,99-129,2 0,1 1,1 0,2 2,1-1,2 1,-10 57,17-69,1 0,2 0,0 0,1 0,0 0,2-1,1 1,1-1,1 1,0-1,2-1,0 1,16 26,-12-27,1-1,1 0,1-1,0 0,2-1,0-1,0-1,26 17,-17-15,1-1,1-1,1-2,0-1,50 14,-32-15,1-2,0-2,0-2,0-2,1-2,-1-3,95-15,-91 7,-2-3,1-2,-2-2,0-2,-1-3,-1-1,-2-3,0-1,-2-3,-1-1,-1-2,-2-2,-1-1,-2-3,-2 0,-1-2,-3-2,50-90,-64 103,-2-2,-1 0,-2 0,-1-1,-1 0,-2-1,-1 0,-2 0,0-45,-4 59,-1 0,-2 0,0 1,-1-1,0 1,-2 0,0 0,-1 0,-1 1,-1 0,-1 1,0 0,-1 0,-1 1,0 0,-2 1,-20-19,9 14,-2 0,1 2,-2 1,-1 1,0 1,0 2,-33-10,-6 2,-1 4,-91-12,19 13,-2 6,1 6,-247 24,255-3,1 6,2 6,0 6,-133 54,66-2,166-70,0 1,2 1,-50 43,73-56,-1 1,1 0,1 1,-1 0,2 0,-1 0,1 0,0 1,0 0,1 0,-5 17,7-18,1 0,0 0,0 1,1-1,0 0,0 1,1-1,0 0,1 1,0-1,0 0,0 0,1 0,5 9,6 10,1-1,2-1,0 0,2-1,1-1,0-1,25 21,7 0,1-2,62 36,-65-46,2-3,97 39,-128-59,0-1,1-1,0 0,0-2,1-1,-1-1,1 0,-1-2,1-1,31-4,-44 2,1 1,-1-1,0-1,0 0,-1 0,1-1,-1 0,0-1,0 0,-1 0,0-1,0 0,7-9,-6 6,-1-1,-1 0,0 0,0-1,-1 0,-1 0,0-1,0 1,4-21,-6 14,0 1,-1-1,-1 1,0-1,-2 0,0 1,-1-1,-1 1,-1-1,0 1,-1 0,-2 1,1-1,-19-32,12 31,-1 1,-1 0,0 1,-1 1,-1 0,-1 1,0 1,0 1,-40-21,11 10,-1 3,-1 2,-65-16,20 12,-1 4,0 5,-1 3,-1 5,-97 6,151 2,1 1,-1 2,1 1,-81 25,115-28,0 0,1 1,-1-1,1 1,-1 1,1 0,-6 5,11-8,0 0,0 0,0 0,0 0,0 1,1-1,-1 0,1 1,0-1,0 1,0 0,0-1,0 1,0 0,1-1,-1 1,1 0,0 0,0 0,0 0,0-1,0 1,2 4,1 4,0 0,1-1,1 1,0-1,0 0,1 0,12 16,0-4,1-1,23 20,-9-13,2 0,1-2,1-2,1-1,0-2,2-2,1-1,0-3,1-1,0-2,57 9,-83-19,-1 0,0-2,0 1,1-2,-1 0,0-1,22-5,-31 5,1 0,-1 0,0 0,0-1,-1 0,1 0,-1-1,1 1,-1-1,0-1,-1 1,1 0,-1-1,1 0,-2 0,1-1,0 1,-1-1,0 1,3-9,-3 5,-1 0,0-1,0 1,-1-1,0 0,-1 1,0-1,0 0,-1 1,0-1,-1 1,0-1,0 1,-1 0,0-1,-1 2,0-1,-1 0,-5-8,-2 0,0 0,-1 0,0 2,-2-1,0 2,-1 0,-32-22,18 17,0 2,-2 1,0 2,-1 1,-57-15,43 17,-1 3,0 1,-77-1,94 9,-60 7,81-7,0 1,1 0,-1 1,0 0,1 1,0 0,0 0,0 1,0 0,-8 7,15-10,0 0,0 0,0 0,0 1,0-1,0 1,1-1,-1 1,1 0,0-1,-1 1,1 0,1 0,-1 0,0 0,0 4,1-2,0 0,1 0,-1 0,1 0,0 0,0 0,1 0,-1-1,4 7,1 0,0 1,2-1,-1 0,1 0,1-1,14 14,-11-13,-4-2,1 0,1-1,-1-1,1 1,20 9,-28-16,1 0,0 0,-1 0,1 0,0-1,0 1,-1-1,1 0,0 1,0-1,0-1,0 1,-1 0,1-1,0 0,0 1,-1-1,1 0,-1 0,1-1,0 1,-1 0,0-1,1 0,-1 1,0-1,0 0,0 0,0 0,3-5,1-1,0-1,-1 0,0 0,0 0,-1-1,0 0,-1 1,0-1,0-1,-1 1,0 0,-1-1,-1 1,1 0,-2-1,1 1,-1-1,-1 1,0 0,-5-17,3 13,-1 1,-1 0,0 0,0 0,-1 1,-1 0,0 0,-1 1,0 0,0 0,-1 1,-1 0,0 1,-22-15,11 13,-1 0,0 1,0 2,-1 0,0 1,-1 2,1 0,-39-1,35 5,-1 0,0 3,0 0,1 2,0 0,0 3,-33 10,55-15,-1 1,0 0,1 0,0 1,-1-1,2 1,-12 10,15-13,1 1,-1 0,1 0,-1 0,1-1,0 1,0 1,0-1,0 0,0 0,0 0,1 0,-1 1,1-1,-1 0,1 1,0-1,0 0,0 1,0-1,1 0,-1 1,0-1,1 0,0 0,0 1,-1-1,1 0,2 2,1 3,0-1,1 1,0-1,0 0,1 0,0-1,0 0,0 0,0 0,1-1,0 0,0 0,9 3,8 3,1 0,46 9,-35-11,1-2,1-2,-1-1,1-1,52-6,-64 1,0-1,0-1,0-1,0-2,-1 0,0-2,-1-1,35-20,-44 21,-1-1,1 0,-2-1,0 0,0-1,-1-1,15-22,-21 28,-2 1,1 0,-1-1,0 0,-1 0,0 0,0-1,-1 1,0-1,0 1,-1-1,0 0,-1 1,0-1,0 0,-1 0,-2-12,-1 10,0 0,-1 0,0 0,-1 1,0-1,-1 1,0 1,0-1,-1 1,0 1,-18-15,4 6,0 1,-2 1,-49-24,33 22,0 2,-1 1,-1 2,-76-12,86 20,1 2,0 1,0 1,-1 1,1 2,0 1,-41 11,67-13,0-1,1 1,-1 0,1 0,-1 0,1 0,-1 1,1 0,0 0,0 0,1 0,-1 1,1 0,-1-1,1 1,0 0,1 1,-3 3,3-3,0 0,0 0,1 0,0 1,0-1,1 0,-1 0,1 0,0 1,1-1,-1 0,1 0,0 0,0 1,1-1,0 0,2 5,0-1,1 0,0-1,1 1,0-1,1 0,-1-1,1 0,1 0,-1 0,1-1,1 0,10 6,4 1,0-1,1-1,40 12,-42-16,0-1,1-1,-1-1,1-1,0-1,34-1,-47-2,0 0,-1 0,1-1,-1 0,1 0,-1-1,0-1,0 0,0 0,-1 0,1-1,-1 0,0-1,0 0,-1 0,0-1,12-14,-15 15,0 1,0-1,-1-1,0 1,0 0,0-1,-1 0,0 1,0-1,-1 0,2-14,-3 11,-1-1,1 1,-2 0,1 0,-1 0,-1 0,-6-16,3 10,-2 1,0 1,0-1,-2 1,1 1,-2 0,0 0,0 1,-27-21,25 23,-1 2,-1-1,0 2,0 0,0 1,-1 0,0 1,0 1,0 1,0 0,-1 1,1 1,-32 1,39 1,0 0,1 1,-1 0,1 0,0 1,0 0,0 1,0-1,0 1,0 1,1 0,0 0,0 0,1 1,-12 11,11-7,-1 0,1 0,1 0,0 1,0-1,1 1,0 1,1-1,0 1,-3 20,4-16,1 0,0 0,1 1,1-1,1 0,0 0,8 32,-8-42,1 0,0 0,0-1,1 1,0-1,0 1,0-1,0 0,1 0,0 0,0-1,1 0,-1 1,1-1,0-1,0 1,0-1,0 0,0 0,1 0,0-1,-1 0,1 0,9 2,-8-3,1 0,0 0,-1 0,1-1,0 0,0 0,-1-1,1 0,0-1,-1 0,1 0,-1 0,9-5,-6 2,-1 0,0-1,0 0,0-1,-1 0,1-1,-2 1,11-14,-3-1,-1 1,-1-2,0 0,-2 0,-1-1,-1-1,7-28,-8 19,-1 1,-2-1,-1-1,-2 1,-4-67,0 80,-1 1,-1 0,0 0,-2 0,0 0,-1 1,-1 0,-1 1,0-1,-2 2,-15-22,21 33,-1 0,0 0,0 0,0 1,-1 0,0 0,0 1,0-1,-1 2,1-1,-1 1,0 0,0 0,0 1,0 0,0 1,0 0,-1 0,1 1,0 0,-1 0,1 1,-9 2,5-1,1 1,0 0,0 1,0 0,0 1,1 0,0 0,0 1,0 1,1 0,0 0,0 1,0 0,1 0,1 1,-8 10,4-1,1 0,1 1,0 0,2 1,0 0,-8 37,10-25,0 1,2-1,3 57,0-78,1-1,1 1,0-1,0 0,1 0,0 0,1 0,0-1,1 1,0-1,0 0,1 0,0-1,0 1,1-1,13 11,-13-13,1 0,-1-1,1 0,1-1,-1 0,1 0,-1 0,1-1,0-1,0 1,1-2,-1 1,0-1,1 0,-1-1,0 0,1-1,17-3,-9-1,-1 0,1-1,-1-1,-1 0,1-2,-1 0,-1 0,0-1,0-1,-1-1,0 0,-1-1,22-28,-9 6,-1-1,-2-1,-2 0,29-71,-30 57,-2-1,-3-1,-1 0,7-73,-17 94,-2 0,-2 1,0-1,-2 0,-2 0,-1 1,-1 0,-19-56,19 72,-1-1,0 1,-1 1,-1-1,0 1,-1 1,0 0,-1 0,-1 1,0 1,-22-17,23 20,-1 1,0 0,-1 1,0 0,1 1,-2 1,1 0,-1 1,1 0,-1 1,0 0,0 2,0-1,-16 3,9 0,0 1,0 1,1 2,-1-1,1 2,1 1,-1 0,1 2,-32 21,39-23,1 0,0 1,1 0,0 1,1 0,0 1,0 0,1 0,0 1,1 0,1 0,0 1,0-1,2 1,-7 27,9-33,1 1,0-1,1 0,0 1,0-1,1 1,0-1,0 0,0 1,1-1,0 0,1 0,6 13,-4-12,0 0,1 0,0-1,0 0,1 0,0 0,0-1,0 0,15 9,-2-4,1-1,0-1,1 0,-1-2,2 0,-1-2,1-1,27 3,-16-5,0-2,0-1,0-2,-1-1,1-1,-1-2,0-2,-1-1,48-21,-46 15,0-1,-2-2,0-1,-1-1,-1-2,-1-1,-1-1,34-42,-42 43,-2-1,-1-1,-1 0,-1-2,-1 1,-2-2,11-35,-18 48,-1 0,0 0,-2 0,1 0,-2 0,0-1,-1 1,-1-1,0 1,-2 0,1 0,-2 0,0 0,-1 0,-8-17,9 26,0 0,0 0,-1 0,1 1,-1 0,-1 0,1 0,-1 1,0-1,-1 1,1 1,-1-1,-11-4,8 4,0 1,-1 1,0 0,1 0,-1 1,0 1,0 0,-22 1,9 2,1 1,-1 1,0 1,1 1,0 1,0 1,1 1,-28 17,20-9,2 1,0 2,1 1,1 1,-45 51,54-54,2 1,0 1,1 1,1 0,1 0,1 1,1 1,-11 39,18-49,1 0,0 0,1 1,1-1,0 1,1-1,0 0,1 1,1-1,0 0,1 0,0-1,7 15,-6-17,1 0,0-1,0 0,1 0,0 0,1-1,0 0,0 0,1-1,0 0,0-1,1 0,0 0,1-1,21 10,-16-10,1-1,0-1,0 0,0-1,0-1,0-1,1 0,-1-1,0-1,25-4,-20 0,0 0,0-2,-1-1,1 0,-2-1,0-2,27-17,-20 9,-1-1,-1-1,-1-1,-1-1,-1-2,-1 0,-1-1,-2-1,0-1,-2 0,15-36,-20 36,-1 0,-1 0,-1-1,-2 0,-1 0,-1-1,0-38,-5 55,0 0,0 0,-2 0,1 0,-1 1,-1-1,-1 1,-6-16,6 20,0 0,-1-1,1 2,-1-1,-1 1,0 0,0 0,0 1,0 0,-1 0,0 1,-12-6,4 3,0 2,0 0,0 1,-1 0,1 1,-1 1,0 1,-1 1,1 0,0 1,0 1,0 0,0 1,0 1,0 1,0 0,-17 8,10-2,0 0,1 2,0 1,1 0,1 2,0 0,1 2,1 0,0 1,-28 35,32-32,0 1,1 0,1 1,2 0,0 1,1 0,2 1,0 0,2 0,1 1,0 0,0 40,5-51,0 0,1 0,1 0,0 0,1 0,1-1,0 1,1-1,1 0,0-1,1 1,0-1,1 0,0-1,1 0,1 0,0-1,0 0,1-1,0 0,1-1,0 0,19 10,-7-7,1 0,0-2,1-1,0-1,0-1,50 7,-23-9,1-2,84-7,-68-3,-1-2,-1-4,0-3,-1-2,108-46,-116 37,-1-2,-1-3,-2-2,-2-2,-1-3,59-57,-86 71,-1-1,-1-1,-1-1,-2 0,-1-2,-1 0,22-54,-32 65,-2 0,0-1,-1 1,-1-1,-1 0,0-1,-2 1,0 0,-1 0,-2-1,0 1,-1 0,0 0,-11-29,10 37,-1 0,0 1,-1 0,-1 0,0 0,0 1,0 0,-2 0,1 1,-17-14,13 13,-1 1,-1 1,0 0,0 0,0 2,-1-1,-26-6,16 7,-1 2,0 0,0 2,1 0,-1 2,0 1,0 1,0 1,0 1,-27 9,30-6,0 1,0 1,1 1,0 1,1 1,0 1,1 1,0 0,1 2,-22 22,30-25,0-1,1 2,0-1,1 1,1 1,0-1,1 2,1-1,0 1,1-1,1 2,0-1,1 0,1 1,-1 31,4-36,0 0,0 0,1 0,1 0,0 0,0 0,1-1,1 0,0 0,11 19,-7-17,1-1,0 0,1 0,0-1,0 0,1-1,21 14,-7-9,0-1,1-1,1-1,0-2,0 0,1-2,0-1,39 4,-30-8,0 0,0-3,0-1,72-11,-87 8,0-2,0 0,0-2,-1 0,-1-1,1-2,-1 0,-1-1,22-17,-32 21,-1 0,-1 0,0-1,0-1,0 1,-1-1,-1 0,0-1,0 0,-1 1,0-2,5-18,-7 20,-1 0,-1 0,0 1,0-1,-1 0,0 0,-1 0,0 0,0 0,-1 1,0-1,-1 1,0-1,-1 1,-9-17,2 9,0 1,-1 0,-1 1,-1 0,0 2,0-1,-2 2,1 0,-2 0,-27-14,16 12,-1 1,0 2,-1 0,0 2,-61-10,53 14,0 2,0 1,-1 2,1 1,0 3,0 1,0 1,-58 19,76-18,0 1,0 1,1 1,0 1,1 0,0 1,-19 17,25-17,0 1,0-1,1 2,1 0,0 0,1 1,0 0,1 0,-10 30,13-28,0-1,1 1,1 0,1 0,0 0,2 1,0-1,0 0,2 0,0 0,1 0,1 0,0 0,1-1,1 1,1-2,0 1,1-1,1 0,0 0,1-1,0 0,1-1,1 0,0-1,1-1,0 1,23 14,-12-12,0 0,1-2,0 0,1-2,47 12,-16-9,104 8,-90-17,0-4,-1-2,1-4,-1-2,0-4,85-25,-77 12,0-3,-1-3,-2-3,-2-4,74-50,-101 56,0-1,-3-3,-1-2,51-58,-73 73,-2-1,-1 0,-1-1,-1 0,-1-2,-2 0,0 0,-2-1,-1 0,6-30,-13 44,0 0,-1-1,0 1,-1-1,-1 1,0-1,-1 1,0 0,-1 0,-1 0,-9-24,7 26,-1 0,1 1,-2 0,1 0,-2 0,1 1,-1 1,-1-1,0 2,0-1,-1 1,-20-12,6 8,-1 0,0 2,-1 1,0 1,0 1,-1 1,1 2,-1 1,0 1,-1 1,1 1,0 2,-34 6,46-5,1 1,0 0,0 1,0 1,1 0,-1 1,2 0,-1 1,1 1,0 0,1 1,0 0,0 1,2 0,-1 1,1 0,1 1,0 0,-8 16,5-6,2 0,0 0,2 1,1 0,0 0,2 1,1 0,1 0,0 48,4-54,0-1,2 0,0 0,1 0,1 0,0-1,2 0,0 0,0 0,2-1,0 0,1-1,1 0,18 21,-10-17,2-1,0-1,0-1,2-1,0-1,0-1,2-1,-1-1,29 8,0-2,2-3,0-2,74 6,-81-14,1-1,0-3,-1-2,1-2,-1-2,0-2,48-15,-70 15,-1-1,0-1,-1-1,0-1,0-1,-2-1,1-2,-2 0,0-1,-1-1,-1-1,-1 0,-1-2,18-26,-21 24,-1 0,-2-1,0-1,-2 0,0 0,-2-1,-1 0,-1-1,-1 1,-1-1,-1 1,-2-1,-1 0,-1 0,-1 1,-8-35,5 38,0-1,-2 1,0 1,-2 0,0 0,-1 1,-2 0,0 1,-1 0,-1 1,-1 1,0 0,-1 1,-1 1,-1 1,0 1,-1 0,-26-13,32 20,0 2,-1-1,1 2,-1 0,0 1,0 0,-1 1,1 1,0 0,0 1,-1 1,1 0,-16 4,13-1,0 1,1 1,-1 0,1 1,1 1,-1 0,1 2,1-1,0 2,-23 20,16-9,0 1,2 0,0 2,2 0,1 2,-26 51,32-54,2 0,0 0,2 1,0 0,2 0,1 1,1 0,1 47,3-58,0-1,1 1,1-1,0 0,1 0,1 0,0 0,1-1,10 19,-5-16,0-1,0 0,2 0,-1-1,2-1,23 19,-4-9,2-1,0-2,1-1,1-2,1-2,48 14,17-1,0-5,1-4,177 8,-164-24,-1-6,0-4,133-26,-38-16,-177 38,-1-1,0-2,58-33,-83 42,0 0,0-1,0 0,0 0,-1-1,0 0,-1 0,1-1,-1 0,8-15,-11 18,-1-1,0 1,0-1,-1 0,0 0,0 0,0 1,0-1,-1 0,0 0,0 0,-1 0,0 0,0 0,0 0,-1 1,0-1,-3-8,1 8,1-1,-1 1,0 0,-1 0,0 1,1 0,-2-1,1 1,-1 1,1-1,-1 1,0 0,-1 1,1-1,-1 1,1 1,-1-1,-14-3,-6 0,0 2,-1 0,-43 0,49 4,-1 0,1 1,-1 2,1 0,0 1,0 2,0 0,-23 10,36-12,0 0,0 1,1 0,0 0,0 1,0 0,1 0,0 1,0 0,1 0,0 0,0 1,0 0,1 0,0 1,1-1,0 1,0 0,1 0,0 1,-1 11,2-10,1 1,1-1,0 1,1-1,0 1,1-1,0 0,1 0,0 1,1-2,0 1,0 0,1-1,1 0,6 10,2-1,0-1,0 0,2-1,0 0,1-1,29 20,-3-7,1-2,0-3,2-1,1-2,60 17,-63-25,0-1,0-3,1-2,0-2,0-2,54-2,-83-2,0-1,0 0,0-1,0-1,18-6,-29 8,0 0,0 0,0-1,0 0,-1 0,1 0,-1 0,0-1,0 1,0-1,-1 0,1 0,-1-1,0 1,0-1,0 1,-1-1,4-9,-3 4,-1 0,0 1,0-1,-1 0,0 0,-1 0,0 0,0 0,-1 0,-3-10,1 6,-1 1,-1-1,0 1,-1 0,0 0,-11-15,-5-2,-1 1,-1 1,-1 2,-45-37,-46-27,97 78,0 0,0 2,-1 0,-36-12,51 21,-1-1,0 1,0 1,0-1,0 1,0 0,0 1,1-1,-1 1,0 0,0 1,0-1,1 1,-1 0,1 0,-1 1,1 0,0 0,0 0,0 1,1-1,-1 1,-7 9,1-1,1 0,1 1,0 0,0 0,1 1,1 0,-10 28,8-13,2 0,0 1,2-1,2 1,0 0,2 1,1-1,2 0,0 0,3 0,0-1,2 1,1-1,18 45,-15-50,0 0,2 0,0-1,2-1,0 0,2-1,0-1,1 0,1-2,1 0,1-1,0-1,1-1,0-1,2-1,41 18,-34-20,1-1,0-2,0-1,1-1,0-2,0-2,0 0,49-6,-63 3,0-2,0-1,-1 0,1-1,-1-1,0 0,-1-2,0 0,0-1,0-1,-1 0,-1-1,0-1,0 0,24-28,-25 21,-1 0,0-1,-2-1,0 0,-1 0,-1-1,-2 0,0-1,-1 0,-1 0,-1 0,-1 0,-2-1,0 1,-1-1,-1 1,-2-1,0 1,-1 0,-2 0,-10-31,11 44,0 0,0 1,-1-1,0 1,0 1,-1-1,0 1,-1 0,0 0,0 1,-1 0,0 1,0 0,0 0,-1 1,-18-8,19 10,0 0,-1 1,1 0,-1 0,0 1,0 0,1 0,-1 1,0 1,0 0,1 0,-1 1,0 0,1 0,0 1,-1 1,1-1,1 2,-11 5,1 3,0 0,1 1,1 1,0 1,1 0,1 1,0 0,1 2,1-1,1 1,-10 25,3-3,3 0,1 1,2 1,-9 69,17-90,2 0,1 0,1 0,0 0,2 0,7 35,-4-39,0-1,1 1,1-1,1-1,0 1,1-1,1-1,14 19,-11-18,1-2,1 1,0-2,1 0,0 0,1-2,0 0,1-1,0-1,1 0,0-2,22 6,-36-11,1 0,0-1,-1 0,1 0,0-1,0 1,7-2,-13 1,1 0,-1 0,0 0,0 1,0-1,0 0,0 0,0 0,0 0,1 0,-1 0,0 0,0 0,0 0,0 0,0 0,0 0,1 0,-1 0,0 0,0 0,0 0,0 0,0 0,0 0,0 0,1 0,-1-1,0 1,0 0,0 0,0 0,0 0,0 0,0 0,0 0,0 0,1 0,-1 0,0-1,0 1,0 0,0 0,0 0,0 0,0 0,0 0,0-1,0 1,0 0,0 0,0 0,0 0,0 0,0 0,0-1,0 1,0 0,0 0,0 0,-11-5,-19-1,10 6,1 1,0 0,0 1,0 1,0 1,0 1,1 0,0 2,-31 14,14-2,0 1,2 2,-53 43,53-36,2 2,1 2,1 0,2 2,1 1,2 1,2 1,1 2,2-1,-27 84,35-87,2-1,1 1,2 1,2-1,1 1,2 0,1 0,2 0,2 0,1-1,1 0,3 0,19 54,-8-45,1 0,3-2,1 0,3-2,1-1,2-1,1-2,2-1,2-2,40 31,-67-58,0 0,0-1,1 0,0-1,0 0,20 6,-27-10,1 0,-1 0,1 0,-1-1,1 0,-1 0,0 0,1 0,-1 0,1-1,-1 1,1-1,-1 0,0 0,1 0,-1-1,0 1,0-1,0 0,0 1,0-1,0-1,-1 1,1 0,3-5,-1 0,0-1,0 0,-1 0,0 0,0 0,-1-1,0 1,-1-1,0 0,1-9,-1 2,-1 1,0-1,-1 1,0-1,-4-16,4 26,-1 0,-1 0,1 0,-1 1,0-1,0 0,-1 1,1-1,-1 1,-1 0,1 0,-1 0,0 1,0-1,0 1,0 0,-1 0,1 0,-1 1,0 0,-1-1,1 2,0-1,-1 1,0 0,1 0,-1 0,0 1,0 0,0 0,0 0,0 1,-12 1,4 1,0 1,1 0,-1 1,1 1,0 0,0 1,0 0,1 1,0 1,0 0,1 0,-16 16,4-3,1 2,2 1,0 0,-26 44,29-38,1 1,1 1,1 0,2 1,2 0,0 1,3 0,1 0,1 0,2 1,1 0,3 36,2-55,-1 0,2-1,0 1,1-1,1 1,0-2,1 1,0-1,1 0,1 0,13 15,-13-17,1-1,1 0,0-1,0 0,1 0,1-2,-1 1,1-1,1-1,-1-1,1 0,15 5,-26-10,0 0,-1-1,1 1,0 0,0-1,0 0,0 1,0-1,0 0,0-1,0 1,0 0,0-1,0 0,-1 0,4-1,-6 2,1 0,-1 0,0-1,1 1,-1 0,0 0,0-1,1 1,-1 0,0-1,0 1,0 0,1-1,-1 1,0-1,0 1,0 0,0-1,0 1,0 0,0-1,0 1,0-1,0 1,0 0,0-1,0 1,0-1,0 1,0 0,-1-1,1 1,0 0,0-1,0 1,0 0,-1-1,1 1,0 0,-1-1,1 1,-1 0,-15-13,2 7,0 0,0 0,-1 1,1 1,-1 0,-28-2,19 4,0 1,0 0,-43 7,33 1,0 1,1 2,0 1,0 2,2 1,-1 2,2 1,0 1,1 1,1 2,-33 31,46-37,1 0,-22 29,32-39,1 0,0-1,0 1,1 0,-1 1,1-1,0 0,1 1,-1-1,1 1,0-1,0 1,1 0,0-1,0 7,1-9,-1-1,1 0,-1 0,1 0,0 0,0 0,0 0,0 0,0 0,0 0,0 0,1-1,-1 1,1 0,-1-1,1 1,2 1,0-1,-1 0,1 0,-1-1,1 1,0-1,0 0,0 0,8 1,-1-1,1-1,-1 0,1-1,-1 0,0-1,12-3,-3-1,-1-1,0-1,-1-1,1 0,-2-2,1 0,-2-1,1 0,26-29,-17 15,-2-2,-1-1,-1-1,29-53,-41 65,0-1,-1-1,-1 0,-1 0,-1 0,6-36,-11 50,0 0,-1 0,0 0,0-1,0 1,-1 0,0 0,0 0,0 0,-1 0,0 0,0 1,-1-1,1 1,-1-1,-1 1,1 0,-1 0,1 0,-2 0,1 1,0 0,-1 0,0 0,1 0,-2 1,-6-5,-7 0,0 0,0 2,0 0,-1 1,0 1,0 0,0 2,-25 0,-167 11,196-8,-162 18,-215 49,380-65,0 0,1-1,-1 2,1 0,-1 0,1 1,-19 11,30-15,0-1,0 0,0 1,0 0,1-1,-1 1,0-1,0 1,1 0,-1-1,0 1,1 0,-1 0,1 0,-1 0,1-1,-1 1,1 0,0 0,-1 0,1 0,0 0,0 0,-1 0,1 0,0 0,0 0,0 0,0 0,1 0,-1 0,0 0,0 0,1 0,-1 0,0 0,1 0,-1 0,1-1,-1 1,1 0,-1 0,2 1,2 1,-1 0,1 0,0 0,0 0,0-1,1 0,-1 0,6 2,9 2,1 0,0-2,1 0,-1-2,1 0,-1-1,1-1,0-1,23-4,-14 0,0-1,-1-1,0-2,0-1,46-22,-63 25,-1 0,1 0,-1-1,-1 0,1-1,-2 0,16-18,-20 20,0 0,0 0,-1 0,0-1,0 0,-1 0,0 0,0 0,-1 0,0-1,0 1,0-18,-2 23,0 0,0-1,0 1,-1 0,1 0,-1-1,0 1,0 0,0 0,0 0,-3-4,0 2,1 0,-1 0,-1 1,1-1,-10-7,-4-1,-1 1,0 0,-31-14,-74-23,27 16,-2 4,-122-19,145 37,1 3,-1 3,-131 10,157 1,1 1,1 3,0 3,0 1,1 2,1 2,1 3,1 1,0 2,2 2,-48 39,78-56,1 0,0 1,0 1,1 0,1 0,-12 17,20-25,-1-1,1 0,0 1,-1-1,1 1,0-1,1 1,-1 0,0-1,1 1,-1 0,1 0,0-1,0 1,0 0,0 0,1-1,-1 1,1 0,-1 0,1-1,0 1,0-1,0 1,1-1,-1 1,1-1,-1 0,1 1,0-1,-1 0,1 0,0 0,1-1,-1 1,0 0,0-1,1 1,-1-1,4 1,7 4,1 0,0-1,0 0,1-2,-1 1,1-2,0 0,0-1,0 0,0-1,0-1,0 0,23-6,-34 6,-1 0,1 0,0 0,-1-1,0 1,1-1,-1 0,0 0,0 0,0 0,0-1,0 1,0-1,-1 0,1 0,2-4,-4 4,0 0,0 0,0 0,-1 1,1-1,-1 0,1 0,-1 0,0 0,0 0,-1 0,1 0,0 0,-1 0,0 0,0 1,0-1,0 0,0 0,0 1,-1-1,-2-3,-2-4,-1 1,-1-1,1 1,-2 1,1-1,-11-7,-65-42,27 26,-2 1,-83-29,-133-30,-110-2,-8 23,359 64,28 4,-38-6,0-1,-62-22,103 29,0 0,-1-1,1 1,1-1,-1 1,0-1,0 0,1 0,-1-1,1 1,-1 0,1-1,0 0,0 1,0-1,0 0,1 0,-1 0,1 0,0 0,0 0,0-1,0 1,0 0,1 0,-1-1,1 1,0-1,0 1,1-6,1-2,0 1,1-1,0 1,0 0,1 0,0 0,1 1,0 0,10-13,163-188,-146 175,605-705,-589 679,70-117,-112 167,0 0,-1-1,0 1,-1-1,0 0,-1 0,3-19,-6 27,1 0,-1 1,-1-1,1 0,0 1,-1-1,0 1,0-1,0 1,0-1,-1 1,1 0,-1-1,0 1,0 0,0 0,0 0,0 0,-1 1,1-1,-1 1,0-1,0 1,0 0,0 0,0 0,0 1,-6-3,-8-2,0 1,0 1,-1 0,0 1,0 1,-21 0,-22 1,0 3,1 2,-1 3,1 2,-63 20,0 7,-161 71,165-55,-131 79,198-99,1 2,2 2,2 2,-73 76,107-100,1 1,1 0,0 0,1 1,1 0,-9 21,15-31,1 1,0 0,0-1,0 1,1 0,0 0,0 0,1 0,0 0,0 0,1 0,0 0,0 0,1-1,0 1,0 0,0-1,1 1,4 7,-2-6,0 0,1-1,-1 0,1 0,1-1,0 0,-1 0,11 6,0-1,1-1,30 13,-14-9,2-2,0-1,0-2,0-1,1-2,54 2,-44-8,1-2,-1-1,0-3,79-20,-47 4,0-4,-2-4,89-47,-109 47,-2-3,-1-3,-2-1,81-78,-116 99,-1-2,-1 0,0 0,-2-1,0-1,-1 0,13-33,-21 43,0 0,-1 0,-1 0,1-1,-2 1,1-1,-1 1,-1-1,0 0,-1 1,0-1,0 0,-1 1,-1-1,1 1,-2 0,0 0,-5-11,2 9,0 1,0 0,-1 1,0 0,-1 0,0 1,-19-15,12 12,-2 1,1 0,-2 1,-25-9,-3 2,-2 3,0 1,-60-6,12 7,1 5,-1 4,0 4,1 5,0 3,0 5,1 4,-182 60,236-64,-66 34,97-43,0 1,0 1,0-1,1 1,0 1,1 0,-1 0,1 1,1 0,0 0,-7 12,11-16,1-1,0 1,0 0,0 0,1 1,-1-1,1 0,1 0,-1 1,1-1,0 0,0 1,0-1,1 0,0 1,0-1,0 0,1 0,-1 0,1 0,1 0,-1 0,1 0,-1-1,6 7,2 0,0 0,0 0,1-1,1 0,0-1,0-1,0 0,17 8,19 6,1-2,0-3,1-1,56 9,4-4,1-4,1-6,0-4,0-5,1-5,-1-5,-1-4,133-34,-199 35,0-2,-1-1,0-3,49-27,-80 36,0 0,-1-1,0 0,-1 0,0-1,0-1,-1 0,-1-1,0 0,10-17,-15 23,-1 0,0-1,0 1,-1-1,1 0,-2 0,1 0,-1 0,0 0,0 0,-1 0,0-1,0 1,-1 0,0 0,0 0,0 0,-1 0,0 0,-1 1,0-1,0 0,-5-8,-1 3,-1 0,0 0,0 1,-2 1,1-1,-1 2,0 0,-1 0,0 1,-1 1,1 0,-26-9,-2 3,-1 1,0 2,-60-7,35 10,0 4,-1 2,1 3,0 4,0 2,1 3,0 3,-74 26,103-27,1 1,0 2,1 2,1 1,1 1,-43 36,59-42,1 1,0 1,1 1,1 0,-15 26,21-30,0 2,1-1,1 1,0 0,1 0,1 1,0-1,-1 19,4-24,0 0,1 0,0 0,1 0,0 0,1 0,0 0,1 0,0-1,6 15,-3-12,1 1,0-1,1-1,1 1,0-2,18 19,-1-7,0-2,2 0,0-2,1-1,50 21,-1-6,2-4,0-3,2-4,156 20,-144-32,0-4,1-5,-1-3,107-18,-134 9,-1-2,-1-3,122-50,-148 49,-1-1,-1-1,-1-3,-1-1,-1-1,-1-2,39-42,-57 52,0 0,-2-1,0-1,-1 0,0-1,-2 0,-1 0,12-37,-17 42,0-1,-1 0,-1 0,-1 0,0 0,-1 0,-1 0,0 0,-1 0,-1 0,0 0,-10-26,3 18,-2-1,-1 2,-1 0,0 0,-2 1,-1 1,0 1,-2 0,0 1,-36-27,6 12,0 1,-2 3,-94-41,-28 6,140 56,-1 0,0 3,-41-4,68 9,0 1,0 0,0 0,0 0,0 1,-13 3,18-3,1-1,-1 1,0 0,1 0,-1 0,1 0,-1 0,1 0,-1 0,1 1,0-1,0 0,0 1,0-1,0 1,0-1,0 1,0 0,0-1,1 1,-1 0,1 0,-1-1,1 1,0 0,-1 0,1 0,0-1,0 1,1 3,0 3,0-1,1 1,0-1,1 1,-1-1,2 0,-1 0,1 0,-1 0,2-1,-1 1,9 8,6 8,1 0,1-2,1 0,1-2,43 29,-13-16,105 46,87 12,-99-49,3-7,0-7,2-6,202 2,-253-23,0-5,101-18,-131 10,-1-3,0-3,103-43,-136 46,-1-1,0-2,62-46,-80 51,0-1,0-1,-2 0,0-1,-1-1,0 0,-2 0,11-23,-18 31,0 0,0-1,-2 0,1 0,-1 0,-1-1,0 1,-1 0,0-1,-1-20,-1 23,0-1,-1 1,-1 0,1-1,-2 1,1 0,-1 1,0-1,-1 1,0-1,-1 1,1 1,-10-10,-1 1,-1 0,-1 1,0 1,-1 1,-1 0,0 1,0 2,-37-15,8 9,-1 1,-97-15,81 22,-121-1,65 14,1 6,-142 31,-234 88,346-80,-200 95,279-109,1 4,2 2,2 3,-94 83,132-100,1 0,1 2,-43 62,59-75,1 0,1 1,1-1,0 2,1-1,1 1,1 0,1 0,-4 32,8-39,0 0,0 0,1 0,1 0,0-1,0 1,2-1,-1 1,10 20,-5-17,1-1,0 0,0 0,2-1,0 0,16 15,2-3,0-2,2-1,1-2,0-1,56 24,-19-15,1-3,122 27,155-2,-238-43,0-4,114-13,-152 3,-1-3,0-4,-1-2,80-31,-124 37,0-1,0-1,-1 0,-1-2,0-1,33-29,-45 34,-1 0,0-1,-1 0,-1 0,1-1,-2 0,0-1,0 1,-1-2,0 1,-2 0,1-1,4-28,-7 23,-2 0,1 0,-2 0,-1 0,0 0,-1 0,-1 1,-1-1,-1 1,0 0,-1 0,-11-18,1 5,-1 1,-2 0,-1 2,-1 0,-47-44,28 35,-2 2,-2 2,-1 1,-61-30,35 27,-1 3,-110-33,51 31,0 5,-2 6,-160-6,177 23,-1 4,-205 24,267-13,0 2,-103 37,123-33,0 1,2 1,0 2,1 1,-34 28,51-35,0 1,1 0,1 1,0 1,1 0,1 1,-15 27,21-32,0 1,1-1,0 1,1 0,1 0,0 0,1 1,0-1,1 0,1 1,0 0,2 18,2-13,-1-1,2 1,1-1,0 0,1-1,1 1,1-1,0-1,22 31,-12-26,0 1,1-2,1-1,1 0,0-2,26 15,6-1,3-2,0-3,2-2,0-3,78 16,-53-18,0-4,1-3,0-4,0-4,151-12,-176 1,-2-3,1-3,88-30,-105 27,0-2,-1-2,-1-2,-1-1,45-36,-62 41,-1-2,0 0,-2-1,0-2,-2 0,0 0,-1-2,-2 0,0 0,-2-1,-1-1,-1 0,-1-1,-2 0,0 0,-2 0,-2-1,0 0,-2 0,-1 0,-1 0,-1 0,-2 1,-7-29,3 25,-2 1,0 0,-2 1,-2 0,0 1,-2 0,-33-43,25 42,-1 1,-2 1,0 1,-2 1,-1 2,-36-22,26 22,0 1,-1 3,-1 2,-1 1,-1 2,0 2,-1 2,0 2,0 2,-1 2,-79 1,110 5,0 0,0 0,0 2,0 0,0 0,-24 10,34-11,1 1,-1-1,0 1,1 0,0 0,-1 0,1 0,0 1,1 0,-1 0,1 0,0 0,0 1,0-1,0 1,1-1,0 1,0 0,0 0,0 0,1 0,-1 10,1-9,1 1,0 0,0 0,1 0,0-1,0 1,1 0,0-1,0 1,0-1,1 1,0-1,0 0,0 0,6 7,4 2,0 0,0 0,1-1,23 16,7 3,1-3,2-1,0-3,2-2,71 25,-46-24,2-3,0-4,90 10,-115-22,0-2,1-2,-1-3,91-12,-119 8,1 0,-1-2,-1 0,1-2,25-14,-33 15,-1 0,-1-2,0 0,0 0,-1-1,0 0,-1-1,15-21,-12 11,-2 0,-1-1,0 0,-2-1,0-1,-2 1,-1-1,0 0,-2 0,-1-1,-1 1,-2-1,0 0,-2 1,-8-49,7 63,0 0,-1 1,0 0,0 0,-1 0,-1 0,-7-10,11 17,0 0,0 0,0 0,-1 1,1-1,-1 1,0-1,0 1,0 0,0 0,0 0,0 1,0-1,-1 1,1-1,-1 1,1 0,-1 1,1-1,-1 0,0 1,1 0,-1 0,0 0,-4 1,0 2,0 0,1 1,-1 0,1 0,0 0,0 1,0 0,0 1,1 0,0 0,-6 8,-12 13,1 1,1 1,2 2,-22 42,-53 141,50-94,5 2,-36 185,60-212,4 0,4 1,9 189,3-239,1-1,2-1,3 1,1-1,23 57,-26-82,1-1,1 0,1-1,0 0,1 0,15 14,-17-20,1-1,0-1,0 0,1 0,0-1,1-1,0 0,0 0,18 5,-15-8,0 0,0-1,0 0,0-2,1 0,-1 0,0-2,1 0,-1-1,0 0,0-1,0-1,0-1,-1 0,16-8,5-5,-1 0,-1-3,-1-1,0-1,33-32,-5-2,-3-2,-2-3,-3-3,-3-1,-3-3,-3-2,36-79,-40 64,-4-2,-4-1,-3-2,-5-1,24-184,-43 224,-2-1,-3 0,-2 0,-3 0,-1 1,-25-93,22 113,-2 1,-1 1,-1 0,-2 0,0 2,-2 0,-2 0,0 2,-2 1,0 0,-2 1,-28-22,19 23,0 1,-1 1,-2 3,0 0,0 2,-2 2,0 2,0 1,-42-7,5 7,1 2,-1 4,-137 8,207-3,-143 16,133-13,-1 0,1 1,0 1,0 0,0 1,1 0,-25 16,31-16,0 1,1 0,-1 0,1 0,1 1,0 0,0 0,0 0,1 0,0 1,0 0,1 0,1 0,-3 10,0 11,0 0,2 1,1 32,2-49,1-1,0 1,1-1,0 0,1 1,1-1,0 0,1-1,0 1,1-1,0 0,1 0,0-1,1 0,1 0,9 9,-5-7,0-1,2 0,-1-1,2-1,-1-1,1 0,0-1,1 0,0-1,0-1,26 5,-13-5,-1-1,2-1,-1-2,0-1,47-5,-62 3,0-1,0-1,0-1,-1 0,1-1,-1 0,0-1,0-1,-1 0,0-1,0 0,21-19,-27 20,-1 1,1-1,-2-1,1 1,-1-1,0 0,-1-1,0 1,0-1,-1 1,0-1,2-12,-3 8,-1 1,0-1,0 0,-2 0,0 0,0 1,-1-1,-4-14,-2 0,-2 0,-1 1,-1 0,-1 0,-2 1,0 1,-25-29,36 47,-14-13,17 18,0 1,1-1,-1 1,0 0,1 0,-1-1,0 1,1 0,-1 0,0 0,0 0,1 0,-1 0,0 0,1 0,-1 0,0 0,1 0,-1 0,0 0,0 1,1-1,-1 0,0 1,1-1,-1 0,1 1,-1-1,1 1,-1-1,0 1,1-1,0 1,-1 0,-12 16,2 0,0 1,1 0,1 1,-12 36,-4 6,-29 49,-26 62,77-167,-7 26,9-30,1 0,0 0,-1 0,1 0,0 1,0-1,0 0,0 0,0 0,0 0,0 0,0 1,0-1,0 0,1 0,-1 0,0 0,1 0,0 2,0-3,0 0,0 1,-1-1,1 0,0 0,0 0,0 0,0 0,0 0,0 0,-1 0,1 0,0 0,0 0,0-1,0 1,0 0,-1 0,1-1,0 1,0-1,-1 1,2-2,15-7,-1-1,0-1,-1 0,0-1,13-15,67-77,-57 58,-2-1,-2-2,-2-2,-2-1,-3-1,-2-1,23-73,-42 108,-1 0,-1-1,-1 1,2-31,-5 42,0 0,0 0,-1 1,-1-1,1 0,-1 0,0 1,-1-1,0 1,0 0,-1 0,0 0,0 0,-5-6,-1 3,0 0,0 0,-1 2,0-1,-1 1,1 1,-1 0,-1 1,0 0,1 1,-2 0,-21-4,-14-1,0 2,-58-2,8 5,-1 4,1 5,-121 19,206-21,-3 1,-33 9,46-11,1 0,0 0,0 0,0 1,0-1,0 1,0 0,0 0,1 0,-1 0,0 0,1 1,0-1,0 1,0-1,-3 5,5-5,-1 0,0 0,1 1,-1-1,1 0,0 1,0-1,0 0,0 1,0-1,0 0,1 1,-1-1,1 0,0 0,-1 1,3 2,22 36,-2-11,2-1,1-2,34 29,95 67,-115-93,1-2,75 38,-95-58,-21-8,0 0,1 0,-1 0,0 0,0 0,0 0,1 0,-1 0,0 0,0 0,0 0,1 0,-1 0,0 0,0 0,0 0,1 0,-1 0,0 0,0 0,0 0,1 0,-1 0,0 0,0-1,0 1,1 0,-1 0,0 0,0 0,0 0,0-1,0 1,0 0,1 0,-1 0,0-1,0 1,0 0,0 0,0 0,0-1,0 1,0 0,0 0,0 0,0-1,0 1,0 0,0 0,0 0,0-1,0 1,0 0,0 0,0 0,0-1,-1 1,1 0,0 0,0-1,-8-12,-3 0,0 1,-1 0,-24-18,-47-28,62 44,-4-3,-1 2,0 0,-1 1,-1 2,-36-11,50 19,0 1,0 0,0 1,0 1,0 0,0 0,0 2,0 0,-1 1,1 0,0 1,1 0,-23 9,13-1,1 1,1 0,0 2,0 0,-30 29,9-2,-50 62,54-54,3 1,1 2,3 2,2 1,3 1,-29 90,30-51,23-86,0 0,1 0,1 1,-1-1,2 1,-1-1,1 0,3 10,-4-16,1 0,0-1,0 1,0 0,1-1,-1 1,1-1,-1 1,1-1,0 0,0 0,0 0,0 0,0 0,1 0,-1 0,0-1,1 1,0-1,-1 0,1 0,0 0,-1 0,1 0,0 0,0-1,4 1,-4-1,1 0,0 0,-1 0,1-1,0 1,0-1,-1 0,1 0,-1-1,1 1,-1 0,0-1,1 0,-1 0,0 0,0 0,0-1,0 1,-1-1,5-4,-3 0,0-1,0 0,0 1,-1-1,0 0,0-1,-1 1,0 0,0-1,-1 0,-1 1,1-1,-1 1,-2-16,0 9,0 1,-1-1,-1 1,0 0,-1 0,0 0,-15-25,13 27,-2 0,1 1,-1 0,-1 0,0 1,-1 0,0 1,0 0,-24-13,17 12,-1 2,-1 0,1 0,-1 2,0 1,-25-4,0 4,1 3,-1 1,0 2,0 2,-76 15,35 1,1 5,1 3,1 4,-151 80,205-96,1 2,1 1,1 2,0 0,1 2,1 0,2 2,-21 27,34-39,1 1,0 0,1 0,1 1,0 0,1 0,0 0,-3 21,6-23,1 1,1-1,0 0,0 1,1-1,1 1,0-1,0 0,1 0,1 0,6 14,-2-9,1-1,1 0,0-1,1 0,0-1,2 0,-1-1,2 0,-1-1,2 0,0-1,0-1,1 0,0-2,0 1,1-2,21 7,-32-13,0 1,0-1,0 0,0 0,0-1,0 0,-1 0,1 0,0-1,0 0,0 0,0 0,8-3,-10 1,1 1,-1 0,0-1,0 0,0 0,0 0,-1-1,1 1,-1-1,0 0,0 0,0 0,0 0,-1 0,0-1,3-6,0-4,0-1,-1 1,-1-1,0 0,-2 0,1 0,-2 0,0 0,-1-1,-1 1,0 1,-1-1,-1 0,0 1,-2-1,1 1,-2 0,-8-14,4 9,-1 0,-1 1,0 0,-2 1,0 1,-1 0,-1 2,0-1,-1 2,-1 0,0 2,-25-13,12 11,0 1,-2 2,1 2,-1 1,0 1,-46-2,6 5,-141 10,42 14,135-13,0 1,-55 19,88-25,0 1,-1-1,1 1,0 0,0 0,0 0,1 1,-1 0,1 0,0 0,0 0,-6 9,6-6,0 0,1 0,0 1,0-1,0 1,1 0,0 0,-1 11,2-6,1 0,0 0,0 0,1 0,1 0,1 0,-1 0,8 19,-1-9,1 0,1-1,22 35,-22-42,1 0,0 0,1-2,0 1,1-2,29 21,-7-10,72 33,-77-41,2-1,0-2,0-2,1-1,0-1,65 6,-86-14,1 0,0-1,0 0,0-1,-1 0,1-2,-1 1,22-10,-26 9,0-1,0-1,-1 1,0-1,0-1,0 1,-1-1,0-1,0 1,-1-1,0 0,0-1,4-9,-5 9,0-1,-1 0,-1 0,1 0,-2-1,1 1,-1-1,-1 1,0-1,-1 0,0 1,0-1,-1 0,0 1,-1-1,-1 1,1-1,-2 1,1 0,-1 0,-1 0,0 1,-8-12,0 2,-1 0,-1 2,0-1,-2 2,0 0,-1 1,0 1,-1 1,-37-20,22 17,0 2,-1 1,0 2,-1 1,-1 2,1 2,-1 1,0 2,0 1,0 2,0 2,0 1,0 2,0 1,1 2,-49 18,74-22,-1 0,2 1,-1 0,-19 13,28-16,-1 0,1 1,-1-1,1 0,0 1,0 0,0-1,0 1,0 0,1 0,-1 0,1 0,0 0,0 0,0 0,0 1,0-1,1 0,0 1,0-1,-1 0,2 5,0-1,0 0,1 0,0 0,0 0,1 0,-1-1,1 1,1-1,0 0,-1 0,2 0,-1 0,1-1,0 1,0-1,0 0,7 4,2 1,1 0,0-1,0-1,1-1,0 0,19 5,6 0,0-3,1-1,0-2,0-2,1-2,0-2,51-6,-25-2,-1-4,-1-2,116-41,-124 32,-1-2,-1-2,-1-3,-1-2,-3-3,91-77,-114 84,0-1,-3-1,0-2,39-64,-50 70,-1-2,-1 0,-2 0,-1-1,-1-1,-1 1,3-34,-9 47,-1-1,0 1,-1-1,-1 0,0 1,-1-1,-9-30,8 36,-1 1,-1 0,1 0,-2 0,1 0,-1 1,-1 0,1 0,-2 0,1 1,-1 1,-15-12,7 7,-1 2,0 0,-1 1,0 0,0 2,-1 0,0 1,0 1,0 1,-1 1,1 0,-1 2,-25 0,10 3,-1 2,1 1,0 1,1 3,0 0,-53 23,10 3,1 3,2 3,-113 84,105-61,2 4,-110 124,165-163,0 2,2 0,-26 49,39-63,2 1,0 1,1-1,1 1,0 1,2-1,0 1,-1 29,5-38,1 0,0 1,0-1,2 0,-1 1,1-1,1-1,0 1,1 0,-1-1,2 0,0 0,8 10,-5-8,1 0,0-1,1 0,0-1,0 0,1-1,1 0,-1-1,26 11,2-2,1-3,0-1,57 9,133 9,60-15,-259-16,-1-2,1-2,0-1,-1-1,0-1,0-2,31-14,-48 16,0 0,-1 0,0-2,-1 0,1 0,-2-1,1-1,-2 1,1-2,-1 0,-1 0,0-1,-1 0,0 0,-1-1,-1 0,0 0,-1 0,0-1,-1 0,-1 0,-1 0,0 0,0-1,-2 1,0-1,-1 1,-3-22,0 16,-1 1,-1 0,-1 0,0 0,-2 1,0 0,-1 1,-1 0,0 0,-2 1,0 1,0 0,-2 1,0 0,-29-20,16 15,-1 1,-1 2,0 2,-1 0,-1 2,0 1,-1 2,-63-12,43 15,0 3,0 1,-1 3,1 3,0 1,0 3,-77 20,51-4,0 3,2 3,1 4,-81 47,140-70,-1 1,2 1,-1 0,2 1,-1 0,2 1,-21 27,26-30,2 1,0 0,0 1,1-1,1 1,0 1,1-1,0 1,1-1,0 1,0 25,3-20,1 0,0 0,2 0,0 0,1-1,1 1,1-1,1 0,0 0,1-1,1 0,12 17,6 5,1-1,3-2,59 57,-32-40,2-3,3-3,100 58,-151-98,33 16,-43-21,0-1,1-1,-1 1,1 0,-1-1,1 1,-1-1,1 0,-1 1,1-1,0-1,-1 1,1 0,-1-1,4 0,-5 0,0 1,0-1,0 0,0 1,0-1,0 0,0 0,0 0,0 0,-1 0,1 0,0 0,0 0,-1 0,1-1,-1 1,1 0,-1 0,0 0,1-1,-1 1,0 0,0 0,0-1,0 1,0 0,0-1,0 1,0 0,-1 0,0-2,0-4,-1 0,0 1,-1-1,-5-9,-7-10,-1 0,-1 2,-1 0,-2 1,0 1,-1 0,-31-23,24 24,-1 1,0 1,-2 1,0 2,-64-24,84 36,-2 0,1 1,0 0,0 1,-1 0,1 1,-1 1,0 0,1 0,-1 2,1-1,-1 1,1 1,0 1,0-1,0 2,1 0,-1 0,1 1,0 0,1 1,-1 0,1 1,1 0,-15 16,7-4,1 1,1 1,1 0,0 1,2 0,1 1,-14 44,10-19,3 1,1 1,-3 53,11-70,2 0,4 60,0-73,0 1,2-1,0 0,2 0,13 31,-7-26,1-1,1 0,1-1,1-1,1-1,26 26,-16-22,1-2,1 0,1-2,41 22,-13-14,1-3,1-3,2-2,0-3,82 13,77-1,-172-28,0-2,75-8,-95 3,-1-1,1-1,-2-2,1-1,36-17,-44 16,-1-1,0-2,-1 0,0 0,-1-2,0 0,25-30,-23 20,0-1,-2-1,-1-1,-2 0,0-1,-2-1,15-52,-19 53,-3 0,0-1,-2 0,-1 0,-1 0,-2-1,-1 1,-6-39,4 51,-2 0,0-1,-1 2,0-1,-2 1,0 0,-1 0,-1 1,0 0,-1 1,-1 0,0 1,-1 0,-1 1,0 1,0 0,-1 0,-1 2,0 0,-1 1,1 0,-2 2,1 0,-1 1,0 0,0 2,-1 0,1 1,-1 1,-21 0,20 2,0 1,0 1,0 0,0 2,1 0,-1 2,1 0,1 1,-29 14,26-10,1 2,1 0,0 1,0 1,1 0,1 1,-27 35,31-34,1 1,0 0,2 1,0 0,1 0,1 1,1 0,-8 38,12-41,1 1,0 0,2-1,0 1,1 0,0 0,2-1,0 1,1-1,1 0,8 21,-3-16,1 0,2-1,0-1,0 0,2-1,1-1,0 0,1-1,1 0,1-2,38 25,-14-14,1-2,1-2,1-2,88 25,-42-21,1-4,110 8,196-14,-298-16,1-4,-1-5,-1-4,159-45,-205 42,0-3,-2-1,89-54,-104 52,-1-2,-1-1,-1-2,-1-1,43-53,-59 61,-1-1,-1-1,-1 0,-1-1,-1-1,-1 0,-1 0,-2-1,10-50,-13 36,-1-1,-1 1,-3 0,-1-1,-13-75,10 94,-2 0,0 0,-1 0,-1 1,-1 0,-1 1,-16-27,19 38,1 1,-1-1,-1 2,0-1,0 1,-1 0,0 1,0 0,0 0,-1 1,0 0,0 1,-1 0,0 1,0 0,-21-5,19 7,1 1,-1 0,0 0,1 1,-1 1,1 0,-1 1,1 0,-1 1,-21 8,18-4,1 0,0 1,1 1,0 0,0 1,1 1,-18 17,12-7,1 0,1 1,1 1,1 0,1 1,1 1,1 0,1 1,-13 47,22-62,0-1,0 1,1-1,0 1,1-1,1 1,-1-1,2 1,-1-1,7 20,-3-16,1 1,0-1,1 0,1-1,0 0,17 21,-2-9,0-1,2-2,0 0,1-2,1-1,33 18,-11-10,1-3,1-2,89 26,-101-38,-1-1,1-3,1-1,-1-1,77-5,-104 0,-1 0,1-1,-1-1,0 0,0 0,0-1,0 0,13-8,-19 9,0 0,0-1,-1 1,0-1,1 0,-1 0,0 0,-1 0,1-1,-1 0,0 0,0 0,-1 0,1 0,-1 0,0-1,-1 1,3-9,-3 7,-1 0,1 1,-1-1,0 0,0 0,-1 0,0 0,0 0,-1 0,0 1,0-1,-1 1,-3-9,0 7,1-1,-1 0,-1 1,1 0,-1 1,-1-1,1 1,-11-6,-3-1,0 1,-1 1,0 1,-1 1,-1 0,-37-8,6 6,0 3,-1 2,1 3,-1 2,-104 9,129-3,1 0,-1 2,1 1,-34 13,42-11,2 0,-1 2,2 0,-1 1,1 1,-22 20,8 0,1 0,2 2,2 1,1 1,2 2,1 0,2 2,2 0,2 2,2 0,1 0,-17 92,29-116,1 1,1 0,0 0,2 0,0 0,1-1,5 21,-4-28,1-1,0 0,0 1,1-2,1 1,-1 0,2-1,-1 0,2-1,-1 0,1 0,1 0,11 9,11 3,2-1,0-1,1-2,0-2,41 13,-37-15,1-1,0-2,1-2,0-1,1-2,62-1,198-21,-59-10,243-60,-116-11,453-184,-513 151,-64 9,-179 85,-1-3,97-79,-155 113,46-43,-50 46,0-1,0 1,0-1,-1 0,1 0,-1 0,0-1,0 1,0 0,-1-1,2-5,-3 9,0-1,0 1,0 0,0-1,0 1,-1-1,1 1,0 0,-1-1,1 1,0 0,-1 0,0-1,1 1,-1 0,0 0,0 0,0 0,1 0,-1 0,0 0,0 0,-1 0,1 0,0 0,0 0,0 1,0-1,-1 1,1-1,0 1,-1-1,1 1,0 0,-1 0,1-1,-3 1,-4-1,0 1,0-1,0 1,0 1,-10 1,-21 7,1 1,1 2,-43 20,24-10,-91 36,-155 86,301-144,-12 7,0 1,0 1,-16 13,27-20,-1 1,1-1,0 1,-1 0,1 0,1 0,-1 0,-3 6,5-7,-1-1,1 1,0 0,-1-1,1 1,0 0,0-1,0 1,0 0,1-1,-1 1,0 0,1-1,-1 1,1-1,-1 1,1-1,0 1,1 1,0 0,0 0,0 0,1-1,-1 0,1 1,0-1,0 0,-1 0,1 0,0-1,1 1,3 1,44 11,-47-14,48 10,1-3,82 0,112-19,-72-6,-1-8,188-53,-341 73,0 0,-1-1,1-1,-1-1,22-13,-41 21,1 0,-1 0,1 0,-1 0,1-1,-1 1,1 0,-1-1,0 1,0-1,0 1,0-1,0 0,0 1,0-3,0 3,-1 0,0 0,0 0,0 0,0 0,-1 0,1 1,0-1,0 0,0 0,-1 0,1 0,0 0,-1 1,1-1,-1 0,1 0,-1 1,0-1,1 0,-1 1,-1-2,-3-2,0 1,-1 0,0-1,0 2,0-1,0 1,-12-3,-25-4,-1 1,1 2,-2 3,-68 2,31 6,-131 25,182-23,1 0,1 2,-1 2,2 0,-38 22,52-26,1 1,0 1,1 0,0 1,0 0,1 1,0 0,1 1,0 0,1 0,1 1,-11 22,16-30,1 1,-1 1,2-1,-1 0,1 0,0 1,0-1,1 0,0 11,0-14,0-1,1 1,-1-1,1 0,0 0,-1 1,1-1,0 0,0 0,1 0,-1 0,0 0,1 0,-1 0,1 0,0-1,-1 1,1-1,0 1,0-1,0 1,0-1,0 0,0 0,0 0,1 0,-1-1,3 2,5-1,-1 1,1-1,0 0,11-1,-17 0,0 0,-1-1,1 1,0-1,0 0,0 0,-1 0,1 0,0-1,-1 1,1-1,4-4,-7 6,-1 0,0 0,0 0,1 0,-1-1,0 1,0 0,1 0,-1 0,0 0,0-1,0 1,0 0,1 0,-1 0,0-1,0 1,0 0,0 0,0-1,0 1,0 0,1 0,-1-1,0 1,0 0,0 0,0-1,0 1,0 0,0-1,0 1,-1 0,1 0,0-1,0 1,0 0,0 0,0-1,0 1,0 0,-1 0,1 0,0-1,0 1,0 0,-1 0,-14-4,7 5,1-1,0 1,1 1,-1-1,0 1,0 0,0 1,-7 4,-52 32,53-31,-15 10,2 2,0 0,1 2,1 0,1 2,-35 45,54-63,0 0,1 0,-1 0,1 0,0 1,-2 7,5-12,-1 0,1 0,0 0,-1 0,1 0,0 0,0 0,1 0,-1 0,0 1,0-1,1 0,0-1,-1 1,1 0,0 0,0 0,0 0,0 0,0-1,0 1,0 0,1-1,-1 1,2 0,2 2,0-1,0 0,-1 0,2-1,-1 0,0 0,0 0,1 0,-1-1,1 0,8 1,4-1,-1 0,26-3,-21-1,0 0,1-2,-1 0,38-16,-46 16,-1-1,0-1,-1 0,0 0,0-2,0 1,-1-1,17-19,-26 27,-1-1,0 1,0-1,1 1,-1-1,0 1,0-1,-1 1,1-1,0 0,0 0,-1 1,1-1,-1 0,0 0,1 0,-1 0,0 0,0 1,0-1,0 0,-1-2,0 2,0 0,0 0,0 0,0 1,-1-1,1 0,0 1,-1-1,0 1,1 0,-1-1,0 1,1 0,-1 0,0 0,-3-1,-5-1,0 0,1 0,-1 1,0 0,0 1,-1 0,-11 0,-3 4,0 1,0 1,0 1,0 2,1 0,0 1,1 2,0 0,-33 23,43-26,2 0,-1 1,1 1,-19 21,25-25,0 1,0 0,1 0,0 0,0 0,1 1,0-1,0 1,0 0,0 9,2-15,1 0,-1 1,1-1,0 0,0 0,0 1,0-1,1 0,-1 1,1-1,-1 0,1 0,0 0,0 1,0-1,0 0,0 0,0 0,1-1,1 3,0-1,-1-1,1 0,0 0,1 0,-1 0,0 0,0-1,1 1,-1-1,1 0,5 1,4 0,-1-1,1 0,0-1,-1-1,1 0,18-3,-12 0,-1-1,1-1,-1 0,0-2,-1 0,1-1,-1 0,-1-1,0-1,-1-1,0 0,-1-1,0-1,-1 0,0-1,-1 0,-1-1,-1 0,0-1,-1 0,9-22,-17 35,1 0,-1 0,0 0,0-1,0 1,-1 0,1 0,-1-1,0 1,-1 0,1 0,-1-1,1 1,-1 0,-3-8,2 9,0 0,0 0,0 0,0 0,-1 1,1-1,-1 1,0-1,0 1,0 0,0 0,0 0,0 1,0-1,-1 1,1-1,-1 1,1 0,-5 0,-2-1,-1 1,1 0,0 1,-1 0,1 0,0 1,-1 1,1 0,0 0,0 1,-15 6,7-1,0 0,1 1,1 1,-1 1,-18 15,17-9,0 0,0 0,2 2,-17 23,24-28,1 0,0 0,1 0,0 1,1 0,0 1,-3 21,8-33,0 1,0 0,1-1,0 1,0 0,0-1,1 1,-1 0,1-1,0 1,1 0,-1-1,1 1,0-1,0 0,0 0,0 0,4 4,-1-1,1-1,0 0,0-1,1 0,0 0,0 0,0-1,0 0,12 5,-10-5,0-1,0 0,0 0,0-1,1 0,-1-1,1 0,-1-1,1 1,-1-2,1 1,-1-2,1 1,-1-1,0 0,0-1,0 0,0-1,0 0,0 0,-1-1,0 0,0 0,9-9,-13 10,0-1,0 0,-1 0,0 0,0-1,0 1,0-1,-1 1,0-1,0 0,-1 0,1 0,-1 0,-1 0,1 0,-1 0,-1-11,1 11,-1 1,1 0,-1 0,-1 0,1 0,-1 0,0 1,0-1,0 0,0 1,-1-1,0 1,0 0,0 0,0 0,-1 0,0 1,0-1,0 1,0 0,-6-4,-3 2,0 0,0 1,0 0,0 1,-1 1,1 0,-1 1,0 0,1 1,-1 0,0 1,-26 6,12-1,0 2,1 1,-1 1,2 1,-31 18,30-13,1 1,0 2,2 0,0 2,1 0,-35 43,43-45,1 1,1 0,0 1,2 1,0-1,2 2,0 0,1 0,-5 29,12-47,0 0,0 0,0-1,1 1,0 0,0 0,0 0,1 0,0 0,-1-1,2 1,-1 0,0-1,1 1,0-1,0 1,4 5,-6-10,0 1,1-1,-1 0,0 1,0-1,0 1,1-1,-1 0,0 1,1-1,-1 0,0 1,1-1,-1 0,0 0,1 1,-1-1,1 0,-1 0,1 0,-1 0,0 1,1-1,-1 0,1 0,-1 0,1 0,-1 0,1 0,-1 0,1 0,-1 0,0 0,1-1,-1 1,1 0,-1 0,1 0,-1 0,0-1,1 1,-1 0,1 0,-1-1,0 1,1 0,-1-1,0 1,0 0,1-1,-1 1,0-1,0 1,1 0,-1-1,0 1,0-1,0 1,0-1,0 1,1 0,-1-1,0 1,0-2,1-2,0-1,0 0,0 0,-1-10,0 0,-2 1,0 0,0 0,-9-25,9 34,1 1,-1 0,1 0,-1 0,0 0,-1 0,1 0,-1 1,1-1,-1 1,0-1,-1 1,1 0,-1 0,1 1,-1-1,0 1,0-1,-6-1,8 3,-1 1,1 0,-1 0,1 0,-1 0,1 0,-1 0,1 1,-1-1,1 1,0 0,-1-1,1 1,0 0,-1 0,1 1,0-1,0 1,0-1,0 1,0-1,0 1,1 0,-1 0,0 0,1 0,-2 3,-3 4,1-1,0 1,1 0,0 1,-4 13,5-12,0-1,1 1,1 0,-1 0,2-1,-1 1,2 0,-1 0,1 0,1 0,0 0,1-1,0 1,0-1,1 0,1 0,-1 0,2 0,-1-1,1 0,1 0,0 0,0-1,0 0,1-1,1 1,16 10,-13-11,1 0,0-1,0-1,1 0,-1-1,1-1,0 0,0-1,0 0,0-1,1 0,-1-2,0 1,0-2,0 0,0-1,0 0,0-1,19-8,-18 6,0-1,0 0,-1-1,-1 0,1-1,-1-1,-1 0,0-1,0 0,-1-1,-1-1,0 1,0-1,-2-1,1 0,11-29,-13 23,-1 0,-1-1,-1 0,-1 0,-1 0,-1-1,-2-35,1 53,-1 0,1 0,-1 0,0 0,0 0,0 0,-1 0,1 0,-1 0,0 1,0-1,-1 0,1 1,-1 0,1 0,-1 0,0 0,-4-3,4 4,0 0,0 0,0 1,-1 0,1-1,0 1,-1 1,1-1,-1 0,1 1,-1-1,1 1,-1 0,1 0,-1 1,1-1,-1 1,1 0,-1 0,1 0,-5 2,-2 2,0 0,0 1,0 1,1-1,0 2,0-1,1 1,0 0,0 1,1 0,-10 14,6-6,1 1,1 0,0 0,2 1,-11 35,12-26,1 0,1 0,1 1,2-1,1 1,1-1,7 48,-6-70,-1 0,1 0,0 0,1-1,-1 1,1 0,0-1,1 0,-1 0,6 5,-8-8,1 0,-1 0,1-1,0 1,0-1,0 0,0 1,0-1,0 0,0 0,0 0,0 0,0-1,1 1,-1-1,0 1,1-1,-1 0,0 0,1 0,-1 0,0 0,1 0,-1-1,0 1,0-1,1 0,-1 1,4-3,-3 0,1 1,-1-1,0 0,1 1,-1-2,-1 1,1 0,0-1,-1 1,0-1,0 1,0-1,0 0,2-8,1-6,0 1,2-21,-5 19,0 1,-1 0,-1 0,-1-1,-1 1,-6-29,6 35,-1 1,-1 0,0 0,0 0,-1 0,-1 0,0 1,0 0,-1 1,0-1,-12-11,16 18,0 1,1-1,-1 1,-1 0,1 0,0 0,0 0,-1 0,1 1,-1-1,1 1,-1 0,0 0,0 1,1-1,-1 1,0 0,0 0,1 0,-1 0,0 1,-4 0,4 0,1 1,-1-1,1 1,0 0,0 0,0 0,0 1,0-1,0 1,0-1,1 1,-1 0,1 0,0 0,0 0,0 1,0-1,1 0,-1 1,1-1,0 1,-1 4,0 2,0-1,1 1,0-1,1 1,0 0,1 0,0-1,0 1,1-1,0 1,0-1,1 1,1-1,0 0,0-1,0 1,1-1,8 10,-6-9,0 1,1-2,1 1,-1-1,1-1,0 0,1 0,0 0,0-1,0-1,1 0,0 0,0-1,21 5,-29-8,0-1,0 1,0-1,0 0,0 0,0 0,0 0,0 0,0-1,0 1,0-1,-1 0,1 0,0 0,0 0,-1 0,1-1,0 1,-1-1,0 0,1 0,-1 0,0 0,0 0,0 0,3-4,-3 3,0-1,0 0,-1-1,1 1,-1 0,1 0,-1-1,-1 1,1 0,-1-1,1 1,-1-1,-1 1,1-1,-1 1,1 0,-3-6,-2-7,-2 1,0 0,0 0,-2 1,0 0,0 0,-1 1,-1 0,-1 1,0 0,0 1,-2 0,-20-14,28 23,0 0,0 0,0 1,0 0,0 0,0 0,0 1,0 0,-13 0,17 0,1 1,-1 0,0 0,0 1,1-1,-1 0,0 1,1-1,-1 1,0-1,1 1,-1 0,1 0,-1 0,1 0,-1 0,1 0,0 0,-1 0,1 0,0 1,0-1,0 0,0 1,0-1,0 1,0-1,0 1,1 0,-1-1,1 1,-1 0,1-1,0 1,0 0,-1 0,1-1,0 1,1 3,0 1,0-1,0 1,1-1,-1 1,1-1,1 0,-1 0,1 0,0 0,0 0,0-1,0 1,1-1,5 5,-4-4,0 0,0-1,1 1,-1-1,1-1,0 1,0-1,1 0,-1 0,0-1,10 3,-13-5,0 0,0 0,1 0,-1 0,0 0,0-1,0 1,0-1,0 0,0 0,0 0,0-1,-1 1,1-1,0 1,-1-1,1 0,-1 0,1 0,-1 0,0-1,0 1,0-1,3-4,1-2,-1 0,0-1,-1 1,1-1,-2 0,4-12,-2-2,-1 0,0 0,-1-27,-2 39,-2-1,1 1,-2-1,0 1,0 0,-1-1,-8-21,9 32,1-1,0 1,0-1,-1 1,0-1,1 1,-1 0,0 0,0 0,0 0,0 0,-1 0,1 1,-1-1,-2-1,4 3,0 0,0-1,0 1,0 0,1 0,-1 0,0 0,0 0,0 0,0 0,0 0,1 0,-1 0,0 1,0-1,0 0,0 1,1-1,-1 0,-1 1,1 0,0 1,0-1,-1 0,1 0,0 1,0-1,0 1,1-1,-1 1,0-1,0 1,1 0,-1 2,-1 5,0-1,0 1,1 0,1 0,-1 0,1-1,1 1,0 0,0 0,1 0,0-1,0 1,1-1,0 1,0-1,1 0,9 14,-9-17,0 0,0 0,0 0,1 0,0-1,0 1,0-1,0-1,0 1,1-1,0 0,0 0,0 0,0-1,0 0,0 0,1 0,-1-1,1 0,-1-1,1 1,-1-1,1 0,11-3,-11 2,0-1,-1 0,1-1,-1 1,1-1,-1-1,0 1,0-1,-1 0,1 0,-1-1,0 1,0-1,0-1,-1 1,0 0,0-1,0 0,0 0,-1 0,3-9,2-6,0-1,-2 0,0 0,-2-1,3-26,-6 34,-1 0,0 1,0-1,-2 1,0-1,0 1,-2-1,0 1,0 0,-1 1,-8-16,10 23,-1 0,1-1,-1 1,-1 1,1-1,-1 1,0-1,0 1,0 1,-1-1,0 1,0 0,0 0,0 0,-1 1,1 0,-1 1,0-1,0 1,0 1,0-1,0 1,0 0,-10 0,10 2,0-1,1 1,-1 1,0-1,0 1,1 0,-1 0,1 1,-1 0,1 0,0 1,0-1,1 1,-1 1,1-1,0 1,0 0,0 0,0 0,1 1,0-1,1 1,-1 0,1 1,0-1,-3 10,3-9,1 0,0 1,0 0,1-1,0 1,1 0,-1-1,1 1,1 0,0 0,0-1,0 1,1 0,0-1,0 0,1 1,0-1,0 0,1 0,0-1,0 1,1-1,7 9,-5-8,1-1,0 1,0-2,0 1,1-1,0-1,0 1,0-1,0-1,1 0,-1 0,1-1,0 0,-1-1,13 1,-14-2,0 0,0 0,0-1,0 0,0 0,-1-1,1 0,0 0,-1-1,0 0,1-1,-1 1,0-1,-1 0,1-1,-1 0,0 0,0 0,6-7,-6 3,1 1,-1-1,-1 0,0-1,0 0,-1 1,0-2,0 1,-1 0,-1-1,0 1,0-1,-1 1,0-20,-2 21,0 0,0-1,-1 1,0 0,-1 0,0 0,0 0,-1 0,0 1,0 0,-1 0,0 0,-1 0,0 1,0 0,-13-12,9 11,-1 0,1 0,-1 1,-1 0,-14-6,18 10,1 1,-1-1,1 1,-1 1,0-1,0 1,0 0,0 1,-13 1,18-1,0 1,0-1,1 1,-1 0,1 0,-1 0,1 0,-1 1,1-1,-1 0,1 1,0 0,0 0,0-1,0 1,0 0,0 0,1 1,-1-1,1 0,-1 1,1-1,0 1,0-1,0 1,0-1,1 1,-1 0,1-1,-1 1,1 0,0 4,0 0,0 0,0 0,1-1,0 1,0 0,1 0,0-1,0 1,0-1,1 0,0 1,5 6,0-3,0 0,1 0,1-1,0-1,0 1,0-2,1 1,0-1,20 9,-21-12,0 0,0 0,0-1,0 0,0-1,0 0,1-1,-1 0,1 0,0-1,-1-1,16-2,-21 2,-1 0,0 0,0-1,0 0,0 0,0 0,0 0,0 0,-1-1,1 0,-1 1,0-1,0-1,4-3,-3 1,0 0,-1 0,0 0,0-1,0 1,0-1,-1 0,1-7,0-8,0 0,-2 0,0 0,-4-34,-3 15,-2 0,-1 1,-2 0,-17-39,13 38,1-1,3 0,-10-63,18 69,1-62,3 83,0 1,1-1,1 1,0 0,1 0,0 0,9-16,-12 27,1 0,-1 0,1 0,0 0,0 0,0 0,1 1,-1-1,1 1,-1 0,1 0,0 0,0 0,0 0,0 0,0 1,0-1,1 1,-1 0,5-1,2 1,1 0,-1 1,1 1,-1-1,14 4,-10-2,0-1,25 0,-35-1,0-1,0 0,0 1,1-1,-1-1,0 1,-1 0,1-1,0 0,0 0,-1 0,1-1,4-3,1-3,0-1,-1 0,0 0,-1-1,0 0,-1-1,0 1,7-22,-2 3,-2-1,7-45,-12 53,-1-1,-2 0,0 0,-2 0,-5-40,3 50,1 1,-2 0,0 0,-1 0,0 0,0 1,-2 0,1 0,-2 0,0 1,-14-17,19 26,0-1,0 0,0 1,0-1,0 1,-1 0,-4-2,7 4,1-1,-1 1,0 0,0 0,0-1,0 1,1 0,-1 0,0 0,0 0,0 0,0 0,1 0,-1 0,0 0,0 1,0-1,0 0,1 0,-1 1,0-1,0 1,1-1,-1 1,0-1,1 1,-1-1,0 1,1-1,-1 1,1 0,-1-1,1 1,-1 0,1 0,0-1,-1 1,1 0,0 0,-1-1,1 1,0 1,-2 7,0 0,1 0,0 0,1 0,0 1,2 14,11 58,-8-59,1 0,0 0,17 36,-20-52,0-1,0 0,0 0,1 0,0 0,1-1,-1 0,1 0,0 0,0 0,0-1,1 1,0-1,0-1,0 1,13 4,-17-7,1 0,-1 0,1-1,-1 1,1-1,-1 1,1-1,-1 0,1 0,-1 0,1-1,-1 1,1 0,-1-1,1 0,-1 0,1 1,-1-1,0-1,1 1,-1 0,0-1,0 1,0-1,0 1,0-1,0 0,-1 0,1 0,0 0,-1 0,0 0,1-1,-1 1,0 0,0-1,1-4,0-1,1-1,-2-1,1 1,-1 0,-1 0,1 0,-2-1,1 1,-3-12,-1 1,-1 1,-1 0,-1 1,0 0,-2 0,0 0,0 1,-2 0,0 1,-1 0,-20-20,28 32,-1 0,1 1,-1 0,0-1,0 2,0-1,0 0,0 1,-6-2,9 4,-1-1,0 0,1 1,-1 0,0 0,1 0,-1 0,0 0,1 0,-1 1,1-1,-1 1,1 0,-1 0,1 0,-1 0,1 0,0 0,-1 1,1-1,0 1,-3 2,-4 6,0 0,0 1,1 1,1-1,0 1,0 0,1 1,1 0,0 0,0 0,-2 16,1-2,2 0,1 0,1 0,2 50,2-54,0 0,2 0,1 0,0-1,2 0,0 0,2 0,15 28,-19-41,1-1,-1 1,1-1,1 0,0-1,0 0,0 0,1 0,0-1,0 0,1 0,-1-1,1 0,1-1,-1 0,0 0,1-1,0 0,0-1,0 0,16 1,-14-3,0-1,0 0,0-1,0-1,0 1,0-2,-1 1,0-2,0 0,0 0,0-1,-1 0,0-1,14-11,1-3,-1-2,-1 0,-2-1,24-34,-27 32,-1-1,-1-1,-1 0,-2-1,-1-1,-1 0,-2 0,12-62,-19 72,0 0,-2-1,0 1,-1 0,-1 0,-6-31,4 36,-1 1,0 0,0 0,-2 1,1-1,-2 1,0 1,0 0,-17-19,16 22,1 1,-2 0,1 0,-1 1,0 0,-1 1,1 0,-1 1,-1 0,1 0,-1 1,1 1,-1 0,0 1,-14-1,17 2,1 1,-1 0,1 1,-1-1,0 2,1-1,0 1,-1 1,1 0,0 0,0 0,0 1,1 0,-1 1,1-1,0 2,0-1,1 1,0 0,0 0,0 0,-5 8,3-1,1-1,0 1,1 0,0 1,1 0,1 0,0 0,1 0,0 0,1 1,1-1,1 1,-1 0,4 20,0-15,0 0,1-1,1 0,1 0,0 0,2 0,0-1,1 0,1-1,12 17,-10-19,0 1,1-1,1-1,19 15,-26-24,0 1,1-1,0 0,0-1,0 0,1 0,-1-1,1 0,0-1,0 1,10 0,-14-3,-1 0,0 0,1 0,-1 0,0-1,1 1,-1-1,0-1,0 1,0 0,0-1,0 0,0 0,5-4,-3 2,-1 0,-1 0,1-1,-1 1,0-1,0-1,0 1,5-12,-2 4,-2-1,0 0,0 0,-2-1,0 0,0 1,0-27,-3 26,-2-1,1 0,-2 1,0-1,-1 1,-1 0,0 0,-1 0,0 1,-2 0,1 0,-2 1,0 0,0 0,-1 1,-1 0,-14-13,14 15,-1 0,0 0,-1 1,0 1,0 0,-1 0,1 1,-2 1,1 1,-1 0,0 1,0 0,0 1,0 1,-1 0,1 2,-27 1,35-1,1 1,-1 1,1-1,0 1,-1 0,1 1,0 0,0 0,1 0,-1 0,1 1,-1 0,1 0,0 0,1 1,-9 10,7-6,1 0,-1 0,2 0,0 1,0 0,0 0,1 0,1 0,0 0,-1 12,-2 35,3 0,8 83,-6-134,1 0,0-1,0 1,0-1,1 1,0-1,0 1,4 6,-5-11,0 1,0-1,0 1,0-1,1 1,-1-1,0 0,0 0,1 0,-1 0,1 0,-1 0,1 0,-1 0,1-1,0 1,-1 0,1-1,0 1,-1-1,1 0,0 0,0 0,-1 1,1-2,0 1,0 0,-1 0,1 0,0-1,3-1,1 0,1-2,-1 1,1-1,-1 0,-1 0,1 0,0-1,-1 0,0 0,6-8,2-4,0-2,12-21,-10 9,0 0,-3-1,0 0,-2-1,-2 0,6-40,-7 16,-2 0,-6-111,1 160,-1-1,0 1,0 0,-1 0,0 0,0 0,-1 1,0-1,-7-12,7 16,1 1,-1 0,0-1,0 1,0 1,-1-1,1 0,-1 1,1 0,-1-1,0 1,0 1,0-1,0 1,0-1,0 1,0 0,0 1,-1-1,-4 1,5-1,-1 1,0 1,1-1,-1 1,0 0,1 0,-1 0,0 0,1 1,0 0,-1 0,1 0,0 0,0 1,0 0,0 0,1 0,-1 0,1 0,0 1,0-1,0 1,0 0,1 0,-3 6,-3 5,1 1,0 1,2 0,0 0,-5 27,5-13,1 0,0 36,4-52,1 1,0-1,1 0,1 0,0 0,8 20,-10-31,1 0,0 0,0 0,0-1,1 1,-1-1,6 6,-7-8,-1 0,1-1,0 1,-1-1,1 1,0-1,0 1,0-1,-1 1,1-1,0 0,0 0,0 1,0-1,-1 0,1 0,0 0,0 0,0 0,0 0,0 0,0 0,0 0,-1 0,1-1,0 1,0 0,0 0,0-1,-1 1,1-1,0 1,0-1,-1 1,1-1,0 1,-1-1,1 0,0 1,-1-1,1 0,0-1,3-4,-1 0,0-1,0 1,0-1,-1 0,1 0,-2 0,1 0,-1 0,0 0,-1-1,0-10,-1-6,-1 0,-7-37,4 40,-1-1,0 1,-2 0,0 0,-1 1,-2 0,0 1,-19-27,20 35,1-1,-2 1,1 1,-2 0,1 0,-1 1,0 1,-1 0,0 1,-1 0,1 1,-1 0,-24-6,14 7,0 1,0 1,-48 0,57 3,0 1,0 1,0 0,1 1,-1 1,1 0,-25 12,36-15,1 0,-1 0,1 1,0-1,-1 1,1-1,0 1,0 0,0 0,0 0,0 0,1 0,-1 0,1 1,-1-1,1 1,0-1,0 1,0-1,0 1,0 0,0 2,1-1,0 0,1 0,-1-1,1 1,-1 0,1-1,0 1,1-1,-1 1,1-1,-1 0,1 0,0 1,0-1,5 5,-1-2,0-1,0 1,0-1,1 0,0-1,0 0,0 0,0 0,1-1,0 0,-1 0,1-1,15 3,2-2,1 0,-1-2,30-2,-47 1,0 0,-1-1,1 0,0-1,-1 0,1 0,-1 0,0-1,0 0,0 0,0-1,9-7,-10 6,-1 0,0 0,0-1,0 1,-1-1,0 0,0 0,-1-1,0 1,0-1,0 0,-1 0,3-11,-1-1,-2 0,0-1,-1 1,-1-1,0 0,-2 1,0-1,-2 1,0 0,-1 0,0 0,-2 1,0 0,-2 0,0 0,-13-18,7 12,-1 2,-1 0,-1 1,-1 0,-1 2,0 0,-2 2,0 0,-1 1,-48-24,58 34,0 1,0 0,0 1,0 1,-1 0,0 0,0 2,1 0,-1 0,0 1,0 1,-24 4,34-4,1 0,-1 1,1 0,0-1,-1 1,1 1,0-1,0 0,0 1,0-1,1 1,-1 0,1 0,0 0,0 0,0 0,0 1,-3 6,1 0,0-1,1 1,0 1,1-1,-3 18,4-15,1 1,1 0,0 0,1-1,0 1,1-1,0 0,1 1,1-1,0-1,1 1,0-1,1 0,0 0,1-1,12 14,-13-17,0-1,0 1,1-1,0-1,1 0,-1 0,1-1,0 0,1 0,-1-1,1 0,0-1,0 0,0 0,0-1,1-1,-1 0,0 0,1-1,-1 0,1-1,10-1,-8-2,0 1,0-2,-1 0,0 0,0-1,0 0,-1-1,0-1,0 0,-1 0,1-1,-2 0,0-1,0 0,-1-1,12-17,-9 10,-2 1,0-1,0-1,-2 1,0-2,-1 1,-1 0,-1-1,-1 0,1-28,-4 33,0 1,-2 0,1-1,-2 1,0 0,-1 0,0 0,-1 1,0-1,-1 1,-1 1,0-1,-10-13,5 11,0 1,-1 1,0 0,-1 0,-1 1,0 1,0 1,-1 0,-25-12,19 13,-1 0,1 2,-1 0,0 1,-1 2,0 0,-30 0,34 3,0 2,0 0,0 1,0 2,1-1,-1 2,1 1,-34 14,33-10,0 0,1 1,0 1,-31 26,43-32,1 1,-1 0,1 1,0-1,1 1,0 0,0 1,1-1,0 1,0 0,1 0,0 0,-3 17,5-16,0-1,0 1,0-1,2 1,-1-1,1 0,0 1,1-1,4 15,-4-21,-1 1,1-1,0 1,0-1,0 1,0-1,1 0,-1 0,1 0,0-1,0 1,0 0,0-1,0 0,1 0,-1 0,1 0,-1-1,1 1,0-1,-1 0,1 0,0 0,0 0,6 0,-1-1,0 0,-1-1,1 0,-1 0,1-1,0 0,-1-1,0 1,0-1,15-9,-14 7,1-1,-1 0,-1 0,1-1,-1 0,0-1,-1 1,10-14,-10 10,0 1,-1-1,0-1,0 1,-2-1,1 0,-1 0,-1-1,0 1,-1-1,-1 1,0-1,0 0,-1 0,-1 1,0-1,-1 0,0 1,-1-1,0 1,-1 0,0 0,-1 0,-1 1,0-1,0 1,-1 1,0-1,-1 1,0 0,-1 1,-15-13,5 7,-1 2,0 0,-1 1,-1 1,0 1,0 1,-1 1,0 1,0 0,-1 2,1 1,-1 1,0 1,-43 3,56 0,0 0,0 1,1 1,-1 0,1 1,-1 0,1 0,0 1,1 0,-17 12,14-7,0 0,1 1,0 0,0 1,2 0,-1 1,-6 13,2-1,2 1,1 0,1 0,1 1,1 0,1 0,2 1,-2 29,6-50,1 0,-1 1,2-1,-1 0,1 0,0 0,0 1,1-1,0 0,3 6,-4-10,1 0,-1-1,1 0,0 1,0-1,0 0,0 0,0 0,1 0,-1 0,0 0,1-1,-1 1,1-1,0 0,0 1,-1-1,1-1,0 1,0 0,0-1,0 1,0-1,0 0,0 0,5-1,-3 1,-1-1,1 0,-1 0,0 0,1-1,-1 0,0 1,0-1,0-1,0 1,0-1,-1 1,1-1,-1 0,0 0,1-1,-1 1,-1-1,1 0,0 1,3-9,1-3,0 0,-2 0,1 0,5-29,-8 26,0 0,-1 0,-1 0,0 0,-2-1,0 1,-1 0,-5-23,5 32,-1 1,1-1,-2 1,1-1,-1 1,-1 0,1 0,-1 1,-1-1,1 1,-1 0,0 1,-1-1,0 1,0 1,0-1,-1 1,-13-7,7 6,-1 1,-1 0,1 1,-1 1,1 0,-1 1,0 1,0 0,0 2,0-1,-16 4,5 1,0 0,1 2,0 1,0 0,-42 22,51-21,0 1,1 1,0 0,1 1,0 1,1 1,-22 26,29-32,0 1,1 0,0 1,1 0,0-1,1 1,0 1,0-1,1 1,1 0,-1-1,2 1,-1 0,2 0,0 13,0-19,1 0,0 0,0-1,1 1,-1 0,1 0,0-1,0 1,1-1,-1 0,1 1,0-1,0 0,0-1,1 1,-1-1,1 1,0-1,0 0,0 0,0-1,1 1,-1-1,1 0,-1 0,1 0,6 0,0 1,-1-1,1 0,0-1,-1 0,1-1,0 0,0-1,0 0,0 0,-1-2,18-4,-11-1,0 1,0-2,-1 0,0-1,-1-1,0 0,-1-1,0-1,18-22,-12 11,-1-2,-1 0,-1-1,24-52,-35 65,0-1,-1 1,-1-1,0 0,-1 0,2-29,-5 37,0 0,0 0,-1 0,0 0,0 0,-1 0,0 0,0 1,0-1,-1 1,0-1,0 1,0 0,-1 0,0 0,-1 1,-6-8,0 4,-1 0,0 1,0 0,0 1,-1 1,0 0,0 1,0 0,-1 1,-26-5,0 3,0 1,-67 2,41 6,1 3,1 3,-1 3,2 2,0 3,0 3,-89 42,128-51,1 1,-1 1,2 1,-25 20,41-29,0 1,0 0,0 1,1-1,0 1,0 0,-5 11,8-13,0 0,0 0,0 0,1 0,0 1,0-1,0 0,1 1,0-1,0 0,0 1,2 9,-1-12,0 1,1-1,-1 0,1 0,-1 0,1 0,0 0,0 0,0 0,1-1,-1 1,0-1,1 0,0 1,0-1,0-1,0 1,0 0,0-1,0 1,0-1,0 0,1 0,5 1,8 1,0 0,1-1,24 0,-42-2,18-1,0 0,0-1,0-1,0-1,-1 0,1-1,-1-1,0-1,-1 0,0-1,0-1,-1-1,0 0,0 0,-1-2,-1 0,0 0,20-26,-29 32,1 0,-2 0,1 0,0 0,-1-1,-1 0,1 0,-1 1,0-1,0-1,-1 1,0 0,0-9,-1 11,-1 0,0 0,1 0,-2 1,1-1,0 0,-1 0,0 1,0-1,-1 1,1-1,-1 1,0 0,0 0,0 0,-1 1,1-1,-1 1,-6-5,-2 0,-1 1,1 0,-1 1,-1 1,1 0,-1 1,0 0,0 1,-22-2,-14 0,-66 4,76 2,1 3,0 1,0 1,0 3,0 1,-66 27,82-27,0 1,0 1,1 1,1 1,0 1,1 1,0 1,2 0,0 1,1 1,-24 35,36-45,0 0,1 1,0-1,0 1,1 0,1 0,-1 1,0 14,3-20,0-1,0 1,0-1,0 1,1-1,0 1,0-1,0 1,3 6,-3-9,0 0,1 0,-1 1,1-1,-1-1,1 1,0 0,-1 0,1-1,0 1,0-1,0 1,0-1,1 0,-1 0,0 0,0 0,4 1,-4-2,0 1,0-1,-1 0,1 0,0 0,0 0,-1 0,1-1,0 1,0 0,-1-1,1 1,0-1,-1 0,1 0,0 1,-1-1,1 0,-1 0,0-1,1 1,-1 0,0 0,0-1,1 1,-1 0,0-1,0 1,-1-1,1 0,0 1,0-1,0-2,1-3,0 1,0-1,0 0,-1 1,0-1,0 0,-1-11,-1 8,-1 1,0-1,-1 1,0-1,0 1,-1 0,0 1,-1-1,0 1,0-1,0 2,-1-1,-13-12,3 4,-1 0,-1 1,-1 2,-34-21,26 20,0 2,-2 0,1 2,-1 1,-1 1,1 2,-39-4,17 6,0 2,0 3,-79 10,74-2,1 3,0 2,0 2,2 3,-99 49,111-46,2 2,0 1,2 2,0 2,2 1,2 2,-51 61,76-82,-1 1,1 0,1 1,0 0,1 0,1 0,0 1,-4 18,7-25,1 1,0-1,0 1,1-1,0 1,1-1,-1 1,2-1,-1 0,1 1,0-1,0 0,1 0,0 0,0 0,1-1,6 10,0-3,1-1,0-1,1 0,0 0,1-1,0-1,0 0,1-1,0-1,1 0,18 6,5 0,1-2,0-1,53 5,-42-9,84-1,-103-7,1 0,0-2,60-16,-76 15,0-1,0 0,0-2,-1 1,0-2,0 0,-1-1,19-16,-23 17,-1-1,0-1,0 1,-1-2,-1 1,0-1,0 0,-1 0,-1-1,0 0,6-23,-9 24,1 0,-2 0,1 0,-2-1,1 1,-2 0,0 0,0 0,-1 0,0 0,-1 0,-1 0,0 1,0 0,-1-1,-1 2,0-1,0 1,-1-1,0 2,-1-1,0 1,0 0,-1 1,0 0,-1 0,0 1,0 1,0-1,-1 2,0-1,-20-6,17 8,-1 1,1 1,0 0,-1 0,1 2,-1 0,1 0,-1 2,1-1,0 2,0 0,0 1,0 0,0 1,1 1,-1 0,-12 8,-3 4,1 1,1 1,0 1,2 2,0 0,-24 31,33-35,1 1,1 0,1 1,1 1,1-1,0 2,2 0,-8 26,14-36,1-1,0 1,1-1,0 1,0 0,2-1,2 21,-1-23,0-1,1 0,0 0,0 0,1 0,0-1,0 0,1 0,1 0,-1 0,8 8,-4-8,0 0,1 0,-1-1,1-1,1 0,-1 0,1-1,0 0,0-1,0 0,1 0,0-2,-1 1,18 0,-17-2,0 0,0-1,0 0,0-1,0 0,0-1,0-1,-1 0,1 0,-1-1,0 0,0-1,0-1,14-9,-12 5,0-1,-1-1,-1 0,0-1,-1 0,0-1,-1 0,0 0,-1-1,-1 0,0-1,-1 0,-1 0,0 0,3-27,-5 24,-1 0,-1 0,-1 0,0-1,-2 1,0 0,-1 0,-1 0,0 0,-2 1,0 0,-1 0,-14-24,14 30,-1 0,-1 0,0 1,0 0,-1 1,0 0,-1 1,0 0,-20-12,13 11,0 1,-1 0,0 2,-1 0,0 1,-21-4,4 5,0 1,0 1,-1 3,1 1,0 1,-70 15,78-11,0 2,1 1,0 1,0 1,1 2,1 0,0 2,-24 19,36-23,0 0,1 0,1 2,0 0,1 0,0 1,1 0,1 1,0 0,1 0,0 1,2 0,-1 1,-6 30,11-35,0 0,1 1,0-1,0 0,2 1,-1-1,2 0,0 1,0-1,1 0,0 0,1-1,1 1,0-1,0 0,1 0,0 0,1-1,0 0,1 0,0-1,1 0,0 0,18 13,-7-9,1 0,0-1,0-2,1 0,1-1,37 10,-6-7,100 10,-95-18,0-2,0-2,0-3,69-13,-100 12,0-2,-1-2,0 0,0-2,-1-1,0 0,-1-3,0 0,-1-1,39-32,-49 34,-1-1,0 0,-1-1,-1 0,0-1,-1 0,-1 0,0-1,-2 0,9-27,-12 30,-1 0,0 0,-1-1,-1 1,0 0,-1-1,0 1,-2 0,1-1,-2 1,0 0,0 0,-2 0,-6-16,4 15,-1 0,0 0,-1 1,0 0,-2 1,1 0,-1 1,-1 0,0 0,-1 1,0 1,-1 0,0 1,0 1,-1 0,0 1,-1 0,1 1,-1 1,0 1,-19-3,-31-1,-1 2,0 4,-127 12,189-9,0-1,0 1,0 0,0 1,1-1,-1 1,1 0,-1 0,1 0,0 1,0 0,0-1,0 2,0-1,-3 4,3-2,0 0,1 0,-1 0,1 1,0-1,1 1,-1 0,1 0,0 0,1 0,-2 7,1 1,0 0,1-1,0 1,1 0,2 15,-1-23,0 0,1 0,-1 0,1 0,1 0,-1-1,1 1,0-1,0 1,0-1,1 0,0 0,7 7,-6-8,0 0,0 0,1 0,-1-1,1 0,0 0,0 0,0-1,0 0,0 0,0 0,1-1,-1 0,0 0,1 0,-1-1,1 0,-1-1,1 1,-1-1,1 0,-1-1,0 0,0 0,0 0,0 0,0-1,0 0,-1-1,1 1,-1-1,0 0,0 0,0-1,-1 1,1-1,-1 0,0 0,-1-1,1 1,-1-1,0 1,0-1,2-9,-3 6,1 0,-2-1,1 1,-2-1,1 1,-1-1,0 1,-1-1,0 0,-1 1,0 0,0-1,-1 1,-1 0,1 0,-1 1,-1-1,-6-9,5 7,-2 1,1 0,-1 1,0 0,-1 0,0 0,-1 1,0 1,0 0,0 0,-1 1,0 0,-22-8,14 10,0 1,-1 1,1 0,0 2,-1 0,-21 3,-20 0,54-3,0 0,-1 1,1 0,0 0,0 0,0 1,0 0,1 1,-10 4,13-5,0-1,0 2,0-1,0 0,0 0,1 1,-1 0,1-1,0 1,0 0,0 0,0 1,0-1,0 0,1 0,0 1,-1-1,1 1,1-1,-2 5,2-7,0 1,-1-1,1 0,0 0,0 1,0-1,0 0,0 0,0 1,0-1,0 0,1 0,-1 1,0-1,1 0,-1 0,1 0,-1 0,1 0,0 1,-1-1,1 0,0 0,0-1,0 1,0 0,0 0,0 0,0-1,0 1,0 0,0-1,0 1,0-1,0 1,1-1,-1 1,2-1,0 0,0 0,0 0,0 0,0 0,-1-1,1 1,0-1,0 0,0 0,0 0,-1 0,1 0,0-1,-1 1,4-3,6-7,-1 1,-1-2,0 1,0-2,-1 1,-1-1,0 0,-1-1,0 0,-1 0,0 0,-2-1,1 0,-2 0,0 0,1-31,-3 43,-1 0,0 1,-1-1,1 0,0 0,-1 1,0-1,1 0,-1 1,0-1,0 1,-1-1,1 1,-1-1,1 1,-1 0,1 0,-1-1,0 1,-4-2,3 2,0 0,0 0,-1 0,1 1,0 0,-1 0,1 0,-1 0,1 0,-1 1,0-1,1 1,-1 0,-4 0,3 1,1-1,0 1,-1-1,1 1,0 0,0 1,0-1,0 1,0 0,0 0,0 0,0 0,1 1,-1-1,1 1,0 0,0 0,0 0,0 1,0-1,1 1,-1 0,1-1,0 1,0 0,1 0,-2 5,1 2,0 0,1 0,0 1,1-1,0 0,1 0,1 0,-1 0,5 12,-6-21,1-1,0 1,0 0,0 0,0-1,0 1,1-1,-1 1,0-1,1 1,-1-1,1 0,0 0,-1 0,1 0,0 0,0 0,-1 0,1 0,0-1,0 1,0-1,0 1,0-1,0 0,0 0,0 0,0 0,0 0,0 0,0-1,3 0,0 0,0-1,0 0,0 0,0 0,-1 0,1-1,-1 0,1 0,-1 0,0 0,4-5,-4 4,-1 0,0 0,0-1,-1 1,1-1,-1 1,3-7,-5 9,1-1,0 1,0-1,-1 1,0-1,1 1,-1-1,0 0,0 1,0-1,-1 1,1-1,-1 0,1 1,-1-1,-1-2,2 5,0 0,0-1,0 1,0-1,0 1,-1-1,1 1,0-1,0 1,0-1,-1 1,1 0,0-1,-1 1,1 0,0-1,-1 1,1 0,0-1,-1 1,1 0,-1 0,1-1,-1 1,1 0,0 0,-1 0,1-1,-1 1,1 0,-1 0,1 0,-1 0,1 0,-1 0,1 0,-1 0,1 0,-1 1,1-1,-1 0,1 0,0 0,-1 0,1 1,-1-1,1 0,-1 0,1 1,0-1,-1 0,1 1,0-1,-1 0,1 1,0-1,0 1,-1-1,1 0,0 1,0-1,-1 1,-1 3,0 0,1 0,-1-1,0 1,-1 8,1-2,1-1,0 1,0 0,1-1,0 1,1 0,3 14,-3-19,0-1,1 1,0-1,0 1,1-1,-1 0,1 0,0 0,0 0,0 0,0 0,1-1,-1 0,1 0,0 0,8 5,12 4,-1-1,2-1,-1-1,1-1,1-1,-1-1,1-1,0-2,0-1,1 0,-1-2,0-1,0-2,0 0,38-10,-38 6,0 0,-1-2,0-1,0-1,-1-1,0-1,-1-1,-1-1,0-1,-1-1,-1-1,0-1,-2 0,32-44,-44 55,-1-1,0 0,-1 1,0-1,-1-1,5-17,-7 24,-1 1,1-1,-1 0,0 0,0 1,0-1,0 0,0 0,-1 0,1 1,-1-1,1 0,-1 1,0-1,0 1,-1-1,1 1,0-1,-1 1,1 0,-1-1,0 1,0 0,0 0,0 1,0-1,0 0,-4-1,-4-2,0 1,0 0,-1 0,1 2,-1-1,0 1,0 1,-22-1,-1 2,-52 8,59-4,0 1,0 1,1 2,0 0,1 2,-1 0,2 2,0 1,-25 17,16-9,23-16,1 1,-16 12,22-16,1 1,0-1,-1 1,1-1,0 1,0 0,1 0,-1 0,1 0,-1 0,1 0,0 0,-1 5,1-3,0 0,1 0,-1 0,1 0,0 0,0 0,1 0,-1 0,1 0,0 0,1-1,-1 1,1 0,0-1,0 1,0-1,1 0,4 7,-3-7,0 0,0 0,0-1,1 1,-1-1,1 0,0 0,0-1,0 0,0 1,1-2,-1 1,0 0,1-1,-1 0,8 0,-10-1,1 1,0-1,0 0,-1 0,1-1,0 1,-1-1,1 0,-1 0,1 0,-1 0,1-1,-1 1,0-1,1 0,-1 0,4-4,-4 3,0 0,0-1,0 1,-1-1,1 0,-1 0,0 0,0 0,-1-1,1 1,-1 0,0-1,0 1,0-7,0 4,-1 0,0 0,0 0,0 0,-1 0,0 0,-1 0,-3-9,4 12,0 1,-1-1,1 1,-1 0,0-1,0 1,0 0,-1 0,1 1,-1-1,1 0,-1 1,0-1,0 1,0 0,-1 0,1 0,-4-1,-5-1,0 1,0 0,-1 1,1 1,-16-1,-67 5,51-1,26-2,0 1,0 1,0 1,-21 6,34-8,0 1,0 0,0 0,0 0,1 0,-1 1,1 0,-1 0,1 0,0 1,0-1,0 1,1 0,-1 0,1 0,0 1,0-1,-3 9,1-2,1 1,0-1,1 0,0 1,1 0,0 0,1 0,0 17,1-23,1-1,0 1,0-1,1 1,0-1,0 1,0-1,0 0,1 0,0 0,0 0,1 0,-1-1,1 1,0-1,0 0,0 0,0-1,8 6,-3-4,0 0,0 0,0-1,1 0,-1-1,1 0,0 0,17 2,-20-5,-1 1,1-1,-1 0,1 0,-1 0,1-1,-1 0,1-1,-1 1,0-1,0 0,0-1,0 1,9-6,-15 7,1 1,0 0,0-1,-1 1,1-1,0 1,-1-1,1 1,0-1,-1 0,1 1,-1-1,1 0,-1 1,1-1,-1 0,0 0,1 1,-1-1,0 0,0 0,1 0,-1 1,0-1,0 0,0 0,0 0,0 0,0 0,-1-1,0 1,0 0,0 0,0 0,0 0,0 0,0 0,0 0,0 0,0 0,-1 0,1 1,0-1,-3 0,-7-3,-1 0,1 1,-13-1,-7 0,0 2,-1 1,1 2,-1 1,1 1,0 1,0 2,0 2,1 0,-44 20,49-18,0-1,0-1,-1-1,-45 6,70-13,0 0,-1 0,1 0,0 0,0 1,0-1,-1 0,1 1,0-1,0 1,0-1,0 1,0 0,0-1,0 1,0 0,0 0,0 0,0 0,0 0,0 0,1 0,-1 0,0 0,1 0,-1 0,1 0,-1 0,1 0,0 1,-1-1,1 0,0 0,0 1,0-1,0 0,0 0,0 2,1 5,1 0,-1-1,1 1,6 14,-6-17,2 4,20 51,-21-54,0 0,1 0,-1-1,1 1,0-1,1 0,5 6,-10-11,0 0,0 1,1-1,-1 0,0 1,0-1,1 0,-1 0,0 1,1-1,-1 0,0 0,1 0,-1 1,0-1,1 0,-1 0,0 0,1 0,-1 0,1 0,-1 0,0 0,1 0,-1 0,1 0,-1 0,0 0,1 0,-1 0,0 0,1 0,-1-1,0 1,1 0,-1 0,0 0,1-1,-1 1,0 0,1 0,-1-1,0 1,0 0,1 0,-1-1,0 1,0 0,0-1,1 1,-1-1,0 0,1-1,-1 1,0-1,1 1,-1-1,0 0,0 1,0-1,0 1,-1-1,1 1,-1-3,-1 0,0 0,0 0,0 0,-1 0,1 0,-1 0,0 1,-1-1,1 1,0 0,-1 0,0 0,0 1,0-1,0 1,0 0,0 0,-8-2,-3-1,0 1,0 0,-1 1,-20-1,24 3,0 1,0 0,0 1,0 0,0 1,1 1,-1 0,1 0,-1 1,1 0,0 1,-14 9,19-11,1 1,-1 0,1 0,0 0,1 1,-1 0,1 0,0 0,0 0,0 1,1-1,-1 1,2 0,-1 0,1 0,-1 0,2 1,-1-1,1 1,0-1,0 1,1-1,0 13,1-16,-1 0,1 0,0 0,0 0,0 0,0 0,0 0,1-1,-1 1,1 0,0-1,0 0,0 1,0-1,0 0,0 0,1 0,-1 0,1 0,-1-1,1 1,4 1,7 3,0 0,1-1,20 4,-4-1,0 4,-1 2,0 0,-1 2,51 39,-66-46,31 24,-1 2,-2 2,-2 2,-1 2,42 56,-12-11,4-3,3-3,4-4,3-3,3-3,3-5,3-4,185 93,-117-83,4-6,3-8,1-7,323 51,-446-94,-1-2,89-2,-125-3,-1-1,0 0,0 0,0-1,0 0,0 0,12-6,-16 6,0 0,-1 0,1 0,-1 0,1 0,-1 0,0-1,0 1,0-1,0 0,0 0,0 1,-1-1,1 0,-1 0,0 0,0-1,1-4,0-6,-1 0,0 0,-1 0,0 0,-1 0,-1 0,0 1,-1-1,0 0,-6-14,2 9,-1 0,-1 1,-1 0,0 0,-2 1,-16-20,8 14,-1 2,-1 0,-1 1,-1 2,0 0,-2 2,0 0,0 2,-2 1,1 1,-2 1,1 2,-1 1,-1 1,1 1,-1 2,0 1,0 1,-60 5,43 3,-1 3,1 2,1 1,0 3,-65 30,23-2,-138 92,139-77,2 4,-141 136,209-181,1 0,1 2,0 0,1 0,-22 43,34-58,0 1,0-1,0 1,1-1,0 1,0 0,0 0,0-1,1 1,0 0,0 0,0 0,1 0,-1-1,1 1,0 0,3 6,-1-5,0-1,0 1,1-1,0 0,0 0,1 0,-1 0,1-1,0 0,0 0,1 0,-1-1,7 4,10 4,-1-1,2 0,45 11,86 9,82-8,-59-19,260-27,171-74,-361 40,-166 36,0-2,85-40,-145 54,30-19,-46 26,0-1,0 0,0 0,0-1,-1 1,0-1,0 0,0 0,5-8,-9 12,1-1,0 1,0-1,-1 1,1-1,-1 0,0 1,1-1,-1 0,0 1,0-1,0 0,0 1,0-1,0 0,-1 1,1-1,0 0,-1 1,1-1,-1 1,0-1,0 1,1-1,-3-1,0-1,0 1,-1-1,1 1,-1 0,0 0,0 0,-9-4,-2 0,0 0,-1 1,0 1,-29-6,-77-6,-2 8,0 5,-1 6,1 5,1 5,0 6,0 5,2 6,2 4,-174 74,230-78,1 2,-92 62,126-74,2 2,0 1,2 0,0 2,2 1,1 1,-24 36,37-50,1 1,1-1,0 1,1 0,0 1,1 0,0-1,1 1,1 0,0 0,1 23,1-28,1 0,1 0,-1 0,2 0,-1 0,1-1,0 1,1-1,0 0,1 0,-1 0,1 0,1-1,0 0,0 0,0 0,1-1,-1 0,11 6,0-1,-1-2,2 0,-1 0,1-2,1 0,-1-2,1 0,0 0,0-2,0-1,22 1,8-2,0-3,1-1,61-14,-49 4,-1-2,-1-3,-1-3,-1-2,-1-3,-1-2,57-38,-73 39,-1-2,-1-1,-2-2,-1-1,-2-2,-1-1,-1-2,-3-1,43-77,-57 88,-1 0,-2-1,-1-1,-1 0,-1-1,-2 1,-1-1,-2 0,-1-1,-1 1,-2 0,-1-1,-1 1,-2 0,-1 1,-2-1,0 1,-21-45,11 36,-2 1,-2 0,-1 2,-1 1,-3 1,0 1,-2 1,-2 2,-1 1,-65-46,67 55,0 2,-2 1,0 1,0 2,-1 1,-1 2,0 1,-1 2,0 1,0 2,0 1,-1 2,-57 4,47 4,0 2,0 2,1 2,0 1,1 3,1 2,1 1,-45 29,39-18,1 2,1 2,2 1,2 3,1 2,-46 59,66-73,2 2,0 1,2 0,2 1,0 1,2 0,-15 56,23-70,2 1,0 0,0 0,2 0,0 1,2-1,0 0,0 0,2 0,0 0,1 0,1-1,1 1,0-1,17 30,-9-26,0 0,2-1,1-1,0 0,1-2,1 0,0-1,2 0,-1-2,2-1,0 0,1-2,37 14,-18-10,1-3,1-1,-1-2,2-2,-1-2,86-2,-79-6,-1-2,1-2,-1-3,0-1,-1-3,0-2,-2-2,0-2,80-48,-81 39,-1-3,-1-1,-2-3,-2-1,-1-2,-1-1,-3-2,-2-2,29-48,-30 37,-3-2,-3-1,-2-1,-2-1,-3-1,17-98,-28 109,-2-1,-3 0,-1 0,-3 0,-2 0,-3 1,-1-1,-23-80,20 99,-2 1,-1 0,-1 1,-2 0,-1 1,-1 1,-1 0,-2 2,-37-38,43 50,-1 0,0 1,-1 1,0 0,-1 2,0 0,-1 1,0 1,0 0,-1 1,0 2,0 0,-1 1,1 1,-1 1,-29 0,32 3,1 1,-1 0,0 1,1 1,0 1,-1 0,2 1,-1 1,1 1,0 0,1 1,-16 11,19-10,0 0,1 0,0 1,1 0,0 1,1 0,1 1,0-1,0 2,1-1,1 1,0 0,1 1,-5 23,6-19,1 1,1 0,1 0,1 0,1 0,1-1,5 30,0-21,1 0,1-1,1 0,24 43,-9-28,2-1,1-1,2-1,2-2,70 63,-48-56,1-2,3-2,93 48,-40-35,133 46,-111-54,1-6,3-5,0-7,2-5,197 5,-295-27,65-7,-101 7,0-1,0-1,-1 1,1-1,-1 0,1 0,-1 0,1 0,-1-1,0 0,4-3,19-12,-16 14,0 1,0-1,0 2,0 0,0 0,1 1,-1 1,21 1,-8-1,24 0,65 7,-98-5,0 0,-1 1,1 1,-1 1,0 0,0 0,0 2,21 12,-31-16,1 1,-1-1,0 1,0 0,0 0,-1 0,1 1,-1-1,0 1,0 0,0 0,-1 0,0 0,0 0,0 0,-1 1,1-1,-1 1,-1-1,1 1,-1-1,0 1,0 0,-1-1,0 8,-5 10,0 0,-1-1,-1 1,-19 34,10-19,10-22,1 0,0 0,1 0,1 0,1 1,-3 26,6-34,0 0,1 0,0 0,0-1,1 1,0 0,0-1,1 1,0-1,1 0,0 0,0 0,1-1,8 12,-3-8,1 1,0-2,0 0,2 0,-1-1,1 0,0-1,0-1,1 0,0-1,1 0,-1-1,1-1,19 3,21 2,0-3,88-2,-137-4,-2 0,6 1,-1-1,1 0,0-1,-1 0,1-1,14-4,-57 54,5-8,2 0,-31 68,48-87,1 0,1 0,0 1,2 0,1 0,1 0,-1 42,4-50,-1-5,1 0,1 0,-1 0,2 0,-1 0,4 12,2-12,-3-15,-2-18,-5 8,-2 0,0 1,0-1,-1 1,-1 1,-1-1,-14-20,21 33,-1 0,0-1,0 1,0 0,0 0,0 0,0 0,0 1,-1-1,1 0,-1 1,1 0,-1-1,1 1,-1 0,0 1,0-1,0 0,1 1,-1-1,0 1,0 0,0 0,0 0,0 1,1-1,-1 0,0 1,0 0,0 0,1 0,-1 0,0 0,1 0,-1 1,1 0,0-1,-1 1,1 0,0 0,0 0,0 0,0 0,1 0,-1 1,-2 4,-4 9,0 0,1 1,0 0,2 0,0 1,1 0,1 0,0 0,0 34,4-47,-1 0,0 0,1-1,0 1,0 0,1 0,-1-1,1 1,0-1,0 1,1-1,-1 0,1 0,0 0,0 0,0 0,4 3,-4-4,0-1,0 0,0 0,1 0,-1 0,0 0,1-1,-1 1,1-1,-1 0,1 0,0 0,0-1,-1 1,1-1,0 0,0 0,-1 0,1-1,0 1,0-1,-1 0,5-2,-2 1,0-1,0 0,0-1,0 0,-1 1,0-2,1 1,-2-1,1 0,0 0,-1 0,0 0,0-1,-1 0,0 1,0-1,0-1,3-10,0-2,-1 0,-1 0,0-1,-2 0,1-22,-3 31,0 0,0 0,-1 1,0-1,-1 0,-1 1,-5-19,6 25,0 0,0 0,-1 0,1 0,-1 0,0 1,0-1,0 1,0 0,0 0,-1 0,0 0,1 1,-1-1,0 1,0 0,-1 0,1 1,0-1,-8-1,6 2,1 0,0 1,0-1,0 1,-1 0,1 1,0-1,0 1,0 0,-1 0,1 1,0-1,1 1,-1 1,0-1,-7 5,10-5,-1 0,0 0,1 0,-1 0,1 1,0-1,0 1,0 0,0 0,0 0,1 0,-1 0,1 0,0 0,0 0,0 0,0 0,0 1,1-1,0 0,-1 1,1-1,1 1,-1-1,0 0,2 7,-1-8,0 1,0 0,0-1,0 1,1-1,-1 1,1-1,-1 0,1 0,0 1,0-1,0 0,0-1,0 1,1 0,-1-1,0 1,1-1,0 0,-1 1,1-1,-1-1,1 1,0 0,0-1,4 1,-4 0,0-1,-1 0,1 0,0 0,-1-1,1 1,-1-1,1 1,0-1,-1 0,1 0,-1 0,0 0,1 0,-1 0,0-1,0 1,0-1,0 0,0 0,0 0,0 0,0 0,-1 0,1 0,-1 0,0 0,2-4,0-8,0 1,0-1,-2 1,1-1,-2 0,0 0,-3-22,1-31,2 65,0 0,0 0,0 0,0 0,0 1,1-1,-1 0,1 0,-1 0,1 0,0 0,0 0,0 1,0-1,0 0,0 1,0-1,1 1,-1-1,2-1,-1 3,-1-1,1 0,0 1,0-1,0 1,-1-1,1 1,0 0,0 0,0 0,0 0,-1 0,1 0,0 0,0 1,0-1,2 1,6 3,0 1,0-1,0 2,-1-1,15 12,-20-14,1 0,0 1,0-2,0 1,0-1,7 3,-11-5,-1 0,1 0,0 1,0-1,-1 0,1 0,0 0,0 0,0 0,-1 0,1 0,0-1,0 1,-1 0,1 0,0-1,0 1,-1 0,1-1,1 0,-1 0,-1 0,1 0,-1 0,1 0,-1 0,1 0,-1 0,1-1,-1 1,0 0,0 0,0 0,0-1,0 1,0 0,0 0,0 0,0-3,-2-7,-1 0,0 0,0 0,-1 0,-7-14,8 18,0 1,0 0,-1 1,0-1,0 1,0-1,-1 1,0 0,0 1,-6-6,10 10,1 0,-1-1,1 1,-1-1,1 1,-1 0,1-1,-1 1,0 0,1 0,-1 0,0-1,1 1,-1 0,0 0,1 0,-1 0,0 0,1 0,-1 0,1 0,-1 1,0-1,1 0,-1 0,0 0,1 1,-1-1,0 1,0 0,1 0,-1 0,0 0,1 0,-1 0,1 0,-1 0,1 0,0 1,-1-1,1 0,0 0,0 0,0 2,0 2,0 0,0 0,1 0,0-1,0 1,0 0,2 4,-1-6,-1 0,1 0,0 0,0-1,0 1,1-1,-1 1,0-1,1 0,0 0,-1 0,1 0,0 0,0-1,4 2,-5-2,0-1,0 1,0-1,0 0,1 0,-1 1,0-1,0-1,0 1,0 0,0 0,1-1,-1 0,0 1,0-1,0 0,0 0,0 0,-1 0,1 0,0 0,0-1,-1 1,1 0,1-3,5-6,0 0,-1 0,0-1,0 0,-1 0,-1-1,0 0,4-15,-2 2,-1-1,-1 1,2-29,-6 44,-1 0,0 0,-1-1,0 1,0 0,-6-17,7 25,-1 0,0 1,1-1,-1 1,0-1,0 0,0 1,0-1,0 1,0 0,0-1,-1 1,1 0,-1 0,1 0,0 0,-1 0,-1-1,1 2,0-1,0 1,0 0,0 0,0 0,0 0,0 1,0-1,0 1,0-1,0 1,0-1,0 1,1 0,-1 0,0 0,1 0,-1 0,0 0,-2 3,2-1,-1 0,0 0,1 0,-1 0,1 0,0 0,0 1,0 0,1-1,-1 1,1 0,0-1,0 1,0 0,0 0,0 5,1 3,-1 0,1-1,1 1,3 14,-3-20,0 0,1-1,-1 1,1-1,1 1,-1-1,1 0,0 0,0 0,1 0,-1-1,1 1,0-1,5 4,-7-5,1-1,0 0,0 0,0-1,0 1,0-1,1 1,-1-1,0 0,1 0,-1 0,1-1,-1 1,0-1,1 0,-1 0,1 0,-1-1,1 1,-1-1,1 1,-1-1,0 0,6-3,-7 3,0 0,0 0,0 0,0-1,0 1,0-1,0 1,-1-1,1 0,-1 0,1 0,-1 0,0 0,1 0,-1 0,0 0,0 0,0-3,1-3,0 0,-1 0,0 1,-1-10,1-3,9 50,-3-2,21 49,-21-59,-6-17,0 1,0 0,-1-1,1 1,-1 0,1 0,-1-1,0 1,1 0,-1 0,0 0,0-1,0 1,-1 0,1 0,0 0,-1-1,1 1,-1 0,0 0,1-1,-1 1,0 0,0-1,0 1,0-1,0 1,-1-1,-1 2,-7 11,8-11,0-1,1 1,-1 0,1 0,0 0,0 1,0-1,0 0,1 0,-1 1,1-1,0 0,0 0,0 1,0-1,1 0,-1 0,1 1,0-1,0 0,0 0,0 0,1 0,-1 0,1 0,-1 0,1 0,0-1,0 1,3 2,-4-5,-1 0,1 1,-1-1,1 1,-1-1,1 0,-1 1,1-1,-1 0,1 0,0 1,-1-1,1 0,-1 0,1 0,0 0,-1 0,1 0,0 0,-1 0,1 0,-1 0,1 0,0 0,-1-1,1 1,-1 0,1 0,0-1,0 1,0-2,0 1,0 0,0 0,0-1,0 1,0-1,0 1,0-1,-1 1,1-1,0-2,1-4,0 1,-1-1,1-16,-2 11,-1-1,0 1,-2 0,1 0,-1-1,-1 2,0-1,-1 0,-13-23,17 34,-1 0,1 1,0-1,-1 0,0 0,1 1,-1-1,0 1,0-1,0 1,0 0,0 0,0-1,0 2,-1-1,1 0,0 0,-1 1,1-1,0 1,-1 0,1 0,0-1,-1 2,1-1,0 0,-1 0,1 1,-4 1,-1 0,1 1,-1 0,1 0,0 0,0 1,0 0,1 0,-8 8,12-11,-1 0,1 1,0-1,0 0,0 0,-1 0,1 0,-1-1,1 1,0 0,-1 0,0-1,1 1,-1-1,1 1,-1-1,0 0,1 0,-1 0,1 0,-1 0,-3 0,3-1,0 0,0-1,0 1,1 0,-1 0,0-1,1 1,-1-1,1 0,-1 1,1-1,0 0,-1 0,1 0,0 0,-1-3,-4-13,0-1,1 0,0 1,-2-38,2 20,-2-15,2 0,2 0,7-83,-4 131,1 0,0 0,0 0,0 0,0 0,0 1,0-1,1 0,0 1,-1-1,1 1,3-4,30-25,-6 6,18-20,-26 26,24-28,-42 41,1 1,-2 0,1-1,0 0,-1 1,0-1,-1 0,1 0,-1 0,1-12,-2 12,1-1,0 1,0 0,0 0,1-1,0 1,0 0,1 0,0 1,6-11,-4 11,1 0,-1 0,1 0,0 1,0 0,0 0,1 0,9-3,-11 5,0 0,0 0,0 0,0-1,0 0,-1 0,0 0,1-1,-1 1,-1-1,1 0,0 0,-1 0,0-1,0 1,0-1,3-6,-4 5,0 0,1 0,0 1,0-1,7-9,-9 14,0 0,-1 0,1 0,0 0,0 0,0 1,0-1,0 0,0 1,0-1,0 1,0-1,0 1,0-1,0 1,0 0,0-1,0 1,0 0,1 0,-1 0,0 0,0 0,0 0,0 0,0 1,0-1,1 0,-1 1,0-1,0 0,0 1,0-1,0 1,0 0,0-1,0 1,0 0,-1-1,3 3,-1-1,0 1,0 0,-1-1,1 1,0 0,-1 0,0 0,1 0,-1 0,0 1,-1-1,1 0,0 4,1 48,-2-41,0 38,-3 132,2-182,1 0,0 0,-1 0,1 0,-1 0,0 0,0 0,1 0,-1-1,0 1,-1 0,1-1,0 1,0-1,-1 1,1-1,-1 0,1 1,-1-1,0 0,-3 2,-2 0,-1 0,0 0,0-1,-9 2,-12 4,17-4,-1 1,1 0,0 1,-17 10,25-12,-1 0,1 0,-1 0,1 0,0 1,1-1,-1 1,1 0,0 0,0 0,1 1,-4 8,-1 6,2 1,0 0,1-1,-1 24,4-34,1 0,0 0,0-1,1 1,1 0,-1-1,1 1,1-1,0 0,0 0,6 10,-9-17,1-1,0 0,0 1,-1-1,1 0,0 0,0 1,0-1,1 0,-1 0,0 0,0-1,0 1,1 0,-1 0,1 0,-1-1,0 1,3 0,-3-1,1 0,-1 0,0-1,1 1,-1 0,1 0,-1-1,0 1,0-1,1 1,-1-1,0 0,0 1,1-1,-1 0,0 0,1-1,3-4,1 0,-1 0,-1 0,1-1,-1 0,3-7,2-5,-1-1,-1 0,0 0,-2-1,0 1,-2-1,0 0,-1 0,-1-1,-4-39,1 120,1-61,0 1,0-1,0 1,0-1,0 1,0 0,0-1,0 1,-1 0,1 0,-1 0,1 0,0 0,-1 0,0 0,1 0,-3 0,-33-14,24 14,1-1,-1 2,0-1,0 2,1 0,-25 5,-16 1,-98-2,-430-10,-17 0,507 6,12-2,-1 4,-106 18,164-15,1 0,0 2,1 0,-28 16,-21 9,66-32,0 1,-1-1,1 1,0 0,1 0,-1 0,0 0,1 1,-1-1,1 1,0 0,-1-1,1 1,1 0,-1 0,0 0,1 0,-1 1,-1 5,2-3,0 0,0 1,1-1,0 0,0 0,0 1,1-1,-1 0,2 0,1 9,-2-14,-1 0,1 0,-1 0,1 0,-1 0,0 1,0-1,1 0,-1 0,0 0,0 1,0-1,0 0,0 0,-1 0,1 1,0-1,-1 0,1 0,0 0,-1 0,0 0,1 0,-1 0,1 0,-1 0,0 0,0 0,0 0,0 0,1 0,-1-1,0 1,0 0,-1-1,1 1,0-1,0 1,0-1,0 1,0-1,0 0,-1 1,0-1,-8 1,-1-1,1 0,0 0,-17-4,12 2,-676-61,535 57,0 8,-226 30,235-5,0 7,3 5,1 7,-222 104,351-143,-133 68,127-64,0 2,1 0,1 2,-30 28,46-41,-1 1,1 0,-1 0,1 0,0 1,0-1,0 1,1-1,-1 1,1-1,0 1,0 0,0-1,0 1,1 0,-1 0,1 0,0 0,0-1,1 1,-1 0,1 0,1 4,0-3,0 0,1 0,-1 0,1 0,0-1,1 1,-1-1,1 1,0-1,0-1,0 1,0 0,1-1,-1 0,7 3,3 2,0-2,1 0,-1-1,1 0,0-1,0-1,0 0,28 1,-22-4,0-1,1-1,-1 0,0-2,39-11,-32 5,-1-1,-1-1,0-1,0-1,-1-2,-1 0,-1-1,0-2,32-33,-35 28,-1 0,-1-1,0-1,-3 0,0-1,-1-1,11-35,-17 40,-1-2,-1 1,-1-1,-1 0,-1 0,-1 0,-2 0,0 0,-5-31,2 43,1 0,-2 0,1 1,-2-1,0 1,0 0,-1 0,-1 1,0-1,0 1,-17-18,11 16,0 1,-1 1,0 1,0 0,-1 0,0 2,-1 0,-17-7,0 4,1 0,-2 3,-47-8,-96 3,165 13,-18-1,-1 1,1 1,-58 11,79-10,1 1,0-1,0 2,0-1,0 1,0 0,-13 11,17-12,-1 1,1 0,1 0,-1 1,0-1,1 1,0 0,0 0,1 0,-1 0,1 0,0 0,-1 9,0 2,1 0,0 0,1 1,1-1,1 1,0-1,2 0,-1 0,2 0,0 0,8 18,0-3,2-1,1 0,1-1,31 42,-30-49,1 1,2-2,0-1,1 0,0-2,2 0,0-1,1-2,1 0,36 15,-57-29,0 1,1-1,-1 1,0-1,1-1,-1 1,9 0,-11-2,-1 1,1 0,-1-1,0 1,1 0,-1-1,0 0,1 1,-1-1,0 0,0 0,1 0,-1 1,0-1,0 0,0-1,0 1,0 0,-1 0,1 0,0 0,0-1,-1 1,1 0,-1-1,1 1,0-3,1-8,0 0,0 0,-1 0,-1 0,0 0,0 0,-1 0,-1 0,-4-18,0 8,-1-1,-1 1,-1 1,-13-24,4 15,-1 0,-2 2,0 0,-2 2,-1 0,-53-42,37 38,-2 1,-1 2,-1 2,-56-23,66 34,0 2,0 1,-50-9,64 17,1 1,-1 0,1 1,-1 1,1 1,-1 1,-37 9,53-10,-1 2,0-1,0 0,1 1,0 0,-1 0,1 0,0 1,1 0,-1-1,0 1,1 0,-5 8,-1 2,1 0,-12 31,11-25,2 1,-6 26,12-41,-1 0,2 0,-1 0,1 0,0 0,0 0,0 0,1 0,0 0,0 0,1 0,0 0,2 6,1-5,-1 0,1 0,0 0,1 0,-1-1,1 0,1 0,-1-1,1 0,0 0,0 0,0-1,15 6,-1-1,1-1,0-2,1 0,23 2,4-2,0-2,1-3,-1-2,0-2,95-19,-49 1,-2-5,98-41,-116 37,-2-4,-1-3,92-63,-131 76,0-1,-2-2,-1-1,-1-1,-2-2,-1-1,-1-1,29-51,-43 63,-1-1,-1 0,-2-1,0 0,-1-1,5-34,-10 43,-1 0,0 0,-1-1,-1 1,0 0,-1-1,-1 1,0 0,-1 0,-1 1,-7-19,2 14,-1 1,0 0,-1 1,-1 0,-1 0,0 2,-1 0,0 0,-2 1,1 1,-2 1,1 1,-2 0,-26-11,18 11,0 1,-1 1,0 1,0 2,-1 0,1 3,-1 0,0 1,0 2,-30 4,16 2,2 2,-1 2,1 1,0 2,1 2,1 2,0 2,2 1,0 1,1 3,2 1,-37 32,59-46,1 1,0 0,0 0,1 1,1 0,0 1,0 0,2 0,0 1,0 0,-7 29,12-34,0 0,0 1,1-1,0 1,1-1,0 1,1 0,0-1,1 1,0-1,0 0,1 0,1 0,0 0,0 0,1-1,0 1,0-1,8 9,-1-5,0 0,0-2,1 1,1-1,0-1,1-1,-1 0,2-1,-1 0,1-1,32 9,-4-5,1-1,0-2,65 3,-27-8,0-5,-1-2,0-5,0-3,82-23,-62 7,-3-5,0-3,145-78,-193 86,-1-1,-2-4,0-1,82-79,-109 91,0 0,-2-1,-1-2,-1 0,-1 0,-2-2,0 0,-2 0,0-1,-3-1,10-41,-14 44,-2-1,-1 0,0 0,-3-1,0 1,-1 0,-2 0,-1 1,-1-1,-1 1,-1 0,-2 1,-15-32,13 35,-1 0,-1 1,0 1,-2 0,0 1,-1 1,-1 0,-1 1,0 1,-1 1,-1 1,0 1,-1 1,-36-16,21 15,-1 2,-1 1,1 2,-1 2,-41-1,-10 4,-98 9,184-6,0 0,-1 1,1 0,-1 0,1 0,0 0,0 0,-1 1,1 0,0 0,-4 2,6-1,-1-1,1 0,0 1,-1-1,1 1,1 0,-1 0,0 0,1 0,-1 0,1 0,0 0,0 1,-1 5,-1 4,1 0,1 0,0 1,1-1,0 0,1 0,1 0,0 0,0 0,2 0,-1-1,2 1,-1-1,9 15,-7-17,0 0,1-1,0 1,0-1,1-1,0 0,0 0,1 0,0-1,1 0,-1-1,1 0,0-1,1 0,-1 0,17 4,-15-5,0-1,0-1,1 0,-1 0,1-1,-1-1,0 0,14-2,-22 1,1 0,-1 0,0 0,0-1,0 1,0-1,0 0,0-1,0 1,-1-1,1 1,-1-1,1 0,-1 0,0 0,0-1,-1 1,1-1,-1 0,0 1,0-1,0 0,0-1,-1 1,3-8,-1-2,-1-1,-1 1,0 0,-1-1,0 1,-1 0,-1-1,0 1,-1 0,-1 0,0 0,0 1,-11-22,-3-1,-2 1,-1 1,-42-53,-76-74,133 153,0 1,0 1,0-1,-1 1,-10-8,14 13,1-1,0 1,0 0,0 0,-1 0,1 0,0 1,-1-1,1 1,-1-1,1 1,-1 0,1 0,0 0,-1 0,1 0,-1 1,1-1,-1 1,1-1,0 1,-1 0,1 0,-4 3,-2 1,0 1,1 0,0 0,0 1,1 0,-1 0,1 0,1 1,0 0,-7 13,-3 11,-17 50,27-69,-20 60,4 1,2 1,4 1,4 0,-4 124,15-191,-1 4,1 1,1-1,1 1,3 16,-5-27,1-1,-1 0,1 0,0 0,0 0,-1 0,1 0,1 0,-1 0,0 0,0 0,1-1,-1 1,1 0,-1-1,1 1,0-1,0 0,-1 1,1-1,0 0,0 0,0 0,0-1,0 1,1 0,-1-1,0 1,0-1,0 0,1 0,-1 0,3 0,4-2,0 1,0-2,0 1,-1-1,1-1,-1 0,0 0,0 0,11-9,9-8,27-26,-52 45,27-26,-1-1,-1-1,30-42,-47 56,0 0,-2-1,0-1,0 1,-2-1,0-1,-1 1,-1-1,2-20,-6 35,0 0,-1 1,0-1,0 0,0 0,0 0,-1 0,1 0,-1 1,0-1,0 0,-1 0,1 1,-1-1,1 1,-1-1,-3-2,2 3,0-1,-1 1,1 1,-1-1,0 0,1 1,-1 0,0 0,-1 0,1 0,0 1,-1-1,1 1,-6 0,-3-1,0 1,-1 1,1 0,0 1,-1 0,1 1,0 1,0 0,0 0,0 2,1-1,-1 2,-12 7,1 0,0 2,1 0,1 2,1 0,-29 31,28-25,2 2,1 0,0 1,2 1,2 1,-14 31,19-36,2 1,0 0,2 0,0 0,2 1,1-1,1 1,1 33,2-45,0-1,2 0,-1 1,2-1,-1 0,2 0,-1-1,2 0,-1 1,2-2,-1 1,2-1,-1 0,19 18,19 15</inkml:trace>
</inkml:ink>
</file>

<file path=ppt/ink/ink1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4.482"/>
    </inkml:context>
    <inkml:brush xml:id="br0">
      <inkml:brushProperty name="width" value="0.05" units="cm"/>
      <inkml:brushProperty name="height" value="0.05" units="cm"/>
      <inkml:brushProperty name="color" value="#66CC00"/>
      <inkml:brushProperty name="ignorePressure" value="1"/>
    </inkml:brush>
  </inkml:definitions>
  <inkml:trace contextRef="#ctx0" brushRef="#br0">304 42,'0'-1,"0"-1,0 1,-1-1,1 1,-1-1,0 1,1 0,-1-1,0 1,0 0,0 0,0-1,0 1,0 0,0 0,0 0,0 0,0 0,-1 0,1 1,0-1,-1 0,1 1,-1-1,1 0,-3 1,-40-10,42 10,-6-1,-1 0,1 1,-1 0,0 0,1 1,-1 1,1-1,-1 1,1 1,0-1,0 1,0 1,0 0,0 0,1 0,0 1,0 0,0 1,0-1,1 1,0 0,0 1,-7 10,8-8,0-1,0 1,1 0,0 1,1-1,0 1,0-1,1 1,1 0,-2 16,2-15,1 0,1 1,-1-1,2 0,-1 0,2 0,-1 0,1-1,7 15,-7-18,1-1,1 0,-1 1,1-1,0-1,1 1,-1-1,1 0,0 0,0-1,12 7,-14-8,0-1,1 0,-1 0,0 0,1-1,-1 0,1 0,0 0,-1 0,1-1,0 1,-1-1,1-1,0 1,0 0,-1-1,1 0,-1 0,9-4,1-3</inkml:trace>
</inkml:ink>
</file>

<file path=ppt/ink/ink1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8.139"/>
    </inkml:context>
    <inkml:brush xml:id="br0">
      <inkml:brushProperty name="width" value="0.05" units="cm"/>
      <inkml:brushProperty name="height" value="0.05" units="cm"/>
      <inkml:brushProperty name="color" value="#66CC00"/>
      <inkml:brushProperty name="ignorePressure" value="1"/>
    </inkml:brush>
  </inkml:definitions>
  <inkml:trace contextRef="#ctx0" brushRef="#br0">1321 261,'-23'-3,"21"2,-1 0,1 1,0-1,0 1,-1 0,1-1,0 1,0 0,-1 0,1 1,0-1,0 0,-1 1,-3 1,3 0,0 0,0-1,0 2,0-1,0 0,1 1,-1-1,1 1,-1 0,1 0,0 0,0 0,0 0,1 0,-1 0,1 1,0-1,0 1,0-1,-1 7,0 3,0 0,2 0,-1 0,3 20,-1-24,1 0,0 0,1-1,0 1,0 0,1-1,0 0,1 0,-1 0,2 0,7 8,-5-6,1 0,1 0,0-1,0-1,1 0,0 0,14 7,-19-12,1 0,0 0,0-1,0 1,0-2,1 1,-1-1,0 0,1-1,-1 1,0-2,1 1,8-2,-5 0,-1-1,0 0,-1-1,1 0,-1 0,1-1,-1 0,15-12,-12 7,1-1,-2 0,0-1,0 0,-1-1,0 0,-1-1,-1 0,0 0,-1-1,0 0,4-18,-8 22,0 0,-1-1,-1 1,1-1,-2 1,0-1,0 1,-1-1,-1 1,-5-22,4 23,-1 1,1 0,-2 0,1 0,-2 0,1 1,-1 0,0 0,0 1,-1-1,0 1,-1 1,-8-7,1 4,-1-1,0 2,0 0,-1 1,0 1,-1 0,1 2,-1 0,0 0,0 2,0 0,-1 1,1 1,-35 5,48-4,1 0,-1 0,0 0,1 1,-1-1,1 1,-1 0,1 1,0-1,0 1,0 0,0 0,1 0,-1 0,1 1,0 0,0-1,0 1,0 0,1 0,-1 1,1-1,0 0,0 1,-1 6,0 3,-1 0,2 0,0 1,1-1,0 1,2-1,1 18,-1-26,0-1,0 0,0 0,1 0,-1 0,1-1,1 1,-1 0,1-1,-1 1,1-1,1 0,-1 0,0 0,1-1,0 1,0-1,0 1,0-2,1 1,-1 0,1-1,0 0,7 3,-8-3,0-1,1 0,-1-1,0 1,0-1,0 1,0-1,1-1,-1 1,0 0,0-1,0 0,0 0,0 0,0-1,0 1,0-1,0 0,-1 0,1 0,-1-1,1 1,-1-1,0 0,0 0,0 0,0 0,-1 0,1-1,2-5,-1 1,-1 1,0-1,0 0,-1 0,0-1,0 1,-1 0,0-1,0 1,-1-1,-1 1,1-1,-1 1,0-1,-1 1,0 0,-1 0,1 0,-1 0,-1 0,0 0,0 1,0 0,-1 0,0 0,0 0,-10-8,7 8,0 0,0 1,-1 0,1 1,-1 0,-1 0,1 1,-1 0,0 1,0 0,0 0,0 1,0 0,0 1,-1 1,1-1,0 1,-1 1,1 0,-20 5,27-5,0 0,0 0,0 1,0 0,0-1,1 1,-1 0,1 0,0 0,-1 1,1-1,0 1,0-1,0 1,1-1,-1 1,1 0,-1 0,1 0,0 0,0 0,0 0,0 0,1 0,0 1,-1-1,1 6,0 1,1 0,-1-1,2 1,-1-1,1 1,1-1,0 1,5 11,-1-9,0 0,0 0,1-1,1 0,0-1,0 0,1 0,0-1,1-1,0 1,0-2,1 1,0-2,16 7,-16-7,0-2,0 0,0 0,1-1,-1-1,1 0,0 0,0-2,0 1,-1-2,1 0,0 0,0-1,-1-1,19-5,-26 6,-1 0,1 0,0-1,-1 1,0-1,1 0,-1-1,0 1,-1-1,1 1,-1-1,1 0,-1 0,0-1,-1 1,1-1,-1 1,0-1,0 0,0 0,-1 0,3-10,-4 9,1-1,-1 0,0 1,-1-1,1 0,-1 1,0-1,-1 1,0-1,0 1,0 0,-1 0,0 0,0 0,-1 0,1 1,-8-9,-2-1,-1 2,-1 0,1 1,-2 1,0 0,0 1,-30-14,32 18,0 0,-1 1,1 1,-1 0,0 1,0 0,0 2,-1-1,1 2,-20 1,31 0,0 0,0 0,1 0,-1 0,0 0,1 1,-1 0,1 0,0 0,-1 0,1 0,0 0,0 1,1 0,-1-1,0 1,1 0,0 0,-1 1,1-1,1 0,-1 1,0-1,1 1,0 0,-1-1,0 7,-1 9,0 0,2 0,0 0,1 25,1-26,-1-5,0-1,2 0,-1 0,1 0,1 0,4 12,-6-20,1-1,-1 1,1-1,0 0,0 1,0-1,0 0,1 0,-1-1,1 1,0 0,0-1,0 1,0-1,0 0,0 0,1 0,-1-1,1 1,-1-1,1 0,0 0,5 1,-5-1,0-1,0 1,0-1,0 0,0 0,0 0,0-1,0 1,0-1,-1 0,1 0,0 0,6-3,-8 2,0 1,0-1,0 0,0 0,0 0,-1 0,1 0,-1-1,1 1,-1 0,0-1,1 1,-1-1,-1 1,1-1,0 0,-1 1,1-1,-1 0,0 1,0-4,0-3,0 1,-1 0,-1-1,0 1,0 0,0 0,-1 0,0 0,0 1,-1-1,0 1,-9-12,5 8,0 1,0 0,-1 0,0 1,-1 0,0 1,-18-12,24 18,1 0,-1 0,0 0,0 0,0 1,0-1,0 1,0 0,0 1,0-1,-1 1,1-1,0 1,0 0,-1 1,1-1,0 1,0 0,0 0,0 0,0 1,-5 1,3 1,-1 0,1 1,1 0,-1 0,0 0,1 0,0 1,1 0,-1 0,1 1,-6 11,1 0,1 0,1 1,1 0,-6 28,9-34,1 1,0 0,1-1,1 1,0 0,1 0,4 17,-4-25,0-1,1 0,0 0,0 0,0-1,1 1,-1 0,1-1,0 0,0 0,1 0,0 0,-1 0,1 0,0-1,1 0,-1 0,0 0,1 0,0-1,0 0,0 0,-1 0,2-1,-1 1,0-1,7 0,4 1,-1-1,1-1,-1 0,1-2,-1 1,1-2,-1 0,18-7,-28 9,-1-1,1 0,-1 0,0 0,0 0,0-1,0 1,0-1,-1 0,1-1,-1 1,0 0,0-1,0 0,0 0,-1 0,0 0,1 0,-1 0,-1-1,1 1,-1-1,1 1,-1-1,-1 1,1-1,-1 0,0-6,0 2,0 0,-1 0,-1-1,0 1,0 0,-1 0,1 1,-2-1,0 0,0 1,0 0,-1 0,-9-12,-1 4,-1 0,-1 1,0 0,-1 1,0 1,-1 1,0 1,-1 1,-1 0,0 1,0 2,0 0,-1 1,0 1,0 1,0 1,-1 1,1 1,0 1,-1 1,-41 7,55-5,-1 0,0 0,1 1,0 1,0-1,0 2,1-1,-1 1,1 0,1 1,-1 0,1 0,0 1,1-1,0 2,0-1,1 0,-7 14,4-5,1 0,1 1,0 0,1 0,1 0,1 0,1 1,0-1,1 24,2-29,0 1,1-1,1 0,0 0,0 0,2-1,-1 1,1-1,1 0,1-1,-1 1,2-1,-1 0,2-1,-1 0,15 13,-11-13,0 0,1 0,0-2,1 0,-1 0,2-1,-1-1,1 0,0-1,0-1,0 0,0-1,25 2,-29-4,0-1,0 0,0-1,0 0,0-1,0 0,-1 0,1-1,18-8,-22 7,1 0,-1-1,0 0,0 0,-1-1,0 0,0 0,0 0,0-1,-1 1,0-1,-1-1,6-9,-5 7,-1-1,0 1,0-1,-1 0,0 0,-1 0,0 0,-1 0,0-1,-1 1,-1 0,1-1,-2 1,1 0,-1 0,-1 0,-4-12,0 7,-1 0,0 0,-1 1,0 0,-1 0,-1 1,0 1,-1 0,-1 0,-19-14,8 9,0 2,-2 1,0 1,0 1,-2 1,1 1,-1 2,-1 1,0 1,0 1,0 2,0 1,-1 1,-45 3,55 1,1 0,0 2,0 0,0 1,0 0,1 2,0 0,0 2,1-1,-22 16,18-9,1 2,0 0,2 0,0 2,0 1,2 0,-16 25,11-8,0 0,3 2,1 0,2 1,2 0,1 1,2 0,2 1,-3 56,10-80,1 0,1-1,0 1,2 0,0 0,1-1,0 1,2-1,0 0,0-1,2 0,11 18,-5-12,1-1,1 0,1-2,1 0,1 0,1-2,36 25,-13-14,1-2,0-3,2-1,1-2,1-3,0-1,97 17,-96-25,0-3,0-2,0-2,0-2,1-2,-1-2,-1-3,58-16,-78 16,-1-2,0-1,0-1,-1-1,-1-2,0 0,-1-2,-1 0,0-2,39-41,-51 46,0 1,-2-2,1 1,-2-1,0 0,-1-1,0 0,7-26,-11 28,-1-1,0 1,0-1,-2 0,0 1,0-1,-2 0,0 1,0-1,-9-27,2 18,-1 1,-1 0,-1 1,-1 0,0 1,-2 0,0 2,-2-1,0 2,-1 0,-1 1,0 1,-26-16,24 19,-1 0,0 1,0 1,-1 1,-1 1,0 1,0 2,0 0,-1 1,0 2,0 0,0 2,-32 2,51-1,1 1,0 0,0 0,0 1,0 0,0 0,0 0,0 0,1 1,-1 0,1 0,-1 0,1 0,0 1,1-1,-1 1,1 0,-1 0,1 1,0-1,1 0,-1 1,1 0,0 0,0 0,-2 5,-1 12,0 0,0 0,2 0,0 41,2-55,1 1,1-1,-1 1,1-1,1 1,-1-1,2 1,-1-1,6 13,-6-17,1-1,-1 1,1-1,-1 1,1-1,0 0,0 0,1 0,-1 0,1-1,-1 1,1-1,0 0,0 0,0 0,0-1,0 1,0-1,0 0,7 1,1 0,0-1,-1 0,1-1,0-1,0 1,0-2,-1 0,1 0,-1-1,1 0,-1-1,0 0,0-1,-1 0,1-1,-1 0,13-11,-11 6,0 0,-1-1,0 0,0-1,-2 0,1-1,-2 1,0-2,0 1,-2-1,10-31,-10 25,-1 0,-1-1,-1 1,-1-1,-1 0,-1 0,-1 1,-1-1,0 0,-2 1,-1 0,0 0,-1 0,-2 0,0 1,-1 0,-1 1,-1 0,-22-30,31 47,1 0,-1 0,0 0,0 0,0 0,0 0,-1 0,1 1,0-1,-1 1,-3-2,5 3,0 0,0 0,0 0,0 0,0 0,-1 0,1 0,0 0,0 1,0-1,0 0,0 1,0-1,0 1,0-1,0 1,0-1,0 1,0-1,1 1,-1 0,0 0,0 0,1-1,-1 1,0 0,1 0,-1 0,1 0,-1 2,-6 9</inkml:trace>
</inkml:ink>
</file>

<file path=ppt/ink/ink1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1:55.243"/>
    </inkml:context>
    <inkml:brush xml:id="br0">
      <inkml:brushProperty name="width" value="0.35" units="cm"/>
      <inkml:brushProperty name="height" value="0.35" units="cm"/>
      <inkml:brushProperty name="color" value="#33CC33"/>
      <inkml:brushProperty name="ignorePressure" value="1"/>
    </inkml:brush>
  </inkml:definitions>
  <inkml:trace contextRef="#ctx0" brushRef="#br0">3927 2864,'22'0,"30"5,6 2,95 2,75-1,348-3,1-43,-311 0,-215 27,-1-2,-1-2,51-23,-82 29,0 0,0-1,-1 0,0-1,19-17,-31 23,1-1,-1 1,1-1,-1 0,-1 0,1 0,-1-1,0 0,-1 0,0 0,0 0,0 0,-1 0,0-1,0 0,0-7,-2 9,-1 1,1-1,-1 1,0-1,-1 0,1 1,-1 0,0-1,0 1,-1 0,1 0,-1 0,-1 1,1-1,0 1,-1-1,0 1,0 1,0-1,-8-5,-4-2,0 1,0 0,-1 1,0 1,-19-6,-21-4,-2 1,1 4,-64-7,-181-2,-20 23,277 3,1 2,-1 1,1 3,0 1,-44 19,66-20,1 1,0 1,0 2,1 0,1 1,0 1,1 0,1 2,1 0,0 1,1 1,-16 28,15-20,1 1,2 0,1 1,2 1,0 0,2 0,2 1,-7 64,8-4,5-1,10 94,-9-182,0 1,0-1,0 1,1-1,0 1,0-1,0 0,0 0,0 1,1-1,-1 0,1 0,4 5,-6-8,0 0,0 1,0-1,1 0,-1 0,0 0,0 0,1 0,-1 0,0 1,0-1,1 0,-1 0,0 0,0 0,1 0,-1 0,0 0,0 0,1 0,-1 0,0 0,0 0,1-1,-1 1,0 0,0 0,1 0,-1 0,0 0,0 0,1-1,-1 1,0 0,6-11,0-15,-4 13,-1 0,0 0,-1 0,0 0,-1 0,-1 0,0 0,-1 1,0-1,-1 1,0-1,-8-13,4 11,-1 0,-1 1,0 0,0 1,-2 0,0 0,0 1,-26-19,22 21,0 0,-1 0,0 2,0 0,-1 1,0 0,0 2,-27-5,4 4,0 1,-76 3,98 3,0 0,0 2,1 0,-1 1,1 1,0 0,0 2,0 0,1 1,-19 12,22-12,2 1,0 1,0 0,0 1,1 0,1 0,0 1,1 1,0 0,1 0,0 0,-11 27,15-29,1 0,-1 1,2-1,0 0,0 1,1 0,0-1,1 1,0 0,1-1,0 1,1-1,5 18,-3-17,1 0,0 0,1-1,0 1,1-2,0 1,1-1,0 0,1 0,0-1,0 0,14 9,-5-5,2-1,-1-1,1-1,1-1,0-1,0-1,0-1,1 0,0-2,25 2,0-1,1-3,0-3,79-9,-68 1,-1-2,67-22,-96 23,0-1,0-1,-1-2,0-1,49-35,-72 46,1-1,-1 0,0 0,0-1,0 0,-1 1,1-2,-1 1,-1 0,1-1,-1 1,3-11,-5 13,0 0,-1-1,1 1,-1-1,0 1,0 0,0-1,0 1,-1-1,0 1,0 0,0 0,0-1,-1 1,0 0,0 0,0 0,0 1,0-1,-1 0,-4-4,-4-3,0 1,-1-1,0 2,-1 0,0 1,0 0,-25-10,4 4,-1 1,-40-8,12 7,0 3,-115-6,128 16,0 3,1 1,0 3,-59 14,90-15,2 0,-1 1,1 1,-1 0,2 1,-1 1,1 0,1 1,-14 13,21-18,2 1,-1 0,0 0,1 0,0 1,1-1,0 1,0 1,0-1,1 0,0 1,0 0,1-1,0 1,0 0,1 0,0 0,0 1,1-1,0 0,2 14,1-8,1-1,0 0,1 1,1-2,0 1,0-1,2 0,-1 0,16 18,3 0,2-1,37 30,-16-19,2-3,2-1,1-3,1-3,2-1,0-4,2-1,1-4,1-2,93 15,-128-29,1-1,-1-2,1 0,-1-2,39-6,-52 4,0 0,0 0,-1-1,1-1,-1 0,0-1,0 0,-1-1,0 0,0-1,0 0,16-17,-11 5,0 0,-1 0,-1-2,-2 0,0 0,-1-1,-1-1,7-25,-7 17,-2-1,-1-1,-2 1,-1-1,-1-52,-4 68,-1 0,0 0,-2 0,0 1,0-1,-2 1,0 0,-1 0,-1 1,0 0,-1 0,-1 1,0 0,-1 1,-1 0,0 1,-1 0,-1 1,1 1,-2 0,0 0,0 2,-1 0,0 0,-26-8,16 7,-1 2,-1 1,1 2,-1 0,0 2,-1 0,1 3,0 0,-1 2,1 0,-31 9,42-7,0 1,0 1,1 0,-1 1,2 1,-1 1,1 0,-17 14,21-13,0 0,0 1,1 0,1 0,0 1,0 1,1-1,1 1,0 1,-8 22,7-12,1 0,2 1,0-1,1 1,2 0,0 0,2 0,1 0,1 0,1 0,1 0,1-1,14 43,-11-47,1 1,0-1,2 0,0-1,1 0,1-1,1-1,1 0,0 0,1-2,0 0,2-1,-1 0,2-2,36 20,-21-17,1-1,-1-2,2-1,0-2,69 8,-59-13,1-2,0-3,-1-1,58-11,-38 0,-1-3,0-4,-1-2,-1-2,-1-4,97-59,-90 42,-2-2,-2-4,-2-2,-3-3,61-73,-73 71,-3-3,-2-1,-3-1,-3-3,50-122,-74 153,-1 0,-2 0,-2-1,-1 0,-1 0,0-58,-6 76,-1-1,-1 1,0-1,-2 1,0 0,-1 0,0 1,-2-1,0 1,-1 1,-1-1,0 1,-1 1,-24-29,15 25,0 1,-2 1,0 1,-1 0,0 2,-2 0,1 2,-37-14,-5 3,-1 3,-75-13,22 11,0 4,-1 6,-212 5,185 22,125-11,0 1,0 1,0 1,-27 12,43-16,0 0,1 0,-1 1,1-1,-1 1,1 1,0-1,1 1,-1-1,1 1,0 1,0-1,0 1,1-1,0 1,0 0,0 0,1 0,0 1,0-1,1 0,0 1,0 0,0-1,1 1,0-1,1 8,0 6,0-1,2 1,1-1,0 0,1-1,1 1,10 21,-4-15,2 0,0-1,2-1,26 31,-4-12,3-3,1-1,1-2,69 43,-51-41,109 52,-127-72,1-1,1-2,73 14,-104-27,-1 0,1 0,-1-2,1 1,-1-2,1 0,-1-1,19-4,-24 4,0-1,-1 0,1-1,-1 1,0-2,0 1,0-1,-1 0,1 0,-1 0,0-1,-1 0,0-1,9-12,-3 1,-2 0,0-1,-1 0,-1 0,0-1,-2 1,0-2,-2 1,0 0,-1-1,-1 1,-1-1,0 1,-2-1,-5-26,-1 11,-1 1,-2 0,-1 1,-1 1,-2 0,-2 0,-37-54,27 49,-2 1,-1 2,-2 1,-1 1,-55-41,79 68,1 0,-1 1,-1-1,1 2,0-1,-16-3,22 7,0 0,-1 0,1 1,-1-1,1 1,-1 0,1 0,-1 1,1-1,-1 1,1-1,0 1,-1 0,1 0,0 1,-1-1,1 1,0-1,0 1,0 0,1 0,-6 5,1 1,0 0,0 1,0 0,1 0,1 0,-1 1,-3 12,-4 10,-7 35,0 19,3 2,4 0,4 1,4 0,13 174,-2-201,24 100,-22-133,1 0,1 0,1-1,2-1,22 37,-30-57,-1-1,1 1,1-1,-1-1,1 1,0-1,1 0,11 7,-17-11,1 0,0 0,0 0,0 0,0 0,0 0,0-1,0 1,0-1,0 0,0 1,0-1,0 0,0 0,0 0,0-1,0 1,0 0,0-1,0 1,0-1,0 0,0 0,0 0,-1 0,1 0,0 0,-1 0,1 0,0-1,-1 1,1-1,-1 1,0-1,0 1,0-1,1 0,0-2,-1 1,1 1,0-1,-1 0,0-1,1 1,-1 0,0 0,-1 0,1-1,-1 1,1 0,-1-1,0 1,0 0,-1-1,1 1,-1 0,1-1,-1 1,0 0,0 0,0-1,-1 1,1 0,-1 1,0-1,0 0,0 0,0 1,0-1,-1 1,1-1,-5-2,-1-1,-1 0,1 1,-1 0,0 1,0 0,-1 0,1 1,-1 0,0 1,-13-2,3 3,1 1,0 0,0 1,0 2,0 0,1 0,-1 2,1 0,0 2,0 0,1 0,0 2,0 0,-19 14,23-13,0 0,0 0,0 1,2 1,-1 0,2 0,-1 1,2 1,0-1,0 2,1-1,1 1,1 0,0 1,1 0,-6 28,10-34,1 0,0 0,0-1,1 1,1 0,-1 0,2 0,-1-1,1 1,1-1,0 0,0 0,0 0,1-1,1 1,-1-1,2 0,10 11,-5-7,1 0,0-1,1 0,1-1,-1 0,1-2,1 1,-1-2,31 10,-39-15,-1-1,1 1,0-1,-1-1,1 0,0 1,-1-2,1 1,0-1,-1 0,1-1,7-2,-4 0,0 0,0-1,-1 0,1 0,-1-1,16-14,-7 3,-1-1,-1-1,-1 0,0-1,-2 0,12-23,-10 13,-1 0,-2-1,-1 0,-2-1,11-59,-17 66,-1 1,-1-1,0 0,-2 0,-1 0,-1 1,-2-1,-9-33,9 45,0-1,-1 1,-1 0,0 1,-1-1,0 1,-14-15,15 20,0-1,-1 1,0 0,0 1,0 0,-1 0,0 0,0 1,-1 1,-18-7,22 10,0 0,0 1,0-1,0 1,0 1,0-1,0 1,0 0,1 0,-1 1,0-1,1 1,-1 1,1-1,-1 1,1 0,0 0,-6 5,-5 4,1 1,0 1,0 0,-13 18,6-3,0 1,2 1,1 1,2 1,1 0,2 1,-16 55,18-43,2 0,2 1,2 0,3 0,2 71,1-110,1 1,0-1,0 1,1-1,0 0,1 0,0 1,4 8,-5-13,0-1,0 0,1 0,-1 0,1 0,-1 0,1-1,0 1,0-1,0 0,1 1,-1-1,0-1,1 1,-1 0,1-1,0 0,-1 0,1 0,6 0,-1 0,1-1,-1 0,0 0,1-1,-1-1,1 0,-1 0,0-1,0 0,0 0,13-8,9-6,50-38,-15 4,-2-3,-3-3,-2-2,-3-3,84-120,-117 149,-2-1,-1 0,-2-2,-1 0,17-55,-30 76,0-1,-2 0,1 0,-2 0,0 0,-1 1,-2-18,0 21,0 1,-1 0,0 0,-1 0,0 1,0-1,-1 1,-1 0,0 0,-13-17,3 10,-1 0,-1 1,0 0,-1 2,0 0,-1 1,0 2,-1 0,-1 0,-25-7,0 3,-1 1,0 3,-97-10,73 17,-1 3,-136 15,-142 52,220-32,-207 81,274-88,1 3,2 3,1 2,1 3,-57 49,97-71,1 1,0 1,1 1,1 1,1 0,-19 31,28-38,0 0,0-1,2 2,-1-1,2 0,-1 1,2 0,0 0,1 0,0 0,1 0,0 0,4 15,0-10,0 0,2-1,0 0,1 0,1-1,1 0,0 0,1-1,1 0,1-1,0 0,1-1,0 0,21 16,5 1,0-3,2-1,2-2,63 27,-37-22,0-3,2-3,118 24,-144-40,-1-2,1-2,0-2,0-2,0-2,0-2,56-12,-82 12,1-2,-1 0,0-2,-1 0,0 0,0-2,-1 0,0-2,-1 1,-1-2,1 0,17-20,-25 23,0 0,0-1,-1 0,-1 0,0-1,0 1,-1-1,-1-1,0 1,0 0,-1-1,-1 0,0 0,-1 0,0 0,-1 0,0 0,-1 0,-1 0,-3-13,-1 7,0 0,-1 1,-1-1,-1 1,0 1,-2 0,0 0,-1 1,0 0,-1 1,-1 1,-21-18,4 7,-1 1,-1 2,-1 1,0 1,-53-20,34 20,0 2,-62-12,15 11,-2 5,-171-2,-211 45,280-1,-234 64,273-45,-284 120,218-54,194-91,0 1,2 2,-57 53,81-67,0 0,1 1,0 1,1-1,0 1,1 1,1 0,0 0,0 0,-6 26,10-29,1 0,1 0,0 1,0-1,1 0,0 1,1-1,0 1,1-1,1 0,0 0,0 0,1 0,0-1,7 13,-2-8,1 0,1 0,0-1,1 0,0-1,1 0,1-1,0-1,25 16,0-3,2-2,74 28,-33-21,1-4,1-3,1-4,1-4,0-3,1-5,-1-3,95-9,-130 1,0-1,0-3,0-3,-2-1,1-3,-2-2,86-44,-108 48,-1-2,-1-1,0 0,-2-2,0-1,-1 0,0-2,-2 0,-1-2,-1 0,-1 0,-1-2,-1 0,-1 0,9-30,-15 35,-1 0,-1 0,-1 0,-1-1,-1 1,-1-1,-1 0,0 1,-2-1,-1 0,0 1,-9-27,7 31,-2 1,0 0,0 0,-2 1,0 0,0 0,-2 1,0 1,0-1,-1 2,-1 0,0 0,0 1,-1 1,-31-17,7 8,-1 2,-1 2,0 2,0 1,-76-11,13 10,-129 2,77 13,1 7,0 7,-177 41,87 9,204-51,1 1,1 2,-66 42,91-51,0 0,1 1,0 1,1 0,0 0,0 1,1 0,-8 15,14-21,1 0,0 0,0 0,1 0,-1 1,1-1,1 1,-1-1,1 1,1 0,-1-1,1 1,0 0,0 0,1-1,0 1,0-1,1 1,0 0,0-1,4 9,-1-6,0-1,0 1,1-1,0-1,0 1,1-1,10 9,7 3,32 20,-7-10,55 26,116 33,-48-33,2-9,2-6,1-9,351 16,-421-45,211-25,-272 16,0-2,0-2,-1-2,0-2,-1-2,78-43,-102 48,-2-1,0-1,-1 0,0-1,-1-1,-1-1,0 0,-1-1,-1 0,15-31,-20 35,-1-1,-1 0,0-1,-1 1,-1-1,-1 0,0-1,-1 1,0 0,-2-1,0 1,0 0,-2-1,0 1,-4-16,3 21,-1 0,0 1,0-1,-1 1,0 0,-1 1,0-1,-1 1,0 0,0 1,-9-9,5 8,-1-1,0 2,-1 0,1 0,-2 1,1 0,-22-6,2 4,1 1,-1 2,0 1,-1 1,1 2,-60 5,30 3,1 3,0 2,1 4,0 2,1 2,1 3,1 3,2 2,0 3,2 2,-89 70,116-80,2 1,0 2,2 1,-33 45,46-57,2 1,-1-1,2 1,0 1,1-1,1 1,0 0,1 0,1 1,0-1,0 26,4-20,1 0,1 0,1-1,0 0,2 0,1 0,0 0,2-1,0 0,1-1,1 0,1-1,0 0,2-1,0 0,22 20,2-5,1-1,1-3,2-1,50 24,-5-10,107 35,-151-60,-1-3,2-1,0-3,0-1,55 2,-92-9,1-1,-1 0,0-1,1 0,-1 0,0 0,0-1,0 0,0-1,0 0,8-4,-11 4,0 0,0 0,-1 0,1 0,-1-1,0 0,0 1,0-1,0-1,-1 1,1 0,-1-1,0 1,0-1,-1 1,0-1,2-7,-1-1,0 0,-1 0,-1 0,0 0,0 0,-1 0,-1 0,-5-20,1 15,0 0,-1 1,0 0,-2 0,-14-22,2 10,-2 0,-1 1,-1 2,-1 0,-50-37,18 23,-2 2,-1 3,-1 3,-2 2,-1 4,-96-27,57 27,-1 4,0 5,-168-6,171 21,0 4,-140 23,187-16,0 2,1 3,1 3,1 1,0 3,-50 28,87-40,-1 1,1 0,1 0,0 2,1 0,0 0,-20 26,28-31,0 1,0 0,1 0,0 1,0-1,0 1,2 0,-1 0,1 0,0 0,1 0,0 1,0-1,1 0,0 1,3 14,-1-11,1 0,0 0,1 0,0-1,1 1,0-1,1 0,1 0,0-1,0 0,1 0,1-1,0 1,0-2,1 0,0 0,0-1,1 0,0 0,1-1,15 7,18 4,0-2,1-2,1-2,0-2,94 7,-131-16,-1-1,1 0,-1-1,1 0,-1 0,1-1,-1 0,0-1,0 0,13-6,-13 3,-1 1,1-2,-1 1,0-1,-1 0,1 0,-1-1,-1 0,9-13,1-4,-1-1,-2 0,0-1,-2 0,0-1,-2 0,-2-1,0 0,-2 0,-1 0,0-36,-4 42,-1-1,-1 1,-1 0,-1 0,-1 0,0 0,-2 1,-1 0,-1 0,-1 1,-1 0,0 1,-2 0,-28-35,17 30,-2 1,0 1,-2 2,0 0,-1 2,-1 1,-1 2,-1 0,-36-11,-3 3,-1 3,-1 3,-89-10,-105 5,231 22,0 3,0 0,0 3,0 0,-46 15,76-18,1 0,0 0,0 0,-1 0,1 1,1 0,-1 0,0 1,1-1,0 1,-1 0,2 0,-7 9,7-9,1 0,0 0,0 0,1 1,-1-1,1 1,0-1,0 1,1 0,-1-1,1 1,0 0,0-1,1 1,-1 0,1-1,2 6,2 8,1 1,1-1,1-1,0 0,2 0,0 0,0-1,18 19,-2-5,2-2,0-1,40 29,-16-20,1-2,1-2,2-2,1-4,1-1,67 18,-47-22,0-3,2-3,0-4,110 2,-137-13,1-3,0-1,-1-3,0-3,-1-1,0-3,0-3,65-30,-84 31,-1-1,-1-2,-1-2,0 0,39-40,-48 41,-2-2,0 0,-2-1,0-1,-2-1,-1 0,18-42,-26 50,1-1,-2 0,-1 0,0 0,-1-1,-1 1,-1-1,0 0,-4-32,1 40,0-1,0 1,-2-1,1 1,-1 0,-1 1,0-1,-1 1,0 0,0 0,-1 0,0 1,-1 0,0 1,0 0,-16-13,6 9,-1 1,0 0,-1 2,1 0,-2 1,-35-9,1 5,-81-8,45 13,-1 4,1 3,-1 5,1 4,0 4,1 3,1 5,0 3,2 5,1 3,-111 58,150-64,1 1,-78 63,106-75,0 1,1 1,1 1,1 0,1 0,0 2,1 0,-19 41,29-54,1 0,0-1,0 2,0-1,0 0,1 0,1 0,-1 1,1-1,0 0,1 1,0-1,2 11,0-11,-1 0,2 0,-1 0,1 0,0-1,0 1,0-1,1 0,0-1,1 1,-1-1,1 0,7 5,7 3,0-1,1-1,1 0,0-2,0-1,1 0,24 4,28 5,1-4,1-3,-1-3,134-5,-108-9,0-4,-2-4,111-33,-140 28,130-56,-173 63,-1-1,0-2,-1 0,-1-2,0-1,-2 0,25-27,-41 38,-1 0,1 0,-1-1,-1 1,0-1,0-1,0 1,-2-1,1 0,-1 0,2-10,-4 12,0 0,-1 1,0-1,0 1,-1-1,0 1,0-1,-1 1,0-1,0 1,0 0,-1 0,0 0,-1 0,-6-9,0 3,-1 1,0 0,0 0,-1 1,-1 1,0 0,0 1,-1 0,0 1,0 1,-1 0,-16-5,-18-4,-1 2,-78-13,25 13,0 3,-109 4,130 9,0 4,1 3,-90 23,140-25,1 2,1 0,0 2,0 2,-27 15,47-22,-1 1,1 0,0 0,0 1,1 0,0 0,-8 12,11-13,1 0,0 0,1 0,-1 0,1 1,1-1,0 1,0 0,0-1,1 1,-1 13,3-5,0 0,1 0,1 0,0 0,1-1,1 1,0-1,1 0,1-1,0 1,18 25,1-4,2-1,1-1,36 33,-7-14,2-4,2-1,2-4,2-3,1-2,2-3,2-4,1-2,2-4,109 24,-148-43,0-1,1-2,-1-2,1-1,-1-2,68-10,-80 6,0-1,0-1,0 0,-1-2,-1-1,1-1,-2 0,1-2,-2 0,0-1,22-22,-12 8,-2-2,-1-1,-1-1,-2-1,-1-1,18-41,-26 46,-2 0,-1-1,-1 0,-1 0,-2-1,-1-1,-2 1,1-43,-5 63,0-1,-1 1,0 0,-1 0,0 0,-5-12,6 19,-1 0,0 0,0 0,-1 0,1 0,-1 0,0 0,0 1,0 0,0-1,-1 1,1 0,-1 1,0-1,1 1,-1-1,-6-1,1 0,-1 1,0 1,1-1,-1 2,0-1,0 1,0 1,0 0,0 0,0 1,0 0,0 1,1 0,-1 1,0 0,1 0,0 1,0 0,-11 7,7-3,1 0,0 0,0 2,1-1,0 1,1 1,0 0,0 1,2-1,-1 2,1-1,-9 22,10-18,1 1,0 0,2 0,0 1,0-1,0 20,4-27,0 0,0 0,1 0,0 0,1-1,0 1,0 0,1-1,0 1,1-1,0 0,1 0,5 8,2-1,1 0,1-1,0-1,1 0,0-1,1 0,0-1,28 14,2-2,0-2,61 18,-31-15,2-3,0-3,149 14,-179-29,0-3,0-1,0-3,0-2,0-2,-1-2,81-27,-111 30,0-1,-1-1,1-1,-2-1,1 0,-1 0,23-23,-34 28,1 0,-1 0,0 0,0-1,0 0,-1 0,0 0,0 0,-1 0,4-11,-6 12,1 0,-1 0,1 0,-1 0,-1 0,1 0,-1 0,0 0,0 1,0-1,-1 0,1 0,-1 1,0-1,-1 1,-3-5,-1-2,-2 1,1 0,-1 0,-1 1,0 1,0-1,0 2,-1-1,-1 2,1-1,-25-9,12 7,0 2,-1 0,0 1,0 1,-30-1,27 4,0 2,0 0,0 2,0 1,0 2,1 0,-1 2,1 1,1 1,0 1,-35 20,54-26,0 0,1 1,0 0,0 0,0 0,1 1,0 0,0 0,0 0,1 0,0 1,-5 10,5-7,0 1,1 0,0 0,1 0,0 0,1 0,-1 22,3-12,1 0,1 0,1 0,1-1,0 1,2-1,0-1,19 36,-10-27,2-1,1 0,1-2,1 0,1-1,1-1,52 39,-52-46,0-1,1-1,1-1,1-1,-1-1,2-1,-1-2,1 0,46 5,-63-12,-1 0,1 0,-1-2,1 1,0-1,-1 0,1-1,-1 0,0-1,16-6,-18 5,-1 1,1-1,-1 0,0-1,-1 1,1-1,-1 0,0-1,0 1,-1-1,1 0,-1 0,-1 0,7-13,-4 2,-1 0,0 1,-1-2,-1 1,-1 0,0-1,-1 1,-1-1,-1 1,0 0,-2-1,0 1,0 0,-10-26,4 19,0 0,-2 1,0 0,-2 0,0 1,-2 1,0 1,-2 0,-23-23,16 21,-44-31,57 46,-1-1,0 2,0-1,0 2,-1-1,-19-4,28 10,-1-1,1 1,0-1,0 1,0 1,0-1,0 1,0-1,0 1,0 0,0 0,0 1,0-1,0 1,1 0,-1 0,-3 3,4-3,1 0,0 0,0 0,0 0,0 0,0 0,1 0,-1 0,1 1,-1-1,1 1,0-1,0 1,0-1,0 1,1 0,-1-1,1 1,-1 0,1 0,0 0,0-1,0 1,1 0,-1 0,1 3,1-3,-1 0,1 0,-1 0,1 0,0 0,0-1,0 1,0-1,1 1,-1-1,1 0,0 0,-1 0,1 0,0 0,0-1,0 1,0-1,0 0,1 0,3 1,5 1,0-1,0 0,0 0,22-1,-18-2,0-1,1-1,-1 0,-1-1,1-1,-1 0,1-2,-2 1,1-2,-1 0,0 0,0-1,-1-1,-1-1,1 1,11-16,0-1,-1-1,-1-1,-2-1,-1-1,-2-1,18-43,-17 29,-1-2,-3 0,-2 0,-2-1,-2-1,-2 1,-3-1,-1 0,-3-1,-2 1,-2 1,-2-1,-3 1,-27-82,31 113,-1 0,-1 0,-1 1,0 1,-1-1,-14-16,16 24,-1-1,0 1,0 1,-1 0,0 0,-1 1,0 0,0 1,-21-9,9 6,1 2,-1 1,0 1,-1 1,1 1,-27-1,37 4,0 0,0 1,0 0,0 1,1 1,-1 0,0 0,1 1,0 1,0 0,0 1,-17 11,23-12,0 0,0 0,1 0,-1 1,1 0,1 0,-1 0,1 1,0 0,1-1,-1 1,2 0,-1 1,1-1,0 0,0 1,1 0,0-1,0 1,0 0,1-1,2 14,0-9,0-1,1 0,0 1,0-1,2 0,-1 0,1-1,1 1,0-1,0-1,1 1,0-1,1 0,13 12,-2-5,1-2,0 0,1-1,0-1,1-1,0-1,38 12,-6-7,-1-3,75 8,-60-14,0-3,-1-3,1-2,-1-4,1-3,-2-2,1-4,-2-2,0-3,-2-3,0-3,-1-3,87-55,-111 60,-2-2,-1-2,50-51,-71 65,-1-1,-1-1,0 0,-1 0,-1-1,0 0,-1-1,-1 0,-1-1,7-27,-12 37,0 0,-1 0,-1 0,1-1,-1 1,-1 0,0 0,0 0,-1 0,0 0,0 0,-1 0,0 1,-9-17,5 14,0 1,-1-1,0 2,-1-1,0 1,0 1,-1-1,0 2,-20-12,0 3,-1 2,0 1,-1 1,-1 2,0 1,0 2,-40-4,14 7,0 2,0 2,0 4,1 2,-111 25,128-20,0 1,1 2,0 2,1 2,-60 37,73-38,0 2,1 0,2 2,0 0,1 2,1 0,1 2,-22 35,33-46,1 0,1 1,0 0,1 1,1 0,0 0,1 0,1 0,-2 20,4-27,1 0,1 0,-1 0,1 0,1 0,0 0,0 0,1 0,0 0,0-1,1 0,0 1,1-1,0-1,0 1,0-1,1 0,8 8,4 0,1 0,0-1,1-1,1-1,0 0,0-2,1-1,0 0,33 7,-1-3,0-3,111 7,-99-15,1-3,-1-2,0-4,77-16,-106 14,1-1,-1-2,-1-2,0-1,-1-2,-1-1,-1-2,46-35,-62 41,-1 0,0-2,-1 0,-1-1,-1 0,0-1,-2-1,0 0,17-40,-24 48,0-1,-2 1,1-1,-1 0,-1 0,0 0,0 0,-3-19,1 22,-1 0,0-1,-1 1,0 0,0 0,-1 0,0 1,0-1,-1 1,-1 0,-10-13,6 11,0 1,0 0,-1 0,0 1,0 1,-1 0,0 0,-1 1,1 1,-1 0,0 0,0 2,-1-1,-19-1,1 2,1 1,-1 1,1 2,-1 2,-41 7,14 3,0 3,1 2,1 2,1 3,1 2,1 3,-67 46,60-31,3 2,1 3,2 2,3 3,-75 97,101-114,1 0,2 2,1 1,2 1,2 0,2 1,-14 53,25-70,1 1,0-1,2 1,1-1,1 1,3 26,0-32,0 0,1-1,2 1,-1-1,2 0,0-1,2 0,15 26,-12-26,0-2,1 0,0 0,1-1,1-1,0 0,1-1,0-1,34 18,-10-10,0-3,2 0,57 12,-86-25,0 0,0-1,0 0,1-1,-1 0,1-1,-1-1,1 0,-1-1,0-1,0 0,0 0,0-1,0-1,-1 0,1-1,-1 0,-1-1,0 0,0-1,17-15,-15 10,-1 0,-1 0,0-1,15-25,-21 30,0 0,-1-1,0 0,0 0,-1 0,0 0,-1 0,0 0,0-12,-2 19,0 0,0 0,0-1,0 1,-1 0,1 0,-1 0,0 0,0 0,0 0,0 0,-1 0,1 1,-1-1,0 0,0 1,0-1,0 1,-3-3,2 3,0 0,0 0,0 0,-1 0,1 1,-1 0,0-1,1 1,-1 0,0 1,1-1,-1 1,0 0,0 0,-7 0,-11 3,-1 1,1 1,1 1,-1 0,1 2,-33 16,24-8,1 1,1 2,-47 39,55-40,1 1,2 1,-1 0,2 1,1 1,1 1,1 0,1 1,0 0,2 0,1 1,2 1,-9 40,15-54,0-1,1 0,0 1,1-1,0 0,0 1,1-1,1 0,0 0,0 0,7 12,-3-10,0 0,1-1,0 0,1 0,0-1,1 0,0-1,12 10,-3-5,2-1,0 0,1-2,0 0,0-1,1-2,1 0,0-2,47 9,-50-13,-1-1,1-2,-1 0,1-1,0-1,-1-1,0-1,0 0,0-2,0 0,-1-1,0-1,0-1,-1-1,-1 0,30-23,-28 17,0 0,0-2,-2 0,0-1,-2 0,0-2,-1 0,-1 0,0-1,-2-1,-1 0,-1-1,8-32,-13 40,-1 0,-1-1,0 1,-1-1,-1 0,-1 1,0-1,-2 0,-4-21,4 27,-1 1,1-1,-1 1,-1 0,0 1,0-1,-1 1,-1 0,1 1,-1-1,0 1,-1 1,0-1,0 1,-13-7,9 6,-1 1,1 1,-2 0,1 1,-1 1,1 0,-1 0,0 2,-1-1,1 2,0 0,-1 1,1 0,-21 4,13 0,0 1,0 1,1 1,0 1,1 1,0 1,0 0,-28 21,26-16,0 2,2 0,0 1,1 1,0 1,-30 44,42-54,1 1,0 0,1 0,0 1,1-1,0 1,0 0,1 0,1 0,0 1,1-1,0 1,1-1,1 0,0 1,0-1,4 16,-2-19,0 0,0-1,0 0,1 0,0 0,1 0,0-1,0 1,0-1,1-1,0 1,0-1,10 7,-5-5,0 0,1-2,0 1,0-2,0 1,1-2,0 0,14 3,2-2,0-1,-1-2,1-1,0-1,0-1,0-2,45-10,-34 3,0-2,-1-2,0-2,-1-1,-1-2,-1-1,-1-2,-1-2,0 0,-2-3,37-39,-47 42,-2-1,0 0,-1-2,-2 0,-1-2,18-42,-24 47,-2-2,-1 1,0-1,-2 0,-1 0,-2 0,0 0,-3-40,-1 44,-1 0,-1 0,-1 0,-1 0,-1 1,0-1,-2 2,-1-1,0 1,-21-29,15 28,-1 0,-1 1,0 1,-2 1,0 0,-1 2,-1 0,-36-19,23 17,0 1,-1 2,0 2,-2 1,1 2,-1 1,-1 2,1 2,-61 0,93 5,0 0,0 0,1 1,-1 0,0 0,1 0,-7 3,11-3,-1-1,1 1,0 0,0 0,0 0,0-1,0 1,0 0,0 0,0 1,0-1,0 0,0 0,1 0,-1 0,0 1,1-1,-1 0,1 1,0-1,-1 0,1 1,0-1,0 0,0 1,0-1,0 1,0-1,0 0,0 1,1-1,-1 0,0 1,2 1,0 2,0 1,1-1,-1 0,1 0,0 0,1-1,-1 1,1-1,0 0,0 0,1 0,-1 0,1-1,0 0,0 0,0 0,0 0,0-1,6 2,5 2,0-1,1-1,-1-1,1 0,23 1,-19-3,-1-2,1 0,-1-1,0-1,0-1,0-1,-1 0,1-2,-1 0,0-1,-1-1,0-1,-1-1,17-12,-22 14,-1 0,-1-1,0 0,0-1,-1 0,0 0,-1-1,0 0,-1-1,-1 0,0 0,0 0,-1-1,-1 1,0-1,-1 0,-1 0,0-1,-1 1,-1-26,-1 23,-1 0,-1 1,-1-1,0 1,-1-1,-1 1,-1 1,-10-20,5 15,0 1,-2 0,0 1,-1 1,-27-25,13 19,0 0,-1 2,-1 2,-1 1,-1 1,0 1,-53-16,64 26,-1 0,0 1,-1 2,1 0,0 2,-1 0,0 2,1 0,-24 5,30-3,0 1,0 1,1 0,-1 1,1 1,1 0,-1 1,1 1,1 1,-1 0,2 0,-21 21,30-26,-1 0,1 0,0 0,0 1,1-1,0 1,0 0,0 0,-2 9,4-11,0 0,1 1,-1-1,1 0,0 1,0-1,0 1,1-1,-1 0,1 1,0-1,1 0,-1 1,1-1,2 4,1 1,1 0,0 0,0-1,1 1,0-2,0 1,1-1,0 0,1 0,17 10,0-3,0-1,50 16,-30-15,1-2,1-2,0-2,0-2,0-2,1-2,-1-3,1-1,-1-3,0-2,0-1,-1-3,0-2,-1-2,0-2,-1-2,68-41,-90 46,-1-2,0-1,-2 0,0-2,-1 0,0-1,-2-1,15-23,-24 33,-1-1,0-1,-1 1,-1-1,0 0,-1 0,0 0,-1-1,0 1,-1-1,-1 0,0 0,-1 0,0 1,-1-1,-1 0,-4-18,0 14,0 1,-2 0,0 0,0 1,-2 0,0 0,-1 1,0 1,-2 0,1 0,-28-21,2 5,0 3,-2 1,-61-29,22 15,-1 3,-112-34,184 69,3 0,-1 0,0 0,0 1,0-1,0 2,0-1,0 1,0 0,-1 0,1 0,-7 2,12-1,0-1,0 1,0-1,0 1,0 0,0 0,0 0,0 0,1 0,-1 0,0 0,1 0,-1 0,0 0,1 0,-1 0,1 0,-1 0,1 1,0-1,0 0,-1 0,1 0,0 1,0-1,0 0,0 0,1 1,-1-1,0 0,0 0,1 0,-1 1,1-1,0 2,2 6,1 0,0 0,7 11,-9-18,14 23,1-1,1-1,1 0,1-2,1 0,1-1,0-2,2 0,0-1,1-2,36 18,-56-31,0 0,0 0,0 0,1-1,-1 1,0-1,1-1,-1 1,1-1,-1 0,7-1,-10 1,1-1,0 0,0 0,-1 0,1 0,0 0,-1-1,0 1,1-1,-1 1,0-1,1 0,-1 0,0 0,-1-1,1 1,0 0,0-1,-1 1,0-1,1 1,1-6,2-8,0-1,-1 0,-1-1,0 1,-1-1,-1 1,-2-23,-3-13,-10-58,-6 4,-5 1,-4 1,-46-106,72 202,-5-12,-2 1,-20-35,28 51,-1 0,1 1,-1-1,0 1,0-1,0 1,0 0,0 0,-1 1,0-1,1 1,-1 0,0 0,0 0,0 0,0 1,0-1,-1 1,1 0,-9-1,9 3,0-1,-1 1,1 0,0 0,0 0,-1 1,1 0,0-1,0 1,1 1,-1-1,0 0,-3 4,-5 5,0 0,-12 15,14-15,-28 32,2 2,2 1,-53 94,73-113,1 1,1 1,1 0,2 1,0 0,3 0,0 1,-2 56,8-71,1-1,0 1,1-1,1 0,0 0,1 0,1 0,12 26,-12-31,0-1,1 0,0 0,1-1,-1 0,2 0,-1-1,1 0,0 0,1 0,-1-1,1-1,1 0,10 5,-4-3,1-1,0-1,0-1,1 0,-1-1,1-1,29 0,-22-4,1 0,0-1,-1-2,45-13,-30 4,-1-2,0-2,-1-1,-1-3,0 0,40-35,-42 28,-1-2,-1-1,-3-1,0-2,-2 0,24-43,-38 54,-1 0,-1-2,-2 1,13-45,-19 51,0 0,-1 0,-2-1,1 1,-2-1,-1 1,-3-25,1 29,-1 0,0 1,-1 0,0 0,-2 0,1 0,-1 1,-1 0,-1 1,0 0,0 0,-1 1,0 0,-1 0,-1 2,1-1,-1 1,-16-8,0 1,0 2,-1 1,0 2,-1 0,0 2,-1 2,-54-7,11 7,0 4,1 3,-133 17,91 2,-186 55,237-54,-77 36,111-42,1 2,0 1,1 1,-35 30,57-43,0 0,1 0,0 1,0-1,0 1,1 1,0-1,0 0,0 1,1 0,0 0,1 0,-1 0,1 1,1-1,-1 1,1-1,1 1,-1-1,1 1,0-1,1 1,0-1,0 1,1-1,0 1,0-1,1 0,-1 0,2 0,-1 0,6 8,8 7,0 0,1-1,1-1,0-1,2 0,29 19,-20-17,2-1,0-2,1-1,44 15,-58-25,0-2,0 0,39 4,-50-8,-1 0,1-1,0 0,-1-1,1 0,-1 0,1 0,-1-1,1 0,-1-1,0 1,0-1,8-5,-11 5,-1 0,1-1,-1 1,1-1,-1 1,0-1,-1 0,1-1,0 1,-1 0,0-1,0 1,-1-1,1 0,-1 1,0-1,0 0,-1 0,1 0,-1 0,0-7,-1-2,-1 0,0 1,-1 0,0-1,-1 1,-10-23,1 10,-2 1,0 1,-1 0,-2 1,0 1,-2 1,0 1,-27-21,3 6,-2 2,-1 2,-64-31,46 31,-2 3,-1 3,-1 3,-140-25,145 37,0 4,-1 2,1 3,-1 3,-117 19,138-12,1 3,-1 1,2 2,-59 29,72-29,1 1,0 1,2 2,0 1,1 1,-42 45,59-57,0 2,1-1,0 1,0 0,1 1,1-1,0 1,1 0,0 1,0-1,2 0,-1 1,2 0,-1 24,3-21,0 0,2 0,0 0,0-1,2 1,0-1,0 0,2 0,0-1,0 0,17 23,0-6,3 0,0-1,2-2,1 0,1-3,62 40,-29-27,2-2,127 48,-137-64,0-3,1-2,1-2,0-4,0-1,1-4,66-2,-87-4,0-1,0-3,0 0,-1-3,0-1,-1-2,0-1,-1-2,0-1,-1-2,61-43,-73 43,-1-1,-1 0,-1-2,-1 0,-1-1,0-1,-2 0,-1-1,-1-1,-1 0,-1-1,-1 0,7-30,-12 35,-1 1,-1-2,-1 1,-1 0,-1 0,0-1,-7-36,4 42,-2-1,1 1,-2 0,0 0,-1 1,-1 0,0 0,-1 0,-1 1,-15-18,11 18,-1 0,0 0,-1 2,-1 0,0 1,0 0,-1 2,0 0,-1 1,0 1,0 0,-38-6,13 6,-1 1,-1 2,1 3,-79 7,56 2,1 3,0 4,1 2,0 3,-71 33,39-8,3 4,-138 95,147-83,2 5,4 3,-122 135,149-141,2 2,3 3,2 2,5 2,-41 93,62-118,2 1,3 0,2 2,-14 90,25-118,0 1,2-1,0 0,1 1,2-1,0 0,1 0,1 0,1-1,1 0,1 0,1 0,17 27,-12-27,2 0,0-1,1 0,2-1,36 29,-25-26,1-1,1-2,54 25,-29-21,1-3,1-2,0-2,108 12,-93-20,1-4,-1-3,1-4,123-19,-146 13,0-3,-1-2,0-3,-2-1,0-3,-1-1,61-41,-81 45,-2-2,0-1,-2-1,0-1,38-49,-48 53,-1-1,-1 0,-1-1,0-1,-2 1,0-2,-1 1,7-42,-12 53,-2 0,0 0,0 0,-1 0,0 0,-1 1,0-1,-1 0,0 0,0 0,-2 1,1-1,-1 1,-1 0,1 0,-2 1,0-1,0 1,0 0,-1 1,0 0,-1 0,0 0,0 1,-1 0,0 1,0 0,0 0,-1 1,-17-8,5 6,1 0,-1 2,-1 0,-34-2,-99 4,66 10,1 3,0 5,-165 48,118-17,-220 108,252-100,2 4,-169 129,214-141,3 2,2 3,2 1,2 3,-70 105,99-129,2 0,1 1,1 0,2 2,1-1,2 1,-10 57,17-69,1 0,2 0,0 0,1 0,0 0,2-1,1 1,1-1,1 1,0-1,2-1,0 1,16 26,-12-27,1-1,1 0,1-1,0 0,2-1,0-1,0-1,26 17,-17-15,1-1,1-1,1-2,0-1,50 14,-32-15,1-2,0-2,0-2,0-2,1-2,-1-3,95-15,-91 7,-2-3,1-2,-2-2,0-2,-1-3,-1-1,-2-3,0-1,-2-3,-1-1,-1-2,-2-2,-1-1,-2-3,-2 0,-1-2,-3-2,50-90,-64 103,-2-2,-1 0,-2 0,-1-1,-1 0,-2-1,-1 0,-2 0,0-45,-4 59,-1 0,-2 0,0 1,-1-1,0 1,-2 0,0 0,-1 0,-1 1,-1 0,-1 1,0 0,-1 0,-1 1,0 0,-2 1,-20-19,9 14,-2 0,1 2,-2 1,-1 1,0 1,0 2,-33-10,-6 2,-1 4,-91-12,19 13,-2 6,1 6,-247 24,255-3,1 6,2 6,0 6,-133 54,66-2,166-70,0 1,2 1,-50 43,73-56,-1 1,1 0,1 1,-1 0,2 0,-1 0,1 0,0 1,0 0,1 0,-5 17,7-18,1 0,0 0,0 1,1-1,0 0,0 1,1-1,0 0,1 1,0-1,0 0,0 0,1 0,5 9,6 10,1-1,2-1,0 0,2-1,1-1,0-1,25 21,7 0,1-2,62 36,-65-46,2-3,97 39,-128-59,0-1,1-1,0 0,0-2,1-1,-1-1,1 0,-1-2,1-1,31-4,-44 2,1 1,-1-1,0-1,0 0,-1 0,1-1,-1 0,0-1,0 0,-1 0,0-1,0 0,7-9,-6 6,-1-1,-1 0,0 0,0-1,-1 0,-1 0,0-1,0 1,4-21,-6 14,0 1,-1-1,-1 1,0-1,-2 0,0 1,-1-1,-1 1,-1-1,0 1,-1 0,-2 1,1-1,-19-32,12 31,-1 1,-1 0,0 1,-1 1,-1 0,-1 1,0 1,0 1,-40-21,11 10,-1 3,-1 2,-65-16,20 12,-1 4,0 5,-1 3,-1 5,-97 6,151 2,1 1,-1 2,1 1,-81 25,115-28,0 0,1 1,-1-1,1 1,-1 1,1 0,-6 5,11-8,0 0,0 0,0 0,0 0,0 1,1-1,-1 0,1 1,0-1,0 1,0 0,0-1,0 1,0 0,1-1,-1 1,1 0,0 0,0 0,0 0,0-1,0 1,2 4,1 4,0 0,1-1,1 1,0-1,0 0,1 0,12 16,0-4,1-1,23 20,-9-13,2 0,1-2,1-2,1-1,0-2,2-2,1-1,0-3,1-1,0-2,57 9,-83-19,-1 0,0-2,0 1,1-2,-1 0,0-1,22-5,-31 5,1 0,-1 0,0 0,0-1,-1 0,1 0,-1-1,1 1,-1-1,0-1,-1 1,1 0,-1-1,1 0,-2 0,1-1,0 1,-1-1,0 1,3-9,-3 5,-1 0,0-1,0 1,-1-1,0 0,-1 1,0-1,0 0,-1 1,0-1,-1 1,0-1,0 1,-1 0,0-1,-1 2,0-1,-1 0,-5-8,-2 0,0 0,-1 0,0 2,-2-1,0 2,-1 0,-32-22,18 17,0 2,-2 1,0 2,-1 1,-57-15,43 17,-1 3,0 1,-77-1,94 9,-60 7,81-7,0 1,1 0,-1 1,0 0,1 1,0 0,0 0,0 1,0 0,-8 7,15-10,0 0,0 0,0 0,0 1,0-1,0 1,1-1,-1 1,1 0,0-1,-1 1,1 0,1 0,-1 0,0 0,0 4,1-2,0 0,1 0,-1 0,1 0,0 0,0 0,1 0,-1-1,4 7,1 0,0 1,2-1,-1 0,1 0,1-1,14 14,-11-13,-4-2,1 0,1-1,-1-1,1 1,20 9,-28-16,1 0,0 0,-1 0,1 0,0-1,0 1,-1-1,1 0,0 1,0-1,0-1,0 1,-1 0,1-1,0 0,0 1,-1-1,1 0,-1 0,1-1,0 1,-1 0,0-1,1 0,-1 1,0-1,0 0,0 0,0 0,3-5,1-1,0-1,-1 0,0 0,0 0,-1-1,0 0,-1 1,0-1,0-1,-1 1,0 0,-1-1,-1 1,1 0,-2-1,1 1,-1-1,-1 1,0 0,-5-17,3 13,-1 1,-1 0,0 0,0 0,-1 1,-1 0,0 0,-1 1,0 0,0 0,-1 1,-1 0,0 1,-22-15,11 13,-1 0,0 1,0 2,-1 0,0 1,-1 2,1 0,-39-1,35 5,-1 0,0 3,0 0,1 2,0 0,0 3,-33 10,55-15,-1 1,0 0,1 0,0 1,-1-1,2 1,-12 10,15-13,1 1,-1 0,1 0,-1 0,1-1,0 1,0 1,0-1,0 0,0 0,0 0,1 0,-1 1,1-1,-1 0,1 1,0-1,0 0,0 1,0-1,1 0,-1 1,0-1,1 0,0 0,0 1,-1-1,1 0,2 2,1 3,0-1,1 1,0-1,0 0,1 0,0-1,0 0,0 0,0 0,1-1,0 0,0 0,9 3,8 3,1 0,46 9,-35-11,1-2,1-2,-1-1,1-1,52-6,-64 1,0-1,0-1,0-1,0-2,-1 0,0-2,-1-1,35-20,-44 21,-1-1,1 0,-2-1,0 0,0-1,-1-1,15-22,-21 28,-2 1,1 0,-1-1,0 0,-1 0,0 0,0-1,-1 1,0-1,0 1,-1-1,0 0,-1 1,0-1,0 0,-1 0,-2-12,-1 10,0 0,-1 0,0 0,-1 1,0-1,-1 1,0 1,0-1,-1 1,0 1,-18-15,4 6,0 1,-2 1,-49-24,33 22,0 2,-1 1,-1 2,-76-12,86 20,1 2,0 1,0 1,-1 1,1 2,0 1,-41 11,67-13,0-1,1 1,-1 0,1 0,-1 0,1 0,-1 1,1 0,0 0,0 0,1 0,-1 1,1 0,-1-1,1 1,0 0,1 1,-3 3,3-3,0 0,0 0,1 0,0 1,0-1,1 0,-1 0,1 0,0 1,1-1,-1 0,1 0,0 0,0 1,1-1,0 0,2 5,0-1,1 0,0-1,1 1,0-1,1 0,-1-1,1 0,1 0,-1 0,1-1,1 0,10 6,4 1,0-1,1-1,40 12,-42-16,0-1,1-1,-1-1,1-1,0-1,34-1,-47-2,0 0,-1 0,1-1,-1 0,1 0,-1-1,0-1,0 0,0 0,-1 0,1-1,-1 0,0-1,0 0,-1 0,0-1,12-14,-15 15,0 1,0-1,-1-1,0 1,0 0,0-1,-1 0,0 1,0-1,-1 0,2-14,-3 11,-1-1,1 1,-2 0,1 0,-1 0,-1 0,-6-16,3 10,-2 1,0 1,0-1,-2 1,1 1,-2 0,0 0,0 1,-27-21,25 23,-1 2,-1-1,0 2,0 0,0 1,-1 0,0 1,0 1,0 1,0 0,-1 1,1 1,-32 1,39 1,0 0,1 1,-1 0,1 0,0 1,0 0,0 1,0-1,0 1,0 1,1 0,0 0,0 0,1 1,-12 11,11-7,-1 0,1 0,1 0,0 1,0-1,1 1,0 1,1-1,0 1,-3 20,4-16,1 0,0 0,1 1,1-1,1 0,0 0,8 32,-8-42,1 0,0 0,0-1,1 1,0-1,0 1,0-1,0 0,1 0,0 0,0-1,1 0,-1 1,1-1,0-1,0 1,0-1,0 0,0 0,1 0,0-1,-1 0,1 0,9 2,-8-3,1 0,0 0,-1 0,1-1,0 0,0 0,-1-1,1 0,0-1,-1 0,1 0,-1 0,9-5,-6 2,-1 0,0-1,0 0,0-1,-1 0,1-1,-2 1,11-14,-3-1,-1 1,-1-2,0 0,-2 0,-1-1,-1-1,7-28,-8 19,-1 1,-2-1,-1-1,-2 1,-4-67,0 80,-1 1,-1 0,0 0,-2 0,0 0,-1 1,-1 0,-1 1,0-1,-2 2,-15-22,21 33,-1 0,0 0,0 0,0 1,-1 0,0 0,0 1,0-1,-1 2,1-1,-1 1,0 0,0 0,0 1,0 0,0 1,0 0,-1 0,1 1,0 0,-1 0,1 1,-9 2,5-1,1 1,0 0,0 1,0 0,0 1,1 0,0 0,0 1,0 1,1 0,0 0,0 1,0 0,1 0,1 1,-8 10,4-1,1 0,1 1,0 0,2 1,0 0,-8 37,10-25,0 1,2-1,3 57,0-78,1-1,1 1,0-1,0 0,1 0,0 0,1 0,0-1,1 1,0-1,0 0,1 0,0-1,0 1,1-1,13 11,-13-13,1 0,-1-1,1 0,1-1,-1 0,1 0,-1 0,1-1,0-1,0 1,1-2,-1 1,0-1,1 0,-1-1,0 0,1-1,17-3,-9-1,-1 0,1-1,-1-1,-1 0,1-2,-1 0,-1 0,0-1,0-1,-1-1,0 0,-1-1,22-28,-9 6,-1-1,-2-1,-2 0,29-71,-30 57,-2-1,-3-1,-1 0,7-73,-17 94,-2 0,-2 1,0-1,-2 0,-2 0,-1 1,-1 0,-19-56,19 72,-1-1,0 1,-1 1,-1-1,0 1,-1 1,0 0,-1 0,-1 1,0 1,-22-17,23 20,-1 1,0 0,-1 1,0 0,1 1,-2 1,1 0,-1 1,1 0,-1 1,0 0,0 2,0-1,-16 3,9 0,0 1,0 1,1 2,-1-1,1 2,1 1,-1 0,1 2,-32 21,39-23,1 0,0 1,1 0,0 1,1 0,0 1,0 0,1 0,0 1,1 0,1 0,0 1,0-1,2 1,-7 27,9-33,1 1,0-1,1 0,0 1,0-1,1 1,0-1,0 0,0 1,1-1,0 0,1 0,6 13,-4-12,0 0,1 0,0-1,0 0,1 0,0 0,0-1,0 0,15 9,-2-4,1-1,0-1,1 0,-1-2,2 0,-1-2,1-1,27 3,-16-5,0-2,0-1,0-2,-1-1,1-1,-1-2,0-2,-1-1,48-21,-46 15,0-1,-2-2,0-1,-1-1,-1-2,-1-1,-1-1,34-42,-42 43,-2-1,-1-1,-1 0,-1-2,-1 1,-2-2,11-35,-18 48,-1 0,0 0,-2 0,1 0,-2 0,0-1,-1 1,-1-1,0 1,-2 0,1 0,-2 0,0 0,-1 0,-8-17,9 26,0 0,0 0,-1 0,1 1,-1 0,-1 0,1 0,-1 1,0-1,-1 1,1 1,-1-1,-11-4,8 4,0 1,-1 1,0 0,1 0,-1 1,0 1,0 0,-22 1,9 2,1 1,-1 1,0 1,1 1,0 1,0 1,1 1,-28 17,20-9,2 1,0 2,1 1,1 1,-45 51,54-54,2 1,0 1,1 1,1 0,1 0,1 1,1 1,-11 39,18-49,1 0,0 0,1 1,1-1,0 1,1-1,0 0,1 1,1-1,0 0,1 0,0-1,7 15,-6-17,1 0,0-1,0 0,1 0,0 0,1-1,0 0,0 0,1-1,0 0,0-1,1 0,0 0,1-1,21 10,-16-10,1-1,0-1,0 0,0-1,0-1,0-1,1 0,-1-1,0-1,25-4,-20 0,0 0,0-2,-1-1,1 0,-2-1,0-2,27-17,-20 9,-1-1,-1-1,-1-1,-1-1,-1-2,-1 0,-1-1,-2-1,0-1,-2 0,15-36,-20 36,-1 0,-1 0,-1-1,-2 0,-1 0,-1-1,0-38,-5 55,0 0,0 0,-2 0,1 0,-1 1,-1-1,-1 1,-6-16,6 20,0 0,-1-1,1 2,-1-1,-1 1,0 0,0 0,0 1,0 0,-1 0,0 1,-12-6,4 3,0 2,0 0,0 1,-1 0,1 1,-1 1,0 1,-1 1,1 0,0 1,0 1,0 0,0 1,0 1,0 1,0 0,-17 8,10-2,0 0,1 2,0 1,1 0,1 2,0 0,1 2,1 0,0 1,-28 35,32-32,0 1,1 0,1 1,2 0,0 1,1 0,2 1,0 0,2 0,1 1,0 0,0 40,5-51,0 0,1 0,1 0,0 0,1 0,1-1,0 1,1-1,1 0,0-1,1 1,0-1,1 0,0-1,1 0,1 0,0-1,0 0,1-1,0 0,1-1,0 0,19 10,-7-7,1 0,0-2,1-1,0-1,0-1,50 7,-23-9,1-2,84-7,-68-3,-1-2,-1-4,0-3,-1-2,108-46,-116 37,-1-2,-1-3,-2-2,-2-2,-1-3,59-57,-86 71,-1-1,-1-1,-1-1,-2 0,-1-2,-1 0,22-54,-32 65,-2 0,0-1,-1 1,-1-1,-1 0,0-1,-2 1,0 0,-1 0,-2-1,0 1,-1 0,0 0,-11-29,10 37,-1 0,0 1,-1 0,-1 0,0 0,0 1,0 0,-2 0,1 1,-17-14,13 13,-1 1,-1 1,0 0,0 0,0 2,-1-1,-26-6,16 7,-1 2,0 0,0 2,1 0,-1 2,0 1,0 1,0 1,0 1,-27 9,30-6,0 1,0 1,1 1,0 1,1 1,0 1,1 1,0 0,1 2,-22 22,30-25,0-1,1 2,0-1,1 1,1 1,0-1,1 2,1-1,0 1,1-1,1 2,0-1,1 0,1 1,-1 31,4-36,0 0,0 0,1 0,1 0,0 0,0 0,1-1,1 0,0 0,11 19,-7-17,1-1,0 0,1 0,0-1,0 0,1-1,21 14,-7-9,0-1,1-1,1-1,0-2,0 0,1-2,0-1,39 4,-30-8,0 0,0-3,0-1,72-11,-87 8,0-2,0 0,0-2,-1 0,-1-1,1-2,-1 0,-1-1,22-17,-32 21,-1 0,-1 0,0-1,0-1,0 1,-1-1,-1 0,0-1,0 0,-1 1,0-2,5-18,-7 20,-1 0,-1 0,0 1,0-1,-1 0,0 0,-1 0,0 0,0 0,-1 1,0-1,-1 1,0-1,-1 1,-9-17,2 9,0 1,-1 0,-1 1,-1 0,0 2,0-1,-2 2,1 0,-2 0,-27-14,16 12,-1 1,0 2,-1 0,0 2,-61-10,53 14,0 2,0 1,-1 2,1 1,0 3,0 1,0 1,-58 19,76-18,0 1,0 1,1 1,0 1,1 0,0 1,-19 17,25-17,0 1,0-1,1 2,1 0,0 0,1 1,0 0,1 0,-10 30,13-28,0-1,1 1,1 0,1 0,0 0,2 1,0-1,0 0,2 0,0 0,1 0,1 0,0 0,1-1,1 1,1-2,0 1,1-1,1 0,0 0,1-1,0 0,1-1,1 0,0-1,1-1,0 1,23 14,-12-12,0 0,1-2,0 0,1-2,47 12,-16-9,104 8,-90-17,0-4,-1-2,1-4,-1-2,0-4,85-25,-77 12,0-3,-1-3,-2-3,-2-4,74-50,-101 56,0-1,-3-3,-1-2,51-58,-73 73,-2-1,-1 0,-1-1,-1 0,-1-2,-2 0,0 0,-2-1,-1 0,6-30,-13 44,0 0,-1-1,0 1,-1-1,-1 1,0-1,-1 1,0 0,-1 0,-1 0,-9-24,7 26,-1 0,1 1,-2 0,1 0,-2 0,1 1,-1 1,-1-1,0 2,0-1,-1 1,-20-12,6 8,-1 0,0 2,-1 1,0 1,0 1,-1 1,1 2,-1 1,0 1,-1 1,1 1,0 2,-34 6,46-5,1 1,0 0,0 1,0 1,1 0,-1 1,2 0,-1 1,1 1,0 0,1 1,0 0,0 1,2 0,-1 1,1 0,1 1,0 0,-8 16,5-6,2 0,0 0,2 1,1 0,0 0,2 1,1 0,1 0,0 48,4-54,0-1,2 0,0 0,1 0,1 0,0-1,2 0,0 0,0 0,2-1,0 0,1-1,1 0,18 21,-10-17,2-1,0-1,0-1,2-1,0-1,0-1,2-1,-1-1,29 8,0-2,2-3,0-2,74 6,-81-14,1-1,0-3,-1-2,1-2,-1-2,0-2,48-15,-70 15,-1-1,0-1,-1-1,0-1,0-1,-2-1,1-2,-2 0,0-1,-1-1,-1-1,-1 0,-1-2,18-26,-21 24,-1 0,-2-1,0-1,-2 0,0 0,-2-1,-1 0,-1-1,-1 1,-1-1,-1 1,-2-1,-1 0,-1 0,-1 1,-8-35,5 38,0-1,-2 1,0 1,-2 0,0 0,-1 1,-2 0,0 1,-1 0,-1 1,-1 1,0 0,-1 1,-1 1,-1 1,0 1,-1 0,-26-13,32 20,0 2,-1-1,1 2,-1 0,0 1,0 0,-1 1,1 1,0 0,0 1,-1 1,1 0,-16 4,13-1,0 1,1 1,-1 0,1 1,1 1,-1 0,1 2,1-1,0 2,-23 20,16-9,0 1,2 0,0 2,2 0,1 2,-26 51,32-54,2 0,0 0,2 1,0 0,2 0,1 1,1 0,1 47,3-58,0-1,1 1,1-1,0 0,1 0,1 0,0 0,1-1,10 19,-5-16,0-1,0 0,2 0,-1-1,2-1,23 19,-4-9,2-1,0-2,1-1,1-2,1-2,48 14,17-1,0-5,1-4,177 8,-164-24,-1-6,0-4,133-26,-38-16,-177 38,-1-1,0-2,58-33,-83 42,0 0,0-1,0 0,0 0,-1-1,0 0,-1 0,1-1,-1 0,8-15,-11 18,-1-1,0 1,0-1,-1 0,0 0,0 0,0 1,0-1,-1 0,0 0,0 0,-1 0,0 0,0 0,0 0,-1 1,0-1,-3-8,1 8,1-1,-1 1,0 0,-1 0,0 1,1 0,-2-1,1 1,-1 1,1-1,-1 1,0 0,-1 1,1-1,-1 1,1 1,-1-1,-14-3,-6 0,0 2,-1 0,-43 0,49 4,-1 0,1 1,-1 2,1 0,0 1,0 2,0 0,-23 10,36-12,0 0,0 1,1 0,0 0,0 1,0 0,1 0,0 1,0 0,1 0,0 0,0 1,0 0,1 0,0 1,1-1,0 1,0 0,1 0,0 1,-1 11,2-10,1 1,1-1,0 1,1-1,0 1,1-1,0 0,1 0,0 1,1-2,0 1,0 0,1-1,1 0,6 10,2-1,0-1,0 0,2-1,0 0,1-1,29 20,-3-7,1-2,0-3,2-1,1-2,60 17,-63-25,0-1,0-3,1-2,0-2,0-2,54-2,-83-2,0-1,0 0,0-1,0-1,18-6,-29 8,0 0,0 0,0-1,0 0,-1 0,1 0,-1 0,0-1,0 1,0-1,-1 0,1 0,-1-1,0 1,0-1,0 1,-1-1,4-9,-3 4,-1 0,0 1,0-1,-1 0,0 0,-1 0,0 0,0 0,-1 0,-3-10,1 6,-1 1,-1-1,0 1,-1 0,0 0,-11-15,-5-2,-1 1,-1 1,-1 2,-45-37,-46-27,97 78,0 0,0 2,-1 0,-36-12,51 21,-1-1,0 1,0 1,0-1,0 1,0 0,0 1,1-1,-1 1,0 0,0 1,0-1,1 1,-1 0,1 0,-1 1,1 0,0 0,0 0,0 1,1-1,-1 1,-7 9,1-1,1 0,1 1,0 0,0 0,1 1,1 0,-10 28,8-13,2 0,0 1,2-1,2 1,0 0,2 1,1-1,2 0,0 0,3 0,0-1,2 1,1-1,18 45,-15-50,0 0,2 0,0-1,2-1,0 0,2-1,0-1,1 0,1-2,1 0,1-1,0-1,1-1,0-1,2-1,41 18,-34-20,1-1,0-2,0-1,1-1,0-2,0-2,0 0,49-6,-63 3,0-2,0-1,-1 0,1-1,-1-1,0 0,-1-2,0 0,0-1,0-1,-1 0,-1-1,0-1,0 0,24-28,-25 21,-1 0,0-1,-2-1,0 0,-1 0,-1-1,-2 0,0-1,-1 0,-1 0,-1 0,-1 0,-2-1,0 1,-1-1,-1 1,-2-1,0 1,-1 0,-2 0,-10-31,11 44,0 0,0 1,-1-1,0 1,0 1,-1-1,0 1,-1 0,0 0,0 1,-1 0,0 1,0 0,0 0,-1 1,-18-8,19 10,0 0,-1 1,1 0,-1 0,0 1,0 0,1 0,-1 1,0 1,0 0,1 0,-1 1,0 0,1 0,0 1,-1 1,1-1,1 2,-11 5,1 3,0 0,1 1,1 1,0 1,1 0,1 1,0 0,1 2,1-1,1 1,-10 25,3-3,3 0,1 1,2 1,-9 69,17-90,2 0,1 0,1 0,0 0,2 0,7 35,-4-39,0-1,1 1,1-1,1-1,0 1,1-1,1-1,14 19,-11-18,1-2,1 1,0-2,1 0,0 0,1-2,0 0,1-1,0-1,1 0,0-2,22 6,-36-11,1 0,0-1,-1 0,1 0,0-1,0 1,7-2,-13 1,1 0,-1 0,0 0,0 1,0-1,0 0,0 0,0 0,0 0,1 0,-1 0,0 0,0 0,0 0,0 0,0 0,0 0,1 0,-1 0,0 0,0 0,0 0,0 0,0 0,0 0,0 0,1 0,-1-1,0 1,0 0,0 0,0 0,0 0,0 0,0 0,0 0,0 0,1 0,-1 0,0-1,0 1,0 0,0 0,0 0,0 0,0 0,0 0,0-1,0 1,0 0,0 0,0 0,0 0,0 0,0 0,0-1,0 1,0 0,0 0,0 0,-11-5,-19-1,10 6,1 1,0 0,0 1,0 1,0 1,0 1,1 0,0 2,-31 14,14-2,0 1,2 2,-53 43,53-36,2 2,1 2,1 0,2 2,1 1,2 1,2 1,1 2,2-1,-27 84,35-87,2-1,1 1,2 1,2-1,1 1,2 0,1 0,2 0,2 0,1-1,1 0,3 0,19 54,-8-45,1 0,3-2,1 0,3-2,1-1,2-1,1-2,2-1,2-2,40 31,-67-58,0 0,0-1,1 0,0-1,0 0,20 6,-27-10,1 0,-1 0,1 0,-1-1,1 0,-1 0,0 0,1 0,-1 0,1-1,-1 1,1-1,-1 0,0 0,1 0,-1-1,0 1,0-1,0 0,0 1,0-1,0-1,-1 1,1 0,3-5,-1 0,0-1,0 0,-1 0,0 0,0 0,-1-1,0 1,-1-1,0 0,1-9,-1 2,-1 1,0-1,-1 1,0-1,-4-16,4 26,-1 0,-1 0,1 0,-1 1,0-1,0 0,-1 1,1-1,-1 1,-1 0,1 0,-1 0,0 1,0-1,0 1,0 0,-1 0,1 0,-1 1,0 0,-1-1,1 2,0-1,-1 1,0 0,1 0,-1 0,0 1,0 0,0 0,0 0,0 1,-12 1,4 1,0 1,1 0,-1 1,1 1,0 0,0 1,0 0,1 1,0 1,0 0,1 0,-16 16,4-3,1 2,2 1,0 0,-26 44,29-38,1 1,1 1,1 0,2 1,2 0,0 1,3 0,1 0,1 0,2 1,1 0,3 36,2-55,-1 0,2-1,0 1,1-1,1 1,0-2,1 1,0-1,1 0,1 0,13 15,-13-17,1-1,1 0,0-1,0 0,1 0,1-2,-1 1,1-1,1-1,-1-1,1 0,15 5,-26-10,0 0,-1-1,1 1,0 0,0-1,0 0,0 1,0-1,0 0,0-1,0 1,0 0,0-1,0 0,-1 0,4-1,-6 2,1 0,-1 0,0-1,1 1,-1 0,0 0,0-1,1 1,-1 0,0-1,0 1,0 0,1-1,-1 1,0-1,0 1,0 0,0-1,0 1,0 0,0-1,0 1,0-1,0 1,0 0,0-1,0 1,0-1,0 1,0 0,-1-1,1 1,0 0,0-1,0 1,0 0,-1-1,1 1,0 0,-1-1,1 1,-1 0,-15-13,2 7,0 0,0 0,-1 1,1 1,-1 0,-28-2,19 4,0 1,0 0,-43 7,33 1,0 1,1 2,0 1,0 2,2 1,-1 2,2 1,0 1,1 1,1 2,-33 31,46-37,1 0,-22 29,32-39,1 0,0-1,0 1,1 0,-1 1,1-1,0 0,1 1,-1-1,1 1,0-1,0 1,1 0,0-1,0 7,1-9,-1-1,1 0,-1 0,1 0,0 0,0 0,0 0,0 0,0 0,0 0,0 0,1-1,-1 1,1 0,-1-1,1 1,2 1,0-1,-1 0,1 0,-1-1,1 1,0-1,0 0,0 0,8 1,-1-1,1-1,-1 0,1-1,-1 0,0-1,12-3,-3-1,-1-1,0-1,-1-1,1 0,-2-2,1 0,-2-1,1 0,26-29,-17 15,-2-2,-1-1,-1-1,29-53,-41 65,0-1,-1-1,-1 0,-1 0,-1 0,6-36,-11 50,0 0,-1 0,0 0,0-1,0 1,-1 0,0 0,0 0,0 0,-1 0,0 0,0 1,-1-1,1 1,-1-1,-1 1,1 0,-1 0,1 0,-2 0,1 1,0 0,-1 0,0 0,1 0,-2 1,-6-5,-7 0,0 0,0 2,0 0,-1 1,0 1,0 0,0 2,-25 0,-167 11,196-8,-162 18,-215 49,380-65,0 0,1-1,-1 2,1 0,-1 0,1 1,-19 11,30-15,0-1,0 0,0 1,0 0,1-1,-1 1,0-1,0 1,1 0,-1-1,0 1,1 0,-1 0,1 0,-1 0,1-1,-1 1,1 0,0 0,-1 0,1 0,0 0,0 0,-1 0,1 0,0 0,0 0,0 0,0 0,1 0,-1 0,0 0,0 0,1 0,-1 0,0 0,1 0,-1 0,1-1,-1 1,1 0,-1 0,2 1,2 1,-1 0,1 0,0 0,0 0,0-1,1 0,-1 0,6 2,9 2,1 0,0-2,1 0,-1-2,1 0,-1-1,1-1,0-1,23-4,-14 0,0-1,-1-1,0-2,0-1,46-22,-63 25,-1 0,1 0,-1-1,-1 0,1-1,-2 0,16-18,-20 20,0 0,0 0,-1 0,0-1,0 0,-1 0,0 0,0 0,-1 0,0-1,0 1,0-18,-2 23,0 0,0-1,0 1,-1 0,1 0,-1-1,0 1,0 0,0 0,0 0,-3-4,0 2,1 0,-1 0,-1 1,1-1,-10-7,-4-1,-1 1,0 0,-31-14,-74-23,27 16,-2 4,-122-19,145 37,1 3,-1 3,-131 10,157 1,1 1,1 3,0 3,0 1,1 2,1 2,1 3,1 1,0 2,2 2,-48 39,78-56,1 0,0 1,0 1,1 0,1 0,-12 17,20-25,-1-1,1 0,0 1,-1-1,1 1,0-1,1 1,-1 0,0-1,1 1,-1 0,1 0,0-1,0 1,0 0,0 0,1-1,-1 1,1 0,-1 0,1-1,0 1,0-1,0 1,1-1,-1 1,1-1,-1 0,1 1,0-1,-1 0,1 0,0 0,1-1,-1 1,0 0,0-1,1 1,-1-1,4 1,7 4,1 0,0-1,0 0,1-2,-1 1,1-2,0 0,0-1,0 0,0-1,0-1,0 0,23-6,-34 6,-1 0,1 0,0 0,-1-1,0 1,1-1,-1 0,0 0,0 0,0 0,0-1,0 1,0-1,-1 0,1 0,2-4,-4 4,0 0,0 0,0 0,-1 1,1-1,-1 0,1 0,-1 0,0 0,0 0,-1 0,1 0,0 0,-1 0,0 0,0 1,0-1,0 0,0 0,0 1,-1-1,-2-3,-2-4,-1 1,-1-1,1 1,-2 1,1-1,-11-7,-65-42,27 26,-2 1,-83-29,-133-30,-110-2,-8 23,359 64,28 4,-38-6,0-1,-62-22,103 29,0 0,-1-1,1 1,1-1,-1 1,0-1,0 0,1 0,-1-1,1 1,-1 0,1-1,0 0,0 1,0-1,0 0,1 0,-1 0,1 0,0 0,0 0,0-1,0 1,0 0,1 0,-1-1,1 1,0-1,0 1,1-6,1-2,0 1,1-1,0 1,0 0,1 0,0 0,1 1,0 0,10-13,163-188,-146 175,605-705,-589 679,70-117,-112 167,0 0,-1-1,0 1,-1-1,0 0,-1 0,3-19,-6 27,1 0,-1 1,-1-1,1 0,0 1,-1-1,0 1,0-1,0 1,0-1,-1 1,1 0,-1-1,0 1,0 0,0 0,0 0,0 0,-1 1,1-1,-1 1,0-1,0 1,0 0,0 0,0 0,0 1,-6-3,-8-2,0 1,0 1,-1 0,0 1,0 1,-21 0,-22 1,0 3,1 2,-1 3,1 2,-63 20,0 7,-161 71,165-55,-131 79,198-99,1 2,2 2,2 2,-73 76,107-100,1 1,1 0,0 0,1 1,1 0,-9 21,15-31,1 1,0 0,0-1,0 1,1 0,0 0,0 0,1 0,0 0,0 0,1 0,0 0,0 0,1-1,0 1,0 0,0-1,1 1,4 7,-2-6,0 0,1-1,-1 0,1 0,1-1,0 0,-1 0,11 6,0-1,1-1,30 13,-14-9,2-2,0-1,0-2,0-1,1-2,54 2,-44-8,1-2,-1-1,0-3,79-20,-47 4,0-4,-2-4,89-47,-109 47,-2-3,-1-3,-2-1,81-78,-116 99,-1-2,-1 0,0 0,-2-1,0-1,-1 0,13-33,-21 43,0 0,-1 0,-1 0,1-1,-2 1,1-1,-1 1,-1-1,0 0,-1 1,0-1,0 0,-1 1,-1-1,1 1,-2 0,0 0,-5-11,2 9,0 1,0 0,-1 1,0 0,-1 0,0 1,-19-15,12 12,-2 1,1 0,-2 1,-25-9,-3 2,-2 3,0 1,-60-6,12 7,1 5,-1 4,0 4,1 5,0 3,0 5,1 4,-182 60,236-64,-66 34,97-43,0 1,0 1,0-1,1 1,0 1,1 0,-1 0,1 1,1 0,0 0,-7 12,11-16,1-1,0 1,0 0,0 0,1 1,-1-1,1 0,1 0,-1 1,1-1,0 0,0 1,0-1,1 0,0 1,0-1,0 0,1 0,-1 0,1 0,1 0,-1 0,1 0,-1-1,6 7,2 0,0 0,0 0,1-1,1 0,0-1,0-1,0 0,17 8,19 6,1-2,0-3,1-1,56 9,4-4,1-4,1-6,0-4,0-5,1-5,-1-5,-1-4,133-34,-199 35,0-2,-1-1,0-3,49-27,-80 36,0 0,-1-1,0 0,-1 0,0-1,0-1,-1 0,-1-1,0 0,10-17,-15 23,-1 0,0-1,0 1,-1-1,1 0,-2 0,1 0,-1 0,0 0,0 0,-1 0,0-1,0 1,-1 0,0 0,0 0,0 0,-1 0,0 0,-1 1,0-1,0 0,-5-8,-1 3,-1 0,0 0,0 1,-2 1,1-1,-1 2,0 0,-1 0,0 1,-1 1,1 0,-26-9,-2 3,-1 1,0 2,-60-7,35 10,0 4,-1 2,1 3,0 4,0 2,1 3,0 3,-74 26,103-27,1 1,0 2,1 2,1 1,1 1,-43 36,59-42,1 1,0 1,1 1,1 0,-15 26,21-30,0 2,1-1,1 1,0 0,1 0,1 1,0-1,-1 19,4-24,0 0,1 0,0 0,1 0,0 0,1 0,0 0,1 0,0-1,6 15,-3-12,1 1,0-1,1-1,1 1,0-2,18 19,-1-7,0-2,2 0,0-2,1-1,50 21,-1-6,2-4,0-3,2-4,156 20,-144-32,0-4,1-5,-1-3,107-18,-134 9,-1-2,-1-3,122-50,-148 49,-1-1,-1-1,-1-3,-1-1,-1-1,-1-2,39-42,-57 52,0 0,-2-1,0-1,-1 0,0-1,-2 0,-1 0,12-37,-17 42,0-1,-1 0,-1 0,-1 0,0 0,-1 0,-1 0,0 0,-1 0,-1 0,0 0,-10-26,3 18,-2-1,-1 2,-1 0,0 0,-2 1,-1 1,0 1,-2 0,0 1,-36-27,6 12,0 1,-2 3,-94-41,-28 6,140 56,-1 0,0 3,-41-4,68 9,0 1,0 0,0 0,0 0,0 1,-13 3,18-3,1-1,-1 1,0 0,1 0,-1 0,1 0,-1 0,1 0,-1 0,1 1,0-1,0 0,0 1,0-1,0 1,0-1,0 1,0 0,0-1,1 1,-1 0,1 0,-1-1,1 1,0 0,-1 0,1 0,0-1,0 1,1 3,0 3,0-1,1 1,0-1,1 1,-1-1,2 0,-1 0,1 0,-1 0,2-1,-1 1,9 8,6 8,1 0,1-2,1 0,1-2,43 29,-13-16,105 46,87 12,-99-49,3-7,0-7,2-6,202 2,-253-23,0-5,101-18,-131 10,-1-3,0-3,103-43,-136 46,-1-1,0-2,62-46,-80 51,0-1,0-1,-2 0,0-1,-1-1,0 0,-2 0,11-23,-18 31,0 0,0-1,-2 0,1 0,-1 0,-1-1,0 1,-1 0,0-1,-1-20,-1 23,0-1,-1 1,-1 0,1-1,-2 1,1 0,-1 1,0-1,-1 1,0-1,-1 1,1 1,-10-10,-1 1,-1 0,-1 1,0 1,-1 1,-1 0,0 1,0 2,-37-15,8 9,-1 1,-97-15,81 22,-121-1,65 14,1 6,-142 31,-234 88,346-80,-200 95,279-109,1 4,2 2,2 3,-94 83,132-100,1 0,1 2,-43 62,59-75,1 0,1 1,1-1,0 2,1-1,1 1,1 0,1 0,-4 32,8-39,0 0,0 0,1 0,1 0,0-1,0 1,2-1,-1 1,10 20,-5-17,1-1,0 0,0 0,2-1,0 0,16 15,2-3,0-2,2-1,1-2,0-1,56 24,-19-15,1-3,122 27,155-2,-238-43,0-4,114-13,-152 3,-1-3,0-4,-1-2,80-31,-124 37,0-1,0-1,-1 0,-1-2,0-1,33-29,-45 34,-1 0,0-1,-1 0,-1 0,1-1,-2 0,0-1,0 1,-1-2,0 1,-2 0,1-1,4-28,-7 23,-2 0,1 0,-2 0,-1 0,0 0,-1 0,-1 1,-1-1,-1 1,0 0,-1 0,-11-18,1 5,-1 1,-2 0,-1 2,-1 0,-47-44,28 35,-2 2,-2 2,-1 1,-61-30,35 27,-1 3,-110-33,51 31,0 5,-2 6,-160-6,177 23,-1 4,-205 24,267-13,0 2,-103 37,123-33,0 1,2 1,0 2,1 1,-34 28,51-35,0 1,1 0,1 1,0 1,1 0,1 1,-15 27,21-32,0 1,1-1,0 1,1 0,1 0,0 0,1 1,0-1,1 0,1 1,0 0,2 18,2-13,-1-1,2 1,1-1,0 0,1-1,1 1,1-1,0-1,22 31,-12-26,0 1,1-2,1-1,1 0,0-2,26 15,6-1,3-2,0-3,2-2,0-3,78 16,-53-18,0-4,1-3,0-4,0-4,151-12,-176 1,-2-3,1-3,88-30,-105 27,0-2,-1-2,-1-2,-1-1,45-36,-62 41,-1-2,0 0,-2-1,0-2,-2 0,0 0,-1-2,-2 0,0 0,-2-1,-1-1,-1 0,-1-1,-2 0,0 0,-2 0,-2-1,0 0,-2 0,-1 0,-1 0,-1 0,-2 1,-7-29,3 25,-2 1,0 0,-2 1,-2 0,0 1,-2 0,-33-43,25 42,-1 1,-2 1,0 1,-2 1,-1 2,-36-22,26 22,0 1,-1 3,-1 2,-1 1,-1 2,0 2,-1 2,0 2,0 2,-1 2,-79 1,110 5,0 0,0 0,0 2,0 0,0 0,-24 10,34-11,1 1,-1-1,0 1,1 0,0 0,-1 0,1 0,0 1,1 0,-1 0,1 0,0 0,0 1,0-1,0 1,1-1,0 1,0 0,0 0,0 0,1 0,-1 10,1-9,1 1,0 0,0 0,1 0,0-1,0 1,1 0,0-1,0 1,0-1,1 1,0-1,0 0,0 0,6 7,4 2,0 0,0 0,1-1,23 16,7 3,1-3,2-1,0-3,2-2,71 25,-46-24,2-3,0-4,90 10,-115-22,0-2,1-2,-1-3,91-12,-119 8,1 0,-1-2,-1 0,1-2,25-14,-33 15,-1 0,-1-2,0 0,0 0,-1-1,0 0,-1-1,15-21,-12 11,-2 0,-1-1,0 0,-2-1,0-1,-2 1,-1-1,0 0,-2 0,-1-1,-1 1,-2-1,0 0,-2 1,-8-49,7 63,0 0,-1 1,0 0,0 0,-1 0,-1 0,-7-10,11 17,0 0,0 0,0 0,-1 1,1-1,-1 1,0-1,0 1,0 0,0 0,0 0,0 1,0-1,-1 1,1-1,-1 1,1 0,-1 1,1-1,-1 0,0 1,1 0,-1 0,0 0,-4 1,0 2,0 0,1 1,-1 0,1 0,0 0,0 1,0 0,0 1,1 0,0 0,-6 8,-12 13,1 1,1 1,2 2,-22 42,-53 141,50-94,5 2,-36 185,60-212,4 0,4 1,9 189,3-239,1-1,2-1,3 1,1-1,23 57,-26-82,1-1,1 0,1-1,0 0,1 0,15 14,-17-20,1-1,0-1,0 0,1 0,0-1,1-1,0 0,0 0,18 5,-15-8,0 0,0-1,0 0,0-2,1 0,-1 0,0-2,1 0,-1-1,0 0,0-1,0-1,0-1,-1 0,16-8,5-5,-1 0,-1-3,-1-1,0-1,33-32,-5-2,-3-2,-2-3,-3-3,-3-1,-3-3,-3-2,36-79,-40 64,-4-2,-4-1,-3-2,-5-1,24-184,-43 224,-2-1,-3 0,-2 0,-3 0,-1 1,-25-93,22 113,-2 1,-1 1,-1 0,-2 0,0 2,-2 0,-2 0,0 2,-2 1,0 0,-2 1,-28-22,19 23,0 1,-1 1,-2 3,0 0,0 2,-2 2,0 2,0 1,-42-7,5 7,1 2,-1 4,-137 8,207-3,-143 16,133-13,-1 0,1 1,0 1,0 0,0 1,1 0,-25 16,31-16,0 1,1 0,-1 0,1 0,1 1,0 0,0 0,0 0,1 0,0 1,0 0,1 0,1 0,-3 10,0 11,0 0,2 1,1 32,2-49,1-1,0 1,1-1,0 0,1 1,1-1,0 0,1-1,0 1,1-1,0 0,1 0,0-1,1 0,1 0,9 9,-5-7,0-1,2 0,-1-1,2-1,-1-1,1 0,0-1,1 0,0-1,0-1,26 5,-13-5,-1-1,2-1,-1-2,0-1,47-5,-62 3,0-1,0-1,0-1,-1 0,1-1,-1 0,0-1,0-1,-1 0,0-1,0 0,21-19,-27 20,-1 1,1-1,-2-1,1 1,-1-1,0 0,-1-1,0 1,0-1,-1 1,0-1,2-12,-3 8,-1 1,0-1,0 0,-2 0,0 0,0 1,-1-1,-4-14,-2 0,-2 0,-1 1,-1 0,-1 0,-2 1,0 1,-25-29,36 47,-14-13,17 18,0 1,1-1,-1 1,0 0,1 0,-1-1,0 1,1 0,-1 0,0 0,0 0,1 0,-1 0,0 0,1 0,-1 0,0 0,1 0,-1 0,0 0,0 1,1-1,-1 0,0 1,1-1,-1 0,1 1,-1-1,1 1,-1-1,0 1,1-1,0 1,-1 0,-12 16,2 0,0 1,1 0,1 1,-12 36,-4 6,-29 49,-26 62,77-167,-7 26,9-30,1 0,0 0,-1 0,1 0,0 1,0-1,0 0,0 0,0 0,0 0,0 0,0 1,0-1,0 0,1 0,-1 0,0 0,1 0,0 2,0-3,0 0,0 1,-1-1,1 0,0 0,0 0,0 0,0 0,0 0,0 0,-1 0,1 0,0 0,0 0,0-1,0 1,0 0,-1 0,1-1,0 1,0-1,-1 1,2-2,15-7,-1-1,0-1,-1 0,0-1,13-15,67-77,-57 58,-2-1,-2-2,-2-2,-2-1,-3-1,-2-1,23-73,-42 108,-1 0,-1-1,-1 1,2-31,-5 42,0 0,0 0,-1 1,-1-1,1 0,-1 0,0 1,-1-1,0 1,0 0,-1 0,0 0,0 0,-5-6,-1 3,0 0,0 0,-1 2,0-1,-1 1,1 1,-1 0,-1 1,0 0,1 1,-2 0,-21-4,-14-1,0 2,-58-2,8 5,-1 4,1 5,-121 19,206-21,-3 1,-33 9,46-11,1 0,0 0,0 0,0 1,0-1,0 1,0 0,0 0,1 0,-1 0,0 0,1 1,0-1,0 1,0-1,-3 5,5-5,-1 0,0 0,1 1,-1-1,1 0,0 1,0-1,0 0,0 1,0-1,0 0,1 1,-1-1,1 0,0 0,-1 1,3 2,22 36,-2-11,2-1,1-2,34 29,95 67,-115-93,1-2,75 38,-95-58,-21-8,0 0,1 0,-1 0,0 0,0 0,0 0,1 0,-1 0,0 0,0 0,0 0,1 0,-1 0,0 0,0 0,0 0,1 0,-1 0,0 0,0 0,0 0,1 0,-1 0,0 0,0-1,0 1,1 0,-1 0,0 0,0 0,0 0,0-1,0 1,0 0,1 0,-1 0,0-1,0 1,0 0,0 0,0 0,0-1,0 1,0 0,0 0,0 0,0-1,0 1,0 0,0 0,0 0,0-1,0 1,0 0,0 0,0 0,0-1,-1 1,1 0,0 0,0-1,-8-12,-3 0,0 1,-1 0,-24-18,-47-28,62 44,-4-3,-1 2,0 0,-1 1,-1 2,-36-11,50 19,0 1,0 0,0 1,0 1,0 0,0 0,0 2,0 0,-1 1,1 0,0 1,1 0,-23 9,13-1,1 1,1 0,0 2,0 0,-30 29,9-2,-50 62,54-54,3 1,1 2,3 2,2 1,3 1,-29 90,30-51,23-86,0 0,1 0,1 1,-1-1,2 1,-1-1,1 0,3 10,-4-16,1 0,0-1,0 1,0 0,1-1,-1 1,1-1,-1 1,1-1,0 0,0 0,0 0,0 0,0 0,1 0,-1 0,0-1,1 1,0-1,-1 0,1 0,0 0,-1 0,1 0,0 0,0-1,4 1,-4-1,1 0,0 0,-1 0,1-1,0 1,0-1,-1 0,1 0,-1-1,1 1,-1 0,0-1,1 0,-1 0,0 0,0 0,0-1,0 1,-1-1,5-4,-3 0,0-1,0 0,0 1,-1-1,0 0,0-1,-1 1,0 0,0-1,-1 0,-1 1,1-1,-1 1,-2-16,0 9,0 1,-1-1,-1 1,0 0,-1 0,0 0,-15-25,13 27,-2 0,1 1,-1 0,-1 0,0 1,-1 0,0 1,0 0,-24-13,17 12,-1 2,-1 0,1 0,-1 2,0 1,-25-4,0 4,1 3,-1 1,0 2,0 2,-76 15,35 1,1 5,1 3,1 4,-151 80,205-96,1 2,1 1,1 2,0 0,1 2,1 0,2 2,-21 27,34-39,1 1,0 0,1 0,1 1,0 0,1 0,0 0,-3 21,6-23,1 1,1-1,0 0,0 1,1-1,1 1,0-1,0 0,1 0,1 0,6 14,-2-9,1-1,1 0,0-1,1 0,0-1,2 0,-1-1,2 0,-1-1,2 0,0-1,0-1,1 0,0-2,0 1,1-2,21 7,-32-13,0 1,0-1,0 0,0 0,0-1,0 0,-1 0,1 0,0-1,0 0,0 0,0 0,8-3,-10 1,1 1,-1 0,0-1,0 0,0 0,0 0,-1-1,1 1,-1-1,0 0,0 0,0 0,0 0,-1 0,0-1,3-6,0-4,0-1,-1 1,-1-1,0 0,-2 0,1 0,-2 0,0 0,-1-1,-1 1,0 1,-1-1,-1 0,0 1,-2-1,1 1,-2 0,-8-14,4 9,-1 0,-1 1,0 0,-2 1,0 1,-1 0,-1 2,0-1,-1 2,-1 0,0 2,-25-13,12 11,0 1,-2 2,1 2,-1 1,0 1,-46-2,6 5,-141 10,42 14,135-13,0 1,-55 19,88-25,0 1,-1-1,1 1,0 0,0 0,0 0,1 1,-1 0,1 0,0 0,0 0,-6 9,6-6,0 0,1 0,0 1,0-1,0 1,1 0,0 0,-1 11,2-6,1 0,0 0,0 0,1 0,1 0,1 0,-1 0,8 19,-1-9,1 0,1-1,22 35,-22-42,1 0,0 0,1-2,0 1,1-2,29 21,-7-10,72 33,-77-41,2-1,0-2,0-2,1-1,0-1,65 6,-86-14,1 0,0-1,0 0,0-1,-1 0,1-2,-1 1,22-10,-26 9,0-1,0-1,-1 1,0-1,0-1,0 1,-1-1,0-1,0 1,-1-1,0 0,0-1,4-9,-5 9,0-1,-1 0,-1 0,1 0,-2-1,1 1,-1-1,-1 1,0-1,-1 0,0 1,0-1,-1 0,0 1,-1-1,-1 1,1-1,-2 1,1 0,-1 0,-1 0,0 1,-8-12,0 2,-1 0,-1 2,0-1,-2 2,0 0,-1 1,0 1,-1 1,-37-20,22 17,0 2,-1 1,0 2,-1 1,-1 2,1 2,-1 1,0 2,0 1,0 2,0 2,0 1,0 2,0 1,1 2,-49 18,74-22,-1 0,2 1,-1 0,-19 13,28-16,-1 0,1 1,-1-1,1 0,0 1,0 0,0-1,0 1,0 0,1 0,-1 0,1 0,0 0,0 0,0 0,0 1,0-1,1 0,0 1,0-1,-1 0,2 5,0-1,0 0,1 0,0 0,0 0,1 0,-1-1,1 1,1-1,0 0,-1 0,2 0,-1 0,1-1,0 1,0-1,0 0,7 4,2 1,1 0,0-1,0-1,1-1,0 0,19 5,6 0,0-3,1-1,0-2,0-2,1-2,0-2,51-6,-25-2,-1-4,-1-2,116-41,-124 32,-1-2,-1-2,-1-3,-1-2,-3-3,91-77,-114 84,0-1,-3-1,0-2,39-64,-50 70,-1-2,-1 0,-2 0,-1-1,-1-1,-1 1,3-34,-9 47,-1-1,0 1,-1-1,-1 0,0 1,-1-1,-9-30,8 36,-1 1,-1 0,1 0,-2 0,1 0,-1 1,-1 0,1 0,-2 0,1 1,-1 1,-15-12,7 7,-1 2,0 0,-1 1,0 0,0 2,-1 0,0 1,0 1,0 1,-1 1,1 0,-1 2,-25 0,10 3,-1 2,1 1,0 1,1 3,0 0,-53 23,10 3,1 3,2 3,-113 84,105-61,2 4,-110 124,165-163,0 2,2 0,-26 49,39-63,2 1,0 1,1-1,1 1,0 1,2-1,0 1,-1 29,5-38,1 0,0 1,0-1,2 0,-1 1,1-1,1-1,0 1,1 0,-1-1,2 0,0 0,8 10,-5-8,1 0,0-1,1 0,0-1,0 0,1-1,1 0,-1-1,26 11,2-2,1-3,0-1,57 9,133 9,60-15,-259-16,-1-2,1-2,0-1,-1-1,0-1,0-2,31-14,-48 16,0 0,-1 0,0-2,-1 0,1 0,-2-1,1-1,-2 1,1-2,-1 0,-1 0,0-1,-1 0,0 0,-1-1,-1 0,0 0,-1 0,0-1,-1 0,-1 0,-1 0,0 0,0-1,-2 1,0-1,-1 1,-3-22,0 16,-1 1,-1 0,-1 0,0 0,-2 1,0 0,-1 1,-1 0,0 0,-2 1,0 1,0 0,-2 1,0 0,-29-20,16 15,-1 1,-1 2,0 2,-1 0,-1 2,0 1,-1 2,-63-12,43 15,0 3,0 1,-1 3,1 3,0 1,0 3,-77 20,51-4,0 3,2 3,1 4,-81 47,140-70,-1 1,2 1,-1 0,2 1,-1 0,2 1,-21 27,26-30,2 1,0 0,0 1,1-1,1 1,0 1,1-1,0 1,1-1,0 1,0 25,3-20,1 0,0 0,2 0,0 0,1-1,1 1,1-1,1 0,0 0,1-1,1 0,12 17,6 5,1-1,3-2,59 57,-32-40,2-3,3-3,100 58,-151-98,33 16,-43-21,0-1,1-1,-1 1,1 0,-1-1,1 1,-1-1,1 0,-1 1,1-1,0-1,-1 1,1 0,-1-1,4 0,-5 0,0 1,0-1,0 0,0 1,0-1,0 0,0 0,0 0,0 0,-1 0,1 0,0 0,0 0,-1 0,1-1,-1 1,1 0,-1 0,0 0,1-1,-1 1,0 0,0 0,0-1,0 1,0 0,0-1,0 1,0 0,-1 0,0-2,0-4,-1 0,0 1,-1-1,-5-9,-7-10,-1 0,-1 2,-1 0,-2 1,0 1,-1 0,-31-23,24 24,-1 1,0 1,-2 1,0 2,-64-24,84 36,-2 0,1 1,0 0,0 1,-1 0,1 1,-1 1,0 0,1 0,-1 2,1-1,-1 1,1 1,0 1,0-1,0 2,1 0,-1 0,1 1,0 0,1 1,-1 0,1 1,1 0,-15 16,7-4,1 1,1 1,1 0,0 1,2 0,1 1,-14 44,10-19,3 1,1 1,-3 53,11-70,2 0,4 60,0-73,0 1,2-1,0 0,2 0,13 31,-7-26,1-1,1 0,1-1,1-1,1-1,26 26,-16-22,1-2,1 0,1-2,41 22,-13-14,1-3,1-3,2-2,0-3,82 13,77-1,-172-28,0-2,75-8,-95 3,-1-1,1-1,-2-2,1-1,36-17,-44 16,-1-1,0-2,-1 0,0 0,-1-2,0 0,25-30,-23 20,0-1,-2-1,-1-1,-2 0,0-1,-2-1,15-52,-19 53,-3 0,0-1,-2 0,-1 0,-1 0,-2-1,-1 1,-6-39,4 51,-2 0,0-1,-1 2,0-1,-2 1,0 0,-1 0,-1 1,0 0,-1 1,-1 0,0 1,-1 0,-1 1,0 1,0 0,-1 0,-1 2,0 0,-1 1,1 0,-2 2,1 0,-1 1,0 0,0 2,-1 0,1 1,-1 1,-21 0,20 2,0 1,0 1,0 0,0 2,1 0,-1 2,1 0,1 1,-29 14,26-10,1 2,1 0,0 1,0 1,1 0,1 1,-27 35,31-34,1 1,0 0,2 1,0 0,1 0,1 1,1 0,-8 38,12-41,1 1,0 0,2-1,0 1,1 0,0 0,2-1,0 1,1-1,1 0,8 21,-3-16,1 0,2-1,0-1,0 0,2-1,1-1,0 0,1-1,1 0,1-2,38 25,-14-14,1-2,1-2,1-2,88 25,-42-21,1-4,110 8,196-14,-298-16,1-4,-1-5,-1-4,159-45,-205 42,0-3,-2-1,89-54,-104 52,-1-2,-1-1,-1-2,-1-1,43-53,-59 61,-1-1,-1-1,-1 0,-1-1,-1-1,-1 0,-1 0,-2-1,10-50,-13 36,-1-1,-1 1,-3 0,-1-1,-13-75,10 94,-2 0,0 0,-1 0,-1 1,-1 0,-1 1,-16-27,19 38,1 1,-1-1,-1 2,0-1,0 1,-1 0,0 1,0 0,0 0,-1 1,0 0,0 1,-1 0,0 1,0 0,-21-5,19 7,1 1,-1 0,0 0,1 1,-1 1,1 0,-1 1,1 0,-1 1,-21 8,18-4,1 0,0 1,1 1,0 0,0 1,1 1,-18 17,12-7,1 0,1 1,1 1,1 0,1 1,1 1,1 0,1 1,-13 47,22-62,0-1,0 1,1-1,0 1,1-1,1 1,-1-1,2 1,-1-1,7 20,-3-16,1 1,0-1,1 0,1-1,0 0,17 21,-2-9,0-1,2-2,0 0,1-2,1-1,33 18,-11-10,1-3,1-2,89 26,-101-38,-1-1,1-3,1-1,-1-1,77-5,-104 0,-1 0,1-1,-1-1,0 0,0 0,0-1,0 0,13-8,-19 9,0 0,0-1,-1 1,0-1,1 0,-1 0,0 0,-1 0,1-1,-1 0,0 0,0 0,-1 0,1 0,-1 0,0-1,-1 1,3-9,-3 7,-1 0,1 1,-1-1,0 0,0 0,-1 0,0 0,0 0,-1 0,0 1,0-1,-1 1,-3-9,0 7,1-1,-1 0,-1 1,1 0,-1 1,-1-1,1 1,-11-6,-3-1,0 1,-1 1,0 1,-1 1,-1 0,-37-8,6 6,0 3,-1 2,1 3,-1 2,-104 9,129-3,1 0,-1 2,1 1,-34 13,42-11,2 0,-1 2,2 0,-1 1,1 1,-22 20,8 0,1 0,2 2,2 1,1 1,2 2,1 0,2 2,2 0,2 2,2 0,1 0,-17 92,29-116,1 1,1 0,0 0,2 0,0 0,1-1,5 21,-4-28,1-1,0 0,0 1,1-2,1 1,-1 0,2-1,-1 0,2-1,-1 0,1 0,1 0,11 9,11 3,2-1,0-1,1-2,0-2,41 13,-37-15,1-1,0-2,1-2,0-1,1-2,62-1,198-21,-59-10,243-60,-116-11,453-184,-513 151,-64 9,-179 85,-1-3,97-79,-155 113,46-43,-50 46,0-1,0 1,0-1,-1 0,1 0,-1 0,0-1,0 1,0 0,-1-1,2-5,-3 9,0-1,0 1,0 0,0-1,0 1,-1-1,1 1,0 0,-1-1,1 1,0 0,-1 0,0-1,1 1,-1 0,0 0,0 0,0 0,1 0,-1 0,0 0,0 0,-1 0,1 0,0 0,0 0,0 1,0-1,-1 1,1-1,0 1,-1-1,1 1,0 0,-1 0,1-1,-3 1,-4-1,0 1,0-1,0 1,0 1,-10 1,-21 7,1 1,1 2,-43 20,24-10,-91 36,-155 86,301-144,-12 7,0 1,0 1,-16 13,27-20,-1 1,1-1,0 1,-1 0,1 0,1 0,-1 0,-3 6,5-7,-1-1,1 1,0 0,-1-1,1 1,0 0,0-1,0 1,0 0,1-1,-1 1,0 0,1-1,-1 1,1-1,-1 1,1-1,0 1,1 1,0 0,0 0,0 0,1-1,-1 0,1 1,0-1,0 0,-1 0,1 0,0-1,1 1,3 1,44 11,-47-14,48 10,1-3,82 0,112-19,-72-6,-1-8,188-53,-341 73,0 0,-1-1,1-1,-1-1,22-13,-41 21,1 0,-1 0,1 0,-1 0,1-1,-1 1,1 0,-1-1,0 1,0-1,0 1,0-1,0 0,0 1,0-3,0 3,-1 0,0 0,0 0,0 0,0 0,-1 0,1 1,0-1,0 0,0 0,-1 0,1 0,0 0,-1 1,1-1,-1 0,1 0,-1 1,0-1,1 0,-1 1,-1-2,-3-2,0 1,-1 0,0-1,0 2,0-1,0 1,-12-3,-25-4,-1 1,1 2,-2 3,-68 2,31 6,-131 25,182-23,1 0,1 2,-1 2,2 0,-38 22,52-26,1 1,0 1,1 0,0 1,0 0,1 1,0 0,1 1,0 0,1 0,1 1,-11 22,16-30,1 1,-1 1,2-1,-1 0,1 0,0 1,0-1,1 0,0 11,0-14,0-1,1 1,-1-1,1 0,0 0,-1 1,1-1,0 0,0 0,1 0,-1 0,0 0,1 0,-1 0,1 0,0-1,-1 1,1-1,0 1,0-1,0 1,0-1,0 0,0 0,0 0,1 0,-1-1,3 2,5-1,-1 1,1-1,0 0,11-1,-17 0,0 0,-1-1,1 1,0-1,0 0,0 0,-1 0,1 0,0-1,-1 1,1-1,4-4,-7 6,-1 0,0 0,0 0,1 0,-1-1,0 1,0 0,1 0,-1 0,0 0,0-1,0 1,0 0,1 0,-1 0,0-1,0 1,0 0,0 0,0-1,0 1,0 0,1 0,-1-1,0 1,0 0,0 0,0-1,0 1,0 0,0-1,0 1,-1 0,1 0,0-1,0 1,0 0,0 0,0-1,0 1,0 0,-1 0,1 0,0-1,0 1,0 0,-1 0,-14-4,7 5,1-1,0 1,1 1,-1-1,0 1,0 0,0 1,-7 4,-52 32,53-31,-15 10,2 2,0 0,1 2,1 0,1 2,-35 45,54-63,0 0,1 0,-1 0,1 0,0 1,-2 7,5-12,-1 0,1 0,0 0,-1 0,1 0,0 0,0 0,1 0,-1 0,0 1,0-1,1 0,0-1,-1 1,1 0,0 0,0 0,0 0,0 0,0-1,0 1,0 0,1-1,-1 1,2 0,2 2,0-1,0 0,-1 0,2-1,-1 0,0 0,0 0,1 0,-1-1,1 0,8 1,4-1,-1 0,26-3,-21-1,0 0,1-2,-1 0,38-16,-46 16,-1-1,0-1,-1 0,0 0,0-2,0 1,-1-1,17-19,-26 27,-1-1,0 1,0-1,1 1,-1-1,0 1,0-1,-1 1,1-1,0 0,0 0,-1 1,1-1,-1 0,0 0,1 0,-1 0,0 0,0 1,0-1,0 0,-1-2,0 2,0 0,0 0,0 0,0 1,-1-1,1 0,0 1,-1-1,0 1,1 0,-1-1,0 1,1 0,-1 0,0 0,-3-1,-5-1,0 0,1 0,-1 1,0 0,0 1,-1 0,-11 0,-3 4,0 1,0 1,0 1,0 2,1 0,0 1,1 2,0 0,-33 23,43-26,2 0,-1 1,1 1,-19 21,25-25,0 1,0 0,1 0,0 0,0 0,1 1,0-1,0 1,0 0,0 9,2-15,1 0,-1 1,1-1,0 0,0 0,0 1,0-1,1 0,-1 1,1-1,-1 0,1 0,0 0,0 1,0-1,0 0,0 0,0 0,1-1,1 3,0-1,-1-1,1 0,0 0,1 0,-1 0,0 0,0-1,1 1,-1-1,1 0,5 1,4 0,-1-1,1 0,0-1,-1-1,1 0,18-3,-12 0,-1-1,1-1,-1 0,0-2,-1 0,1-1,-1 0,-1-1,0-1,-1-1,0 0,-1-1,0-1,-1 0,0-1,-1 0,-1-1,-1 0,0-1,-1 0,9-22,-17 35,1 0,-1 0,0 0,0-1,0 1,-1 0,1 0,-1-1,0 1,-1 0,1 0,-1-1,1 1,-1 0,-3-8,2 9,0 0,0 0,0 0,0 0,-1 1,1-1,-1 1,0-1,0 1,0 0,0 0,0 0,0 1,0-1,-1 1,1-1,-1 1,1 0,-5 0,-2-1,-1 1,1 0,0 1,-1 0,1 0,0 1,-1 1,1 0,0 0,0 1,-15 6,7-1,0 0,1 1,1 1,-1 1,-18 15,17-9,0 0,0 0,2 2,-17 23,24-28,1 0,0 0,1 0,0 1,1 0,0 1,-3 21,8-33,0 1,0 0,1-1,0 1,0 0,0-1,1 1,-1 0,1-1,0 1,1 0,-1-1,1 1,0-1,0 0,0 0,0 0,4 4,-1-1,1-1,0 0,0-1,1 0,0 0,0 0,0-1,0 0,12 5,-10-5,0-1,0 0,0 0,0-1,1 0,-1-1,1 0,-1-1,1 1,-1-2,1 1,-1-2,1 1,-1-1,0 0,0-1,0 0,0-1,0 0,0 0,-1-1,0 0,0 0,9-9,-13 10,0-1,0 0,-1 0,0 0,0-1,0 1,0-1,-1 1,0-1,0 0,-1 0,1 0,-1 0,-1 0,1 0,-1 0,-1-11,1 11,-1 1,1 0,-1 0,-1 0,1 0,-1 0,0 1,0-1,0 0,0 1,-1-1,0 1,0 0,0 0,0 0,-1 0,0 1,0-1,0 1,0 0,-6-4,-3 2,0 0,0 1,0 0,0 1,-1 1,1 0,-1 1,0 0,1 1,-1 0,0 1,-26 6,12-1,0 2,1 1,-1 1,2 1,-31 18,30-13,1 1,0 2,2 0,0 2,1 0,-35 43,43-45,1 1,1 0,0 1,2 1,0-1,2 2,0 0,1 0,-5 29,12-47,0 0,0 0,0-1,1 1,0 0,0 0,0 0,1 0,0 0,-1-1,2 1,-1 0,0-1,1 1,0-1,0 1,4 5,-6-10,0 1,1-1,-1 0,0 1,0-1,0 1,1-1,-1 0,0 1,1-1,-1 0,0 1,1-1,-1 0,0 0,1 1,-1-1,1 0,-1 0,1 0,-1 0,0 1,1-1,-1 0,1 0,-1 0,1 0,-1 0,1 0,-1 0,1 0,-1 0,0 0,1-1,-1 1,1 0,-1 0,1 0,-1 0,0-1,1 1,-1 0,1 0,-1-1,0 1,1 0,-1-1,0 1,0 0,1-1,-1 1,0-1,0 1,1 0,-1-1,0 1,0-1,0 1,0-1,0 1,1 0,-1-1,0 1,0-2,1-2,0-1,0 0,0 0,-1-10,0 0,-2 1,0 0,0 0,-9-25,9 34,1 1,-1 0,1 0,-1 0,0 0,-1 0,1 0,-1 1,1-1,-1 1,0-1,-1 1,1 0,-1 0,1 1,-1-1,0 1,0-1,-6-1,8 3,-1 1,1 0,-1 0,1 0,-1 0,1 0,-1 0,1 1,-1-1,1 1,0 0,-1-1,1 1,0 0,-1 0,1 1,0-1,0 1,0-1,0 1,0-1,0 1,1 0,-1 0,0 0,1 0,-2 3,-3 4,1-1,0 1,1 0,0 1,-4 13,5-12,0-1,1 1,1 0,-1 0,2-1,-1 1,2 0,-1 0,1 0,1 0,0 0,1-1,0 1,0-1,1 0,1 0,-1 0,2 0,-1-1,1 0,1 0,0 0,0-1,0 0,1-1,1 1,16 10,-13-11,1 0,0-1,0-1,1 0,-1-1,1-1,0 0,0-1,0 0,0-1,1 0,-1-2,0 1,0-2,0 0,0-1,0 0,0-1,19-8,-18 6,0-1,0 0,-1-1,-1 0,1-1,-1-1,-1 0,0-1,0 0,-1-1,-1-1,0 1,0-1,-2-1,1 0,11-29,-13 23,-1 0,-1-1,-1 0,-1 0,-1 0,-1-1,-2-35,1 53,-1 0,1 0,-1 0,0 0,0 0,0 0,-1 0,1 0,-1 0,0 1,0-1,-1 0,1 1,-1 0,1 0,-1 0,0 0,-4-3,4 4,0 0,0 0,0 1,-1 0,1-1,0 1,-1 1,1-1,-1 0,1 1,-1-1,1 1,-1 0,1 0,-1 1,1-1,-1 1,1 0,-1 0,1 0,-5 2,-2 2,0 0,0 1,0 1,1-1,0 2,0-1,1 1,0 0,0 1,1 0,-10 14,6-6,1 1,1 0,0 0,2 1,-11 35,12-26,1 0,1 0,1 1,2-1,1 1,1-1,7 48,-6-70,-1 0,1 0,0 0,1-1,-1 1,1 0,0-1,1 0,-1 0,6 5,-8-8,1 0,-1 0,1-1,0 1,0-1,0 0,0 1,0-1,0 0,0 0,0 0,0 0,0-1,1 1,-1-1,0 1,1-1,-1 0,0 0,1 0,-1 0,0 0,1 0,-1-1,0 1,0-1,1 0,-1 1,4-3,-3 0,1 1,-1-1,0 0,1 1,-1-2,-1 1,1 0,0-1,-1 1,0-1,0 1,0-1,0 0,2-8,1-6,0 1,2-21,-5 19,0 1,-1 0,-1 0,-1-1,-1 1,-6-29,6 35,-1 1,-1 0,0 0,0 0,-1 0,-1 0,0 1,0 0,-1 1,0-1,-12-11,16 18,0 1,1-1,-1 1,-1 0,1 0,0 0,0 0,-1 0,1 1,-1-1,1 1,-1 0,0 0,0 1,1-1,-1 1,0 0,0 0,1 0,-1 0,0 1,-4 0,4 0,1 1,-1-1,1 1,0 0,0 0,0 0,0 1,0-1,0 1,0-1,1 1,-1 0,1 0,0 0,0 0,0 1,0-1,1 0,-1 1,1-1,0 1,-1 4,0 2,0-1,1 1,0-1,1 1,0 0,1 0,0-1,0 1,1-1,0 1,0-1,1 1,1-1,0 0,0-1,0 1,1-1,8 10,-6-9,0 1,1-2,1 1,-1-1,1-1,0 0,1 0,0 0,0-1,0-1,1 0,0 0,0-1,21 5,-29-8,0-1,0 1,0-1,0 0,0 0,0 0,0 0,0 0,0-1,0 1,0-1,-1 0,1 0,0 0,0 0,-1 0,1-1,0 1,-1-1,0 0,1 0,-1 0,0 0,0 0,0 0,3-4,-3 3,0-1,0 0,-1-1,1 1,-1 0,1 0,-1-1,-1 1,1 0,-1-1,1 1,-1-1,-1 1,1-1,-1 1,1 0,-3-6,-2-7,-2 1,0 0,0 0,-2 1,0 0,0 0,-1 1,-1 0,-1 1,0 0,0 1,-2 0,-20-14,28 23,0 0,0 0,0 1,0 0,0 0,0 0,0 1,0 0,-13 0,17 0,1 1,-1 0,0 0,0 1,1-1,-1 0,0 1,1-1,-1 1,0-1,1 1,-1 0,1 0,-1 0,1 0,-1 0,1 0,0 0,-1 0,1 0,0 1,0-1,0 0,0 1,0-1,0 1,0-1,0 1,1 0,-1-1,1 1,-1 0,1-1,0 1,0 0,-1 0,1-1,0 1,1 3,0 1,0-1,0 1,1-1,-1 1,1-1,1 0,-1 0,1 0,0 0,0 0,0-1,0 1,1-1,5 5,-4-4,0 0,0-1,1 1,-1-1,1-1,0 1,0-1,1 0,-1 0,0-1,10 3,-13-5,0 0,0 0,1 0,-1 0,0 0,0-1,0 1,0-1,0 0,0 0,0 0,0-1,-1 1,1-1,0 1,-1-1,1 0,-1 0,1 0,-1 0,0-1,0 1,0-1,3-4,1-2,-1 0,0-1,-1 1,1-1,-2 0,4-12,-2-2,-1 0,0 0,-1-27,-2 39,-2-1,1 1,-2-1,0 1,0 0,-1-1,-8-21,9 32,1-1,0 1,0-1,-1 1,0-1,1 1,-1 0,0 0,0 0,0 0,0 0,-1 0,1 1,-1-1,-2-1,4 3,0 0,0-1,0 1,0 0,1 0,-1 0,0 0,0 0,0 0,0 0,0 0,1 0,-1 0,0 1,0-1,0 0,0 1,1-1,-1 0,-1 1,1 0,0 1,0-1,-1 0,1 0,0 1,0-1,0 1,1-1,-1 1,0-1,0 1,1 0,-1 2,-1 5,0-1,0 1,1 0,1 0,-1 0,1-1,1 1,0 0,0 0,1 0,0-1,0 1,1-1,0 1,0-1,1 0,9 14,-9-17,0 0,0 0,0 0,1 0,0-1,0 1,0-1,0-1,0 1,1-1,0 0,0 0,0 0,0-1,0 0,0 0,1 0,-1-1,1 0,-1-1,1 1,-1-1,1 0,11-3,-11 2,0-1,-1 0,1-1,-1 1,1-1,-1-1,0 1,0-1,-1 0,1 0,-1-1,0 1,0-1,0-1,-1 1,0 0,0-1,0 0,0 0,-1 0,3-9,2-6,0-1,-2 0,0 0,-2-1,3-26,-6 34,-1 0,0 1,0-1,-2 1,0-1,0 1,-2-1,0 1,0 0,-1 1,-8-16,10 23,-1 0,1-1,-1 1,-1 1,1-1,-1 1,0-1,0 1,0 1,-1-1,0 1,0 0,0 0,0 0,-1 1,1 0,-1 1,0-1,0 1,0 1,0-1,0 1,0 0,-10 0,10 2,0-1,1 1,-1 1,0-1,0 1,1 0,-1 0,1 1,-1 0,1 0,0 1,0-1,1 1,-1 1,1-1,0 1,0 0,0 0,0 0,1 1,0-1,1 1,-1 0,1 1,0-1,-3 10,3-9,1 0,0 1,0 0,1-1,0 1,1 0,-1-1,1 1,1 0,0 0,0-1,0 1,1 0,0-1,0 0,1 1,0-1,0 0,1 0,0-1,0 1,1-1,7 9,-5-8,1-1,0 1,0-2,0 1,1-1,0-1,0 1,0-1,0-1,1 0,-1 0,1-1,0 0,-1-1,13 1,-14-2,0 0,0 0,0-1,0 0,0 0,-1-1,1 0,0 0,-1-1,0 0,1-1,-1 1,0-1,-1 0,1-1,-1 0,0 0,0 0,6-7,-6 3,1 1,-1-1,-1 0,0-1,0 0,-1 1,0-2,0 1,-1 0,-1-1,0 1,0-1,-1 1,0-20,-2 21,0 0,0-1,-1 1,0 0,-1 0,0 0,0 0,-1 0,0 1,0 0,-1 0,0 0,-1 0,0 1,0 0,-13-12,9 11,-1 0,1 0,-1 1,-1 0,-14-6,18 10,1 1,-1-1,1 1,-1 1,0-1,0 1,0 0,0 1,-13 1,18-1,0 1,0-1,1 1,-1 0,1 0,-1 0,1 0,-1 1,1-1,-1 0,1 1,0 0,0 0,0-1,0 1,0 0,0 0,1 1,-1-1,1 0,-1 1,1-1,0 1,0-1,0 1,0-1,1 1,-1 0,1-1,-1 1,1 0,0 4,0 0,0 0,0 0,1-1,0 1,0 0,1 0,0-1,0 1,0-1,1 0,0 1,5 6,0-3,0 0,1 0,1-1,0-1,0 1,0-2,1 1,0-1,20 9,-21-12,0 0,0 0,0-1,0 0,0-1,0 0,1-1,-1 0,1 0,0-1,-1-1,16-2,-21 2,-1 0,0 0,0-1,0 0,0 0,0 0,0 0,0 0,-1-1,1 0,-1 1,0-1,0-1,4-3,-3 1,0 0,-1 0,0 0,0-1,0 1,0-1,-1 0,1-7,0-8,0 0,-2 0,0 0,-4-34,-3 15,-2 0,-1 1,-2 0,-17-39,13 38,1-1,3 0,-10-63,18 69,1-62,3 83,0 1,1-1,1 1,0 0,1 0,0 0,9-16,-12 27,1 0,-1 0,1 0,0 0,0 0,0 0,1 1,-1-1,1 1,-1 0,1 0,0 0,0 0,0 0,0 0,0 1,0-1,1 1,-1 0,5-1,2 1,1 0,-1 1,1 1,-1-1,14 4,-10-2,0-1,25 0,-35-1,0-1,0 0,0 1,1-1,-1-1,0 1,-1 0,1-1,0 0,0 0,-1 0,1-1,4-3,1-3,0-1,-1 0,0 0,-1-1,0 0,-1-1,0 1,7-22,-2 3,-2-1,7-45,-12 53,-1-1,-2 0,0 0,-2 0,-5-40,3 50,1 1,-2 0,0 0,-1 0,0 0,0 1,-2 0,1 0,-2 0,0 1,-14-17,19 26,0-1,0 0,0 1,0-1,0 1,-1 0,-4-2,7 4,1-1,-1 1,0 0,0 0,0-1,0 1,1 0,-1 0,0 0,0 0,0 0,0 0,1 0,-1 0,0 0,0 1,0-1,0 0,1 0,-1 1,0-1,0 1,1-1,-1 1,0-1,1 1,-1-1,0 1,1-1,-1 1,1 0,-1-1,1 1,-1 0,1 0,0-1,-1 1,1 0,0 0,-1-1,1 1,0 1,-2 7,0 0,1 0,0 0,1 0,0 1,2 14,11 58,-8-59,1 0,0 0,17 36,-20-52,0-1,0 0,0 0,1 0,0 0,1-1,-1 0,1 0,0 0,0 0,0-1,1 1,0-1,0-1,0 1,13 4,-17-7,1 0,-1 0,1-1,-1 1,1-1,-1 1,1-1,-1 0,1 0,-1 0,1-1,-1 1,1 0,-1-1,1 0,-1 0,1 1,-1-1,0-1,1 1,-1 0,0-1,0 1,0-1,0 1,0-1,0 0,-1 0,1 0,0 0,-1 0,0 0,1-1,-1 1,0 0,0-1,1-4,0-1,1-1,-2-1,1 1,-1 0,-1 0,1 0,-2-1,1 1,-3-12,-1 1,-1 1,-1 0,-1 1,0 0,-2 0,0 0,0 1,-2 0,0 1,-1 0,-20-20,28 32,-1 0,1 1,-1 0,0-1,0 2,0-1,0 0,0 1,-6-2,9 4,-1-1,0 0,1 1,-1 0,0 0,1 0,-1 0,0 0,1 0,-1 1,1-1,-1 1,1 0,-1 0,1 0,-1 0,1 0,0 0,-1 1,1-1,0 1,-3 2,-4 6,0 0,0 1,1 1,1-1,0 1,0 0,1 1,1 0,0 0,0 0,-2 16,1-2,2 0,1 0,1 0,2 50,2-54,0 0,2 0,1 0,0-1,2 0,0 0,2 0,15 28,-19-41,1-1,-1 1,1-1,1 0,0-1,0 0,0 0,1 0,0-1,0 0,1 0,-1-1,1 0,1-1,-1 0,0 0,1-1,0 0,0-1,0 0,16 1,-14-3,0-1,0 0,0-1,0-1,0 1,0-2,-1 1,0-2,0 0,0 0,0-1,-1 0,0-1,14-11,1-3,-1-2,-1 0,-2-1,24-34,-27 32,-1-1,-1-1,-1 0,-2-1,-1-1,-1 0,-2 0,12-62,-19 72,0 0,-2-1,0 1,-1 0,-1 0,-6-31,4 36,-1 1,0 0,0 0,-2 1,1-1,-2 1,0 1,0 0,-17-19,16 22,1 1,-2 0,1 0,-1 1,0 0,-1 1,1 0,-1 1,-1 0,1 0,-1 1,1 1,-1 0,0 1,-14-1,17 2,1 1,-1 0,1 1,-1-1,0 2,1-1,0 1,-1 1,1 0,0 0,0 0,0 1,1 0,-1 1,1-1,0 2,0-1,1 1,0 0,0 0,0 0,-5 8,3-1,1-1,0 1,1 0,0 1,1 0,1 0,0 0,1 0,0 0,1 1,1-1,1 1,-1 0,4 20,0-15,0 0,1-1,1 0,1 0,0 0,2 0,0-1,1 0,1-1,12 17,-10-19,0 1,1-1,1-1,19 15,-26-24,0 1,1-1,0 0,0-1,0 0,1 0,-1-1,1 0,0-1,0 1,10 0,-14-3,-1 0,0 0,1 0,-1 0,0-1,1 1,-1-1,0-1,0 1,0 0,0-1,0 0,0 0,5-4,-3 2,-1 0,-1 0,1-1,-1 1,0-1,0-1,0 1,5-12,-2 4,-2-1,0 0,0 0,-2-1,0 0,0 1,0-27,-3 26,-2-1,1 0,-2 1,0-1,-1 1,-1 0,0 0,-1 0,0 1,-2 0,1 0,-2 1,0 0,0 0,-1 1,-1 0,-14-13,14 15,-1 0,0 0,-1 1,0 1,0 0,-1 0,1 1,-2 1,1 1,-1 0,0 1,0 0,0 1,0 1,-1 0,1 2,-27 1,35-1,1 1,-1 1,1-1,0 1,-1 0,1 1,0 0,0 0,1 0,-1 0,1 1,-1 0,1 0,0 0,1 1,-9 10,7-6,1 0,-1 0,2 0,0 1,0 0,0 0,1 0,1 0,0 0,-1 12,-2 35,3 0,8 83,-6-134,1 0,0-1,0 1,0-1,1 1,0-1,0 1,4 6,-5-11,0 1,0-1,0 1,0-1,1 1,-1-1,0 0,0 0,1 0,-1 0,1 0,-1 0,1 0,-1 0,1-1,0 1,-1 0,1-1,0 1,-1-1,1 0,0 0,0 0,-1 1,1-2,0 1,0 0,-1 0,1 0,0-1,3-1,1 0,1-2,-1 1,1-1,-1 0,-1 0,1 0,0-1,-1 0,0 0,6-8,2-4,0-2,12-21,-10 9,0 0,-3-1,0 0,-2-1,-2 0,6-40,-7 16,-2 0,-6-111,1 160,-1-1,0 1,0 0,-1 0,0 0,0 0,-1 1,0-1,-7-12,7 16,1 1,-1 0,0-1,0 1,0 1,-1-1,1 0,-1 1,1 0,-1-1,0 1,0 1,0-1,0 1,0-1,0 1,0 0,0 1,-1-1,-4 1,5-1,-1 1,0 1,1-1,-1 1,0 0,1 0,-1 0,0 0,1 1,0 0,-1 0,1 0,0 0,0 1,0 0,0 0,1 0,-1 0,1 0,0 1,0-1,0 1,0 0,1 0,-3 6,-3 5,1 1,0 1,2 0,0 0,-5 27,5-13,1 0,0 36,4-52,1 1,0-1,1 0,1 0,0 0,8 20,-10-31,1 0,0 0,0 0,0-1,1 1,-1-1,6 6,-7-8,-1 0,1-1,0 1,-1-1,1 1,0-1,0 1,0-1,-1 1,1-1,0 0,0 0,0 1,0-1,-1 0,1 0,0 0,0 0,0 0,0 0,0 0,0 0,0 0,-1 0,1-1,0 1,0 0,0 0,0-1,-1 1,1-1,0 1,0-1,-1 1,1-1,0 1,-1-1,1 0,0 1,-1-1,1 0,0-1,3-4,-1 0,0-1,0 1,0-1,-1 0,1 0,-2 0,1 0,-1 0,0 0,-1-1,0-10,-1-6,-1 0,-7-37,4 40,-1-1,0 1,-2 0,0 0,-1 1,-2 0,0 1,-19-27,20 35,1-1,-2 1,1 1,-2 0,1 0,-1 1,0 1,-1 0,0 1,-1 0,1 1,-1 0,-24-6,14 7,0 1,0 1,-48 0,57 3,0 1,0 1,0 0,1 1,-1 1,1 0,-25 12,36-15,1 0,-1 0,1 1,0-1,-1 1,1-1,0 1,0 0,0 0,0 0,0 0,1 0,-1 0,1 1,-1-1,1 1,0-1,0 1,0-1,0 1,0 0,0 2,1-1,0 0,1 0,-1-1,1 1,-1 0,1-1,0 1,1-1,-1 1,1-1,-1 0,1 0,0 1,0-1,5 5,-1-2,0-1,0 1,0-1,1 0,0-1,0 0,0 0,0 0,1-1,0 0,-1 0,1-1,15 3,2-2,1 0,-1-2,30-2,-47 1,0 0,-1-1,1 0,0-1,-1 0,1 0,-1 0,0-1,0 0,0 0,0-1,9-7,-10 6,-1 0,0 0,0-1,0 1,-1-1,0 0,0 0,-1-1,0 1,0-1,0 0,-1 0,3-11,-1-1,-2 0,0-1,-1 1,-1-1,0 0,-2 1,0-1,-2 1,0 0,-1 0,0 0,-2 1,0 0,-2 0,0 0,-13-18,7 12,-1 2,-1 0,-1 1,-1 0,-1 2,0 0,-2 2,0 0,-1 1,-48-24,58 34,0 1,0 0,0 1,0 1,-1 0,0 0,0 2,1 0,-1 0,0 1,0 1,-24 4,34-4,1 0,-1 1,1 0,0-1,-1 1,1 1,0-1,0 0,0 1,0-1,1 1,-1 0,1 0,0 0,0 0,0 0,0 1,-3 6,1 0,0-1,1 1,0 1,1-1,-3 18,4-15,1 1,1 0,0 0,1-1,0 1,1-1,0 0,1 1,1-1,0-1,1 1,0-1,1 0,0 0,1-1,12 14,-13-17,0-1,0 1,1-1,0-1,1 0,-1 0,1-1,0 0,1 0,-1-1,1 0,0-1,0 0,0 0,0-1,1-1,-1 0,0 0,1-1,-1 0,1-1,10-1,-8-2,0 1,0-2,-1 0,0 0,0-1,0 0,-1-1,0-1,0 0,-1 0,1-1,-2 0,0-1,0 0,-1-1,12-17,-9 10,-2 1,0-1,0-1,-2 1,0-2,-1 1,-1 0,-1-1,-1 0,1-28,-4 33,0 1,-2 0,1-1,-2 1,0 0,-1 0,0 0,-1 1,0-1,-1 1,-1 1,0-1,-10-13,5 11,0 1,-1 1,0 0,-1 0,-1 1,0 1,0 1,-1 0,-25-12,19 13,-1 0,1 2,-1 0,0 1,-1 2,0 0,-30 0,34 3,0 2,0 0,0 1,0 2,1-1,-1 2,1 1,-34 14,33-10,0 0,1 1,0 1,-31 26,43-32,1 1,-1 0,1 1,0-1,1 1,0 0,0 1,1-1,0 1,0 0,1 0,0 0,-3 17,5-16,0-1,0 1,0-1,2 1,-1-1,1 0,0 1,1-1,4 15,-4-21,-1 1,1-1,0 1,0-1,0 1,0-1,1 0,-1 0,1 0,0-1,0 1,0 0,0-1,0 0,1 0,-1 0,1 0,-1-1,1 1,0-1,-1 0,1 0,0 0,0 0,6 0,-1-1,0 0,-1-1,1 0,-1 0,1-1,0 0,-1-1,0 1,0-1,15-9,-14 7,1-1,-1 0,-1 0,1-1,-1 0,0-1,-1 1,10-14,-10 10,0 1,-1-1,0-1,0 1,-2-1,1 0,-1 0,-1-1,0 1,-1-1,-1 1,0-1,0 0,-1 0,-1 1,0-1,-1 0,0 1,-1-1,0 1,-1 0,0 0,-1 0,-1 1,0-1,0 1,-1 1,0-1,-1 1,0 0,-1 1,-15-13,5 7,-1 2,0 0,-1 1,-1 1,0 1,0 1,-1 1,0 1,0 0,-1 2,1 1,-1 1,0 1,-43 3,56 0,0 0,0 1,1 1,-1 0,1 1,-1 0,1 0,0 1,1 0,-17 12,14-7,0 0,1 1,0 0,0 1,2 0,-1 1,-6 13,2-1,2 1,1 0,1 0,1 1,1 0,1 0,2 1,-2 29,6-50,1 0,-1 1,2-1,-1 0,1 0,0 0,0 1,1-1,0 0,3 6,-4-10,1 0,-1-1,1 0,0 1,0-1,0 0,0 0,0 0,1 0,-1 0,0 0,1-1,-1 1,1-1,0 0,0 1,-1-1,1-1,0 1,0 0,0-1,0 1,0-1,0 0,0 0,5-1,-3 1,-1-1,1 0,-1 0,0 0,1-1,-1 0,0 1,0-1,0-1,0 1,0-1,-1 1,1-1,-1 0,0 0,1-1,-1 1,-1-1,1 0,0 1,3-9,1-3,0 0,-2 0,1 0,5-29,-8 26,0 0,-1 0,-1 0,0 0,-2-1,0 1,-1 0,-5-23,5 32,-1 1,1-1,-2 1,1-1,-1 1,-1 0,1 0,-1 1,-1-1,1 1,-1 0,0 1,-1-1,0 1,0 1,0-1,-1 1,-13-7,7 6,-1 1,-1 0,1 1,-1 1,1 0,-1 1,0 1,0 0,0 2,0-1,-16 4,5 1,0 0,1 2,0 1,0 0,-42 22,51-21,0 1,1 1,0 0,1 1,0 1,1 1,-22 26,29-32,0 1,1 0,0 1,1 0,0-1,1 1,0 1,0-1,1 1,1 0,-1-1,2 1,-1 0,2 0,0 13,0-19,1 0,0 0,0-1,1 1,-1 0,1 0,0-1,0 1,1-1,-1 0,1 1,0-1,0 0,0-1,1 1,-1-1,1 1,0-1,0 0,0 0,0-1,1 1,-1-1,1 0,-1 0,1 0,6 0,0 1,-1-1,1 0,0-1,-1 0,1-1,0 0,0-1,0 0,0 0,-1-2,18-4,-11-1,0 1,0-2,-1 0,0-1,-1-1,0 0,-1-1,0-1,18-22,-12 11,-1-2,-1 0,-1-1,24-52,-35 65,0-1,-1 1,-1-1,0 0,-1 0,2-29,-5 37,0 0,0 0,-1 0,0 0,0 0,-1 0,0 0,0 1,0-1,-1 1,0-1,0 1,0 0,-1 0,0 0,-1 1,-6-8,0 4,-1 0,0 1,0 0,0 1,-1 1,0 0,0 1,0 0,-1 1,-26-5,0 3,0 1,-67 2,41 6,1 3,1 3,-1 3,2 2,0 3,0 3,-89 42,128-51,1 1,-1 1,2 1,-25 20,41-29,0 1,0 0,0 1,1-1,0 1,0 0,-5 11,8-13,0 0,0 0,0 0,1 0,0 1,0-1,0 0,1 1,0-1,0 0,0 1,2 9,-1-12,0 1,1-1,-1 0,1 0,-1 0,1 0,0 0,0 0,0 0,1-1,-1 1,0-1,1 0,0 1,0-1,0-1,0 1,0 0,0-1,0 1,0-1,0 0,1 0,5 1,8 1,0 0,1-1,24 0,-42-2,18-1,0 0,0-1,0-1,0-1,-1 0,1-1,-1-1,0-1,-1 0,0-1,0-1,-1-1,0 0,0 0,-1-2,-1 0,0 0,20-26,-29 32,1 0,-2 0,1 0,0 0,-1-1,-1 0,1 0,-1 1,0-1,0-1,-1 1,0 0,0-9,-1 11,-1 0,0 0,1 0,-2 1,1-1,0 0,-1 0,0 1,0-1,-1 1,1-1,-1 1,0 0,0 0,0 0,-1 1,1-1,-1 1,-6-5,-2 0,-1 1,1 0,-1 1,-1 1,1 0,-1 1,0 0,0 1,-22-2,-14 0,-66 4,76 2,1 3,0 1,0 1,0 3,0 1,-66 27,82-27,0 1,0 1,1 1,1 1,0 1,1 1,0 1,2 0,0 1,1 1,-24 35,36-45,0 0,1 1,0-1,0 1,1 0,1 0,-1 1,0 14,3-20,0-1,0 1,0-1,0 1,1-1,0 1,0-1,0 1,3 6,-3-9,0 0,1 0,-1 1,1-1,-1-1,1 1,0 0,-1 0,1-1,0 1,0-1,0 1,0-1,1 0,-1 0,0 0,0 0,4 1,-4-2,0 1,0-1,-1 0,1 0,0 0,0 0,-1 0,1-1,0 1,0 0,-1-1,1 1,0-1,-1 0,1 0,0 1,-1-1,1 0,-1 0,0-1,1 1,-1 0,0 0,0-1,1 1,-1 0,0-1,0 1,-1-1,1 0,0 1,0-1,0-2,1-3,0 1,0-1,0 0,-1 1,0-1,0 0,-1-11,-1 8,-1 1,0-1,-1 1,0-1,0 1,-1 0,0 1,-1-1,0 1,0-1,0 2,-1-1,-13-12,3 4,-1 0,-1 1,-1 2,-34-21,26 20,0 2,-2 0,1 2,-1 1,-1 1,1 2,-39-4,17 6,0 2,0 3,-79 10,74-2,1 3,0 2,0 2,2 3,-99 49,111-46,2 2,0 1,2 2,0 2,2 1,2 2,-51 61,76-82,-1 1,1 0,1 1,0 0,1 0,1 0,0 1,-4 18,7-25,1 1,0-1,0 1,1-1,0 1,1-1,-1 1,2-1,-1 0,1 1,0-1,0 0,1 0,0 0,0 0,1-1,6 10,0-3,1-1,0-1,1 0,0 0,1-1,0-1,0 0,1-1,0-1,1 0,18 6,5 0,1-2,0-1,53 5,-42-9,84-1,-103-7,1 0,0-2,60-16,-76 15,0-1,0 0,0-2,-1 1,0-2,0 0,-1-1,19-16,-23 17,-1-1,0-1,0 1,-1-2,-1 1,0-1,0 0,-1 0,-1-1,0 0,6-23,-9 24,1 0,-2 0,1 0,-2-1,1 1,-2 0,0 0,0 0,-1 0,0 0,-1 0,-1 0,0 1,0 0,-1-1,-1 2,0-1,0 1,-1-1,0 2,-1-1,0 1,0 0,-1 1,0 0,-1 0,0 1,0 1,0-1,-1 2,0-1,-20-6,17 8,-1 1,1 1,0 0,-1 0,1 2,-1 0,1 0,-1 2,1-1,0 2,0 0,0 1,0 0,0 1,1 1,-1 0,-12 8,-3 4,1 1,1 1,0 1,2 2,0 0,-24 31,33-35,1 1,1 0,1 1,1 1,1-1,0 2,2 0,-8 26,14-36,1-1,0 1,1-1,0 1,0 0,2-1,2 21,-1-23,0-1,1 0,0 0,0 0,1 0,0-1,0 0,1 0,1 0,-1 0,8 8,-4-8,0 0,1 0,-1-1,1-1,1 0,-1 0,1-1,0 0,0-1,0 0,1 0,0-2,-1 1,18 0,-17-2,0 0,0-1,0 0,0-1,0 0,0-1,0-1,-1 0,1 0,-1-1,0 0,0-1,0-1,14-9,-12 5,0-1,-1-1,-1 0,0-1,-1 0,0-1,-1 0,0 0,-1-1,-1 0,0-1,-1 0,-1 0,0 0,3-27,-5 24,-1 0,-1 0,-1 0,0-1,-2 1,0 0,-1 0,-1 0,0 0,-2 1,0 0,-1 0,-14-24,14 30,-1 0,-1 0,0 1,0 0,-1 1,0 0,-1 1,0 0,-20-12,13 11,0 1,-1 0,0 2,-1 0,0 1,-21-4,4 5,0 1,0 1,-1 3,1 1,0 1,-70 15,78-11,0 2,1 1,0 1,0 1,1 2,1 0,0 2,-24 19,36-23,0 0,1 0,1 2,0 0,1 0,0 1,1 0,1 1,0 0,1 0,0 1,2 0,-1 1,-6 30,11-35,0 0,1 1,0-1,0 0,2 1,-1-1,2 0,0 1,0-1,1 0,0 0,1-1,1 1,0-1,0 0,1 0,0 0,1-1,0 0,1 0,0-1,1 0,0 0,18 13,-7-9,1 0,0-1,0-2,1 0,1-1,37 10,-6-7,100 10,-95-18,0-2,0-2,0-3,69-13,-100 12,0-2,-1-2,0 0,0-2,-1-1,0 0,-1-3,0 0,-1-1,39-32,-49 34,-1-1,0 0,-1-1,-1 0,0-1,-1 0,-1 0,0-1,-2 0,9-27,-12 30,-1 0,0 0,-1-1,-1 1,0 0,-1-1,0 1,-2 0,1-1,-2 1,0 0,0 0,-2 0,-6-16,4 15,-1 0,0 0,-1 1,0 0,-2 1,1 0,-1 1,-1 0,0 0,-1 1,0 1,-1 0,0 1,0 1,-1 0,0 1,-1 0,1 1,-1 1,0 1,-19-3,-31-1,-1 2,0 4,-127 12,189-9,0-1,0 1,0 0,0 1,1-1,-1 1,1 0,-1 0,1 0,0 1,0 0,0-1,0 2,0-1,-3 4,3-2,0 0,1 0,-1 0,1 1,0-1,1 1,-1 0,1 0,0 0,1 0,-2 7,1 1,0 0,1-1,0 1,1 0,2 15,-1-23,0 0,1 0,-1 0,1 0,1 0,-1-1,1 1,0-1,0 1,0-1,1 0,0 0,7 7,-6-8,0 0,0 0,1 0,-1-1,1 0,0 0,0 0,0-1,0 0,0 0,0 0,1-1,-1 0,0 0,1 0,-1-1,1 0,-1-1,1 1,-1-1,1 0,-1-1,0 0,0 0,0 0,0 0,0-1,0 0,-1-1,1 1,-1-1,0 0,0 0,0-1,-1 1,1-1,-1 0,0 0,-1-1,1 1,-1-1,0 1,0-1,2-9,-3 6,1 0,-2-1,1 1,-2-1,1 1,-1-1,0 1,-1-1,0 0,-1 1,0 0,0-1,-1 1,-1 0,1 0,-1 1,-1-1,-6-9,5 7,-2 1,1 0,-1 1,0 0,-1 0,0 0,-1 1,0 1,0 0,0 0,-1 1,0 0,-22-8,14 10,0 1,-1 1,1 0,0 2,-1 0,-21 3,-20 0,54-3,0 0,-1 1,1 0,0 0,0 0,0 1,0 0,1 1,-10 4,13-5,0-1,0 2,0-1,0 0,0 0,1 1,-1 0,1-1,0 1,0 0,0 0,0 1,0-1,0 0,1 0,0 1,-1-1,1 1,1-1,-2 5,2-7,0 1,-1-1,1 0,0 0,0 1,0-1,0 0,0 0,0 1,0-1,0 0,1 0,-1 1,0-1,1 0,-1 0,1 0,-1 0,1 0,0 1,-1-1,1 0,0 0,0-1,0 1,0 0,0 0,0 0,0-1,0 1,0 0,0-1,0 1,0-1,0 1,1-1,-1 1,2-1,0 0,0 0,0 0,0 0,0 0,-1-1,1 1,0-1,0 0,0 0,0 0,-1 0,1 0,0-1,-1 1,4-3,6-7,-1 1,-1-2,0 1,0-2,-1 1,-1-1,0 0,-1-1,0 0,-1 0,0 0,-2-1,1 0,-2 0,0 0,1-31,-3 43,-1 0,0 1,-1-1,1 0,0 0,-1 1,0-1,1 0,-1 1,0-1,0 1,-1-1,1 1,-1-1,1 1,-1 0,1 0,-1-1,0 1,-4-2,3 2,0 0,0 0,-1 0,1 1,0 0,-1 0,1 0,-1 0,1 0,-1 1,0-1,1 1,-1 0,-4 0,3 1,1-1,0 1,-1-1,1 1,0 0,0 1,0-1,0 1,0 0,0 0,0 0,0 0,1 1,-1-1,1 1,0 0,0 0,0 0,0 1,0-1,1 1,-1 0,1-1,0 1,0 0,1 0,-2 5,1 2,0 0,1 0,0 1,1-1,0 0,1 0,1 0,-1 0,5 12,-6-21,1-1,0 1,0 0,0 0,0-1,0 1,1-1,-1 1,0-1,1 1,-1-1,1 0,0 0,-1 0,1 0,0 0,0 0,-1 0,1 0,0-1,0 1,0-1,0 1,0-1,0 0,0 0,0 0,0 0,0 0,0 0,0-1,3 0,0 0,0-1,0 0,0 0,0 0,-1 0,1-1,-1 0,1 0,-1 0,0 0,4-5,-4 4,-1 0,0 0,0-1,-1 1,1-1,-1 1,3-7,-5 9,1-1,0 1,0-1,-1 1,0-1,1 1,-1-1,0 0,0 1,0-1,-1 1,1-1,-1 0,1 1,-1-1,-1-2,2 5,0 0,0-1,0 1,0-1,0 1,-1-1,1 1,0-1,0 1,0-1,-1 1,1 0,0-1,-1 1,1 0,0-1,-1 1,1 0,0-1,-1 1,1 0,-1 0,1-1,-1 1,1 0,0 0,-1 0,1-1,-1 1,1 0,-1 0,1 0,-1 0,1 0,-1 0,1 0,-1 0,1 0,-1 1,1-1,-1 0,1 0,0 0,-1 0,1 1,-1-1,1 0,-1 0,1 1,0-1,-1 0,1 1,0-1,-1 0,1 1,0-1,0 1,-1-1,1 0,0 1,0-1,-1 1,-1 3,0 0,1 0,-1-1,0 1,-1 8,1-2,1-1,0 1,0 0,1-1,0 1,1 0,3 14,-3-19,0-1,1 1,0-1,0 1,1-1,-1 0,1 0,0 0,0 0,0 0,0 0,1-1,-1 0,1 0,0 0,8 5,12 4,-1-1,2-1,-1-1,1-1,1-1,-1-1,1-1,0-2,0-1,1 0,-1-2,0-1,0-2,0 0,38-10,-38 6,0 0,-1-2,0-1,0-1,-1-1,0-1,-1-1,-1-1,0-1,-1-1,-1-1,0-1,-2 0,32-44,-44 55,-1-1,0 0,-1 1,0-1,-1-1,5-17,-7 24,-1 1,1-1,-1 0,0 0,0 1,0-1,0 0,0 0,-1 0,1 1,-1-1,1 0,-1 1,0-1,0 1,-1-1,1 1,0-1,-1 1,1 0,-1-1,0 1,0 0,0 0,0 1,0-1,0 0,-4-1,-4-2,0 1,0 0,-1 0,1 2,-1-1,0 1,0 1,-22-1,-1 2,-52 8,59-4,0 1,0 1,1 2,0 0,1 2,-1 0,2 2,0 1,-25 17,16-9,23-16,1 1,-16 12,22-16,1 1,0-1,-1 1,1-1,0 1,0 0,1 0,-1 0,1 0,-1 0,1 0,0 0,-1 5,1-3,0 0,1 0,-1 0,1 0,0 0,0 0,1 0,-1 0,1 0,0 0,1-1,-1 1,1 0,0-1,0 1,0-1,1 0,4 7,-3-7,0 0,0 0,0-1,1 1,-1-1,1 0,0 0,0-1,0 0,0 1,1-2,-1 1,0 0,1-1,-1 0,8 0,-10-1,1 1,0-1,0 0,-1 0,1-1,0 1,-1-1,1 0,-1 0,1 0,-1 0,1-1,-1 1,0-1,1 0,-1 0,4-4,-4 3,0 0,0-1,0 1,-1-1,1 0,-1 0,0 0,0 0,-1-1,1 1,-1 0,0-1,0 1,0-7,0 4,-1 0,0 0,0 0,0 0,-1 0,0 0,-1 0,-3-9,4 12,0 1,-1-1,1 1,-1 0,0-1,0 1,0 0,-1 0,1 1,-1-1,1 0,-1 1,0-1,0 1,0 0,-1 0,1 0,-4-1,-5-1,0 1,0 0,-1 1,1 1,-16-1,-67 5,51-1,26-2,0 1,0 1,0 1,-21 6,34-8,0 1,0 0,0 0,0 0,1 0,-1 1,1 0,-1 0,1 0,0 1,0-1,0 1,1 0,-1 0,1 0,0 1,0-1,-3 9,1-2,1 1,0-1,1 0,0 1,1 0,0 0,1 0,0 17,1-23,1-1,0 1,0-1,1 1,0-1,0 1,0-1,0 0,1 0,0 0,0 0,1 0,-1-1,1 1,0-1,0 0,0 0,0-1,8 6,-3-4,0 0,0 0,0-1,1 0,-1-1,1 0,0 0,17 2,-20-5,-1 1,1-1,-1 0,1 0,-1 0,1-1,-1 0,1-1,-1 1,0-1,0 0,0-1,0 1,9-6,-15 7,1 1,0 0,0-1,-1 1,1-1,0 1,-1-1,1 1,0-1,-1 0,1 1,-1-1,1 0,-1 1,1-1,-1 0,0 0,1 1,-1-1,0 0,0 0,1 0,-1 1,0-1,0 0,0 0,0 0,0 0,0 0,-1-1,0 1,0 0,0 0,0 0,0 0,0 0,0 0,0 0,0 0,0 0,-1 0,1 1,0-1,-3 0,-7-3,-1 0,1 1,-13-1,-7 0,0 2,-1 1,1 2,-1 1,1 1,0 1,0 2,0 2,1 0,-44 20,49-18,0-1,0-1,-1-1,-45 6,70-13,0 0,-1 0,1 0,0 0,0 1,0-1,-1 0,1 1,0-1,0 1,0-1,0 1,0 0,0-1,0 1,0 0,0 0,0 0,0 0,0 0,0 0,1 0,-1 0,0 0,1 0,-1 0,1 0,-1 0,1 0,0 1,-1-1,1 0,0 0,0 1,0-1,0 0,0 0,0 2,1 5,1 0,-1-1,1 1,6 14,-6-17,2 4,20 51,-21-54,0 0,1 0,-1-1,1 1,0-1,1 0,5 6,-10-11,0 0,0 1,1-1,-1 0,0 1,0-1,1 0,-1 0,0 1,1-1,-1 0,0 0,1 0,-1 1,0-1,1 0,-1 0,0 0,1 0,-1 0,1 0,-1 0,0 0,1 0,-1 0,1 0,-1 0,0 0,1 0,-1 0,0 0,1 0,-1-1,0 1,1 0,-1 0,0 0,1-1,-1 1,0 0,1 0,-1-1,0 1,0 0,1 0,-1-1,0 1,0 0,0-1,1 1,-1-1,0 0,1-1,-1 1,0-1,1 1,-1-1,0 0,0 1,0-1,0 1,-1-1,1 1,-1-3,-1 0,0 0,0 0,0 0,-1 0,1 0,-1 0,0 1,-1-1,1 1,0 0,-1 0,0 0,0 1,0-1,0 1,0 0,0 0,-8-2,-3-1,0 1,0 0,-1 1,-20-1,24 3,0 1,0 0,0 1,0 0,0 1,1 1,-1 0,1 0,-1 1,1 0,0 1,-14 9,19-11,1 1,-1 0,1 0,0 0,1 1,-1 0,1 0,0 0,0 0,0 1,1-1,-1 1,2 0,-1 0,1 0,-1 0,2 1,-1-1,1 1,0-1,0 1,1-1,0 13,1-16,-1 0,1 0,0 0,0 0,0 0,0 0,0 0,1-1,-1 1,1 0,0-1,0 0,0 1,0-1,0 0,0 0,1 0,-1 0,1 0,-1-1,1 1,4 1,7 3,0 0,1-1,20 4,-4-1,0 4,-1 2,0 0,-1 2,51 39,-66-46,31 24,-1 2,-2 2,-2 2,-1 2,42 56,-12-11,4-3,3-3,4-4,3-3,3-3,3-5,3-4,185 93,-117-83,4-6,3-8,1-7,323 51,-446-94,-1-2,89-2,-125-3,-1-1,0 0,0 0,0-1,0 0,0 0,12-6,-16 6,0 0,-1 0,1 0,-1 0,1 0,-1 0,0-1,0 1,0-1,0 0,0 0,0 1,-1-1,1 0,-1 0,0 0,0-1,1-4,0-6,-1 0,0 0,-1 0,0 0,-1 0,-1 0,0 1,-1-1,0 0,-6-14,2 9,-1 0,-1 1,-1 0,0 0,-2 1,-16-20,8 14,-1 2,-1 0,-1 1,-1 2,0 0,-2 2,0 0,0 2,-2 1,1 1,-2 1,1 2,-1 1,-1 1,1 1,-1 2,0 1,0 1,-60 5,43 3,-1 3,1 2,1 1,0 3,-65 30,23-2,-138 92,139-77,2 4,-141 136,209-181,1 0,1 2,0 0,1 0,-22 43,34-58,0 1,0-1,0 1,1-1,0 1,0 0,0 0,0-1,1 1,0 0,0 0,0 0,1 0,-1-1,1 1,0 0,3 6,-1-5,0-1,0 1,1-1,0 0,0 0,1 0,-1 0,1-1,0 0,0 0,1 0,-1-1,7 4,10 4,-1-1,2 0,45 11,86 9,82-8,-59-19,260-27,171-74,-361 40,-166 36,0-2,85-40,-145 54,30-19,-46 26,0-1,0 0,0 0,0-1,-1 1,0-1,0 0,0 0,5-8,-9 12,1-1,0 1,0-1,-1 1,1-1,-1 0,0 1,1-1,-1 0,0 1,0-1,0 0,0 1,0-1,0 0,-1 1,1-1,0 0,-1 1,1-1,-1 1,0-1,0 1,1-1,-3-1,0-1,0 1,-1-1,1 1,-1 0,0 0,0 0,-9-4,-2 0,0 0,-1 1,0 1,-29-6,-77-6,-2 8,0 5,-1 6,1 5,1 5,0 6,0 5,2 6,2 4,-174 74,230-78,1 2,-92 62,126-74,2 2,0 1,2 0,0 2,2 1,1 1,-24 36,37-50,1 1,1-1,0 1,1 0,0 1,1 0,0-1,1 1,1 0,0 0,1 23,1-28,1 0,1 0,-1 0,2 0,-1 0,1-1,0 1,1-1,0 0,1 0,-1 0,1 0,1-1,0 0,0 0,0 0,1-1,-1 0,11 6,0-1,-1-2,2 0,-1 0,1-2,1 0,-1-2,1 0,0 0,0-2,0-1,22 1,8-2,0-3,1-1,61-14,-49 4,-1-2,-1-3,-1-3,-1-2,-1-3,-1-2,57-38,-73 39,-1-2,-1-1,-2-2,-1-1,-2-2,-1-1,-1-2,-3-1,43-77,-57 88,-1 0,-2-1,-1-1,-1 0,-1-1,-2 1,-1-1,-2 0,-1-1,-1 1,-2 0,-1-1,-1 1,-2 0,-1 1,-2-1,0 1,-21-45,11 36,-2 1,-2 0,-1 2,-1 1,-3 1,0 1,-2 1,-2 2,-1 1,-65-46,67 55,0 2,-2 1,0 1,0 2,-1 1,-1 2,0 1,-1 2,0 1,0 2,0 1,-1 2,-57 4,47 4,0 2,0 2,1 2,0 1,1 3,1 2,1 1,-45 29,39-18,1 2,1 2,2 1,2 3,1 2,-46 59,66-73,2 2,0 1,2 0,2 1,0 1,2 0,-15 56,23-70,2 1,0 0,0 0,2 0,0 1,2-1,0 0,0 0,2 0,0 0,1 0,1-1,1 1,0-1,17 30,-9-26,0 0,2-1,1-1,0 0,1-2,1 0,0-1,2 0,-1-2,2-1,0 0,1-2,37 14,-18-10,1-3,1-1,-1-2,2-2,-1-2,86-2,-79-6,-1-2,1-2,-1-3,0-1,-1-3,0-2,-2-2,0-2,80-48,-81 39,-1-3,-1-1,-2-3,-2-1,-1-2,-1-1,-3-2,-2-2,29-48,-30 37,-3-2,-3-1,-2-1,-2-1,-3-1,17-98,-28 109,-2-1,-3 0,-1 0,-3 0,-2 0,-3 1,-1-1,-23-80,20 99,-2 1,-1 0,-1 1,-2 0,-1 1,-1 1,-1 0,-2 2,-37-38,43 50,-1 0,0 1,-1 1,0 0,-1 2,0 0,-1 1,0 1,0 0,-1 1,0 2,0 0,-1 1,1 1,-1 1,-29 0,32 3,1 1,-1 0,0 1,1 1,0 1,-1 0,2 1,-1 1,1 1,0 0,1 1,-16 11,19-10,0 0,1 0,0 1,1 0,0 1,1 0,1 1,0-1,0 2,1-1,1 1,0 0,1 1,-5 23,6-19,1 1,1 0,1 0,1 0,1 0,1-1,5 30,0-21,1 0,1-1,1 0,24 43,-9-28,2-1,1-1,2-1,2-2,70 63,-48-56,1-2,3-2,93 48,-40-35,133 46,-111-54,1-6,3-5,0-7,2-5,197 5,-295-27,65-7,-101 7,0-1,0-1,-1 1,1-1,-1 0,1 0,-1 0,1 0,-1-1,0 0,4-3,19-12,-16 14,0 1,0-1,0 2,0 0,0 0,1 1,-1 1,21 1,-8-1,24 0,65 7,-98-5,0 0,-1 1,1 1,-1 1,0 0,0 0,0 2,21 12,-31-16,1 1,-1-1,0 1,0 0,0 0,-1 0,1 1,-1-1,0 1,0 0,0 0,-1 0,0 0,0 0,0 0,-1 1,1-1,-1 1,-1-1,1 1,-1-1,0 1,0 0,-1-1,0 8,-5 10,0 0,-1-1,-1 1,-19 34,10-19,10-22,1 0,0 0,1 0,1 0,1 1,-3 26,6-34,0 0,1 0,0 0,0-1,1 1,0 0,0-1,1 1,0-1,1 0,0 0,0 0,1-1,8 12,-3-8,1 1,0-2,0 0,2 0,-1-1,1 0,0-1,0-1,1 0,0-1,1 0,-1-1,1-1,19 3,21 2,0-3,88-2,-137-4,-2 0,6 1,-1-1,1 0,0-1,-1 0,1-1,14-4,-57 54,5-8,2 0,-31 68,48-87,1 0,1 0,0 1,2 0,1 0,1 0,-1 42,4-50,-1-5,1 0,1 0,-1 0,2 0,-1 0,4 12,2-12,-3-15,-2-18,-5 8,-2 0,0 1,0-1,-1 1,-1 1,-1-1,-14-20,21 33,-1 0,0-1,0 1,0 0,0 0,0 0,0 0,0 1,-1-1,1 0,-1 1,1 0,-1-1,1 1,-1 0,0 1,0-1,0 0,1 1,-1-1,0 1,0 0,0 0,0 0,0 1,1-1,-1 0,0 1,0 0,0 0,1 0,-1 0,0 0,1 0,-1 1,1 0,0-1,-1 1,1 0,0 0,0 0,0 0,0 0,1 0,-1 1,-2 4,-4 9,0 0,1 1,0 0,2 0,0 1,1 0,1 0,0 0,0 34,4-47,-1 0,0 0,1-1,0 1,0 0,1 0,-1-1,1 1,0-1,0 1,1-1,-1 0,1 0,0 0,0 0,0 0,4 3,-4-4,0-1,0 0,0 0,1 0,-1 0,0 0,1-1,-1 1,1-1,-1 0,1 0,0 0,0-1,-1 1,1-1,0 0,0 0,-1 0,1-1,0 1,0-1,-1 0,5-2,-2 1,0-1,0 0,0-1,0 0,-1 1,0-2,1 1,-2-1,1 0,0 0,-1 0,0 0,0-1,-1 0,0 1,0-1,0-1,3-10,0-2,-1 0,-1 0,0-1,-2 0,1-22,-3 31,0 0,0 0,-1 1,0-1,-1 0,-1 1,-5-19,6 25,0 0,0 0,-1 0,1 0,-1 0,0 1,0-1,0 1,0 0,0 0,-1 0,0 0,1 1,-1-1,0 1,0 0,-1 0,1 1,0-1,-8-1,6 2,1 0,0 1,0-1,0 1,-1 0,1 1,0-1,0 1,0 0,-1 0,1 1,0-1,1 1,-1 1,0-1,-7 5,10-5,-1 0,0 0,1 0,-1 0,1 1,0-1,0 1,0 0,0 0,0 0,1 0,-1 0,1 0,0 0,0 0,0 0,0 0,0 1,1-1,0 0,-1 1,1-1,1 1,-1-1,0 0,2 7,-1-8,0 1,0 0,0-1,0 1,1-1,-1 1,1-1,-1 0,1 0,0 1,0-1,0 0,0-1,0 1,1 0,-1-1,0 1,1-1,0 0,-1 1,1-1,-1-1,1 1,0 0,0-1,4 1,-4 0,0-1,-1 0,1 0,0 0,-1-1,1 1,-1-1,1 1,0-1,-1 0,1 0,-1 0,0 0,1 0,-1 0,0-1,0 1,0-1,0 0,0 0,0 0,0 0,0 0,-1 0,1 0,-1 0,0 0,2-4,0-8,0 1,0-1,-2 1,1-1,-2 0,0 0,-3-22,1-31,2 65,0 0,0 0,0 0,0 0,0 1,1-1,-1 0,1 0,-1 0,1 0,0 0,0 0,0 1,0-1,0 0,0 1,0-1,1 1,-1-1,2-1,-1 3,-1-1,1 0,0 1,0-1,0 1,-1-1,1 1,0 0,0 0,0 0,0 0,-1 0,1 0,0 0,0 1,0-1,2 1,6 3,0 1,0-1,0 2,-1-1,15 12,-20-14,1 0,0 1,0-2,0 1,0-1,7 3,-11-5,-1 0,1 0,0 1,0-1,-1 0,1 0,0 0,0 0,0 0,-1 0,1 0,0-1,0 1,-1 0,1 0,0-1,0 1,-1 0,1-1,1 0,-1 0,-1 0,1 0,-1 0,1 0,-1 0,1 0,-1 0,1-1,-1 1,0 0,0 0,0 0,0-1,0 1,0 0,0 0,0 0,0-3,-2-7,-1 0,0 0,0 0,-1 0,-7-14,8 18,0 1,0 0,-1 1,0-1,0 1,0-1,-1 1,0 0,0 1,-6-6,10 10,1 0,-1-1,1 1,-1-1,1 1,-1 0,1-1,-1 1,0 0,1 0,-1 0,0-1,1 1,-1 0,0 0,1 0,-1 0,0 0,1 0,-1 0,1 0,-1 1,0-1,1 0,-1 0,0 0,1 1,-1-1,0 1,0 0,1 0,-1 0,0 0,1 0,-1 0,1 0,-1 0,1 0,0 1,-1-1,1 0,0 0,0 0,0 2,0 2,0 0,0 0,1 0,0-1,0 1,0 0,2 4,-1-6,-1 0,1 0,0 0,0-1,0 1,1-1,-1 1,0-1,1 0,0 0,-1 0,1 0,0 0,0-1,4 2,-5-2,0-1,0 1,0-1,0 0,1 0,-1 1,0-1,0-1,0 1,0 0,0 0,1-1,-1 0,0 1,0-1,0 0,0 0,0 0,-1 0,1 0,0 0,0-1,-1 1,1 0,1-3,5-6,0 0,-1 0,0-1,0 0,-1 0,-1-1,0 0,4-15,-2 2,-1-1,-1 1,2-29,-6 44,-1 0,0 0,-1-1,0 1,0 0,-6-17,7 25,-1 0,0 1,1-1,-1 1,0-1,0 0,0 1,0-1,0 1,0 0,0-1,-1 1,1 0,-1 0,1 0,0 0,-1 0,-1-1,1 2,0-1,0 1,0 0,0 0,0 0,0 0,0 1,0-1,0 1,0-1,0 1,0-1,0 1,1 0,-1 0,0 0,1 0,-1 0,0 0,-2 3,2-1,-1 0,0 0,1 0,-1 0,1 0,0 0,0 1,0 0,1-1,-1 1,1 0,0-1,0 1,0 0,0 0,0 5,1 3,-1 0,1-1,1 1,3 14,-3-20,0 0,1-1,-1 1,1-1,1 1,-1-1,1 0,0 0,0 0,1 0,-1-1,1 1,0-1,5 4,-7-5,1-1,0 0,0 0,0-1,0 1,0-1,1 1,-1-1,0 0,1 0,-1 0,1-1,-1 1,0-1,1 0,-1 0,1 0,-1-1,1 1,-1-1,1 1,-1-1,0 0,6-3,-7 3,0 0,0 0,0 0,0-1,0 1,0-1,0 1,-1-1,1 0,-1 0,1 0,-1 0,0 0,1 0,-1 0,0 0,0 0,0-3,1-3,0 0,-1 0,0 1,-1-10,1-3,9 50,-3-2,21 49,-21-59,-6-17,0 1,0 0,-1-1,1 1,-1 0,1 0,-1-1,0 1,1 0,-1 0,0 0,0-1,0 1,-1 0,1 0,0 0,-1-1,1 1,-1 0,0 0,1-1,-1 1,0 0,0-1,0 1,0-1,0 1,-1-1,-1 2,-7 11,8-11,0-1,1 1,-1 0,1 0,0 0,0 1,0-1,0 0,1 0,-1 1,1-1,0 0,0 0,0 1,0-1,1 0,-1 0,1 1,0-1,0 0,0 0,0 0,1 0,-1 0,1 0,-1 0,1 0,0-1,0 1,3 2,-4-5,-1 0,1 1,-1-1,1 1,-1-1,1 0,-1 1,1-1,-1 0,1 0,0 1,-1-1,1 0,-1 0,1 0,0 0,-1 0,1 0,0 0,-1 0,1 0,-1 0,1 0,0 0,-1-1,1 1,-1 0,1 0,0-1,0 1,0-2,0 1,0 0,0 0,0-1,0 1,0-1,0 1,0-1,-1 1,1-1,0-2,1-4,0 1,-1-1,1-16,-2 11,-1-1,0 1,-2 0,1 0,-1-1,-1 2,0-1,-1 0,-13-23,17 34,-1 0,1 1,0-1,-1 0,0 0,1 1,-1-1,0 1,0-1,0 1,0 0,0 0,0-1,0 2,-1-1,1 0,0 0,-1 1,1-1,0 1,-1 0,1 0,0-1,-1 2,1-1,0 0,-1 0,1 1,-4 1,-1 0,1 1,-1 0,1 0,0 0,0 1,0 0,1 0,-8 8,12-11,-1 0,1 1,0-1,0 0,0 0,-1 0,1 0,-1-1,1 1,0 0,-1 0,0-1,1 1,-1-1,1 1,-1-1,0 0,1 0,-1 0,1 0,-1 0,-3 0,3-1,0 0,0-1,0 1,1 0,-1 0,0-1,1 1,-1-1,1 0,-1 1,1-1,0 0,-1 0,1 0,0 0,-1-3,-4-13,0-1,1 0,0 1,-2-38,2 20,-2-15,2 0,2 0,7-83,-4 131,1 0,0 0,0 0,0 0,0 0,0 1,0-1,1 0,0 1,-1-1,1 1,3-4,30-25,-6 6,18-20,-26 26,24-28,-42 41,1 1,-2 0,1-1,0 0,-1 1,0-1,-1 0,1 0,-1 0,1-12,-2 12,1-1,0 1,0 0,0 0,1-1,0 1,0 0,1 0,0 1,6-11,-4 11,1 0,-1 0,1 0,0 1,0 0,0 0,1 0,9-3,-11 5,0 0,0 0,0 0,0-1,0 0,-1 0,0 0,1-1,-1 1,-1-1,1 0,0 0,-1 0,0-1,0 1,0-1,3-6,-4 5,0 0,1 0,0 1,0-1,7-9,-9 14,0 0,-1 0,1 0,0 0,0 0,0 1,0-1,0 0,0 1,0-1,0 1,0-1,0 1,0-1,0 1,0 0,0-1,0 1,0 0,1 0,-1 0,0 0,0 0,0 0,0 0,0 1,0-1,1 0,-1 1,0-1,0 0,0 1,0-1,0 1,0 0,0-1,0 1,0 0,-1-1,3 3,-1-1,0 1,0 0,-1-1,1 1,0 0,-1 0,0 0,1 0,-1 0,0 1,-1-1,1 0,0 4,1 48,-2-41,0 38,-3 132,2-182,1 0,0 0,-1 0,1 0,-1 0,0 0,0 0,1 0,-1-1,0 1,-1 0,1-1,0 1,0-1,-1 1,1-1,-1 0,1 1,-1-1,0 0,-3 2,-2 0,-1 0,0 0,0-1,-9 2,-12 4,17-4,-1 1,1 0,0 1,-17 10,25-12,-1 0,1 0,-1 0,1 0,0 1,1-1,-1 1,1 0,0 0,0 0,1 1,-4 8,-1 6,2 1,0 0,1-1,-1 24,4-34,1 0,0 0,0-1,1 1,1 0,-1-1,1 1,1-1,0 0,0 0,6 10,-9-17,1-1,0 0,0 1,-1-1,1 0,0 0,0 1,0-1,1 0,-1 0,0 0,0-1,0 1,1 0,-1 0,1 0,-1-1,0 1,3 0,-3-1,1 0,-1 0,0-1,1 1,-1 0,1 0,-1-1,0 1,0-1,1 1,-1-1,0 0,0 1,1-1,-1 0,0 0,1-1,3-4,1 0,-1 0,-1 0,1-1,-1 0,3-7,2-5,-1-1,-1 0,0 0,-2-1,0 1,-2-1,0 0,-1 0,-1-1,-4-39,1 120,1-61,0 1,0-1,0 1,0-1,0 1,0 0,0-1,0 1,-1 0,1 0,-1 0,1 0,0 0,-1 0,0 0,1 0,-3 0,-33-14,24 14,1-1,-1 2,0-1,0 2,1 0,-25 5,-16 1,-98-2,-430-10,-17 0,507 6,12-2,-1 4,-106 18,164-15,1 0,0 2,1 0,-28 16,-21 9,66-32,0 1,-1-1,1 1,0 0,1 0,-1 0,0 0,1 1,-1-1,1 1,0 0,-1-1,1 1,1 0,-1 0,0 0,1 0,-1 1,-1 5,2-3,0 0,0 1,1-1,0 0,0 0,0 1,1-1,-1 0,2 0,1 9,-2-14,-1 0,1 0,-1 0,1 0,-1 0,0 1,0-1,1 0,-1 0,0 0,0 1,0-1,0 0,0 0,-1 0,1 1,0-1,-1 0,1 0,0 0,-1 0,0 0,1 0,-1 0,1 0,-1 0,0 0,0 0,0 0,0 0,1 0,-1-1,0 1,0 0,-1-1,1 1,0-1,0 1,0-1,0 1,0-1,0 0,-1 1,0-1,-8 1,-1-1,1 0,0 0,-17-4,12 2,-676-61,535 57,0 8,-226 30,235-5,0 7,3 5,1 7,-222 104,351-143,-133 68,127-64,0 2,1 0,1 2,-30 28,46-41,-1 1,1 0,-1 0,1 0,0 1,0-1,0 1,1-1,-1 1,1-1,0 1,0 0,0-1,0 1,1 0,-1 0,1 0,0 0,0-1,1 1,-1 0,1 0,1 4,0-3,0 0,1 0,-1 0,1 0,0-1,1 1,-1-1,1 1,0-1,0-1,0 1,0 0,1-1,-1 0,7 3,3 2,0-2,1 0,-1-1,1 0,0-1,0-1,0 0,28 1,-22-4,0-1,1-1,-1 0,0-2,39-11,-32 5,-1-1,-1-1,0-1,0-1,-1-2,-1 0,-1-1,0-2,32-33,-35 28,-1 0,-1-1,0-1,-3 0,0-1,-1-1,11-35,-17 40,-1-2,-1 1,-1-1,-1 0,-1 0,-1 0,-2 0,0 0,-5-31,2 43,1 0,-2 0,1 1,-2-1,0 1,0 0,-1 0,-1 1,0-1,0 1,-17-18,11 16,0 1,-1 1,0 1,0 0,-1 0,0 2,-1 0,-17-7,0 4,1 0,-2 3,-47-8,-96 3,165 13,-18-1,-1 1,1 1,-58 11,79-10,1 1,0-1,0 2,0-1,0 1,0 0,-13 11,17-12,-1 1,1 0,1 0,-1 1,0-1,1 1,0 0,0 0,1 0,-1 0,1 0,0 0,-1 9,0 2,1 0,0 0,1 1,1-1,1 1,0-1,2 0,-1 0,2 0,0 0,8 18,0-3,2-1,1 0,1-1,31 42,-30-49,1 1,2-2,0-1,1 0,0-2,2 0,0-1,1-2,1 0,36 15,-57-29,0 1,1-1,-1 1,0-1,1-1,-1 1,9 0,-11-2,-1 1,1 0,-1-1,0 1,1 0,-1-1,0 0,1 1,-1-1,0 0,0 0,1 0,-1 1,0-1,0 0,0-1,0 1,0 0,-1 0,1 0,0 0,0-1,-1 1,1 0,-1-1,1 1,0-3,1-8,0 0,0 0,-1 0,-1 0,0 0,0 0,-1 0,-1 0,-4-18,0 8,-1-1,-1 1,-1 1,-13-24,4 15,-1 0,-2 2,0 0,-2 2,-1 0,-53-42,37 38,-2 1,-1 2,-1 2,-56-23,66 34,0 2,0 1,-50-9,64 17,1 1,-1 0,1 1,-1 1,1 1,-1 1,-37 9,53-10,-1 2,0-1,0 0,1 1,0 0,-1 0,1 0,0 1,1 0,-1-1,0 1,1 0,-5 8,-1 2,1 0,-12 31,11-25,2 1,-6 26,12-41,-1 0,2 0,-1 0,1 0,0 0,0 0,0 0,1 0,0 0,0 0,1 0,0 0,2 6,1-5,-1 0,1 0,0 0,1 0,-1-1,1 0,1 0,-1-1,1 0,0 0,0 0,0-1,15 6,-1-1,1-1,0-2,1 0,23 2,4-2,0-2,1-3,-1-2,0-2,95-19,-49 1,-2-5,98-41,-116 37,-2-4,-1-3,92-63,-131 76,0-1,-2-2,-1-1,-1-1,-2-2,-1-1,-1-1,29-51,-43 63,-1-1,-1 0,-2-1,0 0,-1-1,5-34,-10 43,-1 0,0 0,-1-1,-1 1,0 0,-1-1,-1 1,0 0,-1 0,-1 1,-7-19,2 14,-1 1,0 0,-1 1,-1 0,-1 0,0 2,-1 0,0 0,-2 1,1 1,-2 1,1 1,-2 0,-26-11,18 11,0 1,-1 1,0 1,0 2,-1 0,1 3,-1 0,0 1,0 2,-30 4,16 2,2 2,-1 2,1 1,0 2,1 2,1 2,0 2,2 1,0 1,1 3,2 1,-37 32,59-46,1 1,0 0,0 0,1 1,1 0,0 1,0 0,2 0,0 1,0 0,-7 29,12-34,0 0,0 1,1-1,0 1,1-1,0 1,1 0,0-1,1 1,0-1,0 0,1 0,1 0,0 0,0 0,1-1,0 1,0-1,8 9,-1-5,0 0,0-2,1 1,1-1,0-1,1-1,-1 0,2-1,-1 0,1-1,32 9,-4-5,1-1,0-2,65 3,-27-8,0-5,-1-2,0-5,0-3,82-23,-62 7,-3-5,0-3,145-78,-193 86,-1-1,-2-4,0-1,82-79,-109 91,0 0,-2-1,-1-2,-1 0,-1 0,-2-2,0 0,-2 0,0-1,-3-1,10-41,-14 44,-2-1,-1 0,0 0,-3-1,0 1,-1 0,-2 0,-1 1,-1-1,-1 1,-1 0,-2 1,-15-32,13 35,-1 0,-1 1,0 1,-2 0,0 1,-1 1,-1 0,-1 1,0 1,-1 1,-1 1,0 1,-1 1,-36-16,21 15,-1 2,-1 1,1 2,-1 2,-41-1,-10 4,-98 9,184-6,0 0,-1 1,1 0,-1 0,1 0,0 0,0 0,-1 1,1 0,0 0,-4 2,6-1,-1-1,1 0,0 1,-1-1,1 1,1 0,-1 0,0 0,1 0,-1 0,1 0,0 0,0 1,-1 5,-1 4,1 0,1 0,0 1,1-1,0 0,1 0,1 0,0 0,0 0,2 0,-1-1,2 1,-1-1,9 15,-7-17,0 0,1-1,0 1,0-1,1-1,0 0,0 0,1 0,0-1,1 0,-1-1,1 0,0-1,1 0,-1 0,17 4,-15-5,0-1,0-1,1 0,-1 0,1-1,-1-1,0 0,14-2,-22 1,1 0,-1 0,0 0,0-1,0 1,0-1,0 0,0-1,0 1,-1-1,1 1,-1-1,1 0,-1 0,0 0,0-1,-1 1,1-1,-1 0,0 1,0-1,0 0,0-1,-1 1,3-8,-1-2,-1-1,-1 1,0 0,-1-1,0 1,-1 0,-1-1,0 1,-1 0,-1 0,0 0,0 1,-11-22,-3-1,-2 1,-1 1,-42-53,-76-74,133 153,0 1,0 1,0-1,-1 1,-10-8,14 13,1-1,0 1,0 0,0 0,-1 0,1 0,0 1,-1-1,1 1,-1-1,1 1,-1 0,1 0,0 0,-1 0,1 0,-1 1,1-1,-1 1,1-1,0 1,-1 0,1 0,-4 3,-2 1,0 1,1 0,0 0,0 1,1 0,-1 0,1 0,1 1,0 0,-7 13,-3 11,-17 50,27-69,-20 60,4 1,2 1,4 1,4 0,-4 124,15-191,-1 4,1 1,1-1,1 1,3 16,-5-27,1-1,-1 0,1 0,0 0,0 0,-1 0,1 0,1 0,-1 0,0 0,0 0,1-1,-1 1,1 0,-1-1,1 1,0-1,0 0,-1 1,1-1,0 0,0 0,0 0,0-1,0 1,1 0,-1-1,0 1,0-1,0 0,1 0,-1 0,3 0,4-2,0 1,0-2,0 1,-1-1,1-1,-1 0,0 0,0 0,11-9,9-8,27-26,-52 45,27-26,-1-1,-1-1,30-42,-47 56,0 0,-2-1,0-1,0 1,-2-1,0-1,-1 1,-1-1,2-20,-6 35,0 0,-1 1,0-1,0 0,0 0,0 0,-1 0,1 0,-1 1,0-1,0 0,-1 0,1 1,-1-1,1 1,-1-1,-3-2,2 3,0-1,-1 1,1 1,-1-1,0 0,1 1,-1 0,0 0,-1 0,1 0,0 1,-1-1,1 1,-6 0,-3-1,0 1,-1 1,1 0,0 1,-1 0,1 1,0 1,0 0,0 0,0 2,1-1,-1 2,-12 7,1 0,0 2,1 0,1 2,1 0,-29 31,28-25,2 2,1 0,0 1,2 1,2 1,-14 31,19-36,2 1,0 0,2 0,0 0,2 1,1-1,1 1,1 33,2-45,0-1,2 0,-1 1,2-1,-1 0,2 0,-1-1,2 0,-1 1,2-2,-1 1,2-1,-1 0,19 18,19 15</inkml:trace>
</inkml:ink>
</file>

<file path=ppt/ink/ink1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4.482"/>
    </inkml:context>
    <inkml:brush xml:id="br0">
      <inkml:brushProperty name="width" value="0.05" units="cm"/>
      <inkml:brushProperty name="height" value="0.05" units="cm"/>
      <inkml:brushProperty name="color" value="#66CC00"/>
      <inkml:brushProperty name="ignorePressure" value="1"/>
    </inkml:brush>
  </inkml:definitions>
  <inkml:trace contextRef="#ctx0" brushRef="#br0">304 42,'0'-1,"0"-1,0 1,-1-1,1 1,-1-1,0 1,1 0,-1-1,0 1,0 0,0 0,0-1,0 1,0 0,0 0,0 0,0 0,0 0,-1 0,1 1,0-1,-1 0,1 1,-1-1,1 0,-3 1,-40-10,42 10,-6-1,-1 0,1 1,-1 0,0 0,1 1,-1 1,1-1,-1 1,1 1,0-1,0 1,0 1,0 0,0 0,1 0,0 1,0 0,0 1,0-1,1 1,0 0,0 1,-7 10,8-8,0-1,0 1,1 0,0 1,1-1,0 1,0-1,1 1,1 0,-2 16,2-15,1 0,1 1,-1-1,2 0,-1 0,2 0,-1 0,1-1,7 15,-7-18,1-1,1 0,-1 1,1-1,0-1,1 1,-1-1,1 0,0 0,0-1,12 7,-14-8,0-1,1 0,-1 0,0 0,1-1,-1 0,1 0,0 0,-1 0,1-1,0 1,-1-1,1-1,0 1,0 0,-1-1,1 0,-1 0,9-4,1-3</inkml:trace>
</inkml:ink>
</file>

<file path=ppt/ink/ink1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8.139"/>
    </inkml:context>
    <inkml:brush xml:id="br0">
      <inkml:brushProperty name="width" value="0.05" units="cm"/>
      <inkml:brushProperty name="height" value="0.05" units="cm"/>
      <inkml:brushProperty name="color" value="#66CC00"/>
      <inkml:brushProperty name="ignorePressure" value="1"/>
    </inkml:brush>
  </inkml:definitions>
  <inkml:trace contextRef="#ctx0" brushRef="#br0">1321 261,'-23'-3,"21"2,-1 0,1 1,0-1,0 1,-1 0,1-1,0 1,0 0,-1 0,1 1,0-1,0 0,-1 1,-3 1,3 0,0 0,0-1,0 2,0-1,0 0,1 1,-1-1,1 1,-1 0,1 0,0 0,0 0,0 0,1 0,-1 0,1 1,0-1,0 1,0-1,-1 7,0 3,0 0,2 0,-1 0,3 20,-1-24,1 0,0 0,1-1,0 1,0 0,1-1,0 0,1 0,-1 0,2 0,7 8,-5-6,1 0,1 0,0-1,0-1,1 0,0 0,14 7,-19-12,1 0,0 0,0-1,0 1,0-2,1 1,-1-1,0 0,1-1,-1 1,0-2,1 1,8-2,-5 0,-1-1,0 0,-1-1,1 0,-1 0,1-1,-1 0,15-12,-12 7,1-1,-2 0,0-1,0 0,-1-1,0 0,-1-1,-1 0,0 0,-1-1,0 0,4-18,-8 22,0 0,-1-1,-1 1,1-1,-2 1,0-1,0 1,-1-1,-1 1,-5-22,4 23,-1 1,1 0,-2 0,1 0,-2 0,1 1,-1 0,0 0,0 1,-1-1,0 1,-1 1,-8-7,1 4,-1-1,0 2,0 0,-1 1,0 1,-1 0,1 2,-1 0,0 0,0 2,0 0,-1 1,1 1,-35 5,48-4,1 0,-1 0,0 0,1 1,-1-1,1 1,-1 0,1 1,0-1,0 1,0 0,0 0,1 0,-1 0,1 1,0 0,0-1,0 1,0 0,1 0,-1 1,1-1,0 0,0 1,-1 6,0 3,-1 0,2 0,0 1,1-1,0 1,2-1,1 18,-1-26,0-1,0 0,0 0,1 0,-1 0,1-1,1 1,-1 0,1-1,-1 1,1-1,1 0,-1 0,0 0,1-1,0 1,0-1,0 1,0-2,1 1,-1 0,1-1,0 0,7 3,-8-3,0-1,1 0,-1-1,0 1,0-1,0 1,0-1,1-1,-1 1,0 0,0-1,0 0,0 0,0 0,0-1,0 1,0-1,0 0,-1 0,1 0,-1-1,1 1,-1-1,0 0,0 0,0 0,0 0,-1 0,1-1,2-5,-1 1,-1 1,0-1,0 0,-1 0,0-1,0 1,-1 0,0-1,0 1,-1-1,-1 1,1-1,-1 1,0-1,-1 1,0 0,-1 0,1 0,-1 0,-1 0,0 0,0 1,0 0,-1 0,0 0,0 0,-10-8,7 8,0 0,0 1,-1 0,1 1,-1 0,-1 0,1 1,-1 0,0 1,0 0,0 0,0 1,0 0,0 1,-1 1,1-1,0 1,-1 1,1 0,-20 5,27-5,0 0,0 0,0 1,0 0,0-1,1 1,-1 0,1 0,0 0,-1 1,1-1,0 1,0-1,0 1,1-1,-1 1,1 0,-1 0,1 0,0 0,0 0,0 0,0 0,1 0,0 1,-1-1,1 6,0 1,1 0,-1-1,2 1,-1-1,1 1,1-1,0 1,5 11,-1-9,0 0,0 0,1-1,1 0,0-1,0 0,1 0,0-1,1-1,0 1,0-2,1 1,0-2,16 7,-16-7,0-2,0 0,0 0,1-1,-1-1,1 0,0 0,0-2,0 1,-1-2,1 0,0 0,0-1,-1-1,19-5,-26 6,-1 0,1 0,0-1,-1 1,0-1,1 0,-1-1,0 1,-1-1,1 1,-1-1,1 0,-1 0,0-1,-1 1,1-1,-1 1,0-1,0 0,0 0,-1 0,3-10,-4 9,1-1,-1 0,0 1,-1-1,1 0,-1 1,0-1,-1 1,0-1,0 1,0 0,-1 0,0 0,0 0,-1 0,1 1,-8-9,-2-1,-1 2,-1 0,1 1,-2 1,0 0,0 1,-30-14,32 18,0 0,-1 1,1 1,-1 0,0 1,0 0,0 2,-1-1,1 2,-20 1,31 0,0 0,0 0,1 0,-1 0,0 0,1 1,-1 0,1 0,0 0,-1 0,1 0,0 0,0 1,1 0,-1-1,0 1,1 0,0 0,-1 1,1-1,1 0,-1 1,0-1,1 1,0 0,-1-1,0 7,-1 9,0 0,2 0,0 0,1 25,1-26,-1-5,0-1,2 0,-1 0,1 0,1 0,4 12,-6-20,1-1,-1 1,1-1,0 0,0 1,0-1,0 0,1 0,-1-1,1 1,0 0,0-1,0 1,0-1,0 0,0 0,1 0,-1-1,1 1,-1-1,1 0,0 0,5 1,-5-1,0-1,0 1,0-1,0 0,0 0,0 0,0-1,0 1,0-1,-1 0,1 0,0 0,6-3,-8 2,0 1,0-1,0 0,0 0,0 0,-1 0,1 0,-1-1,1 1,-1 0,0-1,1 1,-1-1,-1 1,1-1,0 0,-1 1,1-1,-1 0,0 1,0-4,0-3,0 1,-1 0,-1-1,0 1,0 0,0 0,-1 0,0 0,0 1,-1-1,0 1,-9-12,5 8,0 1,0 0,-1 0,0 1,-1 0,0 1,-18-12,24 18,1 0,-1 0,0 0,0 0,0 1,0-1,0 1,0 0,0 1,0-1,-1 1,1-1,0 1,0 0,-1 1,1-1,0 1,0 0,0 0,0 0,0 1,-5 1,3 1,-1 0,1 1,1 0,-1 0,0 0,1 0,0 1,1 0,-1 0,1 1,-6 11,1 0,1 0,1 1,1 0,-6 28,9-34,1 1,0 0,1-1,1 1,0 0,1 0,4 17,-4-25,0-1,1 0,0 0,0 0,0-1,1 1,-1 0,1-1,0 0,0 0,1 0,0 0,-1 0,1 0,0-1,1 0,-1 0,0 0,1 0,0-1,0 0,0 0,-1 0,2-1,-1 1,0-1,7 0,4 1,-1-1,1-1,-1 0,1-2,-1 1,1-2,-1 0,18-7,-28 9,-1-1,1 0,-1 0,0 0,0 0,0-1,0 1,0-1,-1 0,1-1,-1 1,0 0,0-1,0 0,0 0,-1 0,0 0,1 0,-1 0,-1-1,1 1,-1-1,1 1,-1-1,-1 1,1-1,-1 0,0-6,0 2,0 0,-1 0,-1-1,0 1,0 0,-1 0,1 1,-2-1,0 0,0 1,0 0,-1 0,-9-12,-1 4,-1 0,-1 1,0 0,-1 1,0 1,-1 1,0 1,-1 1,-1 0,0 1,0 2,0 0,-1 1,0 1,0 1,0 1,-1 1,1 1,0 1,-1 1,-41 7,55-5,-1 0,0 0,1 1,0 1,0-1,0 2,1-1,-1 1,1 0,1 1,-1 0,1 0,0 1,1-1,0 2,0-1,1 0,-7 14,4-5,1 0,1 1,0 0,1 0,1 0,1 0,1 1,0-1,1 24,2-29,0 1,1-1,1 0,0 0,0 0,2-1,-1 1,1-1,1 0,1-1,-1 1,2-1,-1 0,2-1,-1 0,15 13,-11-13,0 0,1 0,0-2,1 0,-1 0,2-1,-1-1,1 0,0-1,0-1,0 0,0-1,25 2,-29-4,0-1,0 0,0-1,0 0,0-1,0 0,-1 0,1-1,18-8,-22 7,1 0,-1-1,0 0,0 0,-1-1,0 0,0 0,0 0,0-1,-1 1,0-1,-1-1,6-9,-5 7,-1-1,0 1,0-1,-1 0,0 0,-1 0,0 0,-1 0,0-1,-1 1,-1 0,1-1,-2 1,1 0,-1 0,-1 0,-4-12,0 7,-1 0,0 0,-1 1,0 0,-1 0,-1 1,0 1,-1 0,-1 0,-19-14,8 9,0 2,-2 1,0 1,0 1,-2 1,1 1,-1 2,-1 1,0 1,0 1,0 2,0 1,-1 1,-45 3,55 1,1 0,0 2,0 0,0 1,0 0,1 2,0 0,0 2,1-1,-22 16,18-9,1 2,0 0,2 0,0 2,0 1,2 0,-16 25,11-8,0 0,3 2,1 0,2 1,2 0,1 1,2 0,2 1,-3 56,10-80,1 0,1-1,0 1,2 0,0 0,1-1,0 1,2-1,0 0,0-1,2 0,11 18,-5-12,1-1,1 0,1-2,1 0,1 0,1-2,36 25,-13-14,1-2,0-3,2-1,1-2,1-3,0-1,97 17,-96-25,0-3,0-2,0-2,0-2,1-2,-1-2,-1-3,58-16,-78 16,-1-2,0-1,0-1,-1-1,-1-2,0 0,-1-2,-1 0,0-2,39-41,-51 46,0 1,-2-2,1 1,-2-1,0 0,-1-1,0 0,7-26,-11 28,-1-1,0 1,0-1,-2 0,0 1,0-1,-2 0,0 1,0-1,-9-27,2 18,-1 1,-1 0,-1 1,-1 0,0 1,-2 0,0 2,-2-1,0 2,-1 0,-1 1,0 1,-26-16,24 19,-1 0,0 1,0 1,-1 1,-1 1,0 1,0 2,0 0,-1 1,0 2,0 0,0 2,-32 2,51-1,1 1,0 0,0 0,0 1,0 0,0 0,0 0,0 0,1 1,-1 0,1 0,-1 0,1 0,0 1,1-1,-1 1,1 0,-1 0,1 1,0-1,1 0,-1 1,1 0,0 0,0 0,-2 5,-1 12,0 0,0 0,2 0,0 41,2-55,1 1,1-1,-1 1,1-1,1 1,-1-1,2 1,-1-1,6 13,-6-17,1-1,-1 1,1-1,-1 1,1-1,0 0,0 0,1 0,-1 0,1-1,-1 1,1-1,0 0,0 0,0 0,0-1,0 1,0-1,0 0,7 1,1 0,0-1,-1 0,1-1,0-1,0 1,0-2,-1 0,1 0,-1-1,1 0,-1-1,0 0,0-1,-1 0,1-1,-1 0,13-11,-11 6,0 0,-1-1,0 0,0-1,-2 0,1-1,-2 1,0-2,0 1,-2-1,10-31,-10 25,-1 0,-1-1,-1 1,-1-1,-1 0,-1 0,-1 1,-1-1,0 0,-2 1,-1 0,0 0,-1 0,-2 0,0 1,-1 0,-1 1,-1 0,-22-30,31 47,1 0,-1 0,0 0,0 0,0 0,0 0,-1 0,1 1,0-1,-1 1,-3-2,5 3,0 0,0 0,0 0,0 0,0 0,-1 0,1 0,0 0,0 1,0-1,0 0,0 1,0-1,0 1,0-1,0 1,0-1,0 1,0-1,1 1,-1 0,0 0,0 0,1-1,-1 1,0 0,1 0,-1 0,1 0,-1 2,-6 9</inkml:trace>
</inkml:ink>
</file>

<file path=ppt/ink/ink1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1:55.243"/>
    </inkml:context>
    <inkml:brush xml:id="br0">
      <inkml:brushProperty name="width" value="0.35" units="cm"/>
      <inkml:brushProperty name="height" value="0.35" units="cm"/>
      <inkml:brushProperty name="color" value="#33CC33"/>
      <inkml:brushProperty name="ignorePressure" value="1"/>
    </inkml:brush>
  </inkml:definitions>
  <inkml:trace contextRef="#ctx0" brushRef="#br0">3927 2864,'22'0,"30"5,6 2,95 2,75-1,348-3,1-43,-311 0,-215 27,-1-2,-1-2,51-23,-82 29,0 0,0-1,-1 0,0-1,19-17,-31 23,1-1,-1 1,1-1,-1 0,-1 0,1 0,-1-1,0 0,-1 0,0 0,0 0,0 0,-1 0,0-1,0 0,0-7,-2 9,-1 1,1-1,-1 1,0-1,-1 0,1 1,-1 0,0-1,0 1,-1 0,1 0,-1 0,-1 1,1-1,0 1,-1-1,0 1,0 1,0-1,-8-5,-4-2,0 1,0 0,-1 1,0 1,-19-6,-21-4,-2 1,1 4,-64-7,-181-2,-20 23,277 3,1 2,-1 1,1 3,0 1,-44 19,66-20,1 1,0 1,0 2,1 0,1 1,0 1,1 0,1 2,1 0,0 1,1 1,-16 28,15-20,1 1,2 0,1 1,2 1,0 0,2 0,2 1,-7 64,8-4,5-1,10 94,-9-182,0 1,0-1,0 1,1-1,0 1,0-1,0 0,0 0,0 1,1-1,-1 0,1 0,4 5,-6-8,0 0,0 1,0-1,1 0,-1 0,0 0,0 0,1 0,-1 0,0 1,0-1,1 0,-1 0,0 0,0 0,1 0,-1 0,0 0,0 0,1 0,-1 0,0 0,0 0,1-1,-1 1,0 0,0 0,1 0,-1 0,0 0,0 0,1-1,-1 1,0 0,6-11,0-15,-4 13,-1 0,0 0,-1 0,0 0,-1 0,-1 0,0 0,-1 1,0-1,-1 1,0-1,-8-13,4 11,-1 0,-1 1,0 0,0 1,-2 0,0 0,0 1,-26-19,22 21,0 0,-1 0,0 2,0 0,-1 1,0 0,0 2,-27-5,4 4,0 1,-76 3,98 3,0 0,0 2,1 0,-1 1,1 1,0 0,0 2,0 0,1 1,-19 12,22-12,2 1,0 1,0 0,0 1,1 0,1 0,0 1,1 1,0 0,1 0,0 0,-11 27,15-29,1 0,-1 1,2-1,0 0,0 1,1 0,0-1,1 1,0 0,1-1,0 1,1-1,5 18,-3-17,1 0,0 0,1-1,0 1,1-2,0 1,1-1,0 0,1 0,0-1,0 0,14 9,-5-5,2-1,-1-1,1-1,1-1,0-1,0-1,0-1,1 0,0-2,25 2,0-1,1-3,0-3,79-9,-68 1,-1-2,67-22,-96 23,0-1,0-1,-1-2,0-1,49-35,-72 46,1-1,-1 0,0 0,0-1,0 0,-1 1,1-2,-1 1,-1 0,1-1,-1 1,3-11,-5 13,0 0,-1-1,1 1,-1-1,0 1,0 0,0-1,0 1,-1-1,0 1,0 0,0 0,0-1,-1 1,0 0,0 0,0 0,0 1,0-1,-1 0,-4-4,-4-3,0 1,-1-1,0 2,-1 0,0 1,0 0,-25-10,4 4,-1 1,-40-8,12 7,0 3,-115-6,128 16,0 3,1 1,0 3,-59 14,90-15,2 0,-1 1,1 1,-1 0,2 1,-1 1,1 0,1 1,-14 13,21-18,2 1,-1 0,0 0,1 0,0 1,1-1,0 1,0 1,0-1,1 0,0 1,0 0,1-1,0 1,0 0,1 0,0 0,0 1,1-1,0 0,2 14,1-8,1-1,0 0,1 1,1-2,0 1,0-1,2 0,-1 0,16 18,3 0,2-1,37 30,-16-19,2-3,2-1,1-3,1-3,2-1,0-4,2-1,1-4,1-2,93 15,-128-29,1-1,-1-2,1 0,-1-2,39-6,-52 4,0 0,0 0,-1-1,1-1,-1 0,0-1,0 0,-1-1,0 0,0-1,0 0,16-17,-11 5,0 0,-1 0,-1-2,-2 0,0 0,-1-1,-1-1,7-25,-7 17,-2-1,-1-1,-2 1,-1-1,-1-52,-4 68,-1 0,0 0,-2 0,0 1,0-1,-2 1,0 0,-1 0,-1 1,0 0,-1 0,-1 1,0 0,-1 1,-1 0,0 1,-1 0,-1 1,1 1,-2 0,0 0,0 2,-1 0,0 0,-26-8,16 7,-1 2,-1 1,1 2,-1 0,0 2,-1 0,1 3,0 0,-1 2,1 0,-31 9,42-7,0 1,0 1,1 0,-1 1,2 1,-1 1,1 0,-17 14,21-13,0 0,0 1,1 0,1 0,0 1,0 1,1-1,1 1,0 1,-8 22,7-12,1 0,2 1,0-1,1 1,2 0,0 0,2 0,1 0,1 0,1 0,1 0,1-1,14 43,-11-47,1 1,0-1,2 0,0-1,1 0,1-1,1-1,1 0,0 0,1-2,0 0,2-1,-1 0,2-2,36 20,-21-17,1-1,-1-2,2-1,0-2,69 8,-59-13,1-2,0-3,-1-1,58-11,-38 0,-1-3,0-4,-1-2,-1-2,-1-4,97-59,-90 42,-2-2,-2-4,-2-2,-3-3,61-73,-73 71,-3-3,-2-1,-3-1,-3-3,50-122,-74 153,-1 0,-2 0,-2-1,-1 0,-1 0,0-58,-6 76,-1-1,-1 1,0-1,-2 1,0 0,-1 0,0 1,-2-1,0 1,-1 1,-1-1,0 1,-1 1,-24-29,15 25,0 1,-2 1,0 1,-1 0,0 2,-2 0,1 2,-37-14,-5 3,-1 3,-75-13,22 11,0 4,-1 6,-212 5,185 22,125-11,0 1,0 1,0 1,-27 12,43-16,0 0,1 0,-1 1,1-1,-1 1,1 1,0-1,1 1,-1-1,1 1,0 1,0-1,0 1,1-1,0 1,0 0,0 0,1 0,0 1,0-1,1 0,0 1,0 0,0-1,1 1,0-1,1 8,0 6,0-1,2 1,1-1,0 0,1-1,1 1,10 21,-4-15,2 0,0-1,2-1,26 31,-4-12,3-3,1-1,1-2,69 43,-51-41,109 52,-127-72,1-1,1-2,73 14,-104-27,-1 0,1 0,-1-2,1 1,-1-2,1 0,-1-1,19-4,-24 4,0-1,-1 0,1-1,-1 1,0-2,0 1,0-1,-1 0,1 0,-1 0,0-1,-1 0,0-1,9-12,-3 1,-2 0,0-1,-1 0,-1 0,0-1,-2 1,0-2,-2 1,0 0,-1-1,-1 1,-1-1,0 1,-2-1,-5-26,-1 11,-1 1,-2 0,-1 1,-1 1,-2 0,-2 0,-37-54,27 49,-2 1,-1 2,-2 1,-1 1,-55-41,79 68,1 0,-1 1,-1-1,1 2,0-1,-16-3,22 7,0 0,-1 0,1 1,-1-1,1 1,-1 0,1 0,-1 1,1-1,-1 1,1-1,0 1,-1 0,1 0,0 1,-1-1,1 1,0-1,0 1,0 0,1 0,-6 5,1 1,0 0,0 1,0 0,1 0,1 0,-1 1,-3 12,-4 10,-7 35,0 19,3 2,4 0,4 1,4 0,13 174,-2-201,24 100,-22-133,1 0,1 0,1-1,2-1,22 37,-30-57,-1-1,1 1,1-1,-1-1,1 1,0-1,1 0,11 7,-17-11,1 0,0 0,0 0,0 0,0 0,0 0,0-1,0 1,0-1,0 0,0 1,0-1,0 0,0 0,0 0,0-1,0 1,0 0,0-1,0 1,0-1,0 0,0 0,0 0,-1 0,1 0,0 0,-1 0,1 0,0-1,-1 1,1-1,-1 1,0-1,0 1,0-1,1 0,0-2,-1 1,1 1,0-1,-1 0,0-1,1 1,-1 0,0 0,-1 0,1-1,-1 1,1 0,-1-1,0 1,0 0,-1-1,1 1,-1 0,1-1,-1 1,0 0,0 0,0-1,-1 1,1 0,-1 1,0-1,0 0,0 0,0 1,0-1,-1 1,1-1,-5-2,-1-1,-1 0,1 1,-1 0,0 1,0 0,-1 0,1 1,-1 0,0 1,-13-2,3 3,1 1,0 0,0 1,0 2,0 0,1 0,-1 2,1 0,0 2,0 0,1 0,0 2,0 0,-19 14,23-13,0 0,0 0,0 1,2 1,-1 0,2 0,-1 1,2 1,0-1,0 2,1-1,1 1,1 0,0 1,1 0,-6 28,10-34,1 0,0 0,0-1,1 1,1 0,-1 0,2 0,-1-1,1 1,1-1,0 0,0 0,0 0,1-1,1 1,-1-1,2 0,10 11,-5-7,1 0,0-1,1 0,1-1,-1 0,1-2,1 1,-1-2,31 10,-39-15,-1-1,1 1,0-1,-1-1,1 0,0 1,-1-2,1 1,0-1,-1 0,1-1,7-2,-4 0,0 0,0-1,-1 0,1 0,-1-1,16-14,-7 3,-1-1,-1-1,-1 0,0-1,-2 0,12-23,-10 13,-1 0,-2-1,-1 0,-2-1,11-59,-17 66,-1 1,-1-1,0 0,-2 0,-1 0,-1 1,-2-1,-9-33,9 45,0-1,-1 1,-1 0,0 1,-1-1,0 1,-14-15,15 20,0-1,-1 1,0 0,0 1,0 0,-1 0,0 0,0 1,-1 1,-18-7,22 10,0 0,0 1,0-1,0 1,0 1,0-1,0 1,0 0,1 0,-1 1,0-1,1 1,-1 1,1-1,-1 1,1 0,0 0,-6 5,-5 4,1 1,0 1,0 0,-13 18,6-3,0 1,2 1,1 1,2 1,1 0,2 1,-16 55,18-43,2 0,2 1,2 0,3 0,2 71,1-110,1 1,0-1,0 1,1-1,0 0,1 0,0 1,4 8,-5-13,0-1,0 0,1 0,-1 0,1 0,-1 0,1-1,0 1,0-1,0 0,1 1,-1-1,0-1,1 1,-1 0,1-1,0 0,-1 0,1 0,6 0,-1 0,1-1,-1 0,0 0,1-1,-1-1,1 0,-1 0,0-1,0 0,0 0,13-8,9-6,50-38,-15 4,-2-3,-3-3,-2-2,-3-3,84-120,-117 149,-2-1,-1 0,-2-2,-1 0,17-55,-30 76,0-1,-2 0,1 0,-2 0,0 0,-1 1,-2-18,0 21,0 1,-1 0,0 0,-1 0,0 1,0-1,-1 1,-1 0,0 0,-13-17,3 10,-1 0,-1 1,0 0,-1 2,0 0,-1 1,0 2,-1 0,-1 0,-25-7,0 3,-1 1,0 3,-97-10,73 17,-1 3,-136 15,-142 52,220-32,-207 81,274-88,1 3,2 3,1 2,1 3,-57 49,97-71,1 1,0 1,1 1,1 1,1 0,-19 31,28-38,0 0,0-1,2 2,-1-1,2 0,-1 1,2 0,0 0,1 0,0 0,1 0,0 0,4 15,0-10,0 0,2-1,0 0,1 0,1-1,1 0,0 0,1-1,1 0,1-1,0 0,1-1,0 0,21 16,5 1,0-3,2-1,2-2,63 27,-37-22,0-3,2-3,118 24,-144-40,-1-2,1-2,0-2,0-2,0-2,0-2,56-12,-82 12,1-2,-1 0,0-2,-1 0,0 0,0-2,-1 0,0-2,-1 1,-1-2,1 0,17-20,-25 23,0 0,0-1,-1 0,-1 0,0-1,0 1,-1-1,-1-1,0 1,0 0,-1-1,-1 0,0 0,-1 0,0 0,-1 0,0 0,-1 0,-1 0,-3-13,-1 7,0 0,-1 1,-1-1,-1 1,0 1,-2 0,0 0,-1 1,0 0,-1 1,-1 1,-21-18,4 7,-1 1,-1 2,-1 1,0 1,-53-20,34 20,0 2,-62-12,15 11,-2 5,-171-2,-211 45,280-1,-234 64,273-45,-284 120,218-54,194-91,0 1,2 2,-57 53,81-67,0 0,1 1,0 1,1-1,0 1,1 1,1 0,0 0,0 0,-6 26,10-29,1 0,1 0,0 1,0-1,1 0,0 1,1-1,0 1,1-1,1 0,0 0,0 0,1 0,0-1,7 13,-2-8,1 0,1 0,0-1,1 0,0-1,1 0,1-1,0-1,25 16,0-3,2-2,74 28,-33-21,1-4,1-3,1-4,1-4,0-3,1-5,-1-3,95-9,-130 1,0-1,0-3,0-3,-2-1,1-3,-2-2,86-44,-108 48,-1-2,-1-1,0 0,-2-2,0-1,-1 0,0-2,-2 0,-1-2,-1 0,-1 0,-1-2,-1 0,-1 0,9-30,-15 35,-1 0,-1 0,-1 0,-1-1,-1 1,-1-1,-1 0,0 1,-2-1,-1 0,0 1,-9-27,7 31,-2 1,0 0,0 0,-2 1,0 0,0 0,-2 1,0 1,0-1,-1 2,-1 0,0 0,0 1,-1 1,-31-17,7 8,-1 2,-1 2,0 2,0 1,-76-11,13 10,-129 2,77 13,1 7,0 7,-177 41,87 9,204-51,1 1,1 2,-66 42,91-51,0 0,1 1,0 1,1 0,0 0,0 1,1 0,-8 15,14-21,1 0,0 0,0 0,1 0,-1 1,1-1,1 1,-1-1,1 1,1 0,-1-1,1 1,0 0,0 0,1-1,0 1,0-1,1 1,0 0,0-1,4 9,-1-6,0-1,0 1,1-1,0-1,0 1,1-1,10 9,7 3,32 20,-7-10,55 26,116 33,-48-33,2-9,2-6,1-9,351 16,-421-45,211-25,-272 16,0-2,0-2,-1-2,0-2,-1-2,78-43,-102 48,-2-1,0-1,-1 0,0-1,-1-1,-1-1,0 0,-1-1,-1 0,15-31,-20 35,-1-1,-1 0,0-1,-1 1,-1-1,-1 0,0-1,-1 1,0 0,-2-1,0 1,0 0,-2-1,0 1,-4-16,3 21,-1 0,0 1,0-1,-1 1,0 0,-1 1,0-1,-1 1,0 0,0 1,-9-9,5 8,-1-1,0 2,-1 0,1 0,-2 1,1 0,-22-6,2 4,1 1,-1 2,0 1,-1 1,1 2,-60 5,30 3,1 3,0 2,1 4,0 2,1 2,1 3,1 3,2 2,0 3,2 2,-89 70,116-80,2 1,0 2,2 1,-33 45,46-57,2 1,-1-1,2 1,0 1,1-1,1 1,0 0,1 0,1 1,0-1,0 26,4-20,1 0,1 0,1-1,0 0,2 0,1 0,0 0,2-1,0 0,1-1,1 0,1-1,0 0,2-1,0 0,22 20,2-5,1-1,1-3,2-1,50 24,-5-10,107 35,-151-60,-1-3,2-1,0-3,0-1,55 2,-92-9,1-1,-1 0,0-1,1 0,-1 0,0 0,0-1,0 0,0-1,0 0,8-4,-11 4,0 0,0 0,-1 0,1 0,-1-1,0 0,0 1,0-1,0-1,-1 1,1 0,-1-1,0 1,0-1,-1 1,0-1,2-7,-1-1,0 0,-1 0,-1 0,0 0,0 0,-1 0,-1 0,-5-20,1 15,0 0,-1 1,0 0,-2 0,-14-22,2 10,-2 0,-1 1,-1 2,-1 0,-50-37,18 23,-2 2,-1 3,-1 3,-2 2,-1 4,-96-27,57 27,-1 4,0 5,-168-6,171 21,0 4,-140 23,187-16,0 2,1 3,1 3,1 1,0 3,-50 28,87-40,-1 1,1 0,1 0,0 2,1 0,0 0,-20 26,28-31,0 1,0 0,1 0,0 1,0-1,0 1,2 0,-1 0,1 0,0 0,1 0,0 1,0-1,1 0,0 1,3 14,-1-11,1 0,0 0,1 0,0-1,1 1,0-1,1 0,1 0,0-1,0 0,1 0,1-1,0 1,0-2,1 0,0 0,0-1,1 0,0 0,1-1,15 7,18 4,0-2,1-2,1-2,0-2,94 7,-131-16,-1-1,1 0,-1-1,1 0,-1 0,1-1,-1 0,0-1,0 0,13-6,-13 3,-1 1,1-2,-1 1,0-1,-1 0,1 0,-1-1,-1 0,9-13,1-4,-1-1,-2 0,0-1,-2 0,0-1,-2 0,-2-1,0 0,-2 0,-1 0,0-36,-4 42,-1-1,-1 1,-1 0,-1 0,-1 0,0 0,-2 1,-1 0,-1 0,-1 1,-1 0,0 1,-2 0,-28-35,17 30,-2 1,0 1,-2 2,0 0,-1 2,-1 1,-1 2,-1 0,-36-11,-3 3,-1 3,-1 3,-89-10,-105 5,231 22,0 3,0 0,0 3,0 0,-46 15,76-18,1 0,0 0,0 0,-1 0,1 1,1 0,-1 0,0 1,1-1,0 1,-1 0,2 0,-7 9,7-9,1 0,0 0,0 0,1 1,-1-1,1 1,0-1,0 1,1 0,-1-1,1 1,0 0,0-1,1 1,-1 0,1-1,2 6,2 8,1 1,1-1,1-1,0 0,2 0,0 0,0-1,18 19,-2-5,2-2,0-1,40 29,-16-20,1-2,1-2,2-2,1-4,1-1,67 18,-47-22,0-3,2-3,0-4,110 2,-137-13,1-3,0-1,-1-3,0-3,-1-1,0-3,0-3,65-30,-84 31,-1-1,-1-2,-1-2,0 0,39-40,-48 41,-2-2,0 0,-2-1,0-1,-2-1,-1 0,18-42,-26 50,1-1,-2 0,-1 0,0 0,-1-1,-1 1,-1-1,0 0,-4-32,1 40,0-1,0 1,-2-1,1 1,-1 0,-1 1,0-1,-1 1,0 0,0 0,-1 0,0 1,-1 0,0 1,0 0,-16-13,6 9,-1 1,0 0,-1 2,1 0,-2 1,-35-9,1 5,-81-8,45 13,-1 4,1 3,-1 5,1 4,0 4,1 3,1 5,0 3,2 5,1 3,-111 58,150-64,1 1,-78 63,106-75,0 1,1 1,1 1,1 0,1 0,0 2,1 0,-19 41,29-54,1 0,0-1,0 2,0-1,0 0,1 0,1 0,-1 1,1-1,0 0,1 1,0-1,2 11,0-11,-1 0,2 0,-1 0,1 0,0-1,0 1,0-1,1 0,0-1,1 1,-1-1,1 0,7 5,7 3,0-1,1-1,1 0,0-2,0-1,1 0,24 4,28 5,1-4,1-3,-1-3,134-5,-108-9,0-4,-2-4,111-33,-140 28,130-56,-173 63,-1-1,0-2,-1 0,-1-2,0-1,-2 0,25-27,-41 38,-1 0,1 0,-1-1,-1 1,0-1,0-1,0 1,-2-1,1 0,-1 0,2-10,-4 12,0 0,-1 1,0-1,0 1,-1-1,0 1,0-1,-1 1,0-1,0 1,0 0,-1 0,0 0,-1 0,-6-9,0 3,-1 1,0 0,0 0,-1 1,-1 1,0 0,0 1,-1 0,0 1,0 1,-1 0,-16-5,-18-4,-1 2,-78-13,25 13,0 3,-109 4,130 9,0 4,1 3,-90 23,140-25,1 2,1 0,0 2,0 2,-27 15,47-22,-1 1,1 0,0 0,0 1,1 0,0 0,-8 12,11-13,1 0,0 0,1 0,-1 0,1 1,1-1,0 1,0 0,0-1,1 1,-1 13,3-5,0 0,1 0,1 0,0 0,1-1,1 1,0-1,1 0,1-1,0 1,18 25,1-4,2-1,1-1,36 33,-7-14,2-4,2-1,2-4,2-3,1-2,2-3,2-4,1-2,2-4,109 24,-148-43,0-1,1-2,-1-2,1-1,-1-2,68-10,-80 6,0-1,0-1,0 0,-1-2,-1-1,1-1,-2 0,1-2,-2 0,0-1,22-22,-12 8,-2-2,-1-1,-1-1,-2-1,-1-1,18-41,-26 46,-2 0,-1-1,-1 0,-1 0,-2-1,-1-1,-2 1,1-43,-5 63,0-1,-1 1,0 0,-1 0,0 0,-5-12,6 19,-1 0,0 0,0 0,-1 0,1 0,-1 0,0 0,0 1,0 0,0-1,-1 1,1 0,-1 1,0-1,1 1,-1-1,-6-1,1 0,-1 1,0 1,1-1,-1 2,0-1,0 1,0 1,0 0,0 0,0 1,0 0,0 1,1 0,-1 1,0 0,1 0,0 1,0 0,-11 7,7-3,1 0,0 0,0 2,1-1,0 1,1 1,0 0,0 1,2-1,-1 2,1-1,-9 22,10-18,1 1,0 0,2 0,0 1,0-1,0 20,4-27,0 0,0 0,1 0,0 0,1-1,0 1,0 0,1-1,0 1,1-1,0 0,1 0,5 8,2-1,1 0,1-1,0-1,1 0,0-1,1 0,0-1,28 14,2-2,0-2,61 18,-31-15,2-3,0-3,149 14,-179-29,0-3,0-1,0-3,0-2,0-2,-1-2,81-27,-111 30,0-1,-1-1,1-1,-2-1,1 0,-1 0,23-23,-34 28,1 0,-1 0,0 0,0-1,0 0,-1 0,0 0,0 0,-1 0,4-11,-6 12,1 0,-1 0,1 0,-1 0,-1 0,1 0,-1 0,0 0,0 1,0-1,-1 0,1 0,-1 1,0-1,-1 1,-3-5,-1-2,-2 1,1 0,-1 0,-1 1,0 1,0-1,0 2,-1-1,-1 2,1-1,-25-9,12 7,0 2,-1 0,0 1,0 1,-30-1,27 4,0 2,0 0,0 2,0 1,0 2,1 0,-1 2,1 1,1 1,0 1,-35 20,54-26,0 0,1 1,0 0,0 0,0 0,1 1,0 0,0 0,0 0,1 0,0 1,-5 10,5-7,0 1,1 0,0 0,1 0,0 0,1 0,-1 22,3-12,1 0,1 0,1 0,1-1,0 1,2-1,0-1,19 36,-10-27,2-1,1 0,1-2,1 0,1-1,1-1,52 39,-52-46,0-1,1-1,1-1,1-1,-1-1,2-1,-1-2,1 0,46 5,-63-12,-1 0,1 0,-1-2,1 1,0-1,-1 0,1-1,-1 0,0-1,16-6,-18 5,-1 1,1-1,-1 0,0-1,-1 1,1-1,-1 0,0-1,0 1,-1-1,1 0,-1 0,-1 0,7-13,-4 2,-1 0,0 1,-1-2,-1 1,-1 0,0-1,-1 1,-1-1,-1 1,0 0,-2-1,0 1,0 0,-10-26,4 19,0 0,-2 1,0 0,-2 0,0 1,-2 1,0 1,-2 0,-23-23,16 21,-44-31,57 46,-1-1,0 2,0-1,0 2,-1-1,-19-4,28 10,-1-1,1 1,0-1,0 1,0 1,0-1,0 1,0-1,0 1,0 0,0 0,0 1,0-1,0 1,1 0,-1 0,-3 3,4-3,1 0,0 0,0 0,0 0,0 0,0 0,1 0,-1 0,1 1,-1-1,1 1,0-1,0 1,0-1,0 1,1 0,-1-1,1 1,-1 0,1 0,0 0,0-1,0 1,1 0,-1 0,1 3,1-3,-1 0,1 0,-1 0,1 0,0 0,0-1,0 1,0-1,1 1,-1-1,1 0,0 0,-1 0,1 0,0 0,0-1,0 1,0-1,0 0,1 0,3 1,5 1,0-1,0 0,0 0,22-1,-18-2,0-1,1-1,-1 0,-1-1,1-1,-1 0,1-2,-2 1,1-2,-1 0,0 0,0-1,-1-1,-1-1,1 1,11-16,0-1,-1-1,-1-1,-2-1,-1-1,-2-1,18-43,-17 29,-1-2,-3 0,-2 0,-2-1,-2-1,-2 1,-3-1,-1 0,-3-1,-2 1,-2 1,-2-1,-3 1,-27-82,31 113,-1 0,-1 0,-1 1,0 1,-1-1,-14-16,16 24,-1-1,0 1,0 1,-1 0,0 0,-1 1,0 0,0 1,-21-9,9 6,1 2,-1 1,0 1,-1 1,1 1,-27-1,37 4,0 0,0 1,0 0,0 1,1 1,-1 0,0 0,1 1,0 1,0 0,0 1,-17 11,23-12,0 0,0 0,1 0,-1 1,1 0,1 0,-1 0,1 1,0 0,1-1,-1 1,2 0,-1 1,1-1,0 0,0 1,1 0,0-1,0 1,0 0,1-1,2 14,0-9,0-1,1 0,0 1,0-1,2 0,-1 0,1-1,1 1,0-1,0-1,1 1,0-1,1 0,13 12,-2-5,1-2,0 0,1-1,0-1,1-1,0-1,38 12,-6-7,-1-3,75 8,-60-14,0-3,-1-3,1-2,-1-4,1-3,-2-2,1-4,-2-2,0-3,-2-3,0-3,-1-3,87-55,-111 60,-2-2,-1-2,50-51,-71 65,-1-1,-1-1,0 0,-1 0,-1-1,0 0,-1-1,-1 0,-1-1,7-27,-12 37,0 0,-1 0,-1 0,1-1,-1 1,-1 0,0 0,0 0,-1 0,0 0,0 0,-1 0,0 1,-9-17,5 14,0 1,-1-1,0 2,-1-1,0 1,0 1,-1-1,0 2,-20-12,0 3,-1 2,0 1,-1 1,-1 2,0 1,0 2,-40-4,14 7,0 2,0 2,0 4,1 2,-111 25,128-20,0 1,1 2,0 2,1 2,-60 37,73-38,0 2,1 0,2 2,0 0,1 2,1 0,1 2,-22 35,33-46,1 0,1 1,0 0,1 1,1 0,0 0,1 0,1 0,-2 20,4-27,1 0,1 0,-1 0,1 0,1 0,0 0,0 0,1 0,0 0,0-1,1 0,0 1,1-1,0-1,0 1,0-1,1 0,8 8,4 0,1 0,0-1,1-1,1-1,0 0,0-2,1-1,0 0,33 7,-1-3,0-3,111 7,-99-15,1-3,-1-2,0-4,77-16,-106 14,1-1,-1-2,-1-2,0-1,-1-2,-1-1,-1-2,46-35,-62 41,-1 0,0-2,-1 0,-1-1,-1 0,0-1,-2-1,0 0,17-40,-24 48,0-1,-2 1,1-1,-1 0,-1 0,0 0,0 0,-3-19,1 22,-1 0,0-1,-1 1,0 0,0 0,-1 0,0 1,0-1,-1 1,-1 0,-10-13,6 11,0 1,0 0,-1 0,0 1,0 1,-1 0,0 0,-1 1,1 1,-1 0,0 0,0 2,-1-1,-19-1,1 2,1 1,-1 1,1 2,-1 2,-41 7,14 3,0 3,1 2,1 2,1 3,1 2,1 3,-67 46,60-31,3 2,1 3,2 2,3 3,-75 97,101-114,1 0,2 2,1 1,2 1,2 0,2 1,-14 53,25-70,1 1,0-1,2 1,1-1,1 1,3 26,0-32,0 0,1-1,2 1,-1-1,2 0,0-1,2 0,15 26,-12-26,0-2,1 0,0 0,1-1,1-1,0 0,1-1,0-1,34 18,-10-10,0-3,2 0,57 12,-86-25,0 0,0-1,0 0,1-1,-1 0,1-1,-1-1,1 0,-1-1,0-1,0 0,0 0,0-1,0-1,-1 0,1-1,-1 0,-1-1,0 0,0-1,17-15,-15 10,-1 0,-1 0,0-1,15-25,-21 30,0 0,-1-1,0 0,0 0,-1 0,0 0,-1 0,0 0,0-12,-2 19,0 0,0 0,0-1,0 1,-1 0,1 0,-1 0,0 0,0 0,0 0,0 0,-1 0,1 1,-1-1,0 0,0 1,0-1,0 1,-3-3,2 3,0 0,0 0,0 0,-1 0,1 1,-1 0,0-1,1 1,-1 0,0 1,1-1,-1 1,0 0,0 0,-7 0,-11 3,-1 1,1 1,1 1,-1 0,1 2,-33 16,24-8,1 1,1 2,-47 39,55-40,1 1,2 1,-1 0,2 1,1 1,1 1,1 0,1 1,0 0,2 0,1 1,2 1,-9 40,15-54,0-1,1 0,0 1,1-1,0 0,0 1,1-1,1 0,0 0,0 0,7 12,-3-10,0 0,1-1,0 0,1 0,0-1,1 0,0-1,12 10,-3-5,2-1,0 0,1-2,0 0,0-1,1-2,1 0,0-2,47 9,-50-13,-1-1,1-2,-1 0,1-1,0-1,-1-1,0-1,0 0,0-2,0 0,-1-1,0-1,0-1,-1-1,-1 0,30-23,-28 17,0 0,0-2,-2 0,0-1,-2 0,0-2,-1 0,-1 0,0-1,-2-1,-1 0,-1-1,8-32,-13 40,-1 0,-1-1,0 1,-1-1,-1 0,-1 1,0-1,-2 0,-4-21,4 27,-1 1,1-1,-1 1,-1 0,0 1,0-1,-1 1,-1 0,1 1,-1-1,0 1,-1 1,0-1,0 1,-13-7,9 6,-1 1,1 1,-2 0,1 1,-1 1,1 0,-1 0,0 2,-1-1,1 2,0 0,-1 1,1 0,-21 4,13 0,0 1,0 1,1 1,0 1,1 1,0 1,0 0,-28 21,26-16,0 2,2 0,0 1,1 1,0 1,-30 44,42-54,1 1,0 0,1 0,0 1,1-1,0 1,0 0,1 0,1 0,0 1,1-1,0 1,1-1,1 0,0 1,0-1,4 16,-2-19,0 0,0-1,0 0,1 0,0 0,1 0,0-1,0 1,0-1,1-1,0 1,0-1,10 7,-5-5,0 0,1-2,0 1,0-2,0 1,1-2,0 0,14 3,2-2,0-1,-1-2,1-1,0-1,0-1,0-2,45-10,-34 3,0-2,-1-2,0-2,-1-1,-1-2,-1-1,-1-2,-1-2,0 0,-2-3,37-39,-47 42,-2-1,0 0,-1-2,-2 0,-1-2,18-42,-24 47,-2-2,-1 1,0-1,-2 0,-1 0,-2 0,0 0,-3-40,-1 44,-1 0,-1 0,-1 0,-1 0,-1 1,0-1,-2 2,-1-1,0 1,-21-29,15 28,-1 0,-1 1,0 1,-2 1,0 0,-1 2,-1 0,-36-19,23 17,0 1,-1 2,0 2,-2 1,1 2,-1 1,-1 2,1 2,-61 0,93 5,0 0,0 0,1 1,-1 0,0 0,1 0,-7 3,11-3,-1-1,1 1,0 0,0 0,0 0,0-1,0 1,0 0,0 0,0 1,0-1,0 0,0 0,1 0,-1 0,0 1,1-1,-1 0,1 1,0-1,-1 0,1 1,0-1,0 0,0 1,0-1,0 1,0-1,0 0,0 1,1-1,-1 0,0 1,2 1,0 2,0 1,1-1,-1 0,1 0,0 0,1-1,-1 1,1-1,0 0,0 0,1 0,-1 0,1-1,0 0,0 0,0 0,0 0,0-1,6 2,5 2,0-1,1-1,-1-1,1 0,23 1,-19-3,-1-2,1 0,-1-1,0-1,0-1,0-1,-1 0,1-2,-1 0,0-1,-1-1,0-1,-1-1,17-12,-22 14,-1 0,-1-1,0 0,0-1,-1 0,0 0,-1-1,0 0,-1-1,-1 0,0 0,0 0,-1-1,-1 1,0-1,-1 0,-1 0,0-1,-1 1,-1-26,-1 23,-1 0,-1 1,-1-1,0 1,-1-1,-1 1,-1 1,-10-20,5 15,0 1,-2 0,0 1,-1 1,-27-25,13 19,0 0,-1 2,-1 2,-1 1,-1 1,0 1,-53-16,64 26,-1 0,0 1,-1 2,1 0,0 2,-1 0,0 2,1 0,-24 5,30-3,0 1,0 1,1 0,-1 1,1 1,1 0,-1 1,1 1,1 1,-1 0,2 0,-21 21,30-26,-1 0,1 0,0 0,0 1,1-1,0 1,0 0,0 0,-2 9,4-11,0 0,1 1,-1-1,1 0,0 1,0-1,0 1,1-1,-1 0,1 1,0-1,1 0,-1 1,1-1,2 4,1 1,1 0,0 0,0-1,1 1,0-2,0 1,1-1,0 0,1 0,17 10,0-3,0-1,50 16,-30-15,1-2,1-2,0-2,0-2,0-2,1-2,-1-3,1-1,-1-3,0-2,0-1,-1-3,0-2,-1-2,0-2,-1-2,68-41,-90 46,-1-2,0-1,-2 0,0-2,-1 0,0-1,-2-1,15-23,-24 33,-1-1,0-1,-1 1,-1-1,0 0,-1 0,0 0,-1-1,0 1,-1-1,-1 0,0 0,-1 0,0 1,-1-1,-1 0,-4-18,0 14,0 1,-2 0,0 0,0 1,-2 0,0 0,-1 1,0 1,-2 0,1 0,-28-21,2 5,0 3,-2 1,-61-29,22 15,-1 3,-112-34,184 69,3 0,-1 0,0 0,0 1,0-1,0 2,0-1,0 1,0 0,-1 0,1 0,-7 2,12-1,0-1,0 1,0-1,0 1,0 0,0 0,0 0,0 0,1 0,-1 0,0 0,1 0,-1 0,0 0,1 0,-1 0,1 0,-1 0,1 1,0-1,0 0,-1 0,1 0,0 1,0-1,0 0,0 0,1 1,-1-1,0 0,0 0,1 0,-1 1,1-1,0 2,2 6,1 0,0 0,7 11,-9-18,14 23,1-1,1-1,1 0,1-2,1 0,1-1,0-2,2 0,0-1,1-2,36 18,-56-31,0 0,0 0,0 0,1-1,-1 1,0-1,1-1,-1 1,1-1,-1 0,7-1,-10 1,1-1,0 0,0 0,-1 0,1 0,0 0,-1-1,0 1,1-1,-1 1,0-1,1 0,-1 0,0 0,-1-1,1 1,0 0,0-1,-1 1,0-1,1 1,1-6,2-8,0-1,-1 0,-1-1,0 1,-1-1,-1 1,-2-23,-3-13,-10-58,-6 4,-5 1,-4 1,-46-106,72 202,-5-12,-2 1,-20-35,28 51,-1 0,1 1,-1-1,0 1,0-1,0 1,0 0,0 0,-1 1,0-1,1 1,-1 0,0 0,0 0,0 0,0 1,0-1,-1 1,1 0,-9-1,9 3,0-1,-1 1,1 0,0 0,0 0,-1 1,1 0,0-1,0 1,1 1,-1-1,0 0,-3 4,-5 5,0 0,-12 15,14-15,-28 32,2 2,2 1,-53 94,73-113,1 1,1 1,1 0,2 1,0 0,3 0,0 1,-2 56,8-71,1-1,0 1,1-1,1 0,0 0,1 0,1 0,12 26,-12-31,0-1,1 0,0 0,1-1,-1 0,2 0,-1-1,1 0,0 0,1 0,-1-1,1-1,1 0,10 5,-4-3,1-1,0-1,0-1,1 0,-1-1,1-1,29 0,-22-4,1 0,0-1,-1-2,45-13,-30 4,-1-2,0-2,-1-1,-1-3,0 0,40-35,-42 28,-1-2,-1-1,-3-1,0-2,-2 0,24-43,-38 54,-1 0,-1-2,-2 1,13-45,-19 51,0 0,-1 0,-2-1,1 1,-2-1,-1 1,-3-25,1 29,-1 0,0 1,-1 0,0 0,-2 0,1 0,-1 1,-1 0,-1 1,0 0,0 0,-1 1,0 0,-1 0,-1 2,1-1,-1 1,-16-8,0 1,0 2,-1 1,0 2,-1 0,0 2,-1 2,-54-7,11 7,0 4,1 3,-133 17,91 2,-186 55,237-54,-77 36,111-42,1 2,0 1,1 1,-35 30,57-43,0 0,1 0,0 1,0-1,0 1,1 1,0-1,0 0,0 1,1 0,0 0,1 0,-1 0,1 1,1-1,-1 1,1-1,1 1,-1-1,1 1,0-1,1 1,0-1,0 1,1-1,0 1,0-1,1 0,-1 0,2 0,-1 0,6 8,8 7,0 0,1-1,1-1,0-1,2 0,29 19,-20-17,2-1,0-2,1-1,44 15,-58-25,0-2,0 0,39 4,-50-8,-1 0,1-1,0 0,-1-1,1 0,-1 0,1 0,-1-1,1 0,-1-1,0 1,0-1,8-5,-11 5,-1 0,1-1,-1 1,1-1,-1 1,0-1,-1 0,1-1,0 1,-1 0,0-1,0 1,-1-1,1 0,-1 1,0-1,0 0,-1 0,1 0,-1 0,0-7,-1-2,-1 0,0 1,-1 0,0-1,-1 1,-10-23,1 10,-2 1,0 1,-1 0,-2 1,0 1,-2 1,0 1,-27-21,3 6,-2 2,-1 2,-64-31,46 31,-2 3,-1 3,-1 3,-140-25,145 37,0 4,-1 2,1 3,-1 3,-117 19,138-12,1 3,-1 1,2 2,-59 29,72-29,1 1,0 1,2 2,0 1,1 1,-42 45,59-57,0 2,1-1,0 1,0 0,1 1,1-1,0 1,1 0,0 1,0-1,2 0,-1 1,2 0,-1 24,3-21,0 0,2 0,0 0,0-1,2 1,0-1,0 0,2 0,0-1,0 0,17 23,0-6,3 0,0-1,2-2,1 0,1-3,62 40,-29-27,2-2,127 48,-137-64,0-3,1-2,1-2,0-4,0-1,1-4,66-2,-87-4,0-1,0-3,0 0,-1-3,0-1,-1-2,0-1,-1-2,0-1,-1-2,61-43,-73 43,-1-1,-1 0,-1-2,-1 0,-1-1,0-1,-2 0,-1-1,-1-1,-1 0,-1-1,-1 0,7-30,-12 35,-1 1,-1-2,-1 1,-1 0,-1 0,0-1,-7-36,4 42,-2-1,1 1,-2 0,0 0,-1 1,-1 0,0 0,-1 0,-1 1,-15-18,11 18,-1 0,0 0,-1 2,-1 0,0 1,0 0,-1 2,0 0,-1 1,0 1,0 0,-38-6,13 6,-1 1,-1 2,1 3,-79 7,56 2,1 3,0 4,1 2,0 3,-71 33,39-8,3 4,-138 95,147-83,2 5,4 3,-122 135,149-141,2 2,3 3,2 2,5 2,-41 93,62-118,2 1,3 0,2 2,-14 90,25-118,0 1,2-1,0 0,1 1,2-1,0 0,1 0,1 0,1-1,1 0,1 0,1 0,17 27,-12-27,2 0,0-1,1 0,2-1,36 29,-25-26,1-1,1-2,54 25,-29-21,1-3,1-2,0-2,108 12,-93-20,1-4,-1-3,1-4,123-19,-146 13,0-3,-1-2,0-3,-2-1,0-3,-1-1,61-41,-81 45,-2-2,0-1,-2-1,0-1,38-49,-48 53,-1-1,-1 0,-1-1,0-1,-2 1,0-2,-1 1,7-42,-12 53,-2 0,0 0,0 0,-1 0,0 0,-1 1,0-1,-1 0,0 0,0 0,-2 1,1-1,-1 1,-1 0,1 0,-2 1,0-1,0 1,0 0,-1 1,0 0,-1 0,0 0,0 1,-1 0,0 1,0 0,0 0,-1 1,-17-8,5 6,1 0,-1 2,-1 0,-34-2,-99 4,66 10,1 3,0 5,-165 48,118-17,-220 108,252-100,2 4,-169 129,214-141,3 2,2 3,2 1,2 3,-70 105,99-129,2 0,1 1,1 0,2 2,1-1,2 1,-10 57,17-69,1 0,2 0,0 0,1 0,0 0,2-1,1 1,1-1,1 1,0-1,2-1,0 1,16 26,-12-27,1-1,1 0,1-1,0 0,2-1,0-1,0-1,26 17,-17-15,1-1,1-1,1-2,0-1,50 14,-32-15,1-2,0-2,0-2,0-2,1-2,-1-3,95-15,-91 7,-2-3,1-2,-2-2,0-2,-1-3,-1-1,-2-3,0-1,-2-3,-1-1,-1-2,-2-2,-1-1,-2-3,-2 0,-1-2,-3-2,50-90,-64 103,-2-2,-1 0,-2 0,-1-1,-1 0,-2-1,-1 0,-2 0,0-45,-4 59,-1 0,-2 0,0 1,-1-1,0 1,-2 0,0 0,-1 0,-1 1,-1 0,-1 1,0 0,-1 0,-1 1,0 0,-2 1,-20-19,9 14,-2 0,1 2,-2 1,-1 1,0 1,0 2,-33-10,-6 2,-1 4,-91-12,19 13,-2 6,1 6,-247 24,255-3,1 6,2 6,0 6,-133 54,66-2,166-70,0 1,2 1,-50 43,73-56,-1 1,1 0,1 1,-1 0,2 0,-1 0,1 0,0 1,0 0,1 0,-5 17,7-18,1 0,0 0,0 1,1-1,0 0,0 1,1-1,0 0,1 1,0-1,0 0,0 0,1 0,5 9,6 10,1-1,2-1,0 0,2-1,1-1,0-1,25 21,7 0,1-2,62 36,-65-46,2-3,97 39,-128-59,0-1,1-1,0 0,0-2,1-1,-1-1,1 0,-1-2,1-1,31-4,-44 2,1 1,-1-1,0-1,0 0,-1 0,1-1,-1 0,0-1,0 0,-1 0,0-1,0 0,7-9,-6 6,-1-1,-1 0,0 0,0-1,-1 0,-1 0,0-1,0 1,4-21,-6 14,0 1,-1-1,-1 1,0-1,-2 0,0 1,-1-1,-1 1,-1-1,0 1,-1 0,-2 1,1-1,-19-32,12 31,-1 1,-1 0,0 1,-1 1,-1 0,-1 1,0 1,0 1,-40-21,11 10,-1 3,-1 2,-65-16,20 12,-1 4,0 5,-1 3,-1 5,-97 6,151 2,1 1,-1 2,1 1,-81 25,115-28,0 0,1 1,-1-1,1 1,-1 1,1 0,-6 5,11-8,0 0,0 0,0 0,0 0,0 1,1-1,-1 0,1 1,0-1,0 1,0 0,0-1,0 1,0 0,1-1,-1 1,1 0,0 0,0 0,0 0,0-1,0 1,2 4,1 4,0 0,1-1,1 1,0-1,0 0,1 0,12 16,0-4,1-1,23 20,-9-13,2 0,1-2,1-2,1-1,0-2,2-2,1-1,0-3,1-1,0-2,57 9,-83-19,-1 0,0-2,0 1,1-2,-1 0,0-1,22-5,-31 5,1 0,-1 0,0 0,0-1,-1 0,1 0,-1-1,1 1,-1-1,0-1,-1 1,1 0,-1-1,1 0,-2 0,1-1,0 1,-1-1,0 1,3-9,-3 5,-1 0,0-1,0 1,-1-1,0 0,-1 1,0-1,0 0,-1 1,0-1,-1 1,0-1,0 1,-1 0,0-1,-1 2,0-1,-1 0,-5-8,-2 0,0 0,-1 0,0 2,-2-1,0 2,-1 0,-32-22,18 17,0 2,-2 1,0 2,-1 1,-57-15,43 17,-1 3,0 1,-77-1,94 9,-60 7,81-7,0 1,1 0,-1 1,0 0,1 1,0 0,0 0,0 1,0 0,-8 7,15-10,0 0,0 0,0 0,0 1,0-1,0 1,1-1,-1 1,1 0,0-1,-1 1,1 0,1 0,-1 0,0 0,0 4,1-2,0 0,1 0,-1 0,1 0,0 0,0 0,1 0,-1-1,4 7,1 0,0 1,2-1,-1 0,1 0,1-1,14 14,-11-13,-4-2,1 0,1-1,-1-1,1 1,20 9,-28-16,1 0,0 0,-1 0,1 0,0-1,0 1,-1-1,1 0,0 1,0-1,0-1,0 1,-1 0,1-1,0 0,0 1,-1-1,1 0,-1 0,1-1,0 1,-1 0,0-1,1 0,-1 1,0-1,0 0,0 0,0 0,3-5,1-1,0-1,-1 0,0 0,0 0,-1-1,0 0,-1 1,0-1,0-1,-1 1,0 0,-1-1,-1 1,1 0,-2-1,1 1,-1-1,-1 1,0 0,-5-17,3 13,-1 1,-1 0,0 0,0 0,-1 1,-1 0,0 0,-1 1,0 0,0 0,-1 1,-1 0,0 1,-22-15,11 13,-1 0,0 1,0 2,-1 0,0 1,-1 2,1 0,-39-1,35 5,-1 0,0 3,0 0,1 2,0 0,0 3,-33 10,55-15,-1 1,0 0,1 0,0 1,-1-1,2 1,-12 10,15-13,1 1,-1 0,1 0,-1 0,1-1,0 1,0 1,0-1,0 0,0 0,0 0,1 0,-1 1,1-1,-1 0,1 1,0-1,0 0,0 1,0-1,1 0,-1 1,0-1,1 0,0 0,0 1,-1-1,1 0,2 2,1 3,0-1,1 1,0-1,0 0,1 0,0-1,0 0,0 0,0 0,1-1,0 0,0 0,9 3,8 3,1 0,46 9,-35-11,1-2,1-2,-1-1,1-1,52-6,-64 1,0-1,0-1,0-1,0-2,-1 0,0-2,-1-1,35-20,-44 21,-1-1,1 0,-2-1,0 0,0-1,-1-1,15-22,-21 28,-2 1,1 0,-1-1,0 0,-1 0,0 0,0-1,-1 1,0-1,0 1,-1-1,0 0,-1 1,0-1,0 0,-1 0,-2-12,-1 10,0 0,-1 0,0 0,-1 1,0-1,-1 1,0 1,0-1,-1 1,0 1,-18-15,4 6,0 1,-2 1,-49-24,33 22,0 2,-1 1,-1 2,-76-12,86 20,1 2,0 1,0 1,-1 1,1 2,0 1,-41 11,67-13,0-1,1 1,-1 0,1 0,-1 0,1 0,-1 1,1 0,0 0,0 0,1 0,-1 1,1 0,-1-1,1 1,0 0,1 1,-3 3,3-3,0 0,0 0,1 0,0 1,0-1,1 0,-1 0,1 0,0 1,1-1,-1 0,1 0,0 0,0 1,1-1,0 0,2 5,0-1,1 0,0-1,1 1,0-1,1 0,-1-1,1 0,1 0,-1 0,1-1,1 0,10 6,4 1,0-1,1-1,40 12,-42-16,0-1,1-1,-1-1,1-1,0-1,34-1,-47-2,0 0,-1 0,1-1,-1 0,1 0,-1-1,0-1,0 0,0 0,-1 0,1-1,-1 0,0-1,0 0,-1 0,0-1,12-14,-15 15,0 1,0-1,-1-1,0 1,0 0,0-1,-1 0,0 1,0-1,-1 0,2-14,-3 11,-1-1,1 1,-2 0,1 0,-1 0,-1 0,-6-16,3 10,-2 1,0 1,0-1,-2 1,1 1,-2 0,0 0,0 1,-27-21,25 23,-1 2,-1-1,0 2,0 0,0 1,-1 0,0 1,0 1,0 1,0 0,-1 1,1 1,-32 1,39 1,0 0,1 1,-1 0,1 0,0 1,0 0,0 1,0-1,0 1,0 1,1 0,0 0,0 0,1 1,-12 11,11-7,-1 0,1 0,1 0,0 1,0-1,1 1,0 1,1-1,0 1,-3 20,4-16,1 0,0 0,1 1,1-1,1 0,0 0,8 32,-8-42,1 0,0 0,0-1,1 1,0-1,0 1,0-1,0 0,1 0,0 0,0-1,1 0,-1 1,1-1,0-1,0 1,0-1,0 0,0 0,1 0,0-1,-1 0,1 0,9 2,-8-3,1 0,0 0,-1 0,1-1,0 0,0 0,-1-1,1 0,0-1,-1 0,1 0,-1 0,9-5,-6 2,-1 0,0-1,0 0,0-1,-1 0,1-1,-2 1,11-14,-3-1,-1 1,-1-2,0 0,-2 0,-1-1,-1-1,7-28,-8 19,-1 1,-2-1,-1-1,-2 1,-4-67,0 80,-1 1,-1 0,0 0,-2 0,0 0,-1 1,-1 0,-1 1,0-1,-2 2,-15-22,21 33,-1 0,0 0,0 0,0 1,-1 0,0 0,0 1,0-1,-1 2,1-1,-1 1,0 0,0 0,0 1,0 0,0 1,0 0,-1 0,1 1,0 0,-1 0,1 1,-9 2,5-1,1 1,0 0,0 1,0 0,0 1,1 0,0 0,0 1,0 1,1 0,0 0,0 1,0 0,1 0,1 1,-8 10,4-1,1 0,1 1,0 0,2 1,0 0,-8 37,10-25,0 1,2-1,3 57,0-78,1-1,1 1,0-1,0 0,1 0,0 0,1 0,0-1,1 1,0-1,0 0,1 0,0-1,0 1,1-1,13 11,-13-13,1 0,-1-1,1 0,1-1,-1 0,1 0,-1 0,1-1,0-1,0 1,1-2,-1 1,0-1,1 0,-1-1,0 0,1-1,17-3,-9-1,-1 0,1-1,-1-1,-1 0,1-2,-1 0,-1 0,0-1,0-1,-1-1,0 0,-1-1,22-28,-9 6,-1-1,-2-1,-2 0,29-71,-30 57,-2-1,-3-1,-1 0,7-73,-17 94,-2 0,-2 1,0-1,-2 0,-2 0,-1 1,-1 0,-19-56,19 72,-1-1,0 1,-1 1,-1-1,0 1,-1 1,0 0,-1 0,-1 1,0 1,-22-17,23 20,-1 1,0 0,-1 1,0 0,1 1,-2 1,1 0,-1 1,1 0,-1 1,0 0,0 2,0-1,-16 3,9 0,0 1,0 1,1 2,-1-1,1 2,1 1,-1 0,1 2,-32 21,39-23,1 0,0 1,1 0,0 1,1 0,0 1,0 0,1 0,0 1,1 0,1 0,0 1,0-1,2 1,-7 27,9-33,1 1,0-1,1 0,0 1,0-1,1 1,0-1,0 0,0 1,1-1,0 0,1 0,6 13,-4-12,0 0,1 0,0-1,0 0,1 0,0 0,0-1,0 0,15 9,-2-4,1-1,0-1,1 0,-1-2,2 0,-1-2,1-1,27 3,-16-5,0-2,0-1,0-2,-1-1,1-1,-1-2,0-2,-1-1,48-21,-46 15,0-1,-2-2,0-1,-1-1,-1-2,-1-1,-1-1,34-42,-42 43,-2-1,-1-1,-1 0,-1-2,-1 1,-2-2,11-35,-18 48,-1 0,0 0,-2 0,1 0,-2 0,0-1,-1 1,-1-1,0 1,-2 0,1 0,-2 0,0 0,-1 0,-8-17,9 26,0 0,0 0,-1 0,1 1,-1 0,-1 0,1 0,-1 1,0-1,-1 1,1 1,-1-1,-11-4,8 4,0 1,-1 1,0 0,1 0,-1 1,0 1,0 0,-22 1,9 2,1 1,-1 1,0 1,1 1,0 1,0 1,1 1,-28 17,20-9,2 1,0 2,1 1,1 1,-45 51,54-54,2 1,0 1,1 1,1 0,1 0,1 1,1 1,-11 39,18-49,1 0,0 0,1 1,1-1,0 1,1-1,0 0,1 1,1-1,0 0,1 0,0-1,7 15,-6-17,1 0,0-1,0 0,1 0,0 0,1-1,0 0,0 0,1-1,0 0,0-1,1 0,0 0,1-1,21 10,-16-10,1-1,0-1,0 0,0-1,0-1,0-1,1 0,-1-1,0-1,25-4,-20 0,0 0,0-2,-1-1,1 0,-2-1,0-2,27-17,-20 9,-1-1,-1-1,-1-1,-1-1,-1-2,-1 0,-1-1,-2-1,0-1,-2 0,15-36,-20 36,-1 0,-1 0,-1-1,-2 0,-1 0,-1-1,0-38,-5 55,0 0,0 0,-2 0,1 0,-1 1,-1-1,-1 1,-6-16,6 20,0 0,-1-1,1 2,-1-1,-1 1,0 0,0 0,0 1,0 0,-1 0,0 1,-12-6,4 3,0 2,0 0,0 1,-1 0,1 1,-1 1,0 1,-1 1,1 0,0 1,0 1,0 0,0 1,0 1,0 1,0 0,-17 8,10-2,0 0,1 2,0 1,1 0,1 2,0 0,1 2,1 0,0 1,-28 35,32-32,0 1,1 0,1 1,2 0,0 1,1 0,2 1,0 0,2 0,1 1,0 0,0 40,5-51,0 0,1 0,1 0,0 0,1 0,1-1,0 1,1-1,1 0,0-1,1 1,0-1,1 0,0-1,1 0,1 0,0-1,0 0,1-1,0 0,1-1,0 0,19 10,-7-7,1 0,0-2,1-1,0-1,0-1,50 7,-23-9,1-2,84-7,-68-3,-1-2,-1-4,0-3,-1-2,108-46,-116 37,-1-2,-1-3,-2-2,-2-2,-1-3,59-57,-86 71,-1-1,-1-1,-1-1,-2 0,-1-2,-1 0,22-54,-32 65,-2 0,0-1,-1 1,-1-1,-1 0,0-1,-2 1,0 0,-1 0,-2-1,0 1,-1 0,0 0,-11-29,10 37,-1 0,0 1,-1 0,-1 0,0 0,0 1,0 0,-2 0,1 1,-17-14,13 13,-1 1,-1 1,0 0,0 0,0 2,-1-1,-26-6,16 7,-1 2,0 0,0 2,1 0,-1 2,0 1,0 1,0 1,0 1,-27 9,30-6,0 1,0 1,1 1,0 1,1 1,0 1,1 1,0 0,1 2,-22 22,30-25,0-1,1 2,0-1,1 1,1 1,0-1,1 2,1-1,0 1,1-1,1 2,0-1,1 0,1 1,-1 31,4-36,0 0,0 0,1 0,1 0,0 0,0 0,1-1,1 0,0 0,11 19,-7-17,1-1,0 0,1 0,0-1,0 0,1-1,21 14,-7-9,0-1,1-1,1-1,0-2,0 0,1-2,0-1,39 4,-30-8,0 0,0-3,0-1,72-11,-87 8,0-2,0 0,0-2,-1 0,-1-1,1-2,-1 0,-1-1,22-17,-32 21,-1 0,-1 0,0-1,0-1,0 1,-1-1,-1 0,0-1,0 0,-1 1,0-2,5-18,-7 20,-1 0,-1 0,0 1,0-1,-1 0,0 0,-1 0,0 0,0 0,-1 1,0-1,-1 1,0-1,-1 1,-9-17,2 9,0 1,-1 0,-1 1,-1 0,0 2,0-1,-2 2,1 0,-2 0,-27-14,16 12,-1 1,0 2,-1 0,0 2,-61-10,53 14,0 2,0 1,-1 2,1 1,0 3,0 1,0 1,-58 19,76-18,0 1,0 1,1 1,0 1,1 0,0 1,-19 17,25-17,0 1,0-1,1 2,1 0,0 0,1 1,0 0,1 0,-10 30,13-28,0-1,1 1,1 0,1 0,0 0,2 1,0-1,0 0,2 0,0 0,1 0,1 0,0 0,1-1,1 1,1-2,0 1,1-1,1 0,0 0,1-1,0 0,1-1,1 0,0-1,1-1,0 1,23 14,-12-12,0 0,1-2,0 0,1-2,47 12,-16-9,104 8,-90-17,0-4,-1-2,1-4,-1-2,0-4,85-25,-77 12,0-3,-1-3,-2-3,-2-4,74-50,-101 56,0-1,-3-3,-1-2,51-58,-73 73,-2-1,-1 0,-1-1,-1 0,-1-2,-2 0,0 0,-2-1,-1 0,6-30,-13 44,0 0,-1-1,0 1,-1-1,-1 1,0-1,-1 1,0 0,-1 0,-1 0,-9-24,7 26,-1 0,1 1,-2 0,1 0,-2 0,1 1,-1 1,-1-1,0 2,0-1,-1 1,-20-12,6 8,-1 0,0 2,-1 1,0 1,0 1,-1 1,1 2,-1 1,0 1,-1 1,1 1,0 2,-34 6,46-5,1 1,0 0,0 1,0 1,1 0,-1 1,2 0,-1 1,1 1,0 0,1 1,0 0,0 1,2 0,-1 1,1 0,1 1,0 0,-8 16,5-6,2 0,0 0,2 1,1 0,0 0,2 1,1 0,1 0,0 48,4-54,0-1,2 0,0 0,1 0,1 0,0-1,2 0,0 0,0 0,2-1,0 0,1-1,1 0,18 21,-10-17,2-1,0-1,0-1,2-1,0-1,0-1,2-1,-1-1,29 8,0-2,2-3,0-2,74 6,-81-14,1-1,0-3,-1-2,1-2,-1-2,0-2,48-15,-70 15,-1-1,0-1,-1-1,0-1,0-1,-2-1,1-2,-2 0,0-1,-1-1,-1-1,-1 0,-1-2,18-26,-21 24,-1 0,-2-1,0-1,-2 0,0 0,-2-1,-1 0,-1-1,-1 1,-1-1,-1 1,-2-1,-1 0,-1 0,-1 1,-8-35,5 38,0-1,-2 1,0 1,-2 0,0 0,-1 1,-2 0,0 1,-1 0,-1 1,-1 1,0 0,-1 1,-1 1,-1 1,0 1,-1 0,-26-13,32 20,0 2,-1-1,1 2,-1 0,0 1,0 0,-1 1,1 1,0 0,0 1,-1 1,1 0,-16 4,13-1,0 1,1 1,-1 0,1 1,1 1,-1 0,1 2,1-1,0 2,-23 20,16-9,0 1,2 0,0 2,2 0,1 2,-26 51,32-54,2 0,0 0,2 1,0 0,2 0,1 1,1 0,1 47,3-58,0-1,1 1,1-1,0 0,1 0,1 0,0 0,1-1,10 19,-5-16,0-1,0 0,2 0,-1-1,2-1,23 19,-4-9,2-1,0-2,1-1,1-2,1-2,48 14,17-1,0-5,1-4,177 8,-164-24,-1-6,0-4,133-26,-38-16,-177 38,-1-1,0-2,58-33,-83 42,0 0,0-1,0 0,0 0,-1-1,0 0,-1 0,1-1,-1 0,8-15,-11 18,-1-1,0 1,0-1,-1 0,0 0,0 0,0 1,0-1,-1 0,0 0,0 0,-1 0,0 0,0 0,0 0,-1 1,0-1,-3-8,1 8,1-1,-1 1,0 0,-1 0,0 1,1 0,-2-1,1 1,-1 1,1-1,-1 1,0 0,-1 1,1-1,-1 1,1 1,-1-1,-14-3,-6 0,0 2,-1 0,-43 0,49 4,-1 0,1 1,-1 2,1 0,0 1,0 2,0 0,-23 10,36-12,0 0,0 1,1 0,0 0,0 1,0 0,1 0,0 1,0 0,1 0,0 0,0 1,0 0,1 0,0 1,1-1,0 1,0 0,1 0,0 1,-1 11,2-10,1 1,1-1,0 1,1-1,0 1,1-1,0 0,1 0,0 1,1-2,0 1,0 0,1-1,1 0,6 10,2-1,0-1,0 0,2-1,0 0,1-1,29 20,-3-7,1-2,0-3,2-1,1-2,60 17,-63-25,0-1,0-3,1-2,0-2,0-2,54-2,-83-2,0-1,0 0,0-1,0-1,18-6,-29 8,0 0,0 0,0-1,0 0,-1 0,1 0,-1 0,0-1,0 1,0-1,-1 0,1 0,-1-1,0 1,0-1,0 1,-1-1,4-9,-3 4,-1 0,0 1,0-1,-1 0,0 0,-1 0,0 0,0 0,-1 0,-3-10,1 6,-1 1,-1-1,0 1,-1 0,0 0,-11-15,-5-2,-1 1,-1 1,-1 2,-45-37,-46-27,97 78,0 0,0 2,-1 0,-36-12,51 21,-1-1,0 1,0 1,0-1,0 1,0 0,0 1,1-1,-1 1,0 0,0 1,0-1,1 1,-1 0,1 0,-1 1,1 0,0 0,0 0,0 1,1-1,-1 1,-7 9,1-1,1 0,1 1,0 0,0 0,1 1,1 0,-10 28,8-13,2 0,0 1,2-1,2 1,0 0,2 1,1-1,2 0,0 0,3 0,0-1,2 1,1-1,18 45,-15-50,0 0,2 0,0-1,2-1,0 0,2-1,0-1,1 0,1-2,1 0,1-1,0-1,1-1,0-1,2-1,41 18,-34-20,1-1,0-2,0-1,1-1,0-2,0-2,0 0,49-6,-63 3,0-2,0-1,-1 0,1-1,-1-1,0 0,-1-2,0 0,0-1,0-1,-1 0,-1-1,0-1,0 0,24-28,-25 21,-1 0,0-1,-2-1,0 0,-1 0,-1-1,-2 0,0-1,-1 0,-1 0,-1 0,-1 0,-2-1,0 1,-1-1,-1 1,-2-1,0 1,-1 0,-2 0,-10-31,11 44,0 0,0 1,-1-1,0 1,0 1,-1-1,0 1,-1 0,0 0,0 1,-1 0,0 1,0 0,0 0,-1 1,-18-8,19 10,0 0,-1 1,1 0,-1 0,0 1,0 0,1 0,-1 1,0 1,0 0,1 0,-1 1,0 0,1 0,0 1,-1 1,1-1,1 2,-11 5,1 3,0 0,1 1,1 1,0 1,1 0,1 1,0 0,1 2,1-1,1 1,-10 25,3-3,3 0,1 1,2 1,-9 69,17-90,2 0,1 0,1 0,0 0,2 0,7 35,-4-39,0-1,1 1,1-1,1-1,0 1,1-1,1-1,14 19,-11-18,1-2,1 1,0-2,1 0,0 0,1-2,0 0,1-1,0-1,1 0,0-2,22 6,-36-11,1 0,0-1,-1 0,1 0,0-1,0 1,7-2,-13 1,1 0,-1 0,0 0,0 1,0-1,0 0,0 0,0 0,0 0,1 0,-1 0,0 0,0 0,0 0,0 0,0 0,0 0,1 0,-1 0,0 0,0 0,0 0,0 0,0 0,0 0,0 0,1 0,-1-1,0 1,0 0,0 0,0 0,0 0,0 0,0 0,0 0,0 0,1 0,-1 0,0-1,0 1,0 0,0 0,0 0,0 0,0 0,0 0,0-1,0 1,0 0,0 0,0 0,0 0,0 0,0 0,0-1,0 1,0 0,0 0,0 0,-11-5,-19-1,10 6,1 1,0 0,0 1,0 1,0 1,0 1,1 0,0 2,-31 14,14-2,0 1,2 2,-53 43,53-36,2 2,1 2,1 0,2 2,1 1,2 1,2 1,1 2,2-1,-27 84,35-87,2-1,1 1,2 1,2-1,1 1,2 0,1 0,2 0,2 0,1-1,1 0,3 0,19 54,-8-45,1 0,3-2,1 0,3-2,1-1,2-1,1-2,2-1,2-2,40 31,-67-58,0 0,0-1,1 0,0-1,0 0,20 6,-27-10,1 0,-1 0,1 0,-1-1,1 0,-1 0,0 0,1 0,-1 0,1-1,-1 1,1-1,-1 0,0 0,1 0,-1-1,0 1,0-1,0 0,0 1,0-1,0-1,-1 1,1 0,3-5,-1 0,0-1,0 0,-1 0,0 0,0 0,-1-1,0 1,-1-1,0 0,1-9,-1 2,-1 1,0-1,-1 1,0-1,-4-16,4 26,-1 0,-1 0,1 0,-1 1,0-1,0 0,-1 1,1-1,-1 1,-1 0,1 0,-1 0,0 1,0-1,0 1,0 0,-1 0,1 0,-1 1,0 0,-1-1,1 2,0-1,-1 1,0 0,1 0,-1 0,0 1,0 0,0 0,0 0,0 1,-12 1,4 1,0 1,1 0,-1 1,1 1,0 0,0 1,0 0,1 1,0 1,0 0,1 0,-16 16,4-3,1 2,2 1,0 0,-26 44,29-38,1 1,1 1,1 0,2 1,2 0,0 1,3 0,1 0,1 0,2 1,1 0,3 36,2-55,-1 0,2-1,0 1,1-1,1 1,0-2,1 1,0-1,1 0,1 0,13 15,-13-17,1-1,1 0,0-1,0 0,1 0,1-2,-1 1,1-1,1-1,-1-1,1 0,15 5,-26-10,0 0,-1-1,1 1,0 0,0-1,0 0,0 1,0-1,0 0,0-1,0 1,0 0,0-1,0 0,-1 0,4-1,-6 2,1 0,-1 0,0-1,1 1,-1 0,0 0,0-1,1 1,-1 0,0-1,0 1,0 0,1-1,-1 1,0-1,0 1,0 0,0-1,0 1,0 0,0-1,0 1,0-1,0 1,0 0,0-1,0 1,0-1,0 1,0 0,-1-1,1 1,0 0,0-1,0 1,0 0,-1-1,1 1,0 0,-1-1,1 1,-1 0,-15-13,2 7,0 0,0 0,-1 1,1 1,-1 0,-28-2,19 4,0 1,0 0,-43 7,33 1,0 1,1 2,0 1,0 2,2 1,-1 2,2 1,0 1,1 1,1 2,-33 31,46-37,1 0,-22 29,32-39,1 0,0-1,0 1,1 0,-1 1,1-1,0 0,1 1,-1-1,1 1,0-1,0 1,1 0,0-1,0 7,1-9,-1-1,1 0,-1 0,1 0,0 0,0 0,0 0,0 0,0 0,0 0,0 0,1-1,-1 1,1 0,-1-1,1 1,2 1,0-1,-1 0,1 0,-1-1,1 1,0-1,0 0,0 0,8 1,-1-1,1-1,-1 0,1-1,-1 0,0-1,12-3,-3-1,-1-1,0-1,-1-1,1 0,-2-2,1 0,-2-1,1 0,26-29,-17 15,-2-2,-1-1,-1-1,29-53,-41 65,0-1,-1-1,-1 0,-1 0,-1 0,6-36,-11 50,0 0,-1 0,0 0,0-1,0 1,-1 0,0 0,0 0,0 0,-1 0,0 0,0 1,-1-1,1 1,-1-1,-1 1,1 0,-1 0,1 0,-2 0,1 1,0 0,-1 0,0 0,1 0,-2 1,-6-5,-7 0,0 0,0 2,0 0,-1 1,0 1,0 0,0 2,-25 0,-167 11,196-8,-162 18,-215 49,380-65,0 0,1-1,-1 2,1 0,-1 0,1 1,-19 11,30-15,0-1,0 0,0 1,0 0,1-1,-1 1,0-1,0 1,1 0,-1-1,0 1,1 0,-1 0,1 0,-1 0,1-1,-1 1,1 0,0 0,-1 0,1 0,0 0,0 0,-1 0,1 0,0 0,0 0,0 0,0 0,1 0,-1 0,0 0,0 0,1 0,-1 0,0 0,1 0,-1 0,1-1,-1 1,1 0,-1 0,2 1,2 1,-1 0,1 0,0 0,0 0,0-1,1 0,-1 0,6 2,9 2,1 0,0-2,1 0,-1-2,1 0,-1-1,1-1,0-1,23-4,-14 0,0-1,-1-1,0-2,0-1,46-22,-63 25,-1 0,1 0,-1-1,-1 0,1-1,-2 0,16-18,-20 20,0 0,0 0,-1 0,0-1,0 0,-1 0,0 0,0 0,-1 0,0-1,0 1,0-18,-2 23,0 0,0-1,0 1,-1 0,1 0,-1-1,0 1,0 0,0 0,0 0,-3-4,0 2,1 0,-1 0,-1 1,1-1,-10-7,-4-1,-1 1,0 0,-31-14,-74-23,27 16,-2 4,-122-19,145 37,1 3,-1 3,-131 10,157 1,1 1,1 3,0 3,0 1,1 2,1 2,1 3,1 1,0 2,2 2,-48 39,78-56,1 0,0 1,0 1,1 0,1 0,-12 17,20-25,-1-1,1 0,0 1,-1-1,1 1,0-1,1 1,-1 0,0-1,1 1,-1 0,1 0,0-1,0 1,0 0,0 0,1-1,-1 1,1 0,-1 0,1-1,0 1,0-1,0 1,1-1,-1 1,1-1,-1 0,1 1,0-1,-1 0,1 0,0 0,1-1,-1 1,0 0,0-1,1 1,-1-1,4 1,7 4,1 0,0-1,0 0,1-2,-1 1,1-2,0 0,0-1,0 0,0-1,0-1,0 0,23-6,-34 6,-1 0,1 0,0 0,-1-1,0 1,1-1,-1 0,0 0,0 0,0 0,0-1,0 1,0-1,-1 0,1 0,2-4,-4 4,0 0,0 0,0 0,-1 1,1-1,-1 0,1 0,-1 0,0 0,0 0,-1 0,1 0,0 0,-1 0,0 0,0 1,0-1,0 0,0 0,0 1,-1-1,-2-3,-2-4,-1 1,-1-1,1 1,-2 1,1-1,-11-7,-65-42,27 26,-2 1,-83-29,-133-30,-110-2,-8 23,359 64,28 4,-38-6,0-1,-62-22,103 29,0 0,-1-1,1 1,1-1,-1 1,0-1,0 0,1 0,-1-1,1 1,-1 0,1-1,0 0,0 1,0-1,0 0,1 0,-1 0,1 0,0 0,0 0,0-1,0 1,0 0,1 0,-1-1,1 1,0-1,0 1,1-6,1-2,0 1,1-1,0 1,0 0,1 0,0 0,1 1,0 0,10-13,163-188,-146 175,605-705,-589 679,70-117,-112 167,0 0,-1-1,0 1,-1-1,0 0,-1 0,3-19,-6 27,1 0,-1 1,-1-1,1 0,0 1,-1-1,0 1,0-1,0 1,0-1,-1 1,1 0,-1-1,0 1,0 0,0 0,0 0,0 0,-1 1,1-1,-1 1,0-1,0 1,0 0,0 0,0 0,0 1,-6-3,-8-2,0 1,0 1,-1 0,0 1,0 1,-21 0,-22 1,0 3,1 2,-1 3,1 2,-63 20,0 7,-161 71,165-55,-131 79,198-99,1 2,2 2,2 2,-73 76,107-100,1 1,1 0,0 0,1 1,1 0,-9 21,15-31,1 1,0 0,0-1,0 1,1 0,0 0,0 0,1 0,0 0,0 0,1 0,0 0,0 0,1-1,0 1,0 0,0-1,1 1,4 7,-2-6,0 0,1-1,-1 0,1 0,1-1,0 0,-1 0,11 6,0-1,1-1,30 13,-14-9,2-2,0-1,0-2,0-1,1-2,54 2,-44-8,1-2,-1-1,0-3,79-20,-47 4,0-4,-2-4,89-47,-109 47,-2-3,-1-3,-2-1,81-78,-116 99,-1-2,-1 0,0 0,-2-1,0-1,-1 0,13-33,-21 43,0 0,-1 0,-1 0,1-1,-2 1,1-1,-1 1,-1-1,0 0,-1 1,0-1,0 0,-1 1,-1-1,1 1,-2 0,0 0,-5-11,2 9,0 1,0 0,-1 1,0 0,-1 0,0 1,-19-15,12 12,-2 1,1 0,-2 1,-25-9,-3 2,-2 3,0 1,-60-6,12 7,1 5,-1 4,0 4,1 5,0 3,0 5,1 4,-182 60,236-64,-66 34,97-43,0 1,0 1,0-1,1 1,0 1,1 0,-1 0,1 1,1 0,0 0,-7 12,11-16,1-1,0 1,0 0,0 0,1 1,-1-1,1 0,1 0,-1 1,1-1,0 0,0 1,0-1,1 0,0 1,0-1,0 0,1 0,-1 0,1 0,1 0,-1 0,1 0,-1-1,6 7,2 0,0 0,0 0,1-1,1 0,0-1,0-1,0 0,17 8,19 6,1-2,0-3,1-1,56 9,4-4,1-4,1-6,0-4,0-5,1-5,-1-5,-1-4,133-34,-199 35,0-2,-1-1,0-3,49-27,-80 36,0 0,-1-1,0 0,-1 0,0-1,0-1,-1 0,-1-1,0 0,10-17,-15 23,-1 0,0-1,0 1,-1-1,1 0,-2 0,1 0,-1 0,0 0,0 0,-1 0,0-1,0 1,-1 0,0 0,0 0,0 0,-1 0,0 0,-1 1,0-1,0 0,-5-8,-1 3,-1 0,0 0,0 1,-2 1,1-1,-1 2,0 0,-1 0,0 1,-1 1,1 0,-26-9,-2 3,-1 1,0 2,-60-7,35 10,0 4,-1 2,1 3,0 4,0 2,1 3,0 3,-74 26,103-27,1 1,0 2,1 2,1 1,1 1,-43 36,59-42,1 1,0 1,1 1,1 0,-15 26,21-30,0 2,1-1,1 1,0 0,1 0,1 1,0-1,-1 19,4-24,0 0,1 0,0 0,1 0,0 0,1 0,0 0,1 0,0-1,6 15,-3-12,1 1,0-1,1-1,1 1,0-2,18 19,-1-7,0-2,2 0,0-2,1-1,50 21,-1-6,2-4,0-3,2-4,156 20,-144-32,0-4,1-5,-1-3,107-18,-134 9,-1-2,-1-3,122-50,-148 49,-1-1,-1-1,-1-3,-1-1,-1-1,-1-2,39-42,-57 52,0 0,-2-1,0-1,-1 0,0-1,-2 0,-1 0,12-37,-17 42,0-1,-1 0,-1 0,-1 0,0 0,-1 0,-1 0,0 0,-1 0,-1 0,0 0,-10-26,3 18,-2-1,-1 2,-1 0,0 0,-2 1,-1 1,0 1,-2 0,0 1,-36-27,6 12,0 1,-2 3,-94-41,-28 6,140 56,-1 0,0 3,-41-4,68 9,0 1,0 0,0 0,0 0,0 1,-13 3,18-3,1-1,-1 1,0 0,1 0,-1 0,1 0,-1 0,1 0,-1 0,1 1,0-1,0 0,0 1,0-1,0 1,0-1,0 1,0 0,0-1,1 1,-1 0,1 0,-1-1,1 1,0 0,-1 0,1 0,0-1,0 1,1 3,0 3,0-1,1 1,0-1,1 1,-1-1,2 0,-1 0,1 0,-1 0,2-1,-1 1,9 8,6 8,1 0,1-2,1 0,1-2,43 29,-13-16,105 46,87 12,-99-49,3-7,0-7,2-6,202 2,-253-23,0-5,101-18,-131 10,-1-3,0-3,103-43,-136 46,-1-1,0-2,62-46,-80 51,0-1,0-1,-2 0,0-1,-1-1,0 0,-2 0,11-23,-18 31,0 0,0-1,-2 0,1 0,-1 0,-1-1,0 1,-1 0,0-1,-1-20,-1 23,0-1,-1 1,-1 0,1-1,-2 1,1 0,-1 1,0-1,-1 1,0-1,-1 1,1 1,-10-10,-1 1,-1 0,-1 1,0 1,-1 1,-1 0,0 1,0 2,-37-15,8 9,-1 1,-97-15,81 22,-121-1,65 14,1 6,-142 31,-234 88,346-80,-200 95,279-109,1 4,2 2,2 3,-94 83,132-100,1 0,1 2,-43 62,59-75,1 0,1 1,1-1,0 2,1-1,1 1,1 0,1 0,-4 32,8-39,0 0,0 0,1 0,1 0,0-1,0 1,2-1,-1 1,10 20,-5-17,1-1,0 0,0 0,2-1,0 0,16 15,2-3,0-2,2-1,1-2,0-1,56 24,-19-15,1-3,122 27,155-2,-238-43,0-4,114-13,-152 3,-1-3,0-4,-1-2,80-31,-124 37,0-1,0-1,-1 0,-1-2,0-1,33-29,-45 34,-1 0,0-1,-1 0,-1 0,1-1,-2 0,0-1,0 1,-1-2,0 1,-2 0,1-1,4-28,-7 23,-2 0,1 0,-2 0,-1 0,0 0,-1 0,-1 1,-1-1,-1 1,0 0,-1 0,-11-18,1 5,-1 1,-2 0,-1 2,-1 0,-47-44,28 35,-2 2,-2 2,-1 1,-61-30,35 27,-1 3,-110-33,51 31,0 5,-2 6,-160-6,177 23,-1 4,-205 24,267-13,0 2,-103 37,123-33,0 1,2 1,0 2,1 1,-34 28,51-35,0 1,1 0,1 1,0 1,1 0,1 1,-15 27,21-32,0 1,1-1,0 1,1 0,1 0,0 0,1 1,0-1,1 0,1 1,0 0,2 18,2-13,-1-1,2 1,1-1,0 0,1-1,1 1,1-1,0-1,22 31,-12-26,0 1,1-2,1-1,1 0,0-2,26 15,6-1,3-2,0-3,2-2,0-3,78 16,-53-18,0-4,1-3,0-4,0-4,151-12,-176 1,-2-3,1-3,88-30,-105 27,0-2,-1-2,-1-2,-1-1,45-36,-62 41,-1-2,0 0,-2-1,0-2,-2 0,0 0,-1-2,-2 0,0 0,-2-1,-1-1,-1 0,-1-1,-2 0,0 0,-2 0,-2-1,0 0,-2 0,-1 0,-1 0,-1 0,-2 1,-7-29,3 25,-2 1,0 0,-2 1,-2 0,0 1,-2 0,-33-43,25 42,-1 1,-2 1,0 1,-2 1,-1 2,-36-22,26 22,0 1,-1 3,-1 2,-1 1,-1 2,0 2,-1 2,0 2,0 2,-1 2,-79 1,110 5,0 0,0 0,0 2,0 0,0 0,-24 10,34-11,1 1,-1-1,0 1,1 0,0 0,-1 0,1 0,0 1,1 0,-1 0,1 0,0 0,0 1,0-1,0 1,1-1,0 1,0 0,0 0,0 0,1 0,-1 10,1-9,1 1,0 0,0 0,1 0,0-1,0 1,1 0,0-1,0 1,0-1,1 1,0-1,0 0,0 0,6 7,4 2,0 0,0 0,1-1,23 16,7 3,1-3,2-1,0-3,2-2,71 25,-46-24,2-3,0-4,90 10,-115-22,0-2,1-2,-1-3,91-12,-119 8,1 0,-1-2,-1 0,1-2,25-14,-33 15,-1 0,-1-2,0 0,0 0,-1-1,0 0,-1-1,15-21,-12 11,-2 0,-1-1,0 0,-2-1,0-1,-2 1,-1-1,0 0,-2 0,-1-1,-1 1,-2-1,0 0,-2 1,-8-49,7 63,0 0,-1 1,0 0,0 0,-1 0,-1 0,-7-10,11 17,0 0,0 0,0 0,-1 1,1-1,-1 1,0-1,0 1,0 0,0 0,0 0,0 1,0-1,-1 1,1-1,-1 1,1 0,-1 1,1-1,-1 0,0 1,1 0,-1 0,0 0,-4 1,0 2,0 0,1 1,-1 0,1 0,0 0,0 1,0 0,0 1,1 0,0 0,-6 8,-12 13,1 1,1 1,2 2,-22 42,-53 141,50-94,5 2,-36 185,60-212,4 0,4 1,9 189,3-239,1-1,2-1,3 1,1-1,23 57,-26-82,1-1,1 0,1-1,0 0,1 0,15 14,-17-20,1-1,0-1,0 0,1 0,0-1,1-1,0 0,0 0,18 5,-15-8,0 0,0-1,0 0,0-2,1 0,-1 0,0-2,1 0,-1-1,0 0,0-1,0-1,0-1,-1 0,16-8,5-5,-1 0,-1-3,-1-1,0-1,33-32,-5-2,-3-2,-2-3,-3-3,-3-1,-3-3,-3-2,36-79,-40 64,-4-2,-4-1,-3-2,-5-1,24-184,-43 224,-2-1,-3 0,-2 0,-3 0,-1 1,-25-93,22 113,-2 1,-1 1,-1 0,-2 0,0 2,-2 0,-2 0,0 2,-2 1,0 0,-2 1,-28-22,19 23,0 1,-1 1,-2 3,0 0,0 2,-2 2,0 2,0 1,-42-7,5 7,1 2,-1 4,-137 8,207-3,-143 16,133-13,-1 0,1 1,0 1,0 0,0 1,1 0,-25 16,31-16,0 1,1 0,-1 0,1 0,1 1,0 0,0 0,0 0,1 0,0 1,0 0,1 0,1 0,-3 10,0 11,0 0,2 1,1 32,2-49,1-1,0 1,1-1,0 0,1 1,1-1,0 0,1-1,0 1,1-1,0 0,1 0,0-1,1 0,1 0,9 9,-5-7,0-1,2 0,-1-1,2-1,-1-1,1 0,0-1,1 0,0-1,0-1,26 5,-13-5,-1-1,2-1,-1-2,0-1,47-5,-62 3,0-1,0-1,0-1,-1 0,1-1,-1 0,0-1,0-1,-1 0,0-1,0 0,21-19,-27 20,-1 1,1-1,-2-1,1 1,-1-1,0 0,-1-1,0 1,0-1,-1 1,0-1,2-12,-3 8,-1 1,0-1,0 0,-2 0,0 0,0 1,-1-1,-4-14,-2 0,-2 0,-1 1,-1 0,-1 0,-2 1,0 1,-25-29,36 47,-14-13,17 18,0 1,1-1,-1 1,0 0,1 0,-1-1,0 1,1 0,-1 0,0 0,0 0,1 0,-1 0,0 0,1 0,-1 0,0 0,1 0,-1 0,0 0,0 1,1-1,-1 0,0 1,1-1,-1 0,1 1,-1-1,1 1,-1-1,0 1,1-1,0 1,-1 0,-12 16,2 0,0 1,1 0,1 1,-12 36,-4 6,-29 49,-26 62,77-167,-7 26,9-30,1 0,0 0,-1 0,1 0,0 1,0-1,0 0,0 0,0 0,0 0,0 0,0 1,0-1,0 0,1 0,-1 0,0 0,1 0,0 2,0-3,0 0,0 1,-1-1,1 0,0 0,0 0,0 0,0 0,0 0,0 0,-1 0,1 0,0 0,0 0,0-1,0 1,0 0,-1 0,1-1,0 1,0-1,-1 1,2-2,15-7,-1-1,0-1,-1 0,0-1,13-15,67-77,-57 58,-2-1,-2-2,-2-2,-2-1,-3-1,-2-1,23-73,-42 108,-1 0,-1-1,-1 1,2-31,-5 42,0 0,0 0,-1 1,-1-1,1 0,-1 0,0 1,-1-1,0 1,0 0,-1 0,0 0,0 0,-5-6,-1 3,0 0,0 0,-1 2,0-1,-1 1,1 1,-1 0,-1 1,0 0,1 1,-2 0,-21-4,-14-1,0 2,-58-2,8 5,-1 4,1 5,-121 19,206-21,-3 1,-33 9,46-11,1 0,0 0,0 0,0 1,0-1,0 1,0 0,0 0,1 0,-1 0,0 0,1 1,0-1,0 1,0-1,-3 5,5-5,-1 0,0 0,1 1,-1-1,1 0,0 1,0-1,0 0,0 1,0-1,0 0,1 1,-1-1,1 0,0 0,-1 1,3 2,22 36,-2-11,2-1,1-2,34 29,95 67,-115-93,1-2,75 38,-95-58,-21-8,0 0,1 0,-1 0,0 0,0 0,0 0,1 0,-1 0,0 0,0 0,0 0,1 0,-1 0,0 0,0 0,0 0,1 0,-1 0,0 0,0 0,0 0,1 0,-1 0,0 0,0-1,0 1,1 0,-1 0,0 0,0 0,0 0,0-1,0 1,0 0,1 0,-1 0,0-1,0 1,0 0,0 0,0 0,0-1,0 1,0 0,0 0,0 0,0-1,0 1,0 0,0 0,0 0,0-1,0 1,0 0,0 0,0 0,0-1,-1 1,1 0,0 0,0-1,-8-12,-3 0,0 1,-1 0,-24-18,-47-28,62 44,-4-3,-1 2,0 0,-1 1,-1 2,-36-11,50 19,0 1,0 0,0 1,0 1,0 0,0 0,0 2,0 0,-1 1,1 0,0 1,1 0,-23 9,13-1,1 1,1 0,0 2,0 0,-30 29,9-2,-50 62,54-54,3 1,1 2,3 2,2 1,3 1,-29 90,30-51,23-86,0 0,1 0,1 1,-1-1,2 1,-1-1,1 0,3 10,-4-16,1 0,0-1,0 1,0 0,1-1,-1 1,1-1,-1 1,1-1,0 0,0 0,0 0,0 0,0 0,1 0,-1 0,0-1,1 1,0-1,-1 0,1 0,0 0,-1 0,1 0,0 0,0-1,4 1,-4-1,1 0,0 0,-1 0,1-1,0 1,0-1,-1 0,1 0,-1-1,1 1,-1 0,0-1,1 0,-1 0,0 0,0 0,0-1,0 1,-1-1,5-4,-3 0,0-1,0 0,0 1,-1-1,0 0,0-1,-1 1,0 0,0-1,-1 0,-1 1,1-1,-1 1,-2-16,0 9,0 1,-1-1,-1 1,0 0,-1 0,0 0,-15-25,13 27,-2 0,1 1,-1 0,-1 0,0 1,-1 0,0 1,0 0,-24-13,17 12,-1 2,-1 0,1 0,-1 2,0 1,-25-4,0 4,1 3,-1 1,0 2,0 2,-76 15,35 1,1 5,1 3,1 4,-151 80,205-96,1 2,1 1,1 2,0 0,1 2,1 0,2 2,-21 27,34-39,1 1,0 0,1 0,1 1,0 0,1 0,0 0,-3 21,6-23,1 1,1-1,0 0,0 1,1-1,1 1,0-1,0 0,1 0,1 0,6 14,-2-9,1-1,1 0,0-1,1 0,0-1,2 0,-1-1,2 0,-1-1,2 0,0-1,0-1,1 0,0-2,0 1,1-2,21 7,-32-13,0 1,0-1,0 0,0 0,0-1,0 0,-1 0,1 0,0-1,0 0,0 0,0 0,8-3,-10 1,1 1,-1 0,0-1,0 0,0 0,0 0,-1-1,1 1,-1-1,0 0,0 0,0 0,0 0,-1 0,0-1,3-6,0-4,0-1,-1 1,-1-1,0 0,-2 0,1 0,-2 0,0 0,-1-1,-1 1,0 1,-1-1,-1 0,0 1,-2-1,1 1,-2 0,-8-14,4 9,-1 0,-1 1,0 0,-2 1,0 1,-1 0,-1 2,0-1,-1 2,-1 0,0 2,-25-13,12 11,0 1,-2 2,1 2,-1 1,0 1,-46-2,6 5,-141 10,42 14,135-13,0 1,-55 19,88-25,0 1,-1-1,1 1,0 0,0 0,0 0,1 1,-1 0,1 0,0 0,0 0,-6 9,6-6,0 0,1 0,0 1,0-1,0 1,1 0,0 0,-1 11,2-6,1 0,0 0,0 0,1 0,1 0,1 0,-1 0,8 19,-1-9,1 0,1-1,22 35,-22-42,1 0,0 0,1-2,0 1,1-2,29 21,-7-10,72 33,-77-41,2-1,0-2,0-2,1-1,0-1,65 6,-86-14,1 0,0-1,0 0,0-1,-1 0,1-2,-1 1,22-10,-26 9,0-1,0-1,-1 1,0-1,0-1,0 1,-1-1,0-1,0 1,-1-1,0 0,0-1,4-9,-5 9,0-1,-1 0,-1 0,1 0,-2-1,1 1,-1-1,-1 1,0-1,-1 0,0 1,0-1,-1 0,0 1,-1-1,-1 1,1-1,-2 1,1 0,-1 0,-1 0,0 1,-8-12,0 2,-1 0,-1 2,0-1,-2 2,0 0,-1 1,0 1,-1 1,-37-20,22 17,0 2,-1 1,0 2,-1 1,-1 2,1 2,-1 1,0 2,0 1,0 2,0 2,0 1,0 2,0 1,1 2,-49 18,74-22,-1 0,2 1,-1 0,-19 13,28-16,-1 0,1 1,-1-1,1 0,0 1,0 0,0-1,0 1,0 0,1 0,-1 0,1 0,0 0,0 0,0 0,0 1,0-1,1 0,0 1,0-1,-1 0,2 5,0-1,0 0,1 0,0 0,0 0,1 0,-1-1,1 1,1-1,0 0,-1 0,2 0,-1 0,1-1,0 1,0-1,0 0,7 4,2 1,1 0,0-1,0-1,1-1,0 0,19 5,6 0,0-3,1-1,0-2,0-2,1-2,0-2,51-6,-25-2,-1-4,-1-2,116-41,-124 32,-1-2,-1-2,-1-3,-1-2,-3-3,91-77,-114 84,0-1,-3-1,0-2,39-64,-50 70,-1-2,-1 0,-2 0,-1-1,-1-1,-1 1,3-34,-9 47,-1-1,0 1,-1-1,-1 0,0 1,-1-1,-9-30,8 36,-1 1,-1 0,1 0,-2 0,1 0,-1 1,-1 0,1 0,-2 0,1 1,-1 1,-15-12,7 7,-1 2,0 0,-1 1,0 0,0 2,-1 0,0 1,0 1,0 1,-1 1,1 0,-1 2,-25 0,10 3,-1 2,1 1,0 1,1 3,0 0,-53 23,10 3,1 3,2 3,-113 84,105-61,2 4,-110 124,165-163,0 2,2 0,-26 49,39-63,2 1,0 1,1-1,1 1,0 1,2-1,0 1,-1 29,5-38,1 0,0 1,0-1,2 0,-1 1,1-1,1-1,0 1,1 0,-1-1,2 0,0 0,8 10,-5-8,1 0,0-1,1 0,0-1,0 0,1-1,1 0,-1-1,26 11,2-2,1-3,0-1,57 9,133 9,60-15,-259-16,-1-2,1-2,0-1,-1-1,0-1,0-2,31-14,-48 16,0 0,-1 0,0-2,-1 0,1 0,-2-1,1-1,-2 1,1-2,-1 0,-1 0,0-1,-1 0,0 0,-1-1,-1 0,0 0,-1 0,0-1,-1 0,-1 0,-1 0,0 0,0-1,-2 1,0-1,-1 1,-3-22,0 16,-1 1,-1 0,-1 0,0 0,-2 1,0 0,-1 1,-1 0,0 0,-2 1,0 1,0 0,-2 1,0 0,-29-20,16 15,-1 1,-1 2,0 2,-1 0,-1 2,0 1,-1 2,-63-12,43 15,0 3,0 1,-1 3,1 3,0 1,0 3,-77 20,51-4,0 3,2 3,1 4,-81 47,140-70,-1 1,2 1,-1 0,2 1,-1 0,2 1,-21 27,26-30,2 1,0 0,0 1,1-1,1 1,0 1,1-1,0 1,1-1,0 1,0 25,3-20,1 0,0 0,2 0,0 0,1-1,1 1,1-1,1 0,0 0,1-1,1 0,12 17,6 5,1-1,3-2,59 57,-32-40,2-3,3-3,100 58,-151-98,33 16,-43-21,0-1,1-1,-1 1,1 0,-1-1,1 1,-1-1,1 0,-1 1,1-1,0-1,-1 1,1 0,-1-1,4 0,-5 0,0 1,0-1,0 0,0 1,0-1,0 0,0 0,0 0,0 0,-1 0,1 0,0 0,0 0,-1 0,1-1,-1 1,1 0,-1 0,0 0,1-1,-1 1,0 0,0 0,0-1,0 1,0 0,0-1,0 1,0 0,-1 0,0-2,0-4,-1 0,0 1,-1-1,-5-9,-7-10,-1 0,-1 2,-1 0,-2 1,0 1,-1 0,-31-23,24 24,-1 1,0 1,-2 1,0 2,-64-24,84 36,-2 0,1 1,0 0,0 1,-1 0,1 1,-1 1,0 0,1 0,-1 2,1-1,-1 1,1 1,0 1,0-1,0 2,1 0,-1 0,1 1,0 0,1 1,-1 0,1 1,1 0,-15 16,7-4,1 1,1 1,1 0,0 1,2 0,1 1,-14 44,10-19,3 1,1 1,-3 53,11-70,2 0,4 60,0-73,0 1,2-1,0 0,2 0,13 31,-7-26,1-1,1 0,1-1,1-1,1-1,26 26,-16-22,1-2,1 0,1-2,41 22,-13-14,1-3,1-3,2-2,0-3,82 13,77-1,-172-28,0-2,75-8,-95 3,-1-1,1-1,-2-2,1-1,36-17,-44 16,-1-1,0-2,-1 0,0 0,-1-2,0 0,25-30,-23 20,0-1,-2-1,-1-1,-2 0,0-1,-2-1,15-52,-19 53,-3 0,0-1,-2 0,-1 0,-1 0,-2-1,-1 1,-6-39,4 51,-2 0,0-1,-1 2,0-1,-2 1,0 0,-1 0,-1 1,0 0,-1 1,-1 0,0 1,-1 0,-1 1,0 1,0 0,-1 0,-1 2,0 0,-1 1,1 0,-2 2,1 0,-1 1,0 0,0 2,-1 0,1 1,-1 1,-21 0,20 2,0 1,0 1,0 0,0 2,1 0,-1 2,1 0,1 1,-29 14,26-10,1 2,1 0,0 1,0 1,1 0,1 1,-27 35,31-34,1 1,0 0,2 1,0 0,1 0,1 1,1 0,-8 38,12-41,1 1,0 0,2-1,0 1,1 0,0 0,2-1,0 1,1-1,1 0,8 21,-3-16,1 0,2-1,0-1,0 0,2-1,1-1,0 0,1-1,1 0,1-2,38 25,-14-14,1-2,1-2,1-2,88 25,-42-21,1-4,110 8,196-14,-298-16,1-4,-1-5,-1-4,159-45,-205 42,0-3,-2-1,89-54,-104 52,-1-2,-1-1,-1-2,-1-1,43-53,-59 61,-1-1,-1-1,-1 0,-1-1,-1-1,-1 0,-1 0,-2-1,10-50,-13 36,-1-1,-1 1,-3 0,-1-1,-13-75,10 94,-2 0,0 0,-1 0,-1 1,-1 0,-1 1,-16-27,19 38,1 1,-1-1,-1 2,0-1,0 1,-1 0,0 1,0 0,0 0,-1 1,0 0,0 1,-1 0,0 1,0 0,-21-5,19 7,1 1,-1 0,0 0,1 1,-1 1,1 0,-1 1,1 0,-1 1,-21 8,18-4,1 0,0 1,1 1,0 0,0 1,1 1,-18 17,12-7,1 0,1 1,1 1,1 0,1 1,1 1,1 0,1 1,-13 47,22-62,0-1,0 1,1-1,0 1,1-1,1 1,-1-1,2 1,-1-1,7 20,-3-16,1 1,0-1,1 0,1-1,0 0,17 21,-2-9,0-1,2-2,0 0,1-2,1-1,33 18,-11-10,1-3,1-2,89 26,-101-38,-1-1,1-3,1-1,-1-1,77-5,-104 0,-1 0,1-1,-1-1,0 0,0 0,0-1,0 0,13-8,-19 9,0 0,0-1,-1 1,0-1,1 0,-1 0,0 0,-1 0,1-1,-1 0,0 0,0 0,-1 0,1 0,-1 0,0-1,-1 1,3-9,-3 7,-1 0,1 1,-1-1,0 0,0 0,-1 0,0 0,0 0,-1 0,0 1,0-1,-1 1,-3-9,0 7,1-1,-1 0,-1 1,1 0,-1 1,-1-1,1 1,-11-6,-3-1,0 1,-1 1,0 1,-1 1,-1 0,-37-8,6 6,0 3,-1 2,1 3,-1 2,-104 9,129-3,1 0,-1 2,1 1,-34 13,42-11,2 0,-1 2,2 0,-1 1,1 1,-22 20,8 0,1 0,2 2,2 1,1 1,2 2,1 0,2 2,2 0,2 2,2 0,1 0,-17 92,29-116,1 1,1 0,0 0,2 0,0 0,1-1,5 21,-4-28,1-1,0 0,0 1,1-2,1 1,-1 0,2-1,-1 0,2-1,-1 0,1 0,1 0,11 9,11 3,2-1,0-1,1-2,0-2,41 13,-37-15,1-1,0-2,1-2,0-1,1-2,62-1,198-21,-59-10,243-60,-116-11,453-184,-513 151,-64 9,-179 85,-1-3,97-79,-155 113,46-43,-50 46,0-1,0 1,0-1,-1 0,1 0,-1 0,0-1,0 1,0 0,-1-1,2-5,-3 9,0-1,0 1,0 0,0-1,0 1,-1-1,1 1,0 0,-1-1,1 1,0 0,-1 0,0-1,1 1,-1 0,0 0,0 0,0 0,1 0,-1 0,0 0,0 0,-1 0,1 0,0 0,0 0,0 1,0-1,-1 1,1-1,0 1,-1-1,1 1,0 0,-1 0,1-1,-3 1,-4-1,0 1,0-1,0 1,0 1,-10 1,-21 7,1 1,1 2,-43 20,24-10,-91 36,-155 86,301-144,-12 7,0 1,0 1,-16 13,27-20,-1 1,1-1,0 1,-1 0,1 0,1 0,-1 0,-3 6,5-7,-1-1,1 1,0 0,-1-1,1 1,0 0,0-1,0 1,0 0,1-1,-1 1,0 0,1-1,-1 1,1-1,-1 1,1-1,0 1,1 1,0 0,0 0,0 0,1-1,-1 0,1 1,0-1,0 0,-1 0,1 0,0-1,1 1,3 1,44 11,-47-14,48 10,1-3,82 0,112-19,-72-6,-1-8,188-53,-341 73,0 0,-1-1,1-1,-1-1,22-13,-41 21,1 0,-1 0,1 0,-1 0,1-1,-1 1,1 0,-1-1,0 1,0-1,0 1,0-1,0 0,0 1,0-3,0 3,-1 0,0 0,0 0,0 0,0 0,-1 0,1 1,0-1,0 0,0 0,-1 0,1 0,0 0,-1 1,1-1,-1 0,1 0,-1 1,0-1,1 0,-1 1,-1-2,-3-2,0 1,-1 0,0-1,0 2,0-1,0 1,-12-3,-25-4,-1 1,1 2,-2 3,-68 2,31 6,-131 25,182-23,1 0,1 2,-1 2,2 0,-38 22,52-26,1 1,0 1,1 0,0 1,0 0,1 1,0 0,1 1,0 0,1 0,1 1,-11 22,16-30,1 1,-1 1,2-1,-1 0,1 0,0 1,0-1,1 0,0 11,0-14,0-1,1 1,-1-1,1 0,0 0,-1 1,1-1,0 0,0 0,1 0,-1 0,0 0,1 0,-1 0,1 0,0-1,-1 1,1-1,0 1,0-1,0 1,0-1,0 0,0 0,0 0,1 0,-1-1,3 2,5-1,-1 1,1-1,0 0,11-1,-17 0,0 0,-1-1,1 1,0-1,0 0,0 0,-1 0,1 0,0-1,-1 1,1-1,4-4,-7 6,-1 0,0 0,0 0,1 0,-1-1,0 1,0 0,1 0,-1 0,0 0,0-1,0 1,0 0,1 0,-1 0,0-1,0 1,0 0,0 0,0-1,0 1,0 0,1 0,-1-1,0 1,0 0,0 0,0-1,0 1,0 0,0-1,0 1,-1 0,1 0,0-1,0 1,0 0,0 0,0-1,0 1,0 0,-1 0,1 0,0-1,0 1,0 0,-1 0,-14-4,7 5,1-1,0 1,1 1,-1-1,0 1,0 0,0 1,-7 4,-52 32,53-31,-15 10,2 2,0 0,1 2,1 0,1 2,-35 45,54-63,0 0,1 0,-1 0,1 0,0 1,-2 7,5-12,-1 0,1 0,0 0,-1 0,1 0,0 0,0 0,1 0,-1 0,0 1,0-1,1 0,0-1,-1 1,1 0,0 0,0 0,0 0,0 0,0-1,0 1,0 0,1-1,-1 1,2 0,2 2,0-1,0 0,-1 0,2-1,-1 0,0 0,0 0,1 0,-1-1,1 0,8 1,4-1,-1 0,26-3,-21-1,0 0,1-2,-1 0,38-16,-46 16,-1-1,0-1,-1 0,0 0,0-2,0 1,-1-1,17-19,-26 27,-1-1,0 1,0-1,1 1,-1-1,0 1,0-1,-1 1,1-1,0 0,0 0,-1 1,1-1,-1 0,0 0,1 0,-1 0,0 0,0 1,0-1,0 0,-1-2,0 2,0 0,0 0,0 0,0 1,-1-1,1 0,0 1,-1-1,0 1,1 0,-1-1,0 1,1 0,-1 0,0 0,-3-1,-5-1,0 0,1 0,-1 1,0 0,0 1,-1 0,-11 0,-3 4,0 1,0 1,0 1,0 2,1 0,0 1,1 2,0 0,-33 23,43-26,2 0,-1 1,1 1,-19 21,25-25,0 1,0 0,1 0,0 0,0 0,1 1,0-1,0 1,0 0,0 9,2-15,1 0,-1 1,1-1,0 0,0 0,0 1,0-1,1 0,-1 1,1-1,-1 0,1 0,0 0,0 1,0-1,0 0,0 0,0 0,1-1,1 3,0-1,-1-1,1 0,0 0,1 0,-1 0,0 0,0-1,1 1,-1-1,1 0,5 1,4 0,-1-1,1 0,0-1,-1-1,1 0,18-3,-12 0,-1-1,1-1,-1 0,0-2,-1 0,1-1,-1 0,-1-1,0-1,-1-1,0 0,-1-1,0-1,-1 0,0-1,-1 0,-1-1,-1 0,0-1,-1 0,9-22,-17 35,1 0,-1 0,0 0,0-1,0 1,-1 0,1 0,-1-1,0 1,-1 0,1 0,-1-1,1 1,-1 0,-3-8,2 9,0 0,0 0,0 0,0 0,-1 1,1-1,-1 1,0-1,0 1,0 0,0 0,0 0,0 1,0-1,-1 1,1-1,-1 1,1 0,-5 0,-2-1,-1 1,1 0,0 1,-1 0,1 0,0 1,-1 1,1 0,0 0,0 1,-15 6,7-1,0 0,1 1,1 1,-1 1,-18 15,17-9,0 0,0 0,2 2,-17 23,24-28,1 0,0 0,1 0,0 1,1 0,0 1,-3 21,8-33,0 1,0 0,1-1,0 1,0 0,0-1,1 1,-1 0,1-1,0 1,1 0,-1-1,1 1,0-1,0 0,0 0,0 0,4 4,-1-1,1-1,0 0,0-1,1 0,0 0,0 0,0-1,0 0,12 5,-10-5,0-1,0 0,0 0,0-1,1 0,-1-1,1 0,-1-1,1 1,-1-2,1 1,-1-2,1 1,-1-1,0 0,0-1,0 0,0-1,0 0,0 0,-1-1,0 0,0 0,9-9,-13 10,0-1,0 0,-1 0,0 0,0-1,0 1,0-1,-1 1,0-1,0 0,-1 0,1 0,-1 0,-1 0,1 0,-1 0,-1-11,1 11,-1 1,1 0,-1 0,-1 0,1 0,-1 0,0 1,0-1,0 0,0 1,-1-1,0 1,0 0,0 0,0 0,-1 0,0 1,0-1,0 1,0 0,-6-4,-3 2,0 0,0 1,0 0,0 1,-1 1,1 0,-1 1,0 0,1 1,-1 0,0 1,-26 6,12-1,0 2,1 1,-1 1,2 1,-31 18,30-13,1 1,0 2,2 0,0 2,1 0,-35 43,43-45,1 1,1 0,0 1,2 1,0-1,2 2,0 0,1 0,-5 29,12-47,0 0,0 0,0-1,1 1,0 0,0 0,0 0,1 0,0 0,-1-1,2 1,-1 0,0-1,1 1,0-1,0 1,4 5,-6-10,0 1,1-1,-1 0,0 1,0-1,0 1,1-1,-1 0,0 1,1-1,-1 0,0 1,1-1,-1 0,0 0,1 1,-1-1,1 0,-1 0,1 0,-1 0,0 1,1-1,-1 0,1 0,-1 0,1 0,-1 0,1 0,-1 0,1 0,-1 0,0 0,1-1,-1 1,1 0,-1 0,1 0,-1 0,0-1,1 1,-1 0,1 0,-1-1,0 1,1 0,-1-1,0 1,0 0,1-1,-1 1,0-1,0 1,1 0,-1-1,0 1,0-1,0 1,0-1,0 1,1 0,-1-1,0 1,0-2,1-2,0-1,0 0,0 0,-1-10,0 0,-2 1,0 0,0 0,-9-25,9 34,1 1,-1 0,1 0,-1 0,0 0,-1 0,1 0,-1 1,1-1,-1 1,0-1,-1 1,1 0,-1 0,1 1,-1-1,0 1,0-1,-6-1,8 3,-1 1,1 0,-1 0,1 0,-1 0,1 0,-1 0,1 1,-1-1,1 1,0 0,-1-1,1 1,0 0,-1 0,1 1,0-1,0 1,0-1,0 1,0-1,0 1,1 0,-1 0,0 0,1 0,-2 3,-3 4,1-1,0 1,1 0,0 1,-4 13,5-12,0-1,1 1,1 0,-1 0,2-1,-1 1,2 0,-1 0,1 0,1 0,0 0,1-1,0 1,0-1,1 0,1 0,-1 0,2 0,-1-1,1 0,1 0,0 0,0-1,0 0,1-1,1 1,16 10,-13-11,1 0,0-1,0-1,1 0,-1-1,1-1,0 0,0-1,0 0,0-1,1 0,-1-2,0 1,0-2,0 0,0-1,0 0,0-1,19-8,-18 6,0-1,0 0,-1-1,-1 0,1-1,-1-1,-1 0,0-1,0 0,-1-1,-1-1,0 1,0-1,-2-1,1 0,11-29,-13 23,-1 0,-1-1,-1 0,-1 0,-1 0,-1-1,-2-35,1 53,-1 0,1 0,-1 0,0 0,0 0,0 0,-1 0,1 0,-1 0,0 1,0-1,-1 0,1 1,-1 0,1 0,-1 0,0 0,-4-3,4 4,0 0,0 0,0 1,-1 0,1-1,0 1,-1 1,1-1,-1 0,1 1,-1-1,1 1,-1 0,1 0,-1 1,1-1,-1 1,1 0,-1 0,1 0,-5 2,-2 2,0 0,0 1,0 1,1-1,0 2,0-1,1 1,0 0,0 1,1 0,-10 14,6-6,1 1,1 0,0 0,2 1,-11 35,12-26,1 0,1 0,1 1,2-1,1 1,1-1,7 48,-6-70,-1 0,1 0,0 0,1-1,-1 1,1 0,0-1,1 0,-1 0,6 5,-8-8,1 0,-1 0,1-1,0 1,0-1,0 0,0 1,0-1,0 0,0 0,0 0,0 0,0-1,1 1,-1-1,0 1,1-1,-1 0,0 0,1 0,-1 0,0 0,1 0,-1-1,0 1,0-1,1 0,-1 1,4-3,-3 0,1 1,-1-1,0 0,1 1,-1-2,-1 1,1 0,0-1,-1 1,0-1,0 1,0-1,0 0,2-8,1-6,0 1,2-21,-5 19,0 1,-1 0,-1 0,-1-1,-1 1,-6-29,6 35,-1 1,-1 0,0 0,0 0,-1 0,-1 0,0 1,0 0,-1 1,0-1,-12-11,16 18,0 1,1-1,-1 1,-1 0,1 0,0 0,0 0,-1 0,1 1,-1-1,1 1,-1 0,0 0,0 1,1-1,-1 1,0 0,0 0,1 0,-1 0,0 1,-4 0,4 0,1 1,-1-1,1 1,0 0,0 0,0 0,0 1,0-1,0 1,0-1,1 1,-1 0,1 0,0 0,0 0,0 1,0-1,1 0,-1 1,1-1,0 1,-1 4,0 2,0-1,1 1,0-1,1 1,0 0,1 0,0-1,0 1,1-1,0 1,0-1,1 1,1-1,0 0,0-1,0 1,1-1,8 10,-6-9,0 1,1-2,1 1,-1-1,1-1,0 0,1 0,0 0,0-1,0-1,1 0,0 0,0-1,21 5,-29-8,0-1,0 1,0-1,0 0,0 0,0 0,0 0,0 0,0-1,0 1,0-1,-1 0,1 0,0 0,0 0,-1 0,1-1,0 1,-1-1,0 0,1 0,-1 0,0 0,0 0,0 0,3-4,-3 3,0-1,0 0,-1-1,1 1,-1 0,1 0,-1-1,-1 1,1 0,-1-1,1 1,-1-1,-1 1,1-1,-1 1,1 0,-3-6,-2-7,-2 1,0 0,0 0,-2 1,0 0,0 0,-1 1,-1 0,-1 1,0 0,0 1,-2 0,-20-14,28 23,0 0,0 0,0 1,0 0,0 0,0 0,0 1,0 0,-13 0,17 0,1 1,-1 0,0 0,0 1,1-1,-1 0,0 1,1-1,-1 1,0-1,1 1,-1 0,1 0,-1 0,1 0,-1 0,1 0,0 0,-1 0,1 0,0 1,0-1,0 0,0 1,0-1,0 1,0-1,0 1,1 0,-1-1,1 1,-1 0,1-1,0 1,0 0,-1 0,1-1,0 1,1 3,0 1,0-1,0 1,1-1,-1 1,1-1,1 0,-1 0,1 0,0 0,0 0,0-1,0 1,1-1,5 5,-4-4,0 0,0-1,1 1,-1-1,1-1,0 1,0-1,1 0,-1 0,0-1,10 3,-13-5,0 0,0 0,1 0,-1 0,0 0,0-1,0 1,0-1,0 0,0 0,0 0,0-1,-1 1,1-1,0 1,-1-1,1 0,-1 0,1 0,-1 0,0-1,0 1,0-1,3-4,1-2,-1 0,0-1,-1 1,1-1,-2 0,4-12,-2-2,-1 0,0 0,-1-27,-2 39,-2-1,1 1,-2-1,0 1,0 0,-1-1,-8-21,9 32,1-1,0 1,0-1,-1 1,0-1,1 1,-1 0,0 0,0 0,0 0,0 0,-1 0,1 1,-1-1,-2-1,4 3,0 0,0-1,0 1,0 0,1 0,-1 0,0 0,0 0,0 0,0 0,0 0,1 0,-1 0,0 1,0-1,0 0,0 1,1-1,-1 0,-1 1,1 0,0 1,0-1,-1 0,1 0,0 1,0-1,0 1,1-1,-1 1,0-1,0 1,1 0,-1 2,-1 5,0-1,0 1,1 0,1 0,-1 0,1-1,1 1,0 0,0 0,1 0,0-1,0 1,1-1,0 1,0-1,1 0,9 14,-9-17,0 0,0 0,0 0,1 0,0-1,0 1,0-1,0-1,0 1,1-1,0 0,0 0,0 0,0-1,0 0,0 0,1 0,-1-1,1 0,-1-1,1 1,-1-1,1 0,11-3,-11 2,0-1,-1 0,1-1,-1 1,1-1,-1-1,0 1,0-1,-1 0,1 0,-1-1,0 1,0-1,0-1,-1 1,0 0,0-1,0 0,0 0,-1 0,3-9,2-6,0-1,-2 0,0 0,-2-1,3-26,-6 34,-1 0,0 1,0-1,-2 1,0-1,0 1,-2-1,0 1,0 0,-1 1,-8-16,10 23,-1 0,1-1,-1 1,-1 1,1-1,-1 1,0-1,0 1,0 1,-1-1,0 1,0 0,0 0,0 0,-1 1,1 0,-1 1,0-1,0 1,0 1,0-1,0 1,0 0,-10 0,10 2,0-1,1 1,-1 1,0-1,0 1,1 0,-1 0,1 1,-1 0,1 0,0 1,0-1,1 1,-1 1,1-1,0 1,0 0,0 0,0 0,1 1,0-1,1 1,-1 0,1 1,0-1,-3 10,3-9,1 0,0 1,0 0,1-1,0 1,1 0,-1-1,1 1,1 0,0 0,0-1,0 1,1 0,0-1,0 0,1 1,0-1,0 0,1 0,0-1,0 1,1-1,7 9,-5-8,1-1,0 1,0-2,0 1,1-1,0-1,0 1,0-1,0-1,1 0,-1 0,1-1,0 0,-1-1,13 1,-14-2,0 0,0 0,0-1,0 0,0 0,-1-1,1 0,0 0,-1-1,0 0,1-1,-1 1,0-1,-1 0,1-1,-1 0,0 0,0 0,6-7,-6 3,1 1,-1-1,-1 0,0-1,0 0,-1 1,0-2,0 1,-1 0,-1-1,0 1,0-1,-1 1,0-20,-2 21,0 0,0-1,-1 1,0 0,-1 0,0 0,0 0,-1 0,0 1,0 0,-1 0,0 0,-1 0,0 1,0 0,-13-12,9 11,-1 0,1 0,-1 1,-1 0,-14-6,18 10,1 1,-1-1,1 1,-1 1,0-1,0 1,0 0,0 1,-13 1,18-1,0 1,0-1,1 1,-1 0,1 0,-1 0,1 0,-1 1,1-1,-1 0,1 1,0 0,0 0,0-1,0 1,0 0,0 0,1 1,-1-1,1 0,-1 1,1-1,0 1,0-1,0 1,0-1,1 1,-1 0,1-1,-1 1,1 0,0 4,0 0,0 0,0 0,1-1,0 1,0 0,1 0,0-1,0 1,0-1,1 0,0 1,5 6,0-3,0 0,1 0,1-1,0-1,0 1,0-2,1 1,0-1,20 9,-21-12,0 0,0 0,0-1,0 0,0-1,0 0,1-1,-1 0,1 0,0-1,-1-1,16-2,-21 2,-1 0,0 0,0-1,0 0,0 0,0 0,0 0,0 0,-1-1,1 0,-1 1,0-1,0-1,4-3,-3 1,0 0,-1 0,0 0,0-1,0 1,0-1,-1 0,1-7,0-8,0 0,-2 0,0 0,-4-34,-3 15,-2 0,-1 1,-2 0,-17-39,13 38,1-1,3 0,-10-63,18 69,1-62,3 83,0 1,1-1,1 1,0 0,1 0,0 0,9-16,-12 27,1 0,-1 0,1 0,0 0,0 0,0 0,1 1,-1-1,1 1,-1 0,1 0,0 0,0 0,0 0,0 0,0 1,0-1,1 1,-1 0,5-1,2 1,1 0,-1 1,1 1,-1-1,14 4,-10-2,0-1,25 0,-35-1,0-1,0 0,0 1,1-1,-1-1,0 1,-1 0,1-1,0 0,0 0,-1 0,1-1,4-3,1-3,0-1,-1 0,0 0,-1-1,0 0,-1-1,0 1,7-22,-2 3,-2-1,7-45,-12 53,-1-1,-2 0,0 0,-2 0,-5-40,3 50,1 1,-2 0,0 0,-1 0,0 0,0 1,-2 0,1 0,-2 0,0 1,-14-17,19 26,0-1,0 0,0 1,0-1,0 1,-1 0,-4-2,7 4,1-1,-1 1,0 0,0 0,0-1,0 1,1 0,-1 0,0 0,0 0,0 0,0 0,1 0,-1 0,0 0,0 1,0-1,0 0,1 0,-1 1,0-1,0 1,1-1,-1 1,0-1,1 1,-1-1,0 1,1-1,-1 1,1 0,-1-1,1 1,-1 0,1 0,0-1,-1 1,1 0,0 0,-1-1,1 1,0 1,-2 7,0 0,1 0,0 0,1 0,0 1,2 14,11 58,-8-59,1 0,0 0,17 36,-20-52,0-1,0 0,0 0,1 0,0 0,1-1,-1 0,1 0,0 0,0 0,0-1,1 1,0-1,0-1,0 1,13 4,-17-7,1 0,-1 0,1-1,-1 1,1-1,-1 1,1-1,-1 0,1 0,-1 0,1-1,-1 1,1 0,-1-1,1 0,-1 0,1 1,-1-1,0-1,1 1,-1 0,0-1,0 1,0-1,0 1,0-1,0 0,-1 0,1 0,0 0,-1 0,0 0,1-1,-1 1,0 0,0-1,1-4,0-1,1-1,-2-1,1 1,-1 0,-1 0,1 0,-2-1,1 1,-3-12,-1 1,-1 1,-1 0,-1 1,0 0,-2 0,0 0,0 1,-2 0,0 1,-1 0,-20-20,28 32,-1 0,1 1,-1 0,0-1,0 2,0-1,0 0,0 1,-6-2,9 4,-1-1,0 0,1 1,-1 0,0 0,1 0,-1 0,0 0,1 0,-1 1,1-1,-1 1,1 0,-1 0,1 0,-1 0,1 0,0 0,-1 1,1-1,0 1,-3 2,-4 6,0 0,0 1,1 1,1-1,0 1,0 0,1 1,1 0,0 0,0 0,-2 16,1-2,2 0,1 0,1 0,2 50,2-54,0 0,2 0,1 0,0-1,2 0,0 0,2 0,15 28,-19-41,1-1,-1 1,1-1,1 0,0-1,0 0,0 0,1 0,0-1,0 0,1 0,-1-1,1 0,1-1,-1 0,0 0,1-1,0 0,0-1,0 0,16 1,-14-3,0-1,0 0,0-1,0-1,0 1,0-2,-1 1,0-2,0 0,0 0,0-1,-1 0,0-1,14-11,1-3,-1-2,-1 0,-2-1,24-34,-27 32,-1-1,-1-1,-1 0,-2-1,-1-1,-1 0,-2 0,12-62,-19 72,0 0,-2-1,0 1,-1 0,-1 0,-6-31,4 36,-1 1,0 0,0 0,-2 1,1-1,-2 1,0 1,0 0,-17-19,16 22,1 1,-2 0,1 0,-1 1,0 0,-1 1,1 0,-1 1,-1 0,1 0,-1 1,1 1,-1 0,0 1,-14-1,17 2,1 1,-1 0,1 1,-1-1,0 2,1-1,0 1,-1 1,1 0,0 0,0 0,0 1,1 0,-1 1,1-1,0 2,0-1,1 1,0 0,0 0,0 0,-5 8,3-1,1-1,0 1,1 0,0 1,1 0,1 0,0 0,1 0,0 0,1 1,1-1,1 1,-1 0,4 20,0-15,0 0,1-1,1 0,1 0,0 0,2 0,0-1,1 0,1-1,12 17,-10-19,0 1,1-1,1-1,19 15,-26-24,0 1,1-1,0 0,0-1,0 0,1 0,-1-1,1 0,0-1,0 1,10 0,-14-3,-1 0,0 0,1 0,-1 0,0-1,1 1,-1-1,0-1,0 1,0 0,0-1,0 0,0 0,5-4,-3 2,-1 0,-1 0,1-1,-1 1,0-1,0-1,0 1,5-12,-2 4,-2-1,0 0,0 0,-2-1,0 0,0 1,0-27,-3 26,-2-1,1 0,-2 1,0-1,-1 1,-1 0,0 0,-1 0,0 1,-2 0,1 0,-2 1,0 0,0 0,-1 1,-1 0,-14-13,14 15,-1 0,0 0,-1 1,0 1,0 0,-1 0,1 1,-2 1,1 1,-1 0,0 1,0 0,0 1,0 1,-1 0,1 2,-27 1,35-1,1 1,-1 1,1-1,0 1,-1 0,1 1,0 0,0 0,1 0,-1 0,1 1,-1 0,1 0,0 0,1 1,-9 10,7-6,1 0,-1 0,2 0,0 1,0 0,0 0,1 0,1 0,0 0,-1 12,-2 35,3 0,8 83,-6-134,1 0,0-1,0 1,0-1,1 1,0-1,0 1,4 6,-5-11,0 1,0-1,0 1,0-1,1 1,-1-1,0 0,0 0,1 0,-1 0,1 0,-1 0,1 0,-1 0,1-1,0 1,-1 0,1-1,0 1,-1-1,1 0,0 0,0 0,-1 1,1-2,0 1,0 0,-1 0,1 0,0-1,3-1,1 0,1-2,-1 1,1-1,-1 0,-1 0,1 0,0-1,-1 0,0 0,6-8,2-4,0-2,12-21,-10 9,0 0,-3-1,0 0,-2-1,-2 0,6-40,-7 16,-2 0,-6-111,1 160,-1-1,0 1,0 0,-1 0,0 0,0 0,-1 1,0-1,-7-12,7 16,1 1,-1 0,0-1,0 1,0 1,-1-1,1 0,-1 1,1 0,-1-1,0 1,0 1,0-1,0 1,0-1,0 1,0 0,0 1,-1-1,-4 1,5-1,-1 1,0 1,1-1,-1 1,0 0,1 0,-1 0,0 0,1 1,0 0,-1 0,1 0,0 0,0 1,0 0,0 0,1 0,-1 0,1 0,0 1,0-1,0 1,0 0,1 0,-3 6,-3 5,1 1,0 1,2 0,0 0,-5 27,5-13,1 0,0 36,4-52,1 1,0-1,1 0,1 0,0 0,8 20,-10-31,1 0,0 0,0 0,0-1,1 1,-1-1,6 6,-7-8,-1 0,1-1,0 1,-1-1,1 1,0-1,0 1,0-1,-1 1,1-1,0 0,0 0,0 1,0-1,-1 0,1 0,0 0,0 0,0 0,0 0,0 0,0 0,0 0,-1 0,1-1,0 1,0 0,0 0,0-1,-1 1,1-1,0 1,0-1,-1 1,1-1,0 1,-1-1,1 0,0 1,-1-1,1 0,0-1,3-4,-1 0,0-1,0 1,0-1,-1 0,1 0,-2 0,1 0,-1 0,0 0,-1-1,0-10,-1-6,-1 0,-7-37,4 40,-1-1,0 1,-2 0,0 0,-1 1,-2 0,0 1,-19-27,20 35,1-1,-2 1,1 1,-2 0,1 0,-1 1,0 1,-1 0,0 1,-1 0,1 1,-1 0,-24-6,14 7,0 1,0 1,-48 0,57 3,0 1,0 1,0 0,1 1,-1 1,1 0,-25 12,36-15,1 0,-1 0,1 1,0-1,-1 1,1-1,0 1,0 0,0 0,0 0,0 0,1 0,-1 0,1 1,-1-1,1 1,0-1,0 1,0-1,0 1,0 0,0 2,1-1,0 0,1 0,-1-1,1 1,-1 0,1-1,0 1,1-1,-1 1,1-1,-1 0,1 0,0 1,0-1,5 5,-1-2,0-1,0 1,0-1,1 0,0-1,0 0,0 0,0 0,1-1,0 0,-1 0,1-1,15 3,2-2,1 0,-1-2,30-2,-47 1,0 0,-1-1,1 0,0-1,-1 0,1 0,-1 0,0-1,0 0,0 0,0-1,9-7,-10 6,-1 0,0 0,0-1,0 1,-1-1,0 0,0 0,-1-1,0 1,0-1,0 0,-1 0,3-11,-1-1,-2 0,0-1,-1 1,-1-1,0 0,-2 1,0-1,-2 1,0 0,-1 0,0 0,-2 1,0 0,-2 0,0 0,-13-18,7 12,-1 2,-1 0,-1 1,-1 0,-1 2,0 0,-2 2,0 0,-1 1,-48-24,58 34,0 1,0 0,0 1,0 1,-1 0,0 0,0 2,1 0,-1 0,0 1,0 1,-24 4,34-4,1 0,-1 1,1 0,0-1,-1 1,1 1,0-1,0 0,0 1,0-1,1 1,-1 0,1 0,0 0,0 0,0 0,0 1,-3 6,1 0,0-1,1 1,0 1,1-1,-3 18,4-15,1 1,1 0,0 0,1-1,0 1,1-1,0 0,1 1,1-1,0-1,1 1,0-1,1 0,0 0,1-1,12 14,-13-17,0-1,0 1,1-1,0-1,1 0,-1 0,1-1,0 0,1 0,-1-1,1 0,0-1,0 0,0 0,0-1,1-1,-1 0,0 0,1-1,-1 0,1-1,10-1,-8-2,0 1,0-2,-1 0,0 0,0-1,0 0,-1-1,0-1,0 0,-1 0,1-1,-2 0,0-1,0 0,-1-1,12-17,-9 10,-2 1,0-1,0-1,-2 1,0-2,-1 1,-1 0,-1-1,-1 0,1-28,-4 33,0 1,-2 0,1-1,-2 1,0 0,-1 0,0 0,-1 1,0-1,-1 1,-1 1,0-1,-10-13,5 11,0 1,-1 1,0 0,-1 0,-1 1,0 1,0 1,-1 0,-25-12,19 13,-1 0,1 2,-1 0,0 1,-1 2,0 0,-30 0,34 3,0 2,0 0,0 1,0 2,1-1,-1 2,1 1,-34 14,33-10,0 0,1 1,0 1,-31 26,43-32,1 1,-1 0,1 1,0-1,1 1,0 0,0 1,1-1,0 1,0 0,1 0,0 0,-3 17,5-16,0-1,0 1,0-1,2 1,-1-1,1 0,0 1,1-1,4 15,-4-21,-1 1,1-1,0 1,0-1,0 1,0-1,1 0,-1 0,1 0,0-1,0 1,0 0,0-1,0 0,1 0,-1 0,1 0,-1-1,1 1,0-1,-1 0,1 0,0 0,0 0,6 0,-1-1,0 0,-1-1,1 0,-1 0,1-1,0 0,-1-1,0 1,0-1,15-9,-14 7,1-1,-1 0,-1 0,1-1,-1 0,0-1,-1 1,10-14,-10 10,0 1,-1-1,0-1,0 1,-2-1,1 0,-1 0,-1-1,0 1,-1-1,-1 1,0-1,0 0,-1 0,-1 1,0-1,-1 0,0 1,-1-1,0 1,-1 0,0 0,-1 0,-1 1,0-1,0 1,-1 1,0-1,-1 1,0 0,-1 1,-15-13,5 7,-1 2,0 0,-1 1,-1 1,0 1,0 1,-1 1,0 1,0 0,-1 2,1 1,-1 1,0 1,-43 3,56 0,0 0,0 1,1 1,-1 0,1 1,-1 0,1 0,0 1,1 0,-17 12,14-7,0 0,1 1,0 0,0 1,2 0,-1 1,-6 13,2-1,2 1,1 0,1 0,1 1,1 0,1 0,2 1,-2 29,6-50,1 0,-1 1,2-1,-1 0,1 0,0 0,0 1,1-1,0 0,3 6,-4-10,1 0,-1-1,1 0,0 1,0-1,0 0,0 0,0 0,1 0,-1 0,0 0,1-1,-1 1,1-1,0 0,0 1,-1-1,1-1,0 1,0 0,0-1,0 1,0-1,0 0,0 0,5-1,-3 1,-1-1,1 0,-1 0,0 0,1-1,-1 0,0 1,0-1,0-1,0 1,0-1,-1 1,1-1,-1 0,0 0,1-1,-1 1,-1-1,1 0,0 1,3-9,1-3,0 0,-2 0,1 0,5-29,-8 26,0 0,-1 0,-1 0,0 0,-2-1,0 1,-1 0,-5-23,5 32,-1 1,1-1,-2 1,1-1,-1 1,-1 0,1 0,-1 1,-1-1,1 1,-1 0,0 1,-1-1,0 1,0 1,0-1,-1 1,-13-7,7 6,-1 1,-1 0,1 1,-1 1,1 0,-1 1,0 1,0 0,0 2,0-1,-16 4,5 1,0 0,1 2,0 1,0 0,-42 22,51-21,0 1,1 1,0 0,1 1,0 1,1 1,-22 26,29-32,0 1,1 0,0 1,1 0,0-1,1 1,0 1,0-1,1 1,1 0,-1-1,2 1,-1 0,2 0,0 13,0-19,1 0,0 0,0-1,1 1,-1 0,1 0,0-1,0 1,1-1,-1 0,1 1,0-1,0 0,0-1,1 1,-1-1,1 1,0-1,0 0,0 0,0-1,1 1,-1-1,1 0,-1 0,1 0,6 0,0 1,-1-1,1 0,0-1,-1 0,1-1,0 0,0-1,0 0,0 0,-1-2,18-4,-11-1,0 1,0-2,-1 0,0-1,-1-1,0 0,-1-1,0-1,18-22,-12 11,-1-2,-1 0,-1-1,24-52,-35 65,0-1,-1 1,-1-1,0 0,-1 0,2-29,-5 37,0 0,0 0,-1 0,0 0,0 0,-1 0,0 0,0 1,0-1,-1 1,0-1,0 1,0 0,-1 0,0 0,-1 1,-6-8,0 4,-1 0,0 1,0 0,0 1,-1 1,0 0,0 1,0 0,-1 1,-26-5,0 3,0 1,-67 2,41 6,1 3,1 3,-1 3,2 2,0 3,0 3,-89 42,128-51,1 1,-1 1,2 1,-25 20,41-29,0 1,0 0,0 1,1-1,0 1,0 0,-5 11,8-13,0 0,0 0,0 0,1 0,0 1,0-1,0 0,1 1,0-1,0 0,0 1,2 9,-1-12,0 1,1-1,-1 0,1 0,-1 0,1 0,0 0,0 0,0 0,1-1,-1 1,0-1,1 0,0 1,0-1,0-1,0 1,0 0,0-1,0 1,0-1,0 0,1 0,5 1,8 1,0 0,1-1,24 0,-42-2,18-1,0 0,0-1,0-1,0-1,-1 0,1-1,-1-1,0-1,-1 0,0-1,0-1,-1-1,0 0,0 0,-1-2,-1 0,0 0,20-26,-29 32,1 0,-2 0,1 0,0 0,-1-1,-1 0,1 0,-1 1,0-1,0-1,-1 1,0 0,0-9,-1 11,-1 0,0 0,1 0,-2 1,1-1,0 0,-1 0,0 1,0-1,-1 1,1-1,-1 1,0 0,0 0,0 0,-1 1,1-1,-1 1,-6-5,-2 0,-1 1,1 0,-1 1,-1 1,1 0,-1 1,0 0,0 1,-22-2,-14 0,-66 4,76 2,1 3,0 1,0 1,0 3,0 1,-66 27,82-27,0 1,0 1,1 1,1 1,0 1,1 1,0 1,2 0,0 1,1 1,-24 35,36-45,0 0,1 1,0-1,0 1,1 0,1 0,-1 1,0 14,3-20,0-1,0 1,0-1,0 1,1-1,0 1,0-1,0 1,3 6,-3-9,0 0,1 0,-1 1,1-1,-1-1,1 1,0 0,-1 0,1-1,0 1,0-1,0 1,0-1,1 0,-1 0,0 0,0 0,4 1,-4-2,0 1,0-1,-1 0,1 0,0 0,0 0,-1 0,1-1,0 1,0 0,-1-1,1 1,0-1,-1 0,1 0,0 1,-1-1,1 0,-1 0,0-1,1 1,-1 0,0 0,0-1,1 1,-1 0,0-1,0 1,-1-1,1 0,0 1,0-1,0-2,1-3,0 1,0-1,0 0,-1 1,0-1,0 0,-1-11,-1 8,-1 1,0-1,-1 1,0-1,0 1,-1 0,0 1,-1-1,0 1,0-1,0 2,-1-1,-13-12,3 4,-1 0,-1 1,-1 2,-34-21,26 20,0 2,-2 0,1 2,-1 1,-1 1,1 2,-39-4,17 6,0 2,0 3,-79 10,74-2,1 3,0 2,0 2,2 3,-99 49,111-46,2 2,0 1,2 2,0 2,2 1,2 2,-51 61,76-82,-1 1,1 0,1 1,0 0,1 0,1 0,0 1,-4 18,7-25,1 1,0-1,0 1,1-1,0 1,1-1,-1 1,2-1,-1 0,1 1,0-1,0 0,1 0,0 0,0 0,1-1,6 10,0-3,1-1,0-1,1 0,0 0,1-1,0-1,0 0,1-1,0-1,1 0,18 6,5 0,1-2,0-1,53 5,-42-9,84-1,-103-7,1 0,0-2,60-16,-76 15,0-1,0 0,0-2,-1 1,0-2,0 0,-1-1,19-16,-23 17,-1-1,0-1,0 1,-1-2,-1 1,0-1,0 0,-1 0,-1-1,0 0,6-23,-9 24,1 0,-2 0,1 0,-2-1,1 1,-2 0,0 0,0 0,-1 0,0 0,-1 0,-1 0,0 1,0 0,-1-1,-1 2,0-1,0 1,-1-1,0 2,-1-1,0 1,0 0,-1 1,0 0,-1 0,0 1,0 1,0-1,-1 2,0-1,-20-6,17 8,-1 1,1 1,0 0,-1 0,1 2,-1 0,1 0,-1 2,1-1,0 2,0 0,0 1,0 0,0 1,1 1,-1 0,-12 8,-3 4,1 1,1 1,0 1,2 2,0 0,-24 31,33-35,1 1,1 0,1 1,1 1,1-1,0 2,2 0,-8 26,14-36,1-1,0 1,1-1,0 1,0 0,2-1,2 21,-1-23,0-1,1 0,0 0,0 0,1 0,0-1,0 0,1 0,1 0,-1 0,8 8,-4-8,0 0,1 0,-1-1,1-1,1 0,-1 0,1-1,0 0,0-1,0 0,1 0,0-2,-1 1,18 0,-17-2,0 0,0-1,0 0,0-1,0 0,0-1,0-1,-1 0,1 0,-1-1,0 0,0-1,0-1,14-9,-12 5,0-1,-1-1,-1 0,0-1,-1 0,0-1,-1 0,0 0,-1-1,-1 0,0-1,-1 0,-1 0,0 0,3-27,-5 24,-1 0,-1 0,-1 0,0-1,-2 1,0 0,-1 0,-1 0,0 0,-2 1,0 0,-1 0,-14-24,14 30,-1 0,-1 0,0 1,0 0,-1 1,0 0,-1 1,0 0,-20-12,13 11,0 1,-1 0,0 2,-1 0,0 1,-21-4,4 5,0 1,0 1,-1 3,1 1,0 1,-70 15,78-11,0 2,1 1,0 1,0 1,1 2,1 0,0 2,-24 19,36-23,0 0,1 0,1 2,0 0,1 0,0 1,1 0,1 1,0 0,1 0,0 1,2 0,-1 1,-6 30,11-35,0 0,1 1,0-1,0 0,2 1,-1-1,2 0,0 1,0-1,1 0,0 0,1-1,1 1,0-1,0 0,1 0,0 0,1-1,0 0,1 0,0-1,1 0,0 0,18 13,-7-9,1 0,0-1,0-2,1 0,1-1,37 10,-6-7,100 10,-95-18,0-2,0-2,0-3,69-13,-100 12,0-2,-1-2,0 0,0-2,-1-1,0 0,-1-3,0 0,-1-1,39-32,-49 34,-1-1,0 0,-1-1,-1 0,0-1,-1 0,-1 0,0-1,-2 0,9-27,-12 30,-1 0,0 0,-1-1,-1 1,0 0,-1-1,0 1,-2 0,1-1,-2 1,0 0,0 0,-2 0,-6-16,4 15,-1 0,0 0,-1 1,0 0,-2 1,1 0,-1 1,-1 0,0 0,-1 1,0 1,-1 0,0 1,0 1,-1 0,0 1,-1 0,1 1,-1 1,0 1,-19-3,-31-1,-1 2,0 4,-127 12,189-9,0-1,0 1,0 0,0 1,1-1,-1 1,1 0,-1 0,1 0,0 1,0 0,0-1,0 2,0-1,-3 4,3-2,0 0,1 0,-1 0,1 1,0-1,1 1,-1 0,1 0,0 0,1 0,-2 7,1 1,0 0,1-1,0 1,1 0,2 15,-1-23,0 0,1 0,-1 0,1 0,1 0,-1-1,1 1,0-1,0 1,0-1,1 0,0 0,7 7,-6-8,0 0,0 0,1 0,-1-1,1 0,0 0,0 0,0-1,0 0,0 0,0 0,1-1,-1 0,0 0,1 0,-1-1,1 0,-1-1,1 1,-1-1,1 0,-1-1,0 0,0 0,0 0,0 0,0-1,0 0,-1-1,1 1,-1-1,0 0,0 0,0-1,-1 1,1-1,-1 0,0 0,-1-1,1 1,-1-1,0 1,0-1,2-9,-3 6,1 0,-2-1,1 1,-2-1,1 1,-1-1,0 1,-1-1,0 0,-1 1,0 0,0-1,-1 1,-1 0,1 0,-1 1,-1-1,-6-9,5 7,-2 1,1 0,-1 1,0 0,-1 0,0 0,-1 1,0 1,0 0,0 0,-1 1,0 0,-22-8,14 10,0 1,-1 1,1 0,0 2,-1 0,-21 3,-20 0,54-3,0 0,-1 1,1 0,0 0,0 0,0 1,0 0,1 1,-10 4,13-5,0-1,0 2,0-1,0 0,0 0,1 1,-1 0,1-1,0 1,0 0,0 0,0 1,0-1,0 0,1 0,0 1,-1-1,1 1,1-1,-2 5,2-7,0 1,-1-1,1 0,0 0,0 1,0-1,0 0,0 0,0 1,0-1,0 0,1 0,-1 1,0-1,1 0,-1 0,1 0,-1 0,1 0,0 1,-1-1,1 0,0 0,0-1,0 1,0 0,0 0,0 0,0-1,0 1,0 0,0-1,0 1,0-1,0 1,1-1,-1 1,2-1,0 0,0 0,0 0,0 0,0 0,-1-1,1 1,0-1,0 0,0 0,0 0,-1 0,1 0,0-1,-1 1,4-3,6-7,-1 1,-1-2,0 1,0-2,-1 1,-1-1,0 0,-1-1,0 0,-1 0,0 0,-2-1,1 0,-2 0,0 0,1-31,-3 43,-1 0,0 1,-1-1,1 0,0 0,-1 1,0-1,1 0,-1 1,0-1,0 1,-1-1,1 1,-1-1,1 1,-1 0,1 0,-1-1,0 1,-4-2,3 2,0 0,0 0,-1 0,1 1,0 0,-1 0,1 0,-1 0,1 0,-1 1,0-1,1 1,-1 0,-4 0,3 1,1-1,0 1,-1-1,1 1,0 0,0 1,0-1,0 1,0 0,0 0,0 0,0 0,1 1,-1-1,1 1,0 0,0 0,0 0,0 1,0-1,1 1,-1 0,1-1,0 1,0 0,1 0,-2 5,1 2,0 0,1 0,0 1,1-1,0 0,1 0,1 0,-1 0,5 12,-6-21,1-1,0 1,0 0,0 0,0-1,0 1,1-1,-1 1,0-1,1 1,-1-1,1 0,0 0,-1 0,1 0,0 0,0 0,-1 0,1 0,0-1,0 1,0-1,0 1,0-1,0 0,0 0,0 0,0 0,0 0,0 0,0-1,3 0,0 0,0-1,0 0,0 0,0 0,-1 0,1-1,-1 0,1 0,-1 0,0 0,4-5,-4 4,-1 0,0 0,0-1,-1 1,1-1,-1 1,3-7,-5 9,1-1,0 1,0-1,-1 1,0-1,1 1,-1-1,0 0,0 1,0-1,-1 1,1-1,-1 0,1 1,-1-1,-1-2,2 5,0 0,0-1,0 1,0-1,0 1,-1-1,1 1,0-1,0 1,0-1,-1 1,1 0,0-1,-1 1,1 0,0-1,-1 1,1 0,0-1,-1 1,1 0,-1 0,1-1,-1 1,1 0,0 0,-1 0,1-1,-1 1,1 0,-1 0,1 0,-1 0,1 0,-1 0,1 0,-1 0,1 0,-1 1,1-1,-1 0,1 0,0 0,-1 0,1 1,-1-1,1 0,-1 0,1 1,0-1,-1 0,1 1,0-1,-1 0,1 1,0-1,0 1,-1-1,1 0,0 1,0-1,-1 1,-1 3,0 0,1 0,-1-1,0 1,-1 8,1-2,1-1,0 1,0 0,1-1,0 1,1 0,3 14,-3-19,0-1,1 1,0-1,0 1,1-1,-1 0,1 0,0 0,0 0,0 0,0 0,1-1,-1 0,1 0,0 0,8 5,12 4,-1-1,2-1,-1-1,1-1,1-1,-1-1,1-1,0-2,0-1,1 0,-1-2,0-1,0-2,0 0,38-10,-38 6,0 0,-1-2,0-1,0-1,-1-1,0-1,-1-1,-1-1,0-1,-1-1,-1-1,0-1,-2 0,32-44,-44 55,-1-1,0 0,-1 1,0-1,-1-1,5-17,-7 24,-1 1,1-1,-1 0,0 0,0 1,0-1,0 0,0 0,-1 0,1 1,-1-1,1 0,-1 1,0-1,0 1,-1-1,1 1,0-1,-1 1,1 0,-1-1,0 1,0 0,0 0,0 1,0-1,0 0,-4-1,-4-2,0 1,0 0,-1 0,1 2,-1-1,0 1,0 1,-22-1,-1 2,-52 8,59-4,0 1,0 1,1 2,0 0,1 2,-1 0,2 2,0 1,-25 17,16-9,23-16,1 1,-16 12,22-16,1 1,0-1,-1 1,1-1,0 1,0 0,1 0,-1 0,1 0,-1 0,1 0,0 0,-1 5,1-3,0 0,1 0,-1 0,1 0,0 0,0 0,1 0,-1 0,1 0,0 0,1-1,-1 1,1 0,0-1,0 1,0-1,1 0,4 7,-3-7,0 0,0 0,0-1,1 1,-1-1,1 0,0 0,0-1,0 0,0 1,1-2,-1 1,0 0,1-1,-1 0,8 0,-10-1,1 1,0-1,0 0,-1 0,1-1,0 1,-1-1,1 0,-1 0,1 0,-1 0,1-1,-1 1,0-1,1 0,-1 0,4-4,-4 3,0 0,0-1,0 1,-1-1,1 0,-1 0,0 0,0 0,-1-1,1 1,-1 0,0-1,0 1,0-7,0 4,-1 0,0 0,0 0,0 0,-1 0,0 0,-1 0,-3-9,4 12,0 1,-1-1,1 1,-1 0,0-1,0 1,0 0,-1 0,1 1,-1-1,1 0,-1 1,0-1,0 1,0 0,-1 0,1 0,-4-1,-5-1,0 1,0 0,-1 1,1 1,-16-1,-67 5,51-1,26-2,0 1,0 1,0 1,-21 6,34-8,0 1,0 0,0 0,0 0,1 0,-1 1,1 0,-1 0,1 0,0 1,0-1,0 1,1 0,-1 0,1 0,0 1,0-1,-3 9,1-2,1 1,0-1,1 0,0 1,1 0,0 0,1 0,0 17,1-23,1-1,0 1,0-1,1 1,0-1,0 1,0-1,0 0,1 0,0 0,0 0,1 0,-1-1,1 1,0-1,0 0,0 0,0-1,8 6,-3-4,0 0,0 0,0-1,1 0,-1-1,1 0,0 0,17 2,-20-5,-1 1,1-1,-1 0,1 0,-1 0,1-1,-1 0,1-1,-1 1,0-1,0 0,0-1,0 1,9-6,-15 7,1 1,0 0,0-1,-1 1,1-1,0 1,-1-1,1 1,0-1,-1 0,1 1,-1-1,1 0,-1 1,1-1,-1 0,0 0,1 1,-1-1,0 0,0 0,1 0,-1 1,0-1,0 0,0 0,0 0,0 0,0 0,-1-1,0 1,0 0,0 0,0 0,0 0,0 0,0 0,0 0,0 0,0 0,-1 0,1 1,0-1,-3 0,-7-3,-1 0,1 1,-13-1,-7 0,0 2,-1 1,1 2,-1 1,1 1,0 1,0 2,0 2,1 0,-44 20,49-18,0-1,0-1,-1-1,-45 6,70-13,0 0,-1 0,1 0,0 0,0 1,0-1,-1 0,1 1,0-1,0 1,0-1,0 1,0 0,0-1,0 1,0 0,0 0,0 0,0 0,0 0,0 0,1 0,-1 0,0 0,1 0,-1 0,1 0,-1 0,1 0,0 1,-1-1,1 0,0 0,0 1,0-1,0 0,0 0,0 2,1 5,1 0,-1-1,1 1,6 14,-6-17,2 4,20 51,-21-54,0 0,1 0,-1-1,1 1,0-1,1 0,5 6,-10-11,0 0,0 1,1-1,-1 0,0 1,0-1,1 0,-1 0,0 1,1-1,-1 0,0 0,1 0,-1 1,0-1,1 0,-1 0,0 0,1 0,-1 0,1 0,-1 0,0 0,1 0,-1 0,1 0,-1 0,0 0,1 0,-1 0,0 0,1 0,-1-1,0 1,1 0,-1 0,0 0,1-1,-1 1,0 0,1 0,-1-1,0 1,0 0,1 0,-1-1,0 1,0 0,0-1,1 1,-1-1,0 0,1-1,-1 1,0-1,1 1,-1-1,0 0,0 1,0-1,0 1,-1-1,1 1,-1-3,-1 0,0 0,0 0,0 0,-1 0,1 0,-1 0,0 1,-1-1,1 1,0 0,-1 0,0 0,0 1,0-1,0 1,0 0,0 0,-8-2,-3-1,0 1,0 0,-1 1,-20-1,24 3,0 1,0 0,0 1,0 0,0 1,1 1,-1 0,1 0,-1 1,1 0,0 1,-14 9,19-11,1 1,-1 0,1 0,0 0,1 1,-1 0,1 0,0 0,0 0,0 1,1-1,-1 1,2 0,-1 0,1 0,-1 0,2 1,-1-1,1 1,0-1,0 1,1-1,0 13,1-16,-1 0,1 0,0 0,0 0,0 0,0 0,0 0,1-1,-1 1,1 0,0-1,0 0,0 1,0-1,0 0,0 0,1 0,-1 0,1 0,-1-1,1 1,4 1,7 3,0 0,1-1,20 4,-4-1,0 4,-1 2,0 0,-1 2,51 39,-66-46,31 24,-1 2,-2 2,-2 2,-1 2,42 56,-12-11,4-3,3-3,4-4,3-3,3-3,3-5,3-4,185 93,-117-83,4-6,3-8,1-7,323 51,-446-94,-1-2,89-2,-125-3,-1-1,0 0,0 0,0-1,0 0,0 0,12-6,-16 6,0 0,-1 0,1 0,-1 0,1 0,-1 0,0-1,0 1,0-1,0 0,0 0,0 1,-1-1,1 0,-1 0,0 0,0-1,1-4,0-6,-1 0,0 0,-1 0,0 0,-1 0,-1 0,0 1,-1-1,0 0,-6-14,2 9,-1 0,-1 1,-1 0,0 0,-2 1,-16-20,8 14,-1 2,-1 0,-1 1,-1 2,0 0,-2 2,0 0,0 2,-2 1,1 1,-2 1,1 2,-1 1,-1 1,1 1,-1 2,0 1,0 1,-60 5,43 3,-1 3,1 2,1 1,0 3,-65 30,23-2,-138 92,139-77,2 4,-141 136,209-181,1 0,1 2,0 0,1 0,-22 43,34-58,0 1,0-1,0 1,1-1,0 1,0 0,0 0,0-1,1 1,0 0,0 0,0 0,1 0,-1-1,1 1,0 0,3 6,-1-5,0-1,0 1,1-1,0 0,0 0,1 0,-1 0,1-1,0 0,0 0,1 0,-1-1,7 4,10 4,-1-1,2 0,45 11,86 9,82-8,-59-19,260-27,171-74,-361 40,-166 36,0-2,85-40,-145 54,30-19,-46 26,0-1,0 0,0 0,0-1,-1 1,0-1,0 0,0 0,5-8,-9 12,1-1,0 1,0-1,-1 1,1-1,-1 0,0 1,1-1,-1 0,0 1,0-1,0 0,0 1,0-1,0 0,-1 1,1-1,0 0,-1 1,1-1,-1 1,0-1,0 1,1-1,-3-1,0-1,0 1,-1-1,1 1,-1 0,0 0,0 0,-9-4,-2 0,0 0,-1 1,0 1,-29-6,-77-6,-2 8,0 5,-1 6,1 5,1 5,0 6,0 5,2 6,2 4,-174 74,230-78,1 2,-92 62,126-74,2 2,0 1,2 0,0 2,2 1,1 1,-24 36,37-50,1 1,1-1,0 1,1 0,0 1,1 0,0-1,1 1,1 0,0 0,1 23,1-28,1 0,1 0,-1 0,2 0,-1 0,1-1,0 1,1-1,0 0,1 0,-1 0,1 0,1-1,0 0,0 0,0 0,1-1,-1 0,11 6,0-1,-1-2,2 0,-1 0,1-2,1 0,-1-2,1 0,0 0,0-2,0-1,22 1,8-2,0-3,1-1,61-14,-49 4,-1-2,-1-3,-1-3,-1-2,-1-3,-1-2,57-38,-73 39,-1-2,-1-1,-2-2,-1-1,-2-2,-1-1,-1-2,-3-1,43-77,-57 88,-1 0,-2-1,-1-1,-1 0,-1-1,-2 1,-1-1,-2 0,-1-1,-1 1,-2 0,-1-1,-1 1,-2 0,-1 1,-2-1,0 1,-21-45,11 36,-2 1,-2 0,-1 2,-1 1,-3 1,0 1,-2 1,-2 2,-1 1,-65-46,67 55,0 2,-2 1,0 1,0 2,-1 1,-1 2,0 1,-1 2,0 1,0 2,0 1,-1 2,-57 4,47 4,0 2,0 2,1 2,0 1,1 3,1 2,1 1,-45 29,39-18,1 2,1 2,2 1,2 3,1 2,-46 59,66-73,2 2,0 1,2 0,2 1,0 1,2 0,-15 56,23-70,2 1,0 0,0 0,2 0,0 1,2-1,0 0,0 0,2 0,0 0,1 0,1-1,1 1,0-1,17 30,-9-26,0 0,2-1,1-1,0 0,1-2,1 0,0-1,2 0,-1-2,2-1,0 0,1-2,37 14,-18-10,1-3,1-1,-1-2,2-2,-1-2,86-2,-79-6,-1-2,1-2,-1-3,0-1,-1-3,0-2,-2-2,0-2,80-48,-81 39,-1-3,-1-1,-2-3,-2-1,-1-2,-1-1,-3-2,-2-2,29-48,-30 37,-3-2,-3-1,-2-1,-2-1,-3-1,17-98,-28 109,-2-1,-3 0,-1 0,-3 0,-2 0,-3 1,-1-1,-23-80,20 99,-2 1,-1 0,-1 1,-2 0,-1 1,-1 1,-1 0,-2 2,-37-38,43 50,-1 0,0 1,-1 1,0 0,-1 2,0 0,-1 1,0 1,0 0,-1 1,0 2,0 0,-1 1,1 1,-1 1,-29 0,32 3,1 1,-1 0,0 1,1 1,0 1,-1 0,2 1,-1 1,1 1,0 0,1 1,-16 11,19-10,0 0,1 0,0 1,1 0,0 1,1 0,1 1,0-1,0 2,1-1,1 1,0 0,1 1,-5 23,6-19,1 1,1 0,1 0,1 0,1 0,1-1,5 30,0-21,1 0,1-1,1 0,24 43,-9-28,2-1,1-1,2-1,2-2,70 63,-48-56,1-2,3-2,93 48,-40-35,133 46,-111-54,1-6,3-5,0-7,2-5,197 5,-295-27,65-7,-101 7,0-1,0-1,-1 1,1-1,-1 0,1 0,-1 0,1 0,-1-1,0 0,4-3,19-12,-16 14,0 1,0-1,0 2,0 0,0 0,1 1,-1 1,21 1,-8-1,24 0,65 7,-98-5,0 0,-1 1,1 1,-1 1,0 0,0 0,0 2,21 12,-31-16,1 1,-1-1,0 1,0 0,0 0,-1 0,1 1,-1-1,0 1,0 0,0 0,-1 0,0 0,0 0,0 0,-1 1,1-1,-1 1,-1-1,1 1,-1-1,0 1,0 0,-1-1,0 8,-5 10,0 0,-1-1,-1 1,-19 34,10-19,10-22,1 0,0 0,1 0,1 0,1 1,-3 26,6-34,0 0,1 0,0 0,0-1,1 1,0 0,0-1,1 1,0-1,1 0,0 0,0 0,1-1,8 12,-3-8,1 1,0-2,0 0,2 0,-1-1,1 0,0-1,0-1,1 0,0-1,1 0,-1-1,1-1,19 3,21 2,0-3,88-2,-137-4,-2 0,6 1,-1-1,1 0,0-1,-1 0,1-1,14-4,-57 54,5-8,2 0,-31 68,48-87,1 0,1 0,0 1,2 0,1 0,1 0,-1 42,4-50,-1-5,1 0,1 0,-1 0,2 0,-1 0,4 12,2-12,-3-15,-2-18,-5 8,-2 0,0 1,0-1,-1 1,-1 1,-1-1,-14-20,21 33,-1 0,0-1,0 1,0 0,0 0,0 0,0 0,0 1,-1-1,1 0,-1 1,1 0,-1-1,1 1,-1 0,0 1,0-1,0 0,1 1,-1-1,0 1,0 0,0 0,0 0,0 1,1-1,-1 0,0 1,0 0,0 0,1 0,-1 0,0 0,1 0,-1 1,1 0,0-1,-1 1,1 0,0 0,0 0,0 0,0 0,1 0,-1 1,-2 4,-4 9,0 0,1 1,0 0,2 0,0 1,1 0,1 0,0 0,0 34,4-47,-1 0,0 0,1-1,0 1,0 0,1 0,-1-1,1 1,0-1,0 1,1-1,-1 0,1 0,0 0,0 0,0 0,4 3,-4-4,0-1,0 0,0 0,1 0,-1 0,0 0,1-1,-1 1,1-1,-1 0,1 0,0 0,0-1,-1 1,1-1,0 0,0 0,-1 0,1-1,0 1,0-1,-1 0,5-2,-2 1,0-1,0 0,0-1,0 0,-1 1,0-2,1 1,-2-1,1 0,0 0,-1 0,0 0,0-1,-1 0,0 1,0-1,0-1,3-10,0-2,-1 0,-1 0,0-1,-2 0,1-22,-3 31,0 0,0 0,-1 1,0-1,-1 0,-1 1,-5-19,6 25,0 0,0 0,-1 0,1 0,-1 0,0 1,0-1,0 1,0 0,0 0,-1 0,0 0,1 1,-1-1,0 1,0 0,-1 0,1 1,0-1,-8-1,6 2,1 0,0 1,0-1,0 1,-1 0,1 1,0-1,0 1,0 0,-1 0,1 1,0-1,1 1,-1 1,0-1,-7 5,10-5,-1 0,0 0,1 0,-1 0,1 1,0-1,0 1,0 0,0 0,0 0,1 0,-1 0,1 0,0 0,0 0,0 0,0 0,0 1,1-1,0 0,-1 1,1-1,1 1,-1-1,0 0,2 7,-1-8,0 1,0 0,0-1,0 1,1-1,-1 1,1-1,-1 0,1 0,0 1,0-1,0 0,0-1,0 1,1 0,-1-1,0 1,1-1,0 0,-1 1,1-1,-1-1,1 1,0 0,0-1,4 1,-4 0,0-1,-1 0,1 0,0 0,-1-1,1 1,-1-1,1 1,0-1,-1 0,1 0,-1 0,0 0,1 0,-1 0,0-1,0 1,0-1,0 0,0 0,0 0,0 0,0 0,-1 0,1 0,-1 0,0 0,2-4,0-8,0 1,0-1,-2 1,1-1,-2 0,0 0,-3-22,1-31,2 65,0 0,0 0,0 0,0 0,0 1,1-1,-1 0,1 0,-1 0,1 0,0 0,0 0,0 1,0-1,0 0,0 1,0-1,1 1,-1-1,2-1,-1 3,-1-1,1 0,0 1,0-1,0 1,-1-1,1 1,0 0,0 0,0 0,0 0,-1 0,1 0,0 0,0 1,0-1,2 1,6 3,0 1,0-1,0 2,-1-1,15 12,-20-14,1 0,0 1,0-2,0 1,0-1,7 3,-11-5,-1 0,1 0,0 1,0-1,-1 0,1 0,0 0,0 0,0 0,-1 0,1 0,0-1,0 1,-1 0,1 0,0-1,0 1,-1 0,1-1,1 0,-1 0,-1 0,1 0,-1 0,1 0,-1 0,1 0,-1 0,1-1,-1 1,0 0,0 0,0 0,0-1,0 1,0 0,0 0,0 0,0-3,-2-7,-1 0,0 0,0 0,-1 0,-7-14,8 18,0 1,0 0,-1 1,0-1,0 1,0-1,-1 1,0 0,0 1,-6-6,10 10,1 0,-1-1,1 1,-1-1,1 1,-1 0,1-1,-1 1,0 0,1 0,-1 0,0-1,1 1,-1 0,0 0,1 0,-1 0,0 0,1 0,-1 0,1 0,-1 1,0-1,1 0,-1 0,0 0,1 1,-1-1,0 1,0 0,1 0,-1 0,0 0,1 0,-1 0,1 0,-1 0,1 0,0 1,-1-1,1 0,0 0,0 0,0 2,0 2,0 0,0 0,1 0,0-1,0 1,0 0,2 4,-1-6,-1 0,1 0,0 0,0-1,0 1,1-1,-1 1,0-1,1 0,0 0,-1 0,1 0,0 0,0-1,4 2,-5-2,0-1,0 1,0-1,0 0,1 0,-1 1,0-1,0-1,0 1,0 0,0 0,1-1,-1 0,0 1,0-1,0 0,0 0,0 0,-1 0,1 0,0 0,0-1,-1 1,1 0,1-3,5-6,0 0,-1 0,0-1,0 0,-1 0,-1-1,0 0,4-15,-2 2,-1-1,-1 1,2-29,-6 44,-1 0,0 0,-1-1,0 1,0 0,-6-17,7 25,-1 0,0 1,1-1,-1 1,0-1,0 0,0 1,0-1,0 1,0 0,0-1,-1 1,1 0,-1 0,1 0,0 0,-1 0,-1-1,1 2,0-1,0 1,0 0,0 0,0 0,0 0,0 1,0-1,0 1,0-1,0 1,0-1,0 1,1 0,-1 0,0 0,1 0,-1 0,0 0,-2 3,2-1,-1 0,0 0,1 0,-1 0,1 0,0 0,0 1,0 0,1-1,-1 1,1 0,0-1,0 1,0 0,0 0,0 5,1 3,-1 0,1-1,1 1,3 14,-3-20,0 0,1-1,-1 1,1-1,1 1,-1-1,1 0,0 0,0 0,1 0,-1-1,1 1,0-1,5 4,-7-5,1-1,0 0,0 0,0-1,0 1,0-1,1 1,-1-1,0 0,1 0,-1 0,1-1,-1 1,0-1,1 0,-1 0,1 0,-1-1,1 1,-1-1,1 1,-1-1,0 0,6-3,-7 3,0 0,0 0,0 0,0-1,0 1,0-1,0 1,-1-1,1 0,-1 0,1 0,-1 0,0 0,1 0,-1 0,0 0,0 0,0-3,1-3,0 0,-1 0,0 1,-1-10,1-3,9 50,-3-2,21 49,-21-59,-6-17,0 1,0 0,-1-1,1 1,-1 0,1 0,-1-1,0 1,1 0,-1 0,0 0,0-1,0 1,-1 0,1 0,0 0,-1-1,1 1,-1 0,0 0,1-1,-1 1,0 0,0-1,0 1,0-1,0 1,-1-1,-1 2,-7 11,8-11,0-1,1 1,-1 0,1 0,0 0,0 1,0-1,0 0,1 0,-1 1,1-1,0 0,0 0,0 1,0-1,1 0,-1 0,1 1,0-1,0 0,0 0,0 0,1 0,-1 0,1 0,-1 0,1 0,0-1,0 1,3 2,-4-5,-1 0,1 1,-1-1,1 1,-1-1,1 0,-1 1,1-1,-1 0,1 0,0 1,-1-1,1 0,-1 0,1 0,0 0,-1 0,1 0,0 0,-1 0,1 0,-1 0,1 0,0 0,-1-1,1 1,-1 0,1 0,0-1,0 1,0-2,0 1,0 0,0 0,0-1,0 1,0-1,0 1,0-1,-1 1,1-1,0-2,1-4,0 1,-1-1,1-16,-2 11,-1-1,0 1,-2 0,1 0,-1-1,-1 2,0-1,-1 0,-13-23,17 34,-1 0,1 1,0-1,-1 0,0 0,1 1,-1-1,0 1,0-1,0 1,0 0,0 0,0-1,0 2,-1-1,1 0,0 0,-1 1,1-1,0 1,-1 0,1 0,0-1,-1 2,1-1,0 0,-1 0,1 1,-4 1,-1 0,1 1,-1 0,1 0,0 0,0 1,0 0,1 0,-8 8,12-11,-1 0,1 1,0-1,0 0,0 0,-1 0,1 0,-1-1,1 1,0 0,-1 0,0-1,1 1,-1-1,1 1,-1-1,0 0,1 0,-1 0,1 0,-1 0,-3 0,3-1,0 0,0-1,0 1,1 0,-1 0,0-1,1 1,-1-1,1 0,-1 1,1-1,0 0,-1 0,1 0,0 0,-1-3,-4-13,0-1,1 0,0 1,-2-38,2 20,-2-15,2 0,2 0,7-83,-4 131,1 0,0 0,0 0,0 0,0 0,0 1,0-1,1 0,0 1,-1-1,1 1,3-4,30-25,-6 6,18-20,-26 26,24-28,-42 41,1 1,-2 0,1-1,0 0,-1 1,0-1,-1 0,1 0,-1 0,1-12,-2 12,1-1,0 1,0 0,0 0,1-1,0 1,0 0,1 0,0 1,6-11,-4 11,1 0,-1 0,1 0,0 1,0 0,0 0,1 0,9-3,-11 5,0 0,0 0,0 0,0-1,0 0,-1 0,0 0,1-1,-1 1,-1-1,1 0,0 0,-1 0,0-1,0 1,0-1,3-6,-4 5,0 0,1 0,0 1,0-1,7-9,-9 14,0 0,-1 0,1 0,0 0,0 0,0 1,0-1,0 0,0 1,0-1,0 1,0-1,0 1,0-1,0 1,0 0,0-1,0 1,0 0,1 0,-1 0,0 0,0 0,0 0,0 0,0 1,0-1,1 0,-1 1,0-1,0 0,0 1,0-1,0 1,0 0,0-1,0 1,0 0,-1-1,3 3,-1-1,0 1,0 0,-1-1,1 1,0 0,-1 0,0 0,1 0,-1 0,0 1,-1-1,1 0,0 4,1 48,-2-41,0 38,-3 132,2-182,1 0,0 0,-1 0,1 0,-1 0,0 0,0 0,1 0,-1-1,0 1,-1 0,1-1,0 1,0-1,-1 1,1-1,-1 0,1 1,-1-1,0 0,-3 2,-2 0,-1 0,0 0,0-1,-9 2,-12 4,17-4,-1 1,1 0,0 1,-17 10,25-12,-1 0,1 0,-1 0,1 0,0 1,1-1,-1 1,1 0,0 0,0 0,1 1,-4 8,-1 6,2 1,0 0,1-1,-1 24,4-34,1 0,0 0,0-1,1 1,1 0,-1-1,1 1,1-1,0 0,0 0,6 10,-9-17,1-1,0 0,0 1,-1-1,1 0,0 0,0 1,0-1,1 0,-1 0,0 0,0-1,0 1,1 0,-1 0,1 0,-1-1,0 1,3 0,-3-1,1 0,-1 0,0-1,1 1,-1 0,1 0,-1-1,0 1,0-1,1 1,-1-1,0 0,0 1,1-1,-1 0,0 0,1-1,3-4,1 0,-1 0,-1 0,1-1,-1 0,3-7,2-5,-1-1,-1 0,0 0,-2-1,0 1,-2-1,0 0,-1 0,-1-1,-4-39,1 120,1-61,0 1,0-1,0 1,0-1,0 1,0 0,0-1,0 1,-1 0,1 0,-1 0,1 0,0 0,-1 0,0 0,1 0,-3 0,-33-14,24 14,1-1,-1 2,0-1,0 2,1 0,-25 5,-16 1,-98-2,-430-10,-17 0,507 6,12-2,-1 4,-106 18,164-15,1 0,0 2,1 0,-28 16,-21 9,66-32,0 1,-1-1,1 1,0 0,1 0,-1 0,0 0,1 1,-1-1,1 1,0 0,-1-1,1 1,1 0,-1 0,0 0,1 0,-1 1,-1 5,2-3,0 0,0 1,1-1,0 0,0 0,0 1,1-1,-1 0,2 0,1 9,-2-14,-1 0,1 0,-1 0,1 0,-1 0,0 1,0-1,1 0,-1 0,0 0,0 1,0-1,0 0,0 0,-1 0,1 1,0-1,-1 0,1 0,0 0,-1 0,0 0,1 0,-1 0,1 0,-1 0,0 0,0 0,0 0,0 0,1 0,-1-1,0 1,0 0,-1-1,1 1,0-1,0 1,0-1,0 1,0-1,0 0,-1 1,0-1,-8 1,-1-1,1 0,0 0,-17-4,12 2,-676-61,535 57,0 8,-226 30,235-5,0 7,3 5,1 7,-222 104,351-143,-133 68,127-64,0 2,1 0,1 2,-30 28,46-41,-1 1,1 0,-1 0,1 0,0 1,0-1,0 1,1-1,-1 1,1-1,0 1,0 0,0-1,0 1,1 0,-1 0,1 0,0 0,0-1,1 1,-1 0,1 0,1 4,0-3,0 0,1 0,-1 0,1 0,0-1,1 1,-1-1,1 1,0-1,0-1,0 1,0 0,1-1,-1 0,7 3,3 2,0-2,1 0,-1-1,1 0,0-1,0-1,0 0,28 1,-22-4,0-1,1-1,-1 0,0-2,39-11,-32 5,-1-1,-1-1,0-1,0-1,-1-2,-1 0,-1-1,0-2,32-33,-35 28,-1 0,-1-1,0-1,-3 0,0-1,-1-1,11-35,-17 40,-1-2,-1 1,-1-1,-1 0,-1 0,-1 0,-2 0,0 0,-5-31,2 43,1 0,-2 0,1 1,-2-1,0 1,0 0,-1 0,-1 1,0-1,0 1,-17-18,11 16,0 1,-1 1,0 1,0 0,-1 0,0 2,-1 0,-17-7,0 4,1 0,-2 3,-47-8,-96 3,165 13,-18-1,-1 1,1 1,-58 11,79-10,1 1,0-1,0 2,0-1,0 1,0 0,-13 11,17-12,-1 1,1 0,1 0,-1 1,0-1,1 1,0 0,0 0,1 0,-1 0,1 0,0 0,-1 9,0 2,1 0,0 0,1 1,1-1,1 1,0-1,2 0,-1 0,2 0,0 0,8 18,0-3,2-1,1 0,1-1,31 42,-30-49,1 1,2-2,0-1,1 0,0-2,2 0,0-1,1-2,1 0,36 15,-57-29,0 1,1-1,-1 1,0-1,1-1,-1 1,9 0,-11-2,-1 1,1 0,-1-1,0 1,1 0,-1-1,0 0,1 1,-1-1,0 0,0 0,1 0,-1 1,0-1,0 0,0-1,0 1,0 0,-1 0,1 0,0 0,0-1,-1 1,1 0,-1-1,1 1,0-3,1-8,0 0,0 0,-1 0,-1 0,0 0,0 0,-1 0,-1 0,-4-18,0 8,-1-1,-1 1,-1 1,-13-24,4 15,-1 0,-2 2,0 0,-2 2,-1 0,-53-42,37 38,-2 1,-1 2,-1 2,-56-23,66 34,0 2,0 1,-50-9,64 17,1 1,-1 0,1 1,-1 1,1 1,-1 1,-37 9,53-10,-1 2,0-1,0 0,1 1,0 0,-1 0,1 0,0 1,1 0,-1-1,0 1,1 0,-5 8,-1 2,1 0,-12 31,11-25,2 1,-6 26,12-41,-1 0,2 0,-1 0,1 0,0 0,0 0,0 0,1 0,0 0,0 0,1 0,0 0,2 6,1-5,-1 0,1 0,0 0,1 0,-1-1,1 0,1 0,-1-1,1 0,0 0,0 0,0-1,15 6,-1-1,1-1,0-2,1 0,23 2,4-2,0-2,1-3,-1-2,0-2,95-19,-49 1,-2-5,98-41,-116 37,-2-4,-1-3,92-63,-131 76,0-1,-2-2,-1-1,-1-1,-2-2,-1-1,-1-1,29-51,-43 63,-1-1,-1 0,-2-1,0 0,-1-1,5-34,-10 43,-1 0,0 0,-1-1,-1 1,0 0,-1-1,-1 1,0 0,-1 0,-1 1,-7-19,2 14,-1 1,0 0,-1 1,-1 0,-1 0,0 2,-1 0,0 0,-2 1,1 1,-2 1,1 1,-2 0,-26-11,18 11,0 1,-1 1,0 1,0 2,-1 0,1 3,-1 0,0 1,0 2,-30 4,16 2,2 2,-1 2,1 1,0 2,1 2,1 2,0 2,2 1,0 1,1 3,2 1,-37 32,59-46,1 1,0 0,0 0,1 1,1 0,0 1,0 0,2 0,0 1,0 0,-7 29,12-34,0 0,0 1,1-1,0 1,1-1,0 1,1 0,0-1,1 1,0-1,0 0,1 0,1 0,0 0,0 0,1-1,0 1,0-1,8 9,-1-5,0 0,0-2,1 1,1-1,0-1,1-1,-1 0,2-1,-1 0,1-1,32 9,-4-5,1-1,0-2,65 3,-27-8,0-5,-1-2,0-5,0-3,82-23,-62 7,-3-5,0-3,145-78,-193 86,-1-1,-2-4,0-1,82-79,-109 91,0 0,-2-1,-1-2,-1 0,-1 0,-2-2,0 0,-2 0,0-1,-3-1,10-41,-14 44,-2-1,-1 0,0 0,-3-1,0 1,-1 0,-2 0,-1 1,-1-1,-1 1,-1 0,-2 1,-15-32,13 35,-1 0,-1 1,0 1,-2 0,0 1,-1 1,-1 0,-1 1,0 1,-1 1,-1 1,0 1,-1 1,-36-16,21 15,-1 2,-1 1,1 2,-1 2,-41-1,-10 4,-98 9,184-6,0 0,-1 1,1 0,-1 0,1 0,0 0,0 0,-1 1,1 0,0 0,-4 2,6-1,-1-1,1 0,0 1,-1-1,1 1,1 0,-1 0,0 0,1 0,-1 0,1 0,0 0,0 1,-1 5,-1 4,1 0,1 0,0 1,1-1,0 0,1 0,1 0,0 0,0 0,2 0,-1-1,2 1,-1-1,9 15,-7-17,0 0,1-1,0 1,0-1,1-1,0 0,0 0,1 0,0-1,1 0,-1-1,1 0,0-1,1 0,-1 0,17 4,-15-5,0-1,0-1,1 0,-1 0,1-1,-1-1,0 0,14-2,-22 1,1 0,-1 0,0 0,0-1,0 1,0-1,0 0,0-1,0 1,-1-1,1 1,-1-1,1 0,-1 0,0 0,0-1,-1 1,1-1,-1 0,0 1,0-1,0 0,0-1,-1 1,3-8,-1-2,-1-1,-1 1,0 0,-1-1,0 1,-1 0,-1-1,0 1,-1 0,-1 0,0 0,0 1,-11-22,-3-1,-2 1,-1 1,-42-53,-76-74,133 153,0 1,0 1,0-1,-1 1,-10-8,14 13,1-1,0 1,0 0,0 0,-1 0,1 0,0 1,-1-1,1 1,-1-1,1 1,-1 0,1 0,0 0,-1 0,1 0,-1 1,1-1,-1 1,1-1,0 1,-1 0,1 0,-4 3,-2 1,0 1,1 0,0 0,0 1,1 0,-1 0,1 0,1 1,0 0,-7 13,-3 11,-17 50,27-69,-20 60,4 1,2 1,4 1,4 0,-4 124,15-191,-1 4,1 1,1-1,1 1,3 16,-5-27,1-1,-1 0,1 0,0 0,0 0,-1 0,1 0,1 0,-1 0,0 0,0 0,1-1,-1 1,1 0,-1-1,1 1,0-1,0 0,-1 1,1-1,0 0,0 0,0 0,0-1,0 1,1 0,-1-1,0 1,0-1,0 0,1 0,-1 0,3 0,4-2,0 1,0-2,0 1,-1-1,1-1,-1 0,0 0,0 0,11-9,9-8,27-26,-52 45,27-26,-1-1,-1-1,30-42,-47 56,0 0,-2-1,0-1,0 1,-2-1,0-1,-1 1,-1-1,2-20,-6 35,0 0,-1 1,0-1,0 0,0 0,0 0,-1 0,1 0,-1 1,0-1,0 0,-1 0,1 1,-1-1,1 1,-1-1,-3-2,2 3,0-1,-1 1,1 1,-1-1,0 0,1 1,-1 0,0 0,-1 0,1 0,0 1,-1-1,1 1,-6 0,-3-1,0 1,-1 1,1 0,0 1,-1 0,1 1,0 1,0 0,0 0,0 2,1-1,-1 2,-12 7,1 0,0 2,1 0,1 2,1 0,-29 31,28-25,2 2,1 0,0 1,2 1,2 1,-14 31,19-36,2 1,0 0,2 0,0 0,2 1,1-1,1 1,1 33,2-45,0-1,2 0,-1 1,2-1,-1 0,2 0,-1-1,2 0,-1 1,2-2,-1 1,2-1,-1 0,19 18,19 15</inkml:trace>
</inkml:ink>
</file>

<file path=ppt/ink/ink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8.139"/>
    </inkml:context>
    <inkml:brush xml:id="br0">
      <inkml:brushProperty name="width" value="0.05" units="cm"/>
      <inkml:brushProperty name="height" value="0.05" units="cm"/>
      <inkml:brushProperty name="color" value="#66CC00"/>
      <inkml:brushProperty name="ignorePressure" value="1"/>
    </inkml:brush>
  </inkml:definitions>
  <inkml:trace contextRef="#ctx0" brushRef="#br0">1321 261,'-23'-3,"21"2,-1 0,1 1,0-1,0 1,-1 0,1-1,0 1,0 0,-1 0,1 1,0-1,0 0,-1 1,-3 1,3 0,0 0,0-1,0 2,0-1,0 0,1 1,-1-1,1 1,-1 0,1 0,0 0,0 0,0 0,1 0,-1 0,1 1,0-1,0 1,0-1,-1 7,0 3,0 0,2 0,-1 0,3 20,-1-24,1 0,0 0,1-1,0 1,0 0,1-1,0 0,1 0,-1 0,2 0,7 8,-5-6,1 0,1 0,0-1,0-1,1 0,0 0,14 7,-19-12,1 0,0 0,0-1,0 1,0-2,1 1,-1-1,0 0,1-1,-1 1,0-2,1 1,8-2,-5 0,-1-1,0 0,-1-1,1 0,-1 0,1-1,-1 0,15-12,-12 7,1-1,-2 0,0-1,0 0,-1-1,0 0,-1-1,-1 0,0 0,-1-1,0 0,4-18,-8 22,0 0,-1-1,-1 1,1-1,-2 1,0-1,0 1,-1-1,-1 1,-5-22,4 23,-1 1,1 0,-2 0,1 0,-2 0,1 1,-1 0,0 0,0 1,-1-1,0 1,-1 1,-8-7,1 4,-1-1,0 2,0 0,-1 1,0 1,-1 0,1 2,-1 0,0 0,0 2,0 0,-1 1,1 1,-35 5,48-4,1 0,-1 0,0 0,1 1,-1-1,1 1,-1 0,1 1,0-1,0 1,0 0,0 0,1 0,-1 0,1 1,0 0,0-1,0 1,0 0,1 0,-1 1,1-1,0 0,0 1,-1 6,0 3,-1 0,2 0,0 1,1-1,0 1,2-1,1 18,-1-26,0-1,0 0,0 0,1 0,-1 0,1-1,1 1,-1 0,1-1,-1 1,1-1,1 0,-1 0,0 0,1-1,0 1,0-1,0 1,0-2,1 1,-1 0,1-1,0 0,7 3,-8-3,0-1,1 0,-1-1,0 1,0-1,0 1,0-1,1-1,-1 1,0 0,0-1,0 0,0 0,0 0,0-1,0 1,0-1,0 0,-1 0,1 0,-1-1,1 1,-1-1,0 0,0 0,0 0,0 0,-1 0,1-1,2-5,-1 1,-1 1,0-1,0 0,-1 0,0-1,0 1,-1 0,0-1,0 1,-1-1,-1 1,1-1,-1 1,0-1,-1 1,0 0,-1 0,1 0,-1 0,-1 0,0 0,0 1,0 0,-1 0,0 0,0 0,-10-8,7 8,0 0,0 1,-1 0,1 1,-1 0,-1 0,1 1,-1 0,0 1,0 0,0 0,0 1,0 0,0 1,-1 1,1-1,0 1,-1 1,1 0,-20 5,27-5,0 0,0 0,0 1,0 0,0-1,1 1,-1 0,1 0,0 0,-1 1,1-1,0 1,0-1,0 1,1-1,-1 1,1 0,-1 0,1 0,0 0,0 0,0 0,0 0,1 0,0 1,-1-1,1 6,0 1,1 0,-1-1,2 1,-1-1,1 1,1-1,0 1,5 11,-1-9,0 0,0 0,1-1,1 0,0-1,0 0,1 0,0-1,1-1,0 1,0-2,1 1,0-2,16 7,-16-7,0-2,0 0,0 0,1-1,-1-1,1 0,0 0,0-2,0 1,-1-2,1 0,0 0,0-1,-1-1,19-5,-26 6,-1 0,1 0,0-1,-1 1,0-1,1 0,-1-1,0 1,-1-1,1 1,-1-1,1 0,-1 0,0-1,-1 1,1-1,-1 1,0-1,0 0,0 0,-1 0,3-10,-4 9,1-1,-1 0,0 1,-1-1,1 0,-1 1,0-1,-1 1,0-1,0 1,0 0,-1 0,0 0,0 0,-1 0,1 1,-8-9,-2-1,-1 2,-1 0,1 1,-2 1,0 0,0 1,-30-14,32 18,0 0,-1 1,1 1,-1 0,0 1,0 0,0 2,-1-1,1 2,-20 1,31 0,0 0,0 0,1 0,-1 0,0 0,1 1,-1 0,1 0,0 0,-1 0,1 0,0 0,0 1,1 0,-1-1,0 1,1 0,0 0,-1 1,1-1,1 0,-1 1,0-1,1 1,0 0,-1-1,0 7,-1 9,0 0,2 0,0 0,1 25,1-26,-1-5,0-1,2 0,-1 0,1 0,1 0,4 12,-6-20,1-1,-1 1,1-1,0 0,0 1,0-1,0 0,1 0,-1-1,1 1,0 0,0-1,0 1,0-1,0 0,0 0,1 0,-1-1,1 1,-1-1,1 0,0 0,5 1,-5-1,0-1,0 1,0-1,0 0,0 0,0 0,0-1,0 1,0-1,-1 0,1 0,0 0,6-3,-8 2,0 1,0-1,0 0,0 0,0 0,-1 0,1 0,-1-1,1 1,-1 0,0-1,1 1,-1-1,-1 1,1-1,0 0,-1 1,1-1,-1 0,0 1,0-4,0-3,0 1,-1 0,-1-1,0 1,0 0,0 0,-1 0,0 0,0 1,-1-1,0 1,-9-12,5 8,0 1,0 0,-1 0,0 1,-1 0,0 1,-18-12,24 18,1 0,-1 0,0 0,0 0,0 1,0-1,0 1,0 0,0 1,0-1,-1 1,1-1,0 1,0 0,-1 1,1-1,0 1,0 0,0 0,0 0,0 1,-5 1,3 1,-1 0,1 1,1 0,-1 0,0 0,1 0,0 1,1 0,-1 0,1 1,-6 11,1 0,1 0,1 1,1 0,-6 28,9-34,1 1,0 0,1-1,1 1,0 0,1 0,4 17,-4-25,0-1,1 0,0 0,0 0,0-1,1 1,-1 0,1-1,0 0,0 0,1 0,0 0,-1 0,1 0,0-1,1 0,-1 0,0 0,1 0,0-1,0 0,0 0,-1 0,2-1,-1 1,0-1,7 0,4 1,-1-1,1-1,-1 0,1-2,-1 1,1-2,-1 0,18-7,-28 9,-1-1,1 0,-1 0,0 0,0 0,0-1,0 1,0-1,-1 0,1-1,-1 1,0 0,0-1,0 0,0 0,-1 0,0 0,1 0,-1 0,-1-1,1 1,-1-1,1 1,-1-1,-1 1,1-1,-1 0,0-6,0 2,0 0,-1 0,-1-1,0 1,0 0,-1 0,1 1,-2-1,0 0,0 1,0 0,-1 0,-9-12,-1 4,-1 0,-1 1,0 0,-1 1,0 1,-1 1,0 1,-1 1,-1 0,0 1,0 2,0 0,-1 1,0 1,0 1,0 1,-1 1,1 1,0 1,-1 1,-41 7,55-5,-1 0,0 0,1 1,0 1,0-1,0 2,1-1,-1 1,1 0,1 1,-1 0,1 0,0 1,1-1,0 2,0-1,1 0,-7 14,4-5,1 0,1 1,0 0,1 0,1 0,1 0,1 1,0-1,1 24,2-29,0 1,1-1,1 0,0 0,0 0,2-1,-1 1,1-1,1 0,1-1,-1 1,2-1,-1 0,2-1,-1 0,15 13,-11-13,0 0,1 0,0-2,1 0,-1 0,2-1,-1-1,1 0,0-1,0-1,0 0,0-1,25 2,-29-4,0-1,0 0,0-1,0 0,0-1,0 0,-1 0,1-1,18-8,-22 7,1 0,-1-1,0 0,0 0,-1-1,0 0,0 0,0 0,0-1,-1 1,0-1,-1-1,6-9,-5 7,-1-1,0 1,0-1,-1 0,0 0,-1 0,0 0,-1 0,0-1,-1 1,-1 0,1-1,-2 1,1 0,-1 0,-1 0,-4-12,0 7,-1 0,0 0,-1 1,0 0,-1 0,-1 1,0 1,-1 0,-1 0,-19-14,8 9,0 2,-2 1,0 1,0 1,-2 1,1 1,-1 2,-1 1,0 1,0 1,0 2,0 1,-1 1,-45 3,55 1,1 0,0 2,0 0,0 1,0 0,1 2,0 0,0 2,1-1,-22 16,18-9,1 2,0 0,2 0,0 2,0 1,2 0,-16 25,11-8,0 0,3 2,1 0,2 1,2 0,1 1,2 0,2 1,-3 56,10-80,1 0,1-1,0 1,2 0,0 0,1-1,0 1,2-1,0 0,0-1,2 0,11 18,-5-12,1-1,1 0,1-2,1 0,1 0,1-2,36 25,-13-14,1-2,0-3,2-1,1-2,1-3,0-1,97 17,-96-25,0-3,0-2,0-2,0-2,1-2,-1-2,-1-3,58-16,-78 16,-1-2,0-1,0-1,-1-1,-1-2,0 0,-1-2,-1 0,0-2,39-41,-51 46,0 1,-2-2,1 1,-2-1,0 0,-1-1,0 0,7-26,-11 28,-1-1,0 1,0-1,-2 0,0 1,0-1,-2 0,0 1,0-1,-9-27,2 18,-1 1,-1 0,-1 1,-1 0,0 1,-2 0,0 2,-2-1,0 2,-1 0,-1 1,0 1,-26-16,24 19,-1 0,0 1,0 1,-1 1,-1 1,0 1,0 2,0 0,-1 1,0 2,0 0,0 2,-32 2,51-1,1 1,0 0,0 0,0 1,0 0,0 0,0 0,0 0,1 1,-1 0,1 0,-1 0,1 0,0 1,1-1,-1 1,1 0,-1 0,1 1,0-1,1 0,-1 1,1 0,0 0,0 0,-2 5,-1 12,0 0,0 0,2 0,0 41,2-55,1 1,1-1,-1 1,1-1,1 1,-1-1,2 1,-1-1,6 13,-6-17,1-1,-1 1,1-1,-1 1,1-1,0 0,0 0,1 0,-1 0,1-1,-1 1,1-1,0 0,0 0,0 0,0-1,0 1,0-1,0 0,7 1,1 0,0-1,-1 0,1-1,0-1,0 1,0-2,-1 0,1 0,-1-1,1 0,-1-1,0 0,0-1,-1 0,1-1,-1 0,13-11,-11 6,0 0,-1-1,0 0,0-1,-2 0,1-1,-2 1,0-2,0 1,-2-1,10-31,-10 25,-1 0,-1-1,-1 1,-1-1,-1 0,-1 0,-1 1,-1-1,0 0,-2 1,-1 0,0 0,-1 0,-2 0,0 1,-1 0,-1 1,-1 0,-22-30,31 47,1 0,-1 0,0 0,0 0,0 0,0 0,-1 0,1 1,0-1,-1 1,-3-2,5 3,0 0,0 0,0 0,0 0,0 0,-1 0,1 0,0 0,0 1,0-1,0 0,0 1,0-1,0 1,0-1,0 1,0-1,0 1,0-1,1 1,-1 0,0 0,0 0,1-1,-1 1,0 0,1 0,-1 0,1 0,-1 2,-6 9</inkml:trace>
</inkml:ink>
</file>

<file path=ppt/ink/ink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1:55.243"/>
    </inkml:context>
    <inkml:brush xml:id="br0">
      <inkml:brushProperty name="width" value="0.35" units="cm"/>
      <inkml:brushProperty name="height" value="0.35" units="cm"/>
      <inkml:brushProperty name="color" value="#33CC33"/>
      <inkml:brushProperty name="ignorePressure" value="1"/>
    </inkml:brush>
  </inkml:definitions>
  <inkml:trace contextRef="#ctx0" brushRef="#br0">3927 2864,'22'0,"30"5,6 2,95 2,75-1,348-3,1-43,-311 0,-215 27,-1-2,-1-2,51-23,-82 29,0 0,0-1,-1 0,0-1,19-17,-31 23,1-1,-1 1,1-1,-1 0,-1 0,1 0,-1-1,0 0,-1 0,0 0,0 0,0 0,-1 0,0-1,0 0,0-7,-2 9,-1 1,1-1,-1 1,0-1,-1 0,1 1,-1 0,0-1,0 1,-1 0,1 0,-1 0,-1 1,1-1,0 1,-1-1,0 1,0 1,0-1,-8-5,-4-2,0 1,0 0,-1 1,0 1,-19-6,-21-4,-2 1,1 4,-64-7,-181-2,-20 23,277 3,1 2,-1 1,1 3,0 1,-44 19,66-20,1 1,0 1,0 2,1 0,1 1,0 1,1 0,1 2,1 0,0 1,1 1,-16 28,15-20,1 1,2 0,1 1,2 1,0 0,2 0,2 1,-7 64,8-4,5-1,10 94,-9-182,0 1,0-1,0 1,1-1,0 1,0-1,0 0,0 0,0 1,1-1,-1 0,1 0,4 5,-6-8,0 0,0 1,0-1,1 0,-1 0,0 0,0 0,1 0,-1 0,0 1,0-1,1 0,-1 0,0 0,0 0,1 0,-1 0,0 0,0 0,1 0,-1 0,0 0,0 0,1-1,-1 1,0 0,0 0,1 0,-1 0,0 0,0 0,1-1,-1 1,0 0,6-11,0-15,-4 13,-1 0,0 0,-1 0,0 0,-1 0,-1 0,0 0,-1 1,0-1,-1 1,0-1,-8-13,4 11,-1 0,-1 1,0 0,0 1,-2 0,0 0,0 1,-26-19,22 21,0 0,-1 0,0 2,0 0,-1 1,0 0,0 2,-27-5,4 4,0 1,-76 3,98 3,0 0,0 2,1 0,-1 1,1 1,0 0,0 2,0 0,1 1,-19 12,22-12,2 1,0 1,0 0,0 1,1 0,1 0,0 1,1 1,0 0,1 0,0 0,-11 27,15-29,1 0,-1 1,2-1,0 0,0 1,1 0,0-1,1 1,0 0,1-1,0 1,1-1,5 18,-3-17,1 0,0 0,1-1,0 1,1-2,0 1,1-1,0 0,1 0,0-1,0 0,14 9,-5-5,2-1,-1-1,1-1,1-1,0-1,0-1,0-1,1 0,0-2,25 2,0-1,1-3,0-3,79-9,-68 1,-1-2,67-22,-96 23,0-1,0-1,-1-2,0-1,49-35,-72 46,1-1,-1 0,0 0,0-1,0 0,-1 1,1-2,-1 1,-1 0,1-1,-1 1,3-11,-5 13,0 0,-1-1,1 1,-1-1,0 1,0 0,0-1,0 1,-1-1,0 1,0 0,0 0,0-1,-1 1,0 0,0 0,0 0,0 1,0-1,-1 0,-4-4,-4-3,0 1,-1-1,0 2,-1 0,0 1,0 0,-25-10,4 4,-1 1,-40-8,12 7,0 3,-115-6,128 16,0 3,1 1,0 3,-59 14,90-15,2 0,-1 1,1 1,-1 0,2 1,-1 1,1 0,1 1,-14 13,21-18,2 1,-1 0,0 0,1 0,0 1,1-1,0 1,0 1,0-1,1 0,0 1,0 0,1-1,0 1,0 0,1 0,0 0,0 1,1-1,0 0,2 14,1-8,1-1,0 0,1 1,1-2,0 1,0-1,2 0,-1 0,16 18,3 0,2-1,37 30,-16-19,2-3,2-1,1-3,1-3,2-1,0-4,2-1,1-4,1-2,93 15,-128-29,1-1,-1-2,1 0,-1-2,39-6,-52 4,0 0,0 0,-1-1,1-1,-1 0,0-1,0 0,-1-1,0 0,0-1,0 0,16-17,-11 5,0 0,-1 0,-1-2,-2 0,0 0,-1-1,-1-1,7-25,-7 17,-2-1,-1-1,-2 1,-1-1,-1-52,-4 68,-1 0,0 0,-2 0,0 1,0-1,-2 1,0 0,-1 0,-1 1,0 0,-1 0,-1 1,0 0,-1 1,-1 0,0 1,-1 0,-1 1,1 1,-2 0,0 0,0 2,-1 0,0 0,-26-8,16 7,-1 2,-1 1,1 2,-1 0,0 2,-1 0,1 3,0 0,-1 2,1 0,-31 9,42-7,0 1,0 1,1 0,-1 1,2 1,-1 1,1 0,-17 14,21-13,0 0,0 1,1 0,1 0,0 1,0 1,1-1,1 1,0 1,-8 22,7-12,1 0,2 1,0-1,1 1,2 0,0 0,2 0,1 0,1 0,1 0,1 0,1-1,14 43,-11-47,1 1,0-1,2 0,0-1,1 0,1-1,1-1,1 0,0 0,1-2,0 0,2-1,-1 0,2-2,36 20,-21-17,1-1,-1-2,2-1,0-2,69 8,-59-13,1-2,0-3,-1-1,58-11,-38 0,-1-3,0-4,-1-2,-1-2,-1-4,97-59,-90 42,-2-2,-2-4,-2-2,-3-3,61-73,-73 71,-3-3,-2-1,-3-1,-3-3,50-122,-74 153,-1 0,-2 0,-2-1,-1 0,-1 0,0-58,-6 76,-1-1,-1 1,0-1,-2 1,0 0,-1 0,0 1,-2-1,0 1,-1 1,-1-1,0 1,-1 1,-24-29,15 25,0 1,-2 1,0 1,-1 0,0 2,-2 0,1 2,-37-14,-5 3,-1 3,-75-13,22 11,0 4,-1 6,-212 5,185 22,125-11,0 1,0 1,0 1,-27 12,43-16,0 0,1 0,-1 1,1-1,-1 1,1 1,0-1,1 1,-1-1,1 1,0 1,0-1,0 1,1-1,0 1,0 0,0 0,1 0,0 1,0-1,1 0,0 1,0 0,0-1,1 1,0-1,1 8,0 6,0-1,2 1,1-1,0 0,1-1,1 1,10 21,-4-15,2 0,0-1,2-1,26 31,-4-12,3-3,1-1,1-2,69 43,-51-41,109 52,-127-72,1-1,1-2,73 14,-104-27,-1 0,1 0,-1-2,1 1,-1-2,1 0,-1-1,19-4,-24 4,0-1,-1 0,1-1,-1 1,0-2,0 1,0-1,-1 0,1 0,-1 0,0-1,-1 0,0-1,9-12,-3 1,-2 0,0-1,-1 0,-1 0,0-1,-2 1,0-2,-2 1,0 0,-1-1,-1 1,-1-1,0 1,-2-1,-5-26,-1 11,-1 1,-2 0,-1 1,-1 1,-2 0,-2 0,-37-54,27 49,-2 1,-1 2,-2 1,-1 1,-55-41,79 68,1 0,-1 1,-1-1,1 2,0-1,-16-3,22 7,0 0,-1 0,1 1,-1-1,1 1,-1 0,1 0,-1 1,1-1,-1 1,1-1,0 1,-1 0,1 0,0 1,-1-1,1 1,0-1,0 1,0 0,1 0,-6 5,1 1,0 0,0 1,0 0,1 0,1 0,-1 1,-3 12,-4 10,-7 35,0 19,3 2,4 0,4 1,4 0,13 174,-2-201,24 100,-22-133,1 0,1 0,1-1,2-1,22 37,-30-57,-1-1,1 1,1-1,-1-1,1 1,0-1,1 0,11 7,-17-11,1 0,0 0,0 0,0 0,0 0,0 0,0-1,0 1,0-1,0 0,0 1,0-1,0 0,0 0,0 0,0-1,0 1,0 0,0-1,0 1,0-1,0 0,0 0,0 0,-1 0,1 0,0 0,-1 0,1 0,0-1,-1 1,1-1,-1 1,0-1,0 1,0-1,1 0,0-2,-1 1,1 1,0-1,-1 0,0-1,1 1,-1 0,0 0,-1 0,1-1,-1 1,1 0,-1-1,0 1,0 0,-1-1,1 1,-1 0,1-1,-1 1,0 0,0 0,0-1,-1 1,1 0,-1 1,0-1,0 0,0 0,0 1,0-1,-1 1,1-1,-5-2,-1-1,-1 0,1 1,-1 0,0 1,0 0,-1 0,1 1,-1 0,0 1,-13-2,3 3,1 1,0 0,0 1,0 2,0 0,1 0,-1 2,1 0,0 2,0 0,1 0,0 2,0 0,-19 14,23-13,0 0,0 0,0 1,2 1,-1 0,2 0,-1 1,2 1,0-1,0 2,1-1,1 1,1 0,0 1,1 0,-6 28,10-34,1 0,0 0,0-1,1 1,1 0,-1 0,2 0,-1-1,1 1,1-1,0 0,0 0,0 0,1-1,1 1,-1-1,2 0,10 11,-5-7,1 0,0-1,1 0,1-1,-1 0,1-2,1 1,-1-2,31 10,-39-15,-1-1,1 1,0-1,-1-1,1 0,0 1,-1-2,1 1,0-1,-1 0,1-1,7-2,-4 0,0 0,0-1,-1 0,1 0,-1-1,16-14,-7 3,-1-1,-1-1,-1 0,0-1,-2 0,12-23,-10 13,-1 0,-2-1,-1 0,-2-1,11-59,-17 66,-1 1,-1-1,0 0,-2 0,-1 0,-1 1,-2-1,-9-33,9 45,0-1,-1 1,-1 0,0 1,-1-1,0 1,-14-15,15 20,0-1,-1 1,0 0,0 1,0 0,-1 0,0 0,0 1,-1 1,-18-7,22 10,0 0,0 1,0-1,0 1,0 1,0-1,0 1,0 0,1 0,-1 1,0-1,1 1,-1 1,1-1,-1 1,1 0,0 0,-6 5,-5 4,1 1,0 1,0 0,-13 18,6-3,0 1,2 1,1 1,2 1,1 0,2 1,-16 55,18-43,2 0,2 1,2 0,3 0,2 71,1-110,1 1,0-1,0 1,1-1,0 0,1 0,0 1,4 8,-5-13,0-1,0 0,1 0,-1 0,1 0,-1 0,1-1,0 1,0-1,0 0,1 1,-1-1,0-1,1 1,-1 0,1-1,0 0,-1 0,1 0,6 0,-1 0,1-1,-1 0,0 0,1-1,-1-1,1 0,-1 0,0-1,0 0,0 0,13-8,9-6,50-38,-15 4,-2-3,-3-3,-2-2,-3-3,84-120,-117 149,-2-1,-1 0,-2-2,-1 0,17-55,-30 76,0-1,-2 0,1 0,-2 0,0 0,-1 1,-2-18,0 21,0 1,-1 0,0 0,-1 0,0 1,0-1,-1 1,-1 0,0 0,-13-17,3 10,-1 0,-1 1,0 0,-1 2,0 0,-1 1,0 2,-1 0,-1 0,-25-7,0 3,-1 1,0 3,-97-10,73 17,-1 3,-136 15,-142 52,220-32,-207 81,274-88,1 3,2 3,1 2,1 3,-57 49,97-71,1 1,0 1,1 1,1 1,1 0,-19 31,28-38,0 0,0-1,2 2,-1-1,2 0,-1 1,2 0,0 0,1 0,0 0,1 0,0 0,4 15,0-10,0 0,2-1,0 0,1 0,1-1,1 0,0 0,1-1,1 0,1-1,0 0,1-1,0 0,21 16,5 1,0-3,2-1,2-2,63 27,-37-22,0-3,2-3,118 24,-144-40,-1-2,1-2,0-2,0-2,0-2,0-2,56-12,-82 12,1-2,-1 0,0-2,-1 0,0 0,0-2,-1 0,0-2,-1 1,-1-2,1 0,17-20,-25 23,0 0,0-1,-1 0,-1 0,0-1,0 1,-1-1,-1-1,0 1,0 0,-1-1,-1 0,0 0,-1 0,0 0,-1 0,0 0,-1 0,-1 0,-3-13,-1 7,0 0,-1 1,-1-1,-1 1,0 1,-2 0,0 0,-1 1,0 0,-1 1,-1 1,-21-18,4 7,-1 1,-1 2,-1 1,0 1,-53-20,34 20,0 2,-62-12,15 11,-2 5,-171-2,-211 45,280-1,-234 64,273-45,-284 120,218-54,194-91,0 1,2 2,-57 53,81-67,0 0,1 1,0 1,1-1,0 1,1 1,1 0,0 0,0 0,-6 26,10-29,1 0,1 0,0 1,0-1,1 0,0 1,1-1,0 1,1-1,1 0,0 0,0 0,1 0,0-1,7 13,-2-8,1 0,1 0,0-1,1 0,0-1,1 0,1-1,0-1,25 16,0-3,2-2,74 28,-33-21,1-4,1-3,1-4,1-4,0-3,1-5,-1-3,95-9,-130 1,0-1,0-3,0-3,-2-1,1-3,-2-2,86-44,-108 48,-1-2,-1-1,0 0,-2-2,0-1,-1 0,0-2,-2 0,-1-2,-1 0,-1 0,-1-2,-1 0,-1 0,9-30,-15 35,-1 0,-1 0,-1 0,-1-1,-1 1,-1-1,-1 0,0 1,-2-1,-1 0,0 1,-9-27,7 31,-2 1,0 0,0 0,-2 1,0 0,0 0,-2 1,0 1,0-1,-1 2,-1 0,0 0,0 1,-1 1,-31-17,7 8,-1 2,-1 2,0 2,0 1,-76-11,13 10,-129 2,77 13,1 7,0 7,-177 41,87 9,204-51,1 1,1 2,-66 42,91-51,0 0,1 1,0 1,1 0,0 0,0 1,1 0,-8 15,14-21,1 0,0 0,0 0,1 0,-1 1,1-1,1 1,-1-1,1 1,1 0,-1-1,1 1,0 0,0 0,1-1,0 1,0-1,1 1,0 0,0-1,4 9,-1-6,0-1,0 1,1-1,0-1,0 1,1-1,10 9,7 3,32 20,-7-10,55 26,116 33,-48-33,2-9,2-6,1-9,351 16,-421-45,211-25,-272 16,0-2,0-2,-1-2,0-2,-1-2,78-43,-102 48,-2-1,0-1,-1 0,0-1,-1-1,-1-1,0 0,-1-1,-1 0,15-31,-20 35,-1-1,-1 0,0-1,-1 1,-1-1,-1 0,0-1,-1 1,0 0,-2-1,0 1,0 0,-2-1,0 1,-4-16,3 21,-1 0,0 1,0-1,-1 1,0 0,-1 1,0-1,-1 1,0 0,0 1,-9-9,5 8,-1-1,0 2,-1 0,1 0,-2 1,1 0,-22-6,2 4,1 1,-1 2,0 1,-1 1,1 2,-60 5,30 3,1 3,0 2,1 4,0 2,1 2,1 3,1 3,2 2,0 3,2 2,-89 70,116-80,2 1,0 2,2 1,-33 45,46-57,2 1,-1-1,2 1,0 1,1-1,1 1,0 0,1 0,1 1,0-1,0 26,4-20,1 0,1 0,1-1,0 0,2 0,1 0,0 0,2-1,0 0,1-1,1 0,1-1,0 0,2-1,0 0,22 20,2-5,1-1,1-3,2-1,50 24,-5-10,107 35,-151-60,-1-3,2-1,0-3,0-1,55 2,-92-9,1-1,-1 0,0-1,1 0,-1 0,0 0,0-1,0 0,0-1,0 0,8-4,-11 4,0 0,0 0,-1 0,1 0,-1-1,0 0,0 1,0-1,0-1,-1 1,1 0,-1-1,0 1,0-1,-1 1,0-1,2-7,-1-1,0 0,-1 0,-1 0,0 0,0 0,-1 0,-1 0,-5-20,1 15,0 0,-1 1,0 0,-2 0,-14-22,2 10,-2 0,-1 1,-1 2,-1 0,-50-37,18 23,-2 2,-1 3,-1 3,-2 2,-1 4,-96-27,57 27,-1 4,0 5,-168-6,171 21,0 4,-140 23,187-16,0 2,1 3,1 3,1 1,0 3,-50 28,87-40,-1 1,1 0,1 0,0 2,1 0,0 0,-20 26,28-31,0 1,0 0,1 0,0 1,0-1,0 1,2 0,-1 0,1 0,0 0,1 0,0 1,0-1,1 0,0 1,3 14,-1-11,1 0,0 0,1 0,0-1,1 1,0-1,1 0,1 0,0-1,0 0,1 0,1-1,0 1,0-2,1 0,0 0,0-1,1 0,0 0,1-1,15 7,18 4,0-2,1-2,1-2,0-2,94 7,-131-16,-1-1,1 0,-1-1,1 0,-1 0,1-1,-1 0,0-1,0 0,13-6,-13 3,-1 1,1-2,-1 1,0-1,-1 0,1 0,-1-1,-1 0,9-13,1-4,-1-1,-2 0,0-1,-2 0,0-1,-2 0,-2-1,0 0,-2 0,-1 0,0-36,-4 42,-1-1,-1 1,-1 0,-1 0,-1 0,0 0,-2 1,-1 0,-1 0,-1 1,-1 0,0 1,-2 0,-28-35,17 30,-2 1,0 1,-2 2,0 0,-1 2,-1 1,-1 2,-1 0,-36-11,-3 3,-1 3,-1 3,-89-10,-105 5,231 22,0 3,0 0,0 3,0 0,-46 15,76-18,1 0,0 0,0 0,-1 0,1 1,1 0,-1 0,0 1,1-1,0 1,-1 0,2 0,-7 9,7-9,1 0,0 0,0 0,1 1,-1-1,1 1,0-1,0 1,1 0,-1-1,1 1,0 0,0-1,1 1,-1 0,1-1,2 6,2 8,1 1,1-1,1-1,0 0,2 0,0 0,0-1,18 19,-2-5,2-2,0-1,40 29,-16-20,1-2,1-2,2-2,1-4,1-1,67 18,-47-22,0-3,2-3,0-4,110 2,-137-13,1-3,0-1,-1-3,0-3,-1-1,0-3,0-3,65-30,-84 31,-1-1,-1-2,-1-2,0 0,39-40,-48 41,-2-2,0 0,-2-1,0-1,-2-1,-1 0,18-42,-26 50,1-1,-2 0,-1 0,0 0,-1-1,-1 1,-1-1,0 0,-4-32,1 40,0-1,0 1,-2-1,1 1,-1 0,-1 1,0-1,-1 1,0 0,0 0,-1 0,0 1,-1 0,0 1,0 0,-16-13,6 9,-1 1,0 0,-1 2,1 0,-2 1,-35-9,1 5,-81-8,45 13,-1 4,1 3,-1 5,1 4,0 4,1 3,1 5,0 3,2 5,1 3,-111 58,150-64,1 1,-78 63,106-75,0 1,1 1,1 1,1 0,1 0,0 2,1 0,-19 41,29-54,1 0,0-1,0 2,0-1,0 0,1 0,1 0,-1 1,1-1,0 0,1 1,0-1,2 11,0-11,-1 0,2 0,-1 0,1 0,0-1,0 1,0-1,1 0,0-1,1 1,-1-1,1 0,7 5,7 3,0-1,1-1,1 0,0-2,0-1,1 0,24 4,28 5,1-4,1-3,-1-3,134-5,-108-9,0-4,-2-4,111-33,-140 28,130-56,-173 63,-1-1,0-2,-1 0,-1-2,0-1,-2 0,25-27,-41 38,-1 0,1 0,-1-1,-1 1,0-1,0-1,0 1,-2-1,1 0,-1 0,2-10,-4 12,0 0,-1 1,0-1,0 1,-1-1,0 1,0-1,-1 1,0-1,0 1,0 0,-1 0,0 0,-1 0,-6-9,0 3,-1 1,0 0,0 0,-1 1,-1 1,0 0,0 1,-1 0,0 1,0 1,-1 0,-16-5,-18-4,-1 2,-78-13,25 13,0 3,-109 4,130 9,0 4,1 3,-90 23,140-25,1 2,1 0,0 2,0 2,-27 15,47-22,-1 1,1 0,0 0,0 1,1 0,0 0,-8 12,11-13,1 0,0 0,1 0,-1 0,1 1,1-1,0 1,0 0,0-1,1 1,-1 13,3-5,0 0,1 0,1 0,0 0,1-1,1 1,0-1,1 0,1-1,0 1,18 25,1-4,2-1,1-1,36 33,-7-14,2-4,2-1,2-4,2-3,1-2,2-3,2-4,1-2,2-4,109 24,-148-43,0-1,1-2,-1-2,1-1,-1-2,68-10,-80 6,0-1,0-1,0 0,-1-2,-1-1,1-1,-2 0,1-2,-2 0,0-1,22-22,-12 8,-2-2,-1-1,-1-1,-2-1,-1-1,18-41,-26 46,-2 0,-1-1,-1 0,-1 0,-2-1,-1-1,-2 1,1-43,-5 63,0-1,-1 1,0 0,-1 0,0 0,-5-12,6 19,-1 0,0 0,0 0,-1 0,1 0,-1 0,0 0,0 1,0 0,0-1,-1 1,1 0,-1 1,0-1,1 1,-1-1,-6-1,1 0,-1 1,0 1,1-1,-1 2,0-1,0 1,0 1,0 0,0 0,0 1,0 0,0 1,1 0,-1 1,0 0,1 0,0 1,0 0,-11 7,7-3,1 0,0 0,0 2,1-1,0 1,1 1,0 0,0 1,2-1,-1 2,1-1,-9 22,10-18,1 1,0 0,2 0,0 1,0-1,0 20,4-27,0 0,0 0,1 0,0 0,1-1,0 1,0 0,1-1,0 1,1-1,0 0,1 0,5 8,2-1,1 0,1-1,0-1,1 0,0-1,1 0,0-1,28 14,2-2,0-2,61 18,-31-15,2-3,0-3,149 14,-179-29,0-3,0-1,0-3,0-2,0-2,-1-2,81-27,-111 30,0-1,-1-1,1-1,-2-1,1 0,-1 0,23-23,-34 28,1 0,-1 0,0 0,0-1,0 0,-1 0,0 0,0 0,-1 0,4-11,-6 12,1 0,-1 0,1 0,-1 0,-1 0,1 0,-1 0,0 0,0 1,0-1,-1 0,1 0,-1 1,0-1,-1 1,-3-5,-1-2,-2 1,1 0,-1 0,-1 1,0 1,0-1,0 2,-1-1,-1 2,1-1,-25-9,12 7,0 2,-1 0,0 1,0 1,-30-1,27 4,0 2,0 0,0 2,0 1,0 2,1 0,-1 2,1 1,1 1,0 1,-35 20,54-26,0 0,1 1,0 0,0 0,0 0,1 1,0 0,0 0,0 0,1 0,0 1,-5 10,5-7,0 1,1 0,0 0,1 0,0 0,1 0,-1 22,3-12,1 0,1 0,1 0,1-1,0 1,2-1,0-1,19 36,-10-27,2-1,1 0,1-2,1 0,1-1,1-1,52 39,-52-46,0-1,1-1,1-1,1-1,-1-1,2-1,-1-2,1 0,46 5,-63-12,-1 0,1 0,-1-2,1 1,0-1,-1 0,1-1,-1 0,0-1,16-6,-18 5,-1 1,1-1,-1 0,0-1,-1 1,1-1,-1 0,0-1,0 1,-1-1,1 0,-1 0,-1 0,7-13,-4 2,-1 0,0 1,-1-2,-1 1,-1 0,0-1,-1 1,-1-1,-1 1,0 0,-2-1,0 1,0 0,-10-26,4 19,0 0,-2 1,0 0,-2 0,0 1,-2 1,0 1,-2 0,-23-23,16 21,-44-31,57 46,-1-1,0 2,0-1,0 2,-1-1,-19-4,28 10,-1-1,1 1,0-1,0 1,0 1,0-1,0 1,0-1,0 1,0 0,0 0,0 1,0-1,0 1,1 0,-1 0,-3 3,4-3,1 0,0 0,0 0,0 0,0 0,0 0,1 0,-1 0,1 1,-1-1,1 1,0-1,0 1,0-1,0 1,1 0,-1-1,1 1,-1 0,1 0,0 0,0-1,0 1,1 0,-1 0,1 3,1-3,-1 0,1 0,-1 0,1 0,0 0,0-1,0 1,0-1,1 1,-1-1,1 0,0 0,-1 0,1 0,0 0,0-1,0 1,0-1,0 0,1 0,3 1,5 1,0-1,0 0,0 0,22-1,-18-2,0-1,1-1,-1 0,-1-1,1-1,-1 0,1-2,-2 1,1-2,-1 0,0 0,0-1,-1-1,-1-1,1 1,11-16,0-1,-1-1,-1-1,-2-1,-1-1,-2-1,18-43,-17 29,-1-2,-3 0,-2 0,-2-1,-2-1,-2 1,-3-1,-1 0,-3-1,-2 1,-2 1,-2-1,-3 1,-27-82,31 113,-1 0,-1 0,-1 1,0 1,-1-1,-14-16,16 24,-1-1,0 1,0 1,-1 0,0 0,-1 1,0 0,0 1,-21-9,9 6,1 2,-1 1,0 1,-1 1,1 1,-27-1,37 4,0 0,0 1,0 0,0 1,1 1,-1 0,0 0,1 1,0 1,0 0,0 1,-17 11,23-12,0 0,0 0,1 0,-1 1,1 0,1 0,-1 0,1 1,0 0,1-1,-1 1,2 0,-1 1,1-1,0 0,0 1,1 0,0-1,0 1,0 0,1-1,2 14,0-9,0-1,1 0,0 1,0-1,2 0,-1 0,1-1,1 1,0-1,0-1,1 1,0-1,1 0,13 12,-2-5,1-2,0 0,1-1,0-1,1-1,0-1,38 12,-6-7,-1-3,75 8,-60-14,0-3,-1-3,1-2,-1-4,1-3,-2-2,1-4,-2-2,0-3,-2-3,0-3,-1-3,87-55,-111 60,-2-2,-1-2,50-51,-71 65,-1-1,-1-1,0 0,-1 0,-1-1,0 0,-1-1,-1 0,-1-1,7-27,-12 37,0 0,-1 0,-1 0,1-1,-1 1,-1 0,0 0,0 0,-1 0,0 0,0 0,-1 0,0 1,-9-17,5 14,0 1,-1-1,0 2,-1-1,0 1,0 1,-1-1,0 2,-20-12,0 3,-1 2,0 1,-1 1,-1 2,0 1,0 2,-40-4,14 7,0 2,0 2,0 4,1 2,-111 25,128-20,0 1,1 2,0 2,1 2,-60 37,73-38,0 2,1 0,2 2,0 0,1 2,1 0,1 2,-22 35,33-46,1 0,1 1,0 0,1 1,1 0,0 0,1 0,1 0,-2 20,4-27,1 0,1 0,-1 0,1 0,1 0,0 0,0 0,1 0,0 0,0-1,1 0,0 1,1-1,0-1,0 1,0-1,1 0,8 8,4 0,1 0,0-1,1-1,1-1,0 0,0-2,1-1,0 0,33 7,-1-3,0-3,111 7,-99-15,1-3,-1-2,0-4,77-16,-106 14,1-1,-1-2,-1-2,0-1,-1-2,-1-1,-1-2,46-35,-62 41,-1 0,0-2,-1 0,-1-1,-1 0,0-1,-2-1,0 0,17-40,-24 48,0-1,-2 1,1-1,-1 0,-1 0,0 0,0 0,-3-19,1 22,-1 0,0-1,-1 1,0 0,0 0,-1 0,0 1,0-1,-1 1,-1 0,-10-13,6 11,0 1,0 0,-1 0,0 1,0 1,-1 0,0 0,-1 1,1 1,-1 0,0 0,0 2,-1-1,-19-1,1 2,1 1,-1 1,1 2,-1 2,-41 7,14 3,0 3,1 2,1 2,1 3,1 2,1 3,-67 46,60-31,3 2,1 3,2 2,3 3,-75 97,101-114,1 0,2 2,1 1,2 1,2 0,2 1,-14 53,25-70,1 1,0-1,2 1,1-1,1 1,3 26,0-32,0 0,1-1,2 1,-1-1,2 0,0-1,2 0,15 26,-12-26,0-2,1 0,0 0,1-1,1-1,0 0,1-1,0-1,34 18,-10-10,0-3,2 0,57 12,-86-25,0 0,0-1,0 0,1-1,-1 0,1-1,-1-1,1 0,-1-1,0-1,0 0,0 0,0-1,0-1,-1 0,1-1,-1 0,-1-1,0 0,0-1,17-15,-15 10,-1 0,-1 0,0-1,15-25,-21 30,0 0,-1-1,0 0,0 0,-1 0,0 0,-1 0,0 0,0-12,-2 19,0 0,0 0,0-1,0 1,-1 0,1 0,-1 0,0 0,0 0,0 0,0 0,-1 0,1 1,-1-1,0 0,0 1,0-1,0 1,-3-3,2 3,0 0,0 0,0 0,-1 0,1 1,-1 0,0-1,1 1,-1 0,0 1,1-1,-1 1,0 0,0 0,-7 0,-11 3,-1 1,1 1,1 1,-1 0,1 2,-33 16,24-8,1 1,1 2,-47 39,55-40,1 1,2 1,-1 0,2 1,1 1,1 1,1 0,1 1,0 0,2 0,1 1,2 1,-9 40,15-54,0-1,1 0,0 1,1-1,0 0,0 1,1-1,1 0,0 0,0 0,7 12,-3-10,0 0,1-1,0 0,1 0,0-1,1 0,0-1,12 10,-3-5,2-1,0 0,1-2,0 0,0-1,1-2,1 0,0-2,47 9,-50-13,-1-1,1-2,-1 0,1-1,0-1,-1-1,0-1,0 0,0-2,0 0,-1-1,0-1,0-1,-1-1,-1 0,30-23,-28 17,0 0,0-2,-2 0,0-1,-2 0,0-2,-1 0,-1 0,0-1,-2-1,-1 0,-1-1,8-32,-13 40,-1 0,-1-1,0 1,-1-1,-1 0,-1 1,0-1,-2 0,-4-21,4 27,-1 1,1-1,-1 1,-1 0,0 1,0-1,-1 1,-1 0,1 1,-1-1,0 1,-1 1,0-1,0 1,-13-7,9 6,-1 1,1 1,-2 0,1 1,-1 1,1 0,-1 0,0 2,-1-1,1 2,0 0,-1 1,1 0,-21 4,13 0,0 1,0 1,1 1,0 1,1 1,0 1,0 0,-28 21,26-16,0 2,2 0,0 1,1 1,0 1,-30 44,42-54,1 1,0 0,1 0,0 1,1-1,0 1,0 0,1 0,1 0,0 1,1-1,0 1,1-1,1 0,0 1,0-1,4 16,-2-19,0 0,0-1,0 0,1 0,0 0,1 0,0-1,0 1,0-1,1-1,0 1,0-1,10 7,-5-5,0 0,1-2,0 1,0-2,0 1,1-2,0 0,14 3,2-2,0-1,-1-2,1-1,0-1,0-1,0-2,45-10,-34 3,0-2,-1-2,0-2,-1-1,-1-2,-1-1,-1-2,-1-2,0 0,-2-3,37-39,-47 42,-2-1,0 0,-1-2,-2 0,-1-2,18-42,-24 47,-2-2,-1 1,0-1,-2 0,-1 0,-2 0,0 0,-3-40,-1 44,-1 0,-1 0,-1 0,-1 0,-1 1,0-1,-2 2,-1-1,0 1,-21-29,15 28,-1 0,-1 1,0 1,-2 1,0 0,-1 2,-1 0,-36-19,23 17,0 1,-1 2,0 2,-2 1,1 2,-1 1,-1 2,1 2,-61 0,93 5,0 0,0 0,1 1,-1 0,0 0,1 0,-7 3,11-3,-1-1,1 1,0 0,0 0,0 0,0-1,0 1,0 0,0 0,0 1,0-1,0 0,0 0,1 0,-1 0,0 1,1-1,-1 0,1 1,0-1,-1 0,1 1,0-1,0 0,0 1,0-1,0 1,0-1,0 0,0 1,1-1,-1 0,0 1,2 1,0 2,0 1,1-1,-1 0,1 0,0 0,1-1,-1 1,1-1,0 0,0 0,1 0,-1 0,1-1,0 0,0 0,0 0,0 0,0-1,6 2,5 2,0-1,1-1,-1-1,1 0,23 1,-19-3,-1-2,1 0,-1-1,0-1,0-1,0-1,-1 0,1-2,-1 0,0-1,-1-1,0-1,-1-1,17-12,-22 14,-1 0,-1-1,0 0,0-1,-1 0,0 0,-1-1,0 0,-1-1,-1 0,0 0,0 0,-1-1,-1 1,0-1,-1 0,-1 0,0-1,-1 1,-1-26,-1 23,-1 0,-1 1,-1-1,0 1,-1-1,-1 1,-1 1,-10-20,5 15,0 1,-2 0,0 1,-1 1,-27-25,13 19,0 0,-1 2,-1 2,-1 1,-1 1,0 1,-53-16,64 26,-1 0,0 1,-1 2,1 0,0 2,-1 0,0 2,1 0,-24 5,30-3,0 1,0 1,1 0,-1 1,1 1,1 0,-1 1,1 1,1 1,-1 0,2 0,-21 21,30-26,-1 0,1 0,0 0,0 1,1-1,0 1,0 0,0 0,-2 9,4-11,0 0,1 1,-1-1,1 0,0 1,0-1,0 1,1-1,-1 0,1 1,0-1,1 0,-1 1,1-1,2 4,1 1,1 0,0 0,0-1,1 1,0-2,0 1,1-1,0 0,1 0,17 10,0-3,0-1,50 16,-30-15,1-2,1-2,0-2,0-2,0-2,1-2,-1-3,1-1,-1-3,0-2,0-1,-1-3,0-2,-1-2,0-2,-1-2,68-41,-90 46,-1-2,0-1,-2 0,0-2,-1 0,0-1,-2-1,15-23,-24 33,-1-1,0-1,-1 1,-1-1,0 0,-1 0,0 0,-1-1,0 1,-1-1,-1 0,0 0,-1 0,0 1,-1-1,-1 0,-4-18,0 14,0 1,-2 0,0 0,0 1,-2 0,0 0,-1 1,0 1,-2 0,1 0,-28-21,2 5,0 3,-2 1,-61-29,22 15,-1 3,-112-34,184 69,3 0,-1 0,0 0,0 1,0-1,0 2,0-1,0 1,0 0,-1 0,1 0,-7 2,12-1,0-1,0 1,0-1,0 1,0 0,0 0,0 0,0 0,1 0,-1 0,0 0,1 0,-1 0,0 0,1 0,-1 0,1 0,-1 0,1 1,0-1,0 0,-1 0,1 0,0 1,0-1,0 0,0 0,1 1,-1-1,0 0,0 0,1 0,-1 1,1-1,0 2,2 6,1 0,0 0,7 11,-9-18,14 23,1-1,1-1,1 0,1-2,1 0,1-1,0-2,2 0,0-1,1-2,36 18,-56-31,0 0,0 0,0 0,1-1,-1 1,0-1,1-1,-1 1,1-1,-1 0,7-1,-10 1,1-1,0 0,0 0,-1 0,1 0,0 0,-1-1,0 1,1-1,-1 1,0-1,1 0,-1 0,0 0,-1-1,1 1,0 0,0-1,-1 1,0-1,1 1,1-6,2-8,0-1,-1 0,-1-1,0 1,-1-1,-1 1,-2-23,-3-13,-10-58,-6 4,-5 1,-4 1,-46-106,72 202,-5-12,-2 1,-20-35,28 51,-1 0,1 1,-1-1,0 1,0-1,0 1,0 0,0 0,-1 1,0-1,1 1,-1 0,0 0,0 0,0 0,0 1,0-1,-1 1,1 0,-9-1,9 3,0-1,-1 1,1 0,0 0,0 0,-1 1,1 0,0-1,0 1,1 1,-1-1,0 0,-3 4,-5 5,0 0,-12 15,14-15,-28 32,2 2,2 1,-53 94,73-113,1 1,1 1,1 0,2 1,0 0,3 0,0 1,-2 56,8-71,1-1,0 1,1-1,1 0,0 0,1 0,1 0,12 26,-12-31,0-1,1 0,0 0,1-1,-1 0,2 0,-1-1,1 0,0 0,1 0,-1-1,1-1,1 0,10 5,-4-3,1-1,0-1,0-1,1 0,-1-1,1-1,29 0,-22-4,1 0,0-1,-1-2,45-13,-30 4,-1-2,0-2,-1-1,-1-3,0 0,40-35,-42 28,-1-2,-1-1,-3-1,0-2,-2 0,24-43,-38 54,-1 0,-1-2,-2 1,13-45,-19 51,0 0,-1 0,-2-1,1 1,-2-1,-1 1,-3-25,1 29,-1 0,0 1,-1 0,0 0,-2 0,1 0,-1 1,-1 0,-1 1,0 0,0 0,-1 1,0 0,-1 0,-1 2,1-1,-1 1,-16-8,0 1,0 2,-1 1,0 2,-1 0,0 2,-1 2,-54-7,11 7,0 4,1 3,-133 17,91 2,-186 55,237-54,-77 36,111-42,1 2,0 1,1 1,-35 30,57-43,0 0,1 0,0 1,0-1,0 1,1 1,0-1,0 0,0 1,1 0,0 0,1 0,-1 0,1 1,1-1,-1 1,1-1,1 1,-1-1,1 1,0-1,1 1,0-1,0 1,1-1,0 1,0-1,1 0,-1 0,2 0,-1 0,6 8,8 7,0 0,1-1,1-1,0-1,2 0,29 19,-20-17,2-1,0-2,1-1,44 15,-58-25,0-2,0 0,39 4,-50-8,-1 0,1-1,0 0,-1-1,1 0,-1 0,1 0,-1-1,1 0,-1-1,0 1,0-1,8-5,-11 5,-1 0,1-1,-1 1,1-1,-1 1,0-1,-1 0,1-1,0 1,-1 0,0-1,0 1,-1-1,1 0,-1 1,0-1,0 0,-1 0,1 0,-1 0,0-7,-1-2,-1 0,0 1,-1 0,0-1,-1 1,-10-23,1 10,-2 1,0 1,-1 0,-2 1,0 1,-2 1,0 1,-27-21,3 6,-2 2,-1 2,-64-31,46 31,-2 3,-1 3,-1 3,-140-25,145 37,0 4,-1 2,1 3,-1 3,-117 19,138-12,1 3,-1 1,2 2,-59 29,72-29,1 1,0 1,2 2,0 1,1 1,-42 45,59-57,0 2,1-1,0 1,0 0,1 1,1-1,0 1,1 0,0 1,0-1,2 0,-1 1,2 0,-1 24,3-21,0 0,2 0,0 0,0-1,2 1,0-1,0 0,2 0,0-1,0 0,17 23,0-6,3 0,0-1,2-2,1 0,1-3,62 40,-29-27,2-2,127 48,-137-64,0-3,1-2,1-2,0-4,0-1,1-4,66-2,-87-4,0-1,0-3,0 0,-1-3,0-1,-1-2,0-1,-1-2,0-1,-1-2,61-43,-73 43,-1-1,-1 0,-1-2,-1 0,-1-1,0-1,-2 0,-1-1,-1-1,-1 0,-1-1,-1 0,7-30,-12 35,-1 1,-1-2,-1 1,-1 0,-1 0,0-1,-7-36,4 42,-2-1,1 1,-2 0,0 0,-1 1,-1 0,0 0,-1 0,-1 1,-15-18,11 18,-1 0,0 0,-1 2,-1 0,0 1,0 0,-1 2,0 0,-1 1,0 1,0 0,-38-6,13 6,-1 1,-1 2,1 3,-79 7,56 2,1 3,0 4,1 2,0 3,-71 33,39-8,3 4,-138 95,147-83,2 5,4 3,-122 135,149-141,2 2,3 3,2 2,5 2,-41 93,62-118,2 1,3 0,2 2,-14 90,25-118,0 1,2-1,0 0,1 1,2-1,0 0,1 0,1 0,1-1,1 0,1 0,1 0,17 27,-12-27,2 0,0-1,1 0,2-1,36 29,-25-26,1-1,1-2,54 25,-29-21,1-3,1-2,0-2,108 12,-93-20,1-4,-1-3,1-4,123-19,-146 13,0-3,-1-2,0-3,-2-1,0-3,-1-1,61-41,-81 45,-2-2,0-1,-2-1,0-1,38-49,-48 53,-1-1,-1 0,-1-1,0-1,-2 1,0-2,-1 1,7-42,-12 53,-2 0,0 0,0 0,-1 0,0 0,-1 1,0-1,-1 0,0 0,0 0,-2 1,1-1,-1 1,-1 0,1 0,-2 1,0-1,0 1,0 0,-1 1,0 0,-1 0,0 0,0 1,-1 0,0 1,0 0,0 0,-1 1,-17-8,5 6,1 0,-1 2,-1 0,-34-2,-99 4,66 10,1 3,0 5,-165 48,118-17,-220 108,252-100,2 4,-169 129,214-141,3 2,2 3,2 1,2 3,-70 105,99-129,2 0,1 1,1 0,2 2,1-1,2 1,-10 57,17-69,1 0,2 0,0 0,1 0,0 0,2-1,1 1,1-1,1 1,0-1,2-1,0 1,16 26,-12-27,1-1,1 0,1-1,0 0,2-1,0-1,0-1,26 17,-17-15,1-1,1-1,1-2,0-1,50 14,-32-15,1-2,0-2,0-2,0-2,1-2,-1-3,95-15,-91 7,-2-3,1-2,-2-2,0-2,-1-3,-1-1,-2-3,0-1,-2-3,-1-1,-1-2,-2-2,-1-1,-2-3,-2 0,-1-2,-3-2,50-90,-64 103,-2-2,-1 0,-2 0,-1-1,-1 0,-2-1,-1 0,-2 0,0-45,-4 59,-1 0,-2 0,0 1,-1-1,0 1,-2 0,0 0,-1 0,-1 1,-1 0,-1 1,0 0,-1 0,-1 1,0 0,-2 1,-20-19,9 14,-2 0,1 2,-2 1,-1 1,0 1,0 2,-33-10,-6 2,-1 4,-91-12,19 13,-2 6,1 6,-247 24,255-3,1 6,2 6,0 6,-133 54,66-2,166-70,0 1,2 1,-50 43,73-56,-1 1,1 0,1 1,-1 0,2 0,-1 0,1 0,0 1,0 0,1 0,-5 17,7-18,1 0,0 0,0 1,1-1,0 0,0 1,1-1,0 0,1 1,0-1,0 0,0 0,1 0,5 9,6 10,1-1,2-1,0 0,2-1,1-1,0-1,25 21,7 0,1-2,62 36,-65-46,2-3,97 39,-128-59,0-1,1-1,0 0,0-2,1-1,-1-1,1 0,-1-2,1-1,31-4,-44 2,1 1,-1-1,0-1,0 0,-1 0,1-1,-1 0,0-1,0 0,-1 0,0-1,0 0,7-9,-6 6,-1-1,-1 0,0 0,0-1,-1 0,-1 0,0-1,0 1,4-21,-6 14,0 1,-1-1,-1 1,0-1,-2 0,0 1,-1-1,-1 1,-1-1,0 1,-1 0,-2 1,1-1,-19-32,12 31,-1 1,-1 0,0 1,-1 1,-1 0,-1 1,0 1,0 1,-40-21,11 10,-1 3,-1 2,-65-16,20 12,-1 4,0 5,-1 3,-1 5,-97 6,151 2,1 1,-1 2,1 1,-81 25,115-28,0 0,1 1,-1-1,1 1,-1 1,1 0,-6 5,11-8,0 0,0 0,0 0,0 0,0 1,1-1,-1 0,1 1,0-1,0 1,0 0,0-1,0 1,0 0,1-1,-1 1,1 0,0 0,0 0,0 0,0-1,0 1,2 4,1 4,0 0,1-1,1 1,0-1,0 0,1 0,12 16,0-4,1-1,23 20,-9-13,2 0,1-2,1-2,1-1,0-2,2-2,1-1,0-3,1-1,0-2,57 9,-83-19,-1 0,0-2,0 1,1-2,-1 0,0-1,22-5,-31 5,1 0,-1 0,0 0,0-1,-1 0,1 0,-1-1,1 1,-1-1,0-1,-1 1,1 0,-1-1,1 0,-2 0,1-1,0 1,-1-1,0 1,3-9,-3 5,-1 0,0-1,0 1,-1-1,0 0,-1 1,0-1,0 0,-1 1,0-1,-1 1,0-1,0 1,-1 0,0-1,-1 2,0-1,-1 0,-5-8,-2 0,0 0,-1 0,0 2,-2-1,0 2,-1 0,-32-22,18 17,0 2,-2 1,0 2,-1 1,-57-15,43 17,-1 3,0 1,-77-1,94 9,-60 7,81-7,0 1,1 0,-1 1,0 0,1 1,0 0,0 0,0 1,0 0,-8 7,15-10,0 0,0 0,0 0,0 1,0-1,0 1,1-1,-1 1,1 0,0-1,-1 1,1 0,1 0,-1 0,0 0,0 4,1-2,0 0,1 0,-1 0,1 0,0 0,0 0,1 0,-1-1,4 7,1 0,0 1,2-1,-1 0,1 0,1-1,14 14,-11-13,-4-2,1 0,1-1,-1-1,1 1,20 9,-28-16,1 0,0 0,-1 0,1 0,0-1,0 1,-1-1,1 0,0 1,0-1,0-1,0 1,-1 0,1-1,0 0,0 1,-1-1,1 0,-1 0,1-1,0 1,-1 0,0-1,1 0,-1 1,0-1,0 0,0 0,0 0,3-5,1-1,0-1,-1 0,0 0,0 0,-1-1,0 0,-1 1,0-1,0-1,-1 1,0 0,-1-1,-1 1,1 0,-2-1,1 1,-1-1,-1 1,0 0,-5-17,3 13,-1 1,-1 0,0 0,0 0,-1 1,-1 0,0 0,-1 1,0 0,0 0,-1 1,-1 0,0 1,-22-15,11 13,-1 0,0 1,0 2,-1 0,0 1,-1 2,1 0,-39-1,35 5,-1 0,0 3,0 0,1 2,0 0,0 3,-33 10,55-15,-1 1,0 0,1 0,0 1,-1-1,2 1,-12 10,15-13,1 1,-1 0,1 0,-1 0,1-1,0 1,0 1,0-1,0 0,0 0,0 0,1 0,-1 1,1-1,-1 0,1 1,0-1,0 0,0 1,0-1,1 0,-1 1,0-1,1 0,0 0,0 1,-1-1,1 0,2 2,1 3,0-1,1 1,0-1,0 0,1 0,0-1,0 0,0 0,0 0,1-1,0 0,0 0,9 3,8 3,1 0,46 9,-35-11,1-2,1-2,-1-1,1-1,52-6,-64 1,0-1,0-1,0-1,0-2,-1 0,0-2,-1-1,35-20,-44 21,-1-1,1 0,-2-1,0 0,0-1,-1-1,15-22,-21 28,-2 1,1 0,-1-1,0 0,-1 0,0 0,0-1,-1 1,0-1,0 1,-1-1,0 0,-1 1,0-1,0 0,-1 0,-2-12,-1 10,0 0,-1 0,0 0,-1 1,0-1,-1 1,0 1,0-1,-1 1,0 1,-18-15,4 6,0 1,-2 1,-49-24,33 22,0 2,-1 1,-1 2,-76-12,86 20,1 2,0 1,0 1,-1 1,1 2,0 1,-41 11,67-13,0-1,1 1,-1 0,1 0,-1 0,1 0,-1 1,1 0,0 0,0 0,1 0,-1 1,1 0,-1-1,1 1,0 0,1 1,-3 3,3-3,0 0,0 0,1 0,0 1,0-1,1 0,-1 0,1 0,0 1,1-1,-1 0,1 0,0 0,0 1,1-1,0 0,2 5,0-1,1 0,0-1,1 1,0-1,1 0,-1-1,1 0,1 0,-1 0,1-1,1 0,10 6,4 1,0-1,1-1,40 12,-42-16,0-1,1-1,-1-1,1-1,0-1,34-1,-47-2,0 0,-1 0,1-1,-1 0,1 0,-1-1,0-1,0 0,0 0,-1 0,1-1,-1 0,0-1,0 0,-1 0,0-1,12-14,-15 15,0 1,0-1,-1-1,0 1,0 0,0-1,-1 0,0 1,0-1,-1 0,2-14,-3 11,-1-1,1 1,-2 0,1 0,-1 0,-1 0,-6-16,3 10,-2 1,0 1,0-1,-2 1,1 1,-2 0,0 0,0 1,-27-21,25 23,-1 2,-1-1,0 2,0 0,0 1,-1 0,0 1,0 1,0 1,0 0,-1 1,1 1,-32 1,39 1,0 0,1 1,-1 0,1 0,0 1,0 0,0 1,0-1,0 1,0 1,1 0,0 0,0 0,1 1,-12 11,11-7,-1 0,1 0,1 0,0 1,0-1,1 1,0 1,1-1,0 1,-3 20,4-16,1 0,0 0,1 1,1-1,1 0,0 0,8 32,-8-42,1 0,0 0,0-1,1 1,0-1,0 1,0-1,0 0,1 0,0 0,0-1,1 0,-1 1,1-1,0-1,0 1,0-1,0 0,0 0,1 0,0-1,-1 0,1 0,9 2,-8-3,1 0,0 0,-1 0,1-1,0 0,0 0,-1-1,1 0,0-1,-1 0,1 0,-1 0,9-5,-6 2,-1 0,0-1,0 0,0-1,-1 0,1-1,-2 1,11-14,-3-1,-1 1,-1-2,0 0,-2 0,-1-1,-1-1,7-28,-8 19,-1 1,-2-1,-1-1,-2 1,-4-67,0 80,-1 1,-1 0,0 0,-2 0,0 0,-1 1,-1 0,-1 1,0-1,-2 2,-15-22,21 33,-1 0,0 0,0 0,0 1,-1 0,0 0,0 1,0-1,-1 2,1-1,-1 1,0 0,0 0,0 1,0 0,0 1,0 0,-1 0,1 1,0 0,-1 0,1 1,-9 2,5-1,1 1,0 0,0 1,0 0,0 1,1 0,0 0,0 1,0 1,1 0,0 0,0 1,0 0,1 0,1 1,-8 10,4-1,1 0,1 1,0 0,2 1,0 0,-8 37,10-25,0 1,2-1,3 57,0-78,1-1,1 1,0-1,0 0,1 0,0 0,1 0,0-1,1 1,0-1,0 0,1 0,0-1,0 1,1-1,13 11,-13-13,1 0,-1-1,1 0,1-1,-1 0,1 0,-1 0,1-1,0-1,0 1,1-2,-1 1,0-1,1 0,-1-1,0 0,1-1,17-3,-9-1,-1 0,1-1,-1-1,-1 0,1-2,-1 0,-1 0,0-1,0-1,-1-1,0 0,-1-1,22-28,-9 6,-1-1,-2-1,-2 0,29-71,-30 57,-2-1,-3-1,-1 0,7-73,-17 94,-2 0,-2 1,0-1,-2 0,-2 0,-1 1,-1 0,-19-56,19 72,-1-1,0 1,-1 1,-1-1,0 1,-1 1,0 0,-1 0,-1 1,0 1,-22-17,23 20,-1 1,0 0,-1 1,0 0,1 1,-2 1,1 0,-1 1,1 0,-1 1,0 0,0 2,0-1,-16 3,9 0,0 1,0 1,1 2,-1-1,1 2,1 1,-1 0,1 2,-32 21,39-23,1 0,0 1,1 0,0 1,1 0,0 1,0 0,1 0,0 1,1 0,1 0,0 1,0-1,2 1,-7 27,9-33,1 1,0-1,1 0,0 1,0-1,1 1,0-1,0 0,0 1,1-1,0 0,1 0,6 13,-4-12,0 0,1 0,0-1,0 0,1 0,0 0,0-1,0 0,15 9,-2-4,1-1,0-1,1 0,-1-2,2 0,-1-2,1-1,27 3,-16-5,0-2,0-1,0-2,-1-1,1-1,-1-2,0-2,-1-1,48-21,-46 15,0-1,-2-2,0-1,-1-1,-1-2,-1-1,-1-1,34-42,-42 43,-2-1,-1-1,-1 0,-1-2,-1 1,-2-2,11-35,-18 48,-1 0,0 0,-2 0,1 0,-2 0,0-1,-1 1,-1-1,0 1,-2 0,1 0,-2 0,0 0,-1 0,-8-17,9 26,0 0,0 0,-1 0,1 1,-1 0,-1 0,1 0,-1 1,0-1,-1 1,1 1,-1-1,-11-4,8 4,0 1,-1 1,0 0,1 0,-1 1,0 1,0 0,-22 1,9 2,1 1,-1 1,0 1,1 1,0 1,0 1,1 1,-28 17,20-9,2 1,0 2,1 1,1 1,-45 51,54-54,2 1,0 1,1 1,1 0,1 0,1 1,1 1,-11 39,18-49,1 0,0 0,1 1,1-1,0 1,1-1,0 0,1 1,1-1,0 0,1 0,0-1,7 15,-6-17,1 0,0-1,0 0,1 0,0 0,1-1,0 0,0 0,1-1,0 0,0-1,1 0,0 0,1-1,21 10,-16-10,1-1,0-1,0 0,0-1,0-1,0-1,1 0,-1-1,0-1,25-4,-20 0,0 0,0-2,-1-1,1 0,-2-1,0-2,27-17,-20 9,-1-1,-1-1,-1-1,-1-1,-1-2,-1 0,-1-1,-2-1,0-1,-2 0,15-36,-20 36,-1 0,-1 0,-1-1,-2 0,-1 0,-1-1,0-38,-5 55,0 0,0 0,-2 0,1 0,-1 1,-1-1,-1 1,-6-16,6 20,0 0,-1-1,1 2,-1-1,-1 1,0 0,0 0,0 1,0 0,-1 0,0 1,-12-6,4 3,0 2,0 0,0 1,-1 0,1 1,-1 1,0 1,-1 1,1 0,0 1,0 1,0 0,0 1,0 1,0 1,0 0,-17 8,10-2,0 0,1 2,0 1,1 0,1 2,0 0,1 2,1 0,0 1,-28 35,32-32,0 1,1 0,1 1,2 0,0 1,1 0,2 1,0 0,2 0,1 1,0 0,0 40,5-51,0 0,1 0,1 0,0 0,1 0,1-1,0 1,1-1,1 0,0-1,1 1,0-1,1 0,0-1,1 0,1 0,0-1,0 0,1-1,0 0,1-1,0 0,19 10,-7-7,1 0,0-2,1-1,0-1,0-1,50 7,-23-9,1-2,84-7,-68-3,-1-2,-1-4,0-3,-1-2,108-46,-116 37,-1-2,-1-3,-2-2,-2-2,-1-3,59-57,-86 71,-1-1,-1-1,-1-1,-2 0,-1-2,-1 0,22-54,-32 65,-2 0,0-1,-1 1,-1-1,-1 0,0-1,-2 1,0 0,-1 0,-2-1,0 1,-1 0,0 0,-11-29,10 37,-1 0,0 1,-1 0,-1 0,0 0,0 1,0 0,-2 0,1 1,-17-14,13 13,-1 1,-1 1,0 0,0 0,0 2,-1-1,-26-6,16 7,-1 2,0 0,0 2,1 0,-1 2,0 1,0 1,0 1,0 1,-27 9,30-6,0 1,0 1,1 1,0 1,1 1,0 1,1 1,0 0,1 2,-22 22,30-25,0-1,1 2,0-1,1 1,1 1,0-1,1 2,1-1,0 1,1-1,1 2,0-1,1 0,1 1,-1 31,4-36,0 0,0 0,1 0,1 0,0 0,0 0,1-1,1 0,0 0,11 19,-7-17,1-1,0 0,1 0,0-1,0 0,1-1,21 14,-7-9,0-1,1-1,1-1,0-2,0 0,1-2,0-1,39 4,-30-8,0 0,0-3,0-1,72-11,-87 8,0-2,0 0,0-2,-1 0,-1-1,1-2,-1 0,-1-1,22-17,-32 21,-1 0,-1 0,0-1,0-1,0 1,-1-1,-1 0,0-1,0 0,-1 1,0-2,5-18,-7 20,-1 0,-1 0,0 1,0-1,-1 0,0 0,-1 0,0 0,0 0,-1 1,0-1,-1 1,0-1,-1 1,-9-17,2 9,0 1,-1 0,-1 1,-1 0,0 2,0-1,-2 2,1 0,-2 0,-27-14,16 12,-1 1,0 2,-1 0,0 2,-61-10,53 14,0 2,0 1,-1 2,1 1,0 3,0 1,0 1,-58 19,76-18,0 1,0 1,1 1,0 1,1 0,0 1,-19 17,25-17,0 1,0-1,1 2,1 0,0 0,1 1,0 0,1 0,-10 30,13-28,0-1,1 1,1 0,1 0,0 0,2 1,0-1,0 0,2 0,0 0,1 0,1 0,0 0,1-1,1 1,1-2,0 1,1-1,1 0,0 0,1-1,0 0,1-1,1 0,0-1,1-1,0 1,23 14,-12-12,0 0,1-2,0 0,1-2,47 12,-16-9,104 8,-90-17,0-4,-1-2,1-4,-1-2,0-4,85-25,-77 12,0-3,-1-3,-2-3,-2-4,74-50,-101 56,0-1,-3-3,-1-2,51-58,-73 73,-2-1,-1 0,-1-1,-1 0,-1-2,-2 0,0 0,-2-1,-1 0,6-30,-13 44,0 0,-1-1,0 1,-1-1,-1 1,0-1,-1 1,0 0,-1 0,-1 0,-9-24,7 26,-1 0,1 1,-2 0,1 0,-2 0,1 1,-1 1,-1-1,0 2,0-1,-1 1,-20-12,6 8,-1 0,0 2,-1 1,0 1,0 1,-1 1,1 2,-1 1,0 1,-1 1,1 1,0 2,-34 6,46-5,1 1,0 0,0 1,0 1,1 0,-1 1,2 0,-1 1,1 1,0 0,1 1,0 0,0 1,2 0,-1 1,1 0,1 1,0 0,-8 16,5-6,2 0,0 0,2 1,1 0,0 0,2 1,1 0,1 0,0 48,4-54,0-1,2 0,0 0,1 0,1 0,0-1,2 0,0 0,0 0,2-1,0 0,1-1,1 0,18 21,-10-17,2-1,0-1,0-1,2-1,0-1,0-1,2-1,-1-1,29 8,0-2,2-3,0-2,74 6,-81-14,1-1,0-3,-1-2,1-2,-1-2,0-2,48-15,-70 15,-1-1,0-1,-1-1,0-1,0-1,-2-1,1-2,-2 0,0-1,-1-1,-1-1,-1 0,-1-2,18-26,-21 24,-1 0,-2-1,0-1,-2 0,0 0,-2-1,-1 0,-1-1,-1 1,-1-1,-1 1,-2-1,-1 0,-1 0,-1 1,-8-35,5 38,0-1,-2 1,0 1,-2 0,0 0,-1 1,-2 0,0 1,-1 0,-1 1,-1 1,0 0,-1 1,-1 1,-1 1,0 1,-1 0,-26-13,32 20,0 2,-1-1,1 2,-1 0,0 1,0 0,-1 1,1 1,0 0,0 1,-1 1,1 0,-16 4,13-1,0 1,1 1,-1 0,1 1,1 1,-1 0,1 2,1-1,0 2,-23 20,16-9,0 1,2 0,0 2,2 0,1 2,-26 51,32-54,2 0,0 0,2 1,0 0,2 0,1 1,1 0,1 47,3-58,0-1,1 1,1-1,0 0,1 0,1 0,0 0,1-1,10 19,-5-16,0-1,0 0,2 0,-1-1,2-1,23 19,-4-9,2-1,0-2,1-1,1-2,1-2,48 14,17-1,0-5,1-4,177 8,-164-24,-1-6,0-4,133-26,-38-16,-177 38,-1-1,0-2,58-33,-83 42,0 0,0-1,0 0,0 0,-1-1,0 0,-1 0,1-1,-1 0,8-15,-11 18,-1-1,0 1,0-1,-1 0,0 0,0 0,0 1,0-1,-1 0,0 0,0 0,-1 0,0 0,0 0,0 0,-1 1,0-1,-3-8,1 8,1-1,-1 1,0 0,-1 0,0 1,1 0,-2-1,1 1,-1 1,1-1,-1 1,0 0,-1 1,1-1,-1 1,1 1,-1-1,-14-3,-6 0,0 2,-1 0,-43 0,49 4,-1 0,1 1,-1 2,1 0,0 1,0 2,0 0,-23 10,36-12,0 0,0 1,1 0,0 0,0 1,0 0,1 0,0 1,0 0,1 0,0 0,0 1,0 0,1 0,0 1,1-1,0 1,0 0,1 0,0 1,-1 11,2-10,1 1,1-1,0 1,1-1,0 1,1-1,0 0,1 0,0 1,1-2,0 1,0 0,1-1,1 0,6 10,2-1,0-1,0 0,2-1,0 0,1-1,29 20,-3-7,1-2,0-3,2-1,1-2,60 17,-63-25,0-1,0-3,1-2,0-2,0-2,54-2,-83-2,0-1,0 0,0-1,0-1,18-6,-29 8,0 0,0 0,0-1,0 0,-1 0,1 0,-1 0,0-1,0 1,0-1,-1 0,1 0,-1-1,0 1,0-1,0 1,-1-1,4-9,-3 4,-1 0,0 1,0-1,-1 0,0 0,-1 0,0 0,0 0,-1 0,-3-10,1 6,-1 1,-1-1,0 1,-1 0,0 0,-11-15,-5-2,-1 1,-1 1,-1 2,-45-37,-46-27,97 78,0 0,0 2,-1 0,-36-12,51 21,-1-1,0 1,0 1,0-1,0 1,0 0,0 1,1-1,-1 1,0 0,0 1,0-1,1 1,-1 0,1 0,-1 1,1 0,0 0,0 0,0 1,1-1,-1 1,-7 9,1-1,1 0,1 1,0 0,0 0,1 1,1 0,-10 28,8-13,2 0,0 1,2-1,2 1,0 0,2 1,1-1,2 0,0 0,3 0,0-1,2 1,1-1,18 45,-15-50,0 0,2 0,0-1,2-1,0 0,2-1,0-1,1 0,1-2,1 0,1-1,0-1,1-1,0-1,2-1,41 18,-34-20,1-1,0-2,0-1,1-1,0-2,0-2,0 0,49-6,-63 3,0-2,0-1,-1 0,1-1,-1-1,0 0,-1-2,0 0,0-1,0-1,-1 0,-1-1,0-1,0 0,24-28,-25 21,-1 0,0-1,-2-1,0 0,-1 0,-1-1,-2 0,0-1,-1 0,-1 0,-1 0,-1 0,-2-1,0 1,-1-1,-1 1,-2-1,0 1,-1 0,-2 0,-10-31,11 44,0 0,0 1,-1-1,0 1,0 1,-1-1,0 1,-1 0,0 0,0 1,-1 0,0 1,0 0,0 0,-1 1,-18-8,19 10,0 0,-1 1,1 0,-1 0,0 1,0 0,1 0,-1 1,0 1,0 0,1 0,-1 1,0 0,1 0,0 1,-1 1,1-1,1 2,-11 5,1 3,0 0,1 1,1 1,0 1,1 0,1 1,0 0,1 2,1-1,1 1,-10 25,3-3,3 0,1 1,2 1,-9 69,17-90,2 0,1 0,1 0,0 0,2 0,7 35,-4-39,0-1,1 1,1-1,1-1,0 1,1-1,1-1,14 19,-11-18,1-2,1 1,0-2,1 0,0 0,1-2,0 0,1-1,0-1,1 0,0-2,22 6,-36-11,1 0,0-1,-1 0,1 0,0-1,0 1,7-2,-13 1,1 0,-1 0,0 0,0 1,0-1,0 0,0 0,0 0,0 0,1 0,-1 0,0 0,0 0,0 0,0 0,0 0,0 0,1 0,-1 0,0 0,0 0,0 0,0 0,0 0,0 0,0 0,1 0,-1-1,0 1,0 0,0 0,0 0,0 0,0 0,0 0,0 0,0 0,1 0,-1 0,0-1,0 1,0 0,0 0,0 0,0 0,0 0,0 0,0-1,0 1,0 0,0 0,0 0,0 0,0 0,0 0,0-1,0 1,0 0,0 0,0 0,-11-5,-19-1,10 6,1 1,0 0,0 1,0 1,0 1,0 1,1 0,0 2,-31 14,14-2,0 1,2 2,-53 43,53-36,2 2,1 2,1 0,2 2,1 1,2 1,2 1,1 2,2-1,-27 84,35-87,2-1,1 1,2 1,2-1,1 1,2 0,1 0,2 0,2 0,1-1,1 0,3 0,19 54,-8-45,1 0,3-2,1 0,3-2,1-1,2-1,1-2,2-1,2-2,40 31,-67-58,0 0,0-1,1 0,0-1,0 0,20 6,-27-10,1 0,-1 0,1 0,-1-1,1 0,-1 0,0 0,1 0,-1 0,1-1,-1 1,1-1,-1 0,0 0,1 0,-1-1,0 1,0-1,0 0,0 1,0-1,0-1,-1 1,1 0,3-5,-1 0,0-1,0 0,-1 0,0 0,0 0,-1-1,0 1,-1-1,0 0,1-9,-1 2,-1 1,0-1,-1 1,0-1,-4-16,4 26,-1 0,-1 0,1 0,-1 1,0-1,0 0,-1 1,1-1,-1 1,-1 0,1 0,-1 0,0 1,0-1,0 1,0 0,-1 0,1 0,-1 1,0 0,-1-1,1 2,0-1,-1 1,0 0,1 0,-1 0,0 1,0 0,0 0,0 0,0 1,-12 1,4 1,0 1,1 0,-1 1,1 1,0 0,0 1,0 0,1 1,0 1,0 0,1 0,-16 16,4-3,1 2,2 1,0 0,-26 44,29-38,1 1,1 1,1 0,2 1,2 0,0 1,3 0,1 0,1 0,2 1,1 0,3 36,2-55,-1 0,2-1,0 1,1-1,1 1,0-2,1 1,0-1,1 0,1 0,13 15,-13-17,1-1,1 0,0-1,0 0,1 0,1-2,-1 1,1-1,1-1,-1-1,1 0,15 5,-26-10,0 0,-1-1,1 1,0 0,0-1,0 0,0 1,0-1,0 0,0-1,0 1,0 0,0-1,0 0,-1 0,4-1,-6 2,1 0,-1 0,0-1,1 1,-1 0,0 0,0-1,1 1,-1 0,0-1,0 1,0 0,1-1,-1 1,0-1,0 1,0 0,0-1,0 1,0 0,0-1,0 1,0-1,0 1,0 0,0-1,0 1,0-1,0 1,0 0,-1-1,1 1,0 0,0-1,0 1,0 0,-1-1,1 1,0 0,-1-1,1 1,-1 0,-15-13,2 7,0 0,0 0,-1 1,1 1,-1 0,-28-2,19 4,0 1,0 0,-43 7,33 1,0 1,1 2,0 1,0 2,2 1,-1 2,2 1,0 1,1 1,1 2,-33 31,46-37,1 0,-22 29,32-39,1 0,0-1,0 1,1 0,-1 1,1-1,0 0,1 1,-1-1,1 1,0-1,0 1,1 0,0-1,0 7,1-9,-1-1,1 0,-1 0,1 0,0 0,0 0,0 0,0 0,0 0,0 0,0 0,1-1,-1 1,1 0,-1-1,1 1,2 1,0-1,-1 0,1 0,-1-1,1 1,0-1,0 0,0 0,8 1,-1-1,1-1,-1 0,1-1,-1 0,0-1,12-3,-3-1,-1-1,0-1,-1-1,1 0,-2-2,1 0,-2-1,1 0,26-29,-17 15,-2-2,-1-1,-1-1,29-53,-41 65,0-1,-1-1,-1 0,-1 0,-1 0,6-36,-11 50,0 0,-1 0,0 0,0-1,0 1,-1 0,0 0,0 0,0 0,-1 0,0 0,0 1,-1-1,1 1,-1-1,-1 1,1 0,-1 0,1 0,-2 0,1 1,0 0,-1 0,0 0,1 0,-2 1,-6-5,-7 0,0 0,0 2,0 0,-1 1,0 1,0 0,0 2,-25 0,-167 11,196-8,-162 18,-215 49,380-65,0 0,1-1,-1 2,1 0,-1 0,1 1,-19 11,30-15,0-1,0 0,0 1,0 0,1-1,-1 1,0-1,0 1,1 0,-1-1,0 1,1 0,-1 0,1 0,-1 0,1-1,-1 1,1 0,0 0,-1 0,1 0,0 0,0 0,-1 0,1 0,0 0,0 0,0 0,0 0,1 0,-1 0,0 0,0 0,1 0,-1 0,0 0,1 0,-1 0,1-1,-1 1,1 0,-1 0,2 1,2 1,-1 0,1 0,0 0,0 0,0-1,1 0,-1 0,6 2,9 2,1 0,0-2,1 0,-1-2,1 0,-1-1,1-1,0-1,23-4,-14 0,0-1,-1-1,0-2,0-1,46-22,-63 25,-1 0,1 0,-1-1,-1 0,1-1,-2 0,16-18,-20 20,0 0,0 0,-1 0,0-1,0 0,-1 0,0 0,0 0,-1 0,0-1,0 1,0-18,-2 23,0 0,0-1,0 1,-1 0,1 0,-1-1,0 1,0 0,0 0,0 0,-3-4,0 2,1 0,-1 0,-1 1,1-1,-10-7,-4-1,-1 1,0 0,-31-14,-74-23,27 16,-2 4,-122-19,145 37,1 3,-1 3,-131 10,157 1,1 1,1 3,0 3,0 1,1 2,1 2,1 3,1 1,0 2,2 2,-48 39,78-56,1 0,0 1,0 1,1 0,1 0,-12 17,20-25,-1-1,1 0,0 1,-1-1,1 1,0-1,1 1,-1 0,0-1,1 1,-1 0,1 0,0-1,0 1,0 0,0 0,1-1,-1 1,1 0,-1 0,1-1,0 1,0-1,0 1,1-1,-1 1,1-1,-1 0,1 1,0-1,-1 0,1 0,0 0,1-1,-1 1,0 0,0-1,1 1,-1-1,4 1,7 4,1 0,0-1,0 0,1-2,-1 1,1-2,0 0,0-1,0 0,0-1,0-1,0 0,23-6,-34 6,-1 0,1 0,0 0,-1-1,0 1,1-1,-1 0,0 0,0 0,0 0,0-1,0 1,0-1,-1 0,1 0,2-4,-4 4,0 0,0 0,0 0,-1 1,1-1,-1 0,1 0,-1 0,0 0,0 0,-1 0,1 0,0 0,-1 0,0 0,0 1,0-1,0 0,0 0,0 1,-1-1,-2-3,-2-4,-1 1,-1-1,1 1,-2 1,1-1,-11-7,-65-42,27 26,-2 1,-83-29,-133-30,-110-2,-8 23,359 64,28 4,-38-6,0-1,-62-22,103 29,0 0,-1-1,1 1,1-1,-1 1,0-1,0 0,1 0,-1-1,1 1,-1 0,1-1,0 0,0 1,0-1,0 0,1 0,-1 0,1 0,0 0,0 0,0-1,0 1,0 0,1 0,-1-1,1 1,0-1,0 1,1-6,1-2,0 1,1-1,0 1,0 0,1 0,0 0,1 1,0 0,10-13,163-188,-146 175,605-705,-589 679,70-117,-112 167,0 0,-1-1,0 1,-1-1,0 0,-1 0,3-19,-6 27,1 0,-1 1,-1-1,1 0,0 1,-1-1,0 1,0-1,0 1,0-1,-1 1,1 0,-1-1,0 1,0 0,0 0,0 0,0 0,-1 1,1-1,-1 1,0-1,0 1,0 0,0 0,0 0,0 1,-6-3,-8-2,0 1,0 1,-1 0,0 1,0 1,-21 0,-22 1,0 3,1 2,-1 3,1 2,-63 20,0 7,-161 71,165-55,-131 79,198-99,1 2,2 2,2 2,-73 76,107-100,1 1,1 0,0 0,1 1,1 0,-9 21,15-31,1 1,0 0,0-1,0 1,1 0,0 0,0 0,1 0,0 0,0 0,1 0,0 0,0 0,1-1,0 1,0 0,0-1,1 1,4 7,-2-6,0 0,1-1,-1 0,1 0,1-1,0 0,-1 0,11 6,0-1,1-1,30 13,-14-9,2-2,0-1,0-2,0-1,1-2,54 2,-44-8,1-2,-1-1,0-3,79-20,-47 4,0-4,-2-4,89-47,-109 47,-2-3,-1-3,-2-1,81-78,-116 99,-1-2,-1 0,0 0,-2-1,0-1,-1 0,13-33,-21 43,0 0,-1 0,-1 0,1-1,-2 1,1-1,-1 1,-1-1,0 0,-1 1,0-1,0 0,-1 1,-1-1,1 1,-2 0,0 0,-5-11,2 9,0 1,0 0,-1 1,0 0,-1 0,0 1,-19-15,12 12,-2 1,1 0,-2 1,-25-9,-3 2,-2 3,0 1,-60-6,12 7,1 5,-1 4,0 4,1 5,0 3,0 5,1 4,-182 60,236-64,-66 34,97-43,0 1,0 1,0-1,1 1,0 1,1 0,-1 0,1 1,1 0,0 0,-7 12,11-16,1-1,0 1,0 0,0 0,1 1,-1-1,1 0,1 0,-1 1,1-1,0 0,0 1,0-1,1 0,0 1,0-1,0 0,1 0,-1 0,1 0,1 0,-1 0,1 0,-1-1,6 7,2 0,0 0,0 0,1-1,1 0,0-1,0-1,0 0,17 8,19 6,1-2,0-3,1-1,56 9,4-4,1-4,1-6,0-4,0-5,1-5,-1-5,-1-4,133-34,-199 35,0-2,-1-1,0-3,49-27,-80 36,0 0,-1-1,0 0,-1 0,0-1,0-1,-1 0,-1-1,0 0,10-17,-15 23,-1 0,0-1,0 1,-1-1,1 0,-2 0,1 0,-1 0,0 0,0 0,-1 0,0-1,0 1,-1 0,0 0,0 0,0 0,-1 0,0 0,-1 1,0-1,0 0,-5-8,-1 3,-1 0,0 0,0 1,-2 1,1-1,-1 2,0 0,-1 0,0 1,-1 1,1 0,-26-9,-2 3,-1 1,0 2,-60-7,35 10,0 4,-1 2,1 3,0 4,0 2,1 3,0 3,-74 26,103-27,1 1,0 2,1 2,1 1,1 1,-43 36,59-42,1 1,0 1,1 1,1 0,-15 26,21-30,0 2,1-1,1 1,0 0,1 0,1 1,0-1,-1 19,4-24,0 0,1 0,0 0,1 0,0 0,1 0,0 0,1 0,0-1,6 15,-3-12,1 1,0-1,1-1,1 1,0-2,18 19,-1-7,0-2,2 0,0-2,1-1,50 21,-1-6,2-4,0-3,2-4,156 20,-144-32,0-4,1-5,-1-3,107-18,-134 9,-1-2,-1-3,122-50,-148 49,-1-1,-1-1,-1-3,-1-1,-1-1,-1-2,39-42,-57 52,0 0,-2-1,0-1,-1 0,0-1,-2 0,-1 0,12-37,-17 42,0-1,-1 0,-1 0,-1 0,0 0,-1 0,-1 0,0 0,-1 0,-1 0,0 0,-10-26,3 18,-2-1,-1 2,-1 0,0 0,-2 1,-1 1,0 1,-2 0,0 1,-36-27,6 12,0 1,-2 3,-94-41,-28 6,140 56,-1 0,0 3,-41-4,68 9,0 1,0 0,0 0,0 0,0 1,-13 3,18-3,1-1,-1 1,0 0,1 0,-1 0,1 0,-1 0,1 0,-1 0,1 1,0-1,0 0,0 1,0-1,0 1,0-1,0 1,0 0,0-1,1 1,-1 0,1 0,-1-1,1 1,0 0,-1 0,1 0,0-1,0 1,1 3,0 3,0-1,1 1,0-1,1 1,-1-1,2 0,-1 0,1 0,-1 0,2-1,-1 1,9 8,6 8,1 0,1-2,1 0,1-2,43 29,-13-16,105 46,87 12,-99-49,3-7,0-7,2-6,202 2,-253-23,0-5,101-18,-131 10,-1-3,0-3,103-43,-136 46,-1-1,0-2,62-46,-80 51,0-1,0-1,-2 0,0-1,-1-1,0 0,-2 0,11-23,-18 31,0 0,0-1,-2 0,1 0,-1 0,-1-1,0 1,-1 0,0-1,-1-20,-1 23,0-1,-1 1,-1 0,1-1,-2 1,1 0,-1 1,0-1,-1 1,0-1,-1 1,1 1,-10-10,-1 1,-1 0,-1 1,0 1,-1 1,-1 0,0 1,0 2,-37-15,8 9,-1 1,-97-15,81 22,-121-1,65 14,1 6,-142 31,-234 88,346-80,-200 95,279-109,1 4,2 2,2 3,-94 83,132-100,1 0,1 2,-43 62,59-75,1 0,1 1,1-1,0 2,1-1,1 1,1 0,1 0,-4 32,8-39,0 0,0 0,1 0,1 0,0-1,0 1,2-1,-1 1,10 20,-5-17,1-1,0 0,0 0,2-1,0 0,16 15,2-3,0-2,2-1,1-2,0-1,56 24,-19-15,1-3,122 27,155-2,-238-43,0-4,114-13,-152 3,-1-3,0-4,-1-2,80-31,-124 37,0-1,0-1,-1 0,-1-2,0-1,33-29,-45 34,-1 0,0-1,-1 0,-1 0,1-1,-2 0,0-1,0 1,-1-2,0 1,-2 0,1-1,4-28,-7 23,-2 0,1 0,-2 0,-1 0,0 0,-1 0,-1 1,-1-1,-1 1,0 0,-1 0,-11-18,1 5,-1 1,-2 0,-1 2,-1 0,-47-44,28 35,-2 2,-2 2,-1 1,-61-30,35 27,-1 3,-110-33,51 31,0 5,-2 6,-160-6,177 23,-1 4,-205 24,267-13,0 2,-103 37,123-33,0 1,2 1,0 2,1 1,-34 28,51-35,0 1,1 0,1 1,0 1,1 0,1 1,-15 27,21-32,0 1,1-1,0 1,1 0,1 0,0 0,1 1,0-1,1 0,1 1,0 0,2 18,2-13,-1-1,2 1,1-1,0 0,1-1,1 1,1-1,0-1,22 31,-12-26,0 1,1-2,1-1,1 0,0-2,26 15,6-1,3-2,0-3,2-2,0-3,78 16,-53-18,0-4,1-3,0-4,0-4,151-12,-176 1,-2-3,1-3,88-30,-105 27,0-2,-1-2,-1-2,-1-1,45-36,-62 41,-1-2,0 0,-2-1,0-2,-2 0,0 0,-1-2,-2 0,0 0,-2-1,-1-1,-1 0,-1-1,-2 0,0 0,-2 0,-2-1,0 0,-2 0,-1 0,-1 0,-1 0,-2 1,-7-29,3 25,-2 1,0 0,-2 1,-2 0,0 1,-2 0,-33-43,25 42,-1 1,-2 1,0 1,-2 1,-1 2,-36-22,26 22,0 1,-1 3,-1 2,-1 1,-1 2,0 2,-1 2,0 2,0 2,-1 2,-79 1,110 5,0 0,0 0,0 2,0 0,0 0,-24 10,34-11,1 1,-1-1,0 1,1 0,0 0,-1 0,1 0,0 1,1 0,-1 0,1 0,0 0,0 1,0-1,0 1,1-1,0 1,0 0,0 0,0 0,1 0,-1 10,1-9,1 1,0 0,0 0,1 0,0-1,0 1,1 0,0-1,0 1,0-1,1 1,0-1,0 0,0 0,6 7,4 2,0 0,0 0,1-1,23 16,7 3,1-3,2-1,0-3,2-2,71 25,-46-24,2-3,0-4,90 10,-115-22,0-2,1-2,-1-3,91-12,-119 8,1 0,-1-2,-1 0,1-2,25-14,-33 15,-1 0,-1-2,0 0,0 0,-1-1,0 0,-1-1,15-21,-12 11,-2 0,-1-1,0 0,-2-1,0-1,-2 1,-1-1,0 0,-2 0,-1-1,-1 1,-2-1,0 0,-2 1,-8-49,7 63,0 0,-1 1,0 0,0 0,-1 0,-1 0,-7-10,11 17,0 0,0 0,0 0,-1 1,1-1,-1 1,0-1,0 1,0 0,0 0,0 0,0 1,0-1,-1 1,1-1,-1 1,1 0,-1 1,1-1,-1 0,0 1,1 0,-1 0,0 0,-4 1,0 2,0 0,1 1,-1 0,1 0,0 0,0 1,0 0,0 1,1 0,0 0,-6 8,-12 13,1 1,1 1,2 2,-22 42,-53 141,50-94,5 2,-36 185,60-212,4 0,4 1,9 189,3-239,1-1,2-1,3 1,1-1,23 57,-26-82,1-1,1 0,1-1,0 0,1 0,15 14,-17-20,1-1,0-1,0 0,1 0,0-1,1-1,0 0,0 0,18 5,-15-8,0 0,0-1,0 0,0-2,1 0,-1 0,0-2,1 0,-1-1,0 0,0-1,0-1,0-1,-1 0,16-8,5-5,-1 0,-1-3,-1-1,0-1,33-32,-5-2,-3-2,-2-3,-3-3,-3-1,-3-3,-3-2,36-79,-40 64,-4-2,-4-1,-3-2,-5-1,24-184,-43 224,-2-1,-3 0,-2 0,-3 0,-1 1,-25-93,22 113,-2 1,-1 1,-1 0,-2 0,0 2,-2 0,-2 0,0 2,-2 1,0 0,-2 1,-28-22,19 23,0 1,-1 1,-2 3,0 0,0 2,-2 2,0 2,0 1,-42-7,5 7,1 2,-1 4,-137 8,207-3,-143 16,133-13,-1 0,1 1,0 1,0 0,0 1,1 0,-25 16,31-16,0 1,1 0,-1 0,1 0,1 1,0 0,0 0,0 0,1 0,0 1,0 0,1 0,1 0,-3 10,0 11,0 0,2 1,1 32,2-49,1-1,0 1,1-1,0 0,1 1,1-1,0 0,1-1,0 1,1-1,0 0,1 0,0-1,1 0,1 0,9 9,-5-7,0-1,2 0,-1-1,2-1,-1-1,1 0,0-1,1 0,0-1,0-1,26 5,-13-5,-1-1,2-1,-1-2,0-1,47-5,-62 3,0-1,0-1,0-1,-1 0,1-1,-1 0,0-1,0-1,-1 0,0-1,0 0,21-19,-27 20,-1 1,1-1,-2-1,1 1,-1-1,0 0,-1-1,0 1,0-1,-1 1,0-1,2-12,-3 8,-1 1,0-1,0 0,-2 0,0 0,0 1,-1-1,-4-14,-2 0,-2 0,-1 1,-1 0,-1 0,-2 1,0 1,-25-29,36 47,-14-13,17 18,0 1,1-1,-1 1,0 0,1 0,-1-1,0 1,1 0,-1 0,0 0,0 0,1 0,-1 0,0 0,1 0,-1 0,0 0,1 0,-1 0,0 0,0 1,1-1,-1 0,0 1,1-1,-1 0,1 1,-1-1,1 1,-1-1,0 1,1-1,0 1,-1 0,-12 16,2 0,0 1,1 0,1 1,-12 36,-4 6,-29 49,-26 62,77-167,-7 26,9-30,1 0,0 0,-1 0,1 0,0 1,0-1,0 0,0 0,0 0,0 0,0 0,0 1,0-1,0 0,1 0,-1 0,0 0,1 0,0 2,0-3,0 0,0 1,-1-1,1 0,0 0,0 0,0 0,0 0,0 0,0 0,-1 0,1 0,0 0,0 0,0-1,0 1,0 0,-1 0,1-1,0 1,0-1,-1 1,2-2,15-7,-1-1,0-1,-1 0,0-1,13-15,67-77,-57 58,-2-1,-2-2,-2-2,-2-1,-3-1,-2-1,23-73,-42 108,-1 0,-1-1,-1 1,2-31,-5 42,0 0,0 0,-1 1,-1-1,1 0,-1 0,0 1,-1-1,0 1,0 0,-1 0,0 0,0 0,-5-6,-1 3,0 0,0 0,-1 2,0-1,-1 1,1 1,-1 0,-1 1,0 0,1 1,-2 0,-21-4,-14-1,0 2,-58-2,8 5,-1 4,1 5,-121 19,206-21,-3 1,-33 9,46-11,1 0,0 0,0 0,0 1,0-1,0 1,0 0,0 0,1 0,-1 0,0 0,1 1,0-1,0 1,0-1,-3 5,5-5,-1 0,0 0,1 1,-1-1,1 0,0 1,0-1,0 0,0 1,0-1,0 0,1 1,-1-1,1 0,0 0,-1 1,3 2,22 36,-2-11,2-1,1-2,34 29,95 67,-115-93,1-2,75 38,-95-58,-21-8,0 0,1 0,-1 0,0 0,0 0,0 0,1 0,-1 0,0 0,0 0,0 0,1 0,-1 0,0 0,0 0,0 0,1 0,-1 0,0 0,0 0,0 0,1 0,-1 0,0 0,0-1,0 1,1 0,-1 0,0 0,0 0,0 0,0-1,0 1,0 0,1 0,-1 0,0-1,0 1,0 0,0 0,0 0,0-1,0 1,0 0,0 0,0 0,0-1,0 1,0 0,0 0,0 0,0-1,0 1,0 0,0 0,0 0,0-1,-1 1,1 0,0 0,0-1,-8-12,-3 0,0 1,-1 0,-24-18,-47-28,62 44,-4-3,-1 2,0 0,-1 1,-1 2,-36-11,50 19,0 1,0 0,0 1,0 1,0 0,0 0,0 2,0 0,-1 1,1 0,0 1,1 0,-23 9,13-1,1 1,1 0,0 2,0 0,-30 29,9-2,-50 62,54-54,3 1,1 2,3 2,2 1,3 1,-29 90,30-51,23-86,0 0,1 0,1 1,-1-1,2 1,-1-1,1 0,3 10,-4-16,1 0,0-1,0 1,0 0,1-1,-1 1,1-1,-1 1,1-1,0 0,0 0,0 0,0 0,0 0,1 0,-1 0,0-1,1 1,0-1,-1 0,1 0,0 0,-1 0,1 0,0 0,0-1,4 1,-4-1,1 0,0 0,-1 0,1-1,0 1,0-1,-1 0,1 0,-1-1,1 1,-1 0,0-1,1 0,-1 0,0 0,0 0,0-1,0 1,-1-1,5-4,-3 0,0-1,0 0,0 1,-1-1,0 0,0-1,-1 1,0 0,0-1,-1 0,-1 1,1-1,-1 1,-2-16,0 9,0 1,-1-1,-1 1,0 0,-1 0,0 0,-15-25,13 27,-2 0,1 1,-1 0,-1 0,0 1,-1 0,0 1,0 0,-24-13,17 12,-1 2,-1 0,1 0,-1 2,0 1,-25-4,0 4,1 3,-1 1,0 2,0 2,-76 15,35 1,1 5,1 3,1 4,-151 80,205-96,1 2,1 1,1 2,0 0,1 2,1 0,2 2,-21 27,34-39,1 1,0 0,1 0,1 1,0 0,1 0,0 0,-3 21,6-23,1 1,1-1,0 0,0 1,1-1,1 1,0-1,0 0,1 0,1 0,6 14,-2-9,1-1,1 0,0-1,1 0,0-1,2 0,-1-1,2 0,-1-1,2 0,0-1,0-1,1 0,0-2,0 1,1-2,21 7,-32-13,0 1,0-1,0 0,0 0,0-1,0 0,-1 0,1 0,0-1,0 0,0 0,0 0,8-3,-10 1,1 1,-1 0,0-1,0 0,0 0,0 0,-1-1,1 1,-1-1,0 0,0 0,0 0,0 0,-1 0,0-1,3-6,0-4,0-1,-1 1,-1-1,0 0,-2 0,1 0,-2 0,0 0,-1-1,-1 1,0 1,-1-1,-1 0,0 1,-2-1,1 1,-2 0,-8-14,4 9,-1 0,-1 1,0 0,-2 1,0 1,-1 0,-1 2,0-1,-1 2,-1 0,0 2,-25-13,12 11,0 1,-2 2,1 2,-1 1,0 1,-46-2,6 5,-141 10,42 14,135-13,0 1,-55 19,88-25,0 1,-1-1,1 1,0 0,0 0,0 0,1 1,-1 0,1 0,0 0,0 0,-6 9,6-6,0 0,1 0,0 1,0-1,0 1,1 0,0 0,-1 11,2-6,1 0,0 0,0 0,1 0,1 0,1 0,-1 0,8 19,-1-9,1 0,1-1,22 35,-22-42,1 0,0 0,1-2,0 1,1-2,29 21,-7-10,72 33,-77-41,2-1,0-2,0-2,1-1,0-1,65 6,-86-14,1 0,0-1,0 0,0-1,-1 0,1-2,-1 1,22-10,-26 9,0-1,0-1,-1 1,0-1,0-1,0 1,-1-1,0-1,0 1,-1-1,0 0,0-1,4-9,-5 9,0-1,-1 0,-1 0,1 0,-2-1,1 1,-1-1,-1 1,0-1,-1 0,0 1,0-1,-1 0,0 1,-1-1,-1 1,1-1,-2 1,1 0,-1 0,-1 0,0 1,-8-12,0 2,-1 0,-1 2,0-1,-2 2,0 0,-1 1,0 1,-1 1,-37-20,22 17,0 2,-1 1,0 2,-1 1,-1 2,1 2,-1 1,0 2,0 1,0 2,0 2,0 1,0 2,0 1,1 2,-49 18,74-22,-1 0,2 1,-1 0,-19 13,28-16,-1 0,1 1,-1-1,1 0,0 1,0 0,0-1,0 1,0 0,1 0,-1 0,1 0,0 0,0 0,0 0,0 1,0-1,1 0,0 1,0-1,-1 0,2 5,0-1,0 0,1 0,0 0,0 0,1 0,-1-1,1 1,1-1,0 0,-1 0,2 0,-1 0,1-1,0 1,0-1,0 0,7 4,2 1,1 0,0-1,0-1,1-1,0 0,19 5,6 0,0-3,1-1,0-2,0-2,1-2,0-2,51-6,-25-2,-1-4,-1-2,116-41,-124 32,-1-2,-1-2,-1-3,-1-2,-3-3,91-77,-114 84,0-1,-3-1,0-2,39-64,-50 70,-1-2,-1 0,-2 0,-1-1,-1-1,-1 1,3-34,-9 47,-1-1,0 1,-1-1,-1 0,0 1,-1-1,-9-30,8 36,-1 1,-1 0,1 0,-2 0,1 0,-1 1,-1 0,1 0,-2 0,1 1,-1 1,-15-12,7 7,-1 2,0 0,-1 1,0 0,0 2,-1 0,0 1,0 1,0 1,-1 1,1 0,-1 2,-25 0,10 3,-1 2,1 1,0 1,1 3,0 0,-53 23,10 3,1 3,2 3,-113 84,105-61,2 4,-110 124,165-163,0 2,2 0,-26 49,39-63,2 1,0 1,1-1,1 1,0 1,2-1,0 1,-1 29,5-38,1 0,0 1,0-1,2 0,-1 1,1-1,1-1,0 1,1 0,-1-1,2 0,0 0,8 10,-5-8,1 0,0-1,1 0,0-1,0 0,1-1,1 0,-1-1,26 11,2-2,1-3,0-1,57 9,133 9,60-15,-259-16,-1-2,1-2,0-1,-1-1,0-1,0-2,31-14,-48 16,0 0,-1 0,0-2,-1 0,1 0,-2-1,1-1,-2 1,1-2,-1 0,-1 0,0-1,-1 0,0 0,-1-1,-1 0,0 0,-1 0,0-1,-1 0,-1 0,-1 0,0 0,0-1,-2 1,0-1,-1 1,-3-22,0 16,-1 1,-1 0,-1 0,0 0,-2 1,0 0,-1 1,-1 0,0 0,-2 1,0 1,0 0,-2 1,0 0,-29-20,16 15,-1 1,-1 2,0 2,-1 0,-1 2,0 1,-1 2,-63-12,43 15,0 3,0 1,-1 3,1 3,0 1,0 3,-77 20,51-4,0 3,2 3,1 4,-81 47,140-70,-1 1,2 1,-1 0,2 1,-1 0,2 1,-21 27,26-30,2 1,0 0,0 1,1-1,1 1,0 1,1-1,0 1,1-1,0 1,0 25,3-20,1 0,0 0,2 0,0 0,1-1,1 1,1-1,1 0,0 0,1-1,1 0,12 17,6 5,1-1,3-2,59 57,-32-40,2-3,3-3,100 58,-151-98,33 16,-43-21,0-1,1-1,-1 1,1 0,-1-1,1 1,-1-1,1 0,-1 1,1-1,0-1,-1 1,1 0,-1-1,4 0,-5 0,0 1,0-1,0 0,0 1,0-1,0 0,0 0,0 0,0 0,-1 0,1 0,0 0,0 0,-1 0,1-1,-1 1,1 0,-1 0,0 0,1-1,-1 1,0 0,0 0,0-1,0 1,0 0,0-1,0 1,0 0,-1 0,0-2,0-4,-1 0,0 1,-1-1,-5-9,-7-10,-1 0,-1 2,-1 0,-2 1,0 1,-1 0,-31-23,24 24,-1 1,0 1,-2 1,0 2,-64-24,84 36,-2 0,1 1,0 0,0 1,-1 0,1 1,-1 1,0 0,1 0,-1 2,1-1,-1 1,1 1,0 1,0-1,0 2,1 0,-1 0,1 1,0 0,1 1,-1 0,1 1,1 0,-15 16,7-4,1 1,1 1,1 0,0 1,2 0,1 1,-14 44,10-19,3 1,1 1,-3 53,11-70,2 0,4 60,0-73,0 1,2-1,0 0,2 0,13 31,-7-26,1-1,1 0,1-1,1-1,1-1,26 26,-16-22,1-2,1 0,1-2,41 22,-13-14,1-3,1-3,2-2,0-3,82 13,77-1,-172-28,0-2,75-8,-95 3,-1-1,1-1,-2-2,1-1,36-17,-44 16,-1-1,0-2,-1 0,0 0,-1-2,0 0,25-30,-23 20,0-1,-2-1,-1-1,-2 0,0-1,-2-1,15-52,-19 53,-3 0,0-1,-2 0,-1 0,-1 0,-2-1,-1 1,-6-39,4 51,-2 0,0-1,-1 2,0-1,-2 1,0 0,-1 0,-1 1,0 0,-1 1,-1 0,0 1,-1 0,-1 1,0 1,0 0,-1 0,-1 2,0 0,-1 1,1 0,-2 2,1 0,-1 1,0 0,0 2,-1 0,1 1,-1 1,-21 0,20 2,0 1,0 1,0 0,0 2,1 0,-1 2,1 0,1 1,-29 14,26-10,1 2,1 0,0 1,0 1,1 0,1 1,-27 35,31-34,1 1,0 0,2 1,0 0,1 0,1 1,1 0,-8 38,12-41,1 1,0 0,2-1,0 1,1 0,0 0,2-1,0 1,1-1,1 0,8 21,-3-16,1 0,2-1,0-1,0 0,2-1,1-1,0 0,1-1,1 0,1-2,38 25,-14-14,1-2,1-2,1-2,88 25,-42-21,1-4,110 8,196-14,-298-16,1-4,-1-5,-1-4,159-45,-205 42,0-3,-2-1,89-54,-104 52,-1-2,-1-1,-1-2,-1-1,43-53,-59 61,-1-1,-1-1,-1 0,-1-1,-1-1,-1 0,-1 0,-2-1,10-50,-13 36,-1-1,-1 1,-3 0,-1-1,-13-75,10 94,-2 0,0 0,-1 0,-1 1,-1 0,-1 1,-16-27,19 38,1 1,-1-1,-1 2,0-1,0 1,-1 0,0 1,0 0,0 0,-1 1,0 0,0 1,-1 0,0 1,0 0,-21-5,19 7,1 1,-1 0,0 0,1 1,-1 1,1 0,-1 1,1 0,-1 1,-21 8,18-4,1 0,0 1,1 1,0 0,0 1,1 1,-18 17,12-7,1 0,1 1,1 1,1 0,1 1,1 1,1 0,1 1,-13 47,22-62,0-1,0 1,1-1,0 1,1-1,1 1,-1-1,2 1,-1-1,7 20,-3-16,1 1,0-1,1 0,1-1,0 0,17 21,-2-9,0-1,2-2,0 0,1-2,1-1,33 18,-11-10,1-3,1-2,89 26,-101-38,-1-1,1-3,1-1,-1-1,77-5,-104 0,-1 0,1-1,-1-1,0 0,0 0,0-1,0 0,13-8,-19 9,0 0,0-1,-1 1,0-1,1 0,-1 0,0 0,-1 0,1-1,-1 0,0 0,0 0,-1 0,1 0,-1 0,0-1,-1 1,3-9,-3 7,-1 0,1 1,-1-1,0 0,0 0,-1 0,0 0,0 0,-1 0,0 1,0-1,-1 1,-3-9,0 7,1-1,-1 0,-1 1,1 0,-1 1,-1-1,1 1,-11-6,-3-1,0 1,-1 1,0 1,-1 1,-1 0,-37-8,6 6,0 3,-1 2,1 3,-1 2,-104 9,129-3,1 0,-1 2,1 1,-34 13,42-11,2 0,-1 2,2 0,-1 1,1 1,-22 20,8 0,1 0,2 2,2 1,1 1,2 2,1 0,2 2,2 0,2 2,2 0,1 0,-17 92,29-116,1 1,1 0,0 0,2 0,0 0,1-1,5 21,-4-28,1-1,0 0,0 1,1-2,1 1,-1 0,2-1,-1 0,2-1,-1 0,1 0,1 0,11 9,11 3,2-1,0-1,1-2,0-2,41 13,-37-15,1-1,0-2,1-2,0-1,1-2,62-1,198-21,-59-10,243-60,-116-11,453-184,-513 151,-64 9,-179 85,-1-3,97-79,-155 113,46-43,-50 46,0-1,0 1,0-1,-1 0,1 0,-1 0,0-1,0 1,0 0,-1-1,2-5,-3 9,0-1,0 1,0 0,0-1,0 1,-1-1,1 1,0 0,-1-1,1 1,0 0,-1 0,0-1,1 1,-1 0,0 0,0 0,0 0,1 0,-1 0,0 0,0 0,-1 0,1 0,0 0,0 0,0 1,0-1,-1 1,1-1,0 1,-1-1,1 1,0 0,-1 0,1-1,-3 1,-4-1,0 1,0-1,0 1,0 1,-10 1,-21 7,1 1,1 2,-43 20,24-10,-91 36,-155 86,301-144,-12 7,0 1,0 1,-16 13,27-20,-1 1,1-1,0 1,-1 0,1 0,1 0,-1 0,-3 6,5-7,-1-1,1 1,0 0,-1-1,1 1,0 0,0-1,0 1,0 0,1-1,-1 1,0 0,1-1,-1 1,1-1,-1 1,1-1,0 1,1 1,0 0,0 0,0 0,1-1,-1 0,1 1,0-1,0 0,-1 0,1 0,0-1,1 1,3 1,44 11,-47-14,48 10,1-3,82 0,112-19,-72-6,-1-8,188-53,-341 73,0 0,-1-1,1-1,-1-1,22-13,-41 21,1 0,-1 0,1 0,-1 0,1-1,-1 1,1 0,-1-1,0 1,0-1,0 1,0-1,0 0,0 1,0-3,0 3,-1 0,0 0,0 0,0 0,0 0,-1 0,1 1,0-1,0 0,0 0,-1 0,1 0,0 0,-1 1,1-1,-1 0,1 0,-1 1,0-1,1 0,-1 1,-1-2,-3-2,0 1,-1 0,0-1,0 2,0-1,0 1,-12-3,-25-4,-1 1,1 2,-2 3,-68 2,31 6,-131 25,182-23,1 0,1 2,-1 2,2 0,-38 22,52-26,1 1,0 1,1 0,0 1,0 0,1 1,0 0,1 1,0 0,1 0,1 1,-11 22,16-30,1 1,-1 1,2-1,-1 0,1 0,0 1,0-1,1 0,0 11,0-14,0-1,1 1,-1-1,1 0,0 0,-1 1,1-1,0 0,0 0,1 0,-1 0,0 0,1 0,-1 0,1 0,0-1,-1 1,1-1,0 1,0-1,0 1,0-1,0 0,0 0,0 0,1 0,-1-1,3 2,5-1,-1 1,1-1,0 0,11-1,-17 0,0 0,-1-1,1 1,0-1,0 0,0 0,-1 0,1 0,0-1,-1 1,1-1,4-4,-7 6,-1 0,0 0,0 0,1 0,-1-1,0 1,0 0,1 0,-1 0,0 0,0-1,0 1,0 0,1 0,-1 0,0-1,0 1,0 0,0 0,0-1,0 1,0 0,1 0,-1-1,0 1,0 0,0 0,0-1,0 1,0 0,0-1,0 1,-1 0,1 0,0-1,0 1,0 0,0 0,0-1,0 1,0 0,-1 0,1 0,0-1,0 1,0 0,-1 0,-14-4,7 5,1-1,0 1,1 1,-1-1,0 1,0 0,0 1,-7 4,-52 32,53-31,-15 10,2 2,0 0,1 2,1 0,1 2,-35 45,54-63,0 0,1 0,-1 0,1 0,0 1,-2 7,5-12,-1 0,1 0,0 0,-1 0,1 0,0 0,0 0,1 0,-1 0,0 1,0-1,1 0,0-1,-1 1,1 0,0 0,0 0,0 0,0 0,0-1,0 1,0 0,1-1,-1 1,2 0,2 2,0-1,0 0,-1 0,2-1,-1 0,0 0,0 0,1 0,-1-1,1 0,8 1,4-1,-1 0,26-3,-21-1,0 0,1-2,-1 0,38-16,-46 16,-1-1,0-1,-1 0,0 0,0-2,0 1,-1-1,17-19,-26 27,-1-1,0 1,0-1,1 1,-1-1,0 1,0-1,-1 1,1-1,0 0,0 0,-1 1,1-1,-1 0,0 0,1 0,-1 0,0 0,0 1,0-1,0 0,-1-2,0 2,0 0,0 0,0 0,0 1,-1-1,1 0,0 1,-1-1,0 1,1 0,-1-1,0 1,1 0,-1 0,0 0,-3-1,-5-1,0 0,1 0,-1 1,0 0,0 1,-1 0,-11 0,-3 4,0 1,0 1,0 1,0 2,1 0,0 1,1 2,0 0,-33 23,43-26,2 0,-1 1,1 1,-19 21,25-25,0 1,0 0,1 0,0 0,0 0,1 1,0-1,0 1,0 0,0 9,2-15,1 0,-1 1,1-1,0 0,0 0,0 1,0-1,1 0,-1 1,1-1,-1 0,1 0,0 0,0 1,0-1,0 0,0 0,0 0,1-1,1 3,0-1,-1-1,1 0,0 0,1 0,-1 0,0 0,0-1,1 1,-1-1,1 0,5 1,4 0,-1-1,1 0,0-1,-1-1,1 0,18-3,-12 0,-1-1,1-1,-1 0,0-2,-1 0,1-1,-1 0,-1-1,0-1,-1-1,0 0,-1-1,0-1,-1 0,0-1,-1 0,-1-1,-1 0,0-1,-1 0,9-22,-17 35,1 0,-1 0,0 0,0-1,0 1,-1 0,1 0,-1-1,0 1,-1 0,1 0,-1-1,1 1,-1 0,-3-8,2 9,0 0,0 0,0 0,0 0,-1 1,1-1,-1 1,0-1,0 1,0 0,0 0,0 0,0 1,0-1,-1 1,1-1,-1 1,1 0,-5 0,-2-1,-1 1,1 0,0 1,-1 0,1 0,0 1,-1 1,1 0,0 0,0 1,-15 6,7-1,0 0,1 1,1 1,-1 1,-18 15,17-9,0 0,0 0,2 2,-17 23,24-28,1 0,0 0,1 0,0 1,1 0,0 1,-3 21,8-33,0 1,0 0,1-1,0 1,0 0,0-1,1 1,-1 0,1-1,0 1,1 0,-1-1,1 1,0-1,0 0,0 0,0 0,4 4,-1-1,1-1,0 0,0-1,1 0,0 0,0 0,0-1,0 0,12 5,-10-5,0-1,0 0,0 0,0-1,1 0,-1-1,1 0,-1-1,1 1,-1-2,1 1,-1-2,1 1,-1-1,0 0,0-1,0 0,0-1,0 0,0 0,-1-1,0 0,0 0,9-9,-13 10,0-1,0 0,-1 0,0 0,0-1,0 1,0-1,-1 1,0-1,0 0,-1 0,1 0,-1 0,-1 0,1 0,-1 0,-1-11,1 11,-1 1,1 0,-1 0,-1 0,1 0,-1 0,0 1,0-1,0 0,0 1,-1-1,0 1,0 0,0 0,0 0,-1 0,0 1,0-1,0 1,0 0,-6-4,-3 2,0 0,0 1,0 0,0 1,-1 1,1 0,-1 1,0 0,1 1,-1 0,0 1,-26 6,12-1,0 2,1 1,-1 1,2 1,-31 18,30-13,1 1,0 2,2 0,0 2,1 0,-35 43,43-45,1 1,1 0,0 1,2 1,0-1,2 2,0 0,1 0,-5 29,12-47,0 0,0 0,0-1,1 1,0 0,0 0,0 0,1 0,0 0,-1-1,2 1,-1 0,0-1,1 1,0-1,0 1,4 5,-6-10,0 1,1-1,-1 0,0 1,0-1,0 1,1-1,-1 0,0 1,1-1,-1 0,0 1,1-1,-1 0,0 0,1 1,-1-1,1 0,-1 0,1 0,-1 0,0 1,1-1,-1 0,1 0,-1 0,1 0,-1 0,1 0,-1 0,1 0,-1 0,0 0,1-1,-1 1,1 0,-1 0,1 0,-1 0,0-1,1 1,-1 0,1 0,-1-1,0 1,1 0,-1-1,0 1,0 0,1-1,-1 1,0-1,0 1,1 0,-1-1,0 1,0-1,0 1,0-1,0 1,1 0,-1-1,0 1,0-2,1-2,0-1,0 0,0 0,-1-10,0 0,-2 1,0 0,0 0,-9-25,9 34,1 1,-1 0,1 0,-1 0,0 0,-1 0,1 0,-1 1,1-1,-1 1,0-1,-1 1,1 0,-1 0,1 1,-1-1,0 1,0-1,-6-1,8 3,-1 1,1 0,-1 0,1 0,-1 0,1 0,-1 0,1 1,-1-1,1 1,0 0,-1-1,1 1,0 0,-1 0,1 1,0-1,0 1,0-1,0 1,0-1,0 1,1 0,-1 0,0 0,1 0,-2 3,-3 4,1-1,0 1,1 0,0 1,-4 13,5-12,0-1,1 1,1 0,-1 0,2-1,-1 1,2 0,-1 0,1 0,1 0,0 0,1-1,0 1,0-1,1 0,1 0,-1 0,2 0,-1-1,1 0,1 0,0 0,0-1,0 0,1-1,1 1,16 10,-13-11,1 0,0-1,0-1,1 0,-1-1,1-1,0 0,0-1,0 0,0-1,1 0,-1-2,0 1,0-2,0 0,0-1,0 0,0-1,19-8,-18 6,0-1,0 0,-1-1,-1 0,1-1,-1-1,-1 0,0-1,0 0,-1-1,-1-1,0 1,0-1,-2-1,1 0,11-29,-13 23,-1 0,-1-1,-1 0,-1 0,-1 0,-1-1,-2-35,1 53,-1 0,1 0,-1 0,0 0,0 0,0 0,-1 0,1 0,-1 0,0 1,0-1,-1 0,1 1,-1 0,1 0,-1 0,0 0,-4-3,4 4,0 0,0 0,0 1,-1 0,1-1,0 1,-1 1,1-1,-1 0,1 1,-1-1,1 1,-1 0,1 0,-1 1,1-1,-1 1,1 0,-1 0,1 0,-5 2,-2 2,0 0,0 1,0 1,1-1,0 2,0-1,1 1,0 0,0 1,1 0,-10 14,6-6,1 1,1 0,0 0,2 1,-11 35,12-26,1 0,1 0,1 1,2-1,1 1,1-1,7 48,-6-70,-1 0,1 0,0 0,1-1,-1 1,1 0,0-1,1 0,-1 0,6 5,-8-8,1 0,-1 0,1-1,0 1,0-1,0 0,0 1,0-1,0 0,0 0,0 0,0 0,0-1,1 1,-1-1,0 1,1-1,-1 0,0 0,1 0,-1 0,0 0,1 0,-1-1,0 1,0-1,1 0,-1 1,4-3,-3 0,1 1,-1-1,0 0,1 1,-1-2,-1 1,1 0,0-1,-1 1,0-1,0 1,0-1,0 0,2-8,1-6,0 1,2-21,-5 19,0 1,-1 0,-1 0,-1-1,-1 1,-6-29,6 35,-1 1,-1 0,0 0,0 0,-1 0,-1 0,0 1,0 0,-1 1,0-1,-12-11,16 18,0 1,1-1,-1 1,-1 0,1 0,0 0,0 0,-1 0,1 1,-1-1,1 1,-1 0,0 0,0 1,1-1,-1 1,0 0,0 0,1 0,-1 0,0 1,-4 0,4 0,1 1,-1-1,1 1,0 0,0 0,0 0,0 1,0-1,0 1,0-1,1 1,-1 0,1 0,0 0,0 0,0 1,0-1,1 0,-1 1,1-1,0 1,-1 4,0 2,0-1,1 1,0-1,1 1,0 0,1 0,0-1,0 1,1-1,0 1,0-1,1 1,1-1,0 0,0-1,0 1,1-1,8 10,-6-9,0 1,1-2,1 1,-1-1,1-1,0 0,1 0,0 0,0-1,0-1,1 0,0 0,0-1,21 5,-29-8,0-1,0 1,0-1,0 0,0 0,0 0,0 0,0 0,0-1,0 1,0-1,-1 0,1 0,0 0,0 0,-1 0,1-1,0 1,-1-1,0 0,1 0,-1 0,0 0,0 0,0 0,3-4,-3 3,0-1,0 0,-1-1,1 1,-1 0,1 0,-1-1,-1 1,1 0,-1-1,1 1,-1-1,-1 1,1-1,-1 1,1 0,-3-6,-2-7,-2 1,0 0,0 0,-2 1,0 0,0 0,-1 1,-1 0,-1 1,0 0,0 1,-2 0,-20-14,28 23,0 0,0 0,0 1,0 0,0 0,0 0,0 1,0 0,-13 0,17 0,1 1,-1 0,0 0,0 1,1-1,-1 0,0 1,1-1,-1 1,0-1,1 1,-1 0,1 0,-1 0,1 0,-1 0,1 0,0 0,-1 0,1 0,0 1,0-1,0 0,0 1,0-1,0 1,0-1,0 1,1 0,-1-1,1 1,-1 0,1-1,0 1,0 0,-1 0,1-1,0 1,1 3,0 1,0-1,0 1,1-1,-1 1,1-1,1 0,-1 0,1 0,0 0,0 0,0-1,0 1,1-1,5 5,-4-4,0 0,0-1,1 1,-1-1,1-1,0 1,0-1,1 0,-1 0,0-1,10 3,-13-5,0 0,0 0,1 0,-1 0,0 0,0-1,0 1,0-1,0 0,0 0,0 0,0-1,-1 1,1-1,0 1,-1-1,1 0,-1 0,1 0,-1 0,0-1,0 1,0-1,3-4,1-2,-1 0,0-1,-1 1,1-1,-2 0,4-12,-2-2,-1 0,0 0,-1-27,-2 39,-2-1,1 1,-2-1,0 1,0 0,-1-1,-8-21,9 32,1-1,0 1,0-1,-1 1,0-1,1 1,-1 0,0 0,0 0,0 0,0 0,-1 0,1 1,-1-1,-2-1,4 3,0 0,0-1,0 1,0 0,1 0,-1 0,0 0,0 0,0 0,0 0,0 0,1 0,-1 0,0 1,0-1,0 0,0 1,1-1,-1 0,-1 1,1 0,0 1,0-1,-1 0,1 0,0 1,0-1,0 1,1-1,-1 1,0-1,0 1,1 0,-1 2,-1 5,0-1,0 1,1 0,1 0,-1 0,1-1,1 1,0 0,0 0,1 0,0-1,0 1,1-1,0 1,0-1,1 0,9 14,-9-17,0 0,0 0,0 0,1 0,0-1,0 1,0-1,0-1,0 1,1-1,0 0,0 0,0 0,0-1,0 0,0 0,1 0,-1-1,1 0,-1-1,1 1,-1-1,1 0,11-3,-11 2,0-1,-1 0,1-1,-1 1,1-1,-1-1,0 1,0-1,-1 0,1 0,-1-1,0 1,0-1,0-1,-1 1,0 0,0-1,0 0,0 0,-1 0,3-9,2-6,0-1,-2 0,0 0,-2-1,3-26,-6 34,-1 0,0 1,0-1,-2 1,0-1,0 1,-2-1,0 1,0 0,-1 1,-8-16,10 23,-1 0,1-1,-1 1,-1 1,1-1,-1 1,0-1,0 1,0 1,-1-1,0 1,0 0,0 0,0 0,-1 1,1 0,-1 1,0-1,0 1,0 1,0-1,0 1,0 0,-10 0,10 2,0-1,1 1,-1 1,0-1,0 1,1 0,-1 0,1 1,-1 0,1 0,0 1,0-1,1 1,-1 1,1-1,0 1,0 0,0 0,0 0,1 1,0-1,1 1,-1 0,1 1,0-1,-3 10,3-9,1 0,0 1,0 0,1-1,0 1,1 0,-1-1,1 1,1 0,0 0,0-1,0 1,1 0,0-1,0 0,1 1,0-1,0 0,1 0,0-1,0 1,1-1,7 9,-5-8,1-1,0 1,0-2,0 1,1-1,0-1,0 1,0-1,0-1,1 0,-1 0,1-1,0 0,-1-1,13 1,-14-2,0 0,0 0,0-1,0 0,0 0,-1-1,1 0,0 0,-1-1,0 0,1-1,-1 1,0-1,-1 0,1-1,-1 0,0 0,0 0,6-7,-6 3,1 1,-1-1,-1 0,0-1,0 0,-1 1,0-2,0 1,-1 0,-1-1,0 1,0-1,-1 1,0-20,-2 21,0 0,0-1,-1 1,0 0,-1 0,0 0,0 0,-1 0,0 1,0 0,-1 0,0 0,-1 0,0 1,0 0,-13-12,9 11,-1 0,1 0,-1 1,-1 0,-14-6,18 10,1 1,-1-1,1 1,-1 1,0-1,0 1,0 0,0 1,-13 1,18-1,0 1,0-1,1 1,-1 0,1 0,-1 0,1 0,-1 1,1-1,-1 0,1 1,0 0,0 0,0-1,0 1,0 0,0 0,1 1,-1-1,1 0,-1 1,1-1,0 1,0-1,0 1,0-1,1 1,-1 0,1-1,-1 1,1 0,0 4,0 0,0 0,0 0,1-1,0 1,0 0,1 0,0-1,0 1,0-1,1 0,0 1,5 6,0-3,0 0,1 0,1-1,0-1,0 1,0-2,1 1,0-1,20 9,-21-12,0 0,0 0,0-1,0 0,0-1,0 0,1-1,-1 0,1 0,0-1,-1-1,16-2,-21 2,-1 0,0 0,0-1,0 0,0 0,0 0,0 0,0 0,-1-1,1 0,-1 1,0-1,0-1,4-3,-3 1,0 0,-1 0,0 0,0-1,0 1,0-1,-1 0,1-7,0-8,0 0,-2 0,0 0,-4-34,-3 15,-2 0,-1 1,-2 0,-17-39,13 38,1-1,3 0,-10-63,18 69,1-62,3 83,0 1,1-1,1 1,0 0,1 0,0 0,9-16,-12 27,1 0,-1 0,1 0,0 0,0 0,0 0,1 1,-1-1,1 1,-1 0,1 0,0 0,0 0,0 0,0 0,0 1,0-1,1 1,-1 0,5-1,2 1,1 0,-1 1,1 1,-1-1,14 4,-10-2,0-1,25 0,-35-1,0-1,0 0,0 1,1-1,-1-1,0 1,-1 0,1-1,0 0,0 0,-1 0,1-1,4-3,1-3,0-1,-1 0,0 0,-1-1,0 0,-1-1,0 1,7-22,-2 3,-2-1,7-45,-12 53,-1-1,-2 0,0 0,-2 0,-5-40,3 50,1 1,-2 0,0 0,-1 0,0 0,0 1,-2 0,1 0,-2 0,0 1,-14-17,19 26,0-1,0 0,0 1,0-1,0 1,-1 0,-4-2,7 4,1-1,-1 1,0 0,0 0,0-1,0 1,1 0,-1 0,0 0,0 0,0 0,0 0,1 0,-1 0,0 0,0 1,0-1,0 0,1 0,-1 1,0-1,0 1,1-1,-1 1,0-1,1 1,-1-1,0 1,1-1,-1 1,1 0,-1-1,1 1,-1 0,1 0,0-1,-1 1,1 0,0 0,-1-1,1 1,0 1,-2 7,0 0,1 0,0 0,1 0,0 1,2 14,11 58,-8-59,1 0,0 0,17 36,-20-52,0-1,0 0,0 0,1 0,0 0,1-1,-1 0,1 0,0 0,0 0,0-1,1 1,0-1,0-1,0 1,13 4,-17-7,1 0,-1 0,1-1,-1 1,1-1,-1 1,1-1,-1 0,1 0,-1 0,1-1,-1 1,1 0,-1-1,1 0,-1 0,1 1,-1-1,0-1,1 1,-1 0,0-1,0 1,0-1,0 1,0-1,0 0,-1 0,1 0,0 0,-1 0,0 0,1-1,-1 1,0 0,0-1,1-4,0-1,1-1,-2-1,1 1,-1 0,-1 0,1 0,-2-1,1 1,-3-12,-1 1,-1 1,-1 0,-1 1,0 0,-2 0,0 0,0 1,-2 0,0 1,-1 0,-20-20,28 32,-1 0,1 1,-1 0,0-1,0 2,0-1,0 0,0 1,-6-2,9 4,-1-1,0 0,1 1,-1 0,0 0,1 0,-1 0,0 0,1 0,-1 1,1-1,-1 1,1 0,-1 0,1 0,-1 0,1 0,0 0,-1 1,1-1,0 1,-3 2,-4 6,0 0,0 1,1 1,1-1,0 1,0 0,1 1,1 0,0 0,0 0,-2 16,1-2,2 0,1 0,1 0,2 50,2-54,0 0,2 0,1 0,0-1,2 0,0 0,2 0,15 28,-19-41,1-1,-1 1,1-1,1 0,0-1,0 0,0 0,1 0,0-1,0 0,1 0,-1-1,1 0,1-1,-1 0,0 0,1-1,0 0,0-1,0 0,16 1,-14-3,0-1,0 0,0-1,0-1,0 1,0-2,-1 1,0-2,0 0,0 0,0-1,-1 0,0-1,14-11,1-3,-1-2,-1 0,-2-1,24-34,-27 32,-1-1,-1-1,-1 0,-2-1,-1-1,-1 0,-2 0,12-62,-19 72,0 0,-2-1,0 1,-1 0,-1 0,-6-31,4 36,-1 1,0 0,0 0,-2 1,1-1,-2 1,0 1,0 0,-17-19,16 22,1 1,-2 0,1 0,-1 1,0 0,-1 1,1 0,-1 1,-1 0,1 0,-1 1,1 1,-1 0,0 1,-14-1,17 2,1 1,-1 0,1 1,-1-1,0 2,1-1,0 1,-1 1,1 0,0 0,0 0,0 1,1 0,-1 1,1-1,0 2,0-1,1 1,0 0,0 0,0 0,-5 8,3-1,1-1,0 1,1 0,0 1,1 0,1 0,0 0,1 0,0 0,1 1,1-1,1 1,-1 0,4 20,0-15,0 0,1-1,1 0,1 0,0 0,2 0,0-1,1 0,1-1,12 17,-10-19,0 1,1-1,1-1,19 15,-26-24,0 1,1-1,0 0,0-1,0 0,1 0,-1-1,1 0,0-1,0 1,10 0,-14-3,-1 0,0 0,1 0,-1 0,0-1,1 1,-1-1,0-1,0 1,0 0,0-1,0 0,0 0,5-4,-3 2,-1 0,-1 0,1-1,-1 1,0-1,0-1,0 1,5-12,-2 4,-2-1,0 0,0 0,-2-1,0 0,0 1,0-27,-3 26,-2-1,1 0,-2 1,0-1,-1 1,-1 0,0 0,-1 0,0 1,-2 0,1 0,-2 1,0 0,0 0,-1 1,-1 0,-14-13,14 15,-1 0,0 0,-1 1,0 1,0 0,-1 0,1 1,-2 1,1 1,-1 0,0 1,0 0,0 1,0 1,-1 0,1 2,-27 1,35-1,1 1,-1 1,1-1,0 1,-1 0,1 1,0 0,0 0,1 0,-1 0,1 1,-1 0,1 0,0 0,1 1,-9 10,7-6,1 0,-1 0,2 0,0 1,0 0,0 0,1 0,1 0,0 0,-1 12,-2 35,3 0,8 83,-6-134,1 0,0-1,0 1,0-1,1 1,0-1,0 1,4 6,-5-11,0 1,0-1,0 1,0-1,1 1,-1-1,0 0,0 0,1 0,-1 0,1 0,-1 0,1 0,-1 0,1-1,0 1,-1 0,1-1,0 1,-1-1,1 0,0 0,0 0,-1 1,1-2,0 1,0 0,-1 0,1 0,0-1,3-1,1 0,1-2,-1 1,1-1,-1 0,-1 0,1 0,0-1,-1 0,0 0,6-8,2-4,0-2,12-21,-10 9,0 0,-3-1,0 0,-2-1,-2 0,6-40,-7 16,-2 0,-6-111,1 160,-1-1,0 1,0 0,-1 0,0 0,0 0,-1 1,0-1,-7-12,7 16,1 1,-1 0,0-1,0 1,0 1,-1-1,1 0,-1 1,1 0,-1-1,0 1,0 1,0-1,0 1,0-1,0 1,0 0,0 1,-1-1,-4 1,5-1,-1 1,0 1,1-1,-1 1,0 0,1 0,-1 0,0 0,1 1,0 0,-1 0,1 0,0 0,0 1,0 0,0 0,1 0,-1 0,1 0,0 1,0-1,0 1,0 0,1 0,-3 6,-3 5,1 1,0 1,2 0,0 0,-5 27,5-13,1 0,0 36,4-52,1 1,0-1,1 0,1 0,0 0,8 20,-10-31,1 0,0 0,0 0,0-1,1 1,-1-1,6 6,-7-8,-1 0,1-1,0 1,-1-1,1 1,0-1,0 1,0-1,-1 1,1-1,0 0,0 0,0 1,0-1,-1 0,1 0,0 0,0 0,0 0,0 0,0 0,0 0,0 0,-1 0,1-1,0 1,0 0,0 0,0-1,-1 1,1-1,0 1,0-1,-1 1,1-1,0 1,-1-1,1 0,0 1,-1-1,1 0,0-1,3-4,-1 0,0-1,0 1,0-1,-1 0,1 0,-2 0,1 0,-1 0,0 0,-1-1,0-10,-1-6,-1 0,-7-37,4 40,-1-1,0 1,-2 0,0 0,-1 1,-2 0,0 1,-19-27,20 35,1-1,-2 1,1 1,-2 0,1 0,-1 1,0 1,-1 0,0 1,-1 0,1 1,-1 0,-24-6,14 7,0 1,0 1,-48 0,57 3,0 1,0 1,0 0,1 1,-1 1,1 0,-25 12,36-15,1 0,-1 0,1 1,0-1,-1 1,1-1,0 1,0 0,0 0,0 0,0 0,1 0,-1 0,1 1,-1-1,1 1,0-1,0 1,0-1,0 1,0 0,0 2,1-1,0 0,1 0,-1-1,1 1,-1 0,1-1,0 1,1-1,-1 1,1-1,-1 0,1 0,0 1,0-1,5 5,-1-2,0-1,0 1,0-1,1 0,0-1,0 0,0 0,0 0,1-1,0 0,-1 0,1-1,15 3,2-2,1 0,-1-2,30-2,-47 1,0 0,-1-1,1 0,0-1,-1 0,1 0,-1 0,0-1,0 0,0 0,0-1,9-7,-10 6,-1 0,0 0,0-1,0 1,-1-1,0 0,0 0,-1-1,0 1,0-1,0 0,-1 0,3-11,-1-1,-2 0,0-1,-1 1,-1-1,0 0,-2 1,0-1,-2 1,0 0,-1 0,0 0,-2 1,0 0,-2 0,0 0,-13-18,7 12,-1 2,-1 0,-1 1,-1 0,-1 2,0 0,-2 2,0 0,-1 1,-48-24,58 34,0 1,0 0,0 1,0 1,-1 0,0 0,0 2,1 0,-1 0,0 1,0 1,-24 4,34-4,1 0,-1 1,1 0,0-1,-1 1,1 1,0-1,0 0,0 1,0-1,1 1,-1 0,1 0,0 0,0 0,0 0,0 1,-3 6,1 0,0-1,1 1,0 1,1-1,-3 18,4-15,1 1,1 0,0 0,1-1,0 1,1-1,0 0,1 1,1-1,0-1,1 1,0-1,1 0,0 0,1-1,12 14,-13-17,0-1,0 1,1-1,0-1,1 0,-1 0,1-1,0 0,1 0,-1-1,1 0,0-1,0 0,0 0,0-1,1-1,-1 0,0 0,1-1,-1 0,1-1,10-1,-8-2,0 1,0-2,-1 0,0 0,0-1,0 0,-1-1,0-1,0 0,-1 0,1-1,-2 0,0-1,0 0,-1-1,12-17,-9 10,-2 1,0-1,0-1,-2 1,0-2,-1 1,-1 0,-1-1,-1 0,1-28,-4 33,0 1,-2 0,1-1,-2 1,0 0,-1 0,0 0,-1 1,0-1,-1 1,-1 1,0-1,-10-13,5 11,0 1,-1 1,0 0,-1 0,-1 1,0 1,0 1,-1 0,-25-12,19 13,-1 0,1 2,-1 0,0 1,-1 2,0 0,-30 0,34 3,0 2,0 0,0 1,0 2,1-1,-1 2,1 1,-34 14,33-10,0 0,1 1,0 1,-31 26,43-32,1 1,-1 0,1 1,0-1,1 1,0 0,0 1,1-1,0 1,0 0,1 0,0 0,-3 17,5-16,0-1,0 1,0-1,2 1,-1-1,1 0,0 1,1-1,4 15,-4-21,-1 1,1-1,0 1,0-1,0 1,0-1,1 0,-1 0,1 0,0-1,0 1,0 0,0-1,0 0,1 0,-1 0,1 0,-1-1,1 1,0-1,-1 0,1 0,0 0,0 0,6 0,-1-1,0 0,-1-1,1 0,-1 0,1-1,0 0,-1-1,0 1,0-1,15-9,-14 7,1-1,-1 0,-1 0,1-1,-1 0,0-1,-1 1,10-14,-10 10,0 1,-1-1,0-1,0 1,-2-1,1 0,-1 0,-1-1,0 1,-1-1,-1 1,0-1,0 0,-1 0,-1 1,0-1,-1 0,0 1,-1-1,0 1,-1 0,0 0,-1 0,-1 1,0-1,0 1,-1 1,0-1,-1 1,0 0,-1 1,-15-13,5 7,-1 2,0 0,-1 1,-1 1,0 1,0 1,-1 1,0 1,0 0,-1 2,1 1,-1 1,0 1,-43 3,56 0,0 0,0 1,1 1,-1 0,1 1,-1 0,1 0,0 1,1 0,-17 12,14-7,0 0,1 1,0 0,0 1,2 0,-1 1,-6 13,2-1,2 1,1 0,1 0,1 1,1 0,1 0,2 1,-2 29,6-50,1 0,-1 1,2-1,-1 0,1 0,0 0,0 1,1-1,0 0,3 6,-4-10,1 0,-1-1,1 0,0 1,0-1,0 0,0 0,0 0,1 0,-1 0,0 0,1-1,-1 1,1-1,0 0,0 1,-1-1,1-1,0 1,0 0,0-1,0 1,0-1,0 0,0 0,5-1,-3 1,-1-1,1 0,-1 0,0 0,1-1,-1 0,0 1,0-1,0-1,0 1,0-1,-1 1,1-1,-1 0,0 0,1-1,-1 1,-1-1,1 0,0 1,3-9,1-3,0 0,-2 0,1 0,5-29,-8 26,0 0,-1 0,-1 0,0 0,-2-1,0 1,-1 0,-5-23,5 32,-1 1,1-1,-2 1,1-1,-1 1,-1 0,1 0,-1 1,-1-1,1 1,-1 0,0 1,-1-1,0 1,0 1,0-1,-1 1,-13-7,7 6,-1 1,-1 0,1 1,-1 1,1 0,-1 1,0 1,0 0,0 2,0-1,-16 4,5 1,0 0,1 2,0 1,0 0,-42 22,51-21,0 1,1 1,0 0,1 1,0 1,1 1,-22 26,29-32,0 1,1 0,0 1,1 0,0-1,1 1,0 1,0-1,1 1,1 0,-1-1,2 1,-1 0,2 0,0 13,0-19,1 0,0 0,0-1,1 1,-1 0,1 0,0-1,0 1,1-1,-1 0,1 1,0-1,0 0,0-1,1 1,-1-1,1 1,0-1,0 0,0 0,0-1,1 1,-1-1,1 0,-1 0,1 0,6 0,0 1,-1-1,1 0,0-1,-1 0,1-1,0 0,0-1,0 0,0 0,-1-2,18-4,-11-1,0 1,0-2,-1 0,0-1,-1-1,0 0,-1-1,0-1,18-22,-12 11,-1-2,-1 0,-1-1,24-52,-35 65,0-1,-1 1,-1-1,0 0,-1 0,2-29,-5 37,0 0,0 0,-1 0,0 0,0 0,-1 0,0 0,0 1,0-1,-1 1,0-1,0 1,0 0,-1 0,0 0,-1 1,-6-8,0 4,-1 0,0 1,0 0,0 1,-1 1,0 0,0 1,0 0,-1 1,-26-5,0 3,0 1,-67 2,41 6,1 3,1 3,-1 3,2 2,0 3,0 3,-89 42,128-51,1 1,-1 1,2 1,-25 20,41-29,0 1,0 0,0 1,1-1,0 1,0 0,-5 11,8-13,0 0,0 0,0 0,1 0,0 1,0-1,0 0,1 1,0-1,0 0,0 1,2 9,-1-12,0 1,1-1,-1 0,1 0,-1 0,1 0,0 0,0 0,0 0,1-1,-1 1,0-1,1 0,0 1,0-1,0-1,0 1,0 0,0-1,0 1,0-1,0 0,1 0,5 1,8 1,0 0,1-1,24 0,-42-2,18-1,0 0,0-1,0-1,0-1,-1 0,1-1,-1-1,0-1,-1 0,0-1,0-1,-1-1,0 0,0 0,-1-2,-1 0,0 0,20-26,-29 32,1 0,-2 0,1 0,0 0,-1-1,-1 0,1 0,-1 1,0-1,0-1,-1 1,0 0,0-9,-1 11,-1 0,0 0,1 0,-2 1,1-1,0 0,-1 0,0 1,0-1,-1 1,1-1,-1 1,0 0,0 0,0 0,-1 1,1-1,-1 1,-6-5,-2 0,-1 1,1 0,-1 1,-1 1,1 0,-1 1,0 0,0 1,-22-2,-14 0,-66 4,76 2,1 3,0 1,0 1,0 3,0 1,-66 27,82-27,0 1,0 1,1 1,1 1,0 1,1 1,0 1,2 0,0 1,1 1,-24 35,36-45,0 0,1 1,0-1,0 1,1 0,1 0,-1 1,0 14,3-20,0-1,0 1,0-1,0 1,1-1,0 1,0-1,0 1,3 6,-3-9,0 0,1 0,-1 1,1-1,-1-1,1 1,0 0,-1 0,1-1,0 1,0-1,0 1,0-1,1 0,-1 0,0 0,0 0,4 1,-4-2,0 1,0-1,-1 0,1 0,0 0,0 0,-1 0,1-1,0 1,0 0,-1-1,1 1,0-1,-1 0,1 0,0 1,-1-1,1 0,-1 0,0-1,1 1,-1 0,0 0,0-1,1 1,-1 0,0-1,0 1,-1-1,1 0,0 1,0-1,0-2,1-3,0 1,0-1,0 0,-1 1,0-1,0 0,-1-11,-1 8,-1 1,0-1,-1 1,0-1,0 1,-1 0,0 1,-1-1,0 1,0-1,0 2,-1-1,-13-12,3 4,-1 0,-1 1,-1 2,-34-21,26 20,0 2,-2 0,1 2,-1 1,-1 1,1 2,-39-4,17 6,0 2,0 3,-79 10,74-2,1 3,0 2,0 2,2 3,-99 49,111-46,2 2,0 1,2 2,0 2,2 1,2 2,-51 61,76-82,-1 1,1 0,1 1,0 0,1 0,1 0,0 1,-4 18,7-25,1 1,0-1,0 1,1-1,0 1,1-1,-1 1,2-1,-1 0,1 1,0-1,0 0,1 0,0 0,0 0,1-1,6 10,0-3,1-1,0-1,1 0,0 0,1-1,0-1,0 0,1-1,0-1,1 0,18 6,5 0,1-2,0-1,53 5,-42-9,84-1,-103-7,1 0,0-2,60-16,-76 15,0-1,0 0,0-2,-1 1,0-2,0 0,-1-1,19-16,-23 17,-1-1,0-1,0 1,-1-2,-1 1,0-1,0 0,-1 0,-1-1,0 0,6-23,-9 24,1 0,-2 0,1 0,-2-1,1 1,-2 0,0 0,0 0,-1 0,0 0,-1 0,-1 0,0 1,0 0,-1-1,-1 2,0-1,0 1,-1-1,0 2,-1-1,0 1,0 0,-1 1,0 0,-1 0,0 1,0 1,0-1,-1 2,0-1,-20-6,17 8,-1 1,1 1,0 0,-1 0,1 2,-1 0,1 0,-1 2,1-1,0 2,0 0,0 1,0 0,0 1,1 1,-1 0,-12 8,-3 4,1 1,1 1,0 1,2 2,0 0,-24 31,33-35,1 1,1 0,1 1,1 1,1-1,0 2,2 0,-8 26,14-36,1-1,0 1,1-1,0 1,0 0,2-1,2 21,-1-23,0-1,1 0,0 0,0 0,1 0,0-1,0 0,1 0,1 0,-1 0,8 8,-4-8,0 0,1 0,-1-1,1-1,1 0,-1 0,1-1,0 0,0-1,0 0,1 0,0-2,-1 1,18 0,-17-2,0 0,0-1,0 0,0-1,0 0,0-1,0-1,-1 0,1 0,-1-1,0 0,0-1,0-1,14-9,-12 5,0-1,-1-1,-1 0,0-1,-1 0,0-1,-1 0,0 0,-1-1,-1 0,0-1,-1 0,-1 0,0 0,3-27,-5 24,-1 0,-1 0,-1 0,0-1,-2 1,0 0,-1 0,-1 0,0 0,-2 1,0 0,-1 0,-14-24,14 30,-1 0,-1 0,0 1,0 0,-1 1,0 0,-1 1,0 0,-20-12,13 11,0 1,-1 0,0 2,-1 0,0 1,-21-4,4 5,0 1,0 1,-1 3,1 1,0 1,-70 15,78-11,0 2,1 1,0 1,0 1,1 2,1 0,0 2,-24 19,36-23,0 0,1 0,1 2,0 0,1 0,0 1,1 0,1 1,0 0,1 0,0 1,2 0,-1 1,-6 30,11-35,0 0,1 1,0-1,0 0,2 1,-1-1,2 0,0 1,0-1,1 0,0 0,1-1,1 1,0-1,0 0,1 0,0 0,1-1,0 0,1 0,0-1,1 0,0 0,18 13,-7-9,1 0,0-1,0-2,1 0,1-1,37 10,-6-7,100 10,-95-18,0-2,0-2,0-3,69-13,-100 12,0-2,-1-2,0 0,0-2,-1-1,0 0,-1-3,0 0,-1-1,39-32,-49 34,-1-1,0 0,-1-1,-1 0,0-1,-1 0,-1 0,0-1,-2 0,9-27,-12 30,-1 0,0 0,-1-1,-1 1,0 0,-1-1,0 1,-2 0,1-1,-2 1,0 0,0 0,-2 0,-6-16,4 15,-1 0,0 0,-1 1,0 0,-2 1,1 0,-1 1,-1 0,0 0,-1 1,0 1,-1 0,0 1,0 1,-1 0,0 1,-1 0,1 1,-1 1,0 1,-19-3,-31-1,-1 2,0 4,-127 12,189-9,0-1,0 1,0 0,0 1,1-1,-1 1,1 0,-1 0,1 0,0 1,0 0,0-1,0 2,0-1,-3 4,3-2,0 0,1 0,-1 0,1 1,0-1,1 1,-1 0,1 0,0 0,1 0,-2 7,1 1,0 0,1-1,0 1,1 0,2 15,-1-23,0 0,1 0,-1 0,1 0,1 0,-1-1,1 1,0-1,0 1,0-1,1 0,0 0,7 7,-6-8,0 0,0 0,1 0,-1-1,1 0,0 0,0 0,0-1,0 0,0 0,0 0,1-1,-1 0,0 0,1 0,-1-1,1 0,-1-1,1 1,-1-1,1 0,-1-1,0 0,0 0,0 0,0 0,0-1,0 0,-1-1,1 1,-1-1,0 0,0 0,0-1,-1 1,1-1,-1 0,0 0,-1-1,1 1,-1-1,0 1,0-1,2-9,-3 6,1 0,-2-1,1 1,-2-1,1 1,-1-1,0 1,-1-1,0 0,-1 1,0 0,0-1,-1 1,-1 0,1 0,-1 1,-1-1,-6-9,5 7,-2 1,1 0,-1 1,0 0,-1 0,0 0,-1 1,0 1,0 0,0 0,-1 1,0 0,-22-8,14 10,0 1,-1 1,1 0,0 2,-1 0,-21 3,-20 0,54-3,0 0,-1 1,1 0,0 0,0 0,0 1,0 0,1 1,-10 4,13-5,0-1,0 2,0-1,0 0,0 0,1 1,-1 0,1-1,0 1,0 0,0 0,0 1,0-1,0 0,1 0,0 1,-1-1,1 1,1-1,-2 5,2-7,0 1,-1-1,1 0,0 0,0 1,0-1,0 0,0 0,0 1,0-1,0 0,1 0,-1 1,0-1,1 0,-1 0,1 0,-1 0,1 0,0 1,-1-1,1 0,0 0,0-1,0 1,0 0,0 0,0 0,0-1,0 1,0 0,0-1,0 1,0-1,0 1,1-1,-1 1,2-1,0 0,0 0,0 0,0 0,0 0,-1-1,1 1,0-1,0 0,0 0,0 0,-1 0,1 0,0-1,-1 1,4-3,6-7,-1 1,-1-2,0 1,0-2,-1 1,-1-1,0 0,-1-1,0 0,-1 0,0 0,-2-1,1 0,-2 0,0 0,1-31,-3 43,-1 0,0 1,-1-1,1 0,0 0,-1 1,0-1,1 0,-1 1,0-1,0 1,-1-1,1 1,-1-1,1 1,-1 0,1 0,-1-1,0 1,-4-2,3 2,0 0,0 0,-1 0,1 1,0 0,-1 0,1 0,-1 0,1 0,-1 1,0-1,1 1,-1 0,-4 0,3 1,1-1,0 1,-1-1,1 1,0 0,0 1,0-1,0 1,0 0,0 0,0 0,0 0,1 1,-1-1,1 1,0 0,0 0,0 0,0 1,0-1,1 1,-1 0,1-1,0 1,0 0,1 0,-2 5,1 2,0 0,1 0,0 1,1-1,0 0,1 0,1 0,-1 0,5 12,-6-21,1-1,0 1,0 0,0 0,0-1,0 1,1-1,-1 1,0-1,1 1,-1-1,1 0,0 0,-1 0,1 0,0 0,0 0,-1 0,1 0,0-1,0 1,0-1,0 1,0-1,0 0,0 0,0 0,0 0,0 0,0 0,0-1,3 0,0 0,0-1,0 0,0 0,0 0,-1 0,1-1,-1 0,1 0,-1 0,0 0,4-5,-4 4,-1 0,0 0,0-1,-1 1,1-1,-1 1,3-7,-5 9,1-1,0 1,0-1,-1 1,0-1,1 1,-1-1,0 0,0 1,0-1,-1 1,1-1,-1 0,1 1,-1-1,-1-2,2 5,0 0,0-1,0 1,0-1,0 1,-1-1,1 1,0-1,0 1,0-1,-1 1,1 0,0-1,-1 1,1 0,0-1,-1 1,1 0,0-1,-1 1,1 0,-1 0,1-1,-1 1,1 0,0 0,-1 0,1-1,-1 1,1 0,-1 0,1 0,-1 0,1 0,-1 0,1 0,-1 0,1 0,-1 1,1-1,-1 0,1 0,0 0,-1 0,1 1,-1-1,1 0,-1 0,1 1,0-1,-1 0,1 1,0-1,-1 0,1 1,0-1,0 1,-1-1,1 0,0 1,0-1,-1 1,-1 3,0 0,1 0,-1-1,0 1,-1 8,1-2,1-1,0 1,0 0,1-1,0 1,1 0,3 14,-3-19,0-1,1 1,0-1,0 1,1-1,-1 0,1 0,0 0,0 0,0 0,0 0,1-1,-1 0,1 0,0 0,8 5,12 4,-1-1,2-1,-1-1,1-1,1-1,-1-1,1-1,0-2,0-1,1 0,-1-2,0-1,0-2,0 0,38-10,-38 6,0 0,-1-2,0-1,0-1,-1-1,0-1,-1-1,-1-1,0-1,-1-1,-1-1,0-1,-2 0,32-44,-44 55,-1-1,0 0,-1 1,0-1,-1-1,5-17,-7 24,-1 1,1-1,-1 0,0 0,0 1,0-1,0 0,0 0,-1 0,1 1,-1-1,1 0,-1 1,0-1,0 1,-1-1,1 1,0-1,-1 1,1 0,-1-1,0 1,0 0,0 0,0 1,0-1,0 0,-4-1,-4-2,0 1,0 0,-1 0,1 2,-1-1,0 1,0 1,-22-1,-1 2,-52 8,59-4,0 1,0 1,1 2,0 0,1 2,-1 0,2 2,0 1,-25 17,16-9,23-16,1 1,-16 12,22-16,1 1,0-1,-1 1,1-1,0 1,0 0,1 0,-1 0,1 0,-1 0,1 0,0 0,-1 5,1-3,0 0,1 0,-1 0,1 0,0 0,0 0,1 0,-1 0,1 0,0 0,1-1,-1 1,1 0,0-1,0 1,0-1,1 0,4 7,-3-7,0 0,0 0,0-1,1 1,-1-1,1 0,0 0,0-1,0 0,0 1,1-2,-1 1,0 0,1-1,-1 0,8 0,-10-1,1 1,0-1,0 0,-1 0,1-1,0 1,-1-1,1 0,-1 0,1 0,-1 0,1-1,-1 1,0-1,1 0,-1 0,4-4,-4 3,0 0,0-1,0 1,-1-1,1 0,-1 0,0 0,0 0,-1-1,1 1,-1 0,0-1,0 1,0-7,0 4,-1 0,0 0,0 0,0 0,-1 0,0 0,-1 0,-3-9,4 12,0 1,-1-1,1 1,-1 0,0-1,0 1,0 0,-1 0,1 1,-1-1,1 0,-1 1,0-1,0 1,0 0,-1 0,1 0,-4-1,-5-1,0 1,0 0,-1 1,1 1,-16-1,-67 5,51-1,26-2,0 1,0 1,0 1,-21 6,34-8,0 1,0 0,0 0,0 0,1 0,-1 1,1 0,-1 0,1 0,0 1,0-1,0 1,1 0,-1 0,1 0,0 1,0-1,-3 9,1-2,1 1,0-1,1 0,0 1,1 0,0 0,1 0,0 17,1-23,1-1,0 1,0-1,1 1,0-1,0 1,0-1,0 0,1 0,0 0,0 0,1 0,-1-1,1 1,0-1,0 0,0 0,0-1,8 6,-3-4,0 0,0 0,0-1,1 0,-1-1,1 0,0 0,17 2,-20-5,-1 1,1-1,-1 0,1 0,-1 0,1-1,-1 0,1-1,-1 1,0-1,0 0,0-1,0 1,9-6,-15 7,1 1,0 0,0-1,-1 1,1-1,0 1,-1-1,1 1,0-1,-1 0,1 1,-1-1,1 0,-1 1,1-1,-1 0,0 0,1 1,-1-1,0 0,0 0,1 0,-1 1,0-1,0 0,0 0,0 0,0 0,0 0,-1-1,0 1,0 0,0 0,0 0,0 0,0 0,0 0,0 0,0 0,0 0,-1 0,1 1,0-1,-3 0,-7-3,-1 0,1 1,-13-1,-7 0,0 2,-1 1,1 2,-1 1,1 1,0 1,0 2,0 2,1 0,-44 20,49-18,0-1,0-1,-1-1,-45 6,70-13,0 0,-1 0,1 0,0 0,0 1,0-1,-1 0,1 1,0-1,0 1,0-1,0 1,0 0,0-1,0 1,0 0,0 0,0 0,0 0,0 0,0 0,1 0,-1 0,0 0,1 0,-1 0,1 0,-1 0,1 0,0 1,-1-1,1 0,0 0,0 1,0-1,0 0,0 0,0 2,1 5,1 0,-1-1,1 1,6 14,-6-17,2 4,20 51,-21-54,0 0,1 0,-1-1,1 1,0-1,1 0,5 6,-10-11,0 0,0 1,1-1,-1 0,0 1,0-1,1 0,-1 0,0 1,1-1,-1 0,0 0,1 0,-1 1,0-1,1 0,-1 0,0 0,1 0,-1 0,1 0,-1 0,0 0,1 0,-1 0,1 0,-1 0,0 0,1 0,-1 0,0 0,1 0,-1-1,0 1,1 0,-1 0,0 0,1-1,-1 1,0 0,1 0,-1-1,0 1,0 0,1 0,-1-1,0 1,0 0,0-1,1 1,-1-1,0 0,1-1,-1 1,0-1,1 1,-1-1,0 0,0 1,0-1,0 1,-1-1,1 1,-1-3,-1 0,0 0,0 0,0 0,-1 0,1 0,-1 0,0 1,-1-1,1 1,0 0,-1 0,0 0,0 1,0-1,0 1,0 0,0 0,-8-2,-3-1,0 1,0 0,-1 1,-20-1,24 3,0 1,0 0,0 1,0 0,0 1,1 1,-1 0,1 0,-1 1,1 0,0 1,-14 9,19-11,1 1,-1 0,1 0,0 0,1 1,-1 0,1 0,0 0,0 0,0 1,1-1,-1 1,2 0,-1 0,1 0,-1 0,2 1,-1-1,1 1,0-1,0 1,1-1,0 13,1-16,-1 0,1 0,0 0,0 0,0 0,0 0,0 0,1-1,-1 1,1 0,0-1,0 0,0 1,0-1,0 0,0 0,1 0,-1 0,1 0,-1-1,1 1,4 1,7 3,0 0,1-1,20 4,-4-1,0 4,-1 2,0 0,-1 2,51 39,-66-46,31 24,-1 2,-2 2,-2 2,-1 2,42 56,-12-11,4-3,3-3,4-4,3-3,3-3,3-5,3-4,185 93,-117-83,4-6,3-8,1-7,323 51,-446-94,-1-2,89-2,-125-3,-1-1,0 0,0 0,0-1,0 0,0 0,12-6,-16 6,0 0,-1 0,1 0,-1 0,1 0,-1 0,0-1,0 1,0-1,0 0,0 0,0 1,-1-1,1 0,-1 0,0 0,0-1,1-4,0-6,-1 0,0 0,-1 0,0 0,-1 0,-1 0,0 1,-1-1,0 0,-6-14,2 9,-1 0,-1 1,-1 0,0 0,-2 1,-16-20,8 14,-1 2,-1 0,-1 1,-1 2,0 0,-2 2,0 0,0 2,-2 1,1 1,-2 1,1 2,-1 1,-1 1,1 1,-1 2,0 1,0 1,-60 5,43 3,-1 3,1 2,1 1,0 3,-65 30,23-2,-138 92,139-77,2 4,-141 136,209-181,1 0,1 2,0 0,1 0,-22 43,34-58,0 1,0-1,0 1,1-1,0 1,0 0,0 0,0-1,1 1,0 0,0 0,0 0,1 0,-1-1,1 1,0 0,3 6,-1-5,0-1,0 1,1-1,0 0,0 0,1 0,-1 0,1-1,0 0,0 0,1 0,-1-1,7 4,10 4,-1-1,2 0,45 11,86 9,82-8,-59-19,260-27,171-74,-361 40,-166 36,0-2,85-40,-145 54,30-19,-46 26,0-1,0 0,0 0,0-1,-1 1,0-1,0 0,0 0,5-8,-9 12,1-1,0 1,0-1,-1 1,1-1,-1 0,0 1,1-1,-1 0,0 1,0-1,0 0,0 1,0-1,0 0,-1 1,1-1,0 0,-1 1,1-1,-1 1,0-1,0 1,1-1,-3-1,0-1,0 1,-1-1,1 1,-1 0,0 0,0 0,-9-4,-2 0,0 0,-1 1,0 1,-29-6,-77-6,-2 8,0 5,-1 6,1 5,1 5,0 6,0 5,2 6,2 4,-174 74,230-78,1 2,-92 62,126-74,2 2,0 1,2 0,0 2,2 1,1 1,-24 36,37-50,1 1,1-1,0 1,1 0,0 1,1 0,0-1,1 1,1 0,0 0,1 23,1-28,1 0,1 0,-1 0,2 0,-1 0,1-1,0 1,1-1,0 0,1 0,-1 0,1 0,1-1,0 0,0 0,0 0,1-1,-1 0,11 6,0-1,-1-2,2 0,-1 0,1-2,1 0,-1-2,1 0,0 0,0-2,0-1,22 1,8-2,0-3,1-1,61-14,-49 4,-1-2,-1-3,-1-3,-1-2,-1-3,-1-2,57-38,-73 39,-1-2,-1-1,-2-2,-1-1,-2-2,-1-1,-1-2,-3-1,43-77,-57 88,-1 0,-2-1,-1-1,-1 0,-1-1,-2 1,-1-1,-2 0,-1-1,-1 1,-2 0,-1-1,-1 1,-2 0,-1 1,-2-1,0 1,-21-45,11 36,-2 1,-2 0,-1 2,-1 1,-3 1,0 1,-2 1,-2 2,-1 1,-65-46,67 55,0 2,-2 1,0 1,0 2,-1 1,-1 2,0 1,-1 2,0 1,0 2,0 1,-1 2,-57 4,47 4,0 2,0 2,1 2,0 1,1 3,1 2,1 1,-45 29,39-18,1 2,1 2,2 1,2 3,1 2,-46 59,66-73,2 2,0 1,2 0,2 1,0 1,2 0,-15 56,23-70,2 1,0 0,0 0,2 0,0 1,2-1,0 0,0 0,2 0,0 0,1 0,1-1,1 1,0-1,17 30,-9-26,0 0,2-1,1-1,0 0,1-2,1 0,0-1,2 0,-1-2,2-1,0 0,1-2,37 14,-18-10,1-3,1-1,-1-2,2-2,-1-2,86-2,-79-6,-1-2,1-2,-1-3,0-1,-1-3,0-2,-2-2,0-2,80-48,-81 39,-1-3,-1-1,-2-3,-2-1,-1-2,-1-1,-3-2,-2-2,29-48,-30 37,-3-2,-3-1,-2-1,-2-1,-3-1,17-98,-28 109,-2-1,-3 0,-1 0,-3 0,-2 0,-3 1,-1-1,-23-80,20 99,-2 1,-1 0,-1 1,-2 0,-1 1,-1 1,-1 0,-2 2,-37-38,43 50,-1 0,0 1,-1 1,0 0,-1 2,0 0,-1 1,0 1,0 0,-1 1,0 2,0 0,-1 1,1 1,-1 1,-29 0,32 3,1 1,-1 0,0 1,1 1,0 1,-1 0,2 1,-1 1,1 1,0 0,1 1,-16 11,19-10,0 0,1 0,0 1,1 0,0 1,1 0,1 1,0-1,0 2,1-1,1 1,0 0,1 1,-5 23,6-19,1 1,1 0,1 0,1 0,1 0,1-1,5 30,0-21,1 0,1-1,1 0,24 43,-9-28,2-1,1-1,2-1,2-2,70 63,-48-56,1-2,3-2,93 48,-40-35,133 46,-111-54,1-6,3-5,0-7,2-5,197 5,-295-27,65-7,-101 7,0-1,0-1,-1 1,1-1,-1 0,1 0,-1 0,1 0,-1-1,0 0,4-3,19-12,-16 14,0 1,0-1,0 2,0 0,0 0,1 1,-1 1,21 1,-8-1,24 0,65 7,-98-5,0 0,-1 1,1 1,-1 1,0 0,0 0,0 2,21 12,-31-16,1 1,-1-1,0 1,0 0,0 0,-1 0,1 1,-1-1,0 1,0 0,0 0,-1 0,0 0,0 0,0 0,-1 1,1-1,-1 1,-1-1,1 1,-1-1,0 1,0 0,-1-1,0 8,-5 10,0 0,-1-1,-1 1,-19 34,10-19,10-22,1 0,0 0,1 0,1 0,1 1,-3 26,6-34,0 0,1 0,0 0,0-1,1 1,0 0,0-1,1 1,0-1,1 0,0 0,0 0,1-1,8 12,-3-8,1 1,0-2,0 0,2 0,-1-1,1 0,0-1,0-1,1 0,0-1,1 0,-1-1,1-1,19 3,21 2,0-3,88-2,-137-4,-2 0,6 1,-1-1,1 0,0-1,-1 0,1-1,14-4,-57 54,5-8,2 0,-31 68,48-87,1 0,1 0,0 1,2 0,1 0,1 0,-1 42,4-50,-1-5,1 0,1 0,-1 0,2 0,-1 0,4 12,2-12,-3-15,-2-18,-5 8,-2 0,0 1,0-1,-1 1,-1 1,-1-1,-14-20,21 33,-1 0,0-1,0 1,0 0,0 0,0 0,0 0,0 1,-1-1,1 0,-1 1,1 0,-1-1,1 1,-1 0,0 1,0-1,0 0,1 1,-1-1,0 1,0 0,0 0,0 0,0 1,1-1,-1 0,0 1,0 0,0 0,1 0,-1 0,0 0,1 0,-1 1,1 0,0-1,-1 1,1 0,0 0,0 0,0 0,0 0,1 0,-1 1,-2 4,-4 9,0 0,1 1,0 0,2 0,0 1,1 0,1 0,0 0,0 34,4-47,-1 0,0 0,1-1,0 1,0 0,1 0,-1-1,1 1,0-1,0 1,1-1,-1 0,1 0,0 0,0 0,0 0,4 3,-4-4,0-1,0 0,0 0,1 0,-1 0,0 0,1-1,-1 1,1-1,-1 0,1 0,0 0,0-1,-1 1,1-1,0 0,0 0,-1 0,1-1,0 1,0-1,-1 0,5-2,-2 1,0-1,0 0,0-1,0 0,-1 1,0-2,1 1,-2-1,1 0,0 0,-1 0,0 0,0-1,-1 0,0 1,0-1,0-1,3-10,0-2,-1 0,-1 0,0-1,-2 0,1-22,-3 31,0 0,0 0,-1 1,0-1,-1 0,-1 1,-5-19,6 25,0 0,0 0,-1 0,1 0,-1 0,0 1,0-1,0 1,0 0,0 0,-1 0,0 0,1 1,-1-1,0 1,0 0,-1 0,1 1,0-1,-8-1,6 2,1 0,0 1,0-1,0 1,-1 0,1 1,0-1,0 1,0 0,-1 0,1 1,0-1,1 1,-1 1,0-1,-7 5,10-5,-1 0,0 0,1 0,-1 0,1 1,0-1,0 1,0 0,0 0,0 0,1 0,-1 0,1 0,0 0,0 0,0 0,0 0,0 1,1-1,0 0,-1 1,1-1,1 1,-1-1,0 0,2 7,-1-8,0 1,0 0,0-1,0 1,1-1,-1 1,1-1,-1 0,1 0,0 1,0-1,0 0,0-1,0 1,1 0,-1-1,0 1,1-1,0 0,-1 1,1-1,-1-1,1 1,0 0,0-1,4 1,-4 0,0-1,-1 0,1 0,0 0,-1-1,1 1,-1-1,1 1,0-1,-1 0,1 0,-1 0,0 0,1 0,-1 0,0-1,0 1,0-1,0 0,0 0,0 0,0 0,0 0,-1 0,1 0,-1 0,0 0,2-4,0-8,0 1,0-1,-2 1,1-1,-2 0,0 0,-3-22,1-31,2 65,0 0,0 0,0 0,0 0,0 1,1-1,-1 0,1 0,-1 0,1 0,0 0,0 0,0 1,0-1,0 0,0 1,0-1,1 1,-1-1,2-1,-1 3,-1-1,1 0,0 1,0-1,0 1,-1-1,1 1,0 0,0 0,0 0,0 0,-1 0,1 0,0 0,0 1,0-1,2 1,6 3,0 1,0-1,0 2,-1-1,15 12,-20-14,1 0,0 1,0-2,0 1,0-1,7 3,-11-5,-1 0,1 0,0 1,0-1,-1 0,1 0,0 0,0 0,0 0,-1 0,1 0,0-1,0 1,-1 0,1 0,0-1,0 1,-1 0,1-1,1 0,-1 0,-1 0,1 0,-1 0,1 0,-1 0,1 0,-1 0,1-1,-1 1,0 0,0 0,0 0,0-1,0 1,0 0,0 0,0 0,0-3,-2-7,-1 0,0 0,0 0,-1 0,-7-14,8 18,0 1,0 0,-1 1,0-1,0 1,0-1,-1 1,0 0,0 1,-6-6,10 10,1 0,-1-1,1 1,-1-1,1 1,-1 0,1-1,-1 1,0 0,1 0,-1 0,0-1,1 1,-1 0,0 0,1 0,-1 0,0 0,1 0,-1 0,1 0,-1 1,0-1,1 0,-1 0,0 0,1 1,-1-1,0 1,0 0,1 0,-1 0,0 0,1 0,-1 0,1 0,-1 0,1 0,0 1,-1-1,1 0,0 0,0 0,0 2,0 2,0 0,0 0,1 0,0-1,0 1,0 0,2 4,-1-6,-1 0,1 0,0 0,0-1,0 1,1-1,-1 1,0-1,1 0,0 0,-1 0,1 0,0 0,0-1,4 2,-5-2,0-1,0 1,0-1,0 0,1 0,-1 1,0-1,0-1,0 1,0 0,0 0,1-1,-1 0,0 1,0-1,0 0,0 0,0 0,-1 0,1 0,0 0,0-1,-1 1,1 0,1-3,5-6,0 0,-1 0,0-1,0 0,-1 0,-1-1,0 0,4-15,-2 2,-1-1,-1 1,2-29,-6 44,-1 0,0 0,-1-1,0 1,0 0,-6-17,7 25,-1 0,0 1,1-1,-1 1,0-1,0 0,0 1,0-1,0 1,0 0,0-1,-1 1,1 0,-1 0,1 0,0 0,-1 0,-1-1,1 2,0-1,0 1,0 0,0 0,0 0,0 0,0 1,0-1,0 1,0-1,0 1,0-1,0 1,1 0,-1 0,0 0,1 0,-1 0,0 0,-2 3,2-1,-1 0,0 0,1 0,-1 0,1 0,0 0,0 1,0 0,1-1,-1 1,1 0,0-1,0 1,0 0,0 0,0 5,1 3,-1 0,1-1,1 1,3 14,-3-20,0 0,1-1,-1 1,1-1,1 1,-1-1,1 0,0 0,0 0,1 0,-1-1,1 1,0-1,5 4,-7-5,1-1,0 0,0 0,0-1,0 1,0-1,1 1,-1-1,0 0,1 0,-1 0,1-1,-1 1,0-1,1 0,-1 0,1 0,-1-1,1 1,-1-1,1 1,-1-1,0 0,6-3,-7 3,0 0,0 0,0 0,0-1,0 1,0-1,0 1,-1-1,1 0,-1 0,1 0,-1 0,0 0,1 0,-1 0,0 0,0 0,0-3,1-3,0 0,-1 0,0 1,-1-10,1-3,9 50,-3-2,21 49,-21-59,-6-17,0 1,0 0,-1-1,1 1,-1 0,1 0,-1-1,0 1,1 0,-1 0,0 0,0-1,0 1,-1 0,1 0,0 0,-1-1,1 1,-1 0,0 0,1-1,-1 1,0 0,0-1,0 1,0-1,0 1,-1-1,-1 2,-7 11,8-11,0-1,1 1,-1 0,1 0,0 0,0 1,0-1,0 0,1 0,-1 1,1-1,0 0,0 0,0 1,0-1,1 0,-1 0,1 1,0-1,0 0,0 0,0 0,1 0,-1 0,1 0,-1 0,1 0,0-1,0 1,3 2,-4-5,-1 0,1 1,-1-1,1 1,-1-1,1 0,-1 1,1-1,-1 0,1 0,0 1,-1-1,1 0,-1 0,1 0,0 0,-1 0,1 0,0 0,-1 0,1 0,-1 0,1 0,0 0,-1-1,1 1,-1 0,1 0,0-1,0 1,0-2,0 1,0 0,0 0,0-1,0 1,0-1,0 1,0-1,-1 1,1-1,0-2,1-4,0 1,-1-1,1-16,-2 11,-1-1,0 1,-2 0,1 0,-1-1,-1 2,0-1,-1 0,-13-23,17 34,-1 0,1 1,0-1,-1 0,0 0,1 1,-1-1,0 1,0-1,0 1,0 0,0 0,0-1,0 2,-1-1,1 0,0 0,-1 1,1-1,0 1,-1 0,1 0,0-1,-1 2,1-1,0 0,-1 0,1 1,-4 1,-1 0,1 1,-1 0,1 0,0 0,0 1,0 0,1 0,-8 8,12-11,-1 0,1 1,0-1,0 0,0 0,-1 0,1 0,-1-1,1 1,0 0,-1 0,0-1,1 1,-1-1,1 1,-1-1,0 0,1 0,-1 0,1 0,-1 0,-3 0,3-1,0 0,0-1,0 1,1 0,-1 0,0-1,1 1,-1-1,1 0,-1 1,1-1,0 0,-1 0,1 0,0 0,-1-3,-4-13,0-1,1 0,0 1,-2-38,2 20,-2-15,2 0,2 0,7-83,-4 131,1 0,0 0,0 0,0 0,0 0,0 1,0-1,1 0,0 1,-1-1,1 1,3-4,30-25,-6 6,18-20,-26 26,24-28,-42 41,1 1,-2 0,1-1,0 0,-1 1,0-1,-1 0,1 0,-1 0,1-12,-2 12,1-1,0 1,0 0,0 0,1-1,0 1,0 0,1 0,0 1,6-11,-4 11,1 0,-1 0,1 0,0 1,0 0,0 0,1 0,9-3,-11 5,0 0,0 0,0 0,0-1,0 0,-1 0,0 0,1-1,-1 1,-1-1,1 0,0 0,-1 0,0-1,0 1,0-1,3-6,-4 5,0 0,1 0,0 1,0-1,7-9,-9 14,0 0,-1 0,1 0,0 0,0 0,0 1,0-1,0 0,0 1,0-1,0 1,0-1,0 1,0-1,0 1,0 0,0-1,0 1,0 0,1 0,-1 0,0 0,0 0,0 0,0 0,0 1,0-1,1 0,-1 1,0-1,0 0,0 1,0-1,0 1,0 0,0-1,0 1,0 0,-1-1,3 3,-1-1,0 1,0 0,-1-1,1 1,0 0,-1 0,0 0,1 0,-1 0,0 1,-1-1,1 0,0 4,1 48,-2-41,0 38,-3 132,2-182,1 0,0 0,-1 0,1 0,-1 0,0 0,0 0,1 0,-1-1,0 1,-1 0,1-1,0 1,0-1,-1 1,1-1,-1 0,1 1,-1-1,0 0,-3 2,-2 0,-1 0,0 0,0-1,-9 2,-12 4,17-4,-1 1,1 0,0 1,-17 10,25-12,-1 0,1 0,-1 0,1 0,0 1,1-1,-1 1,1 0,0 0,0 0,1 1,-4 8,-1 6,2 1,0 0,1-1,-1 24,4-34,1 0,0 0,0-1,1 1,1 0,-1-1,1 1,1-1,0 0,0 0,6 10,-9-17,1-1,0 0,0 1,-1-1,1 0,0 0,0 1,0-1,1 0,-1 0,0 0,0-1,0 1,1 0,-1 0,1 0,-1-1,0 1,3 0,-3-1,1 0,-1 0,0-1,1 1,-1 0,1 0,-1-1,0 1,0-1,1 1,-1-1,0 0,0 1,1-1,-1 0,0 0,1-1,3-4,1 0,-1 0,-1 0,1-1,-1 0,3-7,2-5,-1-1,-1 0,0 0,-2-1,0 1,-2-1,0 0,-1 0,-1-1,-4-39,1 120,1-61,0 1,0-1,0 1,0-1,0 1,0 0,0-1,0 1,-1 0,1 0,-1 0,1 0,0 0,-1 0,0 0,1 0,-3 0,-33-14,24 14,1-1,-1 2,0-1,0 2,1 0,-25 5,-16 1,-98-2,-430-10,-17 0,507 6,12-2,-1 4,-106 18,164-15,1 0,0 2,1 0,-28 16,-21 9,66-32,0 1,-1-1,1 1,0 0,1 0,-1 0,0 0,1 1,-1-1,1 1,0 0,-1-1,1 1,1 0,-1 0,0 0,1 0,-1 1,-1 5,2-3,0 0,0 1,1-1,0 0,0 0,0 1,1-1,-1 0,2 0,1 9,-2-14,-1 0,1 0,-1 0,1 0,-1 0,0 1,0-1,1 0,-1 0,0 0,0 1,0-1,0 0,0 0,-1 0,1 1,0-1,-1 0,1 0,0 0,-1 0,0 0,1 0,-1 0,1 0,-1 0,0 0,0 0,0 0,0 0,1 0,-1-1,0 1,0 0,-1-1,1 1,0-1,0 1,0-1,0 1,0-1,0 0,-1 1,0-1,-8 1,-1-1,1 0,0 0,-17-4,12 2,-676-61,535 57,0 8,-226 30,235-5,0 7,3 5,1 7,-222 104,351-143,-133 68,127-64,0 2,1 0,1 2,-30 28,46-41,-1 1,1 0,-1 0,1 0,0 1,0-1,0 1,1-1,-1 1,1-1,0 1,0 0,0-1,0 1,1 0,-1 0,1 0,0 0,0-1,1 1,-1 0,1 0,1 4,0-3,0 0,1 0,-1 0,1 0,0-1,1 1,-1-1,1 1,0-1,0-1,0 1,0 0,1-1,-1 0,7 3,3 2,0-2,1 0,-1-1,1 0,0-1,0-1,0 0,28 1,-22-4,0-1,1-1,-1 0,0-2,39-11,-32 5,-1-1,-1-1,0-1,0-1,-1-2,-1 0,-1-1,0-2,32-33,-35 28,-1 0,-1-1,0-1,-3 0,0-1,-1-1,11-35,-17 40,-1-2,-1 1,-1-1,-1 0,-1 0,-1 0,-2 0,0 0,-5-31,2 43,1 0,-2 0,1 1,-2-1,0 1,0 0,-1 0,-1 1,0-1,0 1,-17-18,11 16,0 1,-1 1,0 1,0 0,-1 0,0 2,-1 0,-17-7,0 4,1 0,-2 3,-47-8,-96 3,165 13,-18-1,-1 1,1 1,-58 11,79-10,1 1,0-1,0 2,0-1,0 1,0 0,-13 11,17-12,-1 1,1 0,1 0,-1 1,0-1,1 1,0 0,0 0,1 0,-1 0,1 0,0 0,-1 9,0 2,1 0,0 0,1 1,1-1,1 1,0-1,2 0,-1 0,2 0,0 0,8 18,0-3,2-1,1 0,1-1,31 42,-30-49,1 1,2-2,0-1,1 0,0-2,2 0,0-1,1-2,1 0,36 15,-57-29,0 1,1-1,-1 1,0-1,1-1,-1 1,9 0,-11-2,-1 1,1 0,-1-1,0 1,1 0,-1-1,0 0,1 1,-1-1,0 0,0 0,1 0,-1 1,0-1,0 0,0-1,0 1,0 0,-1 0,1 0,0 0,0-1,-1 1,1 0,-1-1,1 1,0-3,1-8,0 0,0 0,-1 0,-1 0,0 0,0 0,-1 0,-1 0,-4-18,0 8,-1-1,-1 1,-1 1,-13-24,4 15,-1 0,-2 2,0 0,-2 2,-1 0,-53-42,37 38,-2 1,-1 2,-1 2,-56-23,66 34,0 2,0 1,-50-9,64 17,1 1,-1 0,1 1,-1 1,1 1,-1 1,-37 9,53-10,-1 2,0-1,0 0,1 1,0 0,-1 0,1 0,0 1,1 0,-1-1,0 1,1 0,-5 8,-1 2,1 0,-12 31,11-25,2 1,-6 26,12-41,-1 0,2 0,-1 0,1 0,0 0,0 0,0 0,1 0,0 0,0 0,1 0,0 0,2 6,1-5,-1 0,1 0,0 0,1 0,-1-1,1 0,1 0,-1-1,1 0,0 0,0 0,0-1,15 6,-1-1,1-1,0-2,1 0,23 2,4-2,0-2,1-3,-1-2,0-2,95-19,-49 1,-2-5,98-41,-116 37,-2-4,-1-3,92-63,-131 76,0-1,-2-2,-1-1,-1-1,-2-2,-1-1,-1-1,29-51,-43 63,-1-1,-1 0,-2-1,0 0,-1-1,5-34,-10 43,-1 0,0 0,-1-1,-1 1,0 0,-1-1,-1 1,0 0,-1 0,-1 1,-7-19,2 14,-1 1,0 0,-1 1,-1 0,-1 0,0 2,-1 0,0 0,-2 1,1 1,-2 1,1 1,-2 0,-26-11,18 11,0 1,-1 1,0 1,0 2,-1 0,1 3,-1 0,0 1,0 2,-30 4,16 2,2 2,-1 2,1 1,0 2,1 2,1 2,0 2,2 1,0 1,1 3,2 1,-37 32,59-46,1 1,0 0,0 0,1 1,1 0,0 1,0 0,2 0,0 1,0 0,-7 29,12-34,0 0,0 1,1-1,0 1,1-1,0 1,1 0,0-1,1 1,0-1,0 0,1 0,1 0,0 0,0 0,1-1,0 1,0-1,8 9,-1-5,0 0,0-2,1 1,1-1,0-1,1-1,-1 0,2-1,-1 0,1-1,32 9,-4-5,1-1,0-2,65 3,-27-8,0-5,-1-2,0-5,0-3,82-23,-62 7,-3-5,0-3,145-78,-193 86,-1-1,-2-4,0-1,82-79,-109 91,0 0,-2-1,-1-2,-1 0,-1 0,-2-2,0 0,-2 0,0-1,-3-1,10-41,-14 44,-2-1,-1 0,0 0,-3-1,0 1,-1 0,-2 0,-1 1,-1-1,-1 1,-1 0,-2 1,-15-32,13 35,-1 0,-1 1,0 1,-2 0,0 1,-1 1,-1 0,-1 1,0 1,-1 1,-1 1,0 1,-1 1,-36-16,21 15,-1 2,-1 1,1 2,-1 2,-41-1,-10 4,-98 9,184-6,0 0,-1 1,1 0,-1 0,1 0,0 0,0 0,-1 1,1 0,0 0,-4 2,6-1,-1-1,1 0,0 1,-1-1,1 1,1 0,-1 0,0 0,1 0,-1 0,1 0,0 0,0 1,-1 5,-1 4,1 0,1 0,0 1,1-1,0 0,1 0,1 0,0 0,0 0,2 0,-1-1,2 1,-1-1,9 15,-7-17,0 0,1-1,0 1,0-1,1-1,0 0,0 0,1 0,0-1,1 0,-1-1,1 0,0-1,1 0,-1 0,17 4,-15-5,0-1,0-1,1 0,-1 0,1-1,-1-1,0 0,14-2,-22 1,1 0,-1 0,0 0,0-1,0 1,0-1,0 0,0-1,0 1,-1-1,1 1,-1-1,1 0,-1 0,0 0,0-1,-1 1,1-1,-1 0,0 1,0-1,0 0,0-1,-1 1,3-8,-1-2,-1-1,-1 1,0 0,-1-1,0 1,-1 0,-1-1,0 1,-1 0,-1 0,0 0,0 1,-11-22,-3-1,-2 1,-1 1,-42-53,-76-74,133 153,0 1,0 1,0-1,-1 1,-10-8,14 13,1-1,0 1,0 0,0 0,-1 0,1 0,0 1,-1-1,1 1,-1-1,1 1,-1 0,1 0,0 0,-1 0,1 0,-1 1,1-1,-1 1,1-1,0 1,-1 0,1 0,-4 3,-2 1,0 1,1 0,0 0,0 1,1 0,-1 0,1 0,1 1,0 0,-7 13,-3 11,-17 50,27-69,-20 60,4 1,2 1,4 1,4 0,-4 124,15-191,-1 4,1 1,1-1,1 1,3 16,-5-27,1-1,-1 0,1 0,0 0,0 0,-1 0,1 0,1 0,-1 0,0 0,0 0,1-1,-1 1,1 0,-1-1,1 1,0-1,0 0,-1 1,1-1,0 0,0 0,0 0,0-1,0 1,1 0,-1-1,0 1,0-1,0 0,1 0,-1 0,3 0,4-2,0 1,0-2,0 1,-1-1,1-1,-1 0,0 0,0 0,11-9,9-8,27-26,-52 45,27-26,-1-1,-1-1,30-42,-47 56,0 0,-2-1,0-1,0 1,-2-1,0-1,-1 1,-1-1,2-20,-6 35,0 0,-1 1,0-1,0 0,0 0,0 0,-1 0,1 0,-1 1,0-1,0 0,-1 0,1 1,-1-1,1 1,-1-1,-3-2,2 3,0-1,-1 1,1 1,-1-1,0 0,1 1,-1 0,0 0,-1 0,1 0,0 1,-1-1,1 1,-6 0,-3-1,0 1,-1 1,1 0,0 1,-1 0,1 1,0 1,0 0,0 0,0 2,1-1,-1 2,-12 7,1 0,0 2,1 0,1 2,1 0,-29 31,28-25,2 2,1 0,0 1,2 1,2 1,-14 31,19-36,2 1,0 0,2 0,0 0,2 1,1-1,1 1,1 33,2-45,0-1,2 0,-1 1,2-1,-1 0,2 0,-1-1,2 0,-1 1,2-2,-1 1,2-1,-1 0,19 18,19 15</inkml:trace>
</inkml:ink>
</file>

<file path=ppt/ink/ink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4.482"/>
    </inkml:context>
    <inkml:brush xml:id="br0">
      <inkml:brushProperty name="width" value="0.05" units="cm"/>
      <inkml:brushProperty name="height" value="0.05" units="cm"/>
      <inkml:brushProperty name="color" value="#66CC00"/>
      <inkml:brushProperty name="ignorePressure" value="1"/>
    </inkml:brush>
  </inkml:definitions>
  <inkml:trace contextRef="#ctx0" brushRef="#br0">304 42,'0'-1,"0"-1,0 1,-1-1,1 1,-1-1,0 1,1 0,-1-1,0 1,0 0,0 0,0-1,0 1,0 0,0 0,0 0,0 0,0 0,-1 0,1 1,0-1,-1 0,1 1,-1-1,1 0,-3 1,-40-10,42 10,-6-1,-1 0,1 1,-1 0,0 0,1 1,-1 1,1-1,-1 1,1 1,0-1,0 1,0 1,0 0,0 0,1 0,0 1,0 0,0 1,0-1,1 1,0 0,0 1,-7 10,8-8,0-1,0 1,1 0,0 1,1-1,0 1,0-1,1 1,1 0,-2 16,2-15,1 0,1 1,-1-1,2 0,-1 0,2 0,-1 0,1-1,7 15,-7-18,1-1,1 0,-1 1,1-1,0-1,1 1,-1-1,1 0,0 0,0-1,12 7,-14-8,0-1,1 0,-1 0,0 0,1-1,-1 0,1 0,0 0,-1 0,1-1,0 1,-1-1,1-1,0 1,0 0,-1-1,1 0,-1 0,9-4,1-3</inkml:trace>
</inkml:ink>
</file>

<file path=ppt/ink/ink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8.139"/>
    </inkml:context>
    <inkml:brush xml:id="br0">
      <inkml:brushProperty name="width" value="0.05" units="cm"/>
      <inkml:brushProperty name="height" value="0.05" units="cm"/>
      <inkml:brushProperty name="color" value="#66CC00"/>
      <inkml:brushProperty name="ignorePressure" value="1"/>
    </inkml:brush>
  </inkml:definitions>
  <inkml:trace contextRef="#ctx0" brushRef="#br0">1321 261,'-23'-3,"21"2,-1 0,1 1,0-1,0 1,-1 0,1-1,0 1,0 0,-1 0,1 1,0-1,0 0,-1 1,-3 1,3 0,0 0,0-1,0 2,0-1,0 0,1 1,-1-1,1 1,-1 0,1 0,0 0,0 0,0 0,1 0,-1 0,1 1,0-1,0 1,0-1,-1 7,0 3,0 0,2 0,-1 0,3 20,-1-24,1 0,0 0,1-1,0 1,0 0,1-1,0 0,1 0,-1 0,2 0,7 8,-5-6,1 0,1 0,0-1,0-1,1 0,0 0,14 7,-19-12,1 0,0 0,0-1,0 1,0-2,1 1,-1-1,0 0,1-1,-1 1,0-2,1 1,8-2,-5 0,-1-1,0 0,-1-1,1 0,-1 0,1-1,-1 0,15-12,-12 7,1-1,-2 0,0-1,0 0,-1-1,0 0,-1-1,-1 0,0 0,-1-1,0 0,4-18,-8 22,0 0,-1-1,-1 1,1-1,-2 1,0-1,0 1,-1-1,-1 1,-5-22,4 23,-1 1,1 0,-2 0,1 0,-2 0,1 1,-1 0,0 0,0 1,-1-1,0 1,-1 1,-8-7,1 4,-1-1,0 2,0 0,-1 1,0 1,-1 0,1 2,-1 0,0 0,0 2,0 0,-1 1,1 1,-35 5,48-4,1 0,-1 0,0 0,1 1,-1-1,1 1,-1 0,1 1,0-1,0 1,0 0,0 0,1 0,-1 0,1 1,0 0,0-1,0 1,0 0,1 0,-1 1,1-1,0 0,0 1,-1 6,0 3,-1 0,2 0,0 1,1-1,0 1,2-1,1 18,-1-26,0-1,0 0,0 0,1 0,-1 0,1-1,1 1,-1 0,1-1,-1 1,1-1,1 0,-1 0,0 0,1-1,0 1,0-1,0 1,0-2,1 1,-1 0,1-1,0 0,7 3,-8-3,0-1,1 0,-1-1,0 1,0-1,0 1,0-1,1-1,-1 1,0 0,0-1,0 0,0 0,0 0,0-1,0 1,0-1,0 0,-1 0,1 0,-1-1,1 1,-1-1,0 0,0 0,0 0,0 0,-1 0,1-1,2-5,-1 1,-1 1,0-1,0 0,-1 0,0-1,0 1,-1 0,0-1,0 1,-1-1,-1 1,1-1,-1 1,0-1,-1 1,0 0,-1 0,1 0,-1 0,-1 0,0 0,0 1,0 0,-1 0,0 0,0 0,-10-8,7 8,0 0,0 1,-1 0,1 1,-1 0,-1 0,1 1,-1 0,0 1,0 0,0 0,0 1,0 0,0 1,-1 1,1-1,0 1,-1 1,1 0,-20 5,27-5,0 0,0 0,0 1,0 0,0-1,1 1,-1 0,1 0,0 0,-1 1,1-1,0 1,0-1,0 1,1-1,-1 1,1 0,-1 0,1 0,0 0,0 0,0 0,0 0,1 0,0 1,-1-1,1 6,0 1,1 0,-1-1,2 1,-1-1,1 1,1-1,0 1,5 11,-1-9,0 0,0 0,1-1,1 0,0-1,0 0,1 0,0-1,1-1,0 1,0-2,1 1,0-2,16 7,-16-7,0-2,0 0,0 0,1-1,-1-1,1 0,0 0,0-2,0 1,-1-2,1 0,0 0,0-1,-1-1,19-5,-26 6,-1 0,1 0,0-1,-1 1,0-1,1 0,-1-1,0 1,-1-1,1 1,-1-1,1 0,-1 0,0-1,-1 1,1-1,-1 1,0-1,0 0,0 0,-1 0,3-10,-4 9,1-1,-1 0,0 1,-1-1,1 0,-1 1,0-1,-1 1,0-1,0 1,0 0,-1 0,0 0,0 0,-1 0,1 1,-8-9,-2-1,-1 2,-1 0,1 1,-2 1,0 0,0 1,-30-14,32 18,0 0,-1 1,1 1,-1 0,0 1,0 0,0 2,-1-1,1 2,-20 1,31 0,0 0,0 0,1 0,-1 0,0 0,1 1,-1 0,1 0,0 0,-1 0,1 0,0 0,0 1,1 0,-1-1,0 1,1 0,0 0,-1 1,1-1,1 0,-1 1,0-1,1 1,0 0,-1-1,0 7,-1 9,0 0,2 0,0 0,1 25,1-26,-1-5,0-1,2 0,-1 0,1 0,1 0,4 12,-6-20,1-1,-1 1,1-1,0 0,0 1,0-1,0 0,1 0,-1-1,1 1,0 0,0-1,0 1,0-1,0 0,0 0,1 0,-1-1,1 1,-1-1,1 0,0 0,5 1,-5-1,0-1,0 1,0-1,0 0,0 0,0 0,0-1,0 1,0-1,-1 0,1 0,0 0,6-3,-8 2,0 1,0-1,0 0,0 0,0 0,-1 0,1 0,-1-1,1 1,-1 0,0-1,1 1,-1-1,-1 1,1-1,0 0,-1 1,1-1,-1 0,0 1,0-4,0-3,0 1,-1 0,-1-1,0 1,0 0,0 0,-1 0,0 0,0 1,-1-1,0 1,-9-12,5 8,0 1,0 0,-1 0,0 1,-1 0,0 1,-18-12,24 18,1 0,-1 0,0 0,0 0,0 1,0-1,0 1,0 0,0 1,0-1,-1 1,1-1,0 1,0 0,-1 1,1-1,0 1,0 0,0 0,0 0,0 1,-5 1,3 1,-1 0,1 1,1 0,-1 0,0 0,1 0,0 1,1 0,-1 0,1 1,-6 11,1 0,1 0,1 1,1 0,-6 28,9-34,1 1,0 0,1-1,1 1,0 0,1 0,4 17,-4-25,0-1,1 0,0 0,0 0,0-1,1 1,-1 0,1-1,0 0,0 0,1 0,0 0,-1 0,1 0,0-1,1 0,-1 0,0 0,1 0,0-1,0 0,0 0,-1 0,2-1,-1 1,0-1,7 0,4 1,-1-1,1-1,-1 0,1-2,-1 1,1-2,-1 0,18-7,-28 9,-1-1,1 0,-1 0,0 0,0 0,0-1,0 1,0-1,-1 0,1-1,-1 1,0 0,0-1,0 0,0 0,-1 0,0 0,1 0,-1 0,-1-1,1 1,-1-1,1 1,-1-1,-1 1,1-1,-1 0,0-6,0 2,0 0,-1 0,-1-1,0 1,0 0,-1 0,1 1,-2-1,0 0,0 1,0 0,-1 0,-9-12,-1 4,-1 0,-1 1,0 0,-1 1,0 1,-1 1,0 1,-1 1,-1 0,0 1,0 2,0 0,-1 1,0 1,0 1,0 1,-1 1,1 1,0 1,-1 1,-41 7,55-5,-1 0,0 0,1 1,0 1,0-1,0 2,1-1,-1 1,1 0,1 1,-1 0,1 0,0 1,1-1,0 2,0-1,1 0,-7 14,4-5,1 0,1 1,0 0,1 0,1 0,1 0,1 1,0-1,1 24,2-29,0 1,1-1,1 0,0 0,0 0,2-1,-1 1,1-1,1 0,1-1,-1 1,2-1,-1 0,2-1,-1 0,15 13,-11-13,0 0,1 0,0-2,1 0,-1 0,2-1,-1-1,1 0,0-1,0-1,0 0,0-1,25 2,-29-4,0-1,0 0,0-1,0 0,0-1,0 0,-1 0,1-1,18-8,-22 7,1 0,-1-1,0 0,0 0,-1-1,0 0,0 0,0 0,0-1,-1 1,0-1,-1-1,6-9,-5 7,-1-1,0 1,0-1,-1 0,0 0,-1 0,0 0,-1 0,0-1,-1 1,-1 0,1-1,-2 1,1 0,-1 0,-1 0,-4-12,0 7,-1 0,0 0,-1 1,0 0,-1 0,-1 1,0 1,-1 0,-1 0,-19-14,8 9,0 2,-2 1,0 1,0 1,-2 1,1 1,-1 2,-1 1,0 1,0 1,0 2,0 1,-1 1,-45 3,55 1,1 0,0 2,0 0,0 1,0 0,1 2,0 0,0 2,1-1,-22 16,18-9,1 2,0 0,2 0,0 2,0 1,2 0,-16 25,11-8,0 0,3 2,1 0,2 1,2 0,1 1,2 0,2 1,-3 56,10-80,1 0,1-1,0 1,2 0,0 0,1-1,0 1,2-1,0 0,0-1,2 0,11 18,-5-12,1-1,1 0,1-2,1 0,1 0,1-2,36 25,-13-14,1-2,0-3,2-1,1-2,1-3,0-1,97 17,-96-25,0-3,0-2,0-2,0-2,1-2,-1-2,-1-3,58-16,-78 16,-1-2,0-1,0-1,-1-1,-1-2,0 0,-1-2,-1 0,0-2,39-41,-51 46,0 1,-2-2,1 1,-2-1,0 0,-1-1,0 0,7-26,-11 28,-1-1,0 1,0-1,-2 0,0 1,0-1,-2 0,0 1,0-1,-9-27,2 18,-1 1,-1 0,-1 1,-1 0,0 1,-2 0,0 2,-2-1,0 2,-1 0,-1 1,0 1,-26-16,24 19,-1 0,0 1,0 1,-1 1,-1 1,0 1,0 2,0 0,-1 1,0 2,0 0,0 2,-32 2,51-1,1 1,0 0,0 0,0 1,0 0,0 0,0 0,0 0,1 1,-1 0,1 0,-1 0,1 0,0 1,1-1,-1 1,1 0,-1 0,1 1,0-1,1 0,-1 1,1 0,0 0,0 0,-2 5,-1 12,0 0,0 0,2 0,0 41,2-55,1 1,1-1,-1 1,1-1,1 1,-1-1,2 1,-1-1,6 13,-6-17,1-1,-1 1,1-1,-1 1,1-1,0 0,0 0,1 0,-1 0,1-1,-1 1,1-1,0 0,0 0,0 0,0-1,0 1,0-1,0 0,7 1,1 0,0-1,-1 0,1-1,0-1,0 1,0-2,-1 0,1 0,-1-1,1 0,-1-1,0 0,0-1,-1 0,1-1,-1 0,13-11,-11 6,0 0,-1-1,0 0,0-1,-2 0,1-1,-2 1,0-2,0 1,-2-1,10-31,-10 25,-1 0,-1-1,-1 1,-1-1,-1 0,-1 0,-1 1,-1-1,0 0,-2 1,-1 0,0 0,-1 0,-2 0,0 1,-1 0,-1 1,-1 0,-22-30,31 47,1 0,-1 0,0 0,0 0,0 0,0 0,-1 0,1 1,0-1,-1 1,-3-2,5 3,0 0,0 0,0 0,0 0,0 0,-1 0,1 0,0 0,0 1,0-1,0 0,0 1,0-1,0 1,0-1,0 1,0-1,0 1,0-1,1 1,-1 0,0 0,0 0,1-1,-1 1,0 0,1 0,-1 0,1 0,-1 2,-6 9</inkml:trace>
</inkml:ink>
</file>

<file path=ppt/ink/ink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1:55.243"/>
    </inkml:context>
    <inkml:brush xml:id="br0">
      <inkml:brushProperty name="width" value="0.35" units="cm"/>
      <inkml:brushProperty name="height" value="0.35" units="cm"/>
      <inkml:brushProperty name="color" value="#33CC33"/>
      <inkml:brushProperty name="ignorePressure" value="1"/>
    </inkml:brush>
  </inkml:definitions>
  <inkml:trace contextRef="#ctx0" brushRef="#br0">3927 2864,'22'0,"30"5,6 2,95 2,75-1,348-3,1-43,-311 0,-215 27,-1-2,-1-2,51-23,-82 29,0 0,0-1,-1 0,0-1,19-17,-31 23,1-1,-1 1,1-1,-1 0,-1 0,1 0,-1-1,0 0,-1 0,0 0,0 0,0 0,-1 0,0-1,0 0,0-7,-2 9,-1 1,1-1,-1 1,0-1,-1 0,1 1,-1 0,0-1,0 1,-1 0,1 0,-1 0,-1 1,1-1,0 1,-1-1,0 1,0 1,0-1,-8-5,-4-2,0 1,0 0,-1 1,0 1,-19-6,-21-4,-2 1,1 4,-64-7,-181-2,-20 23,277 3,1 2,-1 1,1 3,0 1,-44 19,66-20,1 1,0 1,0 2,1 0,1 1,0 1,1 0,1 2,1 0,0 1,1 1,-16 28,15-20,1 1,2 0,1 1,2 1,0 0,2 0,2 1,-7 64,8-4,5-1,10 94,-9-182,0 1,0-1,0 1,1-1,0 1,0-1,0 0,0 0,0 1,1-1,-1 0,1 0,4 5,-6-8,0 0,0 1,0-1,1 0,-1 0,0 0,0 0,1 0,-1 0,0 1,0-1,1 0,-1 0,0 0,0 0,1 0,-1 0,0 0,0 0,1 0,-1 0,0 0,0 0,1-1,-1 1,0 0,0 0,1 0,-1 0,0 0,0 0,1-1,-1 1,0 0,6-11,0-15,-4 13,-1 0,0 0,-1 0,0 0,-1 0,-1 0,0 0,-1 1,0-1,-1 1,0-1,-8-13,4 11,-1 0,-1 1,0 0,0 1,-2 0,0 0,0 1,-26-19,22 21,0 0,-1 0,0 2,0 0,-1 1,0 0,0 2,-27-5,4 4,0 1,-76 3,98 3,0 0,0 2,1 0,-1 1,1 1,0 0,0 2,0 0,1 1,-19 12,22-12,2 1,0 1,0 0,0 1,1 0,1 0,0 1,1 1,0 0,1 0,0 0,-11 27,15-29,1 0,-1 1,2-1,0 0,0 1,1 0,0-1,1 1,0 0,1-1,0 1,1-1,5 18,-3-17,1 0,0 0,1-1,0 1,1-2,0 1,1-1,0 0,1 0,0-1,0 0,14 9,-5-5,2-1,-1-1,1-1,1-1,0-1,0-1,0-1,1 0,0-2,25 2,0-1,1-3,0-3,79-9,-68 1,-1-2,67-22,-96 23,0-1,0-1,-1-2,0-1,49-35,-72 46,1-1,-1 0,0 0,0-1,0 0,-1 1,1-2,-1 1,-1 0,1-1,-1 1,3-11,-5 13,0 0,-1-1,1 1,-1-1,0 1,0 0,0-1,0 1,-1-1,0 1,0 0,0 0,0-1,-1 1,0 0,0 0,0 0,0 1,0-1,-1 0,-4-4,-4-3,0 1,-1-1,0 2,-1 0,0 1,0 0,-25-10,4 4,-1 1,-40-8,12 7,0 3,-115-6,128 16,0 3,1 1,0 3,-59 14,90-15,2 0,-1 1,1 1,-1 0,2 1,-1 1,1 0,1 1,-14 13,21-18,2 1,-1 0,0 0,1 0,0 1,1-1,0 1,0 1,0-1,1 0,0 1,0 0,1-1,0 1,0 0,1 0,0 0,0 1,1-1,0 0,2 14,1-8,1-1,0 0,1 1,1-2,0 1,0-1,2 0,-1 0,16 18,3 0,2-1,37 30,-16-19,2-3,2-1,1-3,1-3,2-1,0-4,2-1,1-4,1-2,93 15,-128-29,1-1,-1-2,1 0,-1-2,39-6,-52 4,0 0,0 0,-1-1,1-1,-1 0,0-1,0 0,-1-1,0 0,0-1,0 0,16-17,-11 5,0 0,-1 0,-1-2,-2 0,0 0,-1-1,-1-1,7-25,-7 17,-2-1,-1-1,-2 1,-1-1,-1-52,-4 68,-1 0,0 0,-2 0,0 1,0-1,-2 1,0 0,-1 0,-1 1,0 0,-1 0,-1 1,0 0,-1 1,-1 0,0 1,-1 0,-1 1,1 1,-2 0,0 0,0 2,-1 0,0 0,-26-8,16 7,-1 2,-1 1,1 2,-1 0,0 2,-1 0,1 3,0 0,-1 2,1 0,-31 9,42-7,0 1,0 1,1 0,-1 1,2 1,-1 1,1 0,-17 14,21-13,0 0,0 1,1 0,1 0,0 1,0 1,1-1,1 1,0 1,-8 22,7-12,1 0,2 1,0-1,1 1,2 0,0 0,2 0,1 0,1 0,1 0,1 0,1-1,14 43,-11-47,1 1,0-1,2 0,0-1,1 0,1-1,1-1,1 0,0 0,1-2,0 0,2-1,-1 0,2-2,36 20,-21-17,1-1,-1-2,2-1,0-2,69 8,-59-13,1-2,0-3,-1-1,58-11,-38 0,-1-3,0-4,-1-2,-1-2,-1-4,97-59,-90 42,-2-2,-2-4,-2-2,-3-3,61-73,-73 71,-3-3,-2-1,-3-1,-3-3,50-122,-74 153,-1 0,-2 0,-2-1,-1 0,-1 0,0-58,-6 76,-1-1,-1 1,0-1,-2 1,0 0,-1 0,0 1,-2-1,0 1,-1 1,-1-1,0 1,-1 1,-24-29,15 25,0 1,-2 1,0 1,-1 0,0 2,-2 0,1 2,-37-14,-5 3,-1 3,-75-13,22 11,0 4,-1 6,-212 5,185 22,125-11,0 1,0 1,0 1,-27 12,43-16,0 0,1 0,-1 1,1-1,-1 1,1 1,0-1,1 1,-1-1,1 1,0 1,0-1,0 1,1-1,0 1,0 0,0 0,1 0,0 1,0-1,1 0,0 1,0 0,0-1,1 1,0-1,1 8,0 6,0-1,2 1,1-1,0 0,1-1,1 1,10 21,-4-15,2 0,0-1,2-1,26 31,-4-12,3-3,1-1,1-2,69 43,-51-41,109 52,-127-72,1-1,1-2,73 14,-104-27,-1 0,1 0,-1-2,1 1,-1-2,1 0,-1-1,19-4,-24 4,0-1,-1 0,1-1,-1 1,0-2,0 1,0-1,-1 0,1 0,-1 0,0-1,-1 0,0-1,9-12,-3 1,-2 0,0-1,-1 0,-1 0,0-1,-2 1,0-2,-2 1,0 0,-1-1,-1 1,-1-1,0 1,-2-1,-5-26,-1 11,-1 1,-2 0,-1 1,-1 1,-2 0,-2 0,-37-54,27 49,-2 1,-1 2,-2 1,-1 1,-55-41,79 68,1 0,-1 1,-1-1,1 2,0-1,-16-3,22 7,0 0,-1 0,1 1,-1-1,1 1,-1 0,1 0,-1 1,1-1,-1 1,1-1,0 1,-1 0,1 0,0 1,-1-1,1 1,0-1,0 1,0 0,1 0,-6 5,1 1,0 0,0 1,0 0,1 0,1 0,-1 1,-3 12,-4 10,-7 35,0 19,3 2,4 0,4 1,4 0,13 174,-2-201,24 100,-22-133,1 0,1 0,1-1,2-1,22 37,-30-57,-1-1,1 1,1-1,-1-1,1 1,0-1,1 0,11 7,-17-11,1 0,0 0,0 0,0 0,0 0,0 0,0-1,0 1,0-1,0 0,0 1,0-1,0 0,0 0,0 0,0-1,0 1,0 0,0-1,0 1,0-1,0 0,0 0,0 0,-1 0,1 0,0 0,-1 0,1 0,0-1,-1 1,1-1,-1 1,0-1,0 1,0-1,1 0,0-2,-1 1,1 1,0-1,-1 0,0-1,1 1,-1 0,0 0,-1 0,1-1,-1 1,1 0,-1-1,0 1,0 0,-1-1,1 1,-1 0,1-1,-1 1,0 0,0 0,0-1,-1 1,1 0,-1 1,0-1,0 0,0 0,0 1,0-1,-1 1,1-1,-5-2,-1-1,-1 0,1 1,-1 0,0 1,0 0,-1 0,1 1,-1 0,0 1,-13-2,3 3,1 1,0 0,0 1,0 2,0 0,1 0,-1 2,1 0,0 2,0 0,1 0,0 2,0 0,-19 14,23-13,0 0,0 0,0 1,2 1,-1 0,2 0,-1 1,2 1,0-1,0 2,1-1,1 1,1 0,0 1,1 0,-6 28,10-34,1 0,0 0,0-1,1 1,1 0,-1 0,2 0,-1-1,1 1,1-1,0 0,0 0,0 0,1-1,1 1,-1-1,2 0,10 11,-5-7,1 0,0-1,1 0,1-1,-1 0,1-2,1 1,-1-2,31 10,-39-15,-1-1,1 1,0-1,-1-1,1 0,0 1,-1-2,1 1,0-1,-1 0,1-1,7-2,-4 0,0 0,0-1,-1 0,1 0,-1-1,16-14,-7 3,-1-1,-1-1,-1 0,0-1,-2 0,12-23,-10 13,-1 0,-2-1,-1 0,-2-1,11-59,-17 66,-1 1,-1-1,0 0,-2 0,-1 0,-1 1,-2-1,-9-33,9 45,0-1,-1 1,-1 0,0 1,-1-1,0 1,-14-15,15 20,0-1,-1 1,0 0,0 1,0 0,-1 0,0 0,0 1,-1 1,-18-7,22 10,0 0,0 1,0-1,0 1,0 1,0-1,0 1,0 0,1 0,-1 1,0-1,1 1,-1 1,1-1,-1 1,1 0,0 0,-6 5,-5 4,1 1,0 1,0 0,-13 18,6-3,0 1,2 1,1 1,2 1,1 0,2 1,-16 55,18-43,2 0,2 1,2 0,3 0,2 71,1-110,1 1,0-1,0 1,1-1,0 0,1 0,0 1,4 8,-5-13,0-1,0 0,1 0,-1 0,1 0,-1 0,1-1,0 1,0-1,0 0,1 1,-1-1,0-1,1 1,-1 0,1-1,0 0,-1 0,1 0,6 0,-1 0,1-1,-1 0,0 0,1-1,-1-1,1 0,-1 0,0-1,0 0,0 0,13-8,9-6,50-38,-15 4,-2-3,-3-3,-2-2,-3-3,84-120,-117 149,-2-1,-1 0,-2-2,-1 0,17-55,-30 76,0-1,-2 0,1 0,-2 0,0 0,-1 1,-2-18,0 21,0 1,-1 0,0 0,-1 0,0 1,0-1,-1 1,-1 0,0 0,-13-17,3 10,-1 0,-1 1,0 0,-1 2,0 0,-1 1,0 2,-1 0,-1 0,-25-7,0 3,-1 1,0 3,-97-10,73 17,-1 3,-136 15,-142 52,220-32,-207 81,274-88,1 3,2 3,1 2,1 3,-57 49,97-71,1 1,0 1,1 1,1 1,1 0,-19 31,28-38,0 0,0-1,2 2,-1-1,2 0,-1 1,2 0,0 0,1 0,0 0,1 0,0 0,4 15,0-10,0 0,2-1,0 0,1 0,1-1,1 0,0 0,1-1,1 0,1-1,0 0,1-1,0 0,21 16,5 1,0-3,2-1,2-2,63 27,-37-22,0-3,2-3,118 24,-144-40,-1-2,1-2,0-2,0-2,0-2,0-2,56-12,-82 12,1-2,-1 0,0-2,-1 0,0 0,0-2,-1 0,0-2,-1 1,-1-2,1 0,17-20,-25 23,0 0,0-1,-1 0,-1 0,0-1,0 1,-1-1,-1-1,0 1,0 0,-1-1,-1 0,0 0,-1 0,0 0,-1 0,0 0,-1 0,-1 0,-3-13,-1 7,0 0,-1 1,-1-1,-1 1,0 1,-2 0,0 0,-1 1,0 0,-1 1,-1 1,-21-18,4 7,-1 1,-1 2,-1 1,0 1,-53-20,34 20,0 2,-62-12,15 11,-2 5,-171-2,-211 45,280-1,-234 64,273-45,-284 120,218-54,194-91,0 1,2 2,-57 53,81-67,0 0,1 1,0 1,1-1,0 1,1 1,1 0,0 0,0 0,-6 26,10-29,1 0,1 0,0 1,0-1,1 0,0 1,1-1,0 1,1-1,1 0,0 0,0 0,1 0,0-1,7 13,-2-8,1 0,1 0,0-1,1 0,0-1,1 0,1-1,0-1,25 16,0-3,2-2,74 28,-33-21,1-4,1-3,1-4,1-4,0-3,1-5,-1-3,95-9,-130 1,0-1,0-3,0-3,-2-1,1-3,-2-2,86-44,-108 48,-1-2,-1-1,0 0,-2-2,0-1,-1 0,0-2,-2 0,-1-2,-1 0,-1 0,-1-2,-1 0,-1 0,9-30,-15 35,-1 0,-1 0,-1 0,-1-1,-1 1,-1-1,-1 0,0 1,-2-1,-1 0,0 1,-9-27,7 31,-2 1,0 0,0 0,-2 1,0 0,0 0,-2 1,0 1,0-1,-1 2,-1 0,0 0,0 1,-1 1,-31-17,7 8,-1 2,-1 2,0 2,0 1,-76-11,13 10,-129 2,77 13,1 7,0 7,-177 41,87 9,204-51,1 1,1 2,-66 42,91-51,0 0,1 1,0 1,1 0,0 0,0 1,1 0,-8 15,14-21,1 0,0 0,0 0,1 0,-1 1,1-1,1 1,-1-1,1 1,1 0,-1-1,1 1,0 0,0 0,1-1,0 1,0-1,1 1,0 0,0-1,4 9,-1-6,0-1,0 1,1-1,0-1,0 1,1-1,10 9,7 3,32 20,-7-10,55 26,116 33,-48-33,2-9,2-6,1-9,351 16,-421-45,211-25,-272 16,0-2,0-2,-1-2,0-2,-1-2,78-43,-102 48,-2-1,0-1,-1 0,0-1,-1-1,-1-1,0 0,-1-1,-1 0,15-31,-20 35,-1-1,-1 0,0-1,-1 1,-1-1,-1 0,0-1,-1 1,0 0,-2-1,0 1,0 0,-2-1,0 1,-4-16,3 21,-1 0,0 1,0-1,-1 1,0 0,-1 1,0-1,-1 1,0 0,0 1,-9-9,5 8,-1-1,0 2,-1 0,1 0,-2 1,1 0,-22-6,2 4,1 1,-1 2,0 1,-1 1,1 2,-60 5,30 3,1 3,0 2,1 4,0 2,1 2,1 3,1 3,2 2,0 3,2 2,-89 70,116-80,2 1,0 2,2 1,-33 45,46-57,2 1,-1-1,2 1,0 1,1-1,1 1,0 0,1 0,1 1,0-1,0 26,4-20,1 0,1 0,1-1,0 0,2 0,1 0,0 0,2-1,0 0,1-1,1 0,1-1,0 0,2-1,0 0,22 20,2-5,1-1,1-3,2-1,50 24,-5-10,107 35,-151-60,-1-3,2-1,0-3,0-1,55 2,-92-9,1-1,-1 0,0-1,1 0,-1 0,0 0,0-1,0 0,0-1,0 0,8-4,-11 4,0 0,0 0,-1 0,1 0,-1-1,0 0,0 1,0-1,0-1,-1 1,1 0,-1-1,0 1,0-1,-1 1,0-1,2-7,-1-1,0 0,-1 0,-1 0,0 0,0 0,-1 0,-1 0,-5-20,1 15,0 0,-1 1,0 0,-2 0,-14-22,2 10,-2 0,-1 1,-1 2,-1 0,-50-37,18 23,-2 2,-1 3,-1 3,-2 2,-1 4,-96-27,57 27,-1 4,0 5,-168-6,171 21,0 4,-140 23,187-16,0 2,1 3,1 3,1 1,0 3,-50 28,87-40,-1 1,1 0,1 0,0 2,1 0,0 0,-20 26,28-31,0 1,0 0,1 0,0 1,0-1,0 1,2 0,-1 0,1 0,0 0,1 0,0 1,0-1,1 0,0 1,3 14,-1-11,1 0,0 0,1 0,0-1,1 1,0-1,1 0,1 0,0-1,0 0,1 0,1-1,0 1,0-2,1 0,0 0,0-1,1 0,0 0,1-1,15 7,18 4,0-2,1-2,1-2,0-2,94 7,-131-16,-1-1,1 0,-1-1,1 0,-1 0,1-1,-1 0,0-1,0 0,13-6,-13 3,-1 1,1-2,-1 1,0-1,-1 0,1 0,-1-1,-1 0,9-13,1-4,-1-1,-2 0,0-1,-2 0,0-1,-2 0,-2-1,0 0,-2 0,-1 0,0-36,-4 42,-1-1,-1 1,-1 0,-1 0,-1 0,0 0,-2 1,-1 0,-1 0,-1 1,-1 0,0 1,-2 0,-28-35,17 30,-2 1,0 1,-2 2,0 0,-1 2,-1 1,-1 2,-1 0,-36-11,-3 3,-1 3,-1 3,-89-10,-105 5,231 22,0 3,0 0,0 3,0 0,-46 15,76-18,1 0,0 0,0 0,-1 0,1 1,1 0,-1 0,0 1,1-1,0 1,-1 0,2 0,-7 9,7-9,1 0,0 0,0 0,1 1,-1-1,1 1,0-1,0 1,1 0,-1-1,1 1,0 0,0-1,1 1,-1 0,1-1,2 6,2 8,1 1,1-1,1-1,0 0,2 0,0 0,0-1,18 19,-2-5,2-2,0-1,40 29,-16-20,1-2,1-2,2-2,1-4,1-1,67 18,-47-22,0-3,2-3,0-4,110 2,-137-13,1-3,0-1,-1-3,0-3,-1-1,0-3,0-3,65-30,-84 31,-1-1,-1-2,-1-2,0 0,39-40,-48 41,-2-2,0 0,-2-1,0-1,-2-1,-1 0,18-42,-26 50,1-1,-2 0,-1 0,0 0,-1-1,-1 1,-1-1,0 0,-4-32,1 40,0-1,0 1,-2-1,1 1,-1 0,-1 1,0-1,-1 1,0 0,0 0,-1 0,0 1,-1 0,0 1,0 0,-16-13,6 9,-1 1,0 0,-1 2,1 0,-2 1,-35-9,1 5,-81-8,45 13,-1 4,1 3,-1 5,1 4,0 4,1 3,1 5,0 3,2 5,1 3,-111 58,150-64,1 1,-78 63,106-75,0 1,1 1,1 1,1 0,1 0,0 2,1 0,-19 41,29-54,1 0,0-1,0 2,0-1,0 0,1 0,1 0,-1 1,1-1,0 0,1 1,0-1,2 11,0-11,-1 0,2 0,-1 0,1 0,0-1,0 1,0-1,1 0,0-1,1 1,-1-1,1 0,7 5,7 3,0-1,1-1,1 0,0-2,0-1,1 0,24 4,28 5,1-4,1-3,-1-3,134-5,-108-9,0-4,-2-4,111-33,-140 28,130-56,-173 63,-1-1,0-2,-1 0,-1-2,0-1,-2 0,25-27,-41 38,-1 0,1 0,-1-1,-1 1,0-1,0-1,0 1,-2-1,1 0,-1 0,2-10,-4 12,0 0,-1 1,0-1,0 1,-1-1,0 1,0-1,-1 1,0-1,0 1,0 0,-1 0,0 0,-1 0,-6-9,0 3,-1 1,0 0,0 0,-1 1,-1 1,0 0,0 1,-1 0,0 1,0 1,-1 0,-16-5,-18-4,-1 2,-78-13,25 13,0 3,-109 4,130 9,0 4,1 3,-90 23,140-25,1 2,1 0,0 2,0 2,-27 15,47-22,-1 1,1 0,0 0,0 1,1 0,0 0,-8 12,11-13,1 0,0 0,1 0,-1 0,1 1,1-1,0 1,0 0,0-1,1 1,-1 13,3-5,0 0,1 0,1 0,0 0,1-1,1 1,0-1,1 0,1-1,0 1,18 25,1-4,2-1,1-1,36 33,-7-14,2-4,2-1,2-4,2-3,1-2,2-3,2-4,1-2,2-4,109 24,-148-43,0-1,1-2,-1-2,1-1,-1-2,68-10,-80 6,0-1,0-1,0 0,-1-2,-1-1,1-1,-2 0,1-2,-2 0,0-1,22-22,-12 8,-2-2,-1-1,-1-1,-2-1,-1-1,18-41,-26 46,-2 0,-1-1,-1 0,-1 0,-2-1,-1-1,-2 1,1-43,-5 63,0-1,-1 1,0 0,-1 0,0 0,-5-12,6 19,-1 0,0 0,0 0,-1 0,1 0,-1 0,0 0,0 1,0 0,0-1,-1 1,1 0,-1 1,0-1,1 1,-1-1,-6-1,1 0,-1 1,0 1,1-1,-1 2,0-1,0 1,0 1,0 0,0 0,0 1,0 0,0 1,1 0,-1 1,0 0,1 0,0 1,0 0,-11 7,7-3,1 0,0 0,0 2,1-1,0 1,1 1,0 0,0 1,2-1,-1 2,1-1,-9 22,10-18,1 1,0 0,2 0,0 1,0-1,0 20,4-27,0 0,0 0,1 0,0 0,1-1,0 1,0 0,1-1,0 1,1-1,0 0,1 0,5 8,2-1,1 0,1-1,0-1,1 0,0-1,1 0,0-1,28 14,2-2,0-2,61 18,-31-15,2-3,0-3,149 14,-179-29,0-3,0-1,0-3,0-2,0-2,-1-2,81-27,-111 30,0-1,-1-1,1-1,-2-1,1 0,-1 0,23-23,-34 28,1 0,-1 0,0 0,0-1,0 0,-1 0,0 0,0 0,-1 0,4-11,-6 12,1 0,-1 0,1 0,-1 0,-1 0,1 0,-1 0,0 0,0 1,0-1,-1 0,1 0,-1 1,0-1,-1 1,-3-5,-1-2,-2 1,1 0,-1 0,-1 1,0 1,0-1,0 2,-1-1,-1 2,1-1,-25-9,12 7,0 2,-1 0,0 1,0 1,-30-1,27 4,0 2,0 0,0 2,0 1,0 2,1 0,-1 2,1 1,1 1,0 1,-35 20,54-26,0 0,1 1,0 0,0 0,0 0,1 1,0 0,0 0,0 0,1 0,0 1,-5 10,5-7,0 1,1 0,0 0,1 0,0 0,1 0,-1 22,3-12,1 0,1 0,1 0,1-1,0 1,2-1,0-1,19 36,-10-27,2-1,1 0,1-2,1 0,1-1,1-1,52 39,-52-46,0-1,1-1,1-1,1-1,-1-1,2-1,-1-2,1 0,46 5,-63-12,-1 0,1 0,-1-2,1 1,0-1,-1 0,1-1,-1 0,0-1,16-6,-18 5,-1 1,1-1,-1 0,0-1,-1 1,1-1,-1 0,0-1,0 1,-1-1,1 0,-1 0,-1 0,7-13,-4 2,-1 0,0 1,-1-2,-1 1,-1 0,0-1,-1 1,-1-1,-1 1,0 0,-2-1,0 1,0 0,-10-26,4 19,0 0,-2 1,0 0,-2 0,0 1,-2 1,0 1,-2 0,-23-23,16 21,-44-31,57 46,-1-1,0 2,0-1,0 2,-1-1,-19-4,28 10,-1-1,1 1,0-1,0 1,0 1,0-1,0 1,0-1,0 1,0 0,0 0,0 1,0-1,0 1,1 0,-1 0,-3 3,4-3,1 0,0 0,0 0,0 0,0 0,0 0,1 0,-1 0,1 1,-1-1,1 1,0-1,0 1,0-1,0 1,1 0,-1-1,1 1,-1 0,1 0,0 0,0-1,0 1,1 0,-1 0,1 3,1-3,-1 0,1 0,-1 0,1 0,0 0,0-1,0 1,0-1,1 1,-1-1,1 0,0 0,-1 0,1 0,0 0,0-1,0 1,0-1,0 0,1 0,3 1,5 1,0-1,0 0,0 0,22-1,-18-2,0-1,1-1,-1 0,-1-1,1-1,-1 0,1-2,-2 1,1-2,-1 0,0 0,0-1,-1-1,-1-1,1 1,11-16,0-1,-1-1,-1-1,-2-1,-1-1,-2-1,18-43,-17 29,-1-2,-3 0,-2 0,-2-1,-2-1,-2 1,-3-1,-1 0,-3-1,-2 1,-2 1,-2-1,-3 1,-27-82,31 113,-1 0,-1 0,-1 1,0 1,-1-1,-14-16,16 24,-1-1,0 1,0 1,-1 0,0 0,-1 1,0 0,0 1,-21-9,9 6,1 2,-1 1,0 1,-1 1,1 1,-27-1,37 4,0 0,0 1,0 0,0 1,1 1,-1 0,0 0,1 1,0 1,0 0,0 1,-17 11,23-12,0 0,0 0,1 0,-1 1,1 0,1 0,-1 0,1 1,0 0,1-1,-1 1,2 0,-1 1,1-1,0 0,0 1,1 0,0-1,0 1,0 0,1-1,2 14,0-9,0-1,1 0,0 1,0-1,2 0,-1 0,1-1,1 1,0-1,0-1,1 1,0-1,1 0,13 12,-2-5,1-2,0 0,1-1,0-1,1-1,0-1,38 12,-6-7,-1-3,75 8,-60-14,0-3,-1-3,1-2,-1-4,1-3,-2-2,1-4,-2-2,0-3,-2-3,0-3,-1-3,87-55,-111 60,-2-2,-1-2,50-51,-71 65,-1-1,-1-1,0 0,-1 0,-1-1,0 0,-1-1,-1 0,-1-1,7-27,-12 37,0 0,-1 0,-1 0,1-1,-1 1,-1 0,0 0,0 0,-1 0,0 0,0 0,-1 0,0 1,-9-17,5 14,0 1,-1-1,0 2,-1-1,0 1,0 1,-1-1,0 2,-20-12,0 3,-1 2,0 1,-1 1,-1 2,0 1,0 2,-40-4,14 7,0 2,0 2,0 4,1 2,-111 25,128-20,0 1,1 2,0 2,1 2,-60 37,73-38,0 2,1 0,2 2,0 0,1 2,1 0,1 2,-22 35,33-46,1 0,1 1,0 0,1 1,1 0,0 0,1 0,1 0,-2 20,4-27,1 0,1 0,-1 0,1 0,1 0,0 0,0 0,1 0,0 0,0-1,1 0,0 1,1-1,0-1,0 1,0-1,1 0,8 8,4 0,1 0,0-1,1-1,1-1,0 0,0-2,1-1,0 0,33 7,-1-3,0-3,111 7,-99-15,1-3,-1-2,0-4,77-16,-106 14,1-1,-1-2,-1-2,0-1,-1-2,-1-1,-1-2,46-35,-62 41,-1 0,0-2,-1 0,-1-1,-1 0,0-1,-2-1,0 0,17-40,-24 48,0-1,-2 1,1-1,-1 0,-1 0,0 0,0 0,-3-19,1 22,-1 0,0-1,-1 1,0 0,0 0,-1 0,0 1,0-1,-1 1,-1 0,-10-13,6 11,0 1,0 0,-1 0,0 1,0 1,-1 0,0 0,-1 1,1 1,-1 0,0 0,0 2,-1-1,-19-1,1 2,1 1,-1 1,1 2,-1 2,-41 7,14 3,0 3,1 2,1 2,1 3,1 2,1 3,-67 46,60-31,3 2,1 3,2 2,3 3,-75 97,101-114,1 0,2 2,1 1,2 1,2 0,2 1,-14 53,25-70,1 1,0-1,2 1,1-1,1 1,3 26,0-32,0 0,1-1,2 1,-1-1,2 0,0-1,2 0,15 26,-12-26,0-2,1 0,0 0,1-1,1-1,0 0,1-1,0-1,34 18,-10-10,0-3,2 0,57 12,-86-25,0 0,0-1,0 0,1-1,-1 0,1-1,-1-1,1 0,-1-1,0-1,0 0,0 0,0-1,0-1,-1 0,1-1,-1 0,-1-1,0 0,0-1,17-15,-15 10,-1 0,-1 0,0-1,15-25,-21 30,0 0,-1-1,0 0,0 0,-1 0,0 0,-1 0,0 0,0-12,-2 19,0 0,0 0,0-1,0 1,-1 0,1 0,-1 0,0 0,0 0,0 0,0 0,-1 0,1 1,-1-1,0 0,0 1,0-1,0 1,-3-3,2 3,0 0,0 0,0 0,-1 0,1 1,-1 0,0-1,1 1,-1 0,0 1,1-1,-1 1,0 0,0 0,-7 0,-11 3,-1 1,1 1,1 1,-1 0,1 2,-33 16,24-8,1 1,1 2,-47 39,55-40,1 1,2 1,-1 0,2 1,1 1,1 1,1 0,1 1,0 0,2 0,1 1,2 1,-9 40,15-54,0-1,1 0,0 1,1-1,0 0,0 1,1-1,1 0,0 0,0 0,7 12,-3-10,0 0,1-1,0 0,1 0,0-1,1 0,0-1,12 10,-3-5,2-1,0 0,1-2,0 0,0-1,1-2,1 0,0-2,47 9,-50-13,-1-1,1-2,-1 0,1-1,0-1,-1-1,0-1,0 0,0-2,0 0,-1-1,0-1,0-1,-1-1,-1 0,30-23,-28 17,0 0,0-2,-2 0,0-1,-2 0,0-2,-1 0,-1 0,0-1,-2-1,-1 0,-1-1,8-32,-13 40,-1 0,-1-1,0 1,-1-1,-1 0,-1 1,0-1,-2 0,-4-21,4 27,-1 1,1-1,-1 1,-1 0,0 1,0-1,-1 1,-1 0,1 1,-1-1,0 1,-1 1,0-1,0 1,-13-7,9 6,-1 1,1 1,-2 0,1 1,-1 1,1 0,-1 0,0 2,-1-1,1 2,0 0,-1 1,1 0,-21 4,13 0,0 1,0 1,1 1,0 1,1 1,0 1,0 0,-28 21,26-16,0 2,2 0,0 1,1 1,0 1,-30 44,42-54,1 1,0 0,1 0,0 1,1-1,0 1,0 0,1 0,1 0,0 1,1-1,0 1,1-1,1 0,0 1,0-1,4 16,-2-19,0 0,0-1,0 0,1 0,0 0,1 0,0-1,0 1,0-1,1-1,0 1,0-1,10 7,-5-5,0 0,1-2,0 1,0-2,0 1,1-2,0 0,14 3,2-2,0-1,-1-2,1-1,0-1,0-1,0-2,45-10,-34 3,0-2,-1-2,0-2,-1-1,-1-2,-1-1,-1-2,-1-2,0 0,-2-3,37-39,-47 42,-2-1,0 0,-1-2,-2 0,-1-2,18-42,-24 47,-2-2,-1 1,0-1,-2 0,-1 0,-2 0,0 0,-3-40,-1 44,-1 0,-1 0,-1 0,-1 0,-1 1,0-1,-2 2,-1-1,0 1,-21-29,15 28,-1 0,-1 1,0 1,-2 1,0 0,-1 2,-1 0,-36-19,23 17,0 1,-1 2,0 2,-2 1,1 2,-1 1,-1 2,1 2,-61 0,93 5,0 0,0 0,1 1,-1 0,0 0,1 0,-7 3,11-3,-1-1,1 1,0 0,0 0,0 0,0-1,0 1,0 0,0 0,0 1,0-1,0 0,0 0,1 0,-1 0,0 1,1-1,-1 0,1 1,0-1,-1 0,1 1,0-1,0 0,0 1,0-1,0 1,0-1,0 0,0 1,1-1,-1 0,0 1,2 1,0 2,0 1,1-1,-1 0,1 0,0 0,1-1,-1 1,1-1,0 0,0 0,1 0,-1 0,1-1,0 0,0 0,0 0,0 0,0-1,6 2,5 2,0-1,1-1,-1-1,1 0,23 1,-19-3,-1-2,1 0,-1-1,0-1,0-1,0-1,-1 0,1-2,-1 0,0-1,-1-1,0-1,-1-1,17-12,-22 14,-1 0,-1-1,0 0,0-1,-1 0,0 0,-1-1,0 0,-1-1,-1 0,0 0,0 0,-1-1,-1 1,0-1,-1 0,-1 0,0-1,-1 1,-1-26,-1 23,-1 0,-1 1,-1-1,0 1,-1-1,-1 1,-1 1,-10-20,5 15,0 1,-2 0,0 1,-1 1,-27-25,13 19,0 0,-1 2,-1 2,-1 1,-1 1,0 1,-53-16,64 26,-1 0,0 1,-1 2,1 0,0 2,-1 0,0 2,1 0,-24 5,30-3,0 1,0 1,1 0,-1 1,1 1,1 0,-1 1,1 1,1 1,-1 0,2 0,-21 21,30-26,-1 0,1 0,0 0,0 1,1-1,0 1,0 0,0 0,-2 9,4-11,0 0,1 1,-1-1,1 0,0 1,0-1,0 1,1-1,-1 0,1 1,0-1,1 0,-1 1,1-1,2 4,1 1,1 0,0 0,0-1,1 1,0-2,0 1,1-1,0 0,1 0,17 10,0-3,0-1,50 16,-30-15,1-2,1-2,0-2,0-2,0-2,1-2,-1-3,1-1,-1-3,0-2,0-1,-1-3,0-2,-1-2,0-2,-1-2,68-41,-90 46,-1-2,0-1,-2 0,0-2,-1 0,0-1,-2-1,15-23,-24 33,-1-1,0-1,-1 1,-1-1,0 0,-1 0,0 0,-1-1,0 1,-1-1,-1 0,0 0,-1 0,0 1,-1-1,-1 0,-4-18,0 14,0 1,-2 0,0 0,0 1,-2 0,0 0,-1 1,0 1,-2 0,1 0,-28-21,2 5,0 3,-2 1,-61-29,22 15,-1 3,-112-34,184 69,3 0,-1 0,0 0,0 1,0-1,0 2,0-1,0 1,0 0,-1 0,1 0,-7 2,12-1,0-1,0 1,0-1,0 1,0 0,0 0,0 0,0 0,1 0,-1 0,0 0,1 0,-1 0,0 0,1 0,-1 0,1 0,-1 0,1 1,0-1,0 0,-1 0,1 0,0 1,0-1,0 0,0 0,1 1,-1-1,0 0,0 0,1 0,-1 1,1-1,0 2,2 6,1 0,0 0,7 11,-9-18,14 23,1-1,1-1,1 0,1-2,1 0,1-1,0-2,2 0,0-1,1-2,36 18,-56-31,0 0,0 0,0 0,1-1,-1 1,0-1,1-1,-1 1,1-1,-1 0,7-1,-10 1,1-1,0 0,0 0,-1 0,1 0,0 0,-1-1,0 1,1-1,-1 1,0-1,1 0,-1 0,0 0,-1-1,1 1,0 0,0-1,-1 1,0-1,1 1,1-6,2-8,0-1,-1 0,-1-1,0 1,-1-1,-1 1,-2-23,-3-13,-10-58,-6 4,-5 1,-4 1,-46-106,72 202,-5-12,-2 1,-20-35,28 51,-1 0,1 1,-1-1,0 1,0-1,0 1,0 0,0 0,-1 1,0-1,1 1,-1 0,0 0,0 0,0 0,0 1,0-1,-1 1,1 0,-9-1,9 3,0-1,-1 1,1 0,0 0,0 0,-1 1,1 0,0-1,0 1,1 1,-1-1,0 0,-3 4,-5 5,0 0,-12 15,14-15,-28 32,2 2,2 1,-53 94,73-113,1 1,1 1,1 0,2 1,0 0,3 0,0 1,-2 56,8-71,1-1,0 1,1-1,1 0,0 0,1 0,1 0,12 26,-12-31,0-1,1 0,0 0,1-1,-1 0,2 0,-1-1,1 0,0 0,1 0,-1-1,1-1,1 0,10 5,-4-3,1-1,0-1,0-1,1 0,-1-1,1-1,29 0,-22-4,1 0,0-1,-1-2,45-13,-30 4,-1-2,0-2,-1-1,-1-3,0 0,40-35,-42 28,-1-2,-1-1,-3-1,0-2,-2 0,24-43,-38 54,-1 0,-1-2,-2 1,13-45,-19 51,0 0,-1 0,-2-1,1 1,-2-1,-1 1,-3-25,1 29,-1 0,0 1,-1 0,0 0,-2 0,1 0,-1 1,-1 0,-1 1,0 0,0 0,-1 1,0 0,-1 0,-1 2,1-1,-1 1,-16-8,0 1,0 2,-1 1,0 2,-1 0,0 2,-1 2,-54-7,11 7,0 4,1 3,-133 17,91 2,-186 55,237-54,-77 36,111-42,1 2,0 1,1 1,-35 30,57-43,0 0,1 0,0 1,0-1,0 1,1 1,0-1,0 0,0 1,1 0,0 0,1 0,-1 0,1 1,1-1,-1 1,1-1,1 1,-1-1,1 1,0-1,1 1,0-1,0 1,1-1,0 1,0-1,1 0,-1 0,2 0,-1 0,6 8,8 7,0 0,1-1,1-1,0-1,2 0,29 19,-20-17,2-1,0-2,1-1,44 15,-58-25,0-2,0 0,39 4,-50-8,-1 0,1-1,0 0,-1-1,1 0,-1 0,1 0,-1-1,1 0,-1-1,0 1,0-1,8-5,-11 5,-1 0,1-1,-1 1,1-1,-1 1,0-1,-1 0,1-1,0 1,-1 0,0-1,0 1,-1-1,1 0,-1 1,0-1,0 0,-1 0,1 0,-1 0,0-7,-1-2,-1 0,0 1,-1 0,0-1,-1 1,-10-23,1 10,-2 1,0 1,-1 0,-2 1,0 1,-2 1,0 1,-27-21,3 6,-2 2,-1 2,-64-31,46 31,-2 3,-1 3,-1 3,-140-25,145 37,0 4,-1 2,1 3,-1 3,-117 19,138-12,1 3,-1 1,2 2,-59 29,72-29,1 1,0 1,2 2,0 1,1 1,-42 45,59-57,0 2,1-1,0 1,0 0,1 1,1-1,0 1,1 0,0 1,0-1,2 0,-1 1,2 0,-1 24,3-21,0 0,2 0,0 0,0-1,2 1,0-1,0 0,2 0,0-1,0 0,17 23,0-6,3 0,0-1,2-2,1 0,1-3,62 40,-29-27,2-2,127 48,-137-64,0-3,1-2,1-2,0-4,0-1,1-4,66-2,-87-4,0-1,0-3,0 0,-1-3,0-1,-1-2,0-1,-1-2,0-1,-1-2,61-43,-73 43,-1-1,-1 0,-1-2,-1 0,-1-1,0-1,-2 0,-1-1,-1-1,-1 0,-1-1,-1 0,7-30,-12 35,-1 1,-1-2,-1 1,-1 0,-1 0,0-1,-7-36,4 42,-2-1,1 1,-2 0,0 0,-1 1,-1 0,0 0,-1 0,-1 1,-15-18,11 18,-1 0,0 0,-1 2,-1 0,0 1,0 0,-1 2,0 0,-1 1,0 1,0 0,-38-6,13 6,-1 1,-1 2,1 3,-79 7,56 2,1 3,0 4,1 2,0 3,-71 33,39-8,3 4,-138 95,147-83,2 5,4 3,-122 135,149-141,2 2,3 3,2 2,5 2,-41 93,62-118,2 1,3 0,2 2,-14 90,25-118,0 1,2-1,0 0,1 1,2-1,0 0,1 0,1 0,1-1,1 0,1 0,1 0,17 27,-12-27,2 0,0-1,1 0,2-1,36 29,-25-26,1-1,1-2,54 25,-29-21,1-3,1-2,0-2,108 12,-93-20,1-4,-1-3,1-4,123-19,-146 13,0-3,-1-2,0-3,-2-1,0-3,-1-1,61-41,-81 45,-2-2,0-1,-2-1,0-1,38-49,-48 53,-1-1,-1 0,-1-1,0-1,-2 1,0-2,-1 1,7-42,-12 53,-2 0,0 0,0 0,-1 0,0 0,-1 1,0-1,-1 0,0 0,0 0,-2 1,1-1,-1 1,-1 0,1 0,-2 1,0-1,0 1,0 0,-1 1,0 0,-1 0,0 0,0 1,-1 0,0 1,0 0,0 0,-1 1,-17-8,5 6,1 0,-1 2,-1 0,-34-2,-99 4,66 10,1 3,0 5,-165 48,118-17,-220 108,252-100,2 4,-169 129,214-141,3 2,2 3,2 1,2 3,-70 105,99-129,2 0,1 1,1 0,2 2,1-1,2 1,-10 57,17-69,1 0,2 0,0 0,1 0,0 0,2-1,1 1,1-1,1 1,0-1,2-1,0 1,16 26,-12-27,1-1,1 0,1-1,0 0,2-1,0-1,0-1,26 17,-17-15,1-1,1-1,1-2,0-1,50 14,-32-15,1-2,0-2,0-2,0-2,1-2,-1-3,95-15,-91 7,-2-3,1-2,-2-2,0-2,-1-3,-1-1,-2-3,0-1,-2-3,-1-1,-1-2,-2-2,-1-1,-2-3,-2 0,-1-2,-3-2,50-90,-64 103,-2-2,-1 0,-2 0,-1-1,-1 0,-2-1,-1 0,-2 0,0-45,-4 59,-1 0,-2 0,0 1,-1-1,0 1,-2 0,0 0,-1 0,-1 1,-1 0,-1 1,0 0,-1 0,-1 1,0 0,-2 1,-20-19,9 14,-2 0,1 2,-2 1,-1 1,0 1,0 2,-33-10,-6 2,-1 4,-91-12,19 13,-2 6,1 6,-247 24,255-3,1 6,2 6,0 6,-133 54,66-2,166-70,0 1,2 1,-50 43,73-56,-1 1,1 0,1 1,-1 0,2 0,-1 0,1 0,0 1,0 0,1 0,-5 17,7-18,1 0,0 0,0 1,1-1,0 0,0 1,1-1,0 0,1 1,0-1,0 0,0 0,1 0,5 9,6 10,1-1,2-1,0 0,2-1,1-1,0-1,25 21,7 0,1-2,62 36,-65-46,2-3,97 39,-128-59,0-1,1-1,0 0,0-2,1-1,-1-1,1 0,-1-2,1-1,31-4,-44 2,1 1,-1-1,0-1,0 0,-1 0,1-1,-1 0,0-1,0 0,-1 0,0-1,0 0,7-9,-6 6,-1-1,-1 0,0 0,0-1,-1 0,-1 0,0-1,0 1,4-21,-6 14,0 1,-1-1,-1 1,0-1,-2 0,0 1,-1-1,-1 1,-1-1,0 1,-1 0,-2 1,1-1,-19-32,12 31,-1 1,-1 0,0 1,-1 1,-1 0,-1 1,0 1,0 1,-40-21,11 10,-1 3,-1 2,-65-16,20 12,-1 4,0 5,-1 3,-1 5,-97 6,151 2,1 1,-1 2,1 1,-81 25,115-28,0 0,1 1,-1-1,1 1,-1 1,1 0,-6 5,11-8,0 0,0 0,0 0,0 0,0 1,1-1,-1 0,1 1,0-1,0 1,0 0,0-1,0 1,0 0,1-1,-1 1,1 0,0 0,0 0,0 0,0-1,0 1,2 4,1 4,0 0,1-1,1 1,0-1,0 0,1 0,12 16,0-4,1-1,23 20,-9-13,2 0,1-2,1-2,1-1,0-2,2-2,1-1,0-3,1-1,0-2,57 9,-83-19,-1 0,0-2,0 1,1-2,-1 0,0-1,22-5,-31 5,1 0,-1 0,0 0,0-1,-1 0,1 0,-1-1,1 1,-1-1,0-1,-1 1,1 0,-1-1,1 0,-2 0,1-1,0 1,-1-1,0 1,3-9,-3 5,-1 0,0-1,0 1,-1-1,0 0,-1 1,0-1,0 0,-1 1,0-1,-1 1,0-1,0 1,-1 0,0-1,-1 2,0-1,-1 0,-5-8,-2 0,0 0,-1 0,0 2,-2-1,0 2,-1 0,-32-22,18 17,0 2,-2 1,0 2,-1 1,-57-15,43 17,-1 3,0 1,-77-1,94 9,-60 7,81-7,0 1,1 0,-1 1,0 0,1 1,0 0,0 0,0 1,0 0,-8 7,15-10,0 0,0 0,0 0,0 1,0-1,0 1,1-1,-1 1,1 0,0-1,-1 1,1 0,1 0,-1 0,0 0,0 4,1-2,0 0,1 0,-1 0,1 0,0 0,0 0,1 0,-1-1,4 7,1 0,0 1,2-1,-1 0,1 0,1-1,14 14,-11-13,-4-2,1 0,1-1,-1-1,1 1,20 9,-28-16,1 0,0 0,-1 0,1 0,0-1,0 1,-1-1,1 0,0 1,0-1,0-1,0 1,-1 0,1-1,0 0,0 1,-1-1,1 0,-1 0,1-1,0 1,-1 0,0-1,1 0,-1 1,0-1,0 0,0 0,0 0,3-5,1-1,0-1,-1 0,0 0,0 0,-1-1,0 0,-1 1,0-1,0-1,-1 1,0 0,-1-1,-1 1,1 0,-2-1,1 1,-1-1,-1 1,0 0,-5-17,3 13,-1 1,-1 0,0 0,0 0,-1 1,-1 0,0 0,-1 1,0 0,0 0,-1 1,-1 0,0 1,-22-15,11 13,-1 0,0 1,0 2,-1 0,0 1,-1 2,1 0,-39-1,35 5,-1 0,0 3,0 0,1 2,0 0,0 3,-33 10,55-15,-1 1,0 0,1 0,0 1,-1-1,2 1,-12 10,15-13,1 1,-1 0,1 0,-1 0,1-1,0 1,0 1,0-1,0 0,0 0,0 0,1 0,-1 1,1-1,-1 0,1 1,0-1,0 0,0 1,0-1,1 0,-1 1,0-1,1 0,0 0,0 1,-1-1,1 0,2 2,1 3,0-1,1 1,0-1,0 0,1 0,0-1,0 0,0 0,0 0,1-1,0 0,0 0,9 3,8 3,1 0,46 9,-35-11,1-2,1-2,-1-1,1-1,52-6,-64 1,0-1,0-1,0-1,0-2,-1 0,0-2,-1-1,35-20,-44 21,-1-1,1 0,-2-1,0 0,0-1,-1-1,15-22,-21 28,-2 1,1 0,-1-1,0 0,-1 0,0 0,0-1,-1 1,0-1,0 1,-1-1,0 0,-1 1,0-1,0 0,-1 0,-2-12,-1 10,0 0,-1 0,0 0,-1 1,0-1,-1 1,0 1,0-1,-1 1,0 1,-18-15,4 6,0 1,-2 1,-49-24,33 22,0 2,-1 1,-1 2,-76-12,86 20,1 2,0 1,0 1,-1 1,1 2,0 1,-41 11,67-13,0-1,1 1,-1 0,1 0,-1 0,1 0,-1 1,1 0,0 0,0 0,1 0,-1 1,1 0,-1-1,1 1,0 0,1 1,-3 3,3-3,0 0,0 0,1 0,0 1,0-1,1 0,-1 0,1 0,0 1,1-1,-1 0,1 0,0 0,0 1,1-1,0 0,2 5,0-1,1 0,0-1,1 1,0-1,1 0,-1-1,1 0,1 0,-1 0,1-1,1 0,10 6,4 1,0-1,1-1,40 12,-42-16,0-1,1-1,-1-1,1-1,0-1,34-1,-47-2,0 0,-1 0,1-1,-1 0,1 0,-1-1,0-1,0 0,0 0,-1 0,1-1,-1 0,0-1,0 0,-1 0,0-1,12-14,-15 15,0 1,0-1,-1-1,0 1,0 0,0-1,-1 0,0 1,0-1,-1 0,2-14,-3 11,-1-1,1 1,-2 0,1 0,-1 0,-1 0,-6-16,3 10,-2 1,0 1,0-1,-2 1,1 1,-2 0,0 0,0 1,-27-21,25 23,-1 2,-1-1,0 2,0 0,0 1,-1 0,0 1,0 1,0 1,0 0,-1 1,1 1,-32 1,39 1,0 0,1 1,-1 0,1 0,0 1,0 0,0 1,0-1,0 1,0 1,1 0,0 0,0 0,1 1,-12 11,11-7,-1 0,1 0,1 0,0 1,0-1,1 1,0 1,1-1,0 1,-3 20,4-16,1 0,0 0,1 1,1-1,1 0,0 0,8 32,-8-42,1 0,0 0,0-1,1 1,0-1,0 1,0-1,0 0,1 0,0 0,0-1,1 0,-1 1,1-1,0-1,0 1,0-1,0 0,0 0,1 0,0-1,-1 0,1 0,9 2,-8-3,1 0,0 0,-1 0,1-1,0 0,0 0,-1-1,1 0,0-1,-1 0,1 0,-1 0,9-5,-6 2,-1 0,0-1,0 0,0-1,-1 0,1-1,-2 1,11-14,-3-1,-1 1,-1-2,0 0,-2 0,-1-1,-1-1,7-28,-8 19,-1 1,-2-1,-1-1,-2 1,-4-67,0 80,-1 1,-1 0,0 0,-2 0,0 0,-1 1,-1 0,-1 1,0-1,-2 2,-15-22,21 33,-1 0,0 0,0 0,0 1,-1 0,0 0,0 1,0-1,-1 2,1-1,-1 1,0 0,0 0,0 1,0 0,0 1,0 0,-1 0,1 1,0 0,-1 0,1 1,-9 2,5-1,1 1,0 0,0 1,0 0,0 1,1 0,0 0,0 1,0 1,1 0,0 0,0 1,0 0,1 0,1 1,-8 10,4-1,1 0,1 1,0 0,2 1,0 0,-8 37,10-25,0 1,2-1,3 57,0-78,1-1,1 1,0-1,0 0,1 0,0 0,1 0,0-1,1 1,0-1,0 0,1 0,0-1,0 1,1-1,13 11,-13-13,1 0,-1-1,1 0,1-1,-1 0,1 0,-1 0,1-1,0-1,0 1,1-2,-1 1,0-1,1 0,-1-1,0 0,1-1,17-3,-9-1,-1 0,1-1,-1-1,-1 0,1-2,-1 0,-1 0,0-1,0-1,-1-1,0 0,-1-1,22-28,-9 6,-1-1,-2-1,-2 0,29-71,-30 57,-2-1,-3-1,-1 0,7-73,-17 94,-2 0,-2 1,0-1,-2 0,-2 0,-1 1,-1 0,-19-56,19 72,-1-1,0 1,-1 1,-1-1,0 1,-1 1,0 0,-1 0,-1 1,0 1,-22-17,23 20,-1 1,0 0,-1 1,0 0,1 1,-2 1,1 0,-1 1,1 0,-1 1,0 0,0 2,0-1,-16 3,9 0,0 1,0 1,1 2,-1-1,1 2,1 1,-1 0,1 2,-32 21,39-23,1 0,0 1,1 0,0 1,1 0,0 1,0 0,1 0,0 1,1 0,1 0,0 1,0-1,2 1,-7 27,9-33,1 1,0-1,1 0,0 1,0-1,1 1,0-1,0 0,0 1,1-1,0 0,1 0,6 13,-4-12,0 0,1 0,0-1,0 0,1 0,0 0,0-1,0 0,15 9,-2-4,1-1,0-1,1 0,-1-2,2 0,-1-2,1-1,27 3,-16-5,0-2,0-1,0-2,-1-1,1-1,-1-2,0-2,-1-1,48-21,-46 15,0-1,-2-2,0-1,-1-1,-1-2,-1-1,-1-1,34-42,-42 43,-2-1,-1-1,-1 0,-1-2,-1 1,-2-2,11-35,-18 48,-1 0,0 0,-2 0,1 0,-2 0,0-1,-1 1,-1-1,0 1,-2 0,1 0,-2 0,0 0,-1 0,-8-17,9 26,0 0,0 0,-1 0,1 1,-1 0,-1 0,1 0,-1 1,0-1,-1 1,1 1,-1-1,-11-4,8 4,0 1,-1 1,0 0,1 0,-1 1,0 1,0 0,-22 1,9 2,1 1,-1 1,0 1,1 1,0 1,0 1,1 1,-28 17,20-9,2 1,0 2,1 1,1 1,-45 51,54-54,2 1,0 1,1 1,1 0,1 0,1 1,1 1,-11 39,18-49,1 0,0 0,1 1,1-1,0 1,1-1,0 0,1 1,1-1,0 0,1 0,0-1,7 15,-6-17,1 0,0-1,0 0,1 0,0 0,1-1,0 0,0 0,1-1,0 0,0-1,1 0,0 0,1-1,21 10,-16-10,1-1,0-1,0 0,0-1,0-1,0-1,1 0,-1-1,0-1,25-4,-20 0,0 0,0-2,-1-1,1 0,-2-1,0-2,27-17,-20 9,-1-1,-1-1,-1-1,-1-1,-1-2,-1 0,-1-1,-2-1,0-1,-2 0,15-36,-20 36,-1 0,-1 0,-1-1,-2 0,-1 0,-1-1,0-38,-5 55,0 0,0 0,-2 0,1 0,-1 1,-1-1,-1 1,-6-16,6 20,0 0,-1-1,1 2,-1-1,-1 1,0 0,0 0,0 1,0 0,-1 0,0 1,-12-6,4 3,0 2,0 0,0 1,-1 0,1 1,-1 1,0 1,-1 1,1 0,0 1,0 1,0 0,0 1,0 1,0 1,0 0,-17 8,10-2,0 0,1 2,0 1,1 0,1 2,0 0,1 2,1 0,0 1,-28 35,32-32,0 1,1 0,1 1,2 0,0 1,1 0,2 1,0 0,2 0,1 1,0 0,0 40,5-51,0 0,1 0,1 0,0 0,1 0,1-1,0 1,1-1,1 0,0-1,1 1,0-1,1 0,0-1,1 0,1 0,0-1,0 0,1-1,0 0,1-1,0 0,19 10,-7-7,1 0,0-2,1-1,0-1,0-1,50 7,-23-9,1-2,84-7,-68-3,-1-2,-1-4,0-3,-1-2,108-46,-116 37,-1-2,-1-3,-2-2,-2-2,-1-3,59-57,-86 71,-1-1,-1-1,-1-1,-2 0,-1-2,-1 0,22-54,-32 65,-2 0,0-1,-1 1,-1-1,-1 0,0-1,-2 1,0 0,-1 0,-2-1,0 1,-1 0,0 0,-11-29,10 37,-1 0,0 1,-1 0,-1 0,0 0,0 1,0 0,-2 0,1 1,-17-14,13 13,-1 1,-1 1,0 0,0 0,0 2,-1-1,-26-6,16 7,-1 2,0 0,0 2,1 0,-1 2,0 1,0 1,0 1,0 1,-27 9,30-6,0 1,0 1,1 1,0 1,1 1,0 1,1 1,0 0,1 2,-22 22,30-25,0-1,1 2,0-1,1 1,1 1,0-1,1 2,1-1,0 1,1-1,1 2,0-1,1 0,1 1,-1 31,4-36,0 0,0 0,1 0,1 0,0 0,0 0,1-1,1 0,0 0,11 19,-7-17,1-1,0 0,1 0,0-1,0 0,1-1,21 14,-7-9,0-1,1-1,1-1,0-2,0 0,1-2,0-1,39 4,-30-8,0 0,0-3,0-1,72-11,-87 8,0-2,0 0,0-2,-1 0,-1-1,1-2,-1 0,-1-1,22-17,-32 21,-1 0,-1 0,0-1,0-1,0 1,-1-1,-1 0,0-1,0 0,-1 1,0-2,5-18,-7 20,-1 0,-1 0,0 1,0-1,-1 0,0 0,-1 0,0 0,0 0,-1 1,0-1,-1 1,0-1,-1 1,-9-17,2 9,0 1,-1 0,-1 1,-1 0,0 2,0-1,-2 2,1 0,-2 0,-27-14,16 12,-1 1,0 2,-1 0,0 2,-61-10,53 14,0 2,0 1,-1 2,1 1,0 3,0 1,0 1,-58 19,76-18,0 1,0 1,1 1,0 1,1 0,0 1,-19 17,25-17,0 1,0-1,1 2,1 0,0 0,1 1,0 0,1 0,-10 30,13-28,0-1,1 1,1 0,1 0,0 0,2 1,0-1,0 0,2 0,0 0,1 0,1 0,0 0,1-1,1 1,1-2,0 1,1-1,1 0,0 0,1-1,0 0,1-1,1 0,0-1,1-1,0 1,23 14,-12-12,0 0,1-2,0 0,1-2,47 12,-16-9,104 8,-90-17,0-4,-1-2,1-4,-1-2,0-4,85-25,-77 12,0-3,-1-3,-2-3,-2-4,74-50,-101 56,0-1,-3-3,-1-2,51-58,-73 73,-2-1,-1 0,-1-1,-1 0,-1-2,-2 0,0 0,-2-1,-1 0,6-30,-13 44,0 0,-1-1,0 1,-1-1,-1 1,0-1,-1 1,0 0,-1 0,-1 0,-9-24,7 26,-1 0,1 1,-2 0,1 0,-2 0,1 1,-1 1,-1-1,0 2,0-1,-1 1,-20-12,6 8,-1 0,0 2,-1 1,0 1,0 1,-1 1,1 2,-1 1,0 1,-1 1,1 1,0 2,-34 6,46-5,1 1,0 0,0 1,0 1,1 0,-1 1,2 0,-1 1,1 1,0 0,1 1,0 0,0 1,2 0,-1 1,1 0,1 1,0 0,-8 16,5-6,2 0,0 0,2 1,1 0,0 0,2 1,1 0,1 0,0 48,4-54,0-1,2 0,0 0,1 0,1 0,0-1,2 0,0 0,0 0,2-1,0 0,1-1,1 0,18 21,-10-17,2-1,0-1,0-1,2-1,0-1,0-1,2-1,-1-1,29 8,0-2,2-3,0-2,74 6,-81-14,1-1,0-3,-1-2,1-2,-1-2,0-2,48-15,-70 15,-1-1,0-1,-1-1,0-1,0-1,-2-1,1-2,-2 0,0-1,-1-1,-1-1,-1 0,-1-2,18-26,-21 24,-1 0,-2-1,0-1,-2 0,0 0,-2-1,-1 0,-1-1,-1 1,-1-1,-1 1,-2-1,-1 0,-1 0,-1 1,-8-35,5 38,0-1,-2 1,0 1,-2 0,0 0,-1 1,-2 0,0 1,-1 0,-1 1,-1 1,0 0,-1 1,-1 1,-1 1,0 1,-1 0,-26-13,32 20,0 2,-1-1,1 2,-1 0,0 1,0 0,-1 1,1 1,0 0,0 1,-1 1,1 0,-16 4,13-1,0 1,1 1,-1 0,1 1,1 1,-1 0,1 2,1-1,0 2,-23 20,16-9,0 1,2 0,0 2,2 0,1 2,-26 51,32-54,2 0,0 0,2 1,0 0,2 0,1 1,1 0,1 47,3-58,0-1,1 1,1-1,0 0,1 0,1 0,0 0,1-1,10 19,-5-16,0-1,0 0,2 0,-1-1,2-1,23 19,-4-9,2-1,0-2,1-1,1-2,1-2,48 14,17-1,0-5,1-4,177 8,-164-24,-1-6,0-4,133-26,-38-16,-177 38,-1-1,0-2,58-33,-83 42,0 0,0-1,0 0,0 0,-1-1,0 0,-1 0,1-1,-1 0,8-15,-11 18,-1-1,0 1,0-1,-1 0,0 0,0 0,0 1,0-1,-1 0,0 0,0 0,-1 0,0 0,0 0,0 0,-1 1,0-1,-3-8,1 8,1-1,-1 1,0 0,-1 0,0 1,1 0,-2-1,1 1,-1 1,1-1,-1 1,0 0,-1 1,1-1,-1 1,1 1,-1-1,-14-3,-6 0,0 2,-1 0,-43 0,49 4,-1 0,1 1,-1 2,1 0,0 1,0 2,0 0,-23 10,36-12,0 0,0 1,1 0,0 0,0 1,0 0,1 0,0 1,0 0,1 0,0 0,0 1,0 0,1 0,0 1,1-1,0 1,0 0,1 0,0 1,-1 11,2-10,1 1,1-1,0 1,1-1,0 1,1-1,0 0,1 0,0 1,1-2,0 1,0 0,1-1,1 0,6 10,2-1,0-1,0 0,2-1,0 0,1-1,29 20,-3-7,1-2,0-3,2-1,1-2,60 17,-63-25,0-1,0-3,1-2,0-2,0-2,54-2,-83-2,0-1,0 0,0-1,0-1,18-6,-29 8,0 0,0 0,0-1,0 0,-1 0,1 0,-1 0,0-1,0 1,0-1,-1 0,1 0,-1-1,0 1,0-1,0 1,-1-1,4-9,-3 4,-1 0,0 1,0-1,-1 0,0 0,-1 0,0 0,0 0,-1 0,-3-10,1 6,-1 1,-1-1,0 1,-1 0,0 0,-11-15,-5-2,-1 1,-1 1,-1 2,-45-37,-46-27,97 78,0 0,0 2,-1 0,-36-12,51 21,-1-1,0 1,0 1,0-1,0 1,0 0,0 1,1-1,-1 1,0 0,0 1,0-1,1 1,-1 0,1 0,-1 1,1 0,0 0,0 0,0 1,1-1,-1 1,-7 9,1-1,1 0,1 1,0 0,0 0,1 1,1 0,-10 28,8-13,2 0,0 1,2-1,2 1,0 0,2 1,1-1,2 0,0 0,3 0,0-1,2 1,1-1,18 45,-15-50,0 0,2 0,0-1,2-1,0 0,2-1,0-1,1 0,1-2,1 0,1-1,0-1,1-1,0-1,2-1,41 18,-34-20,1-1,0-2,0-1,1-1,0-2,0-2,0 0,49-6,-63 3,0-2,0-1,-1 0,1-1,-1-1,0 0,-1-2,0 0,0-1,0-1,-1 0,-1-1,0-1,0 0,24-28,-25 21,-1 0,0-1,-2-1,0 0,-1 0,-1-1,-2 0,0-1,-1 0,-1 0,-1 0,-1 0,-2-1,0 1,-1-1,-1 1,-2-1,0 1,-1 0,-2 0,-10-31,11 44,0 0,0 1,-1-1,0 1,0 1,-1-1,0 1,-1 0,0 0,0 1,-1 0,0 1,0 0,0 0,-1 1,-18-8,19 10,0 0,-1 1,1 0,-1 0,0 1,0 0,1 0,-1 1,0 1,0 0,1 0,-1 1,0 0,1 0,0 1,-1 1,1-1,1 2,-11 5,1 3,0 0,1 1,1 1,0 1,1 0,1 1,0 0,1 2,1-1,1 1,-10 25,3-3,3 0,1 1,2 1,-9 69,17-90,2 0,1 0,1 0,0 0,2 0,7 35,-4-39,0-1,1 1,1-1,1-1,0 1,1-1,1-1,14 19,-11-18,1-2,1 1,0-2,1 0,0 0,1-2,0 0,1-1,0-1,1 0,0-2,22 6,-36-11,1 0,0-1,-1 0,1 0,0-1,0 1,7-2,-13 1,1 0,-1 0,0 0,0 1,0-1,0 0,0 0,0 0,0 0,1 0,-1 0,0 0,0 0,0 0,0 0,0 0,0 0,1 0,-1 0,0 0,0 0,0 0,0 0,0 0,0 0,0 0,1 0,-1-1,0 1,0 0,0 0,0 0,0 0,0 0,0 0,0 0,0 0,1 0,-1 0,0-1,0 1,0 0,0 0,0 0,0 0,0 0,0 0,0-1,0 1,0 0,0 0,0 0,0 0,0 0,0 0,0-1,0 1,0 0,0 0,0 0,-11-5,-19-1,10 6,1 1,0 0,0 1,0 1,0 1,0 1,1 0,0 2,-31 14,14-2,0 1,2 2,-53 43,53-36,2 2,1 2,1 0,2 2,1 1,2 1,2 1,1 2,2-1,-27 84,35-87,2-1,1 1,2 1,2-1,1 1,2 0,1 0,2 0,2 0,1-1,1 0,3 0,19 54,-8-45,1 0,3-2,1 0,3-2,1-1,2-1,1-2,2-1,2-2,40 31,-67-58,0 0,0-1,1 0,0-1,0 0,20 6,-27-10,1 0,-1 0,1 0,-1-1,1 0,-1 0,0 0,1 0,-1 0,1-1,-1 1,1-1,-1 0,0 0,1 0,-1-1,0 1,0-1,0 0,0 1,0-1,0-1,-1 1,1 0,3-5,-1 0,0-1,0 0,-1 0,0 0,0 0,-1-1,0 1,-1-1,0 0,1-9,-1 2,-1 1,0-1,-1 1,0-1,-4-16,4 26,-1 0,-1 0,1 0,-1 1,0-1,0 0,-1 1,1-1,-1 1,-1 0,1 0,-1 0,0 1,0-1,0 1,0 0,-1 0,1 0,-1 1,0 0,-1-1,1 2,0-1,-1 1,0 0,1 0,-1 0,0 1,0 0,0 0,0 0,0 1,-12 1,4 1,0 1,1 0,-1 1,1 1,0 0,0 1,0 0,1 1,0 1,0 0,1 0,-16 16,4-3,1 2,2 1,0 0,-26 44,29-38,1 1,1 1,1 0,2 1,2 0,0 1,3 0,1 0,1 0,2 1,1 0,3 36,2-55,-1 0,2-1,0 1,1-1,1 1,0-2,1 1,0-1,1 0,1 0,13 15,-13-17,1-1,1 0,0-1,0 0,1 0,1-2,-1 1,1-1,1-1,-1-1,1 0,15 5,-26-10,0 0,-1-1,1 1,0 0,0-1,0 0,0 1,0-1,0 0,0-1,0 1,0 0,0-1,0 0,-1 0,4-1,-6 2,1 0,-1 0,0-1,1 1,-1 0,0 0,0-1,1 1,-1 0,0-1,0 1,0 0,1-1,-1 1,0-1,0 1,0 0,0-1,0 1,0 0,0-1,0 1,0-1,0 1,0 0,0-1,0 1,0-1,0 1,0 0,-1-1,1 1,0 0,0-1,0 1,0 0,-1-1,1 1,0 0,-1-1,1 1,-1 0,-15-13,2 7,0 0,0 0,-1 1,1 1,-1 0,-28-2,19 4,0 1,0 0,-43 7,33 1,0 1,1 2,0 1,0 2,2 1,-1 2,2 1,0 1,1 1,1 2,-33 31,46-37,1 0,-22 29,32-39,1 0,0-1,0 1,1 0,-1 1,1-1,0 0,1 1,-1-1,1 1,0-1,0 1,1 0,0-1,0 7,1-9,-1-1,1 0,-1 0,1 0,0 0,0 0,0 0,0 0,0 0,0 0,0 0,1-1,-1 1,1 0,-1-1,1 1,2 1,0-1,-1 0,1 0,-1-1,1 1,0-1,0 0,0 0,8 1,-1-1,1-1,-1 0,1-1,-1 0,0-1,12-3,-3-1,-1-1,0-1,-1-1,1 0,-2-2,1 0,-2-1,1 0,26-29,-17 15,-2-2,-1-1,-1-1,29-53,-41 65,0-1,-1-1,-1 0,-1 0,-1 0,6-36,-11 50,0 0,-1 0,0 0,0-1,0 1,-1 0,0 0,0 0,0 0,-1 0,0 0,0 1,-1-1,1 1,-1-1,-1 1,1 0,-1 0,1 0,-2 0,1 1,0 0,-1 0,0 0,1 0,-2 1,-6-5,-7 0,0 0,0 2,0 0,-1 1,0 1,0 0,0 2,-25 0,-167 11,196-8,-162 18,-215 49,380-65,0 0,1-1,-1 2,1 0,-1 0,1 1,-19 11,30-15,0-1,0 0,0 1,0 0,1-1,-1 1,0-1,0 1,1 0,-1-1,0 1,1 0,-1 0,1 0,-1 0,1-1,-1 1,1 0,0 0,-1 0,1 0,0 0,0 0,-1 0,1 0,0 0,0 0,0 0,0 0,1 0,-1 0,0 0,0 0,1 0,-1 0,0 0,1 0,-1 0,1-1,-1 1,1 0,-1 0,2 1,2 1,-1 0,1 0,0 0,0 0,0-1,1 0,-1 0,6 2,9 2,1 0,0-2,1 0,-1-2,1 0,-1-1,1-1,0-1,23-4,-14 0,0-1,-1-1,0-2,0-1,46-22,-63 25,-1 0,1 0,-1-1,-1 0,1-1,-2 0,16-18,-20 20,0 0,0 0,-1 0,0-1,0 0,-1 0,0 0,0 0,-1 0,0-1,0 1,0-18,-2 23,0 0,0-1,0 1,-1 0,1 0,-1-1,0 1,0 0,0 0,0 0,-3-4,0 2,1 0,-1 0,-1 1,1-1,-10-7,-4-1,-1 1,0 0,-31-14,-74-23,27 16,-2 4,-122-19,145 37,1 3,-1 3,-131 10,157 1,1 1,1 3,0 3,0 1,1 2,1 2,1 3,1 1,0 2,2 2,-48 39,78-56,1 0,0 1,0 1,1 0,1 0,-12 17,20-25,-1-1,1 0,0 1,-1-1,1 1,0-1,1 1,-1 0,0-1,1 1,-1 0,1 0,0-1,0 1,0 0,0 0,1-1,-1 1,1 0,-1 0,1-1,0 1,0-1,0 1,1-1,-1 1,1-1,-1 0,1 1,0-1,-1 0,1 0,0 0,1-1,-1 1,0 0,0-1,1 1,-1-1,4 1,7 4,1 0,0-1,0 0,1-2,-1 1,1-2,0 0,0-1,0 0,0-1,0-1,0 0,23-6,-34 6,-1 0,1 0,0 0,-1-1,0 1,1-1,-1 0,0 0,0 0,0 0,0-1,0 1,0-1,-1 0,1 0,2-4,-4 4,0 0,0 0,0 0,-1 1,1-1,-1 0,1 0,-1 0,0 0,0 0,-1 0,1 0,0 0,-1 0,0 0,0 1,0-1,0 0,0 0,0 1,-1-1,-2-3,-2-4,-1 1,-1-1,1 1,-2 1,1-1,-11-7,-65-42,27 26,-2 1,-83-29,-133-30,-110-2,-8 23,359 64,28 4,-38-6,0-1,-62-22,103 29,0 0,-1-1,1 1,1-1,-1 1,0-1,0 0,1 0,-1-1,1 1,-1 0,1-1,0 0,0 1,0-1,0 0,1 0,-1 0,1 0,0 0,0 0,0-1,0 1,0 0,1 0,-1-1,1 1,0-1,0 1,1-6,1-2,0 1,1-1,0 1,0 0,1 0,0 0,1 1,0 0,10-13,163-188,-146 175,605-705,-589 679,70-117,-112 167,0 0,-1-1,0 1,-1-1,0 0,-1 0,3-19,-6 27,1 0,-1 1,-1-1,1 0,0 1,-1-1,0 1,0-1,0 1,0-1,-1 1,1 0,-1-1,0 1,0 0,0 0,0 0,0 0,-1 1,1-1,-1 1,0-1,0 1,0 0,0 0,0 0,0 1,-6-3,-8-2,0 1,0 1,-1 0,0 1,0 1,-21 0,-22 1,0 3,1 2,-1 3,1 2,-63 20,0 7,-161 71,165-55,-131 79,198-99,1 2,2 2,2 2,-73 76,107-100,1 1,1 0,0 0,1 1,1 0,-9 21,15-31,1 1,0 0,0-1,0 1,1 0,0 0,0 0,1 0,0 0,0 0,1 0,0 0,0 0,1-1,0 1,0 0,0-1,1 1,4 7,-2-6,0 0,1-1,-1 0,1 0,1-1,0 0,-1 0,11 6,0-1,1-1,30 13,-14-9,2-2,0-1,0-2,0-1,1-2,54 2,-44-8,1-2,-1-1,0-3,79-20,-47 4,0-4,-2-4,89-47,-109 47,-2-3,-1-3,-2-1,81-78,-116 99,-1-2,-1 0,0 0,-2-1,0-1,-1 0,13-33,-21 43,0 0,-1 0,-1 0,1-1,-2 1,1-1,-1 1,-1-1,0 0,-1 1,0-1,0 0,-1 1,-1-1,1 1,-2 0,0 0,-5-11,2 9,0 1,0 0,-1 1,0 0,-1 0,0 1,-19-15,12 12,-2 1,1 0,-2 1,-25-9,-3 2,-2 3,0 1,-60-6,12 7,1 5,-1 4,0 4,1 5,0 3,0 5,1 4,-182 60,236-64,-66 34,97-43,0 1,0 1,0-1,1 1,0 1,1 0,-1 0,1 1,1 0,0 0,-7 12,11-16,1-1,0 1,0 0,0 0,1 1,-1-1,1 0,1 0,-1 1,1-1,0 0,0 1,0-1,1 0,0 1,0-1,0 0,1 0,-1 0,1 0,1 0,-1 0,1 0,-1-1,6 7,2 0,0 0,0 0,1-1,1 0,0-1,0-1,0 0,17 8,19 6,1-2,0-3,1-1,56 9,4-4,1-4,1-6,0-4,0-5,1-5,-1-5,-1-4,133-34,-199 35,0-2,-1-1,0-3,49-27,-80 36,0 0,-1-1,0 0,-1 0,0-1,0-1,-1 0,-1-1,0 0,10-17,-15 23,-1 0,0-1,0 1,-1-1,1 0,-2 0,1 0,-1 0,0 0,0 0,-1 0,0-1,0 1,-1 0,0 0,0 0,0 0,-1 0,0 0,-1 1,0-1,0 0,-5-8,-1 3,-1 0,0 0,0 1,-2 1,1-1,-1 2,0 0,-1 0,0 1,-1 1,1 0,-26-9,-2 3,-1 1,0 2,-60-7,35 10,0 4,-1 2,1 3,0 4,0 2,1 3,0 3,-74 26,103-27,1 1,0 2,1 2,1 1,1 1,-43 36,59-42,1 1,0 1,1 1,1 0,-15 26,21-30,0 2,1-1,1 1,0 0,1 0,1 1,0-1,-1 19,4-24,0 0,1 0,0 0,1 0,0 0,1 0,0 0,1 0,0-1,6 15,-3-12,1 1,0-1,1-1,1 1,0-2,18 19,-1-7,0-2,2 0,0-2,1-1,50 21,-1-6,2-4,0-3,2-4,156 20,-144-32,0-4,1-5,-1-3,107-18,-134 9,-1-2,-1-3,122-50,-148 49,-1-1,-1-1,-1-3,-1-1,-1-1,-1-2,39-42,-57 52,0 0,-2-1,0-1,-1 0,0-1,-2 0,-1 0,12-37,-17 42,0-1,-1 0,-1 0,-1 0,0 0,-1 0,-1 0,0 0,-1 0,-1 0,0 0,-10-26,3 18,-2-1,-1 2,-1 0,0 0,-2 1,-1 1,0 1,-2 0,0 1,-36-27,6 12,0 1,-2 3,-94-41,-28 6,140 56,-1 0,0 3,-41-4,68 9,0 1,0 0,0 0,0 0,0 1,-13 3,18-3,1-1,-1 1,0 0,1 0,-1 0,1 0,-1 0,1 0,-1 0,1 1,0-1,0 0,0 1,0-1,0 1,0-1,0 1,0 0,0-1,1 1,-1 0,1 0,-1-1,1 1,0 0,-1 0,1 0,0-1,0 1,1 3,0 3,0-1,1 1,0-1,1 1,-1-1,2 0,-1 0,1 0,-1 0,2-1,-1 1,9 8,6 8,1 0,1-2,1 0,1-2,43 29,-13-16,105 46,87 12,-99-49,3-7,0-7,2-6,202 2,-253-23,0-5,101-18,-131 10,-1-3,0-3,103-43,-136 46,-1-1,0-2,62-46,-80 51,0-1,0-1,-2 0,0-1,-1-1,0 0,-2 0,11-23,-18 31,0 0,0-1,-2 0,1 0,-1 0,-1-1,0 1,-1 0,0-1,-1-20,-1 23,0-1,-1 1,-1 0,1-1,-2 1,1 0,-1 1,0-1,-1 1,0-1,-1 1,1 1,-10-10,-1 1,-1 0,-1 1,0 1,-1 1,-1 0,0 1,0 2,-37-15,8 9,-1 1,-97-15,81 22,-121-1,65 14,1 6,-142 31,-234 88,346-80,-200 95,279-109,1 4,2 2,2 3,-94 83,132-100,1 0,1 2,-43 62,59-75,1 0,1 1,1-1,0 2,1-1,1 1,1 0,1 0,-4 32,8-39,0 0,0 0,1 0,1 0,0-1,0 1,2-1,-1 1,10 20,-5-17,1-1,0 0,0 0,2-1,0 0,16 15,2-3,0-2,2-1,1-2,0-1,56 24,-19-15,1-3,122 27,155-2,-238-43,0-4,114-13,-152 3,-1-3,0-4,-1-2,80-31,-124 37,0-1,0-1,-1 0,-1-2,0-1,33-29,-45 34,-1 0,0-1,-1 0,-1 0,1-1,-2 0,0-1,0 1,-1-2,0 1,-2 0,1-1,4-28,-7 23,-2 0,1 0,-2 0,-1 0,0 0,-1 0,-1 1,-1-1,-1 1,0 0,-1 0,-11-18,1 5,-1 1,-2 0,-1 2,-1 0,-47-44,28 35,-2 2,-2 2,-1 1,-61-30,35 27,-1 3,-110-33,51 31,0 5,-2 6,-160-6,177 23,-1 4,-205 24,267-13,0 2,-103 37,123-33,0 1,2 1,0 2,1 1,-34 28,51-35,0 1,1 0,1 1,0 1,1 0,1 1,-15 27,21-32,0 1,1-1,0 1,1 0,1 0,0 0,1 1,0-1,1 0,1 1,0 0,2 18,2-13,-1-1,2 1,1-1,0 0,1-1,1 1,1-1,0-1,22 31,-12-26,0 1,1-2,1-1,1 0,0-2,26 15,6-1,3-2,0-3,2-2,0-3,78 16,-53-18,0-4,1-3,0-4,0-4,151-12,-176 1,-2-3,1-3,88-30,-105 27,0-2,-1-2,-1-2,-1-1,45-36,-62 41,-1-2,0 0,-2-1,0-2,-2 0,0 0,-1-2,-2 0,0 0,-2-1,-1-1,-1 0,-1-1,-2 0,0 0,-2 0,-2-1,0 0,-2 0,-1 0,-1 0,-1 0,-2 1,-7-29,3 25,-2 1,0 0,-2 1,-2 0,0 1,-2 0,-33-43,25 42,-1 1,-2 1,0 1,-2 1,-1 2,-36-22,26 22,0 1,-1 3,-1 2,-1 1,-1 2,0 2,-1 2,0 2,0 2,-1 2,-79 1,110 5,0 0,0 0,0 2,0 0,0 0,-24 10,34-11,1 1,-1-1,0 1,1 0,0 0,-1 0,1 0,0 1,1 0,-1 0,1 0,0 0,0 1,0-1,0 1,1-1,0 1,0 0,0 0,0 0,1 0,-1 10,1-9,1 1,0 0,0 0,1 0,0-1,0 1,1 0,0-1,0 1,0-1,1 1,0-1,0 0,0 0,6 7,4 2,0 0,0 0,1-1,23 16,7 3,1-3,2-1,0-3,2-2,71 25,-46-24,2-3,0-4,90 10,-115-22,0-2,1-2,-1-3,91-12,-119 8,1 0,-1-2,-1 0,1-2,25-14,-33 15,-1 0,-1-2,0 0,0 0,-1-1,0 0,-1-1,15-21,-12 11,-2 0,-1-1,0 0,-2-1,0-1,-2 1,-1-1,0 0,-2 0,-1-1,-1 1,-2-1,0 0,-2 1,-8-49,7 63,0 0,-1 1,0 0,0 0,-1 0,-1 0,-7-10,11 17,0 0,0 0,0 0,-1 1,1-1,-1 1,0-1,0 1,0 0,0 0,0 0,0 1,0-1,-1 1,1-1,-1 1,1 0,-1 1,1-1,-1 0,0 1,1 0,-1 0,0 0,-4 1,0 2,0 0,1 1,-1 0,1 0,0 0,0 1,0 0,0 1,1 0,0 0,-6 8,-12 13,1 1,1 1,2 2,-22 42,-53 141,50-94,5 2,-36 185,60-212,4 0,4 1,9 189,3-239,1-1,2-1,3 1,1-1,23 57,-26-82,1-1,1 0,1-1,0 0,1 0,15 14,-17-20,1-1,0-1,0 0,1 0,0-1,1-1,0 0,0 0,18 5,-15-8,0 0,0-1,0 0,0-2,1 0,-1 0,0-2,1 0,-1-1,0 0,0-1,0-1,0-1,-1 0,16-8,5-5,-1 0,-1-3,-1-1,0-1,33-32,-5-2,-3-2,-2-3,-3-3,-3-1,-3-3,-3-2,36-79,-40 64,-4-2,-4-1,-3-2,-5-1,24-184,-43 224,-2-1,-3 0,-2 0,-3 0,-1 1,-25-93,22 113,-2 1,-1 1,-1 0,-2 0,0 2,-2 0,-2 0,0 2,-2 1,0 0,-2 1,-28-22,19 23,0 1,-1 1,-2 3,0 0,0 2,-2 2,0 2,0 1,-42-7,5 7,1 2,-1 4,-137 8,207-3,-143 16,133-13,-1 0,1 1,0 1,0 0,0 1,1 0,-25 16,31-16,0 1,1 0,-1 0,1 0,1 1,0 0,0 0,0 0,1 0,0 1,0 0,1 0,1 0,-3 10,0 11,0 0,2 1,1 32,2-49,1-1,0 1,1-1,0 0,1 1,1-1,0 0,1-1,0 1,1-1,0 0,1 0,0-1,1 0,1 0,9 9,-5-7,0-1,2 0,-1-1,2-1,-1-1,1 0,0-1,1 0,0-1,0-1,26 5,-13-5,-1-1,2-1,-1-2,0-1,47-5,-62 3,0-1,0-1,0-1,-1 0,1-1,-1 0,0-1,0-1,-1 0,0-1,0 0,21-19,-27 20,-1 1,1-1,-2-1,1 1,-1-1,0 0,-1-1,0 1,0-1,-1 1,0-1,2-12,-3 8,-1 1,0-1,0 0,-2 0,0 0,0 1,-1-1,-4-14,-2 0,-2 0,-1 1,-1 0,-1 0,-2 1,0 1,-25-29,36 47,-14-13,17 18,0 1,1-1,-1 1,0 0,1 0,-1-1,0 1,1 0,-1 0,0 0,0 0,1 0,-1 0,0 0,1 0,-1 0,0 0,1 0,-1 0,0 0,0 1,1-1,-1 0,0 1,1-1,-1 0,1 1,-1-1,1 1,-1-1,0 1,1-1,0 1,-1 0,-12 16,2 0,0 1,1 0,1 1,-12 36,-4 6,-29 49,-26 62,77-167,-7 26,9-30,1 0,0 0,-1 0,1 0,0 1,0-1,0 0,0 0,0 0,0 0,0 0,0 1,0-1,0 0,1 0,-1 0,0 0,1 0,0 2,0-3,0 0,0 1,-1-1,1 0,0 0,0 0,0 0,0 0,0 0,0 0,-1 0,1 0,0 0,0 0,0-1,0 1,0 0,-1 0,1-1,0 1,0-1,-1 1,2-2,15-7,-1-1,0-1,-1 0,0-1,13-15,67-77,-57 58,-2-1,-2-2,-2-2,-2-1,-3-1,-2-1,23-73,-42 108,-1 0,-1-1,-1 1,2-31,-5 42,0 0,0 0,-1 1,-1-1,1 0,-1 0,0 1,-1-1,0 1,0 0,-1 0,0 0,0 0,-5-6,-1 3,0 0,0 0,-1 2,0-1,-1 1,1 1,-1 0,-1 1,0 0,1 1,-2 0,-21-4,-14-1,0 2,-58-2,8 5,-1 4,1 5,-121 19,206-21,-3 1,-33 9,46-11,1 0,0 0,0 0,0 1,0-1,0 1,0 0,0 0,1 0,-1 0,0 0,1 1,0-1,0 1,0-1,-3 5,5-5,-1 0,0 0,1 1,-1-1,1 0,0 1,0-1,0 0,0 1,0-1,0 0,1 1,-1-1,1 0,0 0,-1 1,3 2,22 36,-2-11,2-1,1-2,34 29,95 67,-115-93,1-2,75 38,-95-58,-21-8,0 0,1 0,-1 0,0 0,0 0,0 0,1 0,-1 0,0 0,0 0,0 0,1 0,-1 0,0 0,0 0,0 0,1 0,-1 0,0 0,0 0,0 0,1 0,-1 0,0 0,0-1,0 1,1 0,-1 0,0 0,0 0,0 0,0-1,0 1,0 0,1 0,-1 0,0-1,0 1,0 0,0 0,0 0,0-1,0 1,0 0,0 0,0 0,0-1,0 1,0 0,0 0,0 0,0-1,0 1,0 0,0 0,0 0,0-1,-1 1,1 0,0 0,0-1,-8-12,-3 0,0 1,-1 0,-24-18,-47-28,62 44,-4-3,-1 2,0 0,-1 1,-1 2,-36-11,50 19,0 1,0 0,0 1,0 1,0 0,0 0,0 2,0 0,-1 1,1 0,0 1,1 0,-23 9,13-1,1 1,1 0,0 2,0 0,-30 29,9-2,-50 62,54-54,3 1,1 2,3 2,2 1,3 1,-29 90,30-51,23-86,0 0,1 0,1 1,-1-1,2 1,-1-1,1 0,3 10,-4-16,1 0,0-1,0 1,0 0,1-1,-1 1,1-1,-1 1,1-1,0 0,0 0,0 0,0 0,0 0,1 0,-1 0,0-1,1 1,0-1,-1 0,1 0,0 0,-1 0,1 0,0 0,0-1,4 1,-4-1,1 0,0 0,-1 0,1-1,0 1,0-1,-1 0,1 0,-1-1,1 1,-1 0,0-1,1 0,-1 0,0 0,0 0,0-1,0 1,-1-1,5-4,-3 0,0-1,0 0,0 1,-1-1,0 0,0-1,-1 1,0 0,0-1,-1 0,-1 1,1-1,-1 1,-2-16,0 9,0 1,-1-1,-1 1,0 0,-1 0,0 0,-15-25,13 27,-2 0,1 1,-1 0,-1 0,0 1,-1 0,0 1,0 0,-24-13,17 12,-1 2,-1 0,1 0,-1 2,0 1,-25-4,0 4,1 3,-1 1,0 2,0 2,-76 15,35 1,1 5,1 3,1 4,-151 80,205-96,1 2,1 1,1 2,0 0,1 2,1 0,2 2,-21 27,34-39,1 1,0 0,1 0,1 1,0 0,1 0,0 0,-3 21,6-23,1 1,1-1,0 0,0 1,1-1,1 1,0-1,0 0,1 0,1 0,6 14,-2-9,1-1,1 0,0-1,1 0,0-1,2 0,-1-1,2 0,-1-1,2 0,0-1,0-1,1 0,0-2,0 1,1-2,21 7,-32-13,0 1,0-1,0 0,0 0,0-1,0 0,-1 0,1 0,0-1,0 0,0 0,0 0,8-3,-10 1,1 1,-1 0,0-1,0 0,0 0,0 0,-1-1,1 1,-1-1,0 0,0 0,0 0,0 0,-1 0,0-1,3-6,0-4,0-1,-1 1,-1-1,0 0,-2 0,1 0,-2 0,0 0,-1-1,-1 1,0 1,-1-1,-1 0,0 1,-2-1,1 1,-2 0,-8-14,4 9,-1 0,-1 1,0 0,-2 1,0 1,-1 0,-1 2,0-1,-1 2,-1 0,0 2,-25-13,12 11,0 1,-2 2,1 2,-1 1,0 1,-46-2,6 5,-141 10,42 14,135-13,0 1,-55 19,88-25,0 1,-1-1,1 1,0 0,0 0,0 0,1 1,-1 0,1 0,0 0,0 0,-6 9,6-6,0 0,1 0,0 1,0-1,0 1,1 0,0 0,-1 11,2-6,1 0,0 0,0 0,1 0,1 0,1 0,-1 0,8 19,-1-9,1 0,1-1,22 35,-22-42,1 0,0 0,1-2,0 1,1-2,29 21,-7-10,72 33,-77-41,2-1,0-2,0-2,1-1,0-1,65 6,-86-14,1 0,0-1,0 0,0-1,-1 0,1-2,-1 1,22-10,-26 9,0-1,0-1,-1 1,0-1,0-1,0 1,-1-1,0-1,0 1,-1-1,0 0,0-1,4-9,-5 9,0-1,-1 0,-1 0,1 0,-2-1,1 1,-1-1,-1 1,0-1,-1 0,0 1,0-1,-1 0,0 1,-1-1,-1 1,1-1,-2 1,1 0,-1 0,-1 0,0 1,-8-12,0 2,-1 0,-1 2,0-1,-2 2,0 0,-1 1,0 1,-1 1,-37-20,22 17,0 2,-1 1,0 2,-1 1,-1 2,1 2,-1 1,0 2,0 1,0 2,0 2,0 1,0 2,0 1,1 2,-49 18,74-22,-1 0,2 1,-1 0,-19 13,28-16,-1 0,1 1,-1-1,1 0,0 1,0 0,0-1,0 1,0 0,1 0,-1 0,1 0,0 0,0 0,0 0,0 1,0-1,1 0,0 1,0-1,-1 0,2 5,0-1,0 0,1 0,0 0,0 0,1 0,-1-1,1 1,1-1,0 0,-1 0,2 0,-1 0,1-1,0 1,0-1,0 0,7 4,2 1,1 0,0-1,0-1,1-1,0 0,19 5,6 0,0-3,1-1,0-2,0-2,1-2,0-2,51-6,-25-2,-1-4,-1-2,116-41,-124 32,-1-2,-1-2,-1-3,-1-2,-3-3,91-77,-114 84,0-1,-3-1,0-2,39-64,-50 70,-1-2,-1 0,-2 0,-1-1,-1-1,-1 1,3-34,-9 47,-1-1,0 1,-1-1,-1 0,0 1,-1-1,-9-30,8 36,-1 1,-1 0,1 0,-2 0,1 0,-1 1,-1 0,1 0,-2 0,1 1,-1 1,-15-12,7 7,-1 2,0 0,-1 1,0 0,0 2,-1 0,0 1,0 1,0 1,-1 1,1 0,-1 2,-25 0,10 3,-1 2,1 1,0 1,1 3,0 0,-53 23,10 3,1 3,2 3,-113 84,105-61,2 4,-110 124,165-163,0 2,2 0,-26 49,39-63,2 1,0 1,1-1,1 1,0 1,2-1,0 1,-1 29,5-38,1 0,0 1,0-1,2 0,-1 1,1-1,1-1,0 1,1 0,-1-1,2 0,0 0,8 10,-5-8,1 0,0-1,1 0,0-1,0 0,1-1,1 0,-1-1,26 11,2-2,1-3,0-1,57 9,133 9,60-15,-259-16,-1-2,1-2,0-1,-1-1,0-1,0-2,31-14,-48 16,0 0,-1 0,0-2,-1 0,1 0,-2-1,1-1,-2 1,1-2,-1 0,-1 0,0-1,-1 0,0 0,-1-1,-1 0,0 0,-1 0,0-1,-1 0,-1 0,-1 0,0 0,0-1,-2 1,0-1,-1 1,-3-22,0 16,-1 1,-1 0,-1 0,0 0,-2 1,0 0,-1 1,-1 0,0 0,-2 1,0 1,0 0,-2 1,0 0,-29-20,16 15,-1 1,-1 2,0 2,-1 0,-1 2,0 1,-1 2,-63-12,43 15,0 3,0 1,-1 3,1 3,0 1,0 3,-77 20,51-4,0 3,2 3,1 4,-81 47,140-70,-1 1,2 1,-1 0,2 1,-1 0,2 1,-21 27,26-30,2 1,0 0,0 1,1-1,1 1,0 1,1-1,0 1,1-1,0 1,0 25,3-20,1 0,0 0,2 0,0 0,1-1,1 1,1-1,1 0,0 0,1-1,1 0,12 17,6 5,1-1,3-2,59 57,-32-40,2-3,3-3,100 58,-151-98,33 16,-43-21,0-1,1-1,-1 1,1 0,-1-1,1 1,-1-1,1 0,-1 1,1-1,0-1,-1 1,1 0,-1-1,4 0,-5 0,0 1,0-1,0 0,0 1,0-1,0 0,0 0,0 0,0 0,-1 0,1 0,0 0,0 0,-1 0,1-1,-1 1,1 0,-1 0,0 0,1-1,-1 1,0 0,0 0,0-1,0 1,0 0,0-1,0 1,0 0,-1 0,0-2,0-4,-1 0,0 1,-1-1,-5-9,-7-10,-1 0,-1 2,-1 0,-2 1,0 1,-1 0,-31-23,24 24,-1 1,0 1,-2 1,0 2,-64-24,84 36,-2 0,1 1,0 0,0 1,-1 0,1 1,-1 1,0 0,1 0,-1 2,1-1,-1 1,1 1,0 1,0-1,0 2,1 0,-1 0,1 1,0 0,1 1,-1 0,1 1,1 0,-15 16,7-4,1 1,1 1,1 0,0 1,2 0,1 1,-14 44,10-19,3 1,1 1,-3 53,11-70,2 0,4 60,0-73,0 1,2-1,0 0,2 0,13 31,-7-26,1-1,1 0,1-1,1-1,1-1,26 26,-16-22,1-2,1 0,1-2,41 22,-13-14,1-3,1-3,2-2,0-3,82 13,77-1,-172-28,0-2,75-8,-95 3,-1-1,1-1,-2-2,1-1,36-17,-44 16,-1-1,0-2,-1 0,0 0,-1-2,0 0,25-30,-23 20,0-1,-2-1,-1-1,-2 0,0-1,-2-1,15-52,-19 53,-3 0,0-1,-2 0,-1 0,-1 0,-2-1,-1 1,-6-39,4 51,-2 0,0-1,-1 2,0-1,-2 1,0 0,-1 0,-1 1,0 0,-1 1,-1 0,0 1,-1 0,-1 1,0 1,0 0,-1 0,-1 2,0 0,-1 1,1 0,-2 2,1 0,-1 1,0 0,0 2,-1 0,1 1,-1 1,-21 0,20 2,0 1,0 1,0 0,0 2,1 0,-1 2,1 0,1 1,-29 14,26-10,1 2,1 0,0 1,0 1,1 0,1 1,-27 35,31-34,1 1,0 0,2 1,0 0,1 0,1 1,1 0,-8 38,12-41,1 1,0 0,2-1,0 1,1 0,0 0,2-1,0 1,1-1,1 0,8 21,-3-16,1 0,2-1,0-1,0 0,2-1,1-1,0 0,1-1,1 0,1-2,38 25,-14-14,1-2,1-2,1-2,88 25,-42-21,1-4,110 8,196-14,-298-16,1-4,-1-5,-1-4,159-45,-205 42,0-3,-2-1,89-54,-104 52,-1-2,-1-1,-1-2,-1-1,43-53,-59 61,-1-1,-1-1,-1 0,-1-1,-1-1,-1 0,-1 0,-2-1,10-50,-13 36,-1-1,-1 1,-3 0,-1-1,-13-75,10 94,-2 0,0 0,-1 0,-1 1,-1 0,-1 1,-16-27,19 38,1 1,-1-1,-1 2,0-1,0 1,-1 0,0 1,0 0,0 0,-1 1,0 0,0 1,-1 0,0 1,0 0,-21-5,19 7,1 1,-1 0,0 0,1 1,-1 1,1 0,-1 1,1 0,-1 1,-21 8,18-4,1 0,0 1,1 1,0 0,0 1,1 1,-18 17,12-7,1 0,1 1,1 1,1 0,1 1,1 1,1 0,1 1,-13 47,22-62,0-1,0 1,1-1,0 1,1-1,1 1,-1-1,2 1,-1-1,7 20,-3-16,1 1,0-1,1 0,1-1,0 0,17 21,-2-9,0-1,2-2,0 0,1-2,1-1,33 18,-11-10,1-3,1-2,89 26,-101-38,-1-1,1-3,1-1,-1-1,77-5,-104 0,-1 0,1-1,-1-1,0 0,0 0,0-1,0 0,13-8,-19 9,0 0,0-1,-1 1,0-1,1 0,-1 0,0 0,-1 0,1-1,-1 0,0 0,0 0,-1 0,1 0,-1 0,0-1,-1 1,3-9,-3 7,-1 0,1 1,-1-1,0 0,0 0,-1 0,0 0,0 0,-1 0,0 1,0-1,-1 1,-3-9,0 7,1-1,-1 0,-1 1,1 0,-1 1,-1-1,1 1,-11-6,-3-1,0 1,-1 1,0 1,-1 1,-1 0,-37-8,6 6,0 3,-1 2,1 3,-1 2,-104 9,129-3,1 0,-1 2,1 1,-34 13,42-11,2 0,-1 2,2 0,-1 1,1 1,-22 20,8 0,1 0,2 2,2 1,1 1,2 2,1 0,2 2,2 0,2 2,2 0,1 0,-17 92,29-116,1 1,1 0,0 0,2 0,0 0,1-1,5 21,-4-28,1-1,0 0,0 1,1-2,1 1,-1 0,2-1,-1 0,2-1,-1 0,1 0,1 0,11 9,11 3,2-1,0-1,1-2,0-2,41 13,-37-15,1-1,0-2,1-2,0-1,1-2,62-1,198-21,-59-10,243-60,-116-11,453-184,-513 151,-64 9,-179 85,-1-3,97-79,-155 113,46-43,-50 46,0-1,0 1,0-1,-1 0,1 0,-1 0,0-1,0 1,0 0,-1-1,2-5,-3 9,0-1,0 1,0 0,0-1,0 1,-1-1,1 1,0 0,-1-1,1 1,0 0,-1 0,0-1,1 1,-1 0,0 0,0 0,0 0,1 0,-1 0,0 0,0 0,-1 0,1 0,0 0,0 0,0 1,0-1,-1 1,1-1,0 1,-1-1,1 1,0 0,-1 0,1-1,-3 1,-4-1,0 1,0-1,0 1,0 1,-10 1,-21 7,1 1,1 2,-43 20,24-10,-91 36,-155 86,301-144,-12 7,0 1,0 1,-16 13,27-20,-1 1,1-1,0 1,-1 0,1 0,1 0,-1 0,-3 6,5-7,-1-1,1 1,0 0,-1-1,1 1,0 0,0-1,0 1,0 0,1-1,-1 1,0 0,1-1,-1 1,1-1,-1 1,1-1,0 1,1 1,0 0,0 0,0 0,1-1,-1 0,1 1,0-1,0 0,-1 0,1 0,0-1,1 1,3 1,44 11,-47-14,48 10,1-3,82 0,112-19,-72-6,-1-8,188-53,-341 73,0 0,-1-1,1-1,-1-1,22-13,-41 21,1 0,-1 0,1 0,-1 0,1-1,-1 1,1 0,-1-1,0 1,0-1,0 1,0-1,0 0,0 1,0-3,0 3,-1 0,0 0,0 0,0 0,0 0,-1 0,1 1,0-1,0 0,0 0,-1 0,1 0,0 0,-1 1,1-1,-1 0,1 0,-1 1,0-1,1 0,-1 1,-1-2,-3-2,0 1,-1 0,0-1,0 2,0-1,0 1,-12-3,-25-4,-1 1,1 2,-2 3,-68 2,31 6,-131 25,182-23,1 0,1 2,-1 2,2 0,-38 22,52-26,1 1,0 1,1 0,0 1,0 0,1 1,0 0,1 1,0 0,1 0,1 1,-11 22,16-30,1 1,-1 1,2-1,-1 0,1 0,0 1,0-1,1 0,0 11,0-14,0-1,1 1,-1-1,1 0,0 0,-1 1,1-1,0 0,0 0,1 0,-1 0,0 0,1 0,-1 0,1 0,0-1,-1 1,1-1,0 1,0-1,0 1,0-1,0 0,0 0,0 0,1 0,-1-1,3 2,5-1,-1 1,1-1,0 0,11-1,-17 0,0 0,-1-1,1 1,0-1,0 0,0 0,-1 0,1 0,0-1,-1 1,1-1,4-4,-7 6,-1 0,0 0,0 0,1 0,-1-1,0 1,0 0,1 0,-1 0,0 0,0-1,0 1,0 0,1 0,-1 0,0-1,0 1,0 0,0 0,0-1,0 1,0 0,1 0,-1-1,0 1,0 0,0 0,0-1,0 1,0 0,0-1,0 1,-1 0,1 0,0-1,0 1,0 0,0 0,0-1,0 1,0 0,-1 0,1 0,0-1,0 1,0 0,-1 0,-14-4,7 5,1-1,0 1,1 1,-1-1,0 1,0 0,0 1,-7 4,-52 32,53-31,-15 10,2 2,0 0,1 2,1 0,1 2,-35 45,54-63,0 0,1 0,-1 0,1 0,0 1,-2 7,5-12,-1 0,1 0,0 0,-1 0,1 0,0 0,0 0,1 0,-1 0,0 1,0-1,1 0,0-1,-1 1,1 0,0 0,0 0,0 0,0 0,0-1,0 1,0 0,1-1,-1 1,2 0,2 2,0-1,0 0,-1 0,2-1,-1 0,0 0,0 0,1 0,-1-1,1 0,8 1,4-1,-1 0,26-3,-21-1,0 0,1-2,-1 0,38-16,-46 16,-1-1,0-1,-1 0,0 0,0-2,0 1,-1-1,17-19,-26 27,-1-1,0 1,0-1,1 1,-1-1,0 1,0-1,-1 1,1-1,0 0,0 0,-1 1,1-1,-1 0,0 0,1 0,-1 0,0 0,0 1,0-1,0 0,-1-2,0 2,0 0,0 0,0 0,0 1,-1-1,1 0,0 1,-1-1,0 1,1 0,-1-1,0 1,1 0,-1 0,0 0,-3-1,-5-1,0 0,1 0,-1 1,0 0,0 1,-1 0,-11 0,-3 4,0 1,0 1,0 1,0 2,1 0,0 1,1 2,0 0,-33 23,43-26,2 0,-1 1,1 1,-19 21,25-25,0 1,0 0,1 0,0 0,0 0,1 1,0-1,0 1,0 0,0 9,2-15,1 0,-1 1,1-1,0 0,0 0,0 1,0-1,1 0,-1 1,1-1,-1 0,1 0,0 0,0 1,0-1,0 0,0 0,0 0,1-1,1 3,0-1,-1-1,1 0,0 0,1 0,-1 0,0 0,0-1,1 1,-1-1,1 0,5 1,4 0,-1-1,1 0,0-1,-1-1,1 0,18-3,-12 0,-1-1,1-1,-1 0,0-2,-1 0,1-1,-1 0,-1-1,0-1,-1-1,0 0,-1-1,0-1,-1 0,0-1,-1 0,-1-1,-1 0,0-1,-1 0,9-22,-17 35,1 0,-1 0,0 0,0-1,0 1,-1 0,1 0,-1-1,0 1,-1 0,1 0,-1-1,1 1,-1 0,-3-8,2 9,0 0,0 0,0 0,0 0,-1 1,1-1,-1 1,0-1,0 1,0 0,0 0,0 0,0 1,0-1,-1 1,1-1,-1 1,1 0,-5 0,-2-1,-1 1,1 0,0 1,-1 0,1 0,0 1,-1 1,1 0,0 0,0 1,-15 6,7-1,0 0,1 1,1 1,-1 1,-18 15,17-9,0 0,0 0,2 2,-17 23,24-28,1 0,0 0,1 0,0 1,1 0,0 1,-3 21,8-33,0 1,0 0,1-1,0 1,0 0,0-1,1 1,-1 0,1-1,0 1,1 0,-1-1,1 1,0-1,0 0,0 0,0 0,4 4,-1-1,1-1,0 0,0-1,1 0,0 0,0 0,0-1,0 0,12 5,-10-5,0-1,0 0,0 0,0-1,1 0,-1-1,1 0,-1-1,1 1,-1-2,1 1,-1-2,1 1,-1-1,0 0,0-1,0 0,0-1,0 0,0 0,-1-1,0 0,0 0,9-9,-13 10,0-1,0 0,-1 0,0 0,0-1,0 1,0-1,-1 1,0-1,0 0,-1 0,1 0,-1 0,-1 0,1 0,-1 0,-1-11,1 11,-1 1,1 0,-1 0,-1 0,1 0,-1 0,0 1,0-1,0 0,0 1,-1-1,0 1,0 0,0 0,0 0,-1 0,0 1,0-1,0 1,0 0,-6-4,-3 2,0 0,0 1,0 0,0 1,-1 1,1 0,-1 1,0 0,1 1,-1 0,0 1,-26 6,12-1,0 2,1 1,-1 1,2 1,-31 18,30-13,1 1,0 2,2 0,0 2,1 0,-35 43,43-45,1 1,1 0,0 1,2 1,0-1,2 2,0 0,1 0,-5 29,12-47,0 0,0 0,0-1,1 1,0 0,0 0,0 0,1 0,0 0,-1-1,2 1,-1 0,0-1,1 1,0-1,0 1,4 5,-6-10,0 1,1-1,-1 0,0 1,0-1,0 1,1-1,-1 0,0 1,1-1,-1 0,0 1,1-1,-1 0,0 0,1 1,-1-1,1 0,-1 0,1 0,-1 0,0 1,1-1,-1 0,1 0,-1 0,1 0,-1 0,1 0,-1 0,1 0,-1 0,0 0,1-1,-1 1,1 0,-1 0,1 0,-1 0,0-1,1 1,-1 0,1 0,-1-1,0 1,1 0,-1-1,0 1,0 0,1-1,-1 1,0-1,0 1,1 0,-1-1,0 1,0-1,0 1,0-1,0 1,1 0,-1-1,0 1,0-2,1-2,0-1,0 0,0 0,-1-10,0 0,-2 1,0 0,0 0,-9-25,9 34,1 1,-1 0,1 0,-1 0,0 0,-1 0,1 0,-1 1,1-1,-1 1,0-1,-1 1,1 0,-1 0,1 1,-1-1,0 1,0-1,-6-1,8 3,-1 1,1 0,-1 0,1 0,-1 0,1 0,-1 0,1 1,-1-1,1 1,0 0,-1-1,1 1,0 0,-1 0,1 1,0-1,0 1,0-1,0 1,0-1,0 1,1 0,-1 0,0 0,1 0,-2 3,-3 4,1-1,0 1,1 0,0 1,-4 13,5-12,0-1,1 1,1 0,-1 0,2-1,-1 1,2 0,-1 0,1 0,1 0,0 0,1-1,0 1,0-1,1 0,1 0,-1 0,2 0,-1-1,1 0,1 0,0 0,0-1,0 0,1-1,1 1,16 10,-13-11,1 0,0-1,0-1,1 0,-1-1,1-1,0 0,0-1,0 0,0-1,1 0,-1-2,0 1,0-2,0 0,0-1,0 0,0-1,19-8,-18 6,0-1,0 0,-1-1,-1 0,1-1,-1-1,-1 0,0-1,0 0,-1-1,-1-1,0 1,0-1,-2-1,1 0,11-29,-13 23,-1 0,-1-1,-1 0,-1 0,-1 0,-1-1,-2-35,1 53,-1 0,1 0,-1 0,0 0,0 0,0 0,-1 0,1 0,-1 0,0 1,0-1,-1 0,1 1,-1 0,1 0,-1 0,0 0,-4-3,4 4,0 0,0 0,0 1,-1 0,1-1,0 1,-1 1,1-1,-1 0,1 1,-1-1,1 1,-1 0,1 0,-1 1,1-1,-1 1,1 0,-1 0,1 0,-5 2,-2 2,0 0,0 1,0 1,1-1,0 2,0-1,1 1,0 0,0 1,1 0,-10 14,6-6,1 1,1 0,0 0,2 1,-11 35,12-26,1 0,1 0,1 1,2-1,1 1,1-1,7 48,-6-70,-1 0,1 0,0 0,1-1,-1 1,1 0,0-1,1 0,-1 0,6 5,-8-8,1 0,-1 0,1-1,0 1,0-1,0 0,0 1,0-1,0 0,0 0,0 0,0 0,0-1,1 1,-1-1,0 1,1-1,-1 0,0 0,1 0,-1 0,0 0,1 0,-1-1,0 1,0-1,1 0,-1 1,4-3,-3 0,1 1,-1-1,0 0,1 1,-1-2,-1 1,1 0,0-1,-1 1,0-1,0 1,0-1,0 0,2-8,1-6,0 1,2-21,-5 19,0 1,-1 0,-1 0,-1-1,-1 1,-6-29,6 35,-1 1,-1 0,0 0,0 0,-1 0,-1 0,0 1,0 0,-1 1,0-1,-12-11,16 18,0 1,1-1,-1 1,-1 0,1 0,0 0,0 0,-1 0,1 1,-1-1,1 1,-1 0,0 0,0 1,1-1,-1 1,0 0,0 0,1 0,-1 0,0 1,-4 0,4 0,1 1,-1-1,1 1,0 0,0 0,0 0,0 1,0-1,0 1,0-1,1 1,-1 0,1 0,0 0,0 0,0 1,0-1,1 0,-1 1,1-1,0 1,-1 4,0 2,0-1,1 1,0-1,1 1,0 0,1 0,0-1,0 1,1-1,0 1,0-1,1 1,1-1,0 0,0-1,0 1,1-1,8 10,-6-9,0 1,1-2,1 1,-1-1,1-1,0 0,1 0,0 0,0-1,0-1,1 0,0 0,0-1,21 5,-29-8,0-1,0 1,0-1,0 0,0 0,0 0,0 0,0 0,0-1,0 1,0-1,-1 0,1 0,0 0,0 0,-1 0,1-1,0 1,-1-1,0 0,1 0,-1 0,0 0,0 0,0 0,3-4,-3 3,0-1,0 0,-1-1,1 1,-1 0,1 0,-1-1,-1 1,1 0,-1-1,1 1,-1-1,-1 1,1-1,-1 1,1 0,-3-6,-2-7,-2 1,0 0,0 0,-2 1,0 0,0 0,-1 1,-1 0,-1 1,0 0,0 1,-2 0,-20-14,28 23,0 0,0 0,0 1,0 0,0 0,0 0,0 1,0 0,-13 0,17 0,1 1,-1 0,0 0,0 1,1-1,-1 0,0 1,1-1,-1 1,0-1,1 1,-1 0,1 0,-1 0,1 0,-1 0,1 0,0 0,-1 0,1 0,0 1,0-1,0 0,0 1,0-1,0 1,0-1,0 1,1 0,-1-1,1 1,-1 0,1-1,0 1,0 0,-1 0,1-1,0 1,1 3,0 1,0-1,0 1,1-1,-1 1,1-1,1 0,-1 0,1 0,0 0,0 0,0-1,0 1,1-1,5 5,-4-4,0 0,0-1,1 1,-1-1,1-1,0 1,0-1,1 0,-1 0,0-1,10 3,-13-5,0 0,0 0,1 0,-1 0,0 0,0-1,0 1,0-1,0 0,0 0,0 0,0-1,-1 1,1-1,0 1,-1-1,1 0,-1 0,1 0,-1 0,0-1,0 1,0-1,3-4,1-2,-1 0,0-1,-1 1,1-1,-2 0,4-12,-2-2,-1 0,0 0,-1-27,-2 39,-2-1,1 1,-2-1,0 1,0 0,-1-1,-8-21,9 32,1-1,0 1,0-1,-1 1,0-1,1 1,-1 0,0 0,0 0,0 0,0 0,-1 0,1 1,-1-1,-2-1,4 3,0 0,0-1,0 1,0 0,1 0,-1 0,0 0,0 0,0 0,0 0,0 0,1 0,-1 0,0 1,0-1,0 0,0 1,1-1,-1 0,-1 1,1 0,0 1,0-1,-1 0,1 0,0 1,0-1,0 1,1-1,-1 1,0-1,0 1,1 0,-1 2,-1 5,0-1,0 1,1 0,1 0,-1 0,1-1,1 1,0 0,0 0,1 0,0-1,0 1,1-1,0 1,0-1,1 0,9 14,-9-17,0 0,0 0,0 0,1 0,0-1,0 1,0-1,0-1,0 1,1-1,0 0,0 0,0 0,0-1,0 0,0 0,1 0,-1-1,1 0,-1-1,1 1,-1-1,1 0,11-3,-11 2,0-1,-1 0,1-1,-1 1,1-1,-1-1,0 1,0-1,-1 0,1 0,-1-1,0 1,0-1,0-1,-1 1,0 0,0-1,0 0,0 0,-1 0,3-9,2-6,0-1,-2 0,0 0,-2-1,3-26,-6 34,-1 0,0 1,0-1,-2 1,0-1,0 1,-2-1,0 1,0 0,-1 1,-8-16,10 23,-1 0,1-1,-1 1,-1 1,1-1,-1 1,0-1,0 1,0 1,-1-1,0 1,0 0,0 0,0 0,-1 1,1 0,-1 1,0-1,0 1,0 1,0-1,0 1,0 0,-10 0,10 2,0-1,1 1,-1 1,0-1,0 1,1 0,-1 0,1 1,-1 0,1 0,0 1,0-1,1 1,-1 1,1-1,0 1,0 0,0 0,0 0,1 1,0-1,1 1,-1 0,1 1,0-1,-3 10,3-9,1 0,0 1,0 0,1-1,0 1,1 0,-1-1,1 1,1 0,0 0,0-1,0 1,1 0,0-1,0 0,1 1,0-1,0 0,1 0,0-1,0 1,1-1,7 9,-5-8,1-1,0 1,0-2,0 1,1-1,0-1,0 1,0-1,0-1,1 0,-1 0,1-1,0 0,-1-1,13 1,-14-2,0 0,0 0,0-1,0 0,0 0,-1-1,1 0,0 0,-1-1,0 0,1-1,-1 1,0-1,-1 0,1-1,-1 0,0 0,0 0,6-7,-6 3,1 1,-1-1,-1 0,0-1,0 0,-1 1,0-2,0 1,-1 0,-1-1,0 1,0-1,-1 1,0-20,-2 21,0 0,0-1,-1 1,0 0,-1 0,0 0,0 0,-1 0,0 1,0 0,-1 0,0 0,-1 0,0 1,0 0,-13-12,9 11,-1 0,1 0,-1 1,-1 0,-14-6,18 10,1 1,-1-1,1 1,-1 1,0-1,0 1,0 0,0 1,-13 1,18-1,0 1,0-1,1 1,-1 0,1 0,-1 0,1 0,-1 1,1-1,-1 0,1 1,0 0,0 0,0-1,0 1,0 0,0 0,1 1,-1-1,1 0,-1 1,1-1,0 1,0-1,0 1,0-1,1 1,-1 0,1-1,-1 1,1 0,0 4,0 0,0 0,0 0,1-1,0 1,0 0,1 0,0-1,0 1,0-1,1 0,0 1,5 6,0-3,0 0,1 0,1-1,0-1,0 1,0-2,1 1,0-1,20 9,-21-12,0 0,0 0,0-1,0 0,0-1,0 0,1-1,-1 0,1 0,0-1,-1-1,16-2,-21 2,-1 0,0 0,0-1,0 0,0 0,0 0,0 0,0 0,-1-1,1 0,-1 1,0-1,0-1,4-3,-3 1,0 0,-1 0,0 0,0-1,0 1,0-1,-1 0,1-7,0-8,0 0,-2 0,0 0,-4-34,-3 15,-2 0,-1 1,-2 0,-17-39,13 38,1-1,3 0,-10-63,18 69,1-62,3 83,0 1,1-1,1 1,0 0,1 0,0 0,9-16,-12 27,1 0,-1 0,1 0,0 0,0 0,0 0,1 1,-1-1,1 1,-1 0,1 0,0 0,0 0,0 0,0 0,0 1,0-1,1 1,-1 0,5-1,2 1,1 0,-1 1,1 1,-1-1,14 4,-10-2,0-1,25 0,-35-1,0-1,0 0,0 1,1-1,-1-1,0 1,-1 0,1-1,0 0,0 0,-1 0,1-1,4-3,1-3,0-1,-1 0,0 0,-1-1,0 0,-1-1,0 1,7-22,-2 3,-2-1,7-45,-12 53,-1-1,-2 0,0 0,-2 0,-5-40,3 50,1 1,-2 0,0 0,-1 0,0 0,0 1,-2 0,1 0,-2 0,0 1,-14-17,19 26,0-1,0 0,0 1,0-1,0 1,-1 0,-4-2,7 4,1-1,-1 1,0 0,0 0,0-1,0 1,1 0,-1 0,0 0,0 0,0 0,0 0,1 0,-1 0,0 0,0 1,0-1,0 0,1 0,-1 1,0-1,0 1,1-1,-1 1,0-1,1 1,-1-1,0 1,1-1,-1 1,1 0,-1-1,1 1,-1 0,1 0,0-1,-1 1,1 0,0 0,-1-1,1 1,0 1,-2 7,0 0,1 0,0 0,1 0,0 1,2 14,11 58,-8-59,1 0,0 0,17 36,-20-52,0-1,0 0,0 0,1 0,0 0,1-1,-1 0,1 0,0 0,0 0,0-1,1 1,0-1,0-1,0 1,13 4,-17-7,1 0,-1 0,1-1,-1 1,1-1,-1 1,1-1,-1 0,1 0,-1 0,1-1,-1 1,1 0,-1-1,1 0,-1 0,1 1,-1-1,0-1,1 1,-1 0,0-1,0 1,0-1,0 1,0-1,0 0,-1 0,1 0,0 0,-1 0,0 0,1-1,-1 1,0 0,0-1,1-4,0-1,1-1,-2-1,1 1,-1 0,-1 0,1 0,-2-1,1 1,-3-12,-1 1,-1 1,-1 0,-1 1,0 0,-2 0,0 0,0 1,-2 0,0 1,-1 0,-20-20,28 32,-1 0,1 1,-1 0,0-1,0 2,0-1,0 0,0 1,-6-2,9 4,-1-1,0 0,1 1,-1 0,0 0,1 0,-1 0,0 0,1 0,-1 1,1-1,-1 1,1 0,-1 0,1 0,-1 0,1 0,0 0,-1 1,1-1,0 1,-3 2,-4 6,0 0,0 1,1 1,1-1,0 1,0 0,1 1,1 0,0 0,0 0,-2 16,1-2,2 0,1 0,1 0,2 50,2-54,0 0,2 0,1 0,0-1,2 0,0 0,2 0,15 28,-19-41,1-1,-1 1,1-1,1 0,0-1,0 0,0 0,1 0,0-1,0 0,1 0,-1-1,1 0,1-1,-1 0,0 0,1-1,0 0,0-1,0 0,16 1,-14-3,0-1,0 0,0-1,0-1,0 1,0-2,-1 1,0-2,0 0,0 0,0-1,-1 0,0-1,14-11,1-3,-1-2,-1 0,-2-1,24-34,-27 32,-1-1,-1-1,-1 0,-2-1,-1-1,-1 0,-2 0,12-62,-19 72,0 0,-2-1,0 1,-1 0,-1 0,-6-31,4 36,-1 1,0 0,0 0,-2 1,1-1,-2 1,0 1,0 0,-17-19,16 22,1 1,-2 0,1 0,-1 1,0 0,-1 1,1 0,-1 1,-1 0,1 0,-1 1,1 1,-1 0,0 1,-14-1,17 2,1 1,-1 0,1 1,-1-1,0 2,1-1,0 1,-1 1,1 0,0 0,0 0,0 1,1 0,-1 1,1-1,0 2,0-1,1 1,0 0,0 0,0 0,-5 8,3-1,1-1,0 1,1 0,0 1,1 0,1 0,0 0,1 0,0 0,1 1,1-1,1 1,-1 0,4 20,0-15,0 0,1-1,1 0,1 0,0 0,2 0,0-1,1 0,1-1,12 17,-10-19,0 1,1-1,1-1,19 15,-26-24,0 1,1-1,0 0,0-1,0 0,1 0,-1-1,1 0,0-1,0 1,10 0,-14-3,-1 0,0 0,1 0,-1 0,0-1,1 1,-1-1,0-1,0 1,0 0,0-1,0 0,0 0,5-4,-3 2,-1 0,-1 0,1-1,-1 1,0-1,0-1,0 1,5-12,-2 4,-2-1,0 0,0 0,-2-1,0 0,0 1,0-27,-3 26,-2-1,1 0,-2 1,0-1,-1 1,-1 0,0 0,-1 0,0 1,-2 0,1 0,-2 1,0 0,0 0,-1 1,-1 0,-14-13,14 15,-1 0,0 0,-1 1,0 1,0 0,-1 0,1 1,-2 1,1 1,-1 0,0 1,0 0,0 1,0 1,-1 0,1 2,-27 1,35-1,1 1,-1 1,1-1,0 1,-1 0,1 1,0 0,0 0,1 0,-1 0,1 1,-1 0,1 0,0 0,1 1,-9 10,7-6,1 0,-1 0,2 0,0 1,0 0,0 0,1 0,1 0,0 0,-1 12,-2 35,3 0,8 83,-6-134,1 0,0-1,0 1,0-1,1 1,0-1,0 1,4 6,-5-11,0 1,0-1,0 1,0-1,1 1,-1-1,0 0,0 0,1 0,-1 0,1 0,-1 0,1 0,-1 0,1-1,0 1,-1 0,1-1,0 1,-1-1,1 0,0 0,0 0,-1 1,1-2,0 1,0 0,-1 0,1 0,0-1,3-1,1 0,1-2,-1 1,1-1,-1 0,-1 0,1 0,0-1,-1 0,0 0,6-8,2-4,0-2,12-21,-10 9,0 0,-3-1,0 0,-2-1,-2 0,6-40,-7 16,-2 0,-6-111,1 160,-1-1,0 1,0 0,-1 0,0 0,0 0,-1 1,0-1,-7-12,7 16,1 1,-1 0,0-1,0 1,0 1,-1-1,1 0,-1 1,1 0,-1-1,0 1,0 1,0-1,0 1,0-1,0 1,0 0,0 1,-1-1,-4 1,5-1,-1 1,0 1,1-1,-1 1,0 0,1 0,-1 0,0 0,1 1,0 0,-1 0,1 0,0 0,0 1,0 0,0 0,1 0,-1 0,1 0,0 1,0-1,0 1,0 0,1 0,-3 6,-3 5,1 1,0 1,2 0,0 0,-5 27,5-13,1 0,0 36,4-52,1 1,0-1,1 0,1 0,0 0,8 20,-10-31,1 0,0 0,0 0,0-1,1 1,-1-1,6 6,-7-8,-1 0,1-1,0 1,-1-1,1 1,0-1,0 1,0-1,-1 1,1-1,0 0,0 0,0 1,0-1,-1 0,1 0,0 0,0 0,0 0,0 0,0 0,0 0,0 0,-1 0,1-1,0 1,0 0,0 0,0-1,-1 1,1-1,0 1,0-1,-1 1,1-1,0 1,-1-1,1 0,0 1,-1-1,1 0,0-1,3-4,-1 0,0-1,0 1,0-1,-1 0,1 0,-2 0,1 0,-1 0,0 0,-1-1,0-10,-1-6,-1 0,-7-37,4 40,-1-1,0 1,-2 0,0 0,-1 1,-2 0,0 1,-19-27,20 35,1-1,-2 1,1 1,-2 0,1 0,-1 1,0 1,-1 0,0 1,-1 0,1 1,-1 0,-24-6,14 7,0 1,0 1,-48 0,57 3,0 1,0 1,0 0,1 1,-1 1,1 0,-25 12,36-15,1 0,-1 0,1 1,0-1,-1 1,1-1,0 1,0 0,0 0,0 0,0 0,1 0,-1 0,1 1,-1-1,1 1,0-1,0 1,0-1,0 1,0 0,0 2,1-1,0 0,1 0,-1-1,1 1,-1 0,1-1,0 1,1-1,-1 1,1-1,-1 0,1 0,0 1,0-1,5 5,-1-2,0-1,0 1,0-1,1 0,0-1,0 0,0 0,0 0,1-1,0 0,-1 0,1-1,15 3,2-2,1 0,-1-2,30-2,-47 1,0 0,-1-1,1 0,0-1,-1 0,1 0,-1 0,0-1,0 0,0 0,0-1,9-7,-10 6,-1 0,0 0,0-1,0 1,-1-1,0 0,0 0,-1-1,0 1,0-1,0 0,-1 0,3-11,-1-1,-2 0,0-1,-1 1,-1-1,0 0,-2 1,0-1,-2 1,0 0,-1 0,0 0,-2 1,0 0,-2 0,0 0,-13-18,7 12,-1 2,-1 0,-1 1,-1 0,-1 2,0 0,-2 2,0 0,-1 1,-48-24,58 34,0 1,0 0,0 1,0 1,-1 0,0 0,0 2,1 0,-1 0,0 1,0 1,-24 4,34-4,1 0,-1 1,1 0,0-1,-1 1,1 1,0-1,0 0,0 1,0-1,1 1,-1 0,1 0,0 0,0 0,0 0,0 1,-3 6,1 0,0-1,1 1,0 1,1-1,-3 18,4-15,1 1,1 0,0 0,1-1,0 1,1-1,0 0,1 1,1-1,0-1,1 1,0-1,1 0,0 0,1-1,12 14,-13-17,0-1,0 1,1-1,0-1,1 0,-1 0,1-1,0 0,1 0,-1-1,1 0,0-1,0 0,0 0,0-1,1-1,-1 0,0 0,1-1,-1 0,1-1,10-1,-8-2,0 1,0-2,-1 0,0 0,0-1,0 0,-1-1,0-1,0 0,-1 0,1-1,-2 0,0-1,0 0,-1-1,12-17,-9 10,-2 1,0-1,0-1,-2 1,0-2,-1 1,-1 0,-1-1,-1 0,1-28,-4 33,0 1,-2 0,1-1,-2 1,0 0,-1 0,0 0,-1 1,0-1,-1 1,-1 1,0-1,-10-13,5 11,0 1,-1 1,0 0,-1 0,-1 1,0 1,0 1,-1 0,-25-12,19 13,-1 0,1 2,-1 0,0 1,-1 2,0 0,-30 0,34 3,0 2,0 0,0 1,0 2,1-1,-1 2,1 1,-34 14,33-10,0 0,1 1,0 1,-31 26,43-32,1 1,-1 0,1 1,0-1,1 1,0 0,0 1,1-1,0 1,0 0,1 0,0 0,-3 17,5-16,0-1,0 1,0-1,2 1,-1-1,1 0,0 1,1-1,4 15,-4-21,-1 1,1-1,0 1,0-1,0 1,0-1,1 0,-1 0,1 0,0-1,0 1,0 0,0-1,0 0,1 0,-1 0,1 0,-1-1,1 1,0-1,-1 0,1 0,0 0,0 0,6 0,-1-1,0 0,-1-1,1 0,-1 0,1-1,0 0,-1-1,0 1,0-1,15-9,-14 7,1-1,-1 0,-1 0,1-1,-1 0,0-1,-1 1,10-14,-10 10,0 1,-1-1,0-1,0 1,-2-1,1 0,-1 0,-1-1,0 1,-1-1,-1 1,0-1,0 0,-1 0,-1 1,0-1,-1 0,0 1,-1-1,0 1,-1 0,0 0,-1 0,-1 1,0-1,0 1,-1 1,0-1,-1 1,0 0,-1 1,-15-13,5 7,-1 2,0 0,-1 1,-1 1,0 1,0 1,-1 1,0 1,0 0,-1 2,1 1,-1 1,0 1,-43 3,56 0,0 0,0 1,1 1,-1 0,1 1,-1 0,1 0,0 1,1 0,-17 12,14-7,0 0,1 1,0 0,0 1,2 0,-1 1,-6 13,2-1,2 1,1 0,1 0,1 1,1 0,1 0,2 1,-2 29,6-50,1 0,-1 1,2-1,-1 0,1 0,0 0,0 1,1-1,0 0,3 6,-4-10,1 0,-1-1,1 0,0 1,0-1,0 0,0 0,0 0,1 0,-1 0,0 0,1-1,-1 1,1-1,0 0,0 1,-1-1,1-1,0 1,0 0,0-1,0 1,0-1,0 0,0 0,5-1,-3 1,-1-1,1 0,-1 0,0 0,1-1,-1 0,0 1,0-1,0-1,0 1,0-1,-1 1,1-1,-1 0,0 0,1-1,-1 1,-1-1,1 0,0 1,3-9,1-3,0 0,-2 0,1 0,5-29,-8 26,0 0,-1 0,-1 0,0 0,-2-1,0 1,-1 0,-5-23,5 32,-1 1,1-1,-2 1,1-1,-1 1,-1 0,1 0,-1 1,-1-1,1 1,-1 0,0 1,-1-1,0 1,0 1,0-1,-1 1,-13-7,7 6,-1 1,-1 0,1 1,-1 1,1 0,-1 1,0 1,0 0,0 2,0-1,-16 4,5 1,0 0,1 2,0 1,0 0,-42 22,51-21,0 1,1 1,0 0,1 1,0 1,1 1,-22 26,29-32,0 1,1 0,0 1,1 0,0-1,1 1,0 1,0-1,1 1,1 0,-1-1,2 1,-1 0,2 0,0 13,0-19,1 0,0 0,0-1,1 1,-1 0,1 0,0-1,0 1,1-1,-1 0,1 1,0-1,0 0,0-1,1 1,-1-1,1 1,0-1,0 0,0 0,0-1,1 1,-1-1,1 0,-1 0,1 0,6 0,0 1,-1-1,1 0,0-1,-1 0,1-1,0 0,0-1,0 0,0 0,-1-2,18-4,-11-1,0 1,0-2,-1 0,0-1,-1-1,0 0,-1-1,0-1,18-22,-12 11,-1-2,-1 0,-1-1,24-52,-35 65,0-1,-1 1,-1-1,0 0,-1 0,2-29,-5 37,0 0,0 0,-1 0,0 0,0 0,-1 0,0 0,0 1,0-1,-1 1,0-1,0 1,0 0,-1 0,0 0,-1 1,-6-8,0 4,-1 0,0 1,0 0,0 1,-1 1,0 0,0 1,0 0,-1 1,-26-5,0 3,0 1,-67 2,41 6,1 3,1 3,-1 3,2 2,0 3,0 3,-89 42,128-51,1 1,-1 1,2 1,-25 20,41-29,0 1,0 0,0 1,1-1,0 1,0 0,-5 11,8-13,0 0,0 0,0 0,1 0,0 1,0-1,0 0,1 1,0-1,0 0,0 1,2 9,-1-12,0 1,1-1,-1 0,1 0,-1 0,1 0,0 0,0 0,0 0,1-1,-1 1,0-1,1 0,0 1,0-1,0-1,0 1,0 0,0-1,0 1,0-1,0 0,1 0,5 1,8 1,0 0,1-1,24 0,-42-2,18-1,0 0,0-1,0-1,0-1,-1 0,1-1,-1-1,0-1,-1 0,0-1,0-1,-1-1,0 0,0 0,-1-2,-1 0,0 0,20-26,-29 32,1 0,-2 0,1 0,0 0,-1-1,-1 0,1 0,-1 1,0-1,0-1,-1 1,0 0,0-9,-1 11,-1 0,0 0,1 0,-2 1,1-1,0 0,-1 0,0 1,0-1,-1 1,1-1,-1 1,0 0,0 0,0 0,-1 1,1-1,-1 1,-6-5,-2 0,-1 1,1 0,-1 1,-1 1,1 0,-1 1,0 0,0 1,-22-2,-14 0,-66 4,76 2,1 3,0 1,0 1,0 3,0 1,-66 27,82-27,0 1,0 1,1 1,1 1,0 1,1 1,0 1,2 0,0 1,1 1,-24 35,36-45,0 0,1 1,0-1,0 1,1 0,1 0,-1 1,0 14,3-20,0-1,0 1,0-1,0 1,1-1,0 1,0-1,0 1,3 6,-3-9,0 0,1 0,-1 1,1-1,-1-1,1 1,0 0,-1 0,1-1,0 1,0-1,0 1,0-1,1 0,-1 0,0 0,0 0,4 1,-4-2,0 1,0-1,-1 0,1 0,0 0,0 0,-1 0,1-1,0 1,0 0,-1-1,1 1,0-1,-1 0,1 0,0 1,-1-1,1 0,-1 0,0-1,1 1,-1 0,0 0,0-1,1 1,-1 0,0-1,0 1,-1-1,1 0,0 1,0-1,0-2,1-3,0 1,0-1,0 0,-1 1,0-1,0 0,-1-11,-1 8,-1 1,0-1,-1 1,0-1,0 1,-1 0,0 1,-1-1,0 1,0-1,0 2,-1-1,-13-12,3 4,-1 0,-1 1,-1 2,-34-21,26 20,0 2,-2 0,1 2,-1 1,-1 1,1 2,-39-4,17 6,0 2,0 3,-79 10,74-2,1 3,0 2,0 2,2 3,-99 49,111-46,2 2,0 1,2 2,0 2,2 1,2 2,-51 61,76-82,-1 1,1 0,1 1,0 0,1 0,1 0,0 1,-4 18,7-25,1 1,0-1,0 1,1-1,0 1,1-1,-1 1,2-1,-1 0,1 1,0-1,0 0,1 0,0 0,0 0,1-1,6 10,0-3,1-1,0-1,1 0,0 0,1-1,0-1,0 0,1-1,0-1,1 0,18 6,5 0,1-2,0-1,53 5,-42-9,84-1,-103-7,1 0,0-2,60-16,-76 15,0-1,0 0,0-2,-1 1,0-2,0 0,-1-1,19-16,-23 17,-1-1,0-1,0 1,-1-2,-1 1,0-1,0 0,-1 0,-1-1,0 0,6-23,-9 24,1 0,-2 0,1 0,-2-1,1 1,-2 0,0 0,0 0,-1 0,0 0,-1 0,-1 0,0 1,0 0,-1-1,-1 2,0-1,0 1,-1-1,0 2,-1-1,0 1,0 0,-1 1,0 0,-1 0,0 1,0 1,0-1,-1 2,0-1,-20-6,17 8,-1 1,1 1,0 0,-1 0,1 2,-1 0,1 0,-1 2,1-1,0 2,0 0,0 1,0 0,0 1,1 1,-1 0,-12 8,-3 4,1 1,1 1,0 1,2 2,0 0,-24 31,33-35,1 1,1 0,1 1,1 1,1-1,0 2,2 0,-8 26,14-36,1-1,0 1,1-1,0 1,0 0,2-1,2 21,-1-23,0-1,1 0,0 0,0 0,1 0,0-1,0 0,1 0,1 0,-1 0,8 8,-4-8,0 0,1 0,-1-1,1-1,1 0,-1 0,1-1,0 0,0-1,0 0,1 0,0-2,-1 1,18 0,-17-2,0 0,0-1,0 0,0-1,0 0,0-1,0-1,-1 0,1 0,-1-1,0 0,0-1,0-1,14-9,-12 5,0-1,-1-1,-1 0,0-1,-1 0,0-1,-1 0,0 0,-1-1,-1 0,0-1,-1 0,-1 0,0 0,3-27,-5 24,-1 0,-1 0,-1 0,0-1,-2 1,0 0,-1 0,-1 0,0 0,-2 1,0 0,-1 0,-14-24,14 30,-1 0,-1 0,0 1,0 0,-1 1,0 0,-1 1,0 0,-20-12,13 11,0 1,-1 0,0 2,-1 0,0 1,-21-4,4 5,0 1,0 1,-1 3,1 1,0 1,-70 15,78-11,0 2,1 1,0 1,0 1,1 2,1 0,0 2,-24 19,36-23,0 0,1 0,1 2,0 0,1 0,0 1,1 0,1 1,0 0,1 0,0 1,2 0,-1 1,-6 30,11-35,0 0,1 1,0-1,0 0,2 1,-1-1,2 0,0 1,0-1,1 0,0 0,1-1,1 1,0-1,0 0,1 0,0 0,1-1,0 0,1 0,0-1,1 0,0 0,18 13,-7-9,1 0,0-1,0-2,1 0,1-1,37 10,-6-7,100 10,-95-18,0-2,0-2,0-3,69-13,-100 12,0-2,-1-2,0 0,0-2,-1-1,0 0,-1-3,0 0,-1-1,39-32,-49 34,-1-1,0 0,-1-1,-1 0,0-1,-1 0,-1 0,0-1,-2 0,9-27,-12 30,-1 0,0 0,-1-1,-1 1,0 0,-1-1,0 1,-2 0,1-1,-2 1,0 0,0 0,-2 0,-6-16,4 15,-1 0,0 0,-1 1,0 0,-2 1,1 0,-1 1,-1 0,0 0,-1 1,0 1,-1 0,0 1,0 1,-1 0,0 1,-1 0,1 1,-1 1,0 1,-19-3,-31-1,-1 2,0 4,-127 12,189-9,0-1,0 1,0 0,0 1,1-1,-1 1,1 0,-1 0,1 0,0 1,0 0,0-1,0 2,0-1,-3 4,3-2,0 0,1 0,-1 0,1 1,0-1,1 1,-1 0,1 0,0 0,1 0,-2 7,1 1,0 0,1-1,0 1,1 0,2 15,-1-23,0 0,1 0,-1 0,1 0,1 0,-1-1,1 1,0-1,0 1,0-1,1 0,0 0,7 7,-6-8,0 0,0 0,1 0,-1-1,1 0,0 0,0 0,0-1,0 0,0 0,0 0,1-1,-1 0,0 0,1 0,-1-1,1 0,-1-1,1 1,-1-1,1 0,-1-1,0 0,0 0,0 0,0 0,0-1,0 0,-1-1,1 1,-1-1,0 0,0 0,0-1,-1 1,1-1,-1 0,0 0,-1-1,1 1,-1-1,0 1,0-1,2-9,-3 6,1 0,-2-1,1 1,-2-1,1 1,-1-1,0 1,-1-1,0 0,-1 1,0 0,0-1,-1 1,-1 0,1 0,-1 1,-1-1,-6-9,5 7,-2 1,1 0,-1 1,0 0,-1 0,0 0,-1 1,0 1,0 0,0 0,-1 1,0 0,-22-8,14 10,0 1,-1 1,1 0,0 2,-1 0,-21 3,-20 0,54-3,0 0,-1 1,1 0,0 0,0 0,0 1,0 0,1 1,-10 4,13-5,0-1,0 2,0-1,0 0,0 0,1 1,-1 0,1-1,0 1,0 0,0 0,0 1,0-1,0 0,1 0,0 1,-1-1,1 1,1-1,-2 5,2-7,0 1,-1-1,1 0,0 0,0 1,0-1,0 0,0 0,0 1,0-1,0 0,1 0,-1 1,0-1,1 0,-1 0,1 0,-1 0,1 0,0 1,-1-1,1 0,0 0,0-1,0 1,0 0,0 0,0 0,0-1,0 1,0 0,0-1,0 1,0-1,0 1,1-1,-1 1,2-1,0 0,0 0,0 0,0 0,0 0,-1-1,1 1,0-1,0 0,0 0,0 0,-1 0,1 0,0-1,-1 1,4-3,6-7,-1 1,-1-2,0 1,0-2,-1 1,-1-1,0 0,-1-1,0 0,-1 0,0 0,-2-1,1 0,-2 0,0 0,1-31,-3 43,-1 0,0 1,-1-1,1 0,0 0,-1 1,0-1,1 0,-1 1,0-1,0 1,-1-1,1 1,-1-1,1 1,-1 0,1 0,-1-1,0 1,-4-2,3 2,0 0,0 0,-1 0,1 1,0 0,-1 0,1 0,-1 0,1 0,-1 1,0-1,1 1,-1 0,-4 0,3 1,1-1,0 1,-1-1,1 1,0 0,0 1,0-1,0 1,0 0,0 0,0 0,0 0,1 1,-1-1,1 1,0 0,0 0,0 0,0 1,0-1,1 1,-1 0,1-1,0 1,0 0,1 0,-2 5,1 2,0 0,1 0,0 1,1-1,0 0,1 0,1 0,-1 0,5 12,-6-21,1-1,0 1,0 0,0 0,0-1,0 1,1-1,-1 1,0-1,1 1,-1-1,1 0,0 0,-1 0,1 0,0 0,0 0,-1 0,1 0,0-1,0 1,0-1,0 1,0-1,0 0,0 0,0 0,0 0,0 0,0 0,0-1,3 0,0 0,0-1,0 0,0 0,0 0,-1 0,1-1,-1 0,1 0,-1 0,0 0,4-5,-4 4,-1 0,0 0,0-1,-1 1,1-1,-1 1,3-7,-5 9,1-1,0 1,0-1,-1 1,0-1,1 1,-1-1,0 0,0 1,0-1,-1 1,1-1,-1 0,1 1,-1-1,-1-2,2 5,0 0,0-1,0 1,0-1,0 1,-1-1,1 1,0-1,0 1,0-1,-1 1,1 0,0-1,-1 1,1 0,0-1,-1 1,1 0,0-1,-1 1,1 0,-1 0,1-1,-1 1,1 0,0 0,-1 0,1-1,-1 1,1 0,-1 0,1 0,-1 0,1 0,-1 0,1 0,-1 0,1 0,-1 1,1-1,-1 0,1 0,0 0,-1 0,1 1,-1-1,1 0,-1 0,1 1,0-1,-1 0,1 1,0-1,-1 0,1 1,0-1,0 1,-1-1,1 0,0 1,0-1,-1 1,-1 3,0 0,1 0,-1-1,0 1,-1 8,1-2,1-1,0 1,0 0,1-1,0 1,1 0,3 14,-3-19,0-1,1 1,0-1,0 1,1-1,-1 0,1 0,0 0,0 0,0 0,0 0,1-1,-1 0,1 0,0 0,8 5,12 4,-1-1,2-1,-1-1,1-1,1-1,-1-1,1-1,0-2,0-1,1 0,-1-2,0-1,0-2,0 0,38-10,-38 6,0 0,-1-2,0-1,0-1,-1-1,0-1,-1-1,-1-1,0-1,-1-1,-1-1,0-1,-2 0,32-44,-44 55,-1-1,0 0,-1 1,0-1,-1-1,5-17,-7 24,-1 1,1-1,-1 0,0 0,0 1,0-1,0 0,0 0,-1 0,1 1,-1-1,1 0,-1 1,0-1,0 1,-1-1,1 1,0-1,-1 1,1 0,-1-1,0 1,0 0,0 0,0 1,0-1,0 0,-4-1,-4-2,0 1,0 0,-1 0,1 2,-1-1,0 1,0 1,-22-1,-1 2,-52 8,59-4,0 1,0 1,1 2,0 0,1 2,-1 0,2 2,0 1,-25 17,16-9,23-16,1 1,-16 12,22-16,1 1,0-1,-1 1,1-1,0 1,0 0,1 0,-1 0,1 0,-1 0,1 0,0 0,-1 5,1-3,0 0,1 0,-1 0,1 0,0 0,0 0,1 0,-1 0,1 0,0 0,1-1,-1 1,1 0,0-1,0 1,0-1,1 0,4 7,-3-7,0 0,0 0,0-1,1 1,-1-1,1 0,0 0,0-1,0 0,0 1,1-2,-1 1,0 0,1-1,-1 0,8 0,-10-1,1 1,0-1,0 0,-1 0,1-1,0 1,-1-1,1 0,-1 0,1 0,-1 0,1-1,-1 1,0-1,1 0,-1 0,4-4,-4 3,0 0,0-1,0 1,-1-1,1 0,-1 0,0 0,0 0,-1-1,1 1,-1 0,0-1,0 1,0-7,0 4,-1 0,0 0,0 0,0 0,-1 0,0 0,-1 0,-3-9,4 12,0 1,-1-1,1 1,-1 0,0-1,0 1,0 0,-1 0,1 1,-1-1,1 0,-1 1,0-1,0 1,0 0,-1 0,1 0,-4-1,-5-1,0 1,0 0,-1 1,1 1,-16-1,-67 5,51-1,26-2,0 1,0 1,0 1,-21 6,34-8,0 1,0 0,0 0,0 0,1 0,-1 1,1 0,-1 0,1 0,0 1,0-1,0 1,1 0,-1 0,1 0,0 1,0-1,-3 9,1-2,1 1,0-1,1 0,0 1,1 0,0 0,1 0,0 17,1-23,1-1,0 1,0-1,1 1,0-1,0 1,0-1,0 0,1 0,0 0,0 0,1 0,-1-1,1 1,0-1,0 0,0 0,0-1,8 6,-3-4,0 0,0 0,0-1,1 0,-1-1,1 0,0 0,17 2,-20-5,-1 1,1-1,-1 0,1 0,-1 0,1-1,-1 0,1-1,-1 1,0-1,0 0,0-1,0 1,9-6,-15 7,1 1,0 0,0-1,-1 1,1-1,0 1,-1-1,1 1,0-1,-1 0,1 1,-1-1,1 0,-1 1,1-1,-1 0,0 0,1 1,-1-1,0 0,0 0,1 0,-1 1,0-1,0 0,0 0,0 0,0 0,0 0,-1-1,0 1,0 0,0 0,0 0,0 0,0 0,0 0,0 0,0 0,0 0,-1 0,1 1,0-1,-3 0,-7-3,-1 0,1 1,-13-1,-7 0,0 2,-1 1,1 2,-1 1,1 1,0 1,0 2,0 2,1 0,-44 20,49-18,0-1,0-1,-1-1,-45 6,70-13,0 0,-1 0,1 0,0 0,0 1,0-1,-1 0,1 1,0-1,0 1,0-1,0 1,0 0,0-1,0 1,0 0,0 0,0 0,0 0,0 0,0 0,1 0,-1 0,0 0,1 0,-1 0,1 0,-1 0,1 0,0 1,-1-1,1 0,0 0,0 1,0-1,0 0,0 0,0 2,1 5,1 0,-1-1,1 1,6 14,-6-17,2 4,20 51,-21-54,0 0,1 0,-1-1,1 1,0-1,1 0,5 6,-10-11,0 0,0 1,1-1,-1 0,0 1,0-1,1 0,-1 0,0 1,1-1,-1 0,0 0,1 0,-1 1,0-1,1 0,-1 0,0 0,1 0,-1 0,1 0,-1 0,0 0,1 0,-1 0,1 0,-1 0,0 0,1 0,-1 0,0 0,1 0,-1-1,0 1,1 0,-1 0,0 0,1-1,-1 1,0 0,1 0,-1-1,0 1,0 0,1 0,-1-1,0 1,0 0,0-1,1 1,-1-1,0 0,1-1,-1 1,0-1,1 1,-1-1,0 0,0 1,0-1,0 1,-1-1,1 1,-1-3,-1 0,0 0,0 0,0 0,-1 0,1 0,-1 0,0 1,-1-1,1 1,0 0,-1 0,0 0,0 1,0-1,0 1,0 0,0 0,-8-2,-3-1,0 1,0 0,-1 1,-20-1,24 3,0 1,0 0,0 1,0 0,0 1,1 1,-1 0,1 0,-1 1,1 0,0 1,-14 9,19-11,1 1,-1 0,1 0,0 0,1 1,-1 0,1 0,0 0,0 0,0 1,1-1,-1 1,2 0,-1 0,1 0,-1 0,2 1,-1-1,1 1,0-1,0 1,1-1,0 13,1-16,-1 0,1 0,0 0,0 0,0 0,0 0,0 0,1-1,-1 1,1 0,0-1,0 0,0 1,0-1,0 0,0 0,1 0,-1 0,1 0,-1-1,1 1,4 1,7 3,0 0,1-1,20 4,-4-1,0 4,-1 2,0 0,-1 2,51 39,-66-46,31 24,-1 2,-2 2,-2 2,-1 2,42 56,-12-11,4-3,3-3,4-4,3-3,3-3,3-5,3-4,185 93,-117-83,4-6,3-8,1-7,323 51,-446-94,-1-2,89-2,-125-3,-1-1,0 0,0 0,0-1,0 0,0 0,12-6,-16 6,0 0,-1 0,1 0,-1 0,1 0,-1 0,0-1,0 1,0-1,0 0,0 0,0 1,-1-1,1 0,-1 0,0 0,0-1,1-4,0-6,-1 0,0 0,-1 0,0 0,-1 0,-1 0,0 1,-1-1,0 0,-6-14,2 9,-1 0,-1 1,-1 0,0 0,-2 1,-16-20,8 14,-1 2,-1 0,-1 1,-1 2,0 0,-2 2,0 0,0 2,-2 1,1 1,-2 1,1 2,-1 1,-1 1,1 1,-1 2,0 1,0 1,-60 5,43 3,-1 3,1 2,1 1,0 3,-65 30,23-2,-138 92,139-77,2 4,-141 136,209-181,1 0,1 2,0 0,1 0,-22 43,34-58,0 1,0-1,0 1,1-1,0 1,0 0,0 0,0-1,1 1,0 0,0 0,0 0,1 0,-1-1,1 1,0 0,3 6,-1-5,0-1,0 1,1-1,0 0,0 0,1 0,-1 0,1-1,0 0,0 0,1 0,-1-1,7 4,10 4,-1-1,2 0,45 11,86 9,82-8,-59-19,260-27,171-74,-361 40,-166 36,0-2,85-40,-145 54,30-19,-46 26,0-1,0 0,0 0,0-1,-1 1,0-1,0 0,0 0,5-8,-9 12,1-1,0 1,0-1,-1 1,1-1,-1 0,0 1,1-1,-1 0,0 1,0-1,0 0,0 1,0-1,0 0,-1 1,1-1,0 0,-1 1,1-1,-1 1,0-1,0 1,1-1,-3-1,0-1,0 1,-1-1,1 1,-1 0,0 0,0 0,-9-4,-2 0,0 0,-1 1,0 1,-29-6,-77-6,-2 8,0 5,-1 6,1 5,1 5,0 6,0 5,2 6,2 4,-174 74,230-78,1 2,-92 62,126-74,2 2,0 1,2 0,0 2,2 1,1 1,-24 36,37-50,1 1,1-1,0 1,1 0,0 1,1 0,0-1,1 1,1 0,0 0,1 23,1-28,1 0,1 0,-1 0,2 0,-1 0,1-1,0 1,1-1,0 0,1 0,-1 0,1 0,1-1,0 0,0 0,0 0,1-1,-1 0,11 6,0-1,-1-2,2 0,-1 0,1-2,1 0,-1-2,1 0,0 0,0-2,0-1,22 1,8-2,0-3,1-1,61-14,-49 4,-1-2,-1-3,-1-3,-1-2,-1-3,-1-2,57-38,-73 39,-1-2,-1-1,-2-2,-1-1,-2-2,-1-1,-1-2,-3-1,43-77,-57 88,-1 0,-2-1,-1-1,-1 0,-1-1,-2 1,-1-1,-2 0,-1-1,-1 1,-2 0,-1-1,-1 1,-2 0,-1 1,-2-1,0 1,-21-45,11 36,-2 1,-2 0,-1 2,-1 1,-3 1,0 1,-2 1,-2 2,-1 1,-65-46,67 55,0 2,-2 1,0 1,0 2,-1 1,-1 2,0 1,-1 2,0 1,0 2,0 1,-1 2,-57 4,47 4,0 2,0 2,1 2,0 1,1 3,1 2,1 1,-45 29,39-18,1 2,1 2,2 1,2 3,1 2,-46 59,66-73,2 2,0 1,2 0,2 1,0 1,2 0,-15 56,23-70,2 1,0 0,0 0,2 0,0 1,2-1,0 0,0 0,2 0,0 0,1 0,1-1,1 1,0-1,17 30,-9-26,0 0,2-1,1-1,0 0,1-2,1 0,0-1,2 0,-1-2,2-1,0 0,1-2,37 14,-18-10,1-3,1-1,-1-2,2-2,-1-2,86-2,-79-6,-1-2,1-2,-1-3,0-1,-1-3,0-2,-2-2,0-2,80-48,-81 39,-1-3,-1-1,-2-3,-2-1,-1-2,-1-1,-3-2,-2-2,29-48,-30 37,-3-2,-3-1,-2-1,-2-1,-3-1,17-98,-28 109,-2-1,-3 0,-1 0,-3 0,-2 0,-3 1,-1-1,-23-80,20 99,-2 1,-1 0,-1 1,-2 0,-1 1,-1 1,-1 0,-2 2,-37-38,43 50,-1 0,0 1,-1 1,0 0,-1 2,0 0,-1 1,0 1,0 0,-1 1,0 2,0 0,-1 1,1 1,-1 1,-29 0,32 3,1 1,-1 0,0 1,1 1,0 1,-1 0,2 1,-1 1,1 1,0 0,1 1,-16 11,19-10,0 0,1 0,0 1,1 0,0 1,1 0,1 1,0-1,0 2,1-1,1 1,0 0,1 1,-5 23,6-19,1 1,1 0,1 0,1 0,1 0,1-1,5 30,0-21,1 0,1-1,1 0,24 43,-9-28,2-1,1-1,2-1,2-2,70 63,-48-56,1-2,3-2,93 48,-40-35,133 46,-111-54,1-6,3-5,0-7,2-5,197 5,-295-27,65-7,-101 7,0-1,0-1,-1 1,1-1,-1 0,1 0,-1 0,1 0,-1-1,0 0,4-3,19-12,-16 14,0 1,0-1,0 2,0 0,0 0,1 1,-1 1,21 1,-8-1,24 0,65 7,-98-5,0 0,-1 1,1 1,-1 1,0 0,0 0,0 2,21 12,-31-16,1 1,-1-1,0 1,0 0,0 0,-1 0,1 1,-1-1,0 1,0 0,0 0,-1 0,0 0,0 0,0 0,-1 1,1-1,-1 1,-1-1,1 1,-1-1,0 1,0 0,-1-1,0 8,-5 10,0 0,-1-1,-1 1,-19 34,10-19,10-22,1 0,0 0,1 0,1 0,1 1,-3 26,6-34,0 0,1 0,0 0,0-1,1 1,0 0,0-1,1 1,0-1,1 0,0 0,0 0,1-1,8 12,-3-8,1 1,0-2,0 0,2 0,-1-1,1 0,0-1,0-1,1 0,0-1,1 0,-1-1,1-1,19 3,21 2,0-3,88-2,-137-4,-2 0,6 1,-1-1,1 0,0-1,-1 0,1-1,14-4,-57 54,5-8,2 0,-31 68,48-87,1 0,1 0,0 1,2 0,1 0,1 0,-1 42,4-50,-1-5,1 0,1 0,-1 0,2 0,-1 0,4 12,2-12,-3-15,-2-18,-5 8,-2 0,0 1,0-1,-1 1,-1 1,-1-1,-14-20,21 33,-1 0,0-1,0 1,0 0,0 0,0 0,0 0,0 1,-1-1,1 0,-1 1,1 0,-1-1,1 1,-1 0,0 1,0-1,0 0,1 1,-1-1,0 1,0 0,0 0,0 0,0 1,1-1,-1 0,0 1,0 0,0 0,1 0,-1 0,0 0,1 0,-1 1,1 0,0-1,-1 1,1 0,0 0,0 0,0 0,0 0,1 0,-1 1,-2 4,-4 9,0 0,1 1,0 0,2 0,0 1,1 0,1 0,0 0,0 34,4-47,-1 0,0 0,1-1,0 1,0 0,1 0,-1-1,1 1,0-1,0 1,1-1,-1 0,1 0,0 0,0 0,0 0,4 3,-4-4,0-1,0 0,0 0,1 0,-1 0,0 0,1-1,-1 1,1-1,-1 0,1 0,0 0,0-1,-1 1,1-1,0 0,0 0,-1 0,1-1,0 1,0-1,-1 0,5-2,-2 1,0-1,0 0,0-1,0 0,-1 1,0-2,1 1,-2-1,1 0,0 0,-1 0,0 0,0-1,-1 0,0 1,0-1,0-1,3-10,0-2,-1 0,-1 0,0-1,-2 0,1-22,-3 31,0 0,0 0,-1 1,0-1,-1 0,-1 1,-5-19,6 25,0 0,0 0,-1 0,1 0,-1 0,0 1,0-1,0 1,0 0,0 0,-1 0,0 0,1 1,-1-1,0 1,0 0,-1 0,1 1,0-1,-8-1,6 2,1 0,0 1,0-1,0 1,-1 0,1 1,0-1,0 1,0 0,-1 0,1 1,0-1,1 1,-1 1,0-1,-7 5,10-5,-1 0,0 0,1 0,-1 0,1 1,0-1,0 1,0 0,0 0,0 0,1 0,-1 0,1 0,0 0,0 0,0 0,0 0,0 1,1-1,0 0,-1 1,1-1,1 1,-1-1,0 0,2 7,-1-8,0 1,0 0,0-1,0 1,1-1,-1 1,1-1,-1 0,1 0,0 1,0-1,0 0,0-1,0 1,1 0,-1-1,0 1,1-1,0 0,-1 1,1-1,-1-1,1 1,0 0,0-1,4 1,-4 0,0-1,-1 0,1 0,0 0,-1-1,1 1,-1-1,1 1,0-1,-1 0,1 0,-1 0,0 0,1 0,-1 0,0-1,0 1,0-1,0 0,0 0,0 0,0 0,0 0,-1 0,1 0,-1 0,0 0,2-4,0-8,0 1,0-1,-2 1,1-1,-2 0,0 0,-3-22,1-31,2 65,0 0,0 0,0 0,0 0,0 1,1-1,-1 0,1 0,-1 0,1 0,0 0,0 0,0 1,0-1,0 0,0 1,0-1,1 1,-1-1,2-1,-1 3,-1-1,1 0,0 1,0-1,0 1,-1-1,1 1,0 0,0 0,0 0,0 0,-1 0,1 0,0 0,0 1,0-1,2 1,6 3,0 1,0-1,0 2,-1-1,15 12,-20-14,1 0,0 1,0-2,0 1,0-1,7 3,-11-5,-1 0,1 0,0 1,0-1,-1 0,1 0,0 0,0 0,0 0,-1 0,1 0,0-1,0 1,-1 0,1 0,0-1,0 1,-1 0,1-1,1 0,-1 0,-1 0,1 0,-1 0,1 0,-1 0,1 0,-1 0,1-1,-1 1,0 0,0 0,0 0,0-1,0 1,0 0,0 0,0 0,0-3,-2-7,-1 0,0 0,0 0,-1 0,-7-14,8 18,0 1,0 0,-1 1,0-1,0 1,0-1,-1 1,0 0,0 1,-6-6,10 10,1 0,-1-1,1 1,-1-1,1 1,-1 0,1-1,-1 1,0 0,1 0,-1 0,0-1,1 1,-1 0,0 0,1 0,-1 0,0 0,1 0,-1 0,1 0,-1 1,0-1,1 0,-1 0,0 0,1 1,-1-1,0 1,0 0,1 0,-1 0,0 0,1 0,-1 0,1 0,-1 0,1 0,0 1,-1-1,1 0,0 0,0 0,0 2,0 2,0 0,0 0,1 0,0-1,0 1,0 0,2 4,-1-6,-1 0,1 0,0 0,0-1,0 1,1-1,-1 1,0-1,1 0,0 0,-1 0,1 0,0 0,0-1,4 2,-5-2,0-1,0 1,0-1,0 0,1 0,-1 1,0-1,0-1,0 1,0 0,0 0,1-1,-1 0,0 1,0-1,0 0,0 0,0 0,-1 0,1 0,0 0,0-1,-1 1,1 0,1-3,5-6,0 0,-1 0,0-1,0 0,-1 0,-1-1,0 0,4-15,-2 2,-1-1,-1 1,2-29,-6 44,-1 0,0 0,-1-1,0 1,0 0,-6-17,7 25,-1 0,0 1,1-1,-1 1,0-1,0 0,0 1,0-1,0 1,0 0,0-1,-1 1,1 0,-1 0,1 0,0 0,-1 0,-1-1,1 2,0-1,0 1,0 0,0 0,0 0,0 0,0 1,0-1,0 1,0-1,0 1,0-1,0 1,1 0,-1 0,0 0,1 0,-1 0,0 0,-2 3,2-1,-1 0,0 0,1 0,-1 0,1 0,0 0,0 1,0 0,1-1,-1 1,1 0,0-1,0 1,0 0,0 0,0 5,1 3,-1 0,1-1,1 1,3 14,-3-20,0 0,1-1,-1 1,1-1,1 1,-1-1,1 0,0 0,0 0,1 0,-1-1,1 1,0-1,5 4,-7-5,1-1,0 0,0 0,0-1,0 1,0-1,1 1,-1-1,0 0,1 0,-1 0,1-1,-1 1,0-1,1 0,-1 0,1 0,-1-1,1 1,-1-1,1 1,-1-1,0 0,6-3,-7 3,0 0,0 0,0 0,0-1,0 1,0-1,0 1,-1-1,1 0,-1 0,1 0,-1 0,0 0,1 0,-1 0,0 0,0 0,0-3,1-3,0 0,-1 0,0 1,-1-10,1-3,9 50,-3-2,21 49,-21-59,-6-17,0 1,0 0,-1-1,1 1,-1 0,1 0,-1-1,0 1,1 0,-1 0,0 0,0-1,0 1,-1 0,1 0,0 0,-1-1,1 1,-1 0,0 0,1-1,-1 1,0 0,0-1,0 1,0-1,0 1,-1-1,-1 2,-7 11,8-11,0-1,1 1,-1 0,1 0,0 0,0 1,0-1,0 0,1 0,-1 1,1-1,0 0,0 0,0 1,0-1,1 0,-1 0,1 1,0-1,0 0,0 0,0 0,1 0,-1 0,1 0,-1 0,1 0,0-1,0 1,3 2,-4-5,-1 0,1 1,-1-1,1 1,-1-1,1 0,-1 1,1-1,-1 0,1 0,0 1,-1-1,1 0,-1 0,1 0,0 0,-1 0,1 0,0 0,-1 0,1 0,-1 0,1 0,0 0,-1-1,1 1,-1 0,1 0,0-1,0 1,0-2,0 1,0 0,0 0,0-1,0 1,0-1,0 1,0-1,-1 1,1-1,0-2,1-4,0 1,-1-1,1-16,-2 11,-1-1,0 1,-2 0,1 0,-1-1,-1 2,0-1,-1 0,-13-23,17 34,-1 0,1 1,0-1,-1 0,0 0,1 1,-1-1,0 1,0-1,0 1,0 0,0 0,0-1,0 2,-1-1,1 0,0 0,-1 1,1-1,0 1,-1 0,1 0,0-1,-1 2,1-1,0 0,-1 0,1 1,-4 1,-1 0,1 1,-1 0,1 0,0 0,0 1,0 0,1 0,-8 8,12-11,-1 0,1 1,0-1,0 0,0 0,-1 0,1 0,-1-1,1 1,0 0,-1 0,0-1,1 1,-1-1,1 1,-1-1,0 0,1 0,-1 0,1 0,-1 0,-3 0,3-1,0 0,0-1,0 1,1 0,-1 0,0-1,1 1,-1-1,1 0,-1 1,1-1,0 0,-1 0,1 0,0 0,-1-3,-4-13,0-1,1 0,0 1,-2-38,2 20,-2-15,2 0,2 0,7-83,-4 131,1 0,0 0,0 0,0 0,0 0,0 1,0-1,1 0,0 1,-1-1,1 1,3-4,30-25,-6 6,18-20,-26 26,24-28,-42 41,1 1,-2 0,1-1,0 0,-1 1,0-1,-1 0,1 0,-1 0,1-12,-2 12,1-1,0 1,0 0,0 0,1-1,0 1,0 0,1 0,0 1,6-11,-4 11,1 0,-1 0,1 0,0 1,0 0,0 0,1 0,9-3,-11 5,0 0,0 0,0 0,0-1,0 0,-1 0,0 0,1-1,-1 1,-1-1,1 0,0 0,-1 0,0-1,0 1,0-1,3-6,-4 5,0 0,1 0,0 1,0-1,7-9,-9 14,0 0,-1 0,1 0,0 0,0 0,0 1,0-1,0 0,0 1,0-1,0 1,0-1,0 1,0-1,0 1,0 0,0-1,0 1,0 0,1 0,-1 0,0 0,0 0,0 0,0 0,0 1,0-1,1 0,-1 1,0-1,0 0,0 1,0-1,0 1,0 0,0-1,0 1,0 0,-1-1,3 3,-1-1,0 1,0 0,-1-1,1 1,0 0,-1 0,0 0,1 0,-1 0,0 1,-1-1,1 0,0 4,1 48,-2-41,0 38,-3 132,2-182,1 0,0 0,-1 0,1 0,-1 0,0 0,0 0,1 0,-1-1,0 1,-1 0,1-1,0 1,0-1,-1 1,1-1,-1 0,1 1,-1-1,0 0,-3 2,-2 0,-1 0,0 0,0-1,-9 2,-12 4,17-4,-1 1,1 0,0 1,-17 10,25-12,-1 0,1 0,-1 0,1 0,0 1,1-1,-1 1,1 0,0 0,0 0,1 1,-4 8,-1 6,2 1,0 0,1-1,-1 24,4-34,1 0,0 0,0-1,1 1,1 0,-1-1,1 1,1-1,0 0,0 0,6 10,-9-17,1-1,0 0,0 1,-1-1,1 0,0 0,0 1,0-1,1 0,-1 0,0 0,0-1,0 1,1 0,-1 0,1 0,-1-1,0 1,3 0,-3-1,1 0,-1 0,0-1,1 1,-1 0,1 0,-1-1,0 1,0-1,1 1,-1-1,0 0,0 1,1-1,-1 0,0 0,1-1,3-4,1 0,-1 0,-1 0,1-1,-1 0,3-7,2-5,-1-1,-1 0,0 0,-2-1,0 1,-2-1,0 0,-1 0,-1-1,-4-39,1 120,1-61,0 1,0-1,0 1,0-1,0 1,0 0,0-1,0 1,-1 0,1 0,-1 0,1 0,0 0,-1 0,0 0,1 0,-3 0,-33-14,24 14,1-1,-1 2,0-1,0 2,1 0,-25 5,-16 1,-98-2,-430-10,-17 0,507 6,12-2,-1 4,-106 18,164-15,1 0,0 2,1 0,-28 16,-21 9,66-32,0 1,-1-1,1 1,0 0,1 0,-1 0,0 0,1 1,-1-1,1 1,0 0,-1-1,1 1,1 0,-1 0,0 0,1 0,-1 1,-1 5,2-3,0 0,0 1,1-1,0 0,0 0,0 1,1-1,-1 0,2 0,1 9,-2-14,-1 0,1 0,-1 0,1 0,-1 0,0 1,0-1,1 0,-1 0,0 0,0 1,0-1,0 0,0 0,-1 0,1 1,0-1,-1 0,1 0,0 0,-1 0,0 0,1 0,-1 0,1 0,-1 0,0 0,0 0,0 0,0 0,1 0,-1-1,0 1,0 0,-1-1,1 1,0-1,0 1,0-1,0 1,0-1,0 0,-1 1,0-1,-8 1,-1-1,1 0,0 0,-17-4,12 2,-676-61,535 57,0 8,-226 30,235-5,0 7,3 5,1 7,-222 104,351-143,-133 68,127-64,0 2,1 0,1 2,-30 28,46-41,-1 1,1 0,-1 0,1 0,0 1,0-1,0 1,1-1,-1 1,1-1,0 1,0 0,0-1,0 1,1 0,-1 0,1 0,0 0,0-1,1 1,-1 0,1 0,1 4,0-3,0 0,1 0,-1 0,1 0,0-1,1 1,-1-1,1 1,0-1,0-1,0 1,0 0,1-1,-1 0,7 3,3 2,0-2,1 0,-1-1,1 0,0-1,0-1,0 0,28 1,-22-4,0-1,1-1,-1 0,0-2,39-11,-32 5,-1-1,-1-1,0-1,0-1,-1-2,-1 0,-1-1,0-2,32-33,-35 28,-1 0,-1-1,0-1,-3 0,0-1,-1-1,11-35,-17 40,-1-2,-1 1,-1-1,-1 0,-1 0,-1 0,-2 0,0 0,-5-31,2 43,1 0,-2 0,1 1,-2-1,0 1,0 0,-1 0,-1 1,0-1,0 1,-17-18,11 16,0 1,-1 1,0 1,0 0,-1 0,0 2,-1 0,-17-7,0 4,1 0,-2 3,-47-8,-96 3,165 13,-18-1,-1 1,1 1,-58 11,79-10,1 1,0-1,0 2,0-1,0 1,0 0,-13 11,17-12,-1 1,1 0,1 0,-1 1,0-1,1 1,0 0,0 0,1 0,-1 0,1 0,0 0,-1 9,0 2,1 0,0 0,1 1,1-1,1 1,0-1,2 0,-1 0,2 0,0 0,8 18,0-3,2-1,1 0,1-1,31 42,-30-49,1 1,2-2,0-1,1 0,0-2,2 0,0-1,1-2,1 0,36 15,-57-29,0 1,1-1,-1 1,0-1,1-1,-1 1,9 0,-11-2,-1 1,1 0,-1-1,0 1,1 0,-1-1,0 0,1 1,-1-1,0 0,0 0,1 0,-1 1,0-1,0 0,0-1,0 1,0 0,-1 0,1 0,0 0,0-1,-1 1,1 0,-1-1,1 1,0-3,1-8,0 0,0 0,-1 0,-1 0,0 0,0 0,-1 0,-1 0,-4-18,0 8,-1-1,-1 1,-1 1,-13-24,4 15,-1 0,-2 2,0 0,-2 2,-1 0,-53-42,37 38,-2 1,-1 2,-1 2,-56-23,66 34,0 2,0 1,-50-9,64 17,1 1,-1 0,1 1,-1 1,1 1,-1 1,-37 9,53-10,-1 2,0-1,0 0,1 1,0 0,-1 0,1 0,0 1,1 0,-1-1,0 1,1 0,-5 8,-1 2,1 0,-12 31,11-25,2 1,-6 26,12-41,-1 0,2 0,-1 0,1 0,0 0,0 0,0 0,1 0,0 0,0 0,1 0,0 0,2 6,1-5,-1 0,1 0,0 0,1 0,-1-1,1 0,1 0,-1-1,1 0,0 0,0 0,0-1,15 6,-1-1,1-1,0-2,1 0,23 2,4-2,0-2,1-3,-1-2,0-2,95-19,-49 1,-2-5,98-41,-116 37,-2-4,-1-3,92-63,-131 76,0-1,-2-2,-1-1,-1-1,-2-2,-1-1,-1-1,29-51,-43 63,-1-1,-1 0,-2-1,0 0,-1-1,5-34,-10 43,-1 0,0 0,-1-1,-1 1,0 0,-1-1,-1 1,0 0,-1 0,-1 1,-7-19,2 14,-1 1,0 0,-1 1,-1 0,-1 0,0 2,-1 0,0 0,-2 1,1 1,-2 1,1 1,-2 0,-26-11,18 11,0 1,-1 1,0 1,0 2,-1 0,1 3,-1 0,0 1,0 2,-30 4,16 2,2 2,-1 2,1 1,0 2,1 2,1 2,0 2,2 1,0 1,1 3,2 1,-37 32,59-46,1 1,0 0,0 0,1 1,1 0,0 1,0 0,2 0,0 1,0 0,-7 29,12-34,0 0,0 1,1-1,0 1,1-1,0 1,1 0,0-1,1 1,0-1,0 0,1 0,1 0,0 0,0 0,1-1,0 1,0-1,8 9,-1-5,0 0,0-2,1 1,1-1,0-1,1-1,-1 0,2-1,-1 0,1-1,32 9,-4-5,1-1,0-2,65 3,-27-8,0-5,-1-2,0-5,0-3,82-23,-62 7,-3-5,0-3,145-78,-193 86,-1-1,-2-4,0-1,82-79,-109 91,0 0,-2-1,-1-2,-1 0,-1 0,-2-2,0 0,-2 0,0-1,-3-1,10-41,-14 44,-2-1,-1 0,0 0,-3-1,0 1,-1 0,-2 0,-1 1,-1-1,-1 1,-1 0,-2 1,-15-32,13 35,-1 0,-1 1,0 1,-2 0,0 1,-1 1,-1 0,-1 1,0 1,-1 1,-1 1,0 1,-1 1,-36-16,21 15,-1 2,-1 1,1 2,-1 2,-41-1,-10 4,-98 9,184-6,0 0,-1 1,1 0,-1 0,1 0,0 0,0 0,-1 1,1 0,0 0,-4 2,6-1,-1-1,1 0,0 1,-1-1,1 1,1 0,-1 0,0 0,1 0,-1 0,1 0,0 0,0 1,-1 5,-1 4,1 0,1 0,0 1,1-1,0 0,1 0,1 0,0 0,0 0,2 0,-1-1,2 1,-1-1,9 15,-7-17,0 0,1-1,0 1,0-1,1-1,0 0,0 0,1 0,0-1,1 0,-1-1,1 0,0-1,1 0,-1 0,17 4,-15-5,0-1,0-1,1 0,-1 0,1-1,-1-1,0 0,14-2,-22 1,1 0,-1 0,0 0,0-1,0 1,0-1,0 0,0-1,0 1,-1-1,1 1,-1-1,1 0,-1 0,0 0,0-1,-1 1,1-1,-1 0,0 1,0-1,0 0,0-1,-1 1,3-8,-1-2,-1-1,-1 1,0 0,-1-1,0 1,-1 0,-1-1,0 1,-1 0,-1 0,0 0,0 1,-11-22,-3-1,-2 1,-1 1,-42-53,-76-74,133 153,0 1,0 1,0-1,-1 1,-10-8,14 13,1-1,0 1,0 0,0 0,-1 0,1 0,0 1,-1-1,1 1,-1-1,1 1,-1 0,1 0,0 0,-1 0,1 0,-1 1,1-1,-1 1,1-1,0 1,-1 0,1 0,-4 3,-2 1,0 1,1 0,0 0,0 1,1 0,-1 0,1 0,1 1,0 0,-7 13,-3 11,-17 50,27-69,-20 60,4 1,2 1,4 1,4 0,-4 124,15-191,-1 4,1 1,1-1,1 1,3 16,-5-27,1-1,-1 0,1 0,0 0,0 0,-1 0,1 0,1 0,-1 0,0 0,0 0,1-1,-1 1,1 0,-1-1,1 1,0-1,0 0,-1 1,1-1,0 0,0 0,0 0,0-1,0 1,1 0,-1-1,0 1,0-1,0 0,1 0,-1 0,3 0,4-2,0 1,0-2,0 1,-1-1,1-1,-1 0,0 0,0 0,11-9,9-8,27-26,-52 45,27-26,-1-1,-1-1,30-42,-47 56,0 0,-2-1,0-1,0 1,-2-1,0-1,-1 1,-1-1,2-20,-6 35,0 0,-1 1,0-1,0 0,0 0,0 0,-1 0,1 0,-1 1,0-1,0 0,-1 0,1 1,-1-1,1 1,-1-1,-3-2,2 3,0-1,-1 1,1 1,-1-1,0 0,1 1,-1 0,0 0,-1 0,1 0,0 1,-1-1,1 1,-6 0,-3-1,0 1,-1 1,1 0,0 1,-1 0,1 1,0 1,0 0,0 0,0 2,1-1,-1 2,-12 7,1 0,0 2,1 0,1 2,1 0,-29 31,28-25,2 2,1 0,0 1,2 1,2 1,-14 31,19-36,2 1,0 0,2 0,0 0,2 1,1-1,1 1,1 33,2-45,0-1,2 0,-1 1,2-1,-1 0,2 0,-1-1,2 0,-1 1,2-2,-1 1,2-1,-1 0,19 18,19 15</inkml:trace>
</inkml:ink>
</file>

<file path=ppt/ink/ink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4.482"/>
    </inkml:context>
    <inkml:brush xml:id="br0">
      <inkml:brushProperty name="width" value="0.05" units="cm"/>
      <inkml:brushProperty name="height" value="0.05" units="cm"/>
      <inkml:brushProperty name="color" value="#66CC00"/>
      <inkml:brushProperty name="ignorePressure" value="1"/>
    </inkml:brush>
  </inkml:definitions>
  <inkml:trace contextRef="#ctx0" brushRef="#br0">304 42,'0'-1,"0"-1,0 1,-1-1,1 1,-1-1,0 1,1 0,-1-1,0 1,0 0,0 0,0-1,0 1,0 0,0 0,0 0,0 0,0 0,-1 0,1 1,0-1,-1 0,1 1,-1-1,1 0,-3 1,-40-10,42 10,-6-1,-1 0,1 1,-1 0,0 0,1 1,-1 1,1-1,-1 1,1 1,0-1,0 1,0 1,0 0,0 0,1 0,0 1,0 0,0 1,0-1,1 1,0 0,0 1,-7 10,8-8,0-1,0 1,1 0,0 1,1-1,0 1,0-1,1 1,1 0,-2 16,2-15,1 0,1 1,-1-1,2 0,-1 0,2 0,-1 0,1-1,7 15,-7-18,1-1,1 0,-1 1,1-1,0-1,1 1,-1-1,1 0,0 0,0-1,12 7,-14-8,0-1,1 0,-1 0,0 0,1-1,-1 0,1 0,0 0,-1 0,1-1,0 1,-1-1,1-1,0 1,0 0,-1-1,1 0,-1 0,9-4,1-3</inkml:trace>
</inkml:ink>
</file>

<file path=ppt/ink/ink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0:58.139"/>
    </inkml:context>
    <inkml:brush xml:id="br0">
      <inkml:brushProperty name="width" value="0.05" units="cm"/>
      <inkml:brushProperty name="height" value="0.05" units="cm"/>
      <inkml:brushProperty name="color" value="#66CC00"/>
      <inkml:brushProperty name="ignorePressure" value="1"/>
    </inkml:brush>
  </inkml:definitions>
  <inkml:trace contextRef="#ctx0" brushRef="#br0">1321 261,'-23'-3,"21"2,-1 0,1 1,0-1,0 1,-1 0,1-1,0 1,0 0,-1 0,1 1,0-1,0 0,-1 1,-3 1,3 0,0 0,0-1,0 2,0-1,0 0,1 1,-1-1,1 1,-1 0,1 0,0 0,0 0,0 0,1 0,-1 0,1 1,0-1,0 1,0-1,-1 7,0 3,0 0,2 0,-1 0,3 20,-1-24,1 0,0 0,1-1,0 1,0 0,1-1,0 0,1 0,-1 0,2 0,7 8,-5-6,1 0,1 0,0-1,0-1,1 0,0 0,14 7,-19-12,1 0,0 0,0-1,0 1,0-2,1 1,-1-1,0 0,1-1,-1 1,0-2,1 1,8-2,-5 0,-1-1,0 0,-1-1,1 0,-1 0,1-1,-1 0,15-12,-12 7,1-1,-2 0,0-1,0 0,-1-1,0 0,-1-1,-1 0,0 0,-1-1,0 0,4-18,-8 22,0 0,-1-1,-1 1,1-1,-2 1,0-1,0 1,-1-1,-1 1,-5-22,4 23,-1 1,1 0,-2 0,1 0,-2 0,1 1,-1 0,0 0,0 1,-1-1,0 1,-1 1,-8-7,1 4,-1-1,0 2,0 0,-1 1,0 1,-1 0,1 2,-1 0,0 0,0 2,0 0,-1 1,1 1,-35 5,48-4,1 0,-1 0,0 0,1 1,-1-1,1 1,-1 0,1 1,0-1,0 1,0 0,0 0,1 0,-1 0,1 1,0 0,0-1,0 1,0 0,1 0,-1 1,1-1,0 0,0 1,-1 6,0 3,-1 0,2 0,0 1,1-1,0 1,2-1,1 18,-1-26,0-1,0 0,0 0,1 0,-1 0,1-1,1 1,-1 0,1-1,-1 1,1-1,1 0,-1 0,0 0,1-1,0 1,0-1,0 1,0-2,1 1,-1 0,1-1,0 0,7 3,-8-3,0-1,1 0,-1-1,0 1,0-1,0 1,0-1,1-1,-1 1,0 0,0-1,0 0,0 0,0 0,0-1,0 1,0-1,0 0,-1 0,1 0,-1-1,1 1,-1-1,0 0,0 0,0 0,0 0,-1 0,1-1,2-5,-1 1,-1 1,0-1,0 0,-1 0,0-1,0 1,-1 0,0-1,0 1,-1-1,-1 1,1-1,-1 1,0-1,-1 1,0 0,-1 0,1 0,-1 0,-1 0,0 0,0 1,0 0,-1 0,0 0,0 0,-10-8,7 8,0 0,0 1,-1 0,1 1,-1 0,-1 0,1 1,-1 0,0 1,0 0,0 0,0 1,0 0,0 1,-1 1,1-1,0 1,-1 1,1 0,-20 5,27-5,0 0,0 0,0 1,0 0,0-1,1 1,-1 0,1 0,0 0,-1 1,1-1,0 1,0-1,0 1,1-1,-1 1,1 0,-1 0,1 0,0 0,0 0,0 0,0 0,1 0,0 1,-1-1,1 6,0 1,1 0,-1-1,2 1,-1-1,1 1,1-1,0 1,5 11,-1-9,0 0,0 0,1-1,1 0,0-1,0 0,1 0,0-1,1-1,0 1,0-2,1 1,0-2,16 7,-16-7,0-2,0 0,0 0,1-1,-1-1,1 0,0 0,0-2,0 1,-1-2,1 0,0 0,0-1,-1-1,19-5,-26 6,-1 0,1 0,0-1,-1 1,0-1,1 0,-1-1,0 1,-1-1,1 1,-1-1,1 0,-1 0,0-1,-1 1,1-1,-1 1,0-1,0 0,0 0,-1 0,3-10,-4 9,1-1,-1 0,0 1,-1-1,1 0,-1 1,0-1,-1 1,0-1,0 1,0 0,-1 0,0 0,0 0,-1 0,1 1,-8-9,-2-1,-1 2,-1 0,1 1,-2 1,0 0,0 1,-30-14,32 18,0 0,-1 1,1 1,-1 0,0 1,0 0,0 2,-1-1,1 2,-20 1,31 0,0 0,0 0,1 0,-1 0,0 0,1 1,-1 0,1 0,0 0,-1 0,1 0,0 0,0 1,1 0,-1-1,0 1,1 0,0 0,-1 1,1-1,1 0,-1 1,0-1,1 1,0 0,-1-1,0 7,-1 9,0 0,2 0,0 0,1 25,1-26,-1-5,0-1,2 0,-1 0,1 0,1 0,4 12,-6-20,1-1,-1 1,1-1,0 0,0 1,0-1,0 0,1 0,-1-1,1 1,0 0,0-1,0 1,0-1,0 0,0 0,1 0,-1-1,1 1,-1-1,1 0,0 0,5 1,-5-1,0-1,0 1,0-1,0 0,0 0,0 0,0-1,0 1,0-1,-1 0,1 0,0 0,6-3,-8 2,0 1,0-1,0 0,0 0,0 0,-1 0,1 0,-1-1,1 1,-1 0,0-1,1 1,-1-1,-1 1,1-1,0 0,-1 1,1-1,-1 0,0 1,0-4,0-3,0 1,-1 0,-1-1,0 1,0 0,0 0,-1 0,0 0,0 1,-1-1,0 1,-9-12,5 8,0 1,0 0,-1 0,0 1,-1 0,0 1,-18-12,24 18,1 0,-1 0,0 0,0 0,0 1,0-1,0 1,0 0,0 1,0-1,-1 1,1-1,0 1,0 0,-1 1,1-1,0 1,0 0,0 0,0 0,0 1,-5 1,3 1,-1 0,1 1,1 0,-1 0,0 0,1 0,0 1,1 0,-1 0,1 1,-6 11,1 0,1 0,1 1,1 0,-6 28,9-34,1 1,0 0,1-1,1 1,0 0,1 0,4 17,-4-25,0-1,1 0,0 0,0 0,0-1,1 1,-1 0,1-1,0 0,0 0,1 0,0 0,-1 0,1 0,0-1,1 0,-1 0,0 0,1 0,0-1,0 0,0 0,-1 0,2-1,-1 1,0-1,7 0,4 1,-1-1,1-1,-1 0,1-2,-1 1,1-2,-1 0,18-7,-28 9,-1-1,1 0,-1 0,0 0,0 0,0-1,0 1,0-1,-1 0,1-1,-1 1,0 0,0-1,0 0,0 0,-1 0,0 0,1 0,-1 0,-1-1,1 1,-1-1,1 1,-1-1,-1 1,1-1,-1 0,0-6,0 2,0 0,-1 0,-1-1,0 1,0 0,-1 0,1 1,-2-1,0 0,0 1,0 0,-1 0,-9-12,-1 4,-1 0,-1 1,0 0,-1 1,0 1,-1 1,0 1,-1 1,-1 0,0 1,0 2,0 0,-1 1,0 1,0 1,0 1,-1 1,1 1,0 1,-1 1,-41 7,55-5,-1 0,0 0,1 1,0 1,0-1,0 2,1-1,-1 1,1 0,1 1,-1 0,1 0,0 1,1-1,0 2,0-1,1 0,-7 14,4-5,1 0,1 1,0 0,1 0,1 0,1 0,1 1,0-1,1 24,2-29,0 1,1-1,1 0,0 0,0 0,2-1,-1 1,1-1,1 0,1-1,-1 1,2-1,-1 0,2-1,-1 0,15 13,-11-13,0 0,1 0,0-2,1 0,-1 0,2-1,-1-1,1 0,0-1,0-1,0 0,0-1,25 2,-29-4,0-1,0 0,0-1,0 0,0-1,0 0,-1 0,1-1,18-8,-22 7,1 0,-1-1,0 0,0 0,-1-1,0 0,0 0,0 0,0-1,-1 1,0-1,-1-1,6-9,-5 7,-1-1,0 1,0-1,-1 0,0 0,-1 0,0 0,-1 0,0-1,-1 1,-1 0,1-1,-2 1,1 0,-1 0,-1 0,-4-12,0 7,-1 0,0 0,-1 1,0 0,-1 0,-1 1,0 1,-1 0,-1 0,-19-14,8 9,0 2,-2 1,0 1,0 1,-2 1,1 1,-1 2,-1 1,0 1,0 1,0 2,0 1,-1 1,-45 3,55 1,1 0,0 2,0 0,0 1,0 0,1 2,0 0,0 2,1-1,-22 16,18-9,1 2,0 0,2 0,0 2,0 1,2 0,-16 25,11-8,0 0,3 2,1 0,2 1,2 0,1 1,2 0,2 1,-3 56,10-80,1 0,1-1,0 1,2 0,0 0,1-1,0 1,2-1,0 0,0-1,2 0,11 18,-5-12,1-1,1 0,1-2,1 0,1 0,1-2,36 25,-13-14,1-2,0-3,2-1,1-2,1-3,0-1,97 17,-96-25,0-3,0-2,0-2,0-2,1-2,-1-2,-1-3,58-16,-78 16,-1-2,0-1,0-1,-1-1,-1-2,0 0,-1-2,-1 0,0-2,39-41,-51 46,0 1,-2-2,1 1,-2-1,0 0,-1-1,0 0,7-26,-11 28,-1-1,0 1,0-1,-2 0,0 1,0-1,-2 0,0 1,0-1,-9-27,2 18,-1 1,-1 0,-1 1,-1 0,0 1,-2 0,0 2,-2-1,0 2,-1 0,-1 1,0 1,-26-16,24 19,-1 0,0 1,0 1,-1 1,-1 1,0 1,0 2,0 0,-1 1,0 2,0 0,0 2,-32 2,51-1,1 1,0 0,0 0,0 1,0 0,0 0,0 0,0 0,1 1,-1 0,1 0,-1 0,1 0,0 1,1-1,-1 1,1 0,-1 0,1 1,0-1,1 0,-1 1,1 0,0 0,0 0,-2 5,-1 12,0 0,0 0,2 0,0 41,2-55,1 1,1-1,-1 1,1-1,1 1,-1-1,2 1,-1-1,6 13,-6-17,1-1,-1 1,1-1,-1 1,1-1,0 0,0 0,1 0,-1 0,1-1,-1 1,1-1,0 0,0 0,0 0,0-1,0 1,0-1,0 0,7 1,1 0,0-1,-1 0,1-1,0-1,0 1,0-2,-1 0,1 0,-1-1,1 0,-1-1,0 0,0-1,-1 0,1-1,-1 0,13-11,-11 6,0 0,-1-1,0 0,0-1,-2 0,1-1,-2 1,0-2,0 1,-2-1,10-31,-10 25,-1 0,-1-1,-1 1,-1-1,-1 0,-1 0,-1 1,-1-1,0 0,-2 1,-1 0,0 0,-1 0,-2 0,0 1,-1 0,-1 1,-1 0,-22-30,31 47,1 0,-1 0,0 0,0 0,0 0,0 0,-1 0,1 1,0-1,-1 1,-3-2,5 3,0 0,0 0,0 0,0 0,0 0,-1 0,1 0,0 0,0 1,0-1,0 0,0 1,0-1,0 1,0-1,0 1,0-1,0 1,0-1,1 1,-1 0,0 0,0 0,1-1,-1 1,0 0,1 0,-1 0,1 0,-1 2,-6 9</inkml:trace>
</inkml:ink>
</file>

<file path=ppt/ink/ink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2-07-02T15:51:55.243"/>
    </inkml:context>
    <inkml:brush xml:id="br0">
      <inkml:brushProperty name="width" value="0.35" units="cm"/>
      <inkml:brushProperty name="height" value="0.35" units="cm"/>
      <inkml:brushProperty name="color" value="#33CC33"/>
      <inkml:brushProperty name="ignorePressure" value="1"/>
    </inkml:brush>
  </inkml:definitions>
  <inkml:trace contextRef="#ctx0" brushRef="#br0">3927 2864,'22'0,"30"5,6 2,95 2,75-1,348-3,1-43,-311 0,-215 27,-1-2,-1-2,51-23,-82 29,0 0,0-1,-1 0,0-1,19-17,-31 23,1-1,-1 1,1-1,-1 0,-1 0,1 0,-1-1,0 0,-1 0,0 0,0 0,0 0,-1 0,0-1,0 0,0-7,-2 9,-1 1,1-1,-1 1,0-1,-1 0,1 1,-1 0,0-1,0 1,-1 0,1 0,-1 0,-1 1,1-1,0 1,-1-1,0 1,0 1,0-1,-8-5,-4-2,0 1,0 0,-1 1,0 1,-19-6,-21-4,-2 1,1 4,-64-7,-181-2,-20 23,277 3,1 2,-1 1,1 3,0 1,-44 19,66-20,1 1,0 1,0 2,1 0,1 1,0 1,1 0,1 2,1 0,0 1,1 1,-16 28,15-20,1 1,2 0,1 1,2 1,0 0,2 0,2 1,-7 64,8-4,5-1,10 94,-9-182,0 1,0-1,0 1,1-1,0 1,0-1,0 0,0 0,0 1,1-1,-1 0,1 0,4 5,-6-8,0 0,0 1,0-1,1 0,-1 0,0 0,0 0,1 0,-1 0,0 1,0-1,1 0,-1 0,0 0,0 0,1 0,-1 0,0 0,0 0,1 0,-1 0,0 0,0 0,1-1,-1 1,0 0,0 0,1 0,-1 0,0 0,0 0,1-1,-1 1,0 0,6-11,0-15,-4 13,-1 0,0 0,-1 0,0 0,-1 0,-1 0,0 0,-1 1,0-1,-1 1,0-1,-8-13,4 11,-1 0,-1 1,0 0,0 1,-2 0,0 0,0 1,-26-19,22 21,0 0,-1 0,0 2,0 0,-1 1,0 0,0 2,-27-5,4 4,0 1,-76 3,98 3,0 0,0 2,1 0,-1 1,1 1,0 0,0 2,0 0,1 1,-19 12,22-12,2 1,0 1,0 0,0 1,1 0,1 0,0 1,1 1,0 0,1 0,0 0,-11 27,15-29,1 0,-1 1,2-1,0 0,0 1,1 0,0-1,1 1,0 0,1-1,0 1,1-1,5 18,-3-17,1 0,0 0,1-1,0 1,1-2,0 1,1-1,0 0,1 0,0-1,0 0,14 9,-5-5,2-1,-1-1,1-1,1-1,0-1,0-1,0-1,1 0,0-2,25 2,0-1,1-3,0-3,79-9,-68 1,-1-2,67-22,-96 23,0-1,0-1,-1-2,0-1,49-35,-72 46,1-1,-1 0,0 0,0-1,0 0,-1 1,1-2,-1 1,-1 0,1-1,-1 1,3-11,-5 13,0 0,-1-1,1 1,-1-1,0 1,0 0,0-1,0 1,-1-1,0 1,0 0,0 0,0-1,-1 1,0 0,0 0,0 0,0 1,0-1,-1 0,-4-4,-4-3,0 1,-1-1,0 2,-1 0,0 1,0 0,-25-10,4 4,-1 1,-40-8,12 7,0 3,-115-6,128 16,0 3,1 1,0 3,-59 14,90-15,2 0,-1 1,1 1,-1 0,2 1,-1 1,1 0,1 1,-14 13,21-18,2 1,-1 0,0 0,1 0,0 1,1-1,0 1,0 1,0-1,1 0,0 1,0 0,1-1,0 1,0 0,1 0,0 0,0 1,1-1,0 0,2 14,1-8,1-1,0 0,1 1,1-2,0 1,0-1,2 0,-1 0,16 18,3 0,2-1,37 30,-16-19,2-3,2-1,1-3,1-3,2-1,0-4,2-1,1-4,1-2,93 15,-128-29,1-1,-1-2,1 0,-1-2,39-6,-52 4,0 0,0 0,-1-1,1-1,-1 0,0-1,0 0,-1-1,0 0,0-1,0 0,16-17,-11 5,0 0,-1 0,-1-2,-2 0,0 0,-1-1,-1-1,7-25,-7 17,-2-1,-1-1,-2 1,-1-1,-1-52,-4 68,-1 0,0 0,-2 0,0 1,0-1,-2 1,0 0,-1 0,-1 1,0 0,-1 0,-1 1,0 0,-1 1,-1 0,0 1,-1 0,-1 1,1 1,-2 0,0 0,0 2,-1 0,0 0,-26-8,16 7,-1 2,-1 1,1 2,-1 0,0 2,-1 0,1 3,0 0,-1 2,1 0,-31 9,42-7,0 1,0 1,1 0,-1 1,2 1,-1 1,1 0,-17 14,21-13,0 0,0 1,1 0,1 0,0 1,0 1,1-1,1 1,0 1,-8 22,7-12,1 0,2 1,0-1,1 1,2 0,0 0,2 0,1 0,1 0,1 0,1 0,1-1,14 43,-11-47,1 1,0-1,2 0,0-1,1 0,1-1,1-1,1 0,0 0,1-2,0 0,2-1,-1 0,2-2,36 20,-21-17,1-1,-1-2,2-1,0-2,69 8,-59-13,1-2,0-3,-1-1,58-11,-38 0,-1-3,0-4,-1-2,-1-2,-1-4,97-59,-90 42,-2-2,-2-4,-2-2,-3-3,61-73,-73 71,-3-3,-2-1,-3-1,-3-3,50-122,-74 153,-1 0,-2 0,-2-1,-1 0,-1 0,0-58,-6 76,-1-1,-1 1,0-1,-2 1,0 0,-1 0,0 1,-2-1,0 1,-1 1,-1-1,0 1,-1 1,-24-29,15 25,0 1,-2 1,0 1,-1 0,0 2,-2 0,1 2,-37-14,-5 3,-1 3,-75-13,22 11,0 4,-1 6,-212 5,185 22,125-11,0 1,0 1,0 1,-27 12,43-16,0 0,1 0,-1 1,1-1,-1 1,1 1,0-1,1 1,-1-1,1 1,0 1,0-1,0 1,1-1,0 1,0 0,0 0,1 0,0 1,0-1,1 0,0 1,0 0,0-1,1 1,0-1,1 8,0 6,0-1,2 1,1-1,0 0,1-1,1 1,10 21,-4-15,2 0,0-1,2-1,26 31,-4-12,3-3,1-1,1-2,69 43,-51-41,109 52,-127-72,1-1,1-2,73 14,-104-27,-1 0,1 0,-1-2,1 1,-1-2,1 0,-1-1,19-4,-24 4,0-1,-1 0,1-1,-1 1,0-2,0 1,0-1,-1 0,1 0,-1 0,0-1,-1 0,0-1,9-12,-3 1,-2 0,0-1,-1 0,-1 0,0-1,-2 1,0-2,-2 1,0 0,-1-1,-1 1,-1-1,0 1,-2-1,-5-26,-1 11,-1 1,-2 0,-1 1,-1 1,-2 0,-2 0,-37-54,27 49,-2 1,-1 2,-2 1,-1 1,-55-41,79 68,1 0,-1 1,-1-1,1 2,0-1,-16-3,22 7,0 0,-1 0,1 1,-1-1,1 1,-1 0,1 0,-1 1,1-1,-1 1,1-1,0 1,-1 0,1 0,0 1,-1-1,1 1,0-1,0 1,0 0,1 0,-6 5,1 1,0 0,0 1,0 0,1 0,1 0,-1 1,-3 12,-4 10,-7 35,0 19,3 2,4 0,4 1,4 0,13 174,-2-201,24 100,-22-133,1 0,1 0,1-1,2-1,22 37,-30-57,-1-1,1 1,1-1,-1-1,1 1,0-1,1 0,11 7,-17-11,1 0,0 0,0 0,0 0,0 0,0 0,0-1,0 1,0-1,0 0,0 1,0-1,0 0,0 0,0 0,0-1,0 1,0 0,0-1,0 1,0-1,0 0,0 0,0 0,-1 0,1 0,0 0,-1 0,1 0,0-1,-1 1,1-1,-1 1,0-1,0 1,0-1,1 0,0-2,-1 1,1 1,0-1,-1 0,0-1,1 1,-1 0,0 0,-1 0,1-1,-1 1,1 0,-1-1,0 1,0 0,-1-1,1 1,-1 0,1-1,-1 1,0 0,0 0,0-1,-1 1,1 0,-1 1,0-1,0 0,0 0,0 1,0-1,-1 1,1-1,-5-2,-1-1,-1 0,1 1,-1 0,0 1,0 0,-1 0,1 1,-1 0,0 1,-13-2,3 3,1 1,0 0,0 1,0 2,0 0,1 0,-1 2,1 0,0 2,0 0,1 0,0 2,0 0,-19 14,23-13,0 0,0 0,0 1,2 1,-1 0,2 0,-1 1,2 1,0-1,0 2,1-1,1 1,1 0,0 1,1 0,-6 28,10-34,1 0,0 0,0-1,1 1,1 0,-1 0,2 0,-1-1,1 1,1-1,0 0,0 0,0 0,1-1,1 1,-1-1,2 0,10 11,-5-7,1 0,0-1,1 0,1-1,-1 0,1-2,1 1,-1-2,31 10,-39-15,-1-1,1 1,0-1,-1-1,1 0,0 1,-1-2,1 1,0-1,-1 0,1-1,7-2,-4 0,0 0,0-1,-1 0,1 0,-1-1,16-14,-7 3,-1-1,-1-1,-1 0,0-1,-2 0,12-23,-10 13,-1 0,-2-1,-1 0,-2-1,11-59,-17 66,-1 1,-1-1,0 0,-2 0,-1 0,-1 1,-2-1,-9-33,9 45,0-1,-1 1,-1 0,0 1,-1-1,0 1,-14-15,15 20,0-1,-1 1,0 0,0 1,0 0,-1 0,0 0,0 1,-1 1,-18-7,22 10,0 0,0 1,0-1,0 1,0 1,0-1,0 1,0 0,1 0,-1 1,0-1,1 1,-1 1,1-1,-1 1,1 0,0 0,-6 5,-5 4,1 1,0 1,0 0,-13 18,6-3,0 1,2 1,1 1,2 1,1 0,2 1,-16 55,18-43,2 0,2 1,2 0,3 0,2 71,1-110,1 1,0-1,0 1,1-1,0 0,1 0,0 1,4 8,-5-13,0-1,0 0,1 0,-1 0,1 0,-1 0,1-1,0 1,0-1,0 0,1 1,-1-1,0-1,1 1,-1 0,1-1,0 0,-1 0,1 0,6 0,-1 0,1-1,-1 0,0 0,1-1,-1-1,1 0,-1 0,0-1,0 0,0 0,13-8,9-6,50-38,-15 4,-2-3,-3-3,-2-2,-3-3,84-120,-117 149,-2-1,-1 0,-2-2,-1 0,17-55,-30 76,0-1,-2 0,1 0,-2 0,0 0,-1 1,-2-18,0 21,0 1,-1 0,0 0,-1 0,0 1,0-1,-1 1,-1 0,0 0,-13-17,3 10,-1 0,-1 1,0 0,-1 2,0 0,-1 1,0 2,-1 0,-1 0,-25-7,0 3,-1 1,0 3,-97-10,73 17,-1 3,-136 15,-142 52,220-32,-207 81,274-88,1 3,2 3,1 2,1 3,-57 49,97-71,1 1,0 1,1 1,1 1,1 0,-19 31,28-38,0 0,0-1,2 2,-1-1,2 0,-1 1,2 0,0 0,1 0,0 0,1 0,0 0,4 15,0-10,0 0,2-1,0 0,1 0,1-1,1 0,0 0,1-1,1 0,1-1,0 0,1-1,0 0,21 16,5 1,0-3,2-1,2-2,63 27,-37-22,0-3,2-3,118 24,-144-40,-1-2,1-2,0-2,0-2,0-2,0-2,56-12,-82 12,1-2,-1 0,0-2,-1 0,0 0,0-2,-1 0,0-2,-1 1,-1-2,1 0,17-20,-25 23,0 0,0-1,-1 0,-1 0,0-1,0 1,-1-1,-1-1,0 1,0 0,-1-1,-1 0,0 0,-1 0,0 0,-1 0,0 0,-1 0,-1 0,-3-13,-1 7,0 0,-1 1,-1-1,-1 1,0 1,-2 0,0 0,-1 1,0 0,-1 1,-1 1,-21-18,4 7,-1 1,-1 2,-1 1,0 1,-53-20,34 20,0 2,-62-12,15 11,-2 5,-171-2,-211 45,280-1,-234 64,273-45,-284 120,218-54,194-91,0 1,2 2,-57 53,81-67,0 0,1 1,0 1,1-1,0 1,1 1,1 0,0 0,0 0,-6 26,10-29,1 0,1 0,0 1,0-1,1 0,0 1,1-1,0 1,1-1,1 0,0 0,0 0,1 0,0-1,7 13,-2-8,1 0,1 0,0-1,1 0,0-1,1 0,1-1,0-1,25 16,0-3,2-2,74 28,-33-21,1-4,1-3,1-4,1-4,0-3,1-5,-1-3,95-9,-130 1,0-1,0-3,0-3,-2-1,1-3,-2-2,86-44,-108 48,-1-2,-1-1,0 0,-2-2,0-1,-1 0,0-2,-2 0,-1-2,-1 0,-1 0,-1-2,-1 0,-1 0,9-30,-15 35,-1 0,-1 0,-1 0,-1-1,-1 1,-1-1,-1 0,0 1,-2-1,-1 0,0 1,-9-27,7 31,-2 1,0 0,0 0,-2 1,0 0,0 0,-2 1,0 1,0-1,-1 2,-1 0,0 0,0 1,-1 1,-31-17,7 8,-1 2,-1 2,0 2,0 1,-76-11,13 10,-129 2,77 13,1 7,0 7,-177 41,87 9,204-51,1 1,1 2,-66 42,91-51,0 0,1 1,0 1,1 0,0 0,0 1,1 0,-8 15,14-21,1 0,0 0,0 0,1 0,-1 1,1-1,1 1,-1-1,1 1,1 0,-1-1,1 1,0 0,0 0,1-1,0 1,0-1,1 1,0 0,0-1,4 9,-1-6,0-1,0 1,1-1,0-1,0 1,1-1,10 9,7 3,32 20,-7-10,55 26,116 33,-48-33,2-9,2-6,1-9,351 16,-421-45,211-25,-272 16,0-2,0-2,-1-2,0-2,-1-2,78-43,-102 48,-2-1,0-1,-1 0,0-1,-1-1,-1-1,0 0,-1-1,-1 0,15-31,-20 35,-1-1,-1 0,0-1,-1 1,-1-1,-1 0,0-1,-1 1,0 0,-2-1,0 1,0 0,-2-1,0 1,-4-16,3 21,-1 0,0 1,0-1,-1 1,0 0,-1 1,0-1,-1 1,0 0,0 1,-9-9,5 8,-1-1,0 2,-1 0,1 0,-2 1,1 0,-22-6,2 4,1 1,-1 2,0 1,-1 1,1 2,-60 5,30 3,1 3,0 2,1 4,0 2,1 2,1 3,1 3,2 2,0 3,2 2,-89 70,116-80,2 1,0 2,2 1,-33 45,46-57,2 1,-1-1,2 1,0 1,1-1,1 1,0 0,1 0,1 1,0-1,0 26,4-20,1 0,1 0,1-1,0 0,2 0,1 0,0 0,2-1,0 0,1-1,1 0,1-1,0 0,2-1,0 0,22 20,2-5,1-1,1-3,2-1,50 24,-5-10,107 35,-151-60,-1-3,2-1,0-3,0-1,55 2,-92-9,1-1,-1 0,0-1,1 0,-1 0,0 0,0-1,0 0,0-1,0 0,8-4,-11 4,0 0,0 0,-1 0,1 0,-1-1,0 0,0 1,0-1,0-1,-1 1,1 0,-1-1,0 1,0-1,-1 1,0-1,2-7,-1-1,0 0,-1 0,-1 0,0 0,0 0,-1 0,-1 0,-5-20,1 15,0 0,-1 1,0 0,-2 0,-14-22,2 10,-2 0,-1 1,-1 2,-1 0,-50-37,18 23,-2 2,-1 3,-1 3,-2 2,-1 4,-96-27,57 27,-1 4,0 5,-168-6,171 21,0 4,-140 23,187-16,0 2,1 3,1 3,1 1,0 3,-50 28,87-40,-1 1,1 0,1 0,0 2,1 0,0 0,-20 26,28-31,0 1,0 0,1 0,0 1,0-1,0 1,2 0,-1 0,1 0,0 0,1 0,0 1,0-1,1 0,0 1,3 14,-1-11,1 0,0 0,1 0,0-1,1 1,0-1,1 0,1 0,0-1,0 0,1 0,1-1,0 1,0-2,1 0,0 0,0-1,1 0,0 0,1-1,15 7,18 4,0-2,1-2,1-2,0-2,94 7,-131-16,-1-1,1 0,-1-1,1 0,-1 0,1-1,-1 0,0-1,0 0,13-6,-13 3,-1 1,1-2,-1 1,0-1,-1 0,1 0,-1-1,-1 0,9-13,1-4,-1-1,-2 0,0-1,-2 0,0-1,-2 0,-2-1,0 0,-2 0,-1 0,0-36,-4 42,-1-1,-1 1,-1 0,-1 0,-1 0,0 0,-2 1,-1 0,-1 0,-1 1,-1 0,0 1,-2 0,-28-35,17 30,-2 1,0 1,-2 2,0 0,-1 2,-1 1,-1 2,-1 0,-36-11,-3 3,-1 3,-1 3,-89-10,-105 5,231 22,0 3,0 0,0 3,0 0,-46 15,76-18,1 0,0 0,0 0,-1 0,1 1,1 0,-1 0,0 1,1-1,0 1,-1 0,2 0,-7 9,7-9,1 0,0 0,0 0,1 1,-1-1,1 1,0-1,0 1,1 0,-1-1,1 1,0 0,0-1,1 1,-1 0,1-1,2 6,2 8,1 1,1-1,1-1,0 0,2 0,0 0,0-1,18 19,-2-5,2-2,0-1,40 29,-16-20,1-2,1-2,2-2,1-4,1-1,67 18,-47-22,0-3,2-3,0-4,110 2,-137-13,1-3,0-1,-1-3,0-3,-1-1,0-3,0-3,65-30,-84 31,-1-1,-1-2,-1-2,0 0,39-40,-48 41,-2-2,0 0,-2-1,0-1,-2-1,-1 0,18-42,-26 50,1-1,-2 0,-1 0,0 0,-1-1,-1 1,-1-1,0 0,-4-32,1 40,0-1,0 1,-2-1,1 1,-1 0,-1 1,0-1,-1 1,0 0,0 0,-1 0,0 1,-1 0,0 1,0 0,-16-13,6 9,-1 1,0 0,-1 2,1 0,-2 1,-35-9,1 5,-81-8,45 13,-1 4,1 3,-1 5,1 4,0 4,1 3,1 5,0 3,2 5,1 3,-111 58,150-64,1 1,-78 63,106-75,0 1,1 1,1 1,1 0,1 0,0 2,1 0,-19 41,29-54,1 0,0-1,0 2,0-1,0 0,1 0,1 0,-1 1,1-1,0 0,1 1,0-1,2 11,0-11,-1 0,2 0,-1 0,1 0,0-1,0 1,0-1,1 0,0-1,1 1,-1-1,1 0,7 5,7 3,0-1,1-1,1 0,0-2,0-1,1 0,24 4,28 5,1-4,1-3,-1-3,134-5,-108-9,0-4,-2-4,111-33,-140 28,130-56,-173 63,-1-1,0-2,-1 0,-1-2,0-1,-2 0,25-27,-41 38,-1 0,1 0,-1-1,-1 1,0-1,0-1,0 1,-2-1,1 0,-1 0,2-10,-4 12,0 0,-1 1,0-1,0 1,-1-1,0 1,0-1,-1 1,0-1,0 1,0 0,-1 0,0 0,-1 0,-6-9,0 3,-1 1,0 0,0 0,-1 1,-1 1,0 0,0 1,-1 0,0 1,0 1,-1 0,-16-5,-18-4,-1 2,-78-13,25 13,0 3,-109 4,130 9,0 4,1 3,-90 23,140-25,1 2,1 0,0 2,0 2,-27 15,47-22,-1 1,1 0,0 0,0 1,1 0,0 0,-8 12,11-13,1 0,0 0,1 0,-1 0,1 1,1-1,0 1,0 0,0-1,1 1,-1 13,3-5,0 0,1 0,1 0,0 0,1-1,1 1,0-1,1 0,1-1,0 1,18 25,1-4,2-1,1-1,36 33,-7-14,2-4,2-1,2-4,2-3,1-2,2-3,2-4,1-2,2-4,109 24,-148-43,0-1,1-2,-1-2,1-1,-1-2,68-10,-80 6,0-1,0-1,0 0,-1-2,-1-1,1-1,-2 0,1-2,-2 0,0-1,22-22,-12 8,-2-2,-1-1,-1-1,-2-1,-1-1,18-41,-26 46,-2 0,-1-1,-1 0,-1 0,-2-1,-1-1,-2 1,1-43,-5 63,0-1,-1 1,0 0,-1 0,0 0,-5-12,6 19,-1 0,0 0,0 0,-1 0,1 0,-1 0,0 0,0 1,0 0,0-1,-1 1,1 0,-1 1,0-1,1 1,-1-1,-6-1,1 0,-1 1,0 1,1-1,-1 2,0-1,0 1,0 1,0 0,0 0,0 1,0 0,0 1,1 0,-1 1,0 0,1 0,0 1,0 0,-11 7,7-3,1 0,0 0,0 2,1-1,0 1,1 1,0 0,0 1,2-1,-1 2,1-1,-9 22,10-18,1 1,0 0,2 0,0 1,0-1,0 20,4-27,0 0,0 0,1 0,0 0,1-1,0 1,0 0,1-1,0 1,1-1,0 0,1 0,5 8,2-1,1 0,1-1,0-1,1 0,0-1,1 0,0-1,28 14,2-2,0-2,61 18,-31-15,2-3,0-3,149 14,-179-29,0-3,0-1,0-3,0-2,0-2,-1-2,81-27,-111 30,0-1,-1-1,1-1,-2-1,1 0,-1 0,23-23,-34 28,1 0,-1 0,0 0,0-1,0 0,-1 0,0 0,0 0,-1 0,4-11,-6 12,1 0,-1 0,1 0,-1 0,-1 0,1 0,-1 0,0 0,0 1,0-1,-1 0,1 0,-1 1,0-1,-1 1,-3-5,-1-2,-2 1,1 0,-1 0,-1 1,0 1,0-1,0 2,-1-1,-1 2,1-1,-25-9,12 7,0 2,-1 0,0 1,0 1,-30-1,27 4,0 2,0 0,0 2,0 1,0 2,1 0,-1 2,1 1,1 1,0 1,-35 20,54-26,0 0,1 1,0 0,0 0,0 0,1 1,0 0,0 0,0 0,1 0,0 1,-5 10,5-7,0 1,1 0,0 0,1 0,0 0,1 0,-1 22,3-12,1 0,1 0,1 0,1-1,0 1,2-1,0-1,19 36,-10-27,2-1,1 0,1-2,1 0,1-1,1-1,52 39,-52-46,0-1,1-1,1-1,1-1,-1-1,2-1,-1-2,1 0,46 5,-63-12,-1 0,1 0,-1-2,1 1,0-1,-1 0,1-1,-1 0,0-1,16-6,-18 5,-1 1,1-1,-1 0,0-1,-1 1,1-1,-1 0,0-1,0 1,-1-1,1 0,-1 0,-1 0,7-13,-4 2,-1 0,0 1,-1-2,-1 1,-1 0,0-1,-1 1,-1-1,-1 1,0 0,-2-1,0 1,0 0,-10-26,4 19,0 0,-2 1,0 0,-2 0,0 1,-2 1,0 1,-2 0,-23-23,16 21,-44-31,57 46,-1-1,0 2,0-1,0 2,-1-1,-19-4,28 10,-1-1,1 1,0-1,0 1,0 1,0-1,0 1,0-1,0 1,0 0,0 0,0 1,0-1,0 1,1 0,-1 0,-3 3,4-3,1 0,0 0,0 0,0 0,0 0,0 0,1 0,-1 0,1 1,-1-1,1 1,0-1,0 1,0-1,0 1,1 0,-1-1,1 1,-1 0,1 0,0 0,0-1,0 1,1 0,-1 0,1 3,1-3,-1 0,1 0,-1 0,1 0,0 0,0-1,0 1,0-1,1 1,-1-1,1 0,0 0,-1 0,1 0,0 0,0-1,0 1,0-1,0 0,1 0,3 1,5 1,0-1,0 0,0 0,22-1,-18-2,0-1,1-1,-1 0,-1-1,1-1,-1 0,1-2,-2 1,1-2,-1 0,0 0,0-1,-1-1,-1-1,1 1,11-16,0-1,-1-1,-1-1,-2-1,-1-1,-2-1,18-43,-17 29,-1-2,-3 0,-2 0,-2-1,-2-1,-2 1,-3-1,-1 0,-3-1,-2 1,-2 1,-2-1,-3 1,-27-82,31 113,-1 0,-1 0,-1 1,0 1,-1-1,-14-16,16 24,-1-1,0 1,0 1,-1 0,0 0,-1 1,0 0,0 1,-21-9,9 6,1 2,-1 1,0 1,-1 1,1 1,-27-1,37 4,0 0,0 1,0 0,0 1,1 1,-1 0,0 0,1 1,0 1,0 0,0 1,-17 11,23-12,0 0,0 0,1 0,-1 1,1 0,1 0,-1 0,1 1,0 0,1-1,-1 1,2 0,-1 1,1-1,0 0,0 1,1 0,0-1,0 1,0 0,1-1,2 14,0-9,0-1,1 0,0 1,0-1,2 0,-1 0,1-1,1 1,0-1,0-1,1 1,0-1,1 0,13 12,-2-5,1-2,0 0,1-1,0-1,1-1,0-1,38 12,-6-7,-1-3,75 8,-60-14,0-3,-1-3,1-2,-1-4,1-3,-2-2,1-4,-2-2,0-3,-2-3,0-3,-1-3,87-55,-111 60,-2-2,-1-2,50-51,-71 65,-1-1,-1-1,0 0,-1 0,-1-1,0 0,-1-1,-1 0,-1-1,7-27,-12 37,0 0,-1 0,-1 0,1-1,-1 1,-1 0,0 0,0 0,-1 0,0 0,0 0,-1 0,0 1,-9-17,5 14,0 1,-1-1,0 2,-1-1,0 1,0 1,-1-1,0 2,-20-12,0 3,-1 2,0 1,-1 1,-1 2,0 1,0 2,-40-4,14 7,0 2,0 2,0 4,1 2,-111 25,128-20,0 1,1 2,0 2,1 2,-60 37,73-38,0 2,1 0,2 2,0 0,1 2,1 0,1 2,-22 35,33-46,1 0,1 1,0 0,1 1,1 0,0 0,1 0,1 0,-2 20,4-27,1 0,1 0,-1 0,1 0,1 0,0 0,0 0,1 0,0 0,0-1,1 0,0 1,1-1,0-1,0 1,0-1,1 0,8 8,4 0,1 0,0-1,1-1,1-1,0 0,0-2,1-1,0 0,33 7,-1-3,0-3,111 7,-99-15,1-3,-1-2,0-4,77-16,-106 14,1-1,-1-2,-1-2,0-1,-1-2,-1-1,-1-2,46-35,-62 41,-1 0,0-2,-1 0,-1-1,-1 0,0-1,-2-1,0 0,17-40,-24 48,0-1,-2 1,1-1,-1 0,-1 0,0 0,0 0,-3-19,1 22,-1 0,0-1,-1 1,0 0,0 0,-1 0,0 1,0-1,-1 1,-1 0,-10-13,6 11,0 1,0 0,-1 0,0 1,0 1,-1 0,0 0,-1 1,1 1,-1 0,0 0,0 2,-1-1,-19-1,1 2,1 1,-1 1,1 2,-1 2,-41 7,14 3,0 3,1 2,1 2,1 3,1 2,1 3,-67 46,60-31,3 2,1 3,2 2,3 3,-75 97,101-114,1 0,2 2,1 1,2 1,2 0,2 1,-14 53,25-70,1 1,0-1,2 1,1-1,1 1,3 26,0-32,0 0,1-1,2 1,-1-1,2 0,0-1,2 0,15 26,-12-26,0-2,1 0,0 0,1-1,1-1,0 0,1-1,0-1,34 18,-10-10,0-3,2 0,57 12,-86-25,0 0,0-1,0 0,1-1,-1 0,1-1,-1-1,1 0,-1-1,0-1,0 0,0 0,0-1,0-1,-1 0,1-1,-1 0,-1-1,0 0,0-1,17-15,-15 10,-1 0,-1 0,0-1,15-25,-21 30,0 0,-1-1,0 0,0 0,-1 0,0 0,-1 0,0 0,0-12,-2 19,0 0,0 0,0-1,0 1,-1 0,1 0,-1 0,0 0,0 0,0 0,0 0,-1 0,1 1,-1-1,0 0,0 1,0-1,0 1,-3-3,2 3,0 0,0 0,0 0,-1 0,1 1,-1 0,0-1,1 1,-1 0,0 1,1-1,-1 1,0 0,0 0,-7 0,-11 3,-1 1,1 1,1 1,-1 0,1 2,-33 16,24-8,1 1,1 2,-47 39,55-40,1 1,2 1,-1 0,2 1,1 1,1 1,1 0,1 1,0 0,2 0,1 1,2 1,-9 40,15-54,0-1,1 0,0 1,1-1,0 0,0 1,1-1,1 0,0 0,0 0,7 12,-3-10,0 0,1-1,0 0,1 0,0-1,1 0,0-1,12 10,-3-5,2-1,0 0,1-2,0 0,0-1,1-2,1 0,0-2,47 9,-50-13,-1-1,1-2,-1 0,1-1,0-1,-1-1,0-1,0 0,0-2,0 0,-1-1,0-1,0-1,-1-1,-1 0,30-23,-28 17,0 0,0-2,-2 0,0-1,-2 0,0-2,-1 0,-1 0,0-1,-2-1,-1 0,-1-1,8-32,-13 40,-1 0,-1-1,0 1,-1-1,-1 0,-1 1,0-1,-2 0,-4-21,4 27,-1 1,1-1,-1 1,-1 0,0 1,0-1,-1 1,-1 0,1 1,-1-1,0 1,-1 1,0-1,0 1,-13-7,9 6,-1 1,1 1,-2 0,1 1,-1 1,1 0,-1 0,0 2,-1-1,1 2,0 0,-1 1,1 0,-21 4,13 0,0 1,0 1,1 1,0 1,1 1,0 1,0 0,-28 21,26-16,0 2,2 0,0 1,1 1,0 1,-30 44,42-54,1 1,0 0,1 0,0 1,1-1,0 1,0 0,1 0,1 0,0 1,1-1,0 1,1-1,1 0,0 1,0-1,4 16,-2-19,0 0,0-1,0 0,1 0,0 0,1 0,0-1,0 1,0-1,1-1,0 1,0-1,10 7,-5-5,0 0,1-2,0 1,0-2,0 1,1-2,0 0,14 3,2-2,0-1,-1-2,1-1,0-1,0-1,0-2,45-10,-34 3,0-2,-1-2,0-2,-1-1,-1-2,-1-1,-1-2,-1-2,0 0,-2-3,37-39,-47 42,-2-1,0 0,-1-2,-2 0,-1-2,18-42,-24 47,-2-2,-1 1,0-1,-2 0,-1 0,-2 0,0 0,-3-40,-1 44,-1 0,-1 0,-1 0,-1 0,-1 1,0-1,-2 2,-1-1,0 1,-21-29,15 28,-1 0,-1 1,0 1,-2 1,0 0,-1 2,-1 0,-36-19,23 17,0 1,-1 2,0 2,-2 1,1 2,-1 1,-1 2,1 2,-61 0,93 5,0 0,0 0,1 1,-1 0,0 0,1 0,-7 3,11-3,-1-1,1 1,0 0,0 0,0 0,0-1,0 1,0 0,0 0,0 1,0-1,0 0,0 0,1 0,-1 0,0 1,1-1,-1 0,1 1,0-1,-1 0,1 1,0-1,0 0,0 1,0-1,0 1,0-1,0 0,0 1,1-1,-1 0,0 1,2 1,0 2,0 1,1-1,-1 0,1 0,0 0,1-1,-1 1,1-1,0 0,0 0,1 0,-1 0,1-1,0 0,0 0,0 0,0 0,0-1,6 2,5 2,0-1,1-1,-1-1,1 0,23 1,-19-3,-1-2,1 0,-1-1,0-1,0-1,0-1,-1 0,1-2,-1 0,0-1,-1-1,0-1,-1-1,17-12,-22 14,-1 0,-1-1,0 0,0-1,-1 0,0 0,-1-1,0 0,-1-1,-1 0,0 0,0 0,-1-1,-1 1,0-1,-1 0,-1 0,0-1,-1 1,-1-26,-1 23,-1 0,-1 1,-1-1,0 1,-1-1,-1 1,-1 1,-10-20,5 15,0 1,-2 0,0 1,-1 1,-27-25,13 19,0 0,-1 2,-1 2,-1 1,-1 1,0 1,-53-16,64 26,-1 0,0 1,-1 2,1 0,0 2,-1 0,0 2,1 0,-24 5,30-3,0 1,0 1,1 0,-1 1,1 1,1 0,-1 1,1 1,1 1,-1 0,2 0,-21 21,30-26,-1 0,1 0,0 0,0 1,1-1,0 1,0 0,0 0,-2 9,4-11,0 0,1 1,-1-1,1 0,0 1,0-1,0 1,1-1,-1 0,1 1,0-1,1 0,-1 1,1-1,2 4,1 1,1 0,0 0,0-1,1 1,0-2,0 1,1-1,0 0,1 0,17 10,0-3,0-1,50 16,-30-15,1-2,1-2,0-2,0-2,0-2,1-2,-1-3,1-1,-1-3,0-2,0-1,-1-3,0-2,-1-2,0-2,-1-2,68-41,-90 46,-1-2,0-1,-2 0,0-2,-1 0,0-1,-2-1,15-23,-24 33,-1-1,0-1,-1 1,-1-1,0 0,-1 0,0 0,-1-1,0 1,-1-1,-1 0,0 0,-1 0,0 1,-1-1,-1 0,-4-18,0 14,0 1,-2 0,0 0,0 1,-2 0,0 0,-1 1,0 1,-2 0,1 0,-28-21,2 5,0 3,-2 1,-61-29,22 15,-1 3,-112-34,184 69,3 0,-1 0,0 0,0 1,0-1,0 2,0-1,0 1,0 0,-1 0,1 0,-7 2,12-1,0-1,0 1,0-1,0 1,0 0,0 0,0 0,0 0,1 0,-1 0,0 0,1 0,-1 0,0 0,1 0,-1 0,1 0,-1 0,1 1,0-1,0 0,-1 0,1 0,0 1,0-1,0 0,0 0,1 1,-1-1,0 0,0 0,1 0,-1 1,1-1,0 2,2 6,1 0,0 0,7 11,-9-18,14 23,1-1,1-1,1 0,1-2,1 0,1-1,0-2,2 0,0-1,1-2,36 18,-56-31,0 0,0 0,0 0,1-1,-1 1,0-1,1-1,-1 1,1-1,-1 0,7-1,-10 1,1-1,0 0,0 0,-1 0,1 0,0 0,-1-1,0 1,1-1,-1 1,0-1,1 0,-1 0,0 0,-1-1,1 1,0 0,0-1,-1 1,0-1,1 1,1-6,2-8,0-1,-1 0,-1-1,0 1,-1-1,-1 1,-2-23,-3-13,-10-58,-6 4,-5 1,-4 1,-46-106,72 202,-5-12,-2 1,-20-35,28 51,-1 0,1 1,-1-1,0 1,0-1,0 1,0 0,0 0,-1 1,0-1,1 1,-1 0,0 0,0 0,0 0,0 1,0-1,-1 1,1 0,-9-1,9 3,0-1,-1 1,1 0,0 0,0 0,-1 1,1 0,0-1,0 1,1 1,-1-1,0 0,-3 4,-5 5,0 0,-12 15,14-15,-28 32,2 2,2 1,-53 94,73-113,1 1,1 1,1 0,2 1,0 0,3 0,0 1,-2 56,8-71,1-1,0 1,1-1,1 0,0 0,1 0,1 0,12 26,-12-31,0-1,1 0,0 0,1-1,-1 0,2 0,-1-1,1 0,0 0,1 0,-1-1,1-1,1 0,10 5,-4-3,1-1,0-1,0-1,1 0,-1-1,1-1,29 0,-22-4,1 0,0-1,-1-2,45-13,-30 4,-1-2,0-2,-1-1,-1-3,0 0,40-35,-42 28,-1-2,-1-1,-3-1,0-2,-2 0,24-43,-38 54,-1 0,-1-2,-2 1,13-45,-19 51,0 0,-1 0,-2-1,1 1,-2-1,-1 1,-3-25,1 29,-1 0,0 1,-1 0,0 0,-2 0,1 0,-1 1,-1 0,-1 1,0 0,0 0,-1 1,0 0,-1 0,-1 2,1-1,-1 1,-16-8,0 1,0 2,-1 1,0 2,-1 0,0 2,-1 2,-54-7,11 7,0 4,1 3,-133 17,91 2,-186 55,237-54,-77 36,111-42,1 2,0 1,1 1,-35 30,57-43,0 0,1 0,0 1,0-1,0 1,1 1,0-1,0 0,0 1,1 0,0 0,1 0,-1 0,1 1,1-1,-1 1,1-1,1 1,-1-1,1 1,0-1,1 1,0-1,0 1,1-1,0 1,0-1,1 0,-1 0,2 0,-1 0,6 8,8 7,0 0,1-1,1-1,0-1,2 0,29 19,-20-17,2-1,0-2,1-1,44 15,-58-25,0-2,0 0,39 4,-50-8,-1 0,1-1,0 0,-1-1,1 0,-1 0,1 0,-1-1,1 0,-1-1,0 1,0-1,8-5,-11 5,-1 0,1-1,-1 1,1-1,-1 1,0-1,-1 0,1-1,0 1,-1 0,0-1,0 1,-1-1,1 0,-1 1,0-1,0 0,-1 0,1 0,-1 0,0-7,-1-2,-1 0,0 1,-1 0,0-1,-1 1,-10-23,1 10,-2 1,0 1,-1 0,-2 1,0 1,-2 1,0 1,-27-21,3 6,-2 2,-1 2,-64-31,46 31,-2 3,-1 3,-1 3,-140-25,145 37,0 4,-1 2,1 3,-1 3,-117 19,138-12,1 3,-1 1,2 2,-59 29,72-29,1 1,0 1,2 2,0 1,1 1,-42 45,59-57,0 2,1-1,0 1,0 0,1 1,1-1,0 1,1 0,0 1,0-1,2 0,-1 1,2 0,-1 24,3-21,0 0,2 0,0 0,0-1,2 1,0-1,0 0,2 0,0-1,0 0,17 23,0-6,3 0,0-1,2-2,1 0,1-3,62 40,-29-27,2-2,127 48,-137-64,0-3,1-2,1-2,0-4,0-1,1-4,66-2,-87-4,0-1,0-3,0 0,-1-3,0-1,-1-2,0-1,-1-2,0-1,-1-2,61-43,-73 43,-1-1,-1 0,-1-2,-1 0,-1-1,0-1,-2 0,-1-1,-1-1,-1 0,-1-1,-1 0,7-30,-12 35,-1 1,-1-2,-1 1,-1 0,-1 0,0-1,-7-36,4 42,-2-1,1 1,-2 0,0 0,-1 1,-1 0,0 0,-1 0,-1 1,-15-18,11 18,-1 0,0 0,-1 2,-1 0,0 1,0 0,-1 2,0 0,-1 1,0 1,0 0,-38-6,13 6,-1 1,-1 2,1 3,-79 7,56 2,1 3,0 4,1 2,0 3,-71 33,39-8,3 4,-138 95,147-83,2 5,4 3,-122 135,149-141,2 2,3 3,2 2,5 2,-41 93,62-118,2 1,3 0,2 2,-14 90,25-118,0 1,2-1,0 0,1 1,2-1,0 0,1 0,1 0,1-1,1 0,1 0,1 0,17 27,-12-27,2 0,0-1,1 0,2-1,36 29,-25-26,1-1,1-2,54 25,-29-21,1-3,1-2,0-2,108 12,-93-20,1-4,-1-3,1-4,123-19,-146 13,0-3,-1-2,0-3,-2-1,0-3,-1-1,61-41,-81 45,-2-2,0-1,-2-1,0-1,38-49,-48 53,-1-1,-1 0,-1-1,0-1,-2 1,0-2,-1 1,7-42,-12 53,-2 0,0 0,0 0,-1 0,0 0,-1 1,0-1,-1 0,0 0,0 0,-2 1,1-1,-1 1,-1 0,1 0,-2 1,0-1,0 1,0 0,-1 1,0 0,-1 0,0 0,0 1,-1 0,0 1,0 0,0 0,-1 1,-17-8,5 6,1 0,-1 2,-1 0,-34-2,-99 4,66 10,1 3,0 5,-165 48,118-17,-220 108,252-100,2 4,-169 129,214-141,3 2,2 3,2 1,2 3,-70 105,99-129,2 0,1 1,1 0,2 2,1-1,2 1,-10 57,17-69,1 0,2 0,0 0,1 0,0 0,2-1,1 1,1-1,1 1,0-1,2-1,0 1,16 26,-12-27,1-1,1 0,1-1,0 0,2-1,0-1,0-1,26 17,-17-15,1-1,1-1,1-2,0-1,50 14,-32-15,1-2,0-2,0-2,0-2,1-2,-1-3,95-15,-91 7,-2-3,1-2,-2-2,0-2,-1-3,-1-1,-2-3,0-1,-2-3,-1-1,-1-2,-2-2,-1-1,-2-3,-2 0,-1-2,-3-2,50-90,-64 103,-2-2,-1 0,-2 0,-1-1,-1 0,-2-1,-1 0,-2 0,0-45,-4 59,-1 0,-2 0,0 1,-1-1,0 1,-2 0,0 0,-1 0,-1 1,-1 0,-1 1,0 0,-1 0,-1 1,0 0,-2 1,-20-19,9 14,-2 0,1 2,-2 1,-1 1,0 1,0 2,-33-10,-6 2,-1 4,-91-12,19 13,-2 6,1 6,-247 24,255-3,1 6,2 6,0 6,-133 54,66-2,166-70,0 1,2 1,-50 43,73-56,-1 1,1 0,1 1,-1 0,2 0,-1 0,1 0,0 1,0 0,1 0,-5 17,7-18,1 0,0 0,0 1,1-1,0 0,0 1,1-1,0 0,1 1,0-1,0 0,0 0,1 0,5 9,6 10,1-1,2-1,0 0,2-1,1-1,0-1,25 21,7 0,1-2,62 36,-65-46,2-3,97 39,-128-59,0-1,1-1,0 0,0-2,1-1,-1-1,1 0,-1-2,1-1,31-4,-44 2,1 1,-1-1,0-1,0 0,-1 0,1-1,-1 0,0-1,0 0,-1 0,0-1,0 0,7-9,-6 6,-1-1,-1 0,0 0,0-1,-1 0,-1 0,0-1,0 1,4-21,-6 14,0 1,-1-1,-1 1,0-1,-2 0,0 1,-1-1,-1 1,-1-1,0 1,-1 0,-2 1,1-1,-19-32,12 31,-1 1,-1 0,0 1,-1 1,-1 0,-1 1,0 1,0 1,-40-21,11 10,-1 3,-1 2,-65-16,20 12,-1 4,0 5,-1 3,-1 5,-97 6,151 2,1 1,-1 2,1 1,-81 25,115-28,0 0,1 1,-1-1,1 1,-1 1,1 0,-6 5,11-8,0 0,0 0,0 0,0 0,0 1,1-1,-1 0,1 1,0-1,0 1,0 0,0-1,0 1,0 0,1-1,-1 1,1 0,0 0,0 0,0 0,0-1,0 1,2 4,1 4,0 0,1-1,1 1,0-1,0 0,1 0,12 16,0-4,1-1,23 20,-9-13,2 0,1-2,1-2,1-1,0-2,2-2,1-1,0-3,1-1,0-2,57 9,-83-19,-1 0,0-2,0 1,1-2,-1 0,0-1,22-5,-31 5,1 0,-1 0,0 0,0-1,-1 0,1 0,-1-1,1 1,-1-1,0-1,-1 1,1 0,-1-1,1 0,-2 0,1-1,0 1,-1-1,0 1,3-9,-3 5,-1 0,0-1,0 1,-1-1,0 0,-1 1,0-1,0 0,-1 1,0-1,-1 1,0-1,0 1,-1 0,0-1,-1 2,0-1,-1 0,-5-8,-2 0,0 0,-1 0,0 2,-2-1,0 2,-1 0,-32-22,18 17,0 2,-2 1,0 2,-1 1,-57-15,43 17,-1 3,0 1,-77-1,94 9,-60 7,81-7,0 1,1 0,-1 1,0 0,1 1,0 0,0 0,0 1,0 0,-8 7,15-10,0 0,0 0,0 0,0 1,0-1,0 1,1-1,-1 1,1 0,0-1,-1 1,1 0,1 0,-1 0,0 0,0 4,1-2,0 0,1 0,-1 0,1 0,0 0,0 0,1 0,-1-1,4 7,1 0,0 1,2-1,-1 0,1 0,1-1,14 14,-11-13,-4-2,1 0,1-1,-1-1,1 1,20 9,-28-16,1 0,0 0,-1 0,1 0,0-1,0 1,-1-1,1 0,0 1,0-1,0-1,0 1,-1 0,1-1,0 0,0 1,-1-1,1 0,-1 0,1-1,0 1,-1 0,0-1,1 0,-1 1,0-1,0 0,0 0,0 0,3-5,1-1,0-1,-1 0,0 0,0 0,-1-1,0 0,-1 1,0-1,0-1,-1 1,0 0,-1-1,-1 1,1 0,-2-1,1 1,-1-1,-1 1,0 0,-5-17,3 13,-1 1,-1 0,0 0,0 0,-1 1,-1 0,0 0,-1 1,0 0,0 0,-1 1,-1 0,0 1,-22-15,11 13,-1 0,0 1,0 2,-1 0,0 1,-1 2,1 0,-39-1,35 5,-1 0,0 3,0 0,1 2,0 0,0 3,-33 10,55-15,-1 1,0 0,1 0,0 1,-1-1,2 1,-12 10,15-13,1 1,-1 0,1 0,-1 0,1-1,0 1,0 1,0-1,0 0,0 0,0 0,1 0,-1 1,1-1,-1 0,1 1,0-1,0 0,0 1,0-1,1 0,-1 1,0-1,1 0,0 0,0 1,-1-1,1 0,2 2,1 3,0-1,1 1,0-1,0 0,1 0,0-1,0 0,0 0,0 0,1-1,0 0,0 0,9 3,8 3,1 0,46 9,-35-11,1-2,1-2,-1-1,1-1,52-6,-64 1,0-1,0-1,0-1,0-2,-1 0,0-2,-1-1,35-20,-44 21,-1-1,1 0,-2-1,0 0,0-1,-1-1,15-22,-21 28,-2 1,1 0,-1-1,0 0,-1 0,0 0,0-1,-1 1,0-1,0 1,-1-1,0 0,-1 1,0-1,0 0,-1 0,-2-12,-1 10,0 0,-1 0,0 0,-1 1,0-1,-1 1,0 1,0-1,-1 1,0 1,-18-15,4 6,0 1,-2 1,-49-24,33 22,0 2,-1 1,-1 2,-76-12,86 20,1 2,0 1,0 1,-1 1,1 2,0 1,-41 11,67-13,0-1,1 1,-1 0,1 0,-1 0,1 0,-1 1,1 0,0 0,0 0,1 0,-1 1,1 0,-1-1,1 1,0 0,1 1,-3 3,3-3,0 0,0 0,1 0,0 1,0-1,1 0,-1 0,1 0,0 1,1-1,-1 0,1 0,0 0,0 1,1-1,0 0,2 5,0-1,1 0,0-1,1 1,0-1,1 0,-1-1,1 0,1 0,-1 0,1-1,1 0,10 6,4 1,0-1,1-1,40 12,-42-16,0-1,1-1,-1-1,1-1,0-1,34-1,-47-2,0 0,-1 0,1-1,-1 0,1 0,-1-1,0-1,0 0,0 0,-1 0,1-1,-1 0,0-1,0 0,-1 0,0-1,12-14,-15 15,0 1,0-1,-1-1,0 1,0 0,0-1,-1 0,0 1,0-1,-1 0,2-14,-3 11,-1-1,1 1,-2 0,1 0,-1 0,-1 0,-6-16,3 10,-2 1,0 1,0-1,-2 1,1 1,-2 0,0 0,0 1,-27-21,25 23,-1 2,-1-1,0 2,0 0,0 1,-1 0,0 1,0 1,0 1,0 0,-1 1,1 1,-32 1,39 1,0 0,1 1,-1 0,1 0,0 1,0 0,0 1,0-1,0 1,0 1,1 0,0 0,0 0,1 1,-12 11,11-7,-1 0,1 0,1 0,0 1,0-1,1 1,0 1,1-1,0 1,-3 20,4-16,1 0,0 0,1 1,1-1,1 0,0 0,8 32,-8-42,1 0,0 0,0-1,1 1,0-1,0 1,0-1,0 0,1 0,0 0,0-1,1 0,-1 1,1-1,0-1,0 1,0-1,0 0,0 0,1 0,0-1,-1 0,1 0,9 2,-8-3,1 0,0 0,-1 0,1-1,0 0,0 0,-1-1,1 0,0-1,-1 0,1 0,-1 0,9-5,-6 2,-1 0,0-1,0 0,0-1,-1 0,1-1,-2 1,11-14,-3-1,-1 1,-1-2,0 0,-2 0,-1-1,-1-1,7-28,-8 19,-1 1,-2-1,-1-1,-2 1,-4-67,0 80,-1 1,-1 0,0 0,-2 0,0 0,-1 1,-1 0,-1 1,0-1,-2 2,-15-22,21 33,-1 0,0 0,0 0,0 1,-1 0,0 0,0 1,0-1,-1 2,1-1,-1 1,0 0,0 0,0 1,0 0,0 1,0 0,-1 0,1 1,0 0,-1 0,1 1,-9 2,5-1,1 1,0 0,0 1,0 0,0 1,1 0,0 0,0 1,0 1,1 0,0 0,0 1,0 0,1 0,1 1,-8 10,4-1,1 0,1 1,0 0,2 1,0 0,-8 37,10-25,0 1,2-1,3 57,0-78,1-1,1 1,0-1,0 0,1 0,0 0,1 0,0-1,1 1,0-1,0 0,1 0,0-1,0 1,1-1,13 11,-13-13,1 0,-1-1,1 0,1-1,-1 0,1 0,-1 0,1-1,0-1,0 1,1-2,-1 1,0-1,1 0,-1-1,0 0,1-1,17-3,-9-1,-1 0,1-1,-1-1,-1 0,1-2,-1 0,-1 0,0-1,0-1,-1-1,0 0,-1-1,22-28,-9 6,-1-1,-2-1,-2 0,29-71,-30 57,-2-1,-3-1,-1 0,7-73,-17 94,-2 0,-2 1,0-1,-2 0,-2 0,-1 1,-1 0,-19-56,19 72,-1-1,0 1,-1 1,-1-1,0 1,-1 1,0 0,-1 0,-1 1,0 1,-22-17,23 20,-1 1,0 0,-1 1,0 0,1 1,-2 1,1 0,-1 1,1 0,-1 1,0 0,0 2,0-1,-16 3,9 0,0 1,0 1,1 2,-1-1,1 2,1 1,-1 0,1 2,-32 21,39-23,1 0,0 1,1 0,0 1,1 0,0 1,0 0,1 0,0 1,1 0,1 0,0 1,0-1,2 1,-7 27,9-33,1 1,0-1,1 0,0 1,0-1,1 1,0-1,0 0,0 1,1-1,0 0,1 0,6 13,-4-12,0 0,1 0,0-1,0 0,1 0,0 0,0-1,0 0,15 9,-2-4,1-1,0-1,1 0,-1-2,2 0,-1-2,1-1,27 3,-16-5,0-2,0-1,0-2,-1-1,1-1,-1-2,0-2,-1-1,48-21,-46 15,0-1,-2-2,0-1,-1-1,-1-2,-1-1,-1-1,34-42,-42 43,-2-1,-1-1,-1 0,-1-2,-1 1,-2-2,11-35,-18 48,-1 0,0 0,-2 0,1 0,-2 0,0-1,-1 1,-1-1,0 1,-2 0,1 0,-2 0,0 0,-1 0,-8-17,9 26,0 0,0 0,-1 0,1 1,-1 0,-1 0,1 0,-1 1,0-1,-1 1,1 1,-1-1,-11-4,8 4,0 1,-1 1,0 0,1 0,-1 1,0 1,0 0,-22 1,9 2,1 1,-1 1,0 1,1 1,0 1,0 1,1 1,-28 17,20-9,2 1,0 2,1 1,1 1,-45 51,54-54,2 1,0 1,1 1,1 0,1 0,1 1,1 1,-11 39,18-49,1 0,0 0,1 1,1-1,0 1,1-1,0 0,1 1,1-1,0 0,1 0,0-1,7 15,-6-17,1 0,0-1,0 0,1 0,0 0,1-1,0 0,0 0,1-1,0 0,0-1,1 0,0 0,1-1,21 10,-16-10,1-1,0-1,0 0,0-1,0-1,0-1,1 0,-1-1,0-1,25-4,-20 0,0 0,0-2,-1-1,1 0,-2-1,0-2,27-17,-20 9,-1-1,-1-1,-1-1,-1-1,-1-2,-1 0,-1-1,-2-1,0-1,-2 0,15-36,-20 36,-1 0,-1 0,-1-1,-2 0,-1 0,-1-1,0-38,-5 55,0 0,0 0,-2 0,1 0,-1 1,-1-1,-1 1,-6-16,6 20,0 0,-1-1,1 2,-1-1,-1 1,0 0,0 0,0 1,0 0,-1 0,0 1,-12-6,4 3,0 2,0 0,0 1,-1 0,1 1,-1 1,0 1,-1 1,1 0,0 1,0 1,0 0,0 1,0 1,0 1,0 0,-17 8,10-2,0 0,1 2,0 1,1 0,1 2,0 0,1 2,1 0,0 1,-28 35,32-32,0 1,1 0,1 1,2 0,0 1,1 0,2 1,0 0,2 0,1 1,0 0,0 40,5-51,0 0,1 0,1 0,0 0,1 0,1-1,0 1,1-1,1 0,0-1,1 1,0-1,1 0,0-1,1 0,1 0,0-1,0 0,1-1,0 0,1-1,0 0,19 10,-7-7,1 0,0-2,1-1,0-1,0-1,50 7,-23-9,1-2,84-7,-68-3,-1-2,-1-4,0-3,-1-2,108-46,-116 37,-1-2,-1-3,-2-2,-2-2,-1-3,59-57,-86 71,-1-1,-1-1,-1-1,-2 0,-1-2,-1 0,22-54,-32 65,-2 0,0-1,-1 1,-1-1,-1 0,0-1,-2 1,0 0,-1 0,-2-1,0 1,-1 0,0 0,-11-29,10 37,-1 0,0 1,-1 0,-1 0,0 0,0 1,0 0,-2 0,1 1,-17-14,13 13,-1 1,-1 1,0 0,0 0,0 2,-1-1,-26-6,16 7,-1 2,0 0,0 2,1 0,-1 2,0 1,0 1,0 1,0 1,-27 9,30-6,0 1,0 1,1 1,0 1,1 1,0 1,1 1,0 0,1 2,-22 22,30-25,0-1,1 2,0-1,1 1,1 1,0-1,1 2,1-1,0 1,1-1,1 2,0-1,1 0,1 1,-1 31,4-36,0 0,0 0,1 0,1 0,0 0,0 0,1-1,1 0,0 0,11 19,-7-17,1-1,0 0,1 0,0-1,0 0,1-1,21 14,-7-9,0-1,1-1,1-1,0-2,0 0,1-2,0-1,39 4,-30-8,0 0,0-3,0-1,72-11,-87 8,0-2,0 0,0-2,-1 0,-1-1,1-2,-1 0,-1-1,22-17,-32 21,-1 0,-1 0,0-1,0-1,0 1,-1-1,-1 0,0-1,0 0,-1 1,0-2,5-18,-7 20,-1 0,-1 0,0 1,0-1,-1 0,0 0,-1 0,0 0,0 0,-1 1,0-1,-1 1,0-1,-1 1,-9-17,2 9,0 1,-1 0,-1 1,-1 0,0 2,0-1,-2 2,1 0,-2 0,-27-14,16 12,-1 1,0 2,-1 0,0 2,-61-10,53 14,0 2,0 1,-1 2,1 1,0 3,0 1,0 1,-58 19,76-18,0 1,0 1,1 1,0 1,1 0,0 1,-19 17,25-17,0 1,0-1,1 2,1 0,0 0,1 1,0 0,1 0,-10 30,13-28,0-1,1 1,1 0,1 0,0 0,2 1,0-1,0 0,2 0,0 0,1 0,1 0,0 0,1-1,1 1,1-2,0 1,1-1,1 0,0 0,1-1,0 0,1-1,1 0,0-1,1-1,0 1,23 14,-12-12,0 0,1-2,0 0,1-2,47 12,-16-9,104 8,-90-17,0-4,-1-2,1-4,-1-2,0-4,85-25,-77 12,0-3,-1-3,-2-3,-2-4,74-50,-101 56,0-1,-3-3,-1-2,51-58,-73 73,-2-1,-1 0,-1-1,-1 0,-1-2,-2 0,0 0,-2-1,-1 0,6-30,-13 44,0 0,-1-1,0 1,-1-1,-1 1,0-1,-1 1,0 0,-1 0,-1 0,-9-24,7 26,-1 0,1 1,-2 0,1 0,-2 0,1 1,-1 1,-1-1,0 2,0-1,-1 1,-20-12,6 8,-1 0,0 2,-1 1,0 1,0 1,-1 1,1 2,-1 1,0 1,-1 1,1 1,0 2,-34 6,46-5,1 1,0 0,0 1,0 1,1 0,-1 1,2 0,-1 1,1 1,0 0,1 1,0 0,0 1,2 0,-1 1,1 0,1 1,0 0,-8 16,5-6,2 0,0 0,2 1,1 0,0 0,2 1,1 0,1 0,0 48,4-54,0-1,2 0,0 0,1 0,1 0,0-1,2 0,0 0,0 0,2-1,0 0,1-1,1 0,18 21,-10-17,2-1,0-1,0-1,2-1,0-1,0-1,2-1,-1-1,29 8,0-2,2-3,0-2,74 6,-81-14,1-1,0-3,-1-2,1-2,-1-2,0-2,48-15,-70 15,-1-1,0-1,-1-1,0-1,0-1,-2-1,1-2,-2 0,0-1,-1-1,-1-1,-1 0,-1-2,18-26,-21 24,-1 0,-2-1,0-1,-2 0,0 0,-2-1,-1 0,-1-1,-1 1,-1-1,-1 1,-2-1,-1 0,-1 0,-1 1,-8-35,5 38,0-1,-2 1,0 1,-2 0,0 0,-1 1,-2 0,0 1,-1 0,-1 1,-1 1,0 0,-1 1,-1 1,-1 1,0 1,-1 0,-26-13,32 20,0 2,-1-1,1 2,-1 0,0 1,0 0,-1 1,1 1,0 0,0 1,-1 1,1 0,-16 4,13-1,0 1,1 1,-1 0,1 1,1 1,-1 0,1 2,1-1,0 2,-23 20,16-9,0 1,2 0,0 2,2 0,1 2,-26 51,32-54,2 0,0 0,2 1,0 0,2 0,1 1,1 0,1 47,3-58,0-1,1 1,1-1,0 0,1 0,1 0,0 0,1-1,10 19,-5-16,0-1,0 0,2 0,-1-1,2-1,23 19,-4-9,2-1,0-2,1-1,1-2,1-2,48 14,17-1,0-5,1-4,177 8,-164-24,-1-6,0-4,133-26,-38-16,-177 38,-1-1,0-2,58-33,-83 42,0 0,0-1,0 0,0 0,-1-1,0 0,-1 0,1-1,-1 0,8-15,-11 18,-1-1,0 1,0-1,-1 0,0 0,0 0,0 1,0-1,-1 0,0 0,0 0,-1 0,0 0,0 0,0 0,-1 1,0-1,-3-8,1 8,1-1,-1 1,0 0,-1 0,0 1,1 0,-2-1,1 1,-1 1,1-1,-1 1,0 0,-1 1,1-1,-1 1,1 1,-1-1,-14-3,-6 0,0 2,-1 0,-43 0,49 4,-1 0,1 1,-1 2,1 0,0 1,0 2,0 0,-23 10,36-12,0 0,0 1,1 0,0 0,0 1,0 0,1 0,0 1,0 0,1 0,0 0,0 1,0 0,1 0,0 1,1-1,0 1,0 0,1 0,0 1,-1 11,2-10,1 1,1-1,0 1,1-1,0 1,1-1,0 0,1 0,0 1,1-2,0 1,0 0,1-1,1 0,6 10,2-1,0-1,0 0,2-1,0 0,1-1,29 20,-3-7,1-2,0-3,2-1,1-2,60 17,-63-25,0-1,0-3,1-2,0-2,0-2,54-2,-83-2,0-1,0 0,0-1,0-1,18-6,-29 8,0 0,0 0,0-1,0 0,-1 0,1 0,-1 0,0-1,0 1,0-1,-1 0,1 0,-1-1,0 1,0-1,0 1,-1-1,4-9,-3 4,-1 0,0 1,0-1,-1 0,0 0,-1 0,0 0,0 0,-1 0,-3-10,1 6,-1 1,-1-1,0 1,-1 0,0 0,-11-15,-5-2,-1 1,-1 1,-1 2,-45-37,-46-27,97 78,0 0,0 2,-1 0,-36-12,51 21,-1-1,0 1,0 1,0-1,0 1,0 0,0 1,1-1,-1 1,0 0,0 1,0-1,1 1,-1 0,1 0,-1 1,1 0,0 0,0 0,0 1,1-1,-1 1,-7 9,1-1,1 0,1 1,0 0,0 0,1 1,1 0,-10 28,8-13,2 0,0 1,2-1,2 1,0 0,2 1,1-1,2 0,0 0,3 0,0-1,2 1,1-1,18 45,-15-50,0 0,2 0,0-1,2-1,0 0,2-1,0-1,1 0,1-2,1 0,1-1,0-1,1-1,0-1,2-1,41 18,-34-20,1-1,0-2,0-1,1-1,0-2,0-2,0 0,49-6,-63 3,0-2,0-1,-1 0,1-1,-1-1,0 0,-1-2,0 0,0-1,0-1,-1 0,-1-1,0-1,0 0,24-28,-25 21,-1 0,0-1,-2-1,0 0,-1 0,-1-1,-2 0,0-1,-1 0,-1 0,-1 0,-1 0,-2-1,0 1,-1-1,-1 1,-2-1,0 1,-1 0,-2 0,-10-31,11 44,0 0,0 1,-1-1,0 1,0 1,-1-1,0 1,-1 0,0 0,0 1,-1 0,0 1,0 0,0 0,-1 1,-18-8,19 10,0 0,-1 1,1 0,-1 0,0 1,0 0,1 0,-1 1,0 1,0 0,1 0,-1 1,0 0,1 0,0 1,-1 1,1-1,1 2,-11 5,1 3,0 0,1 1,1 1,0 1,1 0,1 1,0 0,1 2,1-1,1 1,-10 25,3-3,3 0,1 1,2 1,-9 69,17-90,2 0,1 0,1 0,0 0,2 0,7 35,-4-39,0-1,1 1,1-1,1-1,0 1,1-1,1-1,14 19,-11-18,1-2,1 1,0-2,1 0,0 0,1-2,0 0,1-1,0-1,1 0,0-2,22 6,-36-11,1 0,0-1,-1 0,1 0,0-1,0 1,7-2,-13 1,1 0,-1 0,0 0,0 1,0-1,0 0,0 0,0 0,0 0,1 0,-1 0,0 0,0 0,0 0,0 0,0 0,0 0,1 0,-1 0,0 0,0 0,0 0,0 0,0 0,0 0,0 0,1 0,-1-1,0 1,0 0,0 0,0 0,0 0,0 0,0 0,0 0,0 0,1 0,-1 0,0-1,0 1,0 0,0 0,0 0,0 0,0 0,0 0,0-1,0 1,0 0,0 0,0 0,0 0,0 0,0 0,0-1,0 1,0 0,0 0,0 0,-11-5,-19-1,10 6,1 1,0 0,0 1,0 1,0 1,0 1,1 0,0 2,-31 14,14-2,0 1,2 2,-53 43,53-36,2 2,1 2,1 0,2 2,1 1,2 1,2 1,1 2,2-1,-27 84,35-87,2-1,1 1,2 1,2-1,1 1,2 0,1 0,2 0,2 0,1-1,1 0,3 0,19 54,-8-45,1 0,3-2,1 0,3-2,1-1,2-1,1-2,2-1,2-2,40 31,-67-58,0 0,0-1,1 0,0-1,0 0,20 6,-27-10,1 0,-1 0,1 0,-1-1,1 0,-1 0,0 0,1 0,-1 0,1-1,-1 1,1-1,-1 0,0 0,1 0,-1-1,0 1,0-1,0 0,0 1,0-1,0-1,-1 1,1 0,3-5,-1 0,0-1,0 0,-1 0,0 0,0 0,-1-1,0 1,-1-1,0 0,1-9,-1 2,-1 1,0-1,-1 1,0-1,-4-16,4 26,-1 0,-1 0,1 0,-1 1,0-1,0 0,-1 1,1-1,-1 1,-1 0,1 0,-1 0,0 1,0-1,0 1,0 0,-1 0,1 0,-1 1,0 0,-1-1,1 2,0-1,-1 1,0 0,1 0,-1 0,0 1,0 0,0 0,0 0,0 1,-12 1,4 1,0 1,1 0,-1 1,1 1,0 0,0 1,0 0,1 1,0 1,0 0,1 0,-16 16,4-3,1 2,2 1,0 0,-26 44,29-38,1 1,1 1,1 0,2 1,2 0,0 1,3 0,1 0,1 0,2 1,1 0,3 36,2-55,-1 0,2-1,0 1,1-1,1 1,0-2,1 1,0-1,1 0,1 0,13 15,-13-17,1-1,1 0,0-1,0 0,1 0,1-2,-1 1,1-1,1-1,-1-1,1 0,15 5,-26-10,0 0,-1-1,1 1,0 0,0-1,0 0,0 1,0-1,0 0,0-1,0 1,0 0,0-1,0 0,-1 0,4-1,-6 2,1 0,-1 0,0-1,1 1,-1 0,0 0,0-1,1 1,-1 0,0-1,0 1,0 0,1-1,-1 1,0-1,0 1,0 0,0-1,0 1,0 0,0-1,0 1,0-1,0 1,0 0,0-1,0 1,0-1,0 1,0 0,-1-1,1 1,0 0,0-1,0 1,0 0,-1-1,1 1,0 0,-1-1,1 1,-1 0,-15-13,2 7,0 0,0 0,-1 1,1 1,-1 0,-28-2,19 4,0 1,0 0,-43 7,33 1,0 1,1 2,0 1,0 2,2 1,-1 2,2 1,0 1,1 1,1 2,-33 31,46-37,1 0,-22 29,32-39,1 0,0-1,0 1,1 0,-1 1,1-1,0 0,1 1,-1-1,1 1,0-1,0 1,1 0,0-1,0 7,1-9,-1-1,1 0,-1 0,1 0,0 0,0 0,0 0,0 0,0 0,0 0,0 0,1-1,-1 1,1 0,-1-1,1 1,2 1,0-1,-1 0,1 0,-1-1,1 1,0-1,0 0,0 0,8 1,-1-1,1-1,-1 0,1-1,-1 0,0-1,12-3,-3-1,-1-1,0-1,-1-1,1 0,-2-2,1 0,-2-1,1 0,26-29,-17 15,-2-2,-1-1,-1-1,29-53,-41 65,0-1,-1-1,-1 0,-1 0,-1 0,6-36,-11 50,0 0,-1 0,0 0,0-1,0 1,-1 0,0 0,0 0,0 0,-1 0,0 0,0 1,-1-1,1 1,-1-1,-1 1,1 0,-1 0,1 0,-2 0,1 1,0 0,-1 0,0 0,1 0,-2 1,-6-5,-7 0,0 0,0 2,0 0,-1 1,0 1,0 0,0 2,-25 0,-167 11,196-8,-162 18,-215 49,380-65,0 0,1-1,-1 2,1 0,-1 0,1 1,-19 11,30-15,0-1,0 0,0 1,0 0,1-1,-1 1,0-1,0 1,1 0,-1-1,0 1,1 0,-1 0,1 0,-1 0,1-1,-1 1,1 0,0 0,-1 0,1 0,0 0,0 0,-1 0,1 0,0 0,0 0,0 0,0 0,1 0,-1 0,0 0,0 0,1 0,-1 0,0 0,1 0,-1 0,1-1,-1 1,1 0,-1 0,2 1,2 1,-1 0,1 0,0 0,0 0,0-1,1 0,-1 0,6 2,9 2,1 0,0-2,1 0,-1-2,1 0,-1-1,1-1,0-1,23-4,-14 0,0-1,-1-1,0-2,0-1,46-22,-63 25,-1 0,1 0,-1-1,-1 0,1-1,-2 0,16-18,-20 20,0 0,0 0,-1 0,0-1,0 0,-1 0,0 0,0 0,-1 0,0-1,0 1,0-18,-2 23,0 0,0-1,0 1,-1 0,1 0,-1-1,0 1,0 0,0 0,0 0,-3-4,0 2,1 0,-1 0,-1 1,1-1,-10-7,-4-1,-1 1,0 0,-31-14,-74-23,27 16,-2 4,-122-19,145 37,1 3,-1 3,-131 10,157 1,1 1,1 3,0 3,0 1,1 2,1 2,1 3,1 1,0 2,2 2,-48 39,78-56,1 0,0 1,0 1,1 0,1 0,-12 17,20-25,-1-1,1 0,0 1,-1-1,1 1,0-1,1 1,-1 0,0-1,1 1,-1 0,1 0,0-1,0 1,0 0,0 0,1-1,-1 1,1 0,-1 0,1-1,0 1,0-1,0 1,1-1,-1 1,1-1,-1 0,1 1,0-1,-1 0,1 0,0 0,1-1,-1 1,0 0,0-1,1 1,-1-1,4 1,7 4,1 0,0-1,0 0,1-2,-1 1,1-2,0 0,0-1,0 0,0-1,0-1,0 0,23-6,-34 6,-1 0,1 0,0 0,-1-1,0 1,1-1,-1 0,0 0,0 0,0 0,0-1,0 1,0-1,-1 0,1 0,2-4,-4 4,0 0,0 0,0 0,-1 1,1-1,-1 0,1 0,-1 0,0 0,0 0,-1 0,1 0,0 0,-1 0,0 0,0 1,0-1,0 0,0 0,0 1,-1-1,-2-3,-2-4,-1 1,-1-1,1 1,-2 1,1-1,-11-7,-65-42,27 26,-2 1,-83-29,-133-30,-110-2,-8 23,359 64,28 4,-38-6,0-1,-62-22,103 29,0 0,-1-1,1 1,1-1,-1 1,0-1,0 0,1 0,-1-1,1 1,-1 0,1-1,0 0,0 1,0-1,0 0,1 0,-1 0,1 0,0 0,0 0,0-1,0 1,0 0,1 0,-1-1,1 1,0-1,0 1,1-6,1-2,0 1,1-1,0 1,0 0,1 0,0 0,1 1,0 0,10-13,163-188,-146 175,605-705,-589 679,70-117,-112 167,0 0,-1-1,0 1,-1-1,0 0,-1 0,3-19,-6 27,1 0,-1 1,-1-1,1 0,0 1,-1-1,0 1,0-1,0 1,0-1,-1 1,1 0,-1-1,0 1,0 0,0 0,0 0,0 0,-1 1,1-1,-1 1,0-1,0 1,0 0,0 0,0 0,0 1,-6-3,-8-2,0 1,0 1,-1 0,0 1,0 1,-21 0,-22 1,0 3,1 2,-1 3,1 2,-63 20,0 7,-161 71,165-55,-131 79,198-99,1 2,2 2,2 2,-73 76,107-100,1 1,1 0,0 0,1 1,1 0,-9 21,15-31,1 1,0 0,0-1,0 1,1 0,0 0,0 0,1 0,0 0,0 0,1 0,0 0,0 0,1-1,0 1,0 0,0-1,1 1,4 7,-2-6,0 0,1-1,-1 0,1 0,1-1,0 0,-1 0,11 6,0-1,1-1,30 13,-14-9,2-2,0-1,0-2,0-1,1-2,54 2,-44-8,1-2,-1-1,0-3,79-20,-47 4,0-4,-2-4,89-47,-109 47,-2-3,-1-3,-2-1,81-78,-116 99,-1-2,-1 0,0 0,-2-1,0-1,-1 0,13-33,-21 43,0 0,-1 0,-1 0,1-1,-2 1,1-1,-1 1,-1-1,0 0,-1 1,0-1,0 0,-1 1,-1-1,1 1,-2 0,0 0,-5-11,2 9,0 1,0 0,-1 1,0 0,-1 0,0 1,-19-15,12 12,-2 1,1 0,-2 1,-25-9,-3 2,-2 3,0 1,-60-6,12 7,1 5,-1 4,0 4,1 5,0 3,0 5,1 4,-182 60,236-64,-66 34,97-43,0 1,0 1,0-1,1 1,0 1,1 0,-1 0,1 1,1 0,0 0,-7 12,11-16,1-1,0 1,0 0,0 0,1 1,-1-1,1 0,1 0,-1 1,1-1,0 0,0 1,0-1,1 0,0 1,0-1,0 0,1 0,-1 0,1 0,1 0,-1 0,1 0,-1-1,6 7,2 0,0 0,0 0,1-1,1 0,0-1,0-1,0 0,17 8,19 6,1-2,0-3,1-1,56 9,4-4,1-4,1-6,0-4,0-5,1-5,-1-5,-1-4,133-34,-199 35,0-2,-1-1,0-3,49-27,-80 36,0 0,-1-1,0 0,-1 0,0-1,0-1,-1 0,-1-1,0 0,10-17,-15 23,-1 0,0-1,0 1,-1-1,1 0,-2 0,1 0,-1 0,0 0,0 0,-1 0,0-1,0 1,-1 0,0 0,0 0,0 0,-1 0,0 0,-1 1,0-1,0 0,-5-8,-1 3,-1 0,0 0,0 1,-2 1,1-1,-1 2,0 0,-1 0,0 1,-1 1,1 0,-26-9,-2 3,-1 1,0 2,-60-7,35 10,0 4,-1 2,1 3,0 4,0 2,1 3,0 3,-74 26,103-27,1 1,0 2,1 2,1 1,1 1,-43 36,59-42,1 1,0 1,1 1,1 0,-15 26,21-30,0 2,1-1,1 1,0 0,1 0,1 1,0-1,-1 19,4-24,0 0,1 0,0 0,1 0,0 0,1 0,0 0,1 0,0-1,6 15,-3-12,1 1,0-1,1-1,1 1,0-2,18 19,-1-7,0-2,2 0,0-2,1-1,50 21,-1-6,2-4,0-3,2-4,156 20,-144-32,0-4,1-5,-1-3,107-18,-134 9,-1-2,-1-3,122-50,-148 49,-1-1,-1-1,-1-3,-1-1,-1-1,-1-2,39-42,-57 52,0 0,-2-1,0-1,-1 0,0-1,-2 0,-1 0,12-37,-17 42,0-1,-1 0,-1 0,-1 0,0 0,-1 0,-1 0,0 0,-1 0,-1 0,0 0,-10-26,3 18,-2-1,-1 2,-1 0,0 0,-2 1,-1 1,0 1,-2 0,0 1,-36-27,6 12,0 1,-2 3,-94-41,-28 6,140 56,-1 0,0 3,-41-4,68 9,0 1,0 0,0 0,0 0,0 1,-13 3,18-3,1-1,-1 1,0 0,1 0,-1 0,1 0,-1 0,1 0,-1 0,1 1,0-1,0 0,0 1,0-1,0 1,0-1,0 1,0 0,0-1,1 1,-1 0,1 0,-1-1,1 1,0 0,-1 0,1 0,0-1,0 1,1 3,0 3,0-1,1 1,0-1,1 1,-1-1,2 0,-1 0,1 0,-1 0,2-1,-1 1,9 8,6 8,1 0,1-2,1 0,1-2,43 29,-13-16,105 46,87 12,-99-49,3-7,0-7,2-6,202 2,-253-23,0-5,101-18,-131 10,-1-3,0-3,103-43,-136 46,-1-1,0-2,62-46,-80 51,0-1,0-1,-2 0,0-1,-1-1,0 0,-2 0,11-23,-18 31,0 0,0-1,-2 0,1 0,-1 0,-1-1,0 1,-1 0,0-1,-1-20,-1 23,0-1,-1 1,-1 0,1-1,-2 1,1 0,-1 1,0-1,-1 1,0-1,-1 1,1 1,-10-10,-1 1,-1 0,-1 1,0 1,-1 1,-1 0,0 1,0 2,-37-15,8 9,-1 1,-97-15,81 22,-121-1,65 14,1 6,-142 31,-234 88,346-80,-200 95,279-109,1 4,2 2,2 3,-94 83,132-100,1 0,1 2,-43 62,59-75,1 0,1 1,1-1,0 2,1-1,1 1,1 0,1 0,-4 32,8-39,0 0,0 0,1 0,1 0,0-1,0 1,2-1,-1 1,10 20,-5-17,1-1,0 0,0 0,2-1,0 0,16 15,2-3,0-2,2-1,1-2,0-1,56 24,-19-15,1-3,122 27,155-2,-238-43,0-4,114-13,-152 3,-1-3,0-4,-1-2,80-31,-124 37,0-1,0-1,-1 0,-1-2,0-1,33-29,-45 34,-1 0,0-1,-1 0,-1 0,1-1,-2 0,0-1,0 1,-1-2,0 1,-2 0,1-1,4-28,-7 23,-2 0,1 0,-2 0,-1 0,0 0,-1 0,-1 1,-1-1,-1 1,0 0,-1 0,-11-18,1 5,-1 1,-2 0,-1 2,-1 0,-47-44,28 35,-2 2,-2 2,-1 1,-61-30,35 27,-1 3,-110-33,51 31,0 5,-2 6,-160-6,177 23,-1 4,-205 24,267-13,0 2,-103 37,123-33,0 1,2 1,0 2,1 1,-34 28,51-35,0 1,1 0,1 1,0 1,1 0,1 1,-15 27,21-32,0 1,1-1,0 1,1 0,1 0,0 0,1 1,0-1,1 0,1 1,0 0,2 18,2-13,-1-1,2 1,1-1,0 0,1-1,1 1,1-1,0-1,22 31,-12-26,0 1,1-2,1-1,1 0,0-2,26 15,6-1,3-2,0-3,2-2,0-3,78 16,-53-18,0-4,1-3,0-4,0-4,151-12,-176 1,-2-3,1-3,88-30,-105 27,0-2,-1-2,-1-2,-1-1,45-36,-62 41,-1-2,0 0,-2-1,0-2,-2 0,0 0,-1-2,-2 0,0 0,-2-1,-1-1,-1 0,-1-1,-2 0,0 0,-2 0,-2-1,0 0,-2 0,-1 0,-1 0,-1 0,-2 1,-7-29,3 25,-2 1,0 0,-2 1,-2 0,0 1,-2 0,-33-43,25 42,-1 1,-2 1,0 1,-2 1,-1 2,-36-22,26 22,0 1,-1 3,-1 2,-1 1,-1 2,0 2,-1 2,0 2,0 2,-1 2,-79 1,110 5,0 0,0 0,0 2,0 0,0 0,-24 10,34-11,1 1,-1-1,0 1,1 0,0 0,-1 0,1 0,0 1,1 0,-1 0,1 0,0 0,0 1,0-1,0 1,1-1,0 1,0 0,0 0,0 0,1 0,-1 10,1-9,1 1,0 0,0 0,1 0,0-1,0 1,1 0,0-1,0 1,0-1,1 1,0-1,0 0,0 0,6 7,4 2,0 0,0 0,1-1,23 16,7 3,1-3,2-1,0-3,2-2,71 25,-46-24,2-3,0-4,90 10,-115-22,0-2,1-2,-1-3,91-12,-119 8,1 0,-1-2,-1 0,1-2,25-14,-33 15,-1 0,-1-2,0 0,0 0,-1-1,0 0,-1-1,15-21,-12 11,-2 0,-1-1,0 0,-2-1,0-1,-2 1,-1-1,0 0,-2 0,-1-1,-1 1,-2-1,0 0,-2 1,-8-49,7 63,0 0,-1 1,0 0,0 0,-1 0,-1 0,-7-10,11 17,0 0,0 0,0 0,-1 1,1-1,-1 1,0-1,0 1,0 0,0 0,0 0,0 1,0-1,-1 1,1-1,-1 1,1 0,-1 1,1-1,-1 0,0 1,1 0,-1 0,0 0,-4 1,0 2,0 0,1 1,-1 0,1 0,0 0,0 1,0 0,0 1,1 0,0 0,-6 8,-12 13,1 1,1 1,2 2,-22 42,-53 141,50-94,5 2,-36 185,60-212,4 0,4 1,9 189,3-239,1-1,2-1,3 1,1-1,23 57,-26-82,1-1,1 0,1-1,0 0,1 0,15 14,-17-20,1-1,0-1,0 0,1 0,0-1,1-1,0 0,0 0,18 5,-15-8,0 0,0-1,0 0,0-2,1 0,-1 0,0-2,1 0,-1-1,0 0,0-1,0-1,0-1,-1 0,16-8,5-5,-1 0,-1-3,-1-1,0-1,33-32,-5-2,-3-2,-2-3,-3-3,-3-1,-3-3,-3-2,36-79,-40 64,-4-2,-4-1,-3-2,-5-1,24-184,-43 224,-2-1,-3 0,-2 0,-3 0,-1 1,-25-93,22 113,-2 1,-1 1,-1 0,-2 0,0 2,-2 0,-2 0,0 2,-2 1,0 0,-2 1,-28-22,19 23,0 1,-1 1,-2 3,0 0,0 2,-2 2,0 2,0 1,-42-7,5 7,1 2,-1 4,-137 8,207-3,-143 16,133-13,-1 0,1 1,0 1,0 0,0 1,1 0,-25 16,31-16,0 1,1 0,-1 0,1 0,1 1,0 0,0 0,0 0,1 0,0 1,0 0,1 0,1 0,-3 10,0 11,0 0,2 1,1 32,2-49,1-1,0 1,1-1,0 0,1 1,1-1,0 0,1-1,0 1,1-1,0 0,1 0,0-1,1 0,1 0,9 9,-5-7,0-1,2 0,-1-1,2-1,-1-1,1 0,0-1,1 0,0-1,0-1,26 5,-13-5,-1-1,2-1,-1-2,0-1,47-5,-62 3,0-1,0-1,0-1,-1 0,1-1,-1 0,0-1,0-1,-1 0,0-1,0 0,21-19,-27 20,-1 1,1-1,-2-1,1 1,-1-1,0 0,-1-1,0 1,0-1,-1 1,0-1,2-12,-3 8,-1 1,0-1,0 0,-2 0,0 0,0 1,-1-1,-4-14,-2 0,-2 0,-1 1,-1 0,-1 0,-2 1,0 1,-25-29,36 47,-14-13,17 18,0 1,1-1,-1 1,0 0,1 0,-1-1,0 1,1 0,-1 0,0 0,0 0,1 0,-1 0,0 0,1 0,-1 0,0 0,1 0,-1 0,0 0,0 1,1-1,-1 0,0 1,1-1,-1 0,1 1,-1-1,1 1,-1-1,0 1,1-1,0 1,-1 0,-12 16,2 0,0 1,1 0,1 1,-12 36,-4 6,-29 49,-26 62,77-167,-7 26,9-30,1 0,0 0,-1 0,1 0,0 1,0-1,0 0,0 0,0 0,0 0,0 0,0 1,0-1,0 0,1 0,-1 0,0 0,1 0,0 2,0-3,0 0,0 1,-1-1,1 0,0 0,0 0,0 0,0 0,0 0,0 0,-1 0,1 0,0 0,0 0,0-1,0 1,0 0,-1 0,1-1,0 1,0-1,-1 1,2-2,15-7,-1-1,0-1,-1 0,0-1,13-15,67-77,-57 58,-2-1,-2-2,-2-2,-2-1,-3-1,-2-1,23-73,-42 108,-1 0,-1-1,-1 1,2-31,-5 42,0 0,0 0,-1 1,-1-1,1 0,-1 0,0 1,-1-1,0 1,0 0,-1 0,0 0,0 0,-5-6,-1 3,0 0,0 0,-1 2,0-1,-1 1,1 1,-1 0,-1 1,0 0,1 1,-2 0,-21-4,-14-1,0 2,-58-2,8 5,-1 4,1 5,-121 19,206-21,-3 1,-33 9,46-11,1 0,0 0,0 0,0 1,0-1,0 1,0 0,0 0,1 0,-1 0,0 0,1 1,0-1,0 1,0-1,-3 5,5-5,-1 0,0 0,1 1,-1-1,1 0,0 1,0-1,0 0,0 1,0-1,0 0,1 1,-1-1,1 0,0 0,-1 1,3 2,22 36,-2-11,2-1,1-2,34 29,95 67,-115-93,1-2,75 38,-95-58,-21-8,0 0,1 0,-1 0,0 0,0 0,0 0,1 0,-1 0,0 0,0 0,0 0,1 0,-1 0,0 0,0 0,0 0,1 0,-1 0,0 0,0 0,0 0,1 0,-1 0,0 0,0-1,0 1,1 0,-1 0,0 0,0 0,0 0,0-1,0 1,0 0,1 0,-1 0,0-1,0 1,0 0,0 0,0 0,0-1,0 1,0 0,0 0,0 0,0-1,0 1,0 0,0 0,0 0,0-1,0 1,0 0,0 0,0 0,0-1,-1 1,1 0,0 0,0-1,-8-12,-3 0,0 1,-1 0,-24-18,-47-28,62 44,-4-3,-1 2,0 0,-1 1,-1 2,-36-11,50 19,0 1,0 0,0 1,0 1,0 0,0 0,0 2,0 0,-1 1,1 0,0 1,1 0,-23 9,13-1,1 1,1 0,0 2,0 0,-30 29,9-2,-50 62,54-54,3 1,1 2,3 2,2 1,3 1,-29 90,30-51,23-86,0 0,1 0,1 1,-1-1,2 1,-1-1,1 0,3 10,-4-16,1 0,0-1,0 1,0 0,1-1,-1 1,1-1,-1 1,1-1,0 0,0 0,0 0,0 0,0 0,1 0,-1 0,0-1,1 1,0-1,-1 0,1 0,0 0,-1 0,1 0,0 0,0-1,4 1,-4-1,1 0,0 0,-1 0,1-1,0 1,0-1,-1 0,1 0,-1-1,1 1,-1 0,0-1,1 0,-1 0,0 0,0 0,0-1,0 1,-1-1,5-4,-3 0,0-1,0 0,0 1,-1-1,0 0,0-1,-1 1,0 0,0-1,-1 0,-1 1,1-1,-1 1,-2-16,0 9,0 1,-1-1,-1 1,0 0,-1 0,0 0,-15-25,13 27,-2 0,1 1,-1 0,-1 0,0 1,-1 0,0 1,0 0,-24-13,17 12,-1 2,-1 0,1 0,-1 2,0 1,-25-4,0 4,1 3,-1 1,0 2,0 2,-76 15,35 1,1 5,1 3,1 4,-151 80,205-96,1 2,1 1,1 2,0 0,1 2,1 0,2 2,-21 27,34-39,1 1,0 0,1 0,1 1,0 0,1 0,0 0,-3 21,6-23,1 1,1-1,0 0,0 1,1-1,1 1,0-1,0 0,1 0,1 0,6 14,-2-9,1-1,1 0,0-1,1 0,0-1,2 0,-1-1,2 0,-1-1,2 0,0-1,0-1,1 0,0-2,0 1,1-2,21 7,-32-13,0 1,0-1,0 0,0 0,0-1,0 0,-1 0,1 0,0-1,0 0,0 0,0 0,8-3,-10 1,1 1,-1 0,0-1,0 0,0 0,0 0,-1-1,1 1,-1-1,0 0,0 0,0 0,0 0,-1 0,0-1,3-6,0-4,0-1,-1 1,-1-1,0 0,-2 0,1 0,-2 0,0 0,-1-1,-1 1,0 1,-1-1,-1 0,0 1,-2-1,1 1,-2 0,-8-14,4 9,-1 0,-1 1,0 0,-2 1,0 1,-1 0,-1 2,0-1,-1 2,-1 0,0 2,-25-13,12 11,0 1,-2 2,1 2,-1 1,0 1,-46-2,6 5,-141 10,42 14,135-13,0 1,-55 19,88-25,0 1,-1-1,1 1,0 0,0 0,0 0,1 1,-1 0,1 0,0 0,0 0,-6 9,6-6,0 0,1 0,0 1,0-1,0 1,1 0,0 0,-1 11,2-6,1 0,0 0,0 0,1 0,1 0,1 0,-1 0,8 19,-1-9,1 0,1-1,22 35,-22-42,1 0,0 0,1-2,0 1,1-2,29 21,-7-10,72 33,-77-41,2-1,0-2,0-2,1-1,0-1,65 6,-86-14,1 0,0-1,0 0,0-1,-1 0,1-2,-1 1,22-10,-26 9,0-1,0-1,-1 1,0-1,0-1,0 1,-1-1,0-1,0 1,-1-1,0 0,0-1,4-9,-5 9,0-1,-1 0,-1 0,1 0,-2-1,1 1,-1-1,-1 1,0-1,-1 0,0 1,0-1,-1 0,0 1,-1-1,-1 1,1-1,-2 1,1 0,-1 0,-1 0,0 1,-8-12,0 2,-1 0,-1 2,0-1,-2 2,0 0,-1 1,0 1,-1 1,-37-20,22 17,0 2,-1 1,0 2,-1 1,-1 2,1 2,-1 1,0 2,0 1,0 2,0 2,0 1,0 2,0 1,1 2,-49 18,74-22,-1 0,2 1,-1 0,-19 13,28-16,-1 0,1 1,-1-1,1 0,0 1,0 0,0-1,0 1,0 0,1 0,-1 0,1 0,0 0,0 0,0 0,0 1,0-1,1 0,0 1,0-1,-1 0,2 5,0-1,0 0,1 0,0 0,0 0,1 0,-1-1,1 1,1-1,0 0,-1 0,2 0,-1 0,1-1,0 1,0-1,0 0,7 4,2 1,1 0,0-1,0-1,1-1,0 0,19 5,6 0,0-3,1-1,0-2,0-2,1-2,0-2,51-6,-25-2,-1-4,-1-2,116-41,-124 32,-1-2,-1-2,-1-3,-1-2,-3-3,91-77,-114 84,0-1,-3-1,0-2,39-64,-50 70,-1-2,-1 0,-2 0,-1-1,-1-1,-1 1,3-34,-9 47,-1-1,0 1,-1-1,-1 0,0 1,-1-1,-9-30,8 36,-1 1,-1 0,1 0,-2 0,1 0,-1 1,-1 0,1 0,-2 0,1 1,-1 1,-15-12,7 7,-1 2,0 0,-1 1,0 0,0 2,-1 0,0 1,0 1,0 1,-1 1,1 0,-1 2,-25 0,10 3,-1 2,1 1,0 1,1 3,0 0,-53 23,10 3,1 3,2 3,-113 84,105-61,2 4,-110 124,165-163,0 2,2 0,-26 49,39-63,2 1,0 1,1-1,1 1,0 1,2-1,0 1,-1 29,5-38,1 0,0 1,0-1,2 0,-1 1,1-1,1-1,0 1,1 0,-1-1,2 0,0 0,8 10,-5-8,1 0,0-1,1 0,0-1,0 0,1-1,1 0,-1-1,26 11,2-2,1-3,0-1,57 9,133 9,60-15,-259-16,-1-2,1-2,0-1,-1-1,0-1,0-2,31-14,-48 16,0 0,-1 0,0-2,-1 0,1 0,-2-1,1-1,-2 1,1-2,-1 0,-1 0,0-1,-1 0,0 0,-1-1,-1 0,0 0,-1 0,0-1,-1 0,-1 0,-1 0,0 0,0-1,-2 1,0-1,-1 1,-3-22,0 16,-1 1,-1 0,-1 0,0 0,-2 1,0 0,-1 1,-1 0,0 0,-2 1,0 1,0 0,-2 1,0 0,-29-20,16 15,-1 1,-1 2,0 2,-1 0,-1 2,0 1,-1 2,-63-12,43 15,0 3,0 1,-1 3,1 3,0 1,0 3,-77 20,51-4,0 3,2 3,1 4,-81 47,140-70,-1 1,2 1,-1 0,2 1,-1 0,2 1,-21 27,26-30,2 1,0 0,0 1,1-1,1 1,0 1,1-1,0 1,1-1,0 1,0 25,3-20,1 0,0 0,2 0,0 0,1-1,1 1,1-1,1 0,0 0,1-1,1 0,12 17,6 5,1-1,3-2,59 57,-32-40,2-3,3-3,100 58,-151-98,33 16,-43-21,0-1,1-1,-1 1,1 0,-1-1,1 1,-1-1,1 0,-1 1,1-1,0-1,-1 1,1 0,-1-1,4 0,-5 0,0 1,0-1,0 0,0 1,0-1,0 0,0 0,0 0,0 0,-1 0,1 0,0 0,0 0,-1 0,1-1,-1 1,1 0,-1 0,0 0,1-1,-1 1,0 0,0 0,0-1,0 1,0 0,0-1,0 1,0 0,-1 0,0-2,0-4,-1 0,0 1,-1-1,-5-9,-7-10,-1 0,-1 2,-1 0,-2 1,0 1,-1 0,-31-23,24 24,-1 1,0 1,-2 1,0 2,-64-24,84 36,-2 0,1 1,0 0,0 1,-1 0,1 1,-1 1,0 0,1 0,-1 2,1-1,-1 1,1 1,0 1,0-1,0 2,1 0,-1 0,1 1,0 0,1 1,-1 0,1 1,1 0,-15 16,7-4,1 1,1 1,1 0,0 1,2 0,1 1,-14 44,10-19,3 1,1 1,-3 53,11-70,2 0,4 60,0-73,0 1,2-1,0 0,2 0,13 31,-7-26,1-1,1 0,1-1,1-1,1-1,26 26,-16-22,1-2,1 0,1-2,41 22,-13-14,1-3,1-3,2-2,0-3,82 13,77-1,-172-28,0-2,75-8,-95 3,-1-1,1-1,-2-2,1-1,36-17,-44 16,-1-1,0-2,-1 0,0 0,-1-2,0 0,25-30,-23 20,0-1,-2-1,-1-1,-2 0,0-1,-2-1,15-52,-19 53,-3 0,0-1,-2 0,-1 0,-1 0,-2-1,-1 1,-6-39,4 51,-2 0,0-1,-1 2,0-1,-2 1,0 0,-1 0,-1 1,0 0,-1 1,-1 0,0 1,-1 0,-1 1,0 1,0 0,-1 0,-1 2,0 0,-1 1,1 0,-2 2,1 0,-1 1,0 0,0 2,-1 0,1 1,-1 1,-21 0,20 2,0 1,0 1,0 0,0 2,1 0,-1 2,1 0,1 1,-29 14,26-10,1 2,1 0,0 1,0 1,1 0,1 1,-27 35,31-34,1 1,0 0,2 1,0 0,1 0,1 1,1 0,-8 38,12-41,1 1,0 0,2-1,0 1,1 0,0 0,2-1,0 1,1-1,1 0,8 21,-3-16,1 0,2-1,0-1,0 0,2-1,1-1,0 0,1-1,1 0,1-2,38 25,-14-14,1-2,1-2,1-2,88 25,-42-21,1-4,110 8,196-14,-298-16,1-4,-1-5,-1-4,159-45,-205 42,0-3,-2-1,89-54,-104 52,-1-2,-1-1,-1-2,-1-1,43-53,-59 61,-1-1,-1-1,-1 0,-1-1,-1-1,-1 0,-1 0,-2-1,10-50,-13 36,-1-1,-1 1,-3 0,-1-1,-13-75,10 94,-2 0,0 0,-1 0,-1 1,-1 0,-1 1,-16-27,19 38,1 1,-1-1,-1 2,0-1,0 1,-1 0,0 1,0 0,0 0,-1 1,0 0,0 1,-1 0,0 1,0 0,-21-5,19 7,1 1,-1 0,0 0,1 1,-1 1,1 0,-1 1,1 0,-1 1,-21 8,18-4,1 0,0 1,1 1,0 0,0 1,1 1,-18 17,12-7,1 0,1 1,1 1,1 0,1 1,1 1,1 0,1 1,-13 47,22-62,0-1,0 1,1-1,0 1,1-1,1 1,-1-1,2 1,-1-1,7 20,-3-16,1 1,0-1,1 0,1-1,0 0,17 21,-2-9,0-1,2-2,0 0,1-2,1-1,33 18,-11-10,1-3,1-2,89 26,-101-38,-1-1,1-3,1-1,-1-1,77-5,-104 0,-1 0,1-1,-1-1,0 0,0 0,0-1,0 0,13-8,-19 9,0 0,0-1,-1 1,0-1,1 0,-1 0,0 0,-1 0,1-1,-1 0,0 0,0 0,-1 0,1 0,-1 0,0-1,-1 1,3-9,-3 7,-1 0,1 1,-1-1,0 0,0 0,-1 0,0 0,0 0,-1 0,0 1,0-1,-1 1,-3-9,0 7,1-1,-1 0,-1 1,1 0,-1 1,-1-1,1 1,-11-6,-3-1,0 1,-1 1,0 1,-1 1,-1 0,-37-8,6 6,0 3,-1 2,1 3,-1 2,-104 9,129-3,1 0,-1 2,1 1,-34 13,42-11,2 0,-1 2,2 0,-1 1,1 1,-22 20,8 0,1 0,2 2,2 1,1 1,2 2,1 0,2 2,2 0,2 2,2 0,1 0,-17 92,29-116,1 1,1 0,0 0,2 0,0 0,1-1,5 21,-4-28,1-1,0 0,0 1,1-2,1 1,-1 0,2-1,-1 0,2-1,-1 0,1 0,1 0,11 9,11 3,2-1,0-1,1-2,0-2,41 13,-37-15,1-1,0-2,1-2,0-1,1-2,62-1,198-21,-59-10,243-60,-116-11,453-184,-513 151,-64 9,-179 85,-1-3,97-79,-155 113,46-43,-50 46,0-1,0 1,0-1,-1 0,1 0,-1 0,0-1,0 1,0 0,-1-1,2-5,-3 9,0-1,0 1,0 0,0-1,0 1,-1-1,1 1,0 0,-1-1,1 1,0 0,-1 0,0-1,1 1,-1 0,0 0,0 0,0 0,1 0,-1 0,0 0,0 0,-1 0,1 0,0 0,0 0,0 1,0-1,-1 1,1-1,0 1,-1-1,1 1,0 0,-1 0,1-1,-3 1,-4-1,0 1,0-1,0 1,0 1,-10 1,-21 7,1 1,1 2,-43 20,24-10,-91 36,-155 86,301-144,-12 7,0 1,0 1,-16 13,27-20,-1 1,1-1,0 1,-1 0,1 0,1 0,-1 0,-3 6,5-7,-1-1,1 1,0 0,-1-1,1 1,0 0,0-1,0 1,0 0,1-1,-1 1,0 0,1-1,-1 1,1-1,-1 1,1-1,0 1,1 1,0 0,0 0,0 0,1-1,-1 0,1 1,0-1,0 0,-1 0,1 0,0-1,1 1,3 1,44 11,-47-14,48 10,1-3,82 0,112-19,-72-6,-1-8,188-53,-341 73,0 0,-1-1,1-1,-1-1,22-13,-41 21,1 0,-1 0,1 0,-1 0,1-1,-1 1,1 0,-1-1,0 1,0-1,0 1,0-1,0 0,0 1,0-3,0 3,-1 0,0 0,0 0,0 0,0 0,-1 0,1 1,0-1,0 0,0 0,-1 0,1 0,0 0,-1 1,1-1,-1 0,1 0,-1 1,0-1,1 0,-1 1,-1-2,-3-2,0 1,-1 0,0-1,0 2,0-1,0 1,-12-3,-25-4,-1 1,1 2,-2 3,-68 2,31 6,-131 25,182-23,1 0,1 2,-1 2,2 0,-38 22,52-26,1 1,0 1,1 0,0 1,0 0,1 1,0 0,1 1,0 0,1 0,1 1,-11 22,16-30,1 1,-1 1,2-1,-1 0,1 0,0 1,0-1,1 0,0 11,0-14,0-1,1 1,-1-1,1 0,0 0,-1 1,1-1,0 0,0 0,1 0,-1 0,0 0,1 0,-1 0,1 0,0-1,-1 1,1-1,0 1,0-1,0 1,0-1,0 0,0 0,0 0,1 0,-1-1,3 2,5-1,-1 1,1-1,0 0,11-1,-17 0,0 0,-1-1,1 1,0-1,0 0,0 0,-1 0,1 0,0-1,-1 1,1-1,4-4,-7 6,-1 0,0 0,0 0,1 0,-1-1,0 1,0 0,1 0,-1 0,0 0,0-1,0 1,0 0,1 0,-1 0,0-1,0 1,0 0,0 0,0-1,0 1,0 0,1 0,-1-1,0 1,0 0,0 0,0-1,0 1,0 0,0-1,0 1,-1 0,1 0,0-1,0 1,0 0,0 0,0-1,0 1,0 0,-1 0,1 0,0-1,0 1,0 0,-1 0,-14-4,7 5,1-1,0 1,1 1,-1-1,0 1,0 0,0 1,-7 4,-52 32,53-31,-15 10,2 2,0 0,1 2,1 0,1 2,-35 45,54-63,0 0,1 0,-1 0,1 0,0 1,-2 7,5-12,-1 0,1 0,0 0,-1 0,1 0,0 0,0 0,1 0,-1 0,0 1,0-1,1 0,0-1,-1 1,1 0,0 0,0 0,0 0,0 0,0-1,0 1,0 0,1-1,-1 1,2 0,2 2,0-1,0 0,-1 0,2-1,-1 0,0 0,0 0,1 0,-1-1,1 0,8 1,4-1,-1 0,26-3,-21-1,0 0,1-2,-1 0,38-16,-46 16,-1-1,0-1,-1 0,0 0,0-2,0 1,-1-1,17-19,-26 27,-1-1,0 1,0-1,1 1,-1-1,0 1,0-1,-1 1,1-1,0 0,0 0,-1 1,1-1,-1 0,0 0,1 0,-1 0,0 0,0 1,0-1,0 0,-1-2,0 2,0 0,0 0,0 0,0 1,-1-1,1 0,0 1,-1-1,0 1,1 0,-1-1,0 1,1 0,-1 0,0 0,-3-1,-5-1,0 0,1 0,-1 1,0 0,0 1,-1 0,-11 0,-3 4,0 1,0 1,0 1,0 2,1 0,0 1,1 2,0 0,-33 23,43-26,2 0,-1 1,1 1,-19 21,25-25,0 1,0 0,1 0,0 0,0 0,1 1,0-1,0 1,0 0,0 9,2-15,1 0,-1 1,1-1,0 0,0 0,0 1,0-1,1 0,-1 1,1-1,-1 0,1 0,0 0,0 1,0-1,0 0,0 0,0 0,1-1,1 3,0-1,-1-1,1 0,0 0,1 0,-1 0,0 0,0-1,1 1,-1-1,1 0,5 1,4 0,-1-1,1 0,0-1,-1-1,1 0,18-3,-12 0,-1-1,1-1,-1 0,0-2,-1 0,1-1,-1 0,-1-1,0-1,-1-1,0 0,-1-1,0-1,-1 0,0-1,-1 0,-1-1,-1 0,0-1,-1 0,9-22,-17 35,1 0,-1 0,0 0,0-1,0 1,-1 0,1 0,-1-1,0 1,-1 0,1 0,-1-1,1 1,-1 0,-3-8,2 9,0 0,0 0,0 0,0 0,-1 1,1-1,-1 1,0-1,0 1,0 0,0 0,0 0,0 1,0-1,-1 1,1-1,-1 1,1 0,-5 0,-2-1,-1 1,1 0,0 1,-1 0,1 0,0 1,-1 1,1 0,0 0,0 1,-15 6,7-1,0 0,1 1,1 1,-1 1,-18 15,17-9,0 0,0 0,2 2,-17 23,24-28,1 0,0 0,1 0,0 1,1 0,0 1,-3 21,8-33,0 1,0 0,1-1,0 1,0 0,0-1,1 1,-1 0,1-1,0 1,1 0,-1-1,1 1,0-1,0 0,0 0,0 0,4 4,-1-1,1-1,0 0,0-1,1 0,0 0,0 0,0-1,0 0,12 5,-10-5,0-1,0 0,0 0,0-1,1 0,-1-1,1 0,-1-1,1 1,-1-2,1 1,-1-2,1 1,-1-1,0 0,0-1,0 0,0-1,0 0,0 0,-1-1,0 0,0 0,9-9,-13 10,0-1,0 0,-1 0,0 0,0-1,0 1,0-1,-1 1,0-1,0 0,-1 0,1 0,-1 0,-1 0,1 0,-1 0,-1-11,1 11,-1 1,1 0,-1 0,-1 0,1 0,-1 0,0 1,0-1,0 0,0 1,-1-1,0 1,0 0,0 0,0 0,-1 0,0 1,0-1,0 1,0 0,-6-4,-3 2,0 0,0 1,0 0,0 1,-1 1,1 0,-1 1,0 0,1 1,-1 0,0 1,-26 6,12-1,0 2,1 1,-1 1,2 1,-31 18,30-13,1 1,0 2,2 0,0 2,1 0,-35 43,43-45,1 1,1 0,0 1,2 1,0-1,2 2,0 0,1 0,-5 29,12-47,0 0,0 0,0-1,1 1,0 0,0 0,0 0,1 0,0 0,-1-1,2 1,-1 0,0-1,1 1,0-1,0 1,4 5,-6-10,0 1,1-1,-1 0,0 1,0-1,0 1,1-1,-1 0,0 1,1-1,-1 0,0 1,1-1,-1 0,0 0,1 1,-1-1,1 0,-1 0,1 0,-1 0,0 1,1-1,-1 0,1 0,-1 0,1 0,-1 0,1 0,-1 0,1 0,-1 0,0 0,1-1,-1 1,1 0,-1 0,1 0,-1 0,0-1,1 1,-1 0,1 0,-1-1,0 1,1 0,-1-1,0 1,0 0,1-1,-1 1,0-1,0 1,1 0,-1-1,0 1,0-1,0 1,0-1,0 1,1 0,-1-1,0 1,0-2,1-2,0-1,0 0,0 0,-1-10,0 0,-2 1,0 0,0 0,-9-25,9 34,1 1,-1 0,1 0,-1 0,0 0,-1 0,1 0,-1 1,1-1,-1 1,0-1,-1 1,1 0,-1 0,1 1,-1-1,0 1,0-1,-6-1,8 3,-1 1,1 0,-1 0,1 0,-1 0,1 0,-1 0,1 1,-1-1,1 1,0 0,-1-1,1 1,0 0,-1 0,1 1,0-1,0 1,0-1,0 1,0-1,0 1,1 0,-1 0,0 0,1 0,-2 3,-3 4,1-1,0 1,1 0,0 1,-4 13,5-12,0-1,1 1,1 0,-1 0,2-1,-1 1,2 0,-1 0,1 0,1 0,0 0,1-1,0 1,0-1,1 0,1 0,-1 0,2 0,-1-1,1 0,1 0,0 0,0-1,0 0,1-1,1 1,16 10,-13-11,1 0,0-1,0-1,1 0,-1-1,1-1,0 0,0-1,0 0,0-1,1 0,-1-2,0 1,0-2,0 0,0-1,0 0,0-1,19-8,-18 6,0-1,0 0,-1-1,-1 0,1-1,-1-1,-1 0,0-1,0 0,-1-1,-1-1,0 1,0-1,-2-1,1 0,11-29,-13 23,-1 0,-1-1,-1 0,-1 0,-1 0,-1-1,-2-35,1 53,-1 0,1 0,-1 0,0 0,0 0,0 0,-1 0,1 0,-1 0,0 1,0-1,-1 0,1 1,-1 0,1 0,-1 0,0 0,-4-3,4 4,0 0,0 0,0 1,-1 0,1-1,0 1,-1 1,1-1,-1 0,1 1,-1-1,1 1,-1 0,1 0,-1 1,1-1,-1 1,1 0,-1 0,1 0,-5 2,-2 2,0 0,0 1,0 1,1-1,0 2,0-1,1 1,0 0,0 1,1 0,-10 14,6-6,1 1,1 0,0 0,2 1,-11 35,12-26,1 0,1 0,1 1,2-1,1 1,1-1,7 48,-6-70,-1 0,1 0,0 0,1-1,-1 1,1 0,0-1,1 0,-1 0,6 5,-8-8,1 0,-1 0,1-1,0 1,0-1,0 0,0 1,0-1,0 0,0 0,0 0,0 0,0-1,1 1,-1-1,0 1,1-1,-1 0,0 0,1 0,-1 0,0 0,1 0,-1-1,0 1,0-1,1 0,-1 1,4-3,-3 0,1 1,-1-1,0 0,1 1,-1-2,-1 1,1 0,0-1,-1 1,0-1,0 1,0-1,0 0,2-8,1-6,0 1,2-21,-5 19,0 1,-1 0,-1 0,-1-1,-1 1,-6-29,6 35,-1 1,-1 0,0 0,0 0,-1 0,-1 0,0 1,0 0,-1 1,0-1,-12-11,16 18,0 1,1-1,-1 1,-1 0,1 0,0 0,0 0,-1 0,1 1,-1-1,1 1,-1 0,0 0,0 1,1-1,-1 1,0 0,0 0,1 0,-1 0,0 1,-4 0,4 0,1 1,-1-1,1 1,0 0,0 0,0 0,0 1,0-1,0 1,0-1,1 1,-1 0,1 0,0 0,0 0,0 1,0-1,1 0,-1 1,1-1,0 1,-1 4,0 2,0-1,1 1,0-1,1 1,0 0,1 0,0-1,0 1,1-1,0 1,0-1,1 1,1-1,0 0,0-1,0 1,1-1,8 10,-6-9,0 1,1-2,1 1,-1-1,1-1,0 0,1 0,0 0,0-1,0-1,1 0,0 0,0-1,21 5,-29-8,0-1,0 1,0-1,0 0,0 0,0 0,0 0,0 0,0-1,0 1,0-1,-1 0,1 0,0 0,0 0,-1 0,1-1,0 1,-1-1,0 0,1 0,-1 0,0 0,0 0,0 0,3-4,-3 3,0-1,0 0,-1-1,1 1,-1 0,1 0,-1-1,-1 1,1 0,-1-1,1 1,-1-1,-1 1,1-1,-1 1,1 0,-3-6,-2-7,-2 1,0 0,0 0,-2 1,0 0,0 0,-1 1,-1 0,-1 1,0 0,0 1,-2 0,-20-14,28 23,0 0,0 0,0 1,0 0,0 0,0 0,0 1,0 0,-13 0,17 0,1 1,-1 0,0 0,0 1,1-1,-1 0,0 1,1-1,-1 1,0-1,1 1,-1 0,1 0,-1 0,1 0,-1 0,1 0,0 0,-1 0,1 0,0 1,0-1,0 0,0 1,0-1,0 1,0-1,0 1,1 0,-1-1,1 1,-1 0,1-1,0 1,0 0,-1 0,1-1,0 1,1 3,0 1,0-1,0 1,1-1,-1 1,1-1,1 0,-1 0,1 0,0 0,0 0,0-1,0 1,1-1,5 5,-4-4,0 0,0-1,1 1,-1-1,1-1,0 1,0-1,1 0,-1 0,0-1,10 3,-13-5,0 0,0 0,1 0,-1 0,0 0,0-1,0 1,0-1,0 0,0 0,0 0,0-1,-1 1,1-1,0 1,-1-1,1 0,-1 0,1 0,-1 0,0-1,0 1,0-1,3-4,1-2,-1 0,0-1,-1 1,1-1,-2 0,4-12,-2-2,-1 0,0 0,-1-27,-2 39,-2-1,1 1,-2-1,0 1,0 0,-1-1,-8-21,9 32,1-1,0 1,0-1,-1 1,0-1,1 1,-1 0,0 0,0 0,0 0,0 0,-1 0,1 1,-1-1,-2-1,4 3,0 0,0-1,0 1,0 0,1 0,-1 0,0 0,0 0,0 0,0 0,0 0,1 0,-1 0,0 1,0-1,0 0,0 1,1-1,-1 0,-1 1,1 0,0 1,0-1,-1 0,1 0,0 1,0-1,0 1,1-1,-1 1,0-1,0 1,1 0,-1 2,-1 5,0-1,0 1,1 0,1 0,-1 0,1-1,1 1,0 0,0 0,1 0,0-1,0 1,1-1,0 1,0-1,1 0,9 14,-9-17,0 0,0 0,0 0,1 0,0-1,0 1,0-1,0-1,0 1,1-1,0 0,0 0,0 0,0-1,0 0,0 0,1 0,-1-1,1 0,-1-1,1 1,-1-1,1 0,11-3,-11 2,0-1,-1 0,1-1,-1 1,1-1,-1-1,0 1,0-1,-1 0,1 0,-1-1,0 1,0-1,0-1,-1 1,0 0,0-1,0 0,0 0,-1 0,3-9,2-6,0-1,-2 0,0 0,-2-1,3-26,-6 34,-1 0,0 1,0-1,-2 1,0-1,0 1,-2-1,0 1,0 0,-1 1,-8-16,10 23,-1 0,1-1,-1 1,-1 1,1-1,-1 1,0-1,0 1,0 1,-1-1,0 1,0 0,0 0,0 0,-1 1,1 0,-1 1,0-1,0 1,0 1,0-1,0 1,0 0,-10 0,10 2,0-1,1 1,-1 1,0-1,0 1,1 0,-1 0,1 1,-1 0,1 0,0 1,0-1,1 1,-1 1,1-1,0 1,0 0,0 0,0 0,1 1,0-1,1 1,-1 0,1 1,0-1,-3 10,3-9,1 0,0 1,0 0,1-1,0 1,1 0,-1-1,1 1,1 0,0 0,0-1,0 1,1 0,0-1,0 0,1 1,0-1,0 0,1 0,0-1,0 1,1-1,7 9,-5-8,1-1,0 1,0-2,0 1,1-1,0-1,0 1,0-1,0-1,1 0,-1 0,1-1,0 0,-1-1,13 1,-14-2,0 0,0 0,0-1,0 0,0 0,-1-1,1 0,0 0,-1-1,0 0,1-1,-1 1,0-1,-1 0,1-1,-1 0,0 0,0 0,6-7,-6 3,1 1,-1-1,-1 0,0-1,0 0,-1 1,0-2,0 1,-1 0,-1-1,0 1,0-1,-1 1,0-20,-2 21,0 0,0-1,-1 1,0 0,-1 0,0 0,0 0,-1 0,0 1,0 0,-1 0,0 0,-1 0,0 1,0 0,-13-12,9 11,-1 0,1 0,-1 1,-1 0,-14-6,18 10,1 1,-1-1,1 1,-1 1,0-1,0 1,0 0,0 1,-13 1,18-1,0 1,0-1,1 1,-1 0,1 0,-1 0,1 0,-1 1,1-1,-1 0,1 1,0 0,0 0,0-1,0 1,0 0,0 0,1 1,-1-1,1 0,-1 1,1-1,0 1,0-1,0 1,0-1,1 1,-1 0,1-1,-1 1,1 0,0 4,0 0,0 0,0 0,1-1,0 1,0 0,1 0,0-1,0 1,0-1,1 0,0 1,5 6,0-3,0 0,1 0,1-1,0-1,0 1,0-2,1 1,0-1,20 9,-21-12,0 0,0 0,0-1,0 0,0-1,0 0,1-1,-1 0,1 0,0-1,-1-1,16-2,-21 2,-1 0,0 0,0-1,0 0,0 0,0 0,0 0,0 0,-1-1,1 0,-1 1,0-1,0-1,4-3,-3 1,0 0,-1 0,0 0,0-1,0 1,0-1,-1 0,1-7,0-8,0 0,-2 0,0 0,-4-34,-3 15,-2 0,-1 1,-2 0,-17-39,13 38,1-1,3 0,-10-63,18 69,1-62,3 83,0 1,1-1,1 1,0 0,1 0,0 0,9-16,-12 27,1 0,-1 0,1 0,0 0,0 0,0 0,1 1,-1-1,1 1,-1 0,1 0,0 0,0 0,0 0,0 0,0 1,0-1,1 1,-1 0,5-1,2 1,1 0,-1 1,1 1,-1-1,14 4,-10-2,0-1,25 0,-35-1,0-1,0 0,0 1,1-1,-1-1,0 1,-1 0,1-1,0 0,0 0,-1 0,1-1,4-3,1-3,0-1,-1 0,0 0,-1-1,0 0,-1-1,0 1,7-22,-2 3,-2-1,7-45,-12 53,-1-1,-2 0,0 0,-2 0,-5-40,3 50,1 1,-2 0,0 0,-1 0,0 0,0 1,-2 0,1 0,-2 0,0 1,-14-17,19 26,0-1,0 0,0 1,0-1,0 1,-1 0,-4-2,7 4,1-1,-1 1,0 0,0 0,0-1,0 1,1 0,-1 0,0 0,0 0,0 0,0 0,1 0,-1 0,0 0,0 1,0-1,0 0,1 0,-1 1,0-1,0 1,1-1,-1 1,0-1,1 1,-1-1,0 1,1-1,-1 1,1 0,-1-1,1 1,-1 0,1 0,0-1,-1 1,1 0,0 0,-1-1,1 1,0 1,-2 7,0 0,1 0,0 0,1 0,0 1,2 14,11 58,-8-59,1 0,0 0,17 36,-20-52,0-1,0 0,0 0,1 0,0 0,1-1,-1 0,1 0,0 0,0 0,0-1,1 1,0-1,0-1,0 1,13 4,-17-7,1 0,-1 0,1-1,-1 1,1-1,-1 1,1-1,-1 0,1 0,-1 0,1-1,-1 1,1 0,-1-1,1 0,-1 0,1 1,-1-1,0-1,1 1,-1 0,0-1,0 1,0-1,0 1,0-1,0 0,-1 0,1 0,0 0,-1 0,0 0,1-1,-1 1,0 0,0-1,1-4,0-1,1-1,-2-1,1 1,-1 0,-1 0,1 0,-2-1,1 1,-3-12,-1 1,-1 1,-1 0,-1 1,0 0,-2 0,0 0,0 1,-2 0,0 1,-1 0,-20-20,28 32,-1 0,1 1,-1 0,0-1,0 2,0-1,0 0,0 1,-6-2,9 4,-1-1,0 0,1 1,-1 0,0 0,1 0,-1 0,0 0,1 0,-1 1,1-1,-1 1,1 0,-1 0,1 0,-1 0,1 0,0 0,-1 1,1-1,0 1,-3 2,-4 6,0 0,0 1,1 1,1-1,0 1,0 0,1 1,1 0,0 0,0 0,-2 16,1-2,2 0,1 0,1 0,2 50,2-54,0 0,2 0,1 0,0-1,2 0,0 0,2 0,15 28,-19-41,1-1,-1 1,1-1,1 0,0-1,0 0,0 0,1 0,0-1,0 0,1 0,-1-1,1 0,1-1,-1 0,0 0,1-1,0 0,0-1,0 0,16 1,-14-3,0-1,0 0,0-1,0-1,0 1,0-2,-1 1,0-2,0 0,0 0,0-1,-1 0,0-1,14-11,1-3,-1-2,-1 0,-2-1,24-34,-27 32,-1-1,-1-1,-1 0,-2-1,-1-1,-1 0,-2 0,12-62,-19 72,0 0,-2-1,0 1,-1 0,-1 0,-6-31,4 36,-1 1,0 0,0 0,-2 1,1-1,-2 1,0 1,0 0,-17-19,16 22,1 1,-2 0,1 0,-1 1,0 0,-1 1,1 0,-1 1,-1 0,1 0,-1 1,1 1,-1 0,0 1,-14-1,17 2,1 1,-1 0,1 1,-1-1,0 2,1-1,0 1,-1 1,1 0,0 0,0 0,0 1,1 0,-1 1,1-1,0 2,0-1,1 1,0 0,0 0,0 0,-5 8,3-1,1-1,0 1,1 0,0 1,1 0,1 0,0 0,1 0,0 0,1 1,1-1,1 1,-1 0,4 20,0-15,0 0,1-1,1 0,1 0,0 0,2 0,0-1,1 0,1-1,12 17,-10-19,0 1,1-1,1-1,19 15,-26-24,0 1,1-1,0 0,0-1,0 0,1 0,-1-1,1 0,0-1,0 1,10 0,-14-3,-1 0,0 0,1 0,-1 0,0-1,1 1,-1-1,0-1,0 1,0 0,0-1,0 0,0 0,5-4,-3 2,-1 0,-1 0,1-1,-1 1,0-1,0-1,0 1,5-12,-2 4,-2-1,0 0,0 0,-2-1,0 0,0 1,0-27,-3 26,-2-1,1 0,-2 1,0-1,-1 1,-1 0,0 0,-1 0,0 1,-2 0,1 0,-2 1,0 0,0 0,-1 1,-1 0,-14-13,14 15,-1 0,0 0,-1 1,0 1,0 0,-1 0,1 1,-2 1,1 1,-1 0,0 1,0 0,0 1,0 1,-1 0,1 2,-27 1,35-1,1 1,-1 1,1-1,0 1,-1 0,1 1,0 0,0 0,1 0,-1 0,1 1,-1 0,1 0,0 0,1 1,-9 10,7-6,1 0,-1 0,2 0,0 1,0 0,0 0,1 0,1 0,0 0,-1 12,-2 35,3 0,8 83,-6-134,1 0,0-1,0 1,0-1,1 1,0-1,0 1,4 6,-5-11,0 1,0-1,0 1,0-1,1 1,-1-1,0 0,0 0,1 0,-1 0,1 0,-1 0,1 0,-1 0,1-1,0 1,-1 0,1-1,0 1,-1-1,1 0,0 0,0 0,-1 1,1-2,0 1,0 0,-1 0,1 0,0-1,3-1,1 0,1-2,-1 1,1-1,-1 0,-1 0,1 0,0-1,-1 0,0 0,6-8,2-4,0-2,12-21,-10 9,0 0,-3-1,0 0,-2-1,-2 0,6-40,-7 16,-2 0,-6-111,1 160,-1-1,0 1,0 0,-1 0,0 0,0 0,-1 1,0-1,-7-12,7 16,1 1,-1 0,0-1,0 1,0 1,-1-1,1 0,-1 1,1 0,-1-1,0 1,0 1,0-1,0 1,0-1,0 1,0 0,0 1,-1-1,-4 1,5-1,-1 1,0 1,1-1,-1 1,0 0,1 0,-1 0,0 0,1 1,0 0,-1 0,1 0,0 0,0 1,0 0,0 0,1 0,-1 0,1 0,0 1,0-1,0 1,0 0,1 0,-3 6,-3 5,1 1,0 1,2 0,0 0,-5 27,5-13,1 0,0 36,4-52,1 1,0-1,1 0,1 0,0 0,8 20,-10-31,1 0,0 0,0 0,0-1,1 1,-1-1,6 6,-7-8,-1 0,1-1,0 1,-1-1,1 1,0-1,0 1,0-1,-1 1,1-1,0 0,0 0,0 1,0-1,-1 0,1 0,0 0,0 0,0 0,0 0,0 0,0 0,0 0,-1 0,1-1,0 1,0 0,0 0,0-1,-1 1,1-1,0 1,0-1,-1 1,1-1,0 1,-1-1,1 0,0 1,-1-1,1 0,0-1,3-4,-1 0,0-1,0 1,0-1,-1 0,1 0,-2 0,1 0,-1 0,0 0,-1-1,0-10,-1-6,-1 0,-7-37,4 40,-1-1,0 1,-2 0,0 0,-1 1,-2 0,0 1,-19-27,20 35,1-1,-2 1,1 1,-2 0,1 0,-1 1,0 1,-1 0,0 1,-1 0,1 1,-1 0,-24-6,14 7,0 1,0 1,-48 0,57 3,0 1,0 1,0 0,1 1,-1 1,1 0,-25 12,36-15,1 0,-1 0,1 1,0-1,-1 1,1-1,0 1,0 0,0 0,0 0,0 0,1 0,-1 0,1 1,-1-1,1 1,0-1,0 1,0-1,0 1,0 0,0 2,1-1,0 0,1 0,-1-1,1 1,-1 0,1-1,0 1,1-1,-1 1,1-1,-1 0,1 0,0 1,0-1,5 5,-1-2,0-1,0 1,0-1,1 0,0-1,0 0,0 0,0 0,1-1,0 0,-1 0,1-1,15 3,2-2,1 0,-1-2,30-2,-47 1,0 0,-1-1,1 0,0-1,-1 0,1 0,-1 0,0-1,0 0,0 0,0-1,9-7,-10 6,-1 0,0 0,0-1,0 1,-1-1,0 0,0 0,-1-1,0 1,0-1,0 0,-1 0,3-11,-1-1,-2 0,0-1,-1 1,-1-1,0 0,-2 1,0-1,-2 1,0 0,-1 0,0 0,-2 1,0 0,-2 0,0 0,-13-18,7 12,-1 2,-1 0,-1 1,-1 0,-1 2,0 0,-2 2,0 0,-1 1,-48-24,58 34,0 1,0 0,0 1,0 1,-1 0,0 0,0 2,1 0,-1 0,0 1,0 1,-24 4,34-4,1 0,-1 1,1 0,0-1,-1 1,1 1,0-1,0 0,0 1,0-1,1 1,-1 0,1 0,0 0,0 0,0 0,0 1,-3 6,1 0,0-1,1 1,0 1,1-1,-3 18,4-15,1 1,1 0,0 0,1-1,0 1,1-1,0 0,1 1,1-1,0-1,1 1,0-1,1 0,0 0,1-1,12 14,-13-17,0-1,0 1,1-1,0-1,1 0,-1 0,1-1,0 0,1 0,-1-1,1 0,0-1,0 0,0 0,0-1,1-1,-1 0,0 0,1-1,-1 0,1-1,10-1,-8-2,0 1,0-2,-1 0,0 0,0-1,0 0,-1-1,0-1,0 0,-1 0,1-1,-2 0,0-1,0 0,-1-1,12-17,-9 10,-2 1,0-1,0-1,-2 1,0-2,-1 1,-1 0,-1-1,-1 0,1-28,-4 33,0 1,-2 0,1-1,-2 1,0 0,-1 0,0 0,-1 1,0-1,-1 1,-1 1,0-1,-10-13,5 11,0 1,-1 1,0 0,-1 0,-1 1,0 1,0 1,-1 0,-25-12,19 13,-1 0,1 2,-1 0,0 1,-1 2,0 0,-30 0,34 3,0 2,0 0,0 1,0 2,1-1,-1 2,1 1,-34 14,33-10,0 0,1 1,0 1,-31 26,43-32,1 1,-1 0,1 1,0-1,1 1,0 0,0 1,1-1,0 1,0 0,1 0,0 0,-3 17,5-16,0-1,0 1,0-1,2 1,-1-1,1 0,0 1,1-1,4 15,-4-21,-1 1,1-1,0 1,0-1,0 1,0-1,1 0,-1 0,1 0,0-1,0 1,0 0,0-1,0 0,1 0,-1 0,1 0,-1-1,1 1,0-1,-1 0,1 0,0 0,0 0,6 0,-1-1,0 0,-1-1,1 0,-1 0,1-1,0 0,-1-1,0 1,0-1,15-9,-14 7,1-1,-1 0,-1 0,1-1,-1 0,0-1,-1 1,10-14,-10 10,0 1,-1-1,0-1,0 1,-2-1,1 0,-1 0,-1-1,0 1,-1-1,-1 1,0-1,0 0,-1 0,-1 1,0-1,-1 0,0 1,-1-1,0 1,-1 0,0 0,-1 0,-1 1,0-1,0 1,-1 1,0-1,-1 1,0 0,-1 1,-15-13,5 7,-1 2,0 0,-1 1,-1 1,0 1,0 1,-1 1,0 1,0 0,-1 2,1 1,-1 1,0 1,-43 3,56 0,0 0,0 1,1 1,-1 0,1 1,-1 0,1 0,0 1,1 0,-17 12,14-7,0 0,1 1,0 0,0 1,2 0,-1 1,-6 13,2-1,2 1,1 0,1 0,1 1,1 0,1 0,2 1,-2 29,6-50,1 0,-1 1,2-1,-1 0,1 0,0 0,0 1,1-1,0 0,3 6,-4-10,1 0,-1-1,1 0,0 1,0-1,0 0,0 0,0 0,1 0,-1 0,0 0,1-1,-1 1,1-1,0 0,0 1,-1-1,1-1,0 1,0 0,0-1,0 1,0-1,0 0,0 0,5-1,-3 1,-1-1,1 0,-1 0,0 0,1-1,-1 0,0 1,0-1,0-1,0 1,0-1,-1 1,1-1,-1 0,0 0,1-1,-1 1,-1-1,1 0,0 1,3-9,1-3,0 0,-2 0,1 0,5-29,-8 26,0 0,-1 0,-1 0,0 0,-2-1,0 1,-1 0,-5-23,5 32,-1 1,1-1,-2 1,1-1,-1 1,-1 0,1 0,-1 1,-1-1,1 1,-1 0,0 1,-1-1,0 1,0 1,0-1,-1 1,-13-7,7 6,-1 1,-1 0,1 1,-1 1,1 0,-1 1,0 1,0 0,0 2,0-1,-16 4,5 1,0 0,1 2,0 1,0 0,-42 22,51-21,0 1,1 1,0 0,1 1,0 1,1 1,-22 26,29-32,0 1,1 0,0 1,1 0,0-1,1 1,0 1,0-1,1 1,1 0,-1-1,2 1,-1 0,2 0,0 13,0-19,1 0,0 0,0-1,1 1,-1 0,1 0,0-1,0 1,1-1,-1 0,1 1,0-1,0 0,0-1,1 1,-1-1,1 1,0-1,0 0,0 0,0-1,1 1,-1-1,1 0,-1 0,1 0,6 0,0 1,-1-1,1 0,0-1,-1 0,1-1,0 0,0-1,0 0,0 0,-1-2,18-4,-11-1,0 1,0-2,-1 0,0-1,-1-1,0 0,-1-1,0-1,18-22,-12 11,-1-2,-1 0,-1-1,24-52,-35 65,0-1,-1 1,-1-1,0 0,-1 0,2-29,-5 37,0 0,0 0,-1 0,0 0,0 0,-1 0,0 0,0 1,0-1,-1 1,0-1,0 1,0 0,-1 0,0 0,-1 1,-6-8,0 4,-1 0,0 1,0 0,0 1,-1 1,0 0,0 1,0 0,-1 1,-26-5,0 3,0 1,-67 2,41 6,1 3,1 3,-1 3,2 2,0 3,0 3,-89 42,128-51,1 1,-1 1,2 1,-25 20,41-29,0 1,0 0,0 1,1-1,0 1,0 0,-5 11,8-13,0 0,0 0,0 0,1 0,0 1,0-1,0 0,1 1,0-1,0 0,0 1,2 9,-1-12,0 1,1-1,-1 0,1 0,-1 0,1 0,0 0,0 0,0 0,1-1,-1 1,0-1,1 0,0 1,0-1,0-1,0 1,0 0,0-1,0 1,0-1,0 0,1 0,5 1,8 1,0 0,1-1,24 0,-42-2,18-1,0 0,0-1,0-1,0-1,-1 0,1-1,-1-1,0-1,-1 0,0-1,0-1,-1-1,0 0,0 0,-1-2,-1 0,0 0,20-26,-29 32,1 0,-2 0,1 0,0 0,-1-1,-1 0,1 0,-1 1,0-1,0-1,-1 1,0 0,0-9,-1 11,-1 0,0 0,1 0,-2 1,1-1,0 0,-1 0,0 1,0-1,-1 1,1-1,-1 1,0 0,0 0,0 0,-1 1,1-1,-1 1,-6-5,-2 0,-1 1,1 0,-1 1,-1 1,1 0,-1 1,0 0,0 1,-22-2,-14 0,-66 4,76 2,1 3,0 1,0 1,0 3,0 1,-66 27,82-27,0 1,0 1,1 1,1 1,0 1,1 1,0 1,2 0,0 1,1 1,-24 35,36-45,0 0,1 1,0-1,0 1,1 0,1 0,-1 1,0 14,3-20,0-1,0 1,0-1,0 1,1-1,0 1,0-1,0 1,3 6,-3-9,0 0,1 0,-1 1,1-1,-1-1,1 1,0 0,-1 0,1-1,0 1,0-1,0 1,0-1,1 0,-1 0,0 0,0 0,4 1,-4-2,0 1,0-1,-1 0,1 0,0 0,0 0,-1 0,1-1,0 1,0 0,-1-1,1 1,0-1,-1 0,1 0,0 1,-1-1,1 0,-1 0,0-1,1 1,-1 0,0 0,0-1,1 1,-1 0,0-1,0 1,-1-1,1 0,0 1,0-1,0-2,1-3,0 1,0-1,0 0,-1 1,0-1,0 0,-1-11,-1 8,-1 1,0-1,-1 1,0-1,0 1,-1 0,0 1,-1-1,0 1,0-1,0 2,-1-1,-13-12,3 4,-1 0,-1 1,-1 2,-34-21,26 20,0 2,-2 0,1 2,-1 1,-1 1,1 2,-39-4,17 6,0 2,0 3,-79 10,74-2,1 3,0 2,0 2,2 3,-99 49,111-46,2 2,0 1,2 2,0 2,2 1,2 2,-51 61,76-82,-1 1,1 0,1 1,0 0,1 0,1 0,0 1,-4 18,7-25,1 1,0-1,0 1,1-1,0 1,1-1,-1 1,2-1,-1 0,1 1,0-1,0 0,1 0,0 0,0 0,1-1,6 10,0-3,1-1,0-1,1 0,0 0,1-1,0-1,0 0,1-1,0-1,1 0,18 6,5 0,1-2,0-1,53 5,-42-9,84-1,-103-7,1 0,0-2,60-16,-76 15,0-1,0 0,0-2,-1 1,0-2,0 0,-1-1,19-16,-23 17,-1-1,0-1,0 1,-1-2,-1 1,0-1,0 0,-1 0,-1-1,0 0,6-23,-9 24,1 0,-2 0,1 0,-2-1,1 1,-2 0,0 0,0 0,-1 0,0 0,-1 0,-1 0,0 1,0 0,-1-1,-1 2,0-1,0 1,-1-1,0 2,-1-1,0 1,0 0,-1 1,0 0,-1 0,0 1,0 1,0-1,-1 2,0-1,-20-6,17 8,-1 1,1 1,0 0,-1 0,1 2,-1 0,1 0,-1 2,1-1,0 2,0 0,0 1,0 0,0 1,1 1,-1 0,-12 8,-3 4,1 1,1 1,0 1,2 2,0 0,-24 31,33-35,1 1,1 0,1 1,1 1,1-1,0 2,2 0,-8 26,14-36,1-1,0 1,1-1,0 1,0 0,2-1,2 21,-1-23,0-1,1 0,0 0,0 0,1 0,0-1,0 0,1 0,1 0,-1 0,8 8,-4-8,0 0,1 0,-1-1,1-1,1 0,-1 0,1-1,0 0,0-1,0 0,1 0,0-2,-1 1,18 0,-17-2,0 0,0-1,0 0,0-1,0 0,0-1,0-1,-1 0,1 0,-1-1,0 0,0-1,0-1,14-9,-12 5,0-1,-1-1,-1 0,0-1,-1 0,0-1,-1 0,0 0,-1-1,-1 0,0-1,-1 0,-1 0,0 0,3-27,-5 24,-1 0,-1 0,-1 0,0-1,-2 1,0 0,-1 0,-1 0,0 0,-2 1,0 0,-1 0,-14-24,14 30,-1 0,-1 0,0 1,0 0,-1 1,0 0,-1 1,0 0,-20-12,13 11,0 1,-1 0,0 2,-1 0,0 1,-21-4,4 5,0 1,0 1,-1 3,1 1,0 1,-70 15,78-11,0 2,1 1,0 1,0 1,1 2,1 0,0 2,-24 19,36-23,0 0,1 0,1 2,0 0,1 0,0 1,1 0,1 1,0 0,1 0,0 1,2 0,-1 1,-6 30,11-35,0 0,1 1,0-1,0 0,2 1,-1-1,2 0,0 1,0-1,1 0,0 0,1-1,1 1,0-1,0 0,1 0,0 0,1-1,0 0,1 0,0-1,1 0,0 0,18 13,-7-9,1 0,0-1,0-2,1 0,1-1,37 10,-6-7,100 10,-95-18,0-2,0-2,0-3,69-13,-100 12,0-2,-1-2,0 0,0-2,-1-1,0 0,-1-3,0 0,-1-1,39-32,-49 34,-1-1,0 0,-1-1,-1 0,0-1,-1 0,-1 0,0-1,-2 0,9-27,-12 30,-1 0,0 0,-1-1,-1 1,0 0,-1-1,0 1,-2 0,1-1,-2 1,0 0,0 0,-2 0,-6-16,4 15,-1 0,0 0,-1 1,0 0,-2 1,1 0,-1 1,-1 0,0 0,-1 1,0 1,-1 0,0 1,0 1,-1 0,0 1,-1 0,1 1,-1 1,0 1,-19-3,-31-1,-1 2,0 4,-127 12,189-9,0-1,0 1,0 0,0 1,1-1,-1 1,1 0,-1 0,1 0,0 1,0 0,0-1,0 2,0-1,-3 4,3-2,0 0,1 0,-1 0,1 1,0-1,1 1,-1 0,1 0,0 0,1 0,-2 7,1 1,0 0,1-1,0 1,1 0,2 15,-1-23,0 0,1 0,-1 0,1 0,1 0,-1-1,1 1,0-1,0 1,0-1,1 0,0 0,7 7,-6-8,0 0,0 0,1 0,-1-1,1 0,0 0,0 0,0-1,0 0,0 0,0 0,1-1,-1 0,0 0,1 0,-1-1,1 0,-1-1,1 1,-1-1,1 0,-1-1,0 0,0 0,0 0,0 0,0-1,0 0,-1-1,1 1,-1-1,0 0,0 0,0-1,-1 1,1-1,-1 0,0 0,-1-1,1 1,-1-1,0 1,0-1,2-9,-3 6,1 0,-2-1,1 1,-2-1,1 1,-1-1,0 1,-1-1,0 0,-1 1,0 0,0-1,-1 1,-1 0,1 0,-1 1,-1-1,-6-9,5 7,-2 1,1 0,-1 1,0 0,-1 0,0 0,-1 1,0 1,0 0,0 0,-1 1,0 0,-22-8,14 10,0 1,-1 1,1 0,0 2,-1 0,-21 3,-20 0,54-3,0 0,-1 1,1 0,0 0,0 0,0 1,0 0,1 1,-10 4,13-5,0-1,0 2,0-1,0 0,0 0,1 1,-1 0,1-1,0 1,0 0,0 0,0 1,0-1,0 0,1 0,0 1,-1-1,1 1,1-1,-2 5,2-7,0 1,-1-1,1 0,0 0,0 1,0-1,0 0,0 0,0 1,0-1,0 0,1 0,-1 1,0-1,1 0,-1 0,1 0,-1 0,1 0,0 1,-1-1,1 0,0 0,0-1,0 1,0 0,0 0,0 0,0-1,0 1,0 0,0-1,0 1,0-1,0 1,1-1,-1 1,2-1,0 0,0 0,0 0,0 0,0 0,-1-1,1 1,0-1,0 0,0 0,0 0,-1 0,1 0,0-1,-1 1,4-3,6-7,-1 1,-1-2,0 1,0-2,-1 1,-1-1,0 0,-1-1,0 0,-1 0,0 0,-2-1,1 0,-2 0,0 0,1-31,-3 43,-1 0,0 1,-1-1,1 0,0 0,-1 1,0-1,1 0,-1 1,0-1,0 1,-1-1,1 1,-1-1,1 1,-1 0,1 0,-1-1,0 1,-4-2,3 2,0 0,0 0,-1 0,1 1,0 0,-1 0,1 0,-1 0,1 0,-1 1,0-1,1 1,-1 0,-4 0,3 1,1-1,0 1,-1-1,1 1,0 0,0 1,0-1,0 1,0 0,0 0,0 0,0 0,1 1,-1-1,1 1,0 0,0 0,0 0,0 1,0-1,1 1,-1 0,1-1,0 1,0 0,1 0,-2 5,1 2,0 0,1 0,0 1,1-1,0 0,1 0,1 0,-1 0,5 12,-6-21,1-1,0 1,0 0,0 0,0-1,0 1,1-1,-1 1,0-1,1 1,-1-1,1 0,0 0,-1 0,1 0,0 0,0 0,-1 0,1 0,0-1,0 1,0-1,0 1,0-1,0 0,0 0,0 0,0 0,0 0,0 0,0-1,3 0,0 0,0-1,0 0,0 0,0 0,-1 0,1-1,-1 0,1 0,-1 0,0 0,4-5,-4 4,-1 0,0 0,0-1,-1 1,1-1,-1 1,3-7,-5 9,1-1,0 1,0-1,-1 1,0-1,1 1,-1-1,0 0,0 1,0-1,-1 1,1-1,-1 0,1 1,-1-1,-1-2,2 5,0 0,0-1,0 1,0-1,0 1,-1-1,1 1,0-1,0 1,0-1,-1 1,1 0,0-1,-1 1,1 0,0-1,-1 1,1 0,0-1,-1 1,1 0,-1 0,1-1,-1 1,1 0,0 0,-1 0,1-1,-1 1,1 0,-1 0,1 0,-1 0,1 0,-1 0,1 0,-1 0,1 0,-1 1,1-1,-1 0,1 0,0 0,-1 0,1 1,-1-1,1 0,-1 0,1 1,0-1,-1 0,1 1,0-1,-1 0,1 1,0-1,0 1,-1-1,1 0,0 1,0-1,-1 1,-1 3,0 0,1 0,-1-1,0 1,-1 8,1-2,1-1,0 1,0 0,1-1,0 1,1 0,3 14,-3-19,0-1,1 1,0-1,0 1,1-1,-1 0,1 0,0 0,0 0,0 0,0 0,1-1,-1 0,1 0,0 0,8 5,12 4,-1-1,2-1,-1-1,1-1,1-1,-1-1,1-1,0-2,0-1,1 0,-1-2,0-1,0-2,0 0,38-10,-38 6,0 0,-1-2,0-1,0-1,-1-1,0-1,-1-1,-1-1,0-1,-1-1,-1-1,0-1,-2 0,32-44,-44 55,-1-1,0 0,-1 1,0-1,-1-1,5-17,-7 24,-1 1,1-1,-1 0,0 0,0 1,0-1,0 0,0 0,-1 0,1 1,-1-1,1 0,-1 1,0-1,0 1,-1-1,1 1,0-1,-1 1,1 0,-1-1,0 1,0 0,0 0,0 1,0-1,0 0,-4-1,-4-2,0 1,0 0,-1 0,1 2,-1-1,0 1,0 1,-22-1,-1 2,-52 8,59-4,0 1,0 1,1 2,0 0,1 2,-1 0,2 2,0 1,-25 17,16-9,23-16,1 1,-16 12,22-16,1 1,0-1,-1 1,1-1,0 1,0 0,1 0,-1 0,1 0,-1 0,1 0,0 0,-1 5,1-3,0 0,1 0,-1 0,1 0,0 0,0 0,1 0,-1 0,1 0,0 0,1-1,-1 1,1 0,0-1,0 1,0-1,1 0,4 7,-3-7,0 0,0 0,0-1,1 1,-1-1,1 0,0 0,0-1,0 0,0 1,1-2,-1 1,0 0,1-1,-1 0,8 0,-10-1,1 1,0-1,0 0,-1 0,1-1,0 1,-1-1,1 0,-1 0,1 0,-1 0,1-1,-1 1,0-1,1 0,-1 0,4-4,-4 3,0 0,0-1,0 1,-1-1,1 0,-1 0,0 0,0 0,-1-1,1 1,-1 0,0-1,0 1,0-7,0 4,-1 0,0 0,0 0,0 0,-1 0,0 0,-1 0,-3-9,4 12,0 1,-1-1,1 1,-1 0,0-1,0 1,0 0,-1 0,1 1,-1-1,1 0,-1 1,0-1,0 1,0 0,-1 0,1 0,-4-1,-5-1,0 1,0 0,-1 1,1 1,-16-1,-67 5,51-1,26-2,0 1,0 1,0 1,-21 6,34-8,0 1,0 0,0 0,0 0,1 0,-1 1,1 0,-1 0,1 0,0 1,0-1,0 1,1 0,-1 0,1 0,0 1,0-1,-3 9,1-2,1 1,0-1,1 0,0 1,1 0,0 0,1 0,0 17,1-23,1-1,0 1,0-1,1 1,0-1,0 1,0-1,0 0,1 0,0 0,0 0,1 0,-1-1,1 1,0-1,0 0,0 0,0-1,8 6,-3-4,0 0,0 0,0-1,1 0,-1-1,1 0,0 0,17 2,-20-5,-1 1,1-1,-1 0,1 0,-1 0,1-1,-1 0,1-1,-1 1,0-1,0 0,0-1,0 1,9-6,-15 7,1 1,0 0,0-1,-1 1,1-1,0 1,-1-1,1 1,0-1,-1 0,1 1,-1-1,1 0,-1 1,1-1,-1 0,0 0,1 1,-1-1,0 0,0 0,1 0,-1 1,0-1,0 0,0 0,0 0,0 0,0 0,-1-1,0 1,0 0,0 0,0 0,0 0,0 0,0 0,0 0,0 0,0 0,-1 0,1 1,0-1,-3 0,-7-3,-1 0,1 1,-13-1,-7 0,0 2,-1 1,1 2,-1 1,1 1,0 1,0 2,0 2,1 0,-44 20,49-18,0-1,0-1,-1-1,-45 6,70-13,0 0,-1 0,1 0,0 0,0 1,0-1,-1 0,1 1,0-1,0 1,0-1,0 1,0 0,0-1,0 1,0 0,0 0,0 0,0 0,0 0,0 0,1 0,-1 0,0 0,1 0,-1 0,1 0,-1 0,1 0,0 1,-1-1,1 0,0 0,0 1,0-1,0 0,0 0,0 2,1 5,1 0,-1-1,1 1,6 14,-6-17,2 4,20 51,-21-54,0 0,1 0,-1-1,1 1,0-1,1 0,5 6,-10-11,0 0,0 1,1-1,-1 0,0 1,0-1,1 0,-1 0,0 1,1-1,-1 0,0 0,1 0,-1 1,0-1,1 0,-1 0,0 0,1 0,-1 0,1 0,-1 0,0 0,1 0,-1 0,1 0,-1 0,0 0,1 0,-1 0,0 0,1 0,-1-1,0 1,1 0,-1 0,0 0,1-1,-1 1,0 0,1 0,-1-1,0 1,0 0,1 0,-1-1,0 1,0 0,0-1,1 1,-1-1,0 0,1-1,-1 1,0-1,1 1,-1-1,0 0,0 1,0-1,0 1,-1-1,1 1,-1-3,-1 0,0 0,0 0,0 0,-1 0,1 0,-1 0,0 1,-1-1,1 1,0 0,-1 0,0 0,0 1,0-1,0 1,0 0,0 0,-8-2,-3-1,0 1,0 0,-1 1,-20-1,24 3,0 1,0 0,0 1,0 0,0 1,1 1,-1 0,1 0,-1 1,1 0,0 1,-14 9,19-11,1 1,-1 0,1 0,0 0,1 1,-1 0,1 0,0 0,0 0,0 1,1-1,-1 1,2 0,-1 0,1 0,-1 0,2 1,-1-1,1 1,0-1,0 1,1-1,0 13,1-16,-1 0,1 0,0 0,0 0,0 0,0 0,0 0,1-1,-1 1,1 0,0-1,0 0,0 1,0-1,0 0,0 0,1 0,-1 0,1 0,-1-1,1 1,4 1,7 3,0 0,1-1,20 4,-4-1,0 4,-1 2,0 0,-1 2,51 39,-66-46,31 24,-1 2,-2 2,-2 2,-1 2,42 56,-12-11,4-3,3-3,4-4,3-3,3-3,3-5,3-4,185 93,-117-83,4-6,3-8,1-7,323 51,-446-94,-1-2,89-2,-125-3,-1-1,0 0,0 0,0-1,0 0,0 0,12-6,-16 6,0 0,-1 0,1 0,-1 0,1 0,-1 0,0-1,0 1,0-1,0 0,0 0,0 1,-1-1,1 0,-1 0,0 0,0-1,1-4,0-6,-1 0,0 0,-1 0,0 0,-1 0,-1 0,0 1,-1-1,0 0,-6-14,2 9,-1 0,-1 1,-1 0,0 0,-2 1,-16-20,8 14,-1 2,-1 0,-1 1,-1 2,0 0,-2 2,0 0,0 2,-2 1,1 1,-2 1,1 2,-1 1,-1 1,1 1,-1 2,0 1,0 1,-60 5,43 3,-1 3,1 2,1 1,0 3,-65 30,23-2,-138 92,139-77,2 4,-141 136,209-181,1 0,1 2,0 0,1 0,-22 43,34-58,0 1,0-1,0 1,1-1,0 1,0 0,0 0,0-1,1 1,0 0,0 0,0 0,1 0,-1-1,1 1,0 0,3 6,-1-5,0-1,0 1,1-1,0 0,0 0,1 0,-1 0,1-1,0 0,0 0,1 0,-1-1,7 4,10 4,-1-1,2 0,45 11,86 9,82-8,-59-19,260-27,171-74,-361 40,-166 36,0-2,85-40,-145 54,30-19,-46 26,0-1,0 0,0 0,0-1,-1 1,0-1,0 0,0 0,5-8,-9 12,1-1,0 1,0-1,-1 1,1-1,-1 0,0 1,1-1,-1 0,0 1,0-1,0 0,0 1,0-1,0 0,-1 1,1-1,0 0,-1 1,1-1,-1 1,0-1,0 1,1-1,-3-1,0-1,0 1,-1-1,1 1,-1 0,0 0,0 0,-9-4,-2 0,0 0,-1 1,0 1,-29-6,-77-6,-2 8,0 5,-1 6,1 5,1 5,0 6,0 5,2 6,2 4,-174 74,230-78,1 2,-92 62,126-74,2 2,0 1,2 0,0 2,2 1,1 1,-24 36,37-50,1 1,1-1,0 1,1 0,0 1,1 0,0-1,1 1,1 0,0 0,1 23,1-28,1 0,1 0,-1 0,2 0,-1 0,1-1,0 1,1-1,0 0,1 0,-1 0,1 0,1-1,0 0,0 0,0 0,1-1,-1 0,11 6,0-1,-1-2,2 0,-1 0,1-2,1 0,-1-2,1 0,0 0,0-2,0-1,22 1,8-2,0-3,1-1,61-14,-49 4,-1-2,-1-3,-1-3,-1-2,-1-3,-1-2,57-38,-73 39,-1-2,-1-1,-2-2,-1-1,-2-2,-1-1,-1-2,-3-1,43-77,-57 88,-1 0,-2-1,-1-1,-1 0,-1-1,-2 1,-1-1,-2 0,-1-1,-1 1,-2 0,-1-1,-1 1,-2 0,-1 1,-2-1,0 1,-21-45,11 36,-2 1,-2 0,-1 2,-1 1,-3 1,0 1,-2 1,-2 2,-1 1,-65-46,67 55,0 2,-2 1,0 1,0 2,-1 1,-1 2,0 1,-1 2,0 1,0 2,0 1,-1 2,-57 4,47 4,0 2,0 2,1 2,0 1,1 3,1 2,1 1,-45 29,39-18,1 2,1 2,2 1,2 3,1 2,-46 59,66-73,2 2,0 1,2 0,2 1,0 1,2 0,-15 56,23-70,2 1,0 0,0 0,2 0,0 1,2-1,0 0,0 0,2 0,0 0,1 0,1-1,1 1,0-1,17 30,-9-26,0 0,2-1,1-1,0 0,1-2,1 0,0-1,2 0,-1-2,2-1,0 0,1-2,37 14,-18-10,1-3,1-1,-1-2,2-2,-1-2,86-2,-79-6,-1-2,1-2,-1-3,0-1,-1-3,0-2,-2-2,0-2,80-48,-81 39,-1-3,-1-1,-2-3,-2-1,-1-2,-1-1,-3-2,-2-2,29-48,-30 37,-3-2,-3-1,-2-1,-2-1,-3-1,17-98,-28 109,-2-1,-3 0,-1 0,-3 0,-2 0,-3 1,-1-1,-23-80,20 99,-2 1,-1 0,-1 1,-2 0,-1 1,-1 1,-1 0,-2 2,-37-38,43 50,-1 0,0 1,-1 1,0 0,-1 2,0 0,-1 1,0 1,0 0,-1 1,0 2,0 0,-1 1,1 1,-1 1,-29 0,32 3,1 1,-1 0,0 1,1 1,0 1,-1 0,2 1,-1 1,1 1,0 0,1 1,-16 11,19-10,0 0,1 0,0 1,1 0,0 1,1 0,1 1,0-1,0 2,1-1,1 1,0 0,1 1,-5 23,6-19,1 1,1 0,1 0,1 0,1 0,1-1,5 30,0-21,1 0,1-1,1 0,24 43,-9-28,2-1,1-1,2-1,2-2,70 63,-48-56,1-2,3-2,93 48,-40-35,133 46,-111-54,1-6,3-5,0-7,2-5,197 5,-295-27,65-7,-101 7,0-1,0-1,-1 1,1-1,-1 0,1 0,-1 0,1 0,-1-1,0 0,4-3,19-12,-16 14,0 1,0-1,0 2,0 0,0 0,1 1,-1 1,21 1,-8-1,24 0,65 7,-98-5,0 0,-1 1,1 1,-1 1,0 0,0 0,0 2,21 12,-31-16,1 1,-1-1,0 1,0 0,0 0,-1 0,1 1,-1-1,0 1,0 0,0 0,-1 0,0 0,0 0,0 0,-1 1,1-1,-1 1,-1-1,1 1,-1-1,0 1,0 0,-1-1,0 8,-5 10,0 0,-1-1,-1 1,-19 34,10-19,10-22,1 0,0 0,1 0,1 0,1 1,-3 26,6-34,0 0,1 0,0 0,0-1,1 1,0 0,0-1,1 1,0-1,1 0,0 0,0 0,1-1,8 12,-3-8,1 1,0-2,0 0,2 0,-1-1,1 0,0-1,0-1,1 0,0-1,1 0,-1-1,1-1,19 3,21 2,0-3,88-2,-137-4,-2 0,6 1,-1-1,1 0,0-1,-1 0,1-1,14-4,-57 54,5-8,2 0,-31 68,48-87,1 0,1 0,0 1,2 0,1 0,1 0,-1 42,4-50,-1-5,1 0,1 0,-1 0,2 0,-1 0,4 12,2-12,-3-15,-2-18,-5 8,-2 0,0 1,0-1,-1 1,-1 1,-1-1,-14-20,21 33,-1 0,0-1,0 1,0 0,0 0,0 0,0 0,0 1,-1-1,1 0,-1 1,1 0,-1-1,1 1,-1 0,0 1,0-1,0 0,1 1,-1-1,0 1,0 0,0 0,0 0,0 1,1-1,-1 0,0 1,0 0,0 0,1 0,-1 0,0 0,1 0,-1 1,1 0,0-1,-1 1,1 0,0 0,0 0,0 0,0 0,1 0,-1 1,-2 4,-4 9,0 0,1 1,0 0,2 0,0 1,1 0,1 0,0 0,0 34,4-47,-1 0,0 0,1-1,0 1,0 0,1 0,-1-1,1 1,0-1,0 1,1-1,-1 0,1 0,0 0,0 0,0 0,4 3,-4-4,0-1,0 0,0 0,1 0,-1 0,0 0,1-1,-1 1,1-1,-1 0,1 0,0 0,0-1,-1 1,1-1,0 0,0 0,-1 0,1-1,0 1,0-1,-1 0,5-2,-2 1,0-1,0 0,0-1,0 0,-1 1,0-2,1 1,-2-1,1 0,0 0,-1 0,0 0,0-1,-1 0,0 1,0-1,0-1,3-10,0-2,-1 0,-1 0,0-1,-2 0,1-22,-3 31,0 0,0 0,-1 1,0-1,-1 0,-1 1,-5-19,6 25,0 0,0 0,-1 0,1 0,-1 0,0 1,0-1,0 1,0 0,0 0,-1 0,0 0,1 1,-1-1,0 1,0 0,-1 0,1 1,0-1,-8-1,6 2,1 0,0 1,0-1,0 1,-1 0,1 1,0-1,0 1,0 0,-1 0,1 1,0-1,1 1,-1 1,0-1,-7 5,10-5,-1 0,0 0,1 0,-1 0,1 1,0-1,0 1,0 0,0 0,0 0,1 0,-1 0,1 0,0 0,0 0,0 0,0 0,0 1,1-1,0 0,-1 1,1-1,1 1,-1-1,0 0,2 7,-1-8,0 1,0 0,0-1,0 1,1-1,-1 1,1-1,-1 0,1 0,0 1,0-1,0 0,0-1,0 1,1 0,-1-1,0 1,1-1,0 0,-1 1,1-1,-1-1,1 1,0 0,0-1,4 1,-4 0,0-1,-1 0,1 0,0 0,-1-1,1 1,-1-1,1 1,0-1,-1 0,1 0,-1 0,0 0,1 0,-1 0,0-1,0 1,0-1,0 0,0 0,0 0,0 0,0 0,-1 0,1 0,-1 0,0 0,2-4,0-8,0 1,0-1,-2 1,1-1,-2 0,0 0,-3-22,1-31,2 65,0 0,0 0,0 0,0 0,0 1,1-1,-1 0,1 0,-1 0,1 0,0 0,0 0,0 1,0-1,0 0,0 1,0-1,1 1,-1-1,2-1,-1 3,-1-1,1 0,0 1,0-1,0 1,-1-1,1 1,0 0,0 0,0 0,0 0,-1 0,1 0,0 0,0 1,0-1,2 1,6 3,0 1,0-1,0 2,-1-1,15 12,-20-14,1 0,0 1,0-2,0 1,0-1,7 3,-11-5,-1 0,1 0,0 1,0-1,-1 0,1 0,0 0,0 0,0 0,-1 0,1 0,0-1,0 1,-1 0,1 0,0-1,0 1,-1 0,1-1,1 0,-1 0,-1 0,1 0,-1 0,1 0,-1 0,1 0,-1 0,1-1,-1 1,0 0,0 0,0 0,0-1,0 1,0 0,0 0,0 0,0-3,-2-7,-1 0,0 0,0 0,-1 0,-7-14,8 18,0 1,0 0,-1 1,0-1,0 1,0-1,-1 1,0 0,0 1,-6-6,10 10,1 0,-1-1,1 1,-1-1,1 1,-1 0,1-1,-1 1,0 0,1 0,-1 0,0-1,1 1,-1 0,0 0,1 0,-1 0,0 0,1 0,-1 0,1 0,-1 1,0-1,1 0,-1 0,0 0,1 1,-1-1,0 1,0 0,1 0,-1 0,0 0,1 0,-1 0,1 0,-1 0,1 0,0 1,-1-1,1 0,0 0,0 0,0 2,0 2,0 0,0 0,1 0,0-1,0 1,0 0,2 4,-1-6,-1 0,1 0,0 0,0-1,0 1,1-1,-1 1,0-1,1 0,0 0,-1 0,1 0,0 0,0-1,4 2,-5-2,0-1,0 1,0-1,0 0,1 0,-1 1,0-1,0-1,0 1,0 0,0 0,1-1,-1 0,0 1,0-1,0 0,0 0,0 0,-1 0,1 0,0 0,0-1,-1 1,1 0,1-3,5-6,0 0,-1 0,0-1,0 0,-1 0,-1-1,0 0,4-15,-2 2,-1-1,-1 1,2-29,-6 44,-1 0,0 0,-1-1,0 1,0 0,-6-17,7 25,-1 0,0 1,1-1,-1 1,0-1,0 0,0 1,0-1,0 1,0 0,0-1,-1 1,1 0,-1 0,1 0,0 0,-1 0,-1-1,1 2,0-1,0 1,0 0,0 0,0 0,0 0,0 1,0-1,0 1,0-1,0 1,0-1,0 1,1 0,-1 0,0 0,1 0,-1 0,0 0,-2 3,2-1,-1 0,0 0,1 0,-1 0,1 0,0 0,0 1,0 0,1-1,-1 1,1 0,0-1,0 1,0 0,0 0,0 5,1 3,-1 0,1-1,1 1,3 14,-3-20,0 0,1-1,-1 1,1-1,1 1,-1-1,1 0,0 0,0 0,1 0,-1-1,1 1,0-1,5 4,-7-5,1-1,0 0,0 0,0-1,0 1,0-1,1 1,-1-1,0 0,1 0,-1 0,1-1,-1 1,0-1,1 0,-1 0,1 0,-1-1,1 1,-1-1,1 1,-1-1,0 0,6-3,-7 3,0 0,0 0,0 0,0-1,0 1,0-1,0 1,-1-1,1 0,-1 0,1 0,-1 0,0 0,1 0,-1 0,0 0,0 0,0-3,1-3,0 0,-1 0,0 1,-1-10,1-3,9 50,-3-2,21 49,-21-59,-6-17,0 1,0 0,-1-1,1 1,-1 0,1 0,-1-1,0 1,1 0,-1 0,0 0,0-1,0 1,-1 0,1 0,0 0,-1-1,1 1,-1 0,0 0,1-1,-1 1,0 0,0-1,0 1,0-1,0 1,-1-1,-1 2,-7 11,8-11,0-1,1 1,-1 0,1 0,0 0,0 1,0-1,0 0,1 0,-1 1,1-1,0 0,0 0,0 1,0-1,1 0,-1 0,1 1,0-1,0 0,0 0,0 0,1 0,-1 0,1 0,-1 0,1 0,0-1,0 1,3 2,-4-5,-1 0,1 1,-1-1,1 1,-1-1,1 0,-1 1,1-1,-1 0,1 0,0 1,-1-1,1 0,-1 0,1 0,0 0,-1 0,1 0,0 0,-1 0,1 0,-1 0,1 0,0 0,-1-1,1 1,-1 0,1 0,0-1,0 1,0-2,0 1,0 0,0 0,0-1,0 1,0-1,0 1,0-1,-1 1,1-1,0-2,1-4,0 1,-1-1,1-16,-2 11,-1-1,0 1,-2 0,1 0,-1-1,-1 2,0-1,-1 0,-13-23,17 34,-1 0,1 1,0-1,-1 0,0 0,1 1,-1-1,0 1,0-1,0 1,0 0,0 0,0-1,0 2,-1-1,1 0,0 0,-1 1,1-1,0 1,-1 0,1 0,0-1,-1 2,1-1,0 0,-1 0,1 1,-4 1,-1 0,1 1,-1 0,1 0,0 0,0 1,0 0,1 0,-8 8,12-11,-1 0,1 1,0-1,0 0,0 0,-1 0,1 0,-1-1,1 1,0 0,-1 0,0-1,1 1,-1-1,1 1,-1-1,0 0,1 0,-1 0,1 0,-1 0,-3 0,3-1,0 0,0-1,0 1,1 0,-1 0,0-1,1 1,-1-1,1 0,-1 1,1-1,0 0,-1 0,1 0,0 0,-1-3,-4-13,0-1,1 0,0 1,-2-38,2 20,-2-15,2 0,2 0,7-83,-4 131,1 0,0 0,0 0,0 0,0 0,0 1,0-1,1 0,0 1,-1-1,1 1,3-4,30-25,-6 6,18-20,-26 26,24-28,-42 41,1 1,-2 0,1-1,0 0,-1 1,0-1,-1 0,1 0,-1 0,1-12,-2 12,1-1,0 1,0 0,0 0,1-1,0 1,0 0,1 0,0 1,6-11,-4 11,1 0,-1 0,1 0,0 1,0 0,0 0,1 0,9-3,-11 5,0 0,0 0,0 0,0-1,0 0,-1 0,0 0,1-1,-1 1,-1-1,1 0,0 0,-1 0,0-1,0 1,0-1,3-6,-4 5,0 0,1 0,0 1,0-1,7-9,-9 14,0 0,-1 0,1 0,0 0,0 0,0 1,0-1,0 0,0 1,0-1,0 1,0-1,0 1,0-1,0 1,0 0,0-1,0 1,0 0,1 0,-1 0,0 0,0 0,0 0,0 0,0 1,0-1,1 0,-1 1,0-1,0 0,0 1,0-1,0 1,0 0,0-1,0 1,0 0,-1-1,3 3,-1-1,0 1,0 0,-1-1,1 1,0 0,-1 0,0 0,1 0,-1 0,0 1,-1-1,1 0,0 4,1 48,-2-41,0 38,-3 132,2-182,1 0,0 0,-1 0,1 0,-1 0,0 0,0 0,1 0,-1-1,0 1,-1 0,1-1,0 1,0-1,-1 1,1-1,-1 0,1 1,-1-1,0 0,-3 2,-2 0,-1 0,0 0,0-1,-9 2,-12 4,17-4,-1 1,1 0,0 1,-17 10,25-12,-1 0,1 0,-1 0,1 0,0 1,1-1,-1 1,1 0,0 0,0 0,1 1,-4 8,-1 6,2 1,0 0,1-1,-1 24,4-34,1 0,0 0,0-1,1 1,1 0,-1-1,1 1,1-1,0 0,0 0,6 10,-9-17,1-1,0 0,0 1,-1-1,1 0,0 0,0 1,0-1,1 0,-1 0,0 0,0-1,0 1,1 0,-1 0,1 0,-1-1,0 1,3 0,-3-1,1 0,-1 0,0-1,1 1,-1 0,1 0,-1-1,0 1,0-1,1 1,-1-1,0 0,0 1,1-1,-1 0,0 0,1-1,3-4,1 0,-1 0,-1 0,1-1,-1 0,3-7,2-5,-1-1,-1 0,0 0,-2-1,0 1,-2-1,0 0,-1 0,-1-1,-4-39,1 120,1-61,0 1,0-1,0 1,0-1,0 1,0 0,0-1,0 1,-1 0,1 0,-1 0,1 0,0 0,-1 0,0 0,1 0,-3 0,-33-14,24 14,1-1,-1 2,0-1,0 2,1 0,-25 5,-16 1,-98-2,-430-10,-17 0,507 6,12-2,-1 4,-106 18,164-15,1 0,0 2,1 0,-28 16,-21 9,66-32,0 1,-1-1,1 1,0 0,1 0,-1 0,0 0,1 1,-1-1,1 1,0 0,-1-1,1 1,1 0,-1 0,0 0,1 0,-1 1,-1 5,2-3,0 0,0 1,1-1,0 0,0 0,0 1,1-1,-1 0,2 0,1 9,-2-14,-1 0,1 0,-1 0,1 0,-1 0,0 1,0-1,1 0,-1 0,0 0,0 1,0-1,0 0,0 0,-1 0,1 1,0-1,-1 0,1 0,0 0,-1 0,0 0,1 0,-1 0,1 0,-1 0,0 0,0 0,0 0,0 0,1 0,-1-1,0 1,0 0,-1-1,1 1,0-1,0 1,0-1,0 1,0-1,0 0,-1 1,0-1,-8 1,-1-1,1 0,0 0,-17-4,12 2,-676-61,535 57,0 8,-226 30,235-5,0 7,3 5,1 7,-222 104,351-143,-133 68,127-64,0 2,1 0,1 2,-30 28,46-41,-1 1,1 0,-1 0,1 0,0 1,0-1,0 1,1-1,-1 1,1-1,0 1,0 0,0-1,0 1,1 0,-1 0,1 0,0 0,0-1,1 1,-1 0,1 0,1 4,0-3,0 0,1 0,-1 0,1 0,0-1,1 1,-1-1,1 1,0-1,0-1,0 1,0 0,1-1,-1 0,7 3,3 2,0-2,1 0,-1-1,1 0,0-1,0-1,0 0,28 1,-22-4,0-1,1-1,-1 0,0-2,39-11,-32 5,-1-1,-1-1,0-1,0-1,-1-2,-1 0,-1-1,0-2,32-33,-35 28,-1 0,-1-1,0-1,-3 0,0-1,-1-1,11-35,-17 40,-1-2,-1 1,-1-1,-1 0,-1 0,-1 0,-2 0,0 0,-5-31,2 43,1 0,-2 0,1 1,-2-1,0 1,0 0,-1 0,-1 1,0-1,0 1,-17-18,11 16,0 1,-1 1,0 1,0 0,-1 0,0 2,-1 0,-17-7,0 4,1 0,-2 3,-47-8,-96 3,165 13,-18-1,-1 1,1 1,-58 11,79-10,1 1,0-1,0 2,0-1,0 1,0 0,-13 11,17-12,-1 1,1 0,1 0,-1 1,0-1,1 1,0 0,0 0,1 0,-1 0,1 0,0 0,-1 9,0 2,1 0,0 0,1 1,1-1,1 1,0-1,2 0,-1 0,2 0,0 0,8 18,0-3,2-1,1 0,1-1,31 42,-30-49,1 1,2-2,0-1,1 0,0-2,2 0,0-1,1-2,1 0,36 15,-57-29,0 1,1-1,-1 1,0-1,1-1,-1 1,9 0,-11-2,-1 1,1 0,-1-1,0 1,1 0,-1-1,0 0,1 1,-1-1,0 0,0 0,1 0,-1 1,0-1,0 0,0-1,0 1,0 0,-1 0,1 0,0 0,0-1,-1 1,1 0,-1-1,1 1,0-3,1-8,0 0,0 0,-1 0,-1 0,0 0,0 0,-1 0,-1 0,-4-18,0 8,-1-1,-1 1,-1 1,-13-24,4 15,-1 0,-2 2,0 0,-2 2,-1 0,-53-42,37 38,-2 1,-1 2,-1 2,-56-23,66 34,0 2,0 1,-50-9,64 17,1 1,-1 0,1 1,-1 1,1 1,-1 1,-37 9,53-10,-1 2,0-1,0 0,1 1,0 0,-1 0,1 0,0 1,1 0,-1-1,0 1,1 0,-5 8,-1 2,1 0,-12 31,11-25,2 1,-6 26,12-41,-1 0,2 0,-1 0,1 0,0 0,0 0,0 0,1 0,0 0,0 0,1 0,0 0,2 6,1-5,-1 0,1 0,0 0,1 0,-1-1,1 0,1 0,-1-1,1 0,0 0,0 0,0-1,15 6,-1-1,1-1,0-2,1 0,23 2,4-2,0-2,1-3,-1-2,0-2,95-19,-49 1,-2-5,98-41,-116 37,-2-4,-1-3,92-63,-131 76,0-1,-2-2,-1-1,-1-1,-2-2,-1-1,-1-1,29-51,-43 63,-1-1,-1 0,-2-1,0 0,-1-1,5-34,-10 43,-1 0,0 0,-1-1,-1 1,0 0,-1-1,-1 1,0 0,-1 0,-1 1,-7-19,2 14,-1 1,0 0,-1 1,-1 0,-1 0,0 2,-1 0,0 0,-2 1,1 1,-2 1,1 1,-2 0,-26-11,18 11,0 1,-1 1,0 1,0 2,-1 0,1 3,-1 0,0 1,0 2,-30 4,16 2,2 2,-1 2,1 1,0 2,1 2,1 2,0 2,2 1,0 1,1 3,2 1,-37 32,59-46,1 1,0 0,0 0,1 1,1 0,0 1,0 0,2 0,0 1,0 0,-7 29,12-34,0 0,0 1,1-1,0 1,1-1,0 1,1 0,0-1,1 1,0-1,0 0,1 0,1 0,0 0,0 0,1-1,0 1,0-1,8 9,-1-5,0 0,0-2,1 1,1-1,0-1,1-1,-1 0,2-1,-1 0,1-1,32 9,-4-5,1-1,0-2,65 3,-27-8,0-5,-1-2,0-5,0-3,82-23,-62 7,-3-5,0-3,145-78,-193 86,-1-1,-2-4,0-1,82-79,-109 91,0 0,-2-1,-1-2,-1 0,-1 0,-2-2,0 0,-2 0,0-1,-3-1,10-41,-14 44,-2-1,-1 0,0 0,-3-1,0 1,-1 0,-2 0,-1 1,-1-1,-1 1,-1 0,-2 1,-15-32,13 35,-1 0,-1 1,0 1,-2 0,0 1,-1 1,-1 0,-1 1,0 1,-1 1,-1 1,0 1,-1 1,-36-16,21 15,-1 2,-1 1,1 2,-1 2,-41-1,-10 4,-98 9,184-6,0 0,-1 1,1 0,-1 0,1 0,0 0,0 0,-1 1,1 0,0 0,-4 2,6-1,-1-1,1 0,0 1,-1-1,1 1,1 0,-1 0,0 0,1 0,-1 0,1 0,0 0,0 1,-1 5,-1 4,1 0,1 0,0 1,1-1,0 0,1 0,1 0,0 0,0 0,2 0,-1-1,2 1,-1-1,9 15,-7-17,0 0,1-1,0 1,0-1,1-1,0 0,0 0,1 0,0-1,1 0,-1-1,1 0,0-1,1 0,-1 0,17 4,-15-5,0-1,0-1,1 0,-1 0,1-1,-1-1,0 0,14-2,-22 1,1 0,-1 0,0 0,0-1,0 1,0-1,0 0,0-1,0 1,-1-1,1 1,-1-1,1 0,-1 0,0 0,0-1,-1 1,1-1,-1 0,0 1,0-1,0 0,0-1,-1 1,3-8,-1-2,-1-1,-1 1,0 0,-1-1,0 1,-1 0,-1-1,0 1,-1 0,-1 0,0 0,0 1,-11-22,-3-1,-2 1,-1 1,-42-53,-76-74,133 153,0 1,0 1,0-1,-1 1,-10-8,14 13,1-1,0 1,0 0,0 0,-1 0,1 0,0 1,-1-1,1 1,-1-1,1 1,-1 0,1 0,0 0,-1 0,1 0,-1 1,1-1,-1 1,1-1,0 1,-1 0,1 0,-4 3,-2 1,0 1,1 0,0 0,0 1,1 0,-1 0,1 0,1 1,0 0,-7 13,-3 11,-17 50,27-69,-20 60,4 1,2 1,4 1,4 0,-4 124,15-191,-1 4,1 1,1-1,1 1,3 16,-5-27,1-1,-1 0,1 0,0 0,0 0,-1 0,1 0,1 0,-1 0,0 0,0 0,1-1,-1 1,1 0,-1-1,1 1,0-1,0 0,-1 1,1-1,0 0,0 0,0 0,0-1,0 1,1 0,-1-1,0 1,0-1,0 0,1 0,-1 0,3 0,4-2,0 1,0-2,0 1,-1-1,1-1,-1 0,0 0,0 0,11-9,9-8,27-26,-52 45,27-26,-1-1,-1-1,30-42,-47 56,0 0,-2-1,0-1,0 1,-2-1,0-1,-1 1,-1-1,2-20,-6 35,0 0,-1 1,0-1,0 0,0 0,0 0,-1 0,1 0,-1 1,0-1,0 0,-1 0,1 1,-1-1,1 1,-1-1,-3-2,2 3,0-1,-1 1,1 1,-1-1,0 0,1 1,-1 0,0 0,-1 0,1 0,0 1,-1-1,1 1,-6 0,-3-1,0 1,-1 1,1 0,0 1,-1 0,1 1,0 1,0 0,0 0,0 2,1-1,-1 2,-12 7,1 0,0 2,1 0,1 2,1 0,-29 31,28-25,2 2,1 0,0 1,2 1,2 1,-14 31,19-36,2 1,0 0,2 0,0 0,2 1,1-1,1 1,1 33,2-45,0-1,2 0,-1 1,2-1,-1 0,2 0,-1-1,2 0,-1 1,2-2,-1 1,2-1,-1 0,19 18,19 15</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3038475" cy="465138"/>
          </a:xfrm>
          <a:prstGeom prst="rect">
            <a:avLst/>
          </a:prstGeom>
        </p:spPr>
        <p:txBody>
          <a:bodyPr vert="horz" lIns="91439" tIns="45719" rIns="91439" bIns="45719" rtlCol="0"/>
          <a:lstStyle>
            <a:lvl1pPr algn="l">
              <a:defRPr sz="1200"/>
            </a:lvl1pPr>
          </a:lstStyle>
          <a:p>
            <a:endParaRPr lang="en-US"/>
          </a:p>
        </p:txBody>
      </p:sp>
      <p:sp>
        <p:nvSpPr>
          <p:cNvPr id="3" name="Date Placeholder 2"/>
          <p:cNvSpPr>
            <a:spLocks noGrp="1"/>
          </p:cNvSpPr>
          <p:nvPr>
            <p:ph type="dt" idx="1"/>
          </p:nvPr>
        </p:nvSpPr>
        <p:spPr>
          <a:xfrm>
            <a:off x="3970339" y="0"/>
            <a:ext cx="3038475" cy="465138"/>
          </a:xfrm>
          <a:prstGeom prst="rect">
            <a:avLst/>
          </a:prstGeom>
        </p:spPr>
        <p:txBody>
          <a:bodyPr vert="horz" lIns="91439" tIns="45719" rIns="91439" bIns="45719" rtlCol="0"/>
          <a:lstStyle>
            <a:lvl1pPr algn="r">
              <a:defRPr sz="1200"/>
            </a:lvl1pPr>
          </a:lstStyle>
          <a:p>
            <a:fld id="{28AFE5F6-2465-41A6-AD91-638F2C97125E}" type="datetimeFigureOut">
              <a:rPr lang="en-US" smtClean="0"/>
              <a:t>4/18/2023</a:t>
            </a:fld>
            <a:endParaRPr lang="en-US"/>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1439" tIns="45719" rIns="91439" bIns="45719" rtlCol="0" anchor="ctr"/>
          <a:lstStyle/>
          <a:p>
            <a:endParaRPr lang="en-US"/>
          </a:p>
        </p:txBody>
      </p:sp>
      <p:sp>
        <p:nvSpPr>
          <p:cNvPr id="5" name="Notes Placeholder 4"/>
          <p:cNvSpPr>
            <a:spLocks noGrp="1"/>
          </p:cNvSpPr>
          <p:nvPr>
            <p:ph type="body" sz="quarter" idx="3"/>
          </p:nvPr>
        </p:nvSpPr>
        <p:spPr>
          <a:xfrm>
            <a:off x="701675" y="4416426"/>
            <a:ext cx="5607050" cy="4183063"/>
          </a:xfrm>
          <a:prstGeom prst="rect">
            <a:avLst/>
          </a:prstGeom>
        </p:spPr>
        <p:txBody>
          <a:bodyPr vert="horz" lIns="91439" tIns="45719" rIns="91439" bIns="4571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829676"/>
            <a:ext cx="3038475" cy="465138"/>
          </a:xfrm>
          <a:prstGeom prst="rect">
            <a:avLst/>
          </a:prstGeom>
        </p:spPr>
        <p:txBody>
          <a:bodyPr vert="horz" lIns="91439" tIns="45719" rIns="91439" bIns="45719" rtlCol="0" anchor="b"/>
          <a:lstStyle>
            <a:lvl1pPr algn="l">
              <a:defRPr sz="1200"/>
            </a:lvl1pPr>
          </a:lstStyle>
          <a:p>
            <a:endParaRPr lang="en-US"/>
          </a:p>
        </p:txBody>
      </p:sp>
      <p:sp>
        <p:nvSpPr>
          <p:cNvPr id="7" name="Slide Number Placeholder 6"/>
          <p:cNvSpPr>
            <a:spLocks noGrp="1"/>
          </p:cNvSpPr>
          <p:nvPr>
            <p:ph type="sldNum" sz="quarter" idx="5"/>
          </p:nvPr>
        </p:nvSpPr>
        <p:spPr>
          <a:xfrm>
            <a:off x="3970339" y="8829676"/>
            <a:ext cx="3038475" cy="465138"/>
          </a:xfrm>
          <a:prstGeom prst="rect">
            <a:avLst/>
          </a:prstGeom>
        </p:spPr>
        <p:txBody>
          <a:bodyPr vert="horz" lIns="91439" tIns="45719" rIns="91439" bIns="45719" rtlCol="0" anchor="b"/>
          <a:lstStyle>
            <a:lvl1pPr algn="r">
              <a:defRPr sz="1200"/>
            </a:lvl1pPr>
          </a:lstStyle>
          <a:p>
            <a:fld id="{64852B7C-D082-4672-99B3-9CB2A90DA81C}" type="slidenum">
              <a:rPr lang="en-US" smtClean="0"/>
              <a:t>‹#›</a:t>
            </a:fld>
            <a:endParaRPr lang="en-US"/>
          </a:p>
        </p:txBody>
      </p:sp>
    </p:spTree>
    <p:extLst>
      <p:ext uri="{BB962C8B-B14F-4D97-AF65-F5344CB8AC3E}">
        <p14:creationId xmlns:p14="http://schemas.microsoft.com/office/powerpoint/2010/main" val="5547638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 to facilitator: The notes section on the following slides includes talking points.</a:t>
            </a:r>
          </a:p>
        </p:txBody>
      </p:sp>
      <p:sp>
        <p:nvSpPr>
          <p:cNvPr id="4" name="Slide Number Placeholder 3"/>
          <p:cNvSpPr>
            <a:spLocks noGrp="1"/>
          </p:cNvSpPr>
          <p:nvPr>
            <p:ph type="sldNum" sz="quarter" idx="5"/>
          </p:nvPr>
        </p:nvSpPr>
        <p:spPr/>
        <p:txBody>
          <a:bodyPr/>
          <a:lstStyle/>
          <a:p>
            <a:fld id="{64852B7C-D082-4672-99B3-9CB2A90DA81C}" type="slidenum">
              <a:rPr lang="en-US" smtClean="0"/>
              <a:t>1</a:t>
            </a:fld>
            <a:endParaRPr lang="en-US"/>
          </a:p>
        </p:txBody>
      </p:sp>
    </p:spTree>
    <p:extLst>
      <p:ext uri="{BB962C8B-B14F-4D97-AF65-F5344CB8AC3E}">
        <p14:creationId xmlns:p14="http://schemas.microsoft.com/office/powerpoint/2010/main" val="327462300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solidFill>
                  <a:srgbClr val="000000"/>
                </a:solidFill>
                <a:effectLst/>
                <a:ea typeface="Courier New" panose="02070309020205020404" pitchFamily="49" charset="0"/>
                <a:cs typeface="Calibri" panose="020F0502020204030204" pitchFamily="34" charset="0"/>
              </a:rPr>
              <a:t>The facilitator should explain that</a:t>
            </a:r>
            <a:r>
              <a:rPr lang="en-US" baseline="30000" dirty="0">
                <a:solidFill>
                  <a:srgbClr val="FF0000"/>
                </a:solidFill>
                <a:effectLst/>
                <a:ea typeface="Courier New" panose="02070309020205020404" pitchFamily="49" charset="0"/>
                <a:cs typeface="Calibri" panose="020F0502020204030204" pitchFamily="34" charset="0"/>
              </a:rPr>
              <a:t> </a:t>
            </a:r>
            <a:r>
              <a:rPr lang="en-US" dirty="0">
                <a:solidFill>
                  <a:srgbClr val="000000"/>
                </a:solidFill>
                <a:effectLst/>
                <a:ea typeface="Courier New" panose="02070309020205020404" pitchFamily="49" charset="0"/>
                <a:cs typeface="Calibri" panose="020F0502020204030204" pitchFamily="34" charset="0"/>
              </a:rPr>
              <a:t>mediators have long understood that one of the most important steps in effective conflict management is framing the problem in a way that will aid constructive conflict resolution. That involves conceptualizing the problem in ways that do not sabotage opportunities for successful intervention. Because interactions are “inter-personal,” that is, between people, the definition of the problem must be multi-perspectival, rather than one-sided. Otherwise, the mediator will only be able to solve one party’s problem rather than the problem that exists </a:t>
            </a:r>
            <a:r>
              <a:rPr lang="en-US" i="1" dirty="0">
                <a:solidFill>
                  <a:srgbClr val="000000"/>
                </a:solidFill>
                <a:effectLst/>
                <a:ea typeface="Courier New" panose="02070309020205020404" pitchFamily="49" charset="0"/>
                <a:cs typeface="Calibri" panose="020F0502020204030204" pitchFamily="34" charset="0"/>
              </a:rPr>
              <a:t>between</a:t>
            </a:r>
            <a:r>
              <a:rPr lang="en-US" dirty="0">
                <a:solidFill>
                  <a:srgbClr val="000000"/>
                </a:solidFill>
                <a:effectLst/>
                <a:ea typeface="Courier New" panose="02070309020205020404" pitchFamily="49" charset="0"/>
                <a:cs typeface="Calibri" panose="020F0502020204030204" pitchFamily="34" charset="0"/>
              </a:rPr>
              <a:t> the parties. </a:t>
            </a:r>
            <a:r>
              <a:rPr lang="en-US" dirty="0"/>
              <a:t>Therefore, the first tool in the Mediator’s Toolbox is about defining the problem in a way that enables the mediator to solve it.</a:t>
            </a:r>
          </a:p>
          <a:p>
            <a:endParaRPr lang="en-US" dirty="0"/>
          </a:p>
          <a:p>
            <a:r>
              <a:rPr lang="en-US" dirty="0"/>
              <a:t>Emphasize that what is important in conflict management is improving the interaction and the relationship of the stakeholders. That is the ultimate goal of conflict management.</a:t>
            </a:r>
          </a:p>
        </p:txBody>
      </p:sp>
      <p:sp>
        <p:nvSpPr>
          <p:cNvPr id="4" name="Slide Number Placeholder 3"/>
          <p:cNvSpPr>
            <a:spLocks noGrp="1"/>
          </p:cNvSpPr>
          <p:nvPr>
            <p:ph type="sldNum" sz="quarter" idx="10"/>
          </p:nvPr>
        </p:nvSpPr>
        <p:spPr/>
        <p:txBody>
          <a:bodyPr/>
          <a:lstStyle/>
          <a:p>
            <a:fld id="{4113E939-DDDC-4CBB-AB59-F6D3052E6013}" type="slidenum">
              <a:rPr lang="en-US" smtClean="0"/>
              <a:t>10</a:t>
            </a:fld>
            <a:endParaRPr lang="en-US"/>
          </a:p>
        </p:txBody>
      </p:sp>
    </p:spTree>
    <p:extLst>
      <p:ext uri="{BB962C8B-B14F-4D97-AF65-F5344CB8AC3E}">
        <p14:creationId xmlns:p14="http://schemas.microsoft.com/office/powerpoint/2010/main" val="259839620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knowledge that the clinical team working with Fred will highly likely view the problem as being entirely Fred's fault. Acknowledging the way in which the clinical team is likely to understand Fred is important. Emphasize that the following slides will show how this limited view undermines the prospect of working effectively with Fred.</a:t>
            </a:r>
          </a:p>
          <a:p>
            <a:endParaRPr lang="en-US" dirty="0"/>
          </a:p>
        </p:txBody>
      </p:sp>
      <p:sp>
        <p:nvSpPr>
          <p:cNvPr id="4" name="Slide Number Placeholder 3"/>
          <p:cNvSpPr>
            <a:spLocks noGrp="1"/>
          </p:cNvSpPr>
          <p:nvPr>
            <p:ph type="sldNum" sz="quarter" idx="5"/>
          </p:nvPr>
        </p:nvSpPr>
        <p:spPr/>
        <p:txBody>
          <a:bodyPr/>
          <a:lstStyle/>
          <a:p>
            <a:fld id="{64852B7C-D082-4672-99B3-9CB2A90DA81C}" type="slidenum">
              <a:rPr lang="en-US" smtClean="0"/>
              <a:t>11</a:t>
            </a:fld>
            <a:endParaRPr lang="en-US"/>
          </a:p>
        </p:txBody>
      </p:sp>
    </p:spTree>
    <p:extLst>
      <p:ext uri="{BB962C8B-B14F-4D97-AF65-F5344CB8AC3E}">
        <p14:creationId xmlns:p14="http://schemas.microsoft.com/office/powerpoint/2010/main" val="215114499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should highlight the fact that Fred is not likely to accept the claim that he is the sole cause of the conflict.  Fred will have a different interpretation of the conflict and will reject the one-sided view. The only way to resolve the conflict between Fred and the providers is to understand all of the perspectives on the conflict.</a:t>
            </a:r>
          </a:p>
          <a:p>
            <a:endParaRPr lang="en-US" dirty="0"/>
          </a:p>
          <a:p>
            <a:r>
              <a:rPr lang="en-US" dirty="0"/>
              <a:t>Emphasize the mediation is not focused on who is right or who has acted badly. That kind of focus fails to understand that conflicts occur between individuals and that reducing conflict requires working with all parties.</a:t>
            </a:r>
          </a:p>
        </p:txBody>
      </p:sp>
      <p:sp>
        <p:nvSpPr>
          <p:cNvPr id="4" name="Slide Number Placeholder 3"/>
          <p:cNvSpPr>
            <a:spLocks noGrp="1"/>
          </p:cNvSpPr>
          <p:nvPr>
            <p:ph type="sldNum" sz="quarter" idx="5"/>
          </p:nvPr>
        </p:nvSpPr>
        <p:spPr/>
        <p:txBody>
          <a:bodyPr/>
          <a:lstStyle/>
          <a:p>
            <a:fld id="{64852B7C-D082-4672-99B3-9CB2A90DA81C}" type="slidenum">
              <a:rPr lang="en-US" smtClean="0"/>
              <a:t>12</a:t>
            </a:fld>
            <a:endParaRPr lang="en-US"/>
          </a:p>
        </p:txBody>
      </p:sp>
    </p:spTree>
    <p:extLst>
      <p:ext uri="{BB962C8B-B14F-4D97-AF65-F5344CB8AC3E}">
        <p14:creationId xmlns:p14="http://schemas.microsoft.com/office/powerpoint/2010/main" val="102818163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one stakeholder in the conflict rejects the interpretation of the problem, then the proposed solution will be inherently flawed because it will only be attuned to one's party’s problem. Emphasize that one-sided solutions are often tried, but they inevitably backfire.  </a:t>
            </a:r>
          </a:p>
        </p:txBody>
      </p:sp>
      <p:sp>
        <p:nvSpPr>
          <p:cNvPr id="4" name="Slide Number Placeholder 3"/>
          <p:cNvSpPr>
            <a:spLocks noGrp="1"/>
          </p:cNvSpPr>
          <p:nvPr>
            <p:ph type="sldNum" sz="quarter" idx="5"/>
          </p:nvPr>
        </p:nvSpPr>
        <p:spPr/>
        <p:txBody>
          <a:bodyPr/>
          <a:lstStyle/>
          <a:p>
            <a:fld id="{64852B7C-D082-4672-99B3-9CB2A90DA81C}" type="slidenum">
              <a:rPr lang="en-US" smtClean="0"/>
              <a:t>13</a:t>
            </a:fld>
            <a:endParaRPr lang="en-US"/>
          </a:p>
        </p:txBody>
      </p:sp>
    </p:spTree>
    <p:extLst>
      <p:ext uri="{BB962C8B-B14F-4D97-AF65-F5344CB8AC3E}">
        <p14:creationId xmlns:p14="http://schemas.microsoft.com/office/powerpoint/2010/main" val="248358138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order to effectively serve all of the stakeholders and create the highest prospects for solving the problem, mediators must understand each person's perspective. This is called the "360° view.“ </a:t>
            </a:r>
          </a:p>
          <a:p>
            <a:endParaRPr lang="en-US" dirty="0"/>
          </a:p>
          <a:p>
            <a:r>
              <a:rPr lang="en-US" dirty="0"/>
              <a:t>Emphasize that navigating the conflict and understanding the 360° view will require identifying the relevant stakeholders. Each stakeholder’s perspective is important to resolving the conflict.</a:t>
            </a:r>
          </a:p>
        </p:txBody>
      </p:sp>
      <p:sp>
        <p:nvSpPr>
          <p:cNvPr id="4" name="Slide Number Placeholder 3"/>
          <p:cNvSpPr>
            <a:spLocks noGrp="1"/>
          </p:cNvSpPr>
          <p:nvPr>
            <p:ph type="sldNum" sz="quarter" idx="5"/>
          </p:nvPr>
        </p:nvSpPr>
        <p:spPr/>
        <p:txBody>
          <a:bodyPr/>
          <a:lstStyle/>
          <a:p>
            <a:fld id="{64852B7C-D082-4672-99B3-9CB2A90DA81C}" type="slidenum">
              <a:rPr lang="en-US" smtClean="0"/>
              <a:t>14</a:t>
            </a:fld>
            <a:endParaRPr lang="en-US"/>
          </a:p>
        </p:txBody>
      </p:sp>
    </p:spTree>
    <p:extLst>
      <p:ext uri="{BB962C8B-B14F-4D97-AF65-F5344CB8AC3E}">
        <p14:creationId xmlns:p14="http://schemas.microsoft.com/office/powerpoint/2010/main" val="144323415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solidFill>
                  <a:srgbClr val="000000"/>
                </a:solidFill>
                <a:effectLst/>
                <a:ea typeface="Courier New" panose="02070309020205020404" pitchFamily="49" charset="0"/>
                <a:cs typeface="Calibri" panose="020F0502020204030204" pitchFamily="34" charset="0"/>
              </a:rPr>
              <a:t>Conflict management specialists view the imperative to understand the perspective of all parties in the conflict as part of the “conflict diagnosis.” Adequate conflict diagnosis includes investigating how various stakeholders understand the problem, its scope, and its sources. Untangling the misunderstandings, mischaracterizations, and misperceptions of the stakeholders is essential for an accurate conflict diagnosis.</a:t>
            </a:r>
            <a:endParaRPr lang="en-US" dirty="0"/>
          </a:p>
        </p:txBody>
      </p:sp>
      <p:sp>
        <p:nvSpPr>
          <p:cNvPr id="4" name="Slide Number Placeholder 3"/>
          <p:cNvSpPr>
            <a:spLocks noGrp="1"/>
          </p:cNvSpPr>
          <p:nvPr>
            <p:ph type="sldNum" sz="quarter" idx="5"/>
          </p:nvPr>
        </p:nvSpPr>
        <p:spPr/>
        <p:txBody>
          <a:bodyPr/>
          <a:lstStyle/>
          <a:p>
            <a:fld id="{64852B7C-D082-4672-99B3-9CB2A90DA81C}" type="slidenum">
              <a:rPr lang="en-US" smtClean="0"/>
              <a:t>15</a:t>
            </a:fld>
            <a:endParaRPr lang="en-US"/>
          </a:p>
        </p:txBody>
      </p:sp>
    </p:spTree>
    <p:extLst>
      <p:ext uri="{BB962C8B-B14F-4D97-AF65-F5344CB8AC3E}">
        <p14:creationId xmlns:p14="http://schemas.microsoft.com/office/powerpoint/2010/main" val="254036213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etting an accurate conflict diagnosis requires employing the cognitive faculty of empathy. Stakeholders in a conflict will often hold radically different views about what is happening or has happened. To understand the very different worldviews, interpretations and perspectives of each stakeholder in the conflict requires mediators to be able to “put themselves in someone else’s shoes” so that the mediator can make sense of what is being said.  </a:t>
            </a:r>
          </a:p>
        </p:txBody>
      </p:sp>
      <p:sp>
        <p:nvSpPr>
          <p:cNvPr id="4" name="Slide Number Placeholder 3"/>
          <p:cNvSpPr>
            <a:spLocks noGrp="1"/>
          </p:cNvSpPr>
          <p:nvPr>
            <p:ph type="sldNum" sz="quarter" idx="5"/>
          </p:nvPr>
        </p:nvSpPr>
        <p:spPr/>
        <p:txBody>
          <a:bodyPr/>
          <a:lstStyle/>
          <a:p>
            <a:fld id="{64852B7C-D082-4672-99B3-9CB2A90DA81C}" type="slidenum">
              <a:rPr lang="en-US" smtClean="0"/>
              <a:t>16</a:t>
            </a:fld>
            <a:endParaRPr lang="en-US"/>
          </a:p>
        </p:txBody>
      </p:sp>
    </p:spTree>
    <p:extLst>
      <p:ext uri="{BB962C8B-B14F-4D97-AF65-F5344CB8AC3E}">
        <p14:creationId xmlns:p14="http://schemas.microsoft.com/office/powerpoint/2010/main" val="47864433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two very distinct mental processes that both get described as "empathy." The emotional version of empathy involves having the same emotional response as the other person is having. This is the type of empathy individuals experience when they cry at a movie or are overcome with emotion because of the suffering or loss of a patient. Emotional empathy can include feelings of sadness, grief, despair, hopelessness, awe, or joy. Emphasize that this type of emotional empathy can cause compassion fatigue and burnout because human beings are incapable of constantly feeling potent emotions, especially the negative emotions involved in experiencing the pain of other people. Mediation does not require emotional empathy.</a:t>
            </a:r>
          </a:p>
          <a:p>
            <a:endParaRPr lang="en-US" dirty="0"/>
          </a:p>
          <a:p>
            <a:r>
              <a:rPr lang="en-US" dirty="0"/>
              <a:t>The group should focus on building the cognitive faculty of analytical empathy in which the mediator tries to understand (not feel) the perspective of the other person. This is a cognitive, not affective, activity and does not require the experience of emotions. It is the work of imagination, visualization, emotional intelligence, insight, and acumen – all cognitive functions.</a:t>
            </a:r>
          </a:p>
        </p:txBody>
      </p:sp>
      <p:sp>
        <p:nvSpPr>
          <p:cNvPr id="4" name="Slide Number Placeholder 3"/>
          <p:cNvSpPr>
            <a:spLocks noGrp="1"/>
          </p:cNvSpPr>
          <p:nvPr>
            <p:ph type="sldNum" sz="quarter" idx="5"/>
          </p:nvPr>
        </p:nvSpPr>
        <p:spPr/>
        <p:txBody>
          <a:bodyPr/>
          <a:lstStyle/>
          <a:p>
            <a:fld id="{64852B7C-D082-4672-99B3-9CB2A90DA81C}" type="slidenum">
              <a:rPr lang="en-US" smtClean="0"/>
              <a:t>17</a:t>
            </a:fld>
            <a:endParaRPr lang="en-US"/>
          </a:p>
        </p:txBody>
      </p:sp>
    </p:spTree>
    <p:extLst>
      <p:ext uri="{BB962C8B-B14F-4D97-AF65-F5344CB8AC3E}">
        <p14:creationId xmlns:p14="http://schemas.microsoft.com/office/powerpoint/2010/main" val="274687860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should explain that practicing the task of trying to imaginatively "put themselves in someone else's shoes" prepares them to hear and understand perspectives very different from their own. In the exercises that follow, participants will try to imagine the perspectives taken by different stakeholders in order to build their capacity to view situations from the vantage point of different parties in a conflict. In an actual clinical conflict, participants would solicit perspectives from stakeholders in the conflict, but the ability to hear and understand those stated perspectives in future conflicts will be enhanced by developing their faculty of cognitive/analytical empathy. That is the goal of these exercises. </a:t>
            </a:r>
          </a:p>
        </p:txBody>
      </p:sp>
      <p:sp>
        <p:nvSpPr>
          <p:cNvPr id="4" name="Slide Number Placeholder 3"/>
          <p:cNvSpPr>
            <a:spLocks noGrp="1"/>
          </p:cNvSpPr>
          <p:nvPr>
            <p:ph type="sldNum" sz="quarter" idx="5"/>
          </p:nvPr>
        </p:nvSpPr>
        <p:spPr/>
        <p:txBody>
          <a:bodyPr/>
          <a:lstStyle/>
          <a:p>
            <a:fld id="{64852B7C-D082-4672-99B3-9CB2A90DA81C}" type="slidenum">
              <a:rPr lang="en-US" smtClean="0"/>
              <a:t>18</a:t>
            </a:fld>
            <a:endParaRPr lang="en-US"/>
          </a:p>
        </p:txBody>
      </p:sp>
    </p:spTree>
    <p:extLst>
      <p:ext uri="{BB962C8B-B14F-4D97-AF65-F5344CB8AC3E}">
        <p14:creationId xmlns:p14="http://schemas.microsoft.com/office/powerpoint/2010/main" val="4591168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4852B7C-D082-4672-99B3-9CB2A90DA81C}" type="slidenum">
              <a:rPr lang="en-US" smtClean="0"/>
              <a:t>19</a:t>
            </a:fld>
            <a:endParaRPr lang="en-US"/>
          </a:p>
        </p:txBody>
      </p:sp>
    </p:spTree>
    <p:extLst>
      <p:ext uri="{BB962C8B-B14F-4D97-AF65-F5344CB8AC3E}">
        <p14:creationId xmlns:p14="http://schemas.microsoft.com/office/powerpoint/2010/main" val="9920073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Information for the facilitator:</a:t>
            </a:r>
          </a:p>
          <a:p>
            <a:pPr marL="228600" indent="-228600">
              <a:buFont typeface="+mj-lt"/>
              <a:buAutoNum type="arabicPeriod"/>
            </a:pPr>
            <a:r>
              <a:rPr lang="en-US" dirty="0"/>
              <a:t>An essential part of the strategy of resolving conflicts between patients and providers is resisting categorizing the problem in ways that would make it impossible to solve. This presentation will offer a different lens into the problem of working with challenging patients and families.</a:t>
            </a:r>
          </a:p>
          <a:p>
            <a:pPr marL="228600" indent="-228600">
              <a:buFont typeface="+mj-lt"/>
              <a:buAutoNum type="arabicPeriod"/>
            </a:pPr>
            <a:r>
              <a:rPr lang="en-US" dirty="0"/>
              <a:t>Diagnosing the problem in a way that is accepted by all parties helps to avoid solving only one stakeholder's concerns. After introducing the concept, there will be both a group and breakout exercises to master the concept.</a:t>
            </a:r>
          </a:p>
          <a:p>
            <a:pPr marL="228600" indent="-228600">
              <a:buFont typeface="+mj-lt"/>
              <a:buAutoNum type="arabicPeriod"/>
            </a:pPr>
            <a:r>
              <a:rPr lang="en-US" dirty="0"/>
              <a:t>A fundamental concept in mediation theory is the distinction between "positions" and "interests.“ After introducing the concept, there will be both a group and breakout exercises to master the concept.</a:t>
            </a:r>
          </a:p>
        </p:txBody>
      </p:sp>
      <p:sp>
        <p:nvSpPr>
          <p:cNvPr id="4" name="Slide Number Placeholder 3"/>
          <p:cNvSpPr>
            <a:spLocks noGrp="1"/>
          </p:cNvSpPr>
          <p:nvPr>
            <p:ph type="sldNum" sz="quarter" idx="5"/>
          </p:nvPr>
        </p:nvSpPr>
        <p:spPr/>
        <p:txBody>
          <a:bodyPr/>
          <a:lstStyle/>
          <a:p>
            <a:fld id="{64852B7C-D082-4672-99B3-9CB2A90DA81C}" type="slidenum">
              <a:rPr lang="en-US" smtClean="0"/>
              <a:t>2</a:t>
            </a:fld>
            <a:endParaRPr lang="en-US"/>
          </a:p>
        </p:txBody>
      </p:sp>
    </p:spTree>
    <p:extLst>
      <p:ext uri="{BB962C8B-B14F-4D97-AF65-F5344CB8AC3E}">
        <p14:creationId xmlns:p14="http://schemas.microsoft.com/office/powerpoint/2010/main" val="390281758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4852B7C-D082-4672-99B3-9CB2A90DA81C}" type="slidenum">
              <a:rPr lang="en-US" smtClean="0"/>
              <a:t>20</a:t>
            </a:fld>
            <a:endParaRPr lang="en-US"/>
          </a:p>
        </p:txBody>
      </p:sp>
    </p:spTree>
    <p:extLst>
      <p:ext uri="{BB962C8B-B14F-4D97-AF65-F5344CB8AC3E}">
        <p14:creationId xmlns:p14="http://schemas.microsoft.com/office/powerpoint/2010/main" val="137951655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all-group exercise, participants should try to put themselves in the position of the staff. They should provide an unvarnished view of what Fred's caretakers likely perceive the problem to be and how they view Fred as a patient.</a:t>
            </a:r>
          </a:p>
          <a:p>
            <a:endParaRPr lang="en-US" dirty="0"/>
          </a:p>
          <a:p>
            <a:r>
              <a:rPr lang="en-US" dirty="0"/>
              <a:t>Emphasize that they should not "sugarcoat" this brainstorming session because denying what caretakers would likely experience or feel in working with Fred blinds the mediator to the true depth of the problem.</a:t>
            </a:r>
          </a:p>
          <a:p>
            <a:endParaRPr lang="en-US" dirty="0"/>
          </a:p>
          <a:p>
            <a:r>
              <a:rPr lang="en-US" dirty="0"/>
              <a:t>Participants should assume the role of one of Fred's caretakers and they should speak from that perspective. They should not distance themselves from that perspective with phrases like "the staff probably thinks…" Instead, they should say, as a staff member, "Working with Fred makes me feel…" or "I feel x when I am working with Fred.“</a:t>
            </a:r>
          </a:p>
          <a:p>
            <a:endParaRPr lang="en-US" dirty="0"/>
          </a:p>
          <a:p>
            <a:r>
              <a:rPr lang="en-US" dirty="0"/>
              <a:t>Perspectives that providers might take about Fred and the experience of working with him include: "Working with Fred makes me angry because I shouldn't have to endure this kind of abuse,“  "I feel like I am wasting my time taking care of him when he doesn't want to be here and there are so many other patients who need me and do want to be here,“ “Fred brought this on himself by the kind of activities he was engaged in when he was shot,” “Fred is drug-seeking and that is why he is complaining of pain.”</a:t>
            </a:r>
          </a:p>
          <a:p>
            <a:endParaRPr lang="en-US" dirty="0"/>
          </a:p>
          <a:p>
            <a:r>
              <a:rPr lang="en-US" dirty="0"/>
              <a:t>Going around the room, each participant should take a turn defining the problem from the staff perspective.</a:t>
            </a:r>
          </a:p>
          <a:p>
            <a:endParaRPr lang="en-US" dirty="0"/>
          </a:p>
          <a:p>
            <a:r>
              <a:rPr lang="en-US" dirty="0"/>
              <a:t>Then ask them what they think of Fred. How do they view Fred?</a:t>
            </a:r>
          </a:p>
          <a:p>
            <a:endParaRPr lang="en-US" dirty="0"/>
          </a:p>
        </p:txBody>
      </p:sp>
      <p:sp>
        <p:nvSpPr>
          <p:cNvPr id="4" name="Slide Number Placeholder 3"/>
          <p:cNvSpPr>
            <a:spLocks noGrp="1"/>
          </p:cNvSpPr>
          <p:nvPr>
            <p:ph type="sldNum" sz="quarter" idx="5"/>
          </p:nvPr>
        </p:nvSpPr>
        <p:spPr/>
        <p:txBody>
          <a:bodyPr/>
          <a:lstStyle/>
          <a:p>
            <a:fld id="{64852B7C-D082-4672-99B3-9CB2A90DA81C}" type="slidenum">
              <a:rPr lang="en-US" smtClean="0"/>
              <a:t>21</a:t>
            </a:fld>
            <a:endParaRPr lang="en-US"/>
          </a:p>
        </p:txBody>
      </p:sp>
    </p:spTree>
    <p:extLst>
      <p:ext uri="{BB962C8B-B14F-4D97-AF65-F5344CB8AC3E}">
        <p14:creationId xmlns:p14="http://schemas.microsoft.com/office/powerpoint/2010/main" val="200683550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mphasize that Fred is very unlikely to accept the staff's perspectives on the problem and he will very likely reject the staff's perspectives on who he is as a person and what he's like.</a:t>
            </a:r>
          </a:p>
          <a:p>
            <a:endParaRPr lang="en-US" dirty="0"/>
          </a:p>
          <a:p>
            <a:r>
              <a:rPr lang="en-US" dirty="0"/>
              <a:t>So now turn the tables. Now ask participants to put themselves in Fred's shoes. How does Fred see the problem? How does Fred believe that he is being treated at the hospital? How does Fred believe that the staff view him?</a:t>
            </a:r>
          </a:p>
          <a:p>
            <a:endParaRPr lang="en-US" dirty="0"/>
          </a:p>
          <a:p>
            <a:r>
              <a:rPr lang="en-US" dirty="0"/>
              <a:t>Emphasize that the exercise only works if they truly attempt to see the situation from Fred's point of view. When they respond, prompt them to use the word "I" in their responses.</a:t>
            </a:r>
          </a:p>
          <a:p>
            <a:endParaRPr lang="en-US" dirty="0"/>
          </a:p>
          <a:p>
            <a:r>
              <a:rPr lang="en-US" dirty="0"/>
              <a:t>Perspectives that participants might take from Fred’s vantage point might include: “No one cares about me here,” “They think I am lying about being in pain and my pain is real,” “They are all biased against me because of my past,” “I can never get anyone to help me here; no one listens to me,” “They treat me like a loser.”</a:t>
            </a:r>
          </a:p>
          <a:p>
            <a:endParaRPr lang="en-US" dirty="0"/>
          </a:p>
          <a:p>
            <a:r>
              <a:rPr lang="en-US" dirty="0"/>
              <a:t>Wrap up the discussion of the case of Fred by asking participants if their reflections on Fred's possible interests have altered their earlier views of Fred and his situation. Did the change in focus from positions to interests change the way they see Fred? </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64852B7C-D082-4672-99B3-9CB2A90DA81C}" type="slidenum">
              <a:rPr lang="en-US" smtClean="0"/>
              <a:t>22</a:t>
            </a:fld>
            <a:endParaRPr lang="en-US"/>
          </a:p>
        </p:txBody>
      </p:sp>
    </p:spTree>
    <p:extLst>
      <p:ext uri="{BB962C8B-B14F-4D97-AF65-F5344CB8AC3E}">
        <p14:creationId xmlns:p14="http://schemas.microsoft.com/office/powerpoint/2010/main" val="402851486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small groups of 3-8 people, taking 5-15 minutes, use the breakout assignment of Appendix B. Review the questions on this slide and then read the vignette on the following slide. Keep the case study visible while the small groups work through the questions on Appendix B.</a:t>
            </a:r>
          </a:p>
        </p:txBody>
      </p:sp>
      <p:sp>
        <p:nvSpPr>
          <p:cNvPr id="4" name="Slide Number Placeholder 3"/>
          <p:cNvSpPr>
            <a:spLocks noGrp="1"/>
          </p:cNvSpPr>
          <p:nvPr>
            <p:ph type="sldNum" sz="quarter" idx="5"/>
          </p:nvPr>
        </p:nvSpPr>
        <p:spPr/>
        <p:txBody>
          <a:bodyPr/>
          <a:lstStyle/>
          <a:p>
            <a:fld id="{64852B7C-D082-4672-99B3-9CB2A90DA81C}" type="slidenum">
              <a:rPr lang="en-US" smtClean="0"/>
              <a:t>23</a:t>
            </a:fld>
            <a:endParaRPr lang="en-US"/>
          </a:p>
        </p:txBody>
      </p:sp>
    </p:spTree>
    <p:extLst>
      <p:ext uri="{BB962C8B-B14F-4D97-AF65-F5344CB8AC3E}">
        <p14:creationId xmlns:p14="http://schemas.microsoft.com/office/powerpoint/2010/main" val="247620185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4852B7C-D082-4672-99B3-9CB2A90DA81C}" type="slidenum">
              <a:rPr lang="en-US" smtClean="0"/>
              <a:t>24</a:t>
            </a:fld>
            <a:endParaRPr lang="en-US"/>
          </a:p>
        </p:txBody>
      </p:sp>
    </p:spTree>
    <p:extLst>
      <p:ext uri="{BB962C8B-B14F-4D97-AF65-F5344CB8AC3E}">
        <p14:creationId xmlns:p14="http://schemas.microsoft.com/office/powerpoint/2010/main" val="309825112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the small groups have completed their exercise, reassemble the group and review that the first technique for managing challenging clinical interactions is to gather the perspective of each stakeholder in the conflict.</a:t>
            </a:r>
          </a:p>
        </p:txBody>
      </p:sp>
      <p:sp>
        <p:nvSpPr>
          <p:cNvPr id="4" name="Slide Number Placeholder 3"/>
          <p:cNvSpPr>
            <a:spLocks noGrp="1"/>
          </p:cNvSpPr>
          <p:nvPr>
            <p:ph type="sldNum" sz="quarter" idx="5"/>
          </p:nvPr>
        </p:nvSpPr>
        <p:spPr/>
        <p:txBody>
          <a:bodyPr/>
          <a:lstStyle/>
          <a:p>
            <a:fld id="{64852B7C-D082-4672-99B3-9CB2A90DA81C}" type="slidenum">
              <a:rPr lang="en-US" smtClean="0"/>
              <a:t>25</a:t>
            </a:fld>
            <a:endParaRPr lang="en-US"/>
          </a:p>
        </p:txBody>
      </p:sp>
    </p:spTree>
    <p:extLst>
      <p:ext uri="{BB962C8B-B14F-4D97-AF65-F5344CB8AC3E}">
        <p14:creationId xmlns:p14="http://schemas.microsoft.com/office/powerpoint/2010/main" val="137737134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e this slide to review the theory behind the “View from Everywhere” and it’s crucial role in conflict diagnosis: a conflict cannot be solved if the mediator has an incomplete picture of the problem, that is, the perspective of each involved stakeholder. Ask participants if they have any remaining questions about the employment of cognitive empathy as a kind of “muscle” that enables them to grasp radically different perspectives and vantage points. </a:t>
            </a:r>
          </a:p>
        </p:txBody>
      </p:sp>
      <p:sp>
        <p:nvSpPr>
          <p:cNvPr id="4" name="Slide Number Placeholder 3"/>
          <p:cNvSpPr>
            <a:spLocks noGrp="1"/>
          </p:cNvSpPr>
          <p:nvPr>
            <p:ph type="sldNum" sz="quarter" idx="10"/>
          </p:nvPr>
        </p:nvSpPr>
        <p:spPr/>
        <p:txBody>
          <a:bodyPr/>
          <a:lstStyle/>
          <a:p>
            <a:fld id="{4113E939-DDDC-4CBB-AB59-F6D3052E6013}" type="slidenum">
              <a:rPr lang="en-US" smtClean="0"/>
              <a:t>26</a:t>
            </a:fld>
            <a:endParaRPr lang="en-US"/>
          </a:p>
        </p:txBody>
      </p:sp>
    </p:spTree>
    <p:extLst>
      <p:ext uri="{BB962C8B-B14F-4D97-AF65-F5344CB8AC3E}">
        <p14:creationId xmlns:p14="http://schemas.microsoft.com/office/powerpoint/2010/main" val="54065602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econd technique that mediators use to begin to navigate conflict is to employ the terms "positions" versus "interests.“ These terms will be explained on the subsequent slides, but the purpose in employing this dichotomy is to gain a richer understanding of the motivations and needs that undergird the stances taken by different parties in the conflict.</a:t>
            </a:r>
          </a:p>
        </p:txBody>
      </p:sp>
      <p:sp>
        <p:nvSpPr>
          <p:cNvPr id="4" name="Slide Number Placeholder 3"/>
          <p:cNvSpPr>
            <a:spLocks noGrp="1"/>
          </p:cNvSpPr>
          <p:nvPr>
            <p:ph type="sldNum" sz="quarter" idx="10"/>
          </p:nvPr>
        </p:nvSpPr>
        <p:spPr/>
        <p:txBody>
          <a:bodyPr/>
          <a:lstStyle/>
          <a:p>
            <a:fld id="{4113E939-DDDC-4CBB-AB59-F6D3052E6013}" type="slidenum">
              <a:rPr lang="en-US" smtClean="0"/>
              <a:t>27</a:t>
            </a:fld>
            <a:endParaRPr lang="en-US"/>
          </a:p>
        </p:txBody>
      </p:sp>
    </p:spTree>
    <p:extLst>
      <p:ext uri="{BB962C8B-B14F-4D97-AF65-F5344CB8AC3E}">
        <p14:creationId xmlns:p14="http://schemas.microsoft.com/office/powerpoint/2010/main" val="378105753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terms come from the authors of the classic text, </a:t>
            </a:r>
            <a:r>
              <a:rPr lang="en-US" i="1" dirty="0"/>
              <a:t>Getting to Yes</a:t>
            </a:r>
            <a:r>
              <a:rPr lang="en-US" dirty="0"/>
              <a:t>. The authors were two of the founders of the Harvard Negotiation Project. They introduced a core dichotomy that is now a common framework that mediators use to help stakeholders uncover the underlying motives and reasons.</a:t>
            </a:r>
          </a:p>
        </p:txBody>
      </p:sp>
      <p:sp>
        <p:nvSpPr>
          <p:cNvPr id="4" name="Slide Number Placeholder 3"/>
          <p:cNvSpPr>
            <a:spLocks noGrp="1"/>
          </p:cNvSpPr>
          <p:nvPr>
            <p:ph type="sldNum" sz="quarter" idx="5"/>
          </p:nvPr>
        </p:nvSpPr>
        <p:spPr/>
        <p:txBody>
          <a:bodyPr/>
          <a:lstStyle/>
          <a:p>
            <a:fld id="{64852B7C-D082-4672-99B3-9CB2A90DA81C}" type="slidenum">
              <a:rPr lang="en-US" smtClean="0"/>
              <a:t>28</a:t>
            </a:fld>
            <a:endParaRPr lang="en-US"/>
          </a:p>
        </p:txBody>
      </p:sp>
    </p:spTree>
    <p:extLst>
      <p:ext uri="{BB962C8B-B14F-4D97-AF65-F5344CB8AC3E}">
        <p14:creationId xmlns:p14="http://schemas.microsoft.com/office/powerpoint/2010/main" val="173124886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ing the image of a tree and its roots, explain that positions are the stances that individuals take on a particular issue that are visible and clear from the choices people are making and testimonials they give about the conflict. When participants brainstormed the perspectives of the clinical staff and then Fred in the “View from Everyone” exercise, they were actually stating what mediators call  “positions.” What mediators know is that resolving conflict requires that the parties understand the anchoring reasons – i.e., the "roots" – of the conflict that drive the individual's positions. These are called “interests.” Interests anchor positions. </a:t>
            </a:r>
          </a:p>
        </p:txBody>
      </p:sp>
      <p:sp>
        <p:nvSpPr>
          <p:cNvPr id="4" name="Slide Number Placeholder 3"/>
          <p:cNvSpPr>
            <a:spLocks noGrp="1"/>
          </p:cNvSpPr>
          <p:nvPr>
            <p:ph type="sldNum" sz="quarter" idx="5"/>
          </p:nvPr>
        </p:nvSpPr>
        <p:spPr/>
        <p:txBody>
          <a:bodyPr/>
          <a:lstStyle/>
          <a:p>
            <a:fld id="{64852B7C-D082-4672-99B3-9CB2A90DA81C}" type="slidenum">
              <a:rPr lang="en-US" smtClean="0"/>
              <a:t>29</a:t>
            </a:fld>
            <a:endParaRPr lang="en-US"/>
          </a:p>
        </p:txBody>
      </p:sp>
    </p:spTree>
    <p:extLst>
      <p:ext uri="{BB962C8B-B14F-4D97-AF65-F5344CB8AC3E}">
        <p14:creationId xmlns:p14="http://schemas.microsoft.com/office/powerpoint/2010/main" val="210616591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a:t>
            </a:r>
          </a:p>
          <a:p>
            <a:pPr marL="171450" indent="-171450">
              <a:buFont typeface="Arial" panose="020B0604020202020204" pitchFamily="34" charset="0"/>
              <a:buChar char="•"/>
            </a:pPr>
            <a:r>
              <a:rPr lang="en-US" dirty="0"/>
              <a:t>Many clinical conflict involving patients or families that providers find to be "difficult," so the following slides provide some backdrop from the literature about challenging patients and families.</a:t>
            </a:r>
          </a:p>
        </p:txBody>
      </p:sp>
      <p:sp>
        <p:nvSpPr>
          <p:cNvPr id="4" name="Slide Number Placeholder 3"/>
          <p:cNvSpPr>
            <a:spLocks noGrp="1"/>
          </p:cNvSpPr>
          <p:nvPr>
            <p:ph type="sldNum" sz="quarter" idx="5"/>
          </p:nvPr>
        </p:nvSpPr>
        <p:spPr/>
        <p:txBody>
          <a:bodyPr/>
          <a:lstStyle/>
          <a:p>
            <a:fld id="{64852B7C-D082-4672-99B3-9CB2A90DA81C}" type="slidenum">
              <a:rPr lang="en-US" smtClean="0"/>
              <a:t>3</a:t>
            </a:fld>
            <a:endParaRPr lang="en-US"/>
          </a:p>
        </p:txBody>
      </p:sp>
    </p:spTree>
    <p:extLst>
      <p:ext uri="{BB962C8B-B14F-4D97-AF65-F5344CB8AC3E}">
        <p14:creationId xmlns:p14="http://schemas.microsoft.com/office/powerpoint/2010/main" val="267279438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mphasize that if positions are the “what” people say they want or “what” they think about a situation, the interests are the “why.” An individual's interests are often not easily visible. Those interests are the person's needs and concerns – what matters to the individual and how their values generate the stances they take.</a:t>
            </a:r>
          </a:p>
        </p:txBody>
      </p:sp>
      <p:sp>
        <p:nvSpPr>
          <p:cNvPr id="4" name="Slide Number Placeholder 3"/>
          <p:cNvSpPr>
            <a:spLocks noGrp="1"/>
          </p:cNvSpPr>
          <p:nvPr>
            <p:ph type="sldNum" sz="quarter" idx="5"/>
          </p:nvPr>
        </p:nvSpPr>
        <p:spPr/>
        <p:txBody>
          <a:bodyPr/>
          <a:lstStyle/>
          <a:p>
            <a:fld id="{64852B7C-D082-4672-99B3-9CB2A90DA81C}" type="slidenum">
              <a:rPr lang="en-US" smtClean="0"/>
              <a:t>30</a:t>
            </a:fld>
            <a:endParaRPr lang="en-US"/>
          </a:p>
        </p:txBody>
      </p:sp>
    </p:spTree>
    <p:extLst>
      <p:ext uri="{BB962C8B-B14F-4D97-AF65-F5344CB8AC3E}">
        <p14:creationId xmlns:p14="http://schemas.microsoft.com/office/powerpoint/2010/main" val="2277983854"/>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mphasize that the reason mediators do not focus on positions is that they rarely allow for compromise. It is very hard to solve a problem when focusing on positions since most conflicts involve two contradictory stances and perspectives (as participants saw in the first exercise regarding Fred). But diametrically opposed positions can sometimes be generated by overlapping motives. And even when two diametrically opposed positions are not anchored by overlapping reasons, uncovering those underlying interests enables the stakeholders to see each other as fellow human beings with understandable motivations. </a:t>
            </a:r>
          </a:p>
        </p:txBody>
      </p:sp>
      <p:sp>
        <p:nvSpPr>
          <p:cNvPr id="4" name="Slide Number Placeholder 3"/>
          <p:cNvSpPr>
            <a:spLocks noGrp="1"/>
          </p:cNvSpPr>
          <p:nvPr>
            <p:ph type="sldNum" sz="quarter" idx="5"/>
          </p:nvPr>
        </p:nvSpPr>
        <p:spPr/>
        <p:txBody>
          <a:bodyPr/>
          <a:lstStyle/>
          <a:p>
            <a:fld id="{64852B7C-D082-4672-99B3-9CB2A90DA81C}" type="slidenum">
              <a:rPr lang="en-US" smtClean="0"/>
              <a:t>31</a:t>
            </a:fld>
            <a:endParaRPr lang="en-US"/>
          </a:p>
        </p:txBody>
      </p:sp>
    </p:spTree>
    <p:extLst>
      <p:ext uri="{BB962C8B-B14F-4D97-AF65-F5344CB8AC3E}">
        <p14:creationId xmlns:p14="http://schemas.microsoft.com/office/powerpoint/2010/main" val="342644965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sher and </a:t>
            </a:r>
            <a:r>
              <a:rPr lang="en-US" dirty="0" err="1"/>
              <a:t>Ury</a:t>
            </a:r>
            <a:r>
              <a:rPr lang="en-US" dirty="0"/>
              <a:t> flag the pitfall that is so common among novice mediators: Getting fixated on positions rather than uncovering the motivations that underlie them. Focusing a mediation on positions is likely to have both parties “dig their heels in,” quickly reaching what Fisher and </a:t>
            </a:r>
            <a:r>
              <a:rPr lang="en-US" dirty="0" err="1"/>
              <a:t>Ury</a:t>
            </a:r>
            <a:r>
              <a:rPr lang="en-US" dirty="0"/>
              <a:t> refer to as the “impasse.”  Have participants brainstorm diametrically opposed positions in political life or in the context of healthcare. An example of opposing political positions might be: “I believe we should raise taxes,” and “I believe we should not raise taxes.”  In the healthcare context, a common disagreement in positions is: “I believe Mr. Jones should have a DNR,” and “I believe Mr. Jones should be a full code.”  Have them reflect on the prospect of coming to an agreement or consensus on the positions they list. </a:t>
            </a:r>
          </a:p>
          <a:p>
            <a:endParaRPr lang="en-US" dirty="0"/>
          </a:p>
          <a:p>
            <a:r>
              <a:rPr lang="en-US" dirty="0"/>
              <a:t>Ask participants to name the possible conflicting positions between Fred and the clinical staff.</a:t>
            </a:r>
          </a:p>
        </p:txBody>
      </p:sp>
      <p:sp>
        <p:nvSpPr>
          <p:cNvPr id="4" name="Slide Number Placeholder 3"/>
          <p:cNvSpPr>
            <a:spLocks noGrp="1"/>
          </p:cNvSpPr>
          <p:nvPr>
            <p:ph type="sldNum" sz="quarter" idx="5"/>
          </p:nvPr>
        </p:nvSpPr>
        <p:spPr/>
        <p:txBody>
          <a:bodyPr/>
          <a:lstStyle/>
          <a:p>
            <a:fld id="{64852B7C-D082-4672-99B3-9CB2A90DA81C}" type="slidenum">
              <a:rPr lang="en-US" smtClean="0"/>
              <a:t>32</a:t>
            </a:fld>
            <a:endParaRPr lang="en-US"/>
          </a:p>
        </p:txBody>
      </p:sp>
    </p:spTree>
    <p:extLst>
      <p:ext uri="{BB962C8B-B14F-4D97-AF65-F5344CB8AC3E}">
        <p14:creationId xmlns:p14="http://schemas.microsoft.com/office/powerpoint/2010/main" val="3625302088"/>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break through the impasse, mediators need to understand the “why” behind the positions individuals hold. </a:t>
            </a:r>
          </a:p>
          <a:p>
            <a:endParaRPr lang="en-US" dirty="0"/>
          </a:p>
          <a:p>
            <a:r>
              <a:rPr lang="en-US" dirty="0"/>
              <a:t>Emphasize that stakeholders will not readily reveal their own interests because they, too, believe that the conflict is about their positions. The mediator has to work to help the stakeholders share their underlying reasons so that the conversation can be productive and resolutions can become possible.</a:t>
            </a:r>
          </a:p>
        </p:txBody>
      </p:sp>
      <p:sp>
        <p:nvSpPr>
          <p:cNvPr id="4" name="Slide Number Placeholder 3"/>
          <p:cNvSpPr>
            <a:spLocks noGrp="1"/>
          </p:cNvSpPr>
          <p:nvPr>
            <p:ph type="sldNum" sz="quarter" idx="5"/>
          </p:nvPr>
        </p:nvSpPr>
        <p:spPr/>
        <p:txBody>
          <a:bodyPr/>
          <a:lstStyle/>
          <a:p>
            <a:fld id="{64852B7C-D082-4672-99B3-9CB2A90DA81C}" type="slidenum">
              <a:rPr lang="en-US" smtClean="0"/>
              <a:t>33</a:t>
            </a:fld>
            <a:endParaRPr lang="en-US"/>
          </a:p>
        </p:txBody>
      </p:sp>
    </p:spTree>
    <p:extLst>
      <p:ext uri="{BB962C8B-B14F-4D97-AF65-F5344CB8AC3E}">
        <p14:creationId xmlns:p14="http://schemas.microsoft.com/office/powerpoint/2010/main" val="4225170192"/>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4852B7C-D082-4672-99B3-9CB2A90DA81C}" type="slidenum">
              <a:rPr lang="en-US" smtClean="0"/>
              <a:t>34</a:t>
            </a:fld>
            <a:endParaRPr lang="en-US"/>
          </a:p>
        </p:txBody>
      </p:sp>
    </p:spTree>
    <p:extLst>
      <p:ext uri="{BB962C8B-B14F-4D97-AF65-F5344CB8AC3E}">
        <p14:creationId xmlns:p14="http://schemas.microsoft.com/office/powerpoint/2010/main" val="90757455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all-group exercise, participants will return to the vignette about Fred to try to uncover the interests of both the staff and Fred.</a:t>
            </a:r>
          </a:p>
          <a:p>
            <a:endParaRPr lang="en-US" dirty="0"/>
          </a:p>
          <a:p>
            <a:r>
              <a:rPr lang="en-US" dirty="0"/>
              <a:t>Direct participants to the prompts on the following slide, which are designed to reveal interests and it away from positions.</a:t>
            </a:r>
          </a:p>
        </p:txBody>
      </p:sp>
      <p:sp>
        <p:nvSpPr>
          <p:cNvPr id="4" name="Slide Number Placeholder 3"/>
          <p:cNvSpPr>
            <a:spLocks noGrp="1"/>
          </p:cNvSpPr>
          <p:nvPr>
            <p:ph type="sldNum" sz="quarter" idx="5"/>
          </p:nvPr>
        </p:nvSpPr>
        <p:spPr/>
        <p:txBody>
          <a:bodyPr/>
          <a:lstStyle/>
          <a:p>
            <a:fld id="{64852B7C-D082-4672-99B3-9CB2A90DA81C}" type="slidenum">
              <a:rPr lang="en-US" smtClean="0"/>
              <a:t>35</a:t>
            </a:fld>
            <a:endParaRPr lang="en-US"/>
          </a:p>
        </p:txBody>
      </p:sp>
    </p:spTree>
    <p:extLst>
      <p:ext uri="{BB962C8B-B14F-4D97-AF65-F5344CB8AC3E}">
        <p14:creationId xmlns:p14="http://schemas.microsoft.com/office/powerpoint/2010/main" val="4043898693"/>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gin with the perspective of the staff. Have each member of the group use one of the 4 prompts to try to get underneath the surface of their stance about Fred and their definition of the problem to think through what is driving their perspective. Ask them to use one of the prompts to talk about their worry, need, concern, or values that generate the positions they take about Fred.</a:t>
            </a:r>
          </a:p>
          <a:p>
            <a:endParaRPr lang="en-US" dirty="0"/>
          </a:p>
          <a:p>
            <a:r>
              <a:rPr lang="en-US" dirty="0"/>
              <a:t>Interests that might be underlie the staff’s stated positions about Fred might include: “I have a need to feel that my work matters to patients,”  “I have a need to be treated with respect,” “I am worried about how this patient is affecting my mental well-being,” “I am concerned about burn-out.”</a:t>
            </a:r>
          </a:p>
          <a:p>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64852B7C-D082-4672-99B3-9CB2A90DA81C}" type="slidenum">
              <a:rPr lang="en-US" smtClean="0"/>
              <a:t>36</a:t>
            </a:fld>
            <a:endParaRPr lang="en-US"/>
          </a:p>
        </p:txBody>
      </p:sp>
    </p:spTree>
    <p:extLst>
      <p:ext uri="{BB962C8B-B14F-4D97-AF65-F5344CB8AC3E}">
        <p14:creationId xmlns:p14="http://schemas.microsoft.com/office/powerpoint/2010/main" val="4157493693"/>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move from thinking about the interests of the staff to the potential interest of Fred.</a:t>
            </a:r>
          </a:p>
          <a:p>
            <a:endParaRPr lang="en-US" dirty="0"/>
          </a:p>
          <a:p>
            <a:r>
              <a:rPr lang="en-US" dirty="0"/>
              <a:t>Interests that might be underlie “Fred’s” stated positions might include: “I have a need to feel cared for,”  “I have a need to be treated with respect,” “I am worried about how I will take care of myself after discharge.” </a:t>
            </a:r>
          </a:p>
          <a:p>
            <a:endParaRPr lang="en-US" dirty="0"/>
          </a:p>
        </p:txBody>
      </p:sp>
      <p:sp>
        <p:nvSpPr>
          <p:cNvPr id="4" name="Slide Number Placeholder 3"/>
          <p:cNvSpPr>
            <a:spLocks noGrp="1"/>
          </p:cNvSpPr>
          <p:nvPr>
            <p:ph type="sldNum" sz="quarter" idx="5"/>
          </p:nvPr>
        </p:nvSpPr>
        <p:spPr/>
        <p:txBody>
          <a:bodyPr/>
          <a:lstStyle/>
          <a:p>
            <a:fld id="{64852B7C-D082-4672-99B3-9CB2A90DA81C}" type="slidenum">
              <a:rPr lang="en-US" smtClean="0"/>
              <a:t>37</a:t>
            </a:fld>
            <a:endParaRPr lang="en-US"/>
          </a:p>
        </p:txBody>
      </p:sp>
    </p:spTree>
    <p:extLst>
      <p:ext uri="{BB962C8B-B14F-4D97-AF65-F5344CB8AC3E}">
        <p14:creationId xmlns:p14="http://schemas.microsoft.com/office/powerpoint/2010/main" val="3453133590"/>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ing the same 4 prompts, what are Fred's interests?</a:t>
            </a:r>
          </a:p>
        </p:txBody>
      </p:sp>
      <p:sp>
        <p:nvSpPr>
          <p:cNvPr id="4" name="Slide Number Placeholder 3"/>
          <p:cNvSpPr>
            <a:spLocks noGrp="1"/>
          </p:cNvSpPr>
          <p:nvPr>
            <p:ph type="sldNum" sz="quarter" idx="5"/>
          </p:nvPr>
        </p:nvSpPr>
        <p:spPr/>
        <p:txBody>
          <a:bodyPr/>
          <a:lstStyle/>
          <a:p>
            <a:fld id="{64852B7C-D082-4672-99B3-9CB2A90DA81C}" type="slidenum">
              <a:rPr lang="en-US" smtClean="0"/>
              <a:t>38</a:t>
            </a:fld>
            <a:endParaRPr lang="en-US"/>
          </a:p>
        </p:txBody>
      </p:sp>
    </p:spTree>
    <p:extLst>
      <p:ext uri="{BB962C8B-B14F-4D97-AF65-F5344CB8AC3E}">
        <p14:creationId xmlns:p14="http://schemas.microsoft.com/office/powerpoint/2010/main" val="3009034504"/>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turn to the case of Mr. Roberts. In small groups of 3-8 people, taking 5-15 minutes, use the breakout assignment of Appendix C. </a:t>
            </a:r>
          </a:p>
        </p:txBody>
      </p:sp>
      <p:sp>
        <p:nvSpPr>
          <p:cNvPr id="4" name="Slide Number Placeholder 3"/>
          <p:cNvSpPr>
            <a:spLocks noGrp="1"/>
          </p:cNvSpPr>
          <p:nvPr>
            <p:ph type="sldNum" sz="quarter" idx="5"/>
          </p:nvPr>
        </p:nvSpPr>
        <p:spPr/>
        <p:txBody>
          <a:bodyPr/>
          <a:lstStyle/>
          <a:p>
            <a:fld id="{64852B7C-D082-4672-99B3-9CB2A90DA81C}" type="slidenum">
              <a:rPr lang="en-US" smtClean="0"/>
              <a:t>39</a:t>
            </a:fld>
            <a:endParaRPr lang="en-US"/>
          </a:p>
        </p:txBody>
      </p:sp>
    </p:spTree>
    <p:extLst>
      <p:ext uri="{BB962C8B-B14F-4D97-AF65-F5344CB8AC3E}">
        <p14:creationId xmlns:p14="http://schemas.microsoft.com/office/powerpoint/2010/main" val="445097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is a large literature that documents how common it is for providers to encounter patients or families that they find challenging. An equally large literature documents many types of inappropriate behavior towards the treating team and the impact this has on physicians and other providers.</a:t>
            </a:r>
          </a:p>
        </p:txBody>
      </p:sp>
      <p:sp>
        <p:nvSpPr>
          <p:cNvPr id="4" name="Slide Number Placeholder 3"/>
          <p:cNvSpPr>
            <a:spLocks noGrp="1"/>
          </p:cNvSpPr>
          <p:nvPr>
            <p:ph type="sldNum" sz="quarter" idx="5"/>
          </p:nvPr>
        </p:nvSpPr>
        <p:spPr/>
        <p:txBody>
          <a:bodyPr/>
          <a:lstStyle/>
          <a:p>
            <a:fld id="{64852B7C-D082-4672-99B3-9CB2A90DA81C}" type="slidenum">
              <a:rPr lang="en-US" smtClean="0"/>
              <a:t>4</a:t>
            </a:fld>
            <a:endParaRPr lang="en-US"/>
          </a:p>
        </p:txBody>
      </p:sp>
    </p:spTree>
    <p:extLst>
      <p:ext uri="{BB962C8B-B14F-4D97-AF65-F5344CB8AC3E}">
        <p14:creationId xmlns:p14="http://schemas.microsoft.com/office/powerpoint/2010/main" val="1831762040"/>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eep this vignette slide posted so the participants can refer back to it as they work through the questions of Appendix C.</a:t>
            </a:r>
          </a:p>
        </p:txBody>
      </p:sp>
      <p:sp>
        <p:nvSpPr>
          <p:cNvPr id="4" name="Slide Number Placeholder 3"/>
          <p:cNvSpPr>
            <a:spLocks noGrp="1"/>
          </p:cNvSpPr>
          <p:nvPr>
            <p:ph type="sldNum" sz="quarter" idx="5"/>
          </p:nvPr>
        </p:nvSpPr>
        <p:spPr/>
        <p:txBody>
          <a:bodyPr/>
          <a:lstStyle/>
          <a:p>
            <a:fld id="{64852B7C-D082-4672-99B3-9CB2A90DA81C}" type="slidenum">
              <a:rPr lang="en-US" smtClean="0"/>
              <a:t>40</a:t>
            </a:fld>
            <a:endParaRPr lang="en-US"/>
          </a:p>
        </p:txBody>
      </p:sp>
    </p:spTree>
    <p:extLst>
      <p:ext uri="{BB962C8B-B14F-4D97-AF65-F5344CB8AC3E}">
        <p14:creationId xmlns:p14="http://schemas.microsoft.com/office/powerpoint/2010/main" val="1753260525"/>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9"/>
        <p:cNvGrpSpPr/>
        <p:nvPr/>
      </p:nvGrpSpPr>
      <p:grpSpPr>
        <a:xfrm>
          <a:off x="0" y="0"/>
          <a:ext cx="0" cy="0"/>
          <a:chOff x="0" y="0"/>
          <a:chExt cx="0" cy="0"/>
        </a:xfrm>
      </p:grpSpPr>
      <p:sp>
        <p:nvSpPr>
          <p:cNvPr id="510" name="Google Shape;510;gc0a949d52d_0_1:notes"/>
          <p:cNvSpPr>
            <a:spLocks noGrp="1" noRot="1" noChangeAspect="1"/>
          </p:cNvSpPr>
          <p:nvPr>
            <p:ph type="sldImg" idx="2"/>
          </p:nvPr>
        </p:nvSpPr>
        <p:spPr>
          <a:xfrm>
            <a:off x="1414463" y="1162050"/>
            <a:ext cx="418147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11" name="Google Shape;511;gc0a949d52d_0_1:notes"/>
          <p:cNvSpPr txBox="1">
            <a:spLocks noGrp="1"/>
          </p:cNvSpPr>
          <p:nvPr>
            <p:ph type="body" idx="1"/>
          </p:nvPr>
        </p:nvSpPr>
        <p:spPr>
          <a:xfrm>
            <a:off x="701040" y="4473892"/>
            <a:ext cx="5608200" cy="366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After the breakout session, reassemble as a group to review the key Takeaways from the workshop: Reframe, 360° View, &amp; Interests. Read the summary bullet points for each.</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Encourage participants to discuss what they have learned, raise questions and offer examples of conflicts for which they might use these techniques.</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Pass out the workshop evaluation form to solicit participants’ feedback.</a:t>
            </a:r>
          </a:p>
          <a:p>
            <a:pPr marL="0" lvl="0" indent="0" algn="l" rtl="0">
              <a:lnSpc>
                <a:spcPct val="100000"/>
              </a:lnSpc>
              <a:spcBef>
                <a:spcPts val="0"/>
              </a:spcBef>
              <a:spcAft>
                <a:spcPts val="0"/>
              </a:spcAft>
              <a:buSzPts val="1400"/>
              <a:buNone/>
            </a:pPr>
            <a:endParaRPr dirty="0"/>
          </a:p>
        </p:txBody>
      </p:sp>
      <p:sp>
        <p:nvSpPr>
          <p:cNvPr id="512" name="Google Shape;512;gc0a949d52d_0_1:notes"/>
          <p:cNvSpPr txBox="1">
            <a:spLocks noGrp="1"/>
          </p:cNvSpPr>
          <p:nvPr>
            <p:ph type="sldNum" idx="12"/>
          </p:nvPr>
        </p:nvSpPr>
        <p:spPr>
          <a:xfrm>
            <a:off x="3970938" y="8829970"/>
            <a:ext cx="3037800" cy="4665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41</a:t>
            </a:fld>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courage participants to explore the literature referred to in the workshop.</a:t>
            </a:r>
          </a:p>
        </p:txBody>
      </p:sp>
      <p:sp>
        <p:nvSpPr>
          <p:cNvPr id="4" name="Slide Number Placeholder 3"/>
          <p:cNvSpPr>
            <a:spLocks noGrp="1"/>
          </p:cNvSpPr>
          <p:nvPr>
            <p:ph type="sldNum" sz="quarter" idx="5"/>
          </p:nvPr>
        </p:nvSpPr>
        <p:spPr/>
        <p:txBody>
          <a:bodyPr/>
          <a:lstStyle/>
          <a:p>
            <a:fld id="{64852B7C-D082-4672-99B3-9CB2A90DA81C}" type="slidenum">
              <a:rPr lang="en-US" smtClean="0"/>
              <a:t>42</a:t>
            </a:fld>
            <a:endParaRPr lang="en-US"/>
          </a:p>
        </p:txBody>
      </p:sp>
    </p:spTree>
    <p:extLst>
      <p:ext uri="{BB962C8B-B14F-4D97-AF65-F5344CB8AC3E}">
        <p14:creationId xmlns:p14="http://schemas.microsoft.com/office/powerpoint/2010/main" val="128430647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cause it is typically physicians or nurses who do research on problematic clinical encounters, research on challenging patients or families comes from the vantage point of those on the clinical side of the dyad. Early work in this area frequently labeled the cause of these problematic interactions to be the patient's psychiatric status. </a:t>
            </a:r>
          </a:p>
          <a:p>
            <a:endParaRPr lang="en-US" dirty="0"/>
          </a:p>
          <a:p>
            <a:r>
              <a:rPr lang="en-US" dirty="0"/>
              <a:t>Emphasize that this conventional view of challenging patients and families works against the prospect of improving such interactions because psychiatric status or even moral character is not easily amended. Mediators resist using such explanations because they undermine the resolve at finding a workable solution in the short term.</a:t>
            </a:r>
          </a:p>
        </p:txBody>
      </p:sp>
      <p:sp>
        <p:nvSpPr>
          <p:cNvPr id="4" name="Slide Number Placeholder 3"/>
          <p:cNvSpPr>
            <a:spLocks noGrp="1"/>
          </p:cNvSpPr>
          <p:nvPr>
            <p:ph type="sldNum" sz="quarter" idx="5"/>
          </p:nvPr>
        </p:nvSpPr>
        <p:spPr/>
        <p:txBody>
          <a:bodyPr/>
          <a:lstStyle/>
          <a:p>
            <a:fld id="{64852B7C-D082-4672-99B3-9CB2A90DA81C}" type="slidenum">
              <a:rPr lang="en-US" smtClean="0"/>
              <a:t>5</a:t>
            </a:fld>
            <a:endParaRPr lang="en-US"/>
          </a:p>
        </p:txBody>
      </p:sp>
    </p:spTree>
    <p:extLst>
      <p:ext uri="{BB962C8B-B14F-4D97-AF65-F5344CB8AC3E}">
        <p14:creationId xmlns:p14="http://schemas.microsoft.com/office/powerpoint/2010/main" val="29694338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re recent literature focuses on the interactions between the clinical team and patients and their families rather than locating the cause of the problem in just one of the stakeholders.</a:t>
            </a:r>
          </a:p>
          <a:p>
            <a:endParaRPr lang="en-US" dirty="0"/>
          </a:p>
          <a:p>
            <a:r>
              <a:rPr lang="en-US" dirty="0"/>
              <a:t>Read the short blurb from each of the five papers mentioned and encourage participants to look at that literature after the session (listed in the work cited).</a:t>
            </a:r>
          </a:p>
          <a:p>
            <a:endParaRPr lang="en-US" dirty="0"/>
          </a:p>
          <a:p>
            <a:r>
              <a:rPr lang="en-US" dirty="0"/>
              <a:t>Facilitators can use these quotations as a jumping off point for discussion. For example, ask participants whether they conceive of their medical career as a “calling” and ask whether that conception influences how they perceive provider-patient conflicts. Or, ask participants if they have examples of from their own clinical practice of “blind spots” that might have contributed to conflict escalation.  </a:t>
            </a:r>
          </a:p>
        </p:txBody>
      </p:sp>
      <p:sp>
        <p:nvSpPr>
          <p:cNvPr id="4" name="Slide Number Placeholder 3"/>
          <p:cNvSpPr>
            <a:spLocks noGrp="1"/>
          </p:cNvSpPr>
          <p:nvPr>
            <p:ph type="sldNum" sz="quarter" idx="5"/>
          </p:nvPr>
        </p:nvSpPr>
        <p:spPr/>
        <p:txBody>
          <a:bodyPr/>
          <a:lstStyle/>
          <a:p>
            <a:fld id="{64852B7C-D082-4672-99B3-9CB2A90DA81C}" type="slidenum">
              <a:rPr lang="en-US" smtClean="0"/>
              <a:t>6</a:t>
            </a:fld>
            <a:endParaRPr lang="en-US"/>
          </a:p>
        </p:txBody>
      </p:sp>
    </p:spTree>
    <p:extLst>
      <p:ext uri="{BB962C8B-B14F-4D97-AF65-F5344CB8AC3E}">
        <p14:creationId xmlns:p14="http://schemas.microsoft.com/office/powerpoint/2010/main" val="218001332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ediators define conflict as existing between and among stakeholders. They do not point fingers at particular stakeholders and assign the blame to them. Mediators view conflict as "inter-personal."</a:t>
            </a:r>
          </a:p>
          <a:p>
            <a:endParaRPr lang="en-US" dirty="0"/>
          </a:p>
          <a:p>
            <a:r>
              <a:rPr lang="en-US" dirty="0"/>
              <a:t>Emphasize that the reframing of the "difficult" patients or family involves seeing a shared problem rather than a guilty instigator.</a:t>
            </a:r>
          </a:p>
        </p:txBody>
      </p:sp>
      <p:sp>
        <p:nvSpPr>
          <p:cNvPr id="4" name="Slide Number Placeholder 3"/>
          <p:cNvSpPr>
            <a:spLocks noGrp="1"/>
          </p:cNvSpPr>
          <p:nvPr>
            <p:ph type="sldNum" sz="quarter" idx="5"/>
          </p:nvPr>
        </p:nvSpPr>
        <p:spPr/>
        <p:txBody>
          <a:bodyPr/>
          <a:lstStyle/>
          <a:p>
            <a:fld id="{64852B7C-D082-4672-99B3-9CB2A90DA81C}" type="slidenum">
              <a:rPr lang="en-US" smtClean="0"/>
              <a:t>7</a:t>
            </a:fld>
            <a:endParaRPr lang="en-US"/>
          </a:p>
        </p:txBody>
      </p:sp>
    </p:spTree>
    <p:extLst>
      <p:ext uri="{BB962C8B-B14F-4D97-AF65-F5344CB8AC3E}">
        <p14:creationId xmlns:p14="http://schemas.microsoft.com/office/powerpoint/2010/main" val="305758717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2 main techniques mediators use to launch the process of navigating interpersonal conflict: defining the problem in a way that honors all of the voices in the conflict and moving the conversation away from the stances that stakeholders take and towards the reasons why they take those stances. These are the two techniques participants will learn in this workshop. Both of these techniques will be explained, and then participants will engage in a group exercise and a breakout exercise to practice the concept.</a:t>
            </a:r>
          </a:p>
        </p:txBody>
      </p:sp>
      <p:sp>
        <p:nvSpPr>
          <p:cNvPr id="4" name="Slide Number Placeholder 3"/>
          <p:cNvSpPr>
            <a:spLocks noGrp="1"/>
          </p:cNvSpPr>
          <p:nvPr>
            <p:ph type="sldNum" sz="quarter" idx="10"/>
          </p:nvPr>
        </p:nvSpPr>
        <p:spPr/>
        <p:txBody>
          <a:bodyPr/>
          <a:lstStyle/>
          <a:p>
            <a:fld id="{4113E939-DDDC-4CBB-AB59-F6D3052E6013}" type="slidenum">
              <a:rPr lang="en-US" smtClean="0"/>
              <a:t>8</a:t>
            </a:fld>
            <a:endParaRPr lang="en-US"/>
          </a:p>
        </p:txBody>
      </p:sp>
    </p:spTree>
    <p:extLst>
      <p:ext uri="{BB962C8B-B14F-4D97-AF65-F5344CB8AC3E}">
        <p14:creationId xmlns:p14="http://schemas.microsoft.com/office/powerpoint/2010/main" val="377010600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case out loud. This case will be used to learn both of the techniques and for the group exercises.</a:t>
            </a:r>
          </a:p>
        </p:txBody>
      </p:sp>
      <p:sp>
        <p:nvSpPr>
          <p:cNvPr id="4" name="Slide Number Placeholder 3"/>
          <p:cNvSpPr>
            <a:spLocks noGrp="1"/>
          </p:cNvSpPr>
          <p:nvPr>
            <p:ph type="sldNum" sz="quarter" idx="5"/>
          </p:nvPr>
        </p:nvSpPr>
        <p:spPr/>
        <p:txBody>
          <a:bodyPr/>
          <a:lstStyle/>
          <a:p>
            <a:fld id="{64852B7C-D082-4672-99B3-9CB2A90DA81C}" type="slidenum">
              <a:rPr lang="en-US" smtClean="0"/>
              <a:t>9</a:t>
            </a:fld>
            <a:endParaRPr lang="en-US"/>
          </a:p>
        </p:txBody>
      </p:sp>
    </p:spTree>
    <p:extLst>
      <p:ext uri="{BB962C8B-B14F-4D97-AF65-F5344CB8AC3E}">
        <p14:creationId xmlns:p14="http://schemas.microsoft.com/office/powerpoint/2010/main" val="427393925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9F43C3-CB54-4E3C-BE4D-4A2C7373F518}"/>
              </a:ext>
            </a:extLst>
          </p:cNvPr>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A9E41666-9C56-4856-8F9F-268215CF22F8}"/>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BC3B8B88-CF3F-4F81-9F85-02932251AAA6}"/>
              </a:ext>
            </a:extLst>
          </p:cNvPr>
          <p:cNvSpPr>
            <a:spLocks noGrp="1"/>
          </p:cNvSpPr>
          <p:nvPr>
            <p:ph type="dt" sz="half" idx="10"/>
          </p:nvPr>
        </p:nvSpPr>
        <p:spPr/>
        <p:txBody>
          <a:bodyPr/>
          <a:lstStyle/>
          <a:p>
            <a:pPr>
              <a:defRPr/>
            </a:pPr>
            <a:endParaRPr lang="en-US"/>
          </a:p>
        </p:txBody>
      </p:sp>
      <p:sp>
        <p:nvSpPr>
          <p:cNvPr id="5" name="Footer Placeholder 4">
            <a:extLst>
              <a:ext uri="{FF2B5EF4-FFF2-40B4-BE49-F238E27FC236}">
                <a16:creationId xmlns:a16="http://schemas.microsoft.com/office/drawing/2014/main" id="{293C1AF3-28AA-42A0-8F9D-B8D5CFF16DD3}"/>
              </a:ext>
            </a:extLst>
          </p:cNvPr>
          <p:cNvSpPr>
            <a:spLocks noGrp="1"/>
          </p:cNvSpPr>
          <p:nvPr>
            <p:ph type="ftr" sz="quarter" idx="11"/>
          </p:nvPr>
        </p:nvSpPr>
        <p:spPr/>
        <p:txBody>
          <a:bodyPr/>
          <a:lstStyle/>
          <a:p>
            <a:pPr>
              <a:defRPr/>
            </a:pPr>
            <a:endParaRPr lang="en-US"/>
          </a:p>
        </p:txBody>
      </p:sp>
      <p:sp>
        <p:nvSpPr>
          <p:cNvPr id="6" name="Slide Number Placeholder 5">
            <a:extLst>
              <a:ext uri="{FF2B5EF4-FFF2-40B4-BE49-F238E27FC236}">
                <a16:creationId xmlns:a16="http://schemas.microsoft.com/office/drawing/2014/main" id="{9C446B02-4579-4E95-826F-938FCCA6B57D}"/>
              </a:ext>
            </a:extLst>
          </p:cNvPr>
          <p:cNvSpPr>
            <a:spLocks noGrp="1"/>
          </p:cNvSpPr>
          <p:nvPr>
            <p:ph type="sldNum" sz="quarter" idx="12"/>
          </p:nvPr>
        </p:nvSpPr>
        <p:spPr/>
        <p:txBody>
          <a:bodyPr/>
          <a:lstStyle/>
          <a:p>
            <a:pPr>
              <a:defRPr/>
            </a:pPr>
            <a:fld id="{14479727-C58B-4572-9708-F578FD8D44B8}" type="slidenum">
              <a:rPr lang="en-US" smtClean="0"/>
              <a:pPr>
                <a:defRPr/>
              </a:pPr>
              <a:t>‹#›</a:t>
            </a:fld>
            <a:endParaRPr lang="en-US"/>
          </a:p>
        </p:txBody>
      </p:sp>
    </p:spTree>
    <p:extLst>
      <p:ext uri="{BB962C8B-B14F-4D97-AF65-F5344CB8AC3E}">
        <p14:creationId xmlns:p14="http://schemas.microsoft.com/office/powerpoint/2010/main" val="11169760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0D4332-7A11-44A0-A322-BFC4E218157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CD01004-1B81-4CFF-B71F-78F356A47C8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282B518-E986-4C13-9AA7-0DF54C3DCDD0}"/>
              </a:ext>
            </a:extLst>
          </p:cNvPr>
          <p:cNvSpPr>
            <a:spLocks noGrp="1"/>
          </p:cNvSpPr>
          <p:nvPr>
            <p:ph type="dt" sz="half" idx="10"/>
          </p:nvPr>
        </p:nvSpPr>
        <p:spPr/>
        <p:txBody>
          <a:bodyPr/>
          <a:lstStyle/>
          <a:p>
            <a:pPr>
              <a:defRPr/>
            </a:pPr>
            <a:endParaRPr lang="en-US"/>
          </a:p>
        </p:txBody>
      </p:sp>
      <p:sp>
        <p:nvSpPr>
          <p:cNvPr id="5" name="Footer Placeholder 4">
            <a:extLst>
              <a:ext uri="{FF2B5EF4-FFF2-40B4-BE49-F238E27FC236}">
                <a16:creationId xmlns:a16="http://schemas.microsoft.com/office/drawing/2014/main" id="{4707D21F-291A-4DE8-805B-3A6DB44CACDA}"/>
              </a:ext>
            </a:extLst>
          </p:cNvPr>
          <p:cNvSpPr>
            <a:spLocks noGrp="1"/>
          </p:cNvSpPr>
          <p:nvPr>
            <p:ph type="ftr" sz="quarter" idx="11"/>
          </p:nvPr>
        </p:nvSpPr>
        <p:spPr/>
        <p:txBody>
          <a:bodyPr/>
          <a:lstStyle/>
          <a:p>
            <a:pPr>
              <a:defRPr/>
            </a:pPr>
            <a:endParaRPr lang="en-US"/>
          </a:p>
        </p:txBody>
      </p:sp>
      <p:sp>
        <p:nvSpPr>
          <p:cNvPr id="6" name="Slide Number Placeholder 5">
            <a:extLst>
              <a:ext uri="{FF2B5EF4-FFF2-40B4-BE49-F238E27FC236}">
                <a16:creationId xmlns:a16="http://schemas.microsoft.com/office/drawing/2014/main" id="{D9E42E50-8B75-4621-B834-792474A66CE4}"/>
              </a:ext>
            </a:extLst>
          </p:cNvPr>
          <p:cNvSpPr>
            <a:spLocks noGrp="1"/>
          </p:cNvSpPr>
          <p:nvPr>
            <p:ph type="sldNum" sz="quarter" idx="12"/>
          </p:nvPr>
        </p:nvSpPr>
        <p:spPr/>
        <p:txBody>
          <a:bodyPr/>
          <a:lstStyle/>
          <a:p>
            <a:pPr>
              <a:defRPr/>
            </a:pPr>
            <a:fld id="{9E219872-3A2C-4FF6-8B62-3A8FF6F7C521}" type="slidenum">
              <a:rPr lang="en-US" smtClean="0"/>
              <a:pPr>
                <a:defRPr/>
              </a:pPr>
              <a:t>‹#›</a:t>
            </a:fld>
            <a:endParaRPr lang="en-US"/>
          </a:p>
        </p:txBody>
      </p:sp>
    </p:spTree>
    <p:extLst>
      <p:ext uri="{BB962C8B-B14F-4D97-AF65-F5344CB8AC3E}">
        <p14:creationId xmlns:p14="http://schemas.microsoft.com/office/powerpoint/2010/main" val="4134434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F800D65-9371-434B-8109-2CE6B5E0FEDB}"/>
              </a:ext>
            </a:extLst>
          </p:cNvPr>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B2ADAE2-3B88-4B4A-842D-4AAE1C77AD43}"/>
              </a:ext>
            </a:extLst>
          </p:cNvPr>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3DB4B00-7799-4104-BC28-F5188C33633C}"/>
              </a:ext>
            </a:extLst>
          </p:cNvPr>
          <p:cNvSpPr>
            <a:spLocks noGrp="1"/>
          </p:cNvSpPr>
          <p:nvPr>
            <p:ph type="dt" sz="half" idx="10"/>
          </p:nvPr>
        </p:nvSpPr>
        <p:spPr/>
        <p:txBody>
          <a:bodyPr/>
          <a:lstStyle/>
          <a:p>
            <a:pPr>
              <a:defRPr/>
            </a:pPr>
            <a:endParaRPr lang="en-US"/>
          </a:p>
        </p:txBody>
      </p:sp>
      <p:sp>
        <p:nvSpPr>
          <p:cNvPr id="5" name="Footer Placeholder 4">
            <a:extLst>
              <a:ext uri="{FF2B5EF4-FFF2-40B4-BE49-F238E27FC236}">
                <a16:creationId xmlns:a16="http://schemas.microsoft.com/office/drawing/2014/main" id="{92671F90-1A43-4E1E-AD51-41829D1B1F17}"/>
              </a:ext>
            </a:extLst>
          </p:cNvPr>
          <p:cNvSpPr>
            <a:spLocks noGrp="1"/>
          </p:cNvSpPr>
          <p:nvPr>
            <p:ph type="ftr" sz="quarter" idx="11"/>
          </p:nvPr>
        </p:nvSpPr>
        <p:spPr/>
        <p:txBody>
          <a:bodyPr/>
          <a:lstStyle/>
          <a:p>
            <a:pPr>
              <a:defRPr/>
            </a:pPr>
            <a:endParaRPr lang="en-US"/>
          </a:p>
        </p:txBody>
      </p:sp>
      <p:sp>
        <p:nvSpPr>
          <p:cNvPr id="6" name="Slide Number Placeholder 5">
            <a:extLst>
              <a:ext uri="{FF2B5EF4-FFF2-40B4-BE49-F238E27FC236}">
                <a16:creationId xmlns:a16="http://schemas.microsoft.com/office/drawing/2014/main" id="{1ED1D9A1-B0EE-4D76-A556-14A7ADF01676}"/>
              </a:ext>
            </a:extLst>
          </p:cNvPr>
          <p:cNvSpPr>
            <a:spLocks noGrp="1"/>
          </p:cNvSpPr>
          <p:nvPr>
            <p:ph type="sldNum" sz="quarter" idx="12"/>
          </p:nvPr>
        </p:nvSpPr>
        <p:spPr/>
        <p:txBody>
          <a:bodyPr/>
          <a:lstStyle/>
          <a:p>
            <a:pPr>
              <a:defRPr/>
            </a:pPr>
            <a:fld id="{2208634C-4ED2-4C99-AF10-BF5C5B214A15}" type="slidenum">
              <a:rPr lang="en-US" smtClean="0"/>
              <a:pPr>
                <a:defRPr/>
              </a:pPr>
              <a:t>‹#›</a:t>
            </a:fld>
            <a:endParaRPr lang="en-US"/>
          </a:p>
        </p:txBody>
      </p:sp>
    </p:spTree>
    <p:extLst>
      <p:ext uri="{BB962C8B-B14F-4D97-AF65-F5344CB8AC3E}">
        <p14:creationId xmlns:p14="http://schemas.microsoft.com/office/powerpoint/2010/main" val="6453002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F3F506-CD1C-4BC3-B7E7-A68E1334496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3084A7F-32F7-4455-BBEA-786A6376ADB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AFE4EAC-7279-4A81-9B99-0B55A82EF870}"/>
              </a:ext>
            </a:extLst>
          </p:cNvPr>
          <p:cNvSpPr>
            <a:spLocks noGrp="1"/>
          </p:cNvSpPr>
          <p:nvPr>
            <p:ph type="dt" sz="half" idx="10"/>
          </p:nvPr>
        </p:nvSpPr>
        <p:spPr/>
        <p:txBody>
          <a:bodyPr/>
          <a:lstStyle/>
          <a:p>
            <a:pPr>
              <a:defRPr/>
            </a:pPr>
            <a:endParaRPr lang="en-US"/>
          </a:p>
        </p:txBody>
      </p:sp>
      <p:sp>
        <p:nvSpPr>
          <p:cNvPr id="5" name="Footer Placeholder 4">
            <a:extLst>
              <a:ext uri="{FF2B5EF4-FFF2-40B4-BE49-F238E27FC236}">
                <a16:creationId xmlns:a16="http://schemas.microsoft.com/office/drawing/2014/main" id="{B57EC7D8-EB90-48E5-8691-982F71950FE4}"/>
              </a:ext>
            </a:extLst>
          </p:cNvPr>
          <p:cNvSpPr>
            <a:spLocks noGrp="1"/>
          </p:cNvSpPr>
          <p:nvPr>
            <p:ph type="ftr" sz="quarter" idx="11"/>
          </p:nvPr>
        </p:nvSpPr>
        <p:spPr/>
        <p:txBody>
          <a:bodyPr/>
          <a:lstStyle/>
          <a:p>
            <a:pPr>
              <a:defRPr/>
            </a:pPr>
            <a:endParaRPr lang="en-US"/>
          </a:p>
        </p:txBody>
      </p:sp>
      <p:sp>
        <p:nvSpPr>
          <p:cNvPr id="6" name="Slide Number Placeholder 5">
            <a:extLst>
              <a:ext uri="{FF2B5EF4-FFF2-40B4-BE49-F238E27FC236}">
                <a16:creationId xmlns:a16="http://schemas.microsoft.com/office/drawing/2014/main" id="{8B92F5A3-46B8-4096-89E6-0065B957680C}"/>
              </a:ext>
            </a:extLst>
          </p:cNvPr>
          <p:cNvSpPr>
            <a:spLocks noGrp="1"/>
          </p:cNvSpPr>
          <p:nvPr>
            <p:ph type="sldNum" sz="quarter" idx="12"/>
          </p:nvPr>
        </p:nvSpPr>
        <p:spPr/>
        <p:txBody>
          <a:bodyPr/>
          <a:lstStyle/>
          <a:p>
            <a:pPr>
              <a:defRPr/>
            </a:pPr>
            <a:fld id="{776B1FFF-83E6-4A2E-84F7-25F85DE83D7B}" type="slidenum">
              <a:rPr lang="en-US" smtClean="0"/>
              <a:pPr>
                <a:defRPr/>
              </a:pPr>
              <a:t>‹#›</a:t>
            </a:fld>
            <a:endParaRPr lang="en-US"/>
          </a:p>
        </p:txBody>
      </p:sp>
    </p:spTree>
    <p:extLst>
      <p:ext uri="{BB962C8B-B14F-4D97-AF65-F5344CB8AC3E}">
        <p14:creationId xmlns:p14="http://schemas.microsoft.com/office/powerpoint/2010/main" val="6267698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FAF529-DB68-41A1-B684-DA9745B3274C}"/>
              </a:ext>
            </a:extLst>
          </p:cNvPr>
          <p:cNvSpPr>
            <a:spLocks noGrp="1"/>
          </p:cNvSpPr>
          <p:nvPr>
            <p:ph type="title"/>
          </p:nvPr>
        </p:nvSpPr>
        <p:spPr>
          <a:xfrm>
            <a:off x="623888" y="1709739"/>
            <a:ext cx="7886700" cy="2852737"/>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4A219EB8-7A7B-46F7-956A-AA5AAC50508F}"/>
              </a:ext>
            </a:extLst>
          </p:cNvPr>
          <p:cNvSpPr>
            <a:spLocks noGrp="1"/>
          </p:cNvSpPr>
          <p:nvPr>
            <p:ph type="body" idx="1"/>
          </p:nvPr>
        </p:nvSpPr>
        <p:spPr>
          <a:xfrm>
            <a:off x="623888" y="4589464"/>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7DB3F11-CF8A-48F2-B808-8BCFB1CA8B12}"/>
              </a:ext>
            </a:extLst>
          </p:cNvPr>
          <p:cNvSpPr>
            <a:spLocks noGrp="1"/>
          </p:cNvSpPr>
          <p:nvPr>
            <p:ph type="dt" sz="half" idx="10"/>
          </p:nvPr>
        </p:nvSpPr>
        <p:spPr/>
        <p:txBody>
          <a:bodyPr/>
          <a:lstStyle/>
          <a:p>
            <a:pPr>
              <a:defRPr/>
            </a:pPr>
            <a:endParaRPr lang="en-US"/>
          </a:p>
        </p:txBody>
      </p:sp>
      <p:sp>
        <p:nvSpPr>
          <p:cNvPr id="5" name="Footer Placeholder 4">
            <a:extLst>
              <a:ext uri="{FF2B5EF4-FFF2-40B4-BE49-F238E27FC236}">
                <a16:creationId xmlns:a16="http://schemas.microsoft.com/office/drawing/2014/main" id="{9B80B38C-1C26-466C-8761-DC97491ABFA2}"/>
              </a:ext>
            </a:extLst>
          </p:cNvPr>
          <p:cNvSpPr>
            <a:spLocks noGrp="1"/>
          </p:cNvSpPr>
          <p:nvPr>
            <p:ph type="ftr" sz="quarter" idx="11"/>
          </p:nvPr>
        </p:nvSpPr>
        <p:spPr/>
        <p:txBody>
          <a:bodyPr/>
          <a:lstStyle/>
          <a:p>
            <a:pPr>
              <a:defRPr/>
            </a:pPr>
            <a:endParaRPr lang="en-US"/>
          </a:p>
        </p:txBody>
      </p:sp>
      <p:sp>
        <p:nvSpPr>
          <p:cNvPr id="6" name="Slide Number Placeholder 5">
            <a:extLst>
              <a:ext uri="{FF2B5EF4-FFF2-40B4-BE49-F238E27FC236}">
                <a16:creationId xmlns:a16="http://schemas.microsoft.com/office/drawing/2014/main" id="{66F8856C-B769-499A-B0EC-8BC194355398}"/>
              </a:ext>
            </a:extLst>
          </p:cNvPr>
          <p:cNvSpPr>
            <a:spLocks noGrp="1"/>
          </p:cNvSpPr>
          <p:nvPr>
            <p:ph type="sldNum" sz="quarter" idx="12"/>
          </p:nvPr>
        </p:nvSpPr>
        <p:spPr/>
        <p:txBody>
          <a:bodyPr/>
          <a:lstStyle/>
          <a:p>
            <a:pPr>
              <a:defRPr/>
            </a:pPr>
            <a:fld id="{BAC212B3-F7CE-49EB-A18B-A694E815A3D8}" type="slidenum">
              <a:rPr lang="en-US" smtClean="0"/>
              <a:pPr>
                <a:defRPr/>
              </a:pPr>
              <a:t>‹#›</a:t>
            </a:fld>
            <a:endParaRPr lang="en-US"/>
          </a:p>
        </p:txBody>
      </p:sp>
    </p:spTree>
    <p:extLst>
      <p:ext uri="{BB962C8B-B14F-4D97-AF65-F5344CB8AC3E}">
        <p14:creationId xmlns:p14="http://schemas.microsoft.com/office/powerpoint/2010/main" val="21267021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6324FF-F3EB-48C4-AD74-6A94BC92DBC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83A1FC3-FCC3-433E-B330-DB2A1A1CD7B7}"/>
              </a:ext>
            </a:extLst>
          </p:cNvPr>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F7C3F5E-D897-401D-AD01-A2AF32D3F60D}"/>
              </a:ext>
            </a:extLst>
          </p:cNvPr>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FC2BD4B-73CF-47B7-B878-79F116F61287}"/>
              </a:ext>
            </a:extLst>
          </p:cNvPr>
          <p:cNvSpPr>
            <a:spLocks noGrp="1"/>
          </p:cNvSpPr>
          <p:nvPr>
            <p:ph type="dt" sz="half" idx="10"/>
          </p:nvPr>
        </p:nvSpPr>
        <p:spPr/>
        <p:txBody>
          <a:bodyPr/>
          <a:lstStyle/>
          <a:p>
            <a:pPr>
              <a:defRPr/>
            </a:pPr>
            <a:endParaRPr lang="en-US"/>
          </a:p>
        </p:txBody>
      </p:sp>
      <p:sp>
        <p:nvSpPr>
          <p:cNvPr id="6" name="Footer Placeholder 5">
            <a:extLst>
              <a:ext uri="{FF2B5EF4-FFF2-40B4-BE49-F238E27FC236}">
                <a16:creationId xmlns:a16="http://schemas.microsoft.com/office/drawing/2014/main" id="{9EF9B23C-6DC4-4F26-B89B-E2DF67739F2E}"/>
              </a:ext>
            </a:extLst>
          </p:cNvPr>
          <p:cNvSpPr>
            <a:spLocks noGrp="1"/>
          </p:cNvSpPr>
          <p:nvPr>
            <p:ph type="ftr" sz="quarter" idx="11"/>
          </p:nvPr>
        </p:nvSpPr>
        <p:spPr/>
        <p:txBody>
          <a:bodyPr/>
          <a:lstStyle/>
          <a:p>
            <a:pPr>
              <a:defRPr/>
            </a:pPr>
            <a:endParaRPr lang="en-US"/>
          </a:p>
        </p:txBody>
      </p:sp>
      <p:sp>
        <p:nvSpPr>
          <p:cNvPr id="7" name="Slide Number Placeholder 6">
            <a:extLst>
              <a:ext uri="{FF2B5EF4-FFF2-40B4-BE49-F238E27FC236}">
                <a16:creationId xmlns:a16="http://schemas.microsoft.com/office/drawing/2014/main" id="{1876BCDF-A4AD-421B-B895-DF4256DD502B}"/>
              </a:ext>
            </a:extLst>
          </p:cNvPr>
          <p:cNvSpPr>
            <a:spLocks noGrp="1"/>
          </p:cNvSpPr>
          <p:nvPr>
            <p:ph type="sldNum" sz="quarter" idx="12"/>
          </p:nvPr>
        </p:nvSpPr>
        <p:spPr/>
        <p:txBody>
          <a:bodyPr/>
          <a:lstStyle/>
          <a:p>
            <a:pPr>
              <a:defRPr/>
            </a:pPr>
            <a:fld id="{8F4F18EC-A856-4394-AB45-84F229F80548}" type="slidenum">
              <a:rPr lang="en-US" smtClean="0"/>
              <a:pPr>
                <a:defRPr/>
              </a:pPr>
              <a:t>‹#›</a:t>
            </a:fld>
            <a:endParaRPr lang="en-US"/>
          </a:p>
        </p:txBody>
      </p:sp>
    </p:spTree>
    <p:extLst>
      <p:ext uri="{BB962C8B-B14F-4D97-AF65-F5344CB8AC3E}">
        <p14:creationId xmlns:p14="http://schemas.microsoft.com/office/powerpoint/2010/main" val="35674171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C71241-BFE1-4C26-A571-354C6F4EBDBB}"/>
              </a:ext>
            </a:extLst>
          </p:cNvPr>
          <p:cNvSpPr>
            <a:spLocks noGrp="1"/>
          </p:cNvSpPr>
          <p:nvPr>
            <p:ph type="title"/>
          </p:nvPr>
        </p:nvSpPr>
        <p:spPr>
          <a:xfrm>
            <a:off x="629841" y="365126"/>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66D662E-FF83-4625-A9AC-A180D5733E11}"/>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440C34D0-1589-4217-8B8E-70E73EA862AE}"/>
              </a:ext>
            </a:extLst>
          </p:cNvPr>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6FEF262-3AE3-4235-A4B0-18BE9D99B7BE}"/>
              </a:ext>
            </a:extLst>
          </p:cNvPr>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B4B8340D-844E-4CB4-BC05-921D6D3ADE54}"/>
              </a:ext>
            </a:extLst>
          </p:cNvPr>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3BAAF51-75D6-47C1-A197-8D5E5AC1869F}"/>
              </a:ext>
            </a:extLst>
          </p:cNvPr>
          <p:cNvSpPr>
            <a:spLocks noGrp="1"/>
          </p:cNvSpPr>
          <p:nvPr>
            <p:ph type="dt" sz="half" idx="10"/>
          </p:nvPr>
        </p:nvSpPr>
        <p:spPr/>
        <p:txBody>
          <a:bodyPr/>
          <a:lstStyle/>
          <a:p>
            <a:pPr>
              <a:defRPr/>
            </a:pPr>
            <a:endParaRPr lang="en-US"/>
          </a:p>
        </p:txBody>
      </p:sp>
      <p:sp>
        <p:nvSpPr>
          <p:cNvPr id="8" name="Footer Placeholder 7">
            <a:extLst>
              <a:ext uri="{FF2B5EF4-FFF2-40B4-BE49-F238E27FC236}">
                <a16:creationId xmlns:a16="http://schemas.microsoft.com/office/drawing/2014/main" id="{DD527F1C-1FC2-4E77-8F13-1BDED00611DE}"/>
              </a:ext>
            </a:extLst>
          </p:cNvPr>
          <p:cNvSpPr>
            <a:spLocks noGrp="1"/>
          </p:cNvSpPr>
          <p:nvPr>
            <p:ph type="ftr" sz="quarter" idx="11"/>
          </p:nvPr>
        </p:nvSpPr>
        <p:spPr/>
        <p:txBody>
          <a:bodyPr/>
          <a:lstStyle/>
          <a:p>
            <a:pPr>
              <a:defRPr/>
            </a:pPr>
            <a:endParaRPr lang="en-US"/>
          </a:p>
        </p:txBody>
      </p:sp>
      <p:sp>
        <p:nvSpPr>
          <p:cNvPr id="9" name="Slide Number Placeholder 8">
            <a:extLst>
              <a:ext uri="{FF2B5EF4-FFF2-40B4-BE49-F238E27FC236}">
                <a16:creationId xmlns:a16="http://schemas.microsoft.com/office/drawing/2014/main" id="{731371C0-BC96-4040-B71D-D20DBCCD5CA0}"/>
              </a:ext>
            </a:extLst>
          </p:cNvPr>
          <p:cNvSpPr>
            <a:spLocks noGrp="1"/>
          </p:cNvSpPr>
          <p:nvPr>
            <p:ph type="sldNum" sz="quarter" idx="12"/>
          </p:nvPr>
        </p:nvSpPr>
        <p:spPr/>
        <p:txBody>
          <a:bodyPr/>
          <a:lstStyle/>
          <a:p>
            <a:pPr>
              <a:defRPr/>
            </a:pPr>
            <a:fld id="{DD39CCD9-C7EE-4807-B9C3-E4243C9E1F8A}" type="slidenum">
              <a:rPr lang="en-US" smtClean="0"/>
              <a:pPr>
                <a:defRPr/>
              </a:pPr>
              <a:t>‹#›</a:t>
            </a:fld>
            <a:endParaRPr lang="en-US"/>
          </a:p>
        </p:txBody>
      </p:sp>
    </p:spTree>
    <p:extLst>
      <p:ext uri="{BB962C8B-B14F-4D97-AF65-F5344CB8AC3E}">
        <p14:creationId xmlns:p14="http://schemas.microsoft.com/office/powerpoint/2010/main" val="40229681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410652-9BA9-42DE-9E44-1B724010705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D71E2EF-5208-4C35-91C9-76E4BD8755B9}"/>
              </a:ext>
            </a:extLst>
          </p:cNvPr>
          <p:cNvSpPr>
            <a:spLocks noGrp="1"/>
          </p:cNvSpPr>
          <p:nvPr>
            <p:ph type="dt" sz="half" idx="10"/>
          </p:nvPr>
        </p:nvSpPr>
        <p:spPr/>
        <p:txBody>
          <a:bodyPr/>
          <a:lstStyle/>
          <a:p>
            <a:pPr>
              <a:defRPr/>
            </a:pPr>
            <a:endParaRPr lang="en-US"/>
          </a:p>
        </p:txBody>
      </p:sp>
      <p:sp>
        <p:nvSpPr>
          <p:cNvPr id="4" name="Footer Placeholder 3">
            <a:extLst>
              <a:ext uri="{FF2B5EF4-FFF2-40B4-BE49-F238E27FC236}">
                <a16:creationId xmlns:a16="http://schemas.microsoft.com/office/drawing/2014/main" id="{ABC0B31A-0B76-47D2-ACBB-BBCDAD27911E}"/>
              </a:ext>
            </a:extLst>
          </p:cNvPr>
          <p:cNvSpPr>
            <a:spLocks noGrp="1"/>
          </p:cNvSpPr>
          <p:nvPr>
            <p:ph type="ftr" sz="quarter" idx="11"/>
          </p:nvPr>
        </p:nvSpPr>
        <p:spPr/>
        <p:txBody>
          <a:bodyPr/>
          <a:lstStyle/>
          <a:p>
            <a:pPr>
              <a:defRPr/>
            </a:pPr>
            <a:endParaRPr lang="en-US"/>
          </a:p>
        </p:txBody>
      </p:sp>
      <p:sp>
        <p:nvSpPr>
          <p:cNvPr id="5" name="Slide Number Placeholder 4">
            <a:extLst>
              <a:ext uri="{FF2B5EF4-FFF2-40B4-BE49-F238E27FC236}">
                <a16:creationId xmlns:a16="http://schemas.microsoft.com/office/drawing/2014/main" id="{73F50E6B-0366-425C-86CF-52221407AF44}"/>
              </a:ext>
            </a:extLst>
          </p:cNvPr>
          <p:cNvSpPr>
            <a:spLocks noGrp="1"/>
          </p:cNvSpPr>
          <p:nvPr>
            <p:ph type="sldNum" sz="quarter" idx="12"/>
          </p:nvPr>
        </p:nvSpPr>
        <p:spPr/>
        <p:txBody>
          <a:bodyPr/>
          <a:lstStyle/>
          <a:p>
            <a:pPr>
              <a:defRPr/>
            </a:pPr>
            <a:fld id="{2300572F-A5AF-4982-B5BD-5219CD8A9801}" type="slidenum">
              <a:rPr lang="en-US" smtClean="0"/>
              <a:pPr>
                <a:defRPr/>
              </a:pPr>
              <a:t>‹#›</a:t>
            </a:fld>
            <a:endParaRPr lang="en-US"/>
          </a:p>
        </p:txBody>
      </p:sp>
    </p:spTree>
    <p:extLst>
      <p:ext uri="{BB962C8B-B14F-4D97-AF65-F5344CB8AC3E}">
        <p14:creationId xmlns:p14="http://schemas.microsoft.com/office/powerpoint/2010/main" val="22922735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7337F68-F407-4C73-B2AF-23CDDF0D8CB5}"/>
              </a:ext>
            </a:extLst>
          </p:cNvPr>
          <p:cNvSpPr>
            <a:spLocks noGrp="1"/>
          </p:cNvSpPr>
          <p:nvPr>
            <p:ph type="dt" sz="half" idx="10"/>
          </p:nvPr>
        </p:nvSpPr>
        <p:spPr/>
        <p:txBody>
          <a:bodyPr/>
          <a:lstStyle/>
          <a:p>
            <a:pPr>
              <a:defRPr/>
            </a:pPr>
            <a:endParaRPr lang="en-US"/>
          </a:p>
        </p:txBody>
      </p:sp>
      <p:sp>
        <p:nvSpPr>
          <p:cNvPr id="3" name="Footer Placeholder 2">
            <a:extLst>
              <a:ext uri="{FF2B5EF4-FFF2-40B4-BE49-F238E27FC236}">
                <a16:creationId xmlns:a16="http://schemas.microsoft.com/office/drawing/2014/main" id="{74326C11-F7BE-4277-9315-AC21F9E01D41}"/>
              </a:ext>
            </a:extLst>
          </p:cNvPr>
          <p:cNvSpPr>
            <a:spLocks noGrp="1"/>
          </p:cNvSpPr>
          <p:nvPr>
            <p:ph type="ftr" sz="quarter" idx="11"/>
          </p:nvPr>
        </p:nvSpPr>
        <p:spPr/>
        <p:txBody>
          <a:bodyPr/>
          <a:lstStyle/>
          <a:p>
            <a:pPr>
              <a:defRPr/>
            </a:pPr>
            <a:endParaRPr lang="en-US"/>
          </a:p>
        </p:txBody>
      </p:sp>
      <p:sp>
        <p:nvSpPr>
          <p:cNvPr id="4" name="Slide Number Placeholder 3">
            <a:extLst>
              <a:ext uri="{FF2B5EF4-FFF2-40B4-BE49-F238E27FC236}">
                <a16:creationId xmlns:a16="http://schemas.microsoft.com/office/drawing/2014/main" id="{906ACAC1-C84F-462F-9FC7-D1E1D641E3D4}"/>
              </a:ext>
            </a:extLst>
          </p:cNvPr>
          <p:cNvSpPr>
            <a:spLocks noGrp="1"/>
          </p:cNvSpPr>
          <p:nvPr>
            <p:ph type="sldNum" sz="quarter" idx="12"/>
          </p:nvPr>
        </p:nvSpPr>
        <p:spPr/>
        <p:txBody>
          <a:bodyPr/>
          <a:lstStyle/>
          <a:p>
            <a:pPr>
              <a:defRPr/>
            </a:pPr>
            <a:fld id="{07E50E4A-0983-48BD-A093-48E85EE8AE4E}" type="slidenum">
              <a:rPr lang="en-US" smtClean="0"/>
              <a:pPr>
                <a:defRPr/>
              </a:pPr>
              <a:t>‹#›</a:t>
            </a:fld>
            <a:endParaRPr lang="en-US"/>
          </a:p>
        </p:txBody>
      </p:sp>
    </p:spTree>
    <p:extLst>
      <p:ext uri="{BB962C8B-B14F-4D97-AF65-F5344CB8AC3E}">
        <p14:creationId xmlns:p14="http://schemas.microsoft.com/office/powerpoint/2010/main" val="19611059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435165-9BDA-446D-87AE-C04D6204BBF1}"/>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79380E16-A8B2-4798-96C6-D9D11381B1F7}"/>
              </a:ext>
            </a:extLst>
          </p:cNvPr>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22EC5EA-E4C9-49D5-B797-46F7D04B3B5B}"/>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DA269F1F-AB22-4081-8AD6-A7FD9A023D21}"/>
              </a:ext>
            </a:extLst>
          </p:cNvPr>
          <p:cNvSpPr>
            <a:spLocks noGrp="1"/>
          </p:cNvSpPr>
          <p:nvPr>
            <p:ph type="dt" sz="half" idx="10"/>
          </p:nvPr>
        </p:nvSpPr>
        <p:spPr/>
        <p:txBody>
          <a:bodyPr/>
          <a:lstStyle/>
          <a:p>
            <a:pPr>
              <a:defRPr/>
            </a:pPr>
            <a:endParaRPr lang="en-US"/>
          </a:p>
        </p:txBody>
      </p:sp>
      <p:sp>
        <p:nvSpPr>
          <p:cNvPr id="6" name="Footer Placeholder 5">
            <a:extLst>
              <a:ext uri="{FF2B5EF4-FFF2-40B4-BE49-F238E27FC236}">
                <a16:creationId xmlns:a16="http://schemas.microsoft.com/office/drawing/2014/main" id="{6FCC13FD-F0E5-40FD-9A2A-23AC4B1C5816}"/>
              </a:ext>
            </a:extLst>
          </p:cNvPr>
          <p:cNvSpPr>
            <a:spLocks noGrp="1"/>
          </p:cNvSpPr>
          <p:nvPr>
            <p:ph type="ftr" sz="quarter" idx="11"/>
          </p:nvPr>
        </p:nvSpPr>
        <p:spPr/>
        <p:txBody>
          <a:bodyPr/>
          <a:lstStyle/>
          <a:p>
            <a:pPr>
              <a:defRPr/>
            </a:pPr>
            <a:endParaRPr lang="en-US"/>
          </a:p>
        </p:txBody>
      </p:sp>
      <p:sp>
        <p:nvSpPr>
          <p:cNvPr id="7" name="Slide Number Placeholder 6">
            <a:extLst>
              <a:ext uri="{FF2B5EF4-FFF2-40B4-BE49-F238E27FC236}">
                <a16:creationId xmlns:a16="http://schemas.microsoft.com/office/drawing/2014/main" id="{7572071B-1F15-4103-85D8-E7BC65774777}"/>
              </a:ext>
            </a:extLst>
          </p:cNvPr>
          <p:cNvSpPr>
            <a:spLocks noGrp="1"/>
          </p:cNvSpPr>
          <p:nvPr>
            <p:ph type="sldNum" sz="quarter" idx="12"/>
          </p:nvPr>
        </p:nvSpPr>
        <p:spPr/>
        <p:txBody>
          <a:bodyPr/>
          <a:lstStyle/>
          <a:p>
            <a:pPr>
              <a:defRPr/>
            </a:pPr>
            <a:fld id="{735B5846-C5BB-44B7-93A2-3DA98957D7AA}" type="slidenum">
              <a:rPr lang="en-US" smtClean="0"/>
              <a:pPr>
                <a:defRPr/>
              </a:pPr>
              <a:t>‹#›</a:t>
            </a:fld>
            <a:endParaRPr lang="en-US"/>
          </a:p>
        </p:txBody>
      </p:sp>
    </p:spTree>
    <p:extLst>
      <p:ext uri="{BB962C8B-B14F-4D97-AF65-F5344CB8AC3E}">
        <p14:creationId xmlns:p14="http://schemas.microsoft.com/office/powerpoint/2010/main" val="29293285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5165E7-7541-4735-851E-68F96DC86335}"/>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7263B8F4-1C0D-4115-AE6F-19C80BE0E8EE}"/>
              </a:ext>
            </a:extLst>
          </p:cNvPr>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B8089542-7F90-4F73-8B65-CD8E03A6E915}"/>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29D47AE9-D9CD-4F06-BD69-64B7C7E616E9}"/>
              </a:ext>
            </a:extLst>
          </p:cNvPr>
          <p:cNvSpPr>
            <a:spLocks noGrp="1"/>
          </p:cNvSpPr>
          <p:nvPr>
            <p:ph type="dt" sz="half" idx="10"/>
          </p:nvPr>
        </p:nvSpPr>
        <p:spPr/>
        <p:txBody>
          <a:bodyPr/>
          <a:lstStyle/>
          <a:p>
            <a:pPr>
              <a:defRPr/>
            </a:pPr>
            <a:endParaRPr lang="en-US"/>
          </a:p>
        </p:txBody>
      </p:sp>
      <p:sp>
        <p:nvSpPr>
          <p:cNvPr id="6" name="Footer Placeholder 5">
            <a:extLst>
              <a:ext uri="{FF2B5EF4-FFF2-40B4-BE49-F238E27FC236}">
                <a16:creationId xmlns:a16="http://schemas.microsoft.com/office/drawing/2014/main" id="{3FC471EA-1F29-4C70-BB1D-32186C27D77E}"/>
              </a:ext>
            </a:extLst>
          </p:cNvPr>
          <p:cNvSpPr>
            <a:spLocks noGrp="1"/>
          </p:cNvSpPr>
          <p:nvPr>
            <p:ph type="ftr" sz="quarter" idx="11"/>
          </p:nvPr>
        </p:nvSpPr>
        <p:spPr/>
        <p:txBody>
          <a:bodyPr/>
          <a:lstStyle/>
          <a:p>
            <a:pPr>
              <a:defRPr/>
            </a:pPr>
            <a:endParaRPr lang="en-US"/>
          </a:p>
        </p:txBody>
      </p:sp>
      <p:sp>
        <p:nvSpPr>
          <p:cNvPr id="7" name="Slide Number Placeholder 6">
            <a:extLst>
              <a:ext uri="{FF2B5EF4-FFF2-40B4-BE49-F238E27FC236}">
                <a16:creationId xmlns:a16="http://schemas.microsoft.com/office/drawing/2014/main" id="{25819721-E18B-418E-A334-49E1D9BFBCB6}"/>
              </a:ext>
            </a:extLst>
          </p:cNvPr>
          <p:cNvSpPr>
            <a:spLocks noGrp="1"/>
          </p:cNvSpPr>
          <p:nvPr>
            <p:ph type="sldNum" sz="quarter" idx="12"/>
          </p:nvPr>
        </p:nvSpPr>
        <p:spPr/>
        <p:txBody>
          <a:bodyPr/>
          <a:lstStyle/>
          <a:p>
            <a:pPr>
              <a:defRPr/>
            </a:pPr>
            <a:fld id="{C71A496E-B06F-4820-B058-91B8048FDAB1}" type="slidenum">
              <a:rPr lang="en-US" smtClean="0"/>
              <a:pPr>
                <a:defRPr/>
              </a:pPr>
              <a:t>‹#›</a:t>
            </a:fld>
            <a:endParaRPr lang="en-US"/>
          </a:p>
        </p:txBody>
      </p:sp>
    </p:spTree>
    <p:extLst>
      <p:ext uri="{BB962C8B-B14F-4D97-AF65-F5344CB8AC3E}">
        <p14:creationId xmlns:p14="http://schemas.microsoft.com/office/powerpoint/2010/main" val="36196664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C830FFA-0901-46BF-8FDD-56AD3BEB7D6E}"/>
              </a:ext>
            </a:extLst>
          </p:cNvPr>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5F222CE-4137-4654-ADA6-F392D8828DA8}"/>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5FF3DB5-DDBD-409E-B93C-A0505E419FB2}"/>
              </a:ext>
            </a:extLst>
          </p:cNvPr>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pPr>
              <a:defRPr/>
            </a:pPr>
            <a:endParaRPr lang="en-US"/>
          </a:p>
        </p:txBody>
      </p:sp>
      <p:sp>
        <p:nvSpPr>
          <p:cNvPr id="5" name="Footer Placeholder 4">
            <a:extLst>
              <a:ext uri="{FF2B5EF4-FFF2-40B4-BE49-F238E27FC236}">
                <a16:creationId xmlns:a16="http://schemas.microsoft.com/office/drawing/2014/main" id="{264D7378-81BF-4EAB-8BBF-AFF9E316C33F}"/>
              </a:ext>
            </a:extLst>
          </p:cNvPr>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pPr>
              <a:defRPr/>
            </a:pPr>
            <a:endParaRPr lang="en-US"/>
          </a:p>
        </p:txBody>
      </p:sp>
      <p:sp>
        <p:nvSpPr>
          <p:cNvPr id="6" name="Slide Number Placeholder 5">
            <a:extLst>
              <a:ext uri="{FF2B5EF4-FFF2-40B4-BE49-F238E27FC236}">
                <a16:creationId xmlns:a16="http://schemas.microsoft.com/office/drawing/2014/main" id="{6F93AED1-6592-426B-80F8-185A2EA77EDA}"/>
              </a:ext>
            </a:extLst>
          </p:cNvPr>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pPr>
              <a:defRPr/>
            </a:pPr>
            <a:fld id="{20120A46-B161-4536-A872-08E99A2B8A64}" type="slidenum">
              <a:rPr lang="en-US" smtClean="0"/>
              <a:pPr>
                <a:defRPr/>
              </a:pPr>
              <a:t>‹#›</a:t>
            </a:fld>
            <a:endParaRPr lang="en-US"/>
          </a:p>
        </p:txBody>
      </p:sp>
    </p:spTree>
    <p:extLst>
      <p:ext uri="{BB962C8B-B14F-4D97-AF65-F5344CB8AC3E}">
        <p14:creationId xmlns:p14="http://schemas.microsoft.com/office/powerpoint/2010/main" val="3318157872"/>
      </p:ext>
    </p:extLst>
  </p:cSld>
  <p:clrMap bg1="lt1" tx1="dk1" bg2="lt2" tx2="dk2" accent1="accent1" accent2="accent2" accent3="accent3" accent4="accent4" accent5="accent5" accent6="accent6" hlink="hlink" folHlink="folHlink"/>
  <p:sldLayoutIdLst>
    <p:sldLayoutId id="2147483678" r:id="rId1"/>
    <p:sldLayoutId id="2147483679" r:id="rId2"/>
    <p:sldLayoutId id="2147483680" r:id="rId3"/>
    <p:sldLayoutId id="2147483681" r:id="rId4"/>
    <p:sldLayoutId id="2147483682" r:id="rId5"/>
    <p:sldLayoutId id="2147483683" r:id="rId6"/>
    <p:sldLayoutId id="2147483684" r:id="rId7"/>
    <p:sldLayoutId id="2147483685" r:id="rId8"/>
    <p:sldLayoutId id="2147483686" r:id="rId9"/>
    <p:sldLayoutId id="2147483687" r:id="rId10"/>
    <p:sldLayoutId id="2147483688"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customXml" Target="../ink/ink1.xml"/><Relationship Id="rId7" Type="http://schemas.openxmlformats.org/officeDocument/2006/relationships/customXml" Target="../ink/ink3.xml"/><Relationship Id="rId2" Type="http://schemas.openxmlformats.org/officeDocument/2006/relationships/notesSlide" Target="../notesSlides/notesSlide29.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customXml" Target="../ink/ink2.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30.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customXml" Target="../ink/ink4.xml"/><Relationship Id="rId7" Type="http://schemas.openxmlformats.org/officeDocument/2006/relationships/customXml" Target="../ink/ink6.xml"/><Relationship Id="rId2" Type="http://schemas.openxmlformats.org/officeDocument/2006/relationships/notesSlide" Target="../notesSlides/notesSlide30.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customXml" Target="../ink/ink5.xml"/><Relationship Id="rId4" Type="http://schemas.openxmlformats.org/officeDocument/2006/relationships/image" Target="../media/image4.png"/></Relationships>
</file>

<file path=ppt/slides/_rels/slide3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customXml" Target="../ink/ink7.xml"/><Relationship Id="rId7" Type="http://schemas.openxmlformats.org/officeDocument/2006/relationships/customXml" Target="../ink/ink9.xml"/><Relationship Id="rId2" Type="http://schemas.openxmlformats.org/officeDocument/2006/relationships/notesSlide" Target="../notesSlides/notesSlide31.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customXml" Target="../ink/ink8.xml"/><Relationship Id="rId4" Type="http://schemas.openxmlformats.org/officeDocument/2006/relationships/image" Target="../media/image4.png"/></Relationships>
</file>

<file path=ppt/slides/_rels/slide32.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customXml" Target="../ink/ink10.xml"/><Relationship Id="rId7" Type="http://schemas.openxmlformats.org/officeDocument/2006/relationships/customXml" Target="../ink/ink12.xml"/><Relationship Id="rId2" Type="http://schemas.openxmlformats.org/officeDocument/2006/relationships/notesSlide" Target="../notesSlides/notesSlide32.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customXml" Target="../ink/ink11.xml"/><Relationship Id="rId4" Type="http://schemas.openxmlformats.org/officeDocument/2006/relationships/image" Target="../media/image4.png"/></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customXml" Target="../ink/ink13.xml"/><Relationship Id="rId7" Type="http://schemas.openxmlformats.org/officeDocument/2006/relationships/customXml" Target="../ink/ink15.xml"/><Relationship Id="rId2" Type="http://schemas.openxmlformats.org/officeDocument/2006/relationships/notesSlide" Target="../notesSlides/notesSlide35.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customXml" Target="../ink/ink14.xml"/><Relationship Id="rId4" Type="http://schemas.openxmlformats.org/officeDocument/2006/relationships/image" Target="../media/image4.png"/></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customXml" Target="../ink/ink16.xml"/><Relationship Id="rId7" Type="http://schemas.openxmlformats.org/officeDocument/2006/relationships/customXml" Target="../ink/ink18.xml"/><Relationship Id="rId2" Type="http://schemas.openxmlformats.org/officeDocument/2006/relationships/notesSlide" Target="../notesSlides/notesSlide37.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customXml" Target="../ink/ink17.xml"/><Relationship Id="rId4" Type="http://schemas.openxmlformats.org/officeDocument/2006/relationships/image" Target="../media/image4.png"/></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image" Target="../media/image1.png"/><Relationship Id="rId7" Type="http://schemas.openxmlformats.org/officeDocument/2006/relationships/diagramColors" Target="../diagrams/colors1.xml"/><Relationship Id="rId2" Type="http://schemas.openxmlformats.org/officeDocument/2006/relationships/notesSlide" Target="../notesSlides/notesSlide41.xml"/><Relationship Id="rId1" Type="http://schemas.openxmlformats.org/officeDocument/2006/relationships/slideLayout" Target="../slideLayouts/slideLayout2.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0" name="Rectangle 2"/>
          <p:cNvSpPr>
            <a:spLocks noGrp="1" noChangeArrowheads="1"/>
          </p:cNvSpPr>
          <p:nvPr>
            <p:ph type="ctrTitle"/>
          </p:nvPr>
        </p:nvSpPr>
        <p:spPr>
          <a:xfrm>
            <a:off x="76200" y="1447800"/>
            <a:ext cx="8991600" cy="2743200"/>
          </a:xfrm>
        </p:spPr>
        <p:txBody>
          <a:bodyPr>
            <a:normAutofit fontScale="90000"/>
          </a:bodyPr>
          <a:lstStyle/>
          <a:p>
            <a:pPr>
              <a:lnSpc>
                <a:spcPct val="100000"/>
              </a:lnSpc>
              <a:spcBef>
                <a:spcPts val="1200"/>
              </a:spcBef>
              <a:spcAft>
                <a:spcPts val="1200"/>
              </a:spcAft>
            </a:pPr>
            <a:r>
              <a:rPr lang="en-US" sz="5300" b="1" dirty="0">
                <a:effectLst/>
              </a:rPr>
              <a:t>Using the </a:t>
            </a:r>
            <a:r>
              <a:rPr lang="en-US" sz="5300" b="1">
                <a:effectLst/>
              </a:rPr>
              <a:t>Mediator's Toolbox:</a:t>
            </a:r>
            <a:br>
              <a:rPr lang="en-US" sz="5300" b="1" dirty="0">
                <a:effectLst/>
              </a:rPr>
            </a:br>
            <a:r>
              <a:rPr lang="en-US" b="1" dirty="0">
                <a:effectLst/>
              </a:rPr>
              <a:t>Reducing Clinical Conflict by Learning to Reconceive the "Difficult" Patient or Family</a:t>
            </a:r>
            <a:br>
              <a:rPr lang="en-US" sz="4200" dirty="0">
                <a:solidFill>
                  <a:srgbClr val="FFC000"/>
                </a:solidFill>
                <a:effectLst/>
              </a:rPr>
            </a:br>
            <a:endParaRPr lang="en-US" sz="4200" dirty="0">
              <a:solidFill>
                <a:srgbClr val="FFC000"/>
              </a:solidFill>
              <a:effectLst/>
            </a:endParaRPr>
          </a:p>
        </p:txBody>
      </p:sp>
      <p:sp>
        <p:nvSpPr>
          <p:cNvPr id="7" name="Google Shape;33;p2">
            <a:extLst>
              <a:ext uri="{FF2B5EF4-FFF2-40B4-BE49-F238E27FC236}">
                <a16:creationId xmlns:a16="http://schemas.microsoft.com/office/drawing/2014/main" id="{A6493FBE-478F-4B38-AD1F-40B2BEC14933}"/>
              </a:ext>
            </a:extLst>
          </p:cNvPr>
          <p:cNvSpPr txBox="1"/>
          <p:nvPr/>
        </p:nvSpPr>
        <p:spPr>
          <a:xfrm>
            <a:off x="241369" y="6119336"/>
            <a:ext cx="8083233" cy="73866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dirty="0">
                <a:solidFill>
                  <a:srgbClr val="000000"/>
                </a:solidFill>
                <a:latin typeface="Century Gothic"/>
                <a:ea typeface="Century Gothic"/>
                <a:cs typeface="Century Gothic"/>
                <a:sym typeface="Century Gothic"/>
              </a:rPr>
              <a:t>Created By: Autumn Fiester</a:t>
            </a:r>
            <a:endParaRPr dirty="0"/>
          </a:p>
          <a:p>
            <a:pPr marL="0" marR="0" lvl="0" indent="0" algn="l" rtl="0">
              <a:lnSpc>
                <a:spcPct val="100000"/>
              </a:lnSpc>
              <a:spcBef>
                <a:spcPts val="0"/>
              </a:spcBef>
              <a:spcAft>
                <a:spcPts val="0"/>
              </a:spcAft>
              <a:buNone/>
            </a:pPr>
            <a:r>
              <a:rPr lang="en-US" sz="1400" b="0" i="0" u="none" strike="noStrike" cap="none" dirty="0">
                <a:solidFill>
                  <a:srgbClr val="000000"/>
                </a:solidFill>
                <a:latin typeface="Century Gothic"/>
                <a:ea typeface="Century Gothic"/>
                <a:cs typeface="Century Gothic"/>
                <a:sym typeface="Century Gothic"/>
              </a:rPr>
              <a:t>Presented By:  List Presenters Names</a:t>
            </a:r>
            <a:endParaRPr dirty="0"/>
          </a:p>
          <a:p>
            <a:pPr marL="0" marR="0" lvl="0" indent="0" algn="l" rtl="0">
              <a:lnSpc>
                <a:spcPct val="100000"/>
              </a:lnSpc>
              <a:spcBef>
                <a:spcPts val="0"/>
              </a:spcBef>
              <a:spcAft>
                <a:spcPts val="0"/>
              </a:spcAft>
              <a:buNone/>
            </a:pPr>
            <a:endParaRPr sz="1400" b="0" i="0" u="none" strike="noStrike" cap="none" dirty="0">
              <a:solidFill>
                <a:srgbClr val="000000"/>
              </a:solidFill>
              <a:latin typeface="Arial"/>
              <a:ea typeface="Arial"/>
              <a:cs typeface="Arial"/>
              <a:sym typeface="Aria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0" name="Rectangle 2"/>
          <p:cNvSpPr>
            <a:spLocks noGrp="1" noChangeArrowheads="1"/>
          </p:cNvSpPr>
          <p:nvPr>
            <p:ph type="ctrTitle"/>
          </p:nvPr>
        </p:nvSpPr>
        <p:spPr>
          <a:xfrm>
            <a:off x="228600" y="914400"/>
            <a:ext cx="8326413" cy="1295400"/>
          </a:xfrm>
        </p:spPr>
        <p:txBody>
          <a:bodyPr/>
          <a:lstStyle/>
          <a:p>
            <a:pPr eaLnBrk="1" hangingPunct="1">
              <a:lnSpc>
                <a:spcPct val="95000"/>
              </a:lnSpc>
              <a:spcAft>
                <a:spcPct val="10000"/>
              </a:spcAft>
              <a:defRPr/>
            </a:pPr>
            <a:r>
              <a:rPr lang="en-US" sz="6000" dirty="0">
                <a:effectLst>
                  <a:outerShdw blurRad="38100" dist="38100" dir="2700000" algn="tl">
                    <a:srgbClr val="000000">
                      <a:alpha val="43137"/>
                    </a:srgbClr>
                  </a:outerShdw>
                </a:effectLst>
              </a:rPr>
              <a:t>The Mediator’s Toolbox</a:t>
            </a:r>
          </a:p>
        </p:txBody>
      </p:sp>
      <p:sp>
        <p:nvSpPr>
          <p:cNvPr id="2" name="TextBox 1"/>
          <p:cNvSpPr txBox="1"/>
          <p:nvPr/>
        </p:nvSpPr>
        <p:spPr>
          <a:xfrm>
            <a:off x="1143000" y="5029200"/>
            <a:ext cx="7239000" cy="1447800"/>
          </a:xfrm>
          <a:prstGeom prst="rect">
            <a:avLst/>
          </a:prstGeom>
          <a:noFill/>
        </p:spPr>
        <p:txBody>
          <a:bodyPr wrap="square" rtlCol="0">
            <a:spAutoFit/>
          </a:bodyPr>
          <a:lstStyle/>
          <a:p>
            <a:endParaRPr lang="en-US" dirty="0"/>
          </a:p>
        </p:txBody>
      </p:sp>
      <p:sp>
        <p:nvSpPr>
          <p:cNvPr id="6" name="TextBox 5">
            <a:extLst>
              <a:ext uri="{FF2B5EF4-FFF2-40B4-BE49-F238E27FC236}">
                <a16:creationId xmlns:a16="http://schemas.microsoft.com/office/drawing/2014/main" id="{D6356A7C-2B76-4C02-B1CC-212A6531D855}"/>
              </a:ext>
            </a:extLst>
          </p:cNvPr>
          <p:cNvSpPr txBox="1"/>
          <p:nvPr/>
        </p:nvSpPr>
        <p:spPr>
          <a:xfrm>
            <a:off x="1143000" y="2819400"/>
            <a:ext cx="6858000" cy="2246769"/>
          </a:xfrm>
          <a:prstGeom prst="rect">
            <a:avLst/>
          </a:prstGeom>
          <a:noFill/>
        </p:spPr>
        <p:txBody>
          <a:bodyPr wrap="square" rtlCol="0">
            <a:spAutoFit/>
          </a:bodyPr>
          <a:lstStyle/>
          <a:p>
            <a:pPr marL="231775" indent="-231775">
              <a:buFont typeface="Arial" panose="020B0604020202020204" pitchFamily="34" charset="0"/>
              <a:buChar char="•"/>
            </a:pPr>
            <a:r>
              <a:rPr lang="en-US" sz="2800"/>
              <a:t>Strategies for Diagnosing the Problem: the View from Everywhere</a:t>
            </a:r>
          </a:p>
          <a:p>
            <a:pPr marL="231775" indent="-231775">
              <a:buFont typeface="Arial" panose="020B0604020202020204" pitchFamily="34" charset="0"/>
              <a:buChar char="•"/>
            </a:pPr>
            <a:r>
              <a:rPr lang="en-US" sz="2800"/>
              <a:t>Strategies for Understanding the Underlying Reasons for the Conflict: Positions vs. Interests</a:t>
            </a:r>
            <a:endParaRPr lang="en-US" sz="2800" dirty="0"/>
          </a:p>
        </p:txBody>
      </p:sp>
      <p:sp>
        <p:nvSpPr>
          <p:cNvPr id="7" name="Oval Callout 4">
            <a:extLst>
              <a:ext uri="{FF2B5EF4-FFF2-40B4-BE49-F238E27FC236}">
                <a16:creationId xmlns:a16="http://schemas.microsoft.com/office/drawing/2014/main" id="{831AE61C-B9E9-42F0-B1AB-8339DCFBFA5B}"/>
              </a:ext>
            </a:extLst>
          </p:cNvPr>
          <p:cNvSpPr/>
          <p:nvPr/>
        </p:nvSpPr>
        <p:spPr>
          <a:xfrm rot="21074143">
            <a:off x="4962593" y="5003024"/>
            <a:ext cx="4095940" cy="1539319"/>
          </a:xfrm>
          <a:prstGeom prst="wedgeEllipseCallout">
            <a:avLst>
              <a:gd name="adj1" fmla="val -32460"/>
              <a:gd name="adj2" fmla="val -171266"/>
            </a:avLst>
          </a:prstGeom>
          <a:solidFill>
            <a:srgbClr val="FFC000"/>
          </a:solidFill>
          <a:ln>
            <a:solidFill>
              <a:srgbClr val="FFD54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bg1"/>
                </a:solidFill>
              </a:rPr>
              <a:t>How can we best understand this conflict to be able to solve it?</a:t>
            </a:r>
          </a:p>
        </p:txBody>
      </p:sp>
    </p:spTree>
    <p:extLst>
      <p:ext uri="{BB962C8B-B14F-4D97-AF65-F5344CB8AC3E}">
        <p14:creationId xmlns:p14="http://schemas.microsoft.com/office/powerpoint/2010/main" val="222511299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ctrTitle"/>
          </p:nvPr>
        </p:nvSpPr>
        <p:spPr>
          <a:xfrm>
            <a:off x="1905000" y="2209800"/>
            <a:ext cx="5334000" cy="1431925"/>
          </a:xfrm>
        </p:spPr>
        <p:txBody>
          <a:bodyPr>
            <a:normAutofit fontScale="90000"/>
          </a:bodyPr>
          <a:lstStyle/>
          <a:p>
            <a:r>
              <a:rPr lang="en-US" sz="4400" dirty="0">
                <a:effectLst/>
              </a:rPr>
              <a:t>The team might say: “The problem is Fred. Fred is difficult.”</a:t>
            </a:r>
            <a:endParaRPr lang="en-US" sz="4400" b="1" i="1" dirty="0"/>
          </a:p>
        </p:txBody>
      </p:sp>
    </p:spTree>
    <p:extLst>
      <p:ext uri="{BB962C8B-B14F-4D97-AF65-F5344CB8AC3E}">
        <p14:creationId xmlns:p14="http://schemas.microsoft.com/office/powerpoint/2010/main" val="413437275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Diagnosing </a:t>
            </a:r>
            <a:br>
              <a:rPr lang="en-US" dirty="0">
                <a:solidFill>
                  <a:schemeClr val="tx2">
                    <a:lumMod val="90000"/>
                  </a:schemeClr>
                </a:solidFill>
                <a:effectLst/>
              </a:rPr>
            </a:br>
            <a:r>
              <a:rPr lang="en-US" dirty="0">
                <a:solidFill>
                  <a:schemeClr val="tx2">
                    <a:lumMod val="90000"/>
                  </a:schemeClr>
                </a:solidFill>
                <a:effectLst/>
              </a:rPr>
              <a:t>      the Problem</a:t>
            </a:r>
            <a:endParaRPr lang="en-US" dirty="0">
              <a:solidFill>
                <a:schemeClr val="tx2">
                  <a:lumMod val="90000"/>
                </a:schemeClr>
              </a:solidFill>
            </a:endParaRPr>
          </a:p>
        </p:txBody>
      </p:sp>
      <p:sp>
        <p:nvSpPr>
          <p:cNvPr id="3" name="Content Placeholder 2"/>
          <p:cNvSpPr>
            <a:spLocks noGrp="1"/>
          </p:cNvSpPr>
          <p:nvPr>
            <p:ph idx="1"/>
          </p:nvPr>
        </p:nvSpPr>
        <p:spPr>
          <a:xfrm>
            <a:off x="609600" y="1981200"/>
            <a:ext cx="8229600" cy="4419600"/>
          </a:xfrm>
        </p:spPr>
        <p:txBody>
          <a:bodyPr/>
          <a:lstStyle/>
          <a:p>
            <a:pPr marL="568325" indent="-568325">
              <a:buClr>
                <a:schemeClr val="tx2">
                  <a:lumMod val="50000"/>
                </a:schemeClr>
              </a:buClr>
            </a:pPr>
            <a:r>
              <a:rPr lang="en-US" sz="4000" dirty="0">
                <a:effectLst/>
              </a:rPr>
              <a:t>If the framing of the issue would be categorically rejected by one party, you have a flawed conflict-diagnosis </a:t>
            </a:r>
          </a:p>
        </p:txBody>
      </p:sp>
      <p:sp>
        <p:nvSpPr>
          <p:cNvPr id="6" name="Oval Callout 4">
            <a:extLst>
              <a:ext uri="{FF2B5EF4-FFF2-40B4-BE49-F238E27FC236}">
                <a16:creationId xmlns:a16="http://schemas.microsoft.com/office/drawing/2014/main" id="{4283CDF5-72CB-42D4-97DE-A39BEA2C298A}"/>
              </a:ext>
            </a:extLst>
          </p:cNvPr>
          <p:cNvSpPr/>
          <p:nvPr/>
        </p:nvSpPr>
        <p:spPr>
          <a:xfrm rot="21074143">
            <a:off x="4962593" y="5027462"/>
            <a:ext cx="4095940" cy="1539319"/>
          </a:xfrm>
          <a:prstGeom prst="wedgeEllipseCallout">
            <a:avLst>
              <a:gd name="adj1" fmla="val -77564"/>
              <a:gd name="adj2" fmla="val -159379"/>
            </a:avLst>
          </a:prstGeom>
          <a:solidFill>
            <a:srgbClr val="FFC000"/>
          </a:solidFill>
          <a:ln>
            <a:solidFill>
              <a:srgbClr val="FFD54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bg1"/>
                </a:solidFill>
              </a:rPr>
              <a:t>Conflicts are interpersonal (“inter”=“between”) </a:t>
            </a:r>
          </a:p>
        </p:txBody>
      </p:sp>
    </p:spTree>
    <p:extLst>
      <p:ext uri="{BB962C8B-B14F-4D97-AF65-F5344CB8AC3E}">
        <p14:creationId xmlns:p14="http://schemas.microsoft.com/office/powerpoint/2010/main" val="207109400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ctrTitle"/>
          </p:nvPr>
        </p:nvSpPr>
        <p:spPr>
          <a:xfrm>
            <a:off x="1905000" y="2209800"/>
            <a:ext cx="5334000" cy="1431925"/>
          </a:xfrm>
        </p:spPr>
        <p:txBody>
          <a:bodyPr>
            <a:normAutofit fontScale="90000"/>
          </a:bodyPr>
          <a:lstStyle/>
          <a:p>
            <a:r>
              <a:rPr lang="en-US" sz="4400" dirty="0">
                <a:effectLst/>
              </a:rPr>
              <a:t>The team might say: “The problem is Fred. Fred is difficult.”</a:t>
            </a:r>
            <a:endParaRPr lang="en-US" sz="4400" b="1" i="1" dirty="0"/>
          </a:p>
        </p:txBody>
      </p:sp>
      <p:sp>
        <p:nvSpPr>
          <p:cNvPr id="2" name="Left Brace 1">
            <a:extLst>
              <a:ext uri="{FF2B5EF4-FFF2-40B4-BE49-F238E27FC236}">
                <a16:creationId xmlns:a16="http://schemas.microsoft.com/office/drawing/2014/main" id="{ADE5C1FF-F4FF-4CFF-B0F3-96B54CC2702D}"/>
              </a:ext>
            </a:extLst>
          </p:cNvPr>
          <p:cNvSpPr/>
          <p:nvPr/>
        </p:nvSpPr>
        <p:spPr>
          <a:xfrm>
            <a:off x="1676400" y="1659427"/>
            <a:ext cx="838200" cy="4876800"/>
          </a:xfrm>
          <a:prstGeom prst="leftBrace">
            <a:avLst/>
          </a:prstGeom>
          <a:ln w="5715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 name="Title 2">
            <a:extLst>
              <a:ext uri="{FF2B5EF4-FFF2-40B4-BE49-F238E27FC236}">
                <a16:creationId xmlns:a16="http://schemas.microsoft.com/office/drawing/2014/main" id="{B6DBF4DB-3D2B-449B-BB43-C78E5F290645}"/>
              </a:ext>
            </a:extLst>
          </p:cNvPr>
          <p:cNvSpPr txBox="1">
            <a:spLocks/>
          </p:cNvSpPr>
          <p:nvPr/>
        </p:nvSpPr>
        <p:spPr>
          <a:xfrm>
            <a:off x="457200" y="3429000"/>
            <a:ext cx="1333500" cy="1737794"/>
          </a:xfrm>
          <a:prstGeom prst="rect">
            <a:avLst/>
          </a:prstGeom>
        </p:spPr>
        <p:txBody>
          <a:bodyPr vert="horz" lIns="91440" tIns="45720" rIns="91440" bIns="45720" rtlCol="0" anchor="b">
            <a:normAutofit fontScale="45000" lnSpcReduction="20000"/>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r>
              <a:rPr lang="en-US" sz="4400" b="1" dirty="0">
                <a:solidFill>
                  <a:srgbClr val="FF0000"/>
                </a:solidFill>
              </a:rPr>
              <a:t>A complete picture of the problem is essential for solving it</a:t>
            </a:r>
            <a:endParaRPr lang="en-US" sz="4400" b="1" i="1" dirty="0">
              <a:solidFill>
                <a:srgbClr val="FF0000"/>
              </a:solidFill>
            </a:endParaRPr>
          </a:p>
        </p:txBody>
      </p:sp>
      <p:sp>
        <p:nvSpPr>
          <p:cNvPr id="6" name="Oval Callout 4">
            <a:extLst>
              <a:ext uri="{FF2B5EF4-FFF2-40B4-BE49-F238E27FC236}">
                <a16:creationId xmlns:a16="http://schemas.microsoft.com/office/drawing/2014/main" id="{E8447A20-A3E7-4554-8790-F7ED11B8F5F7}"/>
              </a:ext>
            </a:extLst>
          </p:cNvPr>
          <p:cNvSpPr/>
          <p:nvPr/>
        </p:nvSpPr>
        <p:spPr>
          <a:xfrm rot="21074143">
            <a:off x="4686764" y="4722661"/>
            <a:ext cx="4095940" cy="1539319"/>
          </a:xfrm>
          <a:prstGeom prst="wedgeEllipseCallout">
            <a:avLst>
              <a:gd name="adj1" fmla="val -956"/>
              <a:gd name="adj2" fmla="val -163070"/>
            </a:avLst>
          </a:prstGeom>
          <a:solidFill>
            <a:srgbClr val="FFC000"/>
          </a:solidFill>
          <a:ln>
            <a:solidFill>
              <a:srgbClr val="FFD54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bg1"/>
                </a:solidFill>
              </a:rPr>
              <a:t>Fred is unlikely to agree that the problem is Fred</a:t>
            </a:r>
          </a:p>
        </p:txBody>
      </p:sp>
    </p:spTree>
    <p:extLst>
      <p:ext uri="{BB962C8B-B14F-4D97-AF65-F5344CB8AC3E}">
        <p14:creationId xmlns:p14="http://schemas.microsoft.com/office/powerpoint/2010/main" val="237528013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Diagnosing </a:t>
            </a:r>
            <a:br>
              <a:rPr lang="en-US" dirty="0">
                <a:solidFill>
                  <a:schemeClr val="tx2">
                    <a:lumMod val="90000"/>
                  </a:schemeClr>
                </a:solidFill>
                <a:effectLst/>
              </a:rPr>
            </a:br>
            <a:r>
              <a:rPr lang="en-US" dirty="0">
                <a:solidFill>
                  <a:schemeClr val="tx2">
                    <a:lumMod val="90000"/>
                  </a:schemeClr>
                </a:solidFill>
                <a:effectLst/>
              </a:rPr>
              <a:t>      the Problem</a:t>
            </a:r>
            <a:endParaRPr lang="en-US" dirty="0">
              <a:solidFill>
                <a:schemeClr val="tx2">
                  <a:lumMod val="90000"/>
                </a:schemeClr>
              </a:solidFill>
            </a:endParaRPr>
          </a:p>
        </p:txBody>
      </p:sp>
      <p:sp>
        <p:nvSpPr>
          <p:cNvPr id="3" name="Content Placeholder 2"/>
          <p:cNvSpPr>
            <a:spLocks noGrp="1"/>
          </p:cNvSpPr>
          <p:nvPr>
            <p:ph idx="1"/>
          </p:nvPr>
        </p:nvSpPr>
        <p:spPr>
          <a:xfrm>
            <a:off x="1066800" y="1981200"/>
            <a:ext cx="7239000" cy="4419600"/>
          </a:xfrm>
        </p:spPr>
        <p:txBody>
          <a:bodyPr/>
          <a:lstStyle/>
          <a:p>
            <a:pPr marL="568325" indent="-568325">
              <a:buClr>
                <a:schemeClr val="tx2">
                  <a:lumMod val="50000"/>
                </a:schemeClr>
              </a:buClr>
            </a:pPr>
            <a:r>
              <a:rPr lang="en-US" sz="4200" dirty="0">
                <a:effectLst/>
              </a:rPr>
              <a:t>Mediators pursue the </a:t>
            </a:r>
            <a:r>
              <a:rPr lang="en-US" sz="4200" dirty="0">
                <a:solidFill>
                  <a:srgbClr val="FFC000"/>
                </a:solidFill>
                <a:effectLst/>
              </a:rPr>
              <a:t>“View from Everywhere”</a:t>
            </a:r>
          </a:p>
          <a:p>
            <a:pPr marL="1828800" lvl="1" indent="-457200">
              <a:spcAft>
                <a:spcPts val="600"/>
              </a:spcAft>
              <a:buFont typeface="Wingdings" pitchFamily="2" charset="2"/>
              <a:buChar char="Ø"/>
            </a:pPr>
            <a:r>
              <a:rPr lang="en-US" sz="3200" dirty="0">
                <a:effectLst/>
              </a:rPr>
              <a:t>In a conflict, mediators try to capture the perspective of each party in the dispute</a:t>
            </a:r>
          </a:p>
        </p:txBody>
      </p:sp>
      <p:sp>
        <p:nvSpPr>
          <p:cNvPr id="6" name="Oval Callout 4">
            <a:extLst>
              <a:ext uri="{FF2B5EF4-FFF2-40B4-BE49-F238E27FC236}">
                <a16:creationId xmlns:a16="http://schemas.microsoft.com/office/drawing/2014/main" id="{0AD13FD5-8E58-4A36-A409-10DE7E1D432D}"/>
              </a:ext>
            </a:extLst>
          </p:cNvPr>
          <p:cNvSpPr/>
          <p:nvPr/>
        </p:nvSpPr>
        <p:spPr>
          <a:xfrm rot="630120">
            <a:off x="410442" y="4411085"/>
            <a:ext cx="2988924" cy="2269996"/>
          </a:xfrm>
          <a:prstGeom prst="wedgeEllipseCallout">
            <a:avLst>
              <a:gd name="adj1" fmla="val 14235"/>
              <a:gd name="adj2" fmla="val -69147"/>
            </a:avLst>
          </a:prstGeom>
          <a:solidFill>
            <a:srgbClr val="FFC000"/>
          </a:solidFill>
          <a:ln>
            <a:solidFill>
              <a:srgbClr val="FFD54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bg1"/>
                </a:solidFill>
              </a:rPr>
              <a:t>The 360°</a:t>
            </a:r>
          </a:p>
          <a:p>
            <a:pPr algn="ctr"/>
            <a:r>
              <a:rPr lang="en-US" sz="2400" dirty="0">
                <a:solidFill>
                  <a:schemeClr val="bg1"/>
                </a:solidFill>
              </a:rPr>
              <a:t>View</a:t>
            </a:r>
          </a:p>
        </p:txBody>
      </p:sp>
    </p:spTree>
    <p:extLst>
      <p:ext uri="{BB962C8B-B14F-4D97-AF65-F5344CB8AC3E}">
        <p14:creationId xmlns:p14="http://schemas.microsoft.com/office/powerpoint/2010/main" val="97448221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Diagnosing </a:t>
            </a:r>
            <a:br>
              <a:rPr lang="en-US" dirty="0">
                <a:solidFill>
                  <a:schemeClr val="tx2">
                    <a:lumMod val="90000"/>
                  </a:schemeClr>
                </a:solidFill>
                <a:effectLst/>
              </a:rPr>
            </a:br>
            <a:r>
              <a:rPr lang="en-US" dirty="0">
                <a:solidFill>
                  <a:schemeClr val="tx2">
                    <a:lumMod val="90000"/>
                  </a:schemeClr>
                </a:solidFill>
                <a:effectLst/>
              </a:rPr>
              <a:t>      the Problem</a:t>
            </a:r>
            <a:endParaRPr lang="en-US" dirty="0">
              <a:solidFill>
                <a:schemeClr val="tx2">
                  <a:lumMod val="90000"/>
                </a:schemeClr>
              </a:solidFill>
            </a:endParaRPr>
          </a:p>
        </p:txBody>
      </p:sp>
      <p:sp>
        <p:nvSpPr>
          <p:cNvPr id="3" name="Content Placeholder 2"/>
          <p:cNvSpPr>
            <a:spLocks noGrp="1"/>
          </p:cNvSpPr>
          <p:nvPr>
            <p:ph idx="1"/>
          </p:nvPr>
        </p:nvSpPr>
        <p:spPr>
          <a:xfrm>
            <a:off x="1066800" y="1981200"/>
            <a:ext cx="8001000" cy="4419600"/>
          </a:xfrm>
        </p:spPr>
        <p:txBody>
          <a:bodyPr/>
          <a:lstStyle/>
          <a:p>
            <a:pPr marL="568325" indent="-568325">
              <a:buClr>
                <a:schemeClr val="tx2">
                  <a:lumMod val="50000"/>
                </a:schemeClr>
              </a:buClr>
            </a:pPr>
            <a:r>
              <a:rPr lang="en-US" sz="4200" dirty="0">
                <a:effectLst/>
              </a:rPr>
              <a:t>Mediators pursue the </a:t>
            </a:r>
          </a:p>
          <a:p>
            <a:pPr marL="0" indent="0">
              <a:buClr>
                <a:schemeClr val="tx2">
                  <a:lumMod val="50000"/>
                </a:schemeClr>
              </a:buClr>
              <a:buNone/>
            </a:pPr>
            <a:r>
              <a:rPr lang="en-US" sz="4200" dirty="0">
                <a:solidFill>
                  <a:srgbClr val="FFC000"/>
                </a:solidFill>
                <a:effectLst/>
              </a:rPr>
              <a:t>	“View from Everywhere”</a:t>
            </a:r>
          </a:p>
          <a:p>
            <a:pPr marL="1828800" lvl="1" indent="-457200">
              <a:spcAft>
                <a:spcPts val="600"/>
              </a:spcAft>
              <a:buFont typeface="Wingdings" pitchFamily="2" charset="2"/>
              <a:buChar char="Ø"/>
            </a:pPr>
            <a:r>
              <a:rPr lang="en-US" sz="3200" dirty="0">
                <a:effectLst/>
              </a:rPr>
              <a:t>Whether you are a stakeholder or the problem-solver, correctly naming/framing the problem is essential for solving it</a:t>
            </a:r>
          </a:p>
          <a:p>
            <a:pPr marL="1828800" lvl="1" indent="-457200">
              <a:spcAft>
                <a:spcPts val="600"/>
              </a:spcAft>
              <a:buFont typeface="Wingdings" pitchFamily="2" charset="2"/>
              <a:buChar char="Ø"/>
            </a:pPr>
            <a:r>
              <a:rPr lang="en-US" sz="3200" dirty="0"/>
              <a:t>This is the “conflict diagnosis”</a:t>
            </a:r>
            <a:endParaRPr lang="en-US" sz="3200" dirty="0">
              <a:effectLst/>
            </a:endParaRPr>
          </a:p>
        </p:txBody>
      </p:sp>
    </p:spTree>
    <p:extLst>
      <p:ext uri="{BB962C8B-B14F-4D97-AF65-F5344CB8AC3E}">
        <p14:creationId xmlns:p14="http://schemas.microsoft.com/office/powerpoint/2010/main" val="581875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Diagnosing </a:t>
            </a:r>
            <a:br>
              <a:rPr lang="en-US" dirty="0">
                <a:solidFill>
                  <a:schemeClr val="tx2">
                    <a:lumMod val="90000"/>
                  </a:schemeClr>
                </a:solidFill>
                <a:effectLst/>
              </a:rPr>
            </a:br>
            <a:r>
              <a:rPr lang="en-US" dirty="0">
                <a:solidFill>
                  <a:schemeClr val="tx2">
                    <a:lumMod val="90000"/>
                  </a:schemeClr>
                </a:solidFill>
                <a:effectLst/>
              </a:rPr>
              <a:t>      the Problem</a:t>
            </a:r>
            <a:endParaRPr lang="en-US" dirty="0">
              <a:solidFill>
                <a:schemeClr val="tx2">
                  <a:lumMod val="90000"/>
                </a:schemeClr>
              </a:solidFill>
            </a:endParaRPr>
          </a:p>
        </p:txBody>
      </p:sp>
      <p:sp>
        <p:nvSpPr>
          <p:cNvPr id="3" name="Content Placeholder 2"/>
          <p:cNvSpPr>
            <a:spLocks noGrp="1"/>
          </p:cNvSpPr>
          <p:nvPr>
            <p:ph idx="1"/>
          </p:nvPr>
        </p:nvSpPr>
        <p:spPr>
          <a:xfrm>
            <a:off x="1066800" y="1981200"/>
            <a:ext cx="7239000" cy="4419600"/>
          </a:xfrm>
        </p:spPr>
        <p:txBody>
          <a:bodyPr/>
          <a:lstStyle/>
          <a:p>
            <a:pPr marL="568325" indent="-568325">
              <a:buClr>
                <a:schemeClr val="tx2">
                  <a:lumMod val="50000"/>
                </a:schemeClr>
              </a:buClr>
            </a:pPr>
            <a:r>
              <a:rPr lang="en-US" sz="4200" dirty="0">
                <a:effectLst/>
              </a:rPr>
              <a:t>Mediators pursue the </a:t>
            </a:r>
            <a:r>
              <a:rPr lang="en-US" sz="4200" dirty="0">
                <a:solidFill>
                  <a:srgbClr val="FFC000"/>
                </a:solidFill>
                <a:effectLst/>
              </a:rPr>
              <a:t>“View from Everywhere”</a:t>
            </a:r>
          </a:p>
          <a:p>
            <a:pPr marL="1828800" lvl="1" indent="-457200">
              <a:spcAft>
                <a:spcPts val="1200"/>
              </a:spcAft>
              <a:buFont typeface="Wingdings" pitchFamily="2" charset="2"/>
              <a:buChar char="Ø"/>
            </a:pPr>
            <a:r>
              <a:rPr lang="en-US" sz="3200" dirty="0">
                <a:effectLst/>
              </a:rPr>
              <a:t>This is an exercise in </a:t>
            </a:r>
            <a:r>
              <a:rPr lang="en-US" sz="3200" i="1" dirty="0">
                <a:effectLst/>
              </a:rPr>
              <a:t>empathy</a:t>
            </a:r>
            <a:r>
              <a:rPr lang="en-US" sz="3200" dirty="0">
                <a:effectLst/>
              </a:rPr>
              <a:t> </a:t>
            </a:r>
          </a:p>
        </p:txBody>
      </p:sp>
    </p:spTree>
    <p:extLst>
      <p:ext uri="{BB962C8B-B14F-4D97-AF65-F5344CB8AC3E}">
        <p14:creationId xmlns:p14="http://schemas.microsoft.com/office/powerpoint/2010/main" val="44658662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Diagnosing </a:t>
            </a:r>
            <a:br>
              <a:rPr lang="en-US" dirty="0">
                <a:solidFill>
                  <a:schemeClr val="tx2">
                    <a:lumMod val="90000"/>
                  </a:schemeClr>
                </a:solidFill>
                <a:effectLst/>
              </a:rPr>
            </a:br>
            <a:r>
              <a:rPr lang="en-US" dirty="0">
                <a:solidFill>
                  <a:schemeClr val="tx2">
                    <a:lumMod val="90000"/>
                  </a:schemeClr>
                </a:solidFill>
                <a:effectLst/>
              </a:rPr>
              <a:t>      the Problem</a:t>
            </a:r>
            <a:endParaRPr lang="en-US" dirty="0">
              <a:solidFill>
                <a:schemeClr val="tx2">
                  <a:lumMod val="90000"/>
                </a:schemeClr>
              </a:solidFill>
            </a:endParaRPr>
          </a:p>
        </p:txBody>
      </p:sp>
      <p:sp>
        <p:nvSpPr>
          <p:cNvPr id="3" name="Content Placeholder 2"/>
          <p:cNvSpPr>
            <a:spLocks noGrp="1"/>
          </p:cNvSpPr>
          <p:nvPr>
            <p:ph idx="1"/>
          </p:nvPr>
        </p:nvSpPr>
        <p:spPr>
          <a:xfrm>
            <a:off x="457200" y="1524000"/>
            <a:ext cx="8534400" cy="5105400"/>
          </a:xfrm>
        </p:spPr>
        <p:txBody>
          <a:bodyPr/>
          <a:lstStyle/>
          <a:p>
            <a:pPr marL="457200" indent="-457200">
              <a:spcAft>
                <a:spcPts val="1200"/>
              </a:spcAft>
              <a:buClr>
                <a:schemeClr val="tx2">
                  <a:lumMod val="50000"/>
                </a:schemeClr>
              </a:buClr>
            </a:pPr>
            <a:r>
              <a:rPr lang="en-US" sz="4200" dirty="0">
                <a:solidFill>
                  <a:srgbClr val="FFC000"/>
                </a:solidFill>
                <a:effectLst/>
              </a:rPr>
              <a:t>2 Meanings of “</a:t>
            </a:r>
            <a:r>
              <a:rPr lang="en-US" sz="4200" i="1" dirty="0">
                <a:solidFill>
                  <a:srgbClr val="FFC000"/>
                </a:solidFill>
                <a:effectLst/>
              </a:rPr>
              <a:t>Empathy”</a:t>
            </a:r>
          </a:p>
          <a:p>
            <a:pPr marL="1260475" lvl="1" indent="-519113">
              <a:spcBef>
                <a:spcPts val="0"/>
              </a:spcBef>
              <a:spcAft>
                <a:spcPts val="0"/>
              </a:spcAft>
              <a:buFont typeface="Wingdings" pitchFamily="2" charset="2"/>
              <a:buChar char="Ø"/>
            </a:pPr>
            <a:r>
              <a:rPr lang="en-US" sz="3600" dirty="0">
                <a:effectLst/>
              </a:rPr>
              <a:t>Affective/Emotional</a:t>
            </a:r>
          </a:p>
          <a:p>
            <a:pPr marL="1482725" lvl="1" indent="0">
              <a:spcBef>
                <a:spcPts val="0"/>
              </a:spcBef>
              <a:spcAft>
                <a:spcPts val="600"/>
              </a:spcAft>
              <a:buNone/>
            </a:pPr>
            <a:r>
              <a:rPr lang="en-US" sz="2400" dirty="0">
                <a:solidFill>
                  <a:srgbClr val="000086"/>
                </a:solidFill>
                <a:effectLst/>
              </a:rPr>
              <a:t>“Sharing the feelings of others,” “Vicariously experiencing another’s feelings,” “Psychological identification with someone else”</a:t>
            </a:r>
          </a:p>
          <a:p>
            <a:pPr marL="1308100" indent="-504825">
              <a:spcBef>
                <a:spcPts val="0"/>
              </a:spcBef>
              <a:spcAft>
                <a:spcPts val="0"/>
              </a:spcAft>
              <a:buClr>
                <a:schemeClr val="tx1"/>
              </a:buClr>
              <a:buSzPct val="100000"/>
              <a:buFont typeface="Wingdings" panose="05000000000000000000" pitchFamily="2" charset="2"/>
              <a:buChar char="Ø"/>
            </a:pPr>
            <a:r>
              <a:rPr lang="en-US" sz="3600" dirty="0">
                <a:effectLst/>
              </a:rPr>
              <a:t>Cognitive/Analytical </a:t>
            </a:r>
          </a:p>
          <a:p>
            <a:pPr marL="1482725" lvl="1" indent="0">
              <a:spcBef>
                <a:spcPts val="0"/>
              </a:spcBef>
              <a:spcAft>
                <a:spcPts val="0"/>
              </a:spcAft>
              <a:buNone/>
            </a:pPr>
            <a:r>
              <a:rPr lang="en-US" sz="2400" dirty="0">
                <a:solidFill>
                  <a:srgbClr val="000086"/>
                </a:solidFill>
                <a:effectLst/>
              </a:rPr>
              <a:t>“The ability to understand another’s situation or feelings,” “Imaginatively entering into a person’s feeling”</a:t>
            </a:r>
            <a:endParaRPr lang="en-US" sz="4400" dirty="0">
              <a:solidFill>
                <a:srgbClr val="000086"/>
              </a:solidFill>
              <a:effectLst/>
            </a:endParaRPr>
          </a:p>
        </p:txBody>
      </p:sp>
    </p:spTree>
    <p:extLst>
      <p:ext uri="{BB962C8B-B14F-4D97-AF65-F5344CB8AC3E}">
        <p14:creationId xmlns:p14="http://schemas.microsoft.com/office/powerpoint/2010/main" val="227848205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Diagnosing </a:t>
            </a:r>
            <a:br>
              <a:rPr lang="en-US" dirty="0">
                <a:solidFill>
                  <a:schemeClr val="tx2">
                    <a:lumMod val="90000"/>
                  </a:schemeClr>
                </a:solidFill>
                <a:effectLst/>
              </a:rPr>
            </a:br>
            <a:r>
              <a:rPr lang="en-US" dirty="0">
                <a:solidFill>
                  <a:schemeClr val="tx2">
                    <a:lumMod val="90000"/>
                  </a:schemeClr>
                </a:solidFill>
                <a:effectLst/>
              </a:rPr>
              <a:t>      the Problem</a:t>
            </a:r>
            <a:endParaRPr lang="en-US" dirty="0">
              <a:solidFill>
                <a:schemeClr val="tx2">
                  <a:lumMod val="90000"/>
                </a:schemeClr>
              </a:solidFill>
            </a:endParaRPr>
          </a:p>
        </p:txBody>
      </p:sp>
      <p:sp>
        <p:nvSpPr>
          <p:cNvPr id="3" name="Content Placeholder 2"/>
          <p:cNvSpPr>
            <a:spLocks noGrp="1"/>
          </p:cNvSpPr>
          <p:nvPr>
            <p:ph idx="1"/>
          </p:nvPr>
        </p:nvSpPr>
        <p:spPr>
          <a:xfrm>
            <a:off x="457200" y="1524000"/>
            <a:ext cx="8534400" cy="5105400"/>
          </a:xfrm>
        </p:spPr>
        <p:txBody>
          <a:bodyPr/>
          <a:lstStyle/>
          <a:p>
            <a:pPr marL="457200" indent="-457200">
              <a:spcAft>
                <a:spcPts val="1200"/>
              </a:spcAft>
              <a:buClr>
                <a:schemeClr val="tx2">
                  <a:lumMod val="50000"/>
                </a:schemeClr>
              </a:buClr>
            </a:pPr>
            <a:r>
              <a:rPr lang="en-US" sz="4200" dirty="0">
                <a:solidFill>
                  <a:srgbClr val="FFC000"/>
                </a:solidFill>
                <a:effectLst/>
              </a:rPr>
              <a:t>2 Meanings of “</a:t>
            </a:r>
            <a:r>
              <a:rPr lang="en-US" sz="4200" i="1" dirty="0">
                <a:solidFill>
                  <a:srgbClr val="FFC000"/>
                </a:solidFill>
                <a:effectLst/>
              </a:rPr>
              <a:t>Empathy”</a:t>
            </a:r>
          </a:p>
          <a:p>
            <a:pPr marL="1260475" lvl="1" indent="-519113">
              <a:spcBef>
                <a:spcPts val="0"/>
              </a:spcBef>
              <a:spcAft>
                <a:spcPts val="0"/>
              </a:spcAft>
              <a:buFont typeface="Wingdings" pitchFamily="2" charset="2"/>
              <a:buChar char="Ø"/>
            </a:pPr>
            <a:r>
              <a:rPr lang="en-US" sz="3600" dirty="0">
                <a:effectLst/>
              </a:rPr>
              <a:t>Affective/Emotional</a:t>
            </a:r>
          </a:p>
          <a:p>
            <a:pPr marL="1482725" lvl="1" indent="0">
              <a:spcBef>
                <a:spcPts val="0"/>
              </a:spcBef>
              <a:spcAft>
                <a:spcPts val="600"/>
              </a:spcAft>
              <a:buNone/>
            </a:pPr>
            <a:r>
              <a:rPr lang="en-US" sz="2400" dirty="0">
                <a:solidFill>
                  <a:srgbClr val="000086"/>
                </a:solidFill>
                <a:effectLst/>
              </a:rPr>
              <a:t>“Sharing the feelings of others,” “Vicariously experiencing another’s feelings,” “Psychological identification with someone else”</a:t>
            </a:r>
          </a:p>
          <a:p>
            <a:pPr marL="1308100" indent="-504825">
              <a:spcBef>
                <a:spcPts val="0"/>
              </a:spcBef>
              <a:spcAft>
                <a:spcPts val="0"/>
              </a:spcAft>
              <a:buClr>
                <a:schemeClr val="tx1"/>
              </a:buClr>
              <a:buSzPct val="100000"/>
              <a:buFont typeface="Wingdings" panose="05000000000000000000" pitchFamily="2" charset="2"/>
              <a:buChar char="Ø"/>
            </a:pPr>
            <a:r>
              <a:rPr lang="en-US" sz="3600" dirty="0">
                <a:effectLst/>
              </a:rPr>
              <a:t>Cognitive/Analytical </a:t>
            </a:r>
          </a:p>
          <a:p>
            <a:pPr marL="1482725" lvl="1" indent="0">
              <a:spcBef>
                <a:spcPts val="0"/>
              </a:spcBef>
              <a:spcAft>
                <a:spcPts val="0"/>
              </a:spcAft>
              <a:buNone/>
            </a:pPr>
            <a:r>
              <a:rPr lang="en-US" sz="2400" dirty="0">
                <a:solidFill>
                  <a:srgbClr val="000086"/>
                </a:solidFill>
                <a:effectLst/>
              </a:rPr>
              <a:t>“The ability to understand another’s situation or feelings,” “Imaginatively entering into a person’s feeling”</a:t>
            </a:r>
            <a:endParaRPr lang="en-US" sz="4400" dirty="0">
              <a:solidFill>
                <a:srgbClr val="000086"/>
              </a:solidFill>
              <a:effectLst/>
            </a:endParaRPr>
          </a:p>
        </p:txBody>
      </p:sp>
      <p:sp>
        <p:nvSpPr>
          <p:cNvPr id="6" name="Oval Callout 4">
            <a:extLst>
              <a:ext uri="{FF2B5EF4-FFF2-40B4-BE49-F238E27FC236}">
                <a16:creationId xmlns:a16="http://schemas.microsoft.com/office/drawing/2014/main" id="{D1CD8451-43AC-44A9-9FF3-B20C5ECF2B90}"/>
              </a:ext>
            </a:extLst>
          </p:cNvPr>
          <p:cNvSpPr/>
          <p:nvPr/>
        </p:nvSpPr>
        <p:spPr>
          <a:xfrm>
            <a:off x="4572000" y="1090880"/>
            <a:ext cx="4419600" cy="2063483"/>
          </a:xfrm>
          <a:prstGeom prst="wedgeEllipseCallout">
            <a:avLst>
              <a:gd name="adj1" fmla="val -74176"/>
              <a:gd name="adj2" fmla="val 75847"/>
            </a:avLst>
          </a:prstGeom>
          <a:solidFill>
            <a:srgbClr val="FF0000"/>
          </a:solidFill>
          <a:ln>
            <a:solidFill>
              <a:srgbClr val="FFD54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bg1"/>
                </a:solidFill>
              </a:rPr>
              <a:t>This kind of empathy is essential for understanding another person's perspective</a:t>
            </a:r>
          </a:p>
        </p:txBody>
      </p:sp>
      <p:sp>
        <p:nvSpPr>
          <p:cNvPr id="7" name="Oval 6">
            <a:extLst>
              <a:ext uri="{FF2B5EF4-FFF2-40B4-BE49-F238E27FC236}">
                <a16:creationId xmlns:a16="http://schemas.microsoft.com/office/drawing/2014/main" id="{87DE25B2-2819-4428-9F7F-784F0637D5C0}"/>
              </a:ext>
            </a:extLst>
          </p:cNvPr>
          <p:cNvSpPr/>
          <p:nvPr/>
        </p:nvSpPr>
        <p:spPr>
          <a:xfrm>
            <a:off x="533400" y="3703638"/>
            <a:ext cx="7391400" cy="1752600"/>
          </a:xfrm>
          <a:prstGeom prst="ellipse">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75429090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ctrTitle"/>
          </p:nvPr>
        </p:nvSpPr>
        <p:spPr>
          <a:xfrm>
            <a:off x="1905000" y="2209800"/>
            <a:ext cx="5334000" cy="1431925"/>
          </a:xfrm>
        </p:spPr>
        <p:txBody>
          <a:bodyPr>
            <a:normAutofit fontScale="90000"/>
          </a:bodyPr>
          <a:lstStyle/>
          <a:p>
            <a:r>
              <a:rPr lang="en-US" sz="4400" dirty="0"/>
              <a:t>Mediators use analytical empathy to pursue the View from Everywhere</a:t>
            </a:r>
            <a:endParaRPr lang="en-US" sz="4400" b="1" i="1" dirty="0"/>
          </a:p>
        </p:txBody>
      </p:sp>
    </p:spTree>
    <p:extLst>
      <p:ext uri="{BB962C8B-B14F-4D97-AF65-F5344CB8AC3E}">
        <p14:creationId xmlns:p14="http://schemas.microsoft.com/office/powerpoint/2010/main" val="31560102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Learning Objectives</a:t>
            </a:r>
          </a:p>
        </p:txBody>
      </p:sp>
      <p:sp>
        <p:nvSpPr>
          <p:cNvPr id="3" name="Content Placeholder 2"/>
          <p:cNvSpPr>
            <a:spLocks noGrp="1"/>
          </p:cNvSpPr>
          <p:nvPr>
            <p:ph idx="1"/>
          </p:nvPr>
        </p:nvSpPr>
        <p:spPr>
          <a:xfrm>
            <a:off x="609600" y="1981200"/>
            <a:ext cx="8077200" cy="4114800"/>
          </a:xfrm>
        </p:spPr>
        <p:txBody>
          <a:bodyPr/>
          <a:lstStyle/>
          <a:p>
            <a:pPr marL="0" indent="0">
              <a:buNone/>
            </a:pPr>
            <a:r>
              <a:rPr lang="en-US" sz="2400" dirty="0">
                <a:solidFill>
                  <a:schemeClr val="dk1"/>
                </a:solidFill>
              </a:rPr>
              <a:t>By the end of this presentation, attendees will be able to:</a:t>
            </a:r>
            <a:endParaRPr lang="en-US" sz="2400" dirty="0"/>
          </a:p>
          <a:p>
            <a:pPr marL="0" indent="0">
              <a:buNone/>
            </a:pPr>
            <a:endParaRPr lang="en-US" dirty="0"/>
          </a:p>
          <a:p>
            <a:pPr marL="514350" indent="-514350">
              <a:buFont typeface="+mj-lt"/>
              <a:buAutoNum type="arabicPeriod"/>
            </a:pPr>
            <a:r>
              <a:rPr lang="en-US" sz="2400" dirty="0"/>
              <a:t>Reframe challenging patient and family behavior to enable more constructive collaboration</a:t>
            </a:r>
          </a:p>
          <a:p>
            <a:pPr marL="514350" indent="-514350">
              <a:buFont typeface="+mj-lt"/>
              <a:buAutoNum type="arabicPeriod"/>
            </a:pPr>
            <a:r>
              <a:rPr lang="en-US" sz="2400" dirty="0"/>
              <a:t>Identify the source of provider-patient conflicts by discovering the "View From Everywhere"</a:t>
            </a:r>
          </a:p>
          <a:p>
            <a:pPr marL="514350" indent="-514350">
              <a:buFont typeface="+mj-lt"/>
              <a:buAutoNum type="arabicPeriod"/>
            </a:pPr>
            <a:r>
              <a:rPr lang="en-US" sz="2400" dirty="0"/>
              <a:t>Formulate the distinction between “Positions and Interests” to refocus the conversation on the underlying reasons for the conflict</a:t>
            </a:r>
            <a:endParaRPr lang="en-US" dirty="0"/>
          </a:p>
        </p:txBody>
      </p:sp>
    </p:spTree>
    <p:extLst>
      <p:ext uri="{BB962C8B-B14F-4D97-AF65-F5344CB8AC3E}">
        <p14:creationId xmlns:p14="http://schemas.microsoft.com/office/powerpoint/2010/main" val="10602627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1">
            <a:extLst>
              <a:ext uri="{FF2B5EF4-FFF2-40B4-BE49-F238E27FC236}">
                <a16:creationId xmlns:a16="http://schemas.microsoft.com/office/drawing/2014/main" id="{D3629273-400F-4936-BD29-FF83AF11D9F6}"/>
              </a:ext>
            </a:extLst>
          </p:cNvPr>
          <p:cNvSpPr txBox="1">
            <a:spLocks/>
          </p:cNvSpPr>
          <p:nvPr/>
        </p:nvSpPr>
        <p:spPr bwMode="auto">
          <a:xfrm>
            <a:off x="381000" y="2057400"/>
            <a:ext cx="3505200" cy="6556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mj-lt"/>
                <a:ea typeface="+mj-ea"/>
                <a:cs typeface="+mj-cs"/>
              </a:defRPr>
            </a:lvl1pPr>
            <a:lvl2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2pPr>
            <a:lvl3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3pPr>
            <a:lvl4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4pPr>
            <a:lvl5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5pPr>
            <a:lvl6pPr marL="4572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6pPr>
            <a:lvl7pPr marL="9144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7pPr>
            <a:lvl8pPr marL="13716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8pPr>
            <a:lvl9pPr marL="18288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9pPr>
          </a:lstStyle>
          <a:p>
            <a:pPr algn="r"/>
            <a:r>
              <a:rPr lang="en-US" sz="4000" kern="0" dirty="0">
                <a:solidFill>
                  <a:schemeClr val="tx1"/>
                </a:solidFill>
                <a:effectLst/>
              </a:rPr>
              <a:t>Group Exercise</a:t>
            </a:r>
            <a:endParaRPr lang="en-US" sz="4000" kern="0" dirty="0">
              <a:solidFill>
                <a:schemeClr val="tx1"/>
              </a:solidFill>
            </a:endParaRPr>
          </a:p>
        </p:txBody>
      </p:sp>
      <p:sp>
        <p:nvSpPr>
          <p:cNvPr id="6" name="Title 1">
            <a:extLst>
              <a:ext uri="{FF2B5EF4-FFF2-40B4-BE49-F238E27FC236}">
                <a16:creationId xmlns:a16="http://schemas.microsoft.com/office/drawing/2014/main" id="{739EE702-8BB0-4845-B368-8590A572D8D3}"/>
              </a:ext>
            </a:extLst>
          </p:cNvPr>
          <p:cNvSpPr>
            <a:spLocks noGrp="1"/>
          </p:cNvSpPr>
          <p:nvPr>
            <p:ph type="title"/>
          </p:nvPr>
        </p:nvSpPr>
        <p:spPr>
          <a:xfrm>
            <a:off x="628650" y="365126"/>
            <a:ext cx="7886700" cy="1325563"/>
          </a:xfrm>
        </p:spPr>
        <p:txBody>
          <a:bodyPr/>
          <a:lstStyle/>
          <a:p>
            <a:pPr algn="r"/>
            <a:r>
              <a:rPr lang="en-US" dirty="0">
                <a:solidFill>
                  <a:schemeClr val="tx2">
                    <a:lumMod val="90000"/>
                  </a:schemeClr>
                </a:solidFill>
                <a:effectLst/>
              </a:rPr>
              <a:t>Strategy for Diagnosing </a:t>
            </a:r>
            <a:br>
              <a:rPr lang="en-US" dirty="0">
                <a:solidFill>
                  <a:schemeClr val="tx2">
                    <a:lumMod val="90000"/>
                  </a:schemeClr>
                </a:solidFill>
                <a:effectLst/>
              </a:rPr>
            </a:br>
            <a:r>
              <a:rPr lang="en-US" dirty="0">
                <a:solidFill>
                  <a:schemeClr val="tx2">
                    <a:lumMod val="90000"/>
                  </a:schemeClr>
                </a:solidFill>
                <a:effectLst/>
              </a:rPr>
              <a:t>      the Problem</a:t>
            </a:r>
            <a:endParaRPr lang="en-US" dirty="0">
              <a:solidFill>
                <a:schemeClr val="tx2">
                  <a:lumMod val="90000"/>
                </a:schemeClr>
              </a:solidFill>
            </a:endParaRPr>
          </a:p>
        </p:txBody>
      </p:sp>
    </p:spTree>
    <p:extLst>
      <p:ext uri="{BB962C8B-B14F-4D97-AF65-F5344CB8AC3E}">
        <p14:creationId xmlns:p14="http://schemas.microsoft.com/office/powerpoint/2010/main" val="259346271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140290" name="Rectangle 2"/>
          <p:cNvSpPr>
            <a:spLocks noGrp="1" noChangeArrowheads="1"/>
          </p:cNvSpPr>
          <p:nvPr>
            <p:ph type="title"/>
          </p:nvPr>
        </p:nvSpPr>
        <p:spPr>
          <a:xfrm>
            <a:off x="152400" y="0"/>
            <a:ext cx="8686800" cy="1524000"/>
          </a:xfrm>
        </p:spPr>
        <p:txBody>
          <a:bodyPr>
            <a:normAutofit fontScale="90000"/>
          </a:bodyPr>
          <a:lstStyle/>
          <a:p>
            <a:pPr>
              <a:defRPr/>
            </a:pPr>
            <a:r>
              <a:rPr lang="en-US" sz="3800" dirty="0"/>
              <a:t>Pursing the View from Everywhere:</a:t>
            </a:r>
            <a:br>
              <a:rPr lang="en-US" sz="3800" dirty="0"/>
            </a:br>
            <a:r>
              <a:rPr lang="en-US" sz="3800" dirty="0"/>
              <a:t>What might the </a:t>
            </a:r>
            <a:r>
              <a:rPr lang="en-US" sz="3800" i="1" dirty="0"/>
              <a:t>staff’s</a:t>
            </a:r>
            <a:r>
              <a:rPr lang="en-US" sz="3800" dirty="0"/>
              <a:t> perspective be on the problem?</a:t>
            </a:r>
          </a:p>
        </p:txBody>
      </p:sp>
      <p:sp>
        <p:nvSpPr>
          <p:cNvPr id="140291" name="Rectangle 3"/>
          <p:cNvSpPr>
            <a:spLocks noGrp="1" noChangeArrowheads="1"/>
          </p:cNvSpPr>
          <p:nvPr>
            <p:ph idx="1"/>
          </p:nvPr>
        </p:nvSpPr>
        <p:spPr>
          <a:xfrm>
            <a:off x="228600" y="1676400"/>
            <a:ext cx="8458199" cy="4876800"/>
          </a:xfrm>
        </p:spPr>
        <p:txBody>
          <a:bodyPr/>
          <a:lstStyle/>
          <a:p>
            <a:r>
              <a:rPr lang="en-US" sz="2200" dirty="0">
                <a:effectLst/>
              </a:rPr>
              <a:t>Fred is a 16-year-old with an incomplete C-4 injury to his spinal cord as the result of a gunshot wound. He is currently unable to move his arms or legs. Before his injury, Fred attended school intermittently and was on probation for heroin possession. His mother is unable to visit during the week because of her work schedule and his elderly grandmother is homebound. Since he has come to the rehab hospital, Fred has been verbally abusive to staff. His cursing distresses the other patients, as well as the physicians and other staff. Fred often complains of pain and screams loudly when moved, though his physicians insist he is on the highest dose of narcotics that they feel comfortable prescribing. Because of Fred’s language and derogatory comments, both physicians and nurses are starting to refuse to work with him. </a:t>
            </a:r>
          </a:p>
        </p:txBody>
      </p:sp>
    </p:spTree>
    <p:extLst>
      <p:ext uri="{BB962C8B-B14F-4D97-AF65-F5344CB8AC3E}">
        <p14:creationId xmlns:p14="http://schemas.microsoft.com/office/powerpoint/2010/main" val="353566694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140290" name="Rectangle 2"/>
          <p:cNvSpPr>
            <a:spLocks noGrp="1" noChangeArrowheads="1"/>
          </p:cNvSpPr>
          <p:nvPr>
            <p:ph type="title"/>
          </p:nvPr>
        </p:nvSpPr>
        <p:spPr>
          <a:xfrm>
            <a:off x="152400" y="0"/>
            <a:ext cx="8686800" cy="1524000"/>
          </a:xfrm>
        </p:spPr>
        <p:txBody>
          <a:bodyPr>
            <a:normAutofit fontScale="90000"/>
          </a:bodyPr>
          <a:lstStyle/>
          <a:p>
            <a:pPr>
              <a:defRPr/>
            </a:pPr>
            <a:r>
              <a:rPr lang="en-US" sz="3800" dirty="0"/>
              <a:t>Pursing the View from Everywhere:</a:t>
            </a:r>
            <a:br>
              <a:rPr lang="en-US" sz="3800" dirty="0"/>
            </a:br>
            <a:r>
              <a:rPr lang="en-US" sz="3800" dirty="0"/>
              <a:t>What might the </a:t>
            </a:r>
            <a:r>
              <a:rPr lang="en-US" sz="3800" i="1" dirty="0"/>
              <a:t>Fred’s</a:t>
            </a:r>
            <a:r>
              <a:rPr lang="en-US" sz="3800" dirty="0"/>
              <a:t> perspective be on the problem?</a:t>
            </a:r>
          </a:p>
        </p:txBody>
      </p:sp>
      <p:sp>
        <p:nvSpPr>
          <p:cNvPr id="140291" name="Rectangle 3"/>
          <p:cNvSpPr>
            <a:spLocks noGrp="1" noChangeArrowheads="1"/>
          </p:cNvSpPr>
          <p:nvPr>
            <p:ph idx="1"/>
          </p:nvPr>
        </p:nvSpPr>
        <p:spPr>
          <a:xfrm>
            <a:off x="228600" y="1676400"/>
            <a:ext cx="8458199" cy="4876800"/>
          </a:xfrm>
        </p:spPr>
        <p:txBody>
          <a:bodyPr/>
          <a:lstStyle/>
          <a:p>
            <a:r>
              <a:rPr lang="en-US" sz="2200" dirty="0">
                <a:effectLst/>
              </a:rPr>
              <a:t>Fred is a 16-year-old with an incomplete C-4 injury to his spinal cord as the result of a gunshot wound. He is currently unable to move his arms or legs. Before his injury, Fred attended school intermittently and was on probation for heroin possession. His mother is unable to visit during the week because of her work schedule and his elderly grandmother is homebound. Since he has come to the rehab hospital, Fred has been verbally abusive to staff. His cursing distresses the other patients, as well as the physicians and other staff. Fred often complains of pain and screams loudly when moved, though his physicians insist he is on the highest dose of narcotics that they feel comfortable prescribing. Because of Fred’s language and derogatory comments, both physicians and nurses are starting to refuse to work with him. </a:t>
            </a:r>
          </a:p>
        </p:txBody>
      </p:sp>
    </p:spTree>
    <p:extLst>
      <p:ext uri="{BB962C8B-B14F-4D97-AF65-F5344CB8AC3E}">
        <p14:creationId xmlns:p14="http://schemas.microsoft.com/office/powerpoint/2010/main" val="88574405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739EE702-8BB0-4845-B368-8590A572D8D3}"/>
              </a:ext>
            </a:extLst>
          </p:cNvPr>
          <p:cNvSpPr>
            <a:spLocks noGrp="1"/>
          </p:cNvSpPr>
          <p:nvPr>
            <p:ph type="title"/>
          </p:nvPr>
        </p:nvSpPr>
        <p:spPr>
          <a:xfrm>
            <a:off x="628650" y="365126"/>
            <a:ext cx="7886700" cy="1325563"/>
          </a:xfrm>
        </p:spPr>
        <p:txBody>
          <a:bodyPr/>
          <a:lstStyle/>
          <a:p>
            <a:pPr algn="r"/>
            <a:r>
              <a:rPr lang="en-US" dirty="0">
                <a:solidFill>
                  <a:schemeClr val="tx2">
                    <a:lumMod val="90000"/>
                  </a:schemeClr>
                </a:solidFill>
                <a:effectLst/>
              </a:rPr>
              <a:t>Strategy for Diagnosing </a:t>
            </a:r>
            <a:br>
              <a:rPr lang="en-US" dirty="0">
                <a:solidFill>
                  <a:schemeClr val="tx2">
                    <a:lumMod val="90000"/>
                  </a:schemeClr>
                </a:solidFill>
                <a:effectLst/>
              </a:rPr>
            </a:br>
            <a:r>
              <a:rPr lang="en-US" dirty="0">
                <a:solidFill>
                  <a:schemeClr val="tx2">
                    <a:lumMod val="90000"/>
                  </a:schemeClr>
                </a:solidFill>
                <a:effectLst/>
              </a:rPr>
              <a:t>      the Problem</a:t>
            </a:r>
            <a:endParaRPr lang="en-US" dirty="0">
              <a:solidFill>
                <a:schemeClr val="tx2">
                  <a:lumMod val="90000"/>
                </a:schemeClr>
              </a:solidFill>
            </a:endParaRPr>
          </a:p>
        </p:txBody>
      </p:sp>
      <p:sp>
        <p:nvSpPr>
          <p:cNvPr id="4" name="Title 1">
            <a:extLst>
              <a:ext uri="{FF2B5EF4-FFF2-40B4-BE49-F238E27FC236}">
                <a16:creationId xmlns:a16="http://schemas.microsoft.com/office/drawing/2014/main" id="{64C82B84-6970-4763-B1D5-A57C227D561C}"/>
              </a:ext>
            </a:extLst>
          </p:cNvPr>
          <p:cNvSpPr txBox="1">
            <a:spLocks/>
          </p:cNvSpPr>
          <p:nvPr/>
        </p:nvSpPr>
        <p:spPr bwMode="auto">
          <a:xfrm>
            <a:off x="381000" y="2057400"/>
            <a:ext cx="8382000" cy="6556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mj-lt"/>
                <a:ea typeface="+mj-ea"/>
                <a:cs typeface="+mj-cs"/>
              </a:defRPr>
            </a:lvl1pPr>
            <a:lvl2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2pPr>
            <a:lvl3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3pPr>
            <a:lvl4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4pPr>
            <a:lvl5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5pPr>
            <a:lvl6pPr marL="4572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6pPr>
            <a:lvl7pPr marL="9144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7pPr>
            <a:lvl8pPr marL="13716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8pPr>
            <a:lvl9pPr marL="18288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9pPr>
          </a:lstStyle>
          <a:p>
            <a:pPr algn="l"/>
            <a:r>
              <a:rPr lang="en-US" sz="4000" kern="0" dirty="0">
                <a:solidFill>
                  <a:schemeClr val="tx1"/>
                </a:solidFill>
                <a:effectLst/>
              </a:rPr>
              <a:t>Breakout  Exercise: The Case of          Mr. Roberts</a:t>
            </a:r>
            <a:endParaRPr lang="en-US" sz="4000" kern="0" dirty="0">
              <a:solidFill>
                <a:schemeClr val="tx1"/>
              </a:solidFill>
            </a:endParaRPr>
          </a:p>
        </p:txBody>
      </p:sp>
      <p:sp>
        <p:nvSpPr>
          <p:cNvPr id="5" name="Title 1">
            <a:extLst>
              <a:ext uri="{FF2B5EF4-FFF2-40B4-BE49-F238E27FC236}">
                <a16:creationId xmlns:a16="http://schemas.microsoft.com/office/drawing/2014/main" id="{C88D06C4-3B61-4249-A8F8-44138D347452}"/>
              </a:ext>
            </a:extLst>
          </p:cNvPr>
          <p:cNvSpPr txBox="1">
            <a:spLocks/>
          </p:cNvSpPr>
          <p:nvPr/>
        </p:nvSpPr>
        <p:spPr bwMode="auto">
          <a:xfrm>
            <a:off x="1219200" y="4038600"/>
            <a:ext cx="6172200" cy="6556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mj-lt"/>
                <a:ea typeface="+mj-ea"/>
                <a:cs typeface="+mj-cs"/>
              </a:defRPr>
            </a:lvl1pPr>
            <a:lvl2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2pPr>
            <a:lvl3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3pPr>
            <a:lvl4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4pPr>
            <a:lvl5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5pPr>
            <a:lvl6pPr marL="4572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6pPr>
            <a:lvl7pPr marL="9144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7pPr>
            <a:lvl8pPr marL="13716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8pPr>
            <a:lvl9pPr marL="18288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9pPr>
          </a:lstStyle>
          <a:p>
            <a:pPr marL="230188" indent="-230188" algn="l">
              <a:buFont typeface="Arial" panose="020B0604020202020204" pitchFamily="34" charset="0"/>
              <a:buChar char="•"/>
            </a:pPr>
            <a:r>
              <a:rPr lang="en-US" sz="2800" kern="0" dirty="0">
                <a:solidFill>
                  <a:schemeClr val="tx1"/>
                </a:solidFill>
                <a:effectLst/>
              </a:rPr>
              <a:t>Forming small groups, use the case of Mr. Roberts to pursue the View from Everywhere</a:t>
            </a:r>
          </a:p>
          <a:p>
            <a:pPr marL="684213" lvl="1" indent="-227013" algn="l">
              <a:buFont typeface="Wingdings" panose="05000000000000000000" pitchFamily="2" charset="2"/>
              <a:buChar char="§"/>
            </a:pPr>
            <a:r>
              <a:rPr lang="en-US" sz="2000" kern="0" dirty="0">
                <a:solidFill>
                  <a:schemeClr val="tx1"/>
                </a:solidFill>
                <a:effectLst/>
              </a:rPr>
              <a:t>What is Dr. Richards’ perspective on the problem? </a:t>
            </a:r>
          </a:p>
          <a:p>
            <a:pPr marL="684213" lvl="1" indent="-227013" algn="l">
              <a:buFont typeface="Wingdings" panose="05000000000000000000" pitchFamily="2" charset="2"/>
              <a:buChar char="§"/>
            </a:pPr>
            <a:r>
              <a:rPr lang="en-US" sz="2000" kern="0" dirty="0">
                <a:solidFill>
                  <a:schemeClr val="tx1"/>
                </a:solidFill>
                <a:effectLst/>
              </a:rPr>
              <a:t>What is Mrs. Roberts’ perspective on the problem?</a:t>
            </a:r>
          </a:p>
        </p:txBody>
      </p:sp>
    </p:spTree>
    <p:extLst>
      <p:ext uri="{BB962C8B-B14F-4D97-AF65-F5344CB8AC3E}">
        <p14:creationId xmlns:p14="http://schemas.microsoft.com/office/powerpoint/2010/main" val="125986917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140291" name="Rectangle 3"/>
          <p:cNvSpPr>
            <a:spLocks noGrp="1" noChangeArrowheads="1"/>
          </p:cNvSpPr>
          <p:nvPr>
            <p:ph idx="1"/>
          </p:nvPr>
        </p:nvSpPr>
        <p:spPr>
          <a:xfrm>
            <a:off x="114300" y="1447800"/>
            <a:ext cx="8915400" cy="6477000"/>
          </a:xfrm>
        </p:spPr>
        <p:txBody>
          <a:bodyPr/>
          <a:lstStyle/>
          <a:p>
            <a:pPr marL="227013" indent="-227013"/>
            <a:r>
              <a:rPr lang="en-US" sz="1850" dirty="0">
                <a:effectLst/>
              </a:rPr>
              <a:t>John Roberts is a 73-year-old man who presented to the hospital with respiratory distress.  He required intubation and mechanical ventilation upon arrival.  Subsequently, he underwent a battery of tests that diagnosed metastatic lung cancer.  His hospitalization has been complicated by pneumothorax, venous thromboembolism, cardiac arrhythmias, anemia, pneumonia, and severe malnutrition.  He has undergone multiple procedures including a tracheostomy and feeding tube placement.  One month into his course of treatment, he has persistent respiratory failure and remains ventilator dependent.  Additionally, he has now developed acute renal failure that requires renal replacement therapy to sustain life.  He is otherwise hemodynamically stable.  His wife has medical power of attorney.  During previous conversations, his wife has stated a strong desire to continue aggressive therapy and indicated that her best understanding of the patient’s wishes would be to continue with aggressive therapy indefinitely. Now she is insisting on dialysis. Dr. Richards feels that hemodialysis will not alter the patient’s prognosis.  He has metastatic cancer and is too unstable to safely receive even palliative chemotherapy.  His life expectancy is weeks, and while withholding this life-sustaining treatment could hasten his demise, it will not change the outcome of certain death, as a direct result of complications from his lung cancer.  Therefore, Dr. Richards is refusing the dialysis. </a:t>
            </a:r>
            <a:endParaRPr lang="en-US" sz="2200" dirty="0">
              <a:effectLst/>
            </a:endParaRPr>
          </a:p>
        </p:txBody>
      </p:sp>
      <p:sp>
        <p:nvSpPr>
          <p:cNvPr id="3" name="Rectangle 2">
            <a:extLst>
              <a:ext uri="{FF2B5EF4-FFF2-40B4-BE49-F238E27FC236}">
                <a16:creationId xmlns:a16="http://schemas.microsoft.com/office/drawing/2014/main" id="{43C27CD9-6A42-46EF-9A21-D6555C55C227}"/>
              </a:ext>
            </a:extLst>
          </p:cNvPr>
          <p:cNvSpPr>
            <a:spLocks noGrp="1" noChangeArrowheads="1"/>
          </p:cNvSpPr>
          <p:nvPr>
            <p:ph type="title"/>
          </p:nvPr>
        </p:nvSpPr>
        <p:spPr>
          <a:xfrm>
            <a:off x="217714" y="152400"/>
            <a:ext cx="7467600" cy="914400"/>
          </a:xfrm>
        </p:spPr>
        <p:txBody>
          <a:bodyPr/>
          <a:lstStyle/>
          <a:p>
            <a:pPr eaLnBrk="1" hangingPunct="1">
              <a:defRPr/>
            </a:pPr>
            <a:r>
              <a:rPr lang="en-US" sz="3600" dirty="0">
                <a:solidFill>
                  <a:schemeClr val="tx2">
                    <a:lumMod val="75000"/>
                  </a:schemeClr>
                </a:solidFill>
              </a:rPr>
              <a:t>Case Study: Mr. Roberts</a:t>
            </a:r>
          </a:p>
        </p:txBody>
      </p:sp>
    </p:spTree>
    <p:extLst>
      <p:ext uri="{BB962C8B-B14F-4D97-AF65-F5344CB8AC3E}">
        <p14:creationId xmlns:p14="http://schemas.microsoft.com/office/powerpoint/2010/main" val="1904564787"/>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140291">
                                            <p:txEl>
                                              <p:pRg st="0" end="0"/>
                                            </p:txEl>
                                          </p:spTgt>
                                        </p:tgtEl>
                                        <p:attrNameLst>
                                          <p:attrName>style.visibility</p:attrName>
                                        </p:attrNameLst>
                                      </p:cBhvr>
                                      <p:to>
                                        <p:strVal val="visible"/>
                                      </p:to>
                                    </p:set>
                                    <p:animEffect transition="in" filter="fade">
                                      <p:cBhvr>
                                        <p:cTn id="7" dur="1000"/>
                                        <p:tgtEl>
                                          <p:spTgt spid="140291">
                                            <p:txEl>
                                              <p:pRg st="0" end="0"/>
                                            </p:txEl>
                                          </p:spTgt>
                                        </p:tgtEl>
                                      </p:cBhvr>
                                    </p:animEffect>
                                    <p:anim calcmode="lin" valueType="num">
                                      <p:cBhvr>
                                        <p:cTn id="8" dur="1000" fill="hold"/>
                                        <p:tgtEl>
                                          <p:spTgt spid="140291">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140291">
                                            <p:txEl>
                                              <p:pRg st="0" end="0"/>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0291" grpId="0" build="p"/>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85900" y="3963071"/>
            <a:ext cx="6172200" cy="1143000"/>
          </a:xfrm>
        </p:spPr>
        <p:txBody>
          <a:bodyPr/>
          <a:lstStyle/>
          <a:p>
            <a:pPr algn="r"/>
            <a:r>
              <a:rPr lang="en-US" dirty="0">
                <a:solidFill>
                  <a:schemeClr val="tx2">
                    <a:lumMod val="90000"/>
                  </a:schemeClr>
                </a:solidFill>
                <a:effectLst/>
              </a:rPr>
              <a:t>Strategy for Diagnosing</a:t>
            </a:r>
            <a:br>
              <a:rPr lang="en-US" dirty="0">
                <a:solidFill>
                  <a:schemeClr val="tx2">
                    <a:lumMod val="90000"/>
                  </a:schemeClr>
                </a:solidFill>
                <a:effectLst/>
              </a:rPr>
            </a:br>
            <a:r>
              <a:rPr lang="en-US" dirty="0">
                <a:solidFill>
                  <a:schemeClr val="tx2">
                    <a:lumMod val="90000"/>
                  </a:schemeClr>
                </a:solidFill>
                <a:effectLst/>
              </a:rPr>
              <a:t> the Problem</a:t>
            </a:r>
            <a:endParaRPr lang="en-US" dirty="0">
              <a:solidFill>
                <a:schemeClr val="tx2">
                  <a:lumMod val="90000"/>
                </a:schemeClr>
              </a:solidFill>
            </a:endParaRPr>
          </a:p>
        </p:txBody>
      </p:sp>
      <p:sp>
        <p:nvSpPr>
          <p:cNvPr id="4" name="TextBox 3">
            <a:extLst>
              <a:ext uri="{FF2B5EF4-FFF2-40B4-BE49-F238E27FC236}">
                <a16:creationId xmlns:a16="http://schemas.microsoft.com/office/drawing/2014/main" id="{59906702-AF7D-4B49-A91E-5AAD26F690A9}"/>
              </a:ext>
            </a:extLst>
          </p:cNvPr>
          <p:cNvSpPr txBox="1"/>
          <p:nvPr/>
        </p:nvSpPr>
        <p:spPr>
          <a:xfrm>
            <a:off x="1371600" y="1466486"/>
            <a:ext cx="6172200" cy="1446550"/>
          </a:xfrm>
          <a:prstGeom prst="rect">
            <a:avLst/>
          </a:prstGeom>
          <a:noFill/>
        </p:spPr>
        <p:txBody>
          <a:bodyPr wrap="square">
            <a:spAutoFit/>
          </a:bodyPr>
          <a:lstStyle/>
          <a:p>
            <a:pPr algn="r"/>
            <a:r>
              <a:rPr lang="en-US" sz="4400" dirty="0"/>
              <a:t>Pursuing the View from Everywhere</a:t>
            </a:r>
          </a:p>
        </p:txBody>
      </p:sp>
      <p:sp>
        <p:nvSpPr>
          <p:cNvPr id="5" name="Arrow: Right 4">
            <a:extLst>
              <a:ext uri="{FF2B5EF4-FFF2-40B4-BE49-F238E27FC236}">
                <a16:creationId xmlns:a16="http://schemas.microsoft.com/office/drawing/2014/main" id="{A658E2B0-3C5A-4B7F-A28F-CC7F0BE19C0F}"/>
              </a:ext>
            </a:extLst>
          </p:cNvPr>
          <p:cNvSpPr/>
          <p:nvPr/>
        </p:nvSpPr>
        <p:spPr>
          <a:xfrm rot="5400000">
            <a:off x="2142943" y="2886257"/>
            <a:ext cx="1446550" cy="398436"/>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52397818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0" name="Rectangle 2"/>
          <p:cNvSpPr>
            <a:spLocks noGrp="1" noChangeArrowheads="1"/>
          </p:cNvSpPr>
          <p:nvPr>
            <p:ph type="ctrTitle"/>
          </p:nvPr>
        </p:nvSpPr>
        <p:spPr>
          <a:xfrm>
            <a:off x="228600" y="914400"/>
            <a:ext cx="8326413" cy="1295400"/>
          </a:xfrm>
        </p:spPr>
        <p:txBody>
          <a:bodyPr/>
          <a:lstStyle/>
          <a:p>
            <a:pPr eaLnBrk="1" hangingPunct="1">
              <a:lnSpc>
                <a:spcPct val="95000"/>
              </a:lnSpc>
              <a:spcAft>
                <a:spcPct val="10000"/>
              </a:spcAft>
              <a:defRPr/>
            </a:pPr>
            <a:r>
              <a:rPr lang="en-US" sz="6000" dirty="0">
                <a:effectLst>
                  <a:outerShdw blurRad="38100" dist="38100" dir="2700000" algn="tl">
                    <a:srgbClr val="000000">
                      <a:alpha val="43137"/>
                    </a:srgbClr>
                  </a:outerShdw>
                </a:effectLst>
              </a:rPr>
              <a:t>The Mediator’s Toolbox</a:t>
            </a:r>
          </a:p>
        </p:txBody>
      </p:sp>
      <p:sp>
        <p:nvSpPr>
          <p:cNvPr id="2" name="TextBox 1"/>
          <p:cNvSpPr txBox="1"/>
          <p:nvPr/>
        </p:nvSpPr>
        <p:spPr>
          <a:xfrm>
            <a:off x="1143000" y="5029200"/>
            <a:ext cx="7239000" cy="1447800"/>
          </a:xfrm>
          <a:prstGeom prst="rect">
            <a:avLst/>
          </a:prstGeom>
          <a:noFill/>
        </p:spPr>
        <p:txBody>
          <a:bodyPr wrap="square" rtlCol="0">
            <a:spAutoFit/>
          </a:bodyPr>
          <a:lstStyle/>
          <a:p>
            <a:endParaRPr lang="en-US" dirty="0"/>
          </a:p>
        </p:txBody>
      </p:sp>
      <p:sp>
        <p:nvSpPr>
          <p:cNvPr id="4" name="TextBox 3"/>
          <p:cNvSpPr txBox="1"/>
          <p:nvPr/>
        </p:nvSpPr>
        <p:spPr>
          <a:xfrm>
            <a:off x="1143000" y="2819400"/>
            <a:ext cx="6858000" cy="2246769"/>
          </a:xfrm>
          <a:prstGeom prst="rect">
            <a:avLst/>
          </a:prstGeom>
          <a:noFill/>
        </p:spPr>
        <p:txBody>
          <a:bodyPr wrap="square" rtlCol="0">
            <a:spAutoFit/>
          </a:bodyPr>
          <a:lstStyle/>
          <a:p>
            <a:pPr marL="231775" indent="-231775">
              <a:buFont typeface="Arial" panose="020B0604020202020204" pitchFamily="34" charset="0"/>
              <a:buChar char="•"/>
            </a:pPr>
            <a:r>
              <a:rPr lang="en-US" sz="2800" dirty="0"/>
              <a:t>Strategies for Diagnosing the Problem: the View from Everywhere</a:t>
            </a:r>
          </a:p>
          <a:p>
            <a:pPr marL="231775" indent="-231775">
              <a:buFont typeface="Arial" panose="020B0604020202020204" pitchFamily="34" charset="0"/>
              <a:buChar char="•"/>
            </a:pPr>
            <a:r>
              <a:rPr lang="en-US" sz="2800" dirty="0"/>
              <a:t>Strategies for Understanding the Underlying Reasons for the Conflict: Positions vs. Interests</a:t>
            </a:r>
          </a:p>
        </p:txBody>
      </p:sp>
      <p:sp>
        <p:nvSpPr>
          <p:cNvPr id="5" name="Oval Callout 4">
            <a:extLst>
              <a:ext uri="{FF2B5EF4-FFF2-40B4-BE49-F238E27FC236}">
                <a16:creationId xmlns:a16="http://schemas.microsoft.com/office/drawing/2014/main" id="{C258EB31-C08D-44EB-99A8-C5CC4FBE8ED7}"/>
              </a:ext>
            </a:extLst>
          </p:cNvPr>
          <p:cNvSpPr/>
          <p:nvPr/>
        </p:nvSpPr>
        <p:spPr>
          <a:xfrm rot="21074143">
            <a:off x="4691216" y="4780756"/>
            <a:ext cx="3333380" cy="1539319"/>
          </a:xfrm>
          <a:prstGeom prst="wedgeEllipseCallout">
            <a:avLst>
              <a:gd name="adj1" fmla="val -40896"/>
              <a:gd name="adj2" fmla="val -135512"/>
            </a:avLst>
          </a:prstGeom>
          <a:solidFill>
            <a:srgbClr val="FFC000"/>
          </a:solidFill>
          <a:ln>
            <a:solidFill>
              <a:srgbClr val="FFD54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bg1"/>
                </a:solidFill>
              </a:rPr>
              <a:t>Step #1: Get everyone's perspective on the problem</a:t>
            </a:r>
          </a:p>
        </p:txBody>
      </p:sp>
    </p:spTree>
    <p:extLst>
      <p:ext uri="{BB962C8B-B14F-4D97-AF65-F5344CB8AC3E}">
        <p14:creationId xmlns:p14="http://schemas.microsoft.com/office/powerpoint/2010/main" val="417973080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0" name="Rectangle 2"/>
          <p:cNvSpPr>
            <a:spLocks noGrp="1" noChangeArrowheads="1"/>
          </p:cNvSpPr>
          <p:nvPr>
            <p:ph type="ctrTitle"/>
          </p:nvPr>
        </p:nvSpPr>
        <p:spPr>
          <a:xfrm>
            <a:off x="228600" y="914400"/>
            <a:ext cx="8326413" cy="1295400"/>
          </a:xfrm>
        </p:spPr>
        <p:txBody>
          <a:bodyPr/>
          <a:lstStyle/>
          <a:p>
            <a:pPr eaLnBrk="1" hangingPunct="1">
              <a:lnSpc>
                <a:spcPct val="95000"/>
              </a:lnSpc>
              <a:spcAft>
                <a:spcPct val="10000"/>
              </a:spcAft>
              <a:defRPr/>
            </a:pPr>
            <a:r>
              <a:rPr lang="en-US" sz="6000" dirty="0">
                <a:effectLst>
                  <a:outerShdw blurRad="38100" dist="38100" dir="2700000" algn="tl">
                    <a:srgbClr val="000000">
                      <a:alpha val="43137"/>
                    </a:srgbClr>
                  </a:outerShdw>
                </a:effectLst>
              </a:rPr>
              <a:t>The Mediator’s Toolbox</a:t>
            </a:r>
          </a:p>
        </p:txBody>
      </p:sp>
      <p:sp>
        <p:nvSpPr>
          <p:cNvPr id="2" name="TextBox 1"/>
          <p:cNvSpPr txBox="1"/>
          <p:nvPr/>
        </p:nvSpPr>
        <p:spPr>
          <a:xfrm>
            <a:off x="1143000" y="5029200"/>
            <a:ext cx="7239000" cy="1447800"/>
          </a:xfrm>
          <a:prstGeom prst="rect">
            <a:avLst/>
          </a:prstGeom>
          <a:noFill/>
        </p:spPr>
        <p:txBody>
          <a:bodyPr wrap="square" rtlCol="0">
            <a:spAutoFit/>
          </a:bodyPr>
          <a:lstStyle/>
          <a:p>
            <a:endParaRPr lang="en-US" dirty="0"/>
          </a:p>
        </p:txBody>
      </p:sp>
      <p:sp>
        <p:nvSpPr>
          <p:cNvPr id="4" name="TextBox 3"/>
          <p:cNvSpPr txBox="1"/>
          <p:nvPr/>
        </p:nvSpPr>
        <p:spPr>
          <a:xfrm>
            <a:off x="1143000" y="2819400"/>
            <a:ext cx="6858000" cy="2246769"/>
          </a:xfrm>
          <a:prstGeom prst="rect">
            <a:avLst/>
          </a:prstGeom>
          <a:noFill/>
        </p:spPr>
        <p:txBody>
          <a:bodyPr wrap="square" rtlCol="0">
            <a:spAutoFit/>
          </a:bodyPr>
          <a:lstStyle/>
          <a:p>
            <a:pPr marL="231775" indent="-231775">
              <a:buFont typeface="Arial" panose="020B0604020202020204" pitchFamily="34" charset="0"/>
              <a:buChar char="•"/>
            </a:pPr>
            <a:r>
              <a:rPr lang="en-US" sz="2800" dirty="0"/>
              <a:t>Strategies for Diagnosing the Problem: the View from Everywhere</a:t>
            </a:r>
          </a:p>
          <a:p>
            <a:pPr marL="231775" indent="-231775">
              <a:buFont typeface="Arial" panose="020B0604020202020204" pitchFamily="34" charset="0"/>
              <a:buChar char="•"/>
            </a:pPr>
            <a:r>
              <a:rPr lang="en-US" sz="2800" dirty="0"/>
              <a:t>Strategies for Understanding the Underlying Reasons for the Conflict: Positions vs. Interests</a:t>
            </a:r>
          </a:p>
        </p:txBody>
      </p:sp>
      <p:sp>
        <p:nvSpPr>
          <p:cNvPr id="5" name="Oval Callout 4">
            <a:extLst>
              <a:ext uri="{FF2B5EF4-FFF2-40B4-BE49-F238E27FC236}">
                <a16:creationId xmlns:a16="http://schemas.microsoft.com/office/drawing/2014/main" id="{C258EB31-C08D-44EB-99A8-C5CC4FBE8ED7}"/>
              </a:ext>
            </a:extLst>
          </p:cNvPr>
          <p:cNvSpPr/>
          <p:nvPr/>
        </p:nvSpPr>
        <p:spPr>
          <a:xfrm rot="21074143">
            <a:off x="3079519" y="4883502"/>
            <a:ext cx="4244662" cy="1739194"/>
          </a:xfrm>
          <a:prstGeom prst="wedgeEllipseCallout">
            <a:avLst>
              <a:gd name="adj1" fmla="val -55136"/>
              <a:gd name="adj2" fmla="val -92497"/>
            </a:avLst>
          </a:prstGeom>
          <a:solidFill>
            <a:srgbClr val="FFC000"/>
          </a:solidFill>
          <a:ln>
            <a:solidFill>
              <a:srgbClr val="FFD54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solidFill>
                  <a:schemeClr val="bg1"/>
                </a:solidFill>
              </a:rPr>
              <a:t>Step #2: Understand each stakeholder's underlying motivations &amp; needs</a:t>
            </a:r>
          </a:p>
        </p:txBody>
      </p:sp>
    </p:spTree>
    <p:extLst>
      <p:ext uri="{BB962C8B-B14F-4D97-AF65-F5344CB8AC3E}">
        <p14:creationId xmlns:p14="http://schemas.microsoft.com/office/powerpoint/2010/main" val="273911521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Uncovering </a:t>
            </a:r>
            <a:br>
              <a:rPr lang="en-US" dirty="0">
                <a:solidFill>
                  <a:schemeClr val="tx2">
                    <a:lumMod val="90000"/>
                  </a:schemeClr>
                </a:solidFill>
                <a:effectLst/>
              </a:rPr>
            </a:br>
            <a:r>
              <a:rPr lang="en-US" dirty="0">
                <a:solidFill>
                  <a:schemeClr val="tx2">
                    <a:lumMod val="90000"/>
                  </a:schemeClr>
                </a:solidFill>
                <a:effectLst/>
              </a:rPr>
              <a:t>Interests</a:t>
            </a:r>
            <a:endParaRPr lang="en-US" dirty="0">
              <a:solidFill>
                <a:schemeClr val="tx2">
                  <a:lumMod val="90000"/>
                </a:schemeClr>
              </a:solidFill>
            </a:endParaRPr>
          </a:p>
        </p:txBody>
      </p:sp>
      <p:sp>
        <p:nvSpPr>
          <p:cNvPr id="3" name="Content Placeholder 2"/>
          <p:cNvSpPr>
            <a:spLocks noGrp="1"/>
          </p:cNvSpPr>
          <p:nvPr>
            <p:ph idx="1"/>
          </p:nvPr>
        </p:nvSpPr>
        <p:spPr>
          <a:xfrm>
            <a:off x="457200" y="2057400"/>
            <a:ext cx="8229600" cy="4343400"/>
          </a:xfrm>
        </p:spPr>
        <p:txBody>
          <a:bodyPr/>
          <a:lstStyle/>
          <a:p>
            <a:r>
              <a:rPr lang="en-US" sz="3600" dirty="0">
                <a:effectLst/>
              </a:rPr>
              <a:t>Fisher &amp; </a:t>
            </a:r>
            <a:r>
              <a:rPr lang="en-US" sz="3600" dirty="0" err="1">
                <a:effectLst/>
              </a:rPr>
              <a:t>Ury</a:t>
            </a:r>
            <a:r>
              <a:rPr lang="en-US" sz="3600" dirty="0">
                <a:effectLst/>
              </a:rPr>
              <a:t> (Harvard Negotiation Project, authors of </a:t>
            </a:r>
            <a:r>
              <a:rPr lang="en-US" sz="3600" i="1" dirty="0">
                <a:effectLst/>
              </a:rPr>
              <a:t>Getting to Yes)</a:t>
            </a:r>
            <a:r>
              <a:rPr lang="en-US" sz="3600" i="1" dirty="0"/>
              <a:t> </a:t>
            </a:r>
            <a:r>
              <a:rPr lang="en-US" sz="3600" dirty="0">
                <a:effectLst/>
              </a:rPr>
              <a:t>distinguish between: </a:t>
            </a:r>
          </a:p>
          <a:p>
            <a:pPr marL="457200" lvl="1" indent="0">
              <a:buNone/>
            </a:pPr>
            <a:endParaRPr lang="en-US" sz="3200" dirty="0">
              <a:effectLst/>
            </a:endParaRPr>
          </a:p>
          <a:p>
            <a:pPr marL="2803525" lvl="1" indent="-395288">
              <a:spcAft>
                <a:spcPts val="1200"/>
              </a:spcAft>
              <a:buFont typeface="Wingdings" pitchFamily="2" charset="2"/>
              <a:buChar char="Ø"/>
            </a:pPr>
            <a:r>
              <a:rPr lang="en-US" sz="3200" b="1" dirty="0">
                <a:solidFill>
                  <a:srgbClr val="FFC000"/>
                </a:solidFill>
                <a:effectLst>
                  <a:outerShdw blurRad="38100" dist="38100" dir="2700000" algn="tl">
                    <a:srgbClr val="000000">
                      <a:alpha val="43137"/>
                    </a:srgbClr>
                  </a:outerShdw>
                </a:effectLst>
              </a:rPr>
              <a:t>POSITIONS</a:t>
            </a:r>
          </a:p>
          <a:p>
            <a:pPr marL="2803525" lvl="1" indent="-395288">
              <a:spcAft>
                <a:spcPts val="1200"/>
              </a:spcAft>
              <a:buFont typeface="Wingdings" pitchFamily="2" charset="2"/>
              <a:buChar char="Ø"/>
            </a:pPr>
            <a:r>
              <a:rPr lang="en-US" sz="3200" b="1" dirty="0">
                <a:solidFill>
                  <a:srgbClr val="FFC000"/>
                </a:solidFill>
                <a:effectLst>
                  <a:outerShdw blurRad="38100" dist="38100" dir="2700000" algn="tl">
                    <a:srgbClr val="000000">
                      <a:alpha val="43137"/>
                    </a:srgbClr>
                  </a:outerShdw>
                </a:effectLst>
              </a:rPr>
              <a:t>INTERESTS</a:t>
            </a:r>
          </a:p>
        </p:txBody>
      </p:sp>
    </p:spTree>
    <p:extLst>
      <p:ext uri="{BB962C8B-B14F-4D97-AF65-F5344CB8AC3E}">
        <p14:creationId xmlns:p14="http://schemas.microsoft.com/office/powerpoint/2010/main" val="3883913611"/>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Uncovering </a:t>
            </a:r>
            <a:br>
              <a:rPr lang="en-US" dirty="0">
                <a:solidFill>
                  <a:schemeClr val="tx2">
                    <a:lumMod val="90000"/>
                  </a:schemeClr>
                </a:solidFill>
                <a:effectLst/>
              </a:rPr>
            </a:br>
            <a:r>
              <a:rPr lang="en-US" dirty="0">
                <a:solidFill>
                  <a:schemeClr val="tx2">
                    <a:lumMod val="90000"/>
                  </a:schemeClr>
                </a:solidFill>
                <a:effectLst/>
              </a:rPr>
              <a:t>Interests</a:t>
            </a:r>
            <a:endParaRPr lang="en-US" dirty="0"/>
          </a:p>
        </p:txBody>
      </p:sp>
      <p:sp>
        <p:nvSpPr>
          <p:cNvPr id="3" name="Content Placeholder 2"/>
          <p:cNvSpPr>
            <a:spLocks noGrp="1"/>
          </p:cNvSpPr>
          <p:nvPr>
            <p:ph idx="1"/>
          </p:nvPr>
        </p:nvSpPr>
        <p:spPr>
          <a:xfrm>
            <a:off x="457200" y="2057400"/>
            <a:ext cx="8229600" cy="4343400"/>
          </a:xfrm>
        </p:spPr>
        <p:txBody>
          <a:bodyPr/>
          <a:lstStyle/>
          <a:p>
            <a:r>
              <a:rPr lang="en-US" sz="2800" dirty="0">
                <a:effectLst/>
              </a:rPr>
              <a:t>Mediators distinguish between: </a:t>
            </a:r>
          </a:p>
          <a:p>
            <a:pPr marL="457200" lvl="1" indent="0">
              <a:buNone/>
            </a:pPr>
            <a:endParaRPr lang="en-US" dirty="0">
              <a:effectLst/>
            </a:endParaRPr>
          </a:p>
          <a:p>
            <a:pPr marL="2406650" lvl="1" indent="-866775">
              <a:spcAft>
                <a:spcPts val="0"/>
              </a:spcAft>
              <a:buNone/>
            </a:pPr>
            <a:r>
              <a:rPr lang="en-US" sz="3200" b="1" dirty="0">
                <a:solidFill>
                  <a:srgbClr val="33CC33"/>
                </a:solidFill>
                <a:effectLst>
                  <a:outerShdw blurRad="38100" dist="38100" dir="2700000" algn="tl">
                    <a:srgbClr val="000000">
                      <a:alpha val="43137"/>
                    </a:srgbClr>
                  </a:outerShdw>
                </a:effectLst>
              </a:rPr>
              <a:t>POSITIONS</a:t>
            </a: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a:p>
            <a:pPr marL="2408237" lvl="1" indent="0">
              <a:lnSpc>
                <a:spcPct val="150000"/>
              </a:lnSpc>
              <a:spcAft>
                <a:spcPts val="1200"/>
              </a:spcAft>
              <a:buNone/>
            </a:pPr>
            <a:r>
              <a:rPr lang="en-US" sz="3200" b="1" dirty="0">
                <a:solidFill>
                  <a:srgbClr val="C5C5C5"/>
                </a:solidFill>
                <a:effectLst>
                  <a:outerShdw blurRad="38100" dist="38100" dir="2700000" algn="tl">
                    <a:srgbClr val="000000">
                      <a:alpha val="43137"/>
                    </a:srgbClr>
                  </a:outerShdw>
                </a:effectLst>
              </a:rPr>
              <a:t>INTERESTS</a:t>
            </a:r>
          </a:p>
        </p:txBody>
      </p:sp>
      <p:sp>
        <p:nvSpPr>
          <p:cNvPr id="4" name="Cloud 3">
            <a:extLst>
              <a:ext uri="{FF2B5EF4-FFF2-40B4-BE49-F238E27FC236}">
                <a16:creationId xmlns:a16="http://schemas.microsoft.com/office/drawing/2014/main" id="{06D3AA3A-C6DE-47F9-A404-6BB41C9BCF39}"/>
              </a:ext>
            </a:extLst>
          </p:cNvPr>
          <p:cNvSpPr/>
          <p:nvPr/>
        </p:nvSpPr>
        <p:spPr>
          <a:xfrm rot="390175">
            <a:off x="5602323" y="1842229"/>
            <a:ext cx="1900724" cy="1483145"/>
          </a:xfrm>
          <a:prstGeom prst="cloud">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mc:AlternateContent xmlns:mc="http://schemas.openxmlformats.org/markup-compatibility/2006" xmlns:p14="http://schemas.microsoft.com/office/powerpoint/2010/main">
        <mc:Choice Requires="p14">
          <p:contentPart p14:bwMode="auto" r:id="rId3">
            <p14:nvContentPartPr>
              <p14:cNvPr id="5" name="Ink 4">
                <a:extLst>
                  <a:ext uri="{FF2B5EF4-FFF2-40B4-BE49-F238E27FC236}">
                    <a16:creationId xmlns:a16="http://schemas.microsoft.com/office/drawing/2014/main" id="{1936930B-9D2D-4DEF-B1FD-4B7C06AD587E}"/>
                  </a:ext>
                </a:extLst>
              </p14:cNvPr>
              <p14:cNvContentPartPr/>
              <p14:nvPr/>
            </p14:nvContentPartPr>
            <p14:xfrm>
              <a:off x="6990075" y="2620144"/>
              <a:ext cx="109800" cy="151560"/>
            </p14:xfrm>
          </p:contentPart>
        </mc:Choice>
        <mc:Fallback xmlns="">
          <p:pic>
            <p:nvPicPr>
              <p:cNvPr id="5" name="Ink 4">
                <a:extLst>
                  <a:ext uri="{FF2B5EF4-FFF2-40B4-BE49-F238E27FC236}">
                    <a16:creationId xmlns:a16="http://schemas.microsoft.com/office/drawing/2014/main" id="{1936930B-9D2D-4DEF-B1FD-4B7C06AD587E}"/>
                  </a:ext>
                </a:extLst>
              </p:cNvPr>
              <p:cNvPicPr/>
              <p:nvPr/>
            </p:nvPicPr>
            <p:blipFill>
              <a:blip r:embed="rId4"/>
              <a:stretch>
                <a:fillRect/>
              </a:stretch>
            </p:blipFill>
            <p:spPr>
              <a:xfrm>
                <a:off x="6981075" y="2611144"/>
                <a:ext cx="127440" cy="169200"/>
              </a:xfrm>
              <a:prstGeom prst="rect">
                <a:avLst/>
              </a:prstGeom>
            </p:spPr>
          </p:pic>
        </mc:Fallback>
      </mc:AlternateContent>
      <mc:AlternateContent xmlns:mc="http://schemas.openxmlformats.org/markup-compatibility/2006" xmlns:p14="http://schemas.microsoft.com/office/powerpoint/2010/main">
        <mc:Choice Requires="p14">
          <p:contentPart p14:bwMode="auto" r:id="rId5">
            <p14:nvContentPartPr>
              <p14:cNvPr id="6" name="Ink 5">
                <a:extLst>
                  <a:ext uri="{FF2B5EF4-FFF2-40B4-BE49-F238E27FC236}">
                    <a16:creationId xmlns:a16="http://schemas.microsoft.com/office/drawing/2014/main" id="{7A310F11-CAF1-4054-92C3-4C38A779F2B3}"/>
                  </a:ext>
                </a:extLst>
              </p14:cNvPr>
              <p14:cNvContentPartPr/>
              <p14:nvPr/>
            </p14:nvContentPartPr>
            <p14:xfrm>
              <a:off x="6654915" y="2671984"/>
              <a:ext cx="614520" cy="514440"/>
            </p14:xfrm>
          </p:contentPart>
        </mc:Choice>
        <mc:Fallback xmlns="">
          <p:pic>
            <p:nvPicPr>
              <p:cNvPr id="6" name="Ink 5">
                <a:extLst>
                  <a:ext uri="{FF2B5EF4-FFF2-40B4-BE49-F238E27FC236}">
                    <a16:creationId xmlns:a16="http://schemas.microsoft.com/office/drawing/2014/main" id="{7A310F11-CAF1-4054-92C3-4C38A779F2B3}"/>
                  </a:ext>
                </a:extLst>
              </p:cNvPr>
              <p:cNvPicPr/>
              <p:nvPr/>
            </p:nvPicPr>
            <p:blipFill>
              <a:blip r:embed="rId6"/>
              <a:stretch>
                <a:fillRect/>
              </a:stretch>
            </p:blipFill>
            <p:spPr>
              <a:xfrm>
                <a:off x="6645915" y="2662984"/>
                <a:ext cx="632160" cy="532080"/>
              </a:xfrm>
              <a:prstGeom prst="rect">
                <a:avLst/>
              </a:prstGeom>
            </p:spPr>
          </p:pic>
        </mc:Fallback>
      </mc:AlternateContent>
      <mc:AlternateContent xmlns:mc="http://schemas.openxmlformats.org/markup-compatibility/2006" xmlns:p14="http://schemas.microsoft.com/office/powerpoint/2010/main">
        <mc:Choice Requires="p14">
          <p:contentPart p14:bwMode="auto" r:id="rId7">
            <p14:nvContentPartPr>
              <p14:cNvPr id="7" name="Ink 6">
                <a:extLst>
                  <a:ext uri="{FF2B5EF4-FFF2-40B4-BE49-F238E27FC236}">
                    <a16:creationId xmlns:a16="http://schemas.microsoft.com/office/drawing/2014/main" id="{186A7C5C-2668-4B0E-924F-889C27F9A091}"/>
                  </a:ext>
                </a:extLst>
              </p14:cNvPr>
              <p14:cNvContentPartPr/>
              <p14:nvPr/>
            </p14:nvContentPartPr>
            <p14:xfrm>
              <a:off x="5470875" y="1758304"/>
              <a:ext cx="2513160" cy="1712160"/>
            </p14:xfrm>
          </p:contentPart>
        </mc:Choice>
        <mc:Fallback xmlns="">
          <p:pic>
            <p:nvPicPr>
              <p:cNvPr id="7" name="Ink 6">
                <a:extLst>
                  <a:ext uri="{FF2B5EF4-FFF2-40B4-BE49-F238E27FC236}">
                    <a16:creationId xmlns:a16="http://schemas.microsoft.com/office/drawing/2014/main" id="{186A7C5C-2668-4B0E-924F-889C27F9A091}"/>
                  </a:ext>
                </a:extLst>
              </p:cNvPr>
              <p:cNvPicPr/>
              <p:nvPr/>
            </p:nvPicPr>
            <p:blipFill>
              <a:blip r:embed="rId8"/>
              <a:stretch>
                <a:fillRect/>
              </a:stretch>
            </p:blipFill>
            <p:spPr>
              <a:xfrm>
                <a:off x="5407875" y="1695304"/>
                <a:ext cx="2638800" cy="1837800"/>
              </a:xfrm>
              <a:prstGeom prst="rect">
                <a:avLst/>
              </a:prstGeom>
            </p:spPr>
          </p:pic>
        </mc:Fallback>
      </mc:AlternateContent>
      <p:sp>
        <p:nvSpPr>
          <p:cNvPr id="8" name="Rectangle: Rounded Corners 7">
            <a:extLst>
              <a:ext uri="{FF2B5EF4-FFF2-40B4-BE49-F238E27FC236}">
                <a16:creationId xmlns:a16="http://schemas.microsoft.com/office/drawing/2014/main" id="{DD67AC07-58F5-489A-A35B-1D9157165C94}"/>
              </a:ext>
            </a:extLst>
          </p:cNvPr>
          <p:cNvSpPr/>
          <p:nvPr/>
        </p:nvSpPr>
        <p:spPr>
          <a:xfrm>
            <a:off x="6489757" y="3352800"/>
            <a:ext cx="330315" cy="1177736"/>
          </a:xfrm>
          <a:prstGeom prst="roundRect">
            <a:avLst/>
          </a:prstGeom>
          <a:solidFill>
            <a:srgbClr val="9966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reeform: Shape 11">
            <a:extLst>
              <a:ext uri="{FF2B5EF4-FFF2-40B4-BE49-F238E27FC236}">
                <a16:creationId xmlns:a16="http://schemas.microsoft.com/office/drawing/2014/main" id="{14B9E463-BBB3-4A6E-A00B-C32BAFB414E2}"/>
              </a:ext>
            </a:extLst>
          </p:cNvPr>
          <p:cNvSpPr/>
          <p:nvPr/>
        </p:nvSpPr>
        <p:spPr>
          <a:xfrm>
            <a:off x="6800370" y="45720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Freeform: Shape 12">
            <a:extLst>
              <a:ext uri="{FF2B5EF4-FFF2-40B4-BE49-F238E27FC236}">
                <a16:creationId xmlns:a16="http://schemas.microsoft.com/office/drawing/2014/main" id="{BBFF0C4A-E839-4469-B2C9-2ADEC12E01B5}"/>
              </a:ext>
            </a:extLst>
          </p:cNvPr>
          <p:cNvSpPr/>
          <p:nvPr/>
        </p:nvSpPr>
        <p:spPr>
          <a:xfrm rot="15377824">
            <a:off x="5624291" y="5019923"/>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Freeform: Shape 15">
            <a:extLst>
              <a:ext uri="{FF2B5EF4-FFF2-40B4-BE49-F238E27FC236}">
                <a16:creationId xmlns:a16="http://schemas.microsoft.com/office/drawing/2014/main" id="{6DEC42A5-DB2D-4F3C-87C8-5050D684DB68}"/>
              </a:ext>
            </a:extLst>
          </p:cNvPr>
          <p:cNvSpPr/>
          <p:nvPr/>
        </p:nvSpPr>
        <p:spPr>
          <a:xfrm rot="941520">
            <a:off x="6507095" y="4787321"/>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reeform: Shape 16">
            <a:extLst>
              <a:ext uri="{FF2B5EF4-FFF2-40B4-BE49-F238E27FC236}">
                <a16:creationId xmlns:a16="http://schemas.microsoft.com/office/drawing/2014/main" id="{B751F970-0410-4E65-A78A-C76EAA8E8BF9}"/>
              </a:ext>
            </a:extLst>
          </p:cNvPr>
          <p:cNvSpPr/>
          <p:nvPr/>
        </p:nvSpPr>
        <p:spPr>
          <a:xfrm rot="1963374">
            <a:off x="6286283" y="4998862"/>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9854A418-22FB-4996-A05D-8CD6AB2DAA04}"/>
              </a:ext>
            </a:extLst>
          </p:cNvPr>
          <p:cNvSpPr/>
          <p:nvPr/>
        </p:nvSpPr>
        <p:spPr>
          <a:xfrm rot="17086082">
            <a:off x="5236666" y="47244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Freeform: Shape 18">
            <a:extLst>
              <a:ext uri="{FF2B5EF4-FFF2-40B4-BE49-F238E27FC236}">
                <a16:creationId xmlns:a16="http://schemas.microsoft.com/office/drawing/2014/main" id="{6CEAE087-16A8-4597-B2D2-B61BFA9D3A85}"/>
              </a:ext>
            </a:extLst>
          </p:cNvPr>
          <p:cNvSpPr/>
          <p:nvPr/>
        </p:nvSpPr>
        <p:spPr>
          <a:xfrm rot="17503495">
            <a:off x="4870140" y="4611237"/>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Connector 19">
            <a:extLst>
              <a:ext uri="{FF2B5EF4-FFF2-40B4-BE49-F238E27FC236}">
                <a16:creationId xmlns:a16="http://schemas.microsoft.com/office/drawing/2014/main" id="{3C9EA9A4-8881-496B-9F37-9A5AB00C3603}"/>
              </a:ext>
            </a:extLst>
          </p:cNvPr>
          <p:cNvCxnSpPr/>
          <p:nvPr/>
        </p:nvCxnSpPr>
        <p:spPr>
          <a:xfrm>
            <a:off x="4419600" y="4572000"/>
            <a:ext cx="4191000" cy="0"/>
          </a:xfrm>
          <a:prstGeom prst="line">
            <a:avLst/>
          </a:prstGeom>
          <a:ln>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93A8D74C-A4DF-4D5F-9DED-47B3FA0BC7B5}"/>
              </a:ext>
            </a:extLst>
          </p:cNvPr>
          <p:cNvSpPr txBox="1"/>
          <p:nvPr/>
        </p:nvSpPr>
        <p:spPr>
          <a:xfrm>
            <a:off x="2980234" y="3285149"/>
            <a:ext cx="1981200" cy="1200329"/>
          </a:xfrm>
          <a:prstGeom prst="rect">
            <a:avLst/>
          </a:prstGeom>
          <a:noFill/>
        </p:spPr>
        <p:txBody>
          <a:bodyPr wrap="square" rtlCol="0">
            <a:spAutoFit/>
          </a:bodyPr>
          <a:lstStyle/>
          <a:p>
            <a:r>
              <a:rPr lang="en-US" dirty="0">
                <a:solidFill>
                  <a:srgbClr val="33CC33"/>
                </a:solidFill>
              </a:rPr>
              <a:t>What lies "above ground": like the trunk, leaves, branches of a tree</a:t>
            </a:r>
          </a:p>
        </p:txBody>
      </p:sp>
      <p:sp>
        <p:nvSpPr>
          <p:cNvPr id="22" name="TextBox 21">
            <a:extLst>
              <a:ext uri="{FF2B5EF4-FFF2-40B4-BE49-F238E27FC236}">
                <a16:creationId xmlns:a16="http://schemas.microsoft.com/office/drawing/2014/main" id="{3FFF8332-F88B-4762-9102-86F8AAE4C78E}"/>
              </a:ext>
            </a:extLst>
          </p:cNvPr>
          <p:cNvSpPr txBox="1"/>
          <p:nvPr/>
        </p:nvSpPr>
        <p:spPr>
          <a:xfrm>
            <a:off x="3497280" y="5350240"/>
            <a:ext cx="1981200" cy="923330"/>
          </a:xfrm>
          <a:prstGeom prst="rect">
            <a:avLst/>
          </a:prstGeom>
          <a:noFill/>
        </p:spPr>
        <p:txBody>
          <a:bodyPr wrap="square" rtlCol="0">
            <a:spAutoFit/>
          </a:bodyPr>
          <a:lstStyle/>
          <a:p>
            <a:r>
              <a:rPr lang="en-US" dirty="0">
                <a:solidFill>
                  <a:schemeClr val="bg2">
                    <a:lumMod val="50000"/>
                  </a:schemeClr>
                </a:solidFill>
              </a:rPr>
              <a:t>What lies “under ground": the roots of a tree</a:t>
            </a:r>
          </a:p>
        </p:txBody>
      </p:sp>
    </p:spTree>
    <p:extLst>
      <p:ext uri="{BB962C8B-B14F-4D97-AF65-F5344CB8AC3E}">
        <p14:creationId xmlns:p14="http://schemas.microsoft.com/office/powerpoint/2010/main" val="22740154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516286-EEBA-4621-B0A8-A849F2FC755B}"/>
              </a:ext>
            </a:extLst>
          </p:cNvPr>
          <p:cNvSpPr>
            <a:spLocks noGrp="1"/>
          </p:cNvSpPr>
          <p:nvPr>
            <p:ph type="title"/>
          </p:nvPr>
        </p:nvSpPr>
        <p:spPr/>
        <p:txBody>
          <a:bodyPr/>
          <a:lstStyle/>
          <a:p>
            <a:r>
              <a:rPr lang="en-US" b="1" dirty="0"/>
              <a:t>Stage Setting: The "Difficult" Patient </a:t>
            </a:r>
          </a:p>
        </p:txBody>
      </p:sp>
    </p:spTree>
    <p:extLst>
      <p:ext uri="{BB962C8B-B14F-4D97-AF65-F5344CB8AC3E}">
        <p14:creationId xmlns:p14="http://schemas.microsoft.com/office/powerpoint/2010/main" val="301929911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Uncovering </a:t>
            </a:r>
            <a:br>
              <a:rPr lang="en-US" dirty="0">
                <a:solidFill>
                  <a:schemeClr val="tx2">
                    <a:lumMod val="90000"/>
                  </a:schemeClr>
                </a:solidFill>
                <a:effectLst/>
              </a:rPr>
            </a:br>
            <a:r>
              <a:rPr lang="en-US" dirty="0">
                <a:solidFill>
                  <a:schemeClr val="tx2">
                    <a:lumMod val="90000"/>
                  </a:schemeClr>
                </a:solidFill>
                <a:effectLst/>
              </a:rPr>
              <a:t>Interests</a:t>
            </a:r>
            <a:endParaRPr lang="en-US" dirty="0"/>
          </a:p>
        </p:txBody>
      </p:sp>
      <p:sp>
        <p:nvSpPr>
          <p:cNvPr id="3" name="Content Placeholder 2"/>
          <p:cNvSpPr>
            <a:spLocks noGrp="1"/>
          </p:cNvSpPr>
          <p:nvPr>
            <p:ph idx="1"/>
          </p:nvPr>
        </p:nvSpPr>
        <p:spPr>
          <a:xfrm>
            <a:off x="457200" y="2057400"/>
            <a:ext cx="8229600" cy="4343400"/>
          </a:xfrm>
        </p:spPr>
        <p:txBody>
          <a:bodyPr/>
          <a:lstStyle/>
          <a:p>
            <a:r>
              <a:rPr lang="en-US" sz="2800" dirty="0">
                <a:effectLst/>
              </a:rPr>
              <a:t>Mediators distinguish between: </a:t>
            </a:r>
          </a:p>
          <a:p>
            <a:pPr marL="457200" lvl="1" indent="0">
              <a:buNone/>
            </a:pPr>
            <a:endParaRPr lang="en-US" dirty="0">
              <a:effectLst/>
            </a:endParaRPr>
          </a:p>
          <a:p>
            <a:pPr marL="2406650" lvl="1" indent="-866775">
              <a:spcAft>
                <a:spcPts val="0"/>
              </a:spcAft>
              <a:buNone/>
            </a:pPr>
            <a:r>
              <a:rPr lang="en-US" sz="3200" b="1" dirty="0">
                <a:solidFill>
                  <a:srgbClr val="33CC33"/>
                </a:solidFill>
                <a:effectLst>
                  <a:outerShdw blurRad="38100" dist="38100" dir="2700000" algn="tl">
                    <a:srgbClr val="000000">
                      <a:alpha val="43137"/>
                    </a:srgbClr>
                  </a:outerShdw>
                </a:effectLst>
              </a:rPr>
              <a:t>POSITIONS</a:t>
            </a: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a:p>
            <a:pPr marL="2408237" lvl="1" indent="0">
              <a:lnSpc>
                <a:spcPct val="150000"/>
              </a:lnSpc>
              <a:spcAft>
                <a:spcPts val="1200"/>
              </a:spcAft>
              <a:buNone/>
            </a:pPr>
            <a:r>
              <a:rPr lang="en-US" sz="3200" b="1" dirty="0">
                <a:solidFill>
                  <a:srgbClr val="C5C5C5"/>
                </a:solidFill>
                <a:effectLst>
                  <a:outerShdw blurRad="38100" dist="38100" dir="2700000" algn="tl">
                    <a:srgbClr val="000000">
                      <a:alpha val="43137"/>
                    </a:srgbClr>
                  </a:outerShdw>
                </a:effectLst>
              </a:rPr>
              <a:t>INTERESTS</a:t>
            </a:r>
          </a:p>
        </p:txBody>
      </p:sp>
      <p:sp>
        <p:nvSpPr>
          <p:cNvPr id="4" name="Cloud 3">
            <a:extLst>
              <a:ext uri="{FF2B5EF4-FFF2-40B4-BE49-F238E27FC236}">
                <a16:creationId xmlns:a16="http://schemas.microsoft.com/office/drawing/2014/main" id="{06D3AA3A-C6DE-47F9-A404-6BB41C9BCF39}"/>
              </a:ext>
            </a:extLst>
          </p:cNvPr>
          <p:cNvSpPr/>
          <p:nvPr/>
        </p:nvSpPr>
        <p:spPr>
          <a:xfrm rot="390175">
            <a:off x="5602323" y="1842229"/>
            <a:ext cx="1900724" cy="1483145"/>
          </a:xfrm>
          <a:prstGeom prst="cloud">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mc:AlternateContent xmlns:mc="http://schemas.openxmlformats.org/markup-compatibility/2006" xmlns:p14="http://schemas.microsoft.com/office/powerpoint/2010/main">
        <mc:Choice Requires="p14">
          <p:contentPart p14:bwMode="auto" r:id="rId3">
            <p14:nvContentPartPr>
              <p14:cNvPr id="5" name="Ink 4">
                <a:extLst>
                  <a:ext uri="{FF2B5EF4-FFF2-40B4-BE49-F238E27FC236}">
                    <a16:creationId xmlns:a16="http://schemas.microsoft.com/office/drawing/2014/main" id="{1936930B-9D2D-4DEF-B1FD-4B7C06AD587E}"/>
                  </a:ext>
                </a:extLst>
              </p14:cNvPr>
              <p14:cNvContentPartPr/>
              <p14:nvPr/>
            </p14:nvContentPartPr>
            <p14:xfrm>
              <a:off x="6990075" y="2620144"/>
              <a:ext cx="109800" cy="151560"/>
            </p14:xfrm>
          </p:contentPart>
        </mc:Choice>
        <mc:Fallback xmlns="">
          <p:pic>
            <p:nvPicPr>
              <p:cNvPr id="5" name="Ink 4">
                <a:extLst>
                  <a:ext uri="{FF2B5EF4-FFF2-40B4-BE49-F238E27FC236}">
                    <a16:creationId xmlns:a16="http://schemas.microsoft.com/office/drawing/2014/main" id="{1936930B-9D2D-4DEF-B1FD-4B7C06AD587E}"/>
                  </a:ext>
                </a:extLst>
              </p:cNvPr>
              <p:cNvPicPr/>
              <p:nvPr/>
            </p:nvPicPr>
            <p:blipFill>
              <a:blip r:embed="rId4"/>
              <a:stretch>
                <a:fillRect/>
              </a:stretch>
            </p:blipFill>
            <p:spPr>
              <a:xfrm>
                <a:off x="6981075" y="2611144"/>
                <a:ext cx="127440" cy="169200"/>
              </a:xfrm>
              <a:prstGeom prst="rect">
                <a:avLst/>
              </a:prstGeom>
            </p:spPr>
          </p:pic>
        </mc:Fallback>
      </mc:AlternateContent>
      <mc:AlternateContent xmlns:mc="http://schemas.openxmlformats.org/markup-compatibility/2006" xmlns:p14="http://schemas.microsoft.com/office/powerpoint/2010/main">
        <mc:Choice Requires="p14">
          <p:contentPart p14:bwMode="auto" r:id="rId5">
            <p14:nvContentPartPr>
              <p14:cNvPr id="6" name="Ink 5">
                <a:extLst>
                  <a:ext uri="{FF2B5EF4-FFF2-40B4-BE49-F238E27FC236}">
                    <a16:creationId xmlns:a16="http://schemas.microsoft.com/office/drawing/2014/main" id="{7A310F11-CAF1-4054-92C3-4C38A779F2B3}"/>
                  </a:ext>
                </a:extLst>
              </p14:cNvPr>
              <p14:cNvContentPartPr/>
              <p14:nvPr/>
            </p14:nvContentPartPr>
            <p14:xfrm>
              <a:off x="6654915" y="2671984"/>
              <a:ext cx="614520" cy="514440"/>
            </p14:xfrm>
          </p:contentPart>
        </mc:Choice>
        <mc:Fallback xmlns="">
          <p:pic>
            <p:nvPicPr>
              <p:cNvPr id="6" name="Ink 5">
                <a:extLst>
                  <a:ext uri="{FF2B5EF4-FFF2-40B4-BE49-F238E27FC236}">
                    <a16:creationId xmlns:a16="http://schemas.microsoft.com/office/drawing/2014/main" id="{7A310F11-CAF1-4054-92C3-4C38A779F2B3}"/>
                  </a:ext>
                </a:extLst>
              </p:cNvPr>
              <p:cNvPicPr/>
              <p:nvPr/>
            </p:nvPicPr>
            <p:blipFill>
              <a:blip r:embed="rId6"/>
              <a:stretch>
                <a:fillRect/>
              </a:stretch>
            </p:blipFill>
            <p:spPr>
              <a:xfrm>
                <a:off x="6645915" y="2662984"/>
                <a:ext cx="632160" cy="532080"/>
              </a:xfrm>
              <a:prstGeom prst="rect">
                <a:avLst/>
              </a:prstGeom>
            </p:spPr>
          </p:pic>
        </mc:Fallback>
      </mc:AlternateContent>
      <mc:AlternateContent xmlns:mc="http://schemas.openxmlformats.org/markup-compatibility/2006" xmlns:p14="http://schemas.microsoft.com/office/powerpoint/2010/main">
        <mc:Choice Requires="p14">
          <p:contentPart p14:bwMode="auto" r:id="rId7">
            <p14:nvContentPartPr>
              <p14:cNvPr id="7" name="Ink 6">
                <a:extLst>
                  <a:ext uri="{FF2B5EF4-FFF2-40B4-BE49-F238E27FC236}">
                    <a16:creationId xmlns:a16="http://schemas.microsoft.com/office/drawing/2014/main" id="{186A7C5C-2668-4B0E-924F-889C27F9A091}"/>
                  </a:ext>
                </a:extLst>
              </p14:cNvPr>
              <p14:cNvContentPartPr/>
              <p14:nvPr/>
            </p14:nvContentPartPr>
            <p14:xfrm>
              <a:off x="5470875" y="1758304"/>
              <a:ext cx="2513160" cy="1712160"/>
            </p14:xfrm>
          </p:contentPart>
        </mc:Choice>
        <mc:Fallback xmlns="">
          <p:pic>
            <p:nvPicPr>
              <p:cNvPr id="7" name="Ink 6">
                <a:extLst>
                  <a:ext uri="{FF2B5EF4-FFF2-40B4-BE49-F238E27FC236}">
                    <a16:creationId xmlns:a16="http://schemas.microsoft.com/office/drawing/2014/main" id="{186A7C5C-2668-4B0E-924F-889C27F9A091}"/>
                  </a:ext>
                </a:extLst>
              </p:cNvPr>
              <p:cNvPicPr/>
              <p:nvPr/>
            </p:nvPicPr>
            <p:blipFill>
              <a:blip r:embed="rId8"/>
              <a:stretch>
                <a:fillRect/>
              </a:stretch>
            </p:blipFill>
            <p:spPr>
              <a:xfrm>
                <a:off x="5407875" y="1695304"/>
                <a:ext cx="2638800" cy="1837800"/>
              </a:xfrm>
              <a:prstGeom prst="rect">
                <a:avLst/>
              </a:prstGeom>
            </p:spPr>
          </p:pic>
        </mc:Fallback>
      </mc:AlternateContent>
      <p:sp>
        <p:nvSpPr>
          <p:cNvPr id="8" name="Rectangle: Rounded Corners 7">
            <a:extLst>
              <a:ext uri="{FF2B5EF4-FFF2-40B4-BE49-F238E27FC236}">
                <a16:creationId xmlns:a16="http://schemas.microsoft.com/office/drawing/2014/main" id="{DD67AC07-58F5-489A-A35B-1D9157165C94}"/>
              </a:ext>
            </a:extLst>
          </p:cNvPr>
          <p:cNvSpPr/>
          <p:nvPr/>
        </p:nvSpPr>
        <p:spPr>
          <a:xfrm>
            <a:off x="6489757" y="3352800"/>
            <a:ext cx="330315" cy="1177736"/>
          </a:xfrm>
          <a:prstGeom prst="roundRect">
            <a:avLst/>
          </a:prstGeom>
          <a:solidFill>
            <a:srgbClr val="9966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reeform: Shape 11">
            <a:extLst>
              <a:ext uri="{FF2B5EF4-FFF2-40B4-BE49-F238E27FC236}">
                <a16:creationId xmlns:a16="http://schemas.microsoft.com/office/drawing/2014/main" id="{14B9E463-BBB3-4A6E-A00B-C32BAFB414E2}"/>
              </a:ext>
            </a:extLst>
          </p:cNvPr>
          <p:cNvSpPr/>
          <p:nvPr/>
        </p:nvSpPr>
        <p:spPr>
          <a:xfrm>
            <a:off x="6800370" y="45720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Freeform: Shape 12">
            <a:extLst>
              <a:ext uri="{FF2B5EF4-FFF2-40B4-BE49-F238E27FC236}">
                <a16:creationId xmlns:a16="http://schemas.microsoft.com/office/drawing/2014/main" id="{BBFF0C4A-E839-4469-B2C9-2ADEC12E01B5}"/>
              </a:ext>
            </a:extLst>
          </p:cNvPr>
          <p:cNvSpPr/>
          <p:nvPr/>
        </p:nvSpPr>
        <p:spPr>
          <a:xfrm rot="15377824">
            <a:off x="5624291" y="5019923"/>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Freeform: Shape 15">
            <a:extLst>
              <a:ext uri="{FF2B5EF4-FFF2-40B4-BE49-F238E27FC236}">
                <a16:creationId xmlns:a16="http://schemas.microsoft.com/office/drawing/2014/main" id="{6DEC42A5-DB2D-4F3C-87C8-5050D684DB68}"/>
              </a:ext>
            </a:extLst>
          </p:cNvPr>
          <p:cNvSpPr/>
          <p:nvPr/>
        </p:nvSpPr>
        <p:spPr>
          <a:xfrm rot="941520">
            <a:off x="6507095" y="4787321"/>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reeform: Shape 16">
            <a:extLst>
              <a:ext uri="{FF2B5EF4-FFF2-40B4-BE49-F238E27FC236}">
                <a16:creationId xmlns:a16="http://schemas.microsoft.com/office/drawing/2014/main" id="{B751F970-0410-4E65-A78A-C76EAA8E8BF9}"/>
              </a:ext>
            </a:extLst>
          </p:cNvPr>
          <p:cNvSpPr/>
          <p:nvPr/>
        </p:nvSpPr>
        <p:spPr>
          <a:xfrm rot="1963374">
            <a:off x="6286283" y="4998862"/>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9854A418-22FB-4996-A05D-8CD6AB2DAA04}"/>
              </a:ext>
            </a:extLst>
          </p:cNvPr>
          <p:cNvSpPr/>
          <p:nvPr/>
        </p:nvSpPr>
        <p:spPr>
          <a:xfrm rot="17086082">
            <a:off x="5236666" y="47244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Freeform: Shape 18">
            <a:extLst>
              <a:ext uri="{FF2B5EF4-FFF2-40B4-BE49-F238E27FC236}">
                <a16:creationId xmlns:a16="http://schemas.microsoft.com/office/drawing/2014/main" id="{6CEAE087-16A8-4597-B2D2-B61BFA9D3A85}"/>
              </a:ext>
            </a:extLst>
          </p:cNvPr>
          <p:cNvSpPr/>
          <p:nvPr/>
        </p:nvSpPr>
        <p:spPr>
          <a:xfrm rot="17503495">
            <a:off x="4870140" y="4611237"/>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Connector 19">
            <a:extLst>
              <a:ext uri="{FF2B5EF4-FFF2-40B4-BE49-F238E27FC236}">
                <a16:creationId xmlns:a16="http://schemas.microsoft.com/office/drawing/2014/main" id="{3C9EA9A4-8881-496B-9F37-9A5AB00C3603}"/>
              </a:ext>
            </a:extLst>
          </p:cNvPr>
          <p:cNvCxnSpPr/>
          <p:nvPr/>
        </p:nvCxnSpPr>
        <p:spPr>
          <a:xfrm>
            <a:off x="4419600" y="4572000"/>
            <a:ext cx="4191000" cy="0"/>
          </a:xfrm>
          <a:prstGeom prst="line">
            <a:avLst/>
          </a:prstGeom>
          <a:ln>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93A8D74C-A4DF-4D5F-9DED-47B3FA0BC7B5}"/>
              </a:ext>
            </a:extLst>
          </p:cNvPr>
          <p:cNvSpPr txBox="1"/>
          <p:nvPr/>
        </p:nvSpPr>
        <p:spPr>
          <a:xfrm>
            <a:off x="2325712" y="3264508"/>
            <a:ext cx="1981200" cy="1200329"/>
          </a:xfrm>
          <a:prstGeom prst="rect">
            <a:avLst/>
          </a:prstGeom>
          <a:noFill/>
        </p:spPr>
        <p:txBody>
          <a:bodyPr wrap="square" rtlCol="0">
            <a:spAutoFit/>
          </a:bodyPr>
          <a:lstStyle/>
          <a:p>
            <a:r>
              <a:rPr lang="en-US" sz="1800" b="1" dirty="0">
                <a:solidFill>
                  <a:srgbClr val="33CC33"/>
                </a:solidFill>
              </a:rPr>
              <a:t>Stated claims, stance</a:t>
            </a:r>
          </a:p>
          <a:p>
            <a:r>
              <a:rPr lang="en-US" sz="1800" b="1" dirty="0">
                <a:solidFill>
                  <a:srgbClr val="33CC33"/>
                </a:solidFill>
              </a:rPr>
              <a:t>one is taking on an issue or situation</a:t>
            </a:r>
          </a:p>
        </p:txBody>
      </p:sp>
      <p:sp>
        <p:nvSpPr>
          <p:cNvPr id="23" name="TextBox 22">
            <a:extLst>
              <a:ext uri="{FF2B5EF4-FFF2-40B4-BE49-F238E27FC236}">
                <a16:creationId xmlns:a16="http://schemas.microsoft.com/office/drawing/2014/main" id="{48579398-DF2D-402F-80A5-CE271604945C}"/>
              </a:ext>
            </a:extLst>
          </p:cNvPr>
          <p:cNvSpPr txBox="1"/>
          <p:nvPr/>
        </p:nvSpPr>
        <p:spPr>
          <a:xfrm>
            <a:off x="1123950" y="5460670"/>
            <a:ext cx="7391400" cy="1200329"/>
          </a:xfrm>
          <a:prstGeom prst="rect">
            <a:avLst/>
          </a:prstGeom>
          <a:noFill/>
        </p:spPr>
        <p:txBody>
          <a:bodyPr wrap="square" rtlCol="0">
            <a:spAutoFit/>
          </a:bodyPr>
          <a:lstStyle/>
          <a:p>
            <a:r>
              <a:rPr lang="en-US" sz="2000" b="1" dirty="0">
                <a:solidFill>
                  <a:srgbClr val="C0C0C0"/>
                </a:solidFill>
              </a:rPr>
              <a:t>Normative Content: underlying motivations, needs, concerns, values, “skin in the game,” what’s at stake</a:t>
            </a:r>
            <a:endParaRPr lang="en-US" b="1" dirty="0">
              <a:solidFill>
                <a:srgbClr val="C0C0C0"/>
              </a:solidFill>
            </a:endParaRPr>
          </a:p>
          <a:p>
            <a:endParaRPr lang="en-US" dirty="0"/>
          </a:p>
        </p:txBody>
      </p:sp>
    </p:spTree>
    <p:extLst>
      <p:ext uri="{BB962C8B-B14F-4D97-AF65-F5344CB8AC3E}">
        <p14:creationId xmlns:p14="http://schemas.microsoft.com/office/powerpoint/2010/main" val="21604614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Uncovering </a:t>
            </a:r>
            <a:br>
              <a:rPr lang="en-US" dirty="0">
                <a:solidFill>
                  <a:schemeClr val="tx2">
                    <a:lumMod val="90000"/>
                  </a:schemeClr>
                </a:solidFill>
                <a:effectLst/>
              </a:rPr>
            </a:br>
            <a:r>
              <a:rPr lang="en-US" dirty="0">
                <a:solidFill>
                  <a:schemeClr val="tx2">
                    <a:lumMod val="90000"/>
                  </a:schemeClr>
                </a:solidFill>
                <a:effectLst/>
              </a:rPr>
              <a:t>Interests</a:t>
            </a:r>
            <a:endParaRPr lang="en-US" dirty="0"/>
          </a:p>
        </p:txBody>
      </p:sp>
      <p:sp>
        <p:nvSpPr>
          <p:cNvPr id="3" name="Content Placeholder 2"/>
          <p:cNvSpPr>
            <a:spLocks noGrp="1"/>
          </p:cNvSpPr>
          <p:nvPr>
            <p:ph idx="1"/>
          </p:nvPr>
        </p:nvSpPr>
        <p:spPr>
          <a:xfrm>
            <a:off x="457200" y="2057400"/>
            <a:ext cx="8229600" cy="4343400"/>
          </a:xfrm>
        </p:spPr>
        <p:txBody>
          <a:bodyPr/>
          <a:lstStyle/>
          <a:p>
            <a:r>
              <a:rPr lang="en-US" sz="2800" dirty="0">
                <a:effectLst/>
              </a:rPr>
              <a:t>Mediators distinguish between: </a:t>
            </a:r>
          </a:p>
          <a:p>
            <a:pPr marL="457200" lvl="1" indent="0">
              <a:buNone/>
            </a:pPr>
            <a:endParaRPr lang="en-US" dirty="0">
              <a:effectLst/>
            </a:endParaRPr>
          </a:p>
          <a:p>
            <a:pPr marL="2406650" lvl="1" indent="-866775">
              <a:spcAft>
                <a:spcPts val="0"/>
              </a:spcAft>
              <a:buNone/>
            </a:pPr>
            <a:r>
              <a:rPr lang="en-US" sz="3200" b="1" dirty="0">
                <a:solidFill>
                  <a:srgbClr val="33CC33"/>
                </a:solidFill>
                <a:effectLst>
                  <a:outerShdw blurRad="38100" dist="38100" dir="2700000" algn="tl">
                    <a:srgbClr val="000000">
                      <a:alpha val="43137"/>
                    </a:srgbClr>
                  </a:outerShdw>
                </a:effectLst>
              </a:rPr>
              <a:t>POSITIONS</a:t>
            </a: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a:p>
            <a:pPr marL="2408237" lvl="1" indent="0">
              <a:lnSpc>
                <a:spcPct val="150000"/>
              </a:lnSpc>
              <a:spcAft>
                <a:spcPts val="1200"/>
              </a:spcAft>
              <a:buNone/>
            </a:pPr>
            <a:r>
              <a:rPr lang="en-US" sz="3200" b="1" dirty="0">
                <a:solidFill>
                  <a:srgbClr val="C5C5C5"/>
                </a:solidFill>
                <a:effectLst>
                  <a:outerShdw blurRad="38100" dist="38100" dir="2700000" algn="tl">
                    <a:srgbClr val="000000">
                      <a:alpha val="43137"/>
                    </a:srgbClr>
                  </a:outerShdw>
                </a:effectLst>
              </a:rPr>
              <a:t>INTERESTS</a:t>
            </a:r>
          </a:p>
        </p:txBody>
      </p:sp>
      <p:sp>
        <p:nvSpPr>
          <p:cNvPr id="4" name="Cloud 3">
            <a:extLst>
              <a:ext uri="{FF2B5EF4-FFF2-40B4-BE49-F238E27FC236}">
                <a16:creationId xmlns:a16="http://schemas.microsoft.com/office/drawing/2014/main" id="{06D3AA3A-C6DE-47F9-A404-6BB41C9BCF39}"/>
              </a:ext>
            </a:extLst>
          </p:cNvPr>
          <p:cNvSpPr/>
          <p:nvPr/>
        </p:nvSpPr>
        <p:spPr>
          <a:xfrm rot="390175">
            <a:off x="5602323" y="1842229"/>
            <a:ext cx="1900724" cy="1483145"/>
          </a:xfrm>
          <a:prstGeom prst="cloud">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mc:AlternateContent xmlns:mc="http://schemas.openxmlformats.org/markup-compatibility/2006" xmlns:p14="http://schemas.microsoft.com/office/powerpoint/2010/main">
        <mc:Choice Requires="p14">
          <p:contentPart p14:bwMode="auto" r:id="rId3">
            <p14:nvContentPartPr>
              <p14:cNvPr id="5" name="Ink 4">
                <a:extLst>
                  <a:ext uri="{FF2B5EF4-FFF2-40B4-BE49-F238E27FC236}">
                    <a16:creationId xmlns:a16="http://schemas.microsoft.com/office/drawing/2014/main" id="{1936930B-9D2D-4DEF-B1FD-4B7C06AD587E}"/>
                  </a:ext>
                </a:extLst>
              </p14:cNvPr>
              <p14:cNvContentPartPr/>
              <p14:nvPr/>
            </p14:nvContentPartPr>
            <p14:xfrm>
              <a:off x="6990075" y="2620144"/>
              <a:ext cx="109800" cy="151560"/>
            </p14:xfrm>
          </p:contentPart>
        </mc:Choice>
        <mc:Fallback xmlns="">
          <p:pic>
            <p:nvPicPr>
              <p:cNvPr id="5" name="Ink 4">
                <a:extLst>
                  <a:ext uri="{FF2B5EF4-FFF2-40B4-BE49-F238E27FC236}">
                    <a16:creationId xmlns:a16="http://schemas.microsoft.com/office/drawing/2014/main" id="{1936930B-9D2D-4DEF-B1FD-4B7C06AD587E}"/>
                  </a:ext>
                </a:extLst>
              </p:cNvPr>
              <p:cNvPicPr/>
              <p:nvPr/>
            </p:nvPicPr>
            <p:blipFill>
              <a:blip r:embed="rId4"/>
              <a:stretch>
                <a:fillRect/>
              </a:stretch>
            </p:blipFill>
            <p:spPr>
              <a:xfrm>
                <a:off x="6981075" y="2611144"/>
                <a:ext cx="127440" cy="169200"/>
              </a:xfrm>
              <a:prstGeom prst="rect">
                <a:avLst/>
              </a:prstGeom>
            </p:spPr>
          </p:pic>
        </mc:Fallback>
      </mc:AlternateContent>
      <mc:AlternateContent xmlns:mc="http://schemas.openxmlformats.org/markup-compatibility/2006" xmlns:p14="http://schemas.microsoft.com/office/powerpoint/2010/main">
        <mc:Choice Requires="p14">
          <p:contentPart p14:bwMode="auto" r:id="rId5">
            <p14:nvContentPartPr>
              <p14:cNvPr id="6" name="Ink 5">
                <a:extLst>
                  <a:ext uri="{FF2B5EF4-FFF2-40B4-BE49-F238E27FC236}">
                    <a16:creationId xmlns:a16="http://schemas.microsoft.com/office/drawing/2014/main" id="{7A310F11-CAF1-4054-92C3-4C38A779F2B3}"/>
                  </a:ext>
                </a:extLst>
              </p14:cNvPr>
              <p14:cNvContentPartPr/>
              <p14:nvPr/>
            </p14:nvContentPartPr>
            <p14:xfrm>
              <a:off x="6654915" y="2671984"/>
              <a:ext cx="614520" cy="514440"/>
            </p14:xfrm>
          </p:contentPart>
        </mc:Choice>
        <mc:Fallback xmlns="">
          <p:pic>
            <p:nvPicPr>
              <p:cNvPr id="6" name="Ink 5">
                <a:extLst>
                  <a:ext uri="{FF2B5EF4-FFF2-40B4-BE49-F238E27FC236}">
                    <a16:creationId xmlns:a16="http://schemas.microsoft.com/office/drawing/2014/main" id="{7A310F11-CAF1-4054-92C3-4C38A779F2B3}"/>
                  </a:ext>
                </a:extLst>
              </p:cNvPr>
              <p:cNvPicPr/>
              <p:nvPr/>
            </p:nvPicPr>
            <p:blipFill>
              <a:blip r:embed="rId6"/>
              <a:stretch>
                <a:fillRect/>
              </a:stretch>
            </p:blipFill>
            <p:spPr>
              <a:xfrm>
                <a:off x="6645915" y="2662984"/>
                <a:ext cx="632160" cy="532080"/>
              </a:xfrm>
              <a:prstGeom prst="rect">
                <a:avLst/>
              </a:prstGeom>
            </p:spPr>
          </p:pic>
        </mc:Fallback>
      </mc:AlternateContent>
      <mc:AlternateContent xmlns:mc="http://schemas.openxmlformats.org/markup-compatibility/2006" xmlns:p14="http://schemas.microsoft.com/office/powerpoint/2010/main">
        <mc:Choice Requires="p14">
          <p:contentPart p14:bwMode="auto" r:id="rId7">
            <p14:nvContentPartPr>
              <p14:cNvPr id="7" name="Ink 6">
                <a:extLst>
                  <a:ext uri="{FF2B5EF4-FFF2-40B4-BE49-F238E27FC236}">
                    <a16:creationId xmlns:a16="http://schemas.microsoft.com/office/drawing/2014/main" id="{186A7C5C-2668-4B0E-924F-889C27F9A091}"/>
                  </a:ext>
                </a:extLst>
              </p14:cNvPr>
              <p14:cNvContentPartPr/>
              <p14:nvPr/>
            </p14:nvContentPartPr>
            <p14:xfrm>
              <a:off x="5470875" y="1758304"/>
              <a:ext cx="2513160" cy="1712160"/>
            </p14:xfrm>
          </p:contentPart>
        </mc:Choice>
        <mc:Fallback xmlns="">
          <p:pic>
            <p:nvPicPr>
              <p:cNvPr id="7" name="Ink 6">
                <a:extLst>
                  <a:ext uri="{FF2B5EF4-FFF2-40B4-BE49-F238E27FC236}">
                    <a16:creationId xmlns:a16="http://schemas.microsoft.com/office/drawing/2014/main" id="{186A7C5C-2668-4B0E-924F-889C27F9A091}"/>
                  </a:ext>
                </a:extLst>
              </p:cNvPr>
              <p:cNvPicPr/>
              <p:nvPr/>
            </p:nvPicPr>
            <p:blipFill>
              <a:blip r:embed="rId8"/>
              <a:stretch>
                <a:fillRect/>
              </a:stretch>
            </p:blipFill>
            <p:spPr>
              <a:xfrm>
                <a:off x="5407875" y="1695304"/>
                <a:ext cx="2638800" cy="1837800"/>
              </a:xfrm>
              <a:prstGeom prst="rect">
                <a:avLst/>
              </a:prstGeom>
            </p:spPr>
          </p:pic>
        </mc:Fallback>
      </mc:AlternateContent>
      <p:sp>
        <p:nvSpPr>
          <p:cNvPr id="8" name="Rectangle: Rounded Corners 7">
            <a:extLst>
              <a:ext uri="{FF2B5EF4-FFF2-40B4-BE49-F238E27FC236}">
                <a16:creationId xmlns:a16="http://schemas.microsoft.com/office/drawing/2014/main" id="{DD67AC07-58F5-489A-A35B-1D9157165C94}"/>
              </a:ext>
            </a:extLst>
          </p:cNvPr>
          <p:cNvSpPr/>
          <p:nvPr/>
        </p:nvSpPr>
        <p:spPr>
          <a:xfrm>
            <a:off x="6489757" y="3352800"/>
            <a:ext cx="330315" cy="1177736"/>
          </a:xfrm>
          <a:prstGeom prst="roundRect">
            <a:avLst/>
          </a:prstGeom>
          <a:solidFill>
            <a:srgbClr val="9966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reeform: Shape 11">
            <a:extLst>
              <a:ext uri="{FF2B5EF4-FFF2-40B4-BE49-F238E27FC236}">
                <a16:creationId xmlns:a16="http://schemas.microsoft.com/office/drawing/2014/main" id="{14B9E463-BBB3-4A6E-A00B-C32BAFB414E2}"/>
              </a:ext>
            </a:extLst>
          </p:cNvPr>
          <p:cNvSpPr/>
          <p:nvPr/>
        </p:nvSpPr>
        <p:spPr>
          <a:xfrm>
            <a:off x="6800370" y="45720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Freeform: Shape 12">
            <a:extLst>
              <a:ext uri="{FF2B5EF4-FFF2-40B4-BE49-F238E27FC236}">
                <a16:creationId xmlns:a16="http://schemas.microsoft.com/office/drawing/2014/main" id="{BBFF0C4A-E839-4469-B2C9-2ADEC12E01B5}"/>
              </a:ext>
            </a:extLst>
          </p:cNvPr>
          <p:cNvSpPr/>
          <p:nvPr/>
        </p:nvSpPr>
        <p:spPr>
          <a:xfrm rot="15377824">
            <a:off x="5624291" y="5019923"/>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Freeform: Shape 15">
            <a:extLst>
              <a:ext uri="{FF2B5EF4-FFF2-40B4-BE49-F238E27FC236}">
                <a16:creationId xmlns:a16="http://schemas.microsoft.com/office/drawing/2014/main" id="{6DEC42A5-DB2D-4F3C-87C8-5050D684DB68}"/>
              </a:ext>
            </a:extLst>
          </p:cNvPr>
          <p:cNvSpPr/>
          <p:nvPr/>
        </p:nvSpPr>
        <p:spPr>
          <a:xfrm rot="941520">
            <a:off x="6507095" y="4787321"/>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reeform: Shape 16">
            <a:extLst>
              <a:ext uri="{FF2B5EF4-FFF2-40B4-BE49-F238E27FC236}">
                <a16:creationId xmlns:a16="http://schemas.microsoft.com/office/drawing/2014/main" id="{B751F970-0410-4E65-A78A-C76EAA8E8BF9}"/>
              </a:ext>
            </a:extLst>
          </p:cNvPr>
          <p:cNvSpPr/>
          <p:nvPr/>
        </p:nvSpPr>
        <p:spPr>
          <a:xfrm rot="1963374">
            <a:off x="6286283" y="4998862"/>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9854A418-22FB-4996-A05D-8CD6AB2DAA04}"/>
              </a:ext>
            </a:extLst>
          </p:cNvPr>
          <p:cNvSpPr/>
          <p:nvPr/>
        </p:nvSpPr>
        <p:spPr>
          <a:xfrm rot="17086082">
            <a:off x="5236666" y="47244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Freeform: Shape 18">
            <a:extLst>
              <a:ext uri="{FF2B5EF4-FFF2-40B4-BE49-F238E27FC236}">
                <a16:creationId xmlns:a16="http://schemas.microsoft.com/office/drawing/2014/main" id="{6CEAE087-16A8-4597-B2D2-B61BFA9D3A85}"/>
              </a:ext>
            </a:extLst>
          </p:cNvPr>
          <p:cNvSpPr/>
          <p:nvPr/>
        </p:nvSpPr>
        <p:spPr>
          <a:xfrm rot="17503495">
            <a:off x="4870140" y="4611237"/>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Connector 19">
            <a:extLst>
              <a:ext uri="{FF2B5EF4-FFF2-40B4-BE49-F238E27FC236}">
                <a16:creationId xmlns:a16="http://schemas.microsoft.com/office/drawing/2014/main" id="{3C9EA9A4-8881-496B-9F37-9A5AB00C3603}"/>
              </a:ext>
            </a:extLst>
          </p:cNvPr>
          <p:cNvCxnSpPr/>
          <p:nvPr/>
        </p:nvCxnSpPr>
        <p:spPr>
          <a:xfrm>
            <a:off x="4419600" y="4572000"/>
            <a:ext cx="4191000" cy="0"/>
          </a:xfrm>
          <a:prstGeom prst="line">
            <a:avLst/>
          </a:prstGeom>
          <a:ln>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BAA614E5-5012-4D3A-B8FA-A549FB8AC147}"/>
              </a:ext>
            </a:extLst>
          </p:cNvPr>
          <p:cNvSpPr txBox="1"/>
          <p:nvPr/>
        </p:nvSpPr>
        <p:spPr>
          <a:xfrm>
            <a:off x="1264658" y="3236552"/>
            <a:ext cx="3810000" cy="1323439"/>
          </a:xfrm>
          <a:prstGeom prst="rect">
            <a:avLst/>
          </a:prstGeom>
          <a:noFill/>
        </p:spPr>
        <p:txBody>
          <a:bodyPr wrap="square" rtlCol="0">
            <a:spAutoFit/>
          </a:bodyPr>
          <a:lstStyle/>
          <a:p>
            <a:pPr marL="117475" indent="-117475">
              <a:buFont typeface="Arial" panose="020B0604020202020204" pitchFamily="34" charset="0"/>
              <a:buChar char="•"/>
            </a:pPr>
            <a:r>
              <a:rPr lang="en-US" sz="1600" b="1" dirty="0">
                <a:solidFill>
                  <a:srgbClr val="33CC33"/>
                </a:solidFill>
              </a:rPr>
              <a:t>Are often diametrically opposed in a values conflict</a:t>
            </a:r>
          </a:p>
          <a:p>
            <a:pPr marL="117475" indent="-117475">
              <a:buFont typeface="Arial" panose="020B0604020202020204" pitchFamily="34" charset="0"/>
              <a:buChar char="•"/>
            </a:pPr>
            <a:r>
              <a:rPr lang="en-US" sz="1600" b="1" dirty="0">
                <a:solidFill>
                  <a:srgbClr val="33CC33"/>
                </a:solidFill>
              </a:rPr>
              <a:t>Rarely allow compromise</a:t>
            </a:r>
          </a:p>
          <a:p>
            <a:pPr marL="117475" indent="-117475">
              <a:buFont typeface="Arial" panose="020B0604020202020204" pitchFamily="34" charset="0"/>
              <a:buChar char="•"/>
            </a:pPr>
            <a:r>
              <a:rPr lang="en-US" sz="1600" b="1" dirty="0">
                <a:solidFill>
                  <a:srgbClr val="33CC33"/>
                </a:solidFill>
              </a:rPr>
              <a:t>But can be anchored by many different Interests</a:t>
            </a:r>
          </a:p>
        </p:txBody>
      </p:sp>
      <p:sp>
        <p:nvSpPr>
          <p:cNvPr id="24" name="TextBox 23">
            <a:extLst>
              <a:ext uri="{FF2B5EF4-FFF2-40B4-BE49-F238E27FC236}">
                <a16:creationId xmlns:a16="http://schemas.microsoft.com/office/drawing/2014/main" id="{65070A19-0308-4955-A1E2-EA930F0DDB5F}"/>
              </a:ext>
            </a:extLst>
          </p:cNvPr>
          <p:cNvSpPr txBox="1"/>
          <p:nvPr/>
        </p:nvSpPr>
        <p:spPr>
          <a:xfrm>
            <a:off x="1264658" y="5356964"/>
            <a:ext cx="6934200" cy="830997"/>
          </a:xfrm>
          <a:prstGeom prst="rect">
            <a:avLst/>
          </a:prstGeom>
          <a:noFill/>
        </p:spPr>
        <p:txBody>
          <a:bodyPr wrap="square" rtlCol="0">
            <a:spAutoFit/>
          </a:bodyPr>
          <a:lstStyle/>
          <a:p>
            <a:pPr marL="117475" indent="-117475">
              <a:buFont typeface="Arial" panose="020B0604020202020204" pitchFamily="34" charset="0"/>
              <a:buChar char="•"/>
            </a:pPr>
            <a:r>
              <a:rPr lang="en-US" sz="1600" b="1" dirty="0">
                <a:solidFill>
                  <a:srgbClr val="C0C0C0"/>
                </a:solidFill>
              </a:rPr>
              <a:t>Are “human,” not “partisan”</a:t>
            </a:r>
          </a:p>
          <a:p>
            <a:pPr marL="117475" indent="-117475">
              <a:buFont typeface="Arial" panose="020B0604020202020204" pitchFamily="34" charset="0"/>
              <a:buChar char="•"/>
            </a:pPr>
            <a:r>
              <a:rPr lang="en-US" sz="1600" b="1" dirty="0">
                <a:solidFill>
                  <a:srgbClr val="C0C0C0"/>
                </a:solidFill>
              </a:rPr>
              <a:t>Can be overlapping, even if Positions aren’t</a:t>
            </a:r>
          </a:p>
          <a:p>
            <a:pPr marL="117475" indent="-117475">
              <a:buFont typeface="Arial" panose="020B0604020202020204" pitchFamily="34" charset="0"/>
              <a:buChar char="•"/>
            </a:pPr>
            <a:r>
              <a:rPr lang="en-US" sz="1600" b="1" dirty="0">
                <a:solidFill>
                  <a:srgbClr val="C0C0C0"/>
                </a:solidFill>
              </a:rPr>
              <a:t>Can be game-changing (re: perceptions, possibilities )</a:t>
            </a:r>
          </a:p>
        </p:txBody>
      </p:sp>
    </p:spTree>
    <p:extLst>
      <p:ext uri="{BB962C8B-B14F-4D97-AF65-F5344CB8AC3E}">
        <p14:creationId xmlns:p14="http://schemas.microsoft.com/office/powerpoint/2010/main" val="114160413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Uncovering </a:t>
            </a:r>
            <a:br>
              <a:rPr lang="en-US" dirty="0">
                <a:solidFill>
                  <a:schemeClr val="tx2">
                    <a:lumMod val="90000"/>
                  </a:schemeClr>
                </a:solidFill>
                <a:effectLst/>
              </a:rPr>
            </a:br>
            <a:r>
              <a:rPr lang="en-US" dirty="0">
                <a:solidFill>
                  <a:schemeClr val="tx2">
                    <a:lumMod val="90000"/>
                  </a:schemeClr>
                </a:solidFill>
                <a:effectLst/>
              </a:rPr>
              <a:t>Interests</a:t>
            </a:r>
            <a:endParaRPr lang="en-US" dirty="0"/>
          </a:p>
        </p:txBody>
      </p:sp>
      <p:sp>
        <p:nvSpPr>
          <p:cNvPr id="3" name="Content Placeholder 2"/>
          <p:cNvSpPr>
            <a:spLocks noGrp="1"/>
          </p:cNvSpPr>
          <p:nvPr>
            <p:ph idx="1"/>
          </p:nvPr>
        </p:nvSpPr>
        <p:spPr>
          <a:xfrm>
            <a:off x="457200" y="2057400"/>
            <a:ext cx="8229600" cy="4343400"/>
          </a:xfrm>
        </p:spPr>
        <p:txBody>
          <a:bodyPr/>
          <a:lstStyle/>
          <a:p>
            <a:r>
              <a:rPr lang="en-US" dirty="0">
                <a:effectLst/>
              </a:rPr>
              <a:t>Fisher &amp; </a:t>
            </a:r>
            <a:r>
              <a:rPr lang="en-US" dirty="0" err="1">
                <a:effectLst/>
              </a:rPr>
              <a:t>Ury</a:t>
            </a:r>
            <a:r>
              <a:rPr lang="en-US" dirty="0">
                <a:effectLst/>
              </a:rPr>
              <a:t>, </a:t>
            </a:r>
            <a:r>
              <a:rPr lang="en-US" i="1" dirty="0">
                <a:effectLst/>
              </a:rPr>
              <a:t>Getting to Yes</a:t>
            </a:r>
            <a:r>
              <a:rPr lang="en-US" dirty="0">
                <a:effectLst/>
              </a:rPr>
              <a:t>:</a:t>
            </a:r>
          </a:p>
          <a:p>
            <a:pPr marL="0" indent="0">
              <a:buNone/>
            </a:pPr>
            <a:r>
              <a:rPr lang="en-US" sz="2800" dirty="0">
                <a:effectLst/>
              </a:rPr>
              <a:t> </a:t>
            </a:r>
          </a:p>
          <a:p>
            <a:pPr marL="457200" lvl="1" indent="0">
              <a:buNone/>
            </a:pPr>
            <a:endParaRPr lang="en-US" dirty="0">
              <a:effectLst/>
            </a:endParaRP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p:txBody>
      </p:sp>
      <p:sp>
        <p:nvSpPr>
          <p:cNvPr id="4" name="Cloud 3">
            <a:extLst>
              <a:ext uri="{FF2B5EF4-FFF2-40B4-BE49-F238E27FC236}">
                <a16:creationId xmlns:a16="http://schemas.microsoft.com/office/drawing/2014/main" id="{06D3AA3A-C6DE-47F9-A404-6BB41C9BCF39}"/>
              </a:ext>
            </a:extLst>
          </p:cNvPr>
          <p:cNvSpPr/>
          <p:nvPr/>
        </p:nvSpPr>
        <p:spPr>
          <a:xfrm rot="390175">
            <a:off x="5602323" y="1842229"/>
            <a:ext cx="1900724" cy="1483145"/>
          </a:xfrm>
          <a:prstGeom prst="cloud">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mc:AlternateContent xmlns:mc="http://schemas.openxmlformats.org/markup-compatibility/2006" xmlns:p14="http://schemas.microsoft.com/office/powerpoint/2010/main">
        <mc:Choice Requires="p14">
          <p:contentPart p14:bwMode="auto" r:id="rId3">
            <p14:nvContentPartPr>
              <p14:cNvPr id="5" name="Ink 4">
                <a:extLst>
                  <a:ext uri="{FF2B5EF4-FFF2-40B4-BE49-F238E27FC236}">
                    <a16:creationId xmlns:a16="http://schemas.microsoft.com/office/drawing/2014/main" id="{1936930B-9D2D-4DEF-B1FD-4B7C06AD587E}"/>
                  </a:ext>
                </a:extLst>
              </p14:cNvPr>
              <p14:cNvContentPartPr/>
              <p14:nvPr/>
            </p14:nvContentPartPr>
            <p14:xfrm>
              <a:off x="6990075" y="2620144"/>
              <a:ext cx="109800" cy="151560"/>
            </p14:xfrm>
          </p:contentPart>
        </mc:Choice>
        <mc:Fallback xmlns="">
          <p:pic>
            <p:nvPicPr>
              <p:cNvPr id="5" name="Ink 4">
                <a:extLst>
                  <a:ext uri="{FF2B5EF4-FFF2-40B4-BE49-F238E27FC236}">
                    <a16:creationId xmlns:a16="http://schemas.microsoft.com/office/drawing/2014/main" id="{1936930B-9D2D-4DEF-B1FD-4B7C06AD587E}"/>
                  </a:ext>
                </a:extLst>
              </p:cNvPr>
              <p:cNvPicPr/>
              <p:nvPr/>
            </p:nvPicPr>
            <p:blipFill>
              <a:blip r:embed="rId4"/>
              <a:stretch>
                <a:fillRect/>
              </a:stretch>
            </p:blipFill>
            <p:spPr>
              <a:xfrm>
                <a:off x="6981075" y="2611144"/>
                <a:ext cx="127440" cy="169200"/>
              </a:xfrm>
              <a:prstGeom prst="rect">
                <a:avLst/>
              </a:prstGeom>
            </p:spPr>
          </p:pic>
        </mc:Fallback>
      </mc:AlternateContent>
      <mc:AlternateContent xmlns:mc="http://schemas.openxmlformats.org/markup-compatibility/2006" xmlns:p14="http://schemas.microsoft.com/office/powerpoint/2010/main">
        <mc:Choice Requires="p14">
          <p:contentPart p14:bwMode="auto" r:id="rId5">
            <p14:nvContentPartPr>
              <p14:cNvPr id="6" name="Ink 5">
                <a:extLst>
                  <a:ext uri="{FF2B5EF4-FFF2-40B4-BE49-F238E27FC236}">
                    <a16:creationId xmlns:a16="http://schemas.microsoft.com/office/drawing/2014/main" id="{7A310F11-CAF1-4054-92C3-4C38A779F2B3}"/>
                  </a:ext>
                </a:extLst>
              </p14:cNvPr>
              <p14:cNvContentPartPr/>
              <p14:nvPr/>
            </p14:nvContentPartPr>
            <p14:xfrm>
              <a:off x="6654915" y="2671984"/>
              <a:ext cx="614520" cy="514440"/>
            </p14:xfrm>
          </p:contentPart>
        </mc:Choice>
        <mc:Fallback xmlns="">
          <p:pic>
            <p:nvPicPr>
              <p:cNvPr id="6" name="Ink 5">
                <a:extLst>
                  <a:ext uri="{FF2B5EF4-FFF2-40B4-BE49-F238E27FC236}">
                    <a16:creationId xmlns:a16="http://schemas.microsoft.com/office/drawing/2014/main" id="{7A310F11-CAF1-4054-92C3-4C38A779F2B3}"/>
                  </a:ext>
                </a:extLst>
              </p:cNvPr>
              <p:cNvPicPr/>
              <p:nvPr/>
            </p:nvPicPr>
            <p:blipFill>
              <a:blip r:embed="rId6"/>
              <a:stretch>
                <a:fillRect/>
              </a:stretch>
            </p:blipFill>
            <p:spPr>
              <a:xfrm>
                <a:off x="6645915" y="2662984"/>
                <a:ext cx="632160" cy="532080"/>
              </a:xfrm>
              <a:prstGeom prst="rect">
                <a:avLst/>
              </a:prstGeom>
            </p:spPr>
          </p:pic>
        </mc:Fallback>
      </mc:AlternateContent>
      <mc:AlternateContent xmlns:mc="http://schemas.openxmlformats.org/markup-compatibility/2006" xmlns:p14="http://schemas.microsoft.com/office/powerpoint/2010/main">
        <mc:Choice Requires="p14">
          <p:contentPart p14:bwMode="auto" r:id="rId7">
            <p14:nvContentPartPr>
              <p14:cNvPr id="7" name="Ink 6">
                <a:extLst>
                  <a:ext uri="{FF2B5EF4-FFF2-40B4-BE49-F238E27FC236}">
                    <a16:creationId xmlns:a16="http://schemas.microsoft.com/office/drawing/2014/main" id="{186A7C5C-2668-4B0E-924F-889C27F9A091}"/>
                  </a:ext>
                </a:extLst>
              </p14:cNvPr>
              <p14:cNvContentPartPr/>
              <p14:nvPr/>
            </p14:nvContentPartPr>
            <p14:xfrm>
              <a:off x="5470875" y="1758304"/>
              <a:ext cx="2513160" cy="1712160"/>
            </p14:xfrm>
          </p:contentPart>
        </mc:Choice>
        <mc:Fallback xmlns="">
          <p:pic>
            <p:nvPicPr>
              <p:cNvPr id="7" name="Ink 6">
                <a:extLst>
                  <a:ext uri="{FF2B5EF4-FFF2-40B4-BE49-F238E27FC236}">
                    <a16:creationId xmlns:a16="http://schemas.microsoft.com/office/drawing/2014/main" id="{186A7C5C-2668-4B0E-924F-889C27F9A091}"/>
                  </a:ext>
                </a:extLst>
              </p:cNvPr>
              <p:cNvPicPr/>
              <p:nvPr/>
            </p:nvPicPr>
            <p:blipFill>
              <a:blip r:embed="rId8"/>
              <a:stretch>
                <a:fillRect/>
              </a:stretch>
            </p:blipFill>
            <p:spPr>
              <a:xfrm>
                <a:off x="5407875" y="1695304"/>
                <a:ext cx="2638800" cy="1837800"/>
              </a:xfrm>
              <a:prstGeom prst="rect">
                <a:avLst/>
              </a:prstGeom>
            </p:spPr>
          </p:pic>
        </mc:Fallback>
      </mc:AlternateContent>
      <p:sp>
        <p:nvSpPr>
          <p:cNvPr id="8" name="Rectangle: Rounded Corners 7">
            <a:extLst>
              <a:ext uri="{FF2B5EF4-FFF2-40B4-BE49-F238E27FC236}">
                <a16:creationId xmlns:a16="http://schemas.microsoft.com/office/drawing/2014/main" id="{DD67AC07-58F5-489A-A35B-1D9157165C94}"/>
              </a:ext>
            </a:extLst>
          </p:cNvPr>
          <p:cNvSpPr/>
          <p:nvPr/>
        </p:nvSpPr>
        <p:spPr>
          <a:xfrm>
            <a:off x="6489757" y="3352800"/>
            <a:ext cx="330315" cy="1177736"/>
          </a:xfrm>
          <a:prstGeom prst="roundRect">
            <a:avLst/>
          </a:prstGeom>
          <a:solidFill>
            <a:srgbClr val="9966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reeform: Shape 11">
            <a:extLst>
              <a:ext uri="{FF2B5EF4-FFF2-40B4-BE49-F238E27FC236}">
                <a16:creationId xmlns:a16="http://schemas.microsoft.com/office/drawing/2014/main" id="{14B9E463-BBB3-4A6E-A00B-C32BAFB414E2}"/>
              </a:ext>
            </a:extLst>
          </p:cNvPr>
          <p:cNvSpPr/>
          <p:nvPr/>
        </p:nvSpPr>
        <p:spPr>
          <a:xfrm>
            <a:off x="6800370" y="45720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Freeform: Shape 12">
            <a:extLst>
              <a:ext uri="{FF2B5EF4-FFF2-40B4-BE49-F238E27FC236}">
                <a16:creationId xmlns:a16="http://schemas.microsoft.com/office/drawing/2014/main" id="{BBFF0C4A-E839-4469-B2C9-2ADEC12E01B5}"/>
              </a:ext>
            </a:extLst>
          </p:cNvPr>
          <p:cNvSpPr/>
          <p:nvPr/>
        </p:nvSpPr>
        <p:spPr>
          <a:xfrm rot="15377824">
            <a:off x="5624291" y="5019923"/>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Freeform: Shape 15">
            <a:extLst>
              <a:ext uri="{FF2B5EF4-FFF2-40B4-BE49-F238E27FC236}">
                <a16:creationId xmlns:a16="http://schemas.microsoft.com/office/drawing/2014/main" id="{6DEC42A5-DB2D-4F3C-87C8-5050D684DB68}"/>
              </a:ext>
            </a:extLst>
          </p:cNvPr>
          <p:cNvSpPr/>
          <p:nvPr/>
        </p:nvSpPr>
        <p:spPr>
          <a:xfrm rot="941520">
            <a:off x="6507095" y="4787321"/>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reeform: Shape 16">
            <a:extLst>
              <a:ext uri="{FF2B5EF4-FFF2-40B4-BE49-F238E27FC236}">
                <a16:creationId xmlns:a16="http://schemas.microsoft.com/office/drawing/2014/main" id="{B751F970-0410-4E65-A78A-C76EAA8E8BF9}"/>
              </a:ext>
            </a:extLst>
          </p:cNvPr>
          <p:cNvSpPr/>
          <p:nvPr/>
        </p:nvSpPr>
        <p:spPr>
          <a:xfrm rot="1963374">
            <a:off x="6286283" y="4998862"/>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9854A418-22FB-4996-A05D-8CD6AB2DAA04}"/>
              </a:ext>
            </a:extLst>
          </p:cNvPr>
          <p:cNvSpPr/>
          <p:nvPr/>
        </p:nvSpPr>
        <p:spPr>
          <a:xfrm rot="17086082">
            <a:off x="5236666" y="47244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Freeform: Shape 18">
            <a:extLst>
              <a:ext uri="{FF2B5EF4-FFF2-40B4-BE49-F238E27FC236}">
                <a16:creationId xmlns:a16="http://schemas.microsoft.com/office/drawing/2014/main" id="{6CEAE087-16A8-4597-B2D2-B61BFA9D3A85}"/>
              </a:ext>
            </a:extLst>
          </p:cNvPr>
          <p:cNvSpPr/>
          <p:nvPr/>
        </p:nvSpPr>
        <p:spPr>
          <a:xfrm rot="17503495">
            <a:off x="4870140" y="4611237"/>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Connector 19">
            <a:extLst>
              <a:ext uri="{FF2B5EF4-FFF2-40B4-BE49-F238E27FC236}">
                <a16:creationId xmlns:a16="http://schemas.microsoft.com/office/drawing/2014/main" id="{3C9EA9A4-8881-496B-9F37-9A5AB00C3603}"/>
              </a:ext>
            </a:extLst>
          </p:cNvPr>
          <p:cNvCxnSpPr/>
          <p:nvPr/>
        </p:nvCxnSpPr>
        <p:spPr>
          <a:xfrm>
            <a:off x="4419600" y="4572000"/>
            <a:ext cx="4191000" cy="0"/>
          </a:xfrm>
          <a:prstGeom prst="line">
            <a:avLst/>
          </a:prstGeom>
          <a:ln>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FCC0132D-B769-4EF6-856D-AC80059D954B}"/>
              </a:ext>
            </a:extLst>
          </p:cNvPr>
          <p:cNvSpPr txBox="1"/>
          <p:nvPr/>
        </p:nvSpPr>
        <p:spPr>
          <a:xfrm>
            <a:off x="792468" y="2929204"/>
            <a:ext cx="3810000" cy="2862322"/>
          </a:xfrm>
          <a:prstGeom prst="rect">
            <a:avLst/>
          </a:prstGeom>
          <a:noFill/>
        </p:spPr>
        <p:txBody>
          <a:bodyPr wrap="square" rtlCol="0">
            <a:spAutoFit/>
          </a:bodyPr>
          <a:lstStyle/>
          <a:p>
            <a:pPr algn="ctr"/>
            <a:r>
              <a:rPr lang="en-US" sz="2000" b="1" dirty="0">
                <a:solidFill>
                  <a:srgbClr val="92D050"/>
                </a:solidFill>
              </a:rPr>
              <a:t>“Since the parties’  </a:t>
            </a:r>
          </a:p>
          <a:p>
            <a:pPr algn="ctr"/>
            <a:r>
              <a:rPr lang="en-US" sz="2000" b="1" dirty="0">
                <a:solidFill>
                  <a:srgbClr val="92D050"/>
                </a:solidFill>
              </a:rPr>
              <a:t> problem appears to be a conflict of positions, and since their goal is to agree on a position, they naturally tend to think and talk about positions – and in the process often reach     </a:t>
            </a:r>
          </a:p>
          <a:p>
            <a:pPr algn="ctr"/>
            <a:r>
              <a:rPr lang="en-US" sz="2000" b="1" dirty="0">
                <a:solidFill>
                  <a:srgbClr val="92D050"/>
                </a:solidFill>
              </a:rPr>
              <a:t>an impasse.” </a:t>
            </a:r>
          </a:p>
        </p:txBody>
      </p:sp>
    </p:spTree>
    <p:extLst>
      <p:ext uri="{BB962C8B-B14F-4D97-AF65-F5344CB8AC3E}">
        <p14:creationId xmlns:p14="http://schemas.microsoft.com/office/powerpoint/2010/main" val="413117872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Uncovering </a:t>
            </a:r>
            <a:br>
              <a:rPr lang="en-US" dirty="0">
                <a:solidFill>
                  <a:schemeClr val="tx2">
                    <a:lumMod val="90000"/>
                  </a:schemeClr>
                </a:solidFill>
                <a:effectLst/>
              </a:rPr>
            </a:br>
            <a:r>
              <a:rPr lang="en-US" dirty="0">
                <a:solidFill>
                  <a:schemeClr val="tx2">
                    <a:lumMod val="90000"/>
                  </a:schemeClr>
                </a:solidFill>
                <a:effectLst/>
              </a:rPr>
              <a:t>Interests</a:t>
            </a:r>
            <a:endParaRPr lang="en-US" dirty="0">
              <a:solidFill>
                <a:schemeClr val="tx2">
                  <a:lumMod val="90000"/>
                </a:schemeClr>
              </a:solidFill>
            </a:endParaRPr>
          </a:p>
        </p:txBody>
      </p:sp>
      <p:sp>
        <p:nvSpPr>
          <p:cNvPr id="3" name="Content Placeholder 2"/>
          <p:cNvSpPr>
            <a:spLocks noGrp="1"/>
          </p:cNvSpPr>
          <p:nvPr>
            <p:ph idx="1"/>
          </p:nvPr>
        </p:nvSpPr>
        <p:spPr>
          <a:xfrm>
            <a:off x="457200" y="2057400"/>
            <a:ext cx="8229600" cy="4343400"/>
          </a:xfrm>
        </p:spPr>
        <p:txBody>
          <a:bodyPr/>
          <a:lstStyle/>
          <a:p>
            <a:pPr>
              <a:buClr>
                <a:schemeClr val="tx1"/>
              </a:buClr>
            </a:pPr>
            <a:r>
              <a:rPr lang="en-US" sz="4000" dirty="0">
                <a:solidFill>
                  <a:schemeClr val="tx2">
                    <a:lumMod val="90000"/>
                  </a:schemeClr>
                </a:solidFill>
                <a:effectLst/>
              </a:rPr>
              <a:t> </a:t>
            </a:r>
            <a:r>
              <a:rPr lang="en-US" sz="4000" dirty="0">
                <a:effectLst/>
              </a:rPr>
              <a:t>Do not allow the conversation to fixate on the stakeholders’ </a:t>
            </a:r>
            <a:r>
              <a:rPr lang="en-US" sz="4000" dirty="0">
                <a:solidFill>
                  <a:srgbClr val="92D050"/>
                </a:solidFill>
                <a:effectLst/>
              </a:rPr>
              <a:t>positions</a:t>
            </a:r>
            <a:r>
              <a:rPr lang="en-US" sz="4000" dirty="0">
                <a:solidFill>
                  <a:schemeClr val="tx2">
                    <a:lumMod val="90000"/>
                  </a:schemeClr>
                </a:solidFill>
                <a:effectLst/>
              </a:rPr>
              <a:t> </a:t>
            </a:r>
            <a:r>
              <a:rPr lang="en-US" sz="4000" dirty="0">
                <a:effectLst/>
              </a:rPr>
              <a:t>instead of their </a:t>
            </a:r>
            <a:r>
              <a:rPr lang="en-US" sz="4000" dirty="0">
                <a:solidFill>
                  <a:schemeClr val="bg1">
                    <a:lumMod val="50000"/>
                  </a:schemeClr>
                </a:solidFill>
                <a:effectLst/>
              </a:rPr>
              <a:t>interests</a:t>
            </a:r>
          </a:p>
          <a:p>
            <a:pPr>
              <a:buClr>
                <a:schemeClr val="tx1"/>
              </a:buClr>
            </a:pPr>
            <a:r>
              <a:rPr lang="en-US" sz="4000" dirty="0">
                <a:solidFill>
                  <a:schemeClr val="tx2">
                    <a:lumMod val="90000"/>
                  </a:schemeClr>
                </a:solidFill>
                <a:effectLst/>
              </a:rPr>
              <a:t> </a:t>
            </a:r>
            <a:r>
              <a:rPr lang="en-US" sz="4000" dirty="0">
                <a:effectLst/>
              </a:rPr>
              <a:t>Dig for the underlying </a:t>
            </a:r>
            <a:r>
              <a:rPr lang="en-US" sz="4000" dirty="0">
                <a:solidFill>
                  <a:schemeClr val="accent4">
                    <a:lumMod val="75000"/>
                  </a:schemeClr>
                </a:solidFill>
                <a:effectLst/>
              </a:rPr>
              <a:t>concerns</a:t>
            </a:r>
            <a:r>
              <a:rPr lang="en-US" sz="4000" dirty="0">
                <a:solidFill>
                  <a:schemeClr val="tx2">
                    <a:lumMod val="90000"/>
                  </a:schemeClr>
                </a:solidFill>
                <a:effectLst/>
              </a:rPr>
              <a:t> </a:t>
            </a:r>
            <a:r>
              <a:rPr lang="en-US" sz="4000" dirty="0">
                <a:effectLst/>
              </a:rPr>
              <a:t>of the parties and focus the dialogue on those </a:t>
            </a:r>
            <a:r>
              <a:rPr lang="en-US" sz="4000" dirty="0">
                <a:solidFill>
                  <a:schemeClr val="accent4">
                    <a:lumMod val="75000"/>
                  </a:schemeClr>
                </a:solidFill>
                <a:effectLst/>
              </a:rPr>
              <a:t>concerns</a:t>
            </a:r>
          </a:p>
        </p:txBody>
      </p:sp>
    </p:spTree>
    <p:extLst>
      <p:ext uri="{BB962C8B-B14F-4D97-AF65-F5344CB8AC3E}">
        <p14:creationId xmlns:p14="http://schemas.microsoft.com/office/powerpoint/2010/main" val="6056916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1">
            <a:extLst>
              <a:ext uri="{FF2B5EF4-FFF2-40B4-BE49-F238E27FC236}">
                <a16:creationId xmlns:a16="http://schemas.microsoft.com/office/drawing/2014/main" id="{D3629273-400F-4936-BD29-FF83AF11D9F6}"/>
              </a:ext>
            </a:extLst>
          </p:cNvPr>
          <p:cNvSpPr txBox="1">
            <a:spLocks/>
          </p:cNvSpPr>
          <p:nvPr/>
        </p:nvSpPr>
        <p:spPr bwMode="auto">
          <a:xfrm>
            <a:off x="381000" y="2057400"/>
            <a:ext cx="3505200" cy="6556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mj-lt"/>
                <a:ea typeface="+mj-ea"/>
                <a:cs typeface="+mj-cs"/>
              </a:defRPr>
            </a:lvl1pPr>
            <a:lvl2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2pPr>
            <a:lvl3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3pPr>
            <a:lvl4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4pPr>
            <a:lvl5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5pPr>
            <a:lvl6pPr marL="4572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6pPr>
            <a:lvl7pPr marL="9144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7pPr>
            <a:lvl8pPr marL="13716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8pPr>
            <a:lvl9pPr marL="18288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9pPr>
          </a:lstStyle>
          <a:p>
            <a:pPr algn="r"/>
            <a:r>
              <a:rPr lang="en-US" sz="4000" kern="0" dirty="0">
                <a:solidFill>
                  <a:schemeClr val="tx1"/>
                </a:solidFill>
                <a:effectLst/>
              </a:rPr>
              <a:t>Group Exercise</a:t>
            </a:r>
            <a:endParaRPr lang="en-US" sz="4000" kern="0" dirty="0">
              <a:solidFill>
                <a:schemeClr val="tx1"/>
              </a:solidFill>
            </a:endParaRPr>
          </a:p>
        </p:txBody>
      </p:sp>
      <p:sp>
        <p:nvSpPr>
          <p:cNvPr id="6" name="Title 1">
            <a:extLst>
              <a:ext uri="{FF2B5EF4-FFF2-40B4-BE49-F238E27FC236}">
                <a16:creationId xmlns:a16="http://schemas.microsoft.com/office/drawing/2014/main" id="{739EE702-8BB0-4845-B368-8590A572D8D3}"/>
              </a:ext>
            </a:extLst>
          </p:cNvPr>
          <p:cNvSpPr>
            <a:spLocks noGrp="1"/>
          </p:cNvSpPr>
          <p:nvPr>
            <p:ph type="title"/>
          </p:nvPr>
        </p:nvSpPr>
        <p:spPr>
          <a:xfrm>
            <a:off x="628650" y="365126"/>
            <a:ext cx="7886700" cy="1325563"/>
          </a:xfrm>
        </p:spPr>
        <p:txBody>
          <a:bodyPr/>
          <a:lstStyle/>
          <a:p>
            <a:pPr algn="r"/>
            <a:r>
              <a:rPr lang="en-US" dirty="0">
                <a:solidFill>
                  <a:schemeClr val="tx2">
                    <a:lumMod val="90000"/>
                  </a:schemeClr>
                </a:solidFill>
                <a:effectLst/>
              </a:rPr>
              <a:t>Strategy for Uncovering </a:t>
            </a:r>
            <a:br>
              <a:rPr lang="en-US" dirty="0">
                <a:solidFill>
                  <a:schemeClr val="tx2">
                    <a:lumMod val="90000"/>
                  </a:schemeClr>
                </a:solidFill>
                <a:effectLst/>
              </a:rPr>
            </a:br>
            <a:r>
              <a:rPr lang="en-US" dirty="0">
                <a:solidFill>
                  <a:schemeClr val="tx2">
                    <a:lumMod val="90000"/>
                  </a:schemeClr>
                </a:solidFill>
                <a:effectLst/>
              </a:rPr>
              <a:t>Interests</a:t>
            </a:r>
            <a:endParaRPr lang="en-US" dirty="0">
              <a:solidFill>
                <a:schemeClr val="tx2">
                  <a:lumMod val="90000"/>
                </a:schemeClr>
              </a:solidFill>
            </a:endParaRPr>
          </a:p>
        </p:txBody>
      </p:sp>
    </p:spTree>
    <p:extLst>
      <p:ext uri="{BB962C8B-B14F-4D97-AF65-F5344CB8AC3E}">
        <p14:creationId xmlns:p14="http://schemas.microsoft.com/office/powerpoint/2010/main" val="3959459353"/>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Uncovering </a:t>
            </a:r>
            <a:br>
              <a:rPr lang="en-US" dirty="0">
                <a:solidFill>
                  <a:schemeClr val="tx2">
                    <a:lumMod val="90000"/>
                  </a:schemeClr>
                </a:solidFill>
                <a:effectLst/>
              </a:rPr>
            </a:br>
            <a:r>
              <a:rPr lang="en-US" dirty="0">
                <a:solidFill>
                  <a:schemeClr val="tx2">
                    <a:lumMod val="90000"/>
                  </a:schemeClr>
                </a:solidFill>
                <a:effectLst/>
              </a:rPr>
              <a:t>Interests</a:t>
            </a:r>
            <a:endParaRPr lang="en-US" dirty="0"/>
          </a:p>
        </p:txBody>
      </p:sp>
      <p:sp>
        <p:nvSpPr>
          <p:cNvPr id="3" name="Content Placeholder 2"/>
          <p:cNvSpPr>
            <a:spLocks noGrp="1"/>
          </p:cNvSpPr>
          <p:nvPr>
            <p:ph idx="1"/>
          </p:nvPr>
        </p:nvSpPr>
        <p:spPr>
          <a:xfrm>
            <a:off x="457200" y="2057400"/>
            <a:ext cx="8229600" cy="4343400"/>
          </a:xfrm>
        </p:spPr>
        <p:txBody>
          <a:bodyPr/>
          <a:lstStyle/>
          <a:p>
            <a:r>
              <a:rPr lang="en-US" sz="2800" dirty="0">
                <a:effectLst/>
              </a:rPr>
              <a:t>Mediators distinguish between: </a:t>
            </a:r>
          </a:p>
          <a:p>
            <a:pPr marL="457200" lvl="1" indent="0">
              <a:buNone/>
            </a:pPr>
            <a:endParaRPr lang="en-US" dirty="0">
              <a:effectLst/>
            </a:endParaRPr>
          </a:p>
          <a:p>
            <a:pPr marL="2406650" lvl="1" indent="-866775">
              <a:spcAft>
                <a:spcPts val="0"/>
              </a:spcAft>
              <a:buNone/>
            </a:pPr>
            <a:r>
              <a:rPr lang="en-US" sz="3200" b="1" dirty="0">
                <a:solidFill>
                  <a:srgbClr val="33CC33"/>
                </a:solidFill>
                <a:effectLst>
                  <a:outerShdw blurRad="38100" dist="38100" dir="2700000" algn="tl">
                    <a:srgbClr val="000000">
                      <a:alpha val="43137"/>
                    </a:srgbClr>
                  </a:outerShdw>
                </a:effectLst>
              </a:rPr>
              <a:t>POSITIONS</a:t>
            </a: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a:p>
            <a:pPr marL="2408237" lvl="1" indent="0">
              <a:lnSpc>
                <a:spcPct val="150000"/>
              </a:lnSpc>
              <a:spcAft>
                <a:spcPts val="1200"/>
              </a:spcAft>
              <a:buNone/>
            </a:pPr>
            <a:r>
              <a:rPr lang="en-US" sz="3200" b="1" dirty="0">
                <a:solidFill>
                  <a:srgbClr val="C5C5C5"/>
                </a:solidFill>
                <a:effectLst>
                  <a:outerShdw blurRad="38100" dist="38100" dir="2700000" algn="tl">
                    <a:srgbClr val="000000">
                      <a:alpha val="43137"/>
                    </a:srgbClr>
                  </a:outerShdw>
                </a:effectLst>
              </a:rPr>
              <a:t>INTERESTS</a:t>
            </a:r>
          </a:p>
        </p:txBody>
      </p:sp>
      <p:sp>
        <p:nvSpPr>
          <p:cNvPr id="4" name="Cloud 3">
            <a:extLst>
              <a:ext uri="{FF2B5EF4-FFF2-40B4-BE49-F238E27FC236}">
                <a16:creationId xmlns:a16="http://schemas.microsoft.com/office/drawing/2014/main" id="{06D3AA3A-C6DE-47F9-A404-6BB41C9BCF39}"/>
              </a:ext>
            </a:extLst>
          </p:cNvPr>
          <p:cNvSpPr/>
          <p:nvPr/>
        </p:nvSpPr>
        <p:spPr>
          <a:xfrm rot="390175">
            <a:off x="5602323" y="1842229"/>
            <a:ext cx="1900724" cy="1483145"/>
          </a:xfrm>
          <a:prstGeom prst="cloud">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mc:AlternateContent xmlns:mc="http://schemas.openxmlformats.org/markup-compatibility/2006" xmlns:p14="http://schemas.microsoft.com/office/powerpoint/2010/main">
        <mc:Choice Requires="p14">
          <p:contentPart p14:bwMode="auto" r:id="rId3">
            <p14:nvContentPartPr>
              <p14:cNvPr id="5" name="Ink 4">
                <a:extLst>
                  <a:ext uri="{FF2B5EF4-FFF2-40B4-BE49-F238E27FC236}">
                    <a16:creationId xmlns:a16="http://schemas.microsoft.com/office/drawing/2014/main" id="{1936930B-9D2D-4DEF-B1FD-4B7C06AD587E}"/>
                  </a:ext>
                </a:extLst>
              </p14:cNvPr>
              <p14:cNvContentPartPr/>
              <p14:nvPr/>
            </p14:nvContentPartPr>
            <p14:xfrm>
              <a:off x="6990075" y="2620144"/>
              <a:ext cx="109800" cy="151560"/>
            </p14:xfrm>
          </p:contentPart>
        </mc:Choice>
        <mc:Fallback xmlns="">
          <p:pic>
            <p:nvPicPr>
              <p:cNvPr id="5" name="Ink 4">
                <a:extLst>
                  <a:ext uri="{FF2B5EF4-FFF2-40B4-BE49-F238E27FC236}">
                    <a16:creationId xmlns:a16="http://schemas.microsoft.com/office/drawing/2014/main" id="{1936930B-9D2D-4DEF-B1FD-4B7C06AD587E}"/>
                  </a:ext>
                </a:extLst>
              </p:cNvPr>
              <p:cNvPicPr/>
              <p:nvPr/>
            </p:nvPicPr>
            <p:blipFill>
              <a:blip r:embed="rId4"/>
              <a:stretch>
                <a:fillRect/>
              </a:stretch>
            </p:blipFill>
            <p:spPr>
              <a:xfrm>
                <a:off x="6981075" y="2611144"/>
                <a:ext cx="127440" cy="169200"/>
              </a:xfrm>
              <a:prstGeom prst="rect">
                <a:avLst/>
              </a:prstGeom>
            </p:spPr>
          </p:pic>
        </mc:Fallback>
      </mc:AlternateContent>
      <mc:AlternateContent xmlns:mc="http://schemas.openxmlformats.org/markup-compatibility/2006" xmlns:p14="http://schemas.microsoft.com/office/powerpoint/2010/main">
        <mc:Choice Requires="p14">
          <p:contentPart p14:bwMode="auto" r:id="rId5">
            <p14:nvContentPartPr>
              <p14:cNvPr id="6" name="Ink 5">
                <a:extLst>
                  <a:ext uri="{FF2B5EF4-FFF2-40B4-BE49-F238E27FC236}">
                    <a16:creationId xmlns:a16="http://schemas.microsoft.com/office/drawing/2014/main" id="{7A310F11-CAF1-4054-92C3-4C38A779F2B3}"/>
                  </a:ext>
                </a:extLst>
              </p14:cNvPr>
              <p14:cNvContentPartPr/>
              <p14:nvPr/>
            </p14:nvContentPartPr>
            <p14:xfrm>
              <a:off x="6654915" y="2671984"/>
              <a:ext cx="614520" cy="514440"/>
            </p14:xfrm>
          </p:contentPart>
        </mc:Choice>
        <mc:Fallback xmlns="">
          <p:pic>
            <p:nvPicPr>
              <p:cNvPr id="6" name="Ink 5">
                <a:extLst>
                  <a:ext uri="{FF2B5EF4-FFF2-40B4-BE49-F238E27FC236}">
                    <a16:creationId xmlns:a16="http://schemas.microsoft.com/office/drawing/2014/main" id="{7A310F11-CAF1-4054-92C3-4C38A779F2B3}"/>
                  </a:ext>
                </a:extLst>
              </p:cNvPr>
              <p:cNvPicPr/>
              <p:nvPr/>
            </p:nvPicPr>
            <p:blipFill>
              <a:blip r:embed="rId6"/>
              <a:stretch>
                <a:fillRect/>
              </a:stretch>
            </p:blipFill>
            <p:spPr>
              <a:xfrm>
                <a:off x="6645915" y="2662984"/>
                <a:ext cx="632160" cy="532080"/>
              </a:xfrm>
              <a:prstGeom prst="rect">
                <a:avLst/>
              </a:prstGeom>
            </p:spPr>
          </p:pic>
        </mc:Fallback>
      </mc:AlternateContent>
      <mc:AlternateContent xmlns:mc="http://schemas.openxmlformats.org/markup-compatibility/2006" xmlns:p14="http://schemas.microsoft.com/office/powerpoint/2010/main">
        <mc:Choice Requires="p14">
          <p:contentPart p14:bwMode="auto" r:id="rId7">
            <p14:nvContentPartPr>
              <p14:cNvPr id="7" name="Ink 6">
                <a:extLst>
                  <a:ext uri="{FF2B5EF4-FFF2-40B4-BE49-F238E27FC236}">
                    <a16:creationId xmlns:a16="http://schemas.microsoft.com/office/drawing/2014/main" id="{186A7C5C-2668-4B0E-924F-889C27F9A091}"/>
                  </a:ext>
                </a:extLst>
              </p14:cNvPr>
              <p14:cNvContentPartPr/>
              <p14:nvPr/>
            </p14:nvContentPartPr>
            <p14:xfrm>
              <a:off x="5470875" y="1758304"/>
              <a:ext cx="2513160" cy="1712160"/>
            </p14:xfrm>
          </p:contentPart>
        </mc:Choice>
        <mc:Fallback xmlns="">
          <p:pic>
            <p:nvPicPr>
              <p:cNvPr id="7" name="Ink 6">
                <a:extLst>
                  <a:ext uri="{FF2B5EF4-FFF2-40B4-BE49-F238E27FC236}">
                    <a16:creationId xmlns:a16="http://schemas.microsoft.com/office/drawing/2014/main" id="{186A7C5C-2668-4B0E-924F-889C27F9A091}"/>
                  </a:ext>
                </a:extLst>
              </p:cNvPr>
              <p:cNvPicPr/>
              <p:nvPr/>
            </p:nvPicPr>
            <p:blipFill>
              <a:blip r:embed="rId8"/>
              <a:stretch>
                <a:fillRect/>
              </a:stretch>
            </p:blipFill>
            <p:spPr>
              <a:xfrm>
                <a:off x="5407875" y="1695304"/>
                <a:ext cx="2638800" cy="1837800"/>
              </a:xfrm>
              <a:prstGeom prst="rect">
                <a:avLst/>
              </a:prstGeom>
            </p:spPr>
          </p:pic>
        </mc:Fallback>
      </mc:AlternateContent>
      <p:sp>
        <p:nvSpPr>
          <p:cNvPr id="8" name="Rectangle: Rounded Corners 7">
            <a:extLst>
              <a:ext uri="{FF2B5EF4-FFF2-40B4-BE49-F238E27FC236}">
                <a16:creationId xmlns:a16="http://schemas.microsoft.com/office/drawing/2014/main" id="{DD67AC07-58F5-489A-A35B-1D9157165C94}"/>
              </a:ext>
            </a:extLst>
          </p:cNvPr>
          <p:cNvSpPr/>
          <p:nvPr/>
        </p:nvSpPr>
        <p:spPr>
          <a:xfrm>
            <a:off x="6489757" y="3352800"/>
            <a:ext cx="330315" cy="1177736"/>
          </a:xfrm>
          <a:prstGeom prst="roundRect">
            <a:avLst/>
          </a:prstGeom>
          <a:solidFill>
            <a:srgbClr val="9966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reeform: Shape 11">
            <a:extLst>
              <a:ext uri="{FF2B5EF4-FFF2-40B4-BE49-F238E27FC236}">
                <a16:creationId xmlns:a16="http://schemas.microsoft.com/office/drawing/2014/main" id="{14B9E463-BBB3-4A6E-A00B-C32BAFB414E2}"/>
              </a:ext>
            </a:extLst>
          </p:cNvPr>
          <p:cNvSpPr/>
          <p:nvPr/>
        </p:nvSpPr>
        <p:spPr>
          <a:xfrm>
            <a:off x="6800370" y="45720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Freeform: Shape 12">
            <a:extLst>
              <a:ext uri="{FF2B5EF4-FFF2-40B4-BE49-F238E27FC236}">
                <a16:creationId xmlns:a16="http://schemas.microsoft.com/office/drawing/2014/main" id="{BBFF0C4A-E839-4469-B2C9-2ADEC12E01B5}"/>
              </a:ext>
            </a:extLst>
          </p:cNvPr>
          <p:cNvSpPr/>
          <p:nvPr/>
        </p:nvSpPr>
        <p:spPr>
          <a:xfrm rot="15377824">
            <a:off x="5624291" y="5019923"/>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Freeform: Shape 15">
            <a:extLst>
              <a:ext uri="{FF2B5EF4-FFF2-40B4-BE49-F238E27FC236}">
                <a16:creationId xmlns:a16="http://schemas.microsoft.com/office/drawing/2014/main" id="{6DEC42A5-DB2D-4F3C-87C8-5050D684DB68}"/>
              </a:ext>
            </a:extLst>
          </p:cNvPr>
          <p:cNvSpPr/>
          <p:nvPr/>
        </p:nvSpPr>
        <p:spPr>
          <a:xfrm rot="941520">
            <a:off x="6507095" y="4787321"/>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reeform: Shape 16">
            <a:extLst>
              <a:ext uri="{FF2B5EF4-FFF2-40B4-BE49-F238E27FC236}">
                <a16:creationId xmlns:a16="http://schemas.microsoft.com/office/drawing/2014/main" id="{B751F970-0410-4E65-A78A-C76EAA8E8BF9}"/>
              </a:ext>
            </a:extLst>
          </p:cNvPr>
          <p:cNvSpPr/>
          <p:nvPr/>
        </p:nvSpPr>
        <p:spPr>
          <a:xfrm rot="1963374">
            <a:off x="6286283" y="4998862"/>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9854A418-22FB-4996-A05D-8CD6AB2DAA04}"/>
              </a:ext>
            </a:extLst>
          </p:cNvPr>
          <p:cNvSpPr/>
          <p:nvPr/>
        </p:nvSpPr>
        <p:spPr>
          <a:xfrm rot="17086082">
            <a:off x="5236666" y="47244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Freeform: Shape 18">
            <a:extLst>
              <a:ext uri="{FF2B5EF4-FFF2-40B4-BE49-F238E27FC236}">
                <a16:creationId xmlns:a16="http://schemas.microsoft.com/office/drawing/2014/main" id="{6CEAE087-16A8-4597-B2D2-B61BFA9D3A85}"/>
              </a:ext>
            </a:extLst>
          </p:cNvPr>
          <p:cNvSpPr/>
          <p:nvPr/>
        </p:nvSpPr>
        <p:spPr>
          <a:xfrm rot="17503495">
            <a:off x="4870140" y="4611237"/>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Connector 19">
            <a:extLst>
              <a:ext uri="{FF2B5EF4-FFF2-40B4-BE49-F238E27FC236}">
                <a16:creationId xmlns:a16="http://schemas.microsoft.com/office/drawing/2014/main" id="{3C9EA9A4-8881-496B-9F37-9A5AB00C3603}"/>
              </a:ext>
            </a:extLst>
          </p:cNvPr>
          <p:cNvCxnSpPr/>
          <p:nvPr/>
        </p:nvCxnSpPr>
        <p:spPr>
          <a:xfrm>
            <a:off x="4419600" y="4572000"/>
            <a:ext cx="4191000" cy="0"/>
          </a:xfrm>
          <a:prstGeom prst="line">
            <a:avLst/>
          </a:prstGeom>
          <a:ln>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93A8D74C-A4DF-4D5F-9DED-47B3FA0BC7B5}"/>
              </a:ext>
            </a:extLst>
          </p:cNvPr>
          <p:cNvSpPr txBox="1"/>
          <p:nvPr/>
        </p:nvSpPr>
        <p:spPr>
          <a:xfrm>
            <a:off x="2362911" y="3285149"/>
            <a:ext cx="1981200" cy="923330"/>
          </a:xfrm>
          <a:prstGeom prst="rect">
            <a:avLst/>
          </a:prstGeom>
          <a:noFill/>
        </p:spPr>
        <p:txBody>
          <a:bodyPr wrap="square" rtlCol="0">
            <a:spAutoFit/>
          </a:bodyPr>
          <a:lstStyle/>
          <a:p>
            <a:r>
              <a:rPr lang="en-US" sz="1800" b="1" dirty="0">
                <a:solidFill>
                  <a:srgbClr val="92D050"/>
                </a:solidFill>
              </a:rPr>
              <a:t>The staff are refusing to work with Fred</a:t>
            </a:r>
          </a:p>
        </p:txBody>
      </p:sp>
      <p:sp>
        <p:nvSpPr>
          <p:cNvPr id="22" name="TextBox 21">
            <a:extLst>
              <a:ext uri="{FF2B5EF4-FFF2-40B4-BE49-F238E27FC236}">
                <a16:creationId xmlns:a16="http://schemas.microsoft.com/office/drawing/2014/main" id="{3FFF8332-F88B-4762-9102-86F8AAE4C78E}"/>
              </a:ext>
            </a:extLst>
          </p:cNvPr>
          <p:cNvSpPr txBox="1"/>
          <p:nvPr/>
        </p:nvSpPr>
        <p:spPr>
          <a:xfrm>
            <a:off x="2832284" y="5332947"/>
            <a:ext cx="1981200" cy="1200329"/>
          </a:xfrm>
          <a:prstGeom prst="rect">
            <a:avLst/>
          </a:prstGeom>
          <a:noFill/>
        </p:spPr>
        <p:txBody>
          <a:bodyPr wrap="square" rtlCol="0">
            <a:spAutoFit/>
          </a:bodyPr>
          <a:lstStyle/>
          <a:p>
            <a:pPr algn="ctr"/>
            <a:r>
              <a:rPr lang="en-US" sz="2400" b="1" i="1" dirty="0">
                <a:solidFill>
                  <a:schemeClr val="bg2">
                    <a:lumMod val="50000"/>
                  </a:schemeClr>
                </a:solidFill>
              </a:rPr>
              <a:t>What are the staff’s interests?</a:t>
            </a:r>
          </a:p>
        </p:txBody>
      </p:sp>
      <p:sp>
        <p:nvSpPr>
          <p:cNvPr id="10" name="Arrow: Right 9">
            <a:extLst>
              <a:ext uri="{FF2B5EF4-FFF2-40B4-BE49-F238E27FC236}">
                <a16:creationId xmlns:a16="http://schemas.microsoft.com/office/drawing/2014/main" id="{40D071C3-C51D-435B-8158-6923DC99A638}"/>
              </a:ext>
            </a:extLst>
          </p:cNvPr>
          <p:cNvSpPr/>
          <p:nvPr/>
        </p:nvSpPr>
        <p:spPr>
          <a:xfrm rot="1013072">
            <a:off x="1066800" y="5041543"/>
            <a:ext cx="1311450" cy="444857"/>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7592865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t>Searching for the staff’s </a:t>
            </a:r>
            <a:r>
              <a:rPr lang="en-US" b="1" u="sng" dirty="0">
                <a:solidFill>
                  <a:schemeClr val="bg1">
                    <a:lumMod val="50000"/>
                  </a:schemeClr>
                </a:solidFill>
              </a:rPr>
              <a:t>interests</a:t>
            </a:r>
            <a:r>
              <a:rPr lang="en-US" dirty="0"/>
              <a:t>…</a:t>
            </a:r>
            <a:endParaRPr lang="en-US" dirty="0">
              <a:solidFill>
                <a:schemeClr val="tx2">
                  <a:lumMod val="90000"/>
                </a:schemeClr>
              </a:solidFill>
            </a:endParaRPr>
          </a:p>
        </p:txBody>
      </p:sp>
      <p:sp>
        <p:nvSpPr>
          <p:cNvPr id="8" name="TextBox 7"/>
          <p:cNvSpPr txBox="1"/>
          <p:nvPr/>
        </p:nvSpPr>
        <p:spPr>
          <a:xfrm>
            <a:off x="533400" y="1766979"/>
            <a:ext cx="6553200" cy="2554545"/>
          </a:xfrm>
          <a:prstGeom prst="rect">
            <a:avLst/>
          </a:prstGeom>
          <a:noFill/>
        </p:spPr>
        <p:txBody>
          <a:bodyPr wrap="square" rtlCol="0">
            <a:spAutoFit/>
          </a:bodyPr>
          <a:lstStyle/>
          <a:p>
            <a:pPr marL="109538" lvl="1">
              <a:spcBef>
                <a:spcPts val="600"/>
              </a:spcBef>
              <a:spcAft>
                <a:spcPts val="600"/>
              </a:spcAft>
              <a:buClr>
                <a:schemeClr val="tx2">
                  <a:lumMod val="75000"/>
                </a:schemeClr>
              </a:buClr>
              <a:buSzPct val="125000"/>
            </a:pPr>
            <a:r>
              <a:rPr lang="en-US" sz="2400" b="1" dirty="0"/>
              <a:t>The Staff:</a:t>
            </a:r>
          </a:p>
          <a:p>
            <a:pPr marL="914400" lvl="1" indent="-222250">
              <a:spcBef>
                <a:spcPts val="600"/>
              </a:spcBef>
              <a:spcAft>
                <a:spcPts val="600"/>
              </a:spcAft>
              <a:buClr>
                <a:schemeClr val="tx2">
                  <a:lumMod val="75000"/>
                </a:schemeClr>
              </a:buClr>
              <a:buSzPct val="125000"/>
              <a:buFont typeface="Wingdings" panose="05000000000000000000" pitchFamily="2" charset="2"/>
              <a:buChar char="§"/>
            </a:pPr>
            <a:r>
              <a:rPr lang="en-US" sz="2400" dirty="0"/>
              <a:t>“is worried about…” </a:t>
            </a:r>
          </a:p>
          <a:p>
            <a:pPr marL="914400" lvl="1" indent="-222250">
              <a:spcBef>
                <a:spcPts val="600"/>
              </a:spcBef>
              <a:spcAft>
                <a:spcPts val="600"/>
              </a:spcAft>
              <a:buClr>
                <a:schemeClr val="tx2">
                  <a:lumMod val="75000"/>
                </a:schemeClr>
              </a:buClr>
              <a:buSzPct val="125000"/>
              <a:buFont typeface="Wingdings" panose="05000000000000000000" pitchFamily="2" charset="2"/>
              <a:buChar char="§"/>
            </a:pPr>
            <a:r>
              <a:rPr lang="en-US" sz="2400" dirty="0"/>
              <a:t>“has a need for…”</a:t>
            </a:r>
          </a:p>
          <a:p>
            <a:pPr marL="914400" lvl="1" indent="-222250">
              <a:spcBef>
                <a:spcPts val="600"/>
              </a:spcBef>
              <a:spcAft>
                <a:spcPts val="600"/>
              </a:spcAft>
              <a:buClr>
                <a:schemeClr val="tx2">
                  <a:lumMod val="75000"/>
                </a:schemeClr>
              </a:buClr>
              <a:buSzPct val="125000"/>
              <a:buFont typeface="Wingdings" panose="05000000000000000000" pitchFamily="2" charset="2"/>
              <a:buChar char="§"/>
            </a:pPr>
            <a:r>
              <a:rPr lang="en-US" sz="2400" dirty="0"/>
              <a:t>“is concerned about…”</a:t>
            </a:r>
          </a:p>
          <a:p>
            <a:pPr marL="914400" lvl="1" indent="-222250">
              <a:spcBef>
                <a:spcPts val="600"/>
              </a:spcBef>
              <a:spcAft>
                <a:spcPts val="600"/>
              </a:spcAft>
              <a:buClr>
                <a:schemeClr val="tx2">
                  <a:lumMod val="75000"/>
                </a:schemeClr>
              </a:buClr>
              <a:buSzPct val="125000"/>
              <a:buFont typeface="Wingdings" panose="05000000000000000000" pitchFamily="2" charset="2"/>
              <a:buChar char="§"/>
            </a:pPr>
            <a:r>
              <a:rPr lang="en-US" sz="2400" dirty="0"/>
              <a:t>“values…”</a:t>
            </a:r>
          </a:p>
        </p:txBody>
      </p:sp>
    </p:spTree>
    <p:extLst>
      <p:ext uri="{BB962C8B-B14F-4D97-AF65-F5344CB8AC3E}">
        <p14:creationId xmlns:p14="http://schemas.microsoft.com/office/powerpoint/2010/main" val="3861060033"/>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solidFill>
                  <a:schemeClr val="tx2">
                    <a:lumMod val="90000"/>
                  </a:schemeClr>
                </a:solidFill>
                <a:effectLst/>
              </a:rPr>
              <a:t>Strategy for Uncovering </a:t>
            </a:r>
            <a:br>
              <a:rPr lang="en-US" dirty="0">
                <a:solidFill>
                  <a:schemeClr val="tx2">
                    <a:lumMod val="90000"/>
                  </a:schemeClr>
                </a:solidFill>
                <a:effectLst/>
              </a:rPr>
            </a:br>
            <a:r>
              <a:rPr lang="en-US" dirty="0">
                <a:solidFill>
                  <a:schemeClr val="tx2">
                    <a:lumMod val="90000"/>
                  </a:schemeClr>
                </a:solidFill>
                <a:effectLst/>
              </a:rPr>
              <a:t>Interests</a:t>
            </a:r>
            <a:endParaRPr lang="en-US" dirty="0"/>
          </a:p>
        </p:txBody>
      </p:sp>
      <p:sp>
        <p:nvSpPr>
          <p:cNvPr id="3" name="Content Placeholder 2"/>
          <p:cNvSpPr>
            <a:spLocks noGrp="1"/>
          </p:cNvSpPr>
          <p:nvPr>
            <p:ph idx="1"/>
          </p:nvPr>
        </p:nvSpPr>
        <p:spPr>
          <a:xfrm>
            <a:off x="457200" y="2057400"/>
            <a:ext cx="8229600" cy="4343400"/>
          </a:xfrm>
        </p:spPr>
        <p:txBody>
          <a:bodyPr/>
          <a:lstStyle/>
          <a:p>
            <a:r>
              <a:rPr lang="en-US" sz="2800" dirty="0">
                <a:effectLst/>
              </a:rPr>
              <a:t>Mediators distinguish between: </a:t>
            </a:r>
          </a:p>
          <a:p>
            <a:pPr marL="457200" lvl="1" indent="0">
              <a:buNone/>
            </a:pPr>
            <a:endParaRPr lang="en-US" dirty="0">
              <a:effectLst/>
            </a:endParaRPr>
          </a:p>
          <a:p>
            <a:pPr marL="2406650" lvl="1" indent="-866775">
              <a:spcAft>
                <a:spcPts val="0"/>
              </a:spcAft>
              <a:buNone/>
            </a:pPr>
            <a:r>
              <a:rPr lang="en-US" sz="3200" b="1" dirty="0">
                <a:solidFill>
                  <a:srgbClr val="33CC33"/>
                </a:solidFill>
                <a:effectLst>
                  <a:outerShdw blurRad="38100" dist="38100" dir="2700000" algn="tl">
                    <a:srgbClr val="000000">
                      <a:alpha val="43137"/>
                    </a:srgbClr>
                  </a:outerShdw>
                </a:effectLst>
              </a:rPr>
              <a:t>POSITIONS</a:t>
            </a: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a:p>
            <a:pPr marL="2408237" lvl="1" indent="0">
              <a:spcAft>
                <a:spcPts val="1200"/>
              </a:spcAft>
              <a:buNone/>
            </a:pPr>
            <a:endParaRPr lang="en-US" sz="3200" b="1" dirty="0">
              <a:solidFill>
                <a:srgbClr val="FFC000"/>
              </a:solidFill>
              <a:effectLst>
                <a:outerShdw blurRad="38100" dist="38100" dir="2700000" algn="tl">
                  <a:srgbClr val="000000">
                    <a:alpha val="43137"/>
                  </a:srgbClr>
                </a:outerShdw>
              </a:effectLst>
            </a:endParaRPr>
          </a:p>
          <a:p>
            <a:pPr marL="2408237" lvl="1" indent="0">
              <a:lnSpc>
                <a:spcPct val="150000"/>
              </a:lnSpc>
              <a:spcAft>
                <a:spcPts val="1200"/>
              </a:spcAft>
              <a:buNone/>
            </a:pPr>
            <a:r>
              <a:rPr lang="en-US" sz="3200" b="1" dirty="0">
                <a:solidFill>
                  <a:srgbClr val="C5C5C5"/>
                </a:solidFill>
                <a:effectLst>
                  <a:outerShdw blurRad="38100" dist="38100" dir="2700000" algn="tl">
                    <a:srgbClr val="000000">
                      <a:alpha val="43137"/>
                    </a:srgbClr>
                  </a:outerShdw>
                </a:effectLst>
              </a:rPr>
              <a:t>INTERESTS</a:t>
            </a:r>
          </a:p>
        </p:txBody>
      </p:sp>
      <p:sp>
        <p:nvSpPr>
          <p:cNvPr id="4" name="Cloud 3">
            <a:extLst>
              <a:ext uri="{FF2B5EF4-FFF2-40B4-BE49-F238E27FC236}">
                <a16:creationId xmlns:a16="http://schemas.microsoft.com/office/drawing/2014/main" id="{06D3AA3A-C6DE-47F9-A404-6BB41C9BCF39}"/>
              </a:ext>
            </a:extLst>
          </p:cNvPr>
          <p:cNvSpPr/>
          <p:nvPr/>
        </p:nvSpPr>
        <p:spPr>
          <a:xfrm rot="390175">
            <a:off x="5602323" y="1842229"/>
            <a:ext cx="1900724" cy="1483145"/>
          </a:xfrm>
          <a:prstGeom prst="cloud">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mc:AlternateContent xmlns:mc="http://schemas.openxmlformats.org/markup-compatibility/2006" xmlns:p14="http://schemas.microsoft.com/office/powerpoint/2010/main">
        <mc:Choice Requires="p14">
          <p:contentPart p14:bwMode="auto" r:id="rId3">
            <p14:nvContentPartPr>
              <p14:cNvPr id="5" name="Ink 4">
                <a:extLst>
                  <a:ext uri="{FF2B5EF4-FFF2-40B4-BE49-F238E27FC236}">
                    <a16:creationId xmlns:a16="http://schemas.microsoft.com/office/drawing/2014/main" id="{1936930B-9D2D-4DEF-B1FD-4B7C06AD587E}"/>
                  </a:ext>
                </a:extLst>
              </p14:cNvPr>
              <p14:cNvContentPartPr/>
              <p14:nvPr/>
            </p14:nvContentPartPr>
            <p14:xfrm>
              <a:off x="6990075" y="2620144"/>
              <a:ext cx="109800" cy="151560"/>
            </p14:xfrm>
          </p:contentPart>
        </mc:Choice>
        <mc:Fallback xmlns="">
          <p:pic>
            <p:nvPicPr>
              <p:cNvPr id="5" name="Ink 4">
                <a:extLst>
                  <a:ext uri="{FF2B5EF4-FFF2-40B4-BE49-F238E27FC236}">
                    <a16:creationId xmlns:a16="http://schemas.microsoft.com/office/drawing/2014/main" id="{1936930B-9D2D-4DEF-B1FD-4B7C06AD587E}"/>
                  </a:ext>
                </a:extLst>
              </p:cNvPr>
              <p:cNvPicPr/>
              <p:nvPr/>
            </p:nvPicPr>
            <p:blipFill>
              <a:blip r:embed="rId4"/>
              <a:stretch>
                <a:fillRect/>
              </a:stretch>
            </p:blipFill>
            <p:spPr>
              <a:xfrm>
                <a:off x="6981075" y="2611144"/>
                <a:ext cx="127440" cy="169200"/>
              </a:xfrm>
              <a:prstGeom prst="rect">
                <a:avLst/>
              </a:prstGeom>
            </p:spPr>
          </p:pic>
        </mc:Fallback>
      </mc:AlternateContent>
      <mc:AlternateContent xmlns:mc="http://schemas.openxmlformats.org/markup-compatibility/2006" xmlns:p14="http://schemas.microsoft.com/office/powerpoint/2010/main">
        <mc:Choice Requires="p14">
          <p:contentPart p14:bwMode="auto" r:id="rId5">
            <p14:nvContentPartPr>
              <p14:cNvPr id="6" name="Ink 5">
                <a:extLst>
                  <a:ext uri="{FF2B5EF4-FFF2-40B4-BE49-F238E27FC236}">
                    <a16:creationId xmlns:a16="http://schemas.microsoft.com/office/drawing/2014/main" id="{7A310F11-CAF1-4054-92C3-4C38A779F2B3}"/>
                  </a:ext>
                </a:extLst>
              </p14:cNvPr>
              <p14:cNvContentPartPr/>
              <p14:nvPr/>
            </p14:nvContentPartPr>
            <p14:xfrm>
              <a:off x="6654915" y="2671984"/>
              <a:ext cx="614520" cy="514440"/>
            </p14:xfrm>
          </p:contentPart>
        </mc:Choice>
        <mc:Fallback xmlns="">
          <p:pic>
            <p:nvPicPr>
              <p:cNvPr id="6" name="Ink 5">
                <a:extLst>
                  <a:ext uri="{FF2B5EF4-FFF2-40B4-BE49-F238E27FC236}">
                    <a16:creationId xmlns:a16="http://schemas.microsoft.com/office/drawing/2014/main" id="{7A310F11-CAF1-4054-92C3-4C38A779F2B3}"/>
                  </a:ext>
                </a:extLst>
              </p:cNvPr>
              <p:cNvPicPr/>
              <p:nvPr/>
            </p:nvPicPr>
            <p:blipFill>
              <a:blip r:embed="rId6"/>
              <a:stretch>
                <a:fillRect/>
              </a:stretch>
            </p:blipFill>
            <p:spPr>
              <a:xfrm>
                <a:off x="6645915" y="2662984"/>
                <a:ext cx="632160" cy="532080"/>
              </a:xfrm>
              <a:prstGeom prst="rect">
                <a:avLst/>
              </a:prstGeom>
            </p:spPr>
          </p:pic>
        </mc:Fallback>
      </mc:AlternateContent>
      <mc:AlternateContent xmlns:mc="http://schemas.openxmlformats.org/markup-compatibility/2006" xmlns:p14="http://schemas.microsoft.com/office/powerpoint/2010/main">
        <mc:Choice Requires="p14">
          <p:contentPart p14:bwMode="auto" r:id="rId7">
            <p14:nvContentPartPr>
              <p14:cNvPr id="7" name="Ink 6">
                <a:extLst>
                  <a:ext uri="{FF2B5EF4-FFF2-40B4-BE49-F238E27FC236}">
                    <a16:creationId xmlns:a16="http://schemas.microsoft.com/office/drawing/2014/main" id="{186A7C5C-2668-4B0E-924F-889C27F9A091}"/>
                  </a:ext>
                </a:extLst>
              </p14:cNvPr>
              <p14:cNvContentPartPr/>
              <p14:nvPr/>
            </p14:nvContentPartPr>
            <p14:xfrm>
              <a:off x="5470875" y="1758304"/>
              <a:ext cx="2513160" cy="1712160"/>
            </p14:xfrm>
          </p:contentPart>
        </mc:Choice>
        <mc:Fallback xmlns="">
          <p:pic>
            <p:nvPicPr>
              <p:cNvPr id="7" name="Ink 6">
                <a:extLst>
                  <a:ext uri="{FF2B5EF4-FFF2-40B4-BE49-F238E27FC236}">
                    <a16:creationId xmlns:a16="http://schemas.microsoft.com/office/drawing/2014/main" id="{186A7C5C-2668-4B0E-924F-889C27F9A091}"/>
                  </a:ext>
                </a:extLst>
              </p:cNvPr>
              <p:cNvPicPr/>
              <p:nvPr/>
            </p:nvPicPr>
            <p:blipFill>
              <a:blip r:embed="rId8"/>
              <a:stretch>
                <a:fillRect/>
              </a:stretch>
            </p:blipFill>
            <p:spPr>
              <a:xfrm>
                <a:off x="5407875" y="1695304"/>
                <a:ext cx="2638800" cy="1837800"/>
              </a:xfrm>
              <a:prstGeom prst="rect">
                <a:avLst/>
              </a:prstGeom>
            </p:spPr>
          </p:pic>
        </mc:Fallback>
      </mc:AlternateContent>
      <p:sp>
        <p:nvSpPr>
          <p:cNvPr id="8" name="Rectangle: Rounded Corners 7">
            <a:extLst>
              <a:ext uri="{FF2B5EF4-FFF2-40B4-BE49-F238E27FC236}">
                <a16:creationId xmlns:a16="http://schemas.microsoft.com/office/drawing/2014/main" id="{DD67AC07-58F5-489A-A35B-1D9157165C94}"/>
              </a:ext>
            </a:extLst>
          </p:cNvPr>
          <p:cNvSpPr/>
          <p:nvPr/>
        </p:nvSpPr>
        <p:spPr>
          <a:xfrm>
            <a:off x="6489757" y="3352800"/>
            <a:ext cx="330315" cy="1177736"/>
          </a:xfrm>
          <a:prstGeom prst="roundRect">
            <a:avLst/>
          </a:prstGeom>
          <a:solidFill>
            <a:srgbClr val="9966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reeform: Shape 11">
            <a:extLst>
              <a:ext uri="{FF2B5EF4-FFF2-40B4-BE49-F238E27FC236}">
                <a16:creationId xmlns:a16="http://schemas.microsoft.com/office/drawing/2014/main" id="{14B9E463-BBB3-4A6E-A00B-C32BAFB414E2}"/>
              </a:ext>
            </a:extLst>
          </p:cNvPr>
          <p:cNvSpPr/>
          <p:nvPr/>
        </p:nvSpPr>
        <p:spPr>
          <a:xfrm>
            <a:off x="6800370" y="45720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Freeform: Shape 12">
            <a:extLst>
              <a:ext uri="{FF2B5EF4-FFF2-40B4-BE49-F238E27FC236}">
                <a16:creationId xmlns:a16="http://schemas.microsoft.com/office/drawing/2014/main" id="{BBFF0C4A-E839-4469-B2C9-2ADEC12E01B5}"/>
              </a:ext>
            </a:extLst>
          </p:cNvPr>
          <p:cNvSpPr/>
          <p:nvPr/>
        </p:nvSpPr>
        <p:spPr>
          <a:xfrm rot="15377824">
            <a:off x="5624291" y="5019923"/>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Freeform: Shape 15">
            <a:extLst>
              <a:ext uri="{FF2B5EF4-FFF2-40B4-BE49-F238E27FC236}">
                <a16:creationId xmlns:a16="http://schemas.microsoft.com/office/drawing/2014/main" id="{6DEC42A5-DB2D-4F3C-87C8-5050D684DB68}"/>
              </a:ext>
            </a:extLst>
          </p:cNvPr>
          <p:cNvSpPr/>
          <p:nvPr/>
        </p:nvSpPr>
        <p:spPr>
          <a:xfrm rot="941520">
            <a:off x="6507095" y="4787321"/>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reeform: Shape 16">
            <a:extLst>
              <a:ext uri="{FF2B5EF4-FFF2-40B4-BE49-F238E27FC236}">
                <a16:creationId xmlns:a16="http://schemas.microsoft.com/office/drawing/2014/main" id="{B751F970-0410-4E65-A78A-C76EAA8E8BF9}"/>
              </a:ext>
            </a:extLst>
          </p:cNvPr>
          <p:cNvSpPr/>
          <p:nvPr/>
        </p:nvSpPr>
        <p:spPr>
          <a:xfrm rot="1963374">
            <a:off x="6286283" y="4998862"/>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9854A418-22FB-4996-A05D-8CD6AB2DAA04}"/>
              </a:ext>
            </a:extLst>
          </p:cNvPr>
          <p:cNvSpPr/>
          <p:nvPr/>
        </p:nvSpPr>
        <p:spPr>
          <a:xfrm rot="17086082">
            <a:off x="5236666" y="4724400"/>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Freeform: Shape 18">
            <a:extLst>
              <a:ext uri="{FF2B5EF4-FFF2-40B4-BE49-F238E27FC236}">
                <a16:creationId xmlns:a16="http://schemas.microsoft.com/office/drawing/2014/main" id="{6CEAE087-16A8-4597-B2D2-B61BFA9D3A85}"/>
              </a:ext>
            </a:extLst>
          </p:cNvPr>
          <p:cNvSpPr/>
          <p:nvPr/>
        </p:nvSpPr>
        <p:spPr>
          <a:xfrm rot="17503495">
            <a:off x="4870140" y="4611237"/>
            <a:ext cx="1383126" cy="860612"/>
          </a:xfrm>
          <a:custGeom>
            <a:avLst/>
            <a:gdLst>
              <a:gd name="connsiteX0" fmla="*/ 0 w 1383126"/>
              <a:gd name="connsiteY0" fmla="*/ 0 h 860612"/>
              <a:gd name="connsiteX1" fmla="*/ 184417 w 1383126"/>
              <a:gd name="connsiteY1" fmla="*/ 15368 h 860612"/>
              <a:gd name="connsiteX2" fmla="*/ 268941 w 1383126"/>
              <a:gd name="connsiteY2" fmla="*/ 38420 h 860612"/>
              <a:gd name="connsiteX3" fmla="*/ 307361 w 1383126"/>
              <a:gd name="connsiteY3" fmla="*/ 107576 h 860612"/>
              <a:gd name="connsiteX4" fmla="*/ 384201 w 1383126"/>
              <a:gd name="connsiteY4" fmla="*/ 199785 h 860612"/>
              <a:gd name="connsiteX5" fmla="*/ 414938 w 1383126"/>
              <a:gd name="connsiteY5" fmla="*/ 238205 h 860612"/>
              <a:gd name="connsiteX6" fmla="*/ 568618 w 1383126"/>
              <a:gd name="connsiteY6" fmla="*/ 291993 h 860612"/>
              <a:gd name="connsiteX7" fmla="*/ 737667 w 1383126"/>
              <a:gd name="connsiteY7" fmla="*/ 353466 h 860612"/>
              <a:gd name="connsiteX8" fmla="*/ 768403 w 1383126"/>
              <a:gd name="connsiteY8" fmla="*/ 368834 h 860612"/>
              <a:gd name="connsiteX9" fmla="*/ 837559 w 1383126"/>
              <a:gd name="connsiteY9" fmla="*/ 430306 h 860612"/>
              <a:gd name="connsiteX10" fmla="*/ 868296 w 1383126"/>
              <a:gd name="connsiteY10" fmla="*/ 468726 h 860612"/>
              <a:gd name="connsiteX11" fmla="*/ 945136 w 1383126"/>
              <a:gd name="connsiteY11" fmla="*/ 507146 h 860612"/>
              <a:gd name="connsiteX12" fmla="*/ 983556 w 1383126"/>
              <a:gd name="connsiteY12" fmla="*/ 530198 h 860612"/>
              <a:gd name="connsiteX13" fmla="*/ 1021976 w 1383126"/>
              <a:gd name="connsiteY13" fmla="*/ 599355 h 860612"/>
              <a:gd name="connsiteX14" fmla="*/ 1045028 w 1383126"/>
              <a:gd name="connsiteY14" fmla="*/ 622407 h 860612"/>
              <a:gd name="connsiteX15" fmla="*/ 1137237 w 1383126"/>
              <a:gd name="connsiteY15" fmla="*/ 660827 h 860612"/>
              <a:gd name="connsiteX16" fmla="*/ 1183341 w 1383126"/>
              <a:gd name="connsiteY16" fmla="*/ 699247 h 860612"/>
              <a:gd name="connsiteX17" fmla="*/ 1252497 w 1383126"/>
              <a:gd name="connsiteY17" fmla="*/ 768403 h 860612"/>
              <a:gd name="connsiteX18" fmla="*/ 1283233 w 1383126"/>
              <a:gd name="connsiteY18" fmla="*/ 791455 h 860612"/>
              <a:gd name="connsiteX19" fmla="*/ 1329338 w 1383126"/>
              <a:gd name="connsiteY19" fmla="*/ 829876 h 860612"/>
              <a:gd name="connsiteX20" fmla="*/ 1344706 w 1383126"/>
              <a:gd name="connsiteY20" fmla="*/ 852928 h 860612"/>
              <a:gd name="connsiteX21" fmla="*/ 1383126 w 1383126"/>
              <a:gd name="connsiteY21" fmla="*/ 860612 h 860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383126" h="860612">
                <a:moveTo>
                  <a:pt x="0" y="0"/>
                </a:moveTo>
                <a:cubicBezTo>
                  <a:pt x="61472" y="5123"/>
                  <a:pt x="123352" y="6644"/>
                  <a:pt x="184417" y="15368"/>
                </a:cubicBezTo>
                <a:cubicBezTo>
                  <a:pt x="213327" y="19498"/>
                  <a:pt x="242820" y="25360"/>
                  <a:pt x="268941" y="38420"/>
                </a:cubicBezTo>
                <a:cubicBezTo>
                  <a:pt x="290859" y="49379"/>
                  <a:pt x="297371" y="90450"/>
                  <a:pt x="307361" y="107576"/>
                </a:cubicBezTo>
                <a:cubicBezTo>
                  <a:pt x="342905" y="168510"/>
                  <a:pt x="341218" y="152026"/>
                  <a:pt x="384201" y="199785"/>
                </a:cubicBezTo>
                <a:cubicBezTo>
                  <a:pt x="395173" y="211975"/>
                  <a:pt x="401674" y="228559"/>
                  <a:pt x="414938" y="238205"/>
                </a:cubicBezTo>
                <a:cubicBezTo>
                  <a:pt x="440004" y="256434"/>
                  <a:pt x="558568" y="288643"/>
                  <a:pt x="568618" y="291993"/>
                </a:cubicBezTo>
                <a:cubicBezTo>
                  <a:pt x="578100" y="295154"/>
                  <a:pt x="696449" y="335146"/>
                  <a:pt x="737667" y="353466"/>
                </a:cubicBezTo>
                <a:cubicBezTo>
                  <a:pt x="748134" y="358118"/>
                  <a:pt x="758872" y="362480"/>
                  <a:pt x="768403" y="368834"/>
                </a:cubicBezTo>
                <a:cubicBezTo>
                  <a:pt x="790601" y="383633"/>
                  <a:pt x="819553" y="410049"/>
                  <a:pt x="837559" y="430306"/>
                </a:cubicBezTo>
                <a:cubicBezTo>
                  <a:pt x="848455" y="442564"/>
                  <a:pt x="856038" y="457830"/>
                  <a:pt x="868296" y="468726"/>
                </a:cubicBezTo>
                <a:cubicBezTo>
                  <a:pt x="895776" y="493152"/>
                  <a:pt x="913876" y="491516"/>
                  <a:pt x="945136" y="507146"/>
                </a:cubicBezTo>
                <a:cubicBezTo>
                  <a:pt x="958494" y="513825"/>
                  <a:pt x="970749" y="522514"/>
                  <a:pt x="983556" y="530198"/>
                </a:cubicBezTo>
                <a:cubicBezTo>
                  <a:pt x="999462" y="569964"/>
                  <a:pt x="994565" y="567375"/>
                  <a:pt x="1021976" y="599355"/>
                </a:cubicBezTo>
                <a:cubicBezTo>
                  <a:pt x="1029048" y="607606"/>
                  <a:pt x="1035593" y="617016"/>
                  <a:pt x="1045028" y="622407"/>
                </a:cubicBezTo>
                <a:cubicBezTo>
                  <a:pt x="1121379" y="666036"/>
                  <a:pt x="1015578" y="559444"/>
                  <a:pt x="1137237" y="660827"/>
                </a:cubicBezTo>
                <a:cubicBezTo>
                  <a:pt x="1152605" y="673634"/>
                  <a:pt x="1168716" y="685597"/>
                  <a:pt x="1183341" y="699247"/>
                </a:cubicBezTo>
                <a:cubicBezTo>
                  <a:pt x="1207174" y="721491"/>
                  <a:pt x="1226417" y="748843"/>
                  <a:pt x="1252497" y="768403"/>
                </a:cubicBezTo>
                <a:cubicBezTo>
                  <a:pt x="1262742" y="776087"/>
                  <a:pt x="1273510" y="783120"/>
                  <a:pt x="1283233" y="791455"/>
                </a:cubicBezTo>
                <a:cubicBezTo>
                  <a:pt x="1335000" y="835828"/>
                  <a:pt x="1278389" y="795912"/>
                  <a:pt x="1329338" y="829876"/>
                </a:cubicBezTo>
                <a:cubicBezTo>
                  <a:pt x="1334461" y="837560"/>
                  <a:pt x="1336688" y="848346"/>
                  <a:pt x="1344706" y="852928"/>
                </a:cubicBezTo>
                <a:cubicBezTo>
                  <a:pt x="1356046" y="859408"/>
                  <a:pt x="1383126" y="860612"/>
                  <a:pt x="1383126" y="860612"/>
                </a:cubicBezTo>
              </a:path>
            </a:pathLst>
          </a:cu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Connector 19">
            <a:extLst>
              <a:ext uri="{FF2B5EF4-FFF2-40B4-BE49-F238E27FC236}">
                <a16:creationId xmlns:a16="http://schemas.microsoft.com/office/drawing/2014/main" id="{3C9EA9A4-8881-496B-9F37-9A5AB00C3603}"/>
              </a:ext>
            </a:extLst>
          </p:cNvPr>
          <p:cNvCxnSpPr/>
          <p:nvPr/>
        </p:nvCxnSpPr>
        <p:spPr>
          <a:xfrm>
            <a:off x="4419600" y="4572000"/>
            <a:ext cx="4191000" cy="0"/>
          </a:xfrm>
          <a:prstGeom prst="line">
            <a:avLst/>
          </a:prstGeom>
          <a:ln>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93A8D74C-A4DF-4D5F-9DED-47B3FA0BC7B5}"/>
              </a:ext>
            </a:extLst>
          </p:cNvPr>
          <p:cNvSpPr txBox="1"/>
          <p:nvPr/>
        </p:nvSpPr>
        <p:spPr>
          <a:xfrm>
            <a:off x="2362911" y="3285149"/>
            <a:ext cx="1981200" cy="1200329"/>
          </a:xfrm>
          <a:prstGeom prst="rect">
            <a:avLst/>
          </a:prstGeom>
          <a:noFill/>
        </p:spPr>
        <p:txBody>
          <a:bodyPr wrap="square" rtlCol="0">
            <a:spAutoFit/>
          </a:bodyPr>
          <a:lstStyle/>
          <a:p>
            <a:r>
              <a:rPr lang="en-US" sz="1800" b="1" dirty="0">
                <a:solidFill>
                  <a:srgbClr val="92D050"/>
                </a:solidFill>
              </a:rPr>
              <a:t>Fred appears abusive, rude, disrespectful &amp; uncooperative</a:t>
            </a:r>
          </a:p>
        </p:txBody>
      </p:sp>
      <p:sp>
        <p:nvSpPr>
          <p:cNvPr id="22" name="TextBox 21">
            <a:extLst>
              <a:ext uri="{FF2B5EF4-FFF2-40B4-BE49-F238E27FC236}">
                <a16:creationId xmlns:a16="http://schemas.microsoft.com/office/drawing/2014/main" id="{3FFF8332-F88B-4762-9102-86F8AAE4C78E}"/>
              </a:ext>
            </a:extLst>
          </p:cNvPr>
          <p:cNvSpPr txBox="1"/>
          <p:nvPr/>
        </p:nvSpPr>
        <p:spPr>
          <a:xfrm>
            <a:off x="2832284" y="5332947"/>
            <a:ext cx="1981200" cy="1200329"/>
          </a:xfrm>
          <a:prstGeom prst="rect">
            <a:avLst/>
          </a:prstGeom>
          <a:noFill/>
        </p:spPr>
        <p:txBody>
          <a:bodyPr wrap="square" rtlCol="0">
            <a:spAutoFit/>
          </a:bodyPr>
          <a:lstStyle/>
          <a:p>
            <a:pPr algn="ctr"/>
            <a:r>
              <a:rPr lang="en-US" sz="2400" b="1" i="1" dirty="0">
                <a:solidFill>
                  <a:schemeClr val="bg2">
                    <a:lumMod val="50000"/>
                  </a:schemeClr>
                </a:solidFill>
              </a:rPr>
              <a:t>What are Fred’s interests?</a:t>
            </a:r>
          </a:p>
        </p:txBody>
      </p:sp>
      <p:sp>
        <p:nvSpPr>
          <p:cNvPr id="10" name="Arrow: Right 9">
            <a:extLst>
              <a:ext uri="{FF2B5EF4-FFF2-40B4-BE49-F238E27FC236}">
                <a16:creationId xmlns:a16="http://schemas.microsoft.com/office/drawing/2014/main" id="{40D071C3-C51D-435B-8158-6923DC99A638}"/>
              </a:ext>
            </a:extLst>
          </p:cNvPr>
          <p:cNvSpPr/>
          <p:nvPr/>
        </p:nvSpPr>
        <p:spPr>
          <a:xfrm rot="1013072">
            <a:off x="1066800" y="5041543"/>
            <a:ext cx="1311450" cy="444857"/>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8651229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t>Searching for Fred’s </a:t>
            </a:r>
            <a:r>
              <a:rPr lang="en-US" b="1" u="sng" dirty="0">
                <a:solidFill>
                  <a:schemeClr val="bg1">
                    <a:lumMod val="50000"/>
                  </a:schemeClr>
                </a:solidFill>
              </a:rPr>
              <a:t>interests</a:t>
            </a:r>
            <a:r>
              <a:rPr lang="en-US" dirty="0"/>
              <a:t>…</a:t>
            </a:r>
            <a:endParaRPr lang="en-US" dirty="0">
              <a:solidFill>
                <a:schemeClr val="tx2">
                  <a:lumMod val="90000"/>
                </a:schemeClr>
              </a:solidFill>
            </a:endParaRPr>
          </a:p>
        </p:txBody>
      </p:sp>
      <p:sp>
        <p:nvSpPr>
          <p:cNvPr id="8" name="TextBox 7"/>
          <p:cNvSpPr txBox="1"/>
          <p:nvPr/>
        </p:nvSpPr>
        <p:spPr>
          <a:xfrm>
            <a:off x="533400" y="1766979"/>
            <a:ext cx="6553200" cy="2554545"/>
          </a:xfrm>
          <a:prstGeom prst="rect">
            <a:avLst/>
          </a:prstGeom>
          <a:noFill/>
        </p:spPr>
        <p:txBody>
          <a:bodyPr wrap="square" rtlCol="0">
            <a:spAutoFit/>
          </a:bodyPr>
          <a:lstStyle/>
          <a:p>
            <a:pPr marL="109538" lvl="1">
              <a:spcBef>
                <a:spcPts val="600"/>
              </a:spcBef>
              <a:spcAft>
                <a:spcPts val="600"/>
              </a:spcAft>
              <a:buClr>
                <a:schemeClr val="tx2">
                  <a:lumMod val="75000"/>
                </a:schemeClr>
              </a:buClr>
              <a:buSzPct val="125000"/>
            </a:pPr>
            <a:r>
              <a:rPr lang="en-US" sz="2400" b="1" dirty="0"/>
              <a:t>Fred:</a:t>
            </a:r>
          </a:p>
          <a:p>
            <a:pPr marL="914400" lvl="1" indent="-222250">
              <a:spcBef>
                <a:spcPts val="600"/>
              </a:spcBef>
              <a:spcAft>
                <a:spcPts val="600"/>
              </a:spcAft>
              <a:buClr>
                <a:schemeClr val="tx2">
                  <a:lumMod val="75000"/>
                </a:schemeClr>
              </a:buClr>
              <a:buSzPct val="125000"/>
              <a:buFont typeface="Wingdings" panose="05000000000000000000" pitchFamily="2" charset="2"/>
              <a:buChar char="§"/>
            </a:pPr>
            <a:r>
              <a:rPr lang="en-US" sz="2400" dirty="0"/>
              <a:t>“is worried about…” </a:t>
            </a:r>
          </a:p>
          <a:p>
            <a:pPr marL="914400" lvl="1" indent="-222250">
              <a:spcBef>
                <a:spcPts val="600"/>
              </a:spcBef>
              <a:spcAft>
                <a:spcPts val="600"/>
              </a:spcAft>
              <a:buClr>
                <a:schemeClr val="tx2">
                  <a:lumMod val="75000"/>
                </a:schemeClr>
              </a:buClr>
              <a:buSzPct val="125000"/>
              <a:buFont typeface="Wingdings" panose="05000000000000000000" pitchFamily="2" charset="2"/>
              <a:buChar char="§"/>
            </a:pPr>
            <a:r>
              <a:rPr lang="en-US" sz="2400" dirty="0"/>
              <a:t>“has a need for…”</a:t>
            </a:r>
          </a:p>
          <a:p>
            <a:pPr marL="914400" lvl="1" indent="-222250">
              <a:spcBef>
                <a:spcPts val="600"/>
              </a:spcBef>
              <a:spcAft>
                <a:spcPts val="600"/>
              </a:spcAft>
              <a:buClr>
                <a:schemeClr val="tx2">
                  <a:lumMod val="75000"/>
                </a:schemeClr>
              </a:buClr>
              <a:buSzPct val="125000"/>
              <a:buFont typeface="Wingdings" panose="05000000000000000000" pitchFamily="2" charset="2"/>
              <a:buChar char="§"/>
            </a:pPr>
            <a:r>
              <a:rPr lang="en-US" sz="2400" dirty="0"/>
              <a:t>“is concerned about…”</a:t>
            </a:r>
          </a:p>
          <a:p>
            <a:pPr marL="914400" lvl="1" indent="-222250">
              <a:spcBef>
                <a:spcPts val="600"/>
              </a:spcBef>
              <a:spcAft>
                <a:spcPts val="600"/>
              </a:spcAft>
              <a:buClr>
                <a:schemeClr val="tx2">
                  <a:lumMod val="75000"/>
                </a:schemeClr>
              </a:buClr>
              <a:buSzPct val="125000"/>
              <a:buFont typeface="Wingdings" panose="05000000000000000000" pitchFamily="2" charset="2"/>
              <a:buChar char="§"/>
            </a:pPr>
            <a:r>
              <a:rPr lang="en-US" sz="2400" dirty="0"/>
              <a:t>“values…”</a:t>
            </a:r>
          </a:p>
        </p:txBody>
      </p:sp>
    </p:spTree>
    <p:extLst>
      <p:ext uri="{BB962C8B-B14F-4D97-AF65-F5344CB8AC3E}">
        <p14:creationId xmlns:p14="http://schemas.microsoft.com/office/powerpoint/2010/main" val="1063502261"/>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739EE702-8BB0-4845-B368-8590A572D8D3}"/>
              </a:ext>
            </a:extLst>
          </p:cNvPr>
          <p:cNvSpPr>
            <a:spLocks noGrp="1"/>
          </p:cNvSpPr>
          <p:nvPr>
            <p:ph type="title"/>
          </p:nvPr>
        </p:nvSpPr>
        <p:spPr>
          <a:xfrm>
            <a:off x="628650" y="365126"/>
            <a:ext cx="7886700" cy="1325563"/>
          </a:xfrm>
        </p:spPr>
        <p:txBody>
          <a:bodyPr/>
          <a:lstStyle/>
          <a:p>
            <a:pPr algn="r"/>
            <a:r>
              <a:rPr lang="en-US" dirty="0">
                <a:solidFill>
                  <a:schemeClr val="tx2">
                    <a:lumMod val="90000"/>
                  </a:schemeClr>
                </a:solidFill>
                <a:effectLst/>
              </a:rPr>
              <a:t>Strategy for Uncovering </a:t>
            </a:r>
            <a:br>
              <a:rPr lang="en-US" dirty="0">
                <a:solidFill>
                  <a:schemeClr val="tx2">
                    <a:lumMod val="90000"/>
                  </a:schemeClr>
                </a:solidFill>
                <a:effectLst/>
              </a:rPr>
            </a:br>
            <a:r>
              <a:rPr lang="en-US" dirty="0">
                <a:solidFill>
                  <a:schemeClr val="tx2">
                    <a:lumMod val="90000"/>
                  </a:schemeClr>
                </a:solidFill>
                <a:effectLst/>
              </a:rPr>
              <a:t>Interests</a:t>
            </a:r>
            <a:endParaRPr lang="en-US" dirty="0">
              <a:solidFill>
                <a:schemeClr val="tx2">
                  <a:lumMod val="90000"/>
                </a:schemeClr>
              </a:solidFill>
            </a:endParaRPr>
          </a:p>
        </p:txBody>
      </p:sp>
      <p:sp>
        <p:nvSpPr>
          <p:cNvPr id="4" name="Title 1">
            <a:extLst>
              <a:ext uri="{FF2B5EF4-FFF2-40B4-BE49-F238E27FC236}">
                <a16:creationId xmlns:a16="http://schemas.microsoft.com/office/drawing/2014/main" id="{64C82B84-6970-4763-B1D5-A57C227D561C}"/>
              </a:ext>
            </a:extLst>
          </p:cNvPr>
          <p:cNvSpPr txBox="1">
            <a:spLocks/>
          </p:cNvSpPr>
          <p:nvPr/>
        </p:nvSpPr>
        <p:spPr bwMode="auto">
          <a:xfrm>
            <a:off x="381000" y="2057400"/>
            <a:ext cx="8382000" cy="6556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mj-lt"/>
                <a:ea typeface="+mj-ea"/>
                <a:cs typeface="+mj-cs"/>
              </a:defRPr>
            </a:lvl1pPr>
            <a:lvl2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2pPr>
            <a:lvl3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3pPr>
            <a:lvl4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4pPr>
            <a:lvl5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5pPr>
            <a:lvl6pPr marL="4572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6pPr>
            <a:lvl7pPr marL="9144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7pPr>
            <a:lvl8pPr marL="13716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8pPr>
            <a:lvl9pPr marL="18288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9pPr>
          </a:lstStyle>
          <a:p>
            <a:pPr algn="l"/>
            <a:r>
              <a:rPr lang="en-US" sz="4000" kern="0" dirty="0">
                <a:solidFill>
                  <a:schemeClr val="tx1"/>
                </a:solidFill>
                <a:effectLst/>
              </a:rPr>
              <a:t>Breakout  Exercise: The Case of          Mr. Roberts</a:t>
            </a:r>
            <a:endParaRPr lang="en-US" sz="4000" kern="0" dirty="0">
              <a:solidFill>
                <a:schemeClr val="tx1"/>
              </a:solidFill>
            </a:endParaRPr>
          </a:p>
        </p:txBody>
      </p:sp>
      <p:sp>
        <p:nvSpPr>
          <p:cNvPr id="5" name="Title 1">
            <a:extLst>
              <a:ext uri="{FF2B5EF4-FFF2-40B4-BE49-F238E27FC236}">
                <a16:creationId xmlns:a16="http://schemas.microsoft.com/office/drawing/2014/main" id="{C88D06C4-3B61-4249-A8F8-44138D347452}"/>
              </a:ext>
            </a:extLst>
          </p:cNvPr>
          <p:cNvSpPr txBox="1">
            <a:spLocks/>
          </p:cNvSpPr>
          <p:nvPr/>
        </p:nvSpPr>
        <p:spPr bwMode="auto">
          <a:xfrm>
            <a:off x="1219200" y="4038600"/>
            <a:ext cx="6172200" cy="6556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mj-lt"/>
                <a:ea typeface="+mj-ea"/>
                <a:cs typeface="+mj-cs"/>
              </a:defRPr>
            </a:lvl1pPr>
            <a:lvl2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2pPr>
            <a:lvl3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3pPr>
            <a:lvl4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4pPr>
            <a:lvl5pPr algn="ctr" rtl="0" eaLnBrk="0" fontAlgn="base" hangingPunct="0">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5pPr>
            <a:lvl6pPr marL="4572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6pPr>
            <a:lvl7pPr marL="9144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7pPr>
            <a:lvl8pPr marL="13716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8pPr>
            <a:lvl9pPr marL="1828800" algn="ctr" rtl="0" fontAlgn="base">
              <a:spcBef>
                <a:spcPct val="0"/>
              </a:spcBef>
              <a:spcAft>
                <a:spcPct val="0"/>
              </a:spcAft>
              <a:defRPr sz="4400">
                <a:solidFill>
                  <a:schemeClr val="tx2"/>
                </a:solidFill>
                <a:effectLst>
                  <a:outerShdw blurRad="38100" dist="38100" dir="2700000" algn="tl">
                    <a:srgbClr val="000000"/>
                  </a:outerShdw>
                </a:effectLst>
                <a:latin typeface="Tahoma" pitchFamily="34" charset="0"/>
                <a:cs typeface="Arial" charset="0"/>
              </a:defRPr>
            </a:lvl9pPr>
          </a:lstStyle>
          <a:p>
            <a:pPr marL="230188" indent="-230188" algn="l">
              <a:buFont typeface="Arial" panose="020B0604020202020204" pitchFamily="34" charset="0"/>
              <a:buChar char="•"/>
            </a:pPr>
            <a:r>
              <a:rPr lang="en-US" sz="2800" kern="0" dirty="0">
                <a:solidFill>
                  <a:schemeClr val="tx1"/>
                </a:solidFill>
                <a:effectLst/>
              </a:rPr>
              <a:t>Forming small groups, use the case of Mr. Roberts to uncover the interests of the stakeholders:</a:t>
            </a:r>
          </a:p>
          <a:p>
            <a:pPr marL="684213" lvl="1" indent="-227013" algn="l">
              <a:buFont typeface="Wingdings" panose="05000000000000000000" pitchFamily="2" charset="2"/>
              <a:buChar char="§"/>
            </a:pPr>
            <a:r>
              <a:rPr lang="en-US" sz="2000" kern="0" dirty="0">
                <a:solidFill>
                  <a:schemeClr val="tx1"/>
                </a:solidFill>
                <a:effectLst/>
              </a:rPr>
              <a:t>What are Dr. Richards’ interests in refusing dialysis? </a:t>
            </a:r>
          </a:p>
          <a:p>
            <a:pPr marL="684213" lvl="1" indent="-227013" algn="l">
              <a:buFont typeface="Wingdings" panose="05000000000000000000" pitchFamily="2" charset="2"/>
              <a:buChar char="§"/>
            </a:pPr>
            <a:r>
              <a:rPr lang="en-US" sz="2000" kern="0" dirty="0">
                <a:solidFill>
                  <a:schemeClr val="tx1"/>
                </a:solidFill>
                <a:effectLst/>
              </a:rPr>
              <a:t>What are Mrs. Roberts’ interests in insisting on dialysis?</a:t>
            </a:r>
          </a:p>
        </p:txBody>
      </p:sp>
    </p:spTree>
    <p:extLst>
      <p:ext uri="{BB962C8B-B14F-4D97-AF65-F5344CB8AC3E}">
        <p14:creationId xmlns:p14="http://schemas.microsoft.com/office/powerpoint/2010/main" val="26993644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533400"/>
            <a:ext cx="8362950" cy="1325563"/>
          </a:xfrm>
        </p:spPr>
        <p:txBody>
          <a:bodyPr/>
          <a:lstStyle/>
          <a:p>
            <a:r>
              <a:rPr lang="en-US" b="1" dirty="0">
                <a:effectLst/>
              </a:rPr>
              <a:t>The Problem of Working with “Difficult” Patients &amp; Families</a:t>
            </a:r>
            <a:endParaRPr lang="en-US" dirty="0"/>
          </a:p>
        </p:txBody>
      </p:sp>
      <p:sp>
        <p:nvSpPr>
          <p:cNvPr id="3" name="Content Placeholder 2"/>
          <p:cNvSpPr>
            <a:spLocks noGrp="1"/>
          </p:cNvSpPr>
          <p:nvPr>
            <p:ph idx="1"/>
          </p:nvPr>
        </p:nvSpPr>
        <p:spPr>
          <a:xfrm>
            <a:off x="304800" y="2057400"/>
            <a:ext cx="8229600" cy="4038600"/>
          </a:xfrm>
        </p:spPr>
        <p:txBody>
          <a:bodyPr>
            <a:normAutofit/>
          </a:bodyPr>
          <a:lstStyle/>
          <a:p>
            <a:pPr marL="350838" lvl="1" indent="-292100">
              <a:spcBef>
                <a:spcPts val="1200"/>
              </a:spcBef>
              <a:spcAft>
                <a:spcPts val="1200"/>
              </a:spcAft>
              <a:buClr>
                <a:srgbClr val="FFC000"/>
              </a:buClr>
              <a:buFont typeface="Wingdings" panose="05000000000000000000" pitchFamily="2" charset="2"/>
              <a:buChar char="Ø"/>
            </a:pPr>
            <a:r>
              <a:rPr lang="en-US" sz="2400" dirty="0">
                <a:effectLst/>
              </a:rPr>
              <a:t>Between 15%-60% of patients are considered “difficult” by their treating physicians (</a:t>
            </a:r>
            <a:r>
              <a:rPr lang="en-US" sz="2400" dirty="0">
                <a:effectLst/>
                <a:ea typeface="Calibri" panose="020F0502020204030204" pitchFamily="34" charset="0"/>
              </a:rPr>
              <a:t>Hahn 2001)</a:t>
            </a:r>
            <a:endParaRPr lang="en-US" sz="2400" dirty="0">
              <a:effectLst/>
            </a:endParaRPr>
          </a:p>
          <a:p>
            <a:pPr marL="350838" lvl="1" indent="-292100">
              <a:spcBef>
                <a:spcPts val="1200"/>
              </a:spcBef>
              <a:spcAft>
                <a:spcPts val="1200"/>
              </a:spcAft>
              <a:buClr>
                <a:srgbClr val="FFC000"/>
              </a:buClr>
              <a:buFont typeface="Wingdings" panose="05000000000000000000" pitchFamily="2" charset="2"/>
              <a:buChar char="Ø"/>
            </a:pPr>
            <a:r>
              <a:rPr lang="en-US" sz="2400" dirty="0">
                <a:effectLst/>
                <a:ea typeface="MS Mincho" panose="02020609040205080304" pitchFamily="49" charset="-128"/>
              </a:rPr>
              <a:t>Nurses, physicians, and other staff members are subjected to repeated bouts of discourtesy, abusive language, and disrespectful interactions</a:t>
            </a:r>
          </a:p>
          <a:p>
            <a:pPr marL="350838" lvl="1" indent="-292100">
              <a:spcBef>
                <a:spcPts val="1200"/>
              </a:spcBef>
              <a:spcAft>
                <a:spcPts val="1200"/>
              </a:spcAft>
              <a:buClr>
                <a:srgbClr val="FFC000"/>
              </a:buClr>
              <a:buFont typeface="Wingdings" panose="05000000000000000000" pitchFamily="2" charset="2"/>
              <a:buChar char="Ø"/>
            </a:pPr>
            <a:r>
              <a:rPr lang="en-US" sz="2400" dirty="0">
                <a:effectLst/>
                <a:ea typeface="MS Mincho" panose="02020609040205080304" pitchFamily="49" charset="-128"/>
              </a:rPr>
              <a:t>Consequences: psychological distress and work burnout (</a:t>
            </a:r>
            <a:r>
              <a:rPr lang="en-US" sz="2400" dirty="0" err="1">
                <a:effectLst/>
                <a:ea typeface="MS Mincho" panose="02020609040205080304" pitchFamily="49" charset="-128"/>
              </a:rPr>
              <a:t>Nowrouzi</a:t>
            </a:r>
            <a:r>
              <a:rPr lang="en-US" sz="2400" dirty="0">
                <a:effectLst/>
                <a:ea typeface="MS Mincho" panose="02020609040205080304" pitchFamily="49" charset="-128"/>
              </a:rPr>
              <a:t> et al 2015;West, </a:t>
            </a:r>
            <a:r>
              <a:rPr lang="en-US" sz="2400" dirty="0" err="1">
                <a:effectLst/>
                <a:ea typeface="MS Mincho" panose="02020609040205080304" pitchFamily="49" charset="-128"/>
              </a:rPr>
              <a:t>Dyrbye</a:t>
            </a:r>
            <a:r>
              <a:rPr lang="en-US" sz="2400" dirty="0">
                <a:effectLst/>
                <a:ea typeface="MS Mincho" panose="02020609040205080304" pitchFamily="49" charset="-128"/>
              </a:rPr>
              <a:t>, and </a:t>
            </a:r>
            <a:r>
              <a:rPr lang="en-US" sz="2400" dirty="0" err="1">
                <a:effectLst/>
                <a:ea typeface="MS Mincho" panose="02020609040205080304" pitchFamily="49" charset="-128"/>
              </a:rPr>
              <a:t>Shanafelt</a:t>
            </a:r>
            <a:r>
              <a:rPr lang="en-US" sz="2400" dirty="0">
                <a:effectLst/>
                <a:ea typeface="MS Mincho" panose="02020609040205080304" pitchFamily="49" charset="-128"/>
              </a:rPr>
              <a:t> 2018; Fitzpatrick, </a:t>
            </a:r>
            <a:r>
              <a:rPr lang="en-US" sz="2400" dirty="0" err="1">
                <a:effectLst/>
                <a:ea typeface="MS Mincho" panose="02020609040205080304" pitchFamily="49" charset="-128"/>
              </a:rPr>
              <a:t>Bloore</a:t>
            </a:r>
            <a:r>
              <a:rPr lang="en-US" sz="2400" dirty="0">
                <a:effectLst/>
                <a:ea typeface="MS Mincho" panose="02020609040205080304" pitchFamily="49" charset="-128"/>
              </a:rPr>
              <a:t> and Blake 2019; Yates 2020; </a:t>
            </a:r>
            <a:r>
              <a:rPr lang="en-US" sz="2400" dirty="0" err="1">
                <a:effectLst/>
                <a:ea typeface="MS Mincho" panose="02020609040205080304" pitchFamily="49" charset="-128"/>
              </a:rPr>
              <a:t>Dall’Ora</a:t>
            </a:r>
            <a:r>
              <a:rPr lang="en-US" sz="2400" dirty="0">
                <a:effectLst/>
                <a:ea typeface="MS Mincho" panose="02020609040205080304" pitchFamily="49" charset="-128"/>
              </a:rPr>
              <a:t> et al 2020)</a:t>
            </a:r>
            <a:endParaRPr lang="en-US" sz="2400" dirty="0"/>
          </a:p>
        </p:txBody>
      </p:sp>
    </p:spTree>
    <p:extLst>
      <p:ext uri="{BB962C8B-B14F-4D97-AF65-F5344CB8AC3E}">
        <p14:creationId xmlns:p14="http://schemas.microsoft.com/office/powerpoint/2010/main" val="1256006694"/>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140291" name="Rectangle 3"/>
          <p:cNvSpPr>
            <a:spLocks noGrp="1" noChangeArrowheads="1"/>
          </p:cNvSpPr>
          <p:nvPr>
            <p:ph idx="1"/>
          </p:nvPr>
        </p:nvSpPr>
        <p:spPr>
          <a:xfrm>
            <a:off x="114300" y="1447800"/>
            <a:ext cx="8915400" cy="6477000"/>
          </a:xfrm>
        </p:spPr>
        <p:txBody>
          <a:bodyPr/>
          <a:lstStyle/>
          <a:p>
            <a:pPr marL="227013" indent="-227013"/>
            <a:r>
              <a:rPr lang="en-US" sz="1850" dirty="0">
                <a:effectLst/>
              </a:rPr>
              <a:t>John Roberts is a 73-year-old man who presented to the hospital with respiratory distress.  He required intubation and mechanical ventilation upon arrival.  Subsequently, he underwent a battery of tests that diagnosed metastatic lung cancer.  His hospitalization has been complicated by pneumothorax, venous thromboembolism, cardiac arrhythmias, anemia, pneumonia, and severe malnutrition.  He has undergone multiple procedures including a tracheostomy and feeding tube placement.  One month into his course of treatment, he has persistent respiratory failure and remains ventilator dependent.  Additionally, he has now developed acute renal failure that requires renal replacement therapy to sustain life.  He is otherwise hemodynamically stable.  His wife has medical power of attorney.  During previous conversations, his wife has stated a strong desire to continue aggressive therapy and indicated that her best understanding of the patient’s wishes would be to continue with aggressive therapy indefinitely. Now she is insisting on dialysis. Dr. Richards feels that hemodialysis will not alter the patient’s prognosis.  He has metastatic cancer and is too unstable to safely receive even palliative chemotherapy.  His life expectancy is weeks, and while withholding this life-sustaining treatment could hasten his demise, it will not change the outcome of certain death, as a direct result of complications from his lung cancer.  Therefore, Dr. Richards is refusing the dialysis. </a:t>
            </a:r>
            <a:endParaRPr lang="en-US" sz="2200" dirty="0">
              <a:effectLst/>
            </a:endParaRPr>
          </a:p>
        </p:txBody>
      </p:sp>
      <p:sp>
        <p:nvSpPr>
          <p:cNvPr id="3" name="Rectangle 2">
            <a:extLst>
              <a:ext uri="{FF2B5EF4-FFF2-40B4-BE49-F238E27FC236}">
                <a16:creationId xmlns:a16="http://schemas.microsoft.com/office/drawing/2014/main" id="{43C27CD9-6A42-46EF-9A21-D6555C55C227}"/>
              </a:ext>
            </a:extLst>
          </p:cNvPr>
          <p:cNvSpPr>
            <a:spLocks noGrp="1" noChangeArrowheads="1"/>
          </p:cNvSpPr>
          <p:nvPr>
            <p:ph type="title"/>
          </p:nvPr>
        </p:nvSpPr>
        <p:spPr>
          <a:xfrm>
            <a:off x="217714" y="152400"/>
            <a:ext cx="7467600" cy="914400"/>
          </a:xfrm>
        </p:spPr>
        <p:txBody>
          <a:bodyPr/>
          <a:lstStyle/>
          <a:p>
            <a:pPr eaLnBrk="1" hangingPunct="1">
              <a:defRPr/>
            </a:pPr>
            <a:r>
              <a:rPr lang="en-US" sz="3600" dirty="0">
                <a:solidFill>
                  <a:schemeClr val="tx2">
                    <a:lumMod val="75000"/>
                  </a:schemeClr>
                </a:solidFill>
              </a:rPr>
              <a:t>Case Study: Mr. Roberts</a:t>
            </a:r>
          </a:p>
        </p:txBody>
      </p:sp>
    </p:spTree>
    <p:extLst>
      <p:ext uri="{BB962C8B-B14F-4D97-AF65-F5344CB8AC3E}">
        <p14:creationId xmlns:p14="http://schemas.microsoft.com/office/powerpoint/2010/main" val="3348374752"/>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140291">
                                            <p:txEl>
                                              <p:pRg st="0" end="0"/>
                                            </p:txEl>
                                          </p:spTgt>
                                        </p:tgtEl>
                                        <p:attrNameLst>
                                          <p:attrName>style.visibility</p:attrName>
                                        </p:attrNameLst>
                                      </p:cBhvr>
                                      <p:to>
                                        <p:strVal val="visible"/>
                                      </p:to>
                                    </p:set>
                                    <p:animEffect transition="in" filter="fade">
                                      <p:cBhvr>
                                        <p:cTn id="7" dur="1000"/>
                                        <p:tgtEl>
                                          <p:spTgt spid="140291">
                                            <p:txEl>
                                              <p:pRg st="0" end="0"/>
                                            </p:txEl>
                                          </p:spTgt>
                                        </p:tgtEl>
                                      </p:cBhvr>
                                    </p:animEffect>
                                    <p:anim calcmode="lin" valueType="num">
                                      <p:cBhvr>
                                        <p:cTn id="8" dur="1000" fill="hold"/>
                                        <p:tgtEl>
                                          <p:spTgt spid="140291">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140291">
                                            <p:txEl>
                                              <p:pRg st="0" end="0"/>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0291" grpId="0" build="p"/>
    </p:bld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513"/>
        <p:cNvGrpSpPr/>
        <p:nvPr/>
      </p:nvGrpSpPr>
      <p:grpSpPr>
        <a:xfrm>
          <a:off x="0" y="0"/>
          <a:ext cx="0" cy="0"/>
          <a:chOff x="0" y="0"/>
          <a:chExt cx="0" cy="0"/>
        </a:xfrm>
      </p:grpSpPr>
      <p:sp>
        <p:nvSpPr>
          <p:cNvPr id="514" name="Google Shape;514;gc0a949d52d_0_1"/>
          <p:cNvSpPr txBox="1">
            <a:spLocks noGrp="1"/>
          </p:cNvSpPr>
          <p:nvPr>
            <p:ph type="title"/>
          </p:nvPr>
        </p:nvSpPr>
        <p:spPr>
          <a:xfrm>
            <a:off x="294047" y="459814"/>
            <a:ext cx="7630753" cy="497502"/>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SzPts val="1800"/>
              <a:buNone/>
            </a:pPr>
            <a:r>
              <a:rPr lang="en-US" sz="3600" b="1" dirty="0"/>
              <a:t>Takeaways for Reducing Clinical Conflict</a:t>
            </a:r>
            <a:endParaRPr sz="3600" b="1" dirty="0"/>
          </a:p>
        </p:txBody>
      </p:sp>
      <p:pic>
        <p:nvPicPr>
          <p:cNvPr id="515" name="Google Shape;515;gc0a949d52d_0_1" descr="AMCLogo"/>
          <p:cNvPicPr preferRelativeResize="0"/>
          <p:nvPr/>
        </p:nvPicPr>
        <p:blipFill rotWithShape="1">
          <a:blip r:embed="rId3">
            <a:alphaModFix/>
          </a:blip>
          <a:srcRect/>
          <a:stretch/>
        </p:blipFill>
        <p:spPr>
          <a:xfrm>
            <a:off x="7848600" y="284327"/>
            <a:ext cx="838200" cy="1148832"/>
          </a:xfrm>
          <a:prstGeom prst="rect">
            <a:avLst/>
          </a:prstGeom>
          <a:noFill/>
          <a:ln>
            <a:noFill/>
          </a:ln>
        </p:spPr>
      </p:pic>
      <p:grpSp>
        <p:nvGrpSpPr>
          <p:cNvPr id="516" name="Google Shape;516;gc0a949d52d_0_1"/>
          <p:cNvGrpSpPr/>
          <p:nvPr/>
        </p:nvGrpSpPr>
        <p:grpSpPr>
          <a:xfrm>
            <a:off x="960441" y="2337997"/>
            <a:ext cx="1908405" cy="1375802"/>
            <a:chOff x="1496688" y="1244660"/>
            <a:chExt cx="1451700" cy="972367"/>
          </a:xfrm>
        </p:grpSpPr>
        <p:sp>
          <p:nvSpPr>
            <p:cNvPr id="517" name="Google Shape;517;gc0a949d52d_0_1"/>
            <p:cNvSpPr txBox="1"/>
            <p:nvPr/>
          </p:nvSpPr>
          <p:spPr>
            <a:xfrm>
              <a:off x="1496688" y="1244660"/>
              <a:ext cx="1451700" cy="4599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100"/>
                <a:buFont typeface="Arial"/>
                <a:buNone/>
              </a:pPr>
              <a:r>
                <a:rPr lang="en-US" sz="1100" b="1" i="0" u="none" strike="noStrike" cap="none">
                  <a:solidFill>
                    <a:srgbClr val="FFFFFF"/>
                  </a:solidFill>
                  <a:latin typeface="Roboto"/>
                  <a:ea typeface="Roboto"/>
                  <a:cs typeface="Roboto"/>
                  <a:sym typeface="Roboto"/>
                </a:rPr>
                <a:t>Myanmar Identity </a:t>
              </a:r>
              <a:endParaRPr sz="1100" b="0" i="0" u="none" strike="noStrike" cap="none">
                <a:solidFill>
                  <a:srgbClr val="FFFFFF"/>
                </a:solidFill>
                <a:latin typeface="Roboto"/>
                <a:ea typeface="Roboto"/>
                <a:cs typeface="Roboto"/>
                <a:sym typeface="Roboto"/>
              </a:endParaRPr>
            </a:p>
          </p:txBody>
        </p:sp>
        <p:sp>
          <p:nvSpPr>
            <p:cNvPr id="518" name="Google Shape;518;gc0a949d52d_0_1"/>
            <p:cNvSpPr txBox="1"/>
            <p:nvPr/>
          </p:nvSpPr>
          <p:spPr>
            <a:xfrm>
              <a:off x="1496688" y="1704627"/>
              <a:ext cx="1451700" cy="512400"/>
            </a:xfrm>
            <a:prstGeom prst="rect">
              <a:avLst/>
            </a:prstGeom>
            <a:noFill/>
            <a:ln>
              <a:noFill/>
            </a:ln>
          </p:spPr>
          <p:txBody>
            <a:bodyPr spcFirstLastPara="1" wrap="square" lIns="91425" tIns="91425" rIns="91425" bIns="91425" anchor="t" anchorCtr="0">
              <a:noAutofit/>
            </a:bodyPr>
            <a:lstStyle/>
            <a:p>
              <a:pPr marL="0" marR="0" lvl="0" indent="0" algn="l" rtl="0">
                <a:lnSpc>
                  <a:spcPct val="115000"/>
                </a:lnSpc>
                <a:spcBef>
                  <a:spcPts val="0"/>
                </a:spcBef>
                <a:spcAft>
                  <a:spcPts val="1600"/>
                </a:spcAft>
                <a:buClr>
                  <a:srgbClr val="000000"/>
                </a:buClr>
                <a:buSzPts val="800"/>
                <a:buFont typeface="Arial"/>
                <a:buNone/>
              </a:pPr>
              <a:endParaRPr sz="800" b="0" i="0" u="none" strike="noStrike" cap="none">
                <a:solidFill>
                  <a:srgbClr val="FFFFFF"/>
                </a:solidFill>
                <a:latin typeface="Roboto"/>
                <a:ea typeface="Roboto"/>
                <a:cs typeface="Roboto"/>
                <a:sym typeface="Roboto"/>
              </a:endParaRPr>
            </a:p>
          </p:txBody>
        </p:sp>
      </p:grpSp>
      <p:sp>
        <p:nvSpPr>
          <p:cNvPr id="519" name="Google Shape;519;gc0a949d52d_0_1"/>
          <p:cNvSpPr/>
          <p:nvPr/>
        </p:nvSpPr>
        <p:spPr>
          <a:xfrm>
            <a:off x="7351575" y="96700"/>
            <a:ext cx="1714500" cy="1513800"/>
          </a:xfrm>
          <a:prstGeom prst="rect">
            <a:avLst/>
          </a:prstGeom>
          <a:solidFill>
            <a:srgbClr val="FFFFFF"/>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aphicFrame>
        <p:nvGraphicFramePr>
          <p:cNvPr id="2" name="Diagram 1">
            <a:extLst>
              <a:ext uri="{FF2B5EF4-FFF2-40B4-BE49-F238E27FC236}">
                <a16:creationId xmlns:a16="http://schemas.microsoft.com/office/drawing/2014/main" id="{65C77B77-17A8-4921-B633-D4B8018182C2}"/>
              </a:ext>
            </a:extLst>
          </p:cNvPr>
          <p:cNvGraphicFramePr/>
          <p:nvPr>
            <p:extLst>
              <p:ext uri="{D42A27DB-BD31-4B8C-83A1-F6EECF244321}">
                <p14:modId xmlns:p14="http://schemas.microsoft.com/office/powerpoint/2010/main" val="2248544768"/>
              </p:ext>
            </p:extLst>
          </p:nvPr>
        </p:nvGraphicFramePr>
        <p:xfrm>
          <a:off x="294047" y="1219200"/>
          <a:ext cx="8468953" cy="5354473"/>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12290" name="Rectangle 2"/>
          <p:cNvSpPr>
            <a:spLocks noGrp="1" noChangeArrowheads="1"/>
          </p:cNvSpPr>
          <p:nvPr>
            <p:ph type="title"/>
          </p:nvPr>
        </p:nvSpPr>
        <p:spPr>
          <a:xfrm>
            <a:off x="152400" y="228600"/>
            <a:ext cx="8229600" cy="609600"/>
          </a:xfrm>
        </p:spPr>
        <p:txBody>
          <a:bodyPr>
            <a:normAutofit fontScale="90000"/>
          </a:bodyPr>
          <a:lstStyle/>
          <a:p>
            <a:pPr eaLnBrk="1" hangingPunct="1">
              <a:defRPr/>
            </a:pPr>
            <a:r>
              <a:rPr lang="en-US" sz="4000"/>
              <a:t>Works Cited</a:t>
            </a:r>
            <a:endParaRPr lang="en-US" sz="4000" dirty="0"/>
          </a:p>
        </p:txBody>
      </p:sp>
      <p:sp>
        <p:nvSpPr>
          <p:cNvPr id="12292" name="Rectangle 4"/>
          <p:cNvSpPr>
            <a:spLocks noGrp="1" noChangeArrowheads="1"/>
          </p:cNvSpPr>
          <p:nvPr>
            <p:ph idx="1"/>
          </p:nvPr>
        </p:nvSpPr>
        <p:spPr>
          <a:xfrm>
            <a:off x="0" y="1066800"/>
            <a:ext cx="9144000" cy="5762171"/>
          </a:xfrm>
        </p:spPr>
        <p:txBody>
          <a:bodyPr>
            <a:normAutofit fontScale="77500" lnSpcReduction="20000"/>
          </a:bodyPr>
          <a:lstStyle/>
          <a:p>
            <a:pPr lvl="0"/>
            <a:r>
              <a:rPr lang="en-US" dirty="0"/>
              <a:t>Blackall, GF, Green, MJ. ”Difficult” patients or difficult relationships?, </a:t>
            </a:r>
            <a:r>
              <a:rPr lang="en-US" i="1" dirty="0"/>
              <a:t>American Journal of Bioethics</a:t>
            </a:r>
            <a:r>
              <a:rPr lang="en-US" dirty="0"/>
              <a:t>, 2012; 12:5, 8-9.</a:t>
            </a:r>
          </a:p>
          <a:p>
            <a:pPr lvl="0"/>
            <a:r>
              <a:rPr lang="en-US" dirty="0" err="1"/>
              <a:t>Dall’Ora</a:t>
            </a:r>
            <a:r>
              <a:rPr lang="en-US" dirty="0"/>
              <a:t> C, Ball J, </a:t>
            </a:r>
            <a:r>
              <a:rPr lang="en-US" dirty="0" err="1"/>
              <a:t>Reinius</a:t>
            </a:r>
            <a:r>
              <a:rPr lang="en-US" dirty="0"/>
              <a:t> M, Griffiths P. Burnout in nursing: a theoretical review. </a:t>
            </a:r>
            <a:r>
              <a:rPr lang="en-US" i="1" dirty="0"/>
              <a:t>Human Resources for Health</a:t>
            </a:r>
            <a:r>
              <a:rPr lang="en-US" dirty="0"/>
              <a:t>. 2020;18(1):41. </a:t>
            </a:r>
          </a:p>
          <a:p>
            <a:pPr lvl="0"/>
            <a:r>
              <a:rPr lang="en-US" dirty="0"/>
              <a:t>Elder N, Ricer R, Tobias B. How respected family physicians manage difficult patient encounters. </a:t>
            </a:r>
            <a:r>
              <a:rPr lang="en-US" i="1" dirty="0"/>
              <a:t>J Am Board Fam Med</a:t>
            </a:r>
            <a:r>
              <a:rPr lang="en-US" dirty="0"/>
              <a:t>. 2006;19(6):533-41.</a:t>
            </a:r>
          </a:p>
          <a:p>
            <a:pPr lvl="0"/>
            <a:r>
              <a:rPr lang="en-US" dirty="0"/>
              <a:t>Fiester, A. The “Difficult” Patient reconceived: An expanded mandate for clinical ethics.  </a:t>
            </a:r>
            <a:r>
              <a:rPr lang="en-US" i="1" dirty="0"/>
              <a:t>American Journal of Bioethics</a:t>
            </a:r>
            <a:r>
              <a:rPr lang="en-US" dirty="0"/>
              <a:t> 2012; 12(5): 2-7.</a:t>
            </a:r>
          </a:p>
          <a:p>
            <a:pPr lvl="0"/>
            <a:r>
              <a:rPr lang="en-US" dirty="0"/>
              <a:t>Fisher, R, </a:t>
            </a:r>
            <a:r>
              <a:rPr lang="en-US" dirty="0" err="1"/>
              <a:t>Ury</a:t>
            </a:r>
            <a:r>
              <a:rPr lang="en-US" dirty="0"/>
              <a:t>, W. </a:t>
            </a:r>
            <a:r>
              <a:rPr lang="en-US" i="1" dirty="0"/>
              <a:t>Getting to Yes: Negotiating Agreement Without Giving In</a:t>
            </a:r>
            <a:r>
              <a:rPr lang="en-US" dirty="0"/>
              <a:t> (New York: Penguin Books, 1983).</a:t>
            </a:r>
          </a:p>
          <a:p>
            <a:pPr lvl="0"/>
            <a:r>
              <a:rPr lang="en-US" dirty="0" err="1"/>
              <a:t>Gunderman</a:t>
            </a:r>
            <a:r>
              <a:rPr lang="en-US" dirty="0"/>
              <a:t> RB, </a:t>
            </a:r>
            <a:r>
              <a:rPr lang="en-US" dirty="0" err="1"/>
              <a:t>Gunderman</a:t>
            </a:r>
            <a:r>
              <a:rPr lang="en-US" dirty="0"/>
              <a:t> PR. Forty Years since “Taking care of the hateful patient.” </a:t>
            </a:r>
            <a:r>
              <a:rPr lang="en-US" i="1" dirty="0"/>
              <a:t>AMA J Ethics</a:t>
            </a:r>
            <a:r>
              <a:rPr lang="en-US" dirty="0"/>
              <a:t>. 2017;19(4):369-373.</a:t>
            </a:r>
          </a:p>
          <a:p>
            <a:pPr lvl="0"/>
            <a:r>
              <a:rPr lang="en-US" dirty="0"/>
              <a:t>Haas LJ, </a:t>
            </a:r>
            <a:r>
              <a:rPr lang="en-US" dirty="0" err="1"/>
              <a:t>Leiser</a:t>
            </a:r>
            <a:r>
              <a:rPr lang="en-US" dirty="0"/>
              <a:t> J, Magill MK, </a:t>
            </a:r>
            <a:r>
              <a:rPr lang="en-US" dirty="0" err="1"/>
              <a:t>Sanyer</a:t>
            </a:r>
            <a:r>
              <a:rPr lang="en-US" dirty="0"/>
              <a:t> ON. Management of the Difficult Patient. </a:t>
            </a:r>
            <a:r>
              <a:rPr lang="en-US" i="1" dirty="0"/>
              <a:t>AFP</a:t>
            </a:r>
            <a:r>
              <a:rPr lang="en-US" dirty="0"/>
              <a:t>. 2005;72(10):2063-2068.</a:t>
            </a:r>
          </a:p>
          <a:p>
            <a:pPr lvl="0"/>
            <a:r>
              <a:rPr lang="en-US" dirty="0"/>
              <a:t>Hahn, S.R., K.S. Thompson, T.A. Wills, V. Tern, and N. S. </a:t>
            </a:r>
            <a:r>
              <a:rPr lang="en-US" dirty="0" err="1"/>
              <a:t>Budner</a:t>
            </a:r>
            <a:r>
              <a:rPr lang="en-US" dirty="0"/>
              <a:t>. 1994. The difficult doctor-patient relationship: somatization, personality and psychopathology. </a:t>
            </a:r>
            <a:r>
              <a:rPr lang="en-US" i="1" dirty="0"/>
              <a:t>Journal of Clinical Epidemiology</a:t>
            </a:r>
            <a:r>
              <a:rPr lang="en-US" dirty="0"/>
              <a:t> 47: 647-657.</a:t>
            </a:r>
          </a:p>
          <a:p>
            <a:pPr lvl="0"/>
            <a:r>
              <a:rPr lang="en-US" dirty="0" err="1"/>
              <a:t>Miksanek</a:t>
            </a:r>
            <a:r>
              <a:rPr lang="en-US" dirty="0"/>
              <a:t>, T. On caring for “difficult” patients. </a:t>
            </a:r>
            <a:r>
              <a:rPr lang="en-US" i="1" dirty="0"/>
              <a:t>Health Affairs. </a:t>
            </a:r>
            <a:r>
              <a:rPr lang="en-US" dirty="0"/>
              <a:t> 2008; 27: 1422-1428.</a:t>
            </a:r>
          </a:p>
          <a:p>
            <a:pPr lvl="0"/>
            <a:r>
              <a:rPr lang="en-US" dirty="0" err="1"/>
              <a:t>Nowrouzi</a:t>
            </a:r>
            <a:r>
              <a:rPr lang="en-US" dirty="0"/>
              <a:t> B, Lightfoot N, </a:t>
            </a:r>
            <a:r>
              <a:rPr lang="en-US" dirty="0" err="1"/>
              <a:t>Larivière</a:t>
            </a:r>
            <a:r>
              <a:rPr lang="en-US" dirty="0"/>
              <a:t> M, et al. Occupational Stress Management and Burnout Interventions in Nursing and Their Implications for Healthy Work Environments: A Literature Review. </a:t>
            </a:r>
            <a:r>
              <a:rPr lang="en-US" i="1" dirty="0"/>
              <a:t>Workplace Health </a:t>
            </a:r>
            <a:r>
              <a:rPr lang="en-US" i="1" dirty="0" err="1"/>
              <a:t>Saf</a:t>
            </a:r>
            <a:r>
              <a:rPr lang="en-US" dirty="0"/>
              <a:t>. 2015;63(7):308-315. </a:t>
            </a:r>
          </a:p>
          <a:p>
            <a:pPr lvl="0"/>
            <a:r>
              <a:rPr lang="en-US" dirty="0" err="1"/>
              <a:t>Strous</a:t>
            </a:r>
            <a:r>
              <a:rPr lang="en-US" dirty="0"/>
              <a:t> RD, Ulman A-M, Kotler M. The hateful patient revisited: Relevance for 21st century medicine. </a:t>
            </a:r>
            <a:r>
              <a:rPr lang="en-US" i="1" dirty="0"/>
              <a:t>Eur J Intern Med</a:t>
            </a:r>
            <a:r>
              <a:rPr lang="en-US" dirty="0"/>
              <a:t>. 2006;17(6):387-393. </a:t>
            </a:r>
          </a:p>
          <a:p>
            <a:pPr lvl="0"/>
            <a:r>
              <a:rPr lang="en-US" dirty="0" err="1"/>
              <a:t>Wasan</a:t>
            </a:r>
            <a:r>
              <a:rPr lang="en-US" dirty="0"/>
              <a:t> AD,  Wootton J, Jamison, RN. Dealing with difficult patients in your pain practice. </a:t>
            </a:r>
            <a:r>
              <a:rPr lang="en-US" i="1" dirty="0"/>
              <a:t>Regional Anesthesia and Pain Medicine</a:t>
            </a:r>
            <a:r>
              <a:rPr lang="en-US" dirty="0"/>
              <a:t>. 2005;</a:t>
            </a:r>
            <a:r>
              <a:rPr lang="en-US" i="1" dirty="0"/>
              <a:t> </a:t>
            </a:r>
            <a:r>
              <a:rPr lang="en-US" dirty="0"/>
              <a:t>30: 184–192.</a:t>
            </a:r>
          </a:p>
          <a:p>
            <a:pPr lvl="0"/>
            <a:r>
              <a:rPr lang="en-US" dirty="0"/>
              <a:t>West CP, </a:t>
            </a:r>
            <a:r>
              <a:rPr lang="en-US" dirty="0" err="1"/>
              <a:t>Dyrbye</a:t>
            </a:r>
            <a:r>
              <a:rPr lang="en-US" dirty="0"/>
              <a:t> LN, </a:t>
            </a:r>
            <a:r>
              <a:rPr lang="en-US" dirty="0" err="1"/>
              <a:t>Shanafelt</a:t>
            </a:r>
            <a:r>
              <a:rPr lang="en-US" dirty="0"/>
              <a:t> TD. Physician burnout: contributors, consequences and solutions. </a:t>
            </a:r>
            <a:r>
              <a:rPr lang="en-US" i="1" dirty="0"/>
              <a:t>J Intern Med</a:t>
            </a:r>
            <a:r>
              <a:rPr lang="en-US" dirty="0"/>
              <a:t>. 2018;283(6):516-529. </a:t>
            </a:r>
            <a:endParaRPr lang="en-US" sz="2000" dirty="0">
              <a:effectLst/>
            </a:endParaRPr>
          </a:p>
          <a:p>
            <a:pPr marL="609600" indent="-609600">
              <a:defRPr/>
            </a:pPr>
            <a:endParaRPr lang="en-US" dirty="0"/>
          </a:p>
          <a:p>
            <a:pPr marL="609600" indent="-609600" eaLnBrk="1" hangingPunct="1">
              <a:lnSpc>
                <a:spcPct val="90000"/>
              </a:lnSpc>
              <a:defRPr/>
            </a:pPr>
            <a:endParaRPr lang="en-US" sz="2800" dirty="0">
              <a:effectLst/>
            </a:endParaRPr>
          </a:p>
        </p:txBody>
      </p:sp>
    </p:spTree>
    <p:extLst>
      <p:ext uri="{BB962C8B-B14F-4D97-AF65-F5344CB8AC3E}">
        <p14:creationId xmlns:p14="http://schemas.microsoft.com/office/powerpoint/2010/main" val="20793212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12290"/>
                                        </p:tgtEl>
                                        <p:attrNameLst>
                                          <p:attrName>style.visibility</p:attrName>
                                        </p:attrNameLst>
                                      </p:cBhvr>
                                      <p:to>
                                        <p:strVal val="visible"/>
                                      </p:to>
                                    </p:set>
                                    <p:animEffect transition="in" filter="fade">
                                      <p:cBhvr>
                                        <p:cTn id="7" dur="500"/>
                                        <p:tgtEl>
                                          <p:spTgt spid="1229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290"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8701" y="381000"/>
            <a:ext cx="7886700" cy="1325563"/>
          </a:xfrm>
        </p:spPr>
        <p:txBody>
          <a:bodyPr>
            <a:normAutofit/>
          </a:bodyPr>
          <a:lstStyle/>
          <a:p>
            <a:r>
              <a:rPr lang="en-US" sz="3600" b="1" dirty="0">
                <a:effectLst/>
              </a:rPr>
              <a:t>The Conventional View of the “Difficult” Patient or Family</a:t>
            </a:r>
            <a:endParaRPr lang="en-US" sz="3600" dirty="0"/>
          </a:p>
        </p:txBody>
      </p:sp>
      <p:sp>
        <p:nvSpPr>
          <p:cNvPr id="3" name="Content Placeholder 2"/>
          <p:cNvSpPr>
            <a:spLocks noGrp="1"/>
          </p:cNvSpPr>
          <p:nvPr>
            <p:ph idx="1"/>
          </p:nvPr>
        </p:nvSpPr>
        <p:spPr>
          <a:xfrm>
            <a:off x="0" y="2057400"/>
            <a:ext cx="8664102" cy="4495800"/>
          </a:xfrm>
        </p:spPr>
        <p:txBody>
          <a:bodyPr/>
          <a:lstStyle/>
          <a:p>
            <a:pPr lvl="1">
              <a:spcBef>
                <a:spcPts val="1200"/>
              </a:spcBef>
              <a:spcAft>
                <a:spcPts val="1200"/>
              </a:spcAft>
              <a:buClr>
                <a:srgbClr val="FFC000"/>
              </a:buClr>
              <a:buFont typeface="Wingdings" panose="05000000000000000000" pitchFamily="2" charset="2"/>
              <a:buChar char="Ø"/>
            </a:pPr>
            <a:r>
              <a:rPr lang="en-US" sz="2400" dirty="0">
                <a:effectLst/>
              </a:rPr>
              <a:t>Defines the problem exclusively from the physician’s perspective  </a:t>
            </a:r>
          </a:p>
          <a:p>
            <a:pPr lvl="1">
              <a:spcBef>
                <a:spcPts val="1200"/>
              </a:spcBef>
              <a:spcAft>
                <a:spcPts val="1200"/>
              </a:spcAft>
              <a:buClr>
                <a:srgbClr val="FFC000"/>
              </a:buClr>
              <a:buFont typeface="Wingdings" panose="05000000000000000000" pitchFamily="2" charset="2"/>
              <a:buChar char="Ø"/>
            </a:pPr>
            <a:r>
              <a:rPr lang="en-US" sz="2400" dirty="0">
                <a:effectLst/>
              </a:rPr>
              <a:t>Cause </a:t>
            </a:r>
            <a:r>
              <a:rPr lang="en-US" sz="2400" b="1" dirty="0">
                <a:effectLst/>
                <a:cs typeface="Times New Roman"/>
              </a:rPr>
              <a:t>→</a:t>
            </a:r>
            <a:r>
              <a:rPr lang="en-US" sz="2400" dirty="0">
                <a:effectLst/>
              </a:rPr>
              <a:t> patient’s psychological problems or character flaws (</a:t>
            </a:r>
            <a:r>
              <a:rPr lang="en-US" sz="2400" dirty="0"/>
              <a:t>Haas et al 2005)</a:t>
            </a:r>
            <a:endParaRPr lang="en-US" sz="2400" dirty="0">
              <a:effectLst/>
            </a:endParaRPr>
          </a:p>
          <a:p>
            <a:pPr lvl="1">
              <a:spcBef>
                <a:spcPts val="1200"/>
              </a:spcBef>
              <a:spcAft>
                <a:spcPts val="1200"/>
              </a:spcAft>
              <a:buClr>
                <a:srgbClr val="FFC000"/>
              </a:buClr>
              <a:buFont typeface="Wingdings" panose="05000000000000000000" pitchFamily="2" charset="2"/>
              <a:buChar char="Ø"/>
            </a:pPr>
            <a:r>
              <a:rPr lang="en-US" sz="2400" dirty="0">
                <a:effectLst/>
              </a:rPr>
              <a:t>Common MD Hypothesis: “difficult” patient is caused by presence of a psychiatric disorder (</a:t>
            </a:r>
            <a:r>
              <a:rPr lang="en-US" sz="2400" dirty="0" err="1"/>
              <a:t>Wasan</a:t>
            </a:r>
            <a:r>
              <a:rPr lang="en-US" sz="2400" dirty="0"/>
              <a:t> 2005)</a:t>
            </a:r>
            <a:endParaRPr lang="en-US" sz="2400" dirty="0">
              <a:effectLst/>
            </a:endParaRPr>
          </a:p>
          <a:p>
            <a:pPr lvl="1">
              <a:buClr>
                <a:srgbClr val="FFC000"/>
              </a:buClr>
              <a:buFont typeface="Wingdings" panose="05000000000000000000" pitchFamily="2" charset="2"/>
              <a:buChar char="Ø"/>
            </a:pPr>
            <a:endParaRPr lang="en-US" sz="3200" dirty="0"/>
          </a:p>
        </p:txBody>
      </p:sp>
    </p:spTree>
    <p:extLst>
      <p:ext uri="{BB962C8B-B14F-4D97-AF65-F5344CB8AC3E}">
        <p14:creationId xmlns:p14="http://schemas.microsoft.com/office/powerpoint/2010/main" val="135111408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338738"/>
            <a:ext cx="8839200" cy="1143000"/>
          </a:xfrm>
        </p:spPr>
        <p:txBody>
          <a:bodyPr/>
          <a:lstStyle/>
          <a:p>
            <a:r>
              <a:rPr lang="en-US" sz="3600" b="1" dirty="0">
                <a:effectLst/>
              </a:rPr>
              <a:t>Pushback from researchers on the conventional view of the “difficult” patient</a:t>
            </a:r>
            <a:endParaRPr lang="en-US" sz="3600" dirty="0"/>
          </a:p>
        </p:txBody>
      </p:sp>
      <p:sp>
        <p:nvSpPr>
          <p:cNvPr id="3" name="Content Placeholder 2"/>
          <p:cNvSpPr>
            <a:spLocks noGrp="1"/>
          </p:cNvSpPr>
          <p:nvPr>
            <p:ph idx="1"/>
          </p:nvPr>
        </p:nvSpPr>
        <p:spPr>
          <a:xfrm>
            <a:off x="304800" y="1518237"/>
            <a:ext cx="8686800" cy="5187363"/>
          </a:xfrm>
        </p:spPr>
        <p:txBody>
          <a:bodyPr>
            <a:normAutofit/>
          </a:bodyPr>
          <a:lstStyle/>
          <a:p>
            <a:pPr>
              <a:spcAft>
                <a:spcPts val="600"/>
              </a:spcAft>
              <a:buClr>
                <a:srgbClr val="FFC000"/>
              </a:buClr>
              <a:buSzPct val="106000"/>
              <a:buFont typeface="Wingdings" panose="05000000000000000000" pitchFamily="2" charset="2"/>
              <a:buChar char="§"/>
            </a:pPr>
            <a:r>
              <a:rPr lang="en-US" sz="2400" dirty="0" err="1">
                <a:effectLst/>
              </a:rPr>
              <a:t>Gunderman</a:t>
            </a:r>
            <a:r>
              <a:rPr lang="en-US" sz="2400" dirty="0">
                <a:effectLst/>
              </a:rPr>
              <a:t> &amp; </a:t>
            </a:r>
            <a:r>
              <a:rPr lang="en-US" sz="2400" dirty="0" err="1">
                <a:effectLst/>
              </a:rPr>
              <a:t>Gunderman</a:t>
            </a:r>
            <a:r>
              <a:rPr lang="en-US" sz="2400" dirty="0">
                <a:effectLst/>
              </a:rPr>
              <a:t> 2017: labeling a patient as ‘difficult’ "warns us that we are perceiving neither the patient nor our calling in the proper light" </a:t>
            </a:r>
          </a:p>
          <a:p>
            <a:pPr>
              <a:spcAft>
                <a:spcPts val="600"/>
              </a:spcAft>
              <a:buClr>
                <a:srgbClr val="FFC000"/>
              </a:buClr>
              <a:buSzPct val="106000"/>
              <a:buFont typeface="Wingdings" panose="05000000000000000000" pitchFamily="2" charset="2"/>
              <a:buChar char="§"/>
            </a:pPr>
            <a:r>
              <a:rPr lang="en-US" sz="2400" dirty="0">
                <a:effectLst/>
              </a:rPr>
              <a:t>Elder, Rice, and Tobias 2006: physicians labeling patient as ‘difficult’ need to "check their own attitudes and recognize their own biases“</a:t>
            </a:r>
          </a:p>
          <a:p>
            <a:pPr>
              <a:spcAft>
                <a:spcPts val="600"/>
              </a:spcAft>
              <a:buClr>
                <a:srgbClr val="FFC000"/>
              </a:buClr>
              <a:buSzPct val="106000"/>
              <a:buFont typeface="Wingdings" panose="05000000000000000000" pitchFamily="2" charset="2"/>
              <a:buChar char="§"/>
            </a:pPr>
            <a:r>
              <a:rPr lang="en-US" sz="2400" dirty="0">
                <a:effectLst/>
              </a:rPr>
              <a:t>Blackall &amp; Green 2012: “We all have blind spots that contribute to the escalating cycle of behavior“</a:t>
            </a:r>
          </a:p>
          <a:p>
            <a:pPr>
              <a:spcAft>
                <a:spcPts val="600"/>
              </a:spcAft>
              <a:buClr>
                <a:srgbClr val="FFC000"/>
              </a:buClr>
              <a:buSzPct val="106000"/>
              <a:buFont typeface="Wingdings" panose="05000000000000000000" pitchFamily="2" charset="2"/>
              <a:buChar char="§"/>
            </a:pPr>
            <a:r>
              <a:rPr lang="en-US" sz="2400" dirty="0" err="1">
                <a:effectLst/>
              </a:rPr>
              <a:t>Strous</a:t>
            </a:r>
            <a:r>
              <a:rPr lang="en-US" sz="2400" dirty="0">
                <a:effectLst/>
              </a:rPr>
              <a:t>, Ulman, Kotler 2006: "An understanding of the patient will lead to improved physician well-being and satisfaction, less self-destructive patient behavior, improve treatment compliance and a lower risk of litigation“</a:t>
            </a:r>
          </a:p>
          <a:p>
            <a:pPr>
              <a:spcAft>
                <a:spcPts val="600"/>
              </a:spcAft>
              <a:buClr>
                <a:srgbClr val="FFC000"/>
              </a:buClr>
              <a:buSzPct val="106000"/>
              <a:buFont typeface="Wingdings" panose="05000000000000000000" pitchFamily="2" charset="2"/>
              <a:buChar char="§"/>
            </a:pPr>
            <a:r>
              <a:rPr lang="en-US" sz="2400" dirty="0"/>
              <a:t>Fiester 2012: </a:t>
            </a:r>
            <a:r>
              <a:rPr lang="en-US" sz="2400" dirty="0">
                <a:effectLst/>
                <a:ea typeface="Calibri" panose="020F0502020204030204" pitchFamily="34" charset="0"/>
              </a:rPr>
              <a:t>a “reconceived view of the ‘difficult</a:t>
            </a:r>
            <a:r>
              <a:rPr lang="en-US" sz="2400" dirty="0">
                <a:ea typeface="Calibri" panose="020F0502020204030204" pitchFamily="34" charset="0"/>
              </a:rPr>
              <a:t>’</a:t>
            </a:r>
            <a:r>
              <a:rPr lang="en-US" sz="2400" dirty="0">
                <a:effectLst/>
                <a:ea typeface="Calibri" panose="020F0502020204030204" pitchFamily="34" charset="0"/>
              </a:rPr>
              <a:t> patient” focuses on “the fractured patient-provider relationship”</a:t>
            </a:r>
            <a:endParaRPr lang="en-US" sz="2400" dirty="0">
              <a:effectLst/>
            </a:endParaRPr>
          </a:p>
          <a:p>
            <a:pPr>
              <a:buClr>
                <a:srgbClr val="FFC000"/>
              </a:buClr>
              <a:buSzPct val="106000"/>
              <a:buFont typeface="Wingdings" panose="05000000000000000000" pitchFamily="2" charset="2"/>
              <a:buChar char="§"/>
            </a:pPr>
            <a:endParaRPr lang="en-US" sz="2400" dirty="0">
              <a:effectLst/>
            </a:endParaRPr>
          </a:p>
        </p:txBody>
      </p:sp>
    </p:spTree>
    <p:extLst>
      <p:ext uri="{BB962C8B-B14F-4D97-AF65-F5344CB8AC3E}">
        <p14:creationId xmlns:p14="http://schemas.microsoft.com/office/powerpoint/2010/main" val="179324321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338738"/>
            <a:ext cx="8839200" cy="1143000"/>
          </a:xfrm>
        </p:spPr>
        <p:txBody>
          <a:bodyPr/>
          <a:lstStyle/>
          <a:p>
            <a:r>
              <a:rPr lang="en-US" sz="3600" b="1" dirty="0">
                <a:effectLst/>
              </a:rPr>
              <a:t>Pushback from researchers on the conventional view of the “difficult” patient</a:t>
            </a:r>
            <a:endParaRPr lang="en-US" sz="3600" dirty="0"/>
          </a:p>
        </p:txBody>
      </p:sp>
      <p:sp>
        <p:nvSpPr>
          <p:cNvPr id="3" name="Content Placeholder 2"/>
          <p:cNvSpPr>
            <a:spLocks noGrp="1"/>
          </p:cNvSpPr>
          <p:nvPr>
            <p:ph idx="1"/>
          </p:nvPr>
        </p:nvSpPr>
        <p:spPr>
          <a:xfrm>
            <a:off x="1600200" y="2057399"/>
            <a:ext cx="6096000" cy="4483633"/>
          </a:xfrm>
        </p:spPr>
        <p:txBody>
          <a:bodyPr>
            <a:normAutofit/>
          </a:bodyPr>
          <a:lstStyle/>
          <a:p>
            <a:pPr>
              <a:buClr>
                <a:srgbClr val="FFC000"/>
              </a:buClr>
              <a:buSzPct val="106000"/>
              <a:buFont typeface="Wingdings" panose="05000000000000000000" pitchFamily="2" charset="2"/>
              <a:buChar char="Ø"/>
            </a:pPr>
            <a:r>
              <a:rPr lang="en-US" sz="2800" dirty="0">
                <a:effectLst/>
              </a:rPr>
              <a:t>These researchers ask us to reconceive and reframe the "difficult" patient and family.</a:t>
            </a:r>
          </a:p>
          <a:p>
            <a:pPr marL="0" indent="0" algn="ctr">
              <a:buClr>
                <a:srgbClr val="FFC000"/>
              </a:buClr>
              <a:buSzPct val="106000"/>
              <a:buNone/>
            </a:pPr>
            <a:endParaRPr lang="en-US" sz="2800" dirty="0"/>
          </a:p>
          <a:p>
            <a:pPr marL="0" indent="0" algn="ctr">
              <a:buClr>
                <a:srgbClr val="FFC000"/>
              </a:buClr>
              <a:buSzPct val="106000"/>
              <a:buNone/>
            </a:pPr>
            <a:r>
              <a:rPr lang="en-US" sz="3200" dirty="0">
                <a:effectLst/>
              </a:rPr>
              <a:t>How?</a:t>
            </a:r>
          </a:p>
        </p:txBody>
      </p:sp>
    </p:spTree>
    <p:extLst>
      <p:ext uri="{BB962C8B-B14F-4D97-AF65-F5344CB8AC3E}">
        <p14:creationId xmlns:p14="http://schemas.microsoft.com/office/powerpoint/2010/main" val="64976223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0" name="Rectangle 2"/>
          <p:cNvSpPr>
            <a:spLocks noGrp="1" noChangeArrowheads="1"/>
          </p:cNvSpPr>
          <p:nvPr>
            <p:ph type="ctrTitle"/>
          </p:nvPr>
        </p:nvSpPr>
        <p:spPr>
          <a:xfrm>
            <a:off x="228600" y="914400"/>
            <a:ext cx="8326413" cy="1295400"/>
          </a:xfrm>
        </p:spPr>
        <p:txBody>
          <a:bodyPr/>
          <a:lstStyle/>
          <a:p>
            <a:pPr eaLnBrk="1" hangingPunct="1">
              <a:lnSpc>
                <a:spcPct val="95000"/>
              </a:lnSpc>
              <a:spcAft>
                <a:spcPct val="10000"/>
              </a:spcAft>
              <a:defRPr/>
            </a:pPr>
            <a:r>
              <a:rPr lang="en-US" sz="6000" dirty="0">
                <a:effectLst>
                  <a:outerShdw blurRad="38100" dist="38100" dir="2700000" algn="tl">
                    <a:srgbClr val="000000">
                      <a:alpha val="43137"/>
                    </a:srgbClr>
                  </a:outerShdw>
                </a:effectLst>
              </a:rPr>
              <a:t>The Mediator’s Toolbox</a:t>
            </a:r>
          </a:p>
        </p:txBody>
      </p:sp>
      <p:sp>
        <p:nvSpPr>
          <p:cNvPr id="2" name="TextBox 1"/>
          <p:cNvSpPr txBox="1"/>
          <p:nvPr/>
        </p:nvSpPr>
        <p:spPr>
          <a:xfrm>
            <a:off x="1143000" y="5029200"/>
            <a:ext cx="7239000" cy="1447800"/>
          </a:xfrm>
          <a:prstGeom prst="rect">
            <a:avLst/>
          </a:prstGeom>
          <a:noFill/>
        </p:spPr>
        <p:txBody>
          <a:bodyPr wrap="square" rtlCol="0">
            <a:spAutoFit/>
          </a:bodyPr>
          <a:lstStyle/>
          <a:p>
            <a:endParaRPr lang="en-US" dirty="0"/>
          </a:p>
        </p:txBody>
      </p:sp>
      <p:sp>
        <p:nvSpPr>
          <p:cNvPr id="4" name="TextBox 3"/>
          <p:cNvSpPr txBox="1"/>
          <p:nvPr/>
        </p:nvSpPr>
        <p:spPr>
          <a:xfrm>
            <a:off x="1143000" y="2819400"/>
            <a:ext cx="6858000" cy="2246769"/>
          </a:xfrm>
          <a:prstGeom prst="rect">
            <a:avLst/>
          </a:prstGeom>
          <a:noFill/>
        </p:spPr>
        <p:txBody>
          <a:bodyPr wrap="square" rtlCol="0">
            <a:spAutoFit/>
          </a:bodyPr>
          <a:lstStyle/>
          <a:p>
            <a:pPr marL="231775" indent="-231775">
              <a:buFont typeface="Arial" panose="020B0604020202020204" pitchFamily="34" charset="0"/>
              <a:buChar char="•"/>
            </a:pPr>
            <a:r>
              <a:rPr lang="en-US" sz="2800" dirty="0"/>
              <a:t>Strategies for Diagnosing the Problem: the View from Everywhere</a:t>
            </a:r>
          </a:p>
          <a:p>
            <a:pPr marL="231775" indent="-231775">
              <a:buFont typeface="Arial" panose="020B0604020202020204" pitchFamily="34" charset="0"/>
              <a:buChar char="•"/>
            </a:pPr>
            <a:r>
              <a:rPr lang="en-US" sz="2800" dirty="0"/>
              <a:t>Strategies for Understanding the Underlying Reasons for the Conflict: Positions vs. Interests</a:t>
            </a:r>
          </a:p>
        </p:txBody>
      </p:sp>
    </p:spTree>
    <p:extLst>
      <p:ext uri="{BB962C8B-B14F-4D97-AF65-F5344CB8AC3E}">
        <p14:creationId xmlns:p14="http://schemas.microsoft.com/office/powerpoint/2010/main" val="328084652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140290" name="Rectangle 2"/>
          <p:cNvSpPr>
            <a:spLocks noGrp="1" noChangeArrowheads="1"/>
          </p:cNvSpPr>
          <p:nvPr>
            <p:ph type="title"/>
          </p:nvPr>
        </p:nvSpPr>
        <p:spPr>
          <a:xfrm>
            <a:off x="217714" y="152400"/>
            <a:ext cx="7467600" cy="914400"/>
          </a:xfrm>
        </p:spPr>
        <p:txBody>
          <a:bodyPr/>
          <a:lstStyle/>
          <a:p>
            <a:pPr eaLnBrk="1" hangingPunct="1">
              <a:defRPr/>
            </a:pPr>
            <a:r>
              <a:rPr lang="en-US" sz="3600" dirty="0">
                <a:solidFill>
                  <a:schemeClr val="tx2">
                    <a:lumMod val="75000"/>
                  </a:schemeClr>
                </a:solidFill>
              </a:rPr>
              <a:t>Case Study: Fred</a:t>
            </a:r>
          </a:p>
        </p:txBody>
      </p:sp>
      <p:sp>
        <p:nvSpPr>
          <p:cNvPr id="140291" name="Rectangle 3"/>
          <p:cNvSpPr>
            <a:spLocks noGrp="1" noChangeArrowheads="1"/>
          </p:cNvSpPr>
          <p:nvPr>
            <p:ph idx="1"/>
          </p:nvPr>
        </p:nvSpPr>
        <p:spPr>
          <a:xfrm>
            <a:off x="114300" y="1524000"/>
            <a:ext cx="8915400" cy="5638800"/>
          </a:xfrm>
        </p:spPr>
        <p:txBody>
          <a:bodyPr/>
          <a:lstStyle/>
          <a:p>
            <a:r>
              <a:rPr lang="en-US" sz="2200" dirty="0">
                <a:effectLst/>
              </a:rPr>
              <a:t>Fred is a 16-year-old with an incomplete C-4 injury to his spinal cord as the result of a gunshot wound. He is currently unable to move his arms or legs, though he does have sensation in his lower extremities. Before his injury, Fred attended school intermittently and was on probation for heroin possession. Fred was admitted to an in-patient rehabilitation unit after two weeks in acute care. His mother is unable to visit during the week because of her work schedule and the patient’s only other living relative is an elderly grandmother who is homebound. Since he has come to the rehab hospital, Fred has been verbally abusive to staff. His cursing, often loud, distresses the other patients, as well as the physicians and other staff. Fred often complains of pain and screams loudly when moved, though his physicians insist he is on the highest dose of narcotics that they feel comfortable prescribing. Because of Fred’s language and derogatory comments, both physicians and nurses are starting to refuse to work with him. </a:t>
            </a:r>
          </a:p>
        </p:txBody>
      </p:sp>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140291">
                                            <p:txEl>
                                              <p:pRg st="0" end="0"/>
                                            </p:txEl>
                                          </p:spTgt>
                                        </p:tgtEl>
                                        <p:attrNameLst>
                                          <p:attrName>style.visibility</p:attrName>
                                        </p:attrNameLst>
                                      </p:cBhvr>
                                      <p:to>
                                        <p:strVal val="visible"/>
                                      </p:to>
                                    </p:set>
                                    <p:animEffect transition="in" filter="fade">
                                      <p:cBhvr>
                                        <p:cTn id="7" dur="1000"/>
                                        <p:tgtEl>
                                          <p:spTgt spid="140291">
                                            <p:txEl>
                                              <p:pRg st="0" end="0"/>
                                            </p:txEl>
                                          </p:spTgt>
                                        </p:tgtEl>
                                      </p:cBhvr>
                                    </p:animEffect>
                                    <p:anim calcmode="lin" valueType="num">
                                      <p:cBhvr>
                                        <p:cTn id="8" dur="1000" fill="hold"/>
                                        <p:tgtEl>
                                          <p:spTgt spid="140291">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140291">
                                            <p:txEl>
                                              <p:pRg st="0" end="0"/>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0291" grpId="0" build="p"/>
    </p:bldLst>
  </p:timing>
</p:sld>
</file>

<file path=ppt/theme/theme1.xml><?xml version="1.0" encoding="utf-8"?>
<a:theme xmlns:a="http://schemas.openxmlformats.org/drawingml/2006/main" name="Office Theme">
  <a:themeElements>
    <a:clrScheme name="Grayscale">
      <a:dk1>
        <a:sysClr val="windowText" lastClr="000000"/>
      </a:dk1>
      <a:lt1>
        <a:sysClr val="window" lastClr="FFFFFF"/>
      </a:lt1>
      <a:dk2>
        <a:srgbClr val="000000"/>
      </a:dk2>
      <a:lt2>
        <a:srgbClr val="F8F8F8"/>
      </a:lt2>
      <a:accent1>
        <a:srgbClr val="DDDDDD"/>
      </a:accent1>
      <a:accent2>
        <a:srgbClr val="B2B2B2"/>
      </a:accent2>
      <a:accent3>
        <a:srgbClr val="969696"/>
      </a:accent3>
      <a:accent4>
        <a:srgbClr val="808080"/>
      </a:accent4>
      <a:accent5>
        <a:srgbClr val="5F5F5F"/>
      </a:accent5>
      <a:accent6>
        <a:srgbClr val="4D4D4D"/>
      </a:accent6>
      <a:hlink>
        <a:srgbClr val="5F5F5F"/>
      </a:hlink>
      <a:folHlink>
        <a:srgbClr val="919191"/>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6" ma:contentTypeDescription="Create a new document." ma:contentTypeScope="" ma:versionID="039c42e940a96e8ec4231216ac41c477">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7709120448ce3e536fad73b794f9b1fe"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A4DB58EB-0997-4E0A-A986-54F48767A39F}">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B3A4984F-C85D-4346-9604-13FADF8E60F4}">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
  <TotalTime>23534</TotalTime>
  <Words>6155</Words>
  <Application>Microsoft Office PowerPoint</Application>
  <PresentationFormat>On-screen Show (4:3)</PresentationFormat>
  <Paragraphs>340</Paragraphs>
  <Slides>42</Slides>
  <Notes>42</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42</vt:i4>
      </vt:variant>
    </vt:vector>
  </HeadingPairs>
  <TitlesOfParts>
    <vt:vector size="50" baseType="lpstr">
      <vt:lpstr>Arial</vt:lpstr>
      <vt:lpstr>Calibri</vt:lpstr>
      <vt:lpstr>Calibri Light</vt:lpstr>
      <vt:lpstr>Century Gothic</vt:lpstr>
      <vt:lpstr>Roboto</vt:lpstr>
      <vt:lpstr>Tahoma</vt:lpstr>
      <vt:lpstr>Wingdings</vt:lpstr>
      <vt:lpstr>Office Theme</vt:lpstr>
      <vt:lpstr>Using the Mediator's Toolbox: Reducing Clinical Conflict by Learning to Reconceive the "Difficult" Patient or Family </vt:lpstr>
      <vt:lpstr>Learning Objectives</vt:lpstr>
      <vt:lpstr>Stage Setting: The "Difficult" Patient </vt:lpstr>
      <vt:lpstr>The Problem of Working with “Difficult” Patients &amp; Families</vt:lpstr>
      <vt:lpstr>The Conventional View of the “Difficult” Patient or Family</vt:lpstr>
      <vt:lpstr>Pushback from researchers on the conventional view of the “difficult” patient</vt:lpstr>
      <vt:lpstr>Pushback from researchers on the conventional view of the “difficult” patient</vt:lpstr>
      <vt:lpstr>The Mediator’s Toolbox</vt:lpstr>
      <vt:lpstr>Case Study: Fred</vt:lpstr>
      <vt:lpstr>The Mediator’s Toolbox</vt:lpstr>
      <vt:lpstr>The team might say: “The problem is Fred. Fred is difficult.”</vt:lpstr>
      <vt:lpstr>Strategy for Diagnosing        the Problem</vt:lpstr>
      <vt:lpstr>The team might say: “The problem is Fred. Fred is difficult.”</vt:lpstr>
      <vt:lpstr>Strategy for Diagnosing        the Problem</vt:lpstr>
      <vt:lpstr>Strategy for Diagnosing        the Problem</vt:lpstr>
      <vt:lpstr>Strategy for Diagnosing        the Problem</vt:lpstr>
      <vt:lpstr>Strategy for Diagnosing        the Problem</vt:lpstr>
      <vt:lpstr>Strategy for Diagnosing        the Problem</vt:lpstr>
      <vt:lpstr>Mediators use analytical empathy to pursue the View from Everywhere</vt:lpstr>
      <vt:lpstr>Strategy for Diagnosing        the Problem</vt:lpstr>
      <vt:lpstr>Pursing the View from Everywhere: What might the staff’s perspective be on the problem?</vt:lpstr>
      <vt:lpstr>Pursing the View from Everywhere: What might the Fred’s perspective be on the problem?</vt:lpstr>
      <vt:lpstr>Strategy for Diagnosing        the Problem</vt:lpstr>
      <vt:lpstr>Case Study: Mr. Roberts</vt:lpstr>
      <vt:lpstr>Strategy for Diagnosing  the Problem</vt:lpstr>
      <vt:lpstr>The Mediator’s Toolbox</vt:lpstr>
      <vt:lpstr>The Mediator’s Toolbox</vt:lpstr>
      <vt:lpstr>Strategy for Uncovering  Interests</vt:lpstr>
      <vt:lpstr>Strategy for Uncovering  Interests</vt:lpstr>
      <vt:lpstr>Strategy for Uncovering  Interests</vt:lpstr>
      <vt:lpstr>Strategy for Uncovering  Interests</vt:lpstr>
      <vt:lpstr>Strategy for Uncovering  Interests</vt:lpstr>
      <vt:lpstr>Strategy for Uncovering  Interests</vt:lpstr>
      <vt:lpstr>Strategy for Uncovering  Interests</vt:lpstr>
      <vt:lpstr>Strategy for Uncovering  Interests</vt:lpstr>
      <vt:lpstr>Searching for the staff’s interests…</vt:lpstr>
      <vt:lpstr>Strategy for Uncovering  Interests</vt:lpstr>
      <vt:lpstr>Searching for Fred’s interests…</vt:lpstr>
      <vt:lpstr>Strategy for Uncovering  Interests</vt:lpstr>
      <vt:lpstr>Case Study: Mr. Roberts</vt:lpstr>
      <vt:lpstr>Takeaways for Reducing Clinical Conflict</vt:lpstr>
      <vt:lpstr>Works Cited</vt:lpstr>
    </vt:vector>
  </TitlesOfParts>
  <Company>University of Pennsylvani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thical Issues in Animal Cloning</dc:title>
  <dc:creator>Autumn Fiester</dc:creator>
  <cp:lastModifiedBy>Charles Rhoads</cp:lastModifiedBy>
  <cp:revision>657</cp:revision>
  <cp:lastPrinted>2022-09-24T16:18:55Z</cp:lastPrinted>
  <dcterms:created xsi:type="dcterms:W3CDTF">2003-11-15T04:30:07Z</dcterms:created>
  <dcterms:modified xsi:type="dcterms:W3CDTF">2023-04-18T15:13:41Z</dcterms:modified>
</cp:coreProperties>
</file>